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0" r:id="rId3"/>
    <p:sldId id="257" r:id="rId4"/>
    <p:sldId id="258" r:id="rId5"/>
    <p:sldId id="259" r:id="rId6"/>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C7853C-536D-4A76-A0AE-DD22124D55A5}" styleName="主题样式 1 - 强调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83" d="100"/>
          <a:sy n="83" d="100"/>
        </p:scale>
        <p:origin x="389"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C:\Users\nhkj_020\Desktop\project\songhongyun_results\reho\27&#26465;&#26102;&#38388;&#24207;&#21015;&#26354;&#32447;.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nhkj_020\Desktop\project\songhongyun_results\reho\27&#26465;&#26102;&#38388;&#24207;&#21015;&#26354;&#32447;.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nhkj_020\Desktop\project\songhongyun_results\reho\27&#26465;&#26102;&#38388;&#24207;&#21015;&#26354;&#32447;.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lumMod val="65000"/>
                    <a:lumOff val="35000"/>
                  </a:schemeClr>
                </a:solidFill>
                <a:latin typeface="+mn-lt"/>
                <a:ea typeface="+mn-ea"/>
                <a:cs typeface="+mn-cs"/>
              </a:defRPr>
            </a:pPr>
            <a:r>
              <a:rPr lang="en-US" altLang="zh-CN" b="1" dirty="0" err="1">
                <a:latin typeface="Times New Roman" panose="02020603050405020304" pitchFamily="18" charset="0"/>
                <a:ea typeface="宋体" panose="02010600030101010101" pitchFamily="2" charset="-122"/>
                <a:cs typeface="Times New Roman" panose="02020603050405020304" pitchFamily="18" charset="0"/>
              </a:rPr>
              <a:t>ReHo</a:t>
            </a:r>
            <a:r>
              <a:rPr lang="en-US" altLang="zh-CN" b="1" baseline="0" dirty="0">
                <a:latin typeface="Times New Roman" panose="02020603050405020304" pitchFamily="18" charset="0"/>
                <a:ea typeface="宋体" panose="02010600030101010101" pitchFamily="2" charset="-122"/>
                <a:cs typeface="Times New Roman" panose="02020603050405020304" pitchFamily="18" charset="0"/>
              </a:rPr>
              <a:t> time series plots for one subject in cp group</a:t>
            </a:r>
            <a:endParaRPr lang="zh-CN" altLang="en-US" b="1" dirty="0">
              <a:latin typeface="Times New Roman" panose="02020603050405020304" pitchFamily="18" charset="0"/>
              <a:ea typeface="宋体" panose="02010600030101010101" pitchFamily="2" charset="-122"/>
              <a:cs typeface="Times New Roman" panose="02020603050405020304" pitchFamily="18" charset="0"/>
            </a:endParaRPr>
          </a:p>
        </c:rich>
      </c:tx>
      <c:overlay val="0"/>
      <c:spPr>
        <a:noFill/>
        <a:ln>
          <a:noFill/>
        </a:ln>
        <a:effectLst/>
      </c:spPr>
      <c:txPr>
        <a:bodyPr rot="0" spcFirstLastPara="1" vertOverflow="ellipsis" vert="horz" wrap="square" anchor="ctr" anchorCtr="1"/>
        <a:lstStyle/>
        <a:p>
          <a:pPr>
            <a:defRPr sz="1400" b="1" i="0" u="none" strike="noStrike" kern="1200" spc="0" baseline="0">
              <a:solidFill>
                <a:schemeClr val="tx1">
                  <a:lumMod val="65000"/>
                  <a:lumOff val="35000"/>
                </a:schemeClr>
              </a:solidFill>
              <a:latin typeface="+mn-lt"/>
              <a:ea typeface="+mn-ea"/>
              <a:cs typeface="+mn-cs"/>
            </a:defRPr>
          </a:pPr>
          <a:endParaRPr lang="zh-CN"/>
        </a:p>
      </c:txPr>
    </c:title>
    <c:autoTitleDeleted val="0"/>
    <c:plotArea>
      <c:layout/>
      <c:scatterChart>
        <c:scatterStyle val="smoothMarker"/>
        <c:varyColors val="0"/>
        <c:ser>
          <c:idx val="0"/>
          <c:order val="0"/>
          <c:tx>
            <c:strRef>
              <c:f>cp_sub_001!$A$1</c:f>
              <c:strCache>
                <c:ptCount val="1"/>
                <c:pt idx="0">
                  <c:v>Coor_1</c:v>
                </c:pt>
              </c:strCache>
            </c:strRef>
          </c:tx>
          <c:spPr>
            <a:ln w="28575" cap="rnd">
              <a:solidFill>
                <a:schemeClr val="accent1"/>
              </a:solidFill>
              <a:round/>
            </a:ln>
            <a:effectLst/>
          </c:spPr>
          <c:marker>
            <c:symbol val="none"/>
          </c:marker>
          <c:yVal>
            <c:numRef>
              <c:f>cp_sub_001!$A$2:$A$351</c:f>
              <c:numCache>
                <c:formatCode>0.00000000000_ </c:formatCode>
                <c:ptCount val="350"/>
                <c:pt idx="0">
                  <c:v>7264.90478515625</c:v>
                </c:pt>
                <c:pt idx="1">
                  <c:v>7269.71142578125</c:v>
                </c:pt>
                <c:pt idx="2">
                  <c:v>7253.43603515625</c:v>
                </c:pt>
                <c:pt idx="3">
                  <c:v>7226.52783203125</c:v>
                </c:pt>
                <c:pt idx="4">
                  <c:v>7205.2412109375</c:v>
                </c:pt>
                <c:pt idx="5">
                  <c:v>7201.12646484375</c:v>
                </c:pt>
                <c:pt idx="6">
                  <c:v>7213.4375</c:v>
                </c:pt>
                <c:pt idx="7">
                  <c:v>7229.5224609375</c:v>
                </c:pt>
                <c:pt idx="8">
                  <c:v>7233.04150390625</c:v>
                </c:pt>
                <c:pt idx="9">
                  <c:v>7214.8369140625</c:v>
                </c:pt>
                <c:pt idx="10">
                  <c:v>7179.63037109375</c:v>
                </c:pt>
                <c:pt idx="11">
                  <c:v>7144.32421875</c:v>
                </c:pt>
                <c:pt idx="12">
                  <c:v>7128.73388671875</c:v>
                </c:pt>
                <c:pt idx="13">
                  <c:v>7144.04052734375</c:v>
                </c:pt>
                <c:pt idx="14">
                  <c:v>7185.609375</c:v>
                </c:pt>
                <c:pt idx="15">
                  <c:v>7234.45556640625</c:v>
                </c:pt>
                <c:pt idx="16">
                  <c:v>7266.8828125</c:v>
                </c:pt>
                <c:pt idx="17">
                  <c:v>7267.21142578125</c:v>
                </c:pt>
                <c:pt idx="18">
                  <c:v>7236.541015625</c:v>
                </c:pt>
                <c:pt idx="19">
                  <c:v>7192.33154296875</c:v>
                </c:pt>
                <c:pt idx="20">
                  <c:v>7158.6103515625</c:v>
                </c:pt>
                <c:pt idx="21">
                  <c:v>7152.11572265625</c:v>
                </c:pt>
                <c:pt idx="22">
                  <c:v>7172.49609375</c:v>
                </c:pt>
                <c:pt idx="23">
                  <c:v>7202.73876953125</c:v>
                </c:pt>
                <c:pt idx="24">
                  <c:v>7219.97998046875</c:v>
                </c:pt>
                <c:pt idx="25">
                  <c:v>7210.27587890625</c:v>
                </c:pt>
                <c:pt idx="26">
                  <c:v>7178.01806640625</c:v>
                </c:pt>
                <c:pt idx="27">
                  <c:v>7143.7236328125</c:v>
                </c:pt>
                <c:pt idx="28">
                  <c:v>7131.28515625</c:v>
                </c:pt>
                <c:pt idx="29">
                  <c:v>7152.6923828125</c:v>
                </c:pt>
                <c:pt idx="30">
                  <c:v>7200.05419921875</c:v>
                </c:pt>
                <c:pt idx="31">
                  <c:v>7250.01806640625</c:v>
                </c:pt>
                <c:pt idx="32">
                  <c:v>7277.6015625</c:v>
                </c:pt>
                <c:pt idx="33">
                  <c:v>7270.47412109375</c:v>
                </c:pt>
                <c:pt idx="34">
                  <c:v>7234.8681640625</c:v>
                </c:pt>
                <c:pt idx="35">
                  <c:v>7190.27978515625</c:v>
                </c:pt>
                <c:pt idx="36">
                  <c:v>7157.43505859375</c:v>
                </c:pt>
                <c:pt idx="37">
                  <c:v>7147.69970703125</c:v>
                </c:pt>
                <c:pt idx="38">
                  <c:v>7159.92626953125</c:v>
                </c:pt>
                <c:pt idx="39">
                  <c:v>7184.9072265625</c:v>
                </c:pt>
                <c:pt idx="40">
                  <c:v>7212.6943359375</c:v>
                </c:pt>
                <c:pt idx="41">
                  <c:v>7237.30517578125</c:v>
                </c:pt>
                <c:pt idx="42">
                  <c:v>7256.69091796875</c:v>
                </c:pt>
                <c:pt idx="43">
                  <c:v>7269.9208984375</c:v>
                </c:pt>
                <c:pt idx="44">
                  <c:v>7275.16796875</c:v>
                </c:pt>
                <c:pt idx="45">
                  <c:v>7270.32861328125</c:v>
                </c:pt>
                <c:pt idx="46">
                  <c:v>7255.16748046875</c:v>
                </c:pt>
                <c:pt idx="47">
                  <c:v>7232.46533203125</c:v>
                </c:pt>
                <c:pt idx="48">
                  <c:v>7206.93359375</c:v>
                </c:pt>
                <c:pt idx="49">
                  <c:v>7183.05810546875</c:v>
                </c:pt>
                <c:pt idx="50">
                  <c:v>7164.04296875</c:v>
                </c:pt>
                <c:pt idx="51">
                  <c:v>7152.64013671875</c:v>
                </c:pt>
                <c:pt idx="52">
                  <c:v>7152.236328125</c:v>
                </c:pt>
                <c:pt idx="53">
                  <c:v>7165.7861328125</c:v>
                </c:pt>
                <c:pt idx="54">
                  <c:v>7192.208984375</c:v>
                </c:pt>
                <c:pt idx="55">
                  <c:v>7223.13134765625</c:v>
                </c:pt>
                <c:pt idx="56">
                  <c:v>7244.09619140625</c:v>
                </c:pt>
                <c:pt idx="57">
                  <c:v>7241.70068359375</c:v>
                </c:pt>
                <c:pt idx="58">
                  <c:v>7213.015625</c:v>
                </c:pt>
                <c:pt idx="59">
                  <c:v>7170.28369140625</c:v>
                </c:pt>
                <c:pt idx="60">
                  <c:v>7135.8291015625</c:v>
                </c:pt>
                <c:pt idx="61">
                  <c:v>7128.82763671875</c:v>
                </c:pt>
                <c:pt idx="62">
                  <c:v>7152.40087890625</c:v>
                </c:pt>
                <c:pt idx="63">
                  <c:v>7190.69970703125</c:v>
                </c:pt>
                <c:pt idx="64">
                  <c:v>7219.31201171875</c:v>
                </c:pt>
                <c:pt idx="65">
                  <c:v>7222.4609375</c:v>
                </c:pt>
                <c:pt idx="66">
                  <c:v>7204.5146484375</c:v>
                </c:pt>
                <c:pt idx="67">
                  <c:v>7186.49560546875</c:v>
                </c:pt>
                <c:pt idx="68">
                  <c:v>7189.1640625</c:v>
                </c:pt>
                <c:pt idx="69">
                  <c:v>7215.01025390625</c:v>
                </c:pt>
                <c:pt idx="70">
                  <c:v>7243.57763671875</c:v>
                </c:pt>
                <c:pt idx="71">
                  <c:v>7245.44189453125</c:v>
                </c:pt>
                <c:pt idx="72">
                  <c:v>7205.87353515625</c:v>
                </c:pt>
                <c:pt idx="73">
                  <c:v>7140.51953125</c:v>
                </c:pt>
                <c:pt idx="74">
                  <c:v>7089.68408203125</c:v>
                </c:pt>
                <c:pt idx="75">
                  <c:v>7092.86865234375</c:v>
                </c:pt>
                <c:pt idx="76">
                  <c:v>7160.4501953125</c:v>
                </c:pt>
                <c:pt idx="77">
                  <c:v>7263.07373046875</c:v>
                </c:pt>
                <c:pt idx="78">
                  <c:v>7347.8212890625</c:v>
                </c:pt>
                <c:pt idx="79">
                  <c:v>7371.25244140625</c:v>
                </c:pt>
                <c:pt idx="80">
                  <c:v>7326.7978515625</c:v>
                </c:pt>
                <c:pt idx="81">
                  <c:v>7247.43115234375</c:v>
                </c:pt>
                <c:pt idx="82">
                  <c:v>7181.9921875</c:v>
                </c:pt>
                <c:pt idx="83">
                  <c:v>7162.32177734375</c:v>
                </c:pt>
                <c:pt idx="84">
                  <c:v>7184.5732421875</c:v>
                </c:pt>
                <c:pt idx="85">
                  <c:v>7217.0478515625</c:v>
                </c:pt>
                <c:pt idx="86">
                  <c:v>7227.06005859375</c:v>
                </c:pt>
                <c:pt idx="87">
                  <c:v>7205.68798828125</c:v>
                </c:pt>
                <c:pt idx="88">
                  <c:v>7172.0205078125</c:v>
                </c:pt>
                <c:pt idx="89">
                  <c:v>7155.12109375</c:v>
                </c:pt>
                <c:pt idx="90">
                  <c:v>7169.24169921875</c:v>
                </c:pt>
                <c:pt idx="91">
                  <c:v>7202.32373046875</c:v>
                </c:pt>
                <c:pt idx="92">
                  <c:v>7226.43603515625</c:v>
                </c:pt>
                <c:pt idx="93">
                  <c:v>7220.9736328125</c:v>
                </c:pt>
                <c:pt idx="94">
                  <c:v>7189.552734375</c:v>
                </c:pt>
                <c:pt idx="95">
                  <c:v>7157.2255859375</c:v>
                </c:pt>
                <c:pt idx="96">
                  <c:v>7150.83935546875</c:v>
                </c:pt>
                <c:pt idx="97">
                  <c:v>7178.6572265625</c:v>
                </c:pt>
                <c:pt idx="98">
                  <c:v>7225.078125</c:v>
                </c:pt>
                <c:pt idx="99">
                  <c:v>7263.31689453125</c:v>
                </c:pt>
                <c:pt idx="100">
                  <c:v>7274.421875</c:v>
                </c:pt>
                <c:pt idx="101">
                  <c:v>7257.1865234375</c:v>
                </c:pt>
                <c:pt idx="102">
                  <c:v>7222.88525390625</c:v>
                </c:pt>
                <c:pt idx="103">
                  <c:v>7182.55908203125</c:v>
                </c:pt>
                <c:pt idx="104">
                  <c:v>7140.32861328125</c:v>
                </c:pt>
                <c:pt idx="105">
                  <c:v>7098.869140625</c:v>
                </c:pt>
                <c:pt idx="106">
                  <c:v>7069.7490234375</c:v>
                </c:pt>
                <c:pt idx="107">
                  <c:v>7074.7080078125</c:v>
                </c:pt>
                <c:pt idx="108">
                  <c:v>7131.29443359375</c:v>
                </c:pt>
                <c:pt idx="109">
                  <c:v>7232.07861328125</c:v>
                </c:pt>
                <c:pt idx="110">
                  <c:v>7336.60107421875</c:v>
                </c:pt>
                <c:pt idx="111">
                  <c:v>7388.71875</c:v>
                </c:pt>
                <c:pt idx="112">
                  <c:v>7352.203125</c:v>
                </c:pt>
                <c:pt idx="113">
                  <c:v>7239.9375</c:v>
                </c:pt>
                <c:pt idx="114">
                  <c:v>7112.54052734375</c:v>
                </c:pt>
                <c:pt idx="115">
                  <c:v>7042.85400390625</c:v>
                </c:pt>
                <c:pt idx="116">
                  <c:v>7068.794921875</c:v>
                </c:pt>
                <c:pt idx="117">
                  <c:v>7167.99560546875</c:v>
                </c:pt>
                <c:pt idx="118">
                  <c:v>7273.49267578125</c:v>
                </c:pt>
                <c:pt idx="119">
                  <c:v>7320.02490234375</c:v>
                </c:pt>
                <c:pt idx="120">
                  <c:v>7287.72509765625</c:v>
                </c:pt>
                <c:pt idx="121">
                  <c:v>7211.95849609375</c:v>
                </c:pt>
                <c:pt idx="122">
                  <c:v>7153.583984375</c:v>
                </c:pt>
                <c:pt idx="123">
                  <c:v>7153.3984375</c:v>
                </c:pt>
                <c:pt idx="124">
                  <c:v>7205.18408203125</c:v>
                </c:pt>
                <c:pt idx="125">
                  <c:v>7265.84423828125</c:v>
                </c:pt>
                <c:pt idx="126">
                  <c:v>7291.70849609375</c:v>
                </c:pt>
                <c:pt idx="127">
                  <c:v>7270.80419921875</c:v>
                </c:pt>
                <c:pt idx="128">
                  <c:v>7226.412109375</c:v>
                </c:pt>
                <c:pt idx="129">
                  <c:v>7192.12109375</c:v>
                </c:pt>
                <c:pt idx="130">
                  <c:v>7181.8369140625</c:v>
                </c:pt>
                <c:pt idx="131">
                  <c:v>7180.84716796875</c:v>
                </c:pt>
                <c:pt idx="132">
                  <c:v>7164.64404296875</c:v>
                </c:pt>
                <c:pt idx="133">
                  <c:v>7127.595703125</c:v>
                </c:pt>
                <c:pt idx="134">
                  <c:v>7094.69580078125</c:v>
                </c:pt>
                <c:pt idx="135">
                  <c:v>7103.990234375</c:v>
                </c:pt>
                <c:pt idx="136">
                  <c:v>7172.85400390625</c:v>
                </c:pt>
                <c:pt idx="137">
                  <c:v>7276.44775390625</c:v>
                </c:pt>
                <c:pt idx="138">
                  <c:v>7358.3916015625</c:v>
                </c:pt>
                <c:pt idx="139">
                  <c:v>7368.2177734375</c:v>
                </c:pt>
                <c:pt idx="140">
                  <c:v>7298.05419921875</c:v>
                </c:pt>
                <c:pt idx="141">
                  <c:v>7190.30419921875</c:v>
                </c:pt>
                <c:pt idx="142">
                  <c:v>7109.673828125</c:v>
                </c:pt>
                <c:pt idx="143">
                  <c:v>7099.78955078125</c:v>
                </c:pt>
                <c:pt idx="144">
                  <c:v>7155.857421875</c:v>
                </c:pt>
                <c:pt idx="145">
                  <c:v>7232.0537109375</c:v>
                </c:pt>
                <c:pt idx="146">
                  <c:v>7276.09814453125</c:v>
                </c:pt>
                <c:pt idx="147">
                  <c:v>7264.34619140625</c:v>
                </c:pt>
                <c:pt idx="148">
                  <c:v>7212.73046875</c:v>
                </c:pt>
                <c:pt idx="149">
                  <c:v>7158.95361328125</c:v>
                </c:pt>
                <c:pt idx="150">
                  <c:v>7132.79833984375</c:v>
                </c:pt>
                <c:pt idx="151">
                  <c:v>7137.86962890625</c:v>
                </c:pt>
                <c:pt idx="152">
                  <c:v>7156.15283203125</c:v>
                </c:pt>
                <c:pt idx="153">
                  <c:v>7167.66943359375</c:v>
                </c:pt>
                <c:pt idx="154">
                  <c:v>7167.033203125</c:v>
                </c:pt>
                <c:pt idx="155">
                  <c:v>7164.06591796875</c:v>
                </c:pt>
                <c:pt idx="156">
                  <c:v>7170.7724609375</c:v>
                </c:pt>
                <c:pt idx="157">
                  <c:v>7188.2939453125</c:v>
                </c:pt>
                <c:pt idx="158">
                  <c:v>7205.9765625</c:v>
                </c:pt>
                <c:pt idx="159">
                  <c:v>7212.6943359375</c:v>
                </c:pt>
                <c:pt idx="160">
                  <c:v>7209.17236328125</c:v>
                </c:pt>
                <c:pt idx="161">
                  <c:v>7209.154296875</c:v>
                </c:pt>
                <c:pt idx="162">
                  <c:v>7227.31494140625</c:v>
                </c:pt>
                <c:pt idx="163">
                  <c:v>7263.904296875</c:v>
                </c:pt>
                <c:pt idx="164">
                  <c:v>7299.7880859375</c:v>
                </c:pt>
                <c:pt idx="165">
                  <c:v>7307.57470703125</c:v>
                </c:pt>
                <c:pt idx="166">
                  <c:v>7271.447265625</c:v>
                </c:pt>
                <c:pt idx="167">
                  <c:v>7200.7861328125</c:v>
                </c:pt>
                <c:pt idx="168">
                  <c:v>7126.80078125</c:v>
                </c:pt>
                <c:pt idx="169">
                  <c:v>7083.9365234375</c:v>
                </c:pt>
                <c:pt idx="170">
                  <c:v>7089.046875</c:v>
                </c:pt>
                <c:pt idx="171">
                  <c:v>7132.75048828125</c:v>
                </c:pt>
                <c:pt idx="172">
                  <c:v>7188.25341796875</c:v>
                </c:pt>
                <c:pt idx="173">
                  <c:v>7230.3564453125</c:v>
                </c:pt>
                <c:pt idx="174">
                  <c:v>7250.68994140625</c:v>
                </c:pt>
                <c:pt idx="175">
                  <c:v>7258.97314453125</c:v>
                </c:pt>
                <c:pt idx="176">
                  <c:v>7270.87646484375</c:v>
                </c:pt>
                <c:pt idx="177">
                  <c:v>7292.74951171875</c:v>
                </c:pt>
                <c:pt idx="178">
                  <c:v>7315.07470703125</c:v>
                </c:pt>
                <c:pt idx="179">
                  <c:v>7319.41845703125</c:v>
                </c:pt>
                <c:pt idx="180">
                  <c:v>7293.32177734375</c:v>
                </c:pt>
                <c:pt idx="181">
                  <c:v>7241.71044921875</c:v>
                </c:pt>
                <c:pt idx="182">
                  <c:v>7185.99169921875</c:v>
                </c:pt>
                <c:pt idx="183">
                  <c:v>7151.0673828125</c:v>
                </c:pt>
                <c:pt idx="184">
                  <c:v>7149.349609375</c:v>
                </c:pt>
                <c:pt idx="185">
                  <c:v>7173.14404296875</c:v>
                </c:pt>
                <c:pt idx="186">
                  <c:v>7200.7822265625</c:v>
                </c:pt>
                <c:pt idx="187">
                  <c:v>7211.93603515625</c:v>
                </c:pt>
                <c:pt idx="188">
                  <c:v>7200.88720703125</c:v>
                </c:pt>
                <c:pt idx="189">
                  <c:v>7178.1142578125</c:v>
                </c:pt>
                <c:pt idx="190">
                  <c:v>7159.482421875</c:v>
                </c:pt>
                <c:pt idx="191">
                  <c:v>7151.94287109375</c:v>
                </c:pt>
                <c:pt idx="192">
                  <c:v>7147.60400390625</c:v>
                </c:pt>
                <c:pt idx="193">
                  <c:v>7131.5830078125</c:v>
                </c:pt>
                <c:pt idx="194">
                  <c:v>7097.806640625</c:v>
                </c:pt>
                <c:pt idx="195">
                  <c:v>7059.560546875</c:v>
                </c:pt>
                <c:pt idx="196">
                  <c:v>7044.5263671875</c:v>
                </c:pt>
                <c:pt idx="197">
                  <c:v>7075.77294921875</c:v>
                </c:pt>
                <c:pt idx="198">
                  <c:v>7152.08349609375</c:v>
                </c:pt>
                <c:pt idx="199">
                  <c:v>7243.36767578125</c:v>
                </c:pt>
                <c:pt idx="200">
                  <c:v>7306.88525390625</c:v>
                </c:pt>
                <c:pt idx="201">
                  <c:v>7314.43359375</c:v>
                </c:pt>
                <c:pt idx="202">
                  <c:v>7271.3984375</c:v>
                </c:pt>
                <c:pt idx="203">
                  <c:v>7213.3583984375</c:v>
                </c:pt>
                <c:pt idx="204">
                  <c:v>7181.9326171875</c:v>
                </c:pt>
                <c:pt idx="205">
                  <c:v>7196.8984375</c:v>
                </c:pt>
                <c:pt idx="206">
                  <c:v>7244.5029296875</c:v>
                </c:pt>
                <c:pt idx="207">
                  <c:v>7289.80029296875</c:v>
                </c:pt>
                <c:pt idx="208">
                  <c:v>7302.9931640625</c:v>
                </c:pt>
                <c:pt idx="209">
                  <c:v>7279.826171875</c:v>
                </c:pt>
                <c:pt idx="210">
                  <c:v>7241.595703125</c:v>
                </c:pt>
                <c:pt idx="211">
                  <c:v>7216.5947265625</c:v>
                </c:pt>
                <c:pt idx="212">
                  <c:v>7218.73486328125</c:v>
                </c:pt>
                <c:pt idx="213">
                  <c:v>7239.857421875</c:v>
                </c:pt>
                <c:pt idx="214">
                  <c:v>7259.9228515625</c:v>
                </c:pt>
                <c:pt idx="215">
                  <c:v>7264.599609375</c:v>
                </c:pt>
                <c:pt idx="216">
                  <c:v>7254.83544921875</c:v>
                </c:pt>
                <c:pt idx="217">
                  <c:v>7241.3818359375</c:v>
                </c:pt>
                <c:pt idx="218">
                  <c:v>7231.11572265625</c:v>
                </c:pt>
                <c:pt idx="219">
                  <c:v>7219.0849609375</c:v>
                </c:pt>
                <c:pt idx="220">
                  <c:v>7194.4345703125</c:v>
                </c:pt>
                <c:pt idx="221">
                  <c:v>7154.994140625</c:v>
                </c:pt>
                <c:pt idx="222">
                  <c:v>7116.35400390625</c:v>
                </c:pt>
                <c:pt idx="223">
                  <c:v>7104.94482421875</c:v>
                </c:pt>
                <c:pt idx="224">
                  <c:v>7138.28759765625</c:v>
                </c:pt>
                <c:pt idx="225">
                  <c:v>7207.58203125</c:v>
                </c:pt>
                <c:pt idx="226">
                  <c:v>7277.68359375</c:v>
                </c:pt>
                <c:pt idx="227">
                  <c:v>7306.76611328125</c:v>
                </c:pt>
                <c:pt idx="228">
                  <c:v>7272.68798828125</c:v>
                </c:pt>
                <c:pt idx="229">
                  <c:v>7187.5556640625</c:v>
                </c:pt>
                <c:pt idx="230">
                  <c:v>7090.54052734375</c:v>
                </c:pt>
                <c:pt idx="231">
                  <c:v>7024.66650390625</c:v>
                </c:pt>
                <c:pt idx="232">
                  <c:v>7013.76416015625</c:v>
                </c:pt>
                <c:pt idx="233">
                  <c:v>7053.73046875</c:v>
                </c:pt>
                <c:pt idx="234">
                  <c:v>7120.55615234375</c:v>
                </c:pt>
                <c:pt idx="235">
                  <c:v>7186.3388671875</c:v>
                </c:pt>
                <c:pt idx="236">
                  <c:v>7231.8818359375</c:v>
                </c:pt>
                <c:pt idx="237">
                  <c:v>7250.53125</c:v>
                </c:pt>
                <c:pt idx="238">
                  <c:v>7245.64990234375</c:v>
                </c:pt>
                <c:pt idx="239">
                  <c:v>7226.83837890625</c:v>
                </c:pt>
                <c:pt idx="240">
                  <c:v>7206.9169921875</c:v>
                </c:pt>
                <c:pt idx="241">
                  <c:v>7198.03369140625</c:v>
                </c:pt>
                <c:pt idx="242">
                  <c:v>7205.84765625</c:v>
                </c:pt>
                <c:pt idx="243">
                  <c:v>7224.96923828125</c:v>
                </c:pt>
                <c:pt idx="244">
                  <c:v>7241.1298828125</c:v>
                </c:pt>
                <c:pt idx="245">
                  <c:v>7241.576171875</c:v>
                </c:pt>
                <c:pt idx="246">
                  <c:v>7227.15673828125</c:v>
                </c:pt>
                <c:pt idx="247">
                  <c:v>7215.25146484375</c:v>
                </c:pt>
                <c:pt idx="248">
                  <c:v>7227.986328125</c:v>
                </c:pt>
                <c:pt idx="249">
                  <c:v>7272.55126953125</c:v>
                </c:pt>
                <c:pt idx="250">
                  <c:v>7329.57177734375</c:v>
                </c:pt>
                <c:pt idx="251">
                  <c:v>7361.88623046875</c:v>
                </c:pt>
                <c:pt idx="252">
                  <c:v>7340.482421875</c:v>
                </c:pt>
                <c:pt idx="253">
                  <c:v>7268.69091796875</c:v>
                </c:pt>
                <c:pt idx="254">
                  <c:v>7184.04931640625</c:v>
                </c:pt>
                <c:pt idx="255">
                  <c:v>7133.16455078125</c:v>
                </c:pt>
                <c:pt idx="256">
                  <c:v>7136.98388671875</c:v>
                </c:pt>
                <c:pt idx="257">
                  <c:v>7173.88671875</c:v>
                </c:pt>
                <c:pt idx="258">
                  <c:v>7196.05419921875</c:v>
                </c:pt>
                <c:pt idx="259">
                  <c:v>7168.4736328125</c:v>
                </c:pt>
                <c:pt idx="260">
                  <c:v>7100.36083984375</c:v>
                </c:pt>
                <c:pt idx="261">
                  <c:v>7042.53955078125</c:v>
                </c:pt>
                <c:pt idx="262">
                  <c:v>7050.13134765625</c:v>
                </c:pt>
                <c:pt idx="263">
                  <c:v>7138.02978515625</c:v>
                </c:pt>
                <c:pt idx="264">
                  <c:v>7264.24658203125</c:v>
                </c:pt>
                <c:pt idx="265">
                  <c:v>7356.02392578125</c:v>
                </c:pt>
                <c:pt idx="266">
                  <c:v>7360.65869140625</c:v>
                </c:pt>
                <c:pt idx="267">
                  <c:v>7283.0908203125</c:v>
                </c:pt>
                <c:pt idx="268">
                  <c:v>7181.6884765625</c:v>
                </c:pt>
                <c:pt idx="269">
                  <c:v>7125.361328125</c:v>
                </c:pt>
                <c:pt idx="270">
                  <c:v>7144.51123046875</c:v>
                </c:pt>
                <c:pt idx="271">
                  <c:v>7212.45263671875</c:v>
                </c:pt>
                <c:pt idx="272">
                  <c:v>7269.82763671875</c:v>
                </c:pt>
                <c:pt idx="273">
                  <c:v>7271.5234375</c:v>
                </c:pt>
                <c:pt idx="274">
                  <c:v>7219.44482421875</c:v>
                </c:pt>
                <c:pt idx="275">
                  <c:v>7157.1416015625</c:v>
                </c:pt>
                <c:pt idx="276">
                  <c:v>7132.76953125</c:v>
                </c:pt>
                <c:pt idx="277">
                  <c:v>7160.73095703125</c:v>
                </c:pt>
                <c:pt idx="278">
                  <c:v>7211.5595703125</c:v>
                </c:pt>
                <c:pt idx="279">
                  <c:v>7236.19775390625</c:v>
                </c:pt>
                <c:pt idx="280">
                  <c:v>7204.29296875</c:v>
                </c:pt>
                <c:pt idx="281">
                  <c:v>7127.03857421875</c:v>
                </c:pt>
                <c:pt idx="282">
                  <c:v>7048.9150390625</c:v>
                </c:pt>
                <c:pt idx="283">
                  <c:v>7016.8798828125</c:v>
                </c:pt>
                <c:pt idx="284">
                  <c:v>7050.7978515625</c:v>
                </c:pt>
                <c:pt idx="285">
                  <c:v>7134.84130859375</c:v>
                </c:pt>
                <c:pt idx="286">
                  <c:v>7231.88134765625</c:v>
                </c:pt>
                <c:pt idx="287">
                  <c:v>7306.86279296875</c:v>
                </c:pt>
                <c:pt idx="288">
                  <c:v>7342.416015625</c:v>
                </c:pt>
                <c:pt idx="289">
                  <c:v>7339.9306640625</c:v>
                </c:pt>
                <c:pt idx="290">
                  <c:v>7311.43505859375</c:v>
                </c:pt>
                <c:pt idx="291">
                  <c:v>7271.81689453125</c:v>
                </c:pt>
                <c:pt idx="292">
                  <c:v>7235.81640625</c:v>
                </c:pt>
                <c:pt idx="293">
                  <c:v>7216.92333984375</c:v>
                </c:pt>
                <c:pt idx="294">
                  <c:v>7223.5908203125</c:v>
                </c:pt>
                <c:pt idx="295">
                  <c:v>7253.1337890625</c:v>
                </c:pt>
                <c:pt idx="296">
                  <c:v>7289.19091796875</c:v>
                </c:pt>
                <c:pt idx="297">
                  <c:v>7308.11865234375</c:v>
                </c:pt>
                <c:pt idx="298">
                  <c:v>7292.560546875</c:v>
                </c:pt>
                <c:pt idx="299">
                  <c:v>7243.2138671875</c:v>
                </c:pt>
                <c:pt idx="300">
                  <c:v>7179.5283203125</c:v>
                </c:pt>
                <c:pt idx="301">
                  <c:v>7127.96240234375</c:v>
                </c:pt>
                <c:pt idx="302">
                  <c:v>7106.013671875</c:v>
                </c:pt>
                <c:pt idx="303">
                  <c:v>7113.41259765625</c:v>
                </c:pt>
                <c:pt idx="304">
                  <c:v>7135.888671875</c:v>
                </c:pt>
                <c:pt idx="305">
                  <c:v>7157.015625</c:v>
                </c:pt>
                <c:pt idx="306">
                  <c:v>7168.2236328125</c:v>
                </c:pt>
                <c:pt idx="307">
                  <c:v>7170.291015625</c:v>
                </c:pt>
                <c:pt idx="308">
                  <c:v>7167.88427734375</c:v>
                </c:pt>
                <c:pt idx="309">
                  <c:v>7164.232421875</c:v>
                </c:pt>
                <c:pt idx="310">
                  <c:v>7161.11328125</c:v>
                </c:pt>
                <c:pt idx="311">
                  <c:v>7162.5205078125</c:v>
                </c:pt>
                <c:pt idx="312">
                  <c:v>7175.83154296875</c:v>
                </c:pt>
                <c:pt idx="313">
                  <c:v>7206.72119140625</c:v>
                </c:pt>
                <c:pt idx="314">
                  <c:v>7251.255859375</c:v>
                </c:pt>
                <c:pt idx="315">
                  <c:v>7293.27294921875</c:v>
                </c:pt>
                <c:pt idx="316">
                  <c:v>7311.98828125</c:v>
                </c:pt>
                <c:pt idx="317">
                  <c:v>7295.83544921875</c:v>
                </c:pt>
                <c:pt idx="318">
                  <c:v>7251.796875</c:v>
                </c:pt>
                <c:pt idx="319">
                  <c:v>7201.73828125</c:v>
                </c:pt>
                <c:pt idx="320">
                  <c:v>7167.4697265625</c:v>
                </c:pt>
                <c:pt idx="321">
                  <c:v>7156.03271484375</c:v>
                </c:pt>
                <c:pt idx="322">
                  <c:v>7157.18115234375</c:v>
                </c:pt>
                <c:pt idx="323">
                  <c:v>7155.14111328125</c:v>
                </c:pt>
                <c:pt idx="324">
                  <c:v>7144.5078125</c:v>
                </c:pt>
                <c:pt idx="325">
                  <c:v>7136.22412109375</c:v>
                </c:pt>
                <c:pt idx="326">
                  <c:v>7147.7880859375</c:v>
                </c:pt>
                <c:pt idx="327">
                  <c:v>7185.63671875</c:v>
                </c:pt>
                <c:pt idx="328">
                  <c:v>7235.18359375</c:v>
                </c:pt>
                <c:pt idx="329">
                  <c:v>7268.40625</c:v>
                </c:pt>
                <c:pt idx="330">
                  <c:v>7264.31884765625</c:v>
                </c:pt>
                <c:pt idx="331">
                  <c:v>7226.2578125</c:v>
                </c:pt>
                <c:pt idx="332">
                  <c:v>7181.4365234375</c:v>
                </c:pt>
                <c:pt idx="333">
                  <c:v>7162.015625</c:v>
                </c:pt>
                <c:pt idx="334">
                  <c:v>7181.7958984375</c:v>
                </c:pt>
                <c:pt idx="335">
                  <c:v>7226.4482421875</c:v>
                </c:pt>
                <c:pt idx="336">
                  <c:v>7264.66015625</c:v>
                </c:pt>
                <c:pt idx="337">
                  <c:v>7271.2431640625</c:v>
                </c:pt>
                <c:pt idx="338">
                  <c:v>7244.31982421875</c:v>
                </c:pt>
                <c:pt idx="339">
                  <c:v>7204.09375</c:v>
                </c:pt>
                <c:pt idx="340">
                  <c:v>7175.7060546875</c:v>
                </c:pt>
                <c:pt idx="341">
                  <c:v>7170.7822265625</c:v>
                </c:pt>
                <c:pt idx="342">
                  <c:v>7182.033203125</c:v>
                </c:pt>
                <c:pt idx="343">
                  <c:v>7193.5205078125</c:v>
                </c:pt>
                <c:pt idx="344">
                  <c:v>7196.263671875</c:v>
                </c:pt>
                <c:pt idx="345">
                  <c:v>7195.37646484375</c:v>
                </c:pt>
                <c:pt idx="346">
                  <c:v>7203.22509765625</c:v>
                </c:pt>
                <c:pt idx="347">
                  <c:v>7225.5498046875</c:v>
                </c:pt>
                <c:pt idx="348">
                  <c:v>7253.40234375</c:v>
                </c:pt>
                <c:pt idx="349">
                  <c:v>7268.39453125</c:v>
                </c:pt>
              </c:numCache>
            </c:numRef>
          </c:yVal>
          <c:smooth val="1"/>
          <c:extLst>
            <c:ext xmlns:c16="http://schemas.microsoft.com/office/drawing/2014/chart" uri="{C3380CC4-5D6E-409C-BE32-E72D297353CC}">
              <c16:uniqueId val="{00000000-4A37-429A-A58F-F7AEDA5D1ACA}"/>
            </c:ext>
          </c:extLst>
        </c:ser>
        <c:ser>
          <c:idx val="1"/>
          <c:order val="1"/>
          <c:tx>
            <c:strRef>
              <c:f>cp_sub_001!$B$1</c:f>
              <c:strCache>
                <c:ptCount val="1"/>
                <c:pt idx="0">
                  <c:v>Coor_2</c:v>
                </c:pt>
              </c:strCache>
            </c:strRef>
          </c:tx>
          <c:spPr>
            <a:ln w="28575" cap="rnd">
              <a:solidFill>
                <a:schemeClr val="accent2"/>
              </a:solidFill>
              <a:round/>
            </a:ln>
            <a:effectLst/>
          </c:spPr>
          <c:marker>
            <c:symbol val="none"/>
          </c:marker>
          <c:yVal>
            <c:numRef>
              <c:f>cp_sub_001!$B$2:$B$351</c:f>
              <c:numCache>
                <c:formatCode>0.00000000000_ </c:formatCode>
                <c:ptCount val="350"/>
                <c:pt idx="0">
                  <c:v>6844.130859375</c:v>
                </c:pt>
                <c:pt idx="1">
                  <c:v>6829.65478515625</c:v>
                </c:pt>
                <c:pt idx="2">
                  <c:v>6828.50390625</c:v>
                </c:pt>
                <c:pt idx="3">
                  <c:v>6850.7900390625</c:v>
                </c:pt>
                <c:pt idx="4">
                  <c:v>6888.68408203125</c:v>
                </c:pt>
                <c:pt idx="5">
                  <c:v>6920.22265625</c:v>
                </c:pt>
                <c:pt idx="6">
                  <c:v>6925.42822265625</c:v>
                </c:pt>
                <c:pt idx="7">
                  <c:v>6901.9580078125</c:v>
                </c:pt>
                <c:pt idx="8">
                  <c:v>6867.16796875</c:v>
                </c:pt>
                <c:pt idx="9">
                  <c:v>6844.48046875</c:v>
                </c:pt>
                <c:pt idx="10">
                  <c:v>6845.18017578125</c:v>
                </c:pt>
                <c:pt idx="11">
                  <c:v>6860.763671875</c:v>
                </c:pt>
                <c:pt idx="12">
                  <c:v>6871.978515625</c:v>
                </c:pt>
                <c:pt idx="13">
                  <c:v>6866.24169921875</c:v>
                </c:pt>
                <c:pt idx="14">
                  <c:v>6847.912109375</c:v>
                </c:pt>
                <c:pt idx="15">
                  <c:v>6832.38427734375</c:v>
                </c:pt>
                <c:pt idx="16">
                  <c:v>6829.76953125</c:v>
                </c:pt>
                <c:pt idx="17">
                  <c:v>6833.7685546875</c:v>
                </c:pt>
                <c:pt idx="18">
                  <c:v>6827.08642578125</c:v>
                </c:pt>
                <c:pt idx="19">
                  <c:v>6799.56201171875</c:v>
                </c:pt>
                <c:pt idx="20">
                  <c:v>6762.47998046875</c:v>
                </c:pt>
                <c:pt idx="21">
                  <c:v>6744.2314453125</c:v>
                </c:pt>
                <c:pt idx="22">
                  <c:v>6768.30029296875</c:v>
                </c:pt>
                <c:pt idx="23">
                  <c:v>6831.11865234375</c:v>
                </c:pt>
                <c:pt idx="24">
                  <c:v>6899.7734375</c:v>
                </c:pt>
                <c:pt idx="25">
                  <c:v>6934.2578125</c:v>
                </c:pt>
                <c:pt idx="26">
                  <c:v>6917.9931640625</c:v>
                </c:pt>
                <c:pt idx="27">
                  <c:v>6871.64111328125</c:v>
                </c:pt>
                <c:pt idx="28">
                  <c:v>6837.3857421875</c:v>
                </c:pt>
                <c:pt idx="29">
                  <c:v>6844.9033203125</c:v>
                </c:pt>
                <c:pt idx="30">
                  <c:v>6886.39794921875</c:v>
                </c:pt>
                <c:pt idx="31">
                  <c:v>6922.07958984375</c:v>
                </c:pt>
                <c:pt idx="32">
                  <c:v>6913.0732421875</c:v>
                </c:pt>
                <c:pt idx="33">
                  <c:v>6855.56640625</c:v>
                </c:pt>
                <c:pt idx="34">
                  <c:v>6787.5576171875</c:v>
                </c:pt>
                <c:pt idx="35">
                  <c:v>6760.8740234375</c:v>
                </c:pt>
                <c:pt idx="36">
                  <c:v>6799.55224609375</c:v>
                </c:pt>
                <c:pt idx="37">
                  <c:v>6877.9892578125</c:v>
                </c:pt>
                <c:pt idx="38">
                  <c:v>6937.73974609375</c:v>
                </c:pt>
                <c:pt idx="39">
                  <c:v>6931.44189453125</c:v>
                </c:pt>
                <c:pt idx="40">
                  <c:v>6860.2236328125</c:v>
                </c:pt>
                <c:pt idx="41">
                  <c:v>6775.044921875</c:v>
                </c:pt>
                <c:pt idx="42">
                  <c:v>6739.91748046875</c:v>
                </c:pt>
                <c:pt idx="43">
                  <c:v>6784.34033203125</c:v>
                </c:pt>
                <c:pt idx="44">
                  <c:v>6880.6240234375</c:v>
                </c:pt>
                <c:pt idx="45">
                  <c:v>6962.8486328125</c:v>
                </c:pt>
                <c:pt idx="46">
                  <c:v>6973.00244140625</c:v>
                </c:pt>
                <c:pt idx="47">
                  <c:v>6900.49267578125</c:v>
                </c:pt>
                <c:pt idx="48">
                  <c:v>6787.63720703125</c:v>
                </c:pt>
                <c:pt idx="49">
                  <c:v>6699.69287109375</c:v>
                </c:pt>
                <c:pt idx="50">
                  <c:v>6682.7939453125</c:v>
                </c:pt>
                <c:pt idx="51">
                  <c:v>6738.91015625</c:v>
                </c:pt>
                <c:pt idx="52">
                  <c:v>6831.47509765625</c:v>
                </c:pt>
                <c:pt idx="53">
                  <c:v>6912.66748046875</c:v>
                </c:pt>
                <c:pt idx="54">
                  <c:v>6950.873046875</c:v>
                </c:pt>
                <c:pt idx="55">
                  <c:v>6941.76708984375</c:v>
                </c:pt>
                <c:pt idx="56">
                  <c:v>6901.6005859375</c:v>
                </c:pt>
                <c:pt idx="57">
                  <c:v>6853.16064453125</c:v>
                </c:pt>
                <c:pt idx="58">
                  <c:v>6815.39599609375</c:v>
                </c:pt>
                <c:pt idx="59">
                  <c:v>6799.8408203125</c:v>
                </c:pt>
                <c:pt idx="60">
                  <c:v>6810.02001953125</c:v>
                </c:pt>
                <c:pt idx="61">
                  <c:v>6840.25</c:v>
                </c:pt>
                <c:pt idx="62">
                  <c:v>6875.4208984375</c:v>
                </c:pt>
                <c:pt idx="63">
                  <c:v>6896.16943359375</c:v>
                </c:pt>
                <c:pt idx="64">
                  <c:v>6889.8984375</c:v>
                </c:pt>
                <c:pt idx="65">
                  <c:v>6860.845703125</c:v>
                </c:pt>
                <c:pt idx="66">
                  <c:v>6829.78662109375</c:v>
                </c:pt>
                <c:pt idx="67">
                  <c:v>6820.48681640625</c:v>
                </c:pt>
                <c:pt idx="68">
                  <c:v>6841.3203125</c:v>
                </c:pt>
                <c:pt idx="69">
                  <c:v>6876.61279296875</c:v>
                </c:pt>
                <c:pt idx="70">
                  <c:v>6896.455078125</c:v>
                </c:pt>
                <c:pt idx="71">
                  <c:v>6879.3759765625</c:v>
                </c:pt>
                <c:pt idx="72">
                  <c:v>6830.85009765625</c:v>
                </c:pt>
                <c:pt idx="73">
                  <c:v>6782.30859375</c:v>
                </c:pt>
                <c:pt idx="74">
                  <c:v>6769.83984375</c:v>
                </c:pt>
                <c:pt idx="75">
                  <c:v>6807.884765625</c:v>
                </c:pt>
                <c:pt idx="76">
                  <c:v>6877.82080078125</c:v>
                </c:pt>
                <c:pt idx="77">
                  <c:v>6940.24609375</c:v>
                </c:pt>
                <c:pt idx="78">
                  <c:v>6961.6845703125</c:v>
                </c:pt>
                <c:pt idx="79">
                  <c:v>6935.76123046875</c:v>
                </c:pt>
                <c:pt idx="80">
                  <c:v>6883.9697265625</c:v>
                </c:pt>
                <c:pt idx="81">
                  <c:v>6837.43115234375</c:v>
                </c:pt>
                <c:pt idx="82">
                  <c:v>6815.11865234375</c:v>
                </c:pt>
                <c:pt idx="83">
                  <c:v>6814.87744140625</c:v>
                </c:pt>
                <c:pt idx="84">
                  <c:v>6821.5263671875</c:v>
                </c:pt>
                <c:pt idx="85">
                  <c:v>6822.34375</c:v>
                </c:pt>
                <c:pt idx="86">
                  <c:v>6815.93359375</c:v>
                </c:pt>
                <c:pt idx="87">
                  <c:v>6808.5634765625</c:v>
                </c:pt>
                <c:pt idx="88">
                  <c:v>6804.25830078125</c:v>
                </c:pt>
                <c:pt idx="89">
                  <c:v>6800.00927734375</c:v>
                </c:pt>
                <c:pt idx="90">
                  <c:v>6791.1552734375</c:v>
                </c:pt>
                <c:pt idx="91">
                  <c:v>6780.849609375</c:v>
                </c:pt>
                <c:pt idx="92">
                  <c:v>6782.421875</c:v>
                </c:pt>
                <c:pt idx="93">
                  <c:v>6809.70166015625</c:v>
                </c:pt>
                <c:pt idx="94">
                  <c:v>6862.4921875</c:v>
                </c:pt>
                <c:pt idx="95">
                  <c:v>6920.84619140625</c:v>
                </c:pt>
                <c:pt idx="96">
                  <c:v>6955.77587890625</c:v>
                </c:pt>
                <c:pt idx="97">
                  <c:v>6949.78662109375</c:v>
                </c:pt>
                <c:pt idx="98">
                  <c:v>6910.68212890625</c:v>
                </c:pt>
                <c:pt idx="99">
                  <c:v>6866.0517578125</c:v>
                </c:pt>
                <c:pt idx="100">
                  <c:v>6841.50390625</c:v>
                </c:pt>
                <c:pt idx="101">
                  <c:v>6840.212890625</c:v>
                </c:pt>
                <c:pt idx="102">
                  <c:v>6841.5888671875</c:v>
                </c:pt>
                <c:pt idx="103">
                  <c:v>6821.55517578125</c:v>
                </c:pt>
                <c:pt idx="104">
                  <c:v>6778.03173828125</c:v>
                </c:pt>
                <c:pt idx="105">
                  <c:v>6739.0849609375</c:v>
                </c:pt>
                <c:pt idx="106">
                  <c:v>6744.09375</c:v>
                </c:pt>
                <c:pt idx="107">
                  <c:v>6810.7646484375</c:v>
                </c:pt>
                <c:pt idx="108">
                  <c:v>6914.42724609375</c:v>
                </c:pt>
                <c:pt idx="109">
                  <c:v>6998.6220703125</c:v>
                </c:pt>
                <c:pt idx="110">
                  <c:v>7012.126953125</c:v>
                </c:pt>
                <c:pt idx="111">
                  <c:v>6945.86279296875</c:v>
                </c:pt>
                <c:pt idx="112">
                  <c:v>6841.3544921875</c:v>
                </c:pt>
                <c:pt idx="113">
                  <c:v>6763.0283203125</c:v>
                </c:pt>
                <c:pt idx="114">
                  <c:v>6754.1044921875</c:v>
                </c:pt>
                <c:pt idx="115">
                  <c:v>6808.60546875</c:v>
                </c:pt>
                <c:pt idx="116">
                  <c:v>6879.822265625</c:v>
                </c:pt>
                <c:pt idx="117">
                  <c:v>6917.69091796875</c:v>
                </c:pt>
                <c:pt idx="118">
                  <c:v>6905.7412109375</c:v>
                </c:pt>
                <c:pt idx="119">
                  <c:v>6869.546875</c:v>
                </c:pt>
                <c:pt idx="120">
                  <c:v>6851.62060546875</c:v>
                </c:pt>
                <c:pt idx="121">
                  <c:v>6874.07958984375</c:v>
                </c:pt>
                <c:pt idx="122">
                  <c:v>6919.3505859375</c:v>
                </c:pt>
                <c:pt idx="123">
                  <c:v>6944.02197265625</c:v>
                </c:pt>
                <c:pt idx="124">
                  <c:v>6914.25927734375</c:v>
                </c:pt>
                <c:pt idx="125">
                  <c:v>6834.275390625</c:v>
                </c:pt>
                <c:pt idx="126">
                  <c:v>6745.353515625</c:v>
                </c:pt>
                <c:pt idx="127">
                  <c:v>6696.48046875</c:v>
                </c:pt>
                <c:pt idx="128">
                  <c:v>6709.662109375</c:v>
                </c:pt>
                <c:pt idx="129">
                  <c:v>6766.27294921875</c:v>
                </c:pt>
                <c:pt idx="130">
                  <c:v>6823.52783203125</c:v>
                </c:pt>
                <c:pt idx="131">
                  <c:v>6846.7353515625</c:v>
                </c:pt>
                <c:pt idx="132">
                  <c:v>6832.08447265625</c:v>
                </c:pt>
                <c:pt idx="133">
                  <c:v>6804.021484375</c:v>
                </c:pt>
                <c:pt idx="134">
                  <c:v>6792.20361328125</c:v>
                </c:pt>
                <c:pt idx="135">
                  <c:v>6808.2412109375</c:v>
                </c:pt>
                <c:pt idx="136">
                  <c:v>6840.3173828125</c:v>
                </c:pt>
                <c:pt idx="137">
                  <c:v>6867.41552734375</c:v>
                </c:pt>
                <c:pt idx="138">
                  <c:v>6878.685546875</c:v>
                </c:pt>
                <c:pt idx="139">
                  <c:v>6880.7587890625</c:v>
                </c:pt>
                <c:pt idx="140">
                  <c:v>6887.8408203125</c:v>
                </c:pt>
                <c:pt idx="141">
                  <c:v>6905.0595703125</c:v>
                </c:pt>
                <c:pt idx="142">
                  <c:v>6921.16259765625</c:v>
                </c:pt>
                <c:pt idx="143">
                  <c:v>6917.7802734375</c:v>
                </c:pt>
                <c:pt idx="144">
                  <c:v>6887.2177734375</c:v>
                </c:pt>
                <c:pt idx="145">
                  <c:v>6842.607421875</c:v>
                </c:pt>
                <c:pt idx="146">
                  <c:v>6810.3916015625</c:v>
                </c:pt>
                <c:pt idx="147">
                  <c:v>6810.2958984375</c:v>
                </c:pt>
                <c:pt idx="148">
                  <c:v>6839.1630859375</c:v>
                </c:pt>
                <c:pt idx="149">
                  <c:v>6872.51318359375</c:v>
                </c:pt>
                <c:pt idx="150">
                  <c:v>6883.35986328125</c:v>
                </c:pt>
                <c:pt idx="151">
                  <c:v>6863.50146484375</c:v>
                </c:pt>
                <c:pt idx="152">
                  <c:v>6830.14111328125</c:v>
                </c:pt>
                <c:pt idx="153">
                  <c:v>6812.32177734375</c:v>
                </c:pt>
                <c:pt idx="154">
                  <c:v>6827.8359375</c:v>
                </c:pt>
                <c:pt idx="155">
                  <c:v>6868.86376953125</c:v>
                </c:pt>
                <c:pt idx="156">
                  <c:v>6907.625</c:v>
                </c:pt>
                <c:pt idx="157">
                  <c:v>6917.53125</c:v>
                </c:pt>
                <c:pt idx="158">
                  <c:v>6893.40234375</c:v>
                </c:pt>
                <c:pt idx="159">
                  <c:v>6855.3818359375</c:v>
                </c:pt>
                <c:pt idx="160">
                  <c:v>6833.9453125</c:v>
                </c:pt>
                <c:pt idx="161">
                  <c:v>6847.51611328125</c:v>
                </c:pt>
                <c:pt idx="162">
                  <c:v>6888.9853515625</c:v>
                </c:pt>
                <c:pt idx="163">
                  <c:v>6930.11572265625</c:v>
                </c:pt>
                <c:pt idx="164">
                  <c:v>6939.79833984375</c:v>
                </c:pt>
                <c:pt idx="165">
                  <c:v>6903.34716796875</c:v>
                </c:pt>
                <c:pt idx="166">
                  <c:v>6830.9365234375</c:v>
                </c:pt>
                <c:pt idx="167">
                  <c:v>6751.59228515625</c:v>
                </c:pt>
                <c:pt idx="168">
                  <c:v>6697.931640625</c:v>
                </c:pt>
                <c:pt idx="169">
                  <c:v>6690.5302734375</c:v>
                </c:pt>
                <c:pt idx="170">
                  <c:v>6728.91796875</c:v>
                </c:pt>
                <c:pt idx="171">
                  <c:v>6792.00634765625</c:v>
                </c:pt>
                <c:pt idx="172">
                  <c:v>6847.28955078125</c:v>
                </c:pt>
                <c:pt idx="173">
                  <c:v>6865.76171875</c:v>
                </c:pt>
                <c:pt idx="174">
                  <c:v>6837.140625</c:v>
                </c:pt>
                <c:pt idx="175">
                  <c:v>6778</c:v>
                </c:pt>
                <c:pt idx="176">
                  <c:v>6726.3916015625</c:v>
                </c:pt>
                <c:pt idx="177">
                  <c:v>6722.6103515625</c:v>
                </c:pt>
                <c:pt idx="178">
                  <c:v>6784.9345703125</c:v>
                </c:pt>
                <c:pt idx="179">
                  <c:v>6895.1220703125</c:v>
                </c:pt>
                <c:pt idx="180">
                  <c:v>7005.03369140625</c:v>
                </c:pt>
                <c:pt idx="181">
                  <c:v>7062.96484375</c:v>
                </c:pt>
                <c:pt idx="182">
                  <c:v>7044.16943359375</c:v>
                </c:pt>
                <c:pt idx="183">
                  <c:v>6965.41943359375</c:v>
                </c:pt>
                <c:pt idx="184">
                  <c:v>6873.23681640625</c:v>
                </c:pt>
                <c:pt idx="185">
                  <c:v>6813.62744140625</c:v>
                </c:pt>
                <c:pt idx="186">
                  <c:v>6804.40087890625</c:v>
                </c:pt>
                <c:pt idx="187">
                  <c:v>6829.0400390625</c:v>
                </c:pt>
                <c:pt idx="188">
                  <c:v>6854.7548828125</c:v>
                </c:pt>
                <c:pt idx="189">
                  <c:v>6859.28369140625</c:v>
                </c:pt>
                <c:pt idx="190">
                  <c:v>6845.40478515625</c:v>
                </c:pt>
                <c:pt idx="191">
                  <c:v>6833.2314453125</c:v>
                </c:pt>
                <c:pt idx="192">
                  <c:v>6838.92919921875</c:v>
                </c:pt>
                <c:pt idx="193">
                  <c:v>6859.1572265625</c:v>
                </c:pt>
                <c:pt idx="194">
                  <c:v>6874.60546875</c:v>
                </c:pt>
                <c:pt idx="195">
                  <c:v>6868.75927734375</c:v>
                </c:pt>
                <c:pt idx="196">
                  <c:v>6844.45849609375</c:v>
                </c:pt>
                <c:pt idx="197">
                  <c:v>6822.69775390625</c:v>
                </c:pt>
                <c:pt idx="198">
                  <c:v>6824.00146484375</c:v>
                </c:pt>
                <c:pt idx="199">
                  <c:v>6848.73583984375</c:v>
                </c:pt>
                <c:pt idx="200">
                  <c:v>6874.6396484375</c:v>
                </c:pt>
                <c:pt idx="201">
                  <c:v>6875.30322265625</c:v>
                </c:pt>
                <c:pt idx="202">
                  <c:v>6844.4794921875</c:v>
                </c:pt>
                <c:pt idx="203">
                  <c:v>6804.6015625</c:v>
                </c:pt>
                <c:pt idx="204">
                  <c:v>6790.166015625</c:v>
                </c:pt>
                <c:pt idx="205">
                  <c:v>6818.2138671875</c:v>
                </c:pt>
                <c:pt idx="206">
                  <c:v>6870.61962890625</c:v>
                </c:pt>
                <c:pt idx="207">
                  <c:v>6904.83837890625</c:v>
                </c:pt>
                <c:pt idx="208">
                  <c:v>6886.71142578125</c:v>
                </c:pt>
                <c:pt idx="209">
                  <c:v>6819.69482421875</c:v>
                </c:pt>
                <c:pt idx="210">
                  <c:v>6745.95458984375</c:v>
                </c:pt>
                <c:pt idx="211">
                  <c:v>6716.466796875</c:v>
                </c:pt>
                <c:pt idx="212">
                  <c:v>6752.48974609375</c:v>
                </c:pt>
                <c:pt idx="213">
                  <c:v>6828.83544921875</c:v>
                </c:pt>
                <c:pt idx="214">
                  <c:v>6892.94091796875</c:v>
                </c:pt>
                <c:pt idx="215">
                  <c:v>6905.44580078125</c:v>
                </c:pt>
                <c:pt idx="216">
                  <c:v>6870.45361328125</c:v>
                </c:pt>
                <c:pt idx="217">
                  <c:v>6831.32666015625</c:v>
                </c:pt>
                <c:pt idx="218">
                  <c:v>6834.98974609375</c:v>
                </c:pt>
                <c:pt idx="219">
                  <c:v>6892.80712890625</c:v>
                </c:pt>
                <c:pt idx="220">
                  <c:v>6969.11279296875</c:v>
                </c:pt>
                <c:pt idx="221">
                  <c:v>7006.91357421875</c:v>
                </c:pt>
                <c:pt idx="222">
                  <c:v>6971.20361328125</c:v>
                </c:pt>
                <c:pt idx="223">
                  <c:v>6876.61572265625</c:v>
                </c:pt>
                <c:pt idx="224">
                  <c:v>6778.298828125</c:v>
                </c:pt>
                <c:pt idx="225">
                  <c:v>6733.1064453125</c:v>
                </c:pt>
                <c:pt idx="226">
                  <c:v>6760.30712890625</c:v>
                </c:pt>
                <c:pt idx="227">
                  <c:v>6830.43701171875</c:v>
                </c:pt>
                <c:pt idx="228">
                  <c:v>6888.93408203125</c:v>
                </c:pt>
                <c:pt idx="229">
                  <c:v>6895.525390625</c:v>
                </c:pt>
                <c:pt idx="230">
                  <c:v>6850.31103515625</c:v>
                </c:pt>
                <c:pt idx="231">
                  <c:v>6789.439453125</c:v>
                </c:pt>
                <c:pt idx="232">
                  <c:v>6756.56640625</c:v>
                </c:pt>
                <c:pt idx="233">
                  <c:v>6772.70068359375</c:v>
                </c:pt>
                <c:pt idx="234">
                  <c:v>6825.3681640625</c:v>
                </c:pt>
                <c:pt idx="235">
                  <c:v>6881.61376953125</c:v>
                </c:pt>
                <c:pt idx="236">
                  <c:v>6912.10595703125</c:v>
                </c:pt>
                <c:pt idx="237">
                  <c:v>6908.1396484375</c:v>
                </c:pt>
                <c:pt idx="238">
                  <c:v>6881.71826171875</c:v>
                </c:pt>
                <c:pt idx="239">
                  <c:v>6852.6259765625</c:v>
                </c:pt>
                <c:pt idx="240">
                  <c:v>6834.447265625</c:v>
                </c:pt>
                <c:pt idx="241">
                  <c:v>6829.17041015625</c:v>
                </c:pt>
                <c:pt idx="242">
                  <c:v>6831.2880859375</c:v>
                </c:pt>
                <c:pt idx="243">
                  <c:v>6835.25439453125</c:v>
                </c:pt>
                <c:pt idx="244">
                  <c:v>6839.66552734375</c:v>
                </c:pt>
                <c:pt idx="245">
                  <c:v>6846.2548828125</c:v>
                </c:pt>
                <c:pt idx="246">
                  <c:v>6856.5087890625</c:v>
                </c:pt>
                <c:pt idx="247">
                  <c:v>6869.63818359375</c:v>
                </c:pt>
                <c:pt idx="248">
                  <c:v>6883.09228515625</c:v>
                </c:pt>
                <c:pt idx="249">
                  <c:v>6894.14697265625</c:v>
                </c:pt>
                <c:pt idx="250">
                  <c:v>6900.79541015625</c:v>
                </c:pt>
                <c:pt idx="251">
                  <c:v>6901.74169921875</c:v>
                </c:pt>
                <c:pt idx="252">
                  <c:v>6896.49169921875</c:v>
                </c:pt>
                <c:pt idx="253">
                  <c:v>6885.896484375</c:v>
                </c:pt>
                <c:pt idx="254">
                  <c:v>6872.140625</c:v>
                </c:pt>
                <c:pt idx="255">
                  <c:v>6857.08642578125</c:v>
                </c:pt>
                <c:pt idx="256">
                  <c:v>6839.7666015625</c:v>
                </c:pt>
                <c:pt idx="257">
                  <c:v>6815.74267578125</c:v>
                </c:pt>
                <c:pt idx="258">
                  <c:v>6780.53125</c:v>
                </c:pt>
                <c:pt idx="259">
                  <c:v>6735.865234375</c:v>
                </c:pt>
                <c:pt idx="260">
                  <c:v>6694.01025390625</c:v>
                </c:pt>
                <c:pt idx="261">
                  <c:v>6675.169921875</c:v>
                </c:pt>
                <c:pt idx="262">
                  <c:v>6697.431640625</c:v>
                </c:pt>
                <c:pt idx="263">
                  <c:v>6764.68212890625</c:v>
                </c:pt>
                <c:pt idx="264">
                  <c:v>6860.6630859375</c:v>
                </c:pt>
                <c:pt idx="265">
                  <c:v>6954.17138671875</c:v>
                </c:pt>
                <c:pt idx="266">
                  <c:v>7013.2099609375</c:v>
                </c:pt>
                <c:pt idx="267">
                  <c:v>7020.0087890625</c:v>
                </c:pt>
                <c:pt idx="268">
                  <c:v>6978.4287109375</c:v>
                </c:pt>
                <c:pt idx="269">
                  <c:v>6910.4169921875</c:v>
                </c:pt>
                <c:pt idx="270">
                  <c:v>6844.77392578125</c:v>
                </c:pt>
                <c:pt idx="271">
                  <c:v>6804.9365234375</c:v>
                </c:pt>
                <c:pt idx="272">
                  <c:v>6801.2080078125</c:v>
                </c:pt>
                <c:pt idx="273">
                  <c:v>6829.10888671875</c:v>
                </c:pt>
                <c:pt idx="274">
                  <c:v>6872.615234375</c:v>
                </c:pt>
                <c:pt idx="275">
                  <c:v>6910.431640625</c:v>
                </c:pt>
                <c:pt idx="276">
                  <c:v>6923.82177734375</c:v>
                </c:pt>
                <c:pt idx="277">
                  <c:v>6904.1240234375</c:v>
                </c:pt>
                <c:pt idx="278">
                  <c:v>6856.83740234375</c:v>
                </c:pt>
                <c:pt idx="279">
                  <c:v>6799.28564453125</c:v>
                </c:pt>
                <c:pt idx="280">
                  <c:v>6751.89599609375</c:v>
                </c:pt>
                <c:pt idx="281">
                  <c:v>6727.796875</c:v>
                </c:pt>
                <c:pt idx="282">
                  <c:v>6727.72998046875</c:v>
                </c:pt>
                <c:pt idx="283">
                  <c:v>6744.134765625</c:v>
                </c:pt>
                <c:pt idx="284">
                  <c:v>6771.0556640625</c:v>
                </c:pt>
                <c:pt idx="285">
                  <c:v>6810.9482421875</c:v>
                </c:pt>
                <c:pt idx="286">
                  <c:v>6871.0625</c:v>
                </c:pt>
                <c:pt idx="287">
                  <c:v>6950.82275390625</c:v>
                </c:pt>
                <c:pt idx="288">
                  <c:v>7030.94140625</c:v>
                </c:pt>
                <c:pt idx="289">
                  <c:v>7076.3447265625</c:v>
                </c:pt>
                <c:pt idx="290">
                  <c:v>7055.5166015625</c:v>
                </c:pt>
                <c:pt idx="291">
                  <c:v>6964.810546875</c:v>
                </c:pt>
                <c:pt idx="292">
                  <c:v>6839.05126953125</c:v>
                </c:pt>
                <c:pt idx="293">
                  <c:v>6736.78271484375</c:v>
                </c:pt>
                <c:pt idx="294">
                  <c:v>6706.318359375</c:v>
                </c:pt>
                <c:pt idx="295">
                  <c:v>6754.4443359375</c:v>
                </c:pt>
                <c:pt idx="296">
                  <c:v>6840.37109375</c:v>
                </c:pt>
                <c:pt idx="297">
                  <c:v>6901.22412109375</c:v>
                </c:pt>
                <c:pt idx="298">
                  <c:v>6892.96630859375</c:v>
                </c:pt>
                <c:pt idx="299">
                  <c:v>6818.857421875</c:v>
                </c:pt>
                <c:pt idx="300">
                  <c:v>6725.74365234375</c:v>
                </c:pt>
                <c:pt idx="301">
                  <c:v>6671.16552734375</c:v>
                </c:pt>
                <c:pt idx="302">
                  <c:v>6684.93310546875</c:v>
                </c:pt>
                <c:pt idx="303">
                  <c:v>6752.08154296875</c:v>
                </c:pt>
                <c:pt idx="304">
                  <c:v>6827.77099609375</c:v>
                </c:pt>
                <c:pt idx="305">
                  <c:v>6871.234375</c:v>
                </c:pt>
                <c:pt idx="306">
                  <c:v>6872.916015625</c:v>
                </c:pt>
                <c:pt idx="307">
                  <c:v>6855.79296875</c:v>
                </c:pt>
                <c:pt idx="308">
                  <c:v>6852.4453125</c:v>
                </c:pt>
                <c:pt idx="309">
                  <c:v>6877.59716796875</c:v>
                </c:pt>
                <c:pt idx="310">
                  <c:v>6917.80224609375</c:v>
                </c:pt>
                <c:pt idx="311">
                  <c:v>6945.0751953125</c:v>
                </c:pt>
                <c:pt idx="312">
                  <c:v>6941.84375</c:v>
                </c:pt>
                <c:pt idx="313">
                  <c:v>6916.0908203125</c:v>
                </c:pt>
                <c:pt idx="314">
                  <c:v>6894.236328125</c:v>
                </c:pt>
                <c:pt idx="315">
                  <c:v>6897.80126953125</c:v>
                </c:pt>
                <c:pt idx="316">
                  <c:v>6923.32666015625</c:v>
                </c:pt>
                <c:pt idx="317">
                  <c:v>6942.66162109375</c:v>
                </c:pt>
                <c:pt idx="318">
                  <c:v>6924.58642578125</c:v>
                </c:pt>
                <c:pt idx="319">
                  <c:v>6861.474609375</c:v>
                </c:pt>
                <c:pt idx="320">
                  <c:v>6779.87451171875</c:v>
                </c:pt>
                <c:pt idx="321">
                  <c:v>6725.4794921875</c:v>
                </c:pt>
                <c:pt idx="322">
                  <c:v>6732.18310546875</c:v>
                </c:pt>
                <c:pt idx="323">
                  <c:v>6797.38134765625</c:v>
                </c:pt>
                <c:pt idx="324">
                  <c:v>6881.80908203125</c:v>
                </c:pt>
                <c:pt idx="325">
                  <c:v>6934.7978515625</c:v>
                </c:pt>
                <c:pt idx="326">
                  <c:v>6927.54931640625</c:v>
                </c:pt>
                <c:pt idx="327">
                  <c:v>6871.18359375</c:v>
                </c:pt>
                <c:pt idx="328">
                  <c:v>6807.1552734375</c:v>
                </c:pt>
                <c:pt idx="329">
                  <c:v>6777.2177734375</c:v>
                </c:pt>
                <c:pt idx="330">
                  <c:v>6794.44189453125</c:v>
                </c:pt>
                <c:pt idx="331">
                  <c:v>6835.6904296875</c:v>
                </c:pt>
                <c:pt idx="332">
                  <c:v>6860.35888671875</c:v>
                </c:pt>
                <c:pt idx="333">
                  <c:v>6841.42822265625</c:v>
                </c:pt>
                <c:pt idx="334">
                  <c:v>6786.26611328125</c:v>
                </c:pt>
                <c:pt idx="335">
                  <c:v>6732.171875</c:v>
                </c:pt>
                <c:pt idx="336">
                  <c:v>6719.87548828125</c:v>
                </c:pt>
                <c:pt idx="337">
                  <c:v>6763.98681640625</c:v>
                </c:pt>
                <c:pt idx="338">
                  <c:v>6841.57177734375</c:v>
                </c:pt>
                <c:pt idx="339">
                  <c:v>6907.12939453125</c:v>
                </c:pt>
                <c:pt idx="340">
                  <c:v>6923.52197265625</c:v>
                </c:pt>
                <c:pt idx="341">
                  <c:v>6887.2021484375</c:v>
                </c:pt>
                <c:pt idx="342">
                  <c:v>6830.23974609375</c:v>
                </c:pt>
                <c:pt idx="343">
                  <c:v>6798.04443359375</c:v>
                </c:pt>
                <c:pt idx="344">
                  <c:v>6818.541015625</c:v>
                </c:pt>
                <c:pt idx="345">
                  <c:v>6884.01171875</c:v>
                </c:pt>
                <c:pt idx="346">
                  <c:v>6957.34423828125</c:v>
                </c:pt>
                <c:pt idx="347">
                  <c:v>6997.22021484375</c:v>
                </c:pt>
                <c:pt idx="348">
                  <c:v>6984.2275390625</c:v>
                </c:pt>
                <c:pt idx="349">
                  <c:v>6930.55029296875</c:v>
                </c:pt>
              </c:numCache>
            </c:numRef>
          </c:yVal>
          <c:smooth val="1"/>
          <c:extLst>
            <c:ext xmlns:c16="http://schemas.microsoft.com/office/drawing/2014/chart" uri="{C3380CC4-5D6E-409C-BE32-E72D297353CC}">
              <c16:uniqueId val="{00000001-4A37-429A-A58F-F7AEDA5D1ACA}"/>
            </c:ext>
          </c:extLst>
        </c:ser>
        <c:ser>
          <c:idx val="2"/>
          <c:order val="2"/>
          <c:tx>
            <c:strRef>
              <c:f>cp_sub_001!$C$1</c:f>
              <c:strCache>
                <c:ptCount val="1"/>
                <c:pt idx="0">
                  <c:v>Coor_3</c:v>
                </c:pt>
              </c:strCache>
            </c:strRef>
          </c:tx>
          <c:spPr>
            <a:ln w="28575" cap="rnd">
              <a:solidFill>
                <a:schemeClr val="accent3"/>
              </a:solidFill>
              <a:round/>
            </a:ln>
            <a:effectLst/>
          </c:spPr>
          <c:marker>
            <c:symbol val="none"/>
          </c:marker>
          <c:yVal>
            <c:numRef>
              <c:f>cp_sub_001!$C$2:$C$351</c:f>
              <c:numCache>
                <c:formatCode>0.00000000000_ </c:formatCode>
                <c:ptCount val="350"/>
                <c:pt idx="0">
                  <c:v>3464.23852539062</c:v>
                </c:pt>
                <c:pt idx="1">
                  <c:v>3452.19067382812</c:v>
                </c:pt>
                <c:pt idx="2">
                  <c:v>3423.87329101562</c:v>
                </c:pt>
                <c:pt idx="3">
                  <c:v>3387.69165039062</c:v>
                </c:pt>
                <c:pt idx="4">
                  <c:v>3362.0966796875</c:v>
                </c:pt>
                <c:pt idx="5">
                  <c:v>3366.46948242187</c:v>
                </c:pt>
                <c:pt idx="6">
                  <c:v>3408.10107421875</c:v>
                </c:pt>
                <c:pt idx="7">
                  <c:v>3474.81201171875</c:v>
                </c:pt>
                <c:pt idx="8">
                  <c:v>3539.7587890625</c:v>
                </c:pt>
                <c:pt idx="9">
                  <c:v>3576.10131835937</c:v>
                </c:pt>
                <c:pt idx="10">
                  <c:v>3571.61645507812</c:v>
                </c:pt>
                <c:pt idx="11">
                  <c:v>3533.46435546875</c:v>
                </c:pt>
                <c:pt idx="12">
                  <c:v>3481.05615234375</c:v>
                </c:pt>
                <c:pt idx="13">
                  <c:v>3433.73999023437</c:v>
                </c:pt>
                <c:pt idx="14">
                  <c:v>3402.5380859375</c:v>
                </c:pt>
                <c:pt idx="15">
                  <c:v>3389.94311523437</c:v>
                </c:pt>
                <c:pt idx="16">
                  <c:v>3394.2392578125</c:v>
                </c:pt>
                <c:pt idx="17">
                  <c:v>3412.02514648437</c:v>
                </c:pt>
                <c:pt idx="18">
                  <c:v>3436.66943359375</c:v>
                </c:pt>
                <c:pt idx="19">
                  <c:v>3456.60595703125</c:v>
                </c:pt>
                <c:pt idx="20">
                  <c:v>3458.83862304687</c:v>
                </c:pt>
                <c:pt idx="21">
                  <c:v>3437.77563476562</c:v>
                </c:pt>
                <c:pt idx="22">
                  <c:v>3402.54467773437</c:v>
                </c:pt>
                <c:pt idx="23">
                  <c:v>3374.75366210937</c:v>
                </c:pt>
                <c:pt idx="24">
                  <c:v>3375.60278320312</c:v>
                </c:pt>
                <c:pt idx="25">
                  <c:v>3410.84741210937</c:v>
                </c:pt>
                <c:pt idx="26">
                  <c:v>3465.43017578125</c:v>
                </c:pt>
                <c:pt idx="27">
                  <c:v>3512.77319335937</c:v>
                </c:pt>
                <c:pt idx="28">
                  <c:v>3531.96997070312</c:v>
                </c:pt>
                <c:pt idx="29">
                  <c:v>3519.64868164062</c:v>
                </c:pt>
                <c:pt idx="30">
                  <c:v>3487.98681640625</c:v>
                </c:pt>
                <c:pt idx="31">
                  <c:v>3452.28735351562</c:v>
                </c:pt>
                <c:pt idx="32">
                  <c:v>3419.99267578125</c:v>
                </c:pt>
                <c:pt idx="33">
                  <c:v>3390.41650390625</c:v>
                </c:pt>
                <c:pt idx="34">
                  <c:v>3363.39721679687</c:v>
                </c:pt>
                <c:pt idx="35">
                  <c:v>3346.1591796875</c:v>
                </c:pt>
                <c:pt idx="36">
                  <c:v>3349.7177734375</c:v>
                </c:pt>
                <c:pt idx="37">
                  <c:v>3377.43725585937</c:v>
                </c:pt>
                <c:pt idx="38">
                  <c:v>3417.853515625</c:v>
                </c:pt>
                <c:pt idx="39">
                  <c:v>3451.4228515625</c:v>
                </c:pt>
                <c:pt idx="40">
                  <c:v>3467.49291992187</c:v>
                </c:pt>
                <c:pt idx="41">
                  <c:v>3475.7919921875</c:v>
                </c:pt>
                <c:pt idx="42">
                  <c:v>3498.76245117187</c:v>
                </c:pt>
                <c:pt idx="43">
                  <c:v>3547.61303710937</c:v>
                </c:pt>
                <c:pt idx="44">
                  <c:v>3602.23217773437</c:v>
                </c:pt>
                <c:pt idx="45">
                  <c:v>3616.30297851562</c:v>
                </c:pt>
                <c:pt idx="46">
                  <c:v>3549.99584960937</c:v>
                </c:pt>
                <c:pt idx="47">
                  <c:v>3407.66088867187</c:v>
                </c:pt>
                <c:pt idx="48">
                  <c:v>3248.76879882812</c:v>
                </c:pt>
                <c:pt idx="49">
                  <c:v>3157.51586914062</c:v>
                </c:pt>
                <c:pt idx="50">
                  <c:v>3188.5634765625</c:v>
                </c:pt>
                <c:pt idx="51">
                  <c:v>3327.73413085937</c:v>
                </c:pt>
                <c:pt idx="52">
                  <c:v>3498.29345703125</c:v>
                </c:pt>
                <c:pt idx="53">
                  <c:v>3610.27319335937</c:v>
                </c:pt>
                <c:pt idx="54">
                  <c:v>3617.71630859375</c:v>
                </c:pt>
                <c:pt idx="55">
                  <c:v>3542.8427734375</c:v>
                </c:pt>
                <c:pt idx="56">
                  <c:v>3451.93872070312</c:v>
                </c:pt>
                <c:pt idx="57">
                  <c:v>3404.4892578125</c:v>
                </c:pt>
                <c:pt idx="58">
                  <c:v>3415.36596679687</c:v>
                </c:pt>
                <c:pt idx="59">
                  <c:v>3455.91381835937</c:v>
                </c:pt>
                <c:pt idx="60">
                  <c:v>3486.65600585937</c:v>
                </c:pt>
                <c:pt idx="61">
                  <c:v>3490.27099609375</c:v>
                </c:pt>
                <c:pt idx="62">
                  <c:v>3477.77319335937</c:v>
                </c:pt>
                <c:pt idx="63">
                  <c:v>3467.6552734375</c:v>
                </c:pt>
                <c:pt idx="64">
                  <c:v>3462.19116210937</c:v>
                </c:pt>
                <c:pt idx="65">
                  <c:v>3445.52612304687</c:v>
                </c:pt>
                <c:pt idx="66">
                  <c:v>3405.24096679687</c:v>
                </c:pt>
                <c:pt idx="67">
                  <c:v>3354.75512695312</c:v>
                </c:pt>
                <c:pt idx="68">
                  <c:v>3331.337890625</c:v>
                </c:pt>
                <c:pt idx="69">
                  <c:v>3366.79931640625</c:v>
                </c:pt>
                <c:pt idx="70">
                  <c:v>3455.04736328125</c:v>
                </c:pt>
                <c:pt idx="71">
                  <c:v>3547.22778320312</c:v>
                </c:pt>
                <c:pt idx="72">
                  <c:v>3583.48559570312</c:v>
                </c:pt>
                <c:pt idx="73">
                  <c:v>3538.333984375</c:v>
                </c:pt>
                <c:pt idx="74">
                  <c:v>3442.44775390625</c:v>
                </c:pt>
                <c:pt idx="75">
                  <c:v>3361.1220703125</c:v>
                </c:pt>
                <c:pt idx="76">
                  <c:v>3345.06958007812</c:v>
                </c:pt>
                <c:pt idx="77">
                  <c:v>3392.78540039062</c:v>
                </c:pt>
                <c:pt idx="78">
                  <c:v>3454.86279296875</c:v>
                </c:pt>
                <c:pt idx="79">
                  <c:v>3476.23852539062</c:v>
                </c:pt>
                <c:pt idx="80">
                  <c:v>3441.19653320312</c:v>
                </c:pt>
                <c:pt idx="81">
                  <c:v>3384.26245117187</c:v>
                </c:pt>
                <c:pt idx="82">
                  <c:v>3359.12866210937</c:v>
                </c:pt>
                <c:pt idx="83">
                  <c:v>3392.68359375</c:v>
                </c:pt>
                <c:pt idx="84">
                  <c:v>3462.685546875</c:v>
                </c:pt>
                <c:pt idx="85">
                  <c:v>3516.62939453125</c:v>
                </c:pt>
                <c:pt idx="86">
                  <c:v>3514.53393554687</c:v>
                </c:pt>
                <c:pt idx="87">
                  <c:v>3459.5126953125</c:v>
                </c:pt>
                <c:pt idx="88">
                  <c:v>3392.18994140625</c:v>
                </c:pt>
                <c:pt idx="89">
                  <c:v>3356.47143554687</c:v>
                </c:pt>
                <c:pt idx="90">
                  <c:v>3367.17529296875</c:v>
                </c:pt>
                <c:pt idx="91">
                  <c:v>3405.54711914062</c:v>
                </c:pt>
                <c:pt idx="92">
                  <c:v>3442.4072265625</c:v>
                </c:pt>
                <c:pt idx="93">
                  <c:v>3464.89013671875</c:v>
                </c:pt>
                <c:pt idx="94">
                  <c:v>3482.22583007812</c:v>
                </c:pt>
                <c:pt idx="95">
                  <c:v>3507.76147460937</c:v>
                </c:pt>
                <c:pt idx="96">
                  <c:v>3537.4208984375</c:v>
                </c:pt>
                <c:pt idx="97">
                  <c:v>3547.70776367187</c:v>
                </c:pt>
                <c:pt idx="98">
                  <c:v>3516.89208984375</c:v>
                </c:pt>
                <c:pt idx="99">
                  <c:v>3449.74389648437</c:v>
                </c:pt>
                <c:pt idx="100">
                  <c:v>3381.18286132812</c:v>
                </c:pt>
                <c:pt idx="101">
                  <c:v>3352.63452148437</c:v>
                </c:pt>
                <c:pt idx="102">
                  <c:v>3380.13256835937</c:v>
                </c:pt>
                <c:pt idx="103">
                  <c:v>3441.91479492187</c:v>
                </c:pt>
                <c:pt idx="104">
                  <c:v>3496.85131835937</c:v>
                </c:pt>
                <c:pt idx="105">
                  <c:v>3517.79321289062</c:v>
                </c:pt>
                <c:pt idx="106">
                  <c:v>3510.46435546875</c:v>
                </c:pt>
                <c:pt idx="107">
                  <c:v>3501.43188476562</c:v>
                </c:pt>
                <c:pt idx="108">
                  <c:v>3506.87280273437</c:v>
                </c:pt>
                <c:pt idx="109">
                  <c:v>3511.97119140625</c:v>
                </c:pt>
                <c:pt idx="110">
                  <c:v>3481.95385742187</c:v>
                </c:pt>
                <c:pt idx="111">
                  <c:v>3397.06103515625</c:v>
                </c:pt>
                <c:pt idx="112">
                  <c:v>3280.48974609375</c:v>
                </c:pt>
                <c:pt idx="113">
                  <c:v>3191.88500976562</c:v>
                </c:pt>
                <c:pt idx="114">
                  <c:v>3187.4423828125</c:v>
                </c:pt>
                <c:pt idx="115">
                  <c:v>3277.07543945312</c:v>
                </c:pt>
                <c:pt idx="116">
                  <c:v>3413.71875</c:v>
                </c:pt>
                <c:pt idx="117">
                  <c:v>3524.884765625</c:v>
                </c:pt>
                <c:pt idx="118">
                  <c:v>3562.5625</c:v>
                </c:pt>
                <c:pt idx="119">
                  <c:v>3532.90625</c:v>
                </c:pt>
                <c:pt idx="120">
                  <c:v>3484.05444335937</c:v>
                </c:pt>
                <c:pt idx="121">
                  <c:v>3464.34814453125</c:v>
                </c:pt>
                <c:pt idx="122">
                  <c:v>3485.833984375</c:v>
                </c:pt>
                <c:pt idx="123">
                  <c:v>3521.09350585937</c:v>
                </c:pt>
                <c:pt idx="124">
                  <c:v>3532.29028320312</c:v>
                </c:pt>
                <c:pt idx="125">
                  <c:v>3505.23901367187</c:v>
                </c:pt>
                <c:pt idx="126">
                  <c:v>3459.73706054687</c:v>
                </c:pt>
                <c:pt idx="127">
                  <c:v>3429.9228515625</c:v>
                </c:pt>
                <c:pt idx="128">
                  <c:v>3434.25903320312</c:v>
                </c:pt>
                <c:pt idx="129">
                  <c:v>3461.70776367187</c:v>
                </c:pt>
                <c:pt idx="130">
                  <c:v>3484.26879882812</c:v>
                </c:pt>
                <c:pt idx="131">
                  <c:v>3482.30200195312</c:v>
                </c:pt>
                <c:pt idx="132">
                  <c:v>3459.23950195312</c:v>
                </c:pt>
                <c:pt idx="133">
                  <c:v>3433.99169921875</c:v>
                </c:pt>
                <c:pt idx="134">
                  <c:v>3420.55297851562</c:v>
                </c:pt>
                <c:pt idx="135">
                  <c:v>3415.21215820312</c:v>
                </c:pt>
                <c:pt idx="136">
                  <c:v>3403.08715820312</c:v>
                </c:pt>
                <c:pt idx="137">
                  <c:v>3376.478515625</c:v>
                </c:pt>
                <c:pt idx="138">
                  <c:v>3346.22338867187</c:v>
                </c:pt>
                <c:pt idx="139">
                  <c:v>3334.2724609375</c:v>
                </c:pt>
                <c:pt idx="140">
                  <c:v>3354.0966796875</c:v>
                </c:pt>
                <c:pt idx="141">
                  <c:v>3397.62231445312</c:v>
                </c:pt>
                <c:pt idx="142">
                  <c:v>3441.591796875</c:v>
                </c:pt>
                <c:pt idx="143">
                  <c:v>3467.84936523437</c:v>
                </c:pt>
                <c:pt idx="144">
                  <c:v>3478.40893554687</c:v>
                </c:pt>
                <c:pt idx="145">
                  <c:v>3490.50317382812</c:v>
                </c:pt>
                <c:pt idx="146">
                  <c:v>3515.64013671875</c:v>
                </c:pt>
                <c:pt idx="147">
                  <c:v>3542.71875</c:v>
                </c:pt>
                <c:pt idx="148">
                  <c:v>3543.04028320312</c:v>
                </c:pt>
                <c:pt idx="149">
                  <c:v>3495.55810546875</c:v>
                </c:pt>
                <c:pt idx="150">
                  <c:v>3411.05102539062</c:v>
                </c:pt>
                <c:pt idx="151">
                  <c:v>3332.29736328125</c:v>
                </c:pt>
                <c:pt idx="152">
                  <c:v>3306.47998046875</c:v>
                </c:pt>
                <c:pt idx="153">
                  <c:v>3350.13745117187</c:v>
                </c:pt>
                <c:pt idx="154">
                  <c:v>3434.97827148437</c:v>
                </c:pt>
                <c:pt idx="155">
                  <c:v>3507.13500976562</c:v>
                </c:pt>
                <c:pt idx="156">
                  <c:v>3525.61083984375</c:v>
                </c:pt>
                <c:pt idx="157">
                  <c:v>3490.16479492187</c:v>
                </c:pt>
                <c:pt idx="158">
                  <c:v>3437.68383789062</c:v>
                </c:pt>
                <c:pt idx="159">
                  <c:v>3411.6142578125</c:v>
                </c:pt>
                <c:pt idx="160">
                  <c:v>3429.849609375</c:v>
                </c:pt>
                <c:pt idx="161">
                  <c:v>3475.69921875</c:v>
                </c:pt>
                <c:pt idx="162">
                  <c:v>3515.98168945312</c:v>
                </c:pt>
                <c:pt idx="163">
                  <c:v>3528.20141601562</c:v>
                </c:pt>
                <c:pt idx="164">
                  <c:v>3513.68872070312</c:v>
                </c:pt>
                <c:pt idx="165">
                  <c:v>3488.47802734375</c:v>
                </c:pt>
                <c:pt idx="166">
                  <c:v>3464.09741210937</c:v>
                </c:pt>
                <c:pt idx="167">
                  <c:v>3438.04809570312</c:v>
                </c:pt>
                <c:pt idx="168">
                  <c:v>3402.51538085937</c:v>
                </c:pt>
                <c:pt idx="169">
                  <c:v>3361.056640625</c:v>
                </c:pt>
                <c:pt idx="170">
                  <c:v>3334.431640625</c:v>
                </c:pt>
                <c:pt idx="171">
                  <c:v>3346.58544921875</c:v>
                </c:pt>
                <c:pt idx="172">
                  <c:v>3401.224609375</c:v>
                </c:pt>
                <c:pt idx="173">
                  <c:v>3470.51831054687</c:v>
                </c:pt>
                <c:pt idx="174">
                  <c:v>3509.37158203125</c:v>
                </c:pt>
                <c:pt idx="175">
                  <c:v>3487.4423828125</c:v>
                </c:pt>
                <c:pt idx="176">
                  <c:v>3414.62817382812</c:v>
                </c:pt>
                <c:pt idx="177">
                  <c:v>3338.65356445312</c:v>
                </c:pt>
                <c:pt idx="178">
                  <c:v>3314.14135742187</c:v>
                </c:pt>
                <c:pt idx="179">
                  <c:v>3364.76416015625</c:v>
                </c:pt>
                <c:pt idx="180">
                  <c:v>3465.9853515625</c:v>
                </c:pt>
                <c:pt idx="181">
                  <c:v>3560.8876953125</c:v>
                </c:pt>
                <c:pt idx="182">
                  <c:v>3597.53051757812</c:v>
                </c:pt>
                <c:pt idx="183">
                  <c:v>3561.50561523437</c:v>
                </c:pt>
                <c:pt idx="184">
                  <c:v>3482.21948242187</c:v>
                </c:pt>
                <c:pt idx="185">
                  <c:v>3410.86157226562</c:v>
                </c:pt>
                <c:pt idx="186">
                  <c:v>3386.92431640625</c:v>
                </c:pt>
                <c:pt idx="187">
                  <c:v>3415.56518554687</c:v>
                </c:pt>
                <c:pt idx="188">
                  <c:v>3468.29833984375</c:v>
                </c:pt>
                <c:pt idx="189">
                  <c:v>3503.45703125</c:v>
                </c:pt>
                <c:pt idx="190">
                  <c:v>3491.8720703125</c:v>
                </c:pt>
                <c:pt idx="191">
                  <c:v>3432.82495117187</c:v>
                </c:pt>
                <c:pt idx="192">
                  <c:v>3353.130859375</c:v>
                </c:pt>
                <c:pt idx="193">
                  <c:v>3291.85107421875</c:v>
                </c:pt>
                <c:pt idx="194">
                  <c:v>3279.56665039062</c:v>
                </c:pt>
                <c:pt idx="195">
                  <c:v>3322.72485351562</c:v>
                </c:pt>
                <c:pt idx="196">
                  <c:v>3400.81127929687</c:v>
                </c:pt>
                <c:pt idx="197">
                  <c:v>3478.0498046875</c:v>
                </c:pt>
                <c:pt idx="198">
                  <c:v>3523.751953125</c:v>
                </c:pt>
                <c:pt idx="199">
                  <c:v>3529.701171875</c:v>
                </c:pt>
                <c:pt idx="200">
                  <c:v>3513.32421875</c:v>
                </c:pt>
                <c:pt idx="201">
                  <c:v>3503.501953125</c:v>
                </c:pt>
                <c:pt idx="202">
                  <c:v>3517.77465820312</c:v>
                </c:pt>
                <c:pt idx="203">
                  <c:v>3547.09692382812</c:v>
                </c:pt>
                <c:pt idx="204">
                  <c:v>3560.46704101562</c:v>
                </c:pt>
                <c:pt idx="205">
                  <c:v>3527.84912109375</c:v>
                </c:pt>
                <c:pt idx="206">
                  <c:v>3445.4599609375</c:v>
                </c:pt>
                <c:pt idx="207">
                  <c:v>3344.14428710937</c:v>
                </c:pt>
                <c:pt idx="208">
                  <c:v>3272.96484375</c:v>
                </c:pt>
                <c:pt idx="209">
                  <c:v>3268.45434570312</c:v>
                </c:pt>
                <c:pt idx="210">
                  <c:v>3331.19921875</c:v>
                </c:pt>
                <c:pt idx="211">
                  <c:v>3426.45874023437</c:v>
                </c:pt>
                <c:pt idx="212">
                  <c:v>3507.86059570312</c:v>
                </c:pt>
                <c:pt idx="213">
                  <c:v>3546.49829101562</c:v>
                </c:pt>
                <c:pt idx="214">
                  <c:v>3544.8271484375</c:v>
                </c:pt>
                <c:pt idx="215">
                  <c:v>3527.38940429687</c:v>
                </c:pt>
                <c:pt idx="216">
                  <c:v>3518.0380859375</c:v>
                </c:pt>
                <c:pt idx="217">
                  <c:v>3522.06127929687</c:v>
                </c:pt>
                <c:pt idx="218">
                  <c:v>3525.50463867187</c:v>
                </c:pt>
                <c:pt idx="219">
                  <c:v>3509.34057617187</c:v>
                </c:pt>
                <c:pt idx="220">
                  <c:v>3465.43774414062</c:v>
                </c:pt>
                <c:pt idx="221">
                  <c:v>3402.35766601562</c:v>
                </c:pt>
                <c:pt idx="222">
                  <c:v>3339.12475585937</c:v>
                </c:pt>
                <c:pt idx="223">
                  <c:v>3294.4189453125</c:v>
                </c:pt>
                <c:pt idx="224">
                  <c:v>3279.60498046875</c:v>
                </c:pt>
                <c:pt idx="225">
                  <c:v>3297.6611328125</c:v>
                </c:pt>
                <c:pt idx="226">
                  <c:v>3344.06201171875</c:v>
                </c:pt>
                <c:pt idx="227">
                  <c:v>3406.09033203125</c:v>
                </c:pt>
                <c:pt idx="228">
                  <c:v>3462.5830078125</c:v>
                </c:pt>
                <c:pt idx="229">
                  <c:v>3489.5</c:v>
                </c:pt>
                <c:pt idx="230">
                  <c:v>3472.7373046875</c:v>
                </c:pt>
                <c:pt idx="231">
                  <c:v>3420.9365234375</c:v>
                </c:pt>
                <c:pt idx="232">
                  <c:v>3366.51049804687</c:v>
                </c:pt>
                <c:pt idx="233">
                  <c:v>3349.19213867187</c:v>
                </c:pt>
                <c:pt idx="234">
                  <c:v>3390.10815429687</c:v>
                </c:pt>
                <c:pt idx="235">
                  <c:v>3474.4873046875</c:v>
                </c:pt>
                <c:pt idx="236">
                  <c:v>3557.69311523437</c:v>
                </c:pt>
                <c:pt idx="237">
                  <c:v>3593.01513671875</c:v>
                </c:pt>
                <c:pt idx="238">
                  <c:v>3562.6513671875</c:v>
                </c:pt>
                <c:pt idx="239">
                  <c:v>3489.52880859375</c:v>
                </c:pt>
                <c:pt idx="240">
                  <c:v>3421.06567382812</c:v>
                </c:pt>
                <c:pt idx="241">
                  <c:v>3396.73583984375</c:v>
                </c:pt>
                <c:pt idx="242">
                  <c:v>3423.14599609375</c:v>
                </c:pt>
                <c:pt idx="243">
                  <c:v>3473.96459960937</c:v>
                </c:pt>
                <c:pt idx="244">
                  <c:v>3512.73706054687</c:v>
                </c:pt>
                <c:pt idx="245">
                  <c:v>3519.79370117187</c:v>
                </c:pt>
                <c:pt idx="246">
                  <c:v>3503.02905273437</c:v>
                </c:pt>
                <c:pt idx="247">
                  <c:v>3486.45361328125</c:v>
                </c:pt>
                <c:pt idx="248">
                  <c:v>3487.9326171875</c:v>
                </c:pt>
                <c:pt idx="249">
                  <c:v>3504.53979492187</c:v>
                </c:pt>
                <c:pt idx="250">
                  <c:v>3515.98388671875</c:v>
                </c:pt>
                <c:pt idx="251">
                  <c:v>3501.46557617187</c:v>
                </c:pt>
                <c:pt idx="252">
                  <c:v>3455.6669921875</c:v>
                </c:pt>
                <c:pt idx="253">
                  <c:v>3392.18017578125</c:v>
                </c:pt>
                <c:pt idx="254">
                  <c:v>3333.75537109375</c:v>
                </c:pt>
                <c:pt idx="255">
                  <c:v>3298.3515625</c:v>
                </c:pt>
                <c:pt idx="256">
                  <c:v>3291.0380859375</c:v>
                </c:pt>
                <c:pt idx="257">
                  <c:v>3305.2939453125</c:v>
                </c:pt>
                <c:pt idx="258">
                  <c:v>3330.00122070312</c:v>
                </c:pt>
                <c:pt idx="259">
                  <c:v>3356.16967773437</c:v>
                </c:pt>
                <c:pt idx="260">
                  <c:v>3380.1923828125</c:v>
                </c:pt>
                <c:pt idx="261">
                  <c:v>3403.93041992187</c:v>
                </c:pt>
                <c:pt idx="262">
                  <c:v>3432.75341796875</c:v>
                </c:pt>
                <c:pt idx="263">
                  <c:v>3471.60571289062</c:v>
                </c:pt>
                <c:pt idx="264">
                  <c:v>3519.3935546875</c:v>
                </c:pt>
                <c:pt idx="265">
                  <c:v>3564.67016601562</c:v>
                </c:pt>
                <c:pt idx="266">
                  <c:v>3587.6474609375</c:v>
                </c:pt>
                <c:pt idx="267">
                  <c:v>3570.93017578125</c:v>
                </c:pt>
                <c:pt idx="268">
                  <c:v>3514.05346679687</c:v>
                </c:pt>
                <c:pt idx="269">
                  <c:v>3440.74682617187</c:v>
                </c:pt>
                <c:pt idx="270">
                  <c:v>3389.85546875</c:v>
                </c:pt>
                <c:pt idx="271">
                  <c:v>3392.03295898437</c:v>
                </c:pt>
                <c:pt idx="272">
                  <c:v>3446.96533203125</c:v>
                </c:pt>
                <c:pt idx="273">
                  <c:v>3518.91918945312</c:v>
                </c:pt>
                <c:pt idx="274">
                  <c:v>3557.12353515625</c:v>
                </c:pt>
                <c:pt idx="275">
                  <c:v>3529.00439453125</c:v>
                </c:pt>
                <c:pt idx="276">
                  <c:v>3443.00854492187</c:v>
                </c:pt>
                <c:pt idx="277">
                  <c:v>3343.76049804687</c:v>
                </c:pt>
                <c:pt idx="278">
                  <c:v>3282.24267578125</c:v>
                </c:pt>
                <c:pt idx="279">
                  <c:v>3282.47534179687</c:v>
                </c:pt>
                <c:pt idx="280">
                  <c:v>3328.82153320312</c:v>
                </c:pt>
                <c:pt idx="281">
                  <c:v>3382.12573242187</c:v>
                </c:pt>
                <c:pt idx="282">
                  <c:v>3410.88818359375</c:v>
                </c:pt>
                <c:pt idx="283">
                  <c:v>3413.01147460937</c:v>
                </c:pt>
                <c:pt idx="284">
                  <c:v>3412.43115234375</c:v>
                </c:pt>
                <c:pt idx="285">
                  <c:v>3435.48901367187</c:v>
                </c:pt>
                <c:pt idx="286">
                  <c:v>3487.32080078125</c:v>
                </c:pt>
                <c:pt idx="287">
                  <c:v>3546.88159179687</c:v>
                </c:pt>
                <c:pt idx="288">
                  <c:v>3582.9775390625</c:v>
                </c:pt>
                <c:pt idx="289">
                  <c:v>3577.02001953125</c:v>
                </c:pt>
                <c:pt idx="290">
                  <c:v>3534.556640625</c:v>
                </c:pt>
                <c:pt idx="291">
                  <c:v>3478.60961914062</c:v>
                </c:pt>
                <c:pt idx="292">
                  <c:v>3432.90551757812</c:v>
                </c:pt>
                <c:pt idx="293">
                  <c:v>3409.3193359375</c:v>
                </c:pt>
                <c:pt idx="294">
                  <c:v>3407.33349609375</c:v>
                </c:pt>
                <c:pt idx="295">
                  <c:v>3421.4912109375</c:v>
                </c:pt>
                <c:pt idx="296">
                  <c:v>3446.95825195312</c:v>
                </c:pt>
                <c:pt idx="297">
                  <c:v>3477.95556640625</c:v>
                </c:pt>
                <c:pt idx="298">
                  <c:v>3503.2353515625</c:v>
                </c:pt>
                <c:pt idx="299">
                  <c:v>3506.951171875</c:v>
                </c:pt>
                <c:pt idx="300">
                  <c:v>3477.87573242187</c:v>
                </c:pt>
                <c:pt idx="301">
                  <c:v>3420.30517578125</c:v>
                </c:pt>
                <c:pt idx="302">
                  <c:v>3356.0634765625</c:v>
                </c:pt>
                <c:pt idx="303">
                  <c:v>3313.38452148437</c:v>
                </c:pt>
                <c:pt idx="304">
                  <c:v>3309.87231445312</c:v>
                </c:pt>
                <c:pt idx="305">
                  <c:v>3342.64038085937</c:v>
                </c:pt>
                <c:pt idx="306">
                  <c:v>3393.19140625</c:v>
                </c:pt>
                <c:pt idx="307">
                  <c:v>3442.20654296875</c:v>
                </c:pt>
                <c:pt idx="308">
                  <c:v>3481.23779296875</c:v>
                </c:pt>
                <c:pt idx="309">
                  <c:v>3511.8818359375</c:v>
                </c:pt>
                <c:pt idx="310">
                  <c:v>3535.12646484375</c:v>
                </c:pt>
                <c:pt idx="311">
                  <c:v>3542.99047851562</c:v>
                </c:pt>
                <c:pt idx="312">
                  <c:v>3522.36376953125</c:v>
                </c:pt>
                <c:pt idx="313">
                  <c:v>3468.84106445312</c:v>
                </c:pt>
                <c:pt idx="314">
                  <c:v>3397.53637695312</c:v>
                </c:pt>
                <c:pt idx="315">
                  <c:v>3338.86254882812</c:v>
                </c:pt>
                <c:pt idx="316">
                  <c:v>3319.97583007812</c:v>
                </c:pt>
                <c:pt idx="317">
                  <c:v>3345.9794921875</c:v>
                </c:pt>
                <c:pt idx="318">
                  <c:v>3396.67114257812</c:v>
                </c:pt>
                <c:pt idx="319">
                  <c:v>3442.30395507812</c:v>
                </c:pt>
                <c:pt idx="320">
                  <c:v>3465.77221679687</c:v>
                </c:pt>
                <c:pt idx="321">
                  <c:v>3472.93041992187</c:v>
                </c:pt>
                <c:pt idx="322">
                  <c:v>3482.77978515625</c:v>
                </c:pt>
                <c:pt idx="323">
                  <c:v>3506.58276367187</c:v>
                </c:pt>
                <c:pt idx="324">
                  <c:v>3534.5791015625</c:v>
                </c:pt>
                <c:pt idx="325">
                  <c:v>3542.3583984375</c:v>
                </c:pt>
                <c:pt idx="326">
                  <c:v>3511.7939453125</c:v>
                </c:pt>
                <c:pt idx="327">
                  <c:v>3448.63623046875</c:v>
                </c:pt>
                <c:pt idx="328">
                  <c:v>3381.56176757812</c:v>
                </c:pt>
                <c:pt idx="329">
                  <c:v>3343.17016601562</c:v>
                </c:pt>
                <c:pt idx="330">
                  <c:v>3348.41088867187</c:v>
                </c:pt>
                <c:pt idx="331">
                  <c:v>3387.31811523437</c:v>
                </c:pt>
                <c:pt idx="332">
                  <c:v>3436.07470703125</c:v>
                </c:pt>
                <c:pt idx="333">
                  <c:v>3475.0703125</c:v>
                </c:pt>
                <c:pt idx="334">
                  <c:v>3498.32373046875</c:v>
                </c:pt>
                <c:pt idx="335">
                  <c:v>3508.46313476562</c:v>
                </c:pt>
                <c:pt idx="336">
                  <c:v>3505.67626953125</c:v>
                </c:pt>
                <c:pt idx="337">
                  <c:v>3484.1318359375</c:v>
                </c:pt>
                <c:pt idx="338">
                  <c:v>3440.72778320312</c:v>
                </c:pt>
                <c:pt idx="339">
                  <c:v>3387.08520507812</c:v>
                </c:pt>
                <c:pt idx="340">
                  <c:v>3350.27368164062</c:v>
                </c:pt>
                <c:pt idx="341">
                  <c:v>3356.904296875</c:v>
                </c:pt>
                <c:pt idx="342">
                  <c:v>3411.30395507812</c:v>
                </c:pt>
                <c:pt idx="343">
                  <c:v>3486.62353515625</c:v>
                </c:pt>
                <c:pt idx="344">
                  <c:v>3539.28295898437</c:v>
                </c:pt>
                <c:pt idx="345">
                  <c:v>3538.23071289062</c:v>
                </c:pt>
                <c:pt idx="346">
                  <c:v>3487.0556640625</c:v>
                </c:pt>
                <c:pt idx="347">
                  <c:v>3421.25708007812</c:v>
                </c:pt>
                <c:pt idx="348">
                  <c:v>3382.22290039062</c:v>
                </c:pt>
                <c:pt idx="349">
                  <c:v>3387.99365234375</c:v>
                </c:pt>
              </c:numCache>
            </c:numRef>
          </c:yVal>
          <c:smooth val="1"/>
          <c:extLst>
            <c:ext xmlns:c16="http://schemas.microsoft.com/office/drawing/2014/chart" uri="{C3380CC4-5D6E-409C-BE32-E72D297353CC}">
              <c16:uniqueId val="{00000002-4A37-429A-A58F-F7AEDA5D1ACA}"/>
            </c:ext>
          </c:extLst>
        </c:ser>
        <c:ser>
          <c:idx val="3"/>
          <c:order val="3"/>
          <c:tx>
            <c:strRef>
              <c:f>cp_sub_001!$D$1</c:f>
              <c:strCache>
                <c:ptCount val="1"/>
                <c:pt idx="0">
                  <c:v>Coor_4</c:v>
                </c:pt>
              </c:strCache>
            </c:strRef>
          </c:tx>
          <c:spPr>
            <a:ln w="28575" cap="rnd">
              <a:solidFill>
                <a:schemeClr val="accent4"/>
              </a:solidFill>
              <a:round/>
            </a:ln>
            <a:effectLst/>
          </c:spPr>
          <c:marker>
            <c:symbol val="none"/>
          </c:marker>
          <c:yVal>
            <c:numRef>
              <c:f>cp_sub_001!$D$2:$D$351</c:f>
              <c:numCache>
                <c:formatCode>0.00000000000_ </c:formatCode>
                <c:ptCount val="350"/>
                <c:pt idx="0">
                  <c:v>8043.87255859375</c:v>
                </c:pt>
                <c:pt idx="1">
                  <c:v>8029.73876953125</c:v>
                </c:pt>
                <c:pt idx="2">
                  <c:v>8038.97802734375</c:v>
                </c:pt>
                <c:pt idx="3">
                  <c:v>8074.82421875</c:v>
                </c:pt>
                <c:pt idx="4">
                  <c:v>8126.01806640625</c:v>
                </c:pt>
                <c:pt idx="5">
                  <c:v>8171.25439453125</c:v>
                </c:pt>
                <c:pt idx="6">
                  <c:v>8191.5546875</c:v>
                </c:pt>
                <c:pt idx="7">
                  <c:v>8182.1123046875</c:v>
                </c:pt>
                <c:pt idx="8">
                  <c:v>8154.8857421875</c:v>
                </c:pt>
                <c:pt idx="9">
                  <c:v>8129.982421875</c:v>
                </c:pt>
                <c:pt idx="10">
                  <c:v>8122.333984375</c:v>
                </c:pt>
                <c:pt idx="11">
                  <c:v>8133.427734375</c:v>
                </c:pt>
                <c:pt idx="12">
                  <c:v>8153.287109375</c:v>
                </c:pt>
                <c:pt idx="13">
                  <c:v>8169.57666015625</c:v>
                </c:pt>
                <c:pt idx="14">
                  <c:v>8175.69482421875</c:v>
                </c:pt>
                <c:pt idx="15">
                  <c:v>8172.033203125</c:v>
                </c:pt>
                <c:pt idx="16">
                  <c:v>8161.57275390625</c:v>
                </c:pt>
                <c:pt idx="17">
                  <c:v>8145.953125</c:v>
                </c:pt>
                <c:pt idx="18">
                  <c:v>8126.54443359375</c:v>
                </c:pt>
                <c:pt idx="19">
                  <c:v>8108.6845703125</c:v>
                </c:pt>
                <c:pt idx="20">
                  <c:v>8102.73779296875</c:v>
                </c:pt>
                <c:pt idx="21">
                  <c:v>8117.92431640625</c:v>
                </c:pt>
                <c:pt idx="22">
                  <c:v>8152.4619140625</c:v>
                </c:pt>
                <c:pt idx="23">
                  <c:v>8189.2373046875</c:v>
                </c:pt>
                <c:pt idx="24">
                  <c:v>8203.66015625</c:v>
                </c:pt>
                <c:pt idx="25">
                  <c:v>8180.4619140625</c:v>
                </c:pt>
                <c:pt idx="26">
                  <c:v>8127.11962890625</c:v>
                </c:pt>
                <c:pt idx="27">
                  <c:v>8071.90771484375</c:v>
                </c:pt>
                <c:pt idx="28">
                  <c:v>8045.65380859375</c:v>
                </c:pt>
                <c:pt idx="29">
                  <c:v>8059.7138671875</c:v>
                </c:pt>
                <c:pt idx="30">
                  <c:v>8097.275390625</c:v>
                </c:pt>
                <c:pt idx="31">
                  <c:v>8125.89306640625</c:v>
                </c:pt>
                <c:pt idx="32">
                  <c:v>8122.69775390625</c:v>
                </c:pt>
                <c:pt idx="33">
                  <c:v>8093.02490234375</c:v>
                </c:pt>
                <c:pt idx="34">
                  <c:v>8067.43115234375</c:v>
                </c:pt>
                <c:pt idx="35">
                  <c:v>8078.4912109375</c:v>
                </c:pt>
                <c:pt idx="36">
                  <c:v>8134.68212890625</c:v>
                </c:pt>
                <c:pt idx="37">
                  <c:v>8211.365234375</c:v>
                </c:pt>
                <c:pt idx="38">
                  <c:v>8266.0576171875</c:v>
                </c:pt>
                <c:pt idx="39">
                  <c:v>8266.8818359375</c:v>
                </c:pt>
                <c:pt idx="40">
                  <c:v>8213.5</c:v>
                </c:pt>
                <c:pt idx="41">
                  <c:v>8136.07568359375</c:v>
                </c:pt>
                <c:pt idx="42">
                  <c:v>8074.41015625</c:v>
                </c:pt>
                <c:pt idx="43">
                  <c:v>8053.19580078125</c:v>
                </c:pt>
                <c:pt idx="44">
                  <c:v>8070.24755859375</c:v>
                </c:pt>
                <c:pt idx="45">
                  <c:v>8103.28466796875</c:v>
                </c:pt>
                <c:pt idx="46">
                  <c:v>8127.24853515625</c:v>
                </c:pt>
                <c:pt idx="47">
                  <c:v>8128.76513671875</c:v>
                </c:pt>
                <c:pt idx="48">
                  <c:v>8109.66455078125</c:v>
                </c:pt>
                <c:pt idx="49">
                  <c:v>8081.28564453125</c:v>
                </c:pt>
                <c:pt idx="50">
                  <c:v>8056.84423828125</c:v>
                </c:pt>
                <c:pt idx="51">
                  <c:v>8047.04345703125</c:v>
                </c:pt>
                <c:pt idx="52">
                  <c:v>8058.3896484375</c:v>
                </c:pt>
                <c:pt idx="53">
                  <c:v>8090.99609375</c:v>
                </c:pt>
                <c:pt idx="54">
                  <c:v>8135.498046875</c:v>
                </c:pt>
                <c:pt idx="55">
                  <c:v>8173.19775390625</c:v>
                </c:pt>
                <c:pt idx="56">
                  <c:v>8183.62451171875</c:v>
                </c:pt>
                <c:pt idx="57">
                  <c:v>8157.66552734375</c:v>
                </c:pt>
                <c:pt idx="58">
                  <c:v>8107.37841796875</c:v>
                </c:pt>
                <c:pt idx="59">
                  <c:v>8062.94873046875</c:v>
                </c:pt>
                <c:pt idx="60">
                  <c:v>8055.5498046875</c:v>
                </c:pt>
                <c:pt idx="61">
                  <c:v>8096.35595703125</c:v>
                </c:pt>
                <c:pt idx="62">
                  <c:v>8166.958984375</c:v>
                </c:pt>
                <c:pt idx="63">
                  <c:v>8229.564453125</c:v>
                </c:pt>
                <c:pt idx="64">
                  <c:v>8250.9716796875</c:v>
                </c:pt>
                <c:pt idx="65">
                  <c:v>8223.6005859375</c:v>
                </c:pt>
                <c:pt idx="66">
                  <c:v>8168.62353515625</c:v>
                </c:pt>
                <c:pt idx="67">
                  <c:v>8119.5947265625</c:v>
                </c:pt>
                <c:pt idx="68">
                  <c:v>8099.49072265625</c:v>
                </c:pt>
                <c:pt idx="69">
                  <c:v>8108.2255859375</c:v>
                </c:pt>
                <c:pt idx="70">
                  <c:v>8128.517578125</c:v>
                </c:pt>
                <c:pt idx="71">
                  <c:v>8143.18310546875</c:v>
                </c:pt>
                <c:pt idx="72">
                  <c:v>8148.6484375</c:v>
                </c:pt>
                <c:pt idx="73">
                  <c:v>8154.09521484375</c:v>
                </c:pt>
                <c:pt idx="74">
                  <c:v>8168.69189453125</c:v>
                </c:pt>
                <c:pt idx="75">
                  <c:v>8189.51806640625</c:v>
                </c:pt>
                <c:pt idx="76">
                  <c:v>8201.619140625</c:v>
                </c:pt>
                <c:pt idx="77">
                  <c:v>8190.494140625</c:v>
                </c:pt>
                <c:pt idx="78">
                  <c:v>8156.0615234375</c:v>
                </c:pt>
                <c:pt idx="79">
                  <c:v>8115.43408203125</c:v>
                </c:pt>
                <c:pt idx="80">
                  <c:v>8091.13232421875</c:v>
                </c:pt>
                <c:pt idx="81">
                  <c:v>8093.75537109375</c:v>
                </c:pt>
                <c:pt idx="82">
                  <c:v>8113.17626953125</c:v>
                </c:pt>
                <c:pt idx="83">
                  <c:v>8125.79736328125</c:v>
                </c:pt>
                <c:pt idx="84">
                  <c:v>8112.6787109375</c:v>
                </c:pt>
                <c:pt idx="85">
                  <c:v>8074.67724609375</c:v>
                </c:pt>
                <c:pt idx="86">
                  <c:v>8032.9873046875</c:v>
                </c:pt>
                <c:pt idx="87">
                  <c:v>8014.56787109375</c:v>
                </c:pt>
                <c:pt idx="88">
                  <c:v>8033.162109375</c:v>
                </c:pt>
                <c:pt idx="89">
                  <c:v>8079.474609375</c:v>
                </c:pt>
                <c:pt idx="90">
                  <c:v>8127.07861328125</c:v>
                </c:pt>
                <c:pt idx="91">
                  <c:v>8149.4423828125</c:v>
                </c:pt>
                <c:pt idx="92">
                  <c:v>8136.4013671875</c:v>
                </c:pt>
                <c:pt idx="93">
                  <c:v>8099.720703125</c:v>
                </c:pt>
                <c:pt idx="94">
                  <c:v>8065.1904296875</c:v>
                </c:pt>
                <c:pt idx="95">
                  <c:v>8057.06201171875</c:v>
                </c:pt>
                <c:pt idx="96">
                  <c:v>8084.3759765625</c:v>
                </c:pt>
                <c:pt idx="97">
                  <c:v>8136.57568359375</c:v>
                </c:pt>
                <c:pt idx="98">
                  <c:v>8190.0205078125</c:v>
                </c:pt>
                <c:pt idx="99">
                  <c:v>8221.2236328125</c:v>
                </c:pt>
                <c:pt idx="100">
                  <c:v>8219.44921875</c:v>
                </c:pt>
                <c:pt idx="101">
                  <c:v>8191.8369140625</c:v>
                </c:pt>
                <c:pt idx="102">
                  <c:v>8158.10693359375</c:v>
                </c:pt>
                <c:pt idx="103">
                  <c:v>8137.6640625</c:v>
                </c:pt>
                <c:pt idx="104">
                  <c:v>8136.78564453125</c:v>
                </c:pt>
                <c:pt idx="105">
                  <c:v>8144.4072265625</c:v>
                </c:pt>
                <c:pt idx="106">
                  <c:v>8140.306640625</c:v>
                </c:pt>
                <c:pt idx="107">
                  <c:v>8111.2119140625</c:v>
                </c:pt>
                <c:pt idx="108">
                  <c:v>8063.91357421875</c:v>
                </c:pt>
                <c:pt idx="109">
                  <c:v>8025.02587890625</c:v>
                </c:pt>
                <c:pt idx="110">
                  <c:v>8025.54638671875</c:v>
                </c:pt>
                <c:pt idx="111">
                  <c:v>8079.47802734375</c:v>
                </c:pt>
                <c:pt idx="112">
                  <c:v>8171.30615234375</c:v>
                </c:pt>
                <c:pt idx="113">
                  <c:v>8262.1533203125</c:v>
                </c:pt>
                <c:pt idx="114">
                  <c:v>8311.6767578125</c:v>
                </c:pt>
                <c:pt idx="115">
                  <c:v>8301.4423828125</c:v>
                </c:pt>
                <c:pt idx="116">
                  <c:v>8244.2080078125</c:v>
                </c:pt>
                <c:pt idx="117">
                  <c:v>8173.5400390625</c:v>
                </c:pt>
                <c:pt idx="118">
                  <c:v>8122.06591796875</c:v>
                </c:pt>
                <c:pt idx="119">
                  <c:v>8103.85009765625</c:v>
                </c:pt>
                <c:pt idx="120">
                  <c:v>8111.716796875</c:v>
                </c:pt>
                <c:pt idx="121">
                  <c:v>8128.18798828125</c:v>
                </c:pt>
                <c:pt idx="122">
                  <c:v>8139.0595703125</c:v>
                </c:pt>
                <c:pt idx="123">
                  <c:v>8139.0302734375</c:v>
                </c:pt>
                <c:pt idx="124">
                  <c:v>8127.830078125</c:v>
                </c:pt>
                <c:pt idx="125">
                  <c:v>8104.3408203125</c:v>
                </c:pt>
                <c:pt idx="126">
                  <c:v>8066.97216796875</c:v>
                </c:pt>
                <c:pt idx="127">
                  <c:v>8020.7109375</c:v>
                </c:pt>
                <c:pt idx="128">
                  <c:v>7982.4736328125</c:v>
                </c:pt>
                <c:pt idx="129">
                  <c:v>7975.74658203125</c:v>
                </c:pt>
                <c:pt idx="130">
                  <c:v>8014.6142578125</c:v>
                </c:pt>
                <c:pt idx="131">
                  <c:v>8088.62353515625</c:v>
                </c:pt>
                <c:pt idx="132">
                  <c:v>8162.72021484375</c:v>
                </c:pt>
                <c:pt idx="133">
                  <c:v>8196.587890625</c:v>
                </c:pt>
                <c:pt idx="134">
                  <c:v>8171.97412109375</c:v>
                </c:pt>
                <c:pt idx="135">
                  <c:v>8107.98193359375</c:v>
                </c:pt>
                <c:pt idx="136">
                  <c:v>8051.0712890625</c:v>
                </c:pt>
                <c:pt idx="137">
                  <c:v>8044.75146484375</c:v>
                </c:pt>
                <c:pt idx="138">
                  <c:v>8099.818359375</c:v>
                </c:pt>
                <c:pt idx="139">
                  <c:v>8186.68017578125</c:v>
                </c:pt>
                <c:pt idx="140">
                  <c:v>8255.552734375</c:v>
                </c:pt>
                <c:pt idx="141">
                  <c:v>8269.841796875</c:v>
                </c:pt>
                <c:pt idx="142">
                  <c:v>8228.6455078125</c:v>
                </c:pt>
                <c:pt idx="143">
                  <c:v>8163.1376953125</c:v>
                </c:pt>
                <c:pt idx="144">
                  <c:v>8111.55859375</c:v>
                </c:pt>
                <c:pt idx="145">
                  <c:v>8092.9306640625</c:v>
                </c:pt>
                <c:pt idx="146">
                  <c:v>8098.78662109375</c:v>
                </c:pt>
                <c:pt idx="147">
                  <c:v>8106.63525390625</c:v>
                </c:pt>
                <c:pt idx="148">
                  <c:v>8101.6884765625</c:v>
                </c:pt>
                <c:pt idx="149">
                  <c:v>8088.2880859375</c:v>
                </c:pt>
                <c:pt idx="150">
                  <c:v>8082.79296875</c:v>
                </c:pt>
                <c:pt idx="151">
                  <c:v>8096.0341796875</c:v>
                </c:pt>
                <c:pt idx="152">
                  <c:v>8121.90576171875</c:v>
                </c:pt>
                <c:pt idx="153">
                  <c:v>8142.43798828125</c:v>
                </c:pt>
                <c:pt idx="154">
                  <c:v>8144.65283203125</c:v>
                </c:pt>
                <c:pt idx="155">
                  <c:v>8133.7666015625</c:v>
                </c:pt>
                <c:pt idx="156">
                  <c:v>8130.19873046875</c:v>
                </c:pt>
                <c:pt idx="157">
                  <c:v>8151.8994140625</c:v>
                </c:pt>
                <c:pt idx="158">
                  <c:v>8196.716796875</c:v>
                </c:pt>
                <c:pt idx="159">
                  <c:v>8240.408203125</c:v>
                </c:pt>
                <c:pt idx="160">
                  <c:v>8253.3583984375</c:v>
                </c:pt>
                <c:pt idx="161">
                  <c:v>8223.3388671875</c:v>
                </c:pt>
                <c:pt idx="162">
                  <c:v>8165.9248046875</c:v>
                </c:pt>
                <c:pt idx="163">
                  <c:v>8113.58251953125</c:v>
                </c:pt>
                <c:pt idx="164">
                  <c:v>8091.5595703125</c:v>
                </c:pt>
                <c:pt idx="165">
                  <c:v>8099.638671875</c:v>
                </c:pt>
                <c:pt idx="166">
                  <c:v>8114.37451171875</c:v>
                </c:pt>
                <c:pt idx="167">
                  <c:v>8109.98388671875</c:v>
                </c:pt>
                <c:pt idx="168">
                  <c:v>8080.822265625</c:v>
                </c:pt>
                <c:pt idx="169">
                  <c:v>8046.84521484375</c:v>
                </c:pt>
                <c:pt idx="170">
                  <c:v>8037.1796875</c:v>
                </c:pt>
                <c:pt idx="171">
                  <c:v>8064.97509765625</c:v>
                </c:pt>
                <c:pt idx="172">
                  <c:v>8114.42919921875</c:v>
                </c:pt>
                <c:pt idx="173">
                  <c:v>8151.59912109375</c:v>
                </c:pt>
                <c:pt idx="174">
                  <c:v>8151.375</c:v>
                </c:pt>
                <c:pt idx="175">
                  <c:v>8119.1328125</c:v>
                </c:pt>
                <c:pt idx="176">
                  <c:v>8088.64990234375</c:v>
                </c:pt>
                <c:pt idx="177">
                  <c:v>8096.0947265625</c:v>
                </c:pt>
                <c:pt idx="178">
                  <c:v>8149.3720703125</c:v>
                </c:pt>
                <c:pt idx="179">
                  <c:v>8217.201171875</c:v>
                </c:pt>
                <c:pt idx="180">
                  <c:v>8248.345703125</c:v>
                </c:pt>
                <c:pt idx="181">
                  <c:v>8208.48046875</c:v>
                </c:pt>
                <c:pt idx="182">
                  <c:v>8107.8017578125</c:v>
                </c:pt>
                <c:pt idx="183">
                  <c:v>7998.134765625</c:v>
                </c:pt>
                <c:pt idx="184">
                  <c:v>7940.28369140625</c:v>
                </c:pt>
                <c:pt idx="185">
                  <c:v>7964.33154296875</c:v>
                </c:pt>
                <c:pt idx="186">
                  <c:v>8050.9970703125</c:v>
                </c:pt>
                <c:pt idx="187">
                  <c:v>8146.78173828125</c:v>
                </c:pt>
                <c:pt idx="188">
                  <c:v>8201.056640625</c:v>
                </c:pt>
                <c:pt idx="189">
                  <c:v>8197.94921875</c:v>
                </c:pt>
                <c:pt idx="190">
                  <c:v>8161.03759765625</c:v>
                </c:pt>
                <c:pt idx="191">
                  <c:v>8130.0908203125</c:v>
                </c:pt>
                <c:pt idx="192">
                  <c:v>8129.63232421875</c:v>
                </c:pt>
                <c:pt idx="193">
                  <c:v>8153.57666015625</c:v>
                </c:pt>
                <c:pt idx="194">
                  <c:v>8175.78466796875</c:v>
                </c:pt>
                <c:pt idx="195">
                  <c:v>8175.375</c:v>
                </c:pt>
                <c:pt idx="196">
                  <c:v>8154.78759765625</c:v>
                </c:pt>
                <c:pt idx="197">
                  <c:v>8136.14306640625</c:v>
                </c:pt>
                <c:pt idx="198">
                  <c:v>8140.3662109375</c:v>
                </c:pt>
                <c:pt idx="199">
                  <c:v>8167.93359375</c:v>
                </c:pt>
                <c:pt idx="200">
                  <c:v>8198.0478515625</c:v>
                </c:pt>
                <c:pt idx="201">
                  <c:v>8206.728515625</c:v>
                </c:pt>
                <c:pt idx="202">
                  <c:v>8187.7041015625</c:v>
                </c:pt>
                <c:pt idx="203">
                  <c:v>8157.51318359375</c:v>
                </c:pt>
                <c:pt idx="204">
                  <c:v>8139.96435546875</c:v>
                </c:pt>
                <c:pt idx="205">
                  <c:v>8143.55078125</c:v>
                </c:pt>
                <c:pt idx="206">
                  <c:v>8152.3369140625</c:v>
                </c:pt>
                <c:pt idx="207">
                  <c:v>8139.8017578125</c:v>
                </c:pt>
                <c:pt idx="208">
                  <c:v>8094.90185546875</c:v>
                </c:pt>
                <c:pt idx="209">
                  <c:v>8037.48779296875</c:v>
                </c:pt>
                <c:pt idx="210">
                  <c:v>8007.43798828125</c:v>
                </c:pt>
                <c:pt idx="211">
                  <c:v>8033.5068359375</c:v>
                </c:pt>
                <c:pt idx="212">
                  <c:v>8106.3759765625</c:v>
                </c:pt>
                <c:pt idx="213">
                  <c:v>8179.55517578125</c:v>
                </c:pt>
                <c:pt idx="214">
                  <c:v>8200.818359375</c:v>
                </c:pt>
                <c:pt idx="215">
                  <c:v>8151.86083984375</c:v>
                </c:pt>
                <c:pt idx="216">
                  <c:v>8065.2353515625</c:v>
                </c:pt>
                <c:pt idx="217">
                  <c:v>8003.54833984375</c:v>
                </c:pt>
                <c:pt idx="218">
                  <c:v>8014.70703125</c:v>
                </c:pt>
                <c:pt idx="219">
                  <c:v>8096.32275390625</c:v>
                </c:pt>
                <c:pt idx="220">
                  <c:v>8196.365234375</c:v>
                </c:pt>
                <c:pt idx="221">
                  <c:v>8249.9853515625</c:v>
                </c:pt>
                <c:pt idx="222">
                  <c:v>8225.052734375</c:v>
                </c:pt>
                <c:pt idx="223">
                  <c:v>8142.67822265625</c:v>
                </c:pt>
                <c:pt idx="224">
                  <c:v>8058.68212890625</c:v>
                </c:pt>
                <c:pt idx="225">
                  <c:v>8021.876953125</c:v>
                </c:pt>
                <c:pt idx="226">
                  <c:v>8041.73388671875</c:v>
                </c:pt>
                <c:pt idx="227">
                  <c:v>8088.85107421875</c:v>
                </c:pt>
                <c:pt idx="228">
                  <c:v>8124.72509765625</c:v>
                </c:pt>
                <c:pt idx="229">
                  <c:v>8134.59765625</c:v>
                </c:pt>
                <c:pt idx="230">
                  <c:v>8136.44482421875</c:v>
                </c:pt>
                <c:pt idx="231">
                  <c:v>8160.1767578125</c:v>
                </c:pt>
                <c:pt idx="232">
                  <c:v>8216.0380859375</c:v>
                </c:pt>
                <c:pt idx="233">
                  <c:v>8279.70703125</c:v>
                </c:pt>
                <c:pt idx="234">
                  <c:v>8307.271484375</c:v>
                </c:pt>
                <c:pt idx="235">
                  <c:v>8268.451171875</c:v>
                </c:pt>
                <c:pt idx="236">
                  <c:v>8171.49951171875</c:v>
                </c:pt>
                <c:pt idx="237">
                  <c:v>8060.0927734375</c:v>
                </c:pt>
                <c:pt idx="238">
                  <c:v>7984.82763671875</c:v>
                </c:pt>
                <c:pt idx="239">
                  <c:v>7971.47998046875</c:v>
                </c:pt>
                <c:pt idx="240">
                  <c:v>8009.34521484375</c:v>
                </c:pt>
                <c:pt idx="241">
                  <c:v>8065.88916015625</c:v>
                </c:pt>
                <c:pt idx="242">
                  <c:v>8113.2451171875</c:v>
                </c:pt>
                <c:pt idx="243">
                  <c:v>8144.5849609375</c:v>
                </c:pt>
                <c:pt idx="244">
                  <c:v>8169.18994140625</c:v>
                </c:pt>
                <c:pt idx="245">
                  <c:v>8194.0654296875</c:v>
                </c:pt>
                <c:pt idx="246">
                  <c:v>8210.8525390625</c:v>
                </c:pt>
                <c:pt idx="247">
                  <c:v>8200.87109375</c:v>
                </c:pt>
                <c:pt idx="248">
                  <c:v>8154.14111328125</c:v>
                </c:pt>
                <c:pt idx="249">
                  <c:v>8085.02392578125</c:v>
                </c:pt>
                <c:pt idx="250">
                  <c:v>8029.02294921875</c:v>
                </c:pt>
                <c:pt idx="251">
                  <c:v>8020.71875</c:v>
                </c:pt>
                <c:pt idx="252">
                  <c:v>8068.84130859375</c:v>
                </c:pt>
                <c:pt idx="253">
                  <c:v>8147.87939453125</c:v>
                </c:pt>
                <c:pt idx="254">
                  <c:v>8213.478515625</c:v>
                </c:pt>
                <c:pt idx="255">
                  <c:v>8230.935546875</c:v>
                </c:pt>
                <c:pt idx="256">
                  <c:v>8196.458984375</c:v>
                </c:pt>
                <c:pt idx="257">
                  <c:v>8136.7490234375</c:v>
                </c:pt>
                <c:pt idx="258">
                  <c:v>8088.7646484375</c:v>
                </c:pt>
                <c:pt idx="259">
                  <c:v>8075.4501953125</c:v>
                </c:pt>
                <c:pt idx="260">
                  <c:v>8094.48876953125</c:v>
                </c:pt>
                <c:pt idx="261">
                  <c:v>8125.87451171875</c:v>
                </c:pt>
                <c:pt idx="262">
                  <c:v>8149.79736328125</c:v>
                </c:pt>
                <c:pt idx="263">
                  <c:v>8159.9990234375</c:v>
                </c:pt>
                <c:pt idx="264">
                  <c:v>8163.3486328125</c:v>
                </c:pt>
                <c:pt idx="265">
                  <c:v>8168.359375</c:v>
                </c:pt>
                <c:pt idx="266">
                  <c:v>8173.9462890625</c:v>
                </c:pt>
                <c:pt idx="267">
                  <c:v>8168.5205078125</c:v>
                </c:pt>
                <c:pt idx="268">
                  <c:v>8140.310546875</c:v>
                </c:pt>
                <c:pt idx="269">
                  <c:v>8090.2919921875</c:v>
                </c:pt>
                <c:pt idx="270">
                  <c:v>8036.71826171875</c:v>
                </c:pt>
                <c:pt idx="271">
                  <c:v>8006.54248046875</c:v>
                </c:pt>
                <c:pt idx="272">
                  <c:v>8018.89892578125</c:v>
                </c:pt>
                <c:pt idx="273">
                  <c:v>8071.94775390625</c:v>
                </c:pt>
                <c:pt idx="274">
                  <c:v>8142.349609375</c:v>
                </c:pt>
                <c:pt idx="275">
                  <c:v>8198.1328125</c:v>
                </c:pt>
                <c:pt idx="276">
                  <c:v>8216.7548828125</c:v>
                </c:pt>
                <c:pt idx="277">
                  <c:v>8196.837890625</c:v>
                </c:pt>
                <c:pt idx="278">
                  <c:v>8156.4443359375</c:v>
                </c:pt>
                <c:pt idx="279">
                  <c:v>8119.7216796875</c:v>
                </c:pt>
                <c:pt idx="280">
                  <c:v>8101.2646484375</c:v>
                </c:pt>
                <c:pt idx="281">
                  <c:v>8098.71240234375</c:v>
                </c:pt>
                <c:pt idx="282">
                  <c:v>8098.17138671875</c:v>
                </c:pt>
                <c:pt idx="283">
                  <c:v>8088.06640625</c:v>
                </c:pt>
                <c:pt idx="284">
                  <c:v>8071.01171875</c:v>
                </c:pt>
                <c:pt idx="285">
                  <c:v>8064.482421875</c:v>
                </c:pt>
                <c:pt idx="286">
                  <c:v>8088.86962890625</c:v>
                </c:pt>
                <c:pt idx="287">
                  <c:v>8150.69970703125</c:v>
                </c:pt>
                <c:pt idx="288">
                  <c:v>8232.9775390625</c:v>
                </c:pt>
                <c:pt idx="289">
                  <c:v>8300.5224609375</c:v>
                </c:pt>
                <c:pt idx="290">
                  <c:v>8318.27734375</c:v>
                </c:pt>
                <c:pt idx="291">
                  <c:v>8271.56640625</c:v>
                </c:pt>
                <c:pt idx="292">
                  <c:v>8175.52783203125</c:v>
                </c:pt>
                <c:pt idx="293">
                  <c:v>8067.74365234375</c:v>
                </c:pt>
                <c:pt idx="294">
                  <c:v>7988.82470703125</c:v>
                </c:pt>
                <c:pt idx="295">
                  <c:v>7962.943359375</c:v>
                </c:pt>
                <c:pt idx="296">
                  <c:v>7989.294921875</c:v>
                </c:pt>
                <c:pt idx="297">
                  <c:v>8047.48388671875</c:v>
                </c:pt>
                <c:pt idx="298">
                  <c:v>8110.97021484375</c:v>
                </c:pt>
                <c:pt idx="299">
                  <c:v>8159.18701171875</c:v>
                </c:pt>
                <c:pt idx="300">
                  <c:v>8182.31005859375</c:v>
                </c:pt>
                <c:pt idx="301">
                  <c:v>8179.34228515625</c:v>
                </c:pt>
                <c:pt idx="302">
                  <c:v>8154.45166015625</c:v>
                </c:pt>
                <c:pt idx="303">
                  <c:v>8115.57958984375</c:v>
                </c:pt>
                <c:pt idx="304">
                  <c:v>8075.00634765625</c:v>
                </c:pt>
                <c:pt idx="305">
                  <c:v>8048.39453125</c:v>
                </c:pt>
                <c:pt idx="306">
                  <c:v>8049.861328125</c:v>
                </c:pt>
                <c:pt idx="307">
                  <c:v>8084.72509765625</c:v>
                </c:pt>
                <c:pt idx="308">
                  <c:v>8144.83544921875</c:v>
                </c:pt>
                <c:pt idx="309">
                  <c:v>8210.5517578125</c:v>
                </c:pt>
                <c:pt idx="310">
                  <c:v>8259.0615234375</c:v>
                </c:pt>
                <c:pt idx="311">
                  <c:v>8274.35546875</c:v>
                </c:pt>
                <c:pt idx="312">
                  <c:v>8253.3388671875</c:v>
                </c:pt>
                <c:pt idx="313">
                  <c:v>8205.58203125</c:v>
                </c:pt>
                <c:pt idx="314">
                  <c:v>8148.255859375</c:v>
                </c:pt>
                <c:pt idx="315">
                  <c:v>8099.6484375</c:v>
                </c:pt>
                <c:pt idx="316">
                  <c:v>8073.60595703125</c:v>
                </c:pt>
                <c:pt idx="317">
                  <c:v>8075.3896484375</c:v>
                </c:pt>
                <c:pt idx="318">
                  <c:v>8099.1669921875</c:v>
                </c:pt>
                <c:pt idx="319">
                  <c:v>8128.70751953125</c:v>
                </c:pt>
                <c:pt idx="320">
                  <c:v>8143.34228515625</c:v>
                </c:pt>
                <c:pt idx="321">
                  <c:v>8128.689453125</c:v>
                </c:pt>
                <c:pt idx="322">
                  <c:v>8087.0419921875</c:v>
                </c:pt>
                <c:pt idx="323">
                  <c:v>8039.76220703125</c:v>
                </c:pt>
                <c:pt idx="324">
                  <c:v>8017.27783203125</c:v>
                </c:pt>
                <c:pt idx="325">
                  <c:v>8040.5419921875</c:v>
                </c:pt>
                <c:pt idx="326">
                  <c:v>8105.3935546875</c:v>
                </c:pt>
                <c:pt idx="327">
                  <c:v>8181.5234375</c:v>
                </c:pt>
                <c:pt idx="328">
                  <c:v>8228.912109375</c:v>
                </c:pt>
                <c:pt idx="329">
                  <c:v>8222.2578125</c:v>
                </c:pt>
                <c:pt idx="330">
                  <c:v>8167.18017578125</c:v>
                </c:pt>
                <c:pt idx="331">
                  <c:v>8096.74560546875</c:v>
                </c:pt>
                <c:pt idx="332">
                  <c:v>8050.24755859375</c:v>
                </c:pt>
                <c:pt idx="333">
                  <c:v>8048.6708984375</c:v>
                </c:pt>
                <c:pt idx="334">
                  <c:v>8083.45849609375</c:v>
                </c:pt>
                <c:pt idx="335">
                  <c:v>8125.40673828125</c:v>
                </c:pt>
                <c:pt idx="336">
                  <c:v>8146.154296875</c:v>
                </c:pt>
                <c:pt idx="337">
                  <c:v>8136.5</c:v>
                </c:pt>
                <c:pt idx="338">
                  <c:v>8109.44140625</c:v>
                </c:pt>
                <c:pt idx="339">
                  <c:v>8087.8974609375</c:v>
                </c:pt>
                <c:pt idx="340">
                  <c:v>8087.90087890625</c:v>
                </c:pt>
                <c:pt idx="341">
                  <c:v>8109.6826171875</c:v>
                </c:pt>
                <c:pt idx="342">
                  <c:v>8141.35205078125</c:v>
                </c:pt>
                <c:pt idx="343">
                  <c:v>8169.7587890625</c:v>
                </c:pt>
                <c:pt idx="344">
                  <c:v>8188.83935546875</c:v>
                </c:pt>
                <c:pt idx="345">
                  <c:v>8199.75</c:v>
                </c:pt>
                <c:pt idx="346">
                  <c:v>8205.0390625</c:v>
                </c:pt>
                <c:pt idx="347">
                  <c:v>8203.7724609375</c:v>
                </c:pt>
                <c:pt idx="348">
                  <c:v>8192.4287109375</c:v>
                </c:pt>
                <c:pt idx="349">
                  <c:v>8170.14892578125</c:v>
                </c:pt>
              </c:numCache>
            </c:numRef>
          </c:yVal>
          <c:smooth val="1"/>
          <c:extLst>
            <c:ext xmlns:c16="http://schemas.microsoft.com/office/drawing/2014/chart" uri="{C3380CC4-5D6E-409C-BE32-E72D297353CC}">
              <c16:uniqueId val="{00000003-4A37-429A-A58F-F7AEDA5D1ACA}"/>
            </c:ext>
          </c:extLst>
        </c:ser>
        <c:ser>
          <c:idx val="4"/>
          <c:order val="4"/>
          <c:tx>
            <c:strRef>
              <c:f>cp_sub_001!$E$1</c:f>
              <c:strCache>
                <c:ptCount val="1"/>
                <c:pt idx="0">
                  <c:v>Coor_5</c:v>
                </c:pt>
              </c:strCache>
            </c:strRef>
          </c:tx>
          <c:spPr>
            <a:ln w="28575" cap="rnd">
              <a:solidFill>
                <a:schemeClr val="accent5"/>
              </a:solidFill>
              <a:round/>
            </a:ln>
            <a:effectLst/>
          </c:spPr>
          <c:marker>
            <c:symbol val="none"/>
          </c:marker>
          <c:yVal>
            <c:numRef>
              <c:f>cp_sub_001!$E$2:$E$351</c:f>
              <c:numCache>
                <c:formatCode>0.00000000000_ </c:formatCode>
                <c:ptCount val="350"/>
                <c:pt idx="0">
                  <c:v>3585.20825195312</c:v>
                </c:pt>
                <c:pt idx="1">
                  <c:v>3608.0625</c:v>
                </c:pt>
                <c:pt idx="2">
                  <c:v>3602.87280273437</c:v>
                </c:pt>
                <c:pt idx="3">
                  <c:v>3565.15063476562</c:v>
                </c:pt>
                <c:pt idx="4">
                  <c:v>3513.42138671875</c:v>
                </c:pt>
                <c:pt idx="5">
                  <c:v>3479.86157226562</c:v>
                </c:pt>
                <c:pt idx="6">
                  <c:v>3488.95751953125</c:v>
                </c:pt>
                <c:pt idx="7">
                  <c:v>3539.4814453125</c:v>
                </c:pt>
                <c:pt idx="8">
                  <c:v>3603.8828125</c:v>
                </c:pt>
                <c:pt idx="9">
                  <c:v>3646.44067382812</c:v>
                </c:pt>
                <c:pt idx="10">
                  <c:v>3646.97143554687</c:v>
                </c:pt>
                <c:pt idx="11">
                  <c:v>3612.38598632812</c:v>
                </c:pt>
                <c:pt idx="12">
                  <c:v>3567.99365234375</c:v>
                </c:pt>
                <c:pt idx="13">
                  <c:v>3536.63232421875</c:v>
                </c:pt>
                <c:pt idx="14">
                  <c:v>3523.14331054687</c:v>
                </c:pt>
                <c:pt idx="15">
                  <c:v>3516.46459960937</c:v>
                </c:pt>
                <c:pt idx="16">
                  <c:v>3505.9912109375</c:v>
                </c:pt>
                <c:pt idx="17">
                  <c:v>3496.16186523437</c:v>
                </c:pt>
                <c:pt idx="18">
                  <c:v>3504.66333007812</c:v>
                </c:pt>
                <c:pt idx="19">
                  <c:v>3544.44873046875</c:v>
                </c:pt>
                <c:pt idx="20">
                  <c:v>3605.39331054687</c:v>
                </c:pt>
                <c:pt idx="21">
                  <c:v>3653.85595703125</c:v>
                </c:pt>
                <c:pt idx="22">
                  <c:v>3654.41015625</c:v>
                </c:pt>
                <c:pt idx="23">
                  <c:v>3598.48486328125</c:v>
                </c:pt>
                <c:pt idx="24">
                  <c:v>3516.291015625</c:v>
                </c:pt>
                <c:pt idx="25">
                  <c:v>3459.4873046875</c:v>
                </c:pt>
                <c:pt idx="26">
                  <c:v>3464.9482421875</c:v>
                </c:pt>
                <c:pt idx="27">
                  <c:v>3526.46484375</c:v>
                </c:pt>
                <c:pt idx="28">
                  <c:v>3597.1513671875</c:v>
                </c:pt>
                <c:pt idx="29">
                  <c:v>3622.6767578125</c:v>
                </c:pt>
                <c:pt idx="30">
                  <c:v>3581.41650390625</c:v>
                </c:pt>
                <c:pt idx="31">
                  <c:v>3501.328125</c:v>
                </c:pt>
                <c:pt idx="32">
                  <c:v>3440.33276367187</c:v>
                </c:pt>
                <c:pt idx="33">
                  <c:v>3444.47338867187</c:v>
                </c:pt>
                <c:pt idx="34">
                  <c:v>3514.83203125</c:v>
                </c:pt>
                <c:pt idx="35">
                  <c:v>3607.27172851562</c:v>
                </c:pt>
                <c:pt idx="36">
                  <c:v>3664.1123046875</c:v>
                </c:pt>
                <c:pt idx="37">
                  <c:v>3653.41479492187</c:v>
                </c:pt>
                <c:pt idx="38">
                  <c:v>3587.46411132812</c:v>
                </c:pt>
                <c:pt idx="39">
                  <c:v>3509.43676757812</c:v>
                </c:pt>
                <c:pt idx="40">
                  <c:v>3461.50610351562</c:v>
                </c:pt>
                <c:pt idx="41">
                  <c:v>3459.61279296875</c:v>
                </c:pt>
                <c:pt idx="42">
                  <c:v>3491.59716796875</c:v>
                </c:pt>
                <c:pt idx="43">
                  <c:v>3534.96557617187</c:v>
                </c:pt>
                <c:pt idx="44">
                  <c:v>3575.78442382812</c:v>
                </c:pt>
                <c:pt idx="45">
                  <c:v>3612.63500976562</c:v>
                </c:pt>
                <c:pt idx="46">
                  <c:v>3645.54150390625</c:v>
                </c:pt>
                <c:pt idx="47">
                  <c:v>3664.36474609375</c:v>
                </c:pt>
                <c:pt idx="48">
                  <c:v>3651.23754882812</c:v>
                </c:pt>
                <c:pt idx="49">
                  <c:v>3597.39868164062</c:v>
                </c:pt>
                <c:pt idx="50">
                  <c:v>3519.29614257812</c:v>
                </c:pt>
                <c:pt idx="51">
                  <c:v>3456.56665039062</c:v>
                </c:pt>
                <c:pt idx="52">
                  <c:v>3448.55444335937</c:v>
                </c:pt>
                <c:pt idx="53">
                  <c:v>3505.09350585937</c:v>
                </c:pt>
                <c:pt idx="54">
                  <c:v>3594.85131835937</c:v>
                </c:pt>
                <c:pt idx="55">
                  <c:v>3663.02026367187</c:v>
                </c:pt>
                <c:pt idx="56">
                  <c:v>3667.7216796875</c:v>
                </c:pt>
                <c:pt idx="57">
                  <c:v>3608.91772460937</c:v>
                </c:pt>
                <c:pt idx="58">
                  <c:v>3527.92138671875</c:v>
                </c:pt>
                <c:pt idx="59">
                  <c:v>3477.23071289062</c:v>
                </c:pt>
                <c:pt idx="60">
                  <c:v>3482.85913085937</c:v>
                </c:pt>
                <c:pt idx="61">
                  <c:v>3527.12817382812</c:v>
                </c:pt>
                <c:pt idx="62">
                  <c:v>3564.3818359375</c:v>
                </c:pt>
                <c:pt idx="63">
                  <c:v>3557.1796875</c:v>
                </c:pt>
                <c:pt idx="64">
                  <c:v>3505.34643554687</c:v>
                </c:pt>
                <c:pt idx="65">
                  <c:v>3446.22338867187</c:v>
                </c:pt>
                <c:pt idx="66">
                  <c:v>3426.58520507812</c:v>
                </c:pt>
                <c:pt idx="67">
                  <c:v>3467.83544921875</c:v>
                </c:pt>
                <c:pt idx="68">
                  <c:v>3550.3603515625</c:v>
                </c:pt>
                <c:pt idx="69">
                  <c:v>3627.80151367187</c:v>
                </c:pt>
                <c:pt idx="70">
                  <c:v>3659.59594726562</c:v>
                </c:pt>
                <c:pt idx="71">
                  <c:v>3637.47827148437</c:v>
                </c:pt>
                <c:pt idx="72">
                  <c:v>3587.5224609375</c:v>
                </c:pt>
                <c:pt idx="73">
                  <c:v>3548.23120117187</c:v>
                </c:pt>
                <c:pt idx="74">
                  <c:v>3542.3671875</c:v>
                </c:pt>
                <c:pt idx="75">
                  <c:v>3563.19799804687</c:v>
                </c:pt>
                <c:pt idx="76">
                  <c:v>3583.59814453125</c:v>
                </c:pt>
                <c:pt idx="77">
                  <c:v>3579.17333984375</c:v>
                </c:pt>
                <c:pt idx="78">
                  <c:v>3547.3037109375</c:v>
                </c:pt>
                <c:pt idx="79">
                  <c:v>3508.63012695312</c:v>
                </c:pt>
                <c:pt idx="80">
                  <c:v>3491.3837890625</c:v>
                </c:pt>
                <c:pt idx="81">
                  <c:v>3511.109375</c:v>
                </c:pt>
                <c:pt idx="82">
                  <c:v>3560.31689453125</c:v>
                </c:pt>
                <c:pt idx="83">
                  <c:v>3614.15551757812</c:v>
                </c:pt>
                <c:pt idx="84">
                  <c:v>3646.5517578125</c:v>
                </c:pt>
                <c:pt idx="85">
                  <c:v>3644.95556640625</c:v>
                </c:pt>
                <c:pt idx="86">
                  <c:v>3614.52514648437</c:v>
                </c:pt>
                <c:pt idx="87">
                  <c:v>3571.09521484375</c:v>
                </c:pt>
                <c:pt idx="88">
                  <c:v>3529.83740234375</c:v>
                </c:pt>
                <c:pt idx="89">
                  <c:v>3498.07836914062</c:v>
                </c:pt>
                <c:pt idx="90">
                  <c:v>3476.13256835937</c:v>
                </c:pt>
                <c:pt idx="91">
                  <c:v>3463.43896484375</c:v>
                </c:pt>
                <c:pt idx="92">
                  <c:v>3463.63940429687</c:v>
                </c:pt>
                <c:pt idx="93">
                  <c:v>3483.74755859375</c:v>
                </c:pt>
                <c:pt idx="94">
                  <c:v>3527.62182617187</c:v>
                </c:pt>
                <c:pt idx="95">
                  <c:v>3588.74096679687</c:v>
                </c:pt>
                <c:pt idx="96">
                  <c:v>3648.4365234375</c:v>
                </c:pt>
                <c:pt idx="97">
                  <c:v>3682.48364257812</c:v>
                </c:pt>
                <c:pt idx="98">
                  <c:v>3673.36474609375</c:v>
                </c:pt>
                <c:pt idx="99">
                  <c:v>3621.1865234375</c:v>
                </c:pt>
                <c:pt idx="100">
                  <c:v>3546.08129882812</c:v>
                </c:pt>
                <c:pt idx="101">
                  <c:v>3479.44995117187</c:v>
                </c:pt>
                <c:pt idx="102">
                  <c:v>3448.1650390625</c:v>
                </c:pt>
                <c:pt idx="103">
                  <c:v>3460.6787109375</c:v>
                </c:pt>
                <c:pt idx="104">
                  <c:v>3503.4755859375</c:v>
                </c:pt>
                <c:pt idx="105">
                  <c:v>3550.24291992187</c:v>
                </c:pt>
                <c:pt idx="106">
                  <c:v>3578.03198242187</c:v>
                </c:pt>
                <c:pt idx="107">
                  <c:v>3579.97485351562</c:v>
                </c:pt>
                <c:pt idx="108">
                  <c:v>3566.35717773437</c:v>
                </c:pt>
                <c:pt idx="109">
                  <c:v>3553.95434570312</c:v>
                </c:pt>
                <c:pt idx="110">
                  <c:v>3551.9794921875</c:v>
                </c:pt>
                <c:pt idx="111">
                  <c:v>3555.4931640625</c:v>
                </c:pt>
                <c:pt idx="112">
                  <c:v>3551.41479492187</c:v>
                </c:pt>
                <c:pt idx="113">
                  <c:v>3532.28393554687</c:v>
                </c:pt>
                <c:pt idx="114">
                  <c:v>3506.25244140625</c:v>
                </c:pt>
                <c:pt idx="115">
                  <c:v>3494.03540039062</c:v>
                </c:pt>
                <c:pt idx="116">
                  <c:v>3513.62451171875</c:v>
                </c:pt>
                <c:pt idx="117">
                  <c:v>3563.96728515625</c:v>
                </c:pt>
                <c:pt idx="118">
                  <c:v>3621.06591796875</c:v>
                </c:pt>
                <c:pt idx="119">
                  <c:v>3651.4794921875</c:v>
                </c:pt>
                <c:pt idx="120">
                  <c:v>3634.857421875</c:v>
                </c:pt>
                <c:pt idx="121">
                  <c:v>3579.1865234375</c:v>
                </c:pt>
                <c:pt idx="122">
                  <c:v>3516.70092773437</c:v>
                </c:pt>
                <c:pt idx="123">
                  <c:v>3482.40087890625</c:v>
                </c:pt>
                <c:pt idx="124">
                  <c:v>3490.453125</c:v>
                </c:pt>
                <c:pt idx="125">
                  <c:v>3525.90576171875</c:v>
                </c:pt>
                <c:pt idx="126">
                  <c:v>3557.90454101562</c:v>
                </c:pt>
                <c:pt idx="127">
                  <c:v>3564.2158203125</c:v>
                </c:pt>
                <c:pt idx="128">
                  <c:v>3548.0537109375</c:v>
                </c:pt>
                <c:pt idx="129">
                  <c:v>3534.10083007812</c:v>
                </c:pt>
                <c:pt idx="130">
                  <c:v>3546.95239257812</c:v>
                </c:pt>
                <c:pt idx="131">
                  <c:v>3589.23388671875</c:v>
                </c:pt>
                <c:pt idx="132">
                  <c:v>3637.1728515625</c:v>
                </c:pt>
                <c:pt idx="133">
                  <c:v>3657.7265625</c:v>
                </c:pt>
                <c:pt idx="134">
                  <c:v>3634.14672851562</c:v>
                </c:pt>
                <c:pt idx="135">
                  <c:v>3579.84375</c:v>
                </c:pt>
                <c:pt idx="136">
                  <c:v>3529.33447265625</c:v>
                </c:pt>
                <c:pt idx="137">
                  <c:v>3513.03686523437</c:v>
                </c:pt>
                <c:pt idx="138">
                  <c:v>3535.40209960937</c:v>
                </c:pt>
                <c:pt idx="139">
                  <c:v>3573.17236328125</c:v>
                </c:pt>
                <c:pt idx="140">
                  <c:v>3594.56176757812</c:v>
                </c:pt>
                <c:pt idx="141">
                  <c:v>3583.74340820312</c:v>
                </c:pt>
                <c:pt idx="142">
                  <c:v>3551.32250976562</c:v>
                </c:pt>
                <c:pt idx="143">
                  <c:v>3523.31298828125</c:v>
                </c:pt>
                <c:pt idx="144">
                  <c:v>3518.67138671875</c:v>
                </c:pt>
                <c:pt idx="145">
                  <c:v>3534.28051757812</c:v>
                </c:pt>
                <c:pt idx="146">
                  <c:v>3549.35375976562</c:v>
                </c:pt>
                <c:pt idx="147">
                  <c:v>3544.55249023437</c:v>
                </c:pt>
                <c:pt idx="148">
                  <c:v>3518.81787109375</c:v>
                </c:pt>
                <c:pt idx="149">
                  <c:v>3489.345703125</c:v>
                </c:pt>
                <c:pt idx="150">
                  <c:v>3475.1279296875</c:v>
                </c:pt>
                <c:pt idx="151">
                  <c:v>3479.14526367187</c:v>
                </c:pt>
                <c:pt idx="152">
                  <c:v>3485.80346679687</c:v>
                </c:pt>
                <c:pt idx="153">
                  <c:v>3476.88012695312</c:v>
                </c:pt>
                <c:pt idx="154">
                  <c:v>3452.28784179687</c:v>
                </c:pt>
                <c:pt idx="155">
                  <c:v>3436.21337890625</c:v>
                </c:pt>
                <c:pt idx="156">
                  <c:v>3460.45654296875</c:v>
                </c:pt>
                <c:pt idx="157">
                  <c:v>3536.45336914062</c:v>
                </c:pt>
                <c:pt idx="158">
                  <c:v>3639.01953125</c:v>
                </c:pt>
                <c:pt idx="159">
                  <c:v>3717.70825195312</c:v>
                </c:pt>
                <c:pt idx="160">
                  <c:v>3730.31665039062</c:v>
                </c:pt>
                <c:pt idx="161">
                  <c:v>3674.30517578125</c:v>
                </c:pt>
                <c:pt idx="162">
                  <c:v>3591.33129882812</c:v>
                </c:pt>
                <c:pt idx="163">
                  <c:v>3539.40185546875</c:v>
                </c:pt>
                <c:pt idx="164">
                  <c:v>3551.92749023437</c:v>
                </c:pt>
                <c:pt idx="165">
                  <c:v>3613.83666992187</c:v>
                </c:pt>
                <c:pt idx="166">
                  <c:v>3672.88891601562</c:v>
                </c:pt>
                <c:pt idx="167">
                  <c:v>3678.18920898437</c:v>
                </c:pt>
                <c:pt idx="168">
                  <c:v>3617.54321289062</c:v>
                </c:pt>
                <c:pt idx="169">
                  <c:v>3526.275390625</c:v>
                </c:pt>
                <c:pt idx="170">
                  <c:v>3461.55590820312</c:v>
                </c:pt>
                <c:pt idx="171">
                  <c:v>3461.681640625</c:v>
                </c:pt>
                <c:pt idx="172">
                  <c:v>3520.04931640625</c:v>
                </c:pt>
                <c:pt idx="173">
                  <c:v>3591.64086914062</c:v>
                </c:pt>
                <c:pt idx="174">
                  <c:v>3625.61352539062</c:v>
                </c:pt>
                <c:pt idx="175">
                  <c:v>3599.55688476562</c:v>
                </c:pt>
                <c:pt idx="176">
                  <c:v>3531.82543945312</c:v>
                </c:pt>
                <c:pt idx="177">
                  <c:v>3465.85620117187</c:v>
                </c:pt>
                <c:pt idx="178">
                  <c:v>3440.22802734375</c:v>
                </c:pt>
                <c:pt idx="179">
                  <c:v>3465.95434570312</c:v>
                </c:pt>
                <c:pt idx="180">
                  <c:v>3524.26489257812</c:v>
                </c:pt>
                <c:pt idx="181">
                  <c:v>3582.2744140625</c:v>
                </c:pt>
                <c:pt idx="182">
                  <c:v>3613.06958007812</c:v>
                </c:pt>
                <c:pt idx="183">
                  <c:v>3607.47387695312</c:v>
                </c:pt>
                <c:pt idx="184">
                  <c:v>3573.787109375</c:v>
                </c:pt>
                <c:pt idx="185">
                  <c:v>3530.24438476562</c:v>
                </c:pt>
                <c:pt idx="186">
                  <c:v>3496.72216796875</c:v>
                </c:pt>
                <c:pt idx="187">
                  <c:v>3488.42504882812</c:v>
                </c:pt>
                <c:pt idx="188">
                  <c:v>3510.72802734375</c:v>
                </c:pt>
                <c:pt idx="189">
                  <c:v>3555.07495117187</c:v>
                </c:pt>
                <c:pt idx="190">
                  <c:v>3599.173828125</c:v>
                </c:pt>
                <c:pt idx="191">
                  <c:v>3615.38061523437</c:v>
                </c:pt>
                <c:pt idx="192">
                  <c:v>3586.21240234375</c:v>
                </c:pt>
                <c:pt idx="193">
                  <c:v>3518.53588867187</c:v>
                </c:pt>
                <c:pt idx="194">
                  <c:v>3445.23779296875</c:v>
                </c:pt>
                <c:pt idx="195">
                  <c:v>3409.50048828125</c:v>
                </c:pt>
                <c:pt idx="196">
                  <c:v>3439.0234375</c:v>
                </c:pt>
                <c:pt idx="197">
                  <c:v>3526.51098632812</c:v>
                </c:pt>
                <c:pt idx="198">
                  <c:v>3630.63940429687</c:v>
                </c:pt>
                <c:pt idx="199">
                  <c:v>3698.70434570312</c:v>
                </c:pt>
                <c:pt idx="200">
                  <c:v>3697.24438476562</c:v>
                </c:pt>
                <c:pt idx="201">
                  <c:v>3631.05981445312</c:v>
                </c:pt>
                <c:pt idx="202">
                  <c:v>3538.76684570312</c:v>
                </c:pt>
                <c:pt idx="203">
                  <c:v>3468.73510742187</c:v>
                </c:pt>
                <c:pt idx="204">
                  <c:v>3451.65161132812</c:v>
                </c:pt>
                <c:pt idx="205">
                  <c:v>3486.63525390625</c:v>
                </c:pt>
                <c:pt idx="206">
                  <c:v>3547.30200195312</c:v>
                </c:pt>
                <c:pt idx="207">
                  <c:v>3600.87377929687</c:v>
                </c:pt>
                <c:pt idx="208">
                  <c:v>3626.66650390625</c:v>
                </c:pt>
                <c:pt idx="209">
                  <c:v>3623.50341796875</c:v>
                </c:pt>
                <c:pt idx="210">
                  <c:v>3604.68310546875</c:v>
                </c:pt>
                <c:pt idx="211">
                  <c:v>3586.7802734375</c:v>
                </c:pt>
                <c:pt idx="212">
                  <c:v>3580.16284179687</c:v>
                </c:pt>
                <c:pt idx="213">
                  <c:v>3585.49267578125</c:v>
                </c:pt>
                <c:pt idx="214">
                  <c:v>3595.8203125</c:v>
                </c:pt>
                <c:pt idx="215">
                  <c:v>3601.54174804687</c:v>
                </c:pt>
                <c:pt idx="216">
                  <c:v>3595.626953125</c:v>
                </c:pt>
                <c:pt idx="217">
                  <c:v>3577.31176757812</c:v>
                </c:pt>
                <c:pt idx="218">
                  <c:v>3552.73852539062</c:v>
                </c:pt>
                <c:pt idx="219">
                  <c:v>3531.57666015625</c:v>
                </c:pt>
                <c:pt idx="220">
                  <c:v>3520.66821289062</c:v>
                </c:pt>
                <c:pt idx="221">
                  <c:v>3518.5595703125</c:v>
                </c:pt>
                <c:pt idx="222">
                  <c:v>3515.69360351562</c:v>
                </c:pt>
                <c:pt idx="223">
                  <c:v>3501.86328125</c:v>
                </c:pt>
                <c:pt idx="224">
                  <c:v>3476.55346679687</c:v>
                </c:pt>
                <c:pt idx="225">
                  <c:v>3453.7509765625</c:v>
                </c:pt>
                <c:pt idx="226">
                  <c:v>3455.1728515625</c:v>
                </c:pt>
                <c:pt idx="227">
                  <c:v>3494.3466796875</c:v>
                </c:pt>
                <c:pt idx="228">
                  <c:v>3562.51220703125</c:v>
                </c:pt>
                <c:pt idx="229">
                  <c:v>3628.45190429687</c:v>
                </c:pt>
                <c:pt idx="230">
                  <c:v>3655.53881835937</c:v>
                </c:pt>
                <c:pt idx="231">
                  <c:v>3626.13818359375</c:v>
                </c:pt>
                <c:pt idx="232">
                  <c:v>3556.1220703125</c:v>
                </c:pt>
                <c:pt idx="233">
                  <c:v>3487.44946289062</c:v>
                </c:pt>
                <c:pt idx="234">
                  <c:v>3461.88159179687</c:v>
                </c:pt>
                <c:pt idx="235">
                  <c:v>3493.17236328125</c:v>
                </c:pt>
                <c:pt idx="236">
                  <c:v>3557.40087890625</c:v>
                </c:pt>
                <c:pt idx="237">
                  <c:v>3609.02490234375</c:v>
                </c:pt>
                <c:pt idx="238">
                  <c:v>3612.09692382812</c:v>
                </c:pt>
                <c:pt idx="239">
                  <c:v>3565.12036132812</c:v>
                </c:pt>
                <c:pt idx="240">
                  <c:v>3502.34155273437</c:v>
                </c:pt>
                <c:pt idx="241">
                  <c:v>3470.72045898437</c:v>
                </c:pt>
                <c:pt idx="242">
                  <c:v>3498.46240234375</c:v>
                </c:pt>
                <c:pt idx="243">
                  <c:v>3576.19555664062</c:v>
                </c:pt>
                <c:pt idx="244">
                  <c:v>3662.583984375</c:v>
                </c:pt>
                <c:pt idx="245">
                  <c:v>3709.68896484375</c:v>
                </c:pt>
                <c:pt idx="246">
                  <c:v>3691.28247070312</c:v>
                </c:pt>
                <c:pt idx="247">
                  <c:v>3616.97290039062</c:v>
                </c:pt>
                <c:pt idx="248">
                  <c:v>3525.17504882812</c:v>
                </c:pt>
                <c:pt idx="249">
                  <c:v>3460.85693359375</c:v>
                </c:pt>
                <c:pt idx="250">
                  <c:v>3451.59838867187</c:v>
                </c:pt>
                <c:pt idx="251">
                  <c:v>3494.57690429687</c:v>
                </c:pt>
                <c:pt idx="252">
                  <c:v>3559.9873046875</c:v>
                </c:pt>
                <c:pt idx="253">
                  <c:v>3607.90209960937</c:v>
                </c:pt>
                <c:pt idx="254">
                  <c:v>3609.62768554687</c:v>
                </c:pt>
                <c:pt idx="255">
                  <c:v>3562.94604492187</c:v>
                </c:pt>
                <c:pt idx="256">
                  <c:v>3493.44653320312</c:v>
                </c:pt>
                <c:pt idx="257">
                  <c:v>3440.6650390625</c:v>
                </c:pt>
                <c:pt idx="258">
                  <c:v>3435.783203125</c:v>
                </c:pt>
                <c:pt idx="259">
                  <c:v>3483.2841796875</c:v>
                </c:pt>
                <c:pt idx="260">
                  <c:v>3558.05249023437</c:v>
                </c:pt>
                <c:pt idx="261">
                  <c:v>3620.8095703125</c:v>
                </c:pt>
                <c:pt idx="262">
                  <c:v>3642.78002929687</c:v>
                </c:pt>
                <c:pt idx="263">
                  <c:v>3623.23315429687</c:v>
                </c:pt>
                <c:pt idx="264">
                  <c:v>3587.33349609375</c:v>
                </c:pt>
                <c:pt idx="265">
                  <c:v>3565.40380859375</c:v>
                </c:pt>
                <c:pt idx="266">
                  <c:v>3568.90380859375</c:v>
                </c:pt>
                <c:pt idx="267">
                  <c:v>3581.98950195312</c:v>
                </c:pt>
                <c:pt idx="268">
                  <c:v>3576.34936523437</c:v>
                </c:pt>
                <c:pt idx="269">
                  <c:v>3538.55908203125</c:v>
                </c:pt>
                <c:pt idx="270">
                  <c:v>3487.72192382812</c:v>
                </c:pt>
                <c:pt idx="271">
                  <c:v>3466.80444335937</c:v>
                </c:pt>
                <c:pt idx="272">
                  <c:v>3510.99682617187</c:v>
                </c:pt>
                <c:pt idx="273">
                  <c:v>3615.8154296875</c:v>
                </c:pt>
                <c:pt idx="274">
                  <c:v>3730.74731445312</c:v>
                </c:pt>
                <c:pt idx="275">
                  <c:v>3787.01391601562</c:v>
                </c:pt>
                <c:pt idx="276">
                  <c:v>3742.42919921875</c:v>
                </c:pt>
                <c:pt idx="277">
                  <c:v>3611.85278320312</c:v>
                </c:pt>
                <c:pt idx="278">
                  <c:v>3460.31103515625</c:v>
                </c:pt>
                <c:pt idx="279">
                  <c:v>3362.134765625</c:v>
                </c:pt>
                <c:pt idx="280">
                  <c:v>3354.14672851562</c:v>
                </c:pt>
                <c:pt idx="281">
                  <c:v>3415.447265625</c:v>
                </c:pt>
                <c:pt idx="282">
                  <c:v>3487.05932617187</c:v>
                </c:pt>
                <c:pt idx="283">
                  <c:v>3515.99072265625</c:v>
                </c:pt>
                <c:pt idx="284">
                  <c:v>3491.45922851562</c:v>
                </c:pt>
                <c:pt idx="285">
                  <c:v>3448.19653320312</c:v>
                </c:pt>
                <c:pt idx="286">
                  <c:v>3436.72509765625</c:v>
                </c:pt>
                <c:pt idx="287">
                  <c:v>3484.16723632812</c:v>
                </c:pt>
                <c:pt idx="288">
                  <c:v>3574.26708984375</c:v>
                </c:pt>
                <c:pt idx="289">
                  <c:v>3659.40307617187</c:v>
                </c:pt>
                <c:pt idx="290">
                  <c:v>3693.6513671875</c:v>
                </c:pt>
                <c:pt idx="291">
                  <c:v>3662.28051757812</c:v>
                </c:pt>
                <c:pt idx="292">
                  <c:v>3588.26196289062</c:v>
                </c:pt>
                <c:pt idx="293">
                  <c:v>3514.52294921875</c:v>
                </c:pt>
                <c:pt idx="294">
                  <c:v>3477.078125</c:v>
                </c:pt>
                <c:pt idx="295">
                  <c:v>3487.41455078125</c:v>
                </c:pt>
                <c:pt idx="296">
                  <c:v>3532.59594726562</c:v>
                </c:pt>
                <c:pt idx="297">
                  <c:v>3588.11474609375</c:v>
                </c:pt>
                <c:pt idx="298">
                  <c:v>3632.00952148437</c:v>
                </c:pt>
                <c:pt idx="299">
                  <c:v>3652.1396484375</c:v>
                </c:pt>
                <c:pt idx="300">
                  <c:v>3646.39184570312</c:v>
                </c:pt>
                <c:pt idx="301">
                  <c:v>3620.302734375</c:v>
                </c:pt>
                <c:pt idx="302">
                  <c:v>3585.17456054687</c:v>
                </c:pt>
                <c:pt idx="303">
                  <c:v>3555.6689453125</c:v>
                </c:pt>
                <c:pt idx="304">
                  <c:v>3544.5888671875</c:v>
                </c:pt>
                <c:pt idx="305">
                  <c:v>3555.79760742187</c:v>
                </c:pt>
                <c:pt idx="306">
                  <c:v>3580.30053710937</c:v>
                </c:pt>
                <c:pt idx="307">
                  <c:v>3600.24975585937</c:v>
                </c:pt>
                <c:pt idx="308">
                  <c:v>3599.97607421875</c:v>
                </c:pt>
                <c:pt idx="309">
                  <c:v>3576.66162109375</c:v>
                </c:pt>
                <c:pt idx="310">
                  <c:v>3542.24780273437</c:v>
                </c:pt>
                <c:pt idx="311">
                  <c:v>3514.49072265625</c:v>
                </c:pt>
                <c:pt idx="312">
                  <c:v>3503.94409179687</c:v>
                </c:pt>
                <c:pt idx="313">
                  <c:v>3507.36938476562</c:v>
                </c:pt>
                <c:pt idx="314">
                  <c:v>3512.90551757812</c:v>
                </c:pt>
                <c:pt idx="315">
                  <c:v>3512.28881835937</c:v>
                </c:pt>
                <c:pt idx="316">
                  <c:v>3509.08178710937</c:v>
                </c:pt>
                <c:pt idx="317">
                  <c:v>3515.11840820312</c:v>
                </c:pt>
                <c:pt idx="318">
                  <c:v>3537.82080078125</c:v>
                </c:pt>
                <c:pt idx="319">
                  <c:v>3569.76611328125</c:v>
                </c:pt>
                <c:pt idx="320">
                  <c:v>3590.89624023437</c:v>
                </c:pt>
                <c:pt idx="321">
                  <c:v>3583.2685546875</c:v>
                </c:pt>
                <c:pt idx="322">
                  <c:v>3546.83227539062</c:v>
                </c:pt>
                <c:pt idx="323">
                  <c:v>3502.46875</c:v>
                </c:pt>
                <c:pt idx="324">
                  <c:v>3478.16088867187</c:v>
                </c:pt>
                <c:pt idx="325">
                  <c:v>3488.21899414062</c:v>
                </c:pt>
                <c:pt idx="326">
                  <c:v>3522.20043945312</c:v>
                </c:pt>
                <c:pt idx="327">
                  <c:v>3553.24243164062</c:v>
                </c:pt>
                <c:pt idx="328">
                  <c:v>3559.94116210937</c:v>
                </c:pt>
                <c:pt idx="329">
                  <c:v>3544.251953125</c:v>
                </c:pt>
                <c:pt idx="330">
                  <c:v>3530.18334960937</c:v>
                </c:pt>
                <c:pt idx="331">
                  <c:v>3543.20703125</c:v>
                </c:pt>
                <c:pt idx="332">
                  <c:v>3586.47241210937</c:v>
                </c:pt>
                <c:pt idx="333">
                  <c:v>3633.72924804687</c:v>
                </c:pt>
                <c:pt idx="334">
                  <c:v>3646.55834960937</c:v>
                </c:pt>
                <c:pt idx="335">
                  <c:v>3604.171875</c:v>
                </c:pt>
                <c:pt idx="336">
                  <c:v>3523.00170898437</c:v>
                </c:pt>
                <c:pt idx="337">
                  <c:v>3449.73095703125</c:v>
                </c:pt>
                <c:pt idx="338">
                  <c:v>3431.0517578125</c:v>
                </c:pt>
                <c:pt idx="339">
                  <c:v>3481.3662109375</c:v>
                </c:pt>
                <c:pt idx="340">
                  <c:v>3571.98999023437</c:v>
                </c:pt>
                <c:pt idx="341">
                  <c:v>3650.08129882812</c:v>
                </c:pt>
                <c:pt idx="342">
                  <c:v>3673.9208984375</c:v>
                </c:pt>
                <c:pt idx="343">
                  <c:v>3639.4833984375</c:v>
                </c:pt>
                <c:pt idx="344">
                  <c:v>3580.05517578125</c:v>
                </c:pt>
                <c:pt idx="345">
                  <c:v>3540.49194335937</c:v>
                </c:pt>
                <c:pt idx="346">
                  <c:v>3545.63403320312</c:v>
                </c:pt>
                <c:pt idx="347">
                  <c:v>3585.34106445312</c:v>
                </c:pt>
                <c:pt idx="348">
                  <c:v>3625.24731445312</c:v>
                </c:pt>
                <c:pt idx="349">
                  <c:v>3633.34838867187</c:v>
                </c:pt>
              </c:numCache>
            </c:numRef>
          </c:yVal>
          <c:smooth val="1"/>
          <c:extLst>
            <c:ext xmlns:c16="http://schemas.microsoft.com/office/drawing/2014/chart" uri="{C3380CC4-5D6E-409C-BE32-E72D297353CC}">
              <c16:uniqueId val="{00000004-4A37-429A-A58F-F7AEDA5D1ACA}"/>
            </c:ext>
          </c:extLst>
        </c:ser>
        <c:ser>
          <c:idx val="5"/>
          <c:order val="5"/>
          <c:tx>
            <c:strRef>
              <c:f>cp_sub_001!$F$1</c:f>
              <c:strCache>
                <c:ptCount val="1"/>
                <c:pt idx="0">
                  <c:v>Coor_6</c:v>
                </c:pt>
              </c:strCache>
            </c:strRef>
          </c:tx>
          <c:spPr>
            <a:ln w="28575" cap="rnd">
              <a:solidFill>
                <a:schemeClr val="accent6"/>
              </a:solidFill>
              <a:round/>
            </a:ln>
            <a:effectLst/>
          </c:spPr>
          <c:marker>
            <c:symbol val="none"/>
          </c:marker>
          <c:yVal>
            <c:numRef>
              <c:f>cp_sub_001!$F$2:$F$351</c:f>
              <c:numCache>
                <c:formatCode>0.00000000000_ </c:formatCode>
                <c:ptCount val="350"/>
                <c:pt idx="0">
                  <c:v>8154.47705078125</c:v>
                </c:pt>
                <c:pt idx="1">
                  <c:v>8161.158203125</c:v>
                </c:pt>
                <c:pt idx="2">
                  <c:v>8177.587890625</c:v>
                </c:pt>
                <c:pt idx="3">
                  <c:v>8189.01220703125</c:v>
                </c:pt>
                <c:pt idx="4">
                  <c:v>8186.9794921875</c:v>
                </c:pt>
                <c:pt idx="5">
                  <c:v>8175.08154296875</c:v>
                </c:pt>
                <c:pt idx="6">
                  <c:v>8165.021484375</c:v>
                </c:pt>
                <c:pt idx="7">
                  <c:v>8166.59765625</c:v>
                </c:pt>
                <c:pt idx="8">
                  <c:v>8179.93212890625</c:v>
                </c:pt>
                <c:pt idx="9">
                  <c:v>8196.2138671875</c:v>
                </c:pt>
                <c:pt idx="10">
                  <c:v>8206.048828125</c:v>
                </c:pt>
                <c:pt idx="11">
                  <c:v>8208.09765625</c:v>
                </c:pt>
                <c:pt idx="12">
                  <c:v>8210.3671875</c:v>
                </c:pt>
                <c:pt idx="13">
                  <c:v>8222.625</c:v>
                </c:pt>
                <c:pt idx="14">
                  <c:v>8246.0673828125</c:v>
                </c:pt>
                <c:pt idx="15">
                  <c:v>8269.3095703125</c:v>
                </c:pt>
                <c:pt idx="16">
                  <c:v>8275.1650390625</c:v>
                </c:pt>
                <c:pt idx="17">
                  <c:v>8254.0322265625</c:v>
                </c:pt>
                <c:pt idx="18">
                  <c:v>8213.64453125</c:v>
                </c:pt>
                <c:pt idx="19">
                  <c:v>8176.6875</c:v>
                </c:pt>
                <c:pt idx="20">
                  <c:v>8166.5009765625</c:v>
                </c:pt>
                <c:pt idx="21">
                  <c:v>8190.4248046875</c:v>
                </c:pt>
                <c:pt idx="22">
                  <c:v>8233.138671875</c:v>
                </c:pt>
                <c:pt idx="23">
                  <c:v>8265.8837890625</c:v>
                </c:pt>
                <c:pt idx="24">
                  <c:v>8266.0810546875</c:v>
                </c:pt>
                <c:pt idx="25">
                  <c:v>8233.7314453125</c:v>
                </c:pt>
                <c:pt idx="26">
                  <c:v>8192.423828125</c:v>
                </c:pt>
                <c:pt idx="27">
                  <c:v>8173.2666015625</c:v>
                </c:pt>
                <c:pt idx="28">
                  <c:v>8192.40234375</c:v>
                </c:pt>
                <c:pt idx="29">
                  <c:v>8238.052734375</c:v>
                </c:pt>
                <c:pt idx="30">
                  <c:v>8277.0849609375</c:v>
                </c:pt>
                <c:pt idx="31">
                  <c:v>8277.5927734375</c:v>
                </c:pt>
                <c:pt idx="32">
                  <c:v>8232.2900390625</c:v>
                </c:pt>
                <c:pt idx="33">
                  <c:v>8166.06494140625</c:v>
                </c:pt>
                <c:pt idx="34">
                  <c:v>8121.30224609375</c:v>
                </c:pt>
                <c:pt idx="35">
                  <c:v>8129.88330078125</c:v>
                </c:pt>
                <c:pt idx="36">
                  <c:v>8190.525390625</c:v>
                </c:pt>
                <c:pt idx="37">
                  <c:v>8267.3642578125</c:v>
                </c:pt>
                <c:pt idx="38">
                  <c:v>8311.884765625</c:v>
                </c:pt>
                <c:pt idx="39">
                  <c:v>8294.5009765625</c:v>
                </c:pt>
                <c:pt idx="40">
                  <c:v>8225.103515625</c:v>
                </c:pt>
                <c:pt idx="41">
                  <c:v>8148.4765625</c:v>
                </c:pt>
                <c:pt idx="42">
                  <c:v>8116.70751953125</c:v>
                </c:pt>
                <c:pt idx="43">
                  <c:v>8155.73095703125</c:v>
                </c:pt>
                <c:pt idx="44">
                  <c:v>8247.2900390625</c:v>
                </c:pt>
                <c:pt idx="45">
                  <c:v>8338.0302734375</c:v>
                </c:pt>
                <c:pt idx="46">
                  <c:v>8370.46484375</c:v>
                </c:pt>
                <c:pt idx="47">
                  <c:v>8316.9990234375</c:v>
                </c:pt>
                <c:pt idx="48">
                  <c:v>8196.546875</c:v>
                </c:pt>
                <c:pt idx="49">
                  <c:v>8064.17822265625</c:v>
                </c:pt>
                <c:pt idx="50">
                  <c:v>7980.56201171875</c:v>
                </c:pt>
                <c:pt idx="51">
                  <c:v>7979.5595703125</c:v>
                </c:pt>
                <c:pt idx="52">
                  <c:v>8052.4306640625</c:v>
                </c:pt>
                <c:pt idx="53">
                  <c:v>8156.3916015625</c:v>
                </c:pt>
                <c:pt idx="54">
                  <c:v>8240.7861328125</c:v>
                </c:pt>
                <c:pt idx="55">
                  <c:v>8274.6181640625</c:v>
                </c:pt>
                <c:pt idx="56">
                  <c:v>8259.8779296875</c:v>
                </c:pt>
                <c:pt idx="57">
                  <c:v>8224.728515625</c:v>
                </c:pt>
                <c:pt idx="58">
                  <c:v>8202.787109375</c:v>
                </c:pt>
                <c:pt idx="59">
                  <c:v>8212.2041015625</c:v>
                </c:pt>
                <c:pt idx="60">
                  <c:v>8246.892578125</c:v>
                </c:pt>
                <c:pt idx="61">
                  <c:v>8283.7158203125</c:v>
                </c:pt>
                <c:pt idx="62">
                  <c:v>8299.328125</c:v>
                </c:pt>
                <c:pt idx="63">
                  <c:v>8285.044921875</c:v>
                </c:pt>
                <c:pt idx="64">
                  <c:v>8250.58203125</c:v>
                </c:pt>
                <c:pt idx="65">
                  <c:v>8215.60546875</c:v>
                </c:pt>
                <c:pt idx="66">
                  <c:v>8196.255859375</c:v>
                </c:pt>
                <c:pt idx="67">
                  <c:v>8196.447265625</c:v>
                </c:pt>
                <c:pt idx="68">
                  <c:v>8209.36328125</c:v>
                </c:pt>
                <c:pt idx="69">
                  <c:v>8226.400390625</c:v>
                </c:pt>
                <c:pt idx="70">
                  <c:v>8245.1572265625</c:v>
                </c:pt>
                <c:pt idx="71">
                  <c:v>8269.1748046875</c:v>
                </c:pt>
                <c:pt idx="72">
                  <c:v>8299.4931640625</c:v>
                </c:pt>
                <c:pt idx="73">
                  <c:v>8325.8076171875</c:v>
                </c:pt>
                <c:pt idx="74">
                  <c:v>8326.8388671875</c:v>
                </c:pt>
                <c:pt idx="75">
                  <c:v>8283.015625</c:v>
                </c:pt>
                <c:pt idx="76">
                  <c:v>8194.1328125</c:v>
                </c:pt>
                <c:pt idx="77">
                  <c:v>8088.31982421875</c:v>
                </c:pt>
                <c:pt idx="78">
                  <c:v>8012.46337890625</c:v>
                </c:pt>
                <c:pt idx="79">
                  <c:v>8006.64892578125</c:v>
                </c:pt>
                <c:pt idx="80">
                  <c:v>8077.90234375</c:v>
                </c:pt>
                <c:pt idx="81">
                  <c:v>8191.6005859375</c:v>
                </c:pt>
                <c:pt idx="82">
                  <c:v>8288.7939453125</c:v>
                </c:pt>
                <c:pt idx="83">
                  <c:v>8320.36328125</c:v>
                </c:pt>
                <c:pt idx="84">
                  <c:v>8276.4599609375</c:v>
                </c:pt>
                <c:pt idx="85">
                  <c:v>8191.56005859375</c:v>
                </c:pt>
                <c:pt idx="86">
                  <c:v>8121.3251953125</c:v>
                </c:pt>
                <c:pt idx="87">
                  <c:v>8106.61181640625</c:v>
                </c:pt>
                <c:pt idx="88">
                  <c:v>8148.8857421875</c:v>
                </c:pt>
                <c:pt idx="89">
                  <c:v>8213.265625</c:v>
                </c:pt>
                <c:pt idx="90">
                  <c:v>8255.9228515625</c:v>
                </c:pt>
                <c:pt idx="91">
                  <c:v>8255.5517578125</c:v>
                </c:pt>
                <c:pt idx="92">
                  <c:v>8226.263671875</c:v>
                </c:pt>
                <c:pt idx="93">
                  <c:v>8203.369140625</c:v>
                </c:pt>
                <c:pt idx="94">
                  <c:v>8213.5546875</c:v>
                </c:pt>
                <c:pt idx="95">
                  <c:v>8252.3828125</c:v>
                </c:pt>
                <c:pt idx="96">
                  <c:v>8286.3818359375</c:v>
                </c:pt>
                <c:pt idx="97">
                  <c:v>8278.5380859375</c:v>
                </c:pt>
                <c:pt idx="98">
                  <c:v>8218.365234375</c:v>
                </c:pt>
                <c:pt idx="99">
                  <c:v>8133.94580078125</c:v>
                </c:pt>
                <c:pt idx="100">
                  <c:v>8076.12060546875</c:v>
                </c:pt>
                <c:pt idx="101">
                  <c:v>8085.142578125</c:v>
                </c:pt>
                <c:pt idx="102">
                  <c:v>8162.9375</c:v>
                </c:pt>
                <c:pt idx="103">
                  <c:v>8270.44921875</c:v>
                </c:pt>
                <c:pt idx="104">
                  <c:v>8352.109375</c:v>
                </c:pt>
                <c:pt idx="105">
                  <c:v>8370.75</c:v>
                </c:pt>
                <c:pt idx="106">
                  <c:v>8329.3515625</c:v>
                </c:pt>
                <c:pt idx="107">
                  <c:v>8265.5478515625</c:v>
                </c:pt>
                <c:pt idx="108">
                  <c:v>8223.6845703125</c:v>
                </c:pt>
                <c:pt idx="109">
                  <c:v>8224.255859375</c:v>
                </c:pt>
                <c:pt idx="110">
                  <c:v>8251.5478515625</c:v>
                </c:pt>
                <c:pt idx="111">
                  <c:v>8267.1435546875</c:v>
                </c:pt>
                <c:pt idx="112">
                  <c:v>8239.080078125</c:v>
                </c:pt>
                <c:pt idx="113">
                  <c:v>8166.16259765625</c:v>
                </c:pt>
                <c:pt idx="114">
                  <c:v>8080.86669921875</c:v>
                </c:pt>
                <c:pt idx="115">
                  <c:v>8029.13134765625</c:v>
                </c:pt>
                <c:pt idx="116">
                  <c:v>8040.8681640625</c:v>
                </c:pt>
                <c:pt idx="117">
                  <c:v>8110.79541015625</c:v>
                </c:pt>
                <c:pt idx="118">
                  <c:v>8201.845703125</c:v>
                </c:pt>
                <c:pt idx="119">
                  <c:v>8268.2763671875</c:v>
                </c:pt>
                <c:pt idx="120">
                  <c:v>8283.0166015625</c:v>
                </c:pt>
                <c:pt idx="121">
                  <c:v>8251.740234375</c:v>
                </c:pt>
                <c:pt idx="122">
                  <c:v>8205.640625</c:v>
                </c:pt>
                <c:pt idx="123">
                  <c:v>8179.037109375</c:v>
                </c:pt>
                <c:pt idx="124">
                  <c:v>8187.36669921875</c:v>
                </c:pt>
                <c:pt idx="125">
                  <c:v>8219.771484375</c:v>
                </c:pt>
                <c:pt idx="126">
                  <c:v>8249.8701171875</c:v>
                </c:pt>
                <c:pt idx="127">
                  <c:v>8255.912109375</c:v>
                </c:pt>
                <c:pt idx="128">
                  <c:v>8235.82421875</c:v>
                </c:pt>
                <c:pt idx="129">
                  <c:v>8207.15625</c:v>
                </c:pt>
                <c:pt idx="130">
                  <c:v>8193.0849609375</c:v>
                </c:pt>
                <c:pt idx="131">
                  <c:v>8205.3525390625</c:v>
                </c:pt>
                <c:pt idx="132">
                  <c:v>8236.490234375</c:v>
                </c:pt>
                <c:pt idx="133">
                  <c:v>8266.298828125</c:v>
                </c:pt>
                <c:pt idx="134">
                  <c:v>8276.8818359375</c:v>
                </c:pt>
                <c:pt idx="135">
                  <c:v>8264.615234375</c:v>
                </c:pt>
                <c:pt idx="136">
                  <c:v>8240.3671875</c:v>
                </c:pt>
                <c:pt idx="137">
                  <c:v>8218.775390625</c:v>
                </c:pt>
                <c:pt idx="138">
                  <c:v>8205.8857421875</c:v>
                </c:pt>
                <c:pt idx="139">
                  <c:v>8195.517578125</c:v>
                </c:pt>
                <c:pt idx="140">
                  <c:v>8177.36328125</c:v>
                </c:pt>
                <c:pt idx="141">
                  <c:v>8149.93994140625</c:v>
                </c:pt>
                <c:pt idx="142">
                  <c:v>8126.82080078125</c:v>
                </c:pt>
                <c:pt idx="143">
                  <c:v>8129.3134765625</c:v>
                </c:pt>
                <c:pt idx="144">
                  <c:v>8169.55029296875</c:v>
                </c:pt>
                <c:pt idx="145">
                  <c:v>8236.62890625</c:v>
                </c:pt>
                <c:pt idx="146">
                  <c:v>8297.861328125</c:v>
                </c:pt>
                <c:pt idx="147">
                  <c:v>8316.92578125</c:v>
                </c:pt>
                <c:pt idx="148">
                  <c:v>8277.97265625</c:v>
                </c:pt>
                <c:pt idx="149">
                  <c:v>8198.921875</c:v>
                </c:pt>
                <c:pt idx="150">
                  <c:v>8123.3349609375</c:v>
                </c:pt>
                <c:pt idx="151">
                  <c:v>8094.58984375</c:v>
                </c:pt>
                <c:pt idx="152">
                  <c:v>8128.7783203125</c:v>
                </c:pt>
                <c:pt idx="153">
                  <c:v>8204.4482421875</c:v>
                </c:pt>
                <c:pt idx="154">
                  <c:v>8276.474609375</c:v>
                </c:pt>
                <c:pt idx="155">
                  <c:v>8305.0888671875</c:v>
                </c:pt>
                <c:pt idx="156">
                  <c:v>8280.708984375</c:v>
                </c:pt>
                <c:pt idx="157">
                  <c:v>8228.083984375</c:v>
                </c:pt>
                <c:pt idx="158">
                  <c:v>8187.4052734375</c:v>
                </c:pt>
                <c:pt idx="159">
                  <c:v>8185.791015625</c:v>
                </c:pt>
                <c:pt idx="160">
                  <c:v>8218.9287109375</c:v>
                </c:pt>
                <c:pt idx="161">
                  <c:v>8255.3427734375</c:v>
                </c:pt>
                <c:pt idx="162">
                  <c:v>8259.888671875</c:v>
                </c:pt>
                <c:pt idx="163">
                  <c:v>8219.794921875</c:v>
                </c:pt>
                <c:pt idx="164">
                  <c:v>8154.9208984375</c:v>
                </c:pt>
                <c:pt idx="165">
                  <c:v>8105.05078125</c:v>
                </c:pt>
                <c:pt idx="166">
                  <c:v>8102.9423828125</c:v>
                </c:pt>
                <c:pt idx="167">
                  <c:v>8151.67333984375</c:v>
                </c:pt>
                <c:pt idx="168">
                  <c:v>8221.7548828125</c:v>
                </c:pt>
                <c:pt idx="169">
                  <c:v>8269.955078125</c:v>
                </c:pt>
                <c:pt idx="170">
                  <c:v>8267.15234375</c:v>
                </c:pt>
                <c:pt idx="171">
                  <c:v>8216.7763671875</c:v>
                </c:pt>
                <c:pt idx="172">
                  <c:v>8152.14794921875</c:v>
                </c:pt>
                <c:pt idx="173">
                  <c:v>8115.21728515625</c:v>
                </c:pt>
                <c:pt idx="174">
                  <c:v>8131.09716796875</c:v>
                </c:pt>
                <c:pt idx="175">
                  <c:v>8194.521484375</c:v>
                </c:pt>
                <c:pt idx="176">
                  <c:v>8275.47265625</c:v>
                </c:pt>
                <c:pt idx="177">
                  <c:v>8338.3857421875</c:v>
                </c:pt>
                <c:pt idx="178">
                  <c:v>8361.48046875</c:v>
                </c:pt>
                <c:pt idx="179">
                  <c:v>8344.5947265625</c:v>
                </c:pt>
                <c:pt idx="180">
                  <c:v>8303.123046875</c:v>
                </c:pt>
                <c:pt idx="181">
                  <c:v>8255.0791015625</c:v>
                </c:pt>
                <c:pt idx="182">
                  <c:v>8211.3759765625</c:v>
                </c:pt>
                <c:pt idx="183">
                  <c:v>8174.87109375</c:v>
                </c:pt>
                <c:pt idx="184">
                  <c:v>8145.96923828125</c:v>
                </c:pt>
                <c:pt idx="185">
                  <c:v>8127.94384765625</c:v>
                </c:pt>
                <c:pt idx="186">
                  <c:v>8126.6748046875</c:v>
                </c:pt>
                <c:pt idx="187">
                  <c:v>8145.33984375</c:v>
                </c:pt>
                <c:pt idx="188">
                  <c:v>8179.375</c:v>
                </c:pt>
                <c:pt idx="189">
                  <c:v>8216.8515625</c:v>
                </c:pt>
                <c:pt idx="190">
                  <c:v>8244.69140625</c:v>
                </c:pt>
                <c:pt idx="191">
                  <c:v>8256.0732421875</c:v>
                </c:pt>
                <c:pt idx="192">
                  <c:v>8253.3232421875</c:v>
                </c:pt>
                <c:pt idx="193">
                  <c:v>8244.3173828125</c:v>
                </c:pt>
                <c:pt idx="194">
                  <c:v>8235.71484375</c:v>
                </c:pt>
                <c:pt idx="195">
                  <c:v>8228.6591796875</c:v>
                </c:pt>
                <c:pt idx="196">
                  <c:v>8220.0400390625</c:v>
                </c:pt>
                <c:pt idx="197">
                  <c:v>8207.4072265625</c:v>
                </c:pt>
                <c:pt idx="198">
                  <c:v>8192.544921875</c:v>
                </c:pt>
                <c:pt idx="199">
                  <c:v>8180.25732421875</c:v>
                </c:pt>
                <c:pt idx="200">
                  <c:v>8173.65234375</c:v>
                </c:pt>
                <c:pt idx="201">
                  <c:v>8170.80322265625</c:v>
                </c:pt>
                <c:pt idx="202">
                  <c:v>8166.630859375</c:v>
                </c:pt>
                <c:pt idx="203">
                  <c:v>8158.89208984375</c:v>
                </c:pt>
                <c:pt idx="204">
                  <c:v>8152.6689453125</c:v>
                </c:pt>
                <c:pt idx="205">
                  <c:v>8158.05322265625</c:v>
                </c:pt>
                <c:pt idx="206">
                  <c:v>8181.3037109375</c:v>
                </c:pt>
                <c:pt idx="207">
                  <c:v>8216.1904296875</c:v>
                </c:pt>
                <c:pt idx="208">
                  <c:v>8243.787109375</c:v>
                </c:pt>
                <c:pt idx="209">
                  <c:v>8243.423828125</c:v>
                </c:pt>
                <c:pt idx="210">
                  <c:v>8208.4619140625</c:v>
                </c:pt>
                <c:pt idx="211">
                  <c:v>8155.2470703125</c:v>
                </c:pt>
                <c:pt idx="212">
                  <c:v>8116.82666015625</c:v>
                </c:pt>
                <c:pt idx="213">
                  <c:v>8123.4951171875</c:v>
                </c:pt>
                <c:pt idx="214">
                  <c:v>8182.37451171875</c:v>
                </c:pt>
                <c:pt idx="215">
                  <c:v>8270.330078125</c:v>
                </c:pt>
                <c:pt idx="216">
                  <c:v>8346.1728515625</c:v>
                </c:pt>
                <c:pt idx="217">
                  <c:v>8374.9462890625</c:v>
                </c:pt>
                <c:pt idx="218">
                  <c:v>8348.453125</c:v>
                </c:pt>
                <c:pt idx="219">
                  <c:v>8288.578125</c:v>
                </c:pt>
                <c:pt idx="220">
                  <c:v>8231.7265625</c:v>
                </c:pt>
                <c:pt idx="221">
                  <c:v>8205.49609375</c:v>
                </c:pt>
                <c:pt idx="222">
                  <c:v>8213.3974609375</c:v>
                </c:pt>
                <c:pt idx="223">
                  <c:v>8236.916015625</c:v>
                </c:pt>
                <c:pt idx="224">
                  <c:v>8251.609375</c:v>
                </c:pt>
                <c:pt idx="225">
                  <c:v>8244.5712890625</c:v>
                </c:pt>
                <c:pt idx="226">
                  <c:v>8220.990234375</c:v>
                </c:pt>
                <c:pt idx="227">
                  <c:v>8196.7109375</c:v>
                </c:pt>
                <c:pt idx="228">
                  <c:v>8184.30224609375</c:v>
                </c:pt>
                <c:pt idx="229">
                  <c:v>8184.1298828125</c:v>
                </c:pt>
                <c:pt idx="230">
                  <c:v>8186.8076171875</c:v>
                </c:pt>
                <c:pt idx="231">
                  <c:v>8183.744140625</c:v>
                </c:pt>
                <c:pt idx="232">
                  <c:v>8176.09033203125</c:v>
                </c:pt>
                <c:pt idx="233">
                  <c:v>8174.16650390625</c:v>
                </c:pt>
                <c:pt idx="234">
                  <c:v>8187.68505859375</c:v>
                </c:pt>
                <c:pt idx="235">
                  <c:v>8214.9892578125</c:v>
                </c:pt>
                <c:pt idx="236">
                  <c:v>8240.7470703125</c:v>
                </c:pt>
                <c:pt idx="237">
                  <c:v>8245.041015625</c:v>
                </c:pt>
                <c:pt idx="238">
                  <c:v>8217.736328125</c:v>
                </c:pt>
                <c:pt idx="239">
                  <c:v>8167.41845703125</c:v>
                </c:pt>
                <c:pt idx="240">
                  <c:v>8117.85107421875</c:v>
                </c:pt>
                <c:pt idx="241">
                  <c:v>8093.93212890625</c:v>
                </c:pt>
                <c:pt idx="242">
                  <c:v>8106.75244140625</c:v>
                </c:pt>
                <c:pt idx="243">
                  <c:v>8147.88134765625</c:v>
                </c:pt>
                <c:pt idx="244">
                  <c:v>8196.1337890625</c:v>
                </c:pt>
                <c:pt idx="245">
                  <c:v>8231.2197265625</c:v>
                </c:pt>
                <c:pt idx="246">
                  <c:v>8244.4482421875</c:v>
                </c:pt>
                <c:pt idx="247">
                  <c:v>8239.94140625</c:v>
                </c:pt>
                <c:pt idx="248">
                  <c:v>8227.5478515625</c:v>
                </c:pt>
                <c:pt idx="249">
                  <c:v>8214.6474609375</c:v>
                </c:pt>
                <c:pt idx="250">
                  <c:v>8203.5888671875</c:v>
                </c:pt>
                <c:pt idx="251">
                  <c:v>8195.560546875</c:v>
                </c:pt>
                <c:pt idx="252">
                  <c:v>8195.4462890625</c:v>
                </c:pt>
                <c:pt idx="253">
                  <c:v>8211.22265625</c:v>
                </c:pt>
                <c:pt idx="254">
                  <c:v>8246.6337890625</c:v>
                </c:pt>
                <c:pt idx="255">
                  <c:v>8292.923828125</c:v>
                </c:pt>
                <c:pt idx="256">
                  <c:v>8328.05859375</c:v>
                </c:pt>
                <c:pt idx="257">
                  <c:v>8327.1845703125</c:v>
                </c:pt>
                <c:pt idx="258">
                  <c:v>8279.150390625</c:v>
                </c:pt>
                <c:pt idx="259">
                  <c:v>8197.7265625</c:v>
                </c:pt>
                <c:pt idx="260">
                  <c:v>8118.09521484375</c:v>
                </c:pt>
                <c:pt idx="261">
                  <c:v>8078.77099609375</c:v>
                </c:pt>
                <c:pt idx="262">
                  <c:v>8099.546875</c:v>
                </c:pt>
                <c:pt idx="263">
                  <c:v>8169.76025390625</c:v>
                </c:pt>
                <c:pt idx="264">
                  <c:v>8254.8017578125</c:v>
                </c:pt>
                <c:pt idx="265">
                  <c:v>8316.7099609375</c:v>
                </c:pt>
                <c:pt idx="266">
                  <c:v>8335.357421875</c:v>
                </c:pt>
                <c:pt idx="267">
                  <c:v>8316.76171875</c:v>
                </c:pt>
                <c:pt idx="268">
                  <c:v>8284.2958984375</c:v>
                </c:pt>
                <c:pt idx="269">
                  <c:v>8260.2705078125</c:v>
                </c:pt>
                <c:pt idx="270">
                  <c:v>8251.2216796875</c:v>
                </c:pt>
                <c:pt idx="271">
                  <c:v>8246.4951171875</c:v>
                </c:pt>
                <c:pt idx="272">
                  <c:v>8229.6396484375</c:v>
                </c:pt>
                <c:pt idx="273">
                  <c:v>8193.23046875</c:v>
                </c:pt>
                <c:pt idx="274">
                  <c:v>8146.17333984375</c:v>
                </c:pt>
                <c:pt idx="275">
                  <c:v>8108.7001953125</c:v>
                </c:pt>
                <c:pt idx="276">
                  <c:v>8099.169921875</c:v>
                </c:pt>
                <c:pt idx="277">
                  <c:v>8121.98828125</c:v>
                </c:pt>
                <c:pt idx="278">
                  <c:v>8164.4287109375</c:v>
                </c:pt>
                <c:pt idx="279">
                  <c:v>8203.7568359375</c:v>
                </c:pt>
                <c:pt idx="280">
                  <c:v>8219.7001953125</c:v>
                </c:pt>
                <c:pt idx="281">
                  <c:v>8204.90625</c:v>
                </c:pt>
                <c:pt idx="282">
                  <c:v>8168.1982421875</c:v>
                </c:pt>
                <c:pt idx="283">
                  <c:v>8129.89404296875</c:v>
                </c:pt>
                <c:pt idx="284">
                  <c:v>8112.14599609375</c:v>
                </c:pt>
                <c:pt idx="285">
                  <c:v>8128.853515625</c:v>
                </c:pt>
                <c:pt idx="286">
                  <c:v>8179.25634765625</c:v>
                </c:pt>
                <c:pt idx="287">
                  <c:v>8247.771484375</c:v>
                </c:pt>
                <c:pt idx="288">
                  <c:v>8310.35546875</c:v>
                </c:pt>
                <c:pt idx="289">
                  <c:v>8344.9775390625</c:v>
                </c:pt>
                <c:pt idx="290">
                  <c:v>8341.49609375</c:v>
                </c:pt>
                <c:pt idx="291">
                  <c:v>8305.8232421875</c:v>
                </c:pt>
                <c:pt idx="292">
                  <c:v>8255.82421875</c:v>
                </c:pt>
                <c:pt idx="293">
                  <c:v>8211.1044921875</c:v>
                </c:pt>
                <c:pt idx="294">
                  <c:v>8182.77783203125</c:v>
                </c:pt>
                <c:pt idx="295">
                  <c:v>8169.5205078125</c:v>
                </c:pt>
                <c:pt idx="296">
                  <c:v>8162.0087890625</c:v>
                </c:pt>
                <c:pt idx="297">
                  <c:v>8152.0087890625</c:v>
                </c:pt>
                <c:pt idx="298">
                  <c:v>8139.20263671875</c:v>
                </c:pt>
                <c:pt idx="299">
                  <c:v>8130.876953125</c:v>
                </c:pt>
                <c:pt idx="300">
                  <c:v>8135.31787109375</c:v>
                </c:pt>
                <c:pt idx="301">
                  <c:v>8154.6513671875</c:v>
                </c:pt>
                <c:pt idx="302">
                  <c:v>8182.99072265625</c:v>
                </c:pt>
                <c:pt idx="303">
                  <c:v>8211.1015625</c:v>
                </c:pt>
                <c:pt idx="304">
                  <c:v>8233.318359375</c:v>
                </c:pt>
                <c:pt idx="305">
                  <c:v>8250.76953125</c:v>
                </c:pt>
                <c:pt idx="306">
                  <c:v>8268.435546875</c:v>
                </c:pt>
                <c:pt idx="307">
                  <c:v>8289.0556640625</c:v>
                </c:pt>
                <c:pt idx="308">
                  <c:v>8309.5146484375</c:v>
                </c:pt>
                <c:pt idx="309">
                  <c:v>8322.8955078125</c:v>
                </c:pt>
                <c:pt idx="310">
                  <c:v>8324.0458984375</c:v>
                </c:pt>
                <c:pt idx="311">
                  <c:v>8313.3408203125</c:v>
                </c:pt>
                <c:pt idx="312">
                  <c:v>8295.1611328125</c:v>
                </c:pt>
                <c:pt idx="313">
                  <c:v>8272.8896484375</c:v>
                </c:pt>
                <c:pt idx="314">
                  <c:v>8245.8046875</c:v>
                </c:pt>
                <c:pt idx="315">
                  <c:v>8211.6162109375</c:v>
                </c:pt>
                <c:pt idx="316">
                  <c:v>8172.564453125</c:v>
                </c:pt>
                <c:pt idx="317">
                  <c:v>8138.607421875</c:v>
                </c:pt>
                <c:pt idx="318">
                  <c:v>8122.75439453125</c:v>
                </c:pt>
                <c:pt idx="319">
                  <c:v>8130.6796875</c:v>
                </c:pt>
                <c:pt idx="320">
                  <c:v>8153.2216796875</c:v>
                </c:pt>
                <c:pt idx="321">
                  <c:v>8169.92578125</c:v>
                </c:pt>
                <c:pt idx="322">
                  <c:v>8163.4609375</c:v>
                </c:pt>
                <c:pt idx="323">
                  <c:v>8134.81494140625</c:v>
                </c:pt>
                <c:pt idx="324">
                  <c:v>8106.380859375</c:v>
                </c:pt>
                <c:pt idx="325">
                  <c:v>8107.94970703125</c:v>
                </c:pt>
                <c:pt idx="326">
                  <c:v>8154.07373046875</c:v>
                </c:pt>
                <c:pt idx="327">
                  <c:v>8229.5703125</c:v>
                </c:pt>
                <c:pt idx="328">
                  <c:v>8295.5654296875</c:v>
                </c:pt>
                <c:pt idx="329">
                  <c:v>8313.7607421875</c:v>
                </c:pt>
                <c:pt idx="330">
                  <c:v>8272.4150390625</c:v>
                </c:pt>
                <c:pt idx="331">
                  <c:v>8195.2021484375</c:v>
                </c:pt>
                <c:pt idx="332">
                  <c:v>8126.13671875</c:v>
                </c:pt>
                <c:pt idx="333">
                  <c:v>8101.193359375</c:v>
                </c:pt>
                <c:pt idx="334">
                  <c:v>8126.92236328125</c:v>
                </c:pt>
                <c:pt idx="335">
                  <c:v>8180.619140625</c:v>
                </c:pt>
                <c:pt idx="336">
                  <c:v>8230.1474609375</c:v>
                </c:pt>
                <c:pt idx="337">
                  <c:v>8257.115234375</c:v>
                </c:pt>
                <c:pt idx="338">
                  <c:v>8265.9130859375</c:v>
                </c:pt>
                <c:pt idx="339">
                  <c:v>8273.447265625</c:v>
                </c:pt>
                <c:pt idx="340">
                  <c:v>8290.0556640625</c:v>
                </c:pt>
                <c:pt idx="341">
                  <c:v>8308.3974609375</c:v>
                </c:pt>
                <c:pt idx="342">
                  <c:v>8309.517578125</c:v>
                </c:pt>
                <c:pt idx="343">
                  <c:v>8280.44140625</c:v>
                </c:pt>
                <c:pt idx="344">
                  <c:v>8228.0478515625</c:v>
                </c:pt>
                <c:pt idx="345">
                  <c:v>8177.12451171875</c:v>
                </c:pt>
                <c:pt idx="346">
                  <c:v>8153.6611328125</c:v>
                </c:pt>
                <c:pt idx="347">
                  <c:v>8166.45947265625</c:v>
                </c:pt>
                <c:pt idx="348">
                  <c:v>8201.384765625</c:v>
                </c:pt>
                <c:pt idx="349">
                  <c:v>8232.353515625</c:v>
                </c:pt>
              </c:numCache>
            </c:numRef>
          </c:yVal>
          <c:smooth val="1"/>
          <c:extLst>
            <c:ext xmlns:c16="http://schemas.microsoft.com/office/drawing/2014/chart" uri="{C3380CC4-5D6E-409C-BE32-E72D297353CC}">
              <c16:uniqueId val="{00000005-4A37-429A-A58F-F7AEDA5D1ACA}"/>
            </c:ext>
          </c:extLst>
        </c:ser>
        <c:ser>
          <c:idx val="6"/>
          <c:order val="6"/>
          <c:tx>
            <c:strRef>
              <c:f>cp_sub_001!$G$1</c:f>
              <c:strCache>
                <c:ptCount val="1"/>
                <c:pt idx="0">
                  <c:v>Coor_7</c:v>
                </c:pt>
              </c:strCache>
            </c:strRef>
          </c:tx>
          <c:spPr>
            <a:ln w="28575" cap="rnd">
              <a:solidFill>
                <a:schemeClr val="accent1">
                  <a:lumMod val="60000"/>
                </a:schemeClr>
              </a:solidFill>
              <a:round/>
            </a:ln>
            <a:effectLst/>
          </c:spPr>
          <c:marker>
            <c:symbol val="none"/>
          </c:marker>
          <c:yVal>
            <c:numRef>
              <c:f>cp_sub_001!$G$2:$G$351</c:f>
              <c:numCache>
                <c:formatCode>0.00000000000_ </c:formatCode>
                <c:ptCount val="350"/>
                <c:pt idx="0">
                  <c:v>6235.06884765625</c:v>
                </c:pt>
                <c:pt idx="1">
                  <c:v>6254.01953125</c:v>
                </c:pt>
                <c:pt idx="2">
                  <c:v>6292.36181640625</c:v>
                </c:pt>
                <c:pt idx="3">
                  <c:v>6328.23583984375</c:v>
                </c:pt>
                <c:pt idx="4">
                  <c:v>6340.3486328125</c:v>
                </c:pt>
                <c:pt idx="5">
                  <c:v>6324.3955078125</c:v>
                </c:pt>
                <c:pt idx="6">
                  <c:v>6298.00341796875</c:v>
                </c:pt>
                <c:pt idx="7">
                  <c:v>6288.68798828125</c:v>
                </c:pt>
                <c:pt idx="8">
                  <c:v>6312.23779296875</c:v>
                </c:pt>
                <c:pt idx="9">
                  <c:v>6357.59130859375</c:v>
                </c:pt>
                <c:pt idx="10">
                  <c:v>6391.162109375</c:v>
                </c:pt>
                <c:pt idx="11">
                  <c:v>6379.86572265625</c:v>
                </c:pt>
                <c:pt idx="12">
                  <c:v>6317.36328125</c:v>
                </c:pt>
                <c:pt idx="13">
                  <c:v>6233.724609375</c:v>
                </c:pt>
                <c:pt idx="14">
                  <c:v>6179.1640625</c:v>
                </c:pt>
                <c:pt idx="15">
                  <c:v>6191.0732421875</c:v>
                </c:pt>
                <c:pt idx="16">
                  <c:v>6266.826171875</c:v>
                </c:pt>
                <c:pt idx="17">
                  <c:v>6362.39208984375</c:v>
                </c:pt>
                <c:pt idx="18">
                  <c:v>6419.45654296875</c:v>
                </c:pt>
                <c:pt idx="19">
                  <c:v>6403.47021484375</c:v>
                </c:pt>
                <c:pt idx="20">
                  <c:v>6326.5849609375</c:v>
                </c:pt>
                <c:pt idx="21">
                  <c:v>6239.361328125</c:v>
                </c:pt>
                <c:pt idx="22">
                  <c:v>6196.71923828125</c:v>
                </c:pt>
                <c:pt idx="23">
                  <c:v>6221.5322265625</c:v>
                </c:pt>
                <c:pt idx="24">
                  <c:v>6290.72314453125</c:v>
                </c:pt>
                <c:pt idx="25">
                  <c:v>6352.73291015625</c:v>
                </c:pt>
                <c:pt idx="26">
                  <c:v>6363.44189453125</c:v>
                </c:pt>
                <c:pt idx="27">
                  <c:v>6315.48974609375</c:v>
                </c:pt>
                <c:pt idx="28">
                  <c:v>6241.61962890625</c:v>
                </c:pt>
                <c:pt idx="29">
                  <c:v>6191.38623046875</c:v>
                </c:pt>
                <c:pt idx="30">
                  <c:v>6198.482421875</c:v>
                </c:pt>
                <c:pt idx="31">
                  <c:v>6260.79248046875</c:v>
                </c:pt>
                <c:pt idx="32">
                  <c:v>6344.755859375</c:v>
                </c:pt>
                <c:pt idx="33">
                  <c:v>6408.4326171875</c:v>
                </c:pt>
                <c:pt idx="34">
                  <c:v>6426.28955078125</c:v>
                </c:pt>
                <c:pt idx="35">
                  <c:v>6400.1318359375</c:v>
                </c:pt>
                <c:pt idx="36">
                  <c:v>6352.05615234375</c:v>
                </c:pt>
                <c:pt idx="37">
                  <c:v>6307.44091796875</c:v>
                </c:pt>
                <c:pt idx="38">
                  <c:v>6280.52490234375</c:v>
                </c:pt>
                <c:pt idx="39">
                  <c:v>6270.517578125</c:v>
                </c:pt>
                <c:pt idx="40">
                  <c:v>6267.5859375</c:v>
                </c:pt>
                <c:pt idx="41">
                  <c:v>6262.203125</c:v>
                </c:pt>
                <c:pt idx="42">
                  <c:v>6251.40185546875</c:v>
                </c:pt>
                <c:pt idx="43">
                  <c:v>6239.48291015625</c:v>
                </c:pt>
                <c:pt idx="44">
                  <c:v>6234.60595703125</c:v>
                </c:pt>
                <c:pt idx="45">
                  <c:v>6243.8974609375</c:v>
                </c:pt>
                <c:pt idx="46">
                  <c:v>6269.029296875</c:v>
                </c:pt>
                <c:pt idx="47">
                  <c:v>6303.62353515625</c:v>
                </c:pt>
                <c:pt idx="48">
                  <c:v>6334.0439453125</c:v>
                </c:pt>
                <c:pt idx="49">
                  <c:v>6344.767578125</c:v>
                </c:pt>
                <c:pt idx="50">
                  <c:v>6327.18505859375</c:v>
                </c:pt>
                <c:pt idx="51">
                  <c:v>6287.17822265625</c:v>
                </c:pt>
                <c:pt idx="52">
                  <c:v>6245.41552734375</c:v>
                </c:pt>
                <c:pt idx="53">
                  <c:v>6227.59912109375</c:v>
                </c:pt>
                <c:pt idx="54">
                  <c:v>6248.890625</c:v>
                </c:pt>
                <c:pt idx="55">
                  <c:v>6302.3994140625</c:v>
                </c:pt>
                <c:pt idx="56">
                  <c:v>6360.77001953125</c:v>
                </c:pt>
                <c:pt idx="57">
                  <c:v>6391.7294921875</c:v>
                </c:pt>
                <c:pt idx="58">
                  <c:v>6378.27490234375</c:v>
                </c:pt>
                <c:pt idx="59">
                  <c:v>6329.77490234375</c:v>
                </c:pt>
                <c:pt idx="60">
                  <c:v>6275.75390625</c:v>
                </c:pt>
                <c:pt idx="61">
                  <c:v>6246.201171875</c:v>
                </c:pt>
                <c:pt idx="62">
                  <c:v>6252.06982421875</c:v>
                </c:pt>
                <c:pt idx="63">
                  <c:v>6279.66943359375</c:v>
                </c:pt>
                <c:pt idx="64">
                  <c:v>6302.5830078125</c:v>
                </c:pt>
                <c:pt idx="65">
                  <c:v>6302.0029296875</c:v>
                </c:pt>
                <c:pt idx="66">
                  <c:v>6280.529296875</c:v>
                </c:pt>
                <c:pt idx="67">
                  <c:v>6259.72021484375</c:v>
                </c:pt>
                <c:pt idx="68">
                  <c:v>6263.8388671875</c:v>
                </c:pt>
                <c:pt idx="69">
                  <c:v>6301.9990234375</c:v>
                </c:pt>
                <c:pt idx="70">
                  <c:v>6361.2919921875</c:v>
                </c:pt>
                <c:pt idx="71">
                  <c:v>6414.86328125</c:v>
                </c:pt>
                <c:pt idx="72">
                  <c:v>6438.3349609375</c:v>
                </c:pt>
                <c:pt idx="73">
                  <c:v>6423.1611328125</c:v>
                </c:pt>
                <c:pt idx="74">
                  <c:v>6379.13330078125</c:v>
                </c:pt>
                <c:pt idx="75">
                  <c:v>6326.42236328125</c:v>
                </c:pt>
                <c:pt idx="76">
                  <c:v>6283.83837890625</c:v>
                </c:pt>
                <c:pt idx="77">
                  <c:v>6260.552734375</c:v>
                </c:pt>
                <c:pt idx="78">
                  <c:v>6254.4716796875</c:v>
                </c:pt>
                <c:pt idx="79">
                  <c:v>6255.96435546875</c:v>
                </c:pt>
                <c:pt idx="80">
                  <c:v>6253.77197265625</c:v>
                </c:pt>
                <c:pt idx="81">
                  <c:v>6240.583984375</c:v>
                </c:pt>
                <c:pt idx="82">
                  <c:v>6216.806640625</c:v>
                </c:pt>
                <c:pt idx="83">
                  <c:v>6191.23388671875</c:v>
                </c:pt>
                <c:pt idx="84">
                  <c:v>6177.4296875</c:v>
                </c:pt>
                <c:pt idx="85">
                  <c:v>6186.357421875</c:v>
                </c:pt>
                <c:pt idx="86">
                  <c:v>6218.81494140625</c:v>
                </c:pt>
                <c:pt idx="87">
                  <c:v>6263.00390625</c:v>
                </c:pt>
                <c:pt idx="88">
                  <c:v>6300.337890625</c:v>
                </c:pt>
                <c:pt idx="89">
                  <c:v>6316.85400390625</c:v>
                </c:pt>
                <c:pt idx="90">
                  <c:v>6312.498046875</c:v>
                </c:pt>
                <c:pt idx="91">
                  <c:v>6300.94482421875</c:v>
                </c:pt>
                <c:pt idx="92">
                  <c:v>6299.24853515625</c:v>
                </c:pt>
                <c:pt idx="93">
                  <c:v>6314.81787109375</c:v>
                </c:pt>
                <c:pt idx="94">
                  <c:v>6340.02783203125</c:v>
                </c:pt>
                <c:pt idx="95">
                  <c:v>6359.14990234375</c:v>
                </c:pt>
                <c:pt idx="96">
                  <c:v>6362.1572265625</c:v>
                </c:pt>
                <c:pt idx="97">
                  <c:v>6353.74755859375</c:v>
                </c:pt>
                <c:pt idx="98">
                  <c:v>6349.330078125</c:v>
                </c:pt>
                <c:pt idx="99">
                  <c:v>6360.642578125</c:v>
                </c:pt>
                <c:pt idx="100">
                  <c:v>6383.11474609375</c:v>
                </c:pt>
                <c:pt idx="101">
                  <c:v>6396.67578125</c:v>
                </c:pt>
                <c:pt idx="102">
                  <c:v>6381.00048828125</c:v>
                </c:pt>
                <c:pt idx="103">
                  <c:v>6333.6318359375</c:v>
                </c:pt>
                <c:pt idx="104">
                  <c:v>6275.73681640625</c:v>
                </c:pt>
                <c:pt idx="105">
                  <c:v>6239.248046875</c:v>
                </c:pt>
                <c:pt idx="106">
                  <c:v>6244.05810546875</c:v>
                </c:pt>
                <c:pt idx="107">
                  <c:v>6282.61572265625</c:v>
                </c:pt>
                <c:pt idx="108">
                  <c:v>6324.2353515625</c:v>
                </c:pt>
                <c:pt idx="109">
                  <c:v>6336.3466796875</c:v>
                </c:pt>
                <c:pt idx="110">
                  <c:v>6306.80224609375</c:v>
                </c:pt>
                <c:pt idx="111">
                  <c:v>6250.81689453125</c:v>
                </c:pt>
                <c:pt idx="112">
                  <c:v>6198.44921875</c:v>
                </c:pt>
                <c:pt idx="113">
                  <c:v>6173.5068359375</c:v>
                </c:pt>
                <c:pt idx="114">
                  <c:v>6180.3134765625</c:v>
                </c:pt>
                <c:pt idx="115">
                  <c:v>6206.87109375</c:v>
                </c:pt>
                <c:pt idx="116">
                  <c:v>6238.92529296875</c:v>
                </c:pt>
                <c:pt idx="117">
                  <c:v>6271.35009765625</c:v>
                </c:pt>
                <c:pt idx="118">
                  <c:v>6307.46533203125</c:v>
                </c:pt>
                <c:pt idx="119">
                  <c:v>6348.904296875</c:v>
                </c:pt>
                <c:pt idx="120">
                  <c:v>6387.3779296875</c:v>
                </c:pt>
                <c:pt idx="121">
                  <c:v>6407.3857421875</c:v>
                </c:pt>
                <c:pt idx="122">
                  <c:v>6398.09716796875</c:v>
                </c:pt>
                <c:pt idx="123">
                  <c:v>6363.447265625</c:v>
                </c:pt>
                <c:pt idx="124">
                  <c:v>6320.59326171875</c:v>
                </c:pt>
                <c:pt idx="125">
                  <c:v>6287.37939453125</c:v>
                </c:pt>
                <c:pt idx="126">
                  <c:v>6269.7177734375</c:v>
                </c:pt>
                <c:pt idx="127">
                  <c:v>6260.17822265625</c:v>
                </c:pt>
                <c:pt idx="128">
                  <c:v>6248.8583984375</c:v>
                </c:pt>
                <c:pt idx="129">
                  <c:v>6235.97216796875</c:v>
                </c:pt>
                <c:pt idx="130">
                  <c:v>6233.4677734375</c:v>
                </c:pt>
                <c:pt idx="131">
                  <c:v>6252.94384765625</c:v>
                </c:pt>
                <c:pt idx="132">
                  <c:v>6290.5791015625</c:v>
                </c:pt>
                <c:pt idx="133">
                  <c:v>6324.28125</c:v>
                </c:pt>
                <c:pt idx="134">
                  <c:v>6328.64453125</c:v>
                </c:pt>
                <c:pt idx="135">
                  <c:v>6297.19384765625</c:v>
                </c:pt>
                <c:pt idx="136">
                  <c:v>6252.8427734375</c:v>
                </c:pt>
                <c:pt idx="137">
                  <c:v>6235.17529296875</c:v>
                </c:pt>
                <c:pt idx="138">
                  <c:v>6271.73974609375</c:v>
                </c:pt>
                <c:pt idx="139">
                  <c:v>6354.9248046875</c:v>
                </c:pt>
                <c:pt idx="140">
                  <c:v>6443.40625</c:v>
                </c:pt>
                <c:pt idx="141">
                  <c:v>6488.72607421875</c:v>
                </c:pt>
                <c:pt idx="142">
                  <c:v>6467.7490234375</c:v>
                </c:pt>
                <c:pt idx="143">
                  <c:v>6396.7666015625</c:v>
                </c:pt>
                <c:pt idx="144">
                  <c:v>6317.2177734375</c:v>
                </c:pt>
                <c:pt idx="145">
                  <c:v>6265.029296875</c:v>
                </c:pt>
                <c:pt idx="146">
                  <c:v>6247.64990234375</c:v>
                </c:pt>
                <c:pt idx="147">
                  <c:v>6245.44189453125</c:v>
                </c:pt>
                <c:pt idx="148">
                  <c:v>6233.810546875</c:v>
                </c:pt>
                <c:pt idx="149">
                  <c:v>6206.18896484375</c:v>
                </c:pt>
                <c:pt idx="150">
                  <c:v>6178.880859375</c:v>
                </c:pt>
                <c:pt idx="151">
                  <c:v>6175.17529296875</c:v>
                </c:pt>
                <c:pt idx="152">
                  <c:v>6203.70458984375</c:v>
                </c:pt>
                <c:pt idx="153">
                  <c:v>6250.0048828125</c:v>
                </c:pt>
                <c:pt idx="154">
                  <c:v>6287.9677734375</c:v>
                </c:pt>
                <c:pt idx="155">
                  <c:v>6300.6181640625</c:v>
                </c:pt>
                <c:pt idx="156">
                  <c:v>6292.26318359375</c:v>
                </c:pt>
                <c:pt idx="157">
                  <c:v>6282.439453125</c:v>
                </c:pt>
                <c:pt idx="158">
                  <c:v>6288.1298828125</c:v>
                </c:pt>
                <c:pt idx="159">
                  <c:v>6310.2509765625</c:v>
                </c:pt>
                <c:pt idx="160">
                  <c:v>6335.4345703125</c:v>
                </c:pt>
                <c:pt idx="161">
                  <c:v>6349.85009765625</c:v>
                </c:pt>
                <c:pt idx="162">
                  <c:v>6351.3193359375</c:v>
                </c:pt>
                <c:pt idx="163">
                  <c:v>6348.626953125</c:v>
                </c:pt>
                <c:pt idx="164">
                  <c:v>6349.697265625</c:v>
                </c:pt>
                <c:pt idx="165">
                  <c:v>6351.2099609375</c:v>
                </c:pt>
                <c:pt idx="166">
                  <c:v>6340.89599609375</c:v>
                </c:pt>
                <c:pt idx="167">
                  <c:v>6311.35791015625</c:v>
                </c:pt>
                <c:pt idx="168">
                  <c:v>6272.28857421875</c:v>
                </c:pt>
                <c:pt idx="169">
                  <c:v>6247.88818359375</c:v>
                </c:pt>
                <c:pt idx="170">
                  <c:v>6259.04052734375</c:v>
                </c:pt>
                <c:pt idx="171">
                  <c:v>6304.32080078125</c:v>
                </c:pt>
                <c:pt idx="172">
                  <c:v>6356.92529296875</c:v>
                </c:pt>
                <c:pt idx="173">
                  <c:v>6382.4228515625</c:v>
                </c:pt>
                <c:pt idx="174">
                  <c:v>6364.57470703125</c:v>
                </c:pt>
                <c:pt idx="175">
                  <c:v>6318.50390625</c:v>
                </c:pt>
                <c:pt idx="176">
                  <c:v>6279.68212890625</c:v>
                </c:pt>
                <c:pt idx="177">
                  <c:v>6276.51953125</c:v>
                </c:pt>
                <c:pt idx="178">
                  <c:v>6307.955078125</c:v>
                </c:pt>
                <c:pt idx="179">
                  <c:v>6343.8974609375</c:v>
                </c:pt>
                <c:pt idx="180">
                  <c:v>6348.30810546875</c:v>
                </c:pt>
                <c:pt idx="181">
                  <c:v>6306.8759765625</c:v>
                </c:pt>
                <c:pt idx="182">
                  <c:v>6237.974609375</c:v>
                </c:pt>
                <c:pt idx="183">
                  <c:v>6179.20458984375</c:v>
                </c:pt>
                <c:pt idx="184">
                  <c:v>6160.8779296875</c:v>
                </c:pt>
                <c:pt idx="185">
                  <c:v>6186.89599609375</c:v>
                </c:pt>
                <c:pt idx="186">
                  <c:v>6236.08251953125</c:v>
                </c:pt>
                <c:pt idx="187">
                  <c:v>6280.2685546875</c:v>
                </c:pt>
                <c:pt idx="188">
                  <c:v>6303.3740234375</c:v>
                </c:pt>
                <c:pt idx="189">
                  <c:v>6307.4794921875</c:v>
                </c:pt>
                <c:pt idx="190">
                  <c:v>6304.3779296875</c:v>
                </c:pt>
                <c:pt idx="191">
                  <c:v>6302.80859375</c:v>
                </c:pt>
                <c:pt idx="192">
                  <c:v>6302.912109375</c:v>
                </c:pt>
                <c:pt idx="193">
                  <c:v>6300.775390625</c:v>
                </c:pt>
                <c:pt idx="194">
                  <c:v>6296.16015625</c:v>
                </c:pt>
                <c:pt idx="195">
                  <c:v>6294.625</c:v>
                </c:pt>
                <c:pt idx="196">
                  <c:v>6302.029296875</c:v>
                </c:pt>
                <c:pt idx="197">
                  <c:v>6317.6494140625</c:v>
                </c:pt>
                <c:pt idx="198">
                  <c:v>6333.6005859375</c:v>
                </c:pt>
                <c:pt idx="199">
                  <c:v>6341.73876953125</c:v>
                </c:pt>
                <c:pt idx="200">
                  <c:v>6341.31201171875</c:v>
                </c:pt>
                <c:pt idx="201">
                  <c:v>6339.376953125</c:v>
                </c:pt>
                <c:pt idx="202">
                  <c:v>6342.873046875</c:v>
                </c:pt>
                <c:pt idx="203">
                  <c:v>6349.84326171875</c:v>
                </c:pt>
                <c:pt idx="204">
                  <c:v>6349.01708984375</c:v>
                </c:pt>
                <c:pt idx="205">
                  <c:v>6329.56787109375</c:v>
                </c:pt>
                <c:pt idx="206">
                  <c:v>6292.86083984375</c:v>
                </c:pt>
                <c:pt idx="207">
                  <c:v>6254.87451171875</c:v>
                </c:pt>
                <c:pt idx="208">
                  <c:v>6235.4755859375</c:v>
                </c:pt>
                <c:pt idx="209">
                  <c:v>6242.7158203125</c:v>
                </c:pt>
                <c:pt idx="210">
                  <c:v>6265.9140625</c:v>
                </c:pt>
                <c:pt idx="211">
                  <c:v>6284.68798828125</c:v>
                </c:pt>
                <c:pt idx="212">
                  <c:v>6287.2509765625</c:v>
                </c:pt>
                <c:pt idx="213">
                  <c:v>6282.1484375</c:v>
                </c:pt>
                <c:pt idx="214">
                  <c:v>6291.9169921875</c:v>
                </c:pt>
                <c:pt idx="215">
                  <c:v>6332.15576171875</c:v>
                </c:pt>
                <c:pt idx="216">
                  <c:v>6392.86083984375</c:v>
                </c:pt>
                <c:pt idx="217">
                  <c:v>6438.8408203125</c:v>
                </c:pt>
                <c:pt idx="218">
                  <c:v>6431.634765625</c:v>
                </c:pt>
                <c:pt idx="219">
                  <c:v>6357.880859375</c:v>
                </c:pt>
                <c:pt idx="220">
                  <c:v>6242.80712890625</c:v>
                </c:pt>
                <c:pt idx="221">
                  <c:v>6137.92578125</c:v>
                </c:pt>
                <c:pt idx="222">
                  <c:v>6091.03369140625</c:v>
                </c:pt>
                <c:pt idx="223">
                  <c:v>6119.3408203125</c:v>
                </c:pt>
                <c:pt idx="224">
                  <c:v>6203.22021484375</c:v>
                </c:pt>
                <c:pt idx="225">
                  <c:v>6302.18115234375</c:v>
                </c:pt>
                <c:pt idx="226">
                  <c:v>6379.19677734375</c:v>
                </c:pt>
                <c:pt idx="227">
                  <c:v>6416.30712890625</c:v>
                </c:pt>
                <c:pt idx="228">
                  <c:v>6414.35888671875</c:v>
                </c:pt>
                <c:pt idx="229">
                  <c:v>6383.109375</c:v>
                </c:pt>
                <c:pt idx="230">
                  <c:v>6333.3037109375</c:v>
                </c:pt>
                <c:pt idx="231">
                  <c:v>6276.490234375</c:v>
                </c:pt>
                <c:pt idx="232">
                  <c:v>6228.24609375</c:v>
                </c:pt>
                <c:pt idx="233">
                  <c:v>6206.3818359375</c:v>
                </c:pt>
                <c:pt idx="234">
                  <c:v>6221.43994140625</c:v>
                </c:pt>
                <c:pt idx="235">
                  <c:v>6266.50390625</c:v>
                </c:pt>
                <c:pt idx="236">
                  <c:v>6317.00634765625</c:v>
                </c:pt>
                <c:pt idx="237">
                  <c:v>6344.32177734375</c:v>
                </c:pt>
                <c:pt idx="238">
                  <c:v>6334.82861328125</c:v>
                </c:pt>
                <c:pt idx="239">
                  <c:v>6299.74072265625</c:v>
                </c:pt>
                <c:pt idx="240">
                  <c:v>6266.8876953125</c:v>
                </c:pt>
                <c:pt idx="241">
                  <c:v>6259.7421875</c:v>
                </c:pt>
                <c:pt idx="242">
                  <c:v>6279.7587890625</c:v>
                </c:pt>
                <c:pt idx="243">
                  <c:v>6306.0849609375</c:v>
                </c:pt>
                <c:pt idx="244">
                  <c:v>6313.0654296875</c:v>
                </c:pt>
                <c:pt idx="245">
                  <c:v>6291.63134765625</c:v>
                </c:pt>
                <c:pt idx="246">
                  <c:v>6257.46923828125</c:v>
                </c:pt>
                <c:pt idx="247">
                  <c:v>6239.4560546875</c:v>
                </c:pt>
                <c:pt idx="248">
                  <c:v>6257.6181640625</c:v>
                </c:pt>
                <c:pt idx="249">
                  <c:v>6307.9609375</c:v>
                </c:pt>
                <c:pt idx="250">
                  <c:v>6365.6103515625</c:v>
                </c:pt>
                <c:pt idx="251">
                  <c:v>6402.98486328125</c:v>
                </c:pt>
                <c:pt idx="252">
                  <c:v>6408.2890625</c:v>
                </c:pt>
                <c:pt idx="253">
                  <c:v>6390.4736328125</c:v>
                </c:pt>
                <c:pt idx="254">
                  <c:v>6368.45458984375</c:v>
                </c:pt>
                <c:pt idx="255">
                  <c:v>6354.83837890625</c:v>
                </c:pt>
                <c:pt idx="256">
                  <c:v>6347.5908203125</c:v>
                </c:pt>
                <c:pt idx="257">
                  <c:v>6335.2431640625</c:v>
                </c:pt>
                <c:pt idx="258">
                  <c:v>6309.65234375</c:v>
                </c:pt>
                <c:pt idx="259">
                  <c:v>6274.7900390625</c:v>
                </c:pt>
                <c:pt idx="260">
                  <c:v>6244.46484375</c:v>
                </c:pt>
                <c:pt idx="261">
                  <c:v>6231.7197265625</c:v>
                </c:pt>
                <c:pt idx="262">
                  <c:v>6239.22314453125</c:v>
                </c:pt>
                <c:pt idx="263">
                  <c:v>6258.1767578125</c:v>
                </c:pt>
                <c:pt idx="264">
                  <c:v>6275.51318359375</c:v>
                </c:pt>
                <c:pt idx="265">
                  <c:v>6282.57763671875</c:v>
                </c:pt>
                <c:pt idx="266">
                  <c:v>6278.455078125</c:v>
                </c:pt>
                <c:pt idx="267">
                  <c:v>6266.8544921875</c:v>
                </c:pt>
                <c:pt idx="268">
                  <c:v>6251.18994140625</c:v>
                </c:pt>
                <c:pt idx="269">
                  <c:v>6233.162109375</c:v>
                </c:pt>
                <c:pt idx="270">
                  <c:v>6215.62744140625</c:v>
                </c:pt>
                <c:pt idx="271">
                  <c:v>6205.625</c:v>
                </c:pt>
                <c:pt idx="272">
                  <c:v>6212.90625</c:v>
                </c:pt>
                <c:pt idx="273">
                  <c:v>6243.67138671875</c:v>
                </c:pt>
                <c:pt idx="274">
                  <c:v>6294.28857421875</c:v>
                </c:pt>
                <c:pt idx="275">
                  <c:v>6350.6962890625</c:v>
                </c:pt>
                <c:pt idx="276">
                  <c:v>6394.93603515625</c:v>
                </c:pt>
                <c:pt idx="277">
                  <c:v>6414.4677734375</c:v>
                </c:pt>
                <c:pt idx="278">
                  <c:v>6407.67626953125</c:v>
                </c:pt>
                <c:pt idx="279">
                  <c:v>6382.1650390625</c:v>
                </c:pt>
                <c:pt idx="280">
                  <c:v>6348.169921875</c:v>
                </c:pt>
                <c:pt idx="281">
                  <c:v>6312.837890625</c:v>
                </c:pt>
                <c:pt idx="282">
                  <c:v>6279.4482421875</c:v>
                </c:pt>
                <c:pt idx="283">
                  <c:v>6250.78515625</c:v>
                </c:pt>
                <c:pt idx="284">
                  <c:v>6232.240234375</c:v>
                </c:pt>
                <c:pt idx="285">
                  <c:v>6230.87109375</c:v>
                </c:pt>
                <c:pt idx="286">
                  <c:v>6250.70947265625</c:v>
                </c:pt>
                <c:pt idx="287">
                  <c:v>6288.21484375</c:v>
                </c:pt>
                <c:pt idx="288">
                  <c:v>6331.84423828125</c:v>
                </c:pt>
                <c:pt idx="289">
                  <c:v>6366.396484375</c:v>
                </c:pt>
                <c:pt idx="290">
                  <c:v>6379.318359375</c:v>
                </c:pt>
                <c:pt idx="291">
                  <c:v>6365.30126953125</c:v>
                </c:pt>
                <c:pt idx="292">
                  <c:v>6327.583984375</c:v>
                </c:pt>
                <c:pt idx="293">
                  <c:v>6276.80908203125</c:v>
                </c:pt>
                <c:pt idx="294">
                  <c:v>6228.80712890625</c:v>
                </c:pt>
                <c:pt idx="295">
                  <c:v>6201.29345703125</c:v>
                </c:pt>
                <c:pt idx="296">
                  <c:v>6208.505859375</c:v>
                </c:pt>
                <c:pt idx="297">
                  <c:v>6254.20703125</c:v>
                </c:pt>
                <c:pt idx="298">
                  <c:v>6326.46875</c:v>
                </c:pt>
                <c:pt idx="299">
                  <c:v>6399.03955078125</c:v>
                </c:pt>
                <c:pt idx="300">
                  <c:v>6441.38037109375</c:v>
                </c:pt>
                <c:pt idx="301">
                  <c:v>6433.54931640625</c:v>
                </c:pt>
                <c:pt idx="302">
                  <c:v>6377.44921875</c:v>
                </c:pt>
                <c:pt idx="303">
                  <c:v>6296.78564453125</c:v>
                </c:pt>
                <c:pt idx="304">
                  <c:v>6224.8134765625</c:v>
                </c:pt>
                <c:pt idx="305">
                  <c:v>6187.0615234375</c:v>
                </c:pt>
                <c:pt idx="306">
                  <c:v>6189.68603515625</c:v>
                </c:pt>
                <c:pt idx="307">
                  <c:v>6220.09033203125</c:v>
                </c:pt>
                <c:pt idx="308">
                  <c:v>6257.91015625</c:v>
                </c:pt>
                <c:pt idx="309">
                  <c:v>6287.82177734375</c:v>
                </c:pt>
                <c:pt idx="310">
                  <c:v>6305.62548828125</c:v>
                </c:pt>
                <c:pt idx="311">
                  <c:v>6315.23876953125</c:v>
                </c:pt>
                <c:pt idx="312">
                  <c:v>6321.23828125</c:v>
                </c:pt>
                <c:pt idx="313">
                  <c:v>6323.9697265625</c:v>
                </c:pt>
                <c:pt idx="314">
                  <c:v>6320.66357421875</c:v>
                </c:pt>
                <c:pt idx="315">
                  <c:v>6310.14013671875</c:v>
                </c:pt>
                <c:pt idx="316">
                  <c:v>6295.78271484375</c:v>
                </c:pt>
                <c:pt idx="317">
                  <c:v>6283.71435546875</c:v>
                </c:pt>
                <c:pt idx="318">
                  <c:v>6278.0302734375</c:v>
                </c:pt>
                <c:pt idx="319">
                  <c:v>6277.833984375</c:v>
                </c:pt>
                <c:pt idx="320">
                  <c:v>6279.0107421875</c:v>
                </c:pt>
                <c:pt idx="321">
                  <c:v>6279.0078125</c:v>
                </c:pt>
                <c:pt idx="322">
                  <c:v>6279.80517578125</c:v>
                </c:pt>
                <c:pt idx="323">
                  <c:v>6285.8037109375</c:v>
                </c:pt>
                <c:pt idx="324">
                  <c:v>6298.2783203125</c:v>
                </c:pt>
                <c:pt idx="325">
                  <c:v>6311.7919921875</c:v>
                </c:pt>
                <c:pt idx="326">
                  <c:v>6316.87548828125</c:v>
                </c:pt>
                <c:pt idx="327">
                  <c:v>6307.82666015625</c:v>
                </c:pt>
                <c:pt idx="328">
                  <c:v>6289.36474609375</c:v>
                </c:pt>
                <c:pt idx="329">
                  <c:v>6275.724609375</c:v>
                </c:pt>
                <c:pt idx="330">
                  <c:v>6281.39404296875</c:v>
                </c:pt>
                <c:pt idx="331">
                  <c:v>6309.7373046875</c:v>
                </c:pt>
                <c:pt idx="332">
                  <c:v>6348.37255859375</c:v>
                </c:pt>
                <c:pt idx="333">
                  <c:v>6375.783203125</c:v>
                </c:pt>
                <c:pt idx="334">
                  <c:v>6375.25634765625</c:v>
                </c:pt>
                <c:pt idx="335">
                  <c:v>6346.34521484375</c:v>
                </c:pt>
                <c:pt idx="336">
                  <c:v>6305.38525390625</c:v>
                </c:pt>
                <c:pt idx="337">
                  <c:v>6274.4306640625</c:v>
                </c:pt>
                <c:pt idx="338">
                  <c:v>6266.44921875</c:v>
                </c:pt>
                <c:pt idx="339">
                  <c:v>6277.37353515625</c:v>
                </c:pt>
                <c:pt idx="340">
                  <c:v>6290.525390625</c:v>
                </c:pt>
                <c:pt idx="341">
                  <c:v>6289.9052734375</c:v>
                </c:pt>
                <c:pt idx="342">
                  <c:v>6272.49560546875</c:v>
                </c:pt>
                <c:pt idx="343">
                  <c:v>6250.70703125</c:v>
                </c:pt>
                <c:pt idx="344">
                  <c:v>6243.40234375</c:v>
                </c:pt>
                <c:pt idx="345">
                  <c:v>6262.0986328125</c:v>
                </c:pt>
                <c:pt idx="346">
                  <c:v>6302.146484375</c:v>
                </c:pt>
                <c:pt idx="347">
                  <c:v>6344.88623046875</c:v>
                </c:pt>
                <c:pt idx="348">
                  <c:v>6369.03515625</c:v>
                </c:pt>
                <c:pt idx="349">
                  <c:v>6363.48095703125</c:v>
                </c:pt>
              </c:numCache>
            </c:numRef>
          </c:yVal>
          <c:smooth val="1"/>
          <c:extLst>
            <c:ext xmlns:c16="http://schemas.microsoft.com/office/drawing/2014/chart" uri="{C3380CC4-5D6E-409C-BE32-E72D297353CC}">
              <c16:uniqueId val="{00000006-4A37-429A-A58F-F7AEDA5D1ACA}"/>
            </c:ext>
          </c:extLst>
        </c:ser>
        <c:ser>
          <c:idx val="7"/>
          <c:order val="7"/>
          <c:tx>
            <c:strRef>
              <c:f>cp_sub_001!$H$1</c:f>
              <c:strCache>
                <c:ptCount val="1"/>
                <c:pt idx="0">
                  <c:v>Coor_8</c:v>
                </c:pt>
              </c:strCache>
            </c:strRef>
          </c:tx>
          <c:spPr>
            <a:ln w="28575" cap="rnd">
              <a:solidFill>
                <a:schemeClr val="accent2">
                  <a:lumMod val="60000"/>
                </a:schemeClr>
              </a:solidFill>
              <a:round/>
            </a:ln>
            <a:effectLst/>
          </c:spPr>
          <c:marker>
            <c:symbol val="none"/>
          </c:marker>
          <c:yVal>
            <c:numRef>
              <c:f>cp_sub_001!$H$2:$H$351</c:f>
              <c:numCache>
                <c:formatCode>0.00000000000_ </c:formatCode>
                <c:ptCount val="350"/>
                <c:pt idx="0">
                  <c:v>5147.48974609375</c:v>
                </c:pt>
                <c:pt idx="1">
                  <c:v>5161.97607421875</c:v>
                </c:pt>
                <c:pt idx="2">
                  <c:v>5178.9873046875</c:v>
                </c:pt>
                <c:pt idx="3">
                  <c:v>5196.833984375</c:v>
                </c:pt>
                <c:pt idx="4">
                  <c:v>5204.787109375</c:v>
                </c:pt>
                <c:pt idx="5">
                  <c:v>5191.2265625</c:v>
                </c:pt>
                <c:pt idx="6">
                  <c:v>5155.08056640625</c:v>
                </c:pt>
                <c:pt idx="7">
                  <c:v>5110.353515625</c:v>
                </c:pt>
                <c:pt idx="8">
                  <c:v>5078.56396484375</c:v>
                </c:pt>
                <c:pt idx="9">
                  <c:v>5073.84033203125</c:v>
                </c:pt>
                <c:pt idx="10">
                  <c:v>5092.041015625</c:v>
                </c:pt>
                <c:pt idx="11">
                  <c:v>5112.89697265625</c:v>
                </c:pt>
                <c:pt idx="12">
                  <c:v>5114.39453125</c:v>
                </c:pt>
                <c:pt idx="13">
                  <c:v>5089.107421875</c:v>
                </c:pt>
                <c:pt idx="14">
                  <c:v>5050.314453125</c:v>
                </c:pt>
                <c:pt idx="15">
                  <c:v>5023.12060546875</c:v>
                </c:pt>
                <c:pt idx="16">
                  <c:v>5026.71630859375</c:v>
                </c:pt>
                <c:pt idx="17">
                  <c:v>5060.33447265625</c:v>
                </c:pt>
                <c:pt idx="18">
                  <c:v>5102.82373046875</c:v>
                </c:pt>
                <c:pt idx="19">
                  <c:v>5126.23876953125</c:v>
                </c:pt>
                <c:pt idx="20">
                  <c:v>5114.3046875</c:v>
                </c:pt>
                <c:pt idx="21">
                  <c:v>5073.50048828125</c:v>
                </c:pt>
                <c:pt idx="22">
                  <c:v>5029.49951171875</c:v>
                </c:pt>
                <c:pt idx="23">
                  <c:v>5011.19580078125</c:v>
                </c:pt>
                <c:pt idx="24">
                  <c:v>5032.35400390625</c:v>
                </c:pt>
                <c:pt idx="25">
                  <c:v>5082.3896484375</c:v>
                </c:pt>
                <c:pt idx="26">
                  <c:v>5132.22705078125</c:v>
                </c:pt>
                <c:pt idx="27">
                  <c:v>5152.0029296875</c:v>
                </c:pt>
                <c:pt idx="28">
                  <c:v>5129.9189453125</c:v>
                </c:pt>
                <c:pt idx="29">
                  <c:v>5080.37744140625</c:v>
                </c:pt>
                <c:pt idx="30">
                  <c:v>5035.66845703125</c:v>
                </c:pt>
                <c:pt idx="31">
                  <c:v>5025.73095703125</c:v>
                </c:pt>
                <c:pt idx="32">
                  <c:v>5058.65087890625</c:v>
                </c:pt>
                <c:pt idx="33">
                  <c:v>5114.9404296875</c:v>
                </c:pt>
                <c:pt idx="34">
                  <c:v>5160.1953125</c:v>
                </c:pt>
                <c:pt idx="35">
                  <c:v>5168.3154296875</c:v>
                </c:pt>
                <c:pt idx="36">
                  <c:v>5139.57080078125</c:v>
                </c:pt>
                <c:pt idx="37">
                  <c:v>5100.53857421875</c:v>
                </c:pt>
                <c:pt idx="38">
                  <c:v>5085.2353515625</c:v>
                </c:pt>
                <c:pt idx="39">
                  <c:v>5110.3779296875</c:v>
                </c:pt>
                <c:pt idx="40">
                  <c:v>5162.47021484375</c:v>
                </c:pt>
                <c:pt idx="41">
                  <c:v>5206.369140625</c:v>
                </c:pt>
                <c:pt idx="42">
                  <c:v>5209.5126953125</c:v>
                </c:pt>
                <c:pt idx="43">
                  <c:v>5164.51513671875</c:v>
                </c:pt>
                <c:pt idx="44">
                  <c:v>5094.07763671875</c:v>
                </c:pt>
                <c:pt idx="45">
                  <c:v>5035.244140625</c:v>
                </c:pt>
                <c:pt idx="46">
                  <c:v>5015.02685546875</c:v>
                </c:pt>
                <c:pt idx="47">
                  <c:v>5034.9482421875</c:v>
                </c:pt>
                <c:pt idx="48">
                  <c:v>5074.2939453125</c:v>
                </c:pt>
                <c:pt idx="49">
                  <c:v>5107.45947265625</c:v>
                </c:pt>
                <c:pt idx="50">
                  <c:v>5121.1044921875</c:v>
                </c:pt>
                <c:pt idx="51">
                  <c:v>5118.9677734375</c:v>
                </c:pt>
                <c:pt idx="52">
                  <c:v>5113.30029296875</c:v>
                </c:pt>
                <c:pt idx="53">
                  <c:v>5112.24072265625</c:v>
                </c:pt>
                <c:pt idx="54">
                  <c:v>5113.8955078125</c:v>
                </c:pt>
                <c:pt idx="55">
                  <c:v>5110.41015625</c:v>
                </c:pt>
                <c:pt idx="56">
                  <c:v>5096.38525390625</c:v>
                </c:pt>
                <c:pt idx="57">
                  <c:v>5073.4560546875</c:v>
                </c:pt>
                <c:pt idx="58">
                  <c:v>5048.03173828125</c:v>
                </c:pt>
                <c:pt idx="59">
                  <c:v>5026.240234375</c:v>
                </c:pt>
                <c:pt idx="60">
                  <c:v>5011.9970703125</c:v>
                </c:pt>
                <c:pt idx="61">
                  <c:v>5009.4287109375</c:v>
                </c:pt>
                <c:pt idx="62">
                  <c:v>5024.91552734375</c:v>
                </c:pt>
                <c:pt idx="63">
                  <c:v>5063.55078125</c:v>
                </c:pt>
                <c:pt idx="64">
                  <c:v>5120.9892578125</c:v>
                </c:pt>
                <c:pt idx="65">
                  <c:v>5178.50732421875</c:v>
                </c:pt>
                <c:pt idx="66">
                  <c:v>5209.07470703125</c:v>
                </c:pt>
                <c:pt idx="67">
                  <c:v>5193.65283203125</c:v>
                </c:pt>
                <c:pt idx="68">
                  <c:v>5136.72216796875</c:v>
                </c:pt>
                <c:pt idx="69">
                  <c:v>5067.8037109375</c:v>
                </c:pt>
                <c:pt idx="70">
                  <c:v>5025.04248046875</c:v>
                </c:pt>
                <c:pt idx="71">
                  <c:v>5031.142578125</c:v>
                </c:pt>
                <c:pt idx="72">
                  <c:v>5079.1015625</c:v>
                </c:pt>
                <c:pt idx="73">
                  <c:v>5138.55615234375</c:v>
                </c:pt>
                <c:pt idx="74">
                  <c:v>5177.75341796875</c:v>
                </c:pt>
                <c:pt idx="75">
                  <c:v>5184.09521484375</c:v>
                </c:pt>
                <c:pt idx="76">
                  <c:v>5167.97412109375</c:v>
                </c:pt>
                <c:pt idx="77">
                  <c:v>5148.84033203125</c:v>
                </c:pt>
                <c:pt idx="78">
                  <c:v>5136.9541015625</c:v>
                </c:pt>
                <c:pt idx="79">
                  <c:v>5126.78662109375</c:v>
                </c:pt>
                <c:pt idx="80">
                  <c:v>5106.6513671875</c:v>
                </c:pt>
                <c:pt idx="81">
                  <c:v>5074.2138671875</c:v>
                </c:pt>
                <c:pt idx="82">
                  <c:v>5042.41748046875</c:v>
                </c:pt>
                <c:pt idx="83">
                  <c:v>5029.578125</c:v>
                </c:pt>
                <c:pt idx="84">
                  <c:v>5042.50732421875</c:v>
                </c:pt>
                <c:pt idx="85">
                  <c:v>5068.58984375</c:v>
                </c:pt>
                <c:pt idx="86">
                  <c:v>5085.07421875</c:v>
                </c:pt>
                <c:pt idx="87">
                  <c:v>5078.1220703125</c:v>
                </c:pt>
                <c:pt idx="88">
                  <c:v>5054.73388671875</c:v>
                </c:pt>
                <c:pt idx="89">
                  <c:v>5036.50048828125</c:v>
                </c:pt>
                <c:pt idx="90">
                  <c:v>5040.380859375</c:v>
                </c:pt>
                <c:pt idx="91">
                  <c:v>5063.77197265625</c:v>
                </c:pt>
                <c:pt idx="92">
                  <c:v>5087.67822265625</c:v>
                </c:pt>
                <c:pt idx="93">
                  <c:v>5095.375</c:v>
                </c:pt>
                <c:pt idx="94">
                  <c:v>5089.2705078125</c:v>
                </c:pt>
                <c:pt idx="95">
                  <c:v>5089.48388671875</c:v>
                </c:pt>
                <c:pt idx="96">
                  <c:v>5114.0791015625</c:v>
                </c:pt>
                <c:pt idx="97">
                  <c:v>5158.55078125</c:v>
                </c:pt>
                <c:pt idx="98">
                  <c:v>5194.6044921875</c:v>
                </c:pt>
                <c:pt idx="99">
                  <c:v>5192.07958984375</c:v>
                </c:pt>
                <c:pt idx="100">
                  <c:v>5146.5224609375</c:v>
                </c:pt>
                <c:pt idx="101">
                  <c:v>5087.67529296875</c:v>
                </c:pt>
                <c:pt idx="102">
                  <c:v>5058.80078125</c:v>
                </c:pt>
                <c:pt idx="103">
                  <c:v>5081.8955078125</c:v>
                </c:pt>
                <c:pt idx="104">
                  <c:v>5137.74755859375</c:v>
                </c:pt>
                <c:pt idx="105">
                  <c:v>5179.294921875</c:v>
                </c:pt>
                <c:pt idx="106">
                  <c:v>5169.31982421875</c:v>
                </c:pt>
                <c:pt idx="107">
                  <c:v>5112.02197265625</c:v>
                </c:pt>
                <c:pt idx="108">
                  <c:v>5051.40576171875</c:v>
                </c:pt>
                <c:pt idx="109">
                  <c:v>5036.166015625</c:v>
                </c:pt>
                <c:pt idx="110">
                  <c:v>5079.05078125</c:v>
                </c:pt>
                <c:pt idx="111">
                  <c:v>5144.541015625</c:v>
                </c:pt>
                <c:pt idx="112">
                  <c:v>5176.26171875</c:v>
                </c:pt>
                <c:pt idx="113">
                  <c:v>5142.76318359375</c:v>
                </c:pt>
                <c:pt idx="114">
                  <c:v>5064.4111328125</c:v>
                </c:pt>
                <c:pt idx="115">
                  <c:v>4998.7470703125</c:v>
                </c:pt>
                <c:pt idx="116">
                  <c:v>4995.31005859375</c:v>
                </c:pt>
                <c:pt idx="117">
                  <c:v>5055.99267578125</c:v>
                </c:pt>
                <c:pt idx="118">
                  <c:v>5132.86279296875</c:v>
                </c:pt>
                <c:pt idx="119">
                  <c:v>5165.32275390625</c:v>
                </c:pt>
                <c:pt idx="120">
                  <c:v>5127.037109375</c:v>
                </c:pt>
                <c:pt idx="121">
                  <c:v>5045.677734375</c:v>
                </c:pt>
                <c:pt idx="122">
                  <c:v>4980.74365234375</c:v>
                </c:pt>
                <c:pt idx="123">
                  <c:v>4977.9580078125</c:v>
                </c:pt>
                <c:pt idx="124">
                  <c:v>5036.220703125</c:v>
                </c:pt>
                <c:pt idx="125">
                  <c:v>5111.58837890625</c:v>
                </c:pt>
                <c:pt idx="126">
                  <c:v>5152.8134765625</c:v>
                </c:pt>
                <c:pt idx="127">
                  <c:v>5139.244140625</c:v>
                </c:pt>
                <c:pt idx="128">
                  <c:v>5092.51513671875</c:v>
                </c:pt>
                <c:pt idx="129">
                  <c:v>5055.98876953125</c:v>
                </c:pt>
                <c:pt idx="130">
                  <c:v>5060.8427734375</c:v>
                </c:pt>
                <c:pt idx="131">
                  <c:v>5105.400390625</c:v>
                </c:pt>
                <c:pt idx="132">
                  <c:v>5160.7978515625</c:v>
                </c:pt>
                <c:pt idx="133">
                  <c:v>5194.55419921875</c:v>
                </c:pt>
                <c:pt idx="134">
                  <c:v>5191.93408203125</c:v>
                </c:pt>
                <c:pt idx="135">
                  <c:v>5160.6806640625</c:v>
                </c:pt>
                <c:pt idx="136">
                  <c:v>5120.2197265625</c:v>
                </c:pt>
                <c:pt idx="137">
                  <c:v>5087.55859375</c:v>
                </c:pt>
                <c:pt idx="138">
                  <c:v>5070.73193359375</c:v>
                </c:pt>
                <c:pt idx="139">
                  <c:v>5070.82275390625</c:v>
                </c:pt>
                <c:pt idx="140">
                  <c:v>5085.8916015625</c:v>
                </c:pt>
                <c:pt idx="141">
                  <c:v>5111.27978515625</c:v>
                </c:pt>
                <c:pt idx="142">
                  <c:v>5137.65625</c:v>
                </c:pt>
                <c:pt idx="143">
                  <c:v>5152.4521484375</c:v>
                </c:pt>
                <c:pt idx="144">
                  <c:v>5146.9296875</c:v>
                </c:pt>
                <c:pt idx="145">
                  <c:v>5123.75439453125</c:v>
                </c:pt>
                <c:pt idx="146">
                  <c:v>5096.94580078125</c:v>
                </c:pt>
                <c:pt idx="147">
                  <c:v>5081.73974609375</c:v>
                </c:pt>
                <c:pt idx="148">
                  <c:v>5081.71044921875</c:v>
                </c:pt>
                <c:pt idx="149">
                  <c:v>5084.79248046875</c:v>
                </c:pt>
                <c:pt idx="150">
                  <c:v>5073.41064453125</c:v>
                </c:pt>
                <c:pt idx="151">
                  <c:v>5041.44384765625</c:v>
                </c:pt>
                <c:pt idx="152">
                  <c:v>5003.3564453125</c:v>
                </c:pt>
                <c:pt idx="153">
                  <c:v>4986.07080078125</c:v>
                </c:pt>
                <c:pt idx="154">
                  <c:v>5008.46875</c:v>
                </c:pt>
                <c:pt idx="155">
                  <c:v>5064.7880859375</c:v>
                </c:pt>
                <c:pt idx="156">
                  <c:v>5126.22265625</c:v>
                </c:pt>
                <c:pt idx="157">
                  <c:v>5160.71875</c:v>
                </c:pt>
                <c:pt idx="158">
                  <c:v>5155.9130859375</c:v>
                </c:pt>
                <c:pt idx="159">
                  <c:v>5127.2080078125</c:v>
                </c:pt>
                <c:pt idx="160">
                  <c:v>5104.77587890625</c:v>
                </c:pt>
                <c:pt idx="161">
                  <c:v>5110.0654296875</c:v>
                </c:pt>
                <c:pt idx="162">
                  <c:v>5140.28564453125</c:v>
                </c:pt>
                <c:pt idx="163">
                  <c:v>5172.1357421875</c:v>
                </c:pt>
                <c:pt idx="164">
                  <c:v>5180.30810546875</c:v>
                </c:pt>
                <c:pt idx="165">
                  <c:v>5155.35302734375</c:v>
                </c:pt>
                <c:pt idx="166">
                  <c:v>5107.8359375</c:v>
                </c:pt>
                <c:pt idx="167">
                  <c:v>5058.2275390625</c:v>
                </c:pt>
                <c:pt idx="168">
                  <c:v>5023.09814453125</c:v>
                </c:pt>
                <c:pt idx="169">
                  <c:v>5008.85205078125</c:v>
                </c:pt>
                <c:pt idx="170">
                  <c:v>5015.15576171875</c:v>
                </c:pt>
                <c:pt idx="171">
                  <c:v>5040.87109375</c:v>
                </c:pt>
                <c:pt idx="172">
                  <c:v>5084.396484375</c:v>
                </c:pt>
                <c:pt idx="173">
                  <c:v>5138.044921875</c:v>
                </c:pt>
                <c:pt idx="174">
                  <c:v>5184.1533203125</c:v>
                </c:pt>
                <c:pt idx="175">
                  <c:v>5200.53564453125</c:v>
                </c:pt>
                <c:pt idx="176">
                  <c:v>5174.18701171875</c:v>
                </c:pt>
                <c:pt idx="177">
                  <c:v>5112.9365234375</c:v>
                </c:pt>
                <c:pt idx="178">
                  <c:v>5044.2265625</c:v>
                </c:pt>
                <c:pt idx="179">
                  <c:v>4999.7890625</c:v>
                </c:pt>
                <c:pt idx="180">
                  <c:v>4996.70947265625</c:v>
                </c:pt>
                <c:pt idx="181">
                  <c:v>5028.859375</c:v>
                </c:pt>
                <c:pt idx="182">
                  <c:v>5074.5107421875</c:v>
                </c:pt>
                <c:pt idx="183">
                  <c:v>5113.0244140625</c:v>
                </c:pt>
                <c:pt idx="184">
                  <c:v>5136.91015625</c:v>
                </c:pt>
                <c:pt idx="185">
                  <c:v>5150.72998046875</c:v>
                </c:pt>
                <c:pt idx="186">
                  <c:v>5160.341796875</c:v>
                </c:pt>
                <c:pt idx="187">
                  <c:v>5163.97216796875</c:v>
                </c:pt>
                <c:pt idx="188">
                  <c:v>5153.74853515625</c:v>
                </c:pt>
                <c:pt idx="189">
                  <c:v>5125.66943359375</c:v>
                </c:pt>
                <c:pt idx="190">
                  <c:v>5087.638671875</c:v>
                </c:pt>
                <c:pt idx="191">
                  <c:v>5056.89990234375</c:v>
                </c:pt>
                <c:pt idx="192">
                  <c:v>5048.203125</c:v>
                </c:pt>
                <c:pt idx="193">
                  <c:v>5062.96875</c:v>
                </c:pt>
                <c:pt idx="194">
                  <c:v>5089.123046875</c:v>
                </c:pt>
                <c:pt idx="195">
                  <c:v>5111.6552734375</c:v>
                </c:pt>
                <c:pt idx="196">
                  <c:v>5124.1767578125</c:v>
                </c:pt>
                <c:pt idx="197">
                  <c:v>5131.00830078125</c:v>
                </c:pt>
                <c:pt idx="198">
                  <c:v>5138.39013671875</c:v>
                </c:pt>
                <c:pt idx="199">
                  <c:v>5143.9638671875</c:v>
                </c:pt>
                <c:pt idx="200">
                  <c:v>5135.76171875</c:v>
                </c:pt>
                <c:pt idx="201">
                  <c:v>5103.21875</c:v>
                </c:pt>
                <c:pt idx="202">
                  <c:v>5050.955078125</c:v>
                </c:pt>
                <c:pt idx="203">
                  <c:v>5002.08203125</c:v>
                </c:pt>
                <c:pt idx="204">
                  <c:v>4985.7783203125</c:v>
                </c:pt>
                <c:pt idx="205">
                  <c:v>5017.24951171875</c:v>
                </c:pt>
                <c:pt idx="206">
                  <c:v>5085.38037109375</c:v>
                </c:pt>
                <c:pt idx="207">
                  <c:v>5157.95068359375</c:v>
                </c:pt>
                <c:pt idx="208">
                  <c:v>5200.7509765625</c:v>
                </c:pt>
                <c:pt idx="209">
                  <c:v>5196.6943359375</c:v>
                </c:pt>
                <c:pt idx="210">
                  <c:v>5152.28369140625</c:v>
                </c:pt>
                <c:pt idx="211">
                  <c:v>5089.673828125</c:v>
                </c:pt>
                <c:pt idx="212">
                  <c:v>5033.06640625</c:v>
                </c:pt>
                <c:pt idx="213">
                  <c:v>4999.66357421875</c:v>
                </c:pt>
                <c:pt idx="214">
                  <c:v>4998.11669921875</c:v>
                </c:pt>
                <c:pt idx="215">
                  <c:v>5029.60693359375</c:v>
                </c:pt>
                <c:pt idx="216">
                  <c:v>5086.3115234375</c:v>
                </c:pt>
                <c:pt idx="217">
                  <c:v>5148.72314453125</c:v>
                </c:pt>
                <c:pt idx="218">
                  <c:v>5188.98486328125</c:v>
                </c:pt>
                <c:pt idx="219">
                  <c:v>5184.39990234375</c:v>
                </c:pt>
                <c:pt idx="220">
                  <c:v>5134.77880859375</c:v>
                </c:pt>
                <c:pt idx="221">
                  <c:v>5069.21533203125</c:v>
                </c:pt>
                <c:pt idx="222">
                  <c:v>5032.02978515625</c:v>
                </c:pt>
                <c:pt idx="223">
                  <c:v>5053.2998046875</c:v>
                </c:pt>
                <c:pt idx="224">
                  <c:v>5124.39892578125</c:v>
                </c:pt>
                <c:pt idx="225">
                  <c:v>5199.18212890625</c:v>
                </c:pt>
                <c:pt idx="226">
                  <c:v>5223.9384765625</c:v>
                </c:pt>
                <c:pt idx="227">
                  <c:v>5176.337890625</c:v>
                </c:pt>
                <c:pt idx="228">
                  <c:v>5084.12646484375</c:v>
                </c:pt>
                <c:pt idx="229">
                  <c:v>5007.60546875</c:v>
                </c:pt>
                <c:pt idx="230">
                  <c:v>4997.0888671875</c:v>
                </c:pt>
                <c:pt idx="231">
                  <c:v>5056.49365234375</c:v>
                </c:pt>
                <c:pt idx="232">
                  <c:v>5140.56201171875</c:v>
                </c:pt>
                <c:pt idx="233">
                  <c:v>5187.998046875</c:v>
                </c:pt>
                <c:pt idx="234">
                  <c:v>5165.541015625</c:v>
                </c:pt>
                <c:pt idx="235">
                  <c:v>5090.0791015625</c:v>
                </c:pt>
                <c:pt idx="236">
                  <c:v>5013.4111328125</c:v>
                </c:pt>
                <c:pt idx="237">
                  <c:v>4983.0244140625</c:v>
                </c:pt>
                <c:pt idx="238">
                  <c:v>5009.49560546875</c:v>
                </c:pt>
                <c:pt idx="239">
                  <c:v>5063.93798828125</c:v>
                </c:pt>
                <c:pt idx="240">
                  <c:v>5104.30322265625</c:v>
                </c:pt>
                <c:pt idx="241">
                  <c:v>5107.62060546875</c:v>
                </c:pt>
                <c:pt idx="242">
                  <c:v>5083.259765625</c:v>
                </c:pt>
                <c:pt idx="243">
                  <c:v>5059.88720703125</c:v>
                </c:pt>
                <c:pt idx="244">
                  <c:v>5060.18798828125</c:v>
                </c:pt>
                <c:pt idx="245">
                  <c:v>5085.07275390625</c:v>
                </c:pt>
                <c:pt idx="246">
                  <c:v>5118.29443359375</c:v>
                </c:pt>
                <c:pt idx="247">
                  <c:v>5143.98291015625</c:v>
                </c:pt>
                <c:pt idx="248">
                  <c:v>5159.759765625</c:v>
                </c:pt>
                <c:pt idx="249">
                  <c:v>5174.3330078125</c:v>
                </c:pt>
                <c:pt idx="250">
                  <c:v>5193.79052734375</c:v>
                </c:pt>
                <c:pt idx="251">
                  <c:v>5211.0361328125</c:v>
                </c:pt>
                <c:pt idx="252">
                  <c:v>5209.19091796875</c:v>
                </c:pt>
                <c:pt idx="253">
                  <c:v>5176.3310546875</c:v>
                </c:pt>
                <c:pt idx="254">
                  <c:v>5118.24609375</c:v>
                </c:pt>
                <c:pt idx="255">
                  <c:v>5057.392578125</c:v>
                </c:pt>
                <c:pt idx="256">
                  <c:v>5018.2822265625</c:v>
                </c:pt>
                <c:pt idx="257">
                  <c:v>5011.15625</c:v>
                </c:pt>
                <c:pt idx="258">
                  <c:v>5026.9580078125</c:v>
                </c:pt>
                <c:pt idx="259">
                  <c:v>5046.70166015625</c:v>
                </c:pt>
                <c:pt idx="260">
                  <c:v>5056.494140625</c:v>
                </c:pt>
                <c:pt idx="261">
                  <c:v>5055.83984375</c:v>
                </c:pt>
                <c:pt idx="262">
                  <c:v>5053.89208984375</c:v>
                </c:pt>
                <c:pt idx="263">
                  <c:v>5059.0263671875</c:v>
                </c:pt>
                <c:pt idx="264">
                  <c:v>5071.8818359375</c:v>
                </c:pt>
                <c:pt idx="265">
                  <c:v>5087.25732421875</c:v>
                </c:pt>
                <c:pt idx="266">
                  <c:v>5101.20849609375</c:v>
                </c:pt>
                <c:pt idx="267">
                  <c:v>5115.08349609375</c:v>
                </c:pt>
                <c:pt idx="268">
                  <c:v>5132.099609375</c:v>
                </c:pt>
                <c:pt idx="269">
                  <c:v>5150.2685546875</c:v>
                </c:pt>
                <c:pt idx="270">
                  <c:v>5159.83349609375</c:v>
                </c:pt>
                <c:pt idx="271">
                  <c:v>5149.486328125</c:v>
                </c:pt>
                <c:pt idx="272">
                  <c:v>5117.0048828125</c:v>
                </c:pt>
                <c:pt idx="273">
                  <c:v>5074.7412109375</c:v>
                </c:pt>
                <c:pt idx="274">
                  <c:v>5043.84521484375</c:v>
                </c:pt>
                <c:pt idx="275">
                  <c:v>5040.52197265625</c:v>
                </c:pt>
                <c:pt idx="276">
                  <c:v>5064.82763671875</c:v>
                </c:pt>
                <c:pt idx="277">
                  <c:v>5100.927734375</c:v>
                </c:pt>
                <c:pt idx="278">
                  <c:v>5128.609375</c:v>
                </c:pt>
                <c:pt idx="279">
                  <c:v>5136.82666015625</c:v>
                </c:pt>
                <c:pt idx="280">
                  <c:v>5128.85791015625</c:v>
                </c:pt>
                <c:pt idx="281">
                  <c:v>5116.07421875</c:v>
                </c:pt>
                <c:pt idx="282">
                  <c:v>5106.7998046875</c:v>
                </c:pt>
                <c:pt idx="283">
                  <c:v>5100.205078125</c:v>
                </c:pt>
                <c:pt idx="284">
                  <c:v>5089.9814453125</c:v>
                </c:pt>
                <c:pt idx="285">
                  <c:v>5073.5810546875</c:v>
                </c:pt>
                <c:pt idx="286">
                  <c:v>5057.9423828125</c:v>
                </c:pt>
                <c:pt idx="287">
                  <c:v>5055.923828125</c:v>
                </c:pt>
                <c:pt idx="288">
                  <c:v>5075.98583984375</c:v>
                </c:pt>
                <c:pt idx="289">
                  <c:v>5113.6943359375</c:v>
                </c:pt>
                <c:pt idx="290">
                  <c:v>5152.38818359375</c:v>
                </c:pt>
                <c:pt idx="291">
                  <c:v>5173.0576171875</c:v>
                </c:pt>
                <c:pt idx="292">
                  <c:v>5166.36328125</c:v>
                </c:pt>
                <c:pt idx="293">
                  <c:v>5138.3095703125</c:v>
                </c:pt>
                <c:pt idx="294">
                  <c:v>5106.0439453125</c:v>
                </c:pt>
                <c:pt idx="295">
                  <c:v>5087.162109375</c:v>
                </c:pt>
                <c:pt idx="296">
                  <c:v>5089.63232421875</c:v>
                </c:pt>
                <c:pt idx="297">
                  <c:v>5107.99072265625</c:v>
                </c:pt>
                <c:pt idx="298">
                  <c:v>5126.99072265625</c:v>
                </c:pt>
                <c:pt idx="299">
                  <c:v>5129.9228515625</c:v>
                </c:pt>
                <c:pt idx="300">
                  <c:v>5107.3955078125</c:v>
                </c:pt>
                <c:pt idx="301">
                  <c:v>5062.91748046875</c:v>
                </c:pt>
                <c:pt idx="302">
                  <c:v>5012.88916015625</c:v>
                </c:pt>
                <c:pt idx="303">
                  <c:v>4980.21435546875</c:v>
                </c:pt>
                <c:pt idx="304">
                  <c:v>4983.28271484375</c:v>
                </c:pt>
                <c:pt idx="305">
                  <c:v>5025.14111328125</c:v>
                </c:pt>
                <c:pt idx="306">
                  <c:v>5089.34716796875</c:v>
                </c:pt>
                <c:pt idx="307">
                  <c:v>5146.658203125</c:v>
                </c:pt>
                <c:pt idx="308">
                  <c:v>5170.45556640625</c:v>
                </c:pt>
                <c:pt idx="309">
                  <c:v>5152.2734375</c:v>
                </c:pt>
                <c:pt idx="310">
                  <c:v>5107.22265625</c:v>
                </c:pt>
                <c:pt idx="311">
                  <c:v>5064.8662109375</c:v>
                </c:pt>
                <c:pt idx="312">
                  <c:v>5050.8994140625</c:v>
                </c:pt>
                <c:pt idx="313">
                  <c:v>5071.751953125</c:v>
                </c:pt>
                <c:pt idx="314">
                  <c:v>5112.45703125</c:v>
                </c:pt>
                <c:pt idx="315">
                  <c:v>5148.69091796875</c:v>
                </c:pt>
                <c:pt idx="316">
                  <c:v>5163.73046875</c:v>
                </c:pt>
                <c:pt idx="317">
                  <c:v>5157.96337890625</c:v>
                </c:pt>
                <c:pt idx="318">
                  <c:v>5144.8388671875</c:v>
                </c:pt>
                <c:pt idx="319">
                  <c:v>5137.6640625</c:v>
                </c:pt>
                <c:pt idx="320">
                  <c:v>5138.23681640625</c:v>
                </c:pt>
                <c:pt idx="321">
                  <c:v>5136.0048828125</c:v>
                </c:pt>
                <c:pt idx="322">
                  <c:v>5117.67919921875</c:v>
                </c:pt>
                <c:pt idx="323">
                  <c:v>5079.2216796875</c:v>
                </c:pt>
                <c:pt idx="324">
                  <c:v>5030.98486328125</c:v>
                </c:pt>
                <c:pt idx="325">
                  <c:v>4992.6357421875</c:v>
                </c:pt>
                <c:pt idx="326">
                  <c:v>4982.08203125</c:v>
                </c:pt>
                <c:pt idx="327">
                  <c:v>5005.9990234375</c:v>
                </c:pt>
                <c:pt idx="328">
                  <c:v>5057.0849609375</c:v>
                </c:pt>
                <c:pt idx="329">
                  <c:v>5117.99169921875</c:v>
                </c:pt>
                <c:pt idx="330">
                  <c:v>5168.4921875</c:v>
                </c:pt>
                <c:pt idx="331">
                  <c:v>5192.57666015625</c:v>
                </c:pt>
                <c:pt idx="332">
                  <c:v>5183.9423828125</c:v>
                </c:pt>
                <c:pt idx="333">
                  <c:v>5148.97216796875</c:v>
                </c:pt>
                <c:pt idx="334">
                  <c:v>5105.4931640625</c:v>
                </c:pt>
                <c:pt idx="335">
                  <c:v>5075.67333984375</c:v>
                </c:pt>
                <c:pt idx="336">
                  <c:v>5074.42431640625</c:v>
                </c:pt>
                <c:pt idx="337">
                  <c:v>5099.26953125</c:v>
                </c:pt>
                <c:pt idx="338">
                  <c:v>5129.423828125</c:v>
                </c:pt>
                <c:pt idx="339">
                  <c:v>5137.4375</c:v>
                </c:pt>
                <c:pt idx="340">
                  <c:v>5107.82568359375</c:v>
                </c:pt>
                <c:pt idx="341">
                  <c:v>5050.2998046875</c:v>
                </c:pt>
                <c:pt idx="342">
                  <c:v>4996.8701171875</c:v>
                </c:pt>
                <c:pt idx="343">
                  <c:v>4982.65087890625</c:v>
                </c:pt>
                <c:pt idx="344">
                  <c:v>5022.4013671875</c:v>
                </c:pt>
                <c:pt idx="345">
                  <c:v>5099.2177734375</c:v>
                </c:pt>
                <c:pt idx="346">
                  <c:v>5174.02685546875</c:v>
                </c:pt>
                <c:pt idx="347">
                  <c:v>5209.873046875</c:v>
                </c:pt>
                <c:pt idx="348">
                  <c:v>5194.30419921875</c:v>
                </c:pt>
                <c:pt idx="349">
                  <c:v>5144.6884765625</c:v>
                </c:pt>
              </c:numCache>
            </c:numRef>
          </c:yVal>
          <c:smooth val="1"/>
          <c:extLst>
            <c:ext xmlns:c16="http://schemas.microsoft.com/office/drawing/2014/chart" uri="{C3380CC4-5D6E-409C-BE32-E72D297353CC}">
              <c16:uniqueId val="{00000007-4A37-429A-A58F-F7AEDA5D1ACA}"/>
            </c:ext>
          </c:extLst>
        </c:ser>
        <c:ser>
          <c:idx val="8"/>
          <c:order val="8"/>
          <c:tx>
            <c:strRef>
              <c:f>cp_sub_001!$I$1</c:f>
              <c:strCache>
                <c:ptCount val="1"/>
                <c:pt idx="0">
                  <c:v>Coor_9</c:v>
                </c:pt>
              </c:strCache>
            </c:strRef>
          </c:tx>
          <c:spPr>
            <a:ln w="28575" cap="rnd">
              <a:solidFill>
                <a:schemeClr val="accent3">
                  <a:lumMod val="60000"/>
                </a:schemeClr>
              </a:solidFill>
              <a:round/>
            </a:ln>
            <a:effectLst/>
          </c:spPr>
          <c:marker>
            <c:symbol val="none"/>
          </c:marker>
          <c:yVal>
            <c:numRef>
              <c:f>cp_sub_001!$I$2:$I$351</c:f>
              <c:numCache>
                <c:formatCode>0.00000000000_ </c:formatCode>
                <c:ptCount val="350"/>
                <c:pt idx="0">
                  <c:v>7161.69140625</c:v>
                </c:pt>
                <c:pt idx="1">
                  <c:v>7103.47802734375</c:v>
                </c:pt>
                <c:pt idx="2">
                  <c:v>7082.2998046875</c:v>
                </c:pt>
                <c:pt idx="3">
                  <c:v>7123.3828125</c:v>
                </c:pt>
                <c:pt idx="4">
                  <c:v>7222.24072265625</c:v>
                </c:pt>
                <c:pt idx="5">
                  <c:v>7341.45263671875</c:v>
                </c:pt>
                <c:pt idx="6">
                  <c:v>7429.0546875</c:v>
                </c:pt>
                <c:pt idx="7">
                  <c:v>7448.35107421875</c:v>
                </c:pt>
                <c:pt idx="8">
                  <c:v>7399.40185546875</c:v>
                </c:pt>
                <c:pt idx="9">
                  <c:v>7317.1103515625</c:v>
                </c:pt>
                <c:pt idx="10">
                  <c:v>7247.16845703125</c:v>
                </c:pt>
                <c:pt idx="11">
                  <c:v>7217.19970703125</c:v>
                </c:pt>
                <c:pt idx="12">
                  <c:v>7223.59423828125</c:v>
                </c:pt>
                <c:pt idx="13">
                  <c:v>7242.0888671875</c:v>
                </c:pt>
                <c:pt idx="14">
                  <c:v>7251.6240234375</c:v>
                </c:pt>
                <c:pt idx="15">
                  <c:v>7251.2548828125</c:v>
                </c:pt>
                <c:pt idx="16">
                  <c:v>7256.6513671875</c:v>
                </c:pt>
                <c:pt idx="17">
                  <c:v>7280.44873046875</c:v>
                </c:pt>
                <c:pt idx="18">
                  <c:v>7314.71044921875</c:v>
                </c:pt>
                <c:pt idx="19">
                  <c:v>7332.236328125</c:v>
                </c:pt>
                <c:pt idx="20">
                  <c:v>7307.478515625</c:v>
                </c:pt>
                <c:pt idx="21">
                  <c:v>7240.51220703125</c:v>
                </c:pt>
                <c:pt idx="22">
                  <c:v>7163.45947265625</c:v>
                </c:pt>
                <c:pt idx="23">
                  <c:v>7121.822265625</c:v>
                </c:pt>
                <c:pt idx="24">
                  <c:v>7143.17236328125</c:v>
                </c:pt>
                <c:pt idx="25">
                  <c:v>7216.484375</c:v>
                </c:pt>
                <c:pt idx="26">
                  <c:v>7298.1572265625</c:v>
                </c:pt>
                <c:pt idx="27">
                  <c:v>7340.93310546875</c:v>
                </c:pt>
                <c:pt idx="28">
                  <c:v>7324.9189453125</c:v>
                </c:pt>
                <c:pt idx="29">
                  <c:v>7268.74951171875</c:v>
                </c:pt>
                <c:pt idx="30">
                  <c:v>7214.0302734375</c:v>
                </c:pt>
                <c:pt idx="31">
                  <c:v>7195.6015625</c:v>
                </c:pt>
                <c:pt idx="32">
                  <c:v>7219.2353515625</c:v>
                </c:pt>
                <c:pt idx="33">
                  <c:v>7261.3154296875</c:v>
                </c:pt>
                <c:pt idx="34">
                  <c:v>7288.34521484375</c:v>
                </c:pt>
                <c:pt idx="35">
                  <c:v>7280.86669921875</c:v>
                </c:pt>
                <c:pt idx="36">
                  <c:v>7245.373046875</c:v>
                </c:pt>
                <c:pt idx="37">
                  <c:v>7208.07568359375</c:v>
                </c:pt>
                <c:pt idx="38">
                  <c:v>7196.93359375</c:v>
                </c:pt>
                <c:pt idx="39">
                  <c:v>7224.46240234375</c:v>
                </c:pt>
                <c:pt idx="40">
                  <c:v>7280.93603515625</c:v>
                </c:pt>
                <c:pt idx="41">
                  <c:v>7339.94873046875</c:v>
                </c:pt>
                <c:pt idx="42">
                  <c:v>7371.7841796875</c:v>
                </c:pt>
                <c:pt idx="43">
                  <c:v>7357.7470703125</c:v>
                </c:pt>
                <c:pt idx="44">
                  <c:v>7299.52197265625</c:v>
                </c:pt>
                <c:pt idx="45">
                  <c:v>7219.80419921875</c:v>
                </c:pt>
                <c:pt idx="46">
                  <c:v>7153.13916015625</c:v>
                </c:pt>
                <c:pt idx="47">
                  <c:v>7129.740234375</c:v>
                </c:pt>
                <c:pt idx="48">
                  <c:v>7159.43310546875</c:v>
                </c:pt>
                <c:pt idx="49">
                  <c:v>7224.8603515625</c:v>
                </c:pt>
                <c:pt idx="50">
                  <c:v>7289.5986328125</c:v>
                </c:pt>
                <c:pt idx="51">
                  <c:v>7318.26220703125</c:v>
                </c:pt>
                <c:pt idx="52">
                  <c:v>7297.12060546875</c:v>
                </c:pt>
                <c:pt idx="53">
                  <c:v>7242.0166015625</c:v>
                </c:pt>
                <c:pt idx="54">
                  <c:v>7187.95556640625</c:v>
                </c:pt>
                <c:pt idx="55">
                  <c:v>7167.0380859375</c:v>
                </c:pt>
                <c:pt idx="56">
                  <c:v>7189.443359375</c:v>
                </c:pt>
                <c:pt idx="57">
                  <c:v>7239.7529296875</c:v>
                </c:pt>
                <c:pt idx="58">
                  <c:v>7289.6884765625</c:v>
                </c:pt>
                <c:pt idx="59">
                  <c:v>7316.99951171875</c:v>
                </c:pt>
                <c:pt idx="60">
                  <c:v>7317.23486328125</c:v>
                </c:pt>
                <c:pt idx="61">
                  <c:v>7302.048828125</c:v>
                </c:pt>
                <c:pt idx="62">
                  <c:v>7288.1484375</c:v>
                </c:pt>
                <c:pt idx="63">
                  <c:v>7286.5</c:v>
                </c:pt>
                <c:pt idx="64">
                  <c:v>7298.45751953125</c:v>
                </c:pt>
                <c:pt idx="65">
                  <c:v>7318.2587890625</c:v>
                </c:pt>
                <c:pt idx="66">
                  <c:v>7336.91015625</c:v>
                </c:pt>
                <c:pt idx="67">
                  <c:v>7344.28076171875</c:v>
                </c:pt>
                <c:pt idx="68">
                  <c:v>7330.9609375</c:v>
                </c:pt>
                <c:pt idx="69">
                  <c:v>7292.9111328125</c:v>
                </c:pt>
                <c:pt idx="70">
                  <c:v>7237.8525390625</c:v>
                </c:pt>
                <c:pt idx="71">
                  <c:v>7187.02392578125</c:v>
                </c:pt>
                <c:pt idx="72">
                  <c:v>7166.33447265625</c:v>
                </c:pt>
                <c:pt idx="73">
                  <c:v>7189.06103515625</c:v>
                </c:pt>
                <c:pt idx="74">
                  <c:v>7241.98291015625</c:v>
                </c:pt>
                <c:pt idx="75">
                  <c:v>7288.337890625</c:v>
                </c:pt>
                <c:pt idx="76">
                  <c:v>7290.21142578125</c:v>
                </c:pt>
                <c:pt idx="77">
                  <c:v>7236.794921875</c:v>
                </c:pt>
                <c:pt idx="78">
                  <c:v>7156.92138671875</c:v>
                </c:pt>
                <c:pt idx="79">
                  <c:v>7103.1708984375</c:v>
                </c:pt>
                <c:pt idx="80">
                  <c:v>7115.89013671875</c:v>
                </c:pt>
                <c:pt idx="81">
                  <c:v>7192.62109375</c:v>
                </c:pt>
                <c:pt idx="82">
                  <c:v>7286.9072265625</c:v>
                </c:pt>
                <c:pt idx="83">
                  <c:v>7339.552734375</c:v>
                </c:pt>
                <c:pt idx="84">
                  <c:v>7320.42626953125</c:v>
                </c:pt>
                <c:pt idx="85">
                  <c:v>7249.748046875</c:v>
                </c:pt>
                <c:pt idx="86">
                  <c:v>7182.5380859375</c:v>
                </c:pt>
                <c:pt idx="87">
                  <c:v>7167.8310546875</c:v>
                </c:pt>
                <c:pt idx="88">
                  <c:v>7213.55322265625</c:v>
                </c:pt>
                <c:pt idx="89">
                  <c:v>7283.3193359375</c:v>
                </c:pt>
                <c:pt idx="90">
                  <c:v>7326.41650390625</c:v>
                </c:pt>
                <c:pt idx="91">
                  <c:v>7316.763671875</c:v>
                </c:pt>
                <c:pt idx="92">
                  <c:v>7270.658203125</c:v>
                </c:pt>
                <c:pt idx="93">
                  <c:v>7230.91943359375</c:v>
                </c:pt>
                <c:pt idx="94">
                  <c:v>7231.71728515625</c:v>
                </c:pt>
                <c:pt idx="95">
                  <c:v>7272.61083984375</c:v>
                </c:pt>
                <c:pt idx="96">
                  <c:v>7321.3623046875</c:v>
                </c:pt>
                <c:pt idx="97">
                  <c:v>7341.27685546875</c:v>
                </c:pt>
                <c:pt idx="98">
                  <c:v>7319.8447265625</c:v>
                </c:pt>
                <c:pt idx="99">
                  <c:v>7276.173828125</c:v>
                </c:pt>
                <c:pt idx="100">
                  <c:v>7243.1787109375</c:v>
                </c:pt>
                <c:pt idx="101">
                  <c:v>7240.79296875</c:v>
                </c:pt>
                <c:pt idx="102">
                  <c:v>7262.20458984375</c:v>
                </c:pt>
                <c:pt idx="103">
                  <c:v>7282.78759765625</c:v>
                </c:pt>
                <c:pt idx="104">
                  <c:v>7282.396484375</c:v>
                </c:pt>
                <c:pt idx="105">
                  <c:v>7261.80859375</c:v>
                </c:pt>
                <c:pt idx="106">
                  <c:v>7240.5166015625</c:v>
                </c:pt>
                <c:pt idx="107">
                  <c:v>7239.1826171875</c:v>
                </c:pt>
                <c:pt idx="108">
                  <c:v>7262.06982421875</c:v>
                </c:pt>
                <c:pt idx="109">
                  <c:v>7293.470703125</c:v>
                </c:pt>
                <c:pt idx="110">
                  <c:v>7309.94970703125</c:v>
                </c:pt>
                <c:pt idx="111">
                  <c:v>7297.87060546875</c:v>
                </c:pt>
                <c:pt idx="112">
                  <c:v>7262.79833984375</c:v>
                </c:pt>
                <c:pt idx="113">
                  <c:v>7224.8642578125</c:v>
                </c:pt>
                <c:pt idx="114">
                  <c:v>7204.9033203125</c:v>
                </c:pt>
                <c:pt idx="115">
                  <c:v>7211.671875</c:v>
                </c:pt>
                <c:pt idx="116">
                  <c:v>7237.8798828125</c:v>
                </c:pt>
                <c:pt idx="117">
                  <c:v>7265.7978515625</c:v>
                </c:pt>
                <c:pt idx="118">
                  <c:v>7277.68212890625</c:v>
                </c:pt>
                <c:pt idx="119">
                  <c:v>7265.0576171875</c:v>
                </c:pt>
                <c:pt idx="120">
                  <c:v>7232.89208984375</c:v>
                </c:pt>
                <c:pt idx="121">
                  <c:v>7197.2646484375</c:v>
                </c:pt>
                <c:pt idx="122">
                  <c:v>7177.271484375</c:v>
                </c:pt>
                <c:pt idx="123">
                  <c:v>7184.2275390625</c:v>
                </c:pt>
                <c:pt idx="124">
                  <c:v>7213.64013671875</c:v>
                </c:pt>
                <c:pt idx="125">
                  <c:v>7245.80712890625</c:v>
                </c:pt>
                <c:pt idx="126">
                  <c:v>7256.9228515625</c:v>
                </c:pt>
                <c:pt idx="127">
                  <c:v>7235.2958984375</c:v>
                </c:pt>
                <c:pt idx="128">
                  <c:v>7191.77392578125</c:v>
                </c:pt>
                <c:pt idx="129">
                  <c:v>7155.4052734375</c:v>
                </c:pt>
                <c:pt idx="130">
                  <c:v>7155.21142578125</c:v>
                </c:pt>
                <c:pt idx="131">
                  <c:v>7200.04638671875</c:v>
                </c:pt>
                <c:pt idx="132">
                  <c:v>7271.5478515625</c:v>
                </c:pt>
                <c:pt idx="133">
                  <c:v>7336.3349609375</c:v>
                </c:pt>
                <c:pt idx="134">
                  <c:v>7368.8076171875</c:v>
                </c:pt>
                <c:pt idx="135">
                  <c:v>7367.1279296875</c:v>
                </c:pt>
                <c:pt idx="136">
                  <c:v>7350.10400390625</c:v>
                </c:pt>
                <c:pt idx="137">
                  <c:v>7338.29931640625</c:v>
                </c:pt>
                <c:pt idx="138">
                  <c:v>7335.91259765625</c:v>
                </c:pt>
                <c:pt idx="139">
                  <c:v>7329.24365234375</c:v>
                </c:pt>
                <c:pt idx="140">
                  <c:v>7302.90087890625</c:v>
                </c:pt>
                <c:pt idx="141">
                  <c:v>7258.697265625</c:v>
                </c:pt>
                <c:pt idx="142">
                  <c:v>7218.91845703125</c:v>
                </c:pt>
                <c:pt idx="143">
                  <c:v>7209.03515625</c:v>
                </c:pt>
                <c:pt idx="144">
                  <c:v>7233.92578125</c:v>
                </c:pt>
                <c:pt idx="145">
                  <c:v>7269.3505859375</c:v>
                </c:pt>
                <c:pt idx="146">
                  <c:v>7278.896484375</c:v>
                </c:pt>
                <c:pt idx="147">
                  <c:v>7244.5791015625</c:v>
                </c:pt>
                <c:pt idx="148">
                  <c:v>7185.6650390625</c:v>
                </c:pt>
                <c:pt idx="149">
                  <c:v>7147.8125</c:v>
                </c:pt>
                <c:pt idx="150">
                  <c:v>7168.5302734375</c:v>
                </c:pt>
                <c:pt idx="151">
                  <c:v>7245.68359375</c:v>
                </c:pt>
                <c:pt idx="152">
                  <c:v>7335.29345703125</c:v>
                </c:pt>
                <c:pt idx="153">
                  <c:v>7382.33349609375</c:v>
                </c:pt>
                <c:pt idx="154">
                  <c:v>7361.37939453125</c:v>
                </c:pt>
                <c:pt idx="155">
                  <c:v>7295.130859375</c:v>
                </c:pt>
                <c:pt idx="156">
                  <c:v>7235.85205078125</c:v>
                </c:pt>
                <c:pt idx="157">
                  <c:v>7224.326171875</c:v>
                </c:pt>
                <c:pt idx="158">
                  <c:v>7258.88818359375</c:v>
                </c:pt>
                <c:pt idx="159">
                  <c:v>7298.7705078125</c:v>
                </c:pt>
                <c:pt idx="160">
                  <c:v>7298.23779296875</c:v>
                </c:pt>
                <c:pt idx="161">
                  <c:v>7243.52880859375</c:v>
                </c:pt>
                <c:pt idx="162">
                  <c:v>7163.3193359375</c:v>
                </c:pt>
                <c:pt idx="163">
                  <c:v>7105.68798828125</c:v>
                </c:pt>
                <c:pt idx="164">
                  <c:v>7101.59912109375</c:v>
                </c:pt>
                <c:pt idx="165">
                  <c:v>7144.49169921875</c:v>
                </c:pt>
                <c:pt idx="166">
                  <c:v>7200.6943359375</c:v>
                </c:pt>
                <c:pt idx="167">
                  <c:v>7239.400390625</c:v>
                </c:pt>
                <c:pt idx="168">
                  <c:v>7255.8583984375</c:v>
                </c:pt>
                <c:pt idx="169">
                  <c:v>7269.14501953125</c:v>
                </c:pt>
                <c:pt idx="170">
                  <c:v>7298.7109375</c:v>
                </c:pt>
                <c:pt idx="171">
                  <c:v>7341.89501953125</c:v>
                </c:pt>
                <c:pt idx="172">
                  <c:v>7372.74072265625</c:v>
                </c:pt>
                <c:pt idx="173">
                  <c:v>7363.26416015625</c:v>
                </c:pt>
                <c:pt idx="174">
                  <c:v>7308.7158203125</c:v>
                </c:pt>
                <c:pt idx="175">
                  <c:v>7235.06005859375</c:v>
                </c:pt>
                <c:pt idx="176">
                  <c:v>7182.015625</c:v>
                </c:pt>
                <c:pt idx="177">
                  <c:v>7175.23046875</c:v>
                </c:pt>
                <c:pt idx="178">
                  <c:v>7209.50244140625</c:v>
                </c:pt>
                <c:pt idx="179">
                  <c:v>7255.2265625</c:v>
                </c:pt>
                <c:pt idx="180">
                  <c:v>7281.43505859375</c:v>
                </c:pt>
                <c:pt idx="181">
                  <c:v>7276.75732421875</c:v>
                </c:pt>
                <c:pt idx="182">
                  <c:v>7253.32177734375</c:v>
                </c:pt>
                <c:pt idx="183">
                  <c:v>7233.47265625</c:v>
                </c:pt>
                <c:pt idx="184">
                  <c:v>7232.041015625</c:v>
                </c:pt>
                <c:pt idx="185">
                  <c:v>7247.939453125</c:v>
                </c:pt>
                <c:pt idx="186">
                  <c:v>7269.03369140625</c:v>
                </c:pt>
                <c:pt idx="187">
                  <c:v>7283.38720703125</c:v>
                </c:pt>
                <c:pt idx="188">
                  <c:v>7286.9521484375</c:v>
                </c:pt>
                <c:pt idx="189">
                  <c:v>7283.43212890625</c:v>
                </c:pt>
                <c:pt idx="190">
                  <c:v>7279.4755859375</c:v>
                </c:pt>
                <c:pt idx="191">
                  <c:v>7280.6884765625</c:v>
                </c:pt>
                <c:pt idx="192">
                  <c:v>7290.3935546875</c:v>
                </c:pt>
                <c:pt idx="193">
                  <c:v>7308.900390625</c:v>
                </c:pt>
                <c:pt idx="194">
                  <c:v>7331.30029296875</c:v>
                </c:pt>
                <c:pt idx="195">
                  <c:v>7345.85986328125</c:v>
                </c:pt>
                <c:pt idx="196">
                  <c:v>7337.5166015625</c:v>
                </c:pt>
                <c:pt idx="197">
                  <c:v>7297.6083984375</c:v>
                </c:pt>
                <c:pt idx="198">
                  <c:v>7233.9287109375</c:v>
                </c:pt>
                <c:pt idx="199">
                  <c:v>7171.6884765625</c:v>
                </c:pt>
                <c:pt idx="200">
                  <c:v>7141.01953125</c:v>
                </c:pt>
                <c:pt idx="201">
                  <c:v>7157.58154296875</c:v>
                </c:pt>
                <c:pt idx="202">
                  <c:v>7210.34912109375</c:v>
                </c:pt>
                <c:pt idx="203">
                  <c:v>7267.1513671875</c:v>
                </c:pt>
                <c:pt idx="204">
                  <c:v>7295.42431640625</c:v>
                </c:pt>
                <c:pt idx="205">
                  <c:v>7283.30419921875</c:v>
                </c:pt>
                <c:pt idx="206">
                  <c:v>7245.29052734375</c:v>
                </c:pt>
                <c:pt idx="207">
                  <c:v>7208.7314453125</c:v>
                </c:pt>
                <c:pt idx="208">
                  <c:v>7192.6220703125</c:v>
                </c:pt>
                <c:pt idx="209">
                  <c:v>7195.8720703125</c:v>
                </c:pt>
                <c:pt idx="210">
                  <c:v>7203.470703125</c:v>
                </c:pt>
                <c:pt idx="211">
                  <c:v>7203.38916015625</c:v>
                </c:pt>
                <c:pt idx="212">
                  <c:v>7198.22705078125</c:v>
                </c:pt>
                <c:pt idx="213">
                  <c:v>7201.18115234375</c:v>
                </c:pt>
                <c:pt idx="214">
                  <c:v>7220.7451171875</c:v>
                </c:pt>
                <c:pt idx="215">
                  <c:v>7249.25244140625</c:v>
                </c:pt>
                <c:pt idx="216">
                  <c:v>7267.1455078125</c:v>
                </c:pt>
                <c:pt idx="217">
                  <c:v>7260.33251953125</c:v>
                </c:pt>
                <c:pt idx="218">
                  <c:v>7235.25537109375</c:v>
                </c:pt>
                <c:pt idx="219">
                  <c:v>7217.10205078125</c:v>
                </c:pt>
                <c:pt idx="220">
                  <c:v>7230.8447265625</c:v>
                </c:pt>
                <c:pt idx="221">
                  <c:v>7280.203125</c:v>
                </c:pt>
                <c:pt idx="222">
                  <c:v>7342.4609375</c:v>
                </c:pt>
                <c:pt idx="223">
                  <c:v>7384.28271484375</c:v>
                </c:pt>
                <c:pt idx="224">
                  <c:v>7386.03759765625</c:v>
                </c:pt>
                <c:pt idx="225">
                  <c:v>7354.849609375</c:v>
                </c:pt>
                <c:pt idx="226">
                  <c:v>7316.177734375</c:v>
                </c:pt>
                <c:pt idx="227">
                  <c:v>7291.92724609375</c:v>
                </c:pt>
                <c:pt idx="228">
                  <c:v>7284.21630859375</c:v>
                </c:pt>
                <c:pt idx="229">
                  <c:v>7278.28076171875</c:v>
                </c:pt>
                <c:pt idx="230">
                  <c:v>7260.6884765625</c:v>
                </c:pt>
                <c:pt idx="231">
                  <c:v>7235.3369140625</c:v>
                </c:pt>
                <c:pt idx="232">
                  <c:v>7221.82958984375</c:v>
                </c:pt>
                <c:pt idx="233">
                  <c:v>7236.97412109375</c:v>
                </c:pt>
                <c:pt idx="234">
                  <c:v>7276.0634765625</c:v>
                </c:pt>
                <c:pt idx="235">
                  <c:v>7311.90087890625</c:v>
                </c:pt>
                <c:pt idx="236">
                  <c:v>7314.5751953125</c:v>
                </c:pt>
                <c:pt idx="237">
                  <c:v>7276.39990234375</c:v>
                </c:pt>
                <c:pt idx="238">
                  <c:v>7220.564453125</c:v>
                </c:pt>
                <c:pt idx="239">
                  <c:v>7184.6171875</c:v>
                </c:pt>
                <c:pt idx="240">
                  <c:v>7190.8203125</c:v>
                </c:pt>
                <c:pt idx="241">
                  <c:v>7227.22119140625</c:v>
                </c:pt>
                <c:pt idx="242">
                  <c:v>7255.60302734375</c:v>
                </c:pt>
                <c:pt idx="243">
                  <c:v>7241.19970703125</c:v>
                </c:pt>
                <c:pt idx="244">
                  <c:v>7181.3232421875</c:v>
                </c:pt>
                <c:pt idx="245">
                  <c:v>7110.29638671875</c:v>
                </c:pt>
                <c:pt idx="246">
                  <c:v>7076.21923828125</c:v>
                </c:pt>
                <c:pt idx="247">
                  <c:v>7106.732421875</c:v>
                </c:pt>
                <c:pt idx="248">
                  <c:v>7189.228515625</c:v>
                </c:pt>
                <c:pt idx="249">
                  <c:v>7279.80322265625</c:v>
                </c:pt>
                <c:pt idx="250">
                  <c:v>7333.8369140625</c:v>
                </c:pt>
                <c:pt idx="251">
                  <c:v>7335.76025390625</c:v>
                </c:pt>
                <c:pt idx="252">
                  <c:v>7307.2392578125</c:v>
                </c:pt>
                <c:pt idx="253">
                  <c:v>7289.248046875</c:v>
                </c:pt>
                <c:pt idx="254">
                  <c:v>7311.6552734375</c:v>
                </c:pt>
                <c:pt idx="255">
                  <c:v>7371.3515625</c:v>
                </c:pt>
                <c:pt idx="256">
                  <c:v>7432.82373046875</c:v>
                </c:pt>
                <c:pt idx="257">
                  <c:v>7449.8427734375</c:v>
                </c:pt>
                <c:pt idx="258">
                  <c:v>7394.189453125</c:v>
                </c:pt>
                <c:pt idx="259">
                  <c:v>7274.31689453125</c:v>
                </c:pt>
                <c:pt idx="260">
                  <c:v>7133.6494140625</c:v>
                </c:pt>
                <c:pt idx="261">
                  <c:v>7029.78271484375</c:v>
                </c:pt>
                <c:pt idx="262">
                  <c:v>7005.74267578125</c:v>
                </c:pt>
                <c:pt idx="263">
                  <c:v>7068.349609375</c:v>
                </c:pt>
                <c:pt idx="264">
                  <c:v>7185.16943359375</c:v>
                </c:pt>
                <c:pt idx="265">
                  <c:v>7302.03466796875</c:v>
                </c:pt>
                <c:pt idx="266">
                  <c:v>7371.85302734375</c:v>
                </c:pt>
                <c:pt idx="267">
                  <c:v>7378.4306640625</c:v>
                </c:pt>
                <c:pt idx="268">
                  <c:v>7341.1845703125</c:v>
                </c:pt>
                <c:pt idx="269">
                  <c:v>7298.083984375</c:v>
                </c:pt>
                <c:pt idx="270">
                  <c:v>7278.4287109375</c:v>
                </c:pt>
                <c:pt idx="271">
                  <c:v>7284.38720703125</c:v>
                </c:pt>
                <c:pt idx="272">
                  <c:v>7294.2392578125</c:v>
                </c:pt>
                <c:pt idx="273">
                  <c:v>7284.236328125</c:v>
                </c:pt>
                <c:pt idx="274">
                  <c:v>7251.419921875</c:v>
                </c:pt>
                <c:pt idx="275">
                  <c:v>7218.37109375</c:v>
                </c:pt>
                <c:pt idx="276">
                  <c:v>7214.896484375</c:v>
                </c:pt>
                <c:pt idx="277">
                  <c:v>7250.74755859375</c:v>
                </c:pt>
                <c:pt idx="278">
                  <c:v>7302.26513671875</c:v>
                </c:pt>
                <c:pt idx="279">
                  <c:v>7326.10986328125</c:v>
                </c:pt>
                <c:pt idx="280">
                  <c:v>7291.71923828125</c:v>
                </c:pt>
                <c:pt idx="281">
                  <c:v>7207.75927734375</c:v>
                </c:pt>
                <c:pt idx="282">
                  <c:v>7120.599609375</c:v>
                </c:pt>
                <c:pt idx="283">
                  <c:v>7083.74072265625</c:v>
                </c:pt>
                <c:pt idx="284">
                  <c:v>7120.09130859375</c:v>
                </c:pt>
                <c:pt idx="285">
                  <c:v>7205.619140625</c:v>
                </c:pt>
                <c:pt idx="286">
                  <c:v>7287.14013671875</c:v>
                </c:pt>
                <c:pt idx="287">
                  <c:v>7320.876953125</c:v>
                </c:pt>
                <c:pt idx="288">
                  <c:v>7302.5283203125</c:v>
                </c:pt>
                <c:pt idx="289">
                  <c:v>7266.51123046875</c:v>
                </c:pt>
                <c:pt idx="290">
                  <c:v>7256.263671875</c:v>
                </c:pt>
                <c:pt idx="291">
                  <c:v>7289.63720703125</c:v>
                </c:pt>
                <c:pt idx="292">
                  <c:v>7346.111328125</c:v>
                </c:pt>
                <c:pt idx="293">
                  <c:v>7384.37255859375</c:v>
                </c:pt>
                <c:pt idx="294">
                  <c:v>7374.82421875</c:v>
                </c:pt>
                <c:pt idx="295">
                  <c:v>7321.09423828125</c:v>
                </c:pt>
                <c:pt idx="296">
                  <c:v>7255.01171875</c:v>
                </c:pt>
                <c:pt idx="297">
                  <c:v>7211.30908203125</c:v>
                </c:pt>
                <c:pt idx="298">
                  <c:v>7203.396484375</c:v>
                </c:pt>
                <c:pt idx="299">
                  <c:v>7218.41943359375</c:v>
                </c:pt>
                <c:pt idx="300">
                  <c:v>7232.64599609375</c:v>
                </c:pt>
                <c:pt idx="301">
                  <c:v>7232.0380859375</c:v>
                </c:pt>
                <c:pt idx="302">
                  <c:v>7220.81494140625</c:v>
                </c:pt>
                <c:pt idx="303">
                  <c:v>7213.04443359375</c:v>
                </c:pt>
                <c:pt idx="304">
                  <c:v>7217.2294921875</c:v>
                </c:pt>
                <c:pt idx="305">
                  <c:v>7228.55517578125</c:v>
                </c:pt>
                <c:pt idx="306">
                  <c:v>7234.94580078125</c:v>
                </c:pt>
                <c:pt idx="307">
                  <c:v>7229.93212890625</c:v>
                </c:pt>
                <c:pt idx="308">
                  <c:v>7219.55322265625</c:v>
                </c:pt>
                <c:pt idx="309">
                  <c:v>7216.7763671875</c:v>
                </c:pt>
                <c:pt idx="310">
                  <c:v>7228.8466796875</c:v>
                </c:pt>
                <c:pt idx="311">
                  <c:v>7249.56787109375</c:v>
                </c:pt>
                <c:pt idx="312">
                  <c:v>7263.92822265625</c:v>
                </c:pt>
                <c:pt idx="313">
                  <c:v>7261.18701171875</c:v>
                </c:pt>
                <c:pt idx="314">
                  <c:v>7244.83837890625</c:v>
                </c:pt>
                <c:pt idx="315">
                  <c:v>7230.5908203125</c:v>
                </c:pt>
                <c:pt idx="316">
                  <c:v>7233.98828125</c:v>
                </c:pt>
                <c:pt idx="317">
                  <c:v>7258.181640625</c:v>
                </c:pt>
                <c:pt idx="318">
                  <c:v>7291.93310546875</c:v>
                </c:pt>
                <c:pt idx="319">
                  <c:v>7318.91015625</c:v>
                </c:pt>
                <c:pt idx="320">
                  <c:v>7329.9033203125</c:v>
                </c:pt>
                <c:pt idx="321">
                  <c:v>7327.83154296875</c:v>
                </c:pt>
                <c:pt idx="322">
                  <c:v>7322.3642578125</c:v>
                </c:pt>
                <c:pt idx="323">
                  <c:v>7320.03662109375</c:v>
                </c:pt>
                <c:pt idx="324">
                  <c:v>7318.9150390625</c:v>
                </c:pt>
                <c:pt idx="325">
                  <c:v>7311.86669921875</c:v>
                </c:pt>
                <c:pt idx="326">
                  <c:v>7294.4228515625</c:v>
                </c:pt>
                <c:pt idx="327">
                  <c:v>7269.4931640625</c:v>
                </c:pt>
                <c:pt idx="328">
                  <c:v>7244.85400390625</c:v>
                </c:pt>
                <c:pt idx="329">
                  <c:v>7226.44482421875</c:v>
                </c:pt>
                <c:pt idx="330">
                  <c:v>7214.27490234375</c:v>
                </c:pt>
                <c:pt idx="331">
                  <c:v>7204.7509765625</c:v>
                </c:pt>
                <c:pt idx="332">
                  <c:v>7196.6279296875</c:v>
                </c:pt>
                <c:pt idx="333">
                  <c:v>7194.06787109375</c:v>
                </c:pt>
                <c:pt idx="334">
                  <c:v>7203.04052734375</c:v>
                </c:pt>
                <c:pt idx="335">
                  <c:v>7224.0087890625</c:v>
                </c:pt>
                <c:pt idx="336">
                  <c:v>7248.05224609375</c:v>
                </c:pt>
                <c:pt idx="337">
                  <c:v>7261.109375</c:v>
                </c:pt>
                <c:pt idx="338">
                  <c:v>7253.87060546875</c:v>
                </c:pt>
                <c:pt idx="339">
                  <c:v>7229.40869140625</c:v>
                </c:pt>
                <c:pt idx="340">
                  <c:v>7201.990234375</c:v>
                </c:pt>
                <c:pt idx="341">
                  <c:v>7187.65380859375</c:v>
                </c:pt>
                <c:pt idx="342">
                  <c:v>7193.8916015625</c:v>
                </c:pt>
                <c:pt idx="343">
                  <c:v>7216.29638671875</c:v>
                </c:pt>
                <c:pt idx="344">
                  <c:v>7243.96826171875</c:v>
                </c:pt>
                <c:pt idx="345">
                  <c:v>7268.24609375</c:v>
                </c:pt>
                <c:pt idx="346">
                  <c:v>7287.2294921875</c:v>
                </c:pt>
                <c:pt idx="347">
                  <c:v>7303.0986328125</c:v>
                </c:pt>
                <c:pt idx="348">
                  <c:v>7316.06201171875</c:v>
                </c:pt>
                <c:pt idx="349">
                  <c:v>7321.59912109375</c:v>
                </c:pt>
              </c:numCache>
            </c:numRef>
          </c:yVal>
          <c:smooth val="1"/>
          <c:extLst>
            <c:ext xmlns:c16="http://schemas.microsoft.com/office/drawing/2014/chart" uri="{C3380CC4-5D6E-409C-BE32-E72D297353CC}">
              <c16:uniqueId val="{00000008-4A37-429A-A58F-F7AEDA5D1ACA}"/>
            </c:ext>
          </c:extLst>
        </c:ser>
        <c:ser>
          <c:idx val="9"/>
          <c:order val="9"/>
          <c:tx>
            <c:strRef>
              <c:f>cp_sub_001!$J$1</c:f>
              <c:strCache>
                <c:ptCount val="1"/>
                <c:pt idx="0">
                  <c:v>Coor_10</c:v>
                </c:pt>
              </c:strCache>
            </c:strRef>
          </c:tx>
          <c:spPr>
            <a:ln w="28575" cap="rnd">
              <a:solidFill>
                <a:schemeClr val="accent4">
                  <a:lumMod val="60000"/>
                </a:schemeClr>
              </a:solidFill>
              <a:round/>
            </a:ln>
            <a:effectLst/>
          </c:spPr>
          <c:marker>
            <c:symbol val="none"/>
          </c:marker>
          <c:yVal>
            <c:numRef>
              <c:f>cp_sub_001!$J$2:$J$351</c:f>
              <c:numCache>
                <c:formatCode>0.00000000000_ </c:formatCode>
                <c:ptCount val="350"/>
                <c:pt idx="0">
                  <c:v>5667.2685546875</c:v>
                </c:pt>
                <c:pt idx="1">
                  <c:v>5657.677734375</c:v>
                </c:pt>
                <c:pt idx="2">
                  <c:v>5647.646484375</c:v>
                </c:pt>
                <c:pt idx="3">
                  <c:v>5651.7314453125</c:v>
                </c:pt>
                <c:pt idx="4">
                  <c:v>5670.83740234375</c:v>
                </c:pt>
                <c:pt idx="5">
                  <c:v>5690.94384765625</c:v>
                </c:pt>
                <c:pt idx="6">
                  <c:v>5694.16796875</c:v>
                </c:pt>
                <c:pt idx="7">
                  <c:v>5672.8525390625</c:v>
                </c:pt>
                <c:pt idx="8">
                  <c:v>5635.103515625</c:v>
                </c:pt>
                <c:pt idx="9">
                  <c:v>5597.7373046875</c:v>
                </c:pt>
                <c:pt idx="10">
                  <c:v>5573.25341796875</c:v>
                </c:pt>
                <c:pt idx="11">
                  <c:v>5562.0146484375</c:v>
                </c:pt>
                <c:pt idx="12">
                  <c:v>5555.677734375</c:v>
                </c:pt>
                <c:pt idx="13">
                  <c:v>5547.78125</c:v>
                </c:pt>
                <c:pt idx="14">
                  <c:v>5541.3369140625</c:v>
                </c:pt>
                <c:pt idx="15">
                  <c:v>5546.40478515625</c:v>
                </c:pt>
                <c:pt idx="16">
                  <c:v>5569.984375</c:v>
                </c:pt>
                <c:pt idx="17">
                  <c:v>5607.59619140625</c:v>
                </c:pt>
                <c:pt idx="18">
                  <c:v>5644.443359375</c:v>
                </c:pt>
                <c:pt idx="19">
                  <c:v>5665.4794921875</c:v>
                </c:pt>
                <c:pt idx="20">
                  <c:v>5665.80126953125</c:v>
                </c:pt>
                <c:pt idx="21">
                  <c:v>5652.66015625</c:v>
                </c:pt>
                <c:pt idx="22">
                  <c:v>5637.9931640625</c:v>
                </c:pt>
                <c:pt idx="23">
                  <c:v>5628.72314453125</c:v>
                </c:pt>
                <c:pt idx="24">
                  <c:v>5623.57275390625</c:v>
                </c:pt>
                <c:pt idx="25">
                  <c:v>5618.443359375</c:v>
                </c:pt>
                <c:pt idx="26">
                  <c:v>5613.93115234375</c:v>
                </c:pt>
                <c:pt idx="27">
                  <c:v>5616.33447265625</c:v>
                </c:pt>
                <c:pt idx="28">
                  <c:v>5630.04052734375</c:v>
                </c:pt>
                <c:pt idx="29">
                  <c:v>5648.548828125</c:v>
                </c:pt>
                <c:pt idx="30">
                  <c:v>5654.52197265625</c:v>
                </c:pt>
                <c:pt idx="31">
                  <c:v>5632.208984375</c:v>
                </c:pt>
                <c:pt idx="32">
                  <c:v>5583.71875</c:v>
                </c:pt>
                <c:pt idx="33">
                  <c:v>5534.56982421875</c:v>
                </c:pt>
                <c:pt idx="34">
                  <c:v>5520.306640625</c:v>
                </c:pt>
                <c:pt idx="35">
                  <c:v>5560.99658203125</c:v>
                </c:pt>
                <c:pt idx="36">
                  <c:v>5642.16455078125</c:v>
                </c:pt>
                <c:pt idx="37">
                  <c:v>5718.63232421875</c:v>
                </c:pt>
                <c:pt idx="38">
                  <c:v>5741.84912109375</c:v>
                </c:pt>
                <c:pt idx="39">
                  <c:v>5693.10546875</c:v>
                </c:pt>
                <c:pt idx="40">
                  <c:v>5598.79541015625</c:v>
                </c:pt>
                <c:pt idx="41">
                  <c:v>5515.4228515625</c:v>
                </c:pt>
                <c:pt idx="42">
                  <c:v>5493.4443359375</c:v>
                </c:pt>
                <c:pt idx="43">
                  <c:v>5544.54833984375</c:v>
                </c:pt>
                <c:pt idx="44">
                  <c:v>5634.884765625</c:v>
                </c:pt>
                <c:pt idx="45">
                  <c:v>5708.47119140625</c:v>
                </c:pt>
                <c:pt idx="46">
                  <c:v>5723.955078125</c:v>
                </c:pt>
                <c:pt idx="47">
                  <c:v>5679.38525390625</c:v>
                </c:pt>
                <c:pt idx="48">
                  <c:v>5609.2734375</c:v>
                </c:pt>
                <c:pt idx="49">
                  <c:v>5558.2939453125</c:v>
                </c:pt>
                <c:pt idx="50">
                  <c:v>5551.57666015625</c:v>
                </c:pt>
                <c:pt idx="51">
                  <c:v>5581.9619140625</c:v>
                </c:pt>
                <c:pt idx="52">
                  <c:v>5620.75439453125</c:v>
                </c:pt>
                <c:pt idx="53">
                  <c:v>5641.48388671875</c:v>
                </c:pt>
                <c:pt idx="54">
                  <c:v>5638.314453125</c:v>
                </c:pt>
                <c:pt idx="55">
                  <c:v>5626.70458984375</c:v>
                </c:pt>
                <c:pt idx="56">
                  <c:v>5628.0146484375</c:v>
                </c:pt>
                <c:pt idx="57">
                  <c:v>5651.12451171875</c:v>
                </c:pt>
                <c:pt idx="58">
                  <c:v>5684.939453125</c:v>
                </c:pt>
                <c:pt idx="59">
                  <c:v>5706.51220703125</c:v>
                </c:pt>
                <c:pt idx="60">
                  <c:v>5697.84228515625</c:v>
                </c:pt>
                <c:pt idx="61">
                  <c:v>5658.76025390625</c:v>
                </c:pt>
                <c:pt idx="62">
                  <c:v>5606.97265625</c:v>
                </c:pt>
                <c:pt idx="63">
                  <c:v>5565.919921875</c:v>
                </c:pt>
                <c:pt idx="64">
                  <c:v>5549.4716796875</c:v>
                </c:pt>
                <c:pt idx="65">
                  <c:v>5554.0693359375</c:v>
                </c:pt>
                <c:pt idx="66">
                  <c:v>5563.283203125</c:v>
                </c:pt>
                <c:pt idx="67">
                  <c:v>5561.11328125</c:v>
                </c:pt>
                <c:pt idx="68">
                  <c:v>5544.630859375</c:v>
                </c:pt>
                <c:pt idx="69">
                  <c:v>5527.21630859375</c:v>
                </c:pt>
                <c:pt idx="70">
                  <c:v>5529.98974609375</c:v>
                </c:pt>
                <c:pt idx="71">
                  <c:v>5566.830078125</c:v>
                </c:pt>
                <c:pt idx="72">
                  <c:v>5632.7578125</c:v>
                </c:pt>
                <c:pt idx="73">
                  <c:v>5703.63330078125</c:v>
                </c:pt>
                <c:pt idx="74">
                  <c:v>5748.26513671875</c:v>
                </c:pt>
                <c:pt idx="75">
                  <c:v>5746.19140625</c:v>
                </c:pt>
                <c:pt idx="76">
                  <c:v>5700.4619140625</c:v>
                </c:pt>
                <c:pt idx="77">
                  <c:v>5637.27001953125</c:v>
                </c:pt>
                <c:pt idx="78">
                  <c:v>5591.9169921875</c:v>
                </c:pt>
                <c:pt idx="79">
                  <c:v>5588.890625</c:v>
                </c:pt>
                <c:pt idx="80">
                  <c:v>5627.6650390625</c:v>
                </c:pt>
                <c:pt idx="81">
                  <c:v>5682.689453125</c:v>
                </c:pt>
                <c:pt idx="82">
                  <c:v>5717.76513671875</c:v>
                </c:pt>
                <c:pt idx="83">
                  <c:v>5706.48583984375</c:v>
                </c:pt>
                <c:pt idx="84">
                  <c:v>5646.94580078125</c:v>
                </c:pt>
                <c:pt idx="85">
                  <c:v>5562.46728515625</c:v>
                </c:pt>
                <c:pt idx="86">
                  <c:v>5488.484375</c:v>
                </c:pt>
                <c:pt idx="87">
                  <c:v>5453.6875</c:v>
                </c:pt>
                <c:pt idx="88">
                  <c:v>5466.36328125</c:v>
                </c:pt>
                <c:pt idx="89">
                  <c:v>5513.0712890625</c:v>
                </c:pt>
                <c:pt idx="90">
                  <c:v>5569.0625</c:v>
                </c:pt>
                <c:pt idx="91">
                  <c:v>5613.07080078125</c:v>
                </c:pt>
                <c:pt idx="92">
                  <c:v>5637.34912109375</c:v>
                </c:pt>
                <c:pt idx="93">
                  <c:v>5647.77783203125</c:v>
                </c:pt>
                <c:pt idx="94">
                  <c:v>5655.63818359375</c:v>
                </c:pt>
                <c:pt idx="95">
                  <c:v>5667.72607421875</c:v>
                </c:pt>
                <c:pt idx="96">
                  <c:v>5681.7158203125</c:v>
                </c:pt>
                <c:pt idx="97">
                  <c:v>5689.2783203125</c:v>
                </c:pt>
                <c:pt idx="98">
                  <c:v>5683.70361328125</c:v>
                </c:pt>
                <c:pt idx="99">
                  <c:v>5665.76123046875</c:v>
                </c:pt>
                <c:pt idx="100">
                  <c:v>5643.33642578125</c:v>
                </c:pt>
                <c:pt idx="101">
                  <c:v>5625.46044921875</c:v>
                </c:pt>
                <c:pt idx="102">
                  <c:v>5615.83154296875</c:v>
                </c:pt>
                <c:pt idx="103">
                  <c:v>5611.25244140625</c:v>
                </c:pt>
                <c:pt idx="104">
                  <c:v>5606.2607421875</c:v>
                </c:pt>
                <c:pt idx="105">
                  <c:v>5599.86767578125</c:v>
                </c:pt>
                <c:pt idx="106">
                  <c:v>5598.1455078125</c:v>
                </c:pt>
                <c:pt idx="107">
                  <c:v>5609.548828125</c:v>
                </c:pt>
                <c:pt idx="108">
                  <c:v>5636.0869140625</c:v>
                </c:pt>
                <c:pt idx="109">
                  <c:v>5667.78125</c:v>
                </c:pt>
                <c:pt idx="110">
                  <c:v>5686.27099609375</c:v>
                </c:pt>
                <c:pt idx="111">
                  <c:v>5676.564453125</c:v>
                </c:pt>
                <c:pt idx="112">
                  <c:v>5638.88720703125</c:v>
                </c:pt>
                <c:pt idx="113">
                  <c:v>5591.201171875</c:v>
                </c:pt>
                <c:pt idx="114">
                  <c:v>5559.083984375</c:v>
                </c:pt>
                <c:pt idx="115">
                  <c:v>5559.10400390625</c:v>
                </c:pt>
                <c:pt idx="116">
                  <c:v>5587.3583984375</c:v>
                </c:pt>
                <c:pt idx="117">
                  <c:v>5621.7919921875</c:v>
                </c:pt>
                <c:pt idx="118">
                  <c:v>5637.0791015625</c:v>
                </c:pt>
                <c:pt idx="119">
                  <c:v>5621.5947265625</c:v>
                </c:pt>
                <c:pt idx="120">
                  <c:v>5584.44189453125</c:v>
                </c:pt>
                <c:pt idx="121">
                  <c:v>5547.99365234375</c:v>
                </c:pt>
                <c:pt idx="122">
                  <c:v>5532.17626953125</c:v>
                </c:pt>
                <c:pt idx="123">
                  <c:v>5542.40625</c:v>
                </c:pt>
                <c:pt idx="124">
                  <c:v>5569.44384765625</c:v>
                </c:pt>
                <c:pt idx="125">
                  <c:v>5599.59521484375</c:v>
                </c:pt>
                <c:pt idx="126">
                  <c:v>5625.79052734375</c:v>
                </c:pt>
                <c:pt idx="127">
                  <c:v>5650.3203125</c:v>
                </c:pt>
                <c:pt idx="128">
                  <c:v>5677.89208984375</c:v>
                </c:pt>
                <c:pt idx="129">
                  <c:v>5706.26123046875</c:v>
                </c:pt>
                <c:pt idx="130">
                  <c:v>5723.72119140625</c:v>
                </c:pt>
                <c:pt idx="131">
                  <c:v>5716.59423828125</c:v>
                </c:pt>
                <c:pt idx="132">
                  <c:v>5680.865234375</c:v>
                </c:pt>
                <c:pt idx="133">
                  <c:v>5628.0107421875</c:v>
                </c:pt>
                <c:pt idx="134">
                  <c:v>5579.43212890625</c:v>
                </c:pt>
                <c:pt idx="135">
                  <c:v>5553.1337890625</c:v>
                </c:pt>
                <c:pt idx="136">
                  <c:v>5552.65576171875</c:v>
                </c:pt>
                <c:pt idx="137">
                  <c:v>5566.58349609375</c:v>
                </c:pt>
                <c:pt idx="138">
                  <c:v>5578.58984375</c:v>
                </c:pt>
                <c:pt idx="139">
                  <c:v>5579.89208984375</c:v>
                </c:pt>
                <c:pt idx="140">
                  <c:v>5574.62109375</c:v>
                </c:pt>
                <c:pt idx="141">
                  <c:v>5574.70556640625</c:v>
                </c:pt>
                <c:pt idx="142">
                  <c:v>5589.1953125</c:v>
                </c:pt>
                <c:pt idx="143">
                  <c:v>5616.7509765625</c:v>
                </c:pt>
                <c:pt idx="144">
                  <c:v>5646.72412109375</c:v>
                </c:pt>
                <c:pt idx="145">
                  <c:v>5667.12255859375</c:v>
                </c:pt>
                <c:pt idx="146">
                  <c:v>5672.7578125</c:v>
                </c:pt>
                <c:pt idx="147">
                  <c:v>5667.66455078125</c:v>
                </c:pt>
                <c:pt idx="148">
                  <c:v>5660.984375</c:v>
                </c:pt>
                <c:pt idx="149">
                  <c:v>5660.302734375</c:v>
                </c:pt>
                <c:pt idx="150">
                  <c:v>5667.3251953125</c:v>
                </c:pt>
                <c:pt idx="151">
                  <c:v>5677.9130859375</c:v>
                </c:pt>
                <c:pt idx="152">
                  <c:v>5685.0732421875</c:v>
                </c:pt>
                <c:pt idx="153">
                  <c:v>5682.3203125</c:v>
                </c:pt>
                <c:pt idx="154">
                  <c:v>5666.0166015625</c:v>
                </c:pt>
                <c:pt idx="155">
                  <c:v>5636.7841796875</c:v>
                </c:pt>
                <c:pt idx="156">
                  <c:v>5600.1298828125</c:v>
                </c:pt>
                <c:pt idx="157">
                  <c:v>5565.5244140625</c:v>
                </c:pt>
                <c:pt idx="158">
                  <c:v>5543.1171875</c:v>
                </c:pt>
                <c:pt idx="159">
                  <c:v>5538.9775390625</c:v>
                </c:pt>
                <c:pt idx="160">
                  <c:v>5551.744140625</c:v>
                </c:pt>
                <c:pt idx="161">
                  <c:v>5573.48291015625</c:v>
                </c:pt>
                <c:pt idx="162">
                  <c:v>5594.603515625</c:v>
                </c:pt>
                <c:pt idx="163">
                  <c:v>5609.24560546875</c:v>
                </c:pt>
                <c:pt idx="164">
                  <c:v>5616.8876953125</c:v>
                </c:pt>
                <c:pt idx="165">
                  <c:v>5619.2802734375</c:v>
                </c:pt>
                <c:pt idx="166">
                  <c:v>5616.28515625</c:v>
                </c:pt>
                <c:pt idx="167">
                  <c:v>5605.51708984375</c:v>
                </c:pt>
                <c:pt idx="168">
                  <c:v>5586.90478515625</c:v>
                </c:pt>
                <c:pt idx="169">
                  <c:v>5567.61767578125</c:v>
                </c:pt>
                <c:pt idx="170">
                  <c:v>5560.888671875</c:v>
                </c:pt>
                <c:pt idx="171">
                  <c:v>5576.94970703125</c:v>
                </c:pt>
                <c:pt idx="172">
                  <c:v>5612.3447265625</c:v>
                </c:pt>
                <c:pt idx="173">
                  <c:v>5647.7685546875</c:v>
                </c:pt>
                <c:pt idx="174">
                  <c:v>5659.46484375</c:v>
                </c:pt>
                <c:pt idx="175">
                  <c:v>5637.865234375</c:v>
                </c:pt>
                <c:pt idx="176">
                  <c:v>5598.94189453125</c:v>
                </c:pt>
                <c:pt idx="177">
                  <c:v>5576.8251953125</c:v>
                </c:pt>
                <c:pt idx="178">
                  <c:v>5600.00634765625</c:v>
                </c:pt>
                <c:pt idx="179">
                  <c:v>5667.63720703125</c:v>
                </c:pt>
                <c:pt idx="180">
                  <c:v>5744.89794921875</c:v>
                </c:pt>
                <c:pt idx="181">
                  <c:v>5783.5703125</c:v>
                </c:pt>
                <c:pt idx="182">
                  <c:v>5754.74609375</c:v>
                </c:pt>
                <c:pt idx="183">
                  <c:v>5670.13427734375</c:v>
                </c:pt>
                <c:pt idx="184">
                  <c:v>5575.73046875</c:v>
                </c:pt>
                <c:pt idx="185">
                  <c:v>5521.8115234375</c:v>
                </c:pt>
                <c:pt idx="186">
                  <c:v>5530.76513671875</c:v>
                </c:pt>
                <c:pt idx="187">
                  <c:v>5585.4580078125</c:v>
                </c:pt>
                <c:pt idx="188">
                  <c:v>5644.86767578125</c:v>
                </c:pt>
                <c:pt idx="189">
                  <c:v>5673.45703125</c:v>
                </c:pt>
                <c:pt idx="190">
                  <c:v>5662.1171875</c:v>
                </c:pt>
                <c:pt idx="191">
                  <c:v>5627.4404296875</c:v>
                </c:pt>
                <c:pt idx="192">
                  <c:v>5594.05224609375</c:v>
                </c:pt>
                <c:pt idx="193">
                  <c:v>5576.56494140625</c:v>
                </c:pt>
                <c:pt idx="194">
                  <c:v>5574.5302734375</c:v>
                </c:pt>
                <c:pt idx="195">
                  <c:v>5580.18359375</c:v>
                </c:pt>
                <c:pt idx="196">
                  <c:v>5587.91796875</c:v>
                </c:pt>
                <c:pt idx="197">
                  <c:v>5595.74755859375</c:v>
                </c:pt>
                <c:pt idx="198">
                  <c:v>5599.9091796875</c:v>
                </c:pt>
                <c:pt idx="199">
                  <c:v>5592.3896484375</c:v>
                </c:pt>
                <c:pt idx="200">
                  <c:v>5568.248046875</c:v>
                </c:pt>
                <c:pt idx="201">
                  <c:v>5537.55029296875</c:v>
                </c:pt>
                <c:pt idx="202">
                  <c:v>5527.9130859375</c:v>
                </c:pt>
                <c:pt idx="203">
                  <c:v>5568.7021484375</c:v>
                </c:pt>
                <c:pt idx="204">
                  <c:v>5664.6328125</c:v>
                </c:pt>
                <c:pt idx="205">
                  <c:v>5780.291015625</c:v>
                </c:pt>
                <c:pt idx="206">
                  <c:v>5853.52685546875</c:v>
                </c:pt>
                <c:pt idx="207">
                  <c:v>5834.3720703125</c:v>
                </c:pt>
                <c:pt idx="208">
                  <c:v>5723.21728515625</c:v>
                </c:pt>
                <c:pt idx="209">
                  <c:v>5577.68408203125</c:v>
                </c:pt>
                <c:pt idx="210">
                  <c:v>5478.42138671875</c:v>
                </c:pt>
                <c:pt idx="211">
                  <c:v>5475.5615234375</c:v>
                </c:pt>
                <c:pt idx="212">
                  <c:v>5554.69970703125</c:v>
                </c:pt>
                <c:pt idx="213">
                  <c:v>5648.69091796875</c:v>
                </c:pt>
                <c:pt idx="214">
                  <c:v>5687.43408203125</c:v>
                </c:pt>
                <c:pt idx="215">
                  <c:v>5648.4833984375</c:v>
                </c:pt>
                <c:pt idx="216">
                  <c:v>5570.3203125</c:v>
                </c:pt>
                <c:pt idx="217">
                  <c:v>5519.05224609375</c:v>
                </c:pt>
                <c:pt idx="218">
                  <c:v>5535.45849609375</c:v>
                </c:pt>
                <c:pt idx="219">
                  <c:v>5604.123046875</c:v>
                </c:pt>
                <c:pt idx="220">
                  <c:v>5668.07080078125</c:v>
                </c:pt>
                <c:pt idx="221">
                  <c:v>5675.884765625</c:v>
                </c:pt>
                <c:pt idx="222">
                  <c:v>5622.9814453125</c:v>
                </c:pt>
                <c:pt idx="223">
                  <c:v>5554.46630859375</c:v>
                </c:pt>
                <c:pt idx="224">
                  <c:v>5528.41748046875</c:v>
                </c:pt>
                <c:pt idx="225">
                  <c:v>5569.7392578125</c:v>
                </c:pt>
                <c:pt idx="226">
                  <c:v>5650.99951171875</c:v>
                </c:pt>
                <c:pt idx="227">
                  <c:v>5714.0595703125</c:v>
                </c:pt>
                <c:pt idx="228">
                  <c:v>5713.96923828125</c:v>
                </c:pt>
                <c:pt idx="229">
                  <c:v>5650.6689453125</c:v>
                </c:pt>
                <c:pt idx="230">
                  <c:v>5565.8330078125</c:v>
                </c:pt>
                <c:pt idx="231">
                  <c:v>5510.53076171875</c:v>
                </c:pt>
                <c:pt idx="232">
                  <c:v>5510.62646484375</c:v>
                </c:pt>
                <c:pt idx="233">
                  <c:v>5555.193359375</c:v>
                </c:pt>
                <c:pt idx="234">
                  <c:v>5612.359375</c:v>
                </c:pt>
                <c:pt idx="235">
                  <c:v>5655.703125</c:v>
                </c:pt>
                <c:pt idx="236">
                  <c:v>5679.3818359375</c:v>
                </c:pt>
                <c:pt idx="237">
                  <c:v>5693.23583984375</c:v>
                </c:pt>
                <c:pt idx="238">
                  <c:v>5706.85498046875</c:v>
                </c:pt>
                <c:pt idx="239">
                  <c:v>5718.72607421875</c:v>
                </c:pt>
                <c:pt idx="240">
                  <c:v>5718.84619140625</c:v>
                </c:pt>
                <c:pt idx="241">
                  <c:v>5699.6923828125</c:v>
                </c:pt>
                <c:pt idx="242">
                  <c:v>5663.92578125</c:v>
                </c:pt>
                <c:pt idx="243">
                  <c:v>5622.3955078125</c:v>
                </c:pt>
                <c:pt idx="244">
                  <c:v>5586.2314453125</c:v>
                </c:pt>
                <c:pt idx="245">
                  <c:v>5561.59521484375</c:v>
                </c:pt>
                <c:pt idx="246">
                  <c:v>5550.98828125</c:v>
                </c:pt>
                <c:pt idx="247">
                  <c:v>5556.830078125</c:v>
                </c:pt>
                <c:pt idx="248">
                  <c:v>5580.57080078125</c:v>
                </c:pt>
                <c:pt idx="249">
                  <c:v>5616.70361328125</c:v>
                </c:pt>
                <c:pt idx="250">
                  <c:v>5649.0986328125</c:v>
                </c:pt>
                <c:pt idx="251">
                  <c:v>5657.56640625</c:v>
                </c:pt>
                <c:pt idx="252">
                  <c:v>5633.1611328125</c:v>
                </c:pt>
                <c:pt idx="253">
                  <c:v>5589.80908203125</c:v>
                </c:pt>
                <c:pt idx="254">
                  <c:v>5559.01953125</c:v>
                </c:pt>
                <c:pt idx="255">
                  <c:v>5567.16455078125</c:v>
                </c:pt>
                <c:pt idx="256">
                  <c:v>5611.46728515625</c:v>
                </c:pt>
                <c:pt idx="257">
                  <c:v>5656</c:v>
                </c:pt>
                <c:pt idx="258">
                  <c:v>5655.58544921875</c:v>
                </c:pt>
                <c:pt idx="259">
                  <c:v>5592.47998046875</c:v>
                </c:pt>
                <c:pt idx="260">
                  <c:v>5497.1728515625</c:v>
                </c:pt>
                <c:pt idx="261">
                  <c:v>5433.69091796875</c:v>
                </c:pt>
                <c:pt idx="262">
                  <c:v>5456.4169921875</c:v>
                </c:pt>
                <c:pt idx="263">
                  <c:v>5569.056640625</c:v>
                </c:pt>
                <c:pt idx="264">
                  <c:v>5717.2041015625</c:v>
                </c:pt>
                <c:pt idx="265">
                  <c:v>5821.9150390625</c:v>
                </c:pt>
                <c:pt idx="266">
                  <c:v>5830.86181640625</c:v>
                </c:pt>
                <c:pt idx="267">
                  <c:v>5750.35595703125</c:v>
                </c:pt>
                <c:pt idx="268">
                  <c:v>5636.3037109375</c:v>
                </c:pt>
                <c:pt idx="269">
                  <c:v>5553.19921875</c:v>
                </c:pt>
                <c:pt idx="270">
                  <c:v>5532.97412109375</c:v>
                </c:pt>
                <c:pt idx="271">
                  <c:v>5562.60205078125</c:v>
                </c:pt>
                <c:pt idx="272">
                  <c:v>5604.71875</c:v>
                </c:pt>
                <c:pt idx="273">
                  <c:v>5630.15380859375</c:v>
                </c:pt>
                <c:pt idx="274">
                  <c:v>5635.41943359375</c:v>
                </c:pt>
                <c:pt idx="275">
                  <c:v>5634.71533203125</c:v>
                </c:pt>
                <c:pt idx="276">
                  <c:v>5638.982421875</c:v>
                </c:pt>
                <c:pt idx="277">
                  <c:v>5643.85009765625</c:v>
                </c:pt>
                <c:pt idx="278">
                  <c:v>5637.14990234375</c:v>
                </c:pt>
                <c:pt idx="279">
                  <c:v>5616.50439453125</c:v>
                </c:pt>
                <c:pt idx="280">
                  <c:v>5597.46044921875</c:v>
                </c:pt>
                <c:pt idx="281">
                  <c:v>5601.83447265625</c:v>
                </c:pt>
                <c:pt idx="282">
                  <c:v>5635.64892578125</c:v>
                </c:pt>
                <c:pt idx="283">
                  <c:v>5677.7294921875</c:v>
                </c:pt>
                <c:pt idx="284">
                  <c:v>5692.2021484375</c:v>
                </c:pt>
                <c:pt idx="285">
                  <c:v>5656.9990234375</c:v>
                </c:pt>
                <c:pt idx="286">
                  <c:v>5584.8095703125</c:v>
                </c:pt>
                <c:pt idx="287">
                  <c:v>5517.3115234375</c:v>
                </c:pt>
                <c:pt idx="288">
                  <c:v>5495.28466796875</c:v>
                </c:pt>
                <c:pt idx="289">
                  <c:v>5528.02783203125</c:v>
                </c:pt>
                <c:pt idx="290">
                  <c:v>5587.17724609375</c:v>
                </c:pt>
                <c:pt idx="291">
                  <c:v>5630.35888671875</c:v>
                </c:pt>
                <c:pt idx="292">
                  <c:v>5635.30859375</c:v>
                </c:pt>
                <c:pt idx="293">
                  <c:v>5616.2080078125</c:v>
                </c:pt>
                <c:pt idx="294">
                  <c:v>5608.81005859375</c:v>
                </c:pt>
                <c:pt idx="295">
                  <c:v>5637.25146484375</c:v>
                </c:pt>
                <c:pt idx="296">
                  <c:v>5691.0185546875</c:v>
                </c:pt>
                <c:pt idx="297">
                  <c:v>5732.0849609375</c:v>
                </c:pt>
                <c:pt idx="298">
                  <c:v>5726.65576171875</c:v>
                </c:pt>
                <c:pt idx="299">
                  <c:v>5674.79443359375</c:v>
                </c:pt>
                <c:pt idx="300">
                  <c:v>5612.4208984375</c:v>
                </c:pt>
                <c:pt idx="301">
                  <c:v>5583.0224609375</c:v>
                </c:pt>
                <c:pt idx="302">
                  <c:v>5601.97509765625</c:v>
                </c:pt>
                <c:pt idx="303">
                  <c:v>5643.2099609375</c:v>
                </c:pt>
                <c:pt idx="304">
                  <c:v>5660.09765625</c:v>
                </c:pt>
                <c:pt idx="305">
                  <c:v>5624.36572265625</c:v>
                </c:pt>
                <c:pt idx="306">
                  <c:v>5551.54638671875</c:v>
                </c:pt>
                <c:pt idx="307">
                  <c:v>5491.64501953125</c:v>
                </c:pt>
                <c:pt idx="308">
                  <c:v>5491.32763671875</c:v>
                </c:pt>
                <c:pt idx="309">
                  <c:v>5556.8583984375</c:v>
                </c:pt>
                <c:pt idx="310">
                  <c:v>5646.94775390625</c:v>
                </c:pt>
                <c:pt idx="311">
                  <c:v>5701.6748046875</c:v>
                </c:pt>
                <c:pt idx="312">
                  <c:v>5685.87158203125</c:v>
                </c:pt>
                <c:pt idx="313">
                  <c:v>5614.38427734375</c:v>
                </c:pt>
                <c:pt idx="314">
                  <c:v>5540.60498046875</c:v>
                </c:pt>
                <c:pt idx="315">
                  <c:v>5517.3662109375</c:v>
                </c:pt>
                <c:pt idx="316">
                  <c:v>5559.466796875</c:v>
                </c:pt>
                <c:pt idx="317">
                  <c:v>5634.92333984375</c:v>
                </c:pt>
                <c:pt idx="318">
                  <c:v>5690.12255859375</c:v>
                </c:pt>
                <c:pt idx="319">
                  <c:v>5689.3359375</c:v>
                </c:pt>
                <c:pt idx="320">
                  <c:v>5639.662109375</c:v>
                </c:pt>
                <c:pt idx="321">
                  <c:v>5584.26904296875</c:v>
                </c:pt>
                <c:pt idx="322">
                  <c:v>5570.0546875</c:v>
                </c:pt>
                <c:pt idx="323">
                  <c:v>5613.47412109375</c:v>
                </c:pt>
                <c:pt idx="324">
                  <c:v>5688.3583984375</c:v>
                </c:pt>
                <c:pt idx="325">
                  <c:v>5743.3662109375</c:v>
                </c:pt>
                <c:pt idx="326">
                  <c:v>5736.38427734375</c:v>
                </c:pt>
                <c:pt idx="327">
                  <c:v>5662.6279296875</c:v>
                </c:pt>
                <c:pt idx="328">
                  <c:v>5558.4619140625</c:v>
                </c:pt>
                <c:pt idx="329">
                  <c:v>5479.4267578125</c:v>
                </c:pt>
                <c:pt idx="330">
                  <c:v>5467.16943359375</c:v>
                </c:pt>
                <c:pt idx="331">
                  <c:v>5525.96240234375</c:v>
                </c:pt>
                <c:pt idx="332">
                  <c:v>5622.34228515625</c:v>
                </c:pt>
                <c:pt idx="333">
                  <c:v>5706.60498046875</c:v>
                </c:pt>
                <c:pt idx="334">
                  <c:v>5741.900390625</c:v>
                </c:pt>
                <c:pt idx="335">
                  <c:v>5723.1572265625</c:v>
                </c:pt>
                <c:pt idx="336">
                  <c:v>5675.48828125</c:v>
                </c:pt>
                <c:pt idx="337">
                  <c:v>5634.89990234375</c:v>
                </c:pt>
                <c:pt idx="338">
                  <c:v>5624.6884765625</c:v>
                </c:pt>
                <c:pt idx="339">
                  <c:v>5642.5439453125</c:v>
                </c:pt>
                <c:pt idx="340">
                  <c:v>5665.45166015625</c:v>
                </c:pt>
                <c:pt idx="341">
                  <c:v>5667.572265625</c:v>
                </c:pt>
                <c:pt idx="342">
                  <c:v>5638.27587890625</c:v>
                </c:pt>
                <c:pt idx="343">
                  <c:v>5588.4453125</c:v>
                </c:pt>
                <c:pt idx="344">
                  <c:v>5541.96875</c:v>
                </c:pt>
                <c:pt idx="345">
                  <c:v>5519.54248046875</c:v>
                </c:pt>
                <c:pt idx="346">
                  <c:v>5526.41943359375</c:v>
                </c:pt>
                <c:pt idx="347">
                  <c:v>5551.802734375</c:v>
                </c:pt>
                <c:pt idx="348">
                  <c:v>5578.6630859375</c:v>
                </c:pt>
                <c:pt idx="349">
                  <c:v>5595.671875</c:v>
                </c:pt>
              </c:numCache>
            </c:numRef>
          </c:yVal>
          <c:smooth val="1"/>
          <c:extLst>
            <c:ext xmlns:c16="http://schemas.microsoft.com/office/drawing/2014/chart" uri="{C3380CC4-5D6E-409C-BE32-E72D297353CC}">
              <c16:uniqueId val="{00000009-4A37-429A-A58F-F7AEDA5D1ACA}"/>
            </c:ext>
          </c:extLst>
        </c:ser>
        <c:ser>
          <c:idx val="10"/>
          <c:order val="10"/>
          <c:tx>
            <c:strRef>
              <c:f>cp_sub_001!$K$1</c:f>
              <c:strCache>
                <c:ptCount val="1"/>
                <c:pt idx="0">
                  <c:v>Coor_11</c:v>
                </c:pt>
              </c:strCache>
            </c:strRef>
          </c:tx>
          <c:spPr>
            <a:ln w="28575" cap="rnd">
              <a:solidFill>
                <a:schemeClr val="accent5">
                  <a:lumMod val="60000"/>
                </a:schemeClr>
              </a:solidFill>
              <a:round/>
            </a:ln>
            <a:effectLst/>
          </c:spPr>
          <c:marker>
            <c:symbol val="none"/>
          </c:marker>
          <c:yVal>
            <c:numRef>
              <c:f>cp_sub_001!$K$2:$K$351</c:f>
              <c:numCache>
                <c:formatCode>0.00000000000_ </c:formatCode>
                <c:ptCount val="350"/>
                <c:pt idx="0">
                  <c:v>3039.353515625</c:v>
                </c:pt>
                <c:pt idx="1">
                  <c:v>3015.40942382812</c:v>
                </c:pt>
                <c:pt idx="2">
                  <c:v>2954.59375</c:v>
                </c:pt>
                <c:pt idx="3">
                  <c:v>2887.6533203125</c:v>
                </c:pt>
                <c:pt idx="4">
                  <c:v>2851.15307617187</c:v>
                </c:pt>
                <c:pt idx="5">
                  <c:v>2864.58837890625</c:v>
                </c:pt>
                <c:pt idx="6">
                  <c:v>2918.833984375</c:v>
                </c:pt>
                <c:pt idx="7">
                  <c:v>2982.89526367187</c:v>
                </c:pt>
                <c:pt idx="8">
                  <c:v>3022.99829101562</c:v>
                </c:pt>
                <c:pt idx="9">
                  <c:v>3020.5966796875</c:v>
                </c:pt>
                <c:pt idx="10">
                  <c:v>2978.76440429687</c:v>
                </c:pt>
                <c:pt idx="11">
                  <c:v>2916.185546875</c:v>
                </c:pt>
                <c:pt idx="12">
                  <c:v>2856.14379882812</c:v>
                </c:pt>
                <c:pt idx="13">
                  <c:v>2818.54663085937</c:v>
                </c:pt>
                <c:pt idx="14">
                  <c:v>2817.17578125</c:v>
                </c:pt>
                <c:pt idx="15">
                  <c:v>2858.5361328125</c:v>
                </c:pt>
                <c:pt idx="16">
                  <c:v>2938.56909179687</c:v>
                </c:pt>
                <c:pt idx="17">
                  <c:v>3038.69677734375</c:v>
                </c:pt>
                <c:pt idx="18">
                  <c:v>3127.27563476562</c:v>
                </c:pt>
                <c:pt idx="19">
                  <c:v>3170.80737304687</c:v>
                </c:pt>
                <c:pt idx="20">
                  <c:v>3151.376953125</c:v>
                </c:pt>
                <c:pt idx="21">
                  <c:v>3079.3017578125</c:v>
                </c:pt>
                <c:pt idx="22">
                  <c:v>2990.34204101562</c:v>
                </c:pt>
                <c:pt idx="23">
                  <c:v>2926.4677734375</c:v>
                </c:pt>
                <c:pt idx="24">
                  <c:v>2911.47412109375</c:v>
                </c:pt>
                <c:pt idx="25">
                  <c:v>2937.8759765625</c:v>
                </c:pt>
                <c:pt idx="26">
                  <c:v>2974.51977539062</c:v>
                </c:pt>
                <c:pt idx="27">
                  <c:v>2989.72534179687</c:v>
                </c:pt>
                <c:pt idx="28">
                  <c:v>2973.42724609375</c:v>
                </c:pt>
                <c:pt idx="29">
                  <c:v>2942.5068359375</c:v>
                </c:pt>
                <c:pt idx="30">
                  <c:v>2926.03564453125</c:v>
                </c:pt>
                <c:pt idx="31">
                  <c:v>2941.97314453125</c:v>
                </c:pt>
                <c:pt idx="32">
                  <c:v>2982.80493164062</c:v>
                </c:pt>
                <c:pt idx="33">
                  <c:v>3020.36840820312</c:v>
                </c:pt>
                <c:pt idx="34">
                  <c:v>3025.59252929687</c:v>
                </c:pt>
                <c:pt idx="35">
                  <c:v>2988.28369140625</c:v>
                </c:pt>
                <c:pt idx="36">
                  <c:v>2923.11279296875</c:v>
                </c:pt>
                <c:pt idx="37">
                  <c:v>2858.9775390625</c:v>
                </c:pt>
                <c:pt idx="38">
                  <c:v>2820.90454101562</c:v>
                </c:pt>
                <c:pt idx="39">
                  <c:v>2817.54418945312</c:v>
                </c:pt>
                <c:pt idx="40">
                  <c:v>2841.18823242187</c:v>
                </c:pt>
                <c:pt idx="41">
                  <c:v>2877.08056640625</c:v>
                </c:pt>
                <c:pt idx="42">
                  <c:v>2913.00219726562</c:v>
                </c:pt>
                <c:pt idx="43">
                  <c:v>2942.52099609375</c:v>
                </c:pt>
                <c:pt idx="44">
                  <c:v>2962.50512695312</c:v>
                </c:pt>
                <c:pt idx="45">
                  <c:v>2970.48974609375</c:v>
                </c:pt>
                <c:pt idx="46">
                  <c:v>2966.0380859375</c:v>
                </c:pt>
                <c:pt idx="47">
                  <c:v>2954.44018554687</c:v>
                </c:pt>
                <c:pt idx="48">
                  <c:v>2947.109375</c:v>
                </c:pt>
                <c:pt idx="49">
                  <c:v>2955.21704101562</c:v>
                </c:pt>
                <c:pt idx="50">
                  <c:v>2979.86352539062</c:v>
                </c:pt>
                <c:pt idx="51">
                  <c:v>3007.16333007812</c:v>
                </c:pt>
                <c:pt idx="52">
                  <c:v>3014.619140625</c:v>
                </c:pt>
                <c:pt idx="53">
                  <c:v>2986.7197265625</c:v>
                </c:pt>
                <c:pt idx="54">
                  <c:v>2929.31591796875</c:v>
                </c:pt>
                <c:pt idx="55">
                  <c:v>2871.287109375</c:v>
                </c:pt>
                <c:pt idx="56">
                  <c:v>2850.0537109375</c:v>
                </c:pt>
                <c:pt idx="57">
                  <c:v>2889.09594726562</c:v>
                </c:pt>
                <c:pt idx="58">
                  <c:v>2982.05126953125</c:v>
                </c:pt>
                <c:pt idx="59">
                  <c:v>3094.1435546875</c:v>
                </c:pt>
                <c:pt idx="60">
                  <c:v>3180.2373046875</c:v>
                </c:pt>
                <c:pt idx="61">
                  <c:v>3208.04296875</c:v>
                </c:pt>
                <c:pt idx="62">
                  <c:v>3172.453125</c:v>
                </c:pt>
                <c:pt idx="63">
                  <c:v>3093.9072265625</c:v>
                </c:pt>
                <c:pt idx="64">
                  <c:v>3004.37939453125</c:v>
                </c:pt>
                <c:pt idx="65">
                  <c:v>2931.30078125</c:v>
                </c:pt>
                <c:pt idx="66">
                  <c:v>2888.49780273437</c:v>
                </c:pt>
                <c:pt idx="67">
                  <c:v>2876.41943359375</c:v>
                </c:pt>
                <c:pt idx="68">
                  <c:v>2887.5185546875</c:v>
                </c:pt>
                <c:pt idx="69">
                  <c:v>2911.22143554687</c:v>
                </c:pt>
                <c:pt idx="70">
                  <c:v>2936.17456054687</c:v>
                </c:pt>
                <c:pt idx="71">
                  <c:v>2951.41796875</c:v>
                </c:pt>
                <c:pt idx="72">
                  <c:v>2948.96728515625</c:v>
                </c:pt>
                <c:pt idx="73">
                  <c:v>2927.69213867187</c:v>
                </c:pt>
                <c:pt idx="74">
                  <c:v>2895.44384765625</c:v>
                </c:pt>
                <c:pt idx="75">
                  <c:v>2866.41137695312</c:v>
                </c:pt>
                <c:pt idx="76">
                  <c:v>2854.05981445312</c:v>
                </c:pt>
                <c:pt idx="77">
                  <c:v>2863.84033203125</c:v>
                </c:pt>
                <c:pt idx="78">
                  <c:v>2890.63818359375</c:v>
                </c:pt>
                <c:pt idx="79">
                  <c:v>2922.72875976562</c:v>
                </c:pt>
                <c:pt idx="80">
                  <c:v>2949.28979492187</c:v>
                </c:pt>
                <c:pt idx="81">
                  <c:v>2966.1298828125</c:v>
                </c:pt>
                <c:pt idx="82">
                  <c:v>2976.00170898437</c:v>
                </c:pt>
                <c:pt idx="83">
                  <c:v>2984.15771484375</c:v>
                </c:pt>
                <c:pt idx="84">
                  <c:v>2993.13232421875</c:v>
                </c:pt>
                <c:pt idx="85">
                  <c:v>3000.65087890625</c:v>
                </c:pt>
                <c:pt idx="86">
                  <c:v>3001.599609375</c:v>
                </c:pt>
                <c:pt idx="87">
                  <c:v>2991.90307617187</c:v>
                </c:pt>
                <c:pt idx="88">
                  <c:v>2971.33447265625</c:v>
                </c:pt>
                <c:pt idx="89">
                  <c:v>2943.87255859375</c:v>
                </c:pt>
                <c:pt idx="90">
                  <c:v>2916.28588867187</c:v>
                </c:pt>
                <c:pt idx="91">
                  <c:v>2896.27075195312</c:v>
                </c:pt>
                <c:pt idx="92">
                  <c:v>2890.61376953125</c:v>
                </c:pt>
                <c:pt idx="93">
                  <c:v>2903.01416015625</c:v>
                </c:pt>
                <c:pt idx="94">
                  <c:v>2931.71606445312</c:v>
                </c:pt>
                <c:pt idx="95">
                  <c:v>2968.52026367187</c:v>
                </c:pt>
                <c:pt idx="96">
                  <c:v>3001.14575195312</c:v>
                </c:pt>
                <c:pt idx="97">
                  <c:v>3019.03198242187</c:v>
                </c:pt>
                <c:pt idx="98">
                  <c:v>3019.5224609375</c:v>
                </c:pt>
                <c:pt idx="99">
                  <c:v>3009.81323242187</c:v>
                </c:pt>
                <c:pt idx="100">
                  <c:v>3002.22607421875</c:v>
                </c:pt>
                <c:pt idx="101">
                  <c:v>3005.29931640625</c:v>
                </c:pt>
                <c:pt idx="102">
                  <c:v>3017.09497070312</c:v>
                </c:pt>
                <c:pt idx="103">
                  <c:v>3026.28149414062</c:v>
                </c:pt>
                <c:pt idx="104">
                  <c:v>3020.90844726562</c:v>
                </c:pt>
                <c:pt idx="105">
                  <c:v>2998.43701171875</c:v>
                </c:pt>
                <c:pt idx="106">
                  <c:v>2968.88696289062</c:v>
                </c:pt>
                <c:pt idx="107">
                  <c:v>2947.88061523437</c:v>
                </c:pt>
                <c:pt idx="108">
                  <c:v>2944.48901367187</c:v>
                </c:pt>
                <c:pt idx="109">
                  <c:v>2953.5517578125</c:v>
                </c:pt>
                <c:pt idx="110">
                  <c:v>2959.2626953125</c:v>
                </c:pt>
                <c:pt idx="111">
                  <c:v>2948.00537109375</c:v>
                </c:pt>
                <c:pt idx="112">
                  <c:v>2920.56103515625</c:v>
                </c:pt>
                <c:pt idx="113">
                  <c:v>2893.49951171875</c:v>
                </c:pt>
                <c:pt idx="114">
                  <c:v>2887.6103515625</c:v>
                </c:pt>
                <c:pt idx="115">
                  <c:v>2911.58447265625</c:v>
                </c:pt>
                <c:pt idx="116">
                  <c:v>2953.55859375</c:v>
                </c:pt>
                <c:pt idx="117">
                  <c:v>2987.6591796875</c:v>
                </c:pt>
                <c:pt idx="118">
                  <c:v>2991.3349609375</c:v>
                </c:pt>
                <c:pt idx="119">
                  <c:v>2960.84155273437</c:v>
                </c:pt>
                <c:pt idx="120">
                  <c:v>2913.49658203125</c:v>
                </c:pt>
                <c:pt idx="121">
                  <c:v>2875.38720703125</c:v>
                </c:pt>
                <c:pt idx="122">
                  <c:v>2864.17822265625</c:v>
                </c:pt>
                <c:pt idx="123">
                  <c:v>2879.8994140625</c:v>
                </c:pt>
                <c:pt idx="124">
                  <c:v>2909.65869140625</c:v>
                </c:pt>
                <c:pt idx="125">
                  <c:v>2940.880859375</c:v>
                </c:pt>
                <c:pt idx="126">
                  <c:v>2971.1728515625</c:v>
                </c:pt>
                <c:pt idx="127">
                  <c:v>3006.48852539062</c:v>
                </c:pt>
                <c:pt idx="128">
                  <c:v>3049.78173828125</c:v>
                </c:pt>
                <c:pt idx="129">
                  <c:v>3090.99609375</c:v>
                </c:pt>
                <c:pt idx="130">
                  <c:v>3108.66162109375</c:v>
                </c:pt>
                <c:pt idx="131">
                  <c:v>3083.83447265625</c:v>
                </c:pt>
                <c:pt idx="132">
                  <c:v>3016.32055664062</c:v>
                </c:pt>
                <c:pt idx="133">
                  <c:v>2929.9970703125</c:v>
                </c:pt>
                <c:pt idx="134">
                  <c:v>2861.48852539062</c:v>
                </c:pt>
                <c:pt idx="135">
                  <c:v>2838.90771484375</c:v>
                </c:pt>
                <c:pt idx="136">
                  <c:v>2865.15649414062</c:v>
                </c:pt>
                <c:pt idx="137">
                  <c:v>2917.3388671875</c:v>
                </c:pt>
                <c:pt idx="138">
                  <c:v>2962.36743164062</c:v>
                </c:pt>
                <c:pt idx="139">
                  <c:v>2977.57104492187</c:v>
                </c:pt>
                <c:pt idx="140">
                  <c:v>2962.33569335937</c:v>
                </c:pt>
                <c:pt idx="141">
                  <c:v>2934.17333984375</c:v>
                </c:pt>
                <c:pt idx="142">
                  <c:v>2914.03100585937</c:v>
                </c:pt>
                <c:pt idx="143">
                  <c:v>2912.47607421875</c:v>
                </c:pt>
                <c:pt idx="144">
                  <c:v>2926.06689453125</c:v>
                </c:pt>
                <c:pt idx="145">
                  <c:v>2944.39453125</c:v>
                </c:pt>
                <c:pt idx="146">
                  <c:v>2960.3037109375</c:v>
                </c:pt>
                <c:pt idx="147">
                  <c:v>2974.58837890625</c:v>
                </c:pt>
                <c:pt idx="148">
                  <c:v>2992.169921875</c:v>
                </c:pt>
                <c:pt idx="149">
                  <c:v>3014.1923828125</c:v>
                </c:pt>
                <c:pt idx="150">
                  <c:v>3033.56958007812</c:v>
                </c:pt>
                <c:pt idx="151">
                  <c:v>3038.23120117187</c:v>
                </c:pt>
                <c:pt idx="152">
                  <c:v>3019.748046875</c:v>
                </c:pt>
                <c:pt idx="153">
                  <c:v>2980.59619140625</c:v>
                </c:pt>
                <c:pt idx="154">
                  <c:v>2934.37817382812</c:v>
                </c:pt>
                <c:pt idx="155">
                  <c:v>2898.66625976562</c:v>
                </c:pt>
                <c:pt idx="156">
                  <c:v>2885.4736328125</c:v>
                </c:pt>
                <c:pt idx="157">
                  <c:v>2895.73461914062</c:v>
                </c:pt>
                <c:pt idx="158">
                  <c:v>2920.9658203125</c:v>
                </c:pt>
                <c:pt idx="159">
                  <c:v>2950.1484375</c:v>
                </c:pt>
                <c:pt idx="160">
                  <c:v>2976.61938476562</c:v>
                </c:pt>
                <c:pt idx="161">
                  <c:v>3000.34936523437</c:v>
                </c:pt>
                <c:pt idx="162">
                  <c:v>3024.6025390625</c:v>
                </c:pt>
                <c:pt idx="163">
                  <c:v>3049.91528320312</c:v>
                </c:pt>
                <c:pt idx="164">
                  <c:v>3070.04858398437</c:v>
                </c:pt>
                <c:pt idx="165">
                  <c:v>3073.20263671875</c:v>
                </c:pt>
                <c:pt idx="166">
                  <c:v>3048.37817382812</c:v>
                </c:pt>
                <c:pt idx="167">
                  <c:v>2993.35913085937</c:v>
                </c:pt>
                <c:pt idx="168">
                  <c:v>2919.36547851562</c:v>
                </c:pt>
                <c:pt idx="169">
                  <c:v>2848.81494140625</c:v>
                </c:pt>
                <c:pt idx="170">
                  <c:v>2806.29711914062</c:v>
                </c:pt>
                <c:pt idx="171">
                  <c:v>2806.92163085937</c:v>
                </c:pt>
                <c:pt idx="172">
                  <c:v>2848.28271484375</c:v>
                </c:pt>
                <c:pt idx="173">
                  <c:v>2910.87182617187</c:v>
                </c:pt>
                <c:pt idx="174">
                  <c:v>2967.2880859375</c:v>
                </c:pt>
                <c:pt idx="175">
                  <c:v>2995.5166015625</c:v>
                </c:pt>
                <c:pt idx="176">
                  <c:v>2989.06811523437</c:v>
                </c:pt>
                <c:pt idx="177">
                  <c:v>2958.62524414062</c:v>
                </c:pt>
                <c:pt idx="178">
                  <c:v>2924.92016601562</c:v>
                </c:pt>
                <c:pt idx="179">
                  <c:v>2907.57495117187</c:v>
                </c:pt>
                <c:pt idx="180">
                  <c:v>2916.267578125</c:v>
                </c:pt>
                <c:pt idx="181">
                  <c:v>2948.1494140625</c:v>
                </c:pt>
                <c:pt idx="182">
                  <c:v>2991.0849609375</c:v>
                </c:pt>
                <c:pt idx="183">
                  <c:v>3029.36547851562</c:v>
                </c:pt>
                <c:pt idx="184">
                  <c:v>3048.79565429687</c:v>
                </c:pt>
                <c:pt idx="185">
                  <c:v>3040.29370117187</c:v>
                </c:pt>
                <c:pt idx="186">
                  <c:v>3002.70971679687</c:v>
                </c:pt>
                <c:pt idx="187">
                  <c:v>2944.853515625</c:v>
                </c:pt>
                <c:pt idx="188">
                  <c:v>2884.8603515625</c:v>
                </c:pt>
                <c:pt idx="189">
                  <c:v>2844.74096679687</c:v>
                </c:pt>
                <c:pt idx="190">
                  <c:v>2840.77294921875</c:v>
                </c:pt>
                <c:pt idx="191">
                  <c:v>2874.51806640625</c:v>
                </c:pt>
                <c:pt idx="192">
                  <c:v>2930.85571289062</c:v>
                </c:pt>
                <c:pt idx="193">
                  <c:v>2985.92114257812</c:v>
                </c:pt>
                <c:pt idx="194">
                  <c:v>3020.90478515625</c:v>
                </c:pt>
                <c:pt idx="195">
                  <c:v>3032.55883789062</c:v>
                </c:pt>
                <c:pt idx="196">
                  <c:v>3032.68212890625</c:v>
                </c:pt>
                <c:pt idx="197">
                  <c:v>3036.66333007812</c:v>
                </c:pt>
                <c:pt idx="198">
                  <c:v>3049.7060546875</c:v>
                </c:pt>
                <c:pt idx="199">
                  <c:v>3061.66870117187</c:v>
                </c:pt>
                <c:pt idx="200">
                  <c:v>3055.05517578125</c:v>
                </c:pt>
                <c:pt idx="201">
                  <c:v>3020.189453125</c:v>
                </c:pt>
                <c:pt idx="202">
                  <c:v>2965.404296875</c:v>
                </c:pt>
                <c:pt idx="203">
                  <c:v>2913.55419921875</c:v>
                </c:pt>
                <c:pt idx="204">
                  <c:v>2886.92919921875</c:v>
                </c:pt>
                <c:pt idx="205">
                  <c:v>2892.11547851562</c:v>
                </c:pt>
                <c:pt idx="206">
                  <c:v>2916.60498046875</c:v>
                </c:pt>
                <c:pt idx="207">
                  <c:v>2939.53344726562</c:v>
                </c:pt>
                <c:pt idx="208">
                  <c:v>2947.49096679687</c:v>
                </c:pt>
                <c:pt idx="209">
                  <c:v>2942.46533203125</c:v>
                </c:pt>
                <c:pt idx="210">
                  <c:v>2936.04614257812</c:v>
                </c:pt>
                <c:pt idx="211">
                  <c:v>2936.06298828125</c:v>
                </c:pt>
                <c:pt idx="212">
                  <c:v>2938.4423828125</c:v>
                </c:pt>
                <c:pt idx="213">
                  <c:v>2932.24536132812</c:v>
                </c:pt>
                <c:pt idx="214">
                  <c:v>2913.501953125</c:v>
                </c:pt>
                <c:pt idx="215">
                  <c:v>2894.42724609375</c:v>
                </c:pt>
                <c:pt idx="216">
                  <c:v>2897.42944335937</c:v>
                </c:pt>
                <c:pt idx="217">
                  <c:v>2936.4638671875</c:v>
                </c:pt>
                <c:pt idx="218">
                  <c:v>3000.77954101562</c:v>
                </c:pt>
                <c:pt idx="219">
                  <c:v>3056.56103515625</c:v>
                </c:pt>
                <c:pt idx="220">
                  <c:v>3068.57006835937</c:v>
                </c:pt>
                <c:pt idx="221">
                  <c:v>3026.85498046875</c:v>
                </c:pt>
                <c:pt idx="222">
                  <c:v>2957.27075195312</c:v>
                </c:pt>
                <c:pt idx="223">
                  <c:v>2905.41845703125</c:v>
                </c:pt>
                <c:pt idx="224">
                  <c:v>2904.1630859375</c:v>
                </c:pt>
                <c:pt idx="225">
                  <c:v>2948.8828125</c:v>
                </c:pt>
                <c:pt idx="226">
                  <c:v>3000.12231445312</c:v>
                </c:pt>
                <c:pt idx="227">
                  <c:v>3012.84594726562</c:v>
                </c:pt>
                <c:pt idx="228">
                  <c:v>2970.69116210937</c:v>
                </c:pt>
                <c:pt idx="229">
                  <c:v>2899.06469726562</c:v>
                </c:pt>
                <c:pt idx="230">
                  <c:v>2846.77709960937</c:v>
                </c:pt>
                <c:pt idx="231">
                  <c:v>2850.05517578125</c:v>
                </c:pt>
                <c:pt idx="232">
                  <c:v>2906.3291015625</c:v>
                </c:pt>
                <c:pt idx="233">
                  <c:v>2977.44091796875</c:v>
                </c:pt>
                <c:pt idx="234">
                  <c:v>3019.01147460937</c:v>
                </c:pt>
                <c:pt idx="235">
                  <c:v>3012.72534179687</c:v>
                </c:pt>
                <c:pt idx="236">
                  <c:v>2976.87817382812</c:v>
                </c:pt>
                <c:pt idx="237">
                  <c:v>2948.3505859375</c:v>
                </c:pt>
                <c:pt idx="238">
                  <c:v>2951.68505859375</c:v>
                </c:pt>
                <c:pt idx="239">
                  <c:v>2980.25634765625</c:v>
                </c:pt>
                <c:pt idx="240">
                  <c:v>3003.75732421875</c:v>
                </c:pt>
                <c:pt idx="241">
                  <c:v>2994.69946289062</c:v>
                </c:pt>
                <c:pt idx="242">
                  <c:v>2951.87890625</c:v>
                </c:pt>
                <c:pt idx="243">
                  <c:v>2902.2265625</c:v>
                </c:pt>
                <c:pt idx="244">
                  <c:v>2880.48754882812</c:v>
                </c:pt>
                <c:pt idx="245">
                  <c:v>2903.63500976562</c:v>
                </c:pt>
                <c:pt idx="246">
                  <c:v>2959.94165039062</c:v>
                </c:pt>
                <c:pt idx="247">
                  <c:v>3019.68090820312</c:v>
                </c:pt>
                <c:pt idx="248">
                  <c:v>3057.0029296875</c:v>
                </c:pt>
                <c:pt idx="249">
                  <c:v>3064.9833984375</c:v>
                </c:pt>
                <c:pt idx="250">
                  <c:v>3053.5234375</c:v>
                </c:pt>
                <c:pt idx="251">
                  <c:v>3035.08325195312</c:v>
                </c:pt>
                <c:pt idx="252">
                  <c:v>3012.75439453125</c:v>
                </c:pt>
                <c:pt idx="253">
                  <c:v>2981.26123046875</c:v>
                </c:pt>
                <c:pt idx="254">
                  <c:v>2938.4501953125</c:v>
                </c:pt>
                <c:pt idx="255">
                  <c:v>2894.69995117187</c:v>
                </c:pt>
                <c:pt idx="256">
                  <c:v>2869.54711914062</c:v>
                </c:pt>
                <c:pt idx="257">
                  <c:v>2876.84790039062</c:v>
                </c:pt>
                <c:pt idx="258">
                  <c:v>2911.1572265625</c:v>
                </c:pt>
                <c:pt idx="259">
                  <c:v>2948.3212890625</c:v>
                </c:pt>
                <c:pt idx="260">
                  <c:v>2961.81884765625</c:v>
                </c:pt>
                <c:pt idx="261">
                  <c:v>2942.7646484375</c:v>
                </c:pt>
                <c:pt idx="262">
                  <c:v>2907.45947265625</c:v>
                </c:pt>
                <c:pt idx="263">
                  <c:v>2885.75805664062</c:v>
                </c:pt>
                <c:pt idx="264">
                  <c:v>2898.82495117187</c:v>
                </c:pt>
                <c:pt idx="265">
                  <c:v>2943.48950195312</c:v>
                </c:pt>
                <c:pt idx="266">
                  <c:v>2995.22998046875</c:v>
                </c:pt>
                <c:pt idx="267">
                  <c:v>3027.02001953125</c:v>
                </c:pt>
                <c:pt idx="268">
                  <c:v>3028.88647460937</c:v>
                </c:pt>
                <c:pt idx="269">
                  <c:v>3012.97924804687</c:v>
                </c:pt>
                <c:pt idx="270">
                  <c:v>3000.95288085937</c:v>
                </c:pt>
                <c:pt idx="271">
                  <c:v>3004.58984375</c:v>
                </c:pt>
                <c:pt idx="272">
                  <c:v>3015.50122070312</c:v>
                </c:pt>
                <c:pt idx="273">
                  <c:v>3011.93212890625</c:v>
                </c:pt>
                <c:pt idx="274">
                  <c:v>2976.9140625</c:v>
                </c:pt>
                <c:pt idx="275">
                  <c:v>2913.37451171875</c:v>
                </c:pt>
                <c:pt idx="276">
                  <c:v>2844.75024414062</c:v>
                </c:pt>
                <c:pt idx="277">
                  <c:v>2801.05786132812</c:v>
                </c:pt>
                <c:pt idx="278">
                  <c:v>2800.9111328125</c:v>
                </c:pt>
                <c:pt idx="279">
                  <c:v>2841.76635742187</c:v>
                </c:pt>
                <c:pt idx="280">
                  <c:v>2903.51220703125</c:v>
                </c:pt>
                <c:pt idx="281">
                  <c:v>2960.93896484375</c:v>
                </c:pt>
                <c:pt idx="282">
                  <c:v>2996.02783203125</c:v>
                </c:pt>
                <c:pt idx="283">
                  <c:v>3003.65454101562</c:v>
                </c:pt>
                <c:pt idx="284">
                  <c:v>2990.369140625</c:v>
                </c:pt>
                <c:pt idx="285">
                  <c:v>2969.80834960937</c:v>
                </c:pt>
                <c:pt idx="286">
                  <c:v>2957.69091796875</c:v>
                </c:pt>
                <c:pt idx="287">
                  <c:v>2966.71337890625</c:v>
                </c:pt>
                <c:pt idx="288">
                  <c:v>3000.89672851562</c:v>
                </c:pt>
                <c:pt idx="289">
                  <c:v>3051.1884765625</c:v>
                </c:pt>
                <c:pt idx="290">
                  <c:v>3096.44360351562</c:v>
                </c:pt>
                <c:pt idx="291">
                  <c:v>3112.42626953125</c:v>
                </c:pt>
                <c:pt idx="292">
                  <c:v>3085.81689453125</c:v>
                </c:pt>
                <c:pt idx="293">
                  <c:v>3024.61791992187</c:v>
                </c:pt>
                <c:pt idx="294">
                  <c:v>2956.43017578125</c:v>
                </c:pt>
                <c:pt idx="295">
                  <c:v>2913.3681640625</c:v>
                </c:pt>
                <c:pt idx="296">
                  <c:v>2912.25390625</c:v>
                </c:pt>
                <c:pt idx="297">
                  <c:v>2943.43432617187</c:v>
                </c:pt>
                <c:pt idx="298">
                  <c:v>2976.66333007812</c:v>
                </c:pt>
                <c:pt idx="299">
                  <c:v>2980.84228515625</c:v>
                </c:pt>
                <c:pt idx="300">
                  <c:v>2944.4794921875</c:v>
                </c:pt>
                <c:pt idx="301">
                  <c:v>2883.08862304687</c:v>
                </c:pt>
                <c:pt idx="302">
                  <c:v>2828.95678710937</c:v>
                </c:pt>
                <c:pt idx="303">
                  <c:v>2810.91772460937</c:v>
                </c:pt>
                <c:pt idx="304">
                  <c:v>2837.95947265625</c:v>
                </c:pt>
                <c:pt idx="305">
                  <c:v>2896.56640625</c:v>
                </c:pt>
                <c:pt idx="306">
                  <c:v>2961.34887695312</c:v>
                </c:pt>
                <c:pt idx="307">
                  <c:v>3009.9033203125</c:v>
                </c:pt>
                <c:pt idx="308">
                  <c:v>3031.9755859375</c:v>
                </c:pt>
                <c:pt idx="309">
                  <c:v>3029.26342773437</c:v>
                </c:pt>
                <c:pt idx="310">
                  <c:v>3009.58520507812</c:v>
                </c:pt>
                <c:pt idx="311">
                  <c:v>2981.74560546875</c:v>
                </c:pt>
                <c:pt idx="312">
                  <c:v>2954.16772460937</c:v>
                </c:pt>
                <c:pt idx="313">
                  <c:v>2935.34936523437</c:v>
                </c:pt>
                <c:pt idx="314">
                  <c:v>2932.45483398437</c:v>
                </c:pt>
                <c:pt idx="315">
                  <c:v>2947.2490234375</c:v>
                </c:pt>
                <c:pt idx="316">
                  <c:v>2972.77172851562</c:v>
                </c:pt>
                <c:pt idx="317">
                  <c:v>2995.06079101562</c:v>
                </c:pt>
                <c:pt idx="318">
                  <c:v>3000.48266601562</c:v>
                </c:pt>
                <c:pt idx="319">
                  <c:v>2984.06176757812</c:v>
                </c:pt>
                <c:pt idx="320">
                  <c:v>2952.53540039062</c:v>
                </c:pt>
                <c:pt idx="321">
                  <c:v>2919.65380859375</c:v>
                </c:pt>
                <c:pt idx="322">
                  <c:v>2897.4619140625</c:v>
                </c:pt>
                <c:pt idx="323">
                  <c:v>2890.47045898437</c:v>
                </c:pt>
                <c:pt idx="324">
                  <c:v>2896.8056640625</c:v>
                </c:pt>
                <c:pt idx="325">
                  <c:v>2913.96801757812</c:v>
                </c:pt>
                <c:pt idx="326">
                  <c:v>2942.59350585937</c:v>
                </c:pt>
                <c:pt idx="327">
                  <c:v>2983.66015625</c:v>
                </c:pt>
                <c:pt idx="328">
                  <c:v>3031.37817382812</c:v>
                </c:pt>
                <c:pt idx="329">
                  <c:v>3069.4169921875</c:v>
                </c:pt>
                <c:pt idx="330">
                  <c:v>3076.69409179687</c:v>
                </c:pt>
                <c:pt idx="331">
                  <c:v>3041.03442382812</c:v>
                </c:pt>
                <c:pt idx="332">
                  <c:v>2970.97827148437</c:v>
                </c:pt>
                <c:pt idx="333">
                  <c:v>2895.22387695312</c:v>
                </c:pt>
                <c:pt idx="334">
                  <c:v>2847.431640625</c:v>
                </c:pt>
                <c:pt idx="335">
                  <c:v>2845.60107421875</c:v>
                </c:pt>
                <c:pt idx="336">
                  <c:v>2880.71166992187</c:v>
                </c:pt>
                <c:pt idx="337">
                  <c:v>2923.66577148437</c:v>
                </c:pt>
                <c:pt idx="338">
                  <c:v>2946.3515625</c:v>
                </c:pt>
                <c:pt idx="339">
                  <c:v>2941.7734375</c:v>
                </c:pt>
                <c:pt idx="340">
                  <c:v>2928.34838867187</c:v>
                </c:pt>
                <c:pt idx="341">
                  <c:v>2934.96459960937</c:v>
                </c:pt>
                <c:pt idx="342">
                  <c:v>2977.77221679687</c:v>
                </c:pt>
                <c:pt idx="343">
                  <c:v>3045.96508789062</c:v>
                </c:pt>
                <c:pt idx="344">
                  <c:v>3107.18530273437</c:v>
                </c:pt>
                <c:pt idx="345">
                  <c:v>3128.6552734375</c:v>
                </c:pt>
                <c:pt idx="346">
                  <c:v>3098.72973632812</c:v>
                </c:pt>
                <c:pt idx="347">
                  <c:v>3033.69555664062</c:v>
                </c:pt>
                <c:pt idx="348">
                  <c:v>2965.87646484375</c:v>
                </c:pt>
                <c:pt idx="349">
                  <c:v>2922.57153320312</c:v>
                </c:pt>
              </c:numCache>
            </c:numRef>
          </c:yVal>
          <c:smooth val="1"/>
          <c:extLst>
            <c:ext xmlns:c16="http://schemas.microsoft.com/office/drawing/2014/chart" uri="{C3380CC4-5D6E-409C-BE32-E72D297353CC}">
              <c16:uniqueId val="{0000000A-4A37-429A-A58F-F7AEDA5D1ACA}"/>
            </c:ext>
          </c:extLst>
        </c:ser>
        <c:ser>
          <c:idx val="11"/>
          <c:order val="11"/>
          <c:tx>
            <c:strRef>
              <c:f>cp_sub_001!$L$1</c:f>
              <c:strCache>
                <c:ptCount val="1"/>
                <c:pt idx="0">
                  <c:v>Coor_12</c:v>
                </c:pt>
              </c:strCache>
            </c:strRef>
          </c:tx>
          <c:spPr>
            <a:ln w="28575" cap="rnd">
              <a:solidFill>
                <a:schemeClr val="accent6">
                  <a:lumMod val="60000"/>
                </a:schemeClr>
              </a:solidFill>
              <a:round/>
            </a:ln>
            <a:effectLst/>
          </c:spPr>
          <c:marker>
            <c:symbol val="none"/>
          </c:marker>
          <c:yVal>
            <c:numRef>
              <c:f>cp_sub_001!$L$2:$L$351</c:f>
              <c:numCache>
                <c:formatCode>0.00000000000_ </c:formatCode>
                <c:ptCount val="350"/>
                <c:pt idx="0">
                  <c:v>6727.32080078125</c:v>
                </c:pt>
                <c:pt idx="1">
                  <c:v>6700.162109375</c:v>
                </c:pt>
                <c:pt idx="2">
                  <c:v>6657.69580078125</c:v>
                </c:pt>
                <c:pt idx="3">
                  <c:v>6616.9208984375</c:v>
                </c:pt>
                <c:pt idx="4">
                  <c:v>6600.9892578125</c:v>
                </c:pt>
                <c:pt idx="5">
                  <c:v>6625.25390625</c:v>
                </c:pt>
                <c:pt idx="6">
                  <c:v>6686.416015625</c:v>
                </c:pt>
                <c:pt idx="7">
                  <c:v>6762.23388671875</c:v>
                </c:pt>
                <c:pt idx="8">
                  <c:v>6822.14306640625</c:v>
                </c:pt>
                <c:pt idx="9">
                  <c:v>6842.1396484375</c:v>
                </c:pt>
                <c:pt idx="10">
                  <c:v>6815.3720703125</c:v>
                </c:pt>
                <c:pt idx="11">
                  <c:v>6753.74365234375</c:v>
                </c:pt>
                <c:pt idx="12">
                  <c:v>6681.69580078125</c:v>
                </c:pt>
                <c:pt idx="13">
                  <c:v>6626.69580078125</c:v>
                </c:pt>
                <c:pt idx="14">
                  <c:v>6610.35205078125</c:v>
                </c:pt>
                <c:pt idx="15">
                  <c:v>6641.673828125</c:v>
                </c:pt>
                <c:pt idx="16">
                  <c:v>6713.021484375</c:v>
                </c:pt>
                <c:pt idx="17">
                  <c:v>6800.318359375</c:v>
                </c:pt>
                <c:pt idx="18">
                  <c:v>6869.85009765625</c:v>
                </c:pt>
                <c:pt idx="19">
                  <c:v>6891.6796875</c:v>
                </c:pt>
                <c:pt idx="20">
                  <c:v>6854.70751953125</c:v>
                </c:pt>
                <c:pt idx="21">
                  <c:v>6774.7392578125</c:v>
                </c:pt>
                <c:pt idx="22">
                  <c:v>6688.77587890625</c:v>
                </c:pt>
                <c:pt idx="23">
                  <c:v>6636.59619140625</c:v>
                </c:pt>
                <c:pt idx="24">
                  <c:v>6639.52978515625</c:v>
                </c:pt>
                <c:pt idx="25">
                  <c:v>6689.39404296875</c:v>
                </c:pt>
                <c:pt idx="26">
                  <c:v>6754.71142578125</c:v>
                </c:pt>
                <c:pt idx="27">
                  <c:v>6800.12451171875</c:v>
                </c:pt>
                <c:pt idx="28">
                  <c:v>6806.30419921875</c:v>
                </c:pt>
                <c:pt idx="29">
                  <c:v>6777.947265625</c:v>
                </c:pt>
                <c:pt idx="30">
                  <c:v>6736.2666015625</c:v>
                </c:pt>
                <c:pt idx="31">
                  <c:v>6703.009765625</c:v>
                </c:pt>
                <c:pt idx="32">
                  <c:v>6687.70361328125</c:v>
                </c:pt>
                <c:pt idx="33">
                  <c:v>6685.7587890625</c:v>
                </c:pt>
                <c:pt idx="34">
                  <c:v>6686.2021484375</c:v>
                </c:pt>
                <c:pt idx="35">
                  <c:v>6681.41064453125</c:v>
                </c:pt>
                <c:pt idx="36">
                  <c:v>6671.5966796875</c:v>
                </c:pt>
                <c:pt idx="37">
                  <c:v>6662.5166015625</c:v>
                </c:pt>
                <c:pt idx="38">
                  <c:v>6660.35986328125</c:v>
                </c:pt>
                <c:pt idx="39">
                  <c:v>6668.63623046875</c:v>
                </c:pt>
                <c:pt idx="40">
                  <c:v>6688.32373046875</c:v>
                </c:pt>
                <c:pt idx="41">
                  <c:v>6718.77978515625</c:v>
                </c:pt>
                <c:pt idx="42">
                  <c:v>6756.765625</c:v>
                </c:pt>
                <c:pt idx="43">
                  <c:v>6794.26123046875</c:v>
                </c:pt>
                <c:pt idx="44">
                  <c:v>6818.74951171875</c:v>
                </c:pt>
                <c:pt idx="45">
                  <c:v>6818.60888671875</c:v>
                </c:pt>
                <c:pt idx="46">
                  <c:v>6791.45361328125</c:v>
                </c:pt>
                <c:pt idx="47">
                  <c:v>6748.98193359375</c:v>
                </c:pt>
                <c:pt idx="48">
                  <c:v>6712.73876953125</c:v>
                </c:pt>
                <c:pt idx="49">
                  <c:v>6701.525390625</c:v>
                </c:pt>
                <c:pt idx="50">
                  <c:v>6718.42431640625</c:v>
                </c:pt>
                <c:pt idx="51">
                  <c:v>6747.2236328125</c:v>
                </c:pt>
                <c:pt idx="52">
                  <c:v>6762.19873046875</c:v>
                </c:pt>
                <c:pt idx="53">
                  <c:v>6745.46875</c:v>
                </c:pt>
                <c:pt idx="54">
                  <c:v>6699.9716796875</c:v>
                </c:pt>
                <c:pt idx="55">
                  <c:v>6648.5576171875</c:v>
                </c:pt>
                <c:pt idx="56">
                  <c:v>6619.4111328125</c:v>
                </c:pt>
                <c:pt idx="57">
                  <c:v>6627.849609375</c:v>
                </c:pt>
                <c:pt idx="58">
                  <c:v>6667.15234375</c:v>
                </c:pt>
                <c:pt idx="59">
                  <c:v>6714.43994140625</c:v>
                </c:pt>
                <c:pt idx="60">
                  <c:v>6746.767578125</c:v>
                </c:pt>
                <c:pt idx="61">
                  <c:v>6755.56591796875</c:v>
                </c:pt>
                <c:pt idx="62">
                  <c:v>6749.43359375</c:v>
                </c:pt>
                <c:pt idx="63">
                  <c:v>6744.34619140625</c:v>
                </c:pt>
                <c:pt idx="64">
                  <c:v>6749.65869140625</c:v>
                </c:pt>
                <c:pt idx="65">
                  <c:v>6760.88671875</c:v>
                </c:pt>
                <c:pt idx="66">
                  <c:v>6764.5498046875</c:v>
                </c:pt>
                <c:pt idx="67">
                  <c:v>6750.86865234375</c:v>
                </c:pt>
                <c:pt idx="68">
                  <c:v>6724.02294921875</c:v>
                </c:pt>
                <c:pt idx="69">
                  <c:v>6701.5087890625</c:v>
                </c:pt>
                <c:pt idx="70">
                  <c:v>6702.36962890625</c:v>
                </c:pt>
                <c:pt idx="71">
                  <c:v>6732.58203125</c:v>
                </c:pt>
                <c:pt idx="72">
                  <c:v>6778.42529296875</c:v>
                </c:pt>
                <c:pt idx="73">
                  <c:v>6813.34814453125</c:v>
                </c:pt>
                <c:pt idx="74">
                  <c:v>6814.43701171875</c:v>
                </c:pt>
                <c:pt idx="75">
                  <c:v>6777.6845703125</c:v>
                </c:pt>
                <c:pt idx="76">
                  <c:v>6721.72705078125</c:v>
                </c:pt>
                <c:pt idx="77">
                  <c:v>6677.21630859375</c:v>
                </c:pt>
                <c:pt idx="78">
                  <c:v>6668.4560546875</c:v>
                </c:pt>
                <c:pt idx="79">
                  <c:v>6698.9130859375</c:v>
                </c:pt>
                <c:pt idx="80">
                  <c:v>6749.55078125</c:v>
                </c:pt>
                <c:pt idx="81">
                  <c:v>6790.51806640625</c:v>
                </c:pt>
                <c:pt idx="82">
                  <c:v>6798.42333984375</c:v>
                </c:pt>
                <c:pt idx="83">
                  <c:v>6768.54248046875</c:v>
                </c:pt>
                <c:pt idx="84">
                  <c:v>6715.40771484375</c:v>
                </c:pt>
                <c:pt idx="85">
                  <c:v>6662.96044921875</c:v>
                </c:pt>
                <c:pt idx="86">
                  <c:v>6631.41552734375</c:v>
                </c:pt>
                <c:pt idx="87">
                  <c:v>6628.58544921875</c:v>
                </c:pt>
                <c:pt idx="88">
                  <c:v>6649.14013671875</c:v>
                </c:pt>
                <c:pt idx="89">
                  <c:v>6679.95556640625</c:v>
                </c:pt>
                <c:pt idx="90">
                  <c:v>6707.07177734375</c:v>
                </c:pt>
                <c:pt idx="91">
                  <c:v>6720.8857421875</c:v>
                </c:pt>
                <c:pt idx="92">
                  <c:v>6718.80029296875</c:v>
                </c:pt>
                <c:pt idx="93">
                  <c:v>6705.95068359375</c:v>
                </c:pt>
                <c:pt idx="94">
                  <c:v>6693.91796875</c:v>
                </c:pt>
                <c:pt idx="95">
                  <c:v>6696.39306640625</c:v>
                </c:pt>
                <c:pt idx="96">
                  <c:v>6721.82861328125</c:v>
                </c:pt>
                <c:pt idx="97">
                  <c:v>6766.2158203125</c:v>
                </c:pt>
                <c:pt idx="98">
                  <c:v>6811.44921875</c:v>
                </c:pt>
                <c:pt idx="99">
                  <c:v>6832.92529296875</c:v>
                </c:pt>
                <c:pt idx="100">
                  <c:v>6813.96728515625</c:v>
                </c:pt>
                <c:pt idx="101">
                  <c:v>6758.3642578125</c:v>
                </c:pt>
                <c:pt idx="102">
                  <c:v>6691.390625</c:v>
                </c:pt>
                <c:pt idx="103">
                  <c:v>6646.3720703125</c:v>
                </c:pt>
                <c:pt idx="104">
                  <c:v>6644.2861328125</c:v>
                </c:pt>
                <c:pt idx="105">
                  <c:v>6680.19287109375</c:v>
                </c:pt>
                <c:pt idx="106">
                  <c:v>6726.79345703125</c:v>
                </c:pt>
                <c:pt idx="107">
                  <c:v>6753.58056640625</c:v>
                </c:pt>
                <c:pt idx="108">
                  <c:v>6748.30908203125</c:v>
                </c:pt>
                <c:pt idx="109">
                  <c:v>6725.05712890625</c:v>
                </c:pt>
                <c:pt idx="110">
                  <c:v>6712.5673828125</c:v>
                </c:pt>
                <c:pt idx="111">
                  <c:v>6731.259765625</c:v>
                </c:pt>
                <c:pt idx="112">
                  <c:v>6776.13671875</c:v>
                </c:pt>
                <c:pt idx="113">
                  <c:v>6818.76123046875</c:v>
                </c:pt>
                <c:pt idx="114">
                  <c:v>6827.31689453125</c:v>
                </c:pt>
                <c:pt idx="115">
                  <c:v>6790.12451171875</c:v>
                </c:pt>
                <c:pt idx="116">
                  <c:v>6725.27099609375</c:v>
                </c:pt>
                <c:pt idx="117">
                  <c:v>6669.25732421875</c:v>
                </c:pt>
                <c:pt idx="118">
                  <c:v>6652.873046875</c:v>
                </c:pt>
                <c:pt idx="119">
                  <c:v>6681.43798828125</c:v>
                </c:pt>
                <c:pt idx="120">
                  <c:v>6732.7177734375</c:v>
                </c:pt>
                <c:pt idx="121">
                  <c:v>6772.78369140625</c:v>
                </c:pt>
                <c:pt idx="122">
                  <c:v>6777.8818359375</c:v>
                </c:pt>
                <c:pt idx="123">
                  <c:v>6747.595703125</c:v>
                </c:pt>
                <c:pt idx="124">
                  <c:v>6702.1767578125</c:v>
                </c:pt>
                <c:pt idx="125">
                  <c:v>6668.13330078125</c:v>
                </c:pt>
                <c:pt idx="126">
                  <c:v>6662.7578125</c:v>
                </c:pt>
                <c:pt idx="127">
                  <c:v>6686.60791015625</c:v>
                </c:pt>
                <c:pt idx="128">
                  <c:v>6726.0703125</c:v>
                </c:pt>
                <c:pt idx="129">
                  <c:v>6761.9521484375</c:v>
                </c:pt>
                <c:pt idx="130">
                  <c:v>6778.3818359375</c:v>
                </c:pt>
                <c:pt idx="131">
                  <c:v>6768.50341796875</c:v>
                </c:pt>
                <c:pt idx="132">
                  <c:v>6736.18212890625</c:v>
                </c:pt>
                <c:pt idx="133">
                  <c:v>6694.091796875</c:v>
                </c:pt>
                <c:pt idx="134">
                  <c:v>6658.66064453125</c:v>
                </c:pt>
                <c:pt idx="135">
                  <c:v>6643.119140625</c:v>
                </c:pt>
                <c:pt idx="136">
                  <c:v>6651.57763671875</c:v>
                </c:pt>
                <c:pt idx="137">
                  <c:v>6677.736328125</c:v>
                </c:pt>
                <c:pt idx="138">
                  <c:v>6709.572265625</c:v>
                </c:pt>
                <c:pt idx="139">
                  <c:v>6737.04296875</c:v>
                </c:pt>
                <c:pt idx="140">
                  <c:v>6757.0341796875</c:v>
                </c:pt>
                <c:pt idx="141">
                  <c:v>6771.66162109375</c:v>
                </c:pt>
                <c:pt idx="142">
                  <c:v>6781.79541015625</c:v>
                </c:pt>
                <c:pt idx="143">
                  <c:v>6782.50390625</c:v>
                </c:pt>
                <c:pt idx="144">
                  <c:v>6766.0712890625</c:v>
                </c:pt>
                <c:pt idx="145">
                  <c:v>6731.32763671875</c:v>
                </c:pt>
                <c:pt idx="146">
                  <c:v>6690.90771484375</c:v>
                </c:pt>
                <c:pt idx="147">
                  <c:v>6667.74462890625</c:v>
                </c:pt>
                <c:pt idx="148">
                  <c:v>6680.28515625</c:v>
                </c:pt>
                <c:pt idx="149">
                  <c:v>6726.525390625</c:v>
                </c:pt>
                <c:pt idx="150">
                  <c:v>6780.61669921875</c:v>
                </c:pt>
                <c:pt idx="151">
                  <c:v>6807.79443359375</c:v>
                </c:pt>
                <c:pt idx="152">
                  <c:v>6788.88037109375</c:v>
                </c:pt>
                <c:pt idx="153">
                  <c:v>6736.2021484375</c:v>
                </c:pt>
                <c:pt idx="154">
                  <c:v>6687.2294921875</c:v>
                </c:pt>
                <c:pt idx="155">
                  <c:v>6678.51025390625</c:v>
                </c:pt>
                <c:pt idx="156">
                  <c:v>6718.328125</c:v>
                </c:pt>
                <c:pt idx="157">
                  <c:v>6778.97216796875</c:v>
                </c:pt>
                <c:pt idx="158">
                  <c:v>6815.5576171875</c:v>
                </c:pt>
                <c:pt idx="159">
                  <c:v>6798.21142578125</c:v>
                </c:pt>
                <c:pt idx="160">
                  <c:v>6733.7890625</c:v>
                </c:pt>
                <c:pt idx="161">
                  <c:v>6660.8564453125</c:v>
                </c:pt>
                <c:pt idx="162">
                  <c:v>6621.85009765625</c:v>
                </c:pt>
                <c:pt idx="163">
                  <c:v>6633.50439453125</c:v>
                </c:pt>
                <c:pt idx="164">
                  <c:v>6677.4560546875</c:v>
                </c:pt>
                <c:pt idx="165">
                  <c:v>6716.99755859375</c:v>
                </c:pt>
                <c:pt idx="166">
                  <c:v>6725.958984375</c:v>
                </c:pt>
                <c:pt idx="167">
                  <c:v>6707.2607421875</c:v>
                </c:pt>
                <c:pt idx="168">
                  <c:v>6687.794921875</c:v>
                </c:pt>
                <c:pt idx="169">
                  <c:v>6695.1689453125</c:v>
                </c:pt>
                <c:pt idx="170">
                  <c:v>6735.3330078125</c:v>
                </c:pt>
                <c:pt idx="171">
                  <c:v>6788.1845703125</c:v>
                </c:pt>
                <c:pt idx="172">
                  <c:v>6823.3486328125</c:v>
                </c:pt>
                <c:pt idx="173">
                  <c:v>6822.80908203125</c:v>
                </c:pt>
                <c:pt idx="174">
                  <c:v>6792.8603515625</c:v>
                </c:pt>
                <c:pt idx="175">
                  <c:v>6757.24072265625</c:v>
                </c:pt>
                <c:pt idx="176">
                  <c:v>6738.04638671875</c:v>
                </c:pt>
                <c:pt idx="177">
                  <c:v>6739.5458984375</c:v>
                </c:pt>
                <c:pt idx="178">
                  <c:v>6746.6220703125</c:v>
                </c:pt>
                <c:pt idx="179">
                  <c:v>6737.92919921875</c:v>
                </c:pt>
                <c:pt idx="180">
                  <c:v>6703.32373046875</c:v>
                </c:pt>
                <c:pt idx="181">
                  <c:v>6652.96630859375</c:v>
                </c:pt>
                <c:pt idx="182">
                  <c:v>6612.11279296875</c:v>
                </c:pt>
                <c:pt idx="183">
                  <c:v>6605.46923828125</c:v>
                </c:pt>
                <c:pt idx="184">
                  <c:v>6641.3154296875</c:v>
                </c:pt>
                <c:pt idx="185">
                  <c:v>6705.18115234375</c:v>
                </c:pt>
                <c:pt idx="186">
                  <c:v>6766.876953125</c:v>
                </c:pt>
                <c:pt idx="187">
                  <c:v>6797.06103515625</c:v>
                </c:pt>
                <c:pt idx="188">
                  <c:v>6784.16650390625</c:v>
                </c:pt>
                <c:pt idx="189">
                  <c:v>6741.88525390625</c:v>
                </c:pt>
                <c:pt idx="190">
                  <c:v>6702.00830078125</c:v>
                </c:pt>
                <c:pt idx="191">
                  <c:v>6695.54443359375</c:v>
                </c:pt>
                <c:pt idx="192">
                  <c:v>6732.64306640625</c:v>
                </c:pt>
                <c:pt idx="193">
                  <c:v>6794.0693359375</c:v>
                </c:pt>
                <c:pt idx="194">
                  <c:v>6841.07958984375</c:v>
                </c:pt>
                <c:pt idx="195">
                  <c:v>6838.970703125</c:v>
                </c:pt>
                <c:pt idx="196">
                  <c:v>6779.64990234375</c:v>
                </c:pt>
                <c:pt idx="197">
                  <c:v>6687.9423828125</c:v>
                </c:pt>
                <c:pt idx="198">
                  <c:v>6606.78564453125</c:v>
                </c:pt>
                <c:pt idx="199">
                  <c:v>6571.2451171875</c:v>
                </c:pt>
                <c:pt idx="200">
                  <c:v>6589.3798828125</c:v>
                </c:pt>
                <c:pt idx="201">
                  <c:v>6642.640625</c:v>
                </c:pt>
                <c:pt idx="202">
                  <c:v>6703.3720703125</c:v>
                </c:pt>
                <c:pt idx="203">
                  <c:v>6754.0263671875</c:v>
                </c:pt>
                <c:pt idx="204">
                  <c:v>6792.6572265625</c:v>
                </c:pt>
                <c:pt idx="205">
                  <c:v>6822.3583984375</c:v>
                </c:pt>
                <c:pt idx="206">
                  <c:v>6837.2822265625</c:v>
                </c:pt>
                <c:pt idx="207">
                  <c:v>6821.33251953125</c:v>
                </c:pt>
                <c:pt idx="208">
                  <c:v>6763.6728515625</c:v>
                </c:pt>
                <c:pt idx="209">
                  <c:v>6677.8681640625</c:v>
                </c:pt>
                <c:pt idx="210">
                  <c:v>6604.66357421875</c:v>
                </c:pt>
                <c:pt idx="211">
                  <c:v>6589.955078125</c:v>
                </c:pt>
                <c:pt idx="212">
                  <c:v>6651.16357421875</c:v>
                </c:pt>
                <c:pt idx="213">
                  <c:v>6758.5615234375</c:v>
                </c:pt>
                <c:pt idx="214">
                  <c:v>6849.90185546875</c:v>
                </c:pt>
                <c:pt idx="215">
                  <c:v>6871.4580078125</c:v>
                </c:pt>
                <c:pt idx="216">
                  <c:v>6816.07861328125</c:v>
                </c:pt>
                <c:pt idx="217">
                  <c:v>6728.5849609375</c:v>
                </c:pt>
                <c:pt idx="218">
                  <c:v>6672.80126953125</c:v>
                </c:pt>
                <c:pt idx="219">
                  <c:v>6684.56689453125</c:v>
                </c:pt>
                <c:pt idx="220">
                  <c:v>6746.78271484375</c:v>
                </c:pt>
                <c:pt idx="221">
                  <c:v>6805.5732421875</c:v>
                </c:pt>
                <c:pt idx="222">
                  <c:v>6814.064453125</c:v>
                </c:pt>
                <c:pt idx="223">
                  <c:v>6768.40283203125</c:v>
                </c:pt>
                <c:pt idx="224">
                  <c:v>6707.53369140625</c:v>
                </c:pt>
                <c:pt idx="225">
                  <c:v>6678.29345703125</c:v>
                </c:pt>
                <c:pt idx="226">
                  <c:v>6695.8046875</c:v>
                </c:pt>
                <c:pt idx="227">
                  <c:v>6732.328125</c:v>
                </c:pt>
                <c:pt idx="228">
                  <c:v>6743.23681640625</c:v>
                </c:pt>
                <c:pt idx="229">
                  <c:v>6707.26611328125</c:v>
                </c:pt>
                <c:pt idx="230">
                  <c:v>6646.3115234375</c:v>
                </c:pt>
                <c:pt idx="231">
                  <c:v>6607.650390625</c:v>
                </c:pt>
                <c:pt idx="232">
                  <c:v>6623.6162109375</c:v>
                </c:pt>
                <c:pt idx="233">
                  <c:v>6683.0810546875</c:v>
                </c:pt>
                <c:pt idx="234">
                  <c:v>6739.29052734375</c:v>
                </c:pt>
                <c:pt idx="235">
                  <c:v>6747.97705078125</c:v>
                </c:pt>
                <c:pt idx="236">
                  <c:v>6704.17626953125</c:v>
                </c:pt>
                <c:pt idx="237">
                  <c:v>6647.16357421875</c:v>
                </c:pt>
                <c:pt idx="238">
                  <c:v>6629.41455078125</c:v>
                </c:pt>
                <c:pt idx="239">
                  <c:v>6674.9951171875</c:v>
                </c:pt>
                <c:pt idx="240">
                  <c:v>6760.861328125</c:v>
                </c:pt>
                <c:pt idx="241">
                  <c:v>6835.072265625</c:v>
                </c:pt>
                <c:pt idx="242">
                  <c:v>6855.8544921875</c:v>
                </c:pt>
                <c:pt idx="243">
                  <c:v>6819.92626953125</c:v>
                </c:pt>
                <c:pt idx="244">
                  <c:v>6759.36474609375</c:v>
                </c:pt>
                <c:pt idx="245">
                  <c:v>6713.0283203125</c:v>
                </c:pt>
                <c:pt idx="246">
                  <c:v>6698.0615234375</c:v>
                </c:pt>
                <c:pt idx="247">
                  <c:v>6703.77978515625</c:v>
                </c:pt>
                <c:pt idx="248">
                  <c:v>6709.00927734375</c:v>
                </c:pt>
                <c:pt idx="249">
                  <c:v>6704.27978515625</c:v>
                </c:pt>
                <c:pt idx="250">
                  <c:v>6698.751953125</c:v>
                </c:pt>
                <c:pt idx="251">
                  <c:v>6707.943359375</c:v>
                </c:pt>
                <c:pt idx="252">
                  <c:v>6736.20458984375</c:v>
                </c:pt>
                <c:pt idx="253">
                  <c:v>6771.29541015625</c:v>
                </c:pt>
                <c:pt idx="254">
                  <c:v>6795.36083984375</c:v>
                </c:pt>
                <c:pt idx="255">
                  <c:v>6800.48095703125</c:v>
                </c:pt>
                <c:pt idx="256">
                  <c:v>6793.23193359375</c:v>
                </c:pt>
                <c:pt idx="257">
                  <c:v>6784.4541015625</c:v>
                </c:pt>
                <c:pt idx="258">
                  <c:v>6775.7666015625</c:v>
                </c:pt>
                <c:pt idx="259">
                  <c:v>6757.89404296875</c:v>
                </c:pt>
                <c:pt idx="260">
                  <c:v>6723.7548828125</c:v>
                </c:pt>
                <c:pt idx="261">
                  <c:v>6683.08056640625</c:v>
                </c:pt>
                <c:pt idx="262">
                  <c:v>6661.4482421875</c:v>
                </c:pt>
                <c:pt idx="263">
                  <c:v>6680.25634765625</c:v>
                </c:pt>
                <c:pt idx="264">
                  <c:v>6733.609375</c:v>
                </c:pt>
                <c:pt idx="265">
                  <c:v>6784.68505859375</c:v>
                </c:pt>
                <c:pt idx="266">
                  <c:v>6789.705078125</c:v>
                </c:pt>
                <c:pt idx="267">
                  <c:v>6733.17919921875</c:v>
                </c:pt>
                <c:pt idx="268">
                  <c:v>6645.2119140625</c:v>
                </c:pt>
                <c:pt idx="269">
                  <c:v>6583.5283203125</c:v>
                </c:pt>
                <c:pt idx="270">
                  <c:v>6591.36181640625</c:v>
                </c:pt>
                <c:pt idx="271">
                  <c:v>6663.80419921875</c:v>
                </c:pt>
                <c:pt idx="272">
                  <c:v>6750.4306640625</c:v>
                </c:pt>
                <c:pt idx="273">
                  <c:v>6793.44677734375</c:v>
                </c:pt>
                <c:pt idx="274">
                  <c:v>6771.41845703125</c:v>
                </c:pt>
                <c:pt idx="275">
                  <c:v>6713.51025390625</c:v>
                </c:pt>
                <c:pt idx="276">
                  <c:v>6673.0888671875</c:v>
                </c:pt>
                <c:pt idx="277">
                  <c:v>6682.9609375</c:v>
                </c:pt>
                <c:pt idx="278">
                  <c:v>6729.45263671875</c:v>
                </c:pt>
                <c:pt idx="279">
                  <c:v>6766.35791015625</c:v>
                </c:pt>
                <c:pt idx="280">
                  <c:v>6756.1162109375</c:v>
                </c:pt>
                <c:pt idx="281">
                  <c:v>6702.89404296875</c:v>
                </c:pt>
                <c:pt idx="282">
                  <c:v>6649.619140625</c:v>
                </c:pt>
                <c:pt idx="283">
                  <c:v>6641.96826171875</c:v>
                </c:pt>
                <c:pt idx="284">
                  <c:v>6690.27587890625</c:v>
                </c:pt>
                <c:pt idx="285">
                  <c:v>6761.61669921875</c:v>
                </c:pt>
                <c:pt idx="286">
                  <c:v>6808.10546875</c:v>
                </c:pt>
                <c:pt idx="287">
                  <c:v>6806.54296875</c:v>
                </c:pt>
                <c:pt idx="288">
                  <c:v>6775.37109375</c:v>
                </c:pt>
                <c:pt idx="289">
                  <c:v>6755.07275390625</c:v>
                </c:pt>
                <c:pt idx="290">
                  <c:v>6769.95263671875</c:v>
                </c:pt>
                <c:pt idx="291">
                  <c:v>6805.1689453125</c:v>
                </c:pt>
                <c:pt idx="292">
                  <c:v>6819.37646484375</c:v>
                </c:pt>
                <c:pt idx="293">
                  <c:v>6782.2529296875</c:v>
                </c:pt>
                <c:pt idx="294">
                  <c:v>6704.365234375</c:v>
                </c:pt>
                <c:pt idx="295">
                  <c:v>6633.00390625</c:v>
                </c:pt>
                <c:pt idx="296">
                  <c:v>6616.38818359375</c:v>
                </c:pt>
                <c:pt idx="297">
                  <c:v>6665.4384765625</c:v>
                </c:pt>
                <c:pt idx="298">
                  <c:v>6744.5205078125</c:v>
                </c:pt>
                <c:pt idx="299">
                  <c:v>6798.576171875</c:v>
                </c:pt>
                <c:pt idx="300">
                  <c:v>6794.40576171875</c:v>
                </c:pt>
                <c:pt idx="301">
                  <c:v>6743.1533203125</c:v>
                </c:pt>
                <c:pt idx="302">
                  <c:v>6687.54345703125</c:v>
                </c:pt>
                <c:pt idx="303">
                  <c:v>6666.3837890625</c:v>
                </c:pt>
                <c:pt idx="304">
                  <c:v>6686.052734375</c:v>
                </c:pt>
                <c:pt idx="305">
                  <c:v>6720.6953125</c:v>
                </c:pt>
                <c:pt idx="306">
                  <c:v>6737.875</c:v>
                </c:pt>
                <c:pt idx="307">
                  <c:v>6726.17138671875</c:v>
                </c:pt>
                <c:pt idx="308">
                  <c:v>6701.9560546875</c:v>
                </c:pt>
                <c:pt idx="309">
                  <c:v>6692.02197265625</c:v>
                </c:pt>
                <c:pt idx="310">
                  <c:v>6709.1513671875</c:v>
                </c:pt>
                <c:pt idx="311">
                  <c:v>6741.92333984375</c:v>
                </c:pt>
                <c:pt idx="312">
                  <c:v>6766.02685546875</c:v>
                </c:pt>
                <c:pt idx="313">
                  <c:v>6765.48046875</c:v>
                </c:pt>
                <c:pt idx="314">
                  <c:v>6744.94677734375</c:v>
                </c:pt>
                <c:pt idx="315">
                  <c:v>6723.7724609375</c:v>
                </c:pt>
                <c:pt idx="316">
                  <c:v>6718.79541015625</c:v>
                </c:pt>
                <c:pt idx="317">
                  <c:v>6731.5810546875</c:v>
                </c:pt>
                <c:pt idx="318">
                  <c:v>6749.939453125</c:v>
                </c:pt>
                <c:pt idx="319">
                  <c:v>6760.0185546875</c:v>
                </c:pt>
                <c:pt idx="320">
                  <c:v>6756.76318359375</c:v>
                </c:pt>
                <c:pt idx="321">
                  <c:v>6744.12060546875</c:v>
                </c:pt>
                <c:pt idx="322">
                  <c:v>6727.35546875</c:v>
                </c:pt>
                <c:pt idx="323">
                  <c:v>6707.11572265625</c:v>
                </c:pt>
                <c:pt idx="324">
                  <c:v>6681.74658203125</c:v>
                </c:pt>
                <c:pt idx="325">
                  <c:v>6654.62939453125</c:v>
                </c:pt>
                <c:pt idx="326">
                  <c:v>6637.185546875</c:v>
                </c:pt>
                <c:pt idx="327">
                  <c:v>6642.1328125</c:v>
                </c:pt>
                <c:pt idx="328">
                  <c:v>6671.90576171875</c:v>
                </c:pt>
                <c:pt idx="329">
                  <c:v>6713.4716796875</c:v>
                </c:pt>
                <c:pt idx="330">
                  <c:v>6746.208984375</c:v>
                </c:pt>
                <c:pt idx="331">
                  <c:v>6757.521484375</c:v>
                </c:pt>
                <c:pt idx="332">
                  <c:v>6752.65380859375</c:v>
                </c:pt>
                <c:pt idx="333">
                  <c:v>6749.115234375</c:v>
                </c:pt>
                <c:pt idx="334">
                  <c:v>6759.63916015625</c:v>
                </c:pt>
                <c:pt idx="335">
                  <c:v>6778.7314453125</c:v>
                </c:pt>
                <c:pt idx="336">
                  <c:v>6785.89990234375</c:v>
                </c:pt>
                <c:pt idx="337">
                  <c:v>6764.32763671875</c:v>
                </c:pt>
                <c:pt idx="338">
                  <c:v>6719.24169921875</c:v>
                </c:pt>
                <c:pt idx="339">
                  <c:v>6678.76806640625</c:v>
                </c:pt>
                <c:pt idx="340">
                  <c:v>6674.0830078125</c:v>
                </c:pt>
                <c:pt idx="341">
                  <c:v>6713.77685546875</c:v>
                </c:pt>
                <c:pt idx="342">
                  <c:v>6773.8408203125</c:v>
                </c:pt>
                <c:pt idx="343">
                  <c:v>6813.15185546875</c:v>
                </c:pt>
                <c:pt idx="344">
                  <c:v>6803.6572265625</c:v>
                </c:pt>
                <c:pt idx="345">
                  <c:v>6751.79150390625</c:v>
                </c:pt>
                <c:pt idx="346">
                  <c:v>6693.919921875</c:v>
                </c:pt>
                <c:pt idx="347">
                  <c:v>6669.0595703125</c:v>
                </c:pt>
                <c:pt idx="348">
                  <c:v>6690.17236328125</c:v>
                </c:pt>
                <c:pt idx="349">
                  <c:v>6736.17822265625</c:v>
                </c:pt>
              </c:numCache>
            </c:numRef>
          </c:yVal>
          <c:smooth val="1"/>
          <c:extLst>
            <c:ext xmlns:c16="http://schemas.microsoft.com/office/drawing/2014/chart" uri="{C3380CC4-5D6E-409C-BE32-E72D297353CC}">
              <c16:uniqueId val="{0000000B-4A37-429A-A58F-F7AEDA5D1ACA}"/>
            </c:ext>
          </c:extLst>
        </c:ser>
        <c:ser>
          <c:idx val="12"/>
          <c:order val="12"/>
          <c:tx>
            <c:strRef>
              <c:f>cp_sub_001!$M$1</c:f>
              <c:strCache>
                <c:ptCount val="1"/>
                <c:pt idx="0">
                  <c:v>Coor_13</c:v>
                </c:pt>
              </c:strCache>
            </c:strRef>
          </c:tx>
          <c:spPr>
            <a:ln w="28575" cap="rnd">
              <a:solidFill>
                <a:schemeClr val="accent1">
                  <a:lumMod val="80000"/>
                  <a:lumOff val="20000"/>
                </a:schemeClr>
              </a:solidFill>
              <a:round/>
            </a:ln>
            <a:effectLst/>
          </c:spPr>
          <c:marker>
            <c:symbol val="none"/>
          </c:marker>
          <c:yVal>
            <c:numRef>
              <c:f>cp_sub_001!$M$2:$M$351</c:f>
              <c:numCache>
                <c:formatCode>0.00000000000_ </c:formatCode>
                <c:ptCount val="350"/>
                <c:pt idx="0">
                  <c:v>4627.56884765625</c:v>
                </c:pt>
                <c:pt idx="1">
                  <c:v>4541.302734375</c:v>
                </c:pt>
                <c:pt idx="2">
                  <c:v>4525.22412109375</c:v>
                </c:pt>
                <c:pt idx="3">
                  <c:v>4607.7841796875</c:v>
                </c:pt>
                <c:pt idx="4">
                  <c:v>4757.205078125</c:v>
                </c:pt>
                <c:pt idx="5">
                  <c:v>4896.89404296875</c:v>
                </c:pt>
                <c:pt idx="6">
                  <c:v>4953.66357421875</c:v>
                </c:pt>
                <c:pt idx="7">
                  <c:v>4904.75390625</c:v>
                </c:pt>
                <c:pt idx="8">
                  <c:v>4789.72119140625</c:v>
                </c:pt>
                <c:pt idx="9">
                  <c:v>4679.57421875</c:v>
                </c:pt>
                <c:pt idx="10">
                  <c:v>4627.6201171875</c:v>
                </c:pt>
                <c:pt idx="11">
                  <c:v>4638.8779296875</c:v>
                </c:pt>
                <c:pt idx="12">
                  <c:v>4678.31591796875</c:v>
                </c:pt>
                <c:pt idx="13">
                  <c:v>4706.65673828125</c:v>
                </c:pt>
                <c:pt idx="14">
                  <c:v>4712.0419921875</c:v>
                </c:pt>
                <c:pt idx="15">
                  <c:v>4712.46044921875</c:v>
                </c:pt>
                <c:pt idx="16">
                  <c:v>4730.6640625</c:v>
                </c:pt>
                <c:pt idx="17">
                  <c:v>4766.87548828125</c:v>
                </c:pt>
                <c:pt idx="18">
                  <c:v>4795.017578125</c:v>
                </c:pt>
                <c:pt idx="19">
                  <c:v>4786.00927734375</c:v>
                </c:pt>
                <c:pt idx="20">
                  <c:v>4736.81298828125</c:v>
                </c:pt>
                <c:pt idx="21">
                  <c:v>4678.294921875</c:v>
                </c:pt>
                <c:pt idx="22">
                  <c:v>4653.3154296875</c:v>
                </c:pt>
                <c:pt idx="23">
                  <c:v>4682.68408203125</c:v>
                </c:pt>
                <c:pt idx="24">
                  <c:v>4747.6591796875</c:v>
                </c:pt>
                <c:pt idx="25">
                  <c:v>4803.96240234375</c:v>
                </c:pt>
                <c:pt idx="26">
                  <c:v>4815.68359375</c:v>
                </c:pt>
                <c:pt idx="27">
                  <c:v>4780.98779296875</c:v>
                </c:pt>
                <c:pt idx="28">
                  <c:v>4729.23828125</c:v>
                </c:pt>
                <c:pt idx="29">
                  <c:v>4693.96875</c:v>
                </c:pt>
                <c:pt idx="30">
                  <c:v>4686.29052734375</c:v>
                </c:pt>
                <c:pt idx="31">
                  <c:v>4691.45703125</c:v>
                </c:pt>
                <c:pt idx="32">
                  <c:v>4689.5634765625</c:v>
                </c:pt>
                <c:pt idx="33">
                  <c:v>4679.35498046875</c:v>
                </c:pt>
                <c:pt idx="34">
                  <c:v>4681.5703125</c:v>
                </c:pt>
                <c:pt idx="35">
                  <c:v>4717.46484375</c:v>
                </c:pt>
                <c:pt idx="36">
                  <c:v>4782.00146484375</c:v>
                </c:pt>
                <c:pt idx="37">
                  <c:v>4838.029296875</c:v>
                </c:pt>
                <c:pt idx="38">
                  <c:v>4840.66064453125</c:v>
                </c:pt>
                <c:pt idx="39">
                  <c:v>4774.20654296875</c:v>
                </c:pt>
                <c:pt idx="40">
                  <c:v>4670.814453125</c:v>
                </c:pt>
                <c:pt idx="41">
                  <c:v>4592.7431640625</c:v>
                </c:pt>
                <c:pt idx="42">
                  <c:v>4589.2587890625</c:v>
                </c:pt>
                <c:pt idx="43">
                  <c:v>4660.59765625</c:v>
                </c:pt>
                <c:pt idx="44">
                  <c:v>4757.17431640625</c:v>
                </c:pt>
                <c:pt idx="45">
                  <c:v>4815.19970703125</c:v>
                </c:pt>
                <c:pt idx="46">
                  <c:v>4801.77197265625</c:v>
                </c:pt>
                <c:pt idx="47">
                  <c:v>4735.77880859375</c:v>
                </c:pt>
                <c:pt idx="48">
                  <c:v>4670.44873046875</c:v>
                </c:pt>
                <c:pt idx="49">
                  <c:v>4652.91259765625</c:v>
                </c:pt>
                <c:pt idx="50">
                  <c:v>4692.18359375</c:v>
                </c:pt>
                <c:pt idx="51">
                  <c:v>4757.92626953125</c:v>
                </c:pt>
                <c:pt idx="52">
                  <c:v>4807.0986328125</c:v>
                </c:pt>
                <c:pt idx="53">
                  <c:v>4815.109375</c:v>
                </c:pt>
                <c:pt idx="54">
                  <c:v>4787.9091796875</c:v>
                </c:pt>
                <c:pt idx="55">
                  <c:v>4749.44873046875</c:v>
                </c:pt>
                <c:pt idx="56">
                  <c:v>4718.91064453125</c:v>
                </c:pt>
                <c:pt idx="57">
                  <c:v>4697.85595703125</c:v>
                </c:pt>
                <c:pt idx="58">
                  <c:v>4676.09326171875</c:v>
                </c:pt>
                <c:pt idx="59">
                  <c:v>4647.97119140625</c:v>
                </c:pt>
                <c:pt idx="60">
                  <c:v>4622.70947265625</c:v>
                </c:pt>
                <c:pt idx="61">
                  <c:v>4619.12109375</c:v>
                </c:pt>
                <c:pt idx="62">
                  <c:v>4649.4248046875</c:v>
                </c:pt>
                <c:pt idx="63">
                  <c:v>4706.22021484375</c:v>
                </c:pt>
                <c:pt idx="64">
                  <c:v>4763.75</c:v>
                </c:pt>
                <c:pt idx="65">
                  <c:v>4792.94189453125</c:v>
                </c:pt>
                <c:pt idx="66">
                  <c:v>4779.41552734375</c:v>
                </c:pt>
                <c:pt idx="67">
                  <c:v>4732.36328125</c:v>
                </c:pt>
                <c:pt idx="68">
                  <c:v>4679.44775390625</c:v>
                </c:pt>
                <c:pt idx="69">
                  <c:v>4651.9775390625</c:v>
                </c:pt>
                <c:pt idx="70">
                  <c:v>4669.1396484375</c:v>
                </c:pt>
                <c:pt idx="71">
                  <c:v>4728.7138671875</c:v>
                </c:pt>
                <c:pt idx="72">
                  <c:v>4807.50634765625</c:v>
                </c:pt>
                <c:pt idx="73">
                  <c:v>4871.0126953125</c:v>
                </c:pt>
                <c:pt idx="74">
                  <c:v>4889.11376953125</c:v>
                </c:pt>
                <c:pt idx="75">
                  <c:v>4851.923828125</c:v>
                </c:pt>
                <c:pt idx="76">
                  <c:v>4777.8046875</c:v>
                </c:pt>
                <c:pt idx="77">
                  <c:v>4706.87060546875</c:v>
                </c:pt>
                <c:pt idx="78">
                  <c:v>4680.208984375</c:v>
                </c:pt>
                <c:pt idx="79">
                  <c:v>4714.89404296875</c:v>
                </c:pt>
                <c:pt idx="80">
                  <c:v>4790.60546875</c:v>
                </c:pt>
                <c:pt idx="81">
                  <c:v>4858.8955078125</c:v>
                </c:pt>
                <c:pt idx="82">
                  <c:v>4871.83203125</c:v>
                </c:pt>
                <c:pt idx="83">
                  <c:v>4812.3544921875</c:v>
                </c:pt>
                <c:pt idx="84">
                  <c:v>4705.6630859375</c:v>
                </c:pt>
                <c:pt idx="85">
                  <c:v>4603.12841796875</c:v>
                </c:pt>
                <c:pt idx="86">
                  <c:v>4549.61328125</c:v>
                </c:pt>
                <c:pt idx="87">
                  <c:v>4557.07177734375</c:v>
                </c:pt>
                <c:pt idx="88">
                  <c:v>4602.3251953125</c:v>
                </c:pt>
                <c:pt idx="89">
                  <c:v>4648.556640625</c:v>
                </c:pt>
                <c:pt idx="90">
                  <c:v>4672.625</c:v>
                </c:pt>
                <c:pt idx="91">
                  <c:v>4677.45458984375</c:v>
                </c:pt>
                <c:pt idx="92">
                  <c:v>4682.18994140625</c:v>
                </c:pt>
                <c:pt idx="93">
                  <c:v>4701.08984375</c:v>
                </c:pt>
                <c:pt idx="94">
                  <c:v>4730.119140625</c:v>
                </c:pt>
                <c:pt idx="95">
                  <c:v>4751.88037109375</c:v>
                </c:pt>
                <c:pt idx="96">
                  <c:v>4752.76171875</c:v>
                </c:pt>
                <c:pt idx="97">
                  <c:v>4735.76708984375</c:v>
                </c:pt>
                <c:pt idx="98">
                  <c:v>4717.22998046875</c:v>
                </c:pt>
                <c:pt idx="99">
                  <c:v>4710.89013671875</c:v>
                </c:pt>
                <c:pt idx="100">
                  <c:v>4714.6875</c:v>
                </c:pt>
                <c:pt idx="101">
                  <c:v>4713.3642578125</c:v>
                </c:pt>
                <c:pt idx="102">
                  <c:v>4695.37158203125</c:v>
                </c:pt>
                <c:pt idx="103">
                  <c:v>4668.65283203125</c:v>
                </c:pt>
                <c:pt idx="104">
                  <c:v>4659.421875</c:v>
                </c:pt>
                <c:pt idx="105">
                  <c:v>4692.2021484375</c:v>
                </c:pt>
                <c:pt idx="106">
                  <c:v>4766.40380859375</c:v>
                </c:pt>
                <c:pt idx="107">
                  <c:v>4849.71435546875</c:v>
                </c:pt>
                <c:pt idx="108">
                  <c:v>4896.4169921875</c:v>
                </c:pt>
                <c:pt idx="109">
                  <c:v>4878.7802734375</c:v>
                </c:pt>
                <c:pt idx="110">
                  <c:v>4808.1259765625</c:v>
                </c:pt>
                <c:pt idx="111">
                  <c:v>4728.9208984375</c:v>
                </c:pt>
                <c:pt idx="112">
                  <c:v>4689.314453125</c:v>
                </c:pt>
                <c:pt idx="113">
                  <c:v>4709.26318359375</c:v>
                </c:pt>
                <c:pt idx="114">
                  <c:v>4768.998046875</c:v>
                </c:pt>
                <c:pt idx="115">
                  <c:v>4825.07275390625</c:v>
                </c:pt>
                <c:pt idx="116">
                  <c:v>4840.99267578125</c:v>
                </c:pt>
                <c:pt idx="117">
                  <c:v>4809.86962890625</c:v>
                </c:pt>
                <c:pt idx="118">
                  <c:v>4754.23974609375</c:v>
                </c:pt>
                <c:pt idx="119">
                  <c:v>4706.02392578125</c:v>
                </c:pt>
                <c:pt idx="120">
                  <c:v>4683.525390625</c:v>
                </c:pt>
                <c:pt idx="121">
                  <c:v>4682.3271484375</c:v>
                </c:pt>
                <c:pt idx="122">
                  <c:v>4684.50244140625</c:v>
                </c:pt>
                <c:pt idx="123">
                  <c:v>4676.3095703125</c:v>
                </c:pt>
                <c:pt idx="124">
                  <c:v>4659.462890625</c:v>
                </c:pt>
                <c:pt idx="125">
                  <c:v>4647.82666015625</c:v>
                </c:pt>
                <c:pt idx="126">
                  <c:v>4653.65625</c:v>
                </c:pt>
                <c:pt idx="127">
                  <c:v>4675.36669921875</c:v>
                </c:pt>
                <c:pt idx="128">
                  <c:v>4696.8828125</c:v>
                </c:pt>
                <c:pt idx="129">
                  <c:v>4699.23876953125</c:v>
                </c:pt>
                <c:pt idx="130">
                  <c:v>4675.7470703125</c:v>
                </c:pt>
                <c:pt idx="131">
                  <c:v>4639.4384765625</c:v>
                </c:pt>
                <c:pt idx="132">
                  <c:v>4616.88916015625</c:v>
                </c:pt>
                <c:pt idx="133">
                  <c:v>4631.869140625</c:v>
                </c:pt>
                <c:pt idx="134">
                  <c:v>4689.1259765625</c:v>
                </c:pt>
                <c:pt idx="135">
                  <c:v>4768.8662109375</c:v>
                </c:pt>
                <c:pt idx="136">
                  <c:v>4836.126953125</c:v>
                </c:pt>
                <c:pt idx="137">
                  <c:v>4860.08740234375</c:v>
                </c:pt>
                <c:pt idx="138">
                  <c:v>4831.9638671875</c:v>
                </c:pt>
                <c:pt idx="139">
                  <c:v>4770.36962890625</c:v>
                </c:pt>
                <c:pt idx="140">
                  <c:v>4710.26318359375</c:v>
                </c:pt>
                <c:pt idx="141">
                  <c:v>4681.8505859375</c:v>
                </c:pt>
                <c:pt idx="142">
                  <c:v>4692.697265625</c:v>
                </c:pt>
                <c:pt idx="143">
                  <c:v>4724.86865234375</c:v>
                </c:pt>
                <c:pt idx="144">
                  <c:v>4749.2490234375</c:v>
                </c:pt>
                <c:pt idx="145">
                  <c:v>4747.29443359375</c:v>
                </c:pt>
                <c:pt idx="146">
                  <c:v>4724.71337890625</c:v>
                </c:pt>
                <c:pt idx="147">
                  <c:v>4706.7568359375</c:v>
                </c:pt>
                <c:pt idx="148">
                  <c:v>4718.02099609375</c:v>
                </c:pt>
                <c:pt idx="149">
                  <c:v>4761.54541015625</c:v>
                </c:pt>
                <c:pt idx="150">
                  <c:v>4813.380859375</c:v>
                </c:pt>
                <c:pt idx="151">
                  <c:v>4837.8603515625</c:v>
                </c:pt>
                <c:pt idx="152">
                  <c:v>4813.2421875</c:v>
                </c:pt>
                <c:pt idx="153">
                  <c:v>4748.908203125</c:v>
                </c:pt>
                <c:pt idx="154">
                  <c:v>4680.8310546875</c:v>
                </c:pt>
                <c:pt idx="155">
                  <c:v>4647.8095703125</c:v>
                </c:pt>
                <c:pt idx="156">
                  <c:v>4665.306640625</c:v>
                </c:pt>
                <c:pt idx="157">
                  <c:v>4715.60888671875</c:v>
                </c:pt>
                <c:pt idx="158">
                  <c:v>4761.02783203125</c:v>
                </c:pt>
                <c:pt idx="159">
                  <c:v>4770.09033203125</c:v>
                </c:pt>
                <c:pt idx="160">
                  <c:v>4737.78369140625</c:v>
                </c:pt>
                <c:pt idx="161">
                  <c:v>4686.27099609375</c:v>
                </c:pt>
                <c:pt idx="162">
                  <c:v>4647.39306640625</c:v>
                </c:pt>
                <c:pt idx="163">
                  <c:v>4641.025390625</c:v>
                </c:pt>
                <c:pt idx="164">
                  <c:v>4664.7392578125</c:v>
                </c:pt>
                <c:pt idx="165">
                  <c:v>4700.177734375</c:v>
                </c:pt>
                <c:pt idx="166">
                  <c:v>4728.8076171875</c:v>
                </c:pt>
                <c:pt idx="167">
                  <c:v>4744.07177734375</c:v>
                </c:pt>
                <c:pt idx="168">
                  <c:v>4751.7724609375</c:v>
                </c:pt>
                <c:pt idx="169">
                  <c:v>4760.74169921875</c:v>
                </c:pt>
                <c:pt idx="170">
                  <c:v>4772.9287109375</c:v>
                </c:pt>
                <c:pt idx="171">
                  <c:v>4781.0341796875</c:v>
                </c:pt>
                <c:pt idx="172">
                  <c:v>4774.736328125</c:v>
                </c:pt>
                <c:pt idx="173">
                  <c:v>4749.76416015625</c:v>
                </c:pt>
                <c:pt idx="174">
                  <c:v>4712.685546875</c:v>
                </c:pt>
                <c:pt idx="175">
                  <c:v>4678.29296875</c:v>
                </c:pt>
                <c:pt idx="176">
                  <c:v>4661.89013671875</c:v>
                </c:pt>
                <c:pt idx="177">
                  <c:v>4671.48388671875</c:v>
                </c:pt>
                <c:pt idx="178">
                  <c:v>4703.87890625</c:v>
                </c:pt>
                <c:pt idx="179">
                  <c:v>4745.9072265625</c:v>
                </c:pt>
                <c:pt idx="180">
                  <c:v>4779.80029296875</c:v>
                </c:pt>
                <c:pt idx="181">
                  <c:v>4790.68359375</c:v>
                </c:pt>
                <c:pt idx="182">
                  <c:v>4773.5029296875</c:v>
                </c:pt>
                <c:pt idx="183">
                  <c:v>4736.18603515625</c:v>
                </c:pt>
                <c:pt idx="184">
                  <c:v>4696.486328125</c:v>
                </c:pt>
                <c:pt idx="185">
                  <c:v>4672.8388671875</c:v>
                </c:pt>
                <c:pt idx="186">
                  <c:v>4673.76513671875</c:v>
                </c:pt>
                <c:pt idx="187">
                  <c:v>4692.6669921875</c:v>
                </c:pt>
                <c:pt idx="188">
                  <c:v>4712.43603515625</c:v>
                </c:pt>
                <c:pt idx="189">
                  <c:v>4717.6923828125</c:v>
                </c:pt>
                <c:pt idx="190">
                  <c:v>4706.31787109375</c:v>
                </c:pt>
                <c:pt idx="191">
                  <c:v>4691.4697265625</c:v>
                </c:pt>
                <c:pt idx="192">
                  <c:v>4691.83544921875</c:v>
                </c:pt>
                <c:pt idx="193">
                  <c:v>4716.8759765625</c:v>
                </c:pt>
                <c:pt idx="194">
                  <c:v>4758.17529296875</c:v>
                </c:pt>
                <c:pt idx="195">
                  <c:v>4793.7900390625</c:v>
                </c:pt>
                <c:pt idx="196">
                  <c:v>4802.71044921875</c:v>
                </c:pt>
                <c:pt idx="197">
                  <c:v>4778.859375</c:v>
                </c:pt>
                <c:pt idx="198">
                  <c:v>4734.62158203125</c:v>
                </c:pt>
                <c:pt idx="199">
                  <c:v>4692.15673828125</c:v>
                </c:pt>
                <c:pt idx="200">
                  <c:v>4669.80908203125</c:v>
                </c:pt>
                <c:pt idx="201">
                  <c:v>4673.55322265625</c:v>
                </c:pt>
                <c:pt idx="202">
                  <c:v>4698.02978515625</c:v>
                </c:pt>
                <c:pt idx="203">
                  <c:v>4733.5302734375</c:v>
                </c:pt>
                <c:pt idx="204">
                  <c:v>4771.5390625</c:v>
                </c:pt>
                <c:pt idx="205">
                  <c:v>4804.8564453125</c:v>
                </c:pt>
                <c:pt idx="206">
                  <c:v>4824.95068359375</c:v>
                </c:pt>
                <c:pt idx="207">
                  <c:v>4822.31005859375</c:v>
                </c:pt>
                <c:pt idx="208">
                  <c:v>4792.09375</c:v>
                </c:pt>
                <c:pt idx="209">
                  <c:v>4740.76806640625</c:v>
                </c:pt>
                <c:pt idx="210">
                  <c:v>4686.4990234375</c:v>
                </c:pt>
                <c:pt idx="211">
                  <c:v>4650.34375</c:v>
                </c:pt>
                <c:pt idx="212">
                  <c:v>4643.49169921875</c:v>
                </c:pt>
                <c:pt idx="213">
                  <c:v>4660.36669921875</c:v>
                </c:pt>
                <c:pt idx="214">
                  <c:v>4683.65478515625</c:v>
                </c:pt>
                <c:pt idx="215">
                  <c:v>4697.77001953125</c:v>
                </c:pt>
                <c:pt idx="216">
                  <c:v>4700.09130859375</c:v>
                </c:pt>
                <c:pt idx="217">
                  <c:v>4700.9541015625</c:v>
                </c:pt>
                <c:pt idx="218">
                  <c:v>4712.74658203125</c:v>
                </c:pt>
                <c:pt idx="219">
                  <c:v>4737.642578125</c:v>
                </c:pt>
                <c:pt idx="220">
                  <c:v>4764.50732421875</c:v>
                </c:pt>
                <c:pt idx="221">
                  <c:v>4777.48779296875</c:v>
                </c:pt>
                <c:pt idx="222">
                  <c:v>4768.75537109375</c:v>
                </c:pt>
                <c:pt idx="223">
                  <c:v>4744.55615234375</c:v>
                </c:pt>
                <c:pt idx="224">
                  <c:v>4719.87890625</c:v>
                </c:pt>
                <c:pt idx="225">
                  <c:v>4706.97412109375</c:v>
                </c:pt>
                <c:pt idx="226">
                  <c:v>4707.76123046875</c:v>
                </c:pt>
                <c:pt idx="227">
                  <c:v>4715.79833984375</c:v>
                </c:pt>
                <c:pt idx="228">
                  <c:v>4724.36181640625</c:v>
                </c:pt>
                <c:pt idx="229">
                  <c:v>4731.89990234375</c:v>
                </c:pt>
                <c:pt idx="230">
                  <c:v>4739.60791015625</c:v>
                </c:pt>
                <c:pt idx="231">
                  <c:v>4744.5546875</c:v>
                </c:pt>
                <c:pt idx="232">
                  <c:v>4737.09716796875</c:v>
                </c:pt>
                <c:pt idx="233">
                  <c:v>4707.66943359375</c:v>
                </c:pt>
                <c:pt idx="234">
                  <c:v>4658.4189453125</c:v>
                </c:pt>
                <c:pt idx="235">
                  <c:v>4608.69384765625</c:v>
                </c:pt>
                <c:pt idx="236">
                  <c:v>4586.89501953125</c:v>
                </c:pt>
                <c:pt idx="237">
                  <c:v>4612.54541015625</c:v>
                </c:pt>
                <c:pt idx="238">
                  <c:v>4681.8056640625</c:v>
                </c:pt>
                <c:pt idx="239">
                  <c:v>4768.32275390625</c:v>
                </c:pt>
                <c:pt idx="240">
                  <c:v>4839.5390625</c:v>
                </c:pt>
                <c:pt idx="241">
                  <c:v>4876.1533203125</c:v>
                </c:pt>
                <c:pt idx="242">
                  <c:v>4880.0849609375</c:v>
                </c:pt>
                <c:pt idx="243">
                  <c:v>4866.2216796875</c:v>
                </c:pt>
                <c:pt idx="244">
                  <c:v>4846.83984375</c:v>
                </c:pt>
                <c:pt idx="245">
                  <c:v>4822.9345703125</c:v>
                </c:pt>
                <c:pt idx="246">
                  <c:v>4789.2021484375</c:v>
                </c:pt>
                <c:pt idx="247">
                  <c:v>4746.052734375</c:v>
                </c:pt>
                <c:pt idx="248">
                  <c:v>4705.2333984375</c:v>
                </c:pt>
                <c:pt idx="249">
                  <c:v>4681.90283203125</c:v>
                </c:pt>
                <c:pt idx="250">
                  <c:v>4679.76416015625</c:v>
                </c:pt>
                <c:pt idx="251">
                  <c:v>4684.1337890625</c:v>
                </c:pt>
                <c:pt idx="252">
                  <c:v>4672.111328125</c:v>
                </c:pt>
                <c:pt idx="253">
                  <c:v>4633.4599609375</c:v>
                </c:pt>
                <c:pt idx="254">
                  <c:v>4584.2412109375</c:v>
                </c:pt>
                <c:pt idx="255">
                  <c:v>4559.0556640625</c:v>
                </c:pt>
                <c:pt idx="256">
                  <c:v>4585.08056640625</c:v>
                </c:pt>
                <c:pt idx="257">
                  <c:v>4657.767578125</c:v>
                </c:pt>
                <c:pt idx="258">
                  <c:v>4739.09423828125</c:v>
                </c:pt>
                <c:pt idx="259">
                  <c:v>4782.42041015625</c:v>
                </c:pt>
                <c:pt idx="260">
                  <c:v>4766.40087890625</c:v>
                </c:pt>
                <c:pt idx="261">
                  <c:v>4711.90673828125</c:v>
                </c:pt>
                <c:pt idx="262">
                  <c:v>4668.21923828125</c:v>
                </c:pt>
                <c:pt idx="263">
                  <c:v>4678.306640625</c:v>
                </c:pt>
                <c:pt idx="264">
                  <c:v>4748.92138671875</c:v>
                </c:pt>
                <c:pt idx="265">
                  <c:v>4846.88916015625</c:v>
                </c:pt>
                <c:pt idx="266">
                  <c:v>4922.369140625</c:v>
                </c:pt>
                <c:pt idx="267">
                  <c:v>4940.13916015625</c:v>
                </c:pt>
                <c:pt idx="268">
                  <c:v>4896.53857421875</c:v>
                </c:pt>
                <c:pt idx="269">
                  <c:v>4813.79052734375</c:v>
                </c:pt>
                <c:pt idx="270">
                  <c:v>4721.6630859375</c:v>
                </c:pt>
                <c:pt idx="271">
                  <c:v>4643.3505859375</c:v>
                </c:pt>
                <c:pt idx="272">
                  <c:v>4593.75146484375</c:v>
                </c:pt>
                <c:pt idx="273">
                  <c:v>4584.099609375</c:v>
                </c:pt>
                <c:pt idx="274">
                  <c:v>4621.3525390625</c:v>
                </c:pt>
                <c:pt idx="275">
                  <c:v>4698.95654296875</c:v>
                </c:pt>
                <c:pt idx="276">
                  <c:v>4788.71630859375</c:v>
                </c:pt>
                <c:pt idx="277">
                  <c:v>4847.30078125</c:v>
                </c:pt>
                <c:pt idx="278">
                  <c:v>4839.728515625</c:v>
                </c:pt>
                <c:pt idx="279">
                  <c:v>4765.02880859375</c:v>
                </c:pt>
                <c:pt idx="280">
                  <c:v>4662.55078125</c:v>
                </c:pt>
                <c:pt idx="281">
                  <c:v>4589.55712890625</c:v>
                </c:pt>
                <c:pt idx="282">
                  <c:v>4583.57861328125</c:v>
                </c:pt>
                <c:pt idx="283">
                  <c:v>4637.3896484375</c:v>
                </c:pt>
                <c:pt idx="284">
                  <c:v>4706.7353515625</c:v>
                </c:pt>
                <c:pt idx="285">
                  <c:v>4745.65576171875</c:v>
                </c:pt>
                <c:pt idx="286">
                  <c:v>4741.62109375</c:v>
                </c:pt>
                <c:pt idx="287">
                  <c:v>4722.04052734375</c:v>
                </c:pt>
                <c:pt idx="288">
                  <c:v>4726.77978515625</c:v>
                </c:pt>
                <c:pt idx="289">
                  <c:v>4769.6865234375</c:v>
                </c:pt>
                <c:pt idx="290">
                  <c:v>4822.1533203125</c:v>
                </c:pt>
                <c:pt idx="291">
                  <c:v>4834.224609375</c:v>
                </c:pt>
                <c:pt idx="292">
                  <c:v>4777.41796875</c:v>
                </c:pt>
                <c:pt idx="293">
                  <c:v>4674.08837890625</c:v>
                </c:pt>
                <c:pt idx="294">
                  <c:v>4587.408203125</c:v>
                </c:pt>
                <c:pt idx="295">
                  <c:v>4577.18017578125</c:v>
                </c:pt>
                <c:pt idx="296">
                  <c:v>4654.78662109375</c:v>
                </c:pt>
                <c:pt idx="297">
                  <c:v>4772.5859375</c:v>
                </c:pt>
                <c:pt idx="298">
                  <c:v>4856.85546875</c:v>
                </c:pt>
                <c:pt idx="299">
                  <c:v>4859.63525390625</c:v>
                </c:pt>
                <c:pt idx="300">
                  <c:v>4790.3935546875</c:v>
                </c:pt>
                <c:pt idx="301">
                  <c:v>4704.55029296875</c:v>
                </c:pt>
                <c:pt idx="302">
                  <c:v>4659.5185546875</c:v>
                </c:pt>
                <c:pt idx="303">
                  <c:v>4673.244140625</c:v>
                </c:pt>
                <c:pt idx="304">
                  <c:v>4716.52783203125</c:v>
                </c:pt>
                <c:pt idx="305">
                  <c:v>4742.53662109375</c:v>
                </c:pt>
                <c:pt idx="306">
                  <c:v>4727.6953125</c:v>
                </c:pt>
                <c:pt idx="307">
                  <c:v>4690.5478515625</c:v>
                </c:pt>
                <c:pt idx="308">
                  <c:v>4674.3125</c:v>
                </c:pt>
                <c:pt idx="309">
                  <c:v>4708.51123046875</c:v>
                </c:pt>
                <c:pt idx="310">
                  <c:v>4781.43359375</c:v>
                </c:pt>
                <c:pt idx="311">
                  <c:v>4845.9150390625</c:v>
                </c:pt>
                <c:pt idx="312">
                  <c:v>4854.15771484375</c:v>
                </c:pt>
                <c:pt idx="313">
                  <c:v>4794.552734375</c:v>
                </c:pt>
                <c:pt idx="314">
                  <c:v>4702.18408203125</c:v>
                </c:pt>
                <c:pt idx="315">
                  <c:v>4635.06640625</c:v>
                </c:pt>
                <c:pt idx="316">
                  <c:v>4633.939453125</c:v>
                </c:pt>
                <c:pt idx="317">
                  <c:v>4695.03369140625</c:v>
                </c:pt>
                <c:pt idx="318">
                  <c:v>4774.71142578125</c:v>
                </c:pt>
                <c:pt idx="319">
                  <c:v>4821.17529296875</c:v>
                </c:pt>
                <c:pt idx="320">
                  <c:v>4809.46875</c:v>
                </c:pt>
                <c:pt idx="321">
                  <c:v>4755.16748046875</c:v>
                </c:pt>
                <c:pt idx="322">
                  <c:v>4698.84912109375</c:v>
                </c:pt>
                <c:pt idx="323">
                  <c:v>4674.58056640625</c:v>
                </c:pt>
                <c:pt idx="324">
                  <c:v>4686.03466796875</c:v>
                </c:pt>
                <c:pt idx="325">
                  <c:v>4706.884765625</c:v>
                </c:pt>
                <c:pt idx="326">
                  <c:v>4703.79150390625</c:v>
                </c:pt>
                <c:pt idx="327">
                  <c:v>4664.130859375</c:v>
                </c:pt>
                <c:pt idx="328">
                  <c:v>4607.77734375</c:v>
                </c:pt>
                <c:pt idx="329">
                  <c:v>4574.17041015625</c:v>
                </c:pt>
                <c:pt idx="330">
                  <c:v>4593.8388671875</c:v>
                </c:pt>
                <c:pt idx="331">
                  <c:v>4664.865234375</c:v>
                </c:pt>
                <c:pt idx="332">
                  <c:v>4751.625</c:v>
                </c:pt>
                <c:pt idx="333">
                  <c:v>4807.6416015625</c:v>
                </c:pt>
                <c:pt idx="334">
                  <c:v>4807.2275390625</c:v>
                </c:pt>
                <c:pt idx="335">
                  <c:v>4763.68603515625</c:v>
                </c:pt>
                <c:pt idx="336">
                  <c:v>4720.5087890625</c:v>
                </c:pt>
                <c:pt idx="337">
                  <c:v>4720.65185546875</c:v>
                </c:pt>
                <c:pt idx="338">
                  <c:v>4774.83935546875</c:v>
                </c:pt>
                <c:pt idx="339">
                  <c:v>4851.50244140625</c:v>
                </c:pt>
                <c:pt idx="340">
                  <c:v>4896.53759765625</c:v>
                </c:pt>
                <c:pt idx="341">
                  <c:v>4870.19921875</c:v>
                </c:pt>
                <c:pt idx="342">
                  <c:v>4775.826171875</c:v>
                </c:pt>
                <c:pt idx="343">
                  <c:v>4660.103515625</c:v>
                </c:pt>
                <c:pt idx="344">
                  <c:v>4584.1298828125</c:v>
                </c:pt>
                <c:pt idx="345">
                  <c:v>4584.88427734375</c:v>
                </c:pt>
                <c:pt idx="346">
                  <c:v>4653.248046875</c:v>
                </c:pt>
                <c:pt idx="347">
                  <c:v>4742.77099609375</c:v>
                </c:pt>
                <c:pt idx="348">
                  <c:v>4801.701171875</c:v>
                </c:pt>
                <c:pt idx="349">
                  <c:v>4805.2314453125</c:v>
                </c:pt>
              </c:numCache>
            </c:numRef>
          </c:yVal>
          <c:smooth val="1"/>
          <c:extLst>
            <c:ext xmlns:c16="http://schemas.microsoft.com/office/drawing/2014/chart" uri="{C3380CC4-5D6E-409C-BE32-E72D297353CC}">
              <c16:uniqueId val="{0000000C-4A37-429A-A58F-F7AEDA5D1ACA}"/>
            </c:ext>
          </c:extLst>
        </c:ser>
        <c:ser>
          <c:idx val="13"/>
          <c:order val="13"/>
          <c:tx>
            <c:strRef>
              <c:f>cp_sub_001!$N$1</c:f>
              <c:strCache>
                <c:ptCount val="1"/>
                <c:pt idx="0">
                  <c:v>Coor_14</c:v>
                </c:pt>
              </c:strCache>
            </c:strRef>
          </c:tx>
          <c:spPr>
            <a:ln w="28575" cap="rnd">
              <a:solidFill>
                <a:schemeClr val="accent2">
                  <a:lumMod val="80000"/>
                  <a:lumOff val="20000"/>
                </a:schemeClr>
              </a:solidFill>
              <a:round/>
            </a:ln>
            <a:effectLst/>
          </c:spPr>
          <c:marker>
            <c:symbol val="none"/>
          </c:marker>
          <c:yVal>
            <c:numRef>
              <c:f>cp_sub_001!$N$2:$N$351</c:f>
              <c:numCache>
                <c:formatCode>0.00000000000_ </c:formatCode>
                <c:ptCount val="350"/>
                <c:pt idx="0">
                  <c:v>1668.77746582031</c:v>
                </c:pt>
                <c:pt idx="1">
                  <c:v>1655.16149902343</c:v>
                </c:pt>
                <c:pt idx="2">
                  <c:v>1624.93969726562</c:v>
                </c:pt>
                <c:pt idx="3">
                  <c:v>1606.54858398437</c:v>
                </c:pt>
                <c:pt idx="4">
                  <c:v>1618.02697753906</c:v>
                </c:pt>
                <c:pt idx="5">
                  <c:v>1650.05139160156</c:v>
                </c:pt>
                <c:pt idx="6">
                  <c:v>1671.25024414062</c:v>
                </c:pt>
                <c:pt idx="7">
                  <c:v>1653.37878417968</c:v>
                </c:pt>
                <c:pt idx="8">
                  <c:v>1596.61022949218</c:v>
                </c:pt>
                <c:pt idx="9">
                  <c:v>1533.27099609375</c:v>
                </c:pt>
                <c:pt idx="10">
                  <c:v>1504.75744628906</c:v>
                </c:pt>
                <c:pt idx="11">
                  <c:v>1528.63208007812</c:v>
                </c:pt>
                <c:pt idx="12">
                  <c:v>1582.59484863281</c:v>
                </c:pt>
                <c:pt idx="13">
                  <c:v>1620.03576660156</c:v>
                </c:pt>
                <c:pt idx="14">
                  <c:v>1606.72387695312</c:v>
                </c:pt>
                <c:pt idx="15">
                  <c:v>1549.97741699218</c:v>
                </c:pt>
                <c:pt idx="16">
                  <c:v>1495.97021484375</c:v>
                </c:pt>
                <c:pt idx="17">
                  <c:v>1495.384765625</c:v>
                </c:pt>
                <c:pt idx="18">
                  <c:v>1563.32177734375</c:v>
                </c:pt>
                <c:pt idx="19">
                  <c:v>1665.22692871093</c:v>
                </c:pt>
                <c:pt idx="20">
                  <c:v>1741.02294921875</c:v>
                </c:pt>
                <c:pt idx="21">
                  <c:v>1749.56604003906</c:v>
                </c:pt>
                <c:pt idx="22">
                  <c:v>1698.98278808593</c:v>
                </c:pt>
                <c:pt idx="23">
                  <c:v>1639.01379394531</c:v>
                </c:pt>
                <c:pt idx="24">
                  <c:v>1621.23181152343</c:v>
                </c:pt>
                <c:pt idx="25">
                  <c:v>1658.3232421875</c:v>
                </c:pt>
                <c:pt idx="26">
                  <c:v>1714.29895019531</c:v>
                </c:pt>
                <c:pt idx="27">
                  <c:v>1732.9794921875</c:v>
                </c:pt>
                <c:pt idx="28">
                  <c:v>1682.04797363281</c:v>
                </c:pt>
                <c:pt idx="29">
                  <c:v>1578.30395507812</c:v>
                </c:pt>
                <c:pt idx="30">
                  <c:v>1475.38232421875</c:v>
                </c:pt>
                <c:pt idx="31">
                  <c:v>1425.00903320312</c:v>
                </c:pt>
                <c:pt idx="32">
                  <c:v>1442.70532226562</c:v>
                </c:pt>
                <c:pt idx="33">
                  <c:v>1503.35083007812</c:v>
                </c:pt>
                <c:pt idx="34">
                  <c:v>1566.73742675781</c:v>
                </c:pt>
                <c:pt idx="35">
                  <c:v>1609.56164550781</c:v>
                </c:pt>
                <c:pt idx="36">
                  <c:v>1637.3544921875</c:v>
                </c:pt>
                <c:pt idx="37">
                  <c:v>1668.93151855468</c:v>
                </c:pt>
                <c:pt idx="38">
                  <c:v>1710.01611328125</c:v>
                </c:pt>
                <c:pt idx="39">
                  <c:v>1741.26635742187</c:v>
                </c:pt>
                <c:pt idx="40">
                  <c:v>1732.27319335937</c:v>
                </c:pt>
                <c:pt idx="41">
                  <c:v>1669.57373046875</c:v>
                </c:pt>
                <c:pt idx="42">
                  <c:v>1573.81042480468</c:v>
                </c:pt>
                <c:pt idx="43">
                  <c:v>1489.90856933593</c:v>
                </c:pt>
                <c:pt idx="44">
                  <c:v>1456.92346191406</c:v>
                </c:pt>
                <c:pt idx="45">
                  <c:v>1481.49035644531</c:v>
                </c:pt>
                <c:pt idx="46">
                  <c:v>1535.95458984375</c:v>
                </c:pt>
                <c:pt idx="47">
                  <c:v>1581.85107421875</c:v>
                </c:pt>
                <c:pt idx="48">
                  <c:v>1598.83581542968</c:v>
                </c:pt>
                <c:pt idx="49">
                  <c:v>1595.67663574218</c:v>
                </c:pt>
                <c:pt idx="50">
                  <c:v>1595.98022460937</c:v>
                </c:pt>
                <c:pt idx="51">
                  <c:v>1612.90759277343</c:v>
                </c:pt>
                <c:pt idx="52">
                  <c:v>1635.80285644531</c:v>
                </c:pt>
                <c:pt idx="53">
                  <c:v>1640.41369628906</c:v>
                </c:pt>
                <c:pt idx="54">
                  <c:v>1613.2783203125</c:v>
                </c:pt>
                <c:pt idx="55">
                  <c:v>1568.19873046875</c:v>
                </c:pt>
                <c:pt idx="56">
                  <c:v>1539.2900390625</c:v>
                </c:pt>
                <c:pt idx="57">
                  <c:v>1555.15319824218</c:v>
                </c:pt>
                <c:pt idx="58">
                  <c:v>1615.08203125</c:v>
                </c:pt>
                <c:pt idx="59">
                  <c:v>1687.05529785156</c:v>
                </c:pt>
                <c:pt idx="60">
                  <c:v>1729.66052246093</c:v>
                </c:pt>
                <c:pt idx="61">
                  <c:v>1720.87231445312</c:v>
                </c:pt>
                <c:pt idx="62">
                  <c:v>1671.59460449218</c:v>
                </c:pt>
                <c:pt idx="63">
                  <c:v>1614.71081542968</c:v>
                </c:pt>
                <c:pt idx="64">
                  <c:v>1579.92639160156</c:v>
                </c:pt>
                <c:pt idx="65">
                  <c:v>1574.81201171875</c:v>
                </c:pt>
                <c:pt idx="66">
                  <c:v>1585.59887695312</c:v>
                </c:pt>
                <c:pt idx="67">
                  <c:v>1594.189453125</c:v>
                </c:pt>
                <c:pt idx="68">
                  <c:v>1595.21423339843</c:v>
                </c:pt>
                <c:pt idx="69">
                  <c:v>1598.73010253906</c:v>
                </c:pt>
                <c:pt idx="70">
                  <c:v>1617.67639160156</c:v>
                </c:pt>
                <c:pt idx="71">
                  <c:v>1652.29858398437</c:v>
                </c:pt>
                <c:pt idx="72">
                  <c:v>1685.61145019531</c:v>
                </c:pt>
                <c:pt idx="73">
                  <c:v>1693.96020507812</c:v>
                </c:pt>
                <c:pt idx="74">
                  <c:v>1664.12292480468</c:v>
                </c:pt>
                <c:pt idx="75">
                  <c:v>1603.67590332031</c:v>
                </c:pt>
                <c:pt idx="76">
                  <c:v>1537.466796875</c:v>
                </c:pt>
                <c:pt idx="77">
                  <c:v>1493.79345703125</c:v>
                </c:pt>
                <c:pt idx="78">
                  <c:v>1490.2177734375</c:v>
                </c:pt>
                <c:pt idx="79">
                  <c:v>1526.91137695312</c:v>
                </c:pt>
                <c:pt idx="80">
                  <c:v>1588.64172363281</c:v>
                </c:pt>
                <c:pt idx="81">
                  <c:v>1651.61694335937</c:v>
                </c:pt>
                <c:pt idx="82">
                  <c:v>1691.53930664062</c:v>
                </c:pt>
                <c:pt idx="83">
                  <c:v>1691.75549316406</c:v>
                </c:pt>
                <c:pt idx="84">
                  <c:v>1650.81091308593</c:v>
                </c:pt>
                <c:pt idx="85">
                  <c:v>1586.10827636718</c:v>
                </c:pt>
                <c:pt idx="86">
                  <c:v>1528.72863769531</c:v>
                </c:pt>
                <c:pt idx="87">
                  <c:v>1508.20776367187</c:v>
                </c:pt>
                <c:pt idx="88">
                  <c:v>1534.26330566406</c:v>
                </c:pt>
                <c:pt idx="89">
                  <c:v>1588.20983886718</c:v>
                </c:pt>
                <c:pt idx="90">
                  <c:v>1633.02783203125</c:v>
                </c:pt>
                <c:pt idx="91">
                  <c:v>1638.10974121093</c:v>
                </c:pt>
                <c:pt idx="92">
                  <c:v>1601.93640136718</c:v>
                </c:pt>
                <c:pt idx="93">
                  <c:v>1554.73608398437</c:v>
                </c:pt>
                <c:pt idx="94">
                  <c:v>1536.77893066406</c:v>
                </c:pt>
                <c:pt idx="95">
                  <c:v>1567.09790039062</c:v>
                </c:pt>
                <c:pt idx="96">
                  <c:v>1626.69836425781</c:v>
                </c:pt>
                <c:pt idx="97">
                  <c:v>1670.84411621093</c:v>
                </c:pt>
                <c:pt idx="98">
                  <c:v>1662.79919433593</c:v>
                </c:pt>
                <c:pt idx="99">
                  <c:v>1603.67309570312</c:v>
                </c:pt>
                <c:pt idx="100">
                  <c:v>1534.55981445312</c:v>
                </c:pt>
                <c:pt idx="101">
                  <c:v>1507.875</c:v>
                </c:pt>
                <c:pt idx="102">
                  <c:v>1548.85559082031</c:v>
                </c:pt>
                <c:pt idx="103">
                  <c:v>1636.42736816406</c:v>
                </c:pt>
                <c:pt idx="104">
                  <c:v>1718.08728027343</c:v>
                </c:pt>
                <c:pt idx="105">
                  <c:v>1747.32470703125</c:v>
                </c:pt>
                <c:pt idx="106">
                  <c:v>1715.0400390625</c:v>
                </c:pt>
                <c:pt idx="107">
                  <c:v>1651.80419921875</c:v>
                </c:pt>
                <c:pt idx="108">
                  <c:v>1601.0322265625</c:v>
                </c:pt>
                <c:pt idx="109">
                  <c:v>1585.50207519531</c:v>
                </c:pt>
                <c:pt idx="110">
                  <c:v>1593.53161621093</c:v>
                </c:pt>
                <c:pt idx="111">
                  <c:v>1594.19799804687</c:v>
                </c:pt>
                <c:pt idx="112">
                  <c:v>1567.48754882812</c:v>
                </c:pt>
                <c:pt idx="113">
                  <c:v>1524.09484863281</c:v>
                </c:pt>
                <c:pt idx="114">
                  <c:v>1498.95935058593</c:v>
                </c:pt>
                <c:pt idx="115">
                  <c:v>1524.06420898437</c:v>
                </c:pt>
                <c:pt idx="116">
                  <c:v>1602.0537109375</c:v>
                </c:pt>
                <c:pt idx="117">
                  <c:v>1700.74951171875</c:v>
                </c:pt>
                <c:pt idx="118">
                  <c:v>1772.08874511718</c:v>
                </c:pt>
                <c:pt idx="119">
                  <c:v>1781.20751953125</c:v>
                </c:pt>
                <c:pt idx="120">
                  <c:v>1725.71154785156</c:v>
                </c:pt>
                <c:pt idx="121">
                  <c:v>1634.24230957031</c:v>
                </c:pt>
                <c:pt idx="122">
                  <c:v>1548.47082519531</c:v>
                </c:pt>
                <c:pt idx="123">
                  <c:v>1501.91162109375</c:v>
                </c:pt>
                <c:pt idx="124">
                  <c:v>1507.28479003906</c:v>
                </c:pt>
                <c:pt idx="125">
                  <c:v>1555.68957519531</c:v>
                </c:pt>
                <c:pt idx="126">
                  <c:v>1623.66198730468</c:v>
                </c:pt>
                <c:pt idx="127">
                  <c:v>1682.80395507812</c:v>
                </c:pt>
                <c:pt idx="128">
                  <c:v>1709.21032714843</c:v>
                </c:pt>
                <c:pt idx="129">
                  <c:v>1691.64978027343</c:v>
                </c:pt>
                <c:pt idx="130">
                  <c:v>1636.38269042968</c:v>
                </c:pt>
                <c:pt idx="131">
                  <c:v>1565.20776367187</c:v>
                </c:pt>
                <c:pt idx="132">
                  <c:v>1505.45910644531</c:v>
                </c:pt>
                <c:pt idx="133">
                  <c:v>1476.16284179687</c:v>
                </c:pt>
                <c:pt idx="134">
                  <c:v>1478.79187011718</c:v>
                </c:pt>
                <c:pt idx="135">
                  <c:v>1499.17150878906</c:v>
                </c:pt>
                <c:pt idx="136">
                  <c:v>1519.294921875</c:v>
                </c:pt>
                <c:pt idx="137">
                  <c:v>1530.14868164062</c:v>
                </c:pt>
                <c:pt idx="138">
                  <c:v>1535.8857421875</c:v>
                </c:pt>
                <c:pt idx="139">
                  <c:v>1546.97302246093</c:v>
                </c:pt>
                <c:pt idx="140">
                  <c:v>1569.17028808593</c:v>
                </c:pt>
                <c:pt idx="141">
                  <c:v>1598.25720214843</c:v>
                </c:pt>
                <c:pt idx="142">
                  <c:v>1624.58581542968</c:v>
                </c:pt>
                <c:pt idx="143">
                  <c:v>1642.21142578125</c:v>
                </c:pt>
                <c:pt idx="144">
                  <c:v>1653.30224609375</c:v>
                </c:pt>
                <c:pt idx="145">
                  <c:v>1663.6064453125</c:v>
                </c:pt>
                <c:pt idx="146">
                  <c:v>1674.11218261718</c:v>
                </c:pt>
                <c:pt idx="147">
                  <c:v>1678.388671875</c:v>
                </c:pt>
                <c:pt idx="148">
                  <c:v>1669.65283203125</c:v>
                </c:pt>
                <c:pt idx="149">
                  <c:v>1651.12805175781</c:v>
                </c:pt>
                <c:pt idx="150">
                  <c:v>1638.13928222656</c:v>
                </c:pt>
                <c:pt idx="151">
                  <c:v>1646.79760742187</c:v>
                </c:pt>
                <c:pt idx="152">
                  <c:v>1677.34375</c:v>
                </c:pt>
                <c:pt idx="153">
                  <c:v>1707.94616699218</c:v>
                </c:pt>
                <c:pt idx="154">
                  <c:v>1708.16882324218</c:v>
                </c:pt>
                <c:pt idx="155">
                  <c:v>1664.27465820312</c:v>
                </c:pt>
                <c:pt idx="156">
                  <c:v>1595.54736328125</c:v>
                </c:pt>
                <c:pt idx="157">
                  <c:v>1544.89074707031</c:v>
                </c:pt>
                <c:pt idx="158">
                  <c:v>1547.115234375</c:v>
                </c:pt>
                <c:pt idx="159">
                  <c:v>1598.68347167968</c:v>
                </c:pt>
                <c:pt idx="160">
                  <c:v>1655.04248046875</c:v>
                </c:pt>
                <c:pt idx="161">
                  <c:v>1661.62097167968</c:v>
                </c:pt>
                <c:pt idx="162">
                  <c:v>1596.89025878906</c:v>
                </c:pt>
                <c:pt idx="163">
                  <c:v>1493.53759765625</c:v>
                </c:pt>
                <c:pt idx="164">
                  <c:v>1418.67590332031</c:v>
                </c:pt>
                <c:pt idx="165">
                  <c:v>1425.83471679687</c:v>
                </c:pt>
                <c:pt idx="166">
                  <c:v>1514.91638183593</c:v>
                </c:pt>
                <c:pt idx="167">
                  <c:v>1631.5625</c:v>
                </c:pt>
                <c:pt idx="168">
                  <c:v>1707.06726074218</c:v>
                </c:pt>
                <c:pt idx="169">
                  <c:v>1708.01574707031</c:v>
                </c:pt>
                <c:pt idx="170">
                  <c:v>1657.16259765625</c:v>
                </c:pt>
                <c:pt idx="171">
                  <c:v>1610.26342773437</c:v>
                </c:pt>
                <c:pt idx="172">
                  <c:v>1608.87780761718</c:v>
                </c:pt>
                <c:pt idx="173">
                  <c:v>1647.8203125</c:v>
                </c:pt>
                <c:pt idx="174">
                  <c:v>1682.8662109375</c:v>
                </c:pt>
                <c:pt idx="175">
                  <c:v>1670.68298339843</c:v>
                </c:pt>
                <c:pt idx="176">
                  <c:v>1606.78942871093</c:v>
                </c:pt>
                <c:pt idx="177">
                  <c:v>1530.06652832031</c:v>
                </c:pt>
                <c:pt idx="178">
                  <c:v>1491.04504394531</c:v>
                </c:pt>
                <c:pt idx="179">
                  <c:v>1511.34936523437</c:v>
                </c:pt>
                <c:pt idx="180">
                  <c:v>1568.09057617187</c:v>
                </c:pt>
                <c:pt idx="181">
                  <c:v>1614.99841308593</c:v>
                </c:pt>
                <c:pt idx="182">
                  <c:v>1620.98303222656</c:v>
                </c:pt>
                <c:pt idx="183">
                  <c:v>1593.14489746093</c:v>
                </c:pt>
                <c:pt idx="184">
                  <c:v>1565.99108886718</c:v>
                </c:pt>
                <c:pt idx="185">
                  <c:v>1568.27319335937</c:v>
                </c:pt>
                <c:pt idx="186">
                  <c:v>1597.53796386718</c:v>
                </c:pt>
                <c:pt idx="187">
                  <c:v>1624.40759277343</c:v>
                </c:pt>
                <c:pt idx="188">
                  <c:v>1621.55102539062</c:v>
                </c:pt>
                <c:pt idx="189">
                  <c:v>1590.38806152343</c:v>
                </c:pt>
                <c:pt idx="190">
                  <c:v>1561.00866699218</c:v>
                </c:pt>
                <c:pt idx="191">
                  <c:v>1565.15209960937</c:v>
                </c:pt>
                <c:pt idx="192">
                  <c:v>1606.60278320312</c:v>
                </c:pt>
                <c:pt idx="193">
                  <c:v>1656.15441894531</c:v>
                </c:pt>
                <c:pt idx="194">
                  <c:v>1676.64965820312</c:v>
                </c:pt>
                <c:pt idx="195">
                  <c:v>1656.48596191406</c:v>
                </c:pt>
                <c:pt idx="196">
                  <c:v>1621.45532226562</c:v>
                </c:pt>
                <c:pt idx="197">
                  <c:v>1612.92797851562</c:v>
                </c:pt>
                <c:pt idx="198">
                  <c:v>1649.9326171875</c:v>
                </c:pt>
                <c:pt idx="199">
                  <c:v>1707.98864746093</c:v>
                </c:pt>
                <c:pt idx="200">
                  <c:v>1734.76806640625</c:v>
                </c:pt>
                <c:pt idx="201">
                  <c:v>1691.92834472656</c:v>
                </c:pt>
                <c:pt idx="202">
                  <c:v>1589.55822753906</c:v>
                </c:pt>
                <c:pt idx="203">
                  <c:v>1484.23217773437</c:v>
                </c:pt>
                <c:pt idx="204">
                  <c:v>1440.42565917968</c:v>
                </c:pt>
                <c:pt idx="205">
                  <c:v>1484.48522949218</c:v>
                </c:pt>
                <c:pt idx="206">
                  <c:v>1586.38500976562</c:v>
                </c:pt>
                <c:pt idx="207">
                  <c:v>1682.45251464843</c:v>
                </c:pt>
                <c:pt idx="208">
                  <c:v>1720.41552734375</c:v>
                </c:pt>
                <c:pt idx="209">
                  <c:v>1692.20910644531</c:v>
                </c:pt>
                <c:pt idx="210">
                  <c:v>1631.86462402343</c:v>
                </c:pt>
                <c:pt idx="211">
                  <c:v>1584.37426757812</c:v>
                </c:pt>
                <c:pt idx="212">
                  <c:v>1572.79711914062</c:v>
                </c:pt>
                <c:pt idx="213">
                  <c:v>1588.60571289062</c:v>
                </c:pt>
                <c:pt idx="214">
                  <c:v>1608.35559082031</c:v>
                </c:pt>
                <c:pt idx="215">
                  <c:v>1617.97961425781</c:v>
                </c:pt>
                <c:pt idx="216">
                  <c:v>1622.40270996093</c:v>
                </c:pt>
                <c:pt idx="217">
                  <c:v>1634.03295898437</c:v>
                </c:pt>
                <c:pt idx="218">
                  <c:v>1653.6904296875</c:v>
                </c:pt>
                <c:pt idx="219">
                  <c:v>1663.85046386718</c:v>
                </c:pt>
                <c:pt idx="220">
                  <c:v>1641.91345214843</c:v>
                </c:pt>
                <c:pt idx="221">
                  <c:v>1582.19067382812</c:v>
                </c:pt>
                <c:pt idx="222">
                  <c:v>1506.59631347656</c:v>
                </c:pt>
                <c:pt idx="223">
                  <c:v>1453.20520019531</c:v>
                </c:pt>
                <c:pt idx="224">
                  <c:v>1450.61315917968</c:v>
                </c:pt>
                <c:pt idx="225">
                  <c:v>1498.09448242187</c:v>
                </c:pt>
                <c:pt idx="226">
                  <c:v>1566.814453125</c:v>
                </c:pt>
                <c:pt idx="227">
                  <c:v>1620.34582519531</c:v>
                </c:pt>
                <c:pt idx="228">
                  <c:v>1638.03649902343</c:v>
                </c:pt>
                <c:pt idx="229">
                  <c:v>1624.1865234375</c:v>
                </c:pt>
                <c:pt idx="230">
                  <c:v>1598.822265625</c:v>
                </c:pt>
                <c:pt idx="231">
                  <c:v>1580.41040039062</c:v>
                </c:pt>
                <c:pt idx="232">
                  <c:v>1575.12561035156</c:v>
                </c:pt>
                <c:pt idx="233">
                  <c:v>1579.09912109375</c:v>
                </c:pt>
                <c:pt idx="234">
                  <c:v>1587.96801757812</c:v>
                </c:pt>
                <c:pt idx="235">
                  <c:v>1602.88928222656</c:v>
                </c:pt>
                <c:pt idx="236">
                  <c:v>1627.54052734375</c:v>
                </c:pt>
                <c:pt idx="237">
                  <c:v>1660.36291503906</c:v>
                </c:pt>
                <c:pt idx="238">
                  <c:v>1690.94799804687</c:v>
                </c:pt>
                <c:pt idx="239">
                  <c:v>1705.13928222656</c:v>
                </c:pt>
                <c:pt idx="240">
                  <c:v>1694.82336425781</c:v>
                </c:pt>
                <c:pt idx="241">
                  <c:v>1663.92529296875</c:v>
                </c:pt>
                <c:pt idx="242">
                  <c:v>1625.76306152343</c:v>
                </c:pt>
                <c:pt idx="243">
                  <c:v>1594.76599121093</c:v>
                </c:pt>
                <c:pt idx="244">
                  <c:v>1579.93347167968</c:v>
                </c:pt>
                <c:pt idx="245">
                  <c:v>1584.39501953125</c:v>
                </c:pt>
                <c:pt idx="246">
                  <c:v>1608.51879882812</c:v>
                </c:pt>
                <c:pt idx="247">
                  <c:v>1650.51171875</c:v>
                </c:pt>
                <c:pt idx="248">
                  <c:v>1702.1748046875</c:v>
                </c:pt>
                <c:pt idx="249">
                  <c:v>1744.69982910156</c:v>
                </c:pt>
                <c:pt idx="250">
                  <c:v>1752.32690429687</c:v>
                </c:pt>
                <c:pt idx="251">
                  <c:v>1706.08447265625</c:v>
                </c:pt>
                <c:pt idx="252">
                  <c:v>1609.74035644531</c:v>
                </c:pt>
                <c:pt idx="253">
                  <c:v>1494.83215332031</c:v>
                </c:pt>
                <c:pt idx="254">
                  <c:v>1407.40026855468</c:v>
                </c:pt>
                <c:pt idx="255">
                  <c:v>1382.58410644531</c:v>
                </c:pt>
                <c:pt idx="256">
                  <c:v>1423.86157226562</c:v>
                </c:pt>
                <c:pt idx="257">
                  <c:v>1501.98706054687</c:v>
                </c:pt>
                <c:pt idx="258">
                  <c:v>1574.94189453125</c:v>
                </c:pt>
                <c:pt idx="259">
                  <c:v>1614.76550292968</c:v>
                </c:pt>
                <c:pt idx="260">
                  <c:v>1622.20703125</c:v>
                </c:pt>
                <c:pt idx="261">
                  <c:v>1619.70471191406</c:v>
                </c:pt>
                <c:pt idx="262">
                  <c:v>1629.70971679687</c:v>
                </c:pt>
                <c:pt idx="263">
                  <c:v>1655.83386230468</c:v>
                </c:pt>
                <c:pt idx="264">
                  <c:v>1680.89111328125</c:v>
                </c:pt>
                <c:pt idx="265">
                  <c:v>1681.98718261718</c:v>
                </c:pt>
                <c:pt idx="266">
                  <c:v>1649.81555175781</c:v>
                </c:pt>
                <c:pt idx="267">
                  <c:v>1597.14318847656</c:v>
                </c:pt>
                <c:pt idx="268">
                  <c:v>1550.84838867187</c:v>
                </c:pt>
                <c:pt idx="269">
                  <c:v>1534.50048828125</c:v>
                </c:pt>
                <c:pt idx="270">
                  <c:v>1554.45910644531</c:v>
                </c:pt>
                <c:pt idx="271">
                  <c:v>1598.22668457031</c:v>
                </c:pt>
                <c:pt idx="272">
                  <c:v>1644.04455566406</c:v>
                </c:pt>
                <c:pt idx="273">
                  <c:v>1673.58984375</c:v>
                </c:pt>
                <c:pt idx="274">
                  <c:v>1679.69848632812</c:v>
                </c:pt>
                <c:pt idx="275">
                  <c:v>1666.44555664062</c:v>
                </c:pt>
                <c:pt idx="276">
                  <c:v>1644.19152832031</c:v>
                </c:pt>
                <c:pt idx="277">
                  <c:v>1623.65051269531</c:v>
                </c:pt>
                <c:pt idx="278">
                  <c:v>1611.32092285156</c:v>
                </c:pt>
                <c:pt idx="279">
                  <c:v>1606.90014648437</c:v>
                </c:pt>
                <c:pt idx="280">
                  <c:v>1603.33728027343</c:v>
                </c:pt>
                <c:pt idx="281">
                  <c:v>1590.61376953125</c:v>
                </c:pt>
                <c:pt idx="282">
                  <c:v>1562.86889648437</c:v>
                </c:pt>
                <c:pt idx="283">
                  <c:v>1525.17456054687</c:v>
                </c:pt>
                <c:pt idx="284">
                  <c:v>1494.31945800781</c:v>
                </c:pt>
                <c:pt idx="285">
                  <c:v>1490.63342285156</c:v>
                </c:pt>
                <c:pt idx="286">
                  <c:v>1524.5390625</c:v>
                </c:pt>
                <c:pt idx="287">
                  <c:v>1587.05358886718</c:v>
                </c:pt>
                <c:pt idx="288">
                  <c:v>1652.38427734375</c:v>
                </c:pt>
                <c:pt idx="289">
                  <c:v>1692.54333496093</c:v>
                </c:pt>
                <c:pt idx="290">
                  <c:v>1694.43884277343</c:v>
                </c:pt>
                <c:pt idx="291">
                  <c:v>1667.11462402343</c:v>
                </c:pt>
                <c:pt idx="292">
                  <c:v>1633.76257324218</c:v>
                </c:pt>
                <c:pt idx="293">
                  <c:v>1614.76123046875</c:v>
                </c:pt>
                <c:pt idx="294">
                  <c:v>1614.86352539062</c:v>
                </c:pt>
                <c:pt idx="295">
                  <c:v>1623.89660644531</c:v>
                </c:pt>
                <c:pt idx="296">
                  <c:v>1628.91931152343</c:v>
                </c:pt>
                <c:pt idx="297">
                  <c:v>1626.3505859375</c:v>
                </c:pt>
                <c:pt idx="298">
                  <c:v>1623.25476074218</c:v>
                </c:pt>
                <c:pt idx="299">
                  <c:v>1627.20446777343</c:v>
                </c:pt>
                <c:pt idx="300">
                  <c:v>1634.93371582031</c:v>
                </c:pt>
                <c:pt idx="301">
                  <c:v>1631.64477539062</c:v>
                </c:pt>
                <c:pt idx="302">
                  <c:v>1603.46166992187</c:v>
                </c:pt>
                <c:pt idx="303">
                  <c:v>1553.09643554687</c:v>
                </c:pt>
                <c:pt idx="304">
                  <c:v>1504.36535644531</c:v>
                </c:pt>
                <c:pt idx="305">
                  <c:v>1489.29052734375</c:v>
                </c:pt>
                <c:pt idx="306">
                  <c:v>1525.87475585937</c:v>
                </c:pt>
                <c:pt idx="307">
                  <c:v>1603.24694824218</c:v>
                </c:pt>
                <c:pt idx="308">
                  <c:v>1686.16845703125</c:v>
                </c:pt>
                <c:pt idx="309">
                  <c:v>1736.32458496093</c:v>
                </c:pt>
                <c:pt idx="310">
                  <c:v>1735.11633300781</c:v>
                </c:pt>
                <c:pt idx="311">
                  <c:v>1692.02355957031</c:v>
                </c:pt>
                <c:pt idx="312">
                  <c:v>1634.21105957031</c:v>
                </c:pt>
                <c:pt idx="313">
                  <c:v>1587.12756347656</c:v>
                </c:pt>
                <c:pt idx="314">
                  <c:v>1561.0859375</c:v>
                </c:pt>
                <c:pt idx="315">
                  <c:v>1551.82849121093</c:v>
                </c:pt>
                <c:pt idx="316">
                  <c:v>1550.80310058593</c:v>
                </c:pt>
                <c:pt idx="317">
                  <c:v>1554.04821777343</c:v>
                </c:pt>
                <c:pt idx="318">
                  <c:v>1562.33447265625</c:v>
                </c:pt>
                <c:pt idx="319">
                  <c:v>1574.96459960937</c:v>
                </c:pt>
                <c:pt idx="320">
                  <c:v>1585.80322265625</c:v>
                </c:pt>
                <c:pt idx="321">
                  <c:v>1587.06787109375</c:v>
                </c:pt>
                <c:pt idx="322">
                  <c:v>1577.55651855468</c:v>
                </c:pt>
                <c:pt idx="323">
                  <c:v>1566.32727050781</c:v>
                </c:pt>
                <c:pt idx="324">
                  <c:v>1566.37475585937</c:v>
                </c:pt>
                <c:pt idx="325">
                  <c:v>1582.66003417968</c:v>
                </c:pt>
                <c:pt idx="326">
                  <c:v>1605.58410644531</c:v>
                </c:pt>
                <c:pt idx="327">
                  <c:v>1617.50634765625</c:v>
                </c:pt>
                <c:pt idx="328">
                  <c:v>1608.3642578125</c:v>
                </c:pt>
                <c:pt idx="329">
                  <c:v>1586.99633789062</c:v>
                </c:pt>
                <c:pt idx="330">
                  <c:v>1576.6904296875</c:v>
                </c:pt>
                <c:pt idx="331">
                  <c:v>1596.39465332031</c:v>
                </c:pt>
                <c:pt idx="332">
                  <c:v>1642.38610839843</c:v>
                </c:pt>
                <c:pt idx="333">
                  <c:v>1686.91040039062</c:v>
                </c:pt>
                <c:pt idx="334">
                  <c:v>1697.54345703125</c:v>
                </c:pt>
                <c:pt idx="335">
                  <c:v>1663.48913574218</c:v>
                </c:pt>
                <c:pt idx="336">
                  <c:v>1607.46337890625</c:v>
                </c:pt>
                <c:pt idx="337">
                  <c:v>1571.60180664062</c:v>
                </c:pt>
                <c:pt idx="338">
                  <c:v>1586.17248535156</c:v>
                </c:pt>
                <c:pt idx="339">
                  <c:v>1644.61157226562</c:v>
                </c:pt>
                <c:pt idx="340">
                  <c:v>1705.10546875</c:v>
                </c:pt>
                <c:pt idx="341">
                  <c:v>1719.2880859375</c:v>
                </c:pt>
                <c:pt idx="342">
                  <c:v>1667.61474609375</c:v>
                </c:pt>
                <c:pt idx="343">
                  <c:v>1575.15185546875</c:v>
                </c:pt>
                <c:pt idx="344">
                  <c:v>1495.71228027343</c:v>
                </c:pt>
                <c:pt idx="345">
                  <c:v>1475.67236328125</c:v>
                </c:pt>
                <c:pt idx="346">
                  <c:v>1523.53002929687</c:v>
                </c:pt>
                <c:pt idx="347">
                  <c:v>1606.34594726562</c:v>
                </c:pt>
                <c:pt idx="348">
                  <c:v>1674.00219726562</c:v>
                </c:pt>
                <c:pt idx="349">
                  <c:v>1692.46801757812</c:v>
                </c:pt>
              </c:numCache>
            </c:numRef>
          </c:yVal>
          <c:smooth val="1"/>
          <c:extLst>
            <c:ext xmlns:c16="http://schemas.microsoft.com/office/drawing/2014/chart" uri="{C3380CC4-5D6E-409C-BE32-E72D297353CC}">
              <c16:uniqueId val="{0000000D-4A37-429A-A58F-F7AEDA5D1ACA}"/>
            </c:ext>
          </c:extLst>
        </c:ser>
        <c:ser>
          <c:idx val="14"/>
          <c:order val="14"/>
          <c:tx>
            <c:strRef>
              <c:f>cp_sub_001!$O$1</c:f>
              <c:strCache>
                <c:ptCount val="1"/>
                <c:pt idx="0">
                  <c:v>Coor_15</c:v>
                </c:pt>
              </c:strCache>
            </c:strRef>
          </c:tx>
          <c:spPr>
            <a:ln w="28575" cap="rnd">
              <a:solidFill>
                <a:schemeClr val="accent3">
                  <a:lumMod val="80000"/>
                  <a:lumOff val="20000"/>
                </a:schemeClr>
              </a:solidFill>
              <a:round/>
            </a:ln>
            <a:effectLst/>
          </c:spPr>
          <c:marker>
            <c:symbol val="none"/>
          </c:marker>
          <c:yVal>
            <c:numRef>
              <c:f>cp_sub_001!$O$2:$O$351</c:f>
              <c:numCache>
                <c:formatCode>0.00000000000_ </c:formatCode>
                <c:ptCount val="350"/>
                <c:pt idx="0">
                  <c:v>6346.13330078125</c:v>
                </c:pt>
                <c:pt idx="1">
                  <c:v>6274.7080078125</c:v>
                </c:pt>
                <c:pt idx="2">
                  <c:v>6262.38720703125</c:v>
                </c:pt>
                <c:pt idx="3">
                  <c:v>6326.6064453125</c:v>
                </c:pt>
                <c:pt idx="4">
                  <c:v>6434.244140625</c:v>
                </c:pt>
                <c:pt idx="5">
                  <c:v>6524.4326171875</c:v>
                </c:pt>
                <c:pt idx="6">
                  <c:v>6551.259765625</c:v>
                </c:pt>
                <c:pt idx="7">
                  <c:v>6513.1533203125</c:v>
                </c:pt>
                <c:pt idx="8">
                  <c:v>6447.21630859375</c:v>
                </c:pt>
                <c:pt idx="9">
                  <c:v>6395.61328125</c:v>
                </c:pt>
                <c:pt idx="10">
                  <c:v>6373.18896484375</c:v>
                </c:pt>
                <c:pt idx="11">
                  <c:v>6362.6826171875</c:v>
                </c:pt>
                <c:pt idx="12">
                  <c:v>6339.09375</c:v>
                </c:pt>
                <c:pt idx="13">
                  <c:v>6299.578125</c:v>
                </c:pt>
                <c:pt idx="14">
                  <c:v>6271.0859375</c:v>
                </c:pt>
                <c:pt idx="15">
                  <c:v>6288.08837890625</c:v>
                </c:pt>
                <c:pt idx="16">
                  <c:v>6359.484375</c:v>
                </c:pt>
                <c:pt idx="17">
                  <c:v>6454.03955078125</c:v>
                </c:pt>
                <c:pt idx="18">
                  <c:v>6518.65283203125</c:v>
                </c:pt>
                <c:pt idx="19">
                  <c:v>6516.16748046875</c:v>
                </c:pt>
                <c:pt idx="20">
                  <c:v>6452.80029296875</c:v>
                </c:pt>
                <c:pt idx="21">
                  <c:v>6373.37890625</c:v>
                </c:pt>
                <c:pt idx="22">
                  <c:v>6328.453125</c:v>
                </c:pt>
                <c:pt idx="23">
                  <c:v>6339.29931640625</c:v>
                </c:pt>
                <c:pt idx="24">
                  <c:v>6387.13818359375</c:v>
                </c:pt>
                <c:pt idx="25">
                  <c:v>6432.36669921875</c:v>
                </c:pt>
                <c:pt idx="26">
                  <c:v>6446.0263671875</c:v>
                </c:pt>
                <c:pt idx="27">
                  <c:v>6428.27392578125</c:v>
                </c:pt>
                <c:pt idx="28">
                  <c:v>6401.9130859375</c:v>
                </c:pt>
                <c:pt idx="29">
                  <c:v>6390.20751953125</c:v>
                </c:pt>
                <c:pt idx="30">
                  <c:v>6399.22607421875</c:v>
                </c:pt>
                <c:pt idx="31">
                  <c:v>6417.87939453125</c:v>
                </c:pt>
                <c:pt idx="32">
                  <c:v>6431.83740234375</c:v>
                </c:pt>
                <c:pt idx="33">
                  <c:v>6436.3544921875</c:v>
                </c:pt>
                <c:pt idx="34">
                  <c:v>6436.673828125</c:v>
                </c:pt>
                <c:pt idx="35">
                  <c:v>6438.080078125</c:v>
                </c:pt>
                <c:pt idx="36">
                  <c:v>6437.52490234375</c:v>
                </c:pt>
                <c:pt idx="37">
                  <c:v>6426.0830078125</c:v>
                </c:pt>
                <c:pt idx="38">
                  <c:v>6399.73095703125</c:v>
                </c:pt>
                <c:pt idx="39">
                  <c:v>6366.98828125</c:v>
                </c:pt>
                <c:pt idx="40">
                  <c:v>6344.5791015625</c:v>
                </c:pt>
                <c:pt idx="41">
                  <c:v>6343.9853515625</c:v>
                </c:pt>
                <c:pt idx="42">
                  <c:v>6361.15673828125</c:v>
                </c:pt>
                <c:pt idx="43">
                  <c:v>6379.4990234375</c:v>
                </c:pt>
                <c:pt idx="44">
                  <c:v>6384.185546875</c:v>
                </c:pt>
                <c:pt idx="45">
                  <c:v>6375.0302734375</c:v>
                </c:pt>
                <c:pt idx="46">
                  <c:v>6365.94189453125</c:v>
                </c:pt>
                <c:pt idx="47">
                  <c:v>6371.07568359375</c:v>
                </c:pt>
                <c:pt idx="48">
                  <c:v>6390.33056640625</c:v>
                </c:pt>
                <c:pt idx="49">
                  <c:v>6408.076171875</c:v>
                </c:pt>
                <c:pt idx="50">
                  <c:v>6407.32373046875</c:v>
                </c:pt>
                <c:pt idx="51">
                  <c:v>6387.1396484375</c:v>
                </c:pt>
                <c:pt idx="52">
                  <c:v>6367.07568359375</c:v>
                </c:pt>
                <c:pt idx="53">
                  <c:v>6372.9111328125</c:v>
                </c:pt>
                <c:pt idx="54">
                  <c:v>6414.3369140625</c:v>
                </c:pt>
                <c:pt idx="55">
                  <c:v>6473.15087890625</c:v>
                </c:pt>
                <c:pt idx="56">
                  <c:v>6512.8779296875</c:v>
                </c:pt>
                <c:pt idx="57">
                  <c:v>6503.5849609375</c:v>
                </c:pt>
                <c:pt idx="58">
                  <c:v>6443.33984375</c:v>
                </c:pt>
                <c:pt idx="59">
                  <c:v>6360.33056640625</c:v>
                </c:pt>
                <c:pt idx="60">
                  <c:v>6294.73095703125</c:v>
                </c:pt>
                <c:pt idx="61">
                  <c:v>6274.3154296875</c:v>
                </c:pt>
                <c:pt idx="62">
                  <c:v>6300.89794921875</c:v>
                </c:pt>
                <c:pt idx="63">
                  <c:v>6354.64599609375</c:v>
                </c:pt>
                <c:pt idx="64">
                  <c:v>6409.6015625</c:v>
                </c:pt>
                <c:pt idx="65">
                  <c:v>6447.61083984375</c:v>
                </c:pt>
                <c:pt idx="66">
                  <c:v>6462.71337890625</c:v>
                </c:pt>
                <c:pt idx="67">
                  <c:v>6457.6328125</c:v>
                </c:pt>
                <c:pt idx="68">
                  <c:v>6439.17822265625</c:v>
                </c:pt>
                <c:pt idx="69">
                  <c:v>6416.556640625</c:v>
                </c:pt>
                <c:pt idx="70">
                  <c:v>6400.6083984375</c:v>
                </c:pt>
                <c:pt idx="71">
                  <c:v>6400.0009765625</c:v>
                </c:pt>
                <c:pt idx="72">
                  <c:v>6414.77734375</c:v>
                </c:pt>
                <c:pt idx="73">
                  <c:v>6433.20849609375</c:v>
                </c:pt>
                <c:pt idx="74">
                  <c:v>6437.63916015625</c:v>
                </c:pt>
                <c:pt idx="75">
                  <c:v>6417.59814453125</c:v>
                </c:pt>
                <c:pt idx="76">
                  <c:v>6380.326171875</c:v>
                </c:pt>
                <c:pt idx="77">
                  <c:v>6348.5478515625</c:v>
                </c:pt>
                <c:pt idx="78">
                  <c:v>6344.78564453125</c:v>
                </c:pt>
                <c:pt idx="79">
                  <c:v>6373.412109375</c:v>
                </c:pt>
                <c:pt idx="80">
                  <c:v>6415.2412109375</c:v>
                </c:pt>
                <c:pt idx="81">
                  <c:v>6440.42041015625</c:v>
                </c:pt>
                <c:pt idx="82">
                  <c:v>6430.50634765625</c:v>
                </c:pt>
                <c:pt idx="83">
                  <c:v>6392.46484375</c:v>
                </c:pt>
                <c:pt idx="84">
                  <c:v>6353.3251953125</c:v>
                </c:pt>
                <c:pt idx="85">
                  <c:v>6339.79638671875</c:v>
                </c:pt>
                <c:pt idx="86">
                  <c:v>6359.224609375</c:v>
                </c:pt>
                <c:pt idx="87">
                  <c:v>6396.62060546875</c:v>
                </c:pt>
                <c:pt idx="88">
                  <c:v>6428.66845703125</c:v>
                </c:pt>
                <c:pt idx="89">
                  <c:v>6441.71826171875</c:v>
                </c:pt>
                <c:pt idx="90">
                  <c:v>6438.67431640625</c:v>
                </c:pt>
                <c:pt idx="91">
                  <c:v>6430.765625</c:v>
                </c:pt>
                <c:pt idx="92">
                  <c:v>6423.9921875</c:v>
                </c:pt>
                <c:pt idx="93">
                  <c:v>6414.04345703125</c:v>
                </c:pt>
                <c:pt idx="94">
                  <c:v>6394.2880859375</c:v>
                </c:pt>
                <c:pt idx="95">
                  <c:v>6367.92578125</c:v>
                </c:pt>
                <c:pt idx="96">
                  <c:v>6350.552734375</c:v>
                </c:pt>
                <c:pt idx="97">
                  <c:v>6358.1982421875</c:v>
                </c:pt>
                <c:pt idx="98">
                  <c:v>6390.5322265625</c:v>
                </c:pt>
                <c:pt idx="99">
                  <c:v>6425.54150390625</c:v>
                </c:pt>
                <c:pt idx="100">
                  <c:v>6433.4765625</c:v>
                </c:pt>
                <c:pt idx="101">
                  <c:v>6400.85986328125</c:v>
                </c:pt>
                <c:pt idx="102">
                  <c:v>6344.81494140625</c:v>
                </c:pt>
                <c:pt idx="103">
                  <c:v>6304.07861328125</c:v>
                </c:pt>
                <c:pt idx="104">
                  <c:v>6311.689453125</c:v>
                </c:pt>
                <c:pt idx="105">
                  <c:v>6370.029296875</c:v>
                </c:pt>
                <c:pt idx="106">
                  <c:v>6448.02783203125</c:v>
                </c:pt>
                <c:pt idx="107">
                  <c:v>6503.05029296875</c:v>
                </c:pt>
                <c:pt idx="108">
                  <c:v>6510.41015625</c:v>
                </c:pt>
                <c:pt idx="109">
                  <c:v>6477.8076171875</c:v>
                </c:pt>
                <c:pt idx="110">
                  <c:v>6434.79345703125</c:v>
                </c:pt>
                <c:pt idx="111">
                  <c:v>6407.61669921875</c:v>
                </c:pt>
                <c:pt idx="112">
                  <c:v>6400.6318359375</c:v>
                </c:pt>
                <c:pt idx="113">
                  <c:v>6398.27880859375</c:v>
                </c:pt>
                <c:pt idx="114">
                  <c:v>6383.48046875</c:v>
                </c:pt>
                <c:pt idx="115">
                  <c:v>6354.98779296875</c:v>
                </c:pt>
                <c:pt idx="116">
                  <c:v>6328.685546875</c:v>
                </c:pt>
                <c:pt idx="117">
                  <c:v>6323.01806640625</c:v>
                </c:pt>
                <c:pt idx="118">
                  <c:v>6342.625</c:v>
                </c:pt>
                <c:pt idx="119">
                  <c:v>6374.89697265625</c:v>
                </c:pt>
                <c:pt idx="120">
                  <c:v>6401.6904296875</c:v>
                </c:pt>
                <c:pt idx="121">
                  <c:v>6414.62060546875</c:v>
                </c:pt>
                <c:pt idx="122">
                  <c:v>6419.7119140625</c:v>
                </c:pt>
                <c:pt idx="123">
                  <c:v>6427.66748046875</c:v>
                </c:pt>
                <c:pt idx="124">
                  <c:v>6439.7734375</c:v>
                </c:pt>
                <c:pt idx="125">
                  <c:v>6443.74755859375</c:v>
                </c:pt>
                <c:pt idx="126">
                  <c:v>6424.685546875</c:v>
                </c:pt>
                <c:pt idx="127">
                  <c:v>6381.97607421875</c:v>
                </c:pt>
                <c:pt idx="128">
                  <c:v>6336.47314453125</c:v>
                </c:pt>
                <c:pt idx="129">
                  <c:v>6319.6201171875</c:v>
                </c:pt>
                <c:pt idx="130">
                  <c:v>6351.3359375</c:v>
                </c:pt>
                <c:pt idx="131">
                  <c:v>6423.49365234375</c:v>
                </c:pt>
                <c:pt idx="132">
                  <c:v>6502.1669921875</c:v>
                </c:pt>
                <c:pt idx="133">
                  <c:v>6547.63720703125</c:v>
                </c:pt>
                <c:pt idx="134">
                  <c:v>6538.04345703125</c:v>
                </c:pt>
                <c:pt idx="135">
                  <c:v>6480.7578125</c:v>
                </c:pt>
                <c:pt idx="136">
                  <c:v>6405.45654296875</c:v>
                </c:pt>
                <c:pt idx="137">
                  <c:v>6345.740234375</c:v>
                </c:pt>
                <c:pt idx="138">
                  <c:v>6322.0986328125</c:v>
                </c:pt>
                <c:pt idx="139">
                  <c:v>6335.12060546875</c:v>
                </c:pt>
                <c:pt idx="140">
                  <c:v>6369.3427734375</c:v>
                </c:pt>
                <c:pt idx="141">
                  <c:v>6402.49267578125</c:v>
                </c:pt>
                <c:pt idx="142">
                  <c:v>6415.060546875</c:v>
                </c:pt>
                <c:pt idx="143">
                  <c:v>6398.021484375</c:v>
                </c:pt>
                <c:pt idx="144">
                  <c:v>6357.6416015625</c:v>
                </c:pt>
                <c:pt idx="145">
                  <c:v>6314.89697265625</c:v>
                </c:pt>
                <c:pt idx="146">
                  <c:v>6296.79833984375</c:v>
                </c:pt>
                <c:pt idx="147">
                  <c:v>6321.10107421875</c:v>
                </c:pt>
                <c:pt idx="148">
                  <c:v>6382.53662109375</c:v>
                </c:pt>
                <c:pt idx="149">
                  <c:v>6451.345703125</c:v>
                </c:pt>
                <c:pt idx="150">
                  <c:v>6488.666015625</c:v>
                </c:pt>
                <c:pt idx="151">
                  <c:v>6471.025390625</c:v>
                </c:pt>
                <c:pt idx="152">
                  <c:v>6407.298828125</c:v>
                </c:pt>
                <c:pt idx="153">
                  <c:v>6334.67822265625</c:v>
                </c:pt>
                <c:pt idx="154">
                  <c:v>6294.8505859375</c:v>
                </c:pt>
                <c:pt idx="155">
                  <c:v>6306.89208984375</c:v>
                </c:pt>
                <c:pt idx="156">
                  <c:v>6356.7041015625</c:v>
                </c:pt>
                <c:pt idx="157">
                  <c:v>6410.53076171875</c:v>
                </c:pt>
                <c:pt idx="158">
                  <c:v>6441.38916015625</c:v>
                </c:pt>
                <c:pt idx="159">
                  <c:v>6447.310546875</c:v>
                </c:pt>
                <c:pt idx="160">
                  <c:v>6447.40966796875</c:v>
                </c:pt>
                <c:pt idx="161">
                  <c:v>6460.3662109375</c:v>
                </c:pt>
                <c:pt idx="162">
                  <c:v>6484.4599609375</c:v>
                </c:pt>
                <c:pt idx="163">
                  <c:v>6496.76416015625</c:v>
                </c:pt>
                <c:pt idx="164">
                  <c:v>6472.6767578125</c:v>
                </c:pt>
                <c:pt idx="165">
                  <c:v>6409.54296875</c:v>
                </c:pt>
                <c:pt idx="166">
                  <c:v>6334.2294921875</c:v>
                </c:pt>
                <c:pt idx="167">
                  <c:v>6287.4189453125</c:v>
                </c:pt>
                <c:pt idx="168">
                  <c:v>6296.2119140625</c:v>
                </c:pt>
                <c:pt idx="169">
                  <c:v>6355.8876953125</c:v>
                </c:pt>
                <c:pt idx="170">
                  <c:v>6434.07275390625</c:v>
                </c:pt>
                <c:pt idx="171">
                  <c:v>6493.00537109375</c:v>
                </c:pt>
                <c:pt idx="172">
                  <c:v>6512.4921875</c:v>
                </c:pt>
                <c:pt idx="173">
                  <c:v>6497.58935546875</c:v>
                </c:pt>
                <c:pt idx="174">
                  <c:v>6468.38623046875</c:v>
                </c:pt>
                <c:pt idx="175">
                  <c:v>6442.73583984375</c:v>
                </c:pt>
                <c:pt idx="176">
                  <c:v>6425.69384765625</c:v>
                </c:pt>
                <c:pt idx="177">
                  <c:v>6411.26513671875</c:v>
                </c:pt>
                <c:pt idx="178">
                  <c:v>6391.30908203125</c:v>
                </c:pt>
                <c:pt idx="179">
                  <c:v>6362.583984375</c:v>
                </c:pt>
                <c:pt idx="180">
                  <c:v>6327.63671875</c:v>
                </c:pt>
                <c:pt idx="181">
                  <c:v>6292.3154296875</c:v>
                </c:pt>
                <c:pt idx="182">
                  <c:v>6264.640625</c:v>
                </c:pt>
                <c:pt idx="183">
                  <c:v>6255.45166015625</c:v>
                </c:pt>
                <c:pt idx="184">
                  <c:v>6276.45458984375</c:v>
                </c:pt>
                <c:pt idx="185">
                  <c:v>6332.47900390625</c:v>
                </c:pt>
                <c:pt idx="186">
                  <c:v>6411.8193359375</c:v>
                </c:pt>
                <c:pt idx="187">
                  <c:v>6484.302734375</c:v>
                </c:pt>
                <c:pt idx="188">
                  <c:v>6513.85986328125</c:v>
                </c:pt>
                <c:pt idx="189">
                  <c:v>6481.0625</c:v>
                </c:pt>
                <c:pt idx="190">
                  <c:v>6400.4111328125</c:v>
                </c:pt>
                <c:pt idx="191">
                  <c:v>6317.357421875</c:v>
                </c:pt>
                <c:pt idx="192">
                  <c:v>6283.22607421875</c:v>
                </c:pt>
                <c:pt idx="193">
                  <c:v>6323.05859375</c:v>
                </c:pt>
                <c:pt idx="194">
                  <c:v>6418.4150390625</c:v>
                </c:pt>
                <c:pt idx="195">
                  <c:v>6517.78173828125</c:v>
                </c:pt>
                <c:pt idx="196">
                  <c:v>6567.97509765625</c:v>
                </c:pt>
                <c:pt idx="197">
                  <c:v>6545.33984375</c:v>
                </c:pt>
                <c:pt idx="198">
                  <c:v>6466.6259765625</c:v>
                </c:pt>
                <c:pt idx="199">
                  <c:v>6374.7294921875</c:v>
                </c:pt>
                <c:pt idx="200">
                  <c:v>6311.7001953125</c:v>
                </c:pt>
                <c:pt idx="201">
                  <c:v>6297.78173828125</c:v>
                </c:pt>
                <c:pt idx="202">
                  <c:v>6327.515625</c:v>
                </c:pt>
                <c:pt idx="203">
                  <c:v>6380.18701171875</c:v>
                </c:pt>
                <c:pt idx="204">
                  <c:v>6433.47509765625</c:v>
                </c:pt>
                <c:pt idx="205">
                  <c:v>6471.27197265625</c:v>
                </c:pt>
                <c:pt idx="206">
                  <c:v>6484.81103515625</c:v>
                </c:pt>
                <c:pt idx="207">
                  <c:v>6471.85498046875</c:v>
                </c:pt>
                <c:pt idx="208">
                  <c:v>6437.33740234375</c:v>
                </c:pt>
                <c:pt idx="209">
                  <c:v>6393.72607421875</c:v>
                </c:pt>
                <c:pt idx="210">
                  <c:v>6357.2568359375</c:v>
                </c:pt>
                <c:pt idx="211">
                  <c:v>6339.8818359375</c:v>
                </c:pt>
                <c:pt idx="212">
                  <c:v>6342.4384765625</c:v>
                </c:pt>
                <c:pt idx="213">
                  <c:v>6355.44921875</c:v>
                </c:pt>
                <c:pt idx="214">
                  <c:v>6367.99169921875</c:v>
                </c:pt>
                <c:pt idx="215">
                  <c:v>6377.2880859375</c:v>
                </c:pt>
                <c:pt idx="216">
                  <c:v>6389.9755859375</c:v>
                </c:pt>
                <c:pt idx="217">
                  <c:v>6413.0751953125</c:v>
                </c:pt>
                <c:pt idx="218">
                  <c:v>6442.73486328125</c:v>
                </c:pt>
                <c:pt idx="219">
                  <c:v>6462.2373046875</c:v>
                </c:pt>
                <c:pt idx="220">
                  <c:v>6453.38818359375</c:v>
                </c:pt>
                <c:pt idx="221">
                  <c:v>6412.89794921875</c:v>
                </c:pt>
                <c:pt idx="222">
                  <c:v>6359.22216796875</c:v>
                </c:pt>
                <c:pt idx="223">
                  <c:v>6321.9970703125</c:v>
                </c:pt>
                <c:pt idx="224">
                  <c:v>6320.9912109375</c:v>
                </c:pt>
                <c:pt idx="225">
                  <c:v>6351.53515625</c:v>
                </c:pt>
                <c:pt idx="226">
                  <c:v>6389.10498046875</c:v>
                </c:pt>
                <c:pt idx="227">
                  <c:v>6409.86181640625</c:v>
                </c:pt>
                <c:pt idx="228">
                  <c:v>6409.90283203125</c:v>
                </c:pt>
                <c:pt idx="229">
                  <c:v>6406.47314453125</c:v>
                </c:pt>
                <c:pt idx="230">
                  <c:v>6419.79833984375</c:v>
                </c:pt>
                <c:pt idx="231">
                  <c:v>6451.55908203125</c:v>
                </c:pt>
                <c:pt idx="232">
                  <c:v>6479.86181640625</c:v>
                </c:pt>
                <c:pt idx="233">
                  <c:v>6476.7109375</c:v>
                </c:pt>
                <c:pt idx="234">
                  <c:v>6433.875</c:v>
                </c:pt>
                <c:pt idx="235">
                  <c:v>6374.30078125</c:v>
                </c:pt>
                <c:pt idx="236">
                  <c:v>6337.30419921875</c:v>
                </c:pt>
                <c:pt idx="237">
                  <c:v>6347.97998046875</c:v>
                </c:pt>
                <c:pt idx="238">
                  <c:v>6395.77490234375</c:v>
                </c:pt>
                <c:pt idx="239">
                  <c:v>6440.91064453125</c:v>
                </c:pt>
                <c:pt idx="240">
                  <c:v>6444.8271484375</c:v>
                </c:pt>
                <c:pt idx="241">
                  <c:v>6400.6611328125</c:v>
                </c:pt>
                <c:pt idx="242">
                  <c:v>6339.10986328125</c:v>
                </c:pt>
                <c:pt idx="243">
                  <c:v>6304.76123046875</c:v>
                </c:pt>
                <c:pt idx="244">
                  <c:v>6321.87060546875</c:v>
                </c:pt>
                <c:pt idx="245">
                  <c:v>6376.77197265625</c:v>
                </c:pt>
                <c:pt idx="246">
                  <c:v>6430.06005859375</c:v>
                </c:pt>
                <c:pt idx="247">
                  <c:v>6447.46630859375</c:v>
                </c:pt>
                <c:pt idx="248">
                  <c:v>6424.1806640625</c:v>
                </c:pt>
                <c:pt idx="249">
                  <c:v>6384.45654296875</c:v>
                </c:pt>
                <c:pt idx="250">
                  <c:v>6359.66064453125</c:v>
                </c:pt>
                <c:pt idx="251">
                  <c:v>6364.8271484375</c:v>
                </c:pt>
                <c:pt idx="252">
                  <c:v>6392.4453125</c:v>
                </c:pt>
                <c:pt idx="253">
                  <c:v>6425.20263671875</c:v>
                </c:pt>
                <c:pt idx="254">
                  <c:v>6452.7275390625</c:v>
                </c:pt>
                <c:pt idx="255">
                  <c:v>6475.8671875</c:v>
                </c:pt>
                <c:pt idx="256">
                  <c:v>6496.0908203125</c:v>
                </c:pt>
                <c:pt idx="257">
                  <c:v>6503.37353515625</c:v>
                </c:pt>
                <c:pt idx="258">
                  <c:v>6478.2060546875</c:v>
                </c:pt>
                <c:pt idx="259">
                  <c:v>6409.55810546875</c:v>
                </c:pt>
                <c:pt idx="260">
                  <c:v>6313.4765625</c:v>
                </c:pt>
                <c:pt idx="261">
                  <c:v>6232.94677734375</c:v>
                </c:pt>
                <c:pt idx="262">
                  <c:v>6213.8349609375</c:v>
                </c:pt>
                <c:pt idx="263">
                  <c:v>6272.7294921875</c:v>
                </c:pt>
                <c:pt idx="264">
                  <c:v>6381.8515625</c:v>
                </c:pt>
                <c:pt idx="265">
                  <c:v>6484.70703125</c:v>
                </c:pt>
                <c:pt idx="266">
                  <c:v>6532.36865234375</c:v>
                </c:pt>
                <c:pt idx="267">
                  <c:v>6513.71630859375</c:v>
                </c:pt>
                <c:pt idx="268">
                  <c:v>6457.60205078125</c:v>
                </c:pt>
                <c:pt idx="269">
                  <c:v>6407.08251953125</c:v>
                </c:pt>
                <c:pt idx="270">
                  <c:v>6387.37939453125</c:v>
                </c:pt>
                <c:pt idx="271">
                  <c:v>6392.52294921875</c:v>
                </c:pt>
                <c:pt idx="272">
                  <c:v>6398.69140625</c:v>
                </c:pt>
                <c:pt idx="273">
                  <c:v>6389.88232421875</c:v>
                </c:pt>
                <c:pt idx="274">
                  <c:v>6372.57373046875</c:v>
                </c:pt>
                <c:pt idx="275">
                  <c:v>6367.31640625</c:v>
                </c:pt>
                <c:pt idx="276">
                  <c:v>6386.24560546875</c:v>
                </c:pt>
                <c:pt idx="277">
                  <c:v>6417.83203125</c:v>
                </c:pt>
                <c:pt idx="278">
                  <c:v>6433.47998046875</c:v>
                </c:pt>
                <c:pt idx="279">
                  <c:v>6411.06201171875</c:v>
                </c:pt>
                <c:pt idx="280">
                  <c:v>6355.37841796875</c:v>
                </c:pt>
                <c:pt idx="281">
                  <c:v>6297.7578125</c:v>
                </c:pt>
                <c:pt idx="282">
                  <c:v>6274.470703125</c:v>
                </c:pt>
                <c:pt idx="283">
                  <c:v>6301.18603515625</c:v>
                </c:pt>
                <c:pt idx="284">
                  <c:v>6363.56591796875</c:v>
                </c:pt>
                <c:pt idx="285">
                  <c:v>6430.2744140625</c:v>
                </c:pt>
                <c:pt idx="286">
                  <c:v>6476.36669921875</c:v>
                </c:pt>
                <c:pt idx="287">
                  <c:v>6497.638671875</c:v>
                </c:pt>
                <c:pt idx="288">
                  <c:v>6505.72021484375</c:v>
                </c:pt>
                <c:pt idx="289">
                  <c:v>6510.80078125</c:v>
                </c:pt>
                <c:pt idx="290">
                  <c:v>6508.97265625</c:v>
                </c:pt>
                <c:pt idx="291">
                  <c:v>6485.94775390625</c:v>
                </c:pt>
                <c:pt idx="292">
                  <c:v>6433.5068359375</c:v>
                </c:pt>
                <c:pt idx="293">
                  <c:v>6363.17822265625</c:v>
                </c:pt>
                <c:pt idx="294">
                  <c:v>6303.6318359375</c:v>
                </c:pt>
                <c:pt idx="295">
                  <c:v>6282.22509765625</c:v>
                </c:pt>
                <c:pt idx="296">
                  <c:v>6305.03173828125</c:v>
                </c:pt>
                <c:pt idx="297">
                  <c:v>6351.69970703125</c:v>
                </c:pt>
                <c:pt idx="298">
                  <c:v>6389.86181640625</c:v>
                </c:pt>
                <c:pt idx="299">
                  <c:v>6398.28759765625</c:v>
                </c:pt>
                <c:pt idx="300">
                  <c:v>6381.08642578125</c:v>
                </c:pt>
                <c:pt idx="301">
                  <c:v>6362.41650390625</c:v>
                </c:pt>
                <c:pt idx="302">
                  <c:v>6366.3310546875</c:v>
                </c:pt>
                <c:pt idx="303">
                  <c:v>6397.484375</c:v>
                </c:pt>
                <c:pt idx="304">
                  <c:v>6437.1953125</c:v>
                </c:pt>
                <c:pt idx="305">
                  <c:v>6457.326171875</c:v>
                </c:pt>
                <c:pt idx="306">
                  <c:v>6441.2822265625</c:v>
                </c:pt>
                <c:pt idx="307">
                  <c:v>6396.78515625</c:v>
                </c:pt>
                <c:pt idx="308">
                  <c:v>6351.64892578125</c:v>
                </c:pt>
                <c:pt idx="309">
                  <c:v>6335.955078125</c:v>
                </c:pt>
                <c:pt idx="310">
                  <c:v>6362.91552734375</c:v>
                </c:pt>
                <c:pt idx="311">
                  <c:v>6420.7041015625</c:v>
                </c:pt>
                <c:pt idx="312">
                  <c:v>6479.732421875</c:v>
                </c:pt>
                <c:pt idx="313">
                  <c:v>6510.05517578125</c:v>
                </c:pt>
                <c:pt idx="314">
                  <c:v>6498.05029296875</c:v>
                </c:pt>
                <c:pt idx="315">
                  <c:v>6452.87939453125</c:v>
                </c:pt>
                <c:pt idx="316">
                  <c:v>6399.80419921875</c:v>
                </c:pt>
                <c:pt idx="317">
                  <c:v>6365.00146484375</c:v>
                </c:pt>
                <c:pt idx="318">
                  <c:v>6360.95654296875</c:v>
                </c:pt>
                <c:pt idx="319">
                  <c:v>6380.712890625</c:v>
                </c:pt>
                <c:pt idx="320">
                  <c:v>6403.87939453125</c:v>
                </c:pt>
                <c:pt idx="321">
                  <c:v>6410.3525390625</c:v>
                </c:pt>
                <c:pt idx="322">
                  <c:v>6393.12744140625</c:v>
                </c:pt>
                <c:pt idx="323">
                  <c:v>6362.24462890625</c:v>
                </c:pt>
                <c:pt idx="324">
                  <c:v>6337.59130859375</c:v>
                </c:pt>
                <c:pt idx="325">
                  <c:v>6335.564453125</c:v>
                </c:pt>
                <c:pt idx="326">
                  <c:v>6358.58447265625</c:v>
                </c:pt>
                <c:pt idx="327">
                  <c:v>6394.29931640625</c:v>
                </c:pt>
                <c:pt idx="328">
                  <c:v>6424.43212890625</c:v>
                </c:pt>
                <c:pt idx="329">
                  <c:v>6436.5390625</c:v>
                </c:pt>
                <c:pt idx="330">
                  <c:v>6430.3740234375</c:v>
                </c:pt>
                <c:pt idx="331">
                  <c:v>6415.16064453125</c:v>
                </c:pt>
                <c:pt idx="332">
                  <c:v>6401.0888671875</c:v>
                </c:pt>
                <c:pt idx="333">
                  <c:v>6392.310546875</c:v>
                </c:pt>
                <c:pt idx="334">
                  <c:v>6386.59375</c:v>
                </c:pt>
                <c:pt idx="335">
                  <c:v>6380.72021484375</c:v>
                </c:pt>
                <c:pt idx="336">
                  <c:v>6375.8935546875</c:v>
                </c:pt>
                <c:pt idx="337">
                  <c:v>6377.8427734375</c:v>
                </c:pt>
                <c:pt idx="338">
                  <c:v>6391.3740234375</c:v>
                </c:pt>
                <c:pt idx="339">
                  <c:v>6414.3037109375</c:v>
                </c:pt>
                <c:pt idx="340">
                  <c:v>6436.48486328125</c:v>
                </c:pt>
                <c:pt idx="341">
                  <c:v>6445.4248046875</c:v>
                </c:pt>
                <c:pt idx="342">
                  <c:v>6434.4541015625</c:v>
                </c:pt>
                <c:pt idx="343">
                  <c:v>6407.2939453125</c:v>
                </c:pt>
                <c:pt idx="344">
                  <c:v>6375.765625</c:v>
                </c:pt>
                <c:pt idx="345">
                  <c:v>6352.71923828125</c:v>
                </c:pt>
                <c:pt idx="346">
                  <c:v>6345.45703125</c:v>
                </c:pt>
                <c:pt idx="347">
                  <c:v>6353.73095703125</c:v>
                </c:pt>
                <c:pt idx="348">
                  <c:v>6372.27490234375</c:v>
                </c:pt>
                <c:pt idx="349">
                  <c:v>6394.666015625</c:v>
                </c:pt>
              </c:numCache>
            </c:numRef>
          </c:yVal>
          <c:smooth val="1"/>
          <c:extLst>
            <c:ext xmlns:c16="http://schemas.microsoft.com/office/drawing/2014/chart" uri="{C3380CC4-5D6E-409C-BE32-E72D297353CC}">
              <c16:uniqueId val="{0000000E-4A37-429A-A58F-F7AEDA5D1ACA}"/>
            </c:ext>
          </c:extLst>
        </c:ser>
        <c:ser>
          <c:idx val="15"/>
          <c:order val="15"/>
          <c:tx>
            <c:strRef>
              <c:f>cp_sub_001!$P$1</c:f>
              <c:strCache>
                <c:ptCount val="1"/>
                <c:pt idx="0">
                  <c:v>Coor_16</c:v>
                </c:pt>
              </c:strCache>
            </c:strRef>
          </c:tx>
          <c:spPr>
            <a:ln w="28575" cap="rnd">
              <a:solidFill>
                <a:schemeClr val="accent4">
                  <a:lumMod val="80000"/>
                  <a:lumOff val="20000"/>
                </a:schemeClr>
              </a:solidFill>
              <a:round/>
            </a:ln>
            <a:effectLst/>
          </c:spPr>
          <c:marker>
            <c:symbol val="none"/>
          </c:marker>
          <c:yVal>
            <c:numRef>
              <c:f>cp_sub_001!$P$2:$P$351</c:f>
              <c:numCache>
                <c:formatCode>0.00000000000_ </c:formatCode>
                <c:ptCount val="350"/>
                <c:pt idx="0">
                  <c:v>5816.35498046875</c:v>
                </c:pt>
                <c:pt idx="1">
                  <c:v>5789.509765625</c:v>
                </c:pt>
                <c:pt idx="2">
                  <c:v>5751.53759765625</c:v>
                </c:pt>
                <c:pt idx="3">
                  <c:v>5727.33203125</c:v>
                </c:pt>
                <c:pt idx="4">
                  <c:v>5734.22216796875</c:v>
                </c:pt>
                <c:pt idx="5">
                  <c:v>5769.66259765625</c:v>
                </c:pt>
                <c:pt idx="6">
                  <c:v>5814.72509765625</c:v>
                </c:pt>
                <c:pt idx="7">
                  <c:v>5849.5380859375</c:v>
                </c:pt>
                <c:pt idx="8">
                  <c:v>5866.8955078125</c:v>
                </c:pt>
                <c:pt idx="9">
                  <c:v>5872.71044921875</c:v>
                </c:pt>
                <c:pt idx="10">
                  <c:v>5874.580078125</c:v>
                </c:pt>
                <c:pt idx="11">
                  <c:v>5870.83349609375</c:v>
                </c:pt>
                <c:pt idx="12">
                  <c:v>5851.77978515625</c:v>
                </c:pt>
                <c:pt idx="13">
                  <c:v>5812.70849609375</c:v>
                </c:pt>
                <c:pt idx="14">
                  <c:v>5765.75390625</c:v>
                </c:pt>
                <c:pt idx="15">
                  <c:v>5736.94921875</c:v>
                </c:pt>
                <c:pt idx="16">
                  <c:v>5747.56201171875</c:v>
                </c:pt>
                <c:pt idx="17">
                  <c:v>5794.21630859375</c:v>
                </c:pt>
                <c:pt idx="18">
                  <c:v>5846.162109375</c:v>
                </c:pt>
                <c:pt idx="19">
                  <c:v>5865.39697265625</c:v>
                </c:pt>
                <c:pt idx="20">
                  <c:v>5835.90087890625</c:v>
                </c:pt>
                <c:pt idx="21">
                  <c:v>5778.6171875</c:v>
                </c:pt>
                <c:pt idx="22">
                  <c:v>5738.36962890625</c:v>
                </c:pt>
                <c:pt idx="23">
                  <c:v>5750.8876953125</c:v>
                </c:pt>
                <c:pt idx="24">
                  <c:v>5814.83154296875</c:v>
                </c:pt>
                <c:pt idx="25">
                  <c:v>5890.8525390625</c:v>
                </c:pt>
                <c:pt idx="26">
                  <c:v>5929.00537109375</c:v>
                </c:pt>
                <c:pt idx="27">
                  <c:v>5903.75390625</c:v>
                </c:pt>
                <c:pt idx="28">
                  <c:v>5830.22705078125</c:v>
                </c:pt>
                <c:pt idx="29">
                  <c:v>5750.6689453125</c:v>
                </c:pt>
                <c:pt idx="30">
                  <c:v>5703.41259765625</c:v>
                </c:pt>
                <c:pt idx="31">
                  <c:v>5699.1396484375</c:v>
                </c:pt>
                <c:pt idx="32">
                  <c:v>5721.14453125</c:v>
                </c:pt>
                <c:pt idx="33">
                  <c:v>5745.60888671875</c:v>
                </c:pt>
                <c:pt idx="34">
                  <c:v>5762.29345703125</c:v>
                </c:pt>
                <c:pt idx="35">
                  <c:v>5778.2392578125</c:v>
                </c:pt>
                <c:pt idx="36">
                  <c:v>5803.89404296875</c:v>
                </c:pt>
                <c:pt idx="37">
                  <c:v>5837.0400390625</c:v>
                </c:pt>
                <c:pt idx="38">
                  <c:v>5860.998046875</c:v>
                </c:pt>
                <c:pt idx="39">
                  <c:v>5859.447265625</c:v>
                </c:pt>
                <c:pt idx="40">
                  <c:v>5834.01806640625</c:v>
                </c:pt>
                <c:pt idx="41">
                  <c:v>5807.3857421875</c:v>
                </c:pt>
                <c:pt idx="42">
                  <c:v>5807.13037109375</c:v>
                </c:pt>
                <c:pt idx="43">
                  <c:v>5842.96923828125</c:v>
                </c:pt>
                <c:pt idx="44">
                  <c:v>5896.6796875</c:v>
                </c:pt>
                <c:pt idx="45">
                  <c:v>5933.89990234375</c:v>
                </c:pt>
                <c:pt idx="46">
                  <c:v>5928.73095703125</c:v>
                </c:pt>
                <c:pt idx="47">
                  <c:v>5881.423828125</c:v>
                </c:pt>
                <c:pt idx="48">
                  <c:v>5815.55859375</c:v>
                </c:pt>
                <c:pt idx="49">
                  <c:v>5758.5048828125</c:v>
                </c:pt>
                <c:pt idx="50">
                  <c:v>5722.47705078125</c:v>
                </c:pt>
                <c:pt idx="51">
                  <c:v>5701.64892578125</c:v>
                </c:pt>
                <c:pt idx="52">
                  <c:v>5685.69677734375</c:v>
                </c:pt>
                <c:pt idx="53">
                  <c:v>5675.4150390625</c:v>
                </c:pt>
                <c:pt idx="54">
                  <c:v>5684.72412109375</c:v>
                </c:pt>
                <c:pt idx="55">
                  <c:v>5726.43701171875</c:v>
                </c:pt>
                <c:pt idx="56">
                  <c:v>5794.79443359375</c:v>
                </c:pt>
                <c:pt idx="57">
                  <c:v>5861.89697265625</c:v>
                </c:pt>
                <c:pt idx="58">
                  <c:v>5893.814453125</c:v>
                </c:pt>
                <c:pt idx="59">
                  <c:v>5874.97265625</c:v>
                </c:pt>
                <c:pt idx="60">
                  <c:v>5821.2822265625</c:v>
                </c:pt>
                <c:pt idx="61">
                  <c:v>5770.60498046875</c:v>
                </c:pt>
                <c:pt idx="62">
                  <c:v>5756.982421875</c:v>
                </c:pt>
                <c:pt idx="63">
                  <c:v>5787.8291015625</c:v>
                </c:pt>
                <c:pt idx="64">
                  <c:v>5840.71435546875</c:v>
                </c:pt>
                <c:pt idx="65">
                  <c:v>5880.947265625</c:v>
                </c:pt>
                <c:pt idx="66">
                  <c:v>5885.69287109375</c:v>
                </c:pt>
                <c:pt idx="67">
                  <c:v>5856.95947265625</c:v>
                </c:pt>
                <c:pt idx="68">
                  <c:v>5816.01318359375</c:v>
                </c:pt>
                <c:pt idx="69">
                  <c:v>5786.3125</c:v>
                </c:pt>
                <c:pt idx="70">
                  <c:v>5779.05029296875</c:v>
                </c:pt>
                <c:pt idx="71">
                  <c:v>5790.57080078125</c:v>
                </c:pt>
                <c:pt idx="72">
                  <c:v>5810.0302734375</c:v>
                </c:pt>
                <c:pt idx="73">
                  <c:v>5828.4892578125</c:v>
                </c:pt>
                <c:pt idx="74">
                  <c:v>5842.27001953125</c:v>
                </c:pt>
                <c:pt idx="75">
                  <c:v>5850.57470703125</c:v>
                </c:pt>
                <c:pt idx="76">
                  <c:v>5852.49951171875</c:v>
                </c:pt>
                <c:pt idx="77">
                  <c:v>5847.353515625</c:v>
                </c:pt>
                <c:pt idx="78">
                  <c:v>5837.0068359375</c:v>
                </c:pt>
                <c:pt idx="79">
                  <c:v>5825.99951171875</c:v>
                </c:pt>
                <c:pt idx="80">
                  <c:v>5817.6298828125</c:v>
                </c:pt>
                <c:pt idx="81">
                  <c:v>5809.49462890625</c:v>
                </c:pt>
                <c:pt idx="82">
                  <c:v>5793.97314453125</c:v>
                </c:pt>
                <c:pt idx="83">
                  <c:v>5765.146484375</c:v>
                </c:pt>
                <c:pt idx="84">
                  <c:v>5726.916015625</c:v>
                </c:pt>
                <c:pt idx="85">
                  <c:v>5694.43359375</c:v>
                </c:pt>
                <c:pt idx="86">
                  <c:v>5685.6953125</c:v>
                </c:pt>
                <c:pt idx="87">
                  <c:v>5708.779296875</c:v>
                </c:pt>
                <c:pt idx="88">
                  <c:v>5754.92578125</c:v>
                </c:pt>
                <c:pt idx="89">
                  <c:v>5803.64990234375</c:v>
                </c:pt>
                <c:pt idx="90">
                  <c:v>5836.2958984375</c:v>
                </c:pt>
                <c:pt idx="91">
                  <c:v>5847.29296875</c:v>
                </c:pt>
                <c:pt idx="92">
                  <c:v>5844.35595703125</c:v>
                </c:pt>
                <c:pt idx="93">
                  <c:v>5838.4970703125</c:v>
                </c:pt>
                <c:pt idx="94">
                  <c:v>5833.501953125</c:v>
                </c:pt>
                <c:pt idx="95">
                  <c:v>5824.5654296875</c:v>
                </c:pt>
                <c:pt idx="96">
                  <c:v>5806.92041015625</c:v>
                </c:pt>
                <c:pt idx="97">
                  <c:v>5785.55126953125</c:v>
                </c:pt>
                <c:pt idx="98">
                  <c:v>5775.50927734375</c:v>
                </c:pt>
                <c:pt idx="99">
                  <c:v>5790.76416015625</c:v>
                </c:pt>
                <c:pt idx="100">
                  <c:v>5830.65087890625</c:v>
                </c:pt>
                <c:pt idx="101">
                  <c:v>5876.47265625</c:v>
                </c:pt>
                <c:pt idx="102">
                  <c:v>5903.02099609375</c:v>
                </c:pt>
                <c:pt idx="103">
                  <c:v>5896.86572265625</c:v>
                </c:pt>
                <c:pt idx="104">
                  <c:v>5866.5966796875</c:v>
                </c:pt>
                <c:pt idx="105">
                  <c:v>5836.00927734375</c:v>
                </c:pt>
                <c:pt idx="106">
                  <c:v>5825.1044921875</c:v>
                </c:pt>
                <c:pt idx="107">
                  <c:v>5834.08154296875</c:v>
                </c:pt>
                <c:pt idx="108">
                  <c:v>5843.3310546875</c:v>
                </c:pt>
                <c:pt idx="109">
                  <c:v>5829.4541015625</c:v>
                </c:pt>
                <c:pt idx="110">
                  <c:v>5784.345703125</c:v>
                </c:pt>
                <c:pt idx="111">
                  <c:v>5722.25927734375</c:v>
                </c:pt>
                <c:pt idx="112">
                  <c:v>5669.9814453125</c:v>
                </c:pt>
                <c:pt idx="113">
                  <c:v>5648.87646484375</c:v>
                </c:pt>
                <c:pt idx="114">
                  <c:v>5663.1533203125</c:v>
                </c:pt>
                <c:pt idx="115">
                  <c:v>5702.03759765625</c:v>
                </c:pt>
                <c:pt idx="116">
                  <c:v>5751.203125</c:v>
                </c:pt>
                <c:pt idx="117">
                  <c:v>5801.8759765625</c:v>
                </c:pt>
                <c:pt idx="118">
                  <c:v>5850.21630859375</c:v>
                </c:pt>
                <c:pt idx="119">
                  <c:v>5890.27880859375</c:v>
                </c:pt>
                <c:pt idx="120">
                  <c:v>5910.64208984375</c:v>
                </c:pt>
                <c:pt idx="121">
                  <c:v>5900.99169921875</c:v>
                </c:pt>
                <c:pt idx="122">
                  <c:v>5864.05908203125</c:v>
                </c:pt>
                <c:pt idx="123">
                  <c:v>5820.8154296875</c:v>
                </c:pt>
                <c:pt idx="124">
                  <c:v>5800.61572265625</c:v>
                </c:pt>
                <c:pt idx="125">
                  <c:v>5820.85595703125</c:v>
                </c:pt>
                <c:pt idx="126">
                  <c:v>5871.52734375</c:v>
                </c:pt>
                <c:pt idx="127">
                  <c:v>5918.60205078125</c:v>
                </c:pt>
                <c:pt idx="128">
                  <c:v>5926.2490234375</c:v>
                </c:pt>
                <c:pt idx="129">
                  <c:v>5882.34033203125</c:v>
                </c:pt>
                <c:pt idx="130">
                  <c:v>5807.7236328125</c:v>
                </c:pt>
                <c:pt idx="131">
                  <c:v>5741.4091796875</c:v>
                </c:pt>
                <c:pt idx="132">
                  <c:v>5712.46240234375</c:v>
                </c:pt>
                <c:pt idx="133">
                  <c:v>5720.06005859375</c:v>
                </c:pt>
                <c:pt idx="134">
                  <c:v>5737.056640625</c:v>
                </c:pt>
                <c:pt idx="135">
                  <c:v>5734.0546875</c:v>
                </c:pt>
                <c:pt idx="136">
                  <c:v>5704.87890625</c:v>
                </c:pt>
                <c:pt idx="137">
                  <c:v>5673.2685546875</c:v>
                </c:pt>
                <c:pt idx="138">
                  <c:v>5675.255859375</c:v>
                </c:pt>
                <c:pt idx="139">
                  <c:v>5730.6064453125</c:v>
                </c:pt>
                <c:pt idx="140">
                  <c:v>5825.05908203125</c:v>
                </c:pt>
                <c:pt idx="141">
                  <c:v>5916.841796875</c:v>
                </c:pt>
                <c:pt idx="142">
                  <c:v>5962.80615234375</c:v>
                </c:pt>
                <c:pt idx="143">
                  <c:v>5945.4609375</c:v>
                </c:pt>
                <c:pt idx="144">
                  <c:v>5882.3955078125</c:v>
                </c:pt>
                <c:pt idx="145">
                  <c:v>5812.93017578125</c:v>
                </c:pt>
                <c:pt idx="146">
                  <c:v>5772.7294921875</c:v>
                </c:pt>
                <c:pt idx="147">
                  <c:v>5774.0478515625</c:v>
                </c:pt>
                <c:pt idx="148">
                  <c:v>5803.35986328125</c:v>
                </c:pt>
                <c:pt idx="149">
                  <c:v>5835.06103515625</c:v>
                </c:pt>
                <c:pt idx="150">
                  <c:v>5849.65576171875</c:v>
                </c:pt>
                <c:pt idx="151">
                  <c:v>5843.9716796875</c:v>
                </c:pt>
                <c:pt idx="152">
                  <c:v>5828.482421875</c:v>
                </c:pt>
                <c:pt idx="153">
                  <c:v>5816.23828125</c:v>
                </c:pt>
                <c:pt idx="154">
                  <c:v>5812.5751953125</c:v>
                </c:pt>
                <c:pt idx="155">
                  <c:v>5812.5146484375</c:v>
                </c:pt>
                <c:pt idx="156">
                  <c:v>5806.37109375</c:v>
                </c:pt>
                <c:pt idx="157">
                  <c:v>5788.50927734375</c:v>
                </c:pt>
                <c:pt idx="158">
                  <c:v>5762.7373046875</c:v>
                </c:pt>
                <c:pt idx="159">
                  <c:v>5740.73193359375</c:v>
                </c:pt>
                <c:pt idx="160">
                  <c:v>5734.68408203125</c:v>
                </c:pt>
                <c:pt idx="161">
                  <c:v>5749.0634765625</c:v>
                </c:pt>
                <c:pt idx="162">
                  <c:v>5776.93994140625</c:v>
                </c:pt>
                <c:pt idx="163">
                  <c:v>5803.52978515625</c:v>
                </c:pt>
                <c:pt idx="164">
                  <c:v>5815.1064453125</c:v>
                </c:pt>
                <c:pt idx="165">
                  <c:v>5807.80615234375</c:v>
                </c:pt>
                <c:pt idx="166">
                  <c:v>5790.50537109375</c:v>
                </c:pt>
                <c:pt idx="167">
                  <c:v>5779.46630859375</c:v>
                </c:pt>
                <c:pt idx="168">
                  <c:v>5787.8564453125</c:v>
                </c:pt>
                <c:pt idx="169">
                  <c:v>5816.95947265625</c:v>
                </c:pt>
                <c:pt idx="170">
                  <c:v>5855.0634765625</c:v>
                </c:pt>
                <c:pt idx="171">
                  <c:v>5884.849609375</c:v>
                </c:pt>
                <c:pt idx="172">
                  <c:v>5894.1474609375</c:v>
                </c:pt>
                <c:pt idx="173">
                  <c:v>5882.591796875</c:v>
                </c:pt>
                <c:pt idx="174">
                  <c:v>5859.88134765625</c:v>
                </c:pt>
                <c:pt idx="175">
                  <c:v>5837.669921875</c:v>
                </c:pt>
                <c:pt idx="176">
                  <c:v>5821.67626953125</c:v>
                </c:pt>
                <c:pt idx="177">
                  <c:v>5809.88037109375</c:v>
                </c:pt>
                <c:pt idx="178">
                  <c:v>5797.359375</c:v>
                </c:pt>
                <c:pt idx="179">
                  <c:v>5782.8759765625</c:v>
                </c:pt>
                <c:pt idx="180">
                  <c:v>5771.2333984375</c:v>
                </c:pt>
                <c:pt idx="181">
                  <c:v>5769.38818359375</c:v>
                </c:pt>
                <c:pt idx="182">
                  <c:v>5779.837890625</c:v>
                </c:pt>
                <c:pt idx="183">
                  <c:v>5797.13134765625</c:v>
                </c:pt>
                <c:pt idx="184">
                  <c:v>5810.6025390625</c:v>
                </c:pt>
                <c:pt idx="185">
                  <c:v>5811.2021484375</c:v>
                </c:pt>
                <c:pt idx="186">
                  <c:v>5797.0888671875</c:v>
                </c:pt>
                <c:pt idx="187">
                  <c:v>5774.06298828125</c:v>
                </c:pt>
                <c:pt idx="188">
                  <c:v>5751.35595703125</c:v>
                </c:pt>
                <c:pt idx="189">
                  <c:v>5736.67041015625</c:v>
                </c:pt>
                <c:pt idx="190">
                  <c:v>5733.908203125</c:v>
                </c:pt>
                <c:pt idx="191">
                  <c:v>5743.76220703125</c:v>
                </c:pt>
                <c:pt idx="192">
                  <c:v>5764.75048828125</c:v>
                </c:pt>
                <c:pt idx="193">
                  <c:v>5792.89501953125</c:v>
                </c:pt>
                <c:pt idx="194">
                  <c:v>5821.0830078125</c:v>
                </c:pt>
                <c:pt idx="195">
                  <c:v>5840.7451171875</c:v>
                </c:pt>
                <c:pt idx="196">
                  <c:v>5846.58349609375</c:v>
                </c:pt>
                <c:pt idx="197">
                  <c:v>5841.201171875</c:v>
                </c:pt>
                <c:pt idx="198">
                  <c:v>5834.7802734375</c:v>
                </c:pt>
                <c:pt idx="199">
                  <c:v>5838.15283203125</c:v>
                </c:pt>
                <c:pt idx="200">
                  <c:v>5853.642578125</c:v>
                </c:pt>
                <c:pt idx="201">
                  <c:v>5871.50830078125</c:v>
                </c:pt>
                <c:pt idx="202">
                  <c:v>5876.50244140625</c:v>
                </c:pt>
                <c:pt idx="203">
                  <c:v>5860.65234375</c:v>
                </c:pt>
                <c:pt idx="204">
                  <c:v>5831.8603515625</c:v>
                </c:pt>
                <c:pt idx="205">
                  <c:v>5809.69873046875</c:v>
                </c:pt>
                <c:pt idx="206">
                  <c:v>5809.80517578125</c:v>
                </c:pt>
                <c:pt idx="207">
                  <c:v>5828.8203125</c:v>
                </c:pt>
                <c:pt idx="208">
                  <c:v>5843.4599609375</c:v>
                </c:pt>
                <c:pt idx="209">
                  <c:v>5827.21484375</c:v>
                </c:pt>
                <c:pt idx="210">
                  <c:v>5773.43701171875</c:v>
                </c:pt>
                <c:pt idx="211">
                  <c:v>5706.25927734375</c:v>
                </c:pt>
                <c:pt idx="212">
                  <c:v>5668.173828125</c:v>
                </c:pt>
                <c:pt idx="213">
                  <c:v>5690.716796875</c:v>
                </c:pt>
                <c:pt idx="214">
                  <c:v>5769.1572265625</c:v>
                </c:pt>
                <c:pt idx="215">
                  <c:v>5861.19921875</c:v>
                </c:pt>
                <c:pt idx="216">
                  <c:v>5912.94873046875</c:v>
                </c:pt>
                <c:pt idx="217">
                  <c:v>5894.88427734375</c:v>
                </c:pt>
                <c:pt idx="218">
                  <c:v>5822.18896484375</c:v>
                </c:pt>
                <c:pt idx="219">
                  <c:v>5744.5546875</c:v>
                </c:pt>
                <c:pt idx="220">
                  <c:v>5712.66650390625</c:v>
                </c:pt>
                <c:pt idx="221">
                  <c:v>5745.34423828125</c:v>
                </c:pt>
                <c:pt idx="222">
                  <c:v>5820.06591796875</c:v>
                </c:pt>
                <c:pt idx="223">
                  <c:v>5891.6572265625</c:v>
                </c:pt>
                <c:pt idx="224">
                  <c:v>5923.42578125</c:v>
                </c:pt>
                <c:pt idx="225">
                  <c:v>5907.5771484375</c:v>
                </c:pt>
                <c:pt idx="226">
                  <c:v>5862.259765625</c:v>
                </c:pt>
                <c:pt idx="227">
                  <c:v>5811.6611328125</c:v>
                </c:pt>
                <c:pt idx="228">
                  <c:v>5767.7197265625</c:v>
                </c:pt>
                <c:pt idx="229">
                  <c:v>5728.0341796875</c:v>
                </c:pt>
                <c:pt idx="230">
                  <c:v>5688.8828125</c:v>
                </c:pt>
                <c:pt idx="231">
                  <c:v>5658.74169921875</c:v>
                </c:pt>
                <c:pt idx="232">
                  <c:v>5657.66357421875</c:v>
                </c:pt>
                <c:pt idx="233">
                  <c:v>5701.18212890625</c:v>
                </c:pt>
                <c:pt idx="234">
                  <c:v>5782.28271484375</c:v>
                </c:pt>
                <c:pt idx="235">
                  <c:v>5868.51025390625</c:v>
                </c:pt>
                <c:pt idx="236">
                  <c:v>5919.82373046875</c:v>
                </c:pt>
                <c:pt idx="237">
                  <c:v>5915.50927734375</c:v>
                </c:pt>
                <c:pt idx="238">
                  <c:v>5869.6171875</c:v>
                </c:pt>
                <c:pt idx="239">
                  <c:v>5821.8037109375</c:v>
                </c:pt>
                <c:pt idx="240">
                  <c:v>5808.9658203125</c:v>
                </c:pt>
                <c:pt idx="241">
                  <c:v>5838.26611328125</c:v>
                </c:pt>
                <c:pt idx="242">
                  <c:v>5881.96484375</c:v>
                </c:pt>
                <c:pt idx="243">
                  <c:v>5898.50146484375</c:v>
                </c:pt>
                <c:pt idx="244">
                  <c:v>5864.53125</c:v>
                </c:pt>
                <c:pt idx="245">
                  <c:v>5794.0693359375</c:v>
                </c:pt>
                <c:pt idx="246">
                  <c:v>5730.1923828125</c:v>
                </c:pt>
                <c:pt idx="247">
                  <c:v>5714.9658203125</c:v>
                </c:pt>
                <c:pt idx="248">
                  <c:v>5759.34326171875</c:v>
                </c:pt>
                <c:pt idx="249">
                  <c:v>5834.810546875</c:v>
                </c:pt>
                <c:pt idx="250">
                  <c:v>5892.6787109375</c:v>
                </c:pt>
                <c:pt idx="251">
                  <c:v>5897.01708984375</c:v>
                </c:pt>
                <c:pt idx="252">
                  <c:v>5847.85009765625</c:v>
                </c:pt>
                <c:pt idx="253">
                  <c:v>5778.89794921875</c:v>
                </c:pt>
                <c:pt idx="254">
                  <c:v>5732.7548828125</c:v>
                </c:pt>
                <c:pt idx="255">
                  <c:v>5732.08984375</c:v>
                </c:pt>
                <c:pt idx="256">
                  <c:v>5767.11328125</c:v>
                </c:pt>
                <c:pt idx="257">
                  <c:v>5806.615234375</c:v>
                </c:pt>
                <c:pt idx="258">
                  <c:v>5822.56494140625</c:v>
                </c:pt>
                <c:pt idx="259">
                  <c:v>5809.365234375</c:v>
                </c:pt>
                <c:pt idx="260">
                  <c:v>5784.38623046875</c:v>
                </c:pt>
                <c:pt idx="261">
                  <c:v>5771.37255859375</c:v>
                </c:pt>
                <c:pt idx="262">
                  <c:v>5780.99169921875</c:v>
                </c:pt>
                <c:pt idx="263">
                  <c:v>5803.73388671875</c:v>
                </c:pt>
                <c:pt idx="264">
                  <c:v>5819.63330078125</c:v>
                </c:pt>
                <c:pt idx="265">
                  <c:v>5815.73291015625</c:v>
                </c:pt>
                <c:pt idx="266">
                  <c:v>5796.61767578125</c:v>
                </c:pt>
                <c:pt idx="267">
                  <c:v>5779.7587890625</c:v>
                </c:pt>
                <c:pt idx="268">
                  <c:v>5780.21484375</c:v>
                </c:pt>
                <c:pt idx="269">
                  <c:v>5797.904296875</c:v>
                </c:pt>
                <c:pt idx="270">
                  <c:v>5818.18603515625</c:v>
                </c:pt>
                <c:pt idx="271">
                  <c:v>5825.06103515625</c:v>
                </c:pt>
                <c:pt idx="272">
                  <c:v>5815.51953125</c:v>
                </c:pt>
                <c:pt idx="273">
                  <c:v>5802.42578125</c:v>
                </c:pt>
                <c:pt idx="274">
                  <c:v>5802.9921875</c:v>
                </c:pt>
                <c:pt idx="275">
                  <c:v>5822.3701171875</c:v>
                </c:pt>
                <c:pt idx="276">
                  <c:v>5846.69970703125</c:v>
                </c:pt>
                <c:pt idx="277">
                  <c:v>5852.69580078125</c:v>
                </c:pt>
                <c:pt idx="278">
                  <c:v>5827.08251953125</c:v>
                </c:pt>
                <c:pt idx="279">
                  <c:v>5780.22021484375</c:v>
                </c:pt>
                <c:pt idx="280">
                  <c:v>5741.8291015625</c:v>
                </c:pt>
                <c:pt idx="281">
                  <c:v>5740.51904296875</c:v>
                </c:pt>
                <c:pt idx="282">
                  <c:v>5782.06005859375</c:v>
                </c:pt>
                <c:pt idx="283">
                  <c:v>5843.23681640625</c:v>
                </c:pt>
                <c:pt idx="284">
                  <c:v>5886.7841796875</c:v>
                </c:pt>
                <c:pt idx="285">
                  <c:v>5886.93701171875</c:v>
                </c:pt>
                <c:pt idx="286">
                  <c:v>5847.0029296875</c:v>
                </c:pt>
                <c:pt idx="287">
                  <c:v>5796.34716796875</c:v>
                </c:pt>
                <c:pt idx="288">
                  <c:v>5769.533203125</c:v>
                </c:pt>
                <c:pt idx="289">
                  <c:v>5783.1142578125</c:v>
                </c:pt>
                <c:pt idx="290">
                  <c:v>5826.25244140625</c:v>
                </c:pt>
                <c:pt idx="291">
                  <c:v>5870.185546875</c:v>
                </c:pt>
                <c:pt idx="292">
                  <c:v>5887.8681640625</c:v>
                </c:pt>
                <c:pt idx="293">
                  <c:v>5869.36474609375</c:v>
                </c:pt>
                <c:pt idx="294">
                  <c:v>5824.037109375</c:v>
                </c:pt>
                <c:pt idx="295">
                  <c:v>5771.46435546875</c:v>
                </c:pt>
                <c:pt idx="296">
                  <c:v>5730.11279296875</c:v>
                </c:pt>
                <c:pt idx="297">
                  <c:v>5711.244140625</c:v>
                </c:pt>
                <c:pt idx="298">
                  <c:v>5718.64453125</c:v>
                </c:pt>
                <c:pt idx="299">
                  <c:v>5749.724609375</c:v>
                </c:pt>
                <c:pt idx="300">
                  <c:v>5794.8466796875</c:v>
                </c:pt>
                <c:pt idx="301">
                  <c:v>5836.90576171875</c:v>
                </c:pt>
                <c:pt idx="302">
                  <c:v>5855.85693359375</c:v>
                </c:pt>
                <c:pt idx="303">
                  <c:v>5839.1748046875</c:v>
                </c:pt>
                <c:pt idx="304">
                  <c:v>5792.19775390625</c:v>
                </c:pt>
                <c:pt idx="305">
                  <c:v>5739.09814453125</c:v>
                </c:pt>
                <c:pt idx="306">
                  <c:v>5710.4814453125</c:v>
                </c:pt>
                <c:pt idx="307">
                  <c:v>5724.16845703125</c:v>
                </c:pt>
                <c:pt idx="308">
                  <c:v>5772.75732421875</c:v>
                </c:pt>
                <c:pt idx="309">
                  <c:v>5828.10986328125</c:v>
                </c:pt>
                <c:pt idx="310">
                  <c:v>5860.54541015625</c:v>
                </c:pt>
                <c:pt idx="311">
                  <c:v>5858.83642578125</c:v>
                </c:pt>
                <c:pt idx="312">
                  <c:v>5836.001953125</c:v>
                </c:pt>
                <c:pt idx="313">
                  <c:v>5816.85595703125</c:v>
                </c:pt>
                <c:pt idx="314">
                  <c:v>5817.69580078125</c:v>
                </c:pt>
                <c:pt idx="315">
                  <c:v>5834.560546875</c:v>
                </c:pt>
                <c:pt idx="316">
                  <c:v>5849.0546875</c:v>
                </c:pt>
                <c:pt idx="317">
                  <c:v>5845.96044921875</c:v>
                </c:pt>
                <c:pt idx="318">
                  <c:v>5827.1943359375</c:v>
                </c:pt>
                <c:pt idx="319">
                  <c:v>5810.185546875</c:v>
                </c:pt>
                <c:pt idx="320">
                  <c:v>5812.36083984375</c:v>
                </c:pt>
                <c:pt idx="321">
                  <c:v>5835.392578125</c:v>
                </c:pt>
                <c:pt idx="322">
                  <c:v>5862.92041015625</c:v>
                </c:pt>
                <c:pt idx="323">
                  <c:v>5873.6455078125</c:v>
                </c:pt>
                <c:pt idx="324">
                  <c:v>5858.35693359375</c:v>
                </c:pt>
                <c:pt idx="325">
                  <c:v>5826.21484375</c:v>
                </c:pt>
                <c:pt idx="326">
                  <c:v>5795.2978515625</c:v>
                </c:pt>
                <c:pt idx="327">
                  <c:v>5776.4365234375</c:v>
                </c:pt>
                <c:pt idx="328">
                  <c:v>5765.25830078125</c:v>
                </c:pt>
                <c:pt idx="329">
                  <c:v>5749.798828125</c:v>
                </c:pt>
                <c:pt idx="330">
                  <c:v>5726.50390625</c:v>
                </c:pt>
                <c:pt idx="331">
                  <c:v>5709.02099609375</c:v>
                </c:pt>
                <c:pt idx="332">
                  <c:v>5719.7216796875</c:v>
                </c:pt>
                <c:pt idx="333">
                  <c:v>5769.27392578125</c:v>
                </c:pt>
                <c:pt idx="334">
                  <c:v>5841.49853515625</c:v>
                </c:pt>
                <c:pt idx="335">
                  <c:v>5898.36376953125</c:v>
                </c:pt>
                <c:pt idx="336">
                  <c:v>5904.2568359375</c:v>
                </c:pt>
                <c:pt idx="337">
                  <c:v>5852.26708984375</c:v>
                </c:pt>
                <c:pt idx="338">
                  <c:v>5771.9013671875</c:v>
                </c:pt>
                <c:pt idx="339">
                  <c:v>5710.93359375</c:v>
                </c:pt>
                <c:pt idx="340">
                  <c:v>5703.78173828125</c:v>
                </c:pt>
                <c:pt idx="341">
                  <c:v>5749.32373046875</c:v>
                </c:pt>
                <c:pt idx="342">
                  <c:v>5813.9873046875</c:v>
                </c:pt>
                <c:pt idx="343">
                  <c:v>5856.89990234375</c:v>
                </c:pt>
                <c:pt idx="344">
                  <c:v>5857.8369140625</c:v>
                </c:pt>
                <c:pt idx="345">
                  <c:v>5827.85302734375</c:v>
                </c:pt>
                <c:pt idx="346">
                  <c:v>5796.7548828125</c:v>
                </c:pt>
                <c:pt idx="347">
                  <c:v>5789.07666015625</c:v>
                </c:pt>
                <c:pt idx="348">
                  <c:v>5807.43798828125</c:v>
                </c:pt>
                <c:pt idx="349">
                  <c:v>5834.43798828125</c:v>
                </c:pt>
              </c:numCache>
            </c:numRef>
          </c:yVal>
          <c:smooth val="1"/>
          <c:extLst>
            <c:ext xmlns:c16="http://schemas.microsoft.com/office/drawing/2014/chart" uri="{C3380CC4-5D6E-409C-BE32-E72D297353CC}">
              <c16:uniqueId val="{0000000F-4A37-429A-A58F-F7AEDA5D1ACA}"/>
            </c:ext>
          </c:extLst>
        </c:ser>
        <c:ser>
          <c:idx val="16"/>
          <c:order val="16"/>
          <c:tx>
            <c:strRef>
              <c:f>cp_sub_001!$Q$1</c:f>
              <c:strCache>
                <c:ptCount val="1"/>
                <c:pt idx="0">
                  <c:v>Coor_17</c:v>
                </c:pt>
              </c:strCache>
            </c:strRef>
          </c:tx>
          <c:spPr>
            <a:ln w="28575" cap="rnd">
              <a:solidFill>
                <a:schemeClr val="accent5">
                  <a:lumMod val="80000"/>
                  <a:lumOff val="20000"/>
                </a:schemeClr>
              </a:solidFill>
              <a:round/>
            </a:ln>
            <a:effectLst/>
          </c:spPr>
          <c:marker>
            <c:symbol val="none"/>
          </c:marker>
          <c:yVal>
            <c:numRef>
              <c:f>cp_sub_001!$Q$2:$Q$351</c:f>
              <c:numCache>
                <c:formatCode>0.00000000000_ </c:formatCode>
                <c:ptCount val="350"/>
                <c:pt idx="0">
                  <c:v>4920.09814453125</c:v>
                </c:pt>
                <c:pt idx="1">
                  <c:v>4965.29736328125</c:v>
                </c:pt>
                <c:pt idx="2">
                  <c:v>4961.02783203125</c:v>
                </c:pt>
                <c:pt idx="3">
                  <c:v>4911.2734375</c:v>
                </c:pt>
                <c:pt idx="4">
                  <c:v>4843.642578125</c:v>
                </c:pt>
                <c:pt idx="5">
                  <c:v>4789.99560546875</c:v>
                </c:pt>
                <c:pt idx="6">
                  <c:v>4766.3876953125</c:v>
                </c:pt>
                <c:pt idx="7">
                  <c:v>4766.68408203125</c:v>
                </c:pt>
                <c:pt idx="8">
                  <c:v>4773.00634765625</c:v>
                </c:pt>
                <c:pt idx="9">
                  <c:v>4773.11572265625</c:v>
                </c:pt>
                <c:pt idx="10">
                  <c:v>4770.21875</c:v>
                </c:pt>
                <c:pt idx="11">
                  <c:v>4777.77099609375</c:v>
                </c:pt>
                <c:pt idx="12">
                  <c:v>4804.55078125</c:v>
                </c:pt>
                <c:pt idx="13">
                  <c:v>4843.28125</c:v>
                </c:pt>
                <c:pt idx="14">
                  <c:v>4873.06103515625</c:v>
                </c:pt>
                <c:pt idx="15">
                  <c:v>4874.51904296875</c:v>
                </c:pt>
                <c:pt idx="16">
                  <c:v>4846.06787109375</c:v>
                </c:pt>
                <c:pt idx="17">
                  <c:v>4808.21484375</c:v>
                </c:pt>
                <c:pt idx="18">
                  <c:v>4791.59716796875</c:v>
                </c:pt>
                <c:pt idx="19">
                  <c:v>4816.4091796875</c:v>
                </c:pt>
                <c:pt idx="20">
                  <c:v>4877.24462890625</c:v>
                </c:pt>
                <c:pt idx="21">
                  <c:v>4943.67529296875</c:v>
                </c:pt>
                <c:pt idx="22">
                  <c:v>4976.33154296875</c:v>
                </c:pt>
                <c:pt idx="23">
                  <c:v>4948.54638671875</c:v>
                </c:pt>
                <c:pt idx="24">
                  <c:v>4861.02001953125</c:v>
                </c:pt>
                <c:pt idx="25">
                  <c:v>4742.13818359375</c:v>
                </c:pt>
                <c:pt idx="26">
                  <c:v>4635.08447265625</c:v>
                </c:pt>
                <c:pt idx="27">
                  <c:v>4579.138671875</c:v>
                </c:pt>
                <c:pt idx="28">
                  <c:v>4593.87060546875</c:v>
                </c:pt>
                <c:pt idx="29">
                  <c:v>4672.18017578125</c:v>
                </c:pt>
                <c:pt idx="30">
                  <c:v>4784.01513671875</c:v>
                </c:pt>
                <c:pt idx="31">
                  <c:v>4888.88671875</c:v>
                </c:pt>
                <c:pt idx="32">
                  <c:v>4952.41015625</c:v>
                </c:pt>
                <c:pt idx="33">
                  <c:v>4960.234375</c:v>
                </c:pt>
                <c:pt idx="34">
                  <c:v>4922.8740234375</c:v>
                </c:pt>
                <c:pt idx="35">
                  <c:v>4868.41748046875</c:v>
                </c:pt>
                <c:pt idx="36">
                  <c:v>4826.3681640625</c:v>
                </c:pt>
                <c:pt idx="37">
                  <c:v>4811.64208984375</c:v>
                </c:pt>
                <c:pt idx="38">
                  <c:v>4818.59375</c:v>
                </c:pt>
                <c:pt idx="39">
                  <c:v>4828.9951171875</c:v>
                </c:pt>
                <c:pt idx="40">
                  <c:v>4828.2578125</c:v>
                </c:pt>
                <c:pt idx="41">
                  <c:v>4817.76904296875</c:v>
                </c:pt>
                <c:pt idx="42">
                  <c:v>4813.43798828125</c:v>
                </c:pt>
                <c:pt idx="43">
                  <c:v>4830.85595703125</c:v>
                </c:pt>
                <c:pt idx="44">
                  <c:v>4868.4990234375</c:v>
                </c:pt>
                <c:pt idx="45">
                  <c:v>4903.3564453125</c:v>
                </c:pt>
                <c:pt idx="46">
                  <c:v>4904.81298828125</c:v>
                </c:pt>
                <c:pt idx="47">
                  <c:v>4858.2509765625</c:v>
                </c:pt>
                <c:pt idx="48">
                  <c:v>4780.59765625</c:v>
                </c:pt>
                <c:pt idx="49">
                  <c:v>4714.01123046875</c:v>
                </c:pt>
                <c:pt idx="50">
                  <c:v>4699.37646484375</c:v>
                </c:pt>
                <c:pt idx="51">
                  <c:v>4747.16748046875</c:v>
                </c:pt>
                <c:pt idx="52">
                  <c:v>4827.1669921875</c:v>
                </c:pt>
                <c:pt idx="53">
                  <c:v>4886.38916015625</c:v>
                </c:pt>
                <c:pt idx="54">
                  <c:v>4884.427734375</c:v>
                </c:pt>
                <c:pt idx="55">
                  <c:v>4822.00146484375</c:v>
                </c:pt>
                <c:pt idx="56">
                  <c:v>4742.16259765625</c:v>
                </c:pt>
                <c:pt idx="57">
                  <c:v>4702.39404296875</c:v>
                </c:pt>
                <c:pt idx="58">
                  <c:v>4736.29931640625</c:v>
                </c:pt>
                <c:pt idx="59">
                  <c:v>4830.974609375</c:v>
                </c:pt>
                <c:pt idx="60">
                  <c:v>4935.1044921875</c:v>
                </c:pt>
                <c:pt idx="61">
                  <c:v>4991.541015625</c:v>
                </c:pt>
                <c:pt idx="62">
                  <c:v>4971.99462890625</c:v>
                </c:pt>
                <c:pt idx="63">
                  <c:v>4891.52587890625</c:v>
                </c:pt>
                <c:pt idx="64">
                  <c:v>4795.6767578125</c:v>
                </c:pt>
                <c:pt idx="65">
                  <c:v>4731.4599609375</c:v>
                </c:pt>
                <c:pt idx="66">
                  <c:v>4722.09375</c:v>
                </c:pt>
                <c:pt idx="67">
                  <c:v>4759.62109375</c:v>
                </c:pt>
                <c:pt idx="68">
                  <c:v>4815.69287109375</c:v>
                </c:pt>
                <c:pt idx="69">
                  <c:v>4859.83203125</c:v>
                </c:pt>
                <c:pt idx="70">
                  <c:v>4873.3662109375</c:v>
                </c:pt>
                <c:pt idx="71">
                  <c:v>4854.00390625</c:v>
                </c:pt>
                <c:pt idx="72">
                  <c:v>4813.34375</c:v>
                </c:pt>
                <c:pt idx="73">
                  <c:v>4771.5380859375</c:v>
                </c:pt>
                <c:pt idx="74">
                  <c:v>4750.60693359375</c:v>
                </c:pt>
                <c:pt idx="75">
                  <c:v>4765.6787109375</c:v>
                </c:pt>
                <c:pt idx="76">
                  <c:v>4815.591796875</c:v>
                </c:pt>
                <c:pt idx="77">
                  <c:v>4878.72119140625</c:v>
                </c:pt>
                <c:pt idx="78">
                  <c:v>4920.56787109375</c:v>
                </c:pt>
                <c:pt idx="79">
                  <c:v>4912.97802734375</c:v>
                </c:pt>
                <c:pt idx="80">
                  <c:v>4854.537109375</c:v>
                </c:pt>
                <c:pt idx="81">
                  <c:v>4776.8056640625</c:v>
                </c:pt>
                <c:pt idx="82">
                  <c:v>4728.09033203125</c:v>
                </c:pt>
                <c:pt idx="83">
                  <c:v>4742.421875</c:v>
                </c:pt>
                <c:pt idx="84">
                  <c:v>4814.49365234375</c:v>
                </c:pt>
                <c:pt idx="85">
                  <c:v>4899.95556640625</c:v>
                </c:pt>
                <c:pt idx="86">
                  <c:v>4943.47021484375</c:v>
                </c:pt>
                <c:pt idx="87">
                  <c:v>4916.0732421875</c:v>
                </c:pt>
                <c:pt idx="88">
                  <c:v>4835.0205078125</c:v>
                </c:pt>
                <c:pt idx="89">
                  <c:v>4751.1083984375</c:v>
                </c:pt>
                <c:pt idx="90">
                  <c:v>4712.47900390625</c:v>
                </c:pt>
                <c:pt idx="91">
                  <c:v>4731.7919921875</c:v>
                </c:pt>
                <c:pt idx="92">
                  <c:v>4781.072265625</c:v>
                </c:pt>
                <c:pt idx="93">
                  <c:v>4817.03662109375</c:v>
                </c:pt>
                <c:pt idx="94">
                  <c:v>4816.09033203125</c:v>
                </c:pt>
                <c:pt idx="95">
                  <c:v>4791.1474609375</c:v>
                </c:pt>
                <c:pt idx="96">
                  <c:v>4777.6787109375</c:v>
                </c:pt>
                <c:pt idx="97">
                  <c:v>4801.4892578125</c:v>
                </c:pt>
                <c:pt idx="98">
                  <c:v>4855.31201171875</c:v>
                </c:pt>
                <c:pt idx="99">
                  <c:v>4903.5625</c:v>
                </c:pt>
                <c:pt idx="100">
                  <c:v>4911.10791015625</c:v>
                </c:pt>
                <c:pt idx="101">
                  <c:v>4872.0888671875</c:v>
                </c:pt>
                <c:pt idx="102">
                  <c:v>4815.05224609375</c:v>
                </c:pt>
                <c:pt idx="103">
                  <c:v>4780.45703125</c:v>
                </c:pt>
                <c:pt idx="104">
                  <c:v>4789.3857421875</c:v>
                </c:pt>
                <c:pt idx="105">
                  <c:v>4829.04052734375</c:v>
                </c:pt>
                <c:pt idx="106">
                  <c:v>4866.0322265625</c:v>
                </c:pt>
                <c:pt idx="107">
                  <c:v>4875.07763671875</c:v>
                </c:pt>
                <c:pt idx="108">
                  <c:v>4858.396484375</c:v>
                </c:pt>
                <c:pt idx="109">
                  <c:v>4839.908203125</c:v>
                </c:pt>
                <c:pt idx="110">
                  <c:v>4840.4873046875</c:v>
                </c:pt>
                <c:pt idx="111">
                  <c:v>4856.86962890625</c:v>
                </c:pt>
                <c:pt idx="112">
                  <c:v>4863.35009765625</c:v>
                </c:pt>
                <c:pt idx="113">
                  <c:v>4835.2939453125</c:v>
                </c:pt>
                <c:pt idx="114">
                  <c:v>4774.1064453125</c:v>
                </c:pt>
                <c:pt idx="115">
                  <c:v>4711.41015625</c:v>
                </c:pt>
                <c:pt idx="116">
                  <c:v>4687.50146484375</c:v>
                </c:pt>
                <c:pt idx="117">
                  <c:v>4720.974609375</c:v>
                </c:pt>
                <c:pt idx="118">
                  <c:v>4794.1396484375</c:v>
                </c:pt>
                <c:pt idx="119">
                  <c:v>4865.947265625</c:v>
                </c:pt>
                <c:pt idx="120">
                  <c:v>4901.6611328125</c:v>
                </c:pt>
                <c:pt idx="121">
                  <c:v>4895.349609375</c:v>
                </c:pt>
                <c:pt idx="122">
                  <c:v>4868.29150390625</c:v>
                </c:pt>
                <c:pt idx="123">
                  <c:v>4847.01220703125</c:v>
                </c:pt>
                <c:pt idx="124">
                  <c:v>4841.12353515625</c:v>
                </c:pt>
                <c:pt idx="125">
                  <c:v>4839.609375</c:v>
                </c:pt>
                <c:pt idx="126">
                  <c:v>4826.8212890625</c:v>
                </c:pt>
                <c:pt idx="127">
                  <c:v>4801.81591796875</c:v>
                </c:pt>
                <c:pt idx="128">
                  <c:v>4782.306640625</c:v>
                </c:pt>
                <c:pt idx="129">
                  <c:v>4789.01953125</c:v>
                </c:pt>
                <c:pt idx="130">
                  <c:v>4824.55419921875</c:v>
                </c:pt>
                <c:pt idx="131">
                  <c:v>4866.4716796875</c:v>
                </c:pt>
                <c:pt idx="132">
                  <c:v>4882.28466796875</c:v>
                </c:pt>
                <c:pt idx="133">
                  <c:v>4854.7978515625</c:v>
                </c:pt>
                <c:pt idx="134">
                  <c:v>4796.80615234375</c:v>
                </c:pt>
                <c:pt idx="135">
                  <c:v>4742.732421875</c:v>
                </c:pt>
                <c:pt idx="136">
                  <c:v>4723.96240234375</c:v>
                </c:pt>
                <c:pt idx="137">
                  <c:v>4747.82861328125</c:v>
                </c:pt>
                <c:pt idx="138">
                  <c:v>4796.22900390625</c:v>
                </c:pt>
                <c:pt idx="139">
                  <c:v>4842.75537109375</c:v>
                </c:pt>
                <c:pt idx="140">
                  <c:v>4872.12451171875</c:v>
                </c:pt>
                <c:pt idx="141">
                  <c:v>4885.66357421875</c:v>
                </c:pt>
                <c:pt idx="142">
                  <c:v>4890.8056640625</c:v>
                </c:pt>
                <c:pt idx="143">
                  <c:v>4887.5791015625</c:v>
                </c:pt>
                <c:pt idx="144">
                  <c:v>4867.0302734375</c:v>
                </c:pt>
                <c:pt idx="145">
                  <c:v>4823.8359375</c:v>
                </c:pt>
                <c:pt idx="146">
                  <c:v>4770.09814453125</c:v>
                </c:pt>
                <c:pt idx="147">
                  <c:v>4734.25244140625</c:v>
                </c:pt>
                <c:pt idx="148">
                  <c:v>4741.9296875</c:v>
                </c:pt>
                <c:pt idx="149">
                  <c:v>4793.2939453125</c:v>
                </c:pt>
                <c:pt idx="150">
                  <c:v>4857.3994140625</c:v>
                </c:pt>
                <c:pt idx="151">
                  <c:v>4891.64990234375</c:v>
                </c:pt>
                <c:pt idx="152">
                  <c:v>4873.15478515625</c:v>
                </c:pt>
                <c:pt idx="153">
                  <c:v>4817.04150390625</c:v>
                </c:pt>
                <c:pt idx="154">
                  <c:v>4765.720703125</c:v>
                </c:pt>
                <c:pt idx="155">
                  <c:v>4756.357421875</c:v>
                </c:pt>
                <c:pt idx="156">
                  <c:v>4792.2021484375</c:v>
                </c:pt>
                <c:pt idx="157">
                  <c:v>4841.1123046875</c:v>
                </c:pt>
                <c:pt idx="158">
                  <c:v>4862.74169921875</c:v>
                </c:pt>
                <c:pt idx="159">
                  <c:v>4842.2939453125</c:v>
                </c:pt>
                <c:pt idx="160">
                  <c:v>4803.07373046875</c:v>
                </c:pt>
                <c:pt idx="161">
                  <c:v>4787.29296875</c:v>
                </c:pt>
                <c:pt idx="162">
                  <c:v>4820.61181640625</c:v>
                </c:pt>
                <c:pt idx="163">
                  <c:v>4889.28271484375</c:v>
                </c:pt>
                <c:pt idx="164">
                  <c:v>4948.568359375</c:v>
                </c:pt>
                <c:pt idx="165">
                  <c:v>4955.90966796875</c:v>
                </c:pt>
                <c:pt idx="166">
                  <c:v>4902.76708984375</c:v>
                </c:pt>
                <c:pt idx="167">
                  <c:v>4820.7783203125</c:v>
                </c:pt>
                <c:pt idx="168">
                  <c:v>4758.64208984375</c:v>
                </c:pt>
                <c:pt idx="169">
                  <c:v>4748.5390625</c:v>
                </c:pt>
                <c:pt idx="170">
                  <c:v>4787.15771484375</c:v>
                </c:pt>
                <c:pt idx="171">
                  <c:v>4842.900390625</c:v>
                </c:pt>
                <c:pt idx="172">
                  <c:v>4880.09619140625</c:v>
                </c:pt>
                <c:pt idx="173">
                  <c:v>4880.26708984375</c:v>
                </c:pt>
                <c:pt idx="174">
                  <c:v>4846.81494140625</c:v>
                </c:pt>
                <c:pt idx="175">
                  <c:v>4795.28076171875</c:v>
                </c:pt>
                <c:pt idx="176">
                  <c:v>4741.80126953125</c:v>
                </c:pt>
                <c:pt idx="177">
                  <c:v>4699.4931640625</c:v>
                </c:pt>
                <c:pt idx="178">
                  <c:v>4681.064453125</c:v>
                </c:pt>
                <c:pt idx="179">
                  <c:v>4698.46728515625</c:v>
                </c:pt>
                <c:pt idx="180">
                  <c:v>4754.50146484375</c:v>
                </c:pt>
                <c:pt idx="181">
                  <c:v>4832.62646484375</c:v>
                </c:pt>
                <c:pt idx="182">
                  <c:v>4897.6513671875</c:v>
                </c:pt>
                <c:pt idx="183">
                  <c:v>4913.37353515625</c:v>
                </c:pt>
                <c:pt idx="184">
                  <c:v>4867.931640625</c:v>
                </c:pt>
                <c:pt idx="185">
                  <c:v>4787.3388671875</c:v>
                </c:pt>
                <c:pt idx="186">
                  <c:v>4723.2294921875</c:v>
                </c:pt>
                <c:pt idx="187">
                  <c:v>4719.87060546875</c:v>
                </c:pt>
                <c:pt idx="188">
                  <c:v>4783.11279296875</c:v>
                </c:pt>
                <c:pt idx="189">
                  <c:v>4874.93017578125</c:v>
                </c:pt>
                <c:pt idx="190">
                  <c:v>4939.25634765625</c:v>
                </c:pt>
                <c:pt idx="191">
                  <c:v>4941.146484375</c:v>
                </c:pt>
                <c:pt idx="192">
                  <c:v>4890.6357421875</c:v>
                </c:pt>
                <c:pt idx="193">
                  <c:v>4833.7333984375</c:v>
                </c:pt>
                <c:pt idx="194">
                  <c:v>4817.53955078125</c:v>
                </c:pt>
                <c:pt idx="195">
                  <c:v>4855.51513671875</c:v>
                </c:pt>
                <c:pt idx="196">
                  <c:v>4918.1025390625</c:v>
                </c:pt>
                <c:pt idx="197">
                  <c:v>4954.44921875</c:v>
                </c:pt>
                <c:pt idx="198">
                  <c:v>4928.3134765625</c:v>
                </c:pt>
                <c:pt idx="199">
                  <c:v>4842.37646484375</c:v>
                </c:pt>
                <c:pt idx="200">
                  <c:v>4735.474609375</c:v>
                </c:pt>
                <c:pt idx="201">
                  <c:v>4657.41845703125</c:v>
                </c:pt>
                <c:pt idx="202">
                  <c:v>4640.416015625</c:v>
                </c:pt>
                <c:pt idx="203">
                  <c:v>4685.23095703125</c:v>
                </c:pt>
                <c:pt idx="204">
                  <c:v>4767.17578125</c:v>
                </c:pt>
                <c:pt idx="205">
                  <c:v>4853.3486328125</c:v>
                </c:pt>
                <c:pt idx="206">
                  <c:v>4918.02197265625</c:v>
                </c:pt>
                <c:pt idx="207">
                  <c:v>4948.74609375</c:v>
                </c:pt>
                <c:pt idx="208">
                  <c:v>4944.58251953125</c:v>
                </c:pt>
                <c:pt idx="209">
                  <c:v>4912.265625</c:v>
                </c:pt>
                <c:pt idx="210">
                  <c:v>4863.8896484375</c:v>
                </c:pt>
                <c:pt idx="211">
                  <c:v>4815.10791015625</c:v>
                </c:pt>
                <c:pt idx="212">
                  <c:v>4781.1318359375</c:v>
                </c:pt>
                <c:pt idx="213">
                  <c:v>4770.51025390625</c:v>
                </c:pt>
                <c:pt idx="214">
                  <c:v>4780.42333984375</c:v>
                </c:pt>
                <c:pt idx="215">
                  <c:v>4797.78564453125</c:v>
                </c:pt>
                <c:pt idx="216">
                  <c:v>4806.7314453125</c:v>
                </c:pt>
                <c:pt idx="217">
                  <c:v>4798.24072265625</c:v>
                </c:pt>
                <c:pt idx="218">
                  <c:v>4775.78173828125</c:v>
                </c:pt>
                <c:pt idx="219">
                  <c:v>4753.4462890625</c:v>
                </c:pt>
                <c:pt idx="220">
                  <c:v>4747.87744140625</c:v>
                </c:pt>
                <c:pt idx="221">
                  <c:v>4768.7626953125</c:v>
                </c:pt>
                <c:pt idx="222">
                  <c:v>4812.86474609375</c:v>
                </c:pt>
                <c:pt idx="223">
                  <c:v>4864.31494140625</c:v>
                </c:pt>
                <c:pt idx="224">
                  <c:v>4901.0244140625</c:v>
                </c:pt>
                <c:pt idx="225">
                  <c:v>4904.8076171875</c:v>
                </c:pt>
                <c:pt idx="226">
                  <c:v>4871.09130859375</c:v>
                </c:pt>
                <c:pt idx="227">
                  <c:v>4813.2685546875</c:v>
                </c:pt>
                <c:pt idx="228">
                  <c:v>4757.98095703125</c:v>
                </c:pt>
                <c:pt idx="229">
                  <c:v>4731.916015625</c:v>
                </c:pt>
                <c:pt idx="230">
                  <c:v>4746.59228515625</c:v>
                </c:pt>
                <c:pt idx="231">
                  <c:v>4790.87548828125</c:v>
                </c:pt>
                <c:pt idx="232">
                  <c:v>4837.716796875</c:v>
                </c:pt>
                <c:pt idx="233">
                  <c:v>4862.26220703125</c:v>
                </c:pt>
                <c:pt idx="234">
                  <c:v>4859.265625</c:v>
                </c:pt>
                <c:pt idx="235">
                  <c:v>4846.44580078125</c:v>
                </c:pt>
                <c:pt idx="236">
                  <c:v>4849.81640625</c:v>
                </c:pt>
                <c:pt idx="237">
                  <c:v>4881.09521484375</c:v>
                </c:pt>
                <c:pt idx="238">
                  <c:v>4924.9384765625</c:v>
                </c:pt>
                <c:pt idx="239">
                  <c:v>4947.6142578125</c:v>
                </c:pt>
                <c:pt idx="240">
                  <c:v>4922.23876953125</c:v>
                </c:pt>
                <c:pt idx="241">
                  <c:v>4851.54736328125</c:v>
                </c:pt>
                <c:pt idx="242">
                  <c:v>4769.47900390625</c:v>
                </c:pt>
                <c:pt idx="243">
                  <c:v>4718.66845703125</c:v>
                </c:pt>
                <c:pt idx="244">
                  <c:v>4720.30712890625</c:v>
                </c:pt>
                <c:pt idx="245">
                  <c:v>4759.88623046875</c:v>
                </c:pt>
                <c:pt idx="246">
                  <c:v>4800.3759765625</c:v>
                </c:pt>
                <c:pt idx="247">
                  <c:v>4812.47119140625</c:v>
                </c:pt>
                <c:pt idx="248">
                  <c:v>4797.392578125</c:v>
                </c:pt>
                <c:pt idx="249">
                  <c:v>4783.5498046875</c:v>
                </c:pt>
                <c:pt idx="250">
                  <c:v>4799.92431640625</c:v>
                </c:pt>
                <c:pt idx="251">
                  <c:v>4848.67724609375</c:v>
                </c:pt>
                <c:pt idx="252">
                  <c:v>4900.5849609375</c:v>
                </c:pt>
                <c:pt idx="253">
                  <c:v>4917.96240234375</c:v>
                </c:pt>
                <c:pt idx="254">
                  <c:v>4886.337890625</c:v>
                </c:pt>
                <c:pt idx="255">
                  <c:v>4828.0126953125</c:v>
                </c:pt>
                <c:pt idx="256">
                  <c:v>4785.244140625</c:v>
                </c:pt>
                <c:pt idx="257">
                  <c:v>4786.283203125</c:v>
                </c:pt>
                <c:pt idx="258">
                  <c:v>4822.47705078125</c:v>
                </c:pt>
                <c:pt idx="259">
                  <c:v>4856.06298828125</c:v>
                </c:pt>
                <c:pt idx="260">
                  <c:v>4852.720703125</c:v>
                </c:pt>
                <c:pt idx="261">
                  <c:v>4811.72998046875</c:v>
                </c:pt>
                <c:pt idx="262">
                  <c:v>4767.82275390625</c:v>
                </c:pt>
                <c:pt idx="263">
                  <c:v>4762.119140625</c:v>
                </c:pt>
                <c:pt idx="264">
                  <c:v>4805.77685546875</c:v>
                </c:pt>
                <c:pt idx="265">
                  <c:v>4867.0947265625</c:v>
                </c:pt>
                <c:pt idx="266">
                  <c:v>4894.263671875</c:v>
                </c:pt>
                <c:pt idx="267">
                  <c:v>4856.65234375</c:v>
                </c:pt>
                <c:pt idx="268">
                  <c:v>4771.5185546875</c:v>
                </c:pt>
                <c:pt idx="269">
                  <c:v>4693.8935546875</c:v>
                </c:pt>
                <c:pt idx="270">
                  <c:v>4676.56396484375</c:v>
                </c:pt>
                <c:pt idx="271">
                  <c:v>4731.0283203125</c:v>
                </c:pt>
                <c:pt idx="272">
                  <c:v>4819.62451171875</c:v>
                </c:pt>
                <c:pt idx="273">
                  <c:v>4884.435546875</c:v>
                </c:pt>
                <c:pt idx="274">
                  <c:v>4889.95849609375</c:v>
                </c:pt>
                <c:pt idx="275">
                  <c:v>4846.72119140625</c:v>
                </c:pt>
                <c:pt idx="276">
                  <c:v>4799.1630859375</c:v>
                </c:pt>
                <c:pt idx="277">
                  <c:v>4789.43212890625</c:v>
                </c:pt>
                <c:pt idx="278">
                  <c:v>4826.38818359375</c:v>
                </c:pt>
                <c:pt idx="279">
                  <c:v>4882.7666015625</c:v>
                </c:pt>
                <c:pt idx="280">
                  <c:v>4919.71826171875</c:v>
                </c:pt>
                <c:pt idx="281">
                  <c:v>4916.83203125</c:v>
                </c:pt>
                <c:pt idx="282">
                  <c:v>4883.83056640625</c:v>
                </c:pt>
                <c:pt idx="283">
                  <c:v>4847.32275390625</c:v>
                </c:pt>
                <c:pt idx="284">
                  <c:v>4826.80517578125</c:v>
                </c:pt>
                <c:pt idx="285">
                  <c:v>4821.15283203125</c:v>
                </c:pt>
                <c:pt idx="286">
                  <c:v>4815.59326171875</c:v>
                </c:pt>
                <c:pt idx="287">
                  <c:v>4800.41064453125</c:v>
                </c:pt>
                <c:pt idx="288">
                  <c:v>4782.96630859375</c:v>
                </c:pt>
                <c:pt idx="289">
                  <c:v>4781.6484375</c:v>
                </c:pt>
                <c:pt idx="290">
                  <c:v>4807.26953125</c:v>
                </c:pt>
                <c:pt idx="291">
                  <c:v>4849.083984375</c:v>
                </c:pt>
                <c:pt idx="292">
                  <c:v>4879.01953125</c:v>
                </c:pt>
                <c:pt idx="293">
                  <c:v>4872.1630859375</c:v>
                </c:pt>
                <c:pt idx="294">
                  <c:v>4827.3916015625</c:v>
                </c:pt>
                <c:pt idx="295">
                  <c:v>4771.13232421875</c:v>
                </c:pt>
                <c:pt idx="296">
                  <c:v>4740.29345703125</c:v>
                </c:pt>
                <c:pt idx="297">
                  <c:v>4756.61474609375</c:v>
                </c:pt>
                <c:pt idx="298">
                  <c:v>4811.23876953125</c:v>
                </c:pt>
                <c:pt idx="299">
                  <c:v>4870.421875</c:v>
                </c:pt>
                <c:pt idx="300">
                  <c:v>4897.76708984375</c:v>
                </c:pt>
                <c:pt idx="301">
                  <c:v>4877.16552734375</c:v>
                </c:pt>
                <c:pt idx="302">
                  <c:v>4821.4951171875</c:v>
                </c:pt>
                <c:pt idx="303">
                  <c:v>4763.03564453125</c:v>
                </c:pt>
                <c:pt idx="304">
                  <c:v>4733.62646484375</c:v>
                </c:pt>
                <c:pt idx="305">
                  <c:v>4747.46923828125</c:v>
                </c:pt>
                <c:pt idx="306">
                  <c:v>4795.51611328125</c:v>
                </c:pt>
                <c:pt idx="307">
                  <c:v>4852.13671875</c:v>
                </c:pt>
                <c:pt idx="308">
                  <c:v>4888.5576171875</c:v>
                </c:pt>
                <c:pt idx="309">
                  <c:v>4886.1142578125</c:v>
                </c:pt>
                <c:pt idx="310">
                  <c:v>4844.3916015625</c:v>
                </c:pt>
                <c:pt idx="311">
                  <c:v>4781.900390625</c:v>
                </c:pt>
                <c:pt idx="312">
                  <c:v>4728.9599609375</c:v>
                </c:pt>
                <c:pt idx="313">
                  <c:v>4714.6064453125</c:v>
                </c:pt>
                <c:pt idx="314">
                  <c:v>4752.26953125</c:v>
                </c:pt>
                <c:pt idx="315">
                  <c:v>4831.16748046875</c:v>
                </c:pt>
                <c:pt idx="316">
                  <c:v>4919.185546875</c:v>
                </c:pt>
                <c:pt idx="317">
                  <c:v>4977.46142578125</c:v>
                </c:pt>
                <c:pt idx="318">
                  <c:v>4979.71142578125</c:v>
                </c:pt>
                <c:pt idx="319">
                  <c:v>4925.50341796875</c:v>
                </c:pt>
                <c:pt idx="320">
                  <c:v>4839.705078125</c:v>
                </c:pt>
                <c:pt idx="321">
                  <c:v>4758.69384765625</c:v>
                </c:pt>
                <c:pt idx="322">
                  <c:v>4712.0302734375</c:v>
                </c:pt>
                <c:pt idx="323">
                  <c:v>4710.37744140625</c:v>
                </c:pt>
                <c:pt idx="324">
                  <c:v>4745.28173828125</c:v>
                </c:pt>
                <c:pt idx="325">
                  <c:v>4798.18017578125</c:v>
                </c:pt>
                <c:pt idx="326">
                  <c:v>4850.8369140625</c:v>
                </c:pt>
                <c:pt idx="327">
                  <c:v>4890.69384765625</c:v>
                </c:pt>
                <c:pt idx="328">
                  <c:v>4910.34326171875</c:v>
                </c:pt>
                <c:pt idx="329">
                  <c:v>4905.30859375</c:v>
                </c:pt>
                <c:pt idx="330">
                  <c:v>4874.49365234375</c:v>
                </c:pt>
                <c:pt idx="331">
                  <c:v>4823.56884765625</c:v>
                </c:pt>
                <c:pt idx="332">
                  <c:v>4767.2568359375</c:v>
                </c:pt>
                <c:pt idx="333">
                  <c:v>4726.1513671875</c:v>
                </c:pt>
                <c:pt idx="334">
                  <c:v>4717.76025390625</c:v>
                </c:pt>
                <c:pt idx="335">
                  <c:v>4746.62841796875</c:v>
                </c:pt>
                <c:pt idx="336">
                  <c:v>4800.23828125</c:v>
                </c:pt>
                <c:pt idx="337">
                  <c:v>4854.24072265625</c:v>
                </c:pt>
                <c:pt idx="338">
                  <c:v>4884.63134765625</c:v>
                </c:pt>
                <c:pt idx="339">
                  <c:v>4879.98291015625</c:v>
                </c:pt>
                <c:pt idx="340">
                  <c:v>4846.81689453125</c:v>
                </c:pt>
                <c:pt idx="341">
                  <c:v>4805.41259765625</c:v>
                </c:pt>
                <c:pt idx="342">
                  <c:v>4778.8056640625</c:v>
                </c:pt>
                <c:pt idx="343">
                  <c:v>4781.13623046875</c:v>
                </c:pt>
                <c:pt idx="344">
                  <c:v>4811.24267578125</c:v>
                </c:pt>
                <c:pt idx="345">
                  <c:v>4854.2060546875</c:v>
                </c:pt>
                <c:pt idx="346">
                  <c:v>4889.4609375</c:v>
                </c:pt>
                <c:pt idx="347">
                  <c:v>4901.11328125</c:v>
                </c:pt>
                <c:pt idx="348">
                  <c:v>4885.333984375</c:v>
                </c:pt>
                <c:pt idx="349">
                  <c:v>4851.34228515625</c:v>
                </c:pt>
              </c:numCache>
            </c:numRef>
          </c:yVal>
          <c:smooth val="1"/>
          <c:extLst>
            <c:ext xmlns:c16="http://schemas.microsoft.com/office/drawing/2014/chart" uri="{C3380CC4-5D6E-409C-BE32-E72D297353CC}">
              <c16:uniqueId val="{00000010-4A37-429A-A58F-F7AEDA5D1ACA}"/>
            </c:ext>
          </c:extLst>
        </c:ser>
        <c:ser>
          <c:idx val="17"/>
          <c:order val="17"/>
          <c:tx>
            <c:strRef>
              <c:f>cp_sub_001!$R$1</c:f>
              <c:strCache>
                <c:ptCount val="1"/>
                <c:pt idx="0">
                  <c:v>Coor_18</c:v>
                </c:pt>
              </c:strCache>
            </c:strRef>
          </c:tx>
          <c:spPr>
            <a:ln w="28575" cap="rnd">
              <a:solidFill>
                <a:schemeClr val="accent6">
                  <a:lumMod val="80000"/>
                  <a:lumOff val="20000"/>
                </a:schemeClr>
              </a:solidFill>
              <a:round/>
            </a:ln>
            <a:effectLst/>
          </c:spPr>
          <c:marker>
            <c:symbol val="none"/>
          </c:marker>
          <c:yVal>
            <c:numRef>
              <c:f>cp_sub_001!$R$2:$R$351</c:f>
              <c:numCache>
                <c:formatCode>0.00000000000_ </c:formatCode>
                <c:ptCount val="350"/>
                <c:pt idx="0">
                  <c:v>7318.107421875</c:v>
                </c:pt>
                <c:pt idx="1">
                  <c:v>7326.78466796875</c:v>
                </c:pt>
                <c:pt idx="2">
                  <c:v>7345.8740234375</c:v>
                </c:pt>
                <c:pt idx="3">
                  <c:v>7366.42822265625</c:v>
                </c:pt>
                <c:pt idx="4">
                  <c:v>7377.0986328125</c:v>
                </c:pt>
                <c:pt idx="5">
                  <c:v>7371.5341796875</c:v>
                </c:pt>
                <c:pt idx="6">
                  <c:v>7352.40234375</c:v>
                </c:pt>
                <c:pt idx="7">
                  <c:v>7328.8134765625</c:v>
                </c:pt>
                <c:pt idx="8">
                  <c:v>7309.24169921875</c:v>
                </c:pt>
                <c:pt idx="9">
                  <c:v>7295.791015625</c:v>
                </c:pt>
                <c:pt idx="10">
                  <c:v>7284.4853515625</c:v>
                </c:pt>
                <c:pt idx="11">
                  <c:v>7271.02490234375</c:v>
                </c:pt>
                <c:pt idx="12">
                  <c:v>7256.580078125</c:v>
                </c:pt>
                <c:pt idx="13">
                  <c:v>7248.1259765625</c:v>
                </c:pt>
                <c:pt idx="14">
                  <c:v>7252.69873046875</c:v>
                </c:pt>
                <c:pt idx="15">
                  <c:v>7270.66259765625</c:v>
                </c:pt>
                <c:pt idx="16">
                  <c:v>7294.33251953125</c:v>
                </c:pt>
                <c:pt idx="17">
                  <c:v>7313.78125</c:v>
                </c:pt>
                <c:pt idx="18">
                  <c:v>7325.13916015625</c:v>
                </c:pt>
                <c:pt idx="19">
                  <c:v>7334.00634765625</c:v>
                </c:pt>
                <c:pt idx="20">
                  <c:v>7350.509765625</c:v>
                </c:pt>
                <c:pt idx="21">
                  <c:v>7379.798828125</c:v>
                </c:pt>
                <c:pt idx="22">
                  <c:v>7416.0869140625</c:v>
                </c:pt>
                <c:pt idx="23">
                  <c:v>7445.6171875</c:v>
                </c:pt>
                <c:pt idx="24">
                  <c:v>7456.27490234375</c:v>
                </c:pt>
                <c:pt idx="25">
                  <c:v>7445.75732421875</c:v>
                </c:pt>
                <c:pt idx="26">
                  <c:v>7421.47265625</c:v>
                </c:pt>
                <c:pt idx="27">
                  <c:v>7392.84130859375</c:v>
                </c:pt>
                <c:pt idx="28">
                  <c:v>7363.59765625</c:v>
                </c:pt>
                <c:pt idx="29">
                  <c:v>7331.59130859375</c:v>
                </c:pt>
                <c:pt idx="30">
                  <c:v>7296.15771484375</c:v>
                </c:pt>
                <c:pt idx="31">
                  <c:v>7265.14404296875</c:v>
                </c:pt>
                <c:pt idx="32">
                  <c:v>7252.90966796875</c:v>
                </c:pt>
                <c:pt idx="33">
                  <c:v>7268.75244140625</c:v>
                </c:pt>
                <c:pt idx="34">
                  <c:v>7305.28271484375</c:v>
                </c:pt>
                <c:pt idx="35">
                  <c:v>7338.72412109375</c:v>
                </c:pt>
                <c:pt idx="36">
                  <c:v>7344.24609375</c:v>
                </c:pt>
                <c:pt idx="37">
                  <c:v>7315.849609375</c:v>
                </c:pt>
                <c:pt idx="38">
                  <c:v>7274.03466796875</c:v>
                </c:pt>
                <c:pt idx="39">
                  <c:v>7252.44384765625</c:v>
                </c:pt>
                <c:pt idx="40">
                  <c:v>7271.79931640625</c:v>
                </c:pt>
                <c:pt idx="41">
                  <c:v>7321.69140625</c:v>
                </c:pt>
                <c:pt idx="42">
                  <c:v>7366.60693359375</c:v>
                </c:pt>
                <c:pt idx="43">
                  <c:v>7373.70703125</c:v>
                </c:pt>
                <c:pt idx="44">
                  <c:v>7340.9375</c:v>
                </c:pt>
                <c:pt idx="45">
                  <c:v>7301.5302734375</c:v>
                </c:pt>
                <c:pt idx="46">
                  <c:v>7298.619140625</c:v>
                </c:pt>
                <c:pt idx="47">
                  <c:v>7348.44873046875</c:v>
                </c:pt>
                <c:pt idx="48">
                  <c:v>7422.1416015625</c:v>
                </c:pt>
                <c:pt idx="49">
                  <c:v>7463.27001953125</c:v>
                </c:pt>
                <c:pt idx="50">
                  <c:v>7430.27685546875</c:v>
                </c:pt>
                <c:pt idx="51">
                  <c:v>7331.4052734375</c:v>
                </c:pt>
                <c:pt idx="52">
                  <c:v>7223.4169921875</c:v>
                </c:pt>
                <c:pt idx="53">
                  <c:v>7172.66748046875</c:v>
                </c:pt>
                <c:pt idx="54">
                  <c:v>7207.07861328125</c:v>
                </c:pt>
                <c:pt idx="55">
                  <c:v>7295.98974609375</c:v>
                </c:pt>
                <c:pt idx="56">
                  <c:v>7374.05615234375</c:v>
                </c:pt>
                <c:pt idx="57">
                  <c:v>7391.05712890625</c:v>
                </c:pt>
                <c:pt idx="58">
                  <c:v>7348.9130859375</c:v>
                </c:pt>
                <c:pt idx="59">
                  <c:v>7297.1064453125</c:v>
                </c:pt>
                <c:pt idx="60">
                  <c:v>7290.62646484375</c:v>
                </c:pt>
                <c:pt idx="61">
                  <c:v>7344.28662109375</c:v>
                </c:pt>
                <c:pt idx="62">
                  <c:v>7419.9765625</c:v>
                </c:pt>
                <c:pt idx="63">
                  <c:v>7456.900390625</c:v>
                </c:pt>
                <c:pt idx="64">
                  <c:v>7420.41455078125</c:v>
                </c:pt>
                <c:pt idx="65">
                  <c:v>7330.39306640625</c:v>
                </c:pt>
                <c:pt idx="66">
                  <c:v>7246.69970703125</c:v>
                </c:pt>
                <c:pt idx="67">
                  <c:v>7223.69189453125</c:v>
                </c:pt>
                <c:pt idx="68">
                  <c:v>7269.93310546875</c:v>
                </c:pt>
                <c:pt idx="69">
                  <c:v>7344.29541015625</c:v>
                </c:pt>
                <c:pt idx="70">
                  <c:v>7390.0478515625</c:v>
                </c:pt>
                <c:pt idx="71">
                  <c:v>7378.6201171875</c:v>
                </c:pt>
                <c:pt idx="72">
                  <c:v>7328.439453125</c:v>
                </c:pt>
                <c:pt idx="73">
                  <c:v>7285.72021484375</c:v>
                </c:pt>
                <c:pt idx="74">
                  <c:v>7285.0205078125</c:v>
                </c:pt>
                <c:pt idx="75">
                  <c:v>7322.54541015625</c:v>
                </c:pt>
                <c:pt idx="76">
                  <c:v>7362.95654296875</c:v>
                </c:pt>
                <c:pt idx="77">
                  <c:v>7371.9921875</c:v>
                </c:pt>
                <c:pt idx="78">
                  <c:v>7346.36083984375</c:v>
                </c:pt>
                <c:pt idx="79">
                  <c:v>7315.8720703125</c:v>
                </c:pt>
                <c:pt idx="80">
                  <c:v>7316.7841796875</c:v>
                </c:pt>
                <c:pt idx="81">
                  <c:v>7359.40625</c:v>
                </c:pt>
                <c:pt idx="82">
                  <c:v>7417.27490234375</c:v>
                </c:pt>
                <c:pt idx="83">
                  <c:v>7446.90771484375</c:v>
                </c:pt>
                <c:pt idx="84">
                  <c:v>7421.85546875</c:v>
                </c:pt>
                <c:pt idx="85">
                  <c:v>7353.45458984375</c:v>
                </c:pt>
                <c:pt idx="86">
                  <c:v>7282.017578125</c:v>
                </c:pt>
                <c:pt idx="87">
                  <c:v>7246.2451171875</c:v>
                </c:pt>
                <c:pt idx="88">
                  <c:v>7255.5546875</c:v>
                </c:pt>
                <c:pt idx="89">
                  <c:v>7286.5791015625</c:v>
                </c:pt>
                <c:pt idx="90">
                  <c:v>7304.9931640625</c:v>
                </c:pt>
                <c:pt idx="91">
                  <c:v>7293.92529296875</c:v>
                </c:pt>
                <c:pt idx="92">
                  <c:v>7266.24462890625</c:v>
                </c:pt>
                <c:pt idx="93">
                  <c:v>7252.1767578125</c:v>
                </c:pt>
                <c:pt idx="94">
                  <c:v>7273.60791015625</c:v>
                </c:pt>
                <c:pt idx="95">
                  <c:v>7326.068359375</c:v>
                </c:pt>
                <c:pt idx="96">
                  <c:v>7381.93798828125</c:v>
                </c:pt>
                <c:pt idx="97">
                  <c:v>7411.0244140625</c:v>
                </c:pt>
                <c:pt idx="98">
                  <c:v>7401.7001953125</c:v>
                </c:pt>
                <c:pt idx="99">
                  <c:v>7366.9130859375</c:v>
                </c:pt>
                <c:pt idx="100">
                  <c:v>7332.36279296875</c:v>
                </c:pt>
                <c:pt idx="101">
                  <c:v>7317.7333984375</c:v>
                </c:pt>
                <c:pt idx="102">
                  <c:v>7325.51123046875</c:v>
                </c:pt>
                <c:pt idx="103">
                  <c:v>7343.98828125</c:v>
                </c:pt>
                <c:pt idx="104">
                  <c:v>7359.20361328125</c:v>
                </c:pt>
                <c:pt idx="105">
                  <c:v>7364.65283203125</c:v>
                </c:pt>
                <c:pt idx="106">
                  <c:v>7361.5830078125</c:v>
                </c:pt>
                <c:pt idx="107">
                  <c:v>7352.10498046875</c:v>
                </c:pt>
                <c:pt idx="108">
                  <c:v>7333.66845703125</c:v>
                </c:pt>
                <c:pt idx="109">
                  <c:v>7301.4677734375</c:v>
                </c:pt>
                <c:pt idx="110">
                  <c:v>7257.18212890625</c:v>
                </c:pt>
                <c:pt idx="111">
                  <c:v>7215.4482421875</c:v>
                </c:pt>
                <c:pt idx="112">
                  <c:v>7199.90625</c:v>
                </c:pt>
                <c:pt idx="113">
                  <c:v>7228.69873046875</c:v>
                </c:pt>
                <c:pt idx="114">
                  <c:v>7298.7978515625</c:v>
                </c:pt>
                <c:pt idx="115">
                  <c:v>7381.7255859375</c:v>
                </c:pt>
                <c:pt idx="116">
                  <c:v>7436.78955078125</c:v>
                </c:pt>
                <c:pt idx="117">
                  <c:v>7435.68359375</c:v>
                </c:pt>
                <c:pt idx="118">
                  <c:v>7382.76025390625</c:v>
                </c:pt>
                <c:pt idx="119">
                  <c:v>7315.908203125</c:v>
                </c:pt>
                <c:pt idx="120">
                  <c:v>7284.6181640625</c:v>
                </c:pt>
                <c:pt idx="121">
                  <c:v>7317.5068359375</c:v>
                </c:pt>
                <c:pt idx="122">
                  <c:v>7400.5615234375</c:v>
                </c:pt>
                <c:pt idx="123">
                  <c:v>7482.43994140625</c:v>
                </c:pt>
                <c:pt idx="124">
                  <c:v>7506.06689453125</c:v>
                </c:pt>
                <c:pt idx="125">
                  <c:v>7447.18701171875</c:v>
                </c:pt>
                <c:pt idx="126">
                  <c:v>7333.64697265625</c:v>
                </c:pt>
                <c:pt idx="127">
                  <c:v>7230.251953125</c:v>
                </c:pt>
                <c:pt idx="128">
                  <c:v>7197.08447265625</c:v>
                </c:pt>
                <c:pt idx="129">
                  <c:v>7248.736328125</c:v>
                </c:pt>
                <c:pt idx="130">
                  <c:v>7343.29638671875</c:v>
                </c:pt>
                <c:pt idx="131">
                  <c:v>7410.529296875</c:v>
                </c:pt>
                <c:pt idx="132">
                  <c:v>7400.94921875</c:v>
                </c:pt>
                <c:pt idx="133">
                  <c:v>7321.33837890625</c:v>
                </c:pt>
                <c:pt idx="134">
                  <c:v>7230.53857421875</c:v>
                </c:pt>
                <c:pt idx="135">
                  <c:v>7197.37109375</c:v>
                </c:pt>
                <c:pt idx="136">
                  <c:v>7250.47998046875</c:v>
                </c:pt>
                <c:pt idx="137">
                  <c:v>7356.68994140625</c:v>
                </c:pt>
                <c:pt idx="138">
                  <c:v>7444.2041015625</c:v>
                </c:pt>
                <c:pt idx="139">
                  <c:v>7453.95361328125</c:v>
                </c:pt>
                <c:pt idx="140">
                  <c:v>7381.396484375</c:v>
                </c:pt>
                <c:pt idx="141">
                  <c:v>7278.15087890625</c:v>
                </c:pt>
                <c:pt idx="142">
                  <c:v>7213.048828125</c:v>
                </c:pt>
                <c:pt idx="143">
                  <c:v>7222.49755859375</c:v>
                </c:pt>
                <c:pt idx="144">
                  <c:v>7287.2998046875</c:v>
                </c:pt>
                <c:pt idx="145">
                  <c:v>7351.904296875</c:v>
                </c:pt>
                <c:pt idx="146">
                  <c:v>7369.197265625</c:v>
                </c:pt>
                <c:pt idx="147">
                  <c:v>7335.150390625</c:v>
                </c:pt>
                <c:pt idx="148">
                  <c:v>7287.1953125</c:v>
                </c:pt>
                <c:pt idx="149">
                  <c:v>7269.86474609375</c:v>
                </c:pt>
                <c:pt idx="150">
                  <c:v>7296.98681640625</c:v>
                </c:pt>
                <c:pt idx="151">
                  <c:v>7341.2451171875</c:v>
                </c:pt>
                <c:pt idx="152">
                  <c:v>7358.720703125</c:v>
                </c:pt>
                <c:pt idx="153">
                  <c:v>7327.44921875</c:v>
                </c:pt>
                <c:pt idx="154">
                  <c:v>7268.1357421875</c:v>
                </c:pt>
                <c:pt idx="155">
                  <c:v>7230.169921875</c:v>
                </c:pt>
                <c:pt idx="156">
                  <c:v>7254.15576171875</c:v>
                </c:pt>
                <c:pt idx="157">
                  <c:v>7340.43212890625</c:v>
                </c:pt>
                <c:pt idx="158">
                  <c:v>7447.49267578125</c:v>
                </c:pt>
                <c:pt idx="159">
                  <c:v>7520.31005859375</c:v>
                </c:pt>
                <c:pt idx="160">
                  <c:v>7526.1826171875</c:v>
                </c:pt>
                <c:pt idx="161">
                  <c:v>7472.076171875</c:v>
                </c:pt>
                <c:pt idx="162">
                  <c:v>7393.80029296875</c:v>
                </c:pt>
                <c:pt idx="163">
                  <c:v>7329.01611328125</c:v>
                </c:pt>
                <c:pt idx="164">
                  <c:v>7295.68115234375</c:v>
                </c:pt>
                <c:pt idx="165">
                  <c:v>7289.27294921875</c:v>
                </c:pt>
                <c:pt idx="166">
                  <c:v>7295.26611328125</c:v>
                </c:pt>
                <c:pt idx="167">
                  <c:v>7302.77392578125</c:v>
                </c:pt>
                <c:pt idx="168">
                  <c:v>7308.56640625</c:v>
                </c:pt>
                <c:pt idx="169">
                  <c:v>7312.3427734375</c:v>
                </c:pt>
                <c:pt idx="170">
                  <c:v>7312.1728515625</c:v>
                </c:pt>
                <c:pt idx="171">
                  <c:v>7306.404296875</c:v>
                </c:pt>
                <c:pt idx="172">
                  <c:v>7299.11865234375</c:v>
                </c:pt>
                <c:pt idx="173">
                  <c:v>7300.74609375</c:v>
                </c:pt>
                <c:pt idx="174">
                  <c:v>7319.89892578125</c:v>
                </c:pt>
                <c:pt idx="175">
                  <c:v>7352.5859375</c:v>
                </c:pt>
                <c:pt idx="176">
                  <c:v>7380.193359375</c:v>
                </c:pt>
                <c:pt idx="177">
                  <c:v>7381.43505859375</c:v>
                </c:pt>
                <c:pt idx="178">
                  <c:v>7350.4619140625</c:v>
                </c:pt>
                <c:pt idx="179">
                  <c:v>7305.49609375</c:v>
                </c:pt>
                <c:pt idx="180">
                  <c:v>7278.19677734375</c:v>
                </c:pt>
                <c:pt idx="181">
                  <c:v>7289.8681640625</c:v>
                </c:pt>
                <c:pt idx="182">
                  <c:v>7333.14892578125</c:v>
                </c:pt>
                <c:pt idx="183">
                  <c:v>7375.25927734375</c:v>
                </c:pt>
                <c:pt idx="184">
                  <c:v>7382.0693359375</c:v>
                </c:pt>
                <c:pt idx="185">
                  <c:v>7344.75830078125</c:v>
                </c:pt>
                <c:pt idx="186">
                  <c:v>7287.6787109375</c:v>
                </c:pt>
                <c:pt idx="187">
                  <c:v>7250.56591796875</c:v>
                </c:pt>
                <c:pt idx="188">
                  <c:v>7258.8642578125</c:v>
                </c:pt>
                <c:pt idx="189">
                  <c:v>7305.46533203125</c:v>
                </c:pt>
                <c:pt idx="190">
                  <c:v>7357.64892578125</c:v>
                </c:pt>
                <c:pt idx="191">
                  <c:v>7382.49560546875</c:v>
                </c:pt>
                <c:pt idx="192">
                  <c:v>7369.7109375</c:v>
                </c:pt>
                <c:pt idx="193">
                  <c:v>7334.4208984375</c:v>
                </c:pt>
                <c:pt idx="194">
                  <c:v>7300.287109375</c:v>
                </c:pt>
                <c:pt idx="195">
                  <c:v>7279.55126953125</c:v>
                </c:pt>
                <c:pt idx="196">
                  <c:v>7267.55615234375</c:v>
                </c:pt>
                <c:pt idx="197">
                  <c:v>7254.7861328125</c:v>
                </c:pt>
                <c:pt idx="198">
                  <c:v>7243.0224609375</c:v>
                </c:pt>
                <c:pt idx="199">
                  <c:v>7248.64111328125</c:v>
                </c:pt>
                <c:pt idx="200">
                  <c:v>7288.4453125</c:v>
                </c:pt>
                <c:pt idx="201">
                  <c:v>7360.37158203125</c:v>
                </c:pt>
                <c:pt idx="202">
                  <c:v>7437.44580078125</c:v>
                </c:pt>
                <c:pt idx="203">
                  <c:v>7482.71240234375</c:v>
                </c:pt>
                <c:pt idx="204">
                  <c:v>7474.64013671875</c:v>
                </c:pt>
                <c:pt idx="205">
                  <c:v>7422.7587890625</c:v>
                </c:pt>
                <c:pt idx="206">
                  <c:v>7360.6923828125</c:v>
                </c:pt>
                <c:pt idx="207">
                  <c:v>7322.1142578125</c:v>
                </c:pt>
                <c:pt idx="208">
                  <c:v>7318.7197265625</c:v>
                </c:pt>
                <c:pt idx="209">
                  <c:v>7336.73388671875</c:v>
                </c:pt>
                <c:pt idx="210">
                  <c:v>7352.45947265625</c:v>
                </c:pt>
                <c:pt idx="211">
                  <c:v>7352.10302734375</c:v>
                </c:pt>
                <c:pt idx="212">
                  <c:v>7339.451171875</c:v>
                </c:pt>
                <c:pt idx="213">
                  <c:v>7327.37841796875</c:v>
                </c:pt>
                <c:pt idx="214">
                  <c:v>7323.720703125</c:v>
                </c:pt>
                <c:pt idx="215">
                  <c:v>7325.64892578125</c:v>
                </c:pt>
                <c:pt idx="216">
                  <c:v>7326.78076171875</c:v>
                </c:pt>
                <c:pt idx="217">
                  <c:v>7327.958984375</c:v>
                </c:pt>
                <c:pt idx="218">
                  <c:v>7338.81982421875</c:v>
                </c:pt>
                <c:pt idx="219">
                  <c:v>7366.767578125</c:v>
                </c:pt>
                <c:pt idx="220">
                  <c:v>7403.599609375</c:v>
                </c:pt>
                <c:pt idx="221">
                  <c:v>7424.41796875</c:v>
                </c:pt>
                <c:pt idx="222">
                  <c:v>7403.48583984375</c:v>
                </c:pt>
                <c:pt idx="223">
                  <c:v>7335.7978515625</c:v>
                </c:pt>
                <c:pt idx="224">
                  <c:v>7245.99169921875</c:v>
                </c:pt>
                <c:pt idx="225">
                  <c:v>7175.240234375</c:v>
                </c:pt>
                <c:pt idx="226">
                  <c:v>7154.89697265625</c:v>
                </c:pt>
                <c:pt idx="227">
                  <c:v>7187.15380859375</c:v>
                </c:pt>
                <c:pt idx="228">
                  <c:v>7247.39599609375</c:v>
                </c:pt>
                <c:pt idx="229">
                  <c:v>7304.83642578125</c:v>
                </c:pt>
                <c:pt idx="230">
                  <c:v>7343.1796875</c:v>
                </c:pt>
                <c:pt idx="231">
                  <c:v>7364.57568359375</c:v>
                </c:pt>
                <c:pt idx="232">
                  <c:v>7376.439453125</c:v>
                </c:pt>
                <c:pt idx="233">
                  <c:v>7376.8154296875</c:v>
                </c:pt>
                <c:pt idx="234">
                  <c:v>7354.74853515625</c:v>
                </c:pt>
                <c:pt idx="235">
                  <c:v>7306.591796875</c:v>
                </c:pt>
                <c:pt idx="236">
                  <c:v>7251.59619140625</c:v>
                </c:pt>
                <c:pt idx="237">
                  <c:v>7227.75244140625</c:v>
                </c:pt>
                <c:pt idx="238">
                  <c:v>7265.50830078125</c:v>
                </c:pt>
                <c:pt idx="239">
                  <c:v>7358.86328125</c:v>
                </c:pt>
                <c:pt idx="240">
                  <c:v>7460.13671875</c:v>
                </c:pt>
                <c:pt idx="241">
                  <c:v>7508.134765625</c:v>
                </c:pt>
                <c:pt idx="242">
                  <c:v>7471.65185546875</c:v>
                </c:pt>
                <c:pt idx="243">
                  <c:v>7374.74755859375</c:v>
                </c:pt>
                <c:pt idx="244">
                  <c:v>7281.82177734375</c:v>
                </c:pt>
                <c:pt idx="245">
                  <c:v>7251.533203125</c:v>
                </c:pt>
                <c:pt idx="246">
                  <c:v>7294.26904296875</c:v>
                </c:pt>
                <c:pt idx="247">
                  <c:v>7366.416015625</c:v>
                </c:pt>
                <c:pt idx="248">
                  <c:v>7406.1201171875</c:v>
                </c:pt>
                <c:pt idx="249">
                  <c:v>7382.21435546875</c:v>
                </c:pt>
                <c:pt idx="250">
                  <c:v>7317.48486328125</c:v>
                </c:pt>
                <c:pt idx="251">
                  <c:v>7268.27392578125</c:v>
                </c:pt>
                <c:pt idx="252">
                  <c:v>7277.68896484375</c:v>
                </c:pt>
                <c:pt idx="253">
                  <c:v>7340.64208984375</c:v>
                </c:pt>
                <c:pt idx="254">
                  <c:v>7408.56640625</c:v>
                </c:pt>
                <c:pt idx="255">
                  <c:v>7428.9443359375</c:v>
                </c:pt>
                <c:pt idx="256">
                  <c:v>7386.8447265625</c:v>
                </c:pt>
                <c:pt idx="257">
                  <c:v>7315.103515625</c:v>
                </c:pt>
                <c:pt idx="258">
                  <c:v>7266.3359375</c:v>
                </c:pt>
                <c:pt idx="259">
                  <c:v>7270.958984375</c:v>
                </c:pt>
                <c:pt idx="260">
                  <c:v>7315.44970703125</c:v>
                </c:pt>
                <c:pt idx="261">
                  <c:v>7356.87548828125</c:v>
                </c:pt>
                <c:pt idx="262">
                  <c:v>7359.53857421875</c:v>
                </c:pt>
                <c:pt idx="263">
                  <c:v>7322.74365234375</c:v>
                </c:pt>
                <c:pt idx="264">
                  <c:v>7278.166015625</c:v>
                </c:pt>
                <c:pt idx="265">
                  <c:v>7261.63916015625</c:v>
                </c:pt>
                <c:pt idx="266">
                  <c:v>7284.486328125</c:v>
                </c:pt>
                <c:pt idx="267">
                  <c:v>7327.51904296875</c:v>
                </c:pt>
                <c:pt idx="268">
                  <c:v>7359.92041015625</c:v>
                </c:pt>
                <c:pt idx="269">
                  <c:v>7364.51171875</c:v>
                </c:pt>
                <c:pt idx="270">
                  <c:v>7347.8251953125</c:v>
                </c:pt>
                <c:pt idx="271">
                  <c:v>7328.9541015625</c:v>
                </c:pt>
                <c:pt idx="272">
                  <c:v>7320.2197265625</c:v>
                </c:pt>
                <c:pt idx="273">
                  <c:v>7318.234375</c:v>
                </c:pt>
                <c:pt idx="274">
                  <c:v>7312.1513671875</c:v>
                </c:pt>
                <c:pt idx="275">
                  <c:v>7298.8642578125</c:v>
                </c:pt>
                <c:pt idx="276">
                  <c:v>7288.759765625</c:v>
                </c:pt>
                <c:pt idx="277">
                  <c:v>7295.72998046875</c:v>
                </c:pt>
                <c:pt idx="278">
                  <c:v>7321.37060546875</c:v>
                </c:pt>
                <c:pt idx="279">
                  <c:v>7349.86376953125</c:v>
                </c:pt>
                <c:pt idx="280">
                  <c:v>7360.3388671875</c:v>
                </c:pt>
                <c:pt idx="281">
                  <c:v>7346.3701171875</c:v>
                </c:pt>
                <c:pt idx="282">
                  <c:v>7324.068359375</c:v>
                </c:pt>
                <c:pt idx="283">
                  <c:v>7319.419921875</c:v>
                </c:pt>
                <c:pt idx="284">
                  <c:v>7344.56640625</c:v>
                </c:pt>
                <c:pt idx="285">
                  <c:v>7384.23828125</c:v>
                </c:pt>
                <c:pt idx="286">
                  <c:v>7406.17529296875</c:v>
                </c:pt>
                <c:pt idx="287">
                  <c:v>7388.47607421875</c:v>
                </c:pt>
                <c:pt idx="288">
                  <c:v>7340.64404296875</c:v>
                </c:pt>
                <c:pt idx="289">
                  <c:v>7298.72021484375</c:v>
                </c:pt>
                <c:pt idx="290">
                  <c:v>7296.45654296875</c:v>
                </c:pt>
                <c:pt idx="291">
                  <c:v>7335.90625</c:v>
                </c:pt>
                <c:pt idx="292">
                  <c:v>7383.08837890625</c:v>
                </c:pt>
                <c:pt idx="293">
                  <c:v>7394.3056640625</c:v>
                </c:pt>
                <c:pt idx="294">
                  <c:v>7352.576171875</c:v>
                </c:pt>
                <c:pt idx="295">
                  <c:v>7283.7880859375</c:v>
                </c:pt>
                <c:pt idx="296">
                  <c:v>7237.8369140625</c:v>
                </c:pt>
                <c:pt idx="297">
                  <c:v>7248.904296875</c:v>
                </c:pt>
                <c:pt idx="298">
                  <c:v>7307.10205078125</c:v>
                </c:pt>
                <c:pt idx="299">
                  <c:v>7365.3154296875</c:v>
                </c:pt>
                <c:pt idx="300">
                  <c:v>7376.57763671875</c:v>
                </c:pt>
                <c:pt idx="301">
                  <c:v>7332.0068359375</c:v>
                </c:pt>
                <c:pt idx="302">
                  <c:v>7268.4052734375</c:v>
                </c:pt>
                <c:pt idx="303">
                  <c:v>7239.083984375</c:v>
                </c:pt>
                <c:pt idx="304">
                  <c:v>7271.39990234375</c:v>
                </c:pt>
                <c:pt idx="305">
                  <c:v>7345.2548828125</c:v>
                </c:pt>
                <c:pt idx="306">
                  <c:v>7409.59765625</c:v>
                </c:pt>
                <c:pt idx="307">
                  <c:v>7423.06396484375</c:v>
                </c:pt>
                <c:pt idx="308">
                  <c:v>7385.634765625</c:v>
                </c:pt>
                <c:pt idx="309">
                  <c:v>7336.140625</c:v>
                </c:pt>
                <c:pt idx="310">
                  <c:v>7318.70263671875</c:v>
                </c:pt>
                <c:pt idx="311">
                  <c:v>7346.2958984375</c:v>
                </c:pt>
                <c:pt idx="312">
                  <c:v>7391.2705078125</c:v>
                </c:pt>
                <c:pt idx="313">
                  <c:v>7409.9365234375</c:v>
                </c:pt>
                <c:pt idx="314">
                  <c:v>7380.3349609375</c:v>
                </c:pt>
                <c:pt idx="315">
                  <c:v>7321.86669921875</c:v>
                </c:pt>
                <c:pt idx="316">
                  <c:v>7280.63330078125</c:v>
                </c:pt>
                <c:pt idx="317">
                  <c:v>7292.30419921875</c:v>
                </c:pt>
                <c:pt idx="318">
                  <c:v>7352.28564453125</c:v>
                </c:pt>
                <c:pt idx="319">
                  <c:v>7416.8955078125</c:v>
                </c:pt>
                <c:pt idx="320">
                  <c:v>7434.67919921875</c:v>
                </c:pt>
                <c:pt idx="321">
                  <c:v>7383.79931640625</c:v>
                </c:pt>
                <c:pt idx="322">
                  <c:v>7287.58154296875</c:v>
                </c:pt>
                <c:pt idx="323">
                  <c:v>7197.73974609375</c:v>
                </c:pt>
                <c:pt idx="324">
                  <c:v>7159.05859375</c:v>
                </c:pt>
                <c:pt idx="325">
                  <c:v>7181.67578125</c:v>
                </c:pt>
                <c:pt idx="326">
                  <c:v>7239.3681640625</c:v>
                </c:pt>
                <c:pt idx="327">
                  <c:v>7291.9921875</c:v>
                </c:pt>
                <c:pt idx="328">
                  <c:v>7313.6181640625</c:v>
                </c:pt>
                <c:pt idx="329">
                  <c:v>7306.48876953125</c:v>
                </c:pt>
                <c:pt idx="330">
                  <c:v>7293.7080078125</c:v>
                </c:pt>
                <c:pt idx="331">
                  <c:v>7299.2744140625</c:v>
                </c:pt>
                <c:pt idx="332">
                  <c:v>7331.07958984375</c:v>
                </c:pt>
                <c:pt idx="333">
                  <c:v>7377.4921875</c:v>
                </c:pt>
                <c:pt idx="334">
                  <c:v>7417.015625</c:v>
                </c:pt>
                <c:pt idx="335">
                  <c:v>7432.27099609375</c:v>
                </c:pt>
                <c:pt idx="336">
                  <c:v>7419.0947265625</c:v>
                </c:pt>
                <c:pt idx="337">
                  <c:v>7386.9404296875</c:v>
                </c:pt>
                <c:pt idx="338">
                  <c:v>7352.63427734375</c:v>
                </c:pt>
                <c:pt idx="339">
                  <c:v>7332.021484375</c:v>
                </c:pt>
                <c:pt idx="340">
                  <c:v>7333.19677734375</c:v>
                </c:pt>
                <c:pt idx="341">
                  <c:v>7353.2763671875</c:v>
                </c:pt>
                <c:pt idx="342">
                  <c:v>7379.63232421875</c:v>
                </c:pt>
                <c:pt idx="343">
                  <c:v>7395.62841796875</c:v>
                </c:pt>
                <c:pt idx="344">
                  <c:v>7389.1044921875</c:v>
                </c:pt>
                <c:pt idx="345">
                  <c:v>7359.54541015625</c:v>
                </c:pt>
                <c:pt idx="346">
                  <c:v>7319.28955078125</c:v>
                </c:pt>
                <c:pt idx="347">
                  <c:v>7286.9736328125</c:v>
                </c:pt>
                <c:pt idx="348">
                  <c:v>7276.564453125</c:v>
                </c:pt>
                <c:pt idx="349">
                  <c:v>7289.0087890625</c:v>
                </c:pt>
              </c:numCache>
            </c:numRef>
          </c:yVal>
          <c:smooth val="1"/>
          <c:extLst>
            <c:ext xmlns:c16="http://schemas.microsoft.com/office/drawing/2014/chart" uri="{C3380CC4-5D6E-409C-BE32-E72D297353CC}">
              <c16:uniqueId val="{00000011-4A37-429A-A58F-F7AEDA5D1ACA}"/>
            </c:ext>
          </c:extLst>
        </c:ser>
        <c:ser>
          <c:idx val="18"/>
          <c:order val="18"/>
          <c:tx>
            <c:strRef>
              <c:f>cp_sub_001!$S$1</c:f>
              <c:strCache>
                <c:ptCount val="1"/>
                <c:pt idx="0">
                  <c:v>Coor_19</c:v>
                </c:pt>
              </c:strCache>
            </c:strRef>
          </c:tx>
          <c:spPr>
            <a:ln w="28575" cap="rnd">
              <a:solidFill>
                <a:schemeClr val="accent1">
                  <a:lumMod val="80000"/>
                </a:schemeClr>
              </a:solidFill>
              <a:round/>
            </a:ln>
            <a:effectLst/>
          </c:spPr>
          <c:marker>
            <c:symbol val="none"/>
          </c:marker>
          <c:yVal>
            <c:numRef>
              <c:f>cp_sub_001!$S$2:$S$351</c:f>
              <c:numCache>
                <c:formatCode>0.00000000000_ </c:formatCode>
                <c:ptCount val="350"/>
                <c:pt idx="0">
                  <c:v>7712.572265625</c:v>
                </c:pt>
                <c:pt idx="1">
                  <c:v>7740.93359375</c:v>
                </c:pt>
                <c:pt idx="2">
                  <c:v>7790.43115234375</c:v>
                </c:pt>
                <c:pt idx="3">
                  <c:v>7836.30810546875</c:v>
                </c:pt>
                <c:pt idx="4">
                  <c:v>7856.61474609375</c:v>
                </c:pt>
                <c:pt idx="5">
                  <c:v>7845.91015625</c:v>
                </c:pt>
                <c:pt idx="6">
                  <c:v>7816.35693359375</c:v>
                </c:pt>
                <c:pt idx="7">
                  <c:v>7786.49072265625</c:v>
                </c:pt>
                <c:pt idx="8">
                  <c:v>7767.39306640625</c:v>
                </c:pt>
                <c:pt idx="9">
                  <c:v>7757.078125</c:v>
                </c:pt>
                <c:pt idx="10">
                  <c:v>7746.29541015625</c:v>
                </c:pt>
                <c:pt idx="11">
                  <c:v>7729.38037109375</c:v>
                </c:pt>
                <c:pt idx="12">
                  <c:v>7710.34619140625</c:v>
                </c:pt>
                <c:pt idx="13">
                  <c:v>7699.44970703125</c:v>
                </c:pt>
                <c:pt idx="14">
                  <c:v>7704.08544921875</c:v>
                </c:pt>
                <c:pt idx="15">
                  <c:v>7722.4296875</c:v>
                </c:pt>
                <c:pt idx="16">
                  <c:v>7745.111328125</c:v>
                </c:pt>
                <c:pt idx="17">
                  <c:v>7762.68798828125</c:v>
                </c:pt>
                <c:pt idx="18">
                  <c:v>7771.78125</c:v>
                </c:pt>
                <c:pt idx="19">
                  <c:v>7774.6806640625</c:v>
                </c:pt>
                <c:pt idx="20">
                  <c:v>7773.8564453125</c:v>
                </c:pt>
                <c:pt idx="21">
                  <c:v>7767.75830078125</c:v>
                </c:pt>
                <c:pt idx="22">
                  <c:v>7752.83203125</c:v>
                </c:pt>
                <c:pt idx="23">
                  <c:v>7730.21533203125</c:v>
                </c:pt>
                <c:pt idx="24">
                  <c:v>7710.1943359375</c:v>
                </c:pt>
                <c:pt idx="25">
                  <c:v>7708.5078125</c:v>
                </c:pt>
                <c:pt idx="26">
                  <c:v>7735.57763671875</c:v>
                </c:pt>
                <c:pt idx="27">
                  <c:v>7786.662109375</c:v>
                </c:pt>
                <c:pt idx="28">
                  <c:v>7841.51025390625</c:v>
                </c:pt>
                <c:pt idx="29">
                  <c:v>7875.27685546875</c:v>
                </c:pt>
                <c:pt idx="30">
                  <c:v>7873.619140625</c:v>
                </c:pt>
                <c:pt idx="31">
                  <c:v>7841.2451171875</c:v>
                </c:pt>
                <c:pt idx="32">
                  <c:v>7797.87890625</c:v>
                </c:pt>
                <c:pt idx="33">
                  <c:v>7764.90087890625</c:v>
                </c:pt>
                <c:pt idx="34">
                  <c:v>7752.48046875</c:v>
                </c:pt>
                <c:pt idx="35">
                  <c:v>7755.9365234375</c:v>
                </c:pt>
                <c:pt idx="36">
                  <c:v>7762.59130859375</c:v>
                </c:pt>
                <c:pt idx="37">
                  <c:v>7762.7265625</c:v>
                </c:pt>
                <c:pt idx="38">
                  <c:v>7756.18212890625</c:v>
                </c:pt>
                <c:pt idx="39">
                  <c:v>7750.572265625</c:v>
                </c:pt>
                <c:pt idx="40">
                  <c:v>7753.87841796875</c:v>
                </c:pt>
                <c:pt idx="41">
                  <c:v>7767.81103515625</c:v>
                </c:pt>
                <c:pt idx="42">
                  <c:v>7786.67822265625</c:v>
                </c:pt>
                <c:pt idx="43">
                  <c:v>7801.58056640625</c:v>
                </c:pt>
                <c:pt idx="44">
                  <c:v>7805.97802734375</c:v>
                </c:pt>
                <c:pt idx="45">
                  <c:v>7798.53515625</c:v>
                </c:pt>
                <c:pt idx="46">
                  <c:v>7782.04248046875</c:v>
                </c:pt>
                <c:pt idx="47">
                  <c:v>7760.27587890625</c:v>
                </c:pt>
                <c:pt idx="48">
                  <c:v>7735.630859375</c:v>
                </c:pt>
                <c:pt idx="49">
                  <c:v>7709.13232421875</c:v>
                </c:pt>
                <c:pt idx="50">
                  <c:v>7682.39990234375</c:v>
                </c:pt>
                <c:pt idx="51">
                  <c:v>7659.83154296875</c:v>
                </c:pt>
                <c:pt idx="52">
                  <c:v>7649.1279296875</c:v>
                </c:pt>
                <c:pt idx="53">
                  <c:v>7659.0244140625</c:v>
                </c:pt>
                <c:pt idx="54">
                  <c:v>7694.4921875</c:v>
                </c:pt>
                <c:pt idx="55">
                  <c:v>7751.4541015625</c:v>
                </c:pt>
                <c:pt idx="56">
                  <c:v>7814.484375</c:v>
                </c:pt>
                <c:pt idx="57">
                  <c:v>7860.6591796875</c:v>
                </c:pt>
                <c:pt idx="58">
                  <c:v>7869.703125</c:v>
                </c:pt>
                <c:pt idx="59">
                  <c:v>7835.958984375</c:v>
                </c:pt>
                <c:pt idx="60">
                  <c:v>7774.64453125</c:v>
                </c:pt>
                <c:pt idx="61">
                  <c:v>7716.6455078125</c:v>
                </c:pt>
                <c:pt idx="62">
                  <c:v>7692.8671875</c:v>
                </c:pt>
                <c:pt idx="63">
                  <c:v>7716.77685546875</c:v>
                </c:pt>
                <c:pt idx="64">
                  <c:v>7776.36376953125</c:v>
                </c:pt>
                <c:pt idx="65">
                  <c:v>7841.32861328125</c:v>
                </c:pt>
                <c:pt idx="66">
                  <c:v>7881.08642578125</c:v>
                </c:pt>
                <c:pt idx="67">
                  <c:v>7881.56494140625</c:v>
                </c:pt>
                <c:pt idx="68">
                  <c:v>7849.92138671875</c:v>
                </c:pt>
                <c:pt idx="69">
                  <c:v>7805.55859375</c:v>
                </c:pt>
                <c:pt idx="70">
                  <c:v>7765.9091796875</c:v>
                </c:pt>
                <c:pt idx="71">
                  <c:v>7738.29638671875</c:v>
                </c:pt>
                <c:pt idx="72">
                  <c:v>7722.490234375</c:v>
                </c:pt>
                <c:pt idx="73">
                  <c:v>7718.5009765625</c:v>
                </c:pt>
                <c:pt idx="74">
                  <c:v>7729.7197265625</c:v>
                </c:pt>
                <c:pt idx="75">
                  <c:v>7756.97998046875</c:v>
                </c:pt>
                <c:pt idx="76">
                  <c:v>7789.576171875</c:v>
                </c:pt>
                <c:pt idx="77">
                  <c:v>7804.6884765625</c:v>
                </c:pt>
                <c:pt idx="78">
                  <c:v>7780.79150390625</c:v>
                </c:pt>
                <c:pt idx="79">
                  <c:v>7717.3603515625</c:v>
                </c:pt>
                <c:pt idx="80">
                  <c:v>7644.1943359375</c:v>
                </c:pt>
                <c:pt idx="81">
                  <c:v>7608.38134765625</c:v>
                </c:pt>
                <c:pt idx="82">
                  <c:v>7643.76123046875</c:v>
                </c:pt>
                <c:pt idx="83">
                  <c:v>7743.76171875</c:v>
                </c:pt>
                <c:pt idx="84">
                  <c:v>7859.59375</c:v>
                </c:pt>
                <c:pt idx="85">
                  <c:v>7928.82958984375</c:v>
                </c:pt>
                <c:pt idx="86">
                  <c:v>7916.19189453125</c:v>
                </c:pt>
                <c:pt idx="87">
                  <c:v>7837.26416015625</c:v>
                </c:pt>
                <c:pt idx="88">
                  <c:v>7746.85302734375</c:v>
                </c:pt>
                <c:pt idx="89">
                  <c:v>7699.75830078125</c:v>
                </c:pt>
                <c:pt idx="90">
                  <c:v>7712.87255859375</c:v>
                </c:pt>
                <c:pt idx="91">
                  <c:v>7756.91064453125</c:v>
                </c:pt>
                <c:pt idx="92">
                  <c:v>7783.41552734375</c:v>
                </c:pt>
                <c:pt idx="93">
                  <c:v>7765.2978515625</c:v>
                </c:pt>
                <c:pt idx="94">
                  <c:v>7718.71044921875</c:v>
                </c:pt>
                <c:pt idx="95">
                  <c:v>7689.03173828125</c:v>
                </c:pt>
                <c:pt idx="96">
                  <c:v>7712.455078125</c:v>
                </c:pt>
                <c:pt idx="97">
                  <c:v>7784.34375</c:v>
                </c:pt>
                <c:pt idx="98">
                  <c:v>7860.2294921875</c:v>
                </c:pt>
                <c:pt idx="99">
                  <c:v>7889.193359375</c:v>
                </c:pt>
                <c:pt idx="100">
                  <c:v>7853.22509765625</c:v>
                </c:pt>
                <c:pt idx="101">
                  <c:v>7781.0595703125</c:v>
                </c:pt>
                <c:pt idx="102">
                  <c:v>7725.22119140625</c:v>
                </c:pt>
                <c:pt idx="103">
                  <c:v>7720.4658203125</c:v>
                </c:pt>
                <c:pt idx="104">
                  <c:v>7756.92138671875</c:v>
                </c:pt>
                <c:pt idx="105">
                  <c:v>7789.62548828125</c:v>
                </c:pt>
                <c:pt idx="106">
                  <c:v>7776.990234375</c:v>
                </c:pt>
                <c:pt idx="107">
                  <c:v>7717.1455078125</c:v>
                </c:pt>
                <c:pt idx="108">
                  <c:v>7652.220703125</c:v>
                </c:pt>
                <c:pt idx="109">
                  <c:v>7635.884765625</c:v>
                </c:pt>
                <c:pt idx="110">
                  <c:v>7689.11865234375</c:v>
                </c:pt>
                <c:pt idx="111">
                  <c:v>7779.68212890625</c:v>
                </c:pt>
                <c:pt idx="112">
                  <c:v>7843.21484375</c:v>
                </c:pt>
                <c:pt idx="113">
                  <c:v>7831.568359375</c:v>
                </c:pt>
                <c:pt idx="114">
                  <c:v>7751.7900390625</c:v>
                </c:pt>
                <c:pt idx="115">
                  <c:v>7664.80712890625</c:v>
                </c:pt>
                <c:pt idx="116">
                  <c:v>7642.65087890625</c:v>
                </c:pt>
                <c:pt idx="117">
                  <c:v>7714.78076171875</c:v>
                </c:pt>
                <c:pt idx="118">
                  <c:v>7843.46533203125</c:v>
                </c:pt>
                <c:pt idx="119">
                  <c:v>7947.71484375</c:v>
                </c:pt>
                <c:pt idx="120">
                  <c:v>7959.6728515625</c:v>
                </c:pt>
                <c:pt idx="121">
                  <c:v>7873.06005859375</c:v>
                </c:pt>
                <c:pt idx="122">
                  <c:v>7748.38720703125</c:v>
                </c:pt>
                <c:pt idx="123">
                  <c:v>7670.71044921875</c:v>
                </c:pt>
                <c:pt idx="124">
                  <c:v>7690.05419921875</c:v>
                </c:pt>
                <c:pt idx="125">
                  <c:v>7787.103515625</c:v>
                </c:pt>
                <c:pt idx="126">
                  <c:v>7888.31005859375</c:v>
                </c:pt>
                <c:pt idx="127">
                  <c:v>7918.833984375</c:v>
                </c:pt>
                <c:pt idx="128">
                  <c:v>7854.794921875</c:v>
                </c:pt>
                <c:pt idx="129">
                  <c:v>7737.724609375</c:v>
                </c:pt>
                <c:pt idx="130">
                  <c:v>7642.31787109375</c:v>
                </c:pt>
                <c:pt idx="131">
                  <c:v>7622.5654296875</c:v>
                </c:pt>
                <c:pt idx="132">
                  <c:v>7676.03271484375</c:v>
                </c:pt>
                <c:pt idx="133">
                  <c:v>7751.1806640625</c:v>
                </c:pt>
                <c:pt idx="134">
                  <c:v>7789.8544921875</c:v>
                </c:pt>
                <c:pt idx="135">
                  <c:v>7771.2783203125</c:v>
                </c:pt>
                <c:pt idx="136">
                  <c:v>7724.24951171875</c:v>
                </c:pt>
                <c:pt idx="137">
                  <c:v>7699.77587890625</c:v>
                </c:pt>
                <c:pt idx="138">
                  <c:v>7727.220703125</c:v>
                </c:pt>
                <c:pt idx="139">
                  <c:v>7789.265625</c:v>
                </c:pt>
                <c:pt idx="140">
                  <c:v>7835.54736328125</c:v>
                </c:pt>
                <c:pt idx="141">
                  <c:v>7823.96875</c:v>
                </c:pt>
                <c:pt idx="142">
                  <c:v>7756.607421875</c:v>
                </c:pt>
                <c:pt idx="143">
                  <c:v>7681.224609375</c:v>
                </c:pt>
                <c:pt idx="144">
                  <c:v>7656.31103515625</c:v>
                </c:pt>
                <c:pt idx="145">
                  <c:v>7706.359375</c:v>
                </c:pt>
                <c:pt idx="146">
                  <c:v>7802.00244140625</c:v>
                </c:pt>
                <c:pt idx="147">
                  <c:v>7880.57666015625</c:v>
                </c:pt>
                <c:pt idx="148">
                  <c:v>7891.5361328125</c:v>
                </c:pt>
                <c:pt idx="149">
                  <c:v>7832.2373046875</c:v>
                </c:pt>
                <c:pt idx="150">
                  <c:v>7747.5703125</c:v>
                </c:pt>
                <c:pt idx="151">
                  <c:v>7695.06201171875</c:v>
                </c:pt>
                <c:pt idx="152">
                  <c:v>7703.15966796875</c:v>
                </c:pt>
                <c:pt idx="153">
                  <c:v>7754.2080078125</c:v>
                </c:pt>
                <c:pt idx="154">
                  <c:v>7803.017578125</c:v>
                </c:pt>
                <c:pt idx="155">
                  <c:v>7813.93212890625</c:v>
                </c:pt>
                <c:pt idx="156">
                  <c:v>7786.2734375</c:v>
                </c:pt>
                <c:pt idx="157">
                  <c:v>7749.458984375</c:v>
                </c:pt>
                <c:pt idx="158">
                  <c:v>7734.64208984375</c:v>
                </c:pt>
                <c:pt idx="159">
                  <c:v>7748.11572265625</c:v>
                </c:pt>
                <c:pt idx="160">
                  <c:v>7768.5166015625</c:v>
                </c:pt>
                <c:pt idx="161">
                  <c:v>7768.66796875</c:v>
                </c:pt>
                <c:pt idx="162">
                  <c:v>7742.07861328125</c:v>
                </c:pt>
                <c:pt idx="163">
                  <c:v>7710.78857421875</c:v>
                </c:pt>
                <c:pt idx="164">
                  <c:v>7707.65087890625</c:v>
                </c:pt>
                <c:pt idx="165">
                  <c:v>7747.900390625</c:v>
                </c:pt>
                <c:pt idx="166">
                  <c:v>7813.84814453125</c:v>
                </c:pt>
                <c:pt idx="167">
                  <c:v>7865.60546875</c:v>
                </c:pt>
                <c:pt idx="168">
                  <c:v>7869.53466796875</c:v>
                </c:pt>
                <c:pt idx="169">
                  <c:v>7822.2265625</c:v>
                </c:pt>
                <c:pt idx="170">
                  <c:v>7752.11328125</c:v>
                </c:pt>
                <c:pt idx="171">
                  <c:v>7698.873046875</c:v>
                </c:pt>
                <c:pt idx="172">
                  <c:v>7687.36865234375</c:v>
                </c:pt>
                <c:pt idx="173">
                  <c:v>7715.04248046875</c:v>
                </c:pt>
                <c:pt idx="174">
                  <c:v>7759.271484375</c:v>
                </c:pt>
                <c:pt idx="175">
                  <c:v>7795.63818359375</c:v>
                </c:pt>
                <c:pt idx="176">
                  <c:v>7812.0693359375</c:v>
                </c:pt>
                <c:pt idx="177">
                  <c:v>7810.5107421875</c:v>
                </c:pt>
                <c:pt idx="178">
                  <c:v>7799.4794921875</c:v>
                </c:pt>
                <c:pt idx="179">
                  <c:v>7786.7216796875</c:v>
                </c:pt>
                <c:pt idx="180">
                  <c:v>7777.42822265625</c:v>
                </c:pt>
                <c:pt idx="181">
                  <c:v>7775.62744140625</c:v>
                </c:pt>
                <c:pt idx="182">
                  <c:v>7783.22119140625</c:v>
                </c:pt>
                <c:pt idx="183">
                  <c:v>7795.63818359375</c:v>
                </c:pt>
                <c:pt idx="184">
                  <c:v>7799.73486328125</c:v>
                </c:pt>
                <c:pt idx="185">
                  <c:v>7780.10498046875</c:v>
                </c:pt>
                <c:pt idx="186">
                  <c:v>7732.31396484375</c:v>
                </c:pt>
                <c:pt idx="187">
                  <c:v>7672.55322265625</c:v>
                </c:pt>
                <c:pt idx="188">
                  <c:v>7632.6435546875</c:v>
                </c:pt>
                <c:pt idx="189">
                  <c:v>7640.0048828125</c:v>
                </c:pt>
                <c:pt idx="190">
                  <c:v>7696.10498046875</c:v>
                </c:pt>
                <c:pt idx="191">
                  <c:v>7771.283203125</c:v>
                </c:pt>
                <c:pt idx="192">
                  <c:v>7822.9013671875</c:v>
                </c:pt>
                <c:pt idx="193">
                  <c:v>7825.02587890625</c:v>
                </c:pt>
                <c:pt idx="194">
                  <c:v>7786.93359375</c:v>
                </c:pt>
                <c:pt idx="195">
                  <c:v>7744.9990234375</c:v>
                </c:pt>
                <c:pt idx="196">
                  <c:v>7733.46435546875</c:v>
                </c:pt>
                <c:pt idx="197">
                  <c:v>7757.31298828125</c:v>
                </c:pt>
                <c:pt idx="198">
                  <c:v>7789.65966796875</c:v>
                </c:pt>
                <c:pt idx="199">
                  <c:v>7796.31787109375</c:v>
                </c:pt>
                <c:pt idx="200">
                  <c:v>7767.3046875</c:v>
                </c:pt>
                <c:pt idx="201">
                  <c:v>7728.3271484375</c:v>
                </c:pt>
                <c:pt idx="202">
                  <c:v>7721.18017578125</c:v>
                </c:pt>
                <c:pt idx="203">
                  <c:v>7767.99560546875</c:v>
                </c:pt>
                <c:pt idx="204">
                  <c:v>7848.84619140625</c:v>
                </c:pt>
                <c:pt idx="205">
                  <c:v>7912.57421875</c:v>
                </c:pt>
                <c:pt idx="206">
                  <c:v>7914.056640625</c:v>
                </c:pt>
                <c:pt idx="207">
                  <c:v>7849.05517578125</c:v>
                </c:pt>
                <c:pt idx="208">
                  <c:v>7758.671875</c:v>
                </c:pt>
                <c:pt idx="209">
                  <c:v>7699.10009765625</c:v>
                </c:pt>
                <c:pt idx="210">
                  <c:v>7699.9052734375</c:v>
                </c:pt>
                <c:pt idx="211">
                  <c:v>7743.30126953125</c:v>
                </c:pt>
                <c:pt idx="212">
                  <c:v>7780.29833984375</c:v>
                </c:pt>
                <c:pt idx="213">
                  <c:v>7770.591796875</c:v>
                </c:pt>
                <c:pt idx="214">
                  <c:v>7714.7626953125</c:v>
                </c:pt>
                <c:pt idx="215">
                  <c:v>7654.00048828125</c:v>
                </c:pt>
                <c:pt idx="216">
                  <c:v>7638.28173828125</c:v>
                </c:pt>
                <c:pt idx="217">
                  <c:v>7688.03515625</c:v>
                </c:pt>
                <c:pt idx="218">
                  <c:v>7778.287109375</c:v>
                </c:pt>
                <c:pt idx="219">
                  <c:v>7856.10400390625</c:v>
                </c:pt>
                <c:pt idx="220">
                  <c:v>7877.0654296875</c:v>
                </c:pt>
                <c:pt idx="221">
                  <c:v>7833.8291015625</c:v>
                </c:pt>
                <c:pt idx="222">
                  <c:v>7757.9453125</c:v>
                </c:pt>
                <c:pt idx="223">
                  <c:v>7696.7177734375</c:v>
                </c:pt>
                <c:pt idx="224">
                  <c:v>7683.52734375</c:v>
                </c:pt>
                <c:pt idx="225">
                  <c:v>7721.30224609375</c:v>
                </c:pt>
                <c:pt idx="226">
                  <c:v>7786.443359375</c:v>
                </c:pt>
                <c:pt idx="227">
                  <c:v>7846.00244140625</c:v>
                </c:pt>
                <c:pt idx="228">
                  <c:v>7874.9365234375</c:v>
                </c:pt>
                <c:pt idx="229">
                  <c:v>7864.66455078125</c:v>
                </c:pt>
                <c:pt idx="230">
                  <c:v>7822.4599609375</c:v>
                </c:pt>
                <c:pt idx="231">
                  <c:v>7765.974609375</c:v>
                </c:pt>
                <c:pt idx="232">
                  <c:v>7716.36474609375</c:v>
                </c:pt>
                <c:pt idx="233">
                  <c:v>7690.92236328125</c:v>
                </c:pt>
                <c:pt idx="234">
                  <c:v>7696.01416015625</c:v>
                </c:pt>
                <c:pt idx="235">
                  <c:v>7723.4833984375</c:v>
                </c:pt>
                <c:pt idx="236">
                  <c:v>7754.361328125</c:v>
                </c:pt>
                <c:pt idx="237">
                  <c:v>7769.91455078125</c:v>
                </c:pt>
                <c:pt idx="238">
                  <c:v>7763.74853515625</c:v>
                </c:pt>
                <c:pt idx="239">
                  <c:v>7745.9384765625</c:v>
                </c:pt>
                <c:pt idx="240">
                  <c:v>7734.9052734375</c:v>
                </c:pt>
                <c:pt idx="241">
                  <c:v>7742.353515625</c:v>
                </c:pt>
                <c:pt idx="242">
                  <c:v>7763.11669921875</c:v>
                </c:pt>
                <c:pt idx="243">
                  <c:v>7778.85693359375</c:v>
                </c:pt>
                <c:pt idx="244">
                  <c:v>7773.6083984375</c:v>
                </c:pt>
                <c:pt idx="245">
                  <c:v>7748.84716796875</c:v>
                </c:pt>
                <c:pt idx="246">
                  <c:v>7725.16015625</c:v>
                </c:pt>
                <c:pt idx="247">
                  <c:v>7727.86572265625</c:v>
                </c:pt>
                <c:pt idx="248">
                  <c:v>7767.119140625</c:v>
                </c:pt>
                <c:pt idx="249">
                  <c:v>7828.1181640625</c:v>
                </c:pt>
                <c:pt idx="250">
                  <c:v>7879.50439453125</c:v>
                </c:pt>
                <c:pt idx="251">
                  <c:v>7893.85986328125</c:v>
                </c:pt>
                <c:pt idx="252">
                  <c:v>7864.84765625</c:v>
                </c:pt>
                <c:pt idx="253">
                  <c:v>7808.6650390625</c:v>
                </c:pt>
                <c:pt idx="254">
                  <c:v>7750.22412109375</c:v>
                </c:pt>
                <c:pt idx="255">
                  <c:v>7706.20068359375</c:v>
                </c:pt>
                <c:pt idx="256">
                  <c:v>7678.29150390625</c:v>
                </c:pt>
                <c:pt idx="257">
                  <c:v>7660.23583984375</c:v>
                </c:pt>
                <c:pt idx="258">
                  <c:v>7650.1904296875</c:v>
                </c:pt>
                <c:pt idx="259">
                  <c:v>7656.0634765625</c:v>
                </c:pt>
                <c:pt idx="260">
                  <c:v>7688.498046875</c:v>
                </c:pt>
                <c:pt idx="261">
                  <c:v>7747.7978515625</c:v>
                </c:pt>
                <c:pt idx="262">
                  <c:v>7817.06494140625</c:v>
                </c:pt>
                <c:pt idx="263">
                  <c:v>7868.99365234375</c:v>
                </c:pt>
                <c:pt idx="264">
                  <c:v>7882.3876953125</c:v>
                </c:pt>
                <c:pt idx="265">
                  <c:v>7856.1259765625</c:v>
                </c:pt>
                <c:pt idx="266">
                  <c:v>7809.90087890625</c:v>
                </c:pt>
                <c:pt idx="267">
                  <c:v>7771.14111328125</c:v>
                </c:pt>
                <c:pt idx="268">
                  <c:v>7757.77392578125</c:v>
                </c:pt>
                <c:pt idx="269">
                  <c:v>7768.92431640625</c:v>
                </c:pt>
                <c:pt idx="270">
                  <c:v>7788.9609375</c:v>
                </c:pt>
                <c:pt idx="271">
                  <c:v>7800.32275390625</c:v>
                </c:pt>
                <c:pt idx="272">
                  <c:v>7795.111328125</c:v>
                </c:pt>
                <c:pt idx="273">
                  <c:v>7777.90625</c:v>
                </c:pt>
                <c:pt idx="274">
                  <c:v>7759.67578125</c:v>
                </c:pt>
                <c:pt idx="275">
                  <c:v>7748.77001953125</c:v>
                </c:pt>
                <c:pt idx="276">
                  <c:v>7745.685546875</c:v>
                </c:pt>
                <c:pt idx="277">
                  <c:v>7744.27392578125</c:v>
                </c:pt>
                <c:pt idx="278">
                  <c:v>7737.2626953125</c:v>
                </c:pt>
                <c:pt idx="279">
                  <c:v>7721.83056640625</c:v>
                </c:pt>
                <c:pt idx="280">
                  <c:v>7702.0283203125</c:v>
                </c:pt>
                <c:pt idx="281">
                  <c:v>7687.19970703125</c:v>
                </c:pt>
                <c:pt idx="282">
                  <c:v>7687.40869140625</c:v>
                </c:pt>
                <c:pt idx="283">
                  <c:v>7707.84375</c:v>
                </c:pt>
                <c:pt idx="284">
                  <c:v>7744.7021484375</c:v>
                </c:pt>
                <c:pt idx="285">
                  <c:v>7785.18798828125</c:v>
                </c:pt>
                <c:pt idx="286">
                  <c:v>7812.92626953125</c:v>
                </c:pt>
                <c:pt idx="287">
                  <c:v>7817.0458984375</c:v>
                </c:pt>
                <c:pt idx="288">
                  <c:v>7799.7900390625</c:v>
                </c:pt>
                <c:pt idx="289">
                  <c:v>7776.88037109375</c:v>
                </c:pt>
                <c:pt idx="290">
                  <c:v>7768.60888671875</c:v>
                </c:pt>
                <c:pt idx="291">
                  <c:v>7786.18505859375</c:v>
                </c:pt>
                <c:pt idx="292">
                  <c:v>7822.38916015625</c:v>
                </c:pt>
                <c:pt idx="293">
                  <c:v>7853.97216796875</c:v>
                </c:pt>
                <c:pt idx="294">
                  <c:v>7855.63525390625</c:v>
                </c:pt>
                <c:pt idx="295">
                  <c:v>7816.96826171875</c:v>
                </c:pt>
                <c:pt idx="296">
                  <c:v>7750.83837890625</c:v>
                </c:pt>
                <c:pt idx="297">
                  <c:v>7687.06591796875</c:v>
                </c:pt>
                <c:pt idx="298">
                  <c:v>7655.15869140625</c:v>
                </c:pt>
                <c:pt idx="299">
                  <c:v>7667.3017578125</c:v>
                </c:pt>
                <c:pt idx="300">
                  <c:v>7712.3564453125</c:v>
                </c:pt>
                <c:pt idx="301">
                  <c:v>7763.9296875</c:v>
                </c:pt>
                <c:pt idx="302">
                  <c:v>7796.4697265625</c:v>
                </c:pt>
                <c:pt idx="303">
                  <c:v>7799.05712890625</c:v>
                </c:pt>
                <c:pt idx="304">
                  <c:v>7779.306640625</c:v>
                </c:pt>
                <c:pt idx="305">
                  <c:v>7756.64111328125</c:v>
                </c:pt>
                <c:pt idx="306">
                  <c:v>7750.08203125</c:v>
                </c:pt>
                <c:pt idx="307">
                  <c:v>7767.5048828125</c:v>
                </c:pt>
                <c:pt idx="308">
                  <c:v>7801.32373046875</c:v>
                </c:pt>
                <c:pt idx="309">
                  <c:v>7832.1640625</c:v>
                </c:pt>
                <c:pt idx="310">
                  <c:v>7838.87158203125</c:v>
                </c:pt>
                <c:pt idx="311">
                  <c:v>7810.669921875</c:v>
                </c:pt>
                <c:pt idx="312">
                  <c:v>7755.4990234375</c:v>
                </c:pt>
                <c:pt idx="313">
                  <c:v>7698.89794921875</c:v>
                </c:pt>
                <c:pt idx="314">
                  <c:v>7671.72607421875</c:v>
                </c:pt>
                <c:pt idx="315">
                  <c:v>7691.92578125</c:v>
                </c:pt>
                <c:pt idx="316">
                  <c:v>7751.29296875</c:v>
                </c:pt>
                <c:pt idx="317">
                  <c:v>7817.53955078125</c:v>
                </c:pt>
                <c:pt idx="318">
                  <c:v>7853.0283203125</c:v>
                </c:pt>
                <c:pt idx="319">
                  <c:v>7839.37841796875</c:v>
                </c:pt>
                <c:pt idx="320">
                  <c:v>7790.77490234375</c:v>
                </c:pt>
                <c:pt idx="321">
                  <c:v>7744.8173828125</c:v>
                </c:pt>
                <c:pt idx="322">
                  <c:v>7735.4521484375</c:v>
                </c:pt>
                <c:pt idx="323">
                  <c:v>7766.91455078125</c:v>
                </c:pt>
                <c:pt idx="324">
                  <c:v>7808.83349609375</c:v>
                </c:pt>
                <c:pt idx="325">
                  <c:v>7818.1064453125</c:v>
                </c:pt>
                <c:pt idx="326">
                  <c:v>7772.74365234375</c:v>
                </c:pt>
                <c:pt idx="327">
                  <c:v>7692.29833984375</c:v>
                </c:pt>
                <c:pt idx="328">
                  <c:v>7627.97216796875</c:v>
                </c:pt>
                <c:pt idx="329">
                  <c:v>7627.73974609375</c:v>
                </c:pt>
                <c:pt idx="330">
                  <c:v>7701.2490234375</c:v>
                </c:pt>
                <c:pt idx="331">
                  <c:v>7810.55908203125</c:v>
                </c:pt>
                <c:pt idx="332">
                  <c:v>7894.2587890625</c:v>
                </c:pt>
                <c:pt idx="333">
                  <c:v>7907.91259765625</c:v>
                </c:pt>
                <c:pt idx="334">
                  <c:v>7851.83349609375</c:v>
                </c:pt>
                <c:pt idx="335">
                  <c:v>7766.9931640625</c:v>
                </c:pt>
                <c:pt idx="336">
                  <c:v>7703.75146484375</c:v>
                </c:pt>
                <c:pt idx="337">
                  <c:v>7687.5869140625</c:v>
                </c:pt>
                <c:pt idx="338">
                  <c:v>7706.56689453125</c:v>
                </c:pt>
                <c:pt idx="339">
                  <c:v>7727.376953125</c:v>
                </c:pt>
                <c:pt idx="340">
                  <c:v>7724.95751953125</c:v>
                </c:pt>
                <c:pt idx="341">
                  <c:v>7701.990234375</c:v>
                </c:pt>
                <c:pt idx="342">
                  <c:v>7684.412109375</c:v>
                </c:pt>
                <c:pt idx="343">
                  <c:v>7698.7001953125</c:v>
                </c:pt>
                <c:pt idx="344">
                  <c:v>7750.0693359375</c:v>
                </c:pt>
                <c:pt idx="345">
                  <c:v>7818.14453125</c:v>
                </c:pt>
                <c:pt idx="346">
                  <c:v>7871.71923828125</c:v>
                </c:pt>
                <c:pt idx="347">
                  <c:v>7889.68603515625</c:v>
                </c:pt>
                <c:pt idx="348">
                  <c:v>7872.29638671875</c:v>
                </c:pt>
                <c:pt idx="349">
                  <c:v>7836.40673828125</c:v>
                </c:pt>
              </c:numCache>
            </c:numRef>
          </c:yVal>
          <c:smooth val="1"/>
          <c:extLst>
            <c:ext xmlns:c16="http://schemas.microsoft.com/office/drawing/2014/chart" uri="{C3380CC4-5D6E-409C-BE32-E72D297353CC}">
              <c16:uniqueId val="{00000012-4A37-429A-A58F-F7AEDA5D1ACA}"/>
            </c:ext>
          </c:extLst>
        </c:ser>
        <c:ser>
          <c:idx val="19"/>
          <c:order val="19"/>
          <c:tx>
            <c:strRef>
              <c:f>cp_sub_001!$T$1</c:f>
              <c:strCache>
                <c:ptCount val="1"/>
                <c:pt idx="0">
                  <c:v>Coor_20</c:v>
                </c:pt>
              </c:strCache>
            </c:strRef>
          </c:tx>
          <c:spPr>
            <a:ln w="28575" cap="rnd">
              <a:solidFill>
                <a:schemeClr val="accent2">
                  <a:lumMod val="80000"/>
                </a:schemeClr>
              </a:solidFill>
              <a:round/>
            </a:ln>
            <a:effectLst/>
          </c:spPr>
          <c:marker>
            <c:symbol val="none"/>
          </c:marker>
          <c:yVal>
            <c:numRef>
              <c:f>cp_sub_001!$T$2:$T$351</c:f>
              <c:numCache>
                <c:formatCode>0.00000000000_ </c:formatCode>
                <c:ptCount val="350"/>
                <c:pt idx="0">
                  <c:v>5655.638671875</c:v>
                </c:pt>
                <c:pt idx="1">
                  <c:v>5671.09912109375</c:v>
                </c:pt>
                <c:pt idx="2">
                  <c:v>5665.908203125</c:v>
                </c:pt>
                <c:pt idx="3">
                  <c:v>5642.56201171875</c:v>
                </c:pt>
                <c:pt idx="4">
                  <c:v>5610.26904296875</c:v>
                </c:pt>
                <c:pt idx="5">
                  <c:v>5581.9638671875</c:v>
                </c:pt>
                <c:pt idx="6">
                  <c:v>5569.8173828125</c:v>
                </c:pt>
                <c:pt idx="7">
                  <c:v>5580.146484375</c:v>
                </c:pt>
                <c:pt idx="8">
                  <c:v>5609.390625</c:v>
                </c:pt>
                <c:pt idx="9">
                  <c:v>5643.56298828125</c:v>
                </c:pt>
                <c:pt idx="10">
                  <c:v>5663.02880859375</c:v>
                </c:pt>
                <c:pt idx="11">
                  <c:v>5651.86572265625</c:v>
                </c:pt>
                <c:pt idx="12">
                  <c:v>5607.55224609375</c:v>
                </c:pt>
                <c:pt idx="13">
                  <c:v>5544.9326171875</c:v>
                </c:pt>
                <c:pt idx="14">
                  <c:v>5490.51220703125</c:v>
                </c:pt>
                <c:pt idx="15">
                  <c:v>5468.83447265625</c:v>
                </c:pt>
                <c:pt idx="16">
                  <c:v>5488.47265625</c:v>
                </c:pt>
                <c:pt idx="17">
                  <c:v>5536.64208984375</c:v>
                </c:pt>
                <c:pt idx="18">
                  <c:v>5586.6474609375</c:v>
                </c:pt>
                <c:pt idx="19">
                  <c:v>5613.94091796875</c:v>
                </c:pt>
                <c:pt idx="20">
                  <c:v>5610.4140625</c:v>
                </c:pt>
                <c:pt idx="21">
                  <c:v>5587.44775390625</c:v>
                </c:pt>
                <c:pt idx="22">
                  <c:v>5566.10107421875</c:v>
                </c:pt>
                <c:pt idx="23">
                  <c:v>5562.03369140625</c:v>
                </c:pt>
                <c:pt idx="24">
                  <c:v>5576.27880859375</c:v>
                </c:pt>
                <c:pt idx="25">
                  <c:v>5597.9873046875</c:v>
                </c:pt>
                <c:pt idx="26">
                  <c:v>5615.54052734375</c:v>
                </c:pt>
                <c:pt idx="27">
                  <c:v>5625.86279296875</c:v>
                </c:pt>
                <c:pt idx="28">
                  <c:v>5633.86083984375</c:v>
                </c:pt>
                <c:pt idx="29">
                  <c:v>5643.08056640625</c:v>
                </c:pt>
                <c:pt idx="30">
                  <c:v>5647.15673828125</c:v>
                </c:pt>
                <c:pt idx="31">
                  <c:v>5631.74853515625</c:v>
                </c:pt>
                <c:pt idx="32">
                  <c:v>5587.58935546875</c:v>
                </c:pt>
                <c:pt idx="33">
                  <c:v>5524.341796875</c:v>
                </c:pt>
                <c:pt idx="34">
                  <c:v>5471.82958984375</c:v>
                </c:pt>
                <c:pt idx="35">
                  <c:v>5463.8671875</c:v>
                </c:pt>
                <c:pt idx="36">
                  <c:v>5514.24267578125</c:v>
                </c:pt>
                <c:pt idx="37">
                  <c:v>5602.8095703125</c:v>
                </c:pt>
                <c:pt idx="38">
                  <c:v>5684.15966796875</c:v>
                </c:pt>
                <c:pt idx="39">
                  <c:v>5715.0478515625</c:v>
                </c:pt>
                <c:pt idx="40">
                  <c:v>5681.9248046875</c:v>
                </c:pt>
                <c:pt idx="41">
                  <c:v>5608.685546875</c:v>
                </c:pt>
                <c:pt idx="42">
                  <c:v>5538.89501953125</c:v>
                </c:pt>
                <c:pt idx="43">
                  <c:v>5505.75634765625</c:v>
                </c:pt>
                <c:pt idx="44">
                  <c:v>5512.05615234375</c:v>
                </c:pt>
                <c:pt idx="45">
                  <c:v>5534.09228515625</c:v>
                </c:pt>
                <c:pt idx="46">
                  <c:v>5544.64453125</c:v>
                </c:pt>
                <c:pt idx="47">
                  <c:v>5535.5732421875</c:v>
                </c:pt>
                <c:pt idx="48">
                  <c:v>5522.13427734375</c:v>
                </c:pt>
                <c:pt idx="49">
                  <c:v>5526.95703125</c:v>
                </c:pt>
                <c:pt idx="50">
                  <c:v>5558.482421875</c:v>
                </c:pt>
                <c:pt idx="51">
                  <c:v>5602.5224609375</c:v>
                </c:pt>
                <c:pt idx="52">
                  <c:v>5633.6826171875</c:v>
                </c:pt>
                <c:pt idx="53">
                  <c:v>5636.111328125</c:v>
                </c:pt>
                <c:pt idx="54">
                  <c:v>5615.42822265625</c:v>
                </c:pt>
                <c:pt idx="55">
                  <c:v>5591.98828125</c:v>
                </c:pt>
                <c:pt idx="56">
                  <c:v>5582.4326171875</c:v>
                </c:pt>
                <c:pt idx="57">
                  <c:v>5586.75634765625</c:v>
                </c:pt>
                <c:pt idx="58">
                  <c:v>5592.677734375</c:v>
                </c:pt>
                <c:pt idx="59">
                  <c:v>5592.7001953125</c:v>
                </c:pt>
                <c:pt idx="60">
                  <c:v>5596.6494140625</c:v>
                </c:pt>
                <c:pt idx="61">
                  <c:v>5625.5517578125</c:v>
                </c:pt>
                <c:pt idx="62">
                  <c:v>5689.6025390625</c:v>
                </c:pt>
                <c:pt idx="63">
                  <c:v>5769.154296875</c:v>
                </c:pt>
                <c:pt idx="64">
                  <c:v>5818.17236328125</c:v>
                </c:pt>
                <c:pt idx="65">
                  <c:v>5792.45556640625</c:v>
                </c:pt>
                <c:pt idx="66">
                  <c:v>5683.52978515625</c:v>
                </c:pt>
                <c:pt idx="67">
                  <c:v>5531.65576171875</c:v>
                </c:pt>
                <c:pt idx="68">
                  <c:v>5405.30517578125</c:v>
                </c:pt>
                <c:pt idx="69">
                  <c:v>5359.63525390625</c:v>
                </c:pt>
                <c:pt idx="70">
                  <c:v>5403.02978515625</c:v>
                </c:pt>
                <c:pt idx="71">
                  <c:v>5495.20654296875</c:v>
                </c:pt>
                <c:pt idx="72">
                  <c:v>5576.935546875</c:v>
                </c:pt>
                <c:pt idx="73">
                  <c:v>5608.5185546875</c:v>
                </c:pt>
                <c:pt idx="74">
                  <c:v>5589.63232421875</c:v>
                </c:pt>
                <c:pt idx="75">
                  <c:v>5549.51318359375</c:v>
                </c:pt>
                <c:pt idx="76">
                  <c:v>5519.619140625</c:v>
                </c:pt>
                <c:pt idx="77">
                  <c:v>5512.16064453125</c:v>
                </c:pt>
                <c:pt idx="78">
                  <c:v>5519.4013671875</c:v>
                </c:pt>
                <c:pt idx="79">
                  <c:v>5529.3037109375</c:v>
                </c:pt>
                <c:pt idx="80">
                  <c:v>5540.07861328125</c:v>
                </c:pt>
                <c:pt idx="81">
                  <c:v>5559.9091796875</c:v>
                </c:pt>
                <c:pt idx="82">
                  <c:v>5593.828125</c:v>
                </c:pt>
                <c:pt idx="83">
                  <c:v>5632.4130859375</c:v>
                </c:pt>
                <c:pt idx="84">
                  <c:v>5655.12744140625</c:v>
                </c:pt>
                <c:pt idx="85">
                  <c:v>5646.88623046875</c:v>
                </c:pt>
                <c:pt idx="86">
                  <c:v>5613.11865234375</c:v>
                </c:pt>
                <c:pt idx="87">
                  <c:v>5578.732421875</c:v>
                </c:pt>
                <c:pt idx="88">
                  <c:v>5570.1328125</c:v>
                </c:pt>
                <c:pt idx="89">
                  <c:v>5594.62841796875</c:v>
                </c:pt>
                <c:pt idx="90">
                  <c:v>5634.49560546875</c:v>
                </c:pt>
                <c:pt idx="91">
                  <c:v>5660.84619140625</c:v>
                </c:pt>
                <c:pt idx="92">
                  <c:v>5655.7705078125</c:v>
                </c:pt>
                <c:pt idx="93">
                  <c:v>5624.5712890625</c:v>
                </c:pt>
                <c:pt idx="94">
                  <c:v>5588.9306640625</c:v>
                </c:pt>
                <c:pt idx="95">
                  <c:v>5568.34619140625</c:v>
                </c:pt>
                <c:pt idx="96">
                  <c:v>5566.55126953125</c:v>
                </c:pt>
                <c:pt idx="97">
                  <c:v>5573.8212890625</c:v>
                </c:pt>
                <c:pt idx="98">
                  <c:v>5580.84228515625</c:v>
                </c:pt>
                <c:pt idx="99">
                  <c:v>5589.28955078125</c:v>
                </c:pt>
                <c:pt idx="100">
                  <c:v>5608.103515625</c:v>
                </c:pt>
                <c:pt idx="101">
                  <c:v>5639.04248046875</c:v>
                </c:pt>
                <c:pt idx="102">
                  <c:v>5666.69873046875</c:v>
                </c:pt>
                <c:pt idx="103">
                  <c:v>5665.42138671875</c:v>
                </c:pt>
                <c:pt idx="104">
                  <c:v>5620.2060546875</c:v>
                </c:pt>
                <c:pt idx="105">
                  <c:v>5544.23046875</c:v>
                </c:pt>
                <c:pt idx="106">
                  <c:v>5475.91259765625</c:v>
                </c:pt>
                <c:pt idx="107">
                  <c:v>5454.392578125</c:v>
                </c:pt>
                <c:pt idx="108">
                  <c:v>5491.02490234375</c:v>
                </c:pt>
                <c:pt idx="109">
                  <c:v>5559.6435546875</c:v>
                </c:pt>
                <c:pt idx="110">
                  <c:v>5614.560546875</c:v>
                </c:pt>
                <c:pt idx="111">
                  <c:v>5623.32568359375</c:v>
                </c:pt>
                <c:pt idx="112">
                  <c:v>5589.208984375</c:v>
                </c:pt>
                <c:pt idx="113">
                  <c:v>5546.3330078125</c:v>
                </c:pt>
                <c:pt idx="114">
                  <c:v>5532.01416015625</c:v>
                </c:pt>
                <c:pt idx="115">
                  <c:v>5558.4345703125</c:v>
                </c:pt>
                <c:pt idx="116">
                  <c:v>5605.29296875</c:v>
                </c:pt>
                <c:pt idx="117">
                  <c:v>5637.54736328125</c:v>
                </c:pt>
                <c:pt idx="118">
                  <c:v>5632.68896484375</c:v>
                </c:pt>
                <c:pt idx="119">
                  <c:v>5596.00927734375</c:v>
                </c:pt>
                <c:pt idx="120">
                  <c:v>5553.74951171875</c:v>
                </c:pt>
                <c:pt idx="121">
                  <c:v>5532.1923828125</c:v>
                </c:pt>
                <c:pt idx="122">
                  <c:v>5540.376953125</c:v>
                </c:pt>
                <c:pt idx="123">
                  <c:v>5568.46240234375</c:v>
                </c:pt>
                <c:pt idx="124">
                  <c:v>5599.41259765625</c:v>
                </c:pt>
                <c:pt idx="125">
                  <c:v>5621.75390625</c:v>
                </c:pt>
                <c:pt idx="126">
                  <c:v>5633.283203125</c:v>
                </c:pt>
                <c:pt idx="127">
                  <c:v>5635.98291015625</c:v>
                </c:pt>
                <c:pt idx="128">
                  <c:v>5630.33642578125</c:v>
                </c:pt>
                <c:pt idx="129">
                  <c:v>5615.65087890625</c:v>
                </c:pt>
                <c:pt idx="130">
                  <c:v>5594.7705078125</c:v>
                </c:pt>
                <c:pt idx="131">
                  <c:v>5575.90625</c:v>
                </c:pt>
                <c:pt idx="132">
                  <c:v>5567.40478515625</c:v>
                </c:pt>
                <c:pt idx="133">
                  <c:v>5569.81591796875</c:v>
                </c:pt>
                <c:pt idx="134">
                  <c:v>5574.28466796875</c:v>
                </c:pt>
                <c:pt idx="135">
                  <c:v>5571.18798828125</c:v>
                </c:pt>
                <c:pt idx="136">
                  <c:v>5562.10107421875</c:v>
                </c:pt>
                <c:pt idx="137">
                  <c:v>5562.51171875</c:v>
                </c:pt>
                <c:pt idx="138">
                  <c:v>5589.33203125</c:v>
                </c:pt>
                <c:pt idx="139">
                  <c:v>5641.74169921875</c:v>
                </c:pt>
                <c:pt idx="140">
                  <c:v>5693.04931640625</c:v>
                </c:pt>
                <c:pt idx="141">
                  <c:v>5704.89013671875</c:v>
                </c:pt>
                <c:pt idx="142">
                  <c:v>5656.4365234375</c:v>
                </c:pt>
                <c:pt idx="143">
                  <c:v>5565.81005859375</c:v>
                </c:pt>
                <c:pt idx="144">
                  <c:v>5483.4658203125</c:v>
                </c:pt>
                <c:pt idx="145">
                  <c:v>5458.29638671875</c:v>
                </c:pt>
                <c:pt idx="146">
                  <c:v>5500.58837890625</c:v>
                </c:pt>
                <c:pt idx="147">
                  <c:v>5571.56982421875</c:v>
                </c:pt>
                <c:pt idx="148">
                  <c:v>5610.5048828125</c:v>
                </c:pt>
                <c:pt idx="149">
                  <c:v>5580.68798828125</c:v>
                </c:pt>
                <c:pt idx="150">
                  <c:v>5499.19873046875</c:v>
                </c:pt>
                <c:pt idx="151">
                  <c:v>5426.34130859375</c:v>
                </c:pt>
                <c:pt idx="152">
                  <c:v>5421.630859375</c:v>
                </c:pt>
                <c:pt idx="153">
                  <c:v>5499.5966796875</c:v>
                </c:pt>
                <c:pt idx="154">
                  <c:v>5619.1142578125</c:v>
                </c:pt>
                <c:pt idx="155">
                  <c:v>5713.822265625</c:v>
                </c:pt>
                <c:pt idx="156">
                  <c:v>5739.32958984375</c:v>
                </c:pt>
                <c:pt idx="157">
                  <c:v>5700.93408203125</c:v>
                </c:pt>
                <c:pt idx="158">
                  <c:v>5642.5224609375</c:v>
                </c:pt>
                <c:pt idx="159">
                  <c:v>5608.68310546875</c:v>
                </c:pt>
                <c:pt idx="160">
                  <c:v>5612.0302734375</c:v>
                </c:pt>
                <c:pt idx="161">
                  <c:v>5630.6845703125</c:v>
                </c:pt>
                <c:pt idx="162">
                  <c:v>5634.07470703125</c:v>
                </c:pt>
                <c:pt idx="163">
                  <c:v>5612.009765625</c:v>
                </c:pt>
                <c:pt idx="164">
                  <c:v>5581.53466796875</c:v>
                </c:pt>
                <c:pt idx="165">
                  <c:v>5567.5859375</c:v>
                </c:pt>
                <c:pt idx="166">
                  <c:v>5577.2158203125</c:v>
                </c:pt>
                <c:pt idx="167">
                  <c:v>5592.28125</c:v>
                </c:pt>
                <c:pt idx="168">
                  <c:v>5587.8408203125</c:v>
                </c:pt>
                <c:pt idx="169">
                  <c:v>5559.17578125</c:v>
                </c:pt>
                <c:pt idx="170">
                  <c:v>5531.302734375</c:v>
                </c:pt>
                <c:pt idx="171">
                  <c:v>5539.64501953125</c:v>
                </c:pt>
                <c:pt idx="172">
                  <c:v>5596.630859375</c:v>
                </c:pt>
                <c:pt idx="173">
                  <c:v>5673.47900390625</c:v>
                </c:pt>
                <c:pt idx="174">
                  <c:v>5715.82275390625</c:v>
                </c:pt>
                <c:pt idx="175">
                  <c:v>5683.9912109375</c:v>
                </c:pt>
                <c:pt idx="176">
                  <c:v>5586.8056640625</c:v>
                </c:pt>
                <c:pt idx="177">
                  <c:v>5480.5810546875</c:v>
                </c:pt>
                <c:pt idx="178">
                  <c:v>5431.421875</c:v>
                </c:pt>
                <c:pt idx="179">
                  <c:v>5468.04443359375</c:v>
                </c:pt>
                <c:pt idx="180">
                  <c:v>5560.75048828125</c:v>
                </c:pt>
                <c:pt idx="181">
                  <c:v>5642.80517578125</c:v>
                </c:pt>
                <c:pt idx="182">
                  <c:v>5658.3876953125</c:v>
                </c:pt>
                <c:pt idx="183">
                  <c:v>5601.4931640625</c:v>
                </c:pt>
                <c:pt idx="184">
                  <c:v>5517.69287109375</c:v>
                </c:pt>
                <c:pt idx="185">
                  <c:v>5468.970703125</c:v>
                </c:pt>
                <c:pt idx="186">
                  <c:v>5488.81201171875</c:v>
                </c:pt>
                <c:pt idx="187">
                  <c:v>5560.26220703125</c:v>
                </c:pt>
                <c:pt idx="188">
                  <c:v>5630.96435546875</c:v>
                </c:pt>
                <c:pt idx="189">
                  <c:v>5651.7451171875</c:v>
                </c:pt>
                <c:pt idx="190">
                  <c:v>5609.8857421875</c:v>
                </c:pt>
                <c:pt idx="191">
                  <c:v>5534.81494140625</c:v>
                </c:pt>
                <c:pt idx="192">
                  <c:v>5475.4853515625</c:v>
                </c:pt>
                <c:pt idx="193">
                  <c:v>5468.06103515625</c:v>
                </c:pt>
                <c:pt idx="194">
                  <c:v>5516.2978515625</c:v>
                </c:pt>
                <c:pt idx="195">
                  <c:v>5594.87890625</c:v>
                </c:pt>
                <c:pt idx="196">
                  <c:v>5668.97314453125</c:v>
                </c:pt>
                <c:pt idx="197">
                  <c:v>5714.2021484375</c:v>
                </c:pt>
                <c:pt idx="198">
                  <c:v>5724.74267578125</c:v>
                </c:pt>
                <c:pt idx="199">
                  <c:v>5708.37646484375</c:v>
                </c:pt>
                <c:pt idx="200">
                  <c:v>5676.3603515625</c:v>
                </c:pt>
                <c:pt idx="201">
                  <c:v>5637.0185546875</c:v>
                </c:pt>
                <c:pt idx="202">
                  <c:v>5596.1201171875</c:v>
                </c:pt>
                <c:pt idx="203">
                  <c:v>5560.43408203125</c:v>
                </c:pt>
                <c:pt idx="204">
                  <c:v>5538.76123046875</c:v>
                </c:pt>
                <c:pt idx="205">
                  <c:v>5538.0849609375</c:v>
                </c:pt>
                <c:pt idx="206">
                  <c:v>5557.736328125</c:v>
                </c:pt>
                <c:pt idx="207">
                  <c:v>5587.0703125</c:v>
                </c:pt>
                <c:pt idx="208">
                  <c:v>5610.05517578125</c:v>
                </c:pt>
                <c:pt idx="209">
                  <c:v>5614.93896484375</c:v>
                </c:pt>
                <c:pt idx="210">
                  <c:v>5602.673828125</c:v>
                </c:pt>
                <c:pt idx="211">
                  <c:v>5587.513671875</c:v>
                </c:pt>
                <c:pt idx="212">
                  <c:v>5587.83349609375</c:v>
                </c:pt>
                <c:pt idx="213">
                  <c:v>5612.14794921875</c:v>
                </c:pt>
                <c:pt idx="214">
                  <c:v>5649.869140625</c:v>
                </c:pt>
                <c:pt idx="215">
                  <c:v>5674.72021484375</c:v>
                </c:pt>
                <c:pt idx="216">
                  <c:v>5660.86083984375</c:v>
                </c:pt>
                <c:pt idx="217">
                  <c:v>5602.24169921875</c:v>
                </c:pt>
                <c:pt idx="218">
                  <c:v>5521.4150390625</c:v>
                </c:pt>
                <c:pt idx="219">
                  <c:v>5459.306640625</c:v>
                </c:pt>
                <c:pt idx="220">
                  <c:v>5450.208984375</c:v>
                </c:pt>
                <c:pt idx="221">
                  <c:v>5497.9794921875</c:v>
                </c:pt>
                <c:pt idx="222">
                  <c:v>5570.8916015625</c:v>
                </c:pt>
                <c:pt idx="223">
                  <c:v>5621.00390625</c:v>
                </c:pt>
                <c:pt idx="224">
                  <c:v>5616.34228515625</c:v>
                </c:pt>
                <c:pt idx="225">
                  <c:v>5563.47900390625</c:v>
                </c:pt>
                <c:pt idx="226">
                  <c:v>5503.349609375</c:v>
                </c:pt>
                <c:pt idx="227">
                  <c:v>5481.90185546875</c:v>
                </c:pt>
                <c:pt idx="228">
                  <c:v>5516.19921875</c:v>
                </c:pt>
                <c:pt idx="229">
                  <c:v>5581.1044921875</c:v>
                </c:pt>
                <c:pt idx="230">
                  <c:v>5627.2646484375</c:v>
                </c:pt>
                <c:pt idx="231">
                  <c:v>5617.8134765625</c:v>
                </c:pt>
                <c:pt idx="232">
                  <c:v>5556.67236328125</c:v>
                </c:pt>
                <c:pt idx="233">
                  <c:v>5487.0625</c:v>
                </c:pt>
                <c:pt idx="234">
                  <c:v>5461.00927734375</c:v>
                </c:pt>
                <c:pt idx="235">
                  <c:v>5502.36572265625</c:v>
                </c:pt>
                <c:pt idx="236">
                  <c:v>5590.55322265625</c:v>
                </c:pt>
                <c:pt idx="237">
                  <c:v>5676.22119140625</c:v>
                </c:pt>
                <c:pt idx="238">
                  <c:v>5716.0263671875</c:v>
                </c:pt>
                <c:pt idx="239">
                  <c:v>5700.2880859375</c:v>
                </c:pt>
                <c:pt idx="240">
                  <c:v>5654.3544921875</c:v>
                </c:pt>
                <c:pt idx="241">
                  <c:v>5615.6123046875</c:v>
                </c:pt>
                <c:pt idx="242">
                  <c:v>5606.05419921875</c:v>
                </c:pt>
                <c:pt idx="243">
                  <c:v>5621.32373046875</c:v>
                </c:pt>
                <c:pt idx="244">
                  <c:v>5641.72216796875</c:v>
                </c:pt>
                <c:pt idx="245">
                  <c:v>5652.48193359375</c:v>
                </c:pt>
                <c:pt idx="246">
                  <c:v>5654.734375</c:v>
                </c:pt>
                <c:pt idx="247">
                  <c:v>5658.9150390625</c:v>
                </c:pt>
                <c:pt idx="248">
                  <c:v>5668.96240234375</c:v>
                </c:pt>
                <c:pt idx="249">
                  <c:v>5673.783203125</c:v>
                </c:pt>
                <c:pt idx="250">
                  <c:v>5655.27001953125</c:v>
                </c:pt>
                <c:pt idx="251">
                  <c:v>5606.392578125</c:v>
                </c:pt>
                <c:pt idx="252">
                  <c:v>5542.6884765625</c:v>
                </c:pt>
                <c:pt idx="253">
                  <c:v>5495.09521484375</c:v>
                </c:pt>
                <c:pt idx="254">
                  <c:v>5487.83447265625</c:v>
                </c:pt>
                <c:pt idx="255">
                  <c:v>5518.57177734375</c:v>
                </c:pt>
                <c:pt idx="256">
                  <c:v>5557.62939453125</c:v>
                </c:pt>
                <c:pt idx="257">
                  <c:v>5568.52734375</c:v>
                </c:pt>
                <c:pt idx="258">
                  <c:v>5535.15234375</c:v>
                </c:pt>
                <c:pt idx="259">
                  <c:v>5475.115234375</c:v>
                </c:pt>
                <c:pt idx="260">
                  <c:v>5428.9755859375</c:v>
                </c:pt>
                <c:pt idx="261">
                  <c:v>5432.9443359375</c:v>
                </c:pt>
                <c:pt idx="262">
                  <c:v>5494.5908203125</c:v>
                </c:pt>
                <c:pt idx="263">
                  <c:v>5588.2109375</c:v>
                </c:pt>
                <c:pt idx="264">
                  <c:v>5671.85009765625</c:v>
                </c:pt>
                <c:pt idx="265">
                  <c:v>5713.01806640625</c:v>
                </c:pt>
                <c:pt idx="266">
                  <c:v>5705.59033203125</c:v>
                </c:pt>
                <c:pt idx="267">
                  <c:v>5668.34228515625</c:v>
                </c:pt>
                <c:pt idx="268">
                  <c:v>5628.8779296875</c:v>
                </c:pt>
                <c:pt idx="269">
                  <c:v>5605.49951171875</c:v>
                </c:pt>
                <c:pt idx="270">
                  <c:v>5598.66357421875</c:v>
                </c:pt>
                <c:pt idx="271">
                  <c:v>5595.47265625</c:v>
                </c:pt>
                <c:pt idx="272">
                  <c:v>5581.892578125</c:v>
                </c:pt>
                <c:pt idx="273">
                  <c:v>5553.7021484375</c:v>
                </c:pt>
                <c:pt idx="274">
                  <c:v>5519.60498046875</c:v>
                </c:pt>
                <c:pt idx="275">
                  <c:v>5495.56884765625</c:v>
                </c:pt>
                <c:pt idx="276">
                  <c:v>5494.55029296875</c:v>
                </c:pt>
                <c:pt idx="277">
                  <c:v>5517.962890625</c:v>
                </c:pt>
                <c:pt idx="278">
                  <c:v>5554.0732421875</c:v>
                </c:pt>
                <c:pt idx="279">
                  <c:v>5584.6923828125</c:v>
                </c:pt>
                <c:pt idx="280">
                  <c:v>5596.6220703125</c:v>
                </c:pt>
                <c:pt idx="281">
                  <c:v>5590.7587890625</c:v>
                </c:pt>
                <c:pt idx="282">
                  <c:v>5582.15869140625</c:v>
                </c:pt>
                <c:pt idx="283">
                  <c:v>5589.62939453125</c:v>
                </c:pt>
                <c:pt idx="284">
                  <c:v>5620.97998046875</c:v>
                </c:pt>
                <c:pt idx="285">
                  <c:v>5664.55908203125</c:v>
                </c:pt>
                <c:pt idx="286">
                  <c:v>5694.74072265625</c:v>
                </c:pt>
                <c:pt idx="287">
                  <c:v>5689.33642578125</c:v>
                </c:pt>
                <c:pt idx="288">
                  <c:v>5647.0654296875</c:v>
                </c:pt>
                <c:pt idx="289">
                  <c:v>5591.376953125</c:v>
                </c:pt>
                <c:pt idx="290">
                  <c:v>5555.8994140625</c:v>
                </c:pt>
                <c:pt idx="291">
                  <c:v>5560.81982421875</c:v>
                </c:pt>
                <c:pt idx="292">
                  <c:v>5597.67041015625</c:v>
                </c:pt>
                <c:pt idx="293">
                  <c:v>5634.9599609375</c:v>
                </c:pt>
                <c:pt idx="294">
                  <c:v>5641.5654296875</c:v>
                </c:pt>
                <c:pt idx="295">
                  <c:v>5610.5224609375</c:v>
                </c:pt>
                <c:pt idx="296">
                  <c:v>5564.5791015625</c:v>
                </c:pt>
                <c:pt idx="297">
                  <c:v>5538.45947265625</c:v>
                </c:pt>
                <c:pt idx="298">
                  <c:v>5551.17626953125</c:v>
                </c:pt>
                <c:pt idx="299">
                  <c:v>5590.14794921875</c:v>
                </c:pt>
                <c:pt idx="300">
                  <c:v>5620.201171875</c:v>
                </c:pt>
                <c:pt idx="301">
                  <c:v>5611.05908203125</c:v>
                </c:pt>
                <c:pt idx="302">
                  <c:v>5562.0810546875</c:v>
                </c:pt>
                <c:pt idx="303">
                  <c:v>5504.7646484375</c:v>
                </c:pt>
                <c:pt idx="304">
                  <c:v>5480.66943359375</c:v>
                </c:pt>
                <c:pt idx="305">
                  <c:v>5511.416015625</c:v>
                </c:pt>
                <c:pt idx="306">
                  <c:v>5583.2333984375</c:v>
                </c:pt>
                <c:pt idx="307">
                  <c:v>5656.87841796875</c:v>
                </c:pt>
                <c:pt idx="308">
                  <c:v>5694.2724609375</c:v>
                </c:pt>
                <c:pt idx="309">
                  <c:v>5681.4931640625</c:v>
                </c:pt>
                <c:pt idx="310">
                  <c:v>5632.4345703125</c:v>
                </c:pt>
                <c:pt idx="311">
                  <c:v>5573.6806640625</c:v>
                </c:pt>
                <c:pt idx="312">
                  <c:v>5525.13232421875</c:v>
                </c:pt>
                <c:pt idx="313">
                  <c:v>5491.71484375</c:v>
                </c:pt>
                <c:pt idx="314">
                  <c:v>5469.83203125</c:v>
                </c:pt>
                <c:pt idx="315">
                  <c:v>5459.10302734375</c:v>
                </c:pt>
                <c:pt idx="316">
                  <c:v>5466.6396484375</c:v>
                </c:pt>
                <c:pt idx="317">
                  <c:v>5499.7099609375</c:v>
                </c:pt>
                <c:pt idx="318">
                  <c:v>5554.5341796875</c:v>
                </c:pt>
                <c:pt idx="319">
                  <c:v>5613.12744140625</c:v>
                </c:pt>
                <c:pt idx="320">
                  <c:v>5652.91748046875</c:v>
                </c:pt>
                <c:pt idx="321">
                  <c:v>5661.97705078125</c:v>
                </c:pt>
                <c:pt idx="322">
                  <c:v>5647.0458984375</c:v>
                </c:pt>
                <c:pt idx="323">
                  <c:v>5627.287109375</c:v>
                </c:pt>
                <c:pt idx="324">
                  <c:v>5618.86474609375</c:v>
                </c:pt>
                <c:pt idx="325">
                  <c:v>5623.2490234375</c:v>
                </c:pt>
                <c:pt idx="326">
                  <c:v>5628.74072265625</c:v>
                </c:pt>
                <c:pt idx="327">
                  <c:v>5623.12646484375</c:v>
                </c:pt>
                <c:pt idx="328">
                  <c:v>5605.8349609375</c:v>
                </c:pt>
                <c:pt idx="329">
                  <c:v>5588.791015625</c:v>
                </c:pt>
                <c:pt idx="330">
                  <c:v>5585.48193359375</c:v>
                </c:pt>
                <c:pt idx="331">
                  <c:v>5598.3125</c:v>
                </c:pt>
                <c:pt idx="332">
                  <c:v>5615.8291015625</c:v>
                </c:pt>
                <c:pt idx="333">
                  <c:v>5622.48193359375</c:v>
                </c:pt>
                <c:pt idx="334">
                  <c:v>5612.29833984375</c:v>
                </c:pt>
                <c:pt idx="335">
                  <c:v>5594.138671875</c:v>
                </c:pt>
                <c:pt idx="336">
                  <c:v>5583.53515625</c:v>
                </c:pt>
                <c:pt idx="337">
                  <c:v>5588.0458984375</c:v>
                </c:pt>
                <c:pt idx="338">
                  <c:v>5599.17138671875</c:v>
                </c:pt>
                <c:pt idx="339">
                  <c:v>5598.60546875</c:v>
                </c:pt>
                <c:pt idx="340">
                  <c:v>5574.3291015625</c:v>
                </c:pt>
                <c:pt idx="341">
                  <c:v>5533.19921875</c:v>
                </c:pt>
                <c:pt idx="342">
                  <c:v>5498.94287109375</c:v>
                </c:pt>
                <c:pt idx="343">
                  <c:v>5496.11328125</c:v>
                </c:pt>
                <c:pt idx="344">
                  <c:v>5531.9912109375</c:v>
                </c:pt>
                <c:pt idx="345">
                  <c:v>5590.32275390625</c:v>
                </c:pt>
                <c:pt idx="346">
                  <c:v>5641.625</c:v>
                </c:pt>
                <c:pt idx="347">
                  <c:v>5662.21484375</c:v>
                </c:pt>
                <c:pt idx="348">
                  <c:v>5648.025390625</c:v>
                </c:pt>
                <c:pt idx="349">
                  <c:v>5614.11767578125</c:v>
                </c:pt>
              </c:numCache>
            </c:numRef>
          </c:yVal>
          <c:smooth val="1"/>
          <c:extLst>
            <c:ext xmlns:c16="http://schemas.microsoft.com/office/drawing/2014/chart" uri="{C3380CC4-5D6E-409C-BE32-E72D297353CC}">
              <c16:uniqueId val="{00000013-4A37-429A-A58F-F7AEDA5D1ACA}"/>
            </c:ext>
          </c:extLst>
        </c:ser>
        <c:ser>
          <c:idx val="20"/>
          <c:order val="20"/>
          <c:tx>
            <c:strRef>
              <c:f>cp_sub_001!$U$1</c:f>
              <c:strCache>
                <c:ptCount val="1"/>
                <c:pt idx="0">
                  <c:v>Coor_21</c:v>
                </c:pt>
              </c:strCache>
            </c:strRef>
          </c:tx>
          <c:spPr>
            <a:ln w="28575" cap="rnd">
              <a:solidFill>
                <a:schemeClr val="accent3">
                  <a:lumMod val="80000"/>
                </a:schemeClr>
              </a:solidFill>
              <a:round/>
            </a:ln>
            <a:effectLst/>
          </c:spPr>
          <c:marker>
            <c:symbol val="none"/>
          </c:marker>
          <c:yVal>
            <c:numRef>
              <c:f>cp_sub_001!$U$2:$U$351</c:f>
              <c:numCache>
                <c:formatCode>0.00000000000_ </c:formatCode>
                <c:ptCount val="350"/>
                <c:pt idx="0">
                  <c:v>7941.978515625</c:v>
                </c:pt>
                <c:pt idx="1">
                  <c:v>7971.427734375</c:v>
                </c:pt>
                <c:pt idx="2">
                  <c:v>7987.40380859375</c:v>
                </c:pt>
                <c:pt idx="3">
                  <c:v>7982.77197265625</c:v>
                </c:pt>
                <c:pt idx="4">
                  <c:v>7963.4658203125</c:v>
                </c:pt>
                <c:pt idx="5">
                  <c:v>7944.1376953125</c:v>
                </c:pt>
                <c:pt idx="6">
                  <c:v>7937.76123046875</c:v>
                </c:pt>
                <c:pt idx="7">
                  <c:v>7946.77783203125</c:v>
                </c:pt>
                <c:pt idx="8">
                  <c:v>7962.1337890625</c:v>
                </c:pt>
                <c:pt idx="9">
                  <c:v>7970.55029296875</c:v>
                </c:pt>
                <c:pt idx="10">
                  <c:v>7964.2724609375</c:v>
                </c:pt>
                <c:pt idx="11">
                  <c:v>7945.90771484375</c:v>
                </c:pt>
                <c:pt idx="12">
                  <c:v>7924.97412109375</c:v>
                </c:pt>
                <c:pt idx="13">
                  <c:v>7909.3408203125</c:v>
                </c:pt>
                <c:pt idx="14">
                  <c:v>7898.74853515625</c:v>
                </c:pt>
                <c:pt idx="15">
                  <c:v>7885.9609375</c:v>
                </c:pt>
                <c:pt idx="16">
                  <c:v>7864.90771484375</c:v>
                </c:pt>
                <c:pt idx="17">
                  <c:v>7839.21435546875</c:v>
                </c:pt>
                <c:pt idx="18">
                  <c:v>7823.4609375</c:v>
                </c:pt>
                <c:pt idx="19">
                  <c:v>7834.5888671875</c:v>
                </c:pt>
                <c:pt idx="20">
                  <c:v>7878.58349609375</c:v>
                </c:pt>
                <c:pt idx="21">
                  <c:v>7942.1484375</c:v>
                </c:pt>
                <c:pt idx="22">
                  <c:v>7996.74560546875</c:v>
                </c:pt>
                <c:pt idx="23">
                  <c:v>8014.15185546875</c:v>
                </c:pt>
                <c:pt idx="24">
                  <c:v>7984.21044921875</c:v>
                </c:pt>
                <c:pt idx="25">
                  <c:v>7922.873046875</c:v>
                </c:pt>
                <c:pt idx="26">
                  <c:v>7864.28564453125</c:v>
                </c:pt>
                <c:pt idx="27">
                  <c:v>7841.07763671875</c:v>
                </c:pt>
                <c:pt idx="28">
                  <c:v>7865.07666015625</c:v>
                </c:pt>
                <c:pt idx="29">
                  <c:v>7920.70361328125</c:v>
                </c:pt>
                <c:pt idx="30">
                  <c:v>7975.06005859375</c:v>
                </c:pt>
                <c:pt idx="31">
                  <c:v>7997.8896484375</c:v>
                </c:pt>
                <c:pt idx="32">
                  <c:v>7978.5205078125</c:v>
                </c:pt>
                <c:pt idx="33">
                  <c:v>7929.66015625</c:v>
                </c:pt>
                <c:pt idx="34">
                  <c:v>7877.20263671875</c:v>
                </c:pt>
                <c:pt idx="35">
                  <c:v>7844.251953125</c:v>
                </c:pt>
                <c:pt idx="36">
                  <c:v>7840.181640625</c:v>
                </c:pt>
                <c:pt idx="37">
                  <c:v>7860.45263671875</c:v>
                </c:pt>
                <c:pt idx="38">
                  <c:v>7894.5927734375</c:v>
                </c:pt>
                <c:pt idx="39">
                  <c:v>7934.51416015625</c:v>
                </c:pt>
                <c:pt idx="40">
                  <c:v>7976.7548828125</c:v>
                </c:pt>
                <c:pt idx="41">
                  <c:v>8018.39306640625</c:v>
                </c:pt>
                <c:pt idx="42">
                  <c:v>8051.96630859375</c:v>
                </c:pt>
                <c:pt idx="43">
                  <c:v>8065.2998046875</c:v>
                </c:pt>
                <c:pt idx="44">
                  <c:v>8047.5966796875</c:v>
                </c:pt>
                <c:pt idx="45">
                  <c:v>7997.52880859375</c:v>
                </c:pt>
                <c:pt idx="46">
                  <c:v>7926.9814453125</c:v>
                </c:pt>
                <c:pt idx="47">
                  <c:v>7857.15234375</c:v>
                </c:pt>
                <c:pt idx="48">
                  <c:v>7809.21240234375</c:v>
                </c:pt>
                <c:pt idx="49">
                  <c:v>7795.365234375</c:v>
                </c:pt>
                <c:pt idx="50">
                  <c:v>7815.30615234375</c:v>
                </c:pt>
                <c:pt idx="51">
                  <c:v>7858.8935546875</c:v>
                </c:pt>
                <c:pt idx="52">
                  <c:v>7911.8681640625</c:v>
                </c:pt>
                <c:pt idx="53">
                  <c:v>7960.58544921875</c:v>
                </c:pt>
                <c:pt idx="54">
                  <c:v>7994.025390625</c:v>
                </c:pt>
                <c:pt idx="55">
                  <c:v>8004.2724609375</c:v>
                </c:pt>
                <c:pt idx="56">
                  <c:v>7987.62158203125</c:v>
                </c:pt>
                <c:pt idx="57">
                  <c:v>7946.8623046875</c:v>
                </c:pt>
                <c:pt idx="58">
                  <c:v>7892.9208984375</c:v>
                </c:pt>
                <c:pt idx="59">
                  <c:v>7843.26806640625</c:v>
                </c:pt>
                <c:pt idx="60">
                  <c:v>7816.2197265625</c:v>
                </c:pt>
                <c:pt idx="61">
                  <c:v>7823.19091796875</c:v>
                </c:pt>
                <c:pt idx="62">
                  <c:v>7862.880859375</c:v>
                </c:pt>
                <c:pt idx="63">
                  <c:v>7920.806640625</c:v>
                </c:pt>
                <c:pt idx="64">
                  <c:v>7974.97509765625</c:v>
                </c:pt>
                <c:pt idx="65">
                  <c:v>8005.31640625</c:v>
                </c:pt>
                <c:pt idx="66">
                  <c:v>8002.5986328125</c:v>
                </c:pt>
                <c:pt idx="67">
                  <c:v>7972.60791015625</c:v>
                </c:pt>
                <c:pt idx="68">
                  <c:v>7933.37548828125</c:v>
                </c:pt>
                <c:pt idx="69">
                  <c:v>7906.32373046875</c:v>
                </c:pt>
                <c:pt idx="70">
                  <c:v>7905.27734375</c:v>
                </c:pt>
                <c:pt idx="71">
                  <c:v>7928.923828125</c:v>
                </c:pt>
                <c:pt idx="72">
                  <c:v>7961.25390625</c:v>
                </c:pt>
                <c:pt idx="73">
                  <c:v>7980.5791015625</c:v>
                </c:pt>
                <c:pt idx="74">
                  <c:v>7972.61767578125</c:v>
                </c:pt>
                <c:pt idx="75">
                  <c:v>7939.92431640625</c:v>
                </c:pt>
                <c:pt idx="76">
                  <c:v>7901.26708984375</c:v>
                </c:pt>
                <c:pt idx="77">
                  <c:v>7880.41748046875</c:v>
                </c:pt>
                <c:pt idx="78">
                  <c:v>7890.814453125</c:v>
                </c:pt>
                <c:pt idx="79">
                  <c:v>7925.9248046875</c:v>
                </c:pt>
                <c:pt idx="80">
                  <c:v>7962.0244140625</c:v>
                </c:pt>
                <c:pt idx="81">
                  <c:v>7972.2607421875</c:v>
                </c:pt>
                <c:pt idx="82">
                  <c:v>7943.3505859375</c:v>
                </c:pt>
                <c:pt idx="83">
                  <c:v>7884.4130859375</c:v>
                </c:pt>
                <c:pt idx="84">
                  <c:v>7822.486328125</c:v>
                </c:pt>
                <c:pt idx="85">
                  <c:v>7787.71875</c:v>
                </c:pt>
                <c:pt idx="86">
                  <c:v>7797.32666015625</c:v>
                </c:pt>
                <c:pt idx="87">
                  <c:v>7847.40087890625</c:v>
                </c:pt>
                <c:pt idx="88">
                  <c:v>7916.20068359375</c:v>
                </c:pt>
                <c:pt idx="89">
                  <c:v>7975.87890625</c:v>
                </c:pt>
                <c:pt idx="90">
                  <c:v>8005.76318359375</c:v>
                </c:pt>
                <c:pt idx="91">
                  <c:v>8000.7890625</c:v>
                </c:pt>
                <c:pt idx="92">
                  <c:v>7972.0029296875</c:v>
                </c:pt>
                <c:pt idx="93">
                  <c:v>7939.7109375</c:v>
                </c:pt>
                <c:pt idx="94">
                  <c:v>7922.6015625</c:v>
                </c:pt>
                <c:pt idx="95">
                  <c:v>7927.73486328125</c:v>
                </c:pt>
                <c:pt idx="96">
                  <c:v>7946.5419921875</c:v>
                </c:pt>
                <c:pt idx="97">
                  <c:v>7959.97314453125</c:v>
                </c:pt>
                <c:pt idx="98">
                  <c:v>7951.2431640625</c:v>
                </c:pt>
                <c:pt idx="99">
                  <c:v>7919.07080078125</c:v>
                </c:pt>
                <c:pt idx="100">
                  <c:v>7881.9091796875</c:v>
                </c:pt>
                <c:pt idx="101">
                  <c:v>7867.86962890625</c:v>
                </c:pt>
                <c:pt idx="102">
                  <c:v>7894.77685546875</c:v>
                </c:pt>
                <c:pt idx="103">
                  <c:v>7953.6953125</c:v>
                </c:pt>
                <c:pt idx="104">
                  <c:v>8009.60205078125</c:v>
                </c:pt>
                <c:pt idx="105">
                  <c:v>8022.21484375</c:v>
                </c:pt>
                <c:pt idx="106">
                  <c:v>7974.63720703125</c:v>
                </c:pt>
                <c:pt idx="107">
                  <c:v>7889.171875</c:v>
                </c:pt>
                <c:pt idx="108">
                  <c:v>7816.43798828125</c:v>
                </c:pt>
                <c:pt idx="109">
                  <c:v>7802.6669921875</c:v>
                </c:pt>
                <c:pt idx="110">
                  <c:v>7857.3837890625</c:v>
                </c:pt>
                <c:pt idx="111">
                  <c:v>7945.49365234375</c:v>
                </c:pt>
                <c:pt idx="112">
                  <c:v>8011.06787109375</c:v>
                </c:pt>
                <c:pt idx="113">
                  <c:v>8016.44189453125</c:v>
                </c:pt>
                <c:pt idx="114">
                  <c:v>7967.90087890625</c:v>
                </c:pt>
                <c:pt idx="115">
                  <c:v>7908.6435546875</c:v>
                </c:pt>
                <c:pt idx="116">
                  <c:v>7884.541015625</c:v>
                </c:pt>
                <c:pt idx="117">
                  <c:v>7909.29296875</c:v>
                </c:pt>
                <c:pt idx="118">
                  <c:v>7956.0361328125</c:v>
                </c:pt>
                <c:pt idx="119">
                  <c:v>7981.41845703125</c:v>
                </c:pt>
                <c:pt idx="120">
                  <c:v>7962.1708984375</c:v>
                </c:pt>
                <c:pt idx="121">
                  <c:v>7914.24169921875</c:v>
                </c:pt>
                <c:pt idx="122">
                  <c:v>7878.8955078125</c:v>
                </c:pt>
                <c:pt idx="123">
                  <c:v>7887.34326171875</c:v>
                </c:pt>
                <c:pt idx="124">
                  <c:v>7933.2890625</c:v>
                </c:pt>
                <c:pt idx="125">
                  <c:v>7976.4560546875</c:v>
                </c:pt>
                <c:pt idx="126">
                  <c:v>7974.73388671875</c:v>
                </c:pt>
                <c:pt idx="127">
                  <c:v>7918.88330078125</c:v>
                </c:pt>
                <c:pt idx="128">
                  <c:v>7841.369140625</c:v>
                </c:pt>
                <c:pt idx="129">
                  <c:v>7791.9169921875</c:v>
                </c:pt>
                <c:pt idx="130">
                  <c:v>7799.51318359375</c:v>
                </c:pt>
                <c:pt idx="131">
                  <c:v>7851.431640625</c:v>
                </c:pt>
                <c:pt idx="132">
                  <c:v>7905.6357421875</c:v>
                </c:pt>
                <c:pt idx="133">
                  <c:v>7925.51171875</c:v>
                </c:pt>
                <c:pt idx="134">
                  <c:v>7908.09814453125</c:v>
                </c:pt>
                <c:pt idx="135">
                  <c:v>7883.259765625</c:v>
                </c:pt>
                <c:pt idx="136">
                  <c:v>7885.8876953125</c:v>
                </c:pt>
                <c:pt idx="137">
                  <c:v>7925.3935546875</c:v>
                </c:pt>
                <c:pt idx="138">
                  <c:v>7978.0400390625</c:v>
                </c:pt>
                <c:pt idx="139">
                  <c:v>8007.62744140625</c:v>
                </c:pt>
                <c:pt idx="140">
                  <c:v>7996.05029296875</c:v>
                </c:pt>
                <c:pt idx="141">
                  <c:v>7957.6123046875</c:v>
                </c:pt>
                <c:pt idx="142">
                  <c:v>7925.67041015625</c:v>
                </c:pt>
                <c:pt idx="143">
                  <c:v>7924.0888671875</c:v>
                </c:pt>
                <c:pt idx="144">
                  <c:v>7948.482421875</c:v>
                </c:pt>
                <c:pt idx="145">
                  <c:v>7972.89453125</c:v>
                </c:pt>
                <c:pt idx="146">
                  <c:v>7974.95849609375</c:v>
                </c:pt>
                <c:pt idx="147">
                  <c:v>7956.56396484375</c:v>
                </c:pt>
                <c:pt idx="148">
                  <c:v>7941.4462890625</c:v>
                </c:pt>
                <c:pt idx="149">
                  <c:v>7951.86865234375</c:v>
                </c:pt>
                <c:pt idx="150">
                  <c:v>7985.439453125</c:v>
                </c:pt>
                <c:pt idx="151">
                  <c:v>8013.4921875</c:v>
                </c:pt>
                <c:pt idx="152">
                  <c:v>8003.830078125</c:v>
                </c:pt>
                <c:pt idx="153">
                  <c:v>7949.10009765625</c:v>
                </c:pt>
                <c:pt idx="154">
                  <c:v>7876.2490234375</c:v>
                </c:pt>
                <c:pt idx="155">
                  <c:v>7827.8427734375</c:v>
                </c:pt>
                <c:pt idx="156">
                  <c:v>7829.6220703125</c:v>
                </c:pt>
                <c:pt idx="157">
                  <c:v>7870.6640625</c:v>
                </c:pt>
                <c:pt idx="158">
                  <c:v>7912.576171875</c:v>
                </c:pt>
                <c:pt idx="159">
                  <c:v>7920.48828125</c:v>
                </c:pt>
                <c:pt idx="160">
                  <c:v>7890.83837890625</c:v>
                </c:pt>
                <c:pt idx="161">
                  <c:v>7853.6494140625</c:v>
                </c:pt>
                <c:pt idx="162">
                  <c:v>7847.77392578125</c:v>
                </c:pt>
                <c:pt idx="163">
                  <c:v>7889.1875</c:v>
                </c:pt>
                <c:pt idx="164">
                  <c:v>7957.4306640625</c:v>
                </c:pt>
                <c:pt idx="165">
                  <c:v>8010.27392578125</c:v>
                </c:pt>
                <c:pt idx="166">
                  <c:v>8014.36669921875</c:v>
                </c:pt>
                <c:pt idx="167">
                  <c:v>7968.0859375</c:v>
                </c:pt>
                <c:pt idx="168">
                  <c:v>7900.35595703125</c:v>
                </c:pt>
                <c:pt idx="169">
                  <c:v>7848.5791015625</c:v>
                </c:pt>
                <c:pt idx="170">
                  <c:v>7833.9296875</c:v>
                </c:pt>
                <c:pt idx="171">
                  <c:v>7851.87255859375</c:v>
                </c:pt>
                <c:pt idx="172">
                  <c:v>7881.89306640625</c:v>
                </c:pt>
                <c:pt idx="173">
                  <c:v>7905.59521484375</c:v>
                </c:pt>
                <c:pt idx="174">
                  <c:v>7918.162109375</c:v>
                </c:pt>
                <c:pt idx="175">
                  <c:v>7926.31591796875</c:v>
                </c:pt>
                <c:pt idx="176">
                  <c:v>7937.90087890625</c:v>
                </c:pt>
                <c:pt idx="177">
                  <c:v>7953.67578125</c:v>
                </c:pt>
                <c:pt idx="178">
                  <c:v>7967.599609375</c:v>
                </c:pt>
                <c:pt idx="179">
                  <c:v>7973.19775390625</c:v>
                </c:pt>
                <c:pt idx="180">
                  <c:v>7968.84765625</c:v>
                </c:pt>
                <c:pt idx="181">
                  <c:v>7957.5048828125</c:v>
                </c:pt>
                <c:pt idx="182">
                  <c:v>7942.71044921875</c:v>
                </c:pt>
                <c:pt idx="183">
                  <c:v>7926.1025390625</c:v>
                </c:pt>
                <c:pt idx="184">
                  <c:v>7909.11572265625</c:v>
                </c:pt>
                <c:pt idx="185">
                  <c:v>7896.2236328125</c:v>
                </c:pt>
                <c:pt idx="186">
                  <c:v>7894.83837890625</c:v>
                </c:pt>
                <c:pt idx="187">
                  <c:v>7910.1962890625</c:v>
                </c:pt>
                <c:pt idx="188">
                  <c:v>7939.169921875</c:v>
                </c:pt>
                <c:pt idx="189">
                  <c:v>7969.16162109375</c:v>
                </c:pt>
                <c:pt idx="190">
                  <c:v>7984.47802734375</c:v>
                </c:pt>
                <c:pt idx="191">
                  <c:v>7976.0634765625</c:v>
                </c:pt>
                <c:pt idx="192">
                  <c:v>7947.13671875</c:v>
                </c:pt>
                <c:pt idx="193">
                  <c:v>7910.39501953125</c:v>
                </c:pt>
                <c:pt idx="194">
                  <c:v>7879.35205078125</c:v>
                </c:pt>
                <c:pt idx="195">
                  <c:v>7860.943359375</c:v>
                </c:pt>
                <c:pt idx="196">
                  <c:v>7854.77294921875</c:v>
                </c:pt>
                <c:pt idx="197">
                  <c:v>7858.1064453125</c:v>
                </c:pt>
                <c:pt idx="198">
                  <c:v>7870.7783203125</c:v>
                </c:pt>
                <c:pt idx="199">
                  <c:v>7894.97265625</c:v>
                </c:pt>
                <c:pt idx="200">
                  <c:v>7930.36279296875</c:v>
                </c:pt>
                <c:pt idx="201">
                  <c:v>7969.96533203125</c:v>
                </c:pt>
                <c:pt idx="202">
                  <c:v>8001.60009765625</c:v>
                </c:pt>
                <c:pt idx="203">
                  <c:v>8014.58203125</c:v>
                </c:pt>
                <c:pt idx="204">
                  <c:v>8006.224609375</c:v>
                </c:pt>
                <c:pt idx="205">
                  <c:v>7982.72314453125</c:v>
                </c:pt>
                <c:pt idx="206">
                  <c:v>7954.03662109375</c:v>
                </c:pt>
                <c:pt idx="207">
                  <c:v>7927.61767578125</c:v>
                </c:pt>
                <c:pt idx="208">
                  <c:v>7906.33740234375</c:v>
                </c:pt>
                <c:pt idx="209">
                  <c:v>7891.3359375</c:v>
                </c:pt>
                <c:pt idx="210">
                  <c:v>7885.45556640625</c:v>
                </c:pt>
                <c:pt idx="211">
                  <c:v>7892.53076171875</c:v>
                </c:pt>
                <c:pt idx="212">
                  <c:v>7912.5927734375</c:v>
                </c:pt>
                <c:pt idx="213">
                  <c:v>7938.216796875</c:v>
                </c:pt>
                <c:pt idx="214">
                  <c:v>7957.17431640625</c:v>
                </c:pt>
                <c:pt idx="215">
                  <c:v>7960.67236328125</c:v>
                </c:pt>
                <c:pt idx="216">
                  <c:v>7950.12158203125</c:v>
                </c:pt>
                <c:pt idx="217">
                  <c:v>7935.25634765625</c:v>
                </c:pt>
                <c:pt idx="218">
                  <c:v>7923.85400390625</c:v>
                </c:pt>
                <c:pt idx="219">
                  <c:v>7912.0146484375</c:v>
                </c:pt>
                <c:pt idx="220">
                  <c:v>7885.49169921875</c:v>
                </c:pt>
                <c:pt idx="221">
                  <c:v>7833.896484375</c:v>
                </c:pt>
                <c:pt idx="222">
                  <c:v>7767.16943359375</c:v>
                </c:pt>
                <c:pt idx="223">
                  <c:v>7718.64697265625</c:v>
                </c:pt>
                <c:pt idx="224">
                  <c:v>7727.45703125</c:v>
                </c:pt>
                <c:pt idx="225">
                  <c:v>7809.73095703125</c:v>
                </c:pt>
                <c:pt idx="226">
                  <c:v>7939.8349609375</c:v>
                </c:pt>
                <c:pt idx="227">
                  <c:v>8058.623046875</c:v>
                </c:pt>
                <c:pt idx="228">
                  <c:v>8106.9814453125</c:v>
                </c:pt>
                <c:pt idx="229">
                  <c:v>8063.30078125</c:v>
                </c:pt>
                <c:pt idx="230">
                  <c:v>7958.55712890625</c:v>
                </c:pt>
                <c:pt idx="231">
                  <c:v>7857.40869140625</c:v>
                </c:pt>
                <c:pt idx="232">
                  <c:v>7817.67041015625</c:v>
                </c:pt>
                <c:pt idx="233">
                  <c:v>7855.888671875</c:v>
                </c:pt>
                <c:pt idx="234">
                  <c:v>7941.77880859375</c:v>
                </c:pt>
                <c:pt idx="235">
                  <c:v>8023.05419921875</c:v>
                </c:pt>
                <c:pt idx="236">
                  <c:v>8060.88916015625</c:v>
                </c:pt>
                <c:pt idx="237">
                  <c:v>8050.68505859375</c:v>
                </c:pt>
                <c:pt idx="238">
                  <c:v>8016.126953125</c:v>
                </c:pt>
                <c:pt idx="239">
                  <c:v>7985.26806640625</c:v>
                </c:pt>
                <c:pt idx="240">
                  <c:v>7969.32373046875</c:v>
                </c:pt>
                <c:pt idx="241">
                  <c:v>7959.74609375</c:v>
                </c:pt>
                <c:pt idx="242">
                  <c:v>7942.625</c:v>
                </c:pt>
                <c:pt idx="243">
                  <c:v>7915.61962890625</c:v>
                </c:pt>
                <c:pt idx="244">
                  <c:v>7892.16259765625</c:v>
                </c:pt>
                <c:pt idx="245">
                  <c:v>7889.76513671875</c:v>
                </c:pt>
                <c:pt idx="246">
                  <c:v>7913.109375</c:v>
                </c:pt>
                <c:pt idx="247">
                  <c:v>7946.82080078125</c:v>
                </c:pt>
                <c:pt idx="248">
                  <c:v>7964.642578125</c:v>
                </c:pt>
                <c:pt idx="249">
                  <c:v>7948.35693359375</c:v>
                </c:pt>
                <c:pt idx="250">
                  <c:v>7902.115234375</c:v>
                </c:pt>
                <c:pt idx="251">
                  <c:v>7851.36328125</c:v>
                </c:pt>
                <c:pt idx="252">
                  <c:v>7826.95263671875</c:v>
                </c:pt>
                <c:pt idx="253">
                  <c:v>7845.37060546875</c:v>
                </c:pt>
                <c:pt idx="254">
                  <c:v>7898.095703125</c:v>
                </c:pt>
                <c:pt idx="255">
                  <c:v>7956.42724609375</c:v>
                </c:pt>
                <c:pt idx="256">
                  <c:v>7988.140625</c:v>
                </c:pt>
                <c:pt idx="257">
                  <c:v>7975.6787109375</c:v>
                </c:pt>
                <c:pt idx="258">
                  <c:v>7925.603515625</c:v>
                </c:pt>
                <c:pt idx="259">
                  <c:v>7864.53955078125</c:v>
                </c:pt>
                <c:pt idx="260">
                  <c:v>7824.1396484375</c:v>
                </c:pt>
                <c:pt idx="261">
                  <c:v>7823.18017578125</c:v>
                </c:pt>
                <c:pt idx="262">
                  <c:v>7856.5087890625</c:v>
                </c:pt>
                <c:pt idx="263">
                  <c:v>7897.58203125</c:v>
                </c:pt>
                <c:pt idx="264">
                  <c:v>7914.41845703125</c:v>
                </c:pt>
                <c:pt idx="265">
                  <c:v>7890.76953125</c:v>
                </c:pt>
                <c:pt idx="266">
                  <c:v>7839.59423828125</c:v>
                </c:pt>
                <c:pt idx="267">
                  <c:v>7798.6181640625</c:v>
                </c:pt>
                <c:pt idx="268">
                  <c:v>7807.98828125</c:v>
                </c:pt>
                <c:pt idx="269">
                  <c:v>7882.46630859375</c:v>
                </c:pt>
                <c:pt idx="270">
                  <c:v>7996.61181640625</c:v>
                </c:pt>
                <c:pt idx="271">
                  <c:v>8095.21923828125</c:v>
                </c:pt>
                <c:pt idx="272">
                  <c:v>8125.2841796875</c:v>
                </c:pt>
                <c:pt idx="273">
                  <c:v>8070.12158203125</c:v>
                </c:pt>
                <c:pt idx="274">
                  <c:v>7962.60546875</c:v>
                </c:pt>
                <c:pt idx="275">
                  <c:v>7866.8779296875</c:v>
                </c:pt>
                <c:pt idx="276">
                  <c:v>7838.84228515625</c:v>
                </c:pt>
                <c:pt idx="277">
                  <c:v>7890.94287109375</c:v>
                </c:pt>
                <c:pt idx="278">
                  <c:v>7984.796875</c:v>
                </c:pt>
                <c:pt idx="279">
                  <c:v>8056.88916015625</c:v>
                </c:pt>
                <c:pt idx="280">
                  <c:v>8060.19140625</c:v>
                </c:pt>
                <c:pt idx="281">
                  <c:v>7993.89208984375</c:v>
                </c:pt>
                <c:pt idx="282">
                  <c:v>7901.89501953125</c:v>
                </c:pt>
                <c:pt idx="283">
                  <c:v>7842.20458984375</c:v>
                </c:pt>
                <c:pt idx="284">
                  <c:v>7848.71435546875</c:v>
                </c:pt>
                <c:pt idx="285">
                  <c:v>7910.94921875</c:v>
                </c:pt>
                <c:pt idx="286">
                  <c:v>7983.98583984375</c:v>
                </c:pt>
                <c:pt idx="287">
                  <c:v>8020.02880859375</c:v>
                </c:pt>
                <c:pt idx="288">
                  <c:v>7999.37548828125</c:v>
                </c:pt>
                <c:pt idx="289">
                  <c:v>7940.544921875</c:v>
                </c:pt>
                <c:pt idx="290">
                  <c:v>7884.54443359375</c:v>
                </c:pt>
                <c:pt idx="291">
                  <c:v>7865.62744140625</c:v>
                </c:pt>
                <c:pt idx="292">
                  <c:v>7888.82568359375</c:v>
                </c:pt>
                <c:pt idx="293">
                  <c:v>7928.65771484375</c:v>
                </c:pt>
                <c:pt idx="294">
                  <c:v>7948.63916015625</c:v>
                </c:pt>
                <c:pt idx="295">
                  <c:v>7927.62451171875</c:v>
                </c:pt>
                <c:pt idx="296">
                  <c:v>7875.1943359375</c:v>
                </c:pt>
                <c:pt idx="297">
                  <c:v>7826.00634765625</c:v>
                </c:pt>
                <c:pt idx="298">
                  <c:v>7816.89990234375</c:v>
                </c:pt>
                <c:pt idx="299">
                  <c:v>7861.669921875</c:v>
                </c:pt>
                <c:pt idx="300">
                  <c:v>7939.955078125</c:v>
                </c:pt>
                <c:pt idx="301">
                  <c:v>8007.78857421875</c:v>
                </c:pt>
                <c:pt idx="302">
                  <c:v>8023.61865234375</c:v>
                </c:pt>
                <c:pt idx="303">
                  <c:v>7973.63232421875</c:v>
                </c:pt>
                <c:pt idx="304">
                  <c:v>7880.4931640625</c:v>
                </c:pt>
                <c:pt idx="305">
                  <c:v>7790.0546875</c:v>
                </c:pt>
                <c:pt idx="306">
                  <c:v>7744.65625</c:v>
                </c:pt>
                <c:pt idx="307">
                  <c:v>7759.99169921875</c:v>
                </c:pt>
                <c:pt idx="308">
                  <c:v>7819.6142578125</c:v>
                </c:pt>
                <c:pt idx="309">
                  <c:v>7889.01806640625</c:v>
                </c:pt>
                <c:pt idx="310">
                  <c:v>7938.31494140625</c:v>
                </c:pt>
                <c:pt idx="311">
                  <c:v>7957.9169921875</c:v>
                </c:pt>
                <c:pt idx="312">
                  <c:v>7958.1611328125</c:v>
                </c:pt>
                <c:pt idx="313">
                  <c:v>7956.16015625</c:v>
                </c:pt>
                <c:pt idx="314">
                  <c:v>7961.80322265625</c:v>
                </c:pt>
                <c:pt idx="315">
                  <c:v>7973.4755859375</c:v>
                </c:pt>
                <c:pt idx="316">
                  <c:v>7984.60791015625</c:v>
                </c:pt>
                <c:pt idx="317">
                  <c:v>7992.8818359375</c:v>
                </c:pt>
                <c:pt idx="318">
                  <c:v>8002.607421875</c:v>
                </c:pt>
                <c:pt idx="319">
                  <c:v>8018.1259765625</c:v>
                </c:pt>
                <c:pt idx="320">
                  <c:v>8035.28125</c:v>
                </c:pt>
                <c:pt idx="321">
                  <c:v>8040.51220703125</c:v>
                </c:pt>
                <c:pt idx="322">
                  <c:v>8020.42578125</c:v>
                </c:pt>
                <c:pt idx="323">
                  <c:v>7974.572265625</c:v>
                </c:pt>
                <c:pt idx="324">
                  <c:v>7919.83447265625</c:v>
                </c:pt>
                <c:pt idx="325">
                  <c:v>7880.87158203125</c:v>
                </c:pt>
                <c:pt idx="326">
                  <c:v>7872.8642578125</c:v>
                </c:pt>
                <c:pt idx="327">
                  <c:v>7890.24365234375</c:v>
                </c:pt>
                <c:pt idx="328">
                  <c:v>7911.181640625</c:v>
                </c:pt>
                <c:pt idx="329">
                  <c:v>7914.9501953125</c:v>
                </c:pt>
                <c:pt idx="330">
                  <c:v>7898.25732421875</c:v>
                </c:pt>
                <c:pt idx="331">
                  <c:v>7876.95703125</c:v>
                </c:pt>
                <c:pt idx="332">
                  <c:v>7871.47314453125</c:v>
                </c:pt>
                <c:pt idx="333">
                  <c:v>7888.11083984375</c:v>
                </c:pt>
                <c:pt idx="334">
                  <c:v>7912.39599609375</c:v>
                </c:pt>
                <c:pt idx="335">
                  <c:v>7920.81005859375</c:v>
                </c:pt>
                <c:pt idx="336">
                  <c:v>7901.60205078125</c:v>
                </c:pt>
                <c:pt idx="337">
                  <c:v>7866.9853515625</c:v>
                </c:pt>
                <c:pt idx="338">
                  <c:v>7845.451171875</c:v>
                </c:pt>
                <c:pt idx="339">
                  <c:v>7859.2900390625</c:v>
                </c:pt>
                <c:pt idx="340">
                  <c:v>7905.27294921875</c:v>
                </c:pt>
                <c:pt idx="341">
                  <c:v>7954.79345703125</c:v>
                </c:pt>
                <c:pt idx="342">
                  <c:v>7974.50048828125</c:v>
                </c:pt>
                <c:pt idx="343">
                  <c:v>7951.7705078125</c:v>
                </c:pt>
                <c:pt idx="344">
                  <c:v>7904.98486328125</c:v>
                </c:pt>
                <c:pt idx="345">
                  <c:v>7870.26611328125</c:v>
                </c:pt>
                <c:pt idx="346">
                  <c:v>7874.7666015625</c:v>
                </c:pt>
                <c:pt idx="347">
                  <c:v>7917.00390625</c:v>
                </c:pt>
                <c:pt idx="348">
                  <c:v>7968.94189453125</c:v>
                </c:pt>
                <c:pt idx="349">
                  <c:v>7997.3720703125</c:v>
                </c:pt>
              </c:numCache>
            </c:numRef>
          </c:yVal>
          <c:smooth val="1"/>
          <c:extLst>
            <c:ext xmlns:c16="http://schemas.microsoft.com/office/drawing/2014/chart" uri="{C3380CC4-5D6E-409C-BE32-E72D297353CC}">
              <c16:uniqueId val="{00000014-4A37-429A-A58F-F7AEDA5D1ACA}"/>
            </c:ext>
          </c:extLst>
        </c:ser>
        <c:ser>
          <c:idx val="21"/>
          <c:order val="21"/>
          <c:tx>
            <c:strRef>
              <c:f>cp_sub_001!$V$1</c:f>
              <c:strCache>
                <c:ptCount val="1"/>
                <c:pt idx="0">
                  <c:v>Coor_22</c:v>
                </c:pt>
              </c:strCache>
            </c:strRef>
          </c:tx>
          <c:spPr>
            <a:ln w="28575" cap="rnd">
              <a:solidFill>
                <a:schemeClr val="accent4">
                  <a:lumMod val="80000"/>
                </a:schemeClr>
              </a:solidFill>
              <a:round/>
            </a:ln>
            <a:effectLst/>
          </c:spPr>
          <c:marker>
            <c:symbol val="none"/>
          </c:marker>
          <c:yVal>
            <c:numRef>
              <c:f>cp_sub_001!$V$2:$V$351</c:f>
              <c:numCache>
                <c:formatCode>0.00000000000_ </c:formatCode>
                <c:ptCount val="350"/>
                <c:pt idx="0">
                  <c:v>7737.392578125</c:v>
                </c:pt>
                <c:pt idx="1">
                  <c:v>7778.39990234375</c:v>
                </c:pt>
                <c:pt idx="2">
                  <c:v>7846.18408203125</c:v>
                </c:pt>
                <c:pt idx="3">
                  <c:v>7909.51806640625</c:v>
                </c:pt>
                <c:pt idx="4">
                  <c:v>7933.6064453125</c:v>
                </c:pt>
                <c:pt idx="5">
                  <c:v>7905.41064453125</c:v>
                </c:pt>
                <c:pt idx="6">
                  <c:v>7844.99853515625</c:v>
                </c:pt>
                <c:pt idx="7">
                  <c:v>7792.44580078125</c:v>
                </c:pt>
                <c:pt idx="8">
                  <c:v>7778.77587890625</c:v>
                </c:pt>
                <c:pt idx="9">
                  <c:v>7802.81103515625</c:v>
                </c:pt>
                <c:pt idx="10">
                  <c:v>7832.26318359375</c:v>
                </c:pt>
                <c:pt idx="11">
                  <c:v>7829.005859375</c:v>
                </c:pt>
                <c:pt idx="12">
                  <c:v>7779.45849609375</c:v>
                </c:pt>
                <c:pt idx="13">
                  <c:v>7706.66845703125</c:v>
                </c:pt>
                <c:pt idx="14">
                  <c:v>7654.6162109375</c:v>
                </c:pt>
                <c:pt idx="15">
                  <c:v>7656.65625</c:v>
                </c:pt>
                <c:pt idx="16">
                  <c:v>7711.947265625</c:v>
                </c:pt>
                <c:pt idx="17">
                  <c:v>7787.09814453125</c:v>
                </c:pt>
                <c:pt idx="18">
                  <c:v>7840.630859375</c:v>
                </c:pt>
                <c:pt idx="19">
                  <c:v>7850.970703125</c:v>
                </c:pt>
                <c:pt idx="20">
                  <c:v>7827.36865234375</c:v>
                </c:pt>
                <c:pt idx="21">
                  <c:v>7797.6123046875</c:v>
                </c:pt>
                <c:pt idx="22">
                  <c:v>7784.31982421875</c:v>
                </c:pt>
                <c:pt idx="23">
                  <c:v>7789.00537109375</c:v>
                </c:pt>
                <c:pt idx="24">
                  <c:v>7795.02734375</c:v>
                </c:pt>
                <c:pt idx="25">
                  <c:v>7784.73046875</c:v>
                </c:pt>
                <c:pt idx="26">
                  <c:v>7755.56298828125</c:v>
                </c:pt>
                <c:pt idx="27">
                  <c:v>7722.45849609375</c:v>
                </c:pt>
                <c:pt idx="28">
                  <c:v>7705.93115234375</c:v>
                </c:pt>
                <c:pt idx="29">
                  <c:v>7716.59326171875</c:v>
                </c:pt>
                <c:pt idx="30">
                  <c:v>7748.38330078125</c:v>
                </c:pt>
                <c:pt idx="31">
                  <c:v>7784.60205078125</c:v>
                </c:pt>
                <c:pt idx="32">
                  <c:v>7810.56591796875</c:v>
                </c:pt>
                <c:pt idx="33">
                  <c:v>7822.56787109375</c:v>
                </c:pt>
                <c:pt idx="34">
                  <c:v>7827.25830078125</c:v>
                </c:pt>
                <c:pt idx="35">
                  <c:v>7833.6982421875</c:v>
                </c:pt>
                <c:pt idx="36">
                  <c:v>7845.357421875</c:v>
                </c:pt>
                <c:pt idx="37">
                  <c:v>7857.8896484375</c:v>
                </c:pt>
                <c:pt idx="38">
                  <c:v>7863.08642578125</c:v>
                </c:pt>
                <c:pt idx="39">
                  <c:v>7854.99462890625</c:v>
                </c:pt>
                <c:pt idx="40">
                  <c:v>7833.77783203125</c:v>
                </c:pt>
                <c:pt idx="41">
                  <c:v>7805.6396484375</c:v>
                </c:pt>
                <c:pt idx="42">
                  <c:v>7779.82080078125</c:v>
                </c:pt>
                <c:pt idx="43">
                  <c:v>7764.52783203125</c:v>
                </c:pt>
                <c:pt idx="44">
                  <c:v>7763.11572265625</c:v>
                </c:pt>
                <c:pt idx="45">
                  <c:v>7771.68017578125</c:v>
                </c:pt>
                <c:pt idx="46">
                  <c:v>7779.63232421875</c:v>
                </c:pt>
                <c:pt idx="47">
                  <c:v>7774.45751953125</c:v>
                </c:pt>
                <c:pt idx="48">
                  <c:v>7749.48779296875</c:v>
                </c:pt>
                <c:pt idx="49">
                  <c:v>7710.31298828125</c:v>
                </c:pt>
                <c:pt idx="50">
                  <c:v>7674.505859375</c:v>
                </c:pt>
                <c:pt idx="51">
                  <c:v>7662.81201171875</c:v>
                </c:pt>
                <c:pt idx="52">
                  <c:v>7686.234375</c:v>
                </c:pt>
                <c:pt idx="53">
                  <c:v>7737.658203125</c:v>
                </c:pt>
                <c:pt idx="54">
                  <c:v>7794.6728515625</c:v>
                </c:pt>
                <c:pt idx="55">
                  <c:v>7832.6064453125</c:v>
                </c:pt>
                <c:pt idx="56">
                  <c:v>7839.111328125</c:v>
                </c:pt>
                <c:pt idx="57">
                  <c:v>7820.18017578125</c:v>
                </c:pt>
                <c:pt idx="58">
                  <c:v>7793.83984375</c:v>
                </c:pt>
                <c:pt idx="59">
                  <c:v>7777.015625</c:v>
                </c:pt>
                <c:pt idx="60">
                  <c:v>7775.75830078125</c:v>
                </c:pt>
                <c:pt idx="61">
                  <c:v>7785.37890625</c:v>
                </c:pt>
                <c:pt idx="62">
                  <c:v>7798.33544921875</c:v>
                </c:pt>
                <c:pt idx="63">
                  <c:v>7811.58154296875</c:v>
                </c:pt>
                <c:pt idx="64">
                  <c:v>7826.68994140625</c:v>
                </c:pt>
                <c:pt idx="65">
                  <c:v>7843.697265625</c:v>
                </c:pt>
                <c:pt idx="66">
                  <c:v>7856.09033203125</c:v>
                </c:pt>
                <c:pt idx="67">
                  <c:v>7853.4599609375</c:v>
                </c:pt>
                <c:pt idx="68">
                  <c:v>7830.76904296875</c:v>
                </c:pt>
                <c:pt idx="69">
                  <c:v>7795.87646484375</c:v>
                </c:pt>
                <c:pt idx="70">
                  <c:v>7767.11669921875</c:v>
                </c:pt>
                <c:pt idx="71">
                  <c:v>7760.982421875</c:v>
                </c:pt>
                <c:pt idx="72">
                  <c:v>7779.232421875</c:v>
                </c:pt>
                <c:pt idx="73">
                  <c:v>7806.5400390625</c:v>
                </c:pt>
                <c:pt idx="74">
                  <c:v>7821.669921875</c:v>
                </c:pt>
                <c:pt idx="75">
                  <c:v>7813.64111328125</c:v>
                </c:pt>
                <c:pt idx="76">
                  <c:v>7789.49609375</c:v>
                </c:pt>
                <c:pt idx="77">
                  <c:v>7766.94287109375</c:v>
                </c:pt>
                <c:pt idx="78">
                  <c:v>7758.134765625</c:v>
                </c:pt>
                <c:pt idx="79">
                  <c:v>7758.97412109375</c:v>
                </c:pt>
                <c:pt idx="80">
                  <c:v>7754.00341796875</c:v>
                </c:pt>
                <c:pt idx="81">
                  <c:v>7733.2255859375</c:v>
                </c:pt>
                <c:pt idx="82">
                  <c:v>7705.7158203125</c:v>
                </c:pt>
                <c:pt idx="83">
                  <c:v>7696.23046875</c:v>
                </c:pt>
                <c:pt idx="84">
                  <c:v>7725.0810546875</c:v>
                </c:pt>
                <c:pt idx="85">
                  <c:v>7787.04443359375</c:v>
                </c:pt>
                <c:pt idx="86">
                  <c:v>7848.34912109375</c:v>
                </c:pt>
                <c:pt idx="87">
                  <c:v>7867.748046875</c:v>
                </c:pt>
                <c:pt idx="88">
                  <c:v>7827.8525390625</c:v>
                </c:pt>
                <c:pt idx="89">
                  <c:v>7752.48193359375</c:v>
                </c:pt>
                <c:pt idx="90">
                  <c:v>7694.30419921875</c:v>
                </c:pt>
                <c:pt idx="91">
                  <c:v>7699.0966796875</c:v>
                </c:pt>
                <c:pt idx="92">
                  <c:v>7771.7724609375</c:v>
                </c:pt>
                <c:pt idx="93">
                  <c:v>7869.7412109375</c:v>
                </c:pt>
                <c:pt idx="94">
                  <c:v>7930.00244140625</c:v>
                </c:pt>
                <c:pt idx="95">
                  <c:v>7911.69140625</c:v>
                </c:pt>
                <c:pt idx="96">
                  <c:v>7824.15576171875</c:v>
                </c:pt>
                <c:pt idx="97">
                  <c:v>7720.92822265625</c:v>
                </c:pt>
                <c:pt idx="98">
                  <c:v>7664.29248046875</c:v>
                </c:pt>
                <c:pt idx="99">
                  <c:v>7685.4765625</c:v>
                </c:pt>
                <c:pt idx="100">
                  <c:v>7767.21630859375</c:v>
                </c:pt>
                <c:pt idx="101">
                  <c:v>7858.37646484375</c:v>
                </c:pt>
                <c:pt idx="102">
                  <c:v>7907.978515625</c:v>
                </c:pt>
                <c:pt idx="103">
                  <c:v>7894.5966796875</c:v>
                </c:pt>
                <c:pt idx="104">
                  <c:v>7833.46923828125</c:v>
                </c:pt>
                <c:pt idx="105">
                  <c:v>7760.98828125</c:v>
                </c:pt>
                <c:pt idx="106">
                  <c:v>7710.78955078125</c:v>
                </c:pt>
                <c:pt idx="107">
                  <c:v>7697.7265625</c:v>
                </c:pt>
                <c:pt idx="108">
                  <c:v>7716.68212890625</c:v>
                </c:pt>
                <c:pt idx="109">
                  <c:v>7751.63037109375</c:v>
                </c:pt>
                <c:pt idx="110">
                  <c:v>7785.6181640625</c:v>
                </c:pt>
                <c:pt idx="111">
                  <c:v>7805.99365234375</c:v>
                </c:pt>
                <c:pt idx="112">
                  <c:v>7805.74658203125</c:v>
                </c:pt>
                <c:pt idx="113">
                  <c:v>7784.55322265625</c:v>
                </c:pt>
                <c:pt idx="114">
                  <c:v>7750.421875</c:v>
                </c:pt>
                <c:pt idx="115">
                  <c:v>7718.89697265625</c:v>
                </c:pt>
                <c:pt idx="116">
                  <c:v>7706.8603515625</c:v>
                </c:pt>
                <c:pt idx="117">
                  <c:v>7722.79150390625</c:v>
                </c:pt>
                <c:pt idx="118">
                  <c:v>7760.318359375</c:v>
                </c:pt>
                <c:pt idx="119">
                  <c:v>7801.29150390625</c:v>
                </c:pt>
                <c:pt idx="120">
                  <c:v>7827.76904296875</c:v>
                </c:pt>
                <c:pt idx="121">
                  <c:v>7834.4892578125</c:v>
                </c:pt>
                <c:pt idx="122">
                  <c:v>7831.84228515625</c:v>
                </c:pt>
                <c:pt idx="123">
                  <c:v>7836.34765625</c:v>
                </c:pt>
                <c:pt idx="124">
                  <c:v>7855.9619140625</c:v>
                </c:pt>
                <c:pt idx="125">
                  <c:v>7882.43310546875</c:v>
                </c:pt>
                <c:pt idx="126">
                  <c:v>7897.57275390625</c:v>
                </c:pt>
                <c:pt idx="127">
                  <c:v>7888.63330078125</c:v>
                </c:pt>
                <c:pt idx="128">
                  <c:v>7859.66552734375</c:v>
                </c:pt>
                <c:pt idx="129">
                  <c:v>7828.41845703125</c:v>
                </c:pt>
                <c:pt idx="130">
                  <c:v>7810.51123046875</c:v>
                </c:pt>
                <c:pt idx="131">
                  <c:v>7804.3095703125</c:v>
                </c:pt>
                <c:pt idx="132">
                  <c:v>7790.751953125</c:v>
                </c:pt>
                <c:pt idx="133">
                  <c:v>7750.48828125</c:v>
                </c:pt>
                <c:pt idx="134">
                  <c:v>7685.24462890625</c:v>
                </c:pt>
                <c:pt idx="135">
                  <c:v>7624.50634765625</c:v>
                </c:pt>
                <c:pt idx="136">
                  <c:v>7608.56640625</c:v>
                </c:pt>
                <c:pt idx="137">
                  <c:v>7658.056640625</c:v>
                </c:pt>
                <c:pt idx="138">
                  <c:v>7753.0947265625</c:v>
                </c:pt>
                <c:pt idx="139">
                  <c:v>7840.564453125</c:v>
                </c:pt>
                <c:pt idx="140">
                  <c:v>7867.71728515625</c:v>
                </c:pt>
                <c:pt idx="141">
                  <c:v>7819.2626953125</c:v>
                </c:pt>
                <c:pt idx="142">
                  <c:v>7730.2431640625</c:v>
                </c:pt>
                <c:pt idx="143">
                  <c:v>7663.3759765625</c:v>
                </c:pt>
                <c:pt idx="144">
                  <c:v>7665.7822265625</c:v>
                </c:pt>
                <c:pt idx="145">
                  <c:v>7736.14013671875</c:v>
                </c:pt>
                <c:pt idx="146">
                  <c:v>7826.44775390625</c:v>
                </c:pt>
                <c:pt idx="147">
                  <c:v>7877.158203125</c:v>
                </c:pt>
                <c:pt idx="148">
                  <c:v>7859.63916015625</c:v>
                </c:pt>
                <c:pt idx="149">
                  <c:v>7794.65771484375</c:v>
                </c:pt>
                <c:pt idx="150">
                  <c:v>7734.0986328125</c:v>
                </c:pt>
                <c:pt idx="151">
                  <c:v>7721.08349609375</c:v>
                </c:pt>
                <c:pt idx="152">
                  <c:v>7759.474609375</c:v>
                </c:pt>
                <c:pt idx="153">
                  <c:v>7815.3046875</c:v>
                </c:pt>
                <c:pt idx="154">
                  <c:v>7847.05517578125</c:v>
                </c:pt>
                <c:pt idx="155">
                  <c:v>7839.31201171875</c:v>
                </c:pt>
                <c:pt idx="156">
                  <c:v>7812.80517578125</c:v>
                </c:pt>
                <c:pt idx="157">
                  <c:v>7803.89013671875</c:v>
                </c:pt>
                <c:pt idx="158">
                  <c:v>7831.607421875</c:v>
                </c:pt>
                <c:pt idx="159">
                  <c:v>7880.16845703125</c:v>
                </c:pt>
                <c:pt idx="160">
                  <c:v>7911.42724609375</c:v>
                </c:pt>
                <c:pt idx="161">
                  <c:v>7896.7529296875</c:v>
                </c:pt>
                <c:pt idx="162">
                  <c:v>7841.541015625</c:v>
                </c:pt>
                <c:pt idx="163">
                  <c:v>7781.65625</c:v>
                </c:pt>
                <c:pt idx="164">
                  <c:v>7754.4140625</c:v>
                </c:pt>
                <c:pt idx="165">
                  <c:v>7767.96337890625</c:v>
                </c:pt>
                <c:pt idx="166">
                  <c:v>7794.57080078125</c:v>
                </c:pt>
                <c:pt idx="167">
                  <c:v>7793.82373046875</c:v>
                </c:pt>
                <c:pt idx="168">
                  <c:v>7747.146484375</c:v>
                </c:pt>
                <c:pt idx="169">
                  <c:v>7675.42431640625</c:v>
                </c:pt>
                <c:pt idx="170">
                  <c:v>7624.98193359375</c:v>
                </c:pt>
                <c:pt idx="171">
                  <c:v>7632.65625</c:v>
                </c:pt>
                <c:pt idx="172">
                  <c:v>7697.57861328125</c:v>
                </c:pt>
                <c:pt idx="173">
                  <c:v>7781.85302734375</c:v>
                </c:pt>
                <c:pt idx="174">
                  <c:v>7839.17431640625</c:v>
                </c:pt>
                <c:pt idx="175">
                  <c:v>7848.4443359375</c:v>
                </c:pt>
                <c:pt idx="176">
                  <c:v>7826.18896484375</c:v>
                </c:pt>
                <c:pt idx="177">
                  <c:v>7809.2421875</c:v>
                </c:pt>
                <c:pt idx="178">
                  <c:v>7822.90673828125</c:v>
                </c:pt>
                <c:pt idx="179">
                  <c:v>7860.54052734375</c:v>
                </c:pt>
                <c:pt idx="180">
                  <c:v>7890.0927734375</c:v>
                </c:pt>
                <c:pt idx="181">
                  <c:v>7880.93896484375</c:v>
                </c:pt>
                <c:pt idx="182">
                  <c:v>7828.66357421875</c:v>
                </c:pt>
                <c:pt idx="183">
                  <c:v>7758.4609375</c:v>
                </c:pt>
                <c:pt idx="184">
                  <c:v>7705.92724609375</c:v>
                </c:pt>
                <c:pt idx="185">
                  <c:v>7691.74267578125</c:v>
                </c:pt>
                <c:pt idx="186">
                  <c:v>7709.9267578125</c:v>
                </c:pt>
                <c:pt idx="187">
                  <c:v>7736.744140625</c:v>
                </c:pt>
                <c:pt idx="188">
                  <c:v>7750.556640625</c:v>
                </c:pt>
                <c:pt idx="189">
                  <c:v>7745.93115234375</c:v>
                </c:pt>
                <c:pt idx="190">
                  <c:v>7732.669921875</c:v>
                </c:pt>
                <c:pt idx="191">
                  <c:v>7724.16357421875</c:v>
                </c:pt>
                <c:pt idx="192">
                  <c:v>7727.20166015625</c:v>
                </c:pt>
                <c:pt idx="193">
                  <c:v>7741.18798828125</c:v>
                </c:pt>
                <c:pt idx="194">
                  <c:v>7764.06005859375</c:v>
                </c:pt>
                <c:pt idx="195">
                  <c:v>7795.8837890625</c:v>
                </c:pt>
                <c:pt idx="196">
                  <c:v>7835.00048828125</c:v>
                </c:pt>
                <c:pt idx="197">
                  <c:v>7871.30859375</c:v>
                </c:pt>
                <c:pt idx="198">
                  <c:v>7886.46728515625</c:v>
                </c:pt>
                <c:pt idx="199">
                  <c:v>7865.33984375</c:v>
                </c:pt>
                <c:pt idx="200">
                  <c:v>7811.29345703125</c:v>
                </c:pt>
                <c:pt idx="201">
                  <c:v>7751.22412109375</c:v>
                </c:pt>
                <c:pt idx="202">
                  <c:v>7722.16064453125</c:v>
                </c:pt>
                <c:pt idx="203">
                  <c:v>7746.39892578125</c:v>
                </c:pt>
                <c:pt idx="204">
                  <c:v>7813.58447265625</c:v>
                </c:pt>
                <c:pt idx="205">
                  <c:v>7885.08349609375</c:v>
                </c:pt>
                <c:pt idx="206">
                  <c:v>7919.37890625</c:v>
                </c:pt>
                <c:pt idx="207">
                  <c:v>7900.1328125</c:v>
                </c:pt>
                <c:pt idx="208">
                  <c:v>7845.5029296875</c:v>
                </c:pt>
                <c:pt idx="209">
                  <c:v>7791.69873046875</c:v>
                </c:pt>
                <c:pt idx="210">
                  <c:v>7764.333984375</c:v>
                </c:pt>
                <c:pt idx="211">
                  <c:v>7760.92041015625</c:v>
                </c:pt>
                <c:pt idx="212">
                  <c:v>7758.36572265625</c:v>
                </c:pt>
                <c:pt idx="213">
                  <c:v>7738.19140625</c:v>
                </c:pt>
                <c:pt idx="214">
                  <c:v>7706.9736328125</c:v>
                </c:pt>
                <c:pt idx="215">
                  <c:v>7693.2783203125</c:v>
                </c:pt>
                <c:pt idx="216">
                  <c:v>7722.3896484375</c:v>
                </c:pt>
                <c:pt idx="217">
                  <c:v>7789.83984375</c:v>
                </c:pt>
                <c:pt idx="218">
                  <c:v>7857.3544921875</c:v>
                </c:pt>
                <c:pt idx="219">
                  <c:v>7877.470703125</c:v>
                </c:pt>
                <c:pt idx="220">
                  <c:v>7829.4580078125</c:v>
                </c:pt>
                <c:pt idx="221">
                  <c:v>7738.59814453125</c:v>
                </c:pt>
                <c:pt idx="222">
                  <c:v>7662.41357421875</c:v>
                </c:pt>
                <c:pt idx="223">
                  <c:v>7652.41064453125</c:v>
                </c:pt>
                <c:pt idx="224">
                  <c:v>7718.75146484375</c:v>
                </c:pt>
                <c:pt idx="225">
                  <c:v>7823.3125</c:v>
                </c:pt>
                <c:pt idx="226">
                  <c:v>7905.50927734375</c:v>
                </c:pt>
                <c:pt idx="227">
                  <c:v>7921.5595703125</c:v>
                </c:pt>
                <c:pt idx="228">
                  <c:v>7869.47412109375</c:v>
                </c:pt>
                <c:pt idx="229">
                  <c:v>7784.36474609375</c:v>
                </c:pt>
                <c:pt idx="230">
                  <c:v>7711.06103515625</c:v>
                </c:pt>
                <c:pt idx="231">
                  <c:v>7676.015625</c:v>
                </c:pt>
                <c:pt idx="232">
                  <c:v>7677.6953125</c:v>
                </c:pt>
                <c:pt idx="233">
                  <c:v>7698.1474609375</c:v>
                </c:pt>
                <c:pt idx="234">
                  <c:v>7722.38671875</c:v>
                </c:pt>
                <c:pt idx="235">
                  <c:v>7748.79345703125</c:v>
                </c:pt>
                <c:pt idx="236">
                  <c:v>7783.8984375</c:v>
                </c:pt>
                <c:pt idx="237">
                  <c:v>7828.95703125</c:v>
                </c:pt>
                <c:pt idx="238">
                  <c:v>7871.880859375</c:v>
                </c:pt>
                <c:pt idx="239">
                  <c:v>7892.33056640625</c:v>
                </c:pt>
                <c:pt idx="240">
                  <c:v>7875.97705078125</c:v>
                </c:pt>
                <c:pt idx="241">
                  <c:v>7826.31005859375</c:v>
                </c:pt>
                <c:pt idx="242">
                  <c:v>7764.59912109375</c:v>
                </c:pt>
                <c:pt idx="243">
                  <c:v>7718.0908203125</c:v>
                </c:pt>
                <c:pt idx="244">
                  <c:v>7705.07080078125</c:v>
                </c:pt>
                <c:pt idx="245">
                  <c:v>7726.71044921875</c:v>
                </c:pt>
                <c:pt idx="246">
                  <c:v>7769.60595703125</c:v>
                </c:pt>
                <c:pt idx="247">
                  <c:v>7815.26318359375</c:v>
                </c:pt>
                <c:pt idx="248">
                  <c:v>7849.3037109375</c:v>
                </c:pt>
                <c:pt idx="249">
                  <c:v>7865.50439453125</c:v>
                </c:pt>
                <c:pt idx="250">
                  <c:v>7864.734375</c:v>
                </c:pt>
                <c:pt idx="251">
                  <c:v>7851.9560546875</c:v>
                </c:pt>
                <c:pt idx="252">
                  <c:v>7833.8916015625</c:v>
                </c:pt>
                <c:pt idx="253">
                  <c:v>7817.44091796875</c:v>
                </c:pt>
                <c:pt idx="254">
                  <c:v>7807.59619140625</c:v>
                </c:pt>
                <c:pt idx="255">
                  <c:v>7804.708984375</c:v>
                </c:pt>
                <c:pt idx="256">
                  <c:v>7803.05859375</c:v>
                </c:pt>
                <c:pt idx="257">
                  <c:v>7793.14697265625</c:v>
                </c:pt>
                <c:pt idx="258">
                  <c:v>7767.8369140625</c:v>
                </c:pt>
                <c:pt idx="259">
                  <c:v>7729.0537109375</c:v>
                </c:pt>
                <c:pt idx="260">
                  <c:v>7690.091796875</c:v>
                </c:pt>
                <c:pt idx="261">
                  <c:v>7670.55615234375</c:v>
                </c:pt>
                <c:pt idx="262">
                  <c:v>7685.60986328125</c:v>
                </c:pt>
                <c:pt idx="263">
                  <c:v>7735.47216796875</c:v>
                </c:pt>
                <c:pt idx="264">
                  <c:v>7801.95263671875</c:v>
                </c:pt>
                <c:pt idx="265">
                  <c:v>7855.30517578125</c:v>
                </c:pt>
                <c:pt idx="266">
                  <c:v>7868.76123046875</c:v>
                </c:pt>
                <c:pt idx="267">
                  <c:v>7833.21435546875</c:v>
                </c:pt>
                <c:pt idx="268">
                  <c:v>7763.7255859375</c:v>
                </c:pt>
                <c:pt idx="269">
                  <c:v>7693.556640625</c:v>
                </c:pt>
                <c:pt idx="270">
                  <c:v>7658.2216796875</c:v>
                </c:pt>
                <c:pt idx="271">
                  <c:v>7677.8095703125</c:v>
                </c:pt>
                <c:pt idx="272">
                  <c:v>7747.04052734375</c:v>
                </c:pt>
                <c:pt idx="273">
                  <c:v>7838.279296875</c:v>
                </c:pt>
                <c:pt idx="274">
                  <c:v>7915.39453125</c:v>
                </c:pt>
                <c:pt idx="275">
                  <c:v>7950.41259765625</c:v>
                </c:pt>
                <c:pt idx="276">
                  <c:v>7934.0654296875</c:v>
                </c:pt>
                <c:pt idx="277">
                  <c:v>7875.9638671875</c:v>
                </c:pt>
                <c:pt idx="278">
                  <c:v>7796.8037109375</c:v>
                </c:pt>
                <c:pt idx="279">
                  <c:v>7718.9814453125</c:v>
                </c:pt>
                <c:pt idx="280">
                  <c:v>7660.82568359375</c:v>
                </c:pt>
                <c:pt idx="281">
                  <c:v>7634.95751953125</c:v>
                </c:pt>
                <c:pt idx="282">
                  <c:v>7647.6044921875</c:v>
                </c:pt>
                <c:pt idx="283">
                  <c:v>7696.24951171875</c:v>
                </c:pt>
                <c:pt idx="284">
                  <c:v>7767.037109375</c:v>
                </c:pt>
                <c:pt idx="285">
                  <c:v>7836.46875</c:v>
                </c:pt>
                <c:pt idx="286">
                  <c:v>7880.22314453125</c:v>
                </c:pt>
                <c:pt idx="287">
                  <c:v>7885.8759765625</c:v>
                </c:pt>
                <c:pt idx="288">
                  <c:v>7861.01806640625</c:v>
                </c:pt>
                <c:pt idx="289">
                  <c:v>7829.30810546875</c:v>
                </c:pt>
                <c:pt idx="290">
                  <c:v>7815.03369140625</c:v>
                </c:pt>
                <c:pt idx="291">
                  <c:v>7826.072265625</c:v>
                </c:pt>
                <c:pt idx="292">
                  <c:v>7847.87744140625</c:v>
                </c:pt>
                <c:pt idx="293">
                  <c:v>7853.92333984375</c:v>
                </c:pt>
                <c:pt idx="294">
                  <c:v>7825.65283203125</c:v>
                </c:pt>
                <c:pt idx="295">
                  <c:v>7767.1884765625</c:v>
                </c:pt>
                <c:pt idx="296">
                  <c:v>7703.52587890625</c:v>
                </c:pt>
                <c:pt idx="297">
                  <c:v>7663.52197265625</c:v>
                </c:pt>
                <c:pt idx="298">
                  <c:v>7660.78173828125</c:v>
                </c:pt>
                <c:pt idx="299">
                  <c:v>7686.892578125</c:v>
                </c:pt>
                <c:pt idx="300">
                  <c:v>7721.1904296875</c:v>
                </c:pt>
                <c:pt idx="301">
                  <c:v>7747.85009765625</c:v>
                </c:pt>
                <c:pt idx="302">
                  <c:v>7765.8076171875</c:v>
                </c:pt>
                <c:pt idx="303">
                  <c:v>7784.205078125</c:v>
                </c:pt>
                <c:pt idx="304">
                  <c:v>7809.2001953125</c:v>
                </c:pt>
                <c:pt idx="305">
                  <c:v>7835.44384765625</c:v>
                </c:pt>
                <c:pt idx="306">
                  <c:v>7850.61474609375</c:v>
                </c:pt>
                <c:pt idx="307">
                  <c:v>7848.54931640625</c:v>
                </c:pt>
                <c:pt idx="308">
                  <c:v>7837.587890625</c:v>
                </c:pt>
                <c:pt idx="309">
                  <c:v>7834.50537109375</c:v>
                </c:pt>
                <c:pt idx="310">
                  <c:v>7848.0087890625</c:v>
                </c:pt>
                <c:pt idx="311">
                  <c:v>7867.0283203125</c:v>
                </c:pt>
                <c:pt idx="312">
                  <c:v>7866.76220703125</c:v>
                </c:pt>
                <c:pt idx="313">
                  <c:v>7830.201171875</c:v>
                </c:pt>
                <c:pt idx="314">
                  <c:v>7767.49365234375</c:v>
                </c:pt>
                <c:pt idx="315">
                  <c:v>7714.38330078125</c:v>
                </c:pt>
                <c:pt idx="316">
                  <c:v>7707.05712890625</c:v>
                </c:pt>
                <c:pt idx="317">
                  <c:v>7751.6669921875</c:v>
                </c:pt>
                <c:pt idx="318">
                  <c:v>7814.32568359375</c:v>
                </c:pt>
                <c:pt idx="319">
                  <c:v>7843.2431640625</c:v>
                </c:pt>
                <c:pt idx="320">
                  <c:v>7808.63525390625</c:v>
                </c:pt>
                <c:pt idx="321">
                  <c:v>7729.3095703125</c:v>
                </c:pt>
                <c:pt idx="322">
                  <c:v>7662.56689453125</c:v>
                </c:pt>
                <c:pt idx="323">
                  <c:v>7662.03662109375</c:v>
                </c:pt>
                <c:pt idx="324">
                  <c:v>7734.642578125</c:v>
                </c:pt>
                <c:pt idx="325">
                  <c:v>7831.06494140625</c:v>
                </c:pt>
                <c:pt idx="326">
                  <c:v>7879.67919921875</c:v>
                </c:pt>
                <c:pt idx="327">
                  <c:v>7840.11279296875</c:v>
                </c:pt>
                <c:pt idx="328">
                  <c:v>7735.9384765625</c:v>
                </c:pt>
                <c:pt idx="329">
                  <c:v>7640.50634765625</c:v>
                </c:pt>
                <c:pt idx="330">
                  <c:v>7625.068359375</c:v>
                </c:pt>
                <c:pt idx="331">
                  <c:v>7707.15625</c:v>
                </c:pt>
                <c:pt idx="332">
                  <c:v>7837.32275390625</c:v>
                </c:pt>
                <c:pt idx="333">
                  <c:v>7933.7275390625</c:v>
                </c:pt>
                <c:pt idx="334">
                  <c:v>7938.73828125</c:v>
                </c:pt>
                <c:pt idx="335">
                  <c:v>7856.5419921875</c:v>
                </c:pt>
                <c:pt idx="336">
                  <c:v>7746.3642578125</c:v>
                </c:pt>
                <c:pt idx="337">
                  <c:v>7679.12939453125</c:v>
                </c:pt>
                <c:pt idx="338">
                  <c:v>7690.64306640625</c:v>
                </c:pt>
                <c:pt idx="339">
                  <c:v>7763.5751953125</c:v>
                </c:pt>
                <c:pt idx="340">
                  <c:v>7846.69140625</c:v>
                </c:pt>
                <c:pt idx="341">
                  <c:v>7892.72021484375</c:v>
                </c:pt>
                <c:pt idx="342">
                  <c:v>7886.23583984375</c:v>
                </c:pt>
                <c:pt idx="343">
                  <c:v>7844.9169921875</c:v>
                </c:pt>
                <c:pt idx="344">
                  <c:v>7799.43310546875</c:v>
                </c:pt>
                <c:pt idx="345">
                  <c:v>7771.0703125</c:v>
                </c:pt>
                <c:pt idx="346">
                  <c:v>7763.0888671875</c:v>
                </c:pt>
                <c:pt idx="347">
                  <c:v>7767.41015625</c:v>
                </c:pt>
                <c:pt idx="348">
                  <c:v>7776.11083984375</c:v>
                </c:pt>
                <c:pt idx="349">
                  <c:v>7786.640625</c:v>
                </c:pt>
              </c:numCache>
            </c:numRef>
          </c:yVal>
          <c:smooth val="1"/>
          <c:extLst>
            <c:ext xmlns:c16="http://schemas.microsoft.com/office/drawing/2014/chart" uri="{C3380CC4-5D6E-409C-BE32-E72D297353CC}">
              <c16:uniqueId val="{00000015-4A37-429A-A58F-F7AEDA5D1ACA}"/>
            </c:ext>
          </c:extLst>
        </c:ser>
        <c:ser>
          <c:idx val="22"/>
          <c:order val="22"/>
          <c:tx>
            <c:strRef>
              <c:f>cp_sub_001!$W$1</c:f>
              <c:strCache>
                <c:ptCount val="1"/>
                <c:pt idx="0">
                  <c:v>Coor_23</c:v>
                </c:pt>
              </c:strCache>
            </c:strRef>
          </c:tx>
          <c:spPr>
            <a:ln w="28575" cap="rnd">
              <a:solidFill>
                <a:schemeClr val="accent5">
                  <a:lumMod val="80000"/>
                </a:schemeClr>
              </a:solidFill>
              <a:round/>
            </a:ln>
            <a:effectLst/>
          </c:spPr>
          <c:marker>
            <c:symbol val="none"/>
          </c:marker>
          <c:yVal>
            <c:numRef>
              <c:f>cp_sub_001!$W$2:$W$351</c:f>
              <c:numCache>
                <c:formatCode>0.00000000000_ </c:formatCode>
                <c:ptCount val="350"/>
                <c:pt idx="0">
                  <c:v>4882.9560546875</c:v>
                </c:pt>
                <c:pt idx="1">
                  <c:v>4863.93701171875</c:v>
                </c:pt>
                <c:pt idx="2">
                  <c:v>4841.14013671875</c:v>
                </c:pt>
                <c:pt idx="3">
                  <c:v>4821.81396484375</c:v>
                </c:pt>
                <c:pt idx="4">
                  <c:v>4811.2265625</c:v>
                </c:pt>
                <c:pt idx="5">
                  <c:v>4812.08056640625</c:v>
                </c:pt>
                <c:pt idx="6">
                  <c:v>4825.224609375</c:v>
                </c:pt>
                <c:pt idx="7">
                  <c:v>4850.1396484375</c:v>
                </c:pt>
                <c:pt idx="8">
                  <c:v>4884.25537109375</c:v>
                </c:pt>
                <c:pt idx="9">
                  <c:v>4921.69775390625</c:v>
                </c:pt>
                <c:pt idx="10">
                  <c:v>4953.2763671875</c:v>
                </c:pt>
                <c:pt idx="11">
                  <c:v>4969.30224609375</c:v>
                </c:pt>
                <c:pt idx="12">
                  <c:v>4964.8681640625</c:v>
                </c:pt>
                <c:pt idx="13">
                  <c:v>4944.63134765625</c:v>
                </c:pt>
                <c:pt idx="14">
                  <c:v>4922.94921875</c:v>
                </c:pt>
                <c:pt idx="15">
                  <c:v>4917.13525390625</c:v>
                </c:pt>
                <c:pt idx="16">
                  <c:v>4936.25439453125</c:v>
                </c:pt>
                <c:pt idx="17">
                  <c:v>4972.4130859375</c:v>
                </c:pt>
                <c:pt idx="18">
                  <c:v>5001.888671875</c:v>
                </c:pt>
                <c:pt idx="19">
                  <c:v>4998.05712890625</c:v>
                </c:pt>
                <c:pt idx="20">
                  <c:v>4949.482421875</c:v>
                </c:pt>
                <c:pt idx="21">
                  <c:v>4870.93896484375</c:v>
                </c:pt>
                <c:pt idx="22">
                  <c:v>4797.904296875</c:v>
                </c:pt>
                <c:pt idx="23">
                  <c:v>4765.77685546875</c:v>
                </c:pt>
                <c:pt idx="24">
                  <c:v>4786.7998046875</c:v>
                </c:pt>
                <c:pt idx="25">
                  <c:v>4841.16796875</c:v>
                </c:pt>
                <c:pt idx="26">
                  <c:v>4890.02001953125</c:v>
                </c:pt>
                <c:pt idx="27">
                  <c:v>4902.287109375</c:v>
                </c:pt>
                <c:pt idx="28">
                  <c:v>4876.318359375</c:v>
                </c:pt>
                <c:pt idx="29">
                  <c:v>4840.03564453125</c:v>
                </c:pt>
                <c:pt idx="30">
                  <c:v>4829.03125</c:v>
                </c:pt>
                <c:pt idx="31">
                  <c:v>4858.93896484375</c:v>
                </c:pt>
                <c:pt idx="32">
                  <c:v>4913.1982421875</c:v>
                </c:pt>
                <c:pt idx="33">
                  <c:v>4955.6279296875</c:v>
                </c:pt>
                <c:pt idx="34">
                  <c:v>4957.84228515625</c:v>
                </c:pt>
                <c:pt idx="35">
                  <c:v>4919.9130859375</c:v>
                </c:pt>
                <c:pt idx="36">
                  <c:v>4868.4248046875</c:v>
                </c:pt>
                <c:pt idx="37">
                  <c:v>4834.5546875</c:v>
                </c:pt>
                <c:pt idx="38">
                  <c:v>4830.90087890625</c:v>
                </c:pt>
                <c:pt idx="39">
                  <c:v>4845.93115234375</c:v>
                </c:pt>
                <c:pt idx="40">
                  <c:v>4859.15869140625</c:v>
                </c:pt>
                <c:pt idx="41">
                  <c:v>4861.98291015625</c:v>
                </c:pt>
                <c:pt idx="42">
                  <c:v>4864.5107421875</c:v>
                </c:pt>
                <c:pt idx="43">
                  <c:v>4881.88134765625</c:v>
                </c:pt>
                <c:pt idx="44">
                  <c:v>4913.1923828125</c:v>
                </c:pt>
                <c:pt idx="45">
                  <c:v>4934.4091796875</c:v>
                </c:pt>
                <c:pt idx="46">
                  <c:v>4915.29443359375</c:v>
                </c:pt>
                <c:pt idx="47">
                  <c:v>4848.32763671875</c:v>
                </c:pt>
                <c:pt idx="48">
                  <c:v>4764.20263671875</c:v>
                </c:pt>
                <c:pt idx="49">
                  <c:v>4716.82373046875</c:v>
                </c:pt>
                <c:pt idx="50">
                  <c:v>4745.494140625</c:v>
                </c:pt>
                <c:pt idx="51">
                  <c:v>4842.876953125</c:v>
                </c:pt>
                <c:pt idx="52">
                  <c:v>4955.69775390625</c:v>
                </c:pt>
                <c:pt idx="53">
                  <c:v>5020.56298828125</c:v>
                </c:pt>
                <c:pt idx="54">
                  <c:v>5008.8232421875</c:v>
                </c:pt>
                <c:pt idx="55">
                  <c:v>4945.779296875</c:v>
                </c:pt>
                <c:pt idx="56">
                  <c:v>4888.8349609375</c:v>
                </c:pt>
                <c:pt idx="57">
                  <c:v>4881.662109375</c:v>
                </c:pt>
                <c:pt idx="58">
                  <c:v>4920.76953125</c:v>
                </c:pt>
                <c:pt idx="59">
                  <c:v>4960.94970703125</c:v>
                </c:pt>
                <c:pt idx="60">
                  <c:v>4954.6455078125</c:v>
                </c:pt>
                <c:pt idx="61">
                  <c:v>4892.86767578125</c:v>
                </c:pt>
                <c:pt idx="62">
                  <c:v>4814.296875</c:v>
                </c:pt>
                <c:pt idx="63">
                  <c:v>4775.376953125</c:v>
                </c:pt>
                <c:pt idx="64">
                  <c:v>4805.91162109375</c:v>
                </c:pt>
                <c:pt idx="65">
                  <c:v>4886.02392578125</c:v>
                </c:pt>
                <c:pt idx="66">
                  <c:v>4962.37890625</c:v>
                </c:pt>
                <c:pt idx="67">
                  <c:v>4989.595703125</c:v>
                </c:pt>
                <c:pt idx="68">
                  <c:v>4963.1787109375</c:v>
                </c:pt>
                <c:pt idx="69">
                  <c:v>4918.56005859375</c:v>
                </c:pt>
                <c:pt idx="70">
                  <c:v>4899.19873046875</c:v>
                </c:pt>
                <c:pt idx="71">
                  <c:v>4921.1708984375</c:v>
                </c:pt>
                <c:pt idx="72">
                  <c:v>4962.6181640625</c:v>
                </c:pt>
                <c:pt idx="73">
                  <c:v>4984.40673828125</c:v>
                </c:pt>
                <c:pt idx="74">
                  <c:v>4962.765625</c:v>
                </c:pt>
                <c:pt idx="75">
                  <c:v>4906.72900390625</c:v>
                </c:pt>
                <c:pt idx="76">
                  <c:v>4848.041015625</c:v>
                </c:pt>
                <c:pt idx="77">
                  <c:v>4814.78564453125</c:v>
                </c:pt>
                <c:pt idx="78">
                  <c:v>4811.9833984375</c:v>
                </c:pt>
                <c:pt idx="79">
                  <c:v>4823.78955078125</c:v>
                </c:pt>
                <c:pt idx="80">
                  <c:v>4831.93359375</c:v>
                </c:pt>
                <c:pt idx="81">
                  <c:v>4831.837890625</c:v>
                </c:pt>
                <c:pt idx="82">
                  <c:v>4832.33642578125</c:v>
                </c:pt>
                <c:pt idx="83">
                  <c:v>4841.5673828125</c:v>
                </c:pt>
                <c:pt idx="84">
                  <c:v>4854.494140625</c:v>
                </c:pt>
                <c:pt idx="85">
                  <c:v>4855.1171875</c:v>
                </c:pt>
                <c:pt idx="86">
                  <c:v>4831.703125</c:v>
                </c:pt>
                <c:pt idx="87">
                  <c:v>4790.47705078125</c:v>
                </c:pt>
                <c:pt idx="88">
                  <c:v>4754.26904296875</c:v>
                </c:pt>
                <c:pt idx="89">
                  <c:v>4746.36328125</c:v>
                </c:pt>
                <c:pt idx="90">
                  <c:v>4773.4482421875</c:v>
                </c:pt>
                <c:pt idx="91">
                  <c:v>4822.416015625</c:v>
                </c:pt>
                <c:pt idx="92">
                  <c:v>4873.10791015625</c:v>
                </c:pt>
                <c:pt idx="93">
                  <c:v>4914.76220703125</c:v>
                </c:pt>
                <c:pt idx="94">
                  <c:v>4951.072265625</c:v>
                </c:pt>
                <c:pt idx="95">
                  <c:v>4990.0322265625</c:v>
                </c:pt>
                <c:pt idx="96">
                  <c:v>5029.48095703125</c:v>
                </c:pt>
                <c:pt idx="97">
                  <c:v>5053.61767578125</c:v>
                </c:pt>
                <c:pt idx="98">
                  <c:v>5045.392578125</c:v>
                </c:pt>
                <c:pt idx="99">
                  <c:v>5004.03125</c:v>
                </c:pt>
                <c:pt idx="100">
                  <c:v>4950.6982421875</c:v>
                </c:pt>
                <c:pt idx="101">
                  <c:v>4914.876953125</c:v>
                </c:pt>
                <c:pt idx="102">
                  <c:v>4911.40869140625</c:v>
                </c:pt>
                <c:pt idx="103">
                  <c:v>4927.67578125</c:v>
                </c:pt>
                <c:pt idx="104">
                  <c:v>4932.9931640625</c:v>
                </c:pt>
                <c:pt idx="105">
                  <c:v>4903.68603515625</c:v>
                </c:pt>
                <c:pt idx="106">
                  <c:v>4843.56689453125</c:v>
                </c:pt>
                <c:pt idx="107">
                  <c:v>4782.74267578125</c:v>
                </c:pt>
                <c:pt idx="108">
                  <c:v>4755.4560546875</c:v>
                </c:pt>
                <c:pt idx="109">
                  <c:v>4774.873046875</c:v>
                </c:pt>
                <c:pt idx="110">
                  <c:v>4824.810546875</c:v>
                </c:pt>
                <c:pt idx="111">
                  <c:v>4873.8701171875</c:v>
                </c:pt>
                <c:pt idx="112">
                  <c:v>4899.09814453125</c:v>
                </c:pt>
                <c:pt idx="113">
                  <c:v>4899.69970703125</c:v>
                </c:pt>
                <c:pt idx="114">
                  <c:v>4891.4091796875</c:v>
                </c:pt>
                <c:pt idx="115">
                  <c:v>4889.1875</c:v>
                </c:pt>
                <c:pt idx="116">
                  <c:v>4894.76513671875</c:v>
                </c:pt>
                <c:pt idx="117">
                  <c:v>4899.13232421875</c:v>
                </c:pt>
                <c:pt idx="118">
                  <c:v>4895.2646484375</c:v>
                </c:pt>
                <c:pt idx="119">
                  <c:v>4887.193359375</c:v>
                </c:pt>
                <c:pt idx="120">
                  <c:v>4886.18603515625</c:v>
                </c:pt>
                <c:pt idx="121">
                  <c:v>4898.19189453125</c:v>
                </c:pt>
                <c:pt idx="122">
                  <c:v>4915.73828125</c:v>
                </c:pt>
                <c:pt idx="123">
                  <c:v>4923.30517578125</c:v>
                </c:pt>
                <c:pt idx="124">
                  <c:v>4911.8369140625</c:v>
                </c:pt>
                <c:pt idx="125">
                  <c:v>4888.3720703125</c:v>
                </c:pt>
                <c:pt idx="126">
                  <c:v>4870.55859375</c:v>
                </c:pt>
                <c:pt idx="127">
                  <c:v>4870.0810546875</c:v>
                </c:pt>
                <c:pt idx="128">
                  <c:v>4880.46533203125</c:v>
                </c:pt>
                <c:pt idx="129">
                  <c:v>4881.9609375</c:v>
                </c:pt>
                <c:pt idx="130">
                  <c:v>4860.73095703125</c:v>
                </c:pt>
                <c:pt idx="131">
                  <c:v>4825.224609375</c:v>
                </c:pt>
                <c:pt idx="132">
                  <c:v>4803.18017578125</c:v>
                </c:pt>
                <c:pt idx="133">
                  <c:v>4819.0703125</c:v>
                </c:pt>
                <c:pt idx="134">
                  <c:v>4870.205078125</c:v>
                </c:pt>
                <c:pt idx="135">
                  <c:v>4923.326171875</c:v>
                </c:pt>
                <c:pt idx="136">
                  <c:v>4937.73779296875</c:v>
                </c:pt>
                <c:pt idx="137">
                  <c:v>4898.2705078125</c:v>
                </c:pt>
                <c:pt idx="138">
                  <c:v>4831.17138671875</c:v>
                </c:pt>
                <c:pt idx="139">
                  <c:v>4788.0927734375</c:v>
                </c:pt>
                <c:pt idx="140">
                  <c:v>4808.6708984375</c:v>
                </c:pt>
                <c:pt idx="141">
                  <c:v>4890.05517578125</c:v>
                </c:pt>
                <c:pt idx="142">
                  <c:v>4987.13232421875</c:v>
                </c:pt>
                <c:pt idx="143">
                  <c:v>5043.46826171875</c:v>
                </c:pt>
                <c:pt idx="144">
                  <c:v>5029.421875</c:v>
                </c:pt>
                <c:pt idx="145">
                  <c:v>4959.30078125</c:v>
                </c:pt>
                <c:pt idx="146">
                  <c:v>4876.90283203125</c:v>
                </c:pt>
                <c:pt idx="147">
                  <c:v>4823.275390625</c:v>
                </c:pt>
                <c:pt idx="148">
                  <c:v>4812.220703125</c:v>
                </c:pt>
                <c:pt idx="149">
                  <c:v>4829.7275390625</c:v>
                </c:pt>
                <c:pt idx="150">
                  <c:v>4852.712890625</c:v>
                </c:pt>
                <c:pt idx="151">
                  <c:v>4868.29736328125</c:v>
                </c:pt>
                <c:pt idx="152">
                  <c:v>4878.16162109375</c:v>
                </c:pt>
                <c:pt idx="153">
                  <c:v>4888.31396484375</c:v>
                </c:pt>
                <c:pt idx="154">
                  <c:v>4897.63232421875</c:v>
                </c:pt>
                <c:pt idx="155">
                  <c:v>4897.51708984375</c:v>
                </c:pt>
                <c:pt idx="156">
                  <c:v>4882.32958984375</c:v>
                </c:pt>
                <c:pt idx="157">
                  <c:v>4858.8525390625</c:v>
                </c:pt>
                <c:pt idx="158">
                  <c:v>4843.81787109375</c:v>
                </c:pt>
                <c:pt idx="159">
                  <c:v>4850.48583984375</c:v>
                </c:pt>
                <c:pt idx="160">
                  <c:v>4876.5517578125</c:v>
                </c:pt>
                <c:pt idx="161">
                  <c:v>4905.23779296875</c:v>
                </c:pt>
                <c:pt idx="162">
                  <c:v>4919.384765625</c:v>
                </c:pt>
                <c:pt idx="163">
                  <c:v>4915.9794921875</c:v>
                </c:pt>
                <c:pt idx="164">
                  <c:v>4907.6875</c:v>
                </c:pt>
                <c:pt idx="165">
                  <c:v>4909.79541015625</c:v>
                </c:pt>
                <c:pt idx="166">
                  <c:v>4924.72412109375</c:v>
                </c:pt>
                <c:pt idx="167">
                  <c:v>4938.951171875</c:v>
                </c:pt>
                <c:pt idx="168">
                  <c:v>4935.86865234375</c:v>
                </c:pt>
                <c:pt idx="169">
                  <c:v>4912.89794921875</c:v>
                </c:pt>
                <c:pt idx="170">
                  <c:v>4886.33251953125</c:v>
                </c:pt>
                <c:pt idx="171">
                  <c:v>4877.98828125</c:v>
                </c:pt>
                <c:pt idx="172">
                  <c:v>4894.7314453125</c:v>
                </c:pt>
                <c:pt idx="173">
                  <c:v>4919.77294921875</c:v>
                </c:pt>
                <c:pt idx="174">
                  <c:v>4925.3388671875</c:v>
                </c:pt>
                <c:pt idx="175">
                  <c:v>4897.359375</c:v>
                </c:pt>
                <c:pt idx="176">
                  <c:v>4850.8271484375</c:v>
                </c:pt>
                <c:pt idx="177">
                  <c:v>4820.8427734375</c:v>
                </c:pt>
                <c:pt idx="178">
                  <c:v>4834.6142578125</c:v>
                </c:pt>
                <c:pt idx="179">
                  <c:v>4886.78662109375</c:v>
                </c:pt>
                <c:pt idx="180">
                  <c:v>4939.3681640625</c:v>
                </c:pt>
                <c:pt idx="181">
                  <c:v>4948.25146484375</c:v>
                </c:pt>
                <c:pt idx="182">
                  <c:v>4896.5634765625</c:v>
                </c:pt>
                <c:pt idx="183">
                  <c:v>4808.8974609375</c:v>
                </c:pt>
                <c:pt idx="184">
                  <c:v>4735.18212890625</c:v>
                </c:pt>
                <c:pt idx="185">
                  <c:v>4716.5078125</c:v>
                </c:pt>
                <c:pt idx="186">
                  <c:v>4758.5673828125</c:v>
                </c:pt>
                <c:pt idx="187">
                  <c:v>4831.25439453125</c:v>
                </c:pt>
                <c:pt idx="188">
                  <c:v>4892.123046875</c:v>
                </c:pt>
                <c:pt idx="189">
                  <c:v>4914.2421875</c:v>
                </c:pt>
                <c:pt idx="190">
                  <c:v>4898.57958984375</c:v>
                </c:pt>
                <c:pt idx="191">
                  <c:v>4865.802734375</c:v>
                </c:pt>
                <c:pt idx="192">
                  <c:v>4838.52392578125</c:v>
                </c:pt>
                <c:pt idx="193">
                  <c:v>4829.3310546875</c:v>
                </c:pt>
                <c:pt idx="194">
                  <c:v>4840.8427734375</c:v>
                </c:pt>
                <c:pt idx="195">
                  <c:v>4871.75927734375</c:v>
                </c:pt>
                <c:pt idx="196">
                  <c:v>4919.150390625</c:v>
                </c:pt>
                <c:pt idx="197">
                  <c:v>4974.40087890625</c:v>
                </c:pt>
                <c:pt idx="198">
                  <c:v>5019.82763671875</c:v>
                </c:pt>
                <c:pt idx="199">
                  <c:v>5034.3896484375</c:v>
                </c:pt>
                <c:pt idx="200">
                  <c:v>5007.97412109375</c:v>
                </c:pt>
                <c:pt idx="201">
                  <c:v>4953.04345703125</c:v>
                </c:pt>
                <c:pt idx="202">
                  <c:v>4901.2021484375</c:v>
                </c:pt>
                <c:pt idx="203">
                  <c:v>4883.42431640625</c:v>
                </c:pt>
                <c:pt idx="204">
                  <c:v>4907.30859375</c:v>
                </c:pt>
                <c:pt idx="205">
                  <c:v>4949.56982421875</c:v>
                </c:pt>
                <c:pt idx="206">
                  <c:v>4971.47119140625</c:v>
                </c:pt>
                <c:pt idx="207">
                  <c:v>4946.85400390625</c:v>
                </c:pt>
                <c:pt idx="208">
                  <c:v>4881.716796875</c:v>
                </c:pt>
                <c:pt idx="209">
                  <c:v>4810.34375</c:v>
                </c:pt>
                <c:pt idx="210">
                  <c:v>4771.15576171875</c:v>
                </c:pt>
                <c:pt idx="211">
                  <c:v>4781.009765625</c:v>
                </c:pt>
                <c:pt idx="212">
                  <c:v>4826.986328125</c:v>
                </c:pt>
                <c:pt idx="213">
                  <c:v>4879.98681640625</c:v>
                </c:pt>
                <c:pt idx="214">
                  <c:v>4917.2666015625</c:v>
                </c:pt>
                <c:pt idx="215">
                  <c:v>4935.451171875</c:v>
                </c:pt>
                <c:pt idx="216">
                  <c:v>4945.33642578125</c:v>
                </c:pt>
                <c:pt idx="217">
                  <c:v>4955.7158203125</c:v>
                </c:pt>
                <c:pt idx="218">
                  <c:v>4961.85693359375</c:v>
                </c:pt>
                <c:pt idx="219">
                  <c:v>4948.70703125</c:v>
                </c:pt>
                <c:pt idx="220">
                  <c:v>4905.26708984375</c:v>
                </c:pt>
                <c:pt idx="221">
                  <c:v>4837.06103515625</c:v>
                </c:pt>
                <c:pt idx="222">
                  <c:v>4766.04443359375</c:v>
                </c:pt>
                <c:pt idx="223">
                  <c:v>4718.408203125</c:v>
                </c:pt>
                <c:pt idx="224">
                  <c:v>4710.3427734375</c:v>
                </c:pt>
                <c:pt idx="225">
                  <c:v>4741.85107421875</c:v>
                </c:pt>
                <c:pt idx="226">
                  <c:v>4800.48828125</c:v>
                </c:pt>
                <c:pt idx="227">
                  <c:v>4868.84326171875</c:v>
                </c:pt>
                <c:pt idx="228">
                  <c:v>4928.98388671875</c:v>
                </c:pt>
                <c:pt idx="229">
                  <c:v>4963.3447265625</c:v>
                </c:pt>
                <c:pt idx="230">
                  <c:v>4957.171875</c:v>
                </c:pt>
                <c:pt idx="231">
                  <c:v>4906.1962890625</c:v>
                </c:pt>
                <c:pt idx="232">
                  <c:v>4825.6025390625</c:v>
                </c:pt>
                <c:pt idx="233">
                  <c:v>4750.69140625</c:v>
                </c:pt>
                <c:pt idx="234">
                  <c:v>4722.947265625</c:v>
                </c:pt>
                <c:pt idx="235">
                  <c:v>4766.5712890625</c:v>
                </c:pt>
                <c:pt idx="236">
                  <c:v>4870.61962890625</c:v>
                </c:pt>
                <c:pt idx="237">
                  <c:v>4991.03662109375</c:v>
                </c:pt>
                <c:pt idx="238">
                  <c:v>5074.03125</c:v>
                </c:pt>
                <c:pt idx="239">
                  <c:v>5086.642578125</c:v>
                </c:pt>
                <c:pt idx="240">
                  <c:v>5034.41064453125</c:v>
                </c:pt>
                <c:pt idx="241">
                  <c:v>4954.88671875</c:v>
                </c:pt>
                <c:pt idx="242">
                  <c:v>4892.6767578125</c:v>
                </c:pt>
                <c:pt idx="243">
                  <c:v>4873.8212890625</c:v>
                </c:pt>
                <c:pt idx="244">
                  <c:v>4895.7021484375</c:v>
                </c:pt>
                <c:pt idx="245">
                  <c:v>4935.77001953125</c:v>
                </c:pt>
                <c:pt idx="246">
                  <c:v>4969.06640625</c:v>
                </c:pt>
                <c:pt idx="247">
                  <c:v>4980.939453125</c:v>
                </c:pt>
                <c:pt idx="248">
                  <c:v>4968.669921875</c:v>
                </c:pt>
                <c:pt idx="249">
                  <c:v>4936.052734375</c:v>
                </c:pt>
                <c:pt idx="250">
                  <c:v>4889.18896484375</c:v>
                </c:pt>
                <c:pt idx="251">
                  <c:v>4837.2041015625</c:v>
                </c:pt>
                <c:pt idx="252">
                  <c:v>4794.13232421875</c:v>
                </c:pt>
                <c:pt idx="253">
                  <c:v>4775.748046875</c:v>
                </c:pt>
                <c:pt idx="254">
                  <c:v>4790.32421875</c:v>
                </c:pt>
                <c:pt idx="255">
                  <c:v>4829.97216796875</c:v>
                </c:pt>
                <c:pt idx="256">
                  <c:v>4871.43017578125</c:v>
                </c:pt>
                <c:pt idx="257">
                  <c:v>4888.81298828125</c:v>
                </c:pt>
                <c:pt idx="258">
                  <c:v>4870.73486328125</c:v>
                </c:pt>
                <c:pt idx="259">
                  <c:v>4829.2431640625</c:v>
                </c:pt>
                <c:pt idx="260">
                  <c:v>4792.9794921875</c:v>
                </c:pt>
                <c:pt idx="261">
                  <c:v>4788.51171875</c:v>
                </c:pt>
                <c:pt idx="262">
                  <c:v>4822.75048828125</c:v>
                </c:pt>
                <c:pt idx="263">
                  <c:v>4878.6728515625</c:v>
                </c:pt>
                <c:pt idx="264">
                  <c:v>4926.8369140625</c:v>
                </c:pt>
                <c:pt idx="265">
                  <c:v>4944.1064453125</c:v>
                </c:pt>
                <c:pt idx="266">
                  <c:v>4926.82861328125</c:v>
                </c:pt>
                <c:pt idx="267">
                  <c:v>4890.8369140625</c:v>
                </c:pt>
                <c:pt idx="268">
                  <c:v>4860.23828125</c:v>
                </c:pt>
                <c:pt idx="269">
                  <c:v>4853.607421875</c:v>
                </c:pt>
                <c:pt idx="270">
                  <c:v>4875.876953125</c:v>
                </c:pt>
                <c:pt idx="271">
                  <c:v>4918.69140625</c:v>
                </c:pt>
                <c:pt idx="272">
                  <c:v>4966.3857421875</c:v>
                </c:pt>
                <c:pt idx="273">
                  <c:v>5002.8515625</c:v>
                </c:pt>
                <c:pt idx="274">
                  <c:v>5016.28271484375</c:v>
                </c:pt>
                <c:pt idx="275">
                  <c:v>5001.38330078125</c:v>
                </c:pt>
                <c:pt idx="276">
                  <c:v>4959.81689453125</c:v>
                </c:pt>
                <c:pt idx="277">
                  <c:v>4899.40966796875</c:v>
                </c:pt>
                <c:pt idx="278">
                  <c:v>4832.26416015625</c:v>
                </c:pt>
                <c:pt idx="279">
                  <c:v>4772.2138671875</c:v>
                </c:pt>
                <c:pt idx="280">
                  <c:v>4732.33447265625</c:v>
                </c:pt>
                <c:pt idx="281">
                  <c:v>4722.7392578125</c:v>
                </c:pt>
                <c:pt idx="282">
                  <c:v>4748.03125</c:v>
                </c:pt>
                <c:pt idx="283">
                  <c:v>4804.09375</c:v>
                </c:pt>
                <c:pt idx="284">
                  <c:v>4875.8408203125</c:v>
                </c:pt>
                <c:pt idx="285">
                  <c:v>4939.3662109375</c:v>
                </c:pt>
                <c:pt idx="286">
                  <c:v>4970.7822265625</c:v>
                </c:pt>
                <c:pt idx="287">
                  <c:v>4959.146484375</c:v>
                </c:pt>
                <c:pt idx="288">
                  <c:v>4915.4931640625</c:v>
                </c:pt>
                <c:pt idx="289">
                  <c:v>4869.59521484375</c:v>
                </c:pt>
                <c:pt idx="290">
                  <c:v>4853.09130859375</c:v>
                </c:pt>
                <c:pt idx="291">
                  <c:v>4878.29248046875</c:v>
                </c:pt>
                <c:pt idx="292">
                  <c:v>4927.76904296875</c:v>
                </c:pt>
                <c:pt idx="293">
                  <c:v>4964.423828125</c:v>
                </c:pt>
                <c:pt idx="294">
                  <c:v>4957.3232421875</c:v>
                </c:pt>
                <c:pt idx="295">
                  <c:v>4905.45556640625</c:v>
                </c:pt>
                <c:pt idx="296">
                  <c:v>4840.95849609375</c:v>
                </c:pt>
                <c:pt idx="297">
                  <c:v>4807.42626953125</c:v>
                </c:pt>
                <c:pt idx="298">
                  <c:v>4828</c:v>
                </c:pt>
                <c:pt idx="299">
                  <c:v>4887.11865234375</c:v>
                </c:pt>
                <c:pt idx="300">
                  <c:v>4940.77490234375</c:v>
                </c:pt>
                <c:pt idx="301">
                  <c:v>4948.80419921875</c:v>
                </c:pt>
                <c:pt idx="302">
                  <c:v>4905.333984375</c:v>
                </c:pt>
                <c:pt idx="303">
                  <c:v>4844.07373046875</c:v>
                </c:pt>
                <c:pt idx="304">
                  <c:v>4813.8798828125</c:v>
                </c:pt>
                <c:pt idx="305">
                  <c:v>4842.7041015625</c:v>
                </c:pt>
                <c:pt idx="306">
                  <c:v>4916.95654296875</c:v>
                </c:pt>
                <c:pt idx="307">
                  <c:v>4991.4150390625</c:v>
                </c:pt>
                <c:pt idx="308">
                  <c:v>5021.5048828125</c:v>
                </c:pt>
                <c:pt idx="309">
                  <c:v>4993.35986328125</c:v>
                </c:pt>
                <c:pt idx="310">
                  <c:v>4930.0263671875</c:v>
                </c:pt>
                <c:pt idx="311">
                  <c:v>4871.43896484375</c:v>
                </c:pt>
                <c:pt idx="312">
                  <c:v>4845.51123046875</c:v>
                </c:pt>
                <c:pt idx="313">
                  <c:v>4852.517578125</c:v>
                </c:pt>
                <c:pt idx="314">
                  <c:v>4872.169921875</c:v>
                </c:pt>
                <c:pt idx="315">
                  <c:v>4884.0078125</c:v>
                </c:pt>
                <c:pt idx="316">
                  <c:v>4882.568359375</c:v>
                </c:pt>
                <c:pt idx="317">
                  <c:v>4875.82177734375</c:v>
                </c:pt>
                <c:pt idx="318">
                  <c:v>4871.3671875</c:v>
                </c:pt>
                <c:pt idx="319">
                  <c:v>4865.43603515625</c:v>
                </c:pt>
                <c:pt idx="320">
                  <c:v>4846.064453125</c:v>
                </c:pt>
                <c:pt idx="321">
                  <c:v>4807.7314453125</c:v>
                </c:pt>
                <c:pt idx="322">
                  <c:v>4763.20947265625</c:v>
                </c:pt>
                <c:pt idx="323">
                  <c:v>4739.78759765625</c:v>
                </c:pt>
                <c:pt idx="324">
                  <c:v>4760.373046875</c:v>
                </c:pt>
                <c:pt idx="325">
                  <c:v>4823.83837890625</c:v>
                </c:pt>
                <c:pt idx="326">
                  <c:v>4901.22705078125</c:v>
                </c:pt>
                <c:pt idx="327">
                  <c:v>4952.7373046875</c:v>
                </c:pt>
                <c:pt idx="328">
                  <c:v>4954.0390625</c:v>
                </c:pt>
                <c:pt idx="329">
                  <c:v>4912.6650390625</c:v>
                </c:pt>
                <c:pt idx="330">
                  <c:v>4862.2763671875</c:v>
                </c:pt>
                <c:pt idx="331">
                  <c:v>4838.99365234375</c:v>
                </c:pt>
                <c:pt idx="332">
                  <c:v>4856.990234375</c:v>
                </c:pt>
                <c:pt idx="333">
                  <c:v>4900.48681640625</c:v>
                </c:pt>
                <c:pt idx="334">
                  <c:v>4936.8486328125</c:v>
                </c:pt>
                <c:pt idx="335">
                  <c:v>4940.4423828125</c:v>
                </c:pt>
                <c:pt idx="336">
                  <c:v>4910.23876953125</c:v>
                </c:pt>
                <c:pt idx="337">
                  <c:v>4869.7900390625</c:v>
                </c:pt>
                <c:pt idx="338">
                  <c:v>4850.95361328125</c:v>
                </c:pt>
                <c:pt idx="339">
                  <c:v>4873.1533203125</c:v>
                </c:pt>
                <c:pt idx="340">
                  <c:v>4931.458984375</c:v>
                </c:pt>
                <c:pt idx="341">
                  <c:v>4999.79150390625</c:v>
                </c:pt>
                <c:pt idx="342">
                  <c:v>5045.8505859375</c:v>
                </c:pt>
                <c:pt idx="343">
                  <c:v>5048.2353515625</c:v>
                </c:pt>
                <c:pt idx="344">
                  <c:v>5006.43505859375</c:v>
                </c:pt>
                <c:pt idx="345">
                  <c:v>4939.40283203125</c:v>
                </c:pt>
                <c:pt idx="346">
                  <c:v>4874.7109375</c:v>
                </c:pt>
                <c:pt idx="347">
                  <c:v>4834.6201171875</c:v>
                </c:pt>
                <c:pt idx="348">
                  <c:v>4826.2578125</c:v>
                </c:pt>
                <c:pt idx="349">
                  <c:v>4840.51953125</c:v>
                </c:pt>
              </c:numCache>
            </c:numRef>
          </c:yVal>
          <c:smooth val="1"/>
          <c:extLst>
            <c:ext xmlns:c16="http://schemas.microsoft.com/office/drawing/2014/chart" uri="{C3380CC4-5D6E-409C-BE32-E72D297353CC}">
              <c16:uniqueId val="{00000016-4A37-429A-A58F-F7AEDA5D1ACA}"/>
            </c:ext>
          </c:extLst>
        </c:ser>
        <c:ser>
          <c:idx val="23"/>
          <c:order val="23"/>
          <c:tx>
            <c:strRef>
              <c:f>cp_sub_001!$X$1</c:f>
              <c:strCache>
                <c:ptCount val="1"/>
                <c:pt idx="0">
                  <c:v>Coor_24</c:v>
                </c:pt>
              </c:strCache>
            </c:strRef>
          </c:tx>
          <c:spPr>
            <a:ln w="28575" cap="rnd">
              <a:solidFill>
                <a:schemeClr val="accent6">
                  <a:lumMod val="80000"/>
                </a:schemeClr>
              </a:solidFill>
              <a:round/>
            </a:ln>
            <a:effectLst/>
          </c:spPr>
          <c:marker>
            <c:symbol val="none"/>
          </c:marker>
          <c:yVal>
            <c:numRef>
              <c:f>cp_sub_001!$X$2:$X$351</c:f>
              <c:numCache>
                <c:formatCode>0.00000000000_ </c:formatCode>
                <c:ptCount val="350"/>
                <c:pt idx="0">
                  <c:v>8293.0908203125</c:v>
                </c:pt>
                <c:pt idx="1">
                  <c:v>8299.185546875</c:v>
                </c:pt>
                <c:pt idx="2">
                  <c:v>8343.7841796875</c:v>
                </c:pt>
                <c:pt idx="3">
                  <c:v>8404.1611328125</c:v>
                </c:pt>
                <c:pt idx="4">
                  <c:v>8441.8603515625</c:v>
                </c:pt>
                <c:pt idx="5">
                  <c:v>8428.353515625</c:v>
                </c:pt>
                <c:pt idx="6">
                  <c:v>8367.4443359375</c:v>
                </c:pt>
                <c:pt idx="7">
                  <c:v>8297.3173828125</c:v>
                </c:pt>
                <c:pt idx="8">
                  <c:v>8268.4326171875</c:v>
                </c:pt>
                <c:pt idx="9">
                  <c:v>8310.7119140625</c:v>
                </c:pt>
                <c:pt idx="10">
                  <c:v>8412.037109375</c:v>
                </c:pt>
                <c:pt idx="11">
                  <c:v>8523.13671875</c:v>
                </c:pt>
                <c:pt idx="12">
                  <c:v>8586.275390625</c:v>
                </c:pt>
                <c:pt idx="13">
                  <c:v>8569.12109375</c:v>
                </c:pt>
                <c:pt idx="14">
                  <c:v>8482.173828125</c:v>
                </c:pt>
                <c:pt idx="15">
                  <c:v>8369.771484375</c:v>
                </c:pt>
                <c:pt idx="16">
                  <c:v>8282.2783203125</c:v>
                </c:pt>
                <c:pt idx="17">
                  <c:v>8248.2431640625</c:v>
                </c:pt>
                <c:pt idx="18">
                  <c:v>8263.1943359375</c:v>
                </c:pt>
                <c:pt idx="19">
                  <c:v>8299.2138671875</c:v>
                </c:pt>
                <c:pt idx="20">
                  <c:v>8326.05078125</c:v>
                </c:pt>
                <c:pt idx="21">
                  <c:v>8329.1455078125</c:v>
                </c:pt>
                <c:pt idx="22">
                  <c:v>8314.5556640625</c:v>
                </c:pt>
                <c:pt idx="23">
                  <c:v>8300.5537109375</c:v>
                </c:pt>
                <c:pt idx="24">
                  <c:v>8303.486328125</c:v>
                </c:pt>
                <c:pt idx="25">
                  <c:v>8327.1474609375</c:v>
                </c:pt>
                <c:pt idx="26">
                  <c:v>8361.0810546875</c:v>
                </c:pt>
                <c:pt idx="27">
                  <c:v>8387.51171875</c:v>
                </c:pt>
                <c:pt idx="28">
                  <c:v>8392.3232421875</c:v>
                </c:pt>
                <c:pt idx="29">
                  <c:v>8373.98046875</c:v>
                </c:pt>
                <c:pt idx="30">
                  <c:v>8345.474609375</c:v>
                </c:pt>
                <c:pt idx="31">
                  <c:v>8327.6767578125</c:v>
                </c:pt>
                <c:pt idx="32">
                  <c:v>8337.0947265625</c:v>
                </c:pt>
                <c:pt idx="33">
                  <c:v>8374.92578125</c:v>
                </c:pt>
                <c:pt idx="34">
                  <c:v>8424.8056640625</c:v>
                </c:pt>
                <c:pt idx="35">
                  <c:v>8462.0771484375</c:v>
                </c:pt>
                <c:pt idx="36">
                  <c:v>8469.63671875</c:v>
                </c:pt>
                <c:pt idx="37">
                  <c:v>8449.673828125</c:v>
                </c:pt>
                <c:pt idx="38">
                  <c:v>8422.1064453125</c:v>
                </c:pt>
                <c:pt idx="39">
                  <c:v>8409.564453125</c:v>
                </c:pt>
                <c:pt idx="40">
                  <c:v>8419.4794921875</c:v>
                </c:pt>
                <c:pt idx="41">
                  <c:v>8437.41015625</c:v>
                </c:pt>
                <c:pt idx="42">
                  <c:v>8438.177734375</c:v>
                </c:pt>
                <c:pt idx="43">
                  <c:v>8407.2919921875</c:v>
                </c:pt>
                <c:pt idx="44">
                  <c:v>8355.583984375</c:v>
                </c:pt>
                <c:pt idx="45">
                  <c:v>8313.69140625</c:v>
                </c:pt>
                <c:pt idx="46">
                  <c:v>8308.5771484375</c:v>
                </c:pt>
                <c:pt idx="47">
                  <c:v>8339.908203125</c:v>
                </c:pt>
                <c:pt idx="48">
                  <c:v>8376.5537109375</c:v>
                </c:pt>
                <c:pt idx="49">
                  <c:v>8378.974609375</c:v>
                </c:pt>
                <c:pt idx="50">
                  <c:v>8332.1259765625</c:v>
                </c:pt>
                <c:pt idx="51">
                  <c:v>8262.6220703125</c:v>
                </c:pt>
                <c:pt idx="52">
                  <c:v>8223.6533203125</c:v>
                </c:pt>
                <c:pt idx="53">
                  <c:v>8255.63671875</c:v>
                </c:pt>
                <c:pt idx="54">
                  <c:v>8351.298828125</c:v>
                </c:pt>
                <c:pt idx="55">
                  <c:v>8453.5859375</c:v>
                </c:pt>
                <c:pt idx="56">
                  <c:v>8491.82421875</c:v>
                </c:pt>
                <c:pt idx="57">
                  <c:v>8432.2900390625</c:v>
                </c:pt>
                <c:pt idx="58">
                  <c:v>8306.3427734375</c:v>
                </c:pt>
                <c:pt idx="59">
                  <c:v>8193.7001953125</c:v>
                </c:pt>
                <c:pt idx="60">
                  <c:v>8170.51513671875</c:v>
                </c:pt>
                <c:pt idx="61">
                  <c:v>8258.11328125</c:v>
                </c:pt>
                <c:pt idx="62">
                  <c:v>8408.48046875</c:v>
                </c:pt>
                <c:pt idx="63">
                  <c:v>8536.48828125</c:v>
                </c:pt>
                <c:pt idx="64">
                  <c:v>8575.61328125</c:v>
                </c:pt>
                <c:pt idx="65">
                  <c:v>8518.1484375</c:v>
                </c:pt>
                <c:pt idx="66">
                  <c:v>8413.6796875</c:v>
                </c:pt>
                <c:pt idx="67">
                  <c:v>8330.4267578125</c:v>
                </c:pt>
                <c:pt idx="68">
                  <c:v>8309.54296875</c:v>
                </c:pt>
                <c:pt idx="69">
                  <c:v>8344.3330078125</c:v>
                </c:pt>
                <c:pt idx="70">
                  <c:v>8395.0380859375</c:v>
                </c:pt>
                <c:pt idx="71">
                  <c:v>8423.142578125</c:v>
                </c:pt>
                <c:pt idx="72">
                  <c:v>8417.2919921875</c:v>
                </c:pt>
                <c:pt idx="73">
                  <c:v>8393.3876953125</c:v>
                </c:pt>
                <c:pt idx="74">
                  <c:v>8373.7822265625</c:v>
                </c:pt>
                <c:pt idx="75">
                  <c:v>8366.1845703125</c:v>
                </c:pt>
                <c:pt idx="76">
                  <c:v>8360.21875</c:v>
                </c:pt>
                <c:pt idx="77">
                  <c:v>8342.494140625</c:v>
                </c:pt>
                <c:pt idx="78">
                  <c:v>8314.7138671875</c:v>
                </c:pt>
                <c:pt idx="79">
                  <c:v>8297.287109375</c:v>
                </c:pt>
                <c:pt idx="80">
                  <c:v>8314.037109375</c:v>
                </c:pt>
                <c:pt idx="81">
                  <c:v>8370.359375</c:v>
                </c:pt>
                <c:pt idx="82">
                  <c:v>8443.4326171875</c:v>
                </c:pt>
                <c:pt idx="83">
                  <c:v>8493.888671875</c:v>
                </c:pt>
                <c:pt idx="84">
                  <c:v>8491.3056640625</c:v>
                </c:pt>
                <c:pt idx="85">
                  <c:v>8434.8447265625</c:v>
                </c:pt>
                <c:pt idx="86">
                  <c:v>8353.9013671875</c:v>
                </c:pt>
                <c:pt idx="87">
                  <c:v>8288.61328125</c:v>
                </c:pt>
                <c:pt idx="88">
                  <c:v>8264.6943359375</c:v>
                </c:pt>
                <c:pt idx="89">
                  <c:v>8280.2890625</c:v>
                </c:pt>
                <c:pt idx="90">
                  <c:v>8312.6240234375</c:v>
                </c:pt>
                <c:pt idx="91">
                  <c:v>8337.4326171875</c:v>
                </c:pt>
                <c:pt idx="92">
                  <c:v>8345.7197265625</c:v>
                </c:pt>
                <c:pt idx="93">
                  <c:v>8346.134765625</c:v>
                </c:pt>
                <c:pt idx="94">
                  <c:v>8353.1943359375</c:v>
                </c:pt>
                <c:pt idx="95">
                  <c:v>8372.2763671875</c:v>
                </c:pt>
                <c:pt idx="96">
                  <c:v>8393.8212890625</c:v>
                </c:pt>
                <c:pt idx="97">
                  <c:v>8401.1220703125</c:v>
                </c:pt>
                <c:pt idx="98">
                  <c:v>8385.1162109375</c:v>
                </c:pt>
                <c:pt idx="99">
                  <c:v>8354.208984375</c:v>
                </c:pt>
                <c:pt idx="100">
                  <c:v>8330.865234375</c:v>
                </c:pt>
                <c:pt idx="101">
                  <c:v>8336.7001953125</c:v>
                </c:pt>
                <c:pt idx="102">
                  <c:v>8376.3525390625</c:v>
                </c:pt>
                <c:pt idx="103">
                  <c:v>8431.712890625</c:v>
                </c:pt>
                <c:pt idx="104">
                  <c:v>8471.1669921875</c:v>
                </c:pt>
                <c:pt idx="105">
                  <c:v>8468.421875</c:v>
                </c:pt>
                <c:pt idx="106">
                  <c:v>8419.0361328125</c:v>
                </c:pt>
                <c:pt idx="107">
                  <c:v>8344.1826171875</c:v>
                </c:pt>
                <c:pt idx="108">
                  <c:v>8279.330078125</c:v>
                </c:pt>
                <c:pt idx="109">
                  <c:v>8254.9697265625</c:v>
                </c:pt>
                <c:pt idx="110">
                  <c:v>8281.04296875</c:v>
                </c:pt>
                <c:pt idx="111">
                  <c:v>8343.7578125</c:v>
                </c:pt>
                <c:pt idx="112">
                  <c:v>8415.259765625</c:v>
                </c:pt>
                <c:pt idx="113">
                  <c:v>8468.8701171875</c:v>
                </c:pt>
                <c:pt idx="114">
                  <c:v>8490.3779296875</c:v>
                </c:pt>
                <c:pt idx="115">
                  <c:v>8480.0498046875</c:v>
                </c:pt>
                <c:pt idx="116">
                  <c:v>8447.0673828125</c:v>
                </c:pt>
                <c:pt idx="117">
                  <c:v>8402.6181640625</c:v>
                </c:pt>
                <c:pt idx="118">
                  <c:v>8356.7998046875</c:v>
                </c:pt>
                <c:pt idx="119">
                  <c:v>8319.421875</c:v>
                </c:pt>
                <c:pt idx="120">
                  <c:v>8300.541015625</c:v>
                </c:pt>
                <c:pt idx="121">
                  <c:v>8306.9892578125</c:v>
                </c:pt>
                <c:pt idx="122">
                  <c:v>8336.03125</c:v>
                </c:pt>
                <c:pt idx="123">
                  <c:v>8372.037109375</c:v>
                </c:pt>
                <c:pt idx="124">
                  <c:v>8391.8056640625</c:v>
                </c:pt>
                <c:pt idx="125">
                  <c:v>8377.9375</c:v>
                </c:pt>
                <c:pt idx="126">
                  <c:v>8332.1533203125</c:v>
                </c:pt>
                <c:pt idx="127">
                  <c:v>8278.048828125</c:v>
                </c:pt>
                <c:pt idx="128">
                  <c:v>8248.869140625</c:v>
                </c:pt>
                <c:pt idx="129">
                  <c:v>8266.685546875</c:v>
                </c:pt>
                <c:pt idx="130">
                  <c:v>8326.87890625</c:v>
                </c:pt>
                <c:pt idx="131">
                  <c:v>8399.5439453125</c:v>
                </c:pt>
                <c:pt idx="132">
                  <c:v>8448.05078125</c:v>
                </c:pt>
                <c:pt idx="133">
                  <c:v>8452.5078125</c:v>
                </c:pt>
                <c:pt idx="134">
                  <c:v>8421.7880859375</c:v>
                </c:pt>
                <c:pt idx="135">
                  <c:v>8385.572265625</c:v>
                </c:pt>
                <c:pt idx="136">
                  <c:v>8372.2177734375</c:v>
                </c:pt>
                <c:pt idx="137">
                  <c:v>8388.478515625</c:v>
                </c:pt>
                <c:pt idx="138">
                  <c:v>8415.6220703125</c:v>
                </c:pt>
                <c:pt idx="139">
                  <c:v>8424.3564453125</c:v>
                </c:pt>
                <c:pt idx="140">
                  <c:v>8397.3330078125</c:v>
                </c:pt>
                <c:pt idx="141">
                  <c:v>8342.853515625</c:v>
                </c:pt>
                <c:pt idx="142">
                  <c:v>8290.2734375</c:v>
                </c:pt>
                <c:pt idx="143">
                  <c:v>8270.8828125</c:v>
                </c:pt>
                <c:pt idx="144">
                  <c:v>8297.91015625</c:v>
                </c:pt>
                <c:pt idx="145">
                  <c:v>8358.890625</c:v>
                </c:pt>
                <c:pt idx="146">
                  <c:v>8424.25390625</c:v>
                </c:pt>
                <c:pt idx="147">
                  <c:v>8465.0625</c:v>
                </c:pt>
                <c:pt idx="148">
                  <c:v>8468.064453125</c:v>
                </c:pt>
                <c:pt idx="149">
                  <c:v>8439.8330078125</c:v>
                </c:pt>
                <c:pt idx="150">
                  <c:v>8399.814453125</c:v>
                </c:pt>
                <c:pt idx="151">
                  <c:v>8368.44140625</c:v>
                </c:pt>
                <c:pt idx="152">
                  <c:v>8357.416015625</c:v>
                </c:pt>
                <c:pt idx="153">
                  <c:v>8366.0322265625</c:v>
                </c:pt>
                <c:pt idx="154">
                  <c:v>8383.4404296875</c:v>
                </c:pt>
                <c:pt idx="155">
                  <c:v>8394.6474609375</c:v>
                </c:pt>
                <c:pt idx="156">
                  <c:v>8387.7958984375</c:v>
                </c:pt>
                <c:pt idx="157">
                  <c:v>8360.2880859375</c:v>
                </c:pt>
                <c:pt idx="158">
                  <c:v>8321.0869140625</c:v>
                </c:pt>
                <c:pt idx="159">
                  <c:v>8287.181640625</c:v>
                </c:pt>
                <c:pt idx="160">
                  <c:v>8274.86328125</c:v>
                </c:pt>
                <c:pt idx="161">
                  <c:v>8290.216796875</c:v>
                </c:pt>
                <c:pt idx="162">
                  <c:v>8325.0517578125</c:v>
                </c:pt>
                <c:pt idx="163">
                  <c:v>8361.888671875</c:v>
                </c:pt>
                <c:pt idx="164">
                  <c:v>8385.3310546875</c:v>
                </c:pt>
                <c:pt idx="165">
                  <c:v>8391.876953125</c:v>
                </c:pt>
                <c:pt idx="166">
                  <c:v>8390.5654296875</c:v>
                </c:pt>
                <c:pt idx="167">
                  <c:v>8393.5859375</c:v>
                </c:pt>
                <c:pt idx="168">
                  <c:v>8404.2373046875</c:v>
                </c:pt>
                <c:pt idx="169">
                  <c:v>8412.546875</c:v>
                </c:pt>
                <c:pt idx="170">
                  <c:v>8403.2861328125</c:v>
                </c:pt>
                <c:pt idx="171">
                  <c:v>8370.7685546875</c:v>
                </c:pt>
                <c:pt idx="172">
                  <c:v>8328.078125</c:v>
                </c:pt>
                <c:pt idx="173">
                  <c:v>8301.4345703125</c:v>
                </c:pt>
                <c:pt idx="174">
                  <c:v>8311.79296875</c:v>
                </c:pt>
                <c:pt idx="175">
                  <c:v>8356.95703125</c:v>
                </c:pt>
                <c:pt idx="176">
                  <c:v>8409.0419921875</c:v>
                </c:pt>
                <c:pt idx="177">
                  <c:v>8431.7412109375</c:v>
                </c:pt>
                <c:pt idx="178">
                  <c:v>8406.666015625</c:v>
                </c:pt>
                <c:pt idx="179">
                  <c:v>8349.671875</c:v>
                </c:pt>
                <c:pt idx="180">
                  <c:v>8303.6923828125</c:v>
                </c:pt>
                <c:pt idx="181">
                  <c:v>8310.8916015625</c:v>
                </c:pt>
                <c:pt idx="182">
                  <c:v>8382.369140625</c:v>
                </c:pt>
                <c:pt idx="183">
                  <c:v>8486.6083984375</c:v>
                </c:pt>
                <c:pt idx="184">
                  <c:v>8565.810546875</c:v>
                </c:pt>
                <c:pt idx="185">
                  <c:v>8570.3388671875</c:v>
                </c:pt>
                <c:pt idx="186">
                  <c:v>8489.1748046875</c:v>
                </c:pt>
                <c:pt idx="187">
                  <c:v>8356.91015625</c:v>
                </c:pt>
                <c:pt idx="188">
                  <c:v>8233.482421875</c:v>
                </c:pt>
                <c:pt idx="189">
                  <c:v>8170.3720703125</c:v>
                </c:pt>
                <c:pt idx="190">
                  <c:v>8184.60693359375</c:v>
                </c:pt>
                <c:pt idx="191">
                  <c:v>8255.1796875</c:v>
                </c:pt>
                <c:pt idx="192">
                  <c:v>8341.0078125</c:v>
                </c:pt>
                <c:pt idx="193">
                  <c:v>8406.326171875</c:v>
                </c:pt>
                <c:pt idx="194">
                  <c:v>8436.88671875</c:v>
                </c:pt>
                <c:pt idx="195">
                  <c:v>8439.0205078125</c:v>
                </c:pt>
                <c:pt idx="196">
                  <c:v>8426.3212890625</c:v>
                </c:pt>
                <c:pt idx="197">
                  <c:v>8406.3408203125</c:v>
                </c:pt>
                <c:pt idx="198">
                  <c:v>8377.5146484375</c:v>
                </c:pt>
                <c:pt idx="199">
                  <c:v>8337.099609375</c:v>
                </c:pt>
                <c:pt idx="200">
                  <c:v>8291.7451171875</c:v>
                </c:pt>
                <c:pt idx="201">
                  <c:v>8260.1259765625</c:v>
                </c:pt>
                <c:pt idx="202">
                  <c:v>8263.4677734375</c:v>
                </c:pt>
                <c:pt idx="203">
                  <c:v>8309.806640625</c:v>
                </c:pt>
                <c:pt idx="204">
                  <c:v>8383.974609375</c:v>
                </c:pt>
                <c:pt idx="205">
                  <c:v>8452.55078125</c:v>
                </c:pt>
                <c:pt idx="206">
                  <c:v>8482.75</c:v>
                </c:pt>
                <c:pt idx="207">
                  <c:v>8463.533203125</c:v>
                </c:pt>
                <c:pt idx="208">
                  <c:v>8414.0380859375</c:v>
                </c:pt>
                <c:pt idx="209">
                  <c:v>8371.982421875</c:v>
                </c:pt>
                <c:pt idx="210">
                  <c:v>8368.423828125</c:v>
                </c:pt>
                <c:pt idx="211">
                  <c:v>8405.734375</c:v>
                </c:pt>
                <c:pt idx="212">
                  <c:v>8454.6953125</c:v>
                </c:pt>
                <c:pt idx="213">
                  <c:v>8473.9765625</c:v>
                </c:pt>
                <c:pt idx="214">
                  <c:v>8439.251953125</c:v>
                </c:pt>
                <c:pt idx="215">
                  <c:v>8361.4580078125</c:v>
                </c:pt>
                <c:pt idx="216">
                  <c:v>8280.5869140625</c:v>
                </c:pt>
                <c:pt idx="217">
                  <c:v>8238.7509765625</c:v>
                </c:pt>
                <c:pt idx="218">
                  <c:v>8251.6689453125</c:v>
                </c:pt>
                <c:pt idx="219">
                  <c:v>8299.4228515625</c:v>
                </c:pt>
                <c:pt idx="220">
                  <c:v>8343.3486328125</c:v>
                </c:pt>
                <c:pt idx="221">
                  <c:v>8356.29296875</c:v>
                </c:pt>
                <c:pt idx="222">
                  <c:v>8342.96875</c:v>
                </c:pt>
                <c:pt idx="223">
                  <c:v>8334.404296875</c:v>
                </c:pt>
                <c:pt idx="224">
                  <c:v>8360.4423828125</c:v>
                </c:pt>
                <c:pt idx="225">
                  <c:v>8421.8173828125</c:v>
                </c:pt>
                <c:pt idx="226">
                  <c:v>8484.564453125</c:v>
                </c:pt>
                <c:pt idx="227">
                  <c:v>8502.767578125</c:v>
                </c:pt>
                <c:pt idx="228">
                  <c:v>8453.4482421875</c:v>
                </c:pt>
                <c:pt idx="229">
                  <c:v>8356.96875</c:v>
                </c:pt>
                <c:pt idx="230">
                  <c:v>8266.3291015625</c:v>
                </c:pt>
                <c:pt idx="231">
                  <c:v>8232.0048828125</c:v>
                </c:pt>
                <c:pt idx="232">
                  <c:v>8267.771484375</c:v>
                </c:pt>
                <c:pt idx="233">
                  <c:v>8342.654296875</c:v>
                </c:pt>
                <c:pt idx="234">
                  <c:v>8404.712890625</c:v>
                </c:pt>
                <c:pt idx="235">
                  <c:v>8418.6083984375</c:v>
                </c:pt>
                <c:pt idx="236">
                  <c:v>8388.9765625</c:v>
                </c:pt>
                <c:pt idx="237">
                  <c:v>8353.0478515625</c:v>
                </c:pt>
                <c:pt idx="238">
                  <c:v>8349.501953125</c:v>
                </c:pt>
                <c:pt idx="239">
                  <c:v>8388.09765625</c:v>
                </c:pt>
                <c:pt idx="240">
                  <c:v>8442.8994140625</c:v>
                </c:pt>
                <c:pt idx="241">
                  <c:v>8472.9921875</c:v>
                </c:pt>
                <c:pt idx="242">
                  <c:v>8453.638671875</c:v>
                </c:pt>
                <c:pt idx="243">
                  <c:v>8394.005859375</c:v>
                </c:pt>
                <c:pt idx="244">
                  <c:v>8329.2236328125</c:v>
                </c:pt>
                <c:pt idx="245">
                  <c:v>8294.6767578125</c:v>
                </c:pt>
                <c:pt idx="246">
                  <c:v>8302.94140625</c:v>
                </c:pt>
                <c:pt idx="247">
                  <c:v>8339.6982421875</c:v>
                </c:pt>
                <c:pt idx="248">
                  <c:v>8378.87890625</c:v>
                </c:pt>
                <c:pt idx="249">
                  <c:v>8402.771484375</c:v>
                </c:pt>
                <c:pt idx="250">
                  <c:v>8411.1083984375</c:v>
                </c:pt>
                <c:pt idx="251">
                  <c:v>8414.23828125</c:v>
                </c:pt>
                <c:pt idx="252">
                  <c:v>8419.1240234375</c:v>
                </c:pt>
                <c:pt idx="253">
                  <c:v>8421.6357421875</c:v>
                </c:pt>
                <c:pt idx="254">
                  <c:v>8411.4052734375</c:v>
                </c:pt>
                <c:pt idx="255">
                  <c:v>8383.5947265625</c:v>
                </c:pt>
                <c:pt idx="256">
                  <c:v>8345.935546875</c:v>
                </c:pt>
                <c:pt idx="257">
                  <c:v>8314.2626953125</c:v>
                </c:pt>
                <c:pt idx="258">
                  <c:v>8300.4990234375</c:v>
                </c:pt>
                <c:pt idx="259">
                  <c:v>8303.9638671875</c:v>
                </c:pt>
                <c:pt idx="260">
                  <c:v>8313.744140625</c:v>
                </c:pt>
                <c:pt idx="261">
                  <c:v>8319.78515625</c:v>
                </c:pt>
                <c:pt idx="262">
                  <c:v>8322.3359375</c:v>
                </c:pt>
                <c:pt idx="263">
                  <c:v>8330.8134765625</c:v>
                </c:pt>
                <c:pt idx="264">
                  <c:v>8352.77734375</c:v>
                </c:pt>
                <c:pt idx="265">
                  <c:v>8383.126953125</c:v>
                </c:pt>
                <c:pt idx="266">
                  <c:v>8404.2412109375</c:v>
                </c:pt>
                <c:pt idx="267">
                  <c:v>8398.703125</c:v>
                </c:pt>
                <c:pt idx="268">
                  <c:v>8364.943359375</c:v>
                </c:pt>
                <c:pt idx="269">
                  <c:v>8322.416015625</c:v>
                </c:pt>
                <c:pt idx="270">
                  <c:v>8300.4560546875</c:v>
                </c:pt>
                <c:pt idx="271">
                  <c:v>8317.986328125</c:v>
                </c:pt>
                <c:pt idx="272">
                  <c:v>8369.1748046875</c:v>
                </c:pt>
                <c:pt idx="273">
                  <c:v>8426.3173828125</c:v>
                </c:pt>
                <c:pt idx="274">
                  <c:v>8458.3203125</c:v>
                </c:pt>
                <c:pt idx="275">
                  <c:v>8451.353515625</c:v>
                </c:pt>
                <c:pt idx="276">
                  <c:v>8416.6982421875</c:v>
                </c:pt>
                <c:pt idx="277">
                  <c:v>8380.73046875</c:v>
                </c:pt>
                <c:pt idx="278">
                  <c:v>8365.404296875</c:v>
                </c:pt>
                <c:pt idx="279">
                  <c:v>8374.13671875</c:v>
                </c:pt>
                <c:pt idx="280">
                  <c:v>8392.8994140625</c:v>
                </c:pt>
                <c:pt idx="281">
                  <c:v>8404.0791015625</c:v>
                </c:pt>
                <c:pt idx="282">
                  <c:v>8401.0986328125</c:v>
                </c:pt>
                <c:pt idx="283">
                  <c:v>8392.177734375</c:v>
                </c:pt>
                <c:pt idx="284">
                  <c:v>8391.0712890625</c:v>
                </c:pt>
                <c:pt idx="285">
                  <c:v>8403.2666015625</c:v>
                </c:pt>
                <c:pt idx="286">
                  <c:v>8419.458984375</c:v>
                </c:pt>
                <c:pt idx="287">
                  <c:v>8421.9111328125</c:v>
                </c:pt>
                <c:pt idx="288">
                  <c:v>8398.7314453125</c:v>
                </c:pt>
                <c:pt idx="289">
                  <c:v>8354.708984375</c:v>
                </c:pt>
                <c:pt idx="290">
                  <c:v>8309.9365234375</c:v>
                </c:pt>
                <c:pt idx="291">
                  <c:v>8286.8466796875</c:v>
                </c:pt>
                <c:pt idx="292">
                  <c:v>8295.091796875</c:v>
                </c:pt>
                <c:pt idx="293">
                  <c:v>8325.2978515625</c:v>
                </c:pt>
                <c:pt idx="294">
                  <c:v>8356.109375</c:v>
                </c:pt>
                <c:pt idx="295">
                  <c:v>8369.2958984375</c:v>
                </c:pt>
                <c:pt idx="296">
                  <c:v>8362.03125</c:v>
                </c:pt>
                <c:pt idx="297">
                  <c:v>8347.7646484375</c:v>
                </c:pt>
                <c:pt idx="298">
                  <c:v>8345.353515625</c:v>
                </c:pt>
                <c:pt idx="299">
                  <c:v>8364.3798828125</c:v>
                </c:pt>
                <c:pt idx="300">
                  <c:v>8397.01171875</c:v>
                </c:pt>
                <c:pt idx="301">
                  <c:v>8422.1650390625</c:v>
                </c:pt>
                <c:pt idx="302">
                  <c:v>8419.224609375</c:v>
                </c:pt>
                <c:pt idx="303">
                  <c:v>8382.19921875</c:v>
                </c:pt>
                <c:pt idx="304">
                  <c:v>8324.8828125</c:v>
                </c:pt>
                <c:pt idx="305">
                  <c:v>8273.4580078125</c:v>
                </c:pt>
                <c:pt idx="306">
                  <c:v>8251.1279296875</c:v>
                </c:pt>
                <c:pt idx="307">
                  <c:v>8264.5185546875</c:v>
                </c:pt>
                <c:pt idx="308">
                  <c:v>8300.498046875</c:v>
                </c:pt>
                <c:pt idx="309">
                  <c:v>8335.4736328125</c:v>
                </c:pt>
                <c:pt idx="310">
                  <c:v>8351.173828125</c:v>
                </c:pt>
                <c:pt idx="311">
                  <c:v>8346.6865234375</c:v>
                </c:pt>
                <c:pt idx="312">
                  <c:v>8338.775390625</c:v>
                </c:pt>
                <c:pt idx="313">
                  <c:v>8350.109375</c:v>
                </c:pt>
                <c:pt idx="314">
                  <c:v>8393.0234375</c:v>
                </c:pt>
                <c:pt idx="315">
                  <c:v>8459.658203125</c:v>
                </c:pt>
                <c:pt idx="316">
                  <c:v>8525.240234375</c:v>
                </c:pt>
                <c:pt idx="317">
                  <c:v>8562.5703125</c:v>
                </c:pt>
                <c:pt idx="318">
                  <c:v>8558.1494140625</c:v>
                </c:pt>
                <c:pt idx="319">
                  <c:v>8519.1943359375</c:v>
                </c:pt>
                <c:pt idx="320">
                  <c:v>8467.1123046875</c:v>
                </c:pt>
                <c:pt idx="321">
                  <c:v>8422.427734375</c:v>
                </c:pt>
                <c:pt idx="322">
                  <c:v>8392.1455078125</c:v>
                </c:pt>
                <c:pt idx="323">
                  <c:v>8368.498046875</c:v>
                </c:pt>
                <c:pt idx="324">
                  <c:v>8339.455078125</c:v>
                </c:pt>
                <c:pt idx="325">
                  <c:v>8302.3837890625</c:v>
                </c:pt>
                <c:pt idx="326">
                  <c:v>8269.6767578125</c:v>
                </c:pt>
                <c:pt idx="327">
                  <c:v>8261.125</c:v>
                </c:pt>
                <c:pt idx="328">
                  <c:v>8288.0966796875</c:v>
                </c:pt>
                <c:pt idx="329">
                  <c:v>8341.470703125</c:v>
                </c:pt>
                <c:pt idx="330">
                  <c:v>8393.375</c:v>
                </c:pt>
                <c:pt idx="331">
                  <c:v>8413.0625</c:v>
                </c:pt>
                <c:pt idx="332">
                  <c:v>8386.7216796875</c:v>
                </c:pt>
                <c:pt idx="333">
                  <c:v>8327.4560546875</c:v>
                </c:pt>
                <c:pt idx="334">
                  <c:v>8268.0263671875</c:v>
                </c:pt>
                <c:pt idx="335">
                  <c:v>8240.7763671875</c:v>
                </c:pt>
                <c:pt idx="336">
                  <c:v>8258.0908203125</c:v>
                </c:pt>
                <c:pt idx="337">
                  <c:v>8306.271484375</c:v>
                </c:pt>
                <c:pt idx="338">
                  <c:v>8356.3251953125</c:v>
                </c:pt>
                <c:pt idx="339">
                  <c:v>8383.5498046875</c:v>
                </c:pt>
                <c:pt idx="340">
                  <c:v>8382.3564453125</c:v>
                </c:pt>
                <c:pt idx="341">
                  <c:v>8366.91015625</c:v>
                </c:pt>
                <c:pt idx="342">
                  <c:v>8358.6015625</c:v>
                </c:pt>
                <c:pt idx="343">
                  <c:v>8370.2529296875</c:v>
                </c:pt>
                <c:pt idx="344">
                  <c:v>8398.236328125</c:v>
                </c:pt>
                <c:pt idx="345">
                  <c:v>8426.955078125</c:v>
                </c:pt>
                <c:pt idx="346">
                  <c:v>8441.0068359375</c:v>
                </c:pt>
                <c:pt idx="347">
                  <c:v>8435.5205078125</c:v>
                </c:pt>
                <c:pt idx="348">
                  <c:v>8417.671875</c:v>
                </c:pt>
                <c:pt idx="349">
                  <c:v>8399.6630859375</c:v>
                </c:pt>
              </c:numCache>
            </c:numRef>
          </c:yVal>
          <c:smooth val="1"/>
          <c:extLst>
            <c:ext xmlns:c16="http://schemas.microsoft.com/office/drawing/2014/chart" uri="{C3380CC4-5D6E-409C-BE32-E72D297353CC}">
              <c16:uniqueId val="{00000017-4A37-429A-A58F-F7AEDA5D1ACA}"/>
            </c:ext>
          </c:extLst>
        </c:ser>
        <c:ser>
          <c:idx val="24"/>
          <c:order val="24"/>
          <c:tx>
            <c:strRef>
              <c:f>cp_sub_001!$Y$1</c:f>
              <c:strCache>
                <c:ptCount val="1"/>
                <c:pt idx="0">
                  <c:v>Coor_25</c:v>
                </c:pt>
              </c:strCache>
            </c:strRef>
          </c:tx>
          <c:spPr>
            <a:ln w="28575" cap="rnd">
              <a:solidFill>
                <a:schemeClr val="accent1">
                  <a:lumMod val="60000"/>
                  <a:lumOff val="40000"/>
                </a:schemeClr>
              </a:solidFill>
              <a:round/>
            </a:ln>
            <a:effectLst/>
          </c:spPr>
          <c:marker>
            <c:symbol val="none"/>
          </c:marker>
          <c:yVal>
            <c:numRef>
              <c:f>cp_sub_001!$Y$2:$Y$351</c:f>
              <c:numCache>
                <c:formatCode>0.00000000000_ </c:formatCode>
                <c:ptCount val="350"/>
                <c:pt idx="0">
                  <c:v>8165.875</c:v>
                </c:pt>
                <c:pt idx="1">
                  <c:v>8187.14892578125</c:v>
                </c:pt>
                <c:pt idx="2">
                  <c:v>8182.494140625</c:v>
                </c:pt>
                <c:pt idx="3">
                  <c:v>8153.595703125</c:v>
                </c:pt>
                <c:pt idx="4">
                  <c:v>8120.31884765625</c:v>
                </c:pt>
                <c:pt idx="5">
                  <c:v>8107.27880859375</c:v>
                </c:pt>
                <c:pt idx="6">
                  <c:v>8125.3828125</c:v>
                </c:pt>
                <c:pt idx="7">
                  <c:v>8162.3251953125</c:v>
                </c:pt>
                <c:pt idx="8">
                  <c:v>8189.78125</c:v>
                </c:pt>
                <c:pt idx="9">
                  <c:v>8182.65234375</c:v>
                </c:pt>
                <c:pt idx="10">
                  <c:v>8136.76806640625</c:v>
                </c:pt>
                <c:pt idx="11">
                  <c:v>8072.67822265625</c:v>
                </c:pt>
                <c:pt idx="12">
                  <c:v>8023.30712890625</c:v>
                </c:pt>
                <c:pt idx="13">
                  <c:v>8014.3232421875</c:v>
                </c:pt>
                <c:pt idx="14">
                  <c:v>8050.11328125</c:v>
                </c:pt>
                <c:pt idx="15">
                  <c:v>8113.18212890625</c:v>
                </c:pt>
                <c:pt idx="16">
                  <c:v>8175.41748046875</c:v>
                </c:pt>
                <c:pt idx="17">
                  <c:v>8212.95703125</c:v>
                </c:pt>
                <c:pt idx="18">
                  <c:v>8216.1640625</c:v>
                </c:pt>
                <c:pt idx="19">
                  <c:v>8190.89990234375</c:v>
                </c:pt>
                <c:pt idx="20">
                  <c:v>8152.59619140625</c:v>
                </c:pt>
                <c:pt idx="21">
                  <c:v>8117.3798828125</c:v>
                </c:pt>
                <c:pt idx="22">
                  <c:v>8094.59033203125</c:v>
                </c:pt>
                <c:pt idx="23">
                  <c:v>8083.767578125</c:v>
                </c:pt>
                <c:pt idx="24">
                  <c:v>8077.45849609375</c:v>
                </c:pt>
                <c:pt idx="25">
                  <c:v>8068.6279296875</c:v>
                </c:pt>
                <c:pt idx="26">
                  <c:v>8058.36669921875</c:v>
                </c:pt>
                <c:pt idx="27">
                  <c:v>8058.02099609375</c:v>
                </c:pt>
                <c:pt idx="28">
                  <c:v>8082.30419921875</c:v>
                </c:pt>
                <c:pt idx="29">
                  <c:v>8136.38916015625</c:v>
                </c:pt>
                <c:pt idx="30">
                  <c:v>8206.1630859375</c:v>
                </c:pt>
                <c:pt idx="31">
                  <c:v>8260.955078125</c:v>
                </c:pt>
                <c:pt idx="32">
                  <c:v>8270.1337890625</c:v>
                </c:pt>
                <c:pt idx="33">
                  <c:v>8223.7646484375</c:v>
                </c:pt>
                <c:pt idx="34">
                  <c:v>8142.1591796875</c:v>
                </c:pt>
                <c:pt idx="35">
                  <c:v>8065.42431640625</c:v>
                </c:pt>
                <c:pt idx="36">
                  <c:v>8028.65966796875</c:v>
                </c:pt>
                <c:pt idx="37">
                  <c:v>8040.25341796875</c:v>
                </c:pt>
                <c:pt idx="38">
                  <c:v>8079.45458984375</c:v>
                </c:pt>
                <c:pt idx="39">
                  <c:v>8114.904296875</c:v>
                </c:pt>
                <c:pt idx="40">
                  <c:v>8129.1826171875</c:v>
                </c:pt>
                <c:pt idx="41">
                  <c:v>8129.47021484375</c:v>
                </c:pt>
                <c:pt idx="42">
                  <c:v>8136.05615234375</c:v>
                </c:pt>
                <c:pt idx="43">
                  <c:v>8159.392578125</c:v>
                </c:pt>
                <c:pt idx="44">
                  <c:v>8186.68994140625</c:v>
                </c:pt>
                <c:pt idx="45">
                  <c:v>8191.1787109375</c:v>
                </c:pt>
                <c:pt idx="46">
                  <c:v>8157.15185546875</c:v>
                </c:pt>
                <c:pt idx="47">
                  <c:v>8098.79150390625</c:v>
                </c:pt>
                <c:pt idx="48">
                  <c:v>8054.39404296875</c:v>
                </c:pt>
                <c:pt idx="49">
                  <c:v>8058.00244140625</c:v>
                </c:pt>
                <c:pt idx="50">
                  <c:v>8110.818359375</c:v>
                </c:pt>
                <c:pt idx="51">
                  <c:v>8177.05419921875</c:v>
                </c:pt>
                <c:pt idx="52">
                  <c:v>8209.8779296875</c:v>
                </c:pt>
                <c:pt idx="53">
                  <c:v>8187.8818359375</c:v>
                </c:pt>
                <c:pt idx="54">
                  <c:v>8132.41943359375</c:v>
                </c:pt>
                <c:pt idx="55">
                  <c:v>8090.755859375</c:v>
                </c:pt>
                <c:pt idx="56">
                  <c:v>8097.8603515625</c:v>
                </c:pt>
                <c:pt idx="57">
                  <c:v>8147.82568359375</c:v>
                </c:pt>
                <c:pt idx="58">
                  <c:v>8198.6083984375</c:v>
                </c:pt>
                <c:pt idx="59">
                  <c:v>8206.517578125</c:v>
                </c:pt>
                <c:pt idx="60">
                  <c:v>8162.15478515625</c:v>
                </c:pt>
                <c:pt idx="61">
                  <c:v>8098.17578125</c:v>
                </c:pt>
                <c:pt idx="62">
                  <c:v>8062.5712890625</c:v>
                </c:pt>
                <c:pt idx="63">
                  <c:v>8079.7880859375</c:v>
                </c:pt>
                <c:pt idx="64">
                  <c:v>8131.82568359375</c:v>
                </c:pt>
                <c:pt idx="65">
                  <c:v>8174.34228515625</c:v>
                </c:pt>
                <c:pt idx="66">
                  <c:v>8173.3857421875</c:v>
                </c:pt>
                <c:pt idx="67">
                  <c:v>8131.6142578125</c:v>
                </c:pt>
                <c:pt idx="68">
                  <c:v>8082.73193359375</c:v>
                </c:pt>
                <c:pt idx="69">
                  <c:v>8060.50830078125</c:v>
                </c:pt>
                <c:pt idx="70">
                  <c:v>8070.18505859375</c:v>
                </c:pt>
                <c:pt idx="71">
                  <c:v>8087.03076171875</c:v>
                </c:pt>
                <c:pt idx="72">
                  <c:v>8082.32421875</c:v>
                </c:pt>
                <c:pt idx="73">
                  <c:v>8052.712890625</c:v>
                </c:pt>
                <c:pt idx="74">
                  <c:v>8026.01025390625</c:v>
                </c:pt>
                <c:pt idx="75">
                  <c:v>8037.46142578125</c:v>
                </c:pt>
                <c:pt idx="76">
                  <c:v>8096.94287109375</c:v>
                </c:pt>
                <c:pt idx="77">
                  <c:v>8176.18798828125</c:v>
                </c:pt>
                <c:pt idx="78">
                  <c:v>8228.291015625</c:v>
                </c:pt>
                <c:pt idx="79">
                  <c:v>8223.93359375</c:v>
                </c:pt>
                <c:pt idx="80">
                  <c:v>8174.10986328125</c:v>
                </c:pt>
                <c:pt idx="81">
                  <c:v>8120.39990234375</c:v>
                </c:pt>
                <c:pt idx="82">
                  <c:v>8101.27880859375</c:v>
                </c:pt>
                <c:pt idx="83">
                  <c:v>8122.95849609375</c:v>
                </c:pt>
                <c:pt idx="84">
                  <c:v>8158.68115234375</c:v>
                </c:pt>
                <c:pt idx="85">
                  <c:v>8175.4921875</c:v>
                </c:pt>
                <c:pt idx="86">
                  <c:v>8164.04541015625</c:v>
                </c:pt>
                <c:pt idx="87">
                  <c:v>8145.19189453125</c:v>
                </c:pt>
                <c:pt idx="88">
                  <c:v>8148.22216796875</c:v>
                </c:pt>
                <c:pt idx="89">
                  <c:v>8180.958984375</c:v>
                </c:pt>
                <c:pt idx="90">
                  <c:v>8219.1787109375</c:v>
                </c:pt>
                <c:pt idx="91">
                  <c:v>8225.7900390625</c:v>
                </c:pt>
                <c:pt idx="92">
                  <c:v>8183.712890625</c:v>
                </c:pt>
                <c:pt idx="93">
                  <c:v>8113.6845703125</c:v>
                </c:pt>
                <c:pt idx="94">
                  <c:v>8060.509765625</c:v>
                </c:pt>
                <c:pt idx="95">
                  <c:v>8058.1513671875</c:v>
                </c:pt>
                <c:pt idx="96">
                  <c:v>8102.42822265625</c:v>
                </c:pt>
                <c:pt idx="97">
                  <c:v>8154.20263671875</c:v>
                </c:pt>
                <c:pt idx="98">
                  <c:v>8170.70751953125</c:v>
                </c:pt>
                <c:pt idx="99">
                  <c:v>8139.4150390625</c:v>
                </c:pt>
                <c:pt idx="100">
                  <c:v>8087.01708984375</c:v>
                </c:pt>
                <c:pt idx="101">
                  <c:v>8056.8974609375</c:v>
                </c:pt>
                <c:pt idx="102">
                  <c:v>8074.16845703125</c:v>
                </c:pt>
                <c:pt idx="103">
                  <c:v>8126.6865234375</c:v>
                </c:pt>
                <c:pt idx="104">
                  <c:v>8176.32958984375</c:v>
                </c:pt>
                <c:pt idx="105">
                  <c:v>8189.8095703125</c:v>
                </c:pt>
                <c:pt idx="106">
                  <c:v>8163.30615234375</c:v>
                </c:pt>
                <c:pt idx="107">
                  <c:v>8121.896484375</c:v>
                </c:pt>
                <c:pt idx="108">
                  <c:v>8096.37646484375</c:v>
                </c:pt>
                <c:pt idx="109">
                  <c:v>8098.01708984375</c:v>
                </c:pt>
                <c:pt idx="110">
                  <c:v>8111.8125</c:v>
                </c:pt>
                <c:pt idx="111">
                  <c:v>8112.12353515625</c:v>
                </c:pt>
                <c:pt idx="112">
                  <c:v>8086.18310546875</c:v>
                </c:pt>
                <c:pt idx="113">
                  <c:v>8045.734375</c:v>
                </c:pt>
                <c:pt idx="114">
                  <c:v>8018.17919921875</c:v>
                </c:pt>
                <c:pt idx="115">
                  <c:v>8025.54736328125</c:v>
                </c:pt>
                <c:pt idx="116">
                  <c:v>8068.34814453125</c:v>
                </c:pt>
                <c:pt idx="117">
                  <c:v>8125.8720703125</c:v>
                </c:pt>
                <c:pt idx="118">
                  <c:v>8170.90234375</c:v>
                </c:pt>
                <c:pt idx="119">
                  <c:v>8186.646484375</c:v>
                </c:pt>
                <c:pt idx="120">
                  <c:v>8174.2353515625</c:v>
                </c:pt>
                <c:pt idx="121">
                  <c:v>8147.962890625</c:v>
                </c:pt>
                <c:pt idx="122">
                  <c:v>8124.28759765625</c:v>
                </c:pt>
                <c:pt idx="123">
                  <c:v>8112.96240234375</c:v>
                </c:pt>
                <c:pt idx="124">
                  <c:v>8114.6240234375</c:v>
                </c:pt>
                <c:pt idx="125">
                  <c:v>8123.75732421875</c:v>
                </c:pt>
                <c:pt idx="126">
                  <c:v>8133.568359375</c:v>
                </c:pt>
                <c:pt idx="127">
                  <c:v>8140.12744140625</c:v>
                </c:pt>
                <c:pt idx="128">
                  <c:v>8144.5986328125</c:v>
                </c:pt>
                <c:pt idx="129">
                  <c:v>8152.65283203125</c:v>
                </c:pt>
                <c:pt idx="130">
                  <c:v>8170.35498046875</c:v>
                </c:pt>
                <c:pt idx="131">
                  <c:v>8197.765625</c:v>
                </c:pt>
                <c:pt idx="132">
                  <c:v>8224.6083984375</c:v>
                </c:pt>
                <c:pt idx="133">
                  <c:v>8233.181640625</c:v>
                </c:pt>
                <c:pt idx="134">
                  <c:v>8209.5078125</c:v>
                </c:pt>
                <c:pt idx="135">
                  <c:v>8156.35546875</c:v>
                </c:pt>
                <c:pt idx="136">
                  <c:v>8097.47900390625</c:v>
                </c:pt>
                <c:pt idx="137">
                  <c:v>8066.578125</c:v>
                </c:pt>
                <c:pt idx="138">
                  <c:v>8085.70947265625</c:v>
                </c:pt>
                <c:pt idx="139">
                  <c:v>8147.79296875</c:v>
                </c:pt>
                <c:pt idx="140">
                  <c:v>8217.4013671875</c:v>
                </c:pt>
                <c:pt idx="141">
                  <c:v>8251.759765625</c:v>
                </c:pt>
                <c:pt idx="142">
                  <c:v>8228.46875</c:v>
                </c:pt>
                <c:pt idx="143">
                  <c:v>8160.27734375</c:v>
                </c:pt>
                <c:pt idx="144">
                  <c:v>8086.03076171875</c:v>
                </c:pt>
                <c:pt idx="145">
                  <c:v>8044.458984375</c:v>
                </c:pt>
                <c:pt idx="146">
                  <c:v>8049.97119140625</c:v>
                </c:pt>
                <c:pt idx="147">
                  <c:v>8087.18017578125</c:v>
                </c:pt>
                <c:pt idx="148">
                  <c:v>8125.7802734375</c:v>
                </c:pt>
                <c:pt idx="149">
                  <c:v>8142.19091796875</c:v>
                </c:pt>
                <c:pt idx="150">
                  <c:v>8131.2705078125</c:v>
                </c:pt>
                <c:pt idx="151">
                  <c:v>8101.935546875</c:v>
                </c:pt>
                <c:pt idx="152">
                  <c:v>8064.66748046875</c:v>
                </c:pt>
                <c:pt idx="153">
                  <c:v>8024.1748046875</c:v>
                </c:pt>
                <c:pt idx="154">
                  <c:v>7983.0888671875</c:v>
                </c:pt>
                <c:pt idx="155">
                  <c:v>7950.30078125</c:v>
                </c:pt>
                <c:pt idx="156">
                  <c:v>7942.4072265625</c:v>
                </c:pt>
                <c:pt idx="157">
                  <c:v>7973.65771484375</c:v>
                </c:pt>
                <c:pt idx="158">
                  <c:v>8042.11572265625</c:v>
                </c:pt>
                <c:pt idx="159">
                  <c:v>8125.37939453125</c:v>
                </c:pt>
                <c:pt idx="160">
                  <c:v>8192.09765625</c:v>
                </c:pt>
                <c:pt idx="161">
                  <c:v>8221.5927734375</c:v>
                </c:pt>
                <c:pt idx="162">
                  <c:v>8215.923828125</c:v>
                </c:pt>
                <c:pt idx="163">
                  <c:v>8194.5576171875</c:v>
                </c:pt>
                <c:pt idx="164">
                  <c:v>8176.75537109375</c:v>
                </c:pt>
                <c:pt idx="165">
                  <c:v>8167.46337890625</c:v>
                </c:pt>
                <c:pt idx="166">
                  <c:v>8158.97314453125</c:v>
                </c:pt>
                <c:pt idx="167">
                  <c:v>8145.6171875</c:v>
                </c:pt>
                <c:pt idx="168">
                  <c:v>8136.03076171875</c:v>
                </c:pt>
                <c:pt idx="169">
                  <c:v>8149.1611328125</c:v>
                </c:pt>
                <c:pt idx="170">
                  <c:v>8195.537109375</c:v>
                </c:pt>
                <c:pt idx="171">
                  <c:v>8260.7099609375</c:v>
                </c:pt>
                <c:pt idx="172">
                  <c:v>8308.47265625</c:v>
                </c:pt>
                <c:pt idx="173">
                  <c:v>8305.3427734375</c:v>
                </c:pt>
                <c:pt idx="174">
                  <c:v>8248.1513671875</c:v>
                </c:pt>
                <c:pt idx="175">
                  <c:v>8171.0029296875</c:v>
                </c:pt>
                <c:pt idx="176">
                  <c:v>8122.8935546875</c:v>
                </c:pt>
                <c:pt idx="177">
                  <c:v>8131.3212890625</c:v>
                </c:pt>
                <c:pt idx="178">
                  <c:v>8180.216796875</c:v>
                </c:pt>
                <c:pt idx="179">
                  <c:v>8220.60546875</c:v>
                </c:pt>
                <c:pt idx="180">
                  <c:v>8206.83203125</c:v>
                </c:pt>
                <c:pt idx="181">
                  <c:v>8130.6640625</c:v>
                </c:pt>
                <c:pt idx="182">
                  <c:v>8027.11572265625</c:v>
                </c:pt>
                <c:pt idx="183">
                  <c:v>7948.33642578125</c:v>
                </c:pt>
                <c:pt idx="184">
                  <c:v>7926.83251953125</c:v>
                </c:pt>
                <c:pt idx="185">
                  <c:v>7956.49853515625</c:v>
                </c:pt>
                <c:pt idx="186">
                  <c:v>8004.08544921875</c:v>
                </c:pt>
                <c:pt idx="187">
                  <c:v>8038.8427734375</c:v>
                </c:pt>
                <c:pt idx="188">
                  <c:v>8054.8046875</c:v>
                </c:pt>
                <c:pt idx="189">
                  <c:v>8068.78125</c:v>
                </c:pt>
                <c:pt idx="190">
                  <c:v>8098.91748046875</c:v>
                </c:pt>
                <c:pt idx="191">
                  <c:v>8144.56689453125</c:v>
                </c:pt>
                <c:pt idx="192">
                  <c:v>8185.2197265625</c:v>
                </c:pt>
                <c:pt idx="193">
                  <c:v>8198.1923828125</c:v>
                </c:pt>
                <c:pt idx="194">
                  <c:v>8178.32177734375</c:v>
                </c:pt>
                <c:pt idx="195">
                  <c:v>8142.1435546875</c:v>
                </c:pt>
                <c:pt idx="196">
                  <c:v>8113.708984375</c:v>
                </c:pt>
                <c:pt idx="197">
                  <c:v>8105.45751953125</c:v>
                </c:pt>
                <c:pt idx="198">
                  <c:v>8111.005859375</c:v>
                </c:pt>
                <c:pt idx="199">
                  <c:v>8115.01318359375</c:v>
                </c:pt>
                <c:pt idx="200">
                  <c:v>8109.7021484375</c:v>
                </c:pt>
                <c:pt idx="201">
                  <c:v>8102.3310546875</c:v>
                </c:pt>
                <c:pt idx="202">
                  <c:v>8107.19384765625</c:v>
                </c:pt>
                <c:pt idx="203">
                  <c:v>8130.421875</c:v>
                </c:pt>
                <c:pt idx="204">
                  <c:v>8162.34375</c:v>
                </c:pt>
                <c:pt idx="205">
                  <c:v>8184.73095703125</c:v>
                </c:pt>
                <c:pt idx="206">
                  <c:v>8186.20263671875</c:v>
                </c:pt>
                <c:pt idx="207">
                  <c:v>8171.5595703125</c:v>
                </c:pt>
                <c:pt idx="208">
                  <c:v>8156.66015625</c:v>
                </c:pt>
                <c:pt idx="209">
                  <c:v>8153.92822265625</c:v>
                </c:pt>
                <c:pt idx="210">
                  <c:v>8162.0439453125</c:v>
                </c:pt>
                <c:pt idx="211">
                  <c:v>8169.01806640625</c:v>
                </c:pt>
                <c:pt idx="212">
                  <c:v>8164.99560546875</c:v>
                </c:pt>
                <c:pt idx="213">
                  <c:v>8152.0234375</c:v>
                </c:pt>
                <c:pt idx="214">
                  <c:v>8141.267578125</c:v>
                </c:pt>
                <c:pt idx="215">
                  <c:v>8140.64306640625</c:v>
                </c:pt>
                <c:pt idx="216">
                  <c:v>8145.517578125</c:v>
                </c:pt>
                <c:pt idx="217">
                  <c:v>8142.5419921875</c:v>
                </c:pt>
                <c:pt idx="218">
                  <c:v>8123.8330078125</c:v>
                </c:pt>
                <c:pt idx="219">
                  <c:v>8097.8115234375</c:v>
                </c:pt>
                <c:pt idx="220">
                  <c:v>8084.84814453125</c:v>
                </c:pt>
                <c:pt idx="221">
                  <c:v>8099.6708984375</c:v>
                </c:pt>
                <c:pt idx="222">
                  <c:v>8135.81201171875</c:v>
                </c:pt>
                <c:pt idx="223">
                  <c:v>8167.40283203125</c:v>
                </c:pt>
                <c:pt idx="224">
                  <c:v>8169.07568359375</c:v>
                </c:pt>
                <c:pt idx="225">
                  <c:v>8137.982421875</c:v>
                </c:pt>
                <c:pt idx="226">
                  <c:v>8098.318359375</c:v>
                </c:pt>
                <c:pt idx="227">
                  <c:v>8082.5908203125</c:v>
                </c:pt>
                <c:pt idx="228">
                  <c:v>8104.068359375</c:v>
                </c:pt>
                <c:pt idx="229">
                  <c:v>8143.69970703125</c:v>
                </c:pt>
                <c:pt idx="230">
                  <c:v>8163.8544921875</c:v>
                </c:pt>
                <c:pt idx="231">
                  <c:v>8138.93994140625</c:v>
                </c:pt>
                <c:pt idx="232">
                  <c:v>8078.11328125</c:v>
                </c:pt>
                <c:pt idx="233">
                  <c:v>8020.8916015625</c:v>
                </c:pt>
                <c:pt idx="234">
                  <c:v>8008.32177734375</c:v>
                </c:pt>
                <c:pt idx="235">
                  <c:v>8052.365234375</c:v>
                </c:pt>
                <c:pt idx="236">
                  <c:v>8127.58251953125</c:v>
                </c:pt>
                <c:pt idx="237">
                  <c:v>8190.95556640625</c:v>
                </c:pt>
                <c:pt idx="238">
                  <c:v>8213.1591796875</c:v>
                </c:pt>
                <c:pt idx="239">
                  <c:v>8196.421875</c:v>
                </c:pt>
                <c:pt idx="240">
                  <c:v>8166.47998046875</c:v>
                </c:pt>
                <c:pt idx="241">
                  <c:v>8147.87646484375</c:v>
                </c:pt>
                <c:pt idx="242">
                  <c:v>8144.48876953125</c:v>
                </c:pt>
                <c:pt idx="243">
                  <c:v>8140.7958984375</c:v>
                </c:pt>
                <c:pt idx="244">
                  <c:v>8120.5478515625</c:v>
                </c:pt>
                <c:pt idx="245">
                  <c:v>8084.9501953125</c:v>
                </c:pt>
                <c:pt idx="246">
                  <c:v>8054.162109375</c:v>
                </c:pt>
                <c:pt idx="247">
                  <c:v>8051.33544921875</c:v>
                </c:pt>
                <c:pt idx="248">
                  <c:v>8083.43603515625</c:v>
                </c:pt>
                <c:pt idx="249">
                  <c:v>8134.95751953125</c:v>
                </c:pt>
                <c:pt idx="250">
                  <c:v>8178.84765625</c:v>
                </c:pt>
                <c:pt idx="251">
                  <c:v>8194.6953125</c:v>
                </c:pt>
                <c:pt idx="252">
                  <c:v>8179.75927734375</c:v>
                </c:pt>
                <c:pt idx="253">
                  <c:v>8146.3759765625</c:v>
                </c:pt>
                <c:pt idx="254">
                  <c:v>8111.11572265625</c:v>
                </c:pt>
                <c:pt idx="255">
                  <c:v>8086.0146484375</c:v>
                </c:pt>
                <c:pt idx="256">
                  <c:v>8077.04833984375</c:v>
                </c:pt>
                <c:pt idx="257">
                  <c:v>8086.486328125</c:v>
                </c:pt>
                <c:pt idx="258">
                  <c:v>8112.93994140625</c:v>
                </c:pt>
                <c:pt idx="259">
                  <c:v>8148.20654296875</c:v>
                </c:pt>
                <c:pt idx="260">
                  <c:v>8176.70703125</c:v>
                </c:pt>
                <c:pt idx="261">
                  <c:v>8183.02001953125</c:v>
                </c:pt>
                <c:pt idx="262">
                  <c:v>8164.5947265625</c:v>
                </c:pt>
                <c:pt idx="263">
                  <c:v>8138.42138671875</c:v>
                </c:pt>
                <c:pt idx="264">
                  <c:v>8132.0498046875</c:v>
                </c:pt>
                <c:pt idx="265">
                  <c:v>8161.98828125</c:v>
                </c:pt>
                <c:pt idx="266">
                  <c:v>8215.814453125</c:v>
                </c:pt>
                <c:pt idx="267">
                  <c:v>8255.15234375</c:v>
                </c:pt>
                <c:pt idx="268">
                  <c:v>8241.5537109375</c:v>
                </c:pt>
                <c:pt idx="269">
                  <c:v>8167.44921875</c:v>
                </c:pt>
                <c:pt idx="270">
                  <c:v>8067.08740234375</c:v>
                </c:pt>
                <c:pt idx="271">
                  <c:v>7995.8876953125</c:v>
                </c:pt>
                <c:pt idx="272">
                  <c:v>7991.70068359375</c:v>
                </c:pt>
                <c:pt idx="273">
                  <c:v>8047.45068359375</c:v>
                </c:pt>
                <c:pt idx="274">
                  <c:v>8117.259765625</c:v>
                </c:pt>
                <c:pt idx="275">
                  <c:v>8151.958984375</c:v>
                </c:pt>
                <c:pt idx="276">
                  <c:v>8136.02099609375</c:v>
                </c:pt>
                <c:pt idx="277">
                  <c:v>8096.43896484375</c:v>
                </c:pt>
                <c:pt idx="278">
                  <c:v>8076.9677734375</c:v>
                </c:pt>
                <c:pt idx="279">
                  <c:v>8099.783203125</c:v>
                </c:pt>
                <c:pt idx="280">
                  <c:v>8146.97802734375</c:v>
                </c:pt>
                <c:pt idx="281">
                  <c:v>8177.39501953125</c:v>
                </c:pt>
                <c:pt idx="282">
                  <c:v>8164.09521484375</c:v>
                </c:pt>
                <c:pt idx="283">
                  <c:v>8119.78369140625</c:v>
                </c:pt>
                <c:pt idx="284">
                  <c:v>8087.3984375</c:v>
                </c:pt>
                <c:pt idx="285">
                  <c:v>8102.7666015625</c:v>
                </c:pt>
                <c:pt idx="286">
                  <c:v>8160.82763671875</c:v>
                </c:pt>
                <c:pt idx="287">
                  <c:v>8215.1923828125</c:v>
                </c:pt>
                <c:pt idx="288">
                  <c:v>8213.654296875</c:v>
                </c:pt>
                <c:pt idx="289">
                  <c:v>8141.93896484375</c:v>
                </c:pt>
                <c:pt idx="290">
                  <c:v>8039.88671875</c:v>
                </c:pt>
                <c:pt idx="291">
                  <c:v>7975.46484375</c:v>
                </c:pt>
                <c:pt idx="292">
                  <c:v>7995.5478515625</c:v>
                </c:pt>
                <c:pt idx="293">
                  <c:v>8091.04443359375</c:v>
                </c:pt>
                <c:pt idx="294">
                  <c:v>8202.8330078125</c:v>
                </c:pt>
                <c:pt idx="295">
                  <c:v>8263.3701171875</c:v>
                </c:pt>
                <c:pt idx="296">
                  <c:v>8242.177734375</c:v>
                </c:pt>
                <c:pt idx="297">
                  <c:v>8162.2900390625</c:v>
                </c:pt>
                <c:pt idx="298">
                  <c:v>8078.58251953125</c:v>
                </c:pt>
                <c:pt idx="299">
                  <c:v>8037.69287109375</c:v>
                </c:pt>
                <c:pt idx="300">
                  <c:v>8050.3173828125</c:v>
                </c:pt>
                <c:pt idx="301">
                  <c:v>8093.34423828125</c:v>
                </c:pt>
                <c:pt idx="302">
                  <c:v>8134.478515625</c:v>
                </c:pt>
                <c:pt idx="303">
                  <c:v>8156.4794921875</c:v>
                </c:pt>
                <c:pt idx="304">
                  <c:v>8162.8505859375</c:v>
                </c:pt>
                <c:pt idx="305">
                  <c:v>8165.20654296875</c:v>
                </c:pt>
                <c:pt idx="306">
                  <c:v>8167.6865234375</c:v>
                </c:pt>
                <c:pt idx="307">
                  <c:v>8163.505859375</c:v>
                </c:pt>
                <c:pt idx="308">
                  <c:v>8145.29541015625</c:v>
                </c:pt>
                <c:pt idx="309">
                  <c:v>8117.51806640625</c:v>
                </c:pt>
                <c:pt idx="310">
                  <c:v>8097.76025390625</c:v>
                </c:pt>
                <c:pt idx="311">
                  <c:v>8104.47705078125</c:v>
                </c:pt>
                <c:pt idx="312">
                  <c:v>8141.35791015625</c:v>
                </c:pt>
                <c:pt idx="313">
                  <c:v>8191.72314453125</c:v>
                </c:pt>
                <c:pt idx="314">
                  <c:v>8227.9609375</c:v>
                </c:pt>
                <c:pt idx="315">
                  <c:v>8228.8759765625</c:v>
                </c:pt>
                <c:pt idx="316">
                  <c:v>8192.2802734375</c:v>
                </c:pt>
                <c:pt idx="317">
                  <c:v>8134.97412109375</c:v>
                </c:pt>
                <c:pt idx="318">
                  <c:v>8082.17041015625</c:v>
                </c:pt>
                <c:pt idx="319">
                  <c:v>8054.74853515625</c:v>
                </c:pt>
                <c:pt idx="320">
                  <c:v>8061.4150390625</c:v>
                </c:pt>
                <c:pt idx="321">
                  <c:v>8097.1201171875</c:v>
                </c:pt>
                <c:pt idx="322">
                  <c:v>8145.26513671875</c:v>
                </c:pt>
                <c:pt idx="323">
                  <c:v>8182.1171875</c:v>
                </c:pt>
                <c:pt idx="324">
                  <c:v>8184.4306640625</c:v>
                </c:pt>
                <c:pt idx="325">
                  <c:v>8140.6123046875</c:v>
                </c:pt>
                <c:pt idx="326">
                  <c:v>8061.01513671875</c:v>
                </c:pt>
                <c:pt idx="327">
                  <c:v>7979.03955078125</c:v>
                </c:pt>
                <c:pt idx="328">
                  <c:v>7937.58447265625</c:v>
                </c:pt>
                <c:pt idx="329">
                  <c:v>7965.3017578125</c:v>
                </c:pt>
                <c:pt idx="330">
                  <c:v>8056.93603515625</c:v>
                </c:pt>
                <c:pt idx="331">
                  <c:v>8172.5478515625</c:v>
                </c:pt>
                <c:pt idx="332">
                  <c:v>8258.931640625</c:v>
                </c:pt>
                <c:pt idx="333">
                  <c:v>8280.5615234375</c:v>
                </c:pt>
                <c:pt idx="334">
                  <c:v>8239.36328125</c:v>
                </c:pt>
                <c:pt idx="335">
                  <c:v>8169.73974609375</c:v>
                </c:pt>
                <c:pt idx="336">
                  <c:v>8113.0537109375</c:v>
                </c:pt>
                <c:pt idx="337">
                  <c:v>8090.5947265625</c:v>
                </c:pt>
                <c:pt idx="338">
                  <c:v>8094.41357421875</c:v>
                </c:pt>
                <c:pt idx="339">
                  <c:v>8100.93701171875</c:v>
                </c:pt>
                <c:pt idx="340">
                  <c:v>8094.55517578125</c:v>
                </c:pt>
                <c:pt idx="341">
                  <c:v>8081.4365234375</c:v>
                </c:pt>
                <c:pt idx="342">
                  <c:v>8082.85009765625</c:v>
                </c:pt>
                <c:pt idx="343">
                  <c:v>8114.50439453125</c:v>
                </c:pt>
                <c:pt idx="344">
                  <c:v>8169.7353515625</c:v>
                </c:pt>
                <c:pt idx="345">
                  <c:v>8220.87109375</c:v>
                </c:pt>
                <c:pt idx="346">
                  <c:v>8238.08203125</c:v>
                </c:pt>
                <c:pt idx="347">
                  <c:v>8210.9423828125</c:v>
                </c:pt>
                <c:pt idx="348">
                  <c:v>8156.04931640625</c:v>
                </c:pt>
                <c:pt idx="349">
                  <c:v>8105.22802734375</c:v>
                </c:pt>
              </c:numCache>
            </c:numRef>
          </c:yVal>
          <c:smooth val="1"/>
          <c:extLst>
            <c:ext xmlns:c16="http://schemas.microsoft.com/office/drawing/2014/chart" uri="{C3380CC4-5D6E-409C-BE32-E72D297353CC}">
              <c16:uniqueId val="{00000018-4A37-429A-A58F-F7AEDA5D1ACA}"/>
            </c:ext>
          </c:extLst>
        </c:ser>
        <c:ser>
          <c:idx val="25"/>
          <c:order val="25"/>
          <c:tx>
            <c:strRef>
              <c:f>cp_sub_001!$Z$1</c:f>
              <c:strCache>
                <c:ptCount val="1"/>
                <c:pt idx="0">
                  <c:v>Coor_26</c:v>
                </c:pt>
              </c:strCache>
            </c:strRef>
          </c:tx>
          <c:spPr>
            <a:ln w="28575" cap="rnd">
              <a:solidFill>
                <a:schemeClr val="accent2">
                  <a:lumMod val="60000"/>
                  <a:lumOff val="40000"/>
                </a:schemeClr>
              </a:solidFill>
              <a:round/>
            </a:ln>
            <a:effectLst/>
          </c:spPr>
          <c:marker>
            <c:symbol val="none"/>
          </c:marker>
          <c:yVal>
            <c:numRef>
              <c:f>cp_sub_001!$Z$2:$Z$351</c:f>
              <c:numCache>
                <c:formatCode>0.00000000000_ </c:formatCode>
                <c:ptCount val="350"/>
                <c:pt idx="0">
                  <c:v>6924.7509765625</c:v>
                </c:pt>
                <c:pt idx="1">
                  <c:v>6872.19189453125</c:v>
                </c:pt>
                <c:pt idx="2">
                  <c:v>6849.34326171875</c:v>
                </c:pt>
                <c:pt idx="3">
                  <c:v>6862.29541015625</c:v>
                </c:pt>
                <c:pt idx="4">
                  <c:v>6897.158203125</c:v>
                </c:pt>
                <c:pt idx="5">
                  <c:v>6932.59130859375</c:v>
                </c:pt>
                <c:pt idx="6">
                  <c:v>6957.27880859375</c:v>
                </c:pt>
                <c:pt idx="7">
                  <c:v>6978.03271484375</c:v>
                </c:pt>
                <c:pt idx="8">
                  <c:v>7011.56396484375</c:v>
                </c:pt>
                <c:pt idx="9">
                  <c:v>7066.48193359375</c:v>
                </c:pt>
                <c:pt idx="10">
                  <c:v>7130.7333984375</c:v>
                </c:pt>
                <c:pt idx="11">
                  <c:v>7175.966796875</c:v>
                </c:pt>
                <c:pt idx="12">
                  <c:v>7176.80029296875</c:v>
                </c:pt>
                <c:pt idx="13">
                  <c:v>7130.41748046875</c:v>
                </c:pt>
                <c:pt idx="14">
                  <c:v>7060.84912109375</c:v>
                </c:pt>
                <c:pt idx="15">
                  <c:v>7003.88037109375</c:v>
                </c:pt>
                <c:pt idx="16">
                  <c:v>6983.67138671875</c:v>
                </c:pt>
                <c:pt idx="17">
                  <c:v>6998.548828125</c:v>
                </c:pt>
                <c:pt idx="18">
                  <c:v>7025.953125</c:v>
                </c:pt>
                <c:pt idx="19">
                  <c:v>7041.35791015625</c:v>
                </c:pt>
                <c:pt idx="20">
                  <c:v>7035.5849609375</c:v>
                </c:pt>
                <c:pt idx="21">
                  <c:v>7017.5771484375</c:v>
                </c:pt>
                <c:pt idx="22">
                  <c:v>7002.61669921875</c:v>
                </c:pt>
                <c:pt idx="23">
                  <c:v>6997.93603515625</c:v>
                </c:pt>
                <c:pt idx="24">
                  <c:v>6998.61572265625</c:v>
                </c:pt>
                <c:pt idx="25">
                  <c:v>6996.30322265625</c:v>
                </c:pt>
                <c:pt idx="26">
                  <c:v>6991.1572265625</c:v>
                </c:pt>
                <c:pt idx="27">
                  <c:v>6994.4228515625</c:v>
                </c:pt>
                <c:pt idx="28">
                  <c:v>7017.87451171875</c:v>
                </c:pt>
                <c:pt idx="29">
                  <c:v>7059.12353515625</c:v>
                </c:pt>
                <c:pt idx="30">
                  <c:v>7096.89892578125</c:v>
                </c:pt>
                <c:pt idx="31">
                  <c:v>7102.8310546875</c:v>
                </c:pt>
                <c:pt idx="32">
                  <c:v>7062.154296875</c:v>
                </c:pt>
                <c:pt idx="33">
                  <c:v>6987.1455078125</c:v>
                </c:pt>
                <c:pt idx="34">
                  <c:v>6911.755859375</c:v>
                </c:pt>
                <c:pt idx="35">
                  <c:v>6870.357421875</c:v>
                </c:pt>
                <c:pt idx="36">
                  <c:v>6875.97900390625</c:v>
                </c:pt>
                <c:pt idx="37">
                  <c:v>6913.76513671875</c:v>
                </c:pt>
                <c:pt idx="38">
                  <c:v>6953.50830078125</c:v>
                </c:pt>
                <c:pt idx="39">
                  <c:v>6970.8828125</c:v>
                </c:pt>
                <c:pt idx="40">
                  <c:v>6961.6650390625</c:v>
                </c:pt>
                <c:pt idx="41">
                  <c:v>6940.27392578125</c:v>
                </c:pt>
                <c:pt idx="42">
                  <c:v>6926.55126953125</c:v>
                </c:pt>
                <c:pt idx="43">
                  <c:v>6932.3779296875</c:v>
                </c:pt>
                <c:pt idx="44">
                  <c:v>6957.1484375</c:v>
                </c:pt>
                <c:pt idx="45">
                  <c:v>6992.20556640625</c:v>
                </c:pt>
                <c:pt idx="46">
                  <c:v>7027.587890625</c:v>
                </c:pt>
                <c:pt idx="47">
                  <c:v>7055.236328125</c:v>
                </c:pt>
                <c:pt idx="48">
                  <c:v>7068.69091796875</c:v>
                </c:pt>
                <c:pt idx="49">
                  <c:v>7063.4580078125</c:v>
                </c:pt>
                <c:pt idx="50">
                  <c:v>7040.3994140625</c:v>
                </c:pt>
                <c:pt idx="51">
                  <c:v>7009.1015625</c:v>
                </c:pt>
                <c:pt idx="52">
                  <c:v>6985.77197265625</c:v>
                </c:pt>
                <c:pt idx="53">
                  <c:v>6984.2744140625</c:v>
                </c:pt>
                <c:pt idx="54">
                  <c:v>7006.1259765625</c:v>
                </c:pt>
                <c:pt idx="55">
                  <c:v>7038.208984375</c:v>
                </c:pt>
                <c:pt idx="56">
                  <c:v>7061.5849609375</c:v>
                </c:pt>
                <c:pt idx="57">
                  <c:v>7065.1376953125</c:v>
                </c:pt>
                <c:pt idx="58">
                  <c:v>7052.7158203125</c:v>
                </c:pt>
                <c:pt idx="59">
                  <c:v>7037.51171875</c:v>
                </c:pt>
                <c:pt idx="60">
                  <c:v>7028.890625</c:v>
                </c:pt>
                <c:pt idx="61">
                  <c:v>7024.27734375</c:v>
                </c:pt>
                <c:pt idx="62">
                  <c:v>7014.48095703125</c:v>
                </c:pt>
                <c:pt idx="63">
                  <c:v>6997.81884765625</c:v>
                </c:pt>
                <c:pt idx="64">
                  <c:v>6988.42431640625</c:v>
                </c:pt>
                <c:pt idx="65">
                  <c:v>7007.5341796875</c:v>
                </c:pt>
                <c:pt idx="66">
                  <c:v>7061.98193359375</c:v>
                </c:pt>
                <c:pt idx="67">
                  <c:v>7128.4580078125</c:v>
                </c:pt>
                <c:pt idx="68">
                  <c:v>7161.18896484375</c:v>
                </c:pt>
                <c:pt idx="69">
                  <c:v>7122.76171875</c:v>
                </c:pt>
                <c:pt idx="70">
                  <c:v>7016.61279296875</c:v>
                </c:pt>
                <c:pt idx="71">
                  <c:v>6893.90673828125</c:v>
                </c:pt>
                <c:pt idx="72">
                  <c:v>6824.55712890625</c:v>
                </c:pt>
                <c:pt idx="73">
                  <c:v>6850.18603515625</c:v>
                </c:pt>
                <c:pt idx="74">
                  <c:v>6953.3388671875</c:v>
                </c:pt>
                <c:pt idx="75">
                  <c:v>7067.3876953125</c:v>
                </c:pt>
                <c:pt idx="76">
                  <c:v>7121.49560546875</c:v>
                </c:pt>
                <c:pt idx="77">
                  <c:v>7087.9873046875</c:v>
                </c:pt>
                <c:pt idx="78">
                  <c:v>6997.4208984375</c:v>
                </c:pt>
                <c:pt idx="79">
                  <c:v>6911.62451171875</c:v>
                </c:pt>
                <c:pt idx="80">
                  <c:v>6877.19970703125</c:v>
                </c:pt>
                <c:pt idx="81">
                  <c:v>6895.71533203125</c:v>
                </c:pt>
                <c:pt idx="82">
                  <c:v>6931.494140625</c:v>
                </c:pt>
                <c:pt idx="83">
                  <c:v>6946.8447265625</c:v>
                </c:pt>
                <c:pt idx="84">
                  <c:v>6933.650390625</c:v>
                </c:pt>
                <c:pt idx="85">
                  <c:v>6915.96337890625</c:v>
                </c:pt>
                <c:pt idx="86">
                  <c:v>6924.5068359375</c:v>
                </c:pt>
                <c:pt idx="87">
                  <c:v>6967.61767578125</c:v>
                </c:pt>
                <c:pt idx="88">
                  <c:v>7024.28857421875</c:v>
                </c:pt>
                <c:pt idx="89">
                  <c:v>7063.8291015625</c:v>
                </c:pt>
                <c:pt idx="90">
                  <c:v>7072.7646484375</c:v>
                </c:pt>
                <c:pt idx="91">
                  <c:v>7064.1552734375</c:v>
                </c:pt>
                <c:pt idx="92">
                  <c:v>7061.70361328125</c:v>
                </c:pt>
                <c:pt idx="93">
                  <c:v>7074.72900390625</c:v>
                </c:pt>
                <c:pt idx="94">
                  <c:v>7088.4619140625</c:v>
                </c:pt>
                <c:pt idx="95">
                  <c:v>7079.509765625</c:v>
                </c:pt>
                <c:pt idx="96">
                  <c:v>7042.09765625</c:v>
                </c:pt>
                <c:pt idx="97">
                  <c:v>6999.31201171875</c:v>
                </c:pt>
                <c:pt idx="98">
                  <c:v>6986.19921875</c:v>
                </c:pt>
                <c:pt idx="99">
                  <c:v>7017.5908203125</c:v>
                </c:pt>
                <c:pt idx="100">
                  <c:v>7069.4736328125</c:v>
                </c:pt>
                <c:pt idx="101">
                  <c:v>7093.240234375</c:v>
                </c:pt>
                <c:pt idx="102">
                  <c:v>7054.18505859375</c:v>
                </c:pt>
                <c:pt idx="103">
                  <c:v>6963.1728515625</c:v>
                </c:pt>
                <c:pt idx="104">
                  <c:v>6873.71923828125</c:v>
                </c:pt>
                <c:pt idx="105">
                  <c:v>6844.3134765625</c:v>
                </c:pt>
                <c:pt idx="106">
                  <c:v>6894.8662109375</c:v>
                </c:pt>
                <c:pt idx="107">
                  <c:v>6991.92333984375</c:v>
                </c:pt>
                <c:pt idx="108">
                  <c:v>7074.376953125</c:v>
                </c:pt>
                <c:pt idx="109">
                  <c:v>7098.708984375</c:v>
                </c:pt>
                <c:pt idx="110">
                  <c:v>7067.71533203125</c:v>
                </c:pt>
                <c:pt idx="111">
                  <c:v>7021.43408203125</c:v>
                </c:pt>
                <c:pt idx="112">
                  <c:v>7000.6328125</c:v>
                </c:pt>
                <c:pt idx="113">
                  <c:v>7014.7421875</c:v>
                </c:pt>
                <c:pt idx="114">
                  <c:v>7039.89013671875</c:v>
                </c:pt>
                <c:pt idx="115">
                  <c:v>7045.27294921875</c:v>
                </c:pt>
                <c:pt idx="116">
                  <c:v>7022.06640625</c:v>
                </c:pt>
                <c:pt idx="117">
                  <c:v>6989.01318359375</c:v>
                </c:pt>
                <c:pt idx="118">
                  <c:v>6971.6796875</c:v>
                </c:pt>
                <c:pt idx="119">
                  <c:v>6976.74462890625</c:v>
                </c:pt>
                <c:pt idx="120">
                  <c:v>6986.451171875</c:v>
                </c:pt>
                <c:pt idx="121">
                  <c:v>6978.51708984375</c:v>
                </c:pt>
                <c:pt idx="122">
                  <c:v>6951.9560546875</c:v>
                </c:pt>
                <c:pt idx="123">
                  <c:v>6932.724609375</c:v>
                </c:pt>
                <c:pt idx="124">
                  <c:v>6951.47314453125</c:v>
                </c:pt>
                <c:pt idx="125">
                  <c:v>7012.45068359375</c:v>
                </c:pt>
                <c:pt idx="126">
                  <c:v>7082.96435546875</c:v>
                </c:pt>
                <c:pt idx="127">
                  <c:v>7116.03076171875</c:v>
                </c:pt>
                <c:pt idx="128">
                  <c:v>7088.9169921875</c:v>
                </c:pt>
                <c:pt idx="129">
                  <c:v>7024.04345703125</c:v>
                </c:pt>
                <c:pt idx="130">
                  <c:v>6971.994140625</c:v>
                </c:pt>
                <c:pt idx="131">
                  <c:v>6969.021484375</c:v>
                </c:pt>
                <c:pt idx="132">
                  <c:v>7005.16943359375</c:v>
                </c:pt>
                <c:pt idx="133">
                  <c:v>7032.09521484375</c:v>
                </c:pt>
                <c:pt idx="134">
                  <c:v>7006.24951171875</c:v>
                </c:pt>
                <c:pt idx="135">
                  <c:v>6931.3095703125</c:v>
                </c:pt>
                <c:pt idx="136">
                  <c:v>6861.8837890625</c:v>
                </c:pt>
                <c:pt idx="137">
                  <c:v>6861.81494140625</c:v>
                </c:pt>
                <c:pt idx="138">
                  <c:v>6949.54443359375</c:v>
                </c:pt>
                <c:pt idx="139">
                  <c:v>7076.46533203125</c:v>
                </c:pt>
                <c:pt idx="140">
                  <c:v>7159.1474609375</c:v>
                </c:pt>
                <c:pt idx="141">
                  <c:v>7142.2314453125</c:v>
                </c:pt>
                <c:pt idx="142">
                  <c:v>7042.1845703125</c:v>
                </c:pt>
                <c:pt idx="143">
                  <c:v>6935.84130859375</c:v>
                </c:pt>
                <c:pt idx="144">
                  <c:v>6901.517578125</c:v>
                </c:pt>
                <c:pt idx="145">
                  <c:v>6958.892578125</c:v>
                </c:pt>
                <c:pt idx="146">
                  <c:v>7055.25244140625</c:v>
                </c:pt>
                <c:pt idx="147">
                  <c:v>7108.5732421875</c:v>
                </c:pt>
                <c:pt idx="148">
                  <c:v>7072.5517578125</c:v>
                </c:pt>
                <c:pt idx="149">
                  <c:v>6971.7919921875</c:v>
                </c:pt>
                <c:pt idx="150">
                  <c:v>6880.31201171875</c:v>
                </c:pt>
                <c:pt idx="151">
                  <c:v>6862.38037109375</c:v>
                </c:pt>
                <c:pt idx="152">
                  <c:v>6923.998046875</c:v>
                </c:pt>
                <c:pt idx="153">
                  <c:v>7012.8671875</c:v>
                </c:pt>
                <c:pt idx="154">
                  <c:v>7064.23095703125</c:v>
                </c:pt>
                <c:pt idx="155">
                  <c:v>7053.23828125</c:v>
                </c:pt>
                <c:pt idx="156">
                  <c:v>7011.11962890625</c:v>
                </c:pt>
                <c:pt idx="157">
                  <c:v>6993.89208984375</c:v>
                </c:pt>
                <c:pt idx="158">
                  <c:v>7031.59130859375</c:v>
                </c:pt>
                <c:pt idx="159">
                  <c:v>7100.943359375</c:v>
                </c:pt>
                <c:pt idx="160">
                  <c:v>7143.71728515625</c:v>
                </c:pt>
                <c:pt idx="161">
                  <c:v>7114.953125</c:v>
                </c:pt>
                <c:pt idx="162">
                  <c:v>7021.3544921875</c:v>
                </c:pt>
                <c:pt idx="163">
                  <c:v>6919.05859375</c:v>
                </c:pt>
                <c:pt idx="164">
                  <c:v>6873.171875</c:v>
                </c:pt>
                <c:pt idx="165">
                  <c:v>6911.2578125</c:v>
                </c:pt>
                <c:pt idx="166">
                  <c:v>7006.02685546875</c:v>
                </c:pt>
                <c:pt idx="167">
                  <c:v>7098.02490234375</c:v>
                </c:pt>
                <c:pt idx="168">
                  <c:v>7138.21875</c:v>
                </c:pt>
                <c:pt idx="169">
                  <c:v>7117.537109375</c:v>
                </c:pt>
                <c:pt idx="170">
                  <c:v>7063.96044921875</c:v>
                </c:pt>
                <c:pt idx="171">
                  <c:v>7014.5380859375</c:v>
                </c:pt>
                <c:pt idx="172">
                  <c:v>6987.4755859375</c:v>
                </c:pt>
                <c:pt idx="173">
                  <c:v>6975.41943359375</c:v>
                </c:pt>
                <c:pt idx="174">
                  <c:v>6961.0634765625</c:v>
                </c:pt>
                <c:pt idx="175">
                  <c:v>6938.0908203125</c:v>
                </c:pt>
                <c:pt idx="176">
                  <c:v>6918.556640625</c:v>
                </c:pt>
                <c:pt idx="177">
                  <c:v>6921.65576171875</c:v>
                </c:pt>
                <c:pt idx="178">
                  <c:v>6955.23974609375</c:v>
                </c:pt>
                <c:pt idx="179">
                  <c:v>7006.67578125</c:v>
                </c:pt>
                <c:pt idx="180">
                  <c:v>7050.52734375</c:v>
                </c:pt>
                <c:pt idx="181">
                  <c:v>7066.1044921875</c:v>
                </c:pt>
                <c:pt idx="182">
                  <c:v>7050.49951171875</c:v>
                </c:pt>
                <c:pt idx="183">
                  <c:v>7017.64404296875</c:v>
                </c:pt>
                <c:pt idx="184">
                  <c:v>6985.8720703125</c:v>
                </c:pt>
                <c:pt idx="185">
                  <c:v>6964.99755859375</c:v>
                </c:pt>
                <c:pt idx="186">
                  <c:v>6952.67041015625</c:v>
                </c:pt>
                <c:pt idx="187">
                  <c:v>6940.990234375</c:v>
                </c:pt>
                <c:pt idx="188">
                  <c:v>6926.10302734375</c:v>
                </c:pt>
                <c:pt idx="189">
                  <c:v>6912.3525390625</c:v>
                </c:pt>
                <c:pt idx="190">
                  <c:v>6908.3505859375</c:v>
                </c:pt>
                <c:pt idx="191">
                  <c:v>6919.41357421875</c:v>
                </c:pt>
                <c:pt idx="192">
                  <c:v>6943.20556640625</c:v>
                </c:pt>
                <c:pt idx="193">
                  <c:v>6971.8916015625</c:v>
                </c:pt>
                <c:pt idx="194">
                  <c:v>6998.34716796875</c:v>
                </c:pt>
                <c:pt idx="195">
                  <c:v>7020.9873046875</c:v>
                </c:pt>
                <c:pt idx="196">
                  <c:v>7043.52587890625</c:v>
                </c:pt>
                <c:pt idx="197">
                  <c:v>7070.39453125</c:v>
                </c:pt>
                <c:pt idx="198">
                  <c:v>7101.7392578125</c:v>
                </c:pt>
                <c:pt idx="199">
                  <c:v>7131.6650390625</c:v>
                </c:pt>
                <c:pt idx="200">
                  <c:v>7150.5830078125</c:v>
                </c:pt>
                <c:pt idx="201">
                  <c:v>7149.73388671875</c:v>
                </c:pt>
                <c:pt idx="202">
                  <c:v>7125.20654296875</c:v>
                </c:pt>
                <c:pt idx="203">
                  <c:v>7079.95361328125</c:v>
                </c:pt>
                <c:pt idx="204">
                  <c:v>7023.74462890625</c:v>
                </c:pt>
                <c:pt idx="205">
                  <c:v>6971.46630859375</c:v>
                </c:pt>
                <c:pt idx="206">
                  <c:v>6939.6806640625</c:v>
                </c:pt>
                <c:pt idx="207">
                  <c:v>6941.1611328125</c:v>
                </c:pt>
                <c:pt idx="208">
                  <c:v>6978.24951171875</c:v>
                </c:pt>
                <c:pt idx="209">
                  <c:v>7037.9208984375</c:v>
                </c:pt>
                <c:pt idx="210">
                  <c:v>7092.68359375</c:v>
                </c:pt>
                <c:pt idx="211">
                  <c:v>7109.97021484375</c:v>
                </c:pt>
                <c:pt idx="212">
                  <c:v>7068.1611328125</c:v>
                </c:pt>
                <c:pt idx="213">
                  <c:v>6971.947265625</c:v>
                </c:pt>
                <c:pt idx="214">
                  <c:v>6857.11376953125</c:v>
                </c:pt>
                <c:pt idx="215">
                  <c:v>6778.24365234375</c:v>
                </c:pt>
                <c:pt idx="216">
                  <c:v>6782.0341796875</c:v>
                </c:pt>
                <c:pt idx="217">
                  <c:v>6879.2666015625</c:v>
                </c:pt>
                <c:pt idx="218">
                  <c:v>7032.7607421875</c:v>
                </c:pt>
                <c:pt idx="219">
                  <c:v>7172.11767578125</c:v>
                </c:pt>
                <c:pt idx="220">
                  <c:v>7230.4365234375</c:v>
                </c:pt>
                <c:pt idx="221">
                  <c:v>7182.72265625</c:v>
                </c:pt>
                <c:pt idx="222">
                  <c:v>7061.5146484375</c:v>
                </c:pt>
                <c:pt idx="223">
                  <c:v>6937.5625</c:v>
                </c:pt>
                <c:pt idx="224">
                  <c:v>6875.953125</c:v>
                </c:pt>
                <c:pt idx="225">
                  <c:v>6895.87255859375</c:v>
                </c:pt>
                <c:pt idx="226">
                  <c:v>6961.5478515625</c:v>
                </c:pt>
                <c:pt idx="227">
                  <c:v>7011.25830078125</c:v>
                </c:pt>
                <c:pt idx="228">
                  <c:v>7004.0791015625</c:v>
                </c:pt>
                <c:pt idx="229">
                  <c:v>6950.2255859375</c:v>
                </c:pt>
                <c:pt idx="230">
                  <c:v>6901.9306640625</c:v>
                </c:pt>
                <c:pt idx="231">
                  <c:v>6910.99951171875</c:v>
                </c:pt>
                <c:pt idx="232">
                  <c:v>6985.12158203125</c:v>
                </c:pt>
                <c:pt idx="233">
                  <c:v>7077.3486328125</c:v>
                </c:pt>
                <c:pt idx="234">
                  <c:v>7118.7265625</c:v>
                </c:pt>
                <c:pt idx="235">
                  <c:v>7070.68408203125</c:v>
                </c:pt>
                <c:pt idx="236">
                  <c:v>6957.22802734375</c:v>
                </c:pt>
                <c:pt idx="237">
                  <c:v>6851.0439453125</c:v>
                </c:pt>
                <c:pt idx="238">
                  <c:v>6822.47509765625</c:v>
                </c:pt>
                <c:pt idx="239">
                  <c:v>6889.27880859375</c:v>
                </c:pt>
                <c:pt idx="240">
                  <c:v>7005.1796875</c:v>
                </c:pt>
                <c:pt idx="241">
                  <c:v>7095.7470703125</c:v>
                </c:pt>
                <c:pt idx="242">
                  <c:v>7113.73779296875</c:v>
                </c:pt>
                <c:pt idx="243">
                  <c:v>7071.27880859375</c:v>
                </c:pt>
                <c:pt idx="244">
                  <c:v>7024.896484375</c:v>
                </c:pt>
                <c:pt idx="245">
                  <c:v>7026.736328125</c:v>
                </c:pt>
                <c:pt idx="246">
                  <c:v>7081.68359375</c:v>
                </c:pt>
                <c:pt idx="247">
                  <c:v>7144.57177734375</c:v>
                </c:pt>
                <c:pt idx="248">
                  <c:v>7158.88525390625</c:v>
                </c:pt>
                <c:pt idx="249">
                  <c:v>7104.83349609375</c:v>
                </c:pt>
                <c:pt idx="250">
                  <c:v>7017.35595703125</c:v>
                </c:pt>
                <c:pt idx="251">
                  <c:v>6959.26708984375</c:v>
                </c:pt>
                <c:pt idx="252">
                  <c:v>6971.16796875</c:v>
                </c:pt>
                <c:pt idx="253">
                  <c:v>7038.54296875</c:v>
                </c:pt>
                <c:pt idx="254">
                  <c:v>7102.537109375</c:v>
                </c:pt>
                <c:pt idx="255">
                  <c:v>7105.8291015625</c:v>
                </c:pt>
                <c:pt idx="256">
                  <c:v>7037.1591796875</c:v>
                </c:pt>
                <c:pt idx="257">
                  <c:v>6939.62353515625</c:v>
                </c:pt>
                <c:pt idx="258">
                  <c:v>6877.02783203125</c:v>
                </c:pt>
                <c:pt idx="259">
                  <c:v>6885.57568359375</c:v>
                </c:pt>
                <c:pt idx="260">
                  <c:v>6948.70361328125</c:v>
                </c:pt>
                <c:pt idx="261">
                  <c:v>7013.3271484375</c:v>
                </c:pt>
                <c:pt idx="262">
                  <c:v>7032.69677734375</c:v>
                </c:pt>
                <c:pt idx="263">
                  <c:v>7001.17578125</c:v>
                </c:pt>
                <c:pt idx="264">
                  <c:v>6954.53271484375</c:v>
                </c:pt>
                <c:pt idx="265">
                  <c:v>6937.93310546875</c:v>
                </c:pt>
                <c:pt idx="266">
                  <c:v>6968.90283203125</c:v>
                </c:pt>
                <c:pt idx="267">
                  <c:v>7024.63916015625</c:v>
                </c:pt>
                <c:pt idx="268">
                  <c:v>7061.8544921875</c:v>
                </c:pt>
                <c:pt idx="269">
                  <c:v>7051.2373046875</c:v>
                </c:pt>
                <c:pt idx="270">
                  <c:v>6998.60986328125</c:v>
                </c:pt>
                <c:pt idx="271">
                  <c:v>6937.69873046875</c:v>
                </c:pt>
                <c:pt idx="272">
                  <c:v>6903.05126953125</c:v>
                </c:pt>
                <c:pt idx="273">
                  <c:v>6906.31591796875</c:v>
                </c:pt>
                <c:pt idx="274">
                  <c:v>6933.734375</c:v>
                </c:pt>
                <c:pt idx="275">
                  <c:v>6963.50634765625</c:v>
                </c:pt>
                <c:pt idx="276">
                  <c:v>6985.509765625</c:v>
                </c:pt>
                <c:pt idx="277">
                  <c:v>7005.97265625</c:v>
                </c:pt>
                <c:pt idx="278">
                  <c:v>7034.6689453125</c:v>
                </c:pt>
                <c:pt idx="279">
                  <c:v>7068.33447265625</c:v>
                </c:pt>
                <c:pt idx="280">
                  <c:v>7087.23193359375</c:v>
                </c:pt>
                <c:pt idx="281">
                  <c:v>7069.75927734375</c:v>
                </c:pt>
                <c:pt idx="282">
                  <c:v>7013.3896484375</c:v>
                </c:pt>
                <c:pt idx="283">
                  <c:v>6943.48388671875</c:v>
                </c:pt>
                <c:pt idx="284">
                  <c:v>6900.4970703125</c:v>
                </c:pt>
                <c:pt idx="285">
                  <c:v>6913.46435546875</c:v>
                </c:pt>
                <c:pt idx="286">
                  <c:v>6979.2080078125</c:v>
                </c:pt>
                <c:pt idx="287">
                  <c:v>7063.056640625</c:v>
                </c:pt>
                <c:pt idx="288">
                  <c:v>7120.9638671875</c:v>
                </c:pt>
                <c:pt idx="289">
                  <c:v>7127.23681640625</c:v>
                </c:pt>
                <c:pt idx="290">
                  <c:v>7088.57421875</c:v>
                </c:pt>
                <c:pt idx="291">
                  <c:v>7035.8701171875</c:v>
                </c:pt>
                <c:pt idx="292">
                  <c:v>7001.4326171875</c:v>
                </c:pt>
                <c:pt idx="293">
                  <c:v>6998.65087890625</c:v>
                </c:pt>
                <c:pt idx="294">
                  <c:v>7017.43701171875</c:v>
                </c:pt>
                <c:pt idx="295">
                  <c:v>7035.99365234375</c:v>
                </c:pt>
                <c:pt idx="296">
                  <c:v>7037.9658203125</c:v>
                </c:pt>
                <c:pt idx="297">
                  <c:v>7022.044921875</c:v>
                </c:pt>
                <c:pt idx="298">
                  <c:v>6998.85400390625</c:v>
                </c:pt>
                <c:pt idx="299">
                  <c:v>6980.28662109375</c:v>
                </c:pt>
                <c:pt idx="300">
                  <c:v>6971.1943359375</c:v>
                </c:pt>
                <c:pt idx="301">
                  <c:v>6969.52587890625</c:v>
                </c:pt>
                <c:pt idx="302">
                  <c:v>6972.8359375</c:v>
                </c:pt>
                <c:pt idx="303">
                  <c:v>6983.66796875</c:v>
                </c:pt>
                <c:pt idx="304">
                  <c:v>7007.9892578125</c:v>
                </c:pt>
                <c:pt idx="305">
                  <c:v>7047.65771484375</c:v>
                </c:pt>
                <c:pt idx="306">
                  <c:v>7093.85498046875</c:v>
                </c:pt>
                <c:pt idx="307">
                  <c:v>7128.26953125</c:v>
                </c:pt>
                <c:pt idx="308">
                  <c:v>7132.6474609375</c:v>
                </c:pt>
                <c:pt idx="309">
                  <c:v>7100.185546875</c:v>
                </c:pt>
                <c:pt idx="310">
                  <c:v>7040.13916015625</c:v>
                </c:pt>
                <c:pt idx="311">
                  <c:v>6971.91455078125</c:v>
                </c:pt>
                <c:pt idx="312">
                  <c:v>6913.08935546875</c:v>
                </c:pt>
                <c:pt idx="313">
                  <c:v>6870.64404296875</c:v>
                </c:pt>
                <c:pt idx="314">
                  <c:v>6842.04150390625</c:v>
                </c:pt>
                <c:pt idx="315">
                  <c:v>6824.47998046875</c:v>
                </c:pt>
                <c:pt idx="316">
                  <c:v>6823.380859375</c:v>
                </c:pt>
                <c:pt idx="317">
                  <c:v>6851.1875</c:v>
                </c:pt>
                <c:pt idx="318">
                  <c:v>6915.56640625</c:v>
                </c:pt>
                <c:pt idx="319">
                  <c:v>7006.03173828125</c:v>
                </c:pt>
                <c:pt idx="320">
                  <c:v>7091.521484375</c:v>
                </c:pt>
                <c:pt idx="321">
                  <c:v>7134.568359375</c:v>
                </c:pt>
                <c:pt idx="322">
                  <c:v>7114.779296875</c:v>
                </c:pt>
                <c:pt idx="323">
                  <c:v>7045.21826171875</c:v>
                </c:pt>
                <c:pt idx="324">
                  <c:v>6968.0234375</c:v>
                </c:pt>
                <c:pt idx="325">
                  <c:v>6929.55615234375</c:v>
                </c:pt>
                <c:pt idx="326">
                  <c:v>6950.81689453125</c:v>
                </c:pt>
                <c:pt idx="327">
                  <c:v>7013.8388671875</c:v>
                </c:pt>
                <c:pt idx="328">
                  <c:v>7074.4921875</c:v>
                </c:pt>
                <c:pt idx="329">
                  <c:v>7093.32373046875</c:v>
                </c:pt>
                <c:pt idx="330">
                  <c:v>7062.5712890625</c:v>
                </c:pt>
                <c:pt idx="331">
                  <c:v>7009.90673828125</c:v>
                </c:pt>
                <c:pt idx="332">
                  <c:v>6976.4951171875</c:v>
                </c:pt>
                <c:pt idx="333">
                  <c:v>6986.080078125</c:v>
                </c:pt>
                <c:pt idx="334">
                  <c:v>7028.3466796875</c:v>
                </c:pt>
                <c:pt idx="335">
                  <c:v>7068.67236328125</c:v>
                </c:pt>
                <c:pt idx="336">
                  <c:v>7076.021484375</c:v>
                </c:pt>
                <c:pt idx="337">
                  <c:v>7046.9189453125</c:v>
                </c:pt>
                <c:pt idx="338">
                  <c:v>7006.9716796875</c:v>
                </c:pt>
                <c:pt idx="339">
                  <c:v>6989.32568359375</c:v>
                </c:pt>
                <c:pt idx="340">
                  <c:v>7007.64306640625</c:v>
                </c:pt>
                <c:pt idx="341">
                  <c:v>7045.19384765625</c:v>
                </c:pt>
                <c:pt idx="342">
                  <c:v>7068.53955078125</c:v>
                </c:pt>
                <c:pt idx="343">
                  <c:v>7054.59521484375</c:v>
                </c:pt>
                <c:pt idx="344">
                  <c:v>7009.37939453125</c:v>
                </c:pt>
                <c:pt idx="345">
                  <c:v>6963.65576171875</c:v>
                </c:pt>
                <c:pt idx="346">
                  <c:v>6949.177734375</c:v>
                </c:pt>
                <c:pt idx="347">
                  <c:v>6974.42578125</c:v>
                </c:pt>
                <c:pt idx="348">
                  <c:v>7018.6630859375</c:v>
                </c:pt>
                <c:pt idx="349">
                  <c:v>7048.2763671875</c:v>
                </c:pt>
              </c:numCache>
            </c:numRef>
          </c:yVal>
          <c:smooth val="1"/>
          <c:extLst>
            <c:ext xmlns:c16="http://schemas.microsoft.com/office/drawing/2014/chart" uri="{C3380CC4-5D6E-409C-BE32-E72D297353CC}">
              <c16:uniqueId val="{00000019-4A37-429A-A58F-F7AEDA5D1ACA}"/>
            </c:ext>
          </c:extLst>
        </c:ser>
        <c:ser>
          <c:idx val="26"/>
          <c:order val="26"/>
          <c:tx>
            <c:strRef>
              <c:f>cp_sub_001!$AA$1</c:f>
              <c:strCache>
                <c:ptCount val="1"/>
                <c:pt idx="0">
                  <c:v>Coor_27</c:v>
                </c:pt>
              </c:strCache>
            </c:strRef>
          </c:tx>
          <c:spPr>
            <a:ln w="28575" cap="rnd">
              <a:solidFill>
                <a:schemeClr val="accent3">
                  <a:lumMod val="60000"/>
                  <a:lumOff val="40000"/>
                </a:schemeClr>
              </a:solidFill>
              <a:round/>
            </a:ln>
            <a:effectLst/>
          </c:spPr>
          <c:marker>
            <c:symbol val="none"/>
          </c:marker>
          <c:yVal>
            <c:numRef>
              <c:f>cp_sub_001!$AA$2:$AA$351</c:f>
              <c:numCache>
                <c:formatCode>0.00000000000_ </c:formatCode>
                <c:ptCount val="350"/>
                <c:pt idx="0">
                  <c:v>8031.30908203125</c:v>
                </c:pt>
                <c:pt idx="1">
                  <c:v>8034.06201171875</c:v>
                </c:pt>
                <c:pt idx="2">
                  <c:v>8042.02392578125</c:v>
                </c:pt>
                <c:pt idx="3">
                  <c:v>8051.47216796875</c:v>
                </c:pt>
                <c:pt idx="4">
                  <c:v>8063.5107421875</c:v>
                </c:pt>
                <c:pt idx="5">
                  <c:v>8083.10595703125</c:v>
                </c:pt>
                <c:pt idx="6">
                  <c:v>8112.75</c:v>
                </c:pt>
                <c:pt idx="7">
                  <c:v>8146.45166015625</c:v>
                </c:pt>
                <c:pt idx="8">
                  <c:v>8170.19873046875</c:v>
                </c:pt>
                <c:pt idx="9">
                  <c:v>8169.796875</c:v>
                </c:pt>
                <c:pt idx="10">
                  <c:v>8140.48291015625</c:v>
                </c:pt>
                <c:pt idx="11">
                  <c:v>8090.69189453125</c:v>
                </c:pt>
                <c:pt idx="12">
                  <c:v>8036.76953125</c:v>
                </c:pt>
                <c:pt idx="13">
                  <c:v>7992.74853515625</c:v>
                </c:pt>
                <c:pt idx="14">
                  <c:v>7963.24267578125</c:v>
                </c:pt>
                <c:pt idx="15">
                  <c:v>7944.70654296875</c:v>
                </c:pt>
                <c:pt idx="16">
                  <c:v>7933.10107421875</c:v>
                </c:pt>
                <c:pt idx="17">
                  <c:v>7930.60888671875</c:v>
                </c:pt>
                <c:pt idx="18">
                  <c:v>7945.083984375</c:v>
                </c:pt>
                <c:pt idx="19">
                  <c:v>7982.46826171875</c:v>
                </c:pt>
                <c:pt idx="20">
                  <c:v>8038.7646484375</c:v>
                </c:pt>
                <c:pt idx="21">
                  <c:v>8098.8583984375</c:v>
                </c:pt>
                <c:pt idx="22">
                  <c:v>8143.9267578125</c:v>
                </c:pt>
                <c:pt idx="23">
                  <c:v>8162.095703125</c:v>
                </c:pt>
                <c:pt idx="24">
                  <c:v>8154.40966796875</c:v>
                </c:pt>
                <c:pt idx="25">
                  <c:v>8132.05322265625</c:v>
                </c:pt>
                <c:pt idx="26">
                  <c:v>8107.68603515625</c:v>
                </c:pt>
                <c:pt idx="27">
                  <c:v>8087.912109375</c:v>
                </c:pt>
                <c:pt idx="28">
                  <c:v>8072.09033203125</c:v>
                </c:pt>
                <c:pt idx="29">
                  <c:v>8056.9697265625</c:v>
                </c:pt>
                <c:pt idx="30">
                  <c:v>8042.04150390625</c:v>
                </c:pt>
                <c:pt idx="31">
                  <c:v>8030.7734375</c:v>
                </c:pt>
                <c:pt idx="32">
                  <c:v>8027.251953125</c:v>
                </c:pt>
                <c:pt idx="33">
                  <c:v>8032.00390625</c:v>
                </c:pt>
                <c:pt idx="34">
                  <c:v>8041.19091796875</c:v>
                </c:pt>
                <c:pt idx="35">
                  <c:v>8049.9609375</c:v>
                </c:pt>
                <c:pt idx="36">
                  <c:v>8056.80029296875</c:v>
                </c:pt>
                <c:pt idx="37">
                  <c:v>8064.82080078125</c:v>
                </c:pt>
                <c:pt idx="38">
                  <c:v>8078.61767578125</c:v>
                </c:pt>
                <c:pt idx="39">
                  <c:v>8099.119140625</c:v>
                </c:pt>
                <c:pt idx="40">
                  <c:v>8120.51904296875</c:v>
                </c:pt>
                <c:pt idx="41">
                  <c:v>8131.84228515625</c:v>
                </c:pt>
                <c:pt idx="42">
                  <c:v>8122.5048828125</c:v>
                </c:pt>
                <c:pt idx="43">
                  <c:v>8088.84033203125</c:v>
                </c:pt>
                <c:pt idx="44">
                  <c:v>8038.17431640625</c:v>
                </c:pt>
                <c:pt idx="45">
                  <c:v>7988.1240234375</c:v>
                </c:pt>
                <c:pt idx="46">
                  <c:v>7960.4921875</c:v>
                </c:pt>
                <c:pt idx="47">
                  <c:v>7971.1982421875</c:v>
                </c:pt>
                <c:pt idx="48">
                  <c:v>8020.1796875</c:v>
                </c:pt>
                <c:pt idx="49">
                  <c:v>8087.146484375</c:v>
                </c:pt>
                <c:pt idx="50">
                  <c:v>8138.17724609375</c:v>
                </c:pt>
                <c:pt idx="51">
                  <c:v>8142.8310546875</c:v>
                </c:pt>
                <c:pt idx="52">
                  <c:v>8093.6435546875</c:v>
                </c:pt>
                <c:pt idx="53">
                  <c:v>8015.107421875</c:v>
                </c:pt>
                <c:pt idx="54">
                  <c:v>7953.0087890625</c:v>
                </c:pt>
                <c:pt idx="55">
                  <c:v>7947.203125</c:v>
                </c:pt>
                <c:pt idx="56">
                  <c:v>8004.14501953125</c:v>
                </c:pt>
                <c:pt idx="57">
                  <c:v>8089.02880859375</c:v>
                </c:pt>
                <c:pt idx="58">
                  <c:v>8146.21044921875</c:v>
                </c:pt>
                <c:pt idx="59">
                  <c:v>8136.58642578125</c:v>
                </c:pt>
                <c:pt idx="60">
                  <c:v>8066.36083984375</c:v>
                </c:pt>
                <c:pt idx="61">
                  <c:v>7985.18603515625</c:v>
                </c:pt>
                <c:pt idx="62">
                  <c:v>7952.65478515625</c:v>
                </c:pt>
                <c:pt idx="63">
                  <c:v>7995.8896484375</c:v>
                </c:pt>
                <c:pt idx="64">
                  <c:v>8089.16796875</c:v>
                </c:pt>
                <c:pt idx="65">
                  <c:v>8171.51318359375</c:v>
                </c:pt>
                <c:pt idx="66">
                  <c:v>8190.08935546875</c:v>
                </c:pt>
                <c:pt idx="67">
                  <c:v>8137.4140625</c:v>
                </c:pt>
                <c:pt idx="68">
                  <c:v>8054.60205078125</c:v>
                </c:pt>
                <c:pt idx="69">
                  <c:v>7998.6259765625</c:v>
                </c:pt>
                <c:pt idx="70">
                  <c:v>7999.189453125</c:v>
                </c:pt>
                <c:pt idx="71">
                  <c:v>8038.58154296875</c:v>
                </c:pt>
                <c:pt idx="72">
                  <c:v>8069.52587890625</c:v>
                </c:pt>
                <c:pt idx="73">
                  <c:v>8055.97802734375</c:v>
                </c:pt>
                <c:pt idx="74">
                  <c:v>8003.89794921875</c:v>
                </c:pt>
                <c:pt idx="75">
                  <c:v>7957.4833984375</c:v>
                </c:pt>
                <c:pt idx="76">
                  <c:v>7964.15771484375</c:v>
                </c:pt>
                <c:pt idx="77">
                  <c:v>8036.4111328125</c:v>
                </c:pt>
                <c:pt idx="78">
                  <c:v>8140.58740234375</c:v>
                </c:pt>
                <c:pt idx="79">
                  <c:v>8220.80859375</c:v>
                </c:pt>
                <c:pt idx="80">
                  <c:v>8238.4990234375</c:v>
                </c:pt>
                <c:pt idx="81">
                  <c:v>8196.6923828125</c:v>
                </c:pt>
                <c:pt idx="82">
                  <c:v>8131.892578125</c:v>
                </c:pt>
                <c:pt idx="83">
                  <c:v>8082.66259765625</c:v>
                </c:pt>
                <c:pt idx="84">
                  <c:v>8061.63720703125</c:v>
                </c:pt>
                <c:pt idx="85">
                  <c:v>8052.57177734375</c:v>
                </c:pt>
                <c:pt idx="86">
                  <c:v>8031.876953125</c:v>
                </c:pt>
                <c:pt idx="87">
                  <c:v>7993.94921875</c:v>
                </c:pt>
                <c:pt idx="88">
                  <c:v>7958.01416015625</c:v>
                </c:pt>
                <c:pt idx="89">
                  <c:v>7951.337890625</c:v>
                </c:pt>
                <c:pt idx="90">
                  <c:v>7984.2451171875</c:v>
                </c:pt>
                <c:pt idx="91">
                  <c:v>8038.86865234375</c:v>
                </c:pt>
                <c:pt idx="92">
                  <c:v>8081.21484375</c:v>
                </c:pt>
                <c:pt idx="93">
                  <c:v>8086.2177734375</c:v>
                </c:pt>
                <c:pt idx="94">
                  <c:v>8055.12060546875</c:v>
                </c:pt>
                <c:pt idx="95">
                  <c:v>8011.93310546875</c:v>
                </c:pt>
                <c:pt idx="96">
                  <c:v>7983.65185546875</c:v>
                </c:pt>
                <c:pt idx="97">
                  <c:v>7981.65185546875</c:v>
                </c:pt>
                <c:pt idx="98">
                  <c:v>7998.8095703125</c:v>
                </c:pt>
                <c:pt idx="99">
                  <c:v>8021.95263671875</c:v>
                </c:pt>
                <c:pt idx="100">
                  <c:v>8046.01416015625</c:v>
                </c:pt>
                <c:pt idx="101">
                  <c:v>8076.20068359375</c:v>
                </c:pt>
                <c:pt idx="102">
                  <c:v>8116.947265625</c:v>
                </c:pt>
                <c:pt idx="103">
                  <c:v>8159.599609375</c:v>
                </c:pt>
                <c:pt idx="104">
                  <c:v>8182.53125</c:v>
                </c:pt>
                <c:pt idx="105">
                  <c:v>8166.115234375</c:v>
                </c:pt>
                <c:pt idx="106">
                  <c:v>8110.77978515625</c:v>
                </c:pt>
                <c:pt idx="107">
                  <c:v>8042.10546875</c:v>
                </c:pt>
                <c:pt idx="108">
                  <c:v>7996.7109375</c:v>
                </c:pt>
                <c:pt idx="109">
                  <c:v>7998.400390625</c:v>
                </c:pt>
                <c:pt idx="110">
                  <c:v>8042.37646484375</c:v>
                </c:pt>
                <c:pt idx="111">
                  <c:v>8099.2431640625</c:v>
                </c:pt>
                <c:pt idx="112">
                  <c:v>8135.193359375</c:v>
                </c:pt>
                <c:pt idx="113">
                  <c:v>8132.908203125</c:v>
                </c:pt>
                <c:pt idx="114">
                  <c:v>8098.591796875</c:v>
                </c:pt>
                <c:pt idx="115">
                  <c:v>8052.6259765625</c:v>
                </c:pt>
                <c:pt idx="116">
                  <c:v>8013.89501953125</c:v>
                </c:pt>
                <c:pt idx="117">
                  <c:v>7990.68505859375</c:v>
                </c:pt>
                <c:pt idx="118">
                  <c:v>7983.0478515625</c:v>
                </c:pt>
                <c:pt idx="119">
                  <c:v>7990.6533203125</c:v>
                </c:pt>
                <c:pt idx="120">
                  <c:v>8016.232421875</c:v>
                </c:pt>
                <c:pt idx="121">
                  <c:v>8060.5771484375</c:v>
                </c:pt>
                <c:pt idx="122">
                  <c:v>8114.56005859375</c:v>
                </c:pt>
                <c:pt idx="123">
                  <c:v>8157.69482421875</c:v>
                </c:pt>
                <c:pt idx="124">
                  <c:v>8167.48486328125</c:v>
                </c:pt>
                <c:pt idx="125">
                  <c:v>8133.9912109375</c:v>
                </c:pt>
                <c:pt idx="126">
                  <c:v>8068.474609375</c:v>
                </c:pt>
                <c:pt idx="127">
                  <c:v>7998.71826171875</c:v>
                </c:pt>
                <c:pt idx="128">
                  <c:v>7953.64501953125</c:v>
                </c:pt>
                <c:pt idx="129">
                  <c:v>7947.77685546875</c:v>
                </c:pt>
                <c:pt idx="130">
                  <c:v>7975.6611328125</c:v>
                </c:pt>
                <c:pt idx="131">
                  <c:v>8018.49951171875</c:v>
                </c:pt>
                <c:pt idx="132">
                  <c:v>8056.65625</c:v>
                </c:pt>
                <c:pt idx="133">
                  <c:v>8079.123046875</c:v>
                </c:pt>
                <c:pt idx="134">
                  <c:v>8085.2919921875</c:v>
                </c:pt>
                <c:pt idx="135">
                  <c:v>8080.92578125</c:v>
                </c:pt>
                <c:pt idx="136">
                  <c:v>8073.27783203125</c:v>
                </c:pt>
                <c:pt idx="137">
                  <c:v>8068.4443359375</c:v>
                </c:pt>
                <c:pt idx="138">
                  <c:v>8070.34423828125</c:v>
                </c:pt>
                <c:pt idx="139">
                  <c:v>8079.44970703125</c:v>
                </c:pt>
                <c:pt idx="140">
                  <c:v>8091.39404296875</c:v>
                </c:pt>
                <c:pt idx="141">
                  <c:v>8097.935546875</c:v>
                </c:pt>
                <c:pt idx="142">
                  <c:v>8091.89111328125</c:v>
                </c:pt>
                <c:pt idx="143">
                  <c:v>8073.70751953125</c:v>
                </c:pt>
                <c:pt idx="144">
                  <c:v>8054.076171875</c:v>
                </c:pt>
                <c:pt idx="145">
                  <c:v>8048.5576171875</c:v>
                </c:pt>
                <c:pt idx="146">
                  <c:v>8066.3544921875</c:v>
                </c:pt>
                <c:pt idx="147">
                  <c:v>8101.2490234375</c:v>
                </c:pt>
                <c:pt idx="148">
                  <c:v>8132.6826171875</c:v>
                </c:pt>
                <c:pt idx="149">
                  <c:v>8137.9521484375</c:v>
                </c:pt>
                <c:pt idx="150">
                  <c:v>8107.6318359375</c:v>
                </c:pt>
                <c:pt idx="151">
                  <c:v>8052.93505859375</c:v>
                </c:pt>
                <c:pt idx="152">
                  <c:v>7999.12744140625</c:v>
                </c:pt>
                <c:pt idx="153">
                  <c:v>7969.43408203125</c:v>
                </c:pt>
                <c:pt idx="154">
                  <c:v>7971.033203125</c:v>
                </c:pt>
                <c:pt idx="155">
                  <c:v>7992.94775390625</c:v>
                </c:pt>
                <c:pt idx="156">
                  <c:v>8016.369140625</c:v>
                </c:pt>
                <c:pt idx="157">
                  <c:v>8028.658203125</c:v>
                </c:pt>
                <c:pt idx="158">
                  <c:v>8030.27294921875</c:v>
                </c:pt>
                <c:pt idx="159">
                  <c:v>8030.396484375</c:v>
                </c:pt>
                <c:pt idx="160">
                  <c:v>8036.38134765625</c:v>
                </c:pt>
                <c:pt idx="161">
                  <c:v>8046.57666015625</c:v>
                </c:pt>
                <c:pt idx="162">
                  <c:v>8052.44482421875</c:v>
                </c:pt>
                <c:pt idx="163">
                  <c:v>8047.53662109375</c:v>
                </c:pt>
                <c:pt idx="164">
                  <c:v>8035.14892578125</c:v>
                </c:pt>
                <c:pt idx="165">
                  <c:v>8027.77978515625</c:v>
                </c:pt>
                <c:pt idx="166">
                  <c:v>8038.4970703125</c:v>
                </c:pt>
                <c:pt idx="167">
                  <c:v>8070.93115234375</c:v>
                </c:pt>
                <c:pt idx="168">
                  <c:v>8115.56201171875</c:v>
                </c:pt>
                <c:pt idx="169">
                  <c:v>8154.93359375</c:v>
                </c:pt>
                <c:pt idx="170">
                  <c:v>8173.75634765625</c:v>
                </c:pt>
                <c:pt idx="171">
                  <c:v>8166.8466796875</c:v>
                </c:pt>
                <c:pt idx="172">
                  <c:v>8140.27392578125</c:v>
                </c:pt>
                <c:pt idx="173">
                  <c:v>8106.365234375</c:v>
                </c:pt>
                <c:pt idx="174">
                  <c:v>8076.99755859375</c:v>
                </c:pt>
                <c:pt idx="175">
                  <c:v>8059.412109375</c:v>
                </c:pt>
                <c:pt idx="176">
                  <c:v>8055.69970703125</c:v>
                </c:pt>
                <c:pt idx="177">
                  <c:v>8064.1806640625</c:v>
                </c:pt>
                <c:pt idx="178">
                  <c:v>8080.41064453125</c:v>
                </c:pt>
                <c:pt idx="179">
                  <c:v>8097.21923828125</c:v>
                </c:pt>
                <c:pt idx="180">
                  <c:v>8105.080078125</c:v>
                </c:pt>
                <c:pt idx="181">
                  <c:v>8094.3837890625</c:v>
                </c:pt>
                <c:pt idx="182">
                  <c:v>8059.72412109375</c:v>
                </c:pt>
                <c:pt idx="183">
                  <c:v>8004.3798828125</c:v>
                </c:pt>
                <c:pt idx="184">
                  <c:v>7942.22705078125</c:v>
                </c:pt>
                <c:pt idx="185">
                  <c:v>7894.97021484375</c:v>
                </c:pt>
                <c:pt idx="186">
                  <c:v>7884.5205078125</c:v>
                </c:pt>
                <c:pt idx="187">
                  <c:v>7922.849609375</c:v>
                </c:pt>
                <c:pt idx="188">
                  <c:v>8003.71533203125</c:v>
                </c:pt>
                <c:pt idx="189">
                  <c:v>8101.1708984375</c:v>
                </c:pt>
                <c:pt idx="190">
                  <c:v>8177.67626953125</c:v>
                </c:pt>
                <c:pt idx="191">
                  <c:v>8200.05078125</c:v>
                </c:pt>
                <c:pt idx="192">
                  <c:v>8156.3076171875</c:v>
                </c:pt>
                <c:pt idx="193">
                  <c:v>8064.048828125</c:v>
                </c:pt>
                <c:pt idx="194">
                  <c:v>7964.1728515625</c:v>
                </c:pt>
                <c:pt idx="195">
                  <c:v>7901.53173828125</c:v>
                </c:pt>
                <c:pt idx="196">
                  <c:v>7902.46044921875</c:v>
                </c:pt>
                <c:pt idx="197">
                  <c:v>7962.025390625</c:v>
                </c:pt>
                <c:pt idx="198">
                  <c:v>8048.64892578125</c:v>
                </c:pt>
                <c:pt idx="199">
                  <c:v>8123.1904296875</c:v>
                </c:pt>
                <c:pt idx="200">
                  <c:v>8160.56689453125</c:v>
                </c:pt>
                <c:pt idx="201">
                  <c:v>8160.80712890625</c:v>
                </c:pt>
                <c:pt idx="202">
                  <c:v>8143.87109375</c:v>
                </c:pt>
                <c:pt idx="203">
                  <c:v>8133.318359375</c:v>
                </c:pt>
                <c:pt idx="204">
                  <c:v>8140.46630859375</c:v>
                </c:pt>
                <c:pt idx="205">
                  <c:v>8158.85400390625</c:v>
                </c:pt>
                <c:pt idx="206">
                  <c:v>8170.802734375</c:v>
                </c:pt>
                <c:pt idx="207">
                  <c:v>8159.9052734375</c:v>
                </c:pt>
                <c:pt idx="208">
                  <c:v>8120.849609375</c:v>
                </c:pt>
                <c:pt idx="209">
                  <c:v>8061.607421875</c:v>
                </c:pt>
                <c:pt idx="210">
                  <c:v>7998.8203125</c:v>
                </c:pt>
                <c:pt idx="211">
                  <c:v>7950.595703125</c:v>
                </c:pt>
                <c:pt idx="212">
                  <c:v>7930.36669921875</c:v>
                </c:pt>
                <c:pt idx="213">
                  <c:v>7943.0693359375</c:v>
                </c:pt>
                <c:pt idx="214">
                  <c:v>7983.552734375</c:v>
                </c:pt>
                <c:pt idx="215">
                  <c:v>8037.62353515625</c:v>
                </c:pt>
                <c:pt idx="216">
                  <c:v>8086.61279296875</c:v>
                </c:pt>
                <c:pt idx="217">
                  <c:v>8114.90087890625</c:v>
                </c:pt>
                <c:pt idx="218">
                  <c:v>8117.01708984375</c:v>
                </c:pt>
                <c:pt idx="219">
                  <c:v>8099.60791015625</c:v>
                </c:pt>
                <c:pt idx="220">
                  <c:v>8076.111328125</c:v>
                </c:pt>
                <c:pt idx="221">
                  <c:v>8057.25830078125</c:v>
                </c:pt>
                <c:pt idx="222">
                  <c:v>8044.32080078125</c:v>
                </c:pt>
                <c:pt idx="223">
                  <c:v>8030.52001953125</c:v>
                </c:pt>
                <c:pt idx="224">
                  <c:v>8009.6513671875</c:v>
                </c:pt>
                <c:pt idx="225">
                  <c:v>7984.75390625</c:v>
                </c:pt>
                <c:pt idx="226">
                  <c:v>7969.03662109375</c:v>
                </c:pt>
                <c:pt idx="227">
                  <c:v>7977.3271484375</c:v>
                </c:pt>
                <c:pt idx="228">
                  <c:v>8014.32958984375</c:v>
                </c:pt>
                <c:pt idx="229">
                  <c:v>8069.142578125</c:v>
                </c:pt>
                <c:pt idx="230">
                  <c:v>8120.8388671875</c:v>
                </c:pt>
                <c:pt idx="231">
                  <c:v>8151.11669921875</c:v>
                </c:pt>
                <c:pt idx="232">
                  <c:v>8154.4521484375</c:v>
                </c:pt>
                <c:pt idx="233">
                  <c:v>8138.51708984375</c:v>
                </c:pt>
                <c:pt idx="234">
                  <c:v>8115.8203125</c:v>
                </c:pt>
                <c:pt idx="235">
                  <c:v>8094.40576171875</c:v>
                </c:pt>
                <c:pt idx="236">
                  <c:v>8075.18798828125</c:v>
                </c:pt>
                <c:pt idx="237">
                  <c:v>8056.65283203125</c:v>
                </c:pt>
                <c:pt idx="238">
                  <c:v>8040.7275390625</c:v>
                </c:pt>
                <c:pt idx="239">
                  <c:v>8033.0234375</c:v>
                </c:pt>
                <c:pt idx="240">
                  <c:v>8036.83349609375</c:v>
                </c:pt>
                <c:pt idx="241">
                  <c:v>8047.23974609375</c:v>
                </c:pt>
                <c:pt idx="242">
                  <c:v>8052.439453125</c:v>
                </c:pt>
                <c:pt idx="243">
                  <c:v>8042.84619140625</c:v>
                </c:pt>
                <c:pt idx="244">
                  <c:v>8020.5009765625</c:v>
                </c:pt>
                <c:pt idx="245">
                  <c:v>7999.6923828125</c:v>
                </c:pt>
                <c:pt idx="246">
                  <c:v>7996.76171875</c:v>
                </c:pt>
                <c:pt idx="247">
                  <c:v>8016.9208984375</c:v>
                </c:pt>
                <c:pt idx="248">
                  <c:v>8049.5244140625</c:v>
                </c:pt>
                <c:pt idx="249">
                  <c:v>8076.5595703125</c:v>
                </c:pt>
                <c:pt idx="250">
                  <c:v>8087.4853515625</c:v>
                </c:pt>
                <c:pt idx="251">
                  <c:v>8087.3359375</c:v>
                </c:pt>
                <c:pt idx="252">
                  <c:v>8090.38623046875</c:v>
                </c:pt>
                <c:pt idx="253">
                  <c:v>8104.65869140625</c:v>
                </c:pt>
                <c:pt idx="254">
                  <c:v>8121.62646484375</c:v>
                </c:pt>
                <c:pt idx="255">
                  <c:v>8121.9150390625</c:v>
                </c:pt>
                <c:pt idx="256">
                  <c:v>8093.67724609375</c:v>
                </c:pt>
                <c:pt idx="257">
                  <c:v>8047.70458984375</c:v>
                </c:pt>
                <c:pt idx="258">
                  <c:v>8014.06103515625</c:v>
                </c:pt>
                <c:pt idx="259">
                  <c:v>8019.89404296875</c:v>
                </c:pt>
                <c:pt idx="260">
                  <c:v>8065.212890625</c:v>
                </c:pt>
                <c:pt idx="261">
                  <c:v>8117.68798828125</c:v>
                </c:pt>
                <c:pt idx="262">
                  <c:v>8133.783203125</c:v>
                </c:pt>
                <c:pt idx="263">
                  <c:v>8091.97802734375</c:v>
                </c:pt>
                <c:pt idx="264">
                  <c:v>8012.19873046875</c:v>
                </c:pt>
                <c:pt idx="265">
                  <c:v>7944.5751953125</c:v>
                </c:pt>
                <c:pt idx="266">
                  <c:v>7934.173828125</c:v>
                </c:pt>
                <c:pt idx="267">
                  <c:v>7987.8759765625</c:v>
                </c:pt>
                <c:pt idx="268">
                  <c:v>8068.947265625</c:v>
                </c:pt>
                <c:pt idx="269">
                  <c:v>8123.876953125</c:v>
                </c:pt>
                <c:pt idx="270">
                  <c:v>8121.13916015625</c:v>
                </c:pt>
                <c:pt idx="271">
                  <c:v>8072.4697265625</c:v>
                </c:pt>
                <c:pt idx="272">
                  <c:v>8021.24560546875</c:v>
                </c:pt>
                <c:pt idx="273">
                  <c:v>8008.22216796875</c:v>
                </c:pt>
                <c:pt idx="274">
                  <c:v>8041.74951171875</c:v>
                </c:pt>
                <c:pt idx="275">
                  <c:v>8094.6298828125</c:v>
                </c:pt>
                <c:pt idx="276">
                  <c:v>8127.85888671875</c:v>
                </c:pt>
                <c:pt idx="277">
                  <c:v>8120.79345703125</c:v>
                </c:pt>
                <c:pt idx="278">
                  <c:v>8084.08935546875</c:v>
                </c:pt>
                <c:pt idx="279">
                  <c:v>8047.41015625</c:v>
                </c:pt>
                <c:pt idx="280">
                  <c:v>8034.47705078125</c:v>
                </c:pt>
                <c:pt idx="281">
                  <c:v>8046.60400390625</c:v>
                </c:pt>
                <c:pt idx="282">
                  <c:v>8066.53125</c:v>
                </c:pt>
                <c:pt idx="283">
                  <c:v>8076.4208984375</c:v>
                </c:pt>
                <c:pt idx="284">
                  <c:v>8072.92333984375</c:v>
                </c:pt>
                <c:pt idx="285">
                  <c:v>8066.837890625</c:v>
                </c:pt>
                <c:pt idx="286">
                  <c:v>8069.66064453125</c:v>
                </c:pt>
                <c:pt idx="287">
                  <c:v>8080.75</c:v>
                </c:pt>
                <c:pt idx="288">
                  <c:v>8087.12841796875</c:v>
                </c:pt>
                <c:pt idx="289">
                  <c:v>8075.64794921875</c:v>
                </c:pt>
                <c:pt idx="290">
                  <c:v>8045.869140625</c:v>
                </c:pt>
                <c:pt idx="291">
                  <c:v>8011.76318359375</c:v>
                </c:pt>
                <c:pt idx="292">
                  <c:v>7990.85107421875</c:v>
                </c:pt>
                <c:pt idx="293">
                  <c:v>7990.75439453125</c:v>
                </c:pt>
                <c:pt idx="294">
                  <c:v>8005.0361328125</c:v>
                </c:pt>
                <c:pt idx="295">
                  <c:v>8021.27587890625</c:v>
                </c:pt>
                <c:pt idx="296">
                  <c:v>8033.0791015625</c:v>
                </c:pt>
                <c:pt idx="297">
                  <c:v>8044.55126953125</c:v>
                </c:pt>
                <c:pt idx="298">
                  <c:v>8063.3701171875</c:v>
                </c:pt>
                <c:pt idx="299">
                  <c:v>8089.7353515625</c:v>
                </c:pt>
                <c:pt idx="300">
                  <c:v>8112.6455078125</c:v>
                </c:pt>
                <c:pt idx="301">
                  <c:v>8118.1083984375</c:v>
                </c:pt>
                <c:pt idx="302">
                  <c:v>8102.27001953125</c:v>
                </c:pt>
                <c:pt idx="303">
                  <c:v>8076.9501953125</c:v>
                </c:pt>
                <c:pt idx="304">
                  <c:v>8061.169921875</c:v>
                </c:pt>
                <c:pt idx="305">
                  <c:v>8064.96337890625</c:v>
                </c:pt>
                <c:pt idx="306">
                  <c:v>8079.625</c:v>
                </c:pt>
                <c:pt idx="307">
                  <c:v>8084.02880859375</c:v>
                </c:pt>
                <c:pt idx="308">
                  <c:v>8063.03271484375</c:v>
                </c:pt>
                <c:pt idx="309">
                  <c:v>8022.8623046875</c:v>
                </c:pt>
                <c:pt idx="310">
                  <c:v>7989.7294921875</c:v>
                </c:pt>
                <c:pt idx="311">
                  <c:v>7991.279296875</c:v>
                </c:pt>
                <c:pt idx="312">
                  <c:v>8034.873046875</c:v>
                </c:pt>
                <c:pt idx="313">
                  <c:v>8100.04541015625</c:v>
                </c:pt>
                <c:pt idx="314">
                  <c:v>8151.66455078125</c:v>
                </c:pt>
                <c:pt idx="315">
                  <c:v>8164.0380859375</c:v>
                </c:pt>
                <c:pt idx="316">
                  <c:v>8137.7001953125</c:v>
                </c:pt>
                <c:pt idx="317">
                  <c:v>8096.66552734375</c:v>
                </c:pt>
                <c:pt idx="318">
                  <c:v>8069.3076171875</c:v>
                </c:pt>
                <c:pt idx="319">
                  <c:v>8068.2119140625</c:v>
                </c:pt>
                <c:pt idx="320">
                  <c:v>8083.85546875</c:v>
                </c:pt>
                <c:pt idx="321">
                  <c:v>8095.0673828125</c:v>
                </c:pt>
                <c:pt idx="322">
                  <c:v>8086.17236328125</c:v>
                </c:pt>
                <c:pt idx="323">
                  <c:v>8057.0068359375</c:v>
                </c:pt>
                <c:pt idx="324">
                  <c:v>8019.55712890625</c:v>
                </c:pt>
                <c:pt idx="325">
                  <c:v>7986.5126953125</c:v>
                </c:pt>
                <c:pt idx="326">
                  <c:v>7962.646484375</c:v>
                </c:pt>
                <c:pt idx="327">
                  <c:v>7945.6630859375</c:v>
                </c:pt>
                <c:pt idx="328">
                  <c:v>7933.787109375</c:v>
                </c:pt>
                <c:pt idx="329">
                  <c:v>7931.5263671875</c:v>
                </c:pt>
                <c:pt idx="330">
                  <c:v>7947.5400390625</c:v>
                </c:pt>
                <c:pt idx="331">
                  <c:v>7986.43408203125</c:v>
                </c:pt>
                <c:pt idx="332">
                  <c:v>8042.1513671875</c:v>
                </c:pt>
                <c:pt idx="333">
                  <c:v>8099.232421875</c:v>
                </c:pt>
                <c:pt idx="334">
                  <c:v>8141.26953125</c:v>
                </c:pt>
                <c:pt idx="335">
                  <c:v>8159.77197265625</c:v>
                </c:pt>
                <c:pt idx="336">
                  <c:v>8156.7861328125</c:v>
                </c:pt>
                <c:pt idx="337">
                  <c:v>8140.41162109375</c:v>
                </c:pt>
                <c:pt idx="338">
                  <c:v>8118.28466796875</c:v>
                </c:pt>
                <c:pt idx="339">
                  <c:v>8094.8564453125</c:v>
                </c:pt>
                <c:pt idx="340">
                  <c:v>8073.60205078125</c:v>
                </c:pt>
                <c:pt idx="341">
                  <c:v>8060.01171875</c:v>
                </c:pt>
                <c:pt idx="342">
                  <c:v>8060.47802734375</c:v>
                </c:pt>
                <c:pt idx="343">
                  <c:v>8076.759765625</c:v>
                </c:pt>
                <c:pt idx="344">
                  <c:v>8101.10400390625</c:v>
                </c:pt>
                <c:pt idx="345">
                  <c:v>8117.9345703125</c:v>
                </c:pt>
                <c:pt idx="346">
                  <c:v>8112.90380859375</c:v>
                </c:pt>
                <c:pt idx="347">
                  <c:v>8083.34765625</c:v>
                </c:pt>
                <c:pt idx="348">
                  <c:v>8041.8193359375</c:v>
                </c:pt>
                <c:pt idx="349">
                  <c:v>8009.013671875</c:v>
                </c:pt>
              </c:numCache>
            </c:numRef>
          </c:yVal>
          <c:smooth val="1"/>
          <c:extLst>
            <c:ext xmlns:c16="http://schemas.microsoft.com/office/drawing/2014/chart" uri="{C3380CC4-5D6E-409C-BE32-E72D297353CC}">
              <c16:uniqueId val="{0000001A-4A37-429A-A58F-F7AEDA5D1ACA}"/>
            </c:ext>
          </c:extLst>
        </c:ser>
        <c:dLbls>
          <c:showLegendKey val="0"/>
          <c:showVal val="0"/>
          <c:showCatName val="0"/>
          <c:showSerName val="0"/>
          <c:showPercent val="0"/>
          <c:showBubbleSize val="0"/>
        </c:dLbls>
        <c:axId val="1133792736"/>
        <c:axId val="1133786976"/>
      </c:scatterChart>
      <c:valAx>
        <c:axId val="1133792736"/>
        <c:scaling>
          <c:orientation val="minMax"/>
          <c:max val="350"/>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zh-CN" sz="1100" b="1">
                    <a:latin typeface="Times New Roman" panose="02020603050405020304" pitchFamily="18" charset="0"/>
                    <a:cs typeface="Times New Roman" panose="02020603050405020304" pitchFamily="18" charset="0"/>
                  </a:rPr>
                  <a:t>Timepoint</a:t>
                </a:r>
                <a:endParaRPr lang="zh-CN" altLang="en-US" sz="1100" b="1">
                  <a:latin typeface="Times New Roman" panose="02020603050405020304" pitchFamily="18" charset="0"/>
                  <a:cs typeface="Times New Roman" panose="02020603050405020304" pitchFamily="18" charset="0"/>
                </a:endParaRP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zh-CN"/>
            </a:p>
          </c:txPr>
        </c:title>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crossAx val="1133786976"/>
        <c:crosses val="autoZero"/>
        <c:crossBetween val="midCat"/>
      </c:valAx>
      <c:valAx>
        <c:axId val="1133786976"/>
        <c:scaling>
          <c:orientation val="minMax"/>
          <c:min val="100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zh-CN" sz="1100" b="1" dirty="0">
                    <a:latin typeface="Times New Roman" panose="02020603050405020304" pitchFamily="18" charset="0"/>
                    <a:ea typeface="宋体" panose="02010600030101010101" pitchFamily="2" charset="-122"/>
                    <a:cs typeface="Times New Roman" panose="02020603050405020304" pitchFamily="18" charset="0"/>
                  </a:rPr>
                  <a:t>Time series value</a:t>
                </a:r>
                <a:endParaRPr lang="zh-CN" altLang="en-US" sz="1100" b="1" dirty="0">
                  <a:latin typeface="Times New Roman" panose="02020603050405020304" pitchFamily="18" charset="0"/>
                  <a:ea typeface="宋体" panose="02010600030101010101" pitchFamily="2" charset="-122"/>
                  <a:cs typeface="Times New Roman" panose="02020603050405020304" pitchFamily="18" charset="0"/>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zh-CN"/>
            </a:p>
          </c:txPr>
        </c:title>
        <c:numFmt formatCode="0_ " sourceLinked="0"/>
        <c:majorTickMark val="none"/>
        <c:minorTickMark val="none"/>
        <c:tickLblPos val="nextTo"/>
        <c:spPr>
          <a:noFill/>
          <a:ln>
            <a:solidFill>
              <a:schemeClr val="bg1">
                <a:lumMod val="8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crossAx val="1133792736"/>
        <c:crosses val="autoZero"/>
        <c:crossBetween val="midCat"/>
        <c:majorUnit val="500"/>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a:noFill/>
    </a:ln>
    <a:effectLst/>
  </c:spPr>
  <c:txPr>
    <a:bodyPr/>
    <a:lstStyle/>
    <a:p>
      <a:pPr>
        <a:defRPr/>
      </a:pPr>
      <a:endParaRPr lang="zh-CN"/>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zh-CN" b="1" dirty="0" err="1">
                <a:latin typeface="Times New Roman" panose="02020603050405020304" pitchFamily="18" charset="0"/>
                <a:ea typeface="宋体" panose="02010600030101010101" pitchFamily="2" charset="-122"/>
                <a:cs typeface="Times New Roman" panose="02020603050405020304" pitchFamily="18" charset="0"/>
              </a:rPr>
              <a:t>ReHo</a:t>
            </a:r>
            <a:r>
              <a:rPr lang="en-US" altLang="zh-CN" b="1" baseline="0" dirty="0">
                <a:latin typeface="Times New Roman" panose="02020603050405020304" pitchFamily="18" charset="0"/>
                <a:ea typeface="宋体" panose="02010600030101010101" pitchFamily="2" charset="-122"/>
                <a:cs typeface="Times New Roman" panose="02020603050405020304" pitchFamily="18" charset="0"/>
              </a:rPr>
              <a:t> time series plots for one subject in </a:t>
            </a:r>
            <a:r>
              <a:rPr lang="en-US" altLang="zh-CN" b="1" baseline="0" dirty="0" err="1">
                <a:latin typeface="Times New Roman" panose="02020603050405020304" pitchFamily="18" charset="0"/>
                <a:ea typeface="宋体" panose="02010600030101010101" pitchFamily="2" charset="-122"/>
                <a:cs typeface="Times New Roman" panose="02020603050405020304" pitchFamily="18" charset="0"/>
              </a:rPr>
              <a:t>hc</a:t>
            </a:r>
            <a:r>
              <a:rPr lang="en-US" altLang="zh-CN" b="1" baseline="0" dirty="0">
                <a:latin typeface="Times New Roman" panose="02020603050405020304" pitchFamily="18" charset="0"/>
                <a:ea typeface="宋体" panose="02010600030101010101" pitchFamily="2" charset="-122"/>
                <a:cs typeface="Times New Roman" panose="02020603050405020304" pitchFamily="18" charset="0"/>
              </a:rPr>
              <a:t> group</a:t>
            </a:r>
            <a:endParaRPr lang="zh-CN" altLang="en-US" b="1" dirty="0">
              <a:latin typeface="Times New Roman" panose="02020603050405020304" pitchFamily="18" charset="0"/>
              <a:ea typeface="宋体" panose="02010600030101010101" pitchFamily="2" charset="-122"/>
              <a:cs typeface="Times New Roman" panose="02020603050405020304" pitchFamily="18" charset="0"/>
            </a:endParaRP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zh-CN"/>
        </a:p>
      </c:txPr>
    </c:title>
    <c:autoTitleDeleted val="0"/>
    <c:plotArea>
      <c:layout/>
      <c:scatterChart>
        <c:scatterStyle val="smoothMarker"/>
        <c:varyColors val="0"/>
        <c:ser>
          <c:idx val="0"/>
          <c:order val="0"/>
          <c:tx>
            <c:strRef>
              <c:f>hc_sub_007!$A$1</c:f>
              <c:strCache>
                <c:ptCount val="1"/>
                <c:pt idx="0">
                  <c:v>Coor_1</c:v>
                </c:pt>
              </c:strCache>
            </c:strRef>
          </c:tx>
          <c:spPr>
            <a:ln w="28575" cap="rnd">
              <a:solidFill>
                <a:schemeClr val="accent1"/>
              </a:solidFill>
              <a:round/>
            </a:ln>
            <a:effectLst/>
          </c:spPr>
          <c:marker>
            <c:symbol val="none"/>
          </c:marker>
          <c:yVal>
            <c:numRef>
              <c:f>hc_sub_007!$A$2:$A$351</c:f>
              <c:numCache>
                <c:formatCode>0.00000000000_ </c:formatCode>
                <c:ptCount val="350"/>
                <c:pt idx="0">
                  <c:v>7495.873046875</c:v>
                </c:pt>
                <c:pt idx="1">
                  <c:v>7486.65234375</c:v>
                </c:pt>
                <c:pt idx="2">
                  <c:v>7474.00634765625</c:v>
                </c:pt>
                <c:pt idx="3">
                  <c:v>7465.77099609375</c:v>
                </c:pt>
                <c:pt idx="4">
                  <c:v>7461.97900390625</c:v>
                </c:pt>
                <c:pt idx="5">
                  <c:v>7453.90234375</c:v>
                </c:pt>
                <c:pt idx="6">
                  <c:v>7433.09814453125</c:v>
                </c:pt>
                <c:pt idx="7">
                  <c:v>7402.806640625</c:v>
                </c:pt>
                <c:pt idx="8">
                  <c:v>7380.58056640625</c:v>
                </c:pt>
                <c:pt idx="9">
                  <c:v>7387.73095703125</c:v>
                </c:pt>
                <c:pt idx="10">
                  <c:v>7432.83056640625</c:v>
                </c:pt>
                <c:pt idx="11">
                  <c:v>7502.85986328125</c:v>
                </c:pt>
                <c:pt idx="12">
                  <c:v>7570.35693359375</c:v>
                </c:pt>
                <c:pt idx="13">
                  <c:v>7611.81982421875</c:v>
                </c:pt>
                <c:pt idx="14">
                  <c:v>7622.716796875</c:v>
                </c:pt>
                <c:pt idx="15">
                  <c:v>7616.74462890625</c:v>
                </c:pt>
                <c:pt idx="16">
                  <c:v>7610.1904296875</c:v>
                </c:pt>
                <c:pt idx="17">
                  <c:v>7605.3173828125</c:v>
                </c:pt>
                <c:pt idx="18">
                  <c:v>7588.03466796875</c:v>
                </c:pt>
                <c:pt idx="19">
                  <c:v>7542.8525390625</c:v>
                </c:pt>
                <c:pt idx="20">
                  <c:v>7472.34228515625</c:v>
                </c:pt>
                <c:pt idx="21">
                  <c:v>7402.849609375</c:v>
                </c:pt>
                <c:pt idx="22">
                  <c:v>7368.73486328125</c:v>
                </c:pt>
                <c:pt idx="23">
                  <c:v>7385.85986328125</c:v>
                </c:pt>
                <c:pt idx="24">
                  <c:v>7435.9091796875</c:v>
                </c:pt>
                <c:pt idx="25">
                  <c:v>7476.3828125</c:v>
                </c:pt>
                <c:pt idx="26">
                  <c:v>7471.1240234375</c:v>
                </c:pt>
                <c:pt idx="27">
                  <c:v>7418.8896484375</c:v>
                </c:pt>
                <c:pt idx="28">
                  <c:v>7357.31396484375</c:v>
                </c:pt>
                <c:pt idx="29">
                  <c:v>7337.6201171875</c:v>
                </c:pt>
                <c:pt idx="30">
                  <c:v>7387.86767578125</c:v>
                </c:pt>
                <c:pt idx="31">
                  <c:v>7491.71728515625</c:v>
                </c:pt>
                <c:pt idx="32">
                  <c:v>7598.2705078125</c:v>
                </c:pt>
                <c:pt idx="33">
                  <c:v>7655.44091796875</c:v>
                </c:pt>
                <c:pt idx="34">
                  <c:v>7642.46240234375</c:v>
                </c:pt>
                <c:pt idx="35">
                  <c:v>7579.1044921875</c:v>
                </c:pt>
                <c:pt idx="36">
                  <c:v>7507.55029296875</c:v>
                </c:pt>
                <c:pt idx="37">
                  <c:v>7462.7109375</c:v>
                </c:pt>
                <c:pt idx="38">
                  <c:v>7453.0166015625</c:v>
                </c:pt>
                <c:pt idx="39">
                  <c:v>7463.01171875</c:v>
                </c:pt>
                <c:pt idx="40">
                  <c:v>7471.4462890625</c:v>
                </c:pt>
                <c:pt idx="41">
                  <c:v>7468.2763671875</c:v>
                </c:pt>
                <c:pt idx="42">
                  <c:v>7458.06787109375</c:v>
                </c:pt>
                <c:pt idx="43">
                  <c:v>7450.48291015625</c:v>
                </c:pt>
                <c:pt idx="44">
                  <c:v>7448.931640625</c:v>
                </c:pt>
                <c:pt idx="45">
                  <c:v>7448.01904296875</c:v>
                </c:pt>
                <c:pt idx="46">
                  <c:v>7440.9365234375</c:v>
                </c:pt>
                <c:pt idx="47">
                  <c:v>7428.6708984375</c:v>
                </c:pt>
                <c:pt idx="48">
                  <c:v>7421.80224609375</c:v>
                </c:pt>
                <c:pt idx="49">
                  <c:v>7432.859375</c:v>
                </c:pt>
                <c:pt idx="50">
                  <c:v>7465.7255859375</c:v>
                </c:pt>
                <c:pt idx="51">
                  <c:v>7510.95703125</c:v>
                </c:pt>
                <c:pt idx="52">
                  <c:v>7550.6708984375</c:v>
                </c:pt>
                <c:pt idx="53">
                  <c:v>7568.9638671875</c:v>
                </c:pt>
                <c:pt idx="54">
                  <c:v>7560.23046875</c:v>
                </c:pt>
                <c:pt idx="55">
                  <c:v>7530.51171875</c:v>
                </c:pt>
                <c:pt idx="56">
                  <c:v>7492.80615234375</c:v>
                </c:pt>
                <c:pt idx="57">
                  <c:v>7460.81298828125</c:v>
                </c:pt>
                <c:pt idx="58">
                  <c:v>7444.67236328125</c:v>
                </c:pt>
                <c:pt idx="59">
                  <c:v>7449.07470703125</c:v>
                </c:pt>
                <c:pt idx="60">
                  <c:v>7472.41015625</c:v>
                </c:pt>
                <c:pt idx="61">
                  <c:v>7506.6494140625</c:v>
                </c:pt>
                <c:pt idx="62">
                  <c:v>7539.33642578125</c:v>
                </c:pt>
                <c:pt idx="63">
                  <c:v>7558.5068359375</c:v>
                </c:pt>
                <c:pt idx="64">
                  <c:v>7558.52783203125</c:v>
                </c:pt>
                <c:pt idx="65">
                  <c:v>7542.73046875</c:v>
                </c:pt>
                <c:pt idx="66">
                  <c:v>7520.27294921875</c:v>
                </c:pt>
                <c:pt idx="67">
                  <c:v>7499.3642578125</c:v>
                </c:pt>
                <c:pt idx="68">
                  <c:v>7482.51318359375</c:v>
                </c:pt>
                <c:pt idx="69">
                  <c:v>7468.03076171875</c:v>
                </c:pt>
                <c:pt idx="70">
                  <c:v>7456.14404296875</c:v>
                </c:pt>
                <c:pt idx="71">
                  <c:v>7453.0634765625</c:v>
                </c:pt>
                <c:pt idx="72">
                  <c:v>7467.41845703125</c:v>
                </c:pt>
                <c:pt idx="73">
                  <c:v>7500.60888671875</c:v>
                </c:pt>
                <c:pt idx="74">
                  <c:v>7539.69873046875</c:v>
                </c:pt>
                <c:pt idx="75">
                  <c:v>7561.349609375</c:v>
                </c:pt>
                <c:pt idx="76">
                  <c:v>7546.74951171875</c:v>
                </c:pt>
                <c:pt idx="77">
                  <c:v>7497.1142578125</c:v>
                </c:pt>
                <c:pt idx="78">
                  <c:v>7436.546875</c:v>
                </c:pt>
                <c:pt idx="79">
                  <c:v>7397.61083984375</c:v>
                </c:pt>
                <c:pt idx="80">
                  <c:v>7398.84326171875</c:v>
                </c:pt>
                <c:pt idx="81">
                  <c:v>7431.13720703125</c:v>
                </c:pt>
                <c:pt idx="82">
                  <c:v>7464.22509765625</c:v>
                </c:pt>
                <c:pt idx="83">
                  <c:v>7469.08740234375</c:v>
                </c:pt>
                <c:pt idx="84">
                  <c:v>7439.3486328125</c:v>
                </c:pt>
                <c:pt idx="85">
                  <c:v>7395.25048828125</c:v>
                </c:pt>
                <c:pt idx="86">
                  <c:v>7367.6171875</c:v>
                </c:pt>
                <c:pt idx="87">
                  <c:v>7375.04345703125</c:v>
                </c:pt>
                <c:pt idx="88">
                  <c:v>7412.29052734375</c:v>
                </c:pt>
                <c:pt idx="89">
                  <c:v>7457.85107421875</c:v>
                </c:pt>
                <c:pt idx="90">
                  <c:v>7492.51318359375</c:v>
                </c:pt>
                <c:pt idx="91">
                  <c:v>7512.4521484375</c:v>
                </c:pt>
                <c:pt idx="92">
                  <c:v>7526.60498046875</c:v>
                </c:pt>
                <c:pt idx="93">
                  <c:v>7542.923828125</c:v>
                </c:pt>
                <c:pt idx="94">
                  <c:v>7557.98828125</c:v>
                </c:pt>
                <c:pt idx="95">
                  <c:v>7560.53662109375</c:v>
                </c:pt>
                <c:pt idx="96">
                  <c:v>7545.4755859375</c:v>
                </c:pt>
                <c:pt idx="97">
                  <c:v>7523.92431640625</c:v>
                </c:pt>
                <c:pt idx="98">
                  <c:v>7517.48046875</c:v>
                </c:pt>
                <c:pt idx="99">
                  <c:v>7539.4169921875</c:v>
                </c:pt>
                <c:pt idx="100">
                  <c:v>7578.9658203125</c:v>
                </c:pt>
                <c:pt idx="101">
                  <c:v>7604.404296875</c:v>
                </c:pt>
                <c:pt idx="102">
                  <c:v>7585.49365234375</c:v>
                </c:pt>
                <c:pt idx="103">
                  <c:v>7518.52197265625</c:v>
                </c:pt>
                <c:pt idx="104">
                  <c:v>7433.13232421875</c:v>
                </c:pt>
                <c:pt idx="105">
                  <c:v>7373.828125</c:v>
                </c:pt>
                <c:pt idx="106">
                  <c:v>7369.61279296875</c:v>
                </c:pt>
                <c:pt idx="107">
                  <c:v>7415.26513671875</c:v>
                </c:pt>
                <c:pt idx="108">
                  <c:v>7478.38427734375</c:v>
                </c:pt>
                <c:pt idx="109">
                  <c:v>7525.220703125</c:v>
                </c:pt>
                <c:pt idx="110">
                  <c:v>7543.3759765625</c:v>
                </c:pt>
                <c:pt idx="111">
                  <c:v>7543.43212890625</c:v>
                </c:pt>
                <c:pt idx="112">
                  <c:v>7540.8125</c:v>
                </c:pt>
                <c:pt idx="113">
                  <c:v>7536.68017578125</c:v>
                </c:pt>
                <c:pt idx="114">
                  <c:v>7516.83837890625</c:v>
                </c:pt>
                <c:pt idx="115">
                  <c:v>7470.17431640625</c:v>
                </c:pt>
                <c:pt idx="116">
                  <c:v>7408.76953125</c:v>
                </c:pt>
                <c:pt idx="117">
                  <c:v>7368.30712890625</c:v>
                </c:pt>
                <c:pt idx="118">
                  <c:v>7383.95166015625</c:v>
                </c:pt>
                <c:pt idx="119">
                  <c:v>7459.64501953125</c:v>
                </c:pt>
                <c:pt idx="120">
                  <c:v>7557.42333984375</c:v>
                </c:pt>
                <c:pt idx="121">
                  <c:v>7619.05517578125</c:v>
                </c:pt>
                <c:pt idx="122">
                  <c:v>7605.90673828125</c:v>
                </c:pt>
                <c:pt idx="123">
                  <c:v>7526.62451171875</c:v>
                </c:pt>
                <c:pt idx="124">
                  <c:v>7430.47314453125</c:v>
                </c:pt>
                <c:pt idx="125">
                  <c:v>7371.095703125</c:v>
                </c:pt>
                <c:pt idx="126">
                  <c:v>7369.09814453125</c:v>
                </c:pt>
                <c:pt idx="127">
                  <c:v>7402.46875</c:v>
                </c:pt>
                <c:pt idx="128">
                  <c:v>7430.76416015625</c:v>
                </c:pt>
                <c:pt idx="129">
                  <c:v>7431.35595703125</c:v>
                </c:pt>
                <c:pt idx="130">
                  <c:v>7416.94921875</c:v>
                </c:pt>
                <c:pt idx="131">
                  <c:v>7420.3828125</c:v>
                </c:pt>
                <c:pt idx="132">
                  <c:v>7461.0849609375</c:v>
                </c:pt>
                <c:pt idx="133">
                  <c:v>7523.23974609375</c:v>
                </c:pt>
                <c:pt idx="134">
                  <c:v>7565.54638671875</c:v>
                </c:pt>
                <c:pt idx="135">
                  <c:v>7555.126953125</c:v>
                </c:pt>
                <c:pt idx="136">
                  <c:v>7496.95556640625</c:v>
                </c:pt>
                <c:pt idx="137">
                  <c:v>7433.26953125</c:v>
                </c:pt>
                <c:pt idx="138">
                  <c:v>7412.22314453125</c:v>
                </c:pt>
                <c:pt idx="139">
                  <c:v>7450.720703125</c:v>
                </c:pt>
                <c:pt idx="140">
                  <c:v>7521.44189453125</c:v>
                </c:pt>
                <c:pt idx="141">
                  <c:v>7574.38427734375</c:v>
                </c:pt>
                <c:pt idx="142">
                  <c:v>7575.3359375</c:v>
                </c:pt>
                <c:pt idx="143">
                  <c:v>7530.6171875</c:v>
                </c:pt>
                <c:pt idx="144">
                  <c:v>7479.45751953125</c:v>
                </c:pt>
                <c:pt idx="145">
                  <c:v>7461.84130859375</c:v>
                </c:pt>
                <c:pt idx="146">
                  <c:v>7488.517578125</c:v>
                </c:pt>
                <c:pt idx="147">
                  <c:v>7536.21142578125</c:v>
                </c:pt>
                <c:pt idx="148">
                  <c:v>7569.2880859375</c:v>
                </c:pt>
                <c:pt idx="149">
                  <c:v>7568.04150390625</c:v>
                </c:pt>
                <c:pt idx="150">
                  <c:v>7540.60400390625</c:v>
                </c:pt>
                <c:pt idx="151">
                  <c:v>7511.263671875</c:v>
                </c:pt>
                <c:pt idx="152">
                  <c:v>7498.078125</c:v>
                </c:pt>
                <c:pt idx="153">
                  <c:v>7499.93896484375</c:v>
                </c:pt>
                <c:pt idx="154">
                  <c:v>7502.66650390625</c:v>
                </c:pt>
                <c:pt idx="155">
                  <c:v>7496.01025390625</c:v>
                </c:pt>
                <c:pt idx="156">
                  <c:v>7484.47998046875</c:v>
                </c:pt>
                <c:pt idx="157">
                  <c:v>7482.02880859375</c:v>
                </c:pt>
                <c:pt idx="158">
                  <c:v>7496.3125</c:v>
                </c:pt>
                <c:pt idx="159">
                  <c:v>7517.974609375</c:v>
                </c:pt>
                <c:pt idx="160">
                  <c:v>7525.65869140625</c:v>
                </c:pt>
                <c:pt idx="161">
                  <c:v>7502.97021484375</c:v>
                </c:pt>
                <c:pt idx="162">
                  <c:v>7452.771484375</c:v>
                </c:pt>
                <c:pt idx="163">
                  <c:v>7396.5439453125</c:v>
                </c:pt>
                <c:pt idx="164">
                  <c:v>7359.57568359375</c:v>
                </c:pt>
                <c:pt idx="165">
                  <c:v>7354.52001953125</c:v>
                </c:pt>
                <c:pt idx="166">
                  <c:v>7376.16650390625</c:v>
                </c:pt>
                <c:pt idx="167">
                  <c:v>7409.5537109375</c:v>
                </c:pt>
                <c:pt idx="168">
                  <c:v>7442.18212890625</c:v>
                </c:pt>
                <c:pt idx="169">
                  <c:v>7469.26513671875</c:v>
                </c:pt>
                <c:pt idx="170">
                  <c:v>7489.59326171875</c:v>
                </c:pt>
                <c:pt idx="171">
                  <c:v>7499.55029296875</c:v>
                </c:pt>
                <c:pt idx="172">
                  <c:v>7494.12646484375</c:v>
                </c:pt>
                <c:pt idx="173">
                  <c:v>7475.14990234375</c:v>
                </c:pt>
                <c:pt idx="174">
                  <c:v>7457.24462890625</c:v>
                </c:pt>
                <c:pt idx="175">
                  <c:v>7461.74462890625</c:v>
                </c:pt>
                <c:pt idx="176">
                  <c:v>7499.6884765625</c:v>
                </c:pt>
                <c:pt idx="177">
                  <c:v>7557.478515625</c:v>
                </c:pt>
                <c:pt idx="178">
                  <c:v>7600.2626953125</c:v>
                </c:pt>
                <c:pt idx="179">
                  <c:v>7594.99169921875</c:v>
                </c:pt>
                <c:pt idx="180">
                  <c:v>7537.43359375</c:v>
                </c:pt>
                <c:pt idx="181">
                  <c:v>7460.80810546875</c:v>
                </c:pt>
                <c:pt idx="182">
                  <c:v>7415.8427734375</c:v>
                </c:pt>
                <c:pt idx="183">
                  <c:v>7434.61279296875</c:v>
                </c:pt>
                <c:pt idx="184">
                  <c:v>7505.23828125</c:v>
                </c:pt>
                <c:pt idx="185">
                  <c:v>7578.12255859375</c:v>
                </c:pt>
                <c:pt idx="186">
                  <c:v>7600.70166015625</c:v>
                </c:pt>
                <c:pt idx="187">
                  <c:v>7555.10595703125</c:v>
                </c:pt>
                <c:pt idx="188">
                  <c:v>7470.22216796875</c:v>
                </c:pt>
                <c:pt idx="189">
                  <c:v>7399.27294921875</c:v>
                </c:pt>
                <c:pt idx="190">
                  <c:v>7380.765625</c:v>
                </c:pt>
                <c:pt idx="191">
                  <c:v>7413.0458984375</c:v>
                </c:pt>
                <c:pt idx="192">
                  <c:v>7460.94384765625</c:v>
                </c:pt>
                <c:pt idx="193">
                  <c:v>7487.0068359375</c:v>
                </c:pt>
                <c:pt idx="194">
                  <c:v>7480.90869140625</c:v>
                </c:pt>
                <c:pt idx="195">
                  <c:v>7463.81982421875</c:v>
                </c:pt>
                <c:pt idx="196">
                  <c:v>7466.31689453125</c:v>
                </c:pt>
                <c:pt idx="197">
                  <c:v>7500.1328125</c:v>
                </c:pt>
                <c:pt idx="198">
                  <c:v>7547.81298828125</c:v>
                </c:pt>
                <c:pt idx="199">
                  <c:v>7577.87646484375</c:v>
                </c:pt>
                <c:pt idx="200">
                  <c:v>7571.205078125</c:v>
                </c:pt>
                <c:pt idx="201">
                  <c:v>7535.74853515625</c:v>
                </c:pt>
                <c:pt idx="202">
                  <c:v>7497.97509765625</c:v>
                </c:pt>
                <c:pt idx="203">
                  <c:v>7480.12255859375</c:v>
                </c:pt>
                <c:pt idx="204">
                  <c:v>7483.93212890625</c:v>
                </c:pt>
                <c:pt idx="205">
                  <c:v>7494.39404296875</c:v>
                </c:pt>
                <c:pt idx="206">
                  <c:v>7498.1015625</c:v>
                </c:pt>
                <c:pt idx="207">
                  <c:v>7497.45654296875</c:v>
                </c:pt>
                <c:pt idx="208">
                  <c:v>7506.33935546875</c:v>
                </c:pt>
                <c:pt idx="209">
                  <c:v>7531.0205078125</c:v>
                </c:pt>
                <c:pt idx="210">
                  <c:v>7555.42919921875</c:v>
                </c:pt>
                <c:pt idx="211">
                  <c:v>7547.78369140625</c:v>
                </c:pt>
                <c:pt idx="212">
                  <c:v>7486.8173828125</c:v>
                </c:pt>
                <c:pt idx="213">
                  <c:v>7386.47265625</c:v>
                </c:pt>
                <c:pt idx="214">
                  <c:v>7295.66943359375</c:v>
                </c:pt>
                <c:pt idx="215">
                  <c:v>7268.41259765625</c:v>
                </c:pt>
                <c:pt idx="216">
                  <c:v>7324.52685546875</c:v>
                </c:pt>
                <c:pt idx="217">
                  <c:v>7431.689453125</c:v>
                </c:pt>
                <c:pt idx="218">
                  <c:v>7525.11083984375</c:v>
                </c:pt>
                <c:pt idx="219">
                  <c:v>7552.37548828125</c:v>
                </c:pt>
                <c:pt idx="220">
                  <c:v>7510.3994140625</c:v>
                </c:pt>
                <c:pt idx="221">
                  <c:v>7446.22412109375</c:v>
                </c:pt>
                <c:pt idx="222">
                  <c:v>7420.51806640625</c:v>
                </c:pt>
                <c:pt idx="223">
                  <c:v>7461.28515625</c:v>
                </c:pt>
                <c:pt idx="224">
                  <c:v>7542.87158203125</c:v>
                </c:pt>
                <c:pt idx="225">
                  <c:v>7605.912109375</c:v>
                </c:pt>
                <c:pt idx="226">
                  <c:v>7602.54248046875</c:v>
                </c:pt>
                <c:pt idx="227">
                  <c:v>7532.35546875</c:v>
                </c:pt>
                <c:pt idx="228">
                  <c:v>7442.43408203125</c:v>
                </c:pt>
                <c:pt idx="229">
                  <c:v>7392.60205078125</c:v>
                </c:pt>
                <c:pt idx="230">
                  <c:v>7412.90283203125</c:v>
                </c:pt>
                <c:pt idx="231">
                  <c:v>7484.70458984375</c:v>
                </c:pt>
                <c:pt idx="232">
                  <c:v>7557.5361328125</c:v>
                </c:pt>
                <c:pt idx="233">
                  <c:v>7586.69970703125</c:v>
                </c:pt>
                <c:pt idx="234">
                  <c:v>7562.78125</c:v>
                </c:pt>
                <c:pt idx="235">
                  <c:v>7512.791015625</c:v>
                </c:pt>
                <c:pt idx="236">
                  <c:v>7475.48583984375</c:v>
                </c:pt>
                <c:pt idx="237">
                  <c:v>7472.001953125</c:v>
                </c:pt>
                <c:pt idx="238">
                  <c:v>7493.78173828125</c:v>
                </c:pt>
                <c:pt idx="239">
                  <c:v>7514.1640625</c:v>
                </c:pt>
                <c:pt idx="240">
                  <c:v>7511.5791015625</c:v>
                </c:pt>
                <c:pt idx="241">
                  <c:v>7485.34716796875</c:v>
                </c:pt>
                <c:pt idx="242">
                  <c:v>7453.43115234375</c:v>
                </c:pt>
                <c:pt idx="243">
                  <c:v>7436.72412109375</c:v>
                </c:pt>
                <c:pt idx="244">
                  <c:v>7443.9228515625</c:v>
                </c:pt>
                <c:pt idx="245">
                  <c:v>7468.2060546875</c:v>
                </c:pt>
                <c:pt idx="246">
                  <c:v>7495.857421875</c:v>
                </c:pt>
                <c:pt idx="247">
                  <c:v>7517.5859375</c:v>
                </c:pt>
                <c:pt idx="248">
                  <c:v>7532.900390625</c:v>
                </c:pt>
                <c:pt idx="249">
                  <c:v>7545.451171875</c:v>
                </c:pt>
                <c:pt idx="250">
                  <c:v>7555.39892578125</c:v>
                </c:pt>
                <c:pt idx="251">
                  <c:v>7556.69384765625</c:v>
                </c:pt>
                <c:pt idx="252">
                  <c:v>7541.84765625</c:v>
                </c:pt>
                <c:pt idx="253">
                  <c:v>7509.6806640625</c:v>
                </c:pt>
                <c:pt idx="254">
                  <c:v>7468.865234375</c:v>
                </c:pt>
                <c:pt idx="255">
                  <c:v>7433.80517578125</c:v>
                </c:pt>
                <c:pt idx="256">
                  <c:v>7415.89111328125</c:v>
                </c:pt>
                <c:pt idx="257">
                  <c:v>7416.82568359375</c:v>
                </c:pt>
                <c:pt idx="258">
                  <c:v>7428.81689453125</c:v>
                </c:pt>
                <c:pt idx="259">
                  <c:v>7440.9716796875</c:v>
                </c:pt>
                <c:pt idx="260">
                  <c:v>7446.7998046875</c:v>
                </c:pt>
                <c:pt idx="261">
                  <c:v>7447.560546875</c:v>
                </c:pt>
                <c:pt idx="262">
                  <c:v>7449.759765625</c:v>
                </c:pt>
                <c:pt idx="263">
                  <c:v>7459.279296875</c:v>
                </c:pt>
                <c:pt idx="264">
                  <c:v>7476.36474609375</c:v>
                </c:pt>
                <c:pt idx="265">
                  <c:v>7494.4970703125</c:v>
                </c:pt>
                <c:pt idx="266">
                  <c:v>7503.52197265625</c:v>
                </c:pt>
                <c:pt idx="267">
                  <c:v>7495.26171875</c:v>
                </c:pt>
                <c:pt idx="268">
                  <c:v>7468.86376953125</c:v>
                </c:pt>
                <c:pt idx="269">
                  <c:v>7433.224609375</c:v>
                </c:pt>
                <c:pt idx="270">
                  <c:v>7404.6416015625</c:v>
                </c:pt>
                <c:pt idx="271">
                  <c:v>7399.66357421875</c:v>
                </c:pt>
                <c:pt idx="272">
                  <c:v>7425.8603515625</c:v>
                </c:pt>
                <c:pt idx="273">
                  <c:v>7475.5712890625</c:v>
                </c:pt>
                <c:pt idx="274">
                  <c:v>7527.5341796875</c:v>
                </c:pt>
                <c:pt idx="275">
                  <c:v>7557.37890625</c:v>
                </c:pt>
                <c:pt idx="276">
                  <c:v>7552.0107421875</c:v>
                </c:pt>
                <c:pt idx="277">
                  <c:v>7518.97119140625</c:v>
                </c:pt>
                <c:pt idx="278">
                  <c:v>7483.6328125</c:v>
                </c:pt>
                <c:pt idx="279">
                  <c:v>7474.501953125</c:v>
                </c:pt>
                <c:pt idx="280">
                  <c:v>7505.25830078125</c:v>
                </c:pt>
                <c:pt idx="281">
                  <c:v>7565.294921875</c:v>
                </c:pt>
                <c:pt idx="282">
                  <c:v>7625.43310546875</c:v>
                </c:pt>
                <c:pt idx="283">
                  <c:v>7655.31787109375</c:v>
                </c:pt>
                <c:pt idx="284">
                  <c:v>7640.9423828125</c:v>
                </c:pt>
                <c:pt idx="285">
                  <c:v>7590.8818359375</c:v>
                </c:pt>
                <c:pt idx="286">
                  <c:v>7528.04736328125</c:v>
                </c:pt>
                <c:pt idx="287">
                  <c:v>7473.9921875</c:v>
                </c:pt>
                <c:pt idx="288">
                  <c:v>7437.359375</c:v>
                </c:pt>
                <c:pt idx="289">
                  <c:v>7413.78515625</c:v>
                </c:pt>
                <c:pt idx="290">
                  <c:v>7395.2705078125</c:v>
                </c:pt>
                <c:pt idx="291">
                  <c:v>7380.099609375</c:v>
                </c:pt>
                <c:pt idx="292">
                  <c:v>7375.06396484375</c:v>
                </c:pt>
                <c:pt idx="293">
                  <c:v>7388.869140625</c:v>
                </c:pt>
                <c:pt idx="294">
                  <c:v>7422.98388671875</c:v>
                </c:pt>
                <c:pt idx="295">
                  <c:v>7467.8662109375</c:v>
                </c:pt>
                <c:pt idx="296">
                  <c:v>7507.5859375</c:v>
                </c:pt>
                <c:pt idx="297">
                  <c:v>7528.92431640625</c:v>
                </c:pt>
                <c:pt idx="298">
                  <c:v>7527.94873046875</c:v>
                </c:pt>
                <c:pt idx="299">
                  <c:v>7509.9736328125</c:v>
                </c:pt>
                <c:pt idx="300">
                  <c:v>7484.5673828125</c:v>
                </c:pt>
                <c:pt idx="301">
                  <c:v>7460.64111328125</c:v>
                </c:pt>
                <c:pt idx="302">
                  <c:v>7444.98193359375</c:v>
                </c:pt>
                <c:pt idx="303">
                  <c:v>7443.1240234375</c:v>
                </c:pt>
                <c:pt idx="304">
                  <c:v>7458.92041015625</c:v>
                </c:pt>
                <c:pt idx="305">
                  <c:v>7491.15869140625</c:v>
                </c:pt>
                <c:pt idx="306">
                  <c:v>7530.072265625</c:v>
                </c:pt>
                <c:pt idx="307">
                  <c:v>7558.74267578125</c:v>
                </c:pt>
                <c:pt idx="308">
                  <c:v>7561.25439453125</c:v>
                </c:pt>
                <c:pt idx="309">
                  <c:v>7533.18310546875</c:v>
                </c:pt>
                <c:pt idx="310">
                  <c:v>7486.30224609375</c:v>
                </c:pt>
                <c:pt idx="311">
                  <c:v>7442.4296875</c:v>
                </c:pt>
                <c:pt idx="312">
                  <c:v>7419.5791015625</c:v>
                </c:pt>
                <c:pt idx="313">
                  <c:v>7420.43701171875</c:v>
                </c:pt>
                <c:pt idx="314">
                  <c:v>7432.3525390625</c:v>
                </c:pt>
                <c:pt idx="315">
                  <c:v>7439.345703125</c:v>
                </c:pt>
                <c:pt idx="316">
                  <c:v>7436.671875</c:v>
                </c:pt>
                <c:pt idx="317">
                  <c:v>7435.64990234375</c:v>
                </c:pt>
                <c:pt idx="318">
                  <c:v>7453.81396484375</c:v>
                </c:pt>
                <c:pt idx="319">
                  <c:v>7497.583984375</c:v>
                </c:pt>
                <c:pt idx="320">
                  <c:v>7551.8046875</c:v>
                </c:pt>
                <c:pt idx="321">
                  <c:v>7586.22216796875</c:v>
                </c:pt>
                <c:pt idx="322">
                  <c:v>7575.95947265625</c:v>
                </c:pt>
                <c:pt idx="323">
                  <c:v>7521.33642578125</c:v>
                </c:pt>
                <c:pt idx="324">
                  <c:v>7451.4755859375</c:v>
                </c:pt>
                <c:pt idx="325">
                  <c:v>7407.43505859375</c:v>
                </c:pt>
                <c:pt idx="326">
                  <c:v>7415.7841796875</c:v>
                </c:pt>
                <c:pt idx="327">
                  <c:v>7471.03955078125</c:v>
                </c:pt>
                <c:pt idx="328">
                  <c:v>7539.36083984375</c:v>
                </c:pt>
                <c:pt idx="329">
                  <c:v>7580.80859375</c:v>
                </c:pt>
                <c:pt idx="330">
                  <c:v>7574.6083984375</c:v>
                </c:pt>
                <c:pt idx="331">
                  <c:v>7530.4990234375</c:v>
                </c:pt>
                <c:pt idx="332">
                  <c:v>7479.85302734375</c:v>
                </c:pt>
                <c:pt idx="333">
                  <c:v>7454.35791015625</c:v>
                </c:pt>
                <c:pt idx="334">
                  <c:v>7467.37744140625</c:v>
                </c:pt>
                <c:pt idx="335">
                  <c:v>7509.1708984375</c:v>
                </c:pt>
                <c:pt idx="336">
                  <c:v>7556.263671875</c:v>
                </c:pt>
                <c:pt idx="337">
                  <c:v>7586.12548828125</c:v>
                </c:pt>
                <c:pt idx="338">
                  <c:v>7587.146484375</c:v>
                </c:pt>
                <c:pt idx="339">
                  <c:v>7559.859375</c:v>
                </c:pt>
                <c:pt idx="340">
                  <c:v>7512.45703125</c:v>
                </c:pt>
                <c:pt idx="341">
                  <c:v>7456.16943359375</c:v>
                </c:pt>
                <c:pt idx="342">
                  <c:v>7403.2275390625</c:v>
                </c:pt>
                <c:pt idx="343">
                  <c:v>7365.8681640625</c:v>
                </c:pt>
                <c:pt idx="344">
                  <c:v>7353.62890625</c:v>
                </c:pt>
                <c:pt idx="345">
                  <c:v>7368.8818359375</c:v>
                </c:pt>
                <c:pt idx="346">
                  <c:v>7404.01416015625</c:v>
                </c:pt>
                <c:pt idx="347">
                  <c:v>7443.873046875</c:v>
                </c:pt>
                <c:pt idx="348">
                  <c:v>7473.37451171875</c:v>
                </c:pt>
                <c:pt idx="349">
                  <c:v>7485.59521484375</c:v>
                </c:pt>
              </c:numCache>
            </c:numRef>
          </c:yVal>
          <c:smooth val="1"/>
          <c:extLst>
            <c:ext xmlns:c16="http://schemas.microsoft.com/office/drawing/2014/chart" uri="{C3380CC4-5D6E-409C-BE32-E72D297353CC}">
              <c16:uniqueId val="{00000000-0DDB-41B5-BE83-A9CFE49F3CE3}"/>
            </c:ext>
          </c:extLst>
        </c:ser>
        <c:ser>
          <c:idx val="1"/>
          <c:order val="1"/>
          <c:tx>
            <c:strRef>
              <c:f>hc_sub_007!$B$1</c:f>
              <c:strCache>
                <c:ptCount val="1"/>
                <c:pt idx="0">
                  <c:v>Coor_2</c:v>
                </c:pt>
              </c:strCache>
            </c:strRef>
          </c:tx>
          <c:spPr>
            <a:ln w="28575" cap="rnd">
              <a:solidFill>
                <a:schemeClr val="accent2"/>
              </a:solidFill>
              <a:round/>
            </a:ln>
            <a:effectLst/>
          </c:spPr>
          <c:marker>
            <c:symbol val="none"/>
          </c:marker>
          <c:yVal>
            <c:numRef>
              <c:f>hc_sub_007!$B$2:$B$351</c:f>
              <c:numCache>
                <c:formatCode>0.00000000000_ </c:formatCode>
                <c:ptCount val="350"/>
                <c:pt idx="0">
                  <c:v>6733.70458984375</c:v>
                </c:pt>
                <c:pt idx="1">
                  <c:v>6728.7099609375</c:v>
                </c:pt>
                <c:pt idx="2">
                  <c:v>6722.28466796875</c:v>
                </c:pt>
                <c:pt idx="3">
                  <c:v>6711.87451171875</c:v>
                </c:pt>
                <c:pt idx="4">
                  <c:v>6703.16357421875</c:v>
                </c:pt>
                <c:pt idx="5">
                  <c:v>6705.97314453125</c:v>
                </c:pt>
                <c:pt idx="6">
                  <c:v>6724.6298828125</c:v>
                </c:pt>
                <c:pt idx="7">
                  <c:v>6751.57958984375</c:v>
                </c:pt>
                <c:pt idx="8">
                  <c:v>6771.0751953125</c:v>
                </c:pt>
                <c:pt idx="9">
                  <c:v>6771.26904296875</c:v>
                </c:pt>
                <c:pt idx="10">
                  <c:v>6755.11083984375</c:v>
                </c:pt>
                <c:pt idx="11">
                  <c:v>6740.37548828125</c:v>
                </c:pt>
                <c:pt idx="12">
                  <c:v>6747.5185546875</c:v>
                </c:pt>
                <c:pt idx="13">
                  <c:v>6784.171875</c:v>
                </c:pt>
                <c:pt idx="14">
                  <c:v>6838.3193359375</c:v>
                </c:pt>
                <c:pt idx="15">
                  <c:v>6885.58251953125</c:v>
                </c:pt>
                <c:pt idx="16">
                  <c:v>6904.912109375</c:v>
                </c:pt>
                <c:pt idx="17">
                  <c:v>6890.69482421875</c:v>
                </c:pt>
                <c:pt idx="18">
                  <c:v>6852.880859375</c:v>
                </c:pt>
                <c:pt idx="19">
                  <c:v>6807.00830078125</c:v>
                </c:pt>
                <c:pt idx="20">
                  <c:v>6763.8271484375</c:v>
                </c:pt>
                <c:pt idx="21">
                  <c:v>6727.06591796875</c:v>
                </c:pt>
                <c:pt idx="22">
                  <c:v>6699.16796875</c:v>
                </c:pt>
                <c:pt idx="23">
                  <c:v>6686.84912109375</c:v>
                </c:pt>
                <c:pt idx="24">
                  <c:v>6698.650390625</c:v>
                </c:pt>
                <c:pt idx="25">
                  <c:v>6735.150390625</c:v>
                </c:pt>
                <c:pt idx="26">
                  <c:v>6781.271484375</c:v>
                </c:pt>
                <c:pt idx="27">
                  <c:v>6810.4931640625</c:v>
                </c:pt>
                <c:pt idx="28">
                  <c:v>6801.333984375</c:v>
                </c:pt>
                <c:pt idx="29">
                  <c:v>6754.88525390625</c:v>
                </c:pt>
                <c:pt idx="30">
                  <c:v>6698.79345703125</c:v>
                </c:pt>
                <c:pt idx="31">
                  <c:v>6672.0087890625</c:v>
                </c:pt>
                <c:pt idx="32">
                  <c:v>6699.37060546875</c:v>
                </c:pt>
                <c:pt idx="33">
                  <c:v>6773.8828125</c:v>
                </c:pt>
                <c:pt idx="34">
                  <c:v>6859.76025390625</c:v>
                </c:pt>
                <c:pt idx="35">
                  <c:v>6914.35107421875</c:v>
                </c:pt>
                <c:pt idx="36">
                  <c:v>6913.4599609375</c:v>
                </c:pt>
                <c:pt idx="37">
                  <c:v>6862.91748046875</c:v>
                </c:pt>
                <c:pt idx="38">
                  <c:v>6790.30712890625</c:v>
                </c:pt>
                <c:pt idx="39">
                  <c:v>6725.33837890625</c:v>
                </c:pt>
                <c:pt idx="40">
                  <c:v>6684.02392578125</c:v>
                </c:pt>
                <c:pt idx="41">
                  <c:v>6666.26171875</c:v>
                </c:pt>
                <c:pt idx="42">
                  <c:v>6664.498046875</c:v>
                </c:pt>
                <c:pt idx="43">
                  <c:v>6673.2158203125</c:v>
                </c:pt>
                <c:pt idx="44">
                  <c:v>6691.005859375</c:v>
                </c:pt>
                <c:pt idx="45">
                  <c:v>6715.73388671875</c:v>
                </c:pt>
                <c:pt idx="46">
                  <c:v>6740.18994140625</c:v>
                </c:pt>
                <c:pt idx="47">
                  <c:v>6754.392578125</c:v>
                </c:pt>
                <c:pt idx="48">
                  <c:v>6753.2509765625</c:v>
                </c:pt>
                <c:pt idx="49">
                  <c:v>6742.1123046875</c:v>
                </c:pt>
                <c:pt idx="50">
                  <c:v>6734.0029296875</c:v>
                </c:pt>
                <c:pt idx="51">
                  <c:v>6739.98779296875</c:v>
                </c:pt>
                <c:pt idx="52">
                  <c:v>6760.82421875</c:v>
                </c:pt>
                <c:pt idx="53">
                  <c:v>6787.37841796875</c:v>
                </c:pt>
                <c:pt idx="54">
                  <c:v>6809.44873046875</c:v>
                </c:pt>
                <c:pt idx="55">
                  <c:v>6824.8076171875</c:v>
                </c:pt>
                <c:pt idx="56">
                  <c:v>6839.8388671875</c:v>
                </c:pt>
                <c:pt idx="57">
                  <c:v>6860.8935546875</c:v>
                </c:pt>
                <c:pt idx="58">
                  <c:v>6884.55908203125</c:v>
                </c:pt>
                <c:pt idx="59">
                  <c:v>6896.89794921875</c:v>
                </c:pt>
                <c:pt idx="60">
                  <c:v>6884.10693359375</c:v>
                </c:pt>
                <c:pt idx="61">
                  <c:v>6846.25390625</c:v>
                </c:pt>
                <c:pt idx="62">
                  <c:v>6801.55322265625</c:v>
                </c:pt>
                <c:pt idx="63">
                  <c:v>6775.44921875</c:v>
                </c:pt>
                <c:pt idx="64">
                  <c:v>6781.55224609375</c:v>
                </c:pt>
                <c:pt idx="65">
                  <c:v>6809.3857421875</c:v>
                </c:pt>
                <c:pt idx="66">
                  <c:v>6829.81689453125</c:v>
                </c:pt>
                <c:pt idx="67">
                  <c:v>6815.50439453125</c:v>
                </c:pt>
                <c:pt idx="68">
                  <c:v>6761.5205078125</c:v>
                </c:pt>
                <c:pt idx="69">
                  <c:v>6690.462890625</c:v>
                </c:pt>
                <c:pt idx="70">
                  <c:v>6637.88916015625</c:v>
                </c:pt>
                <c:pt idx="71">
                  <c:v>6628.6953125</c:v>
                </c:pt>
                <c:pt idx="72">
                  <c:v>6661.58935546875</c:v>
                </c:pt>
                <c:pt idx="73">
                  <c:v>6712.13916015625</c:v>
                </c:pt>
                <c:pt idx="74">
                  <c:v>6750.69384765625</c:v>
                </c:pt>
                <c:pt idx="75">
                  <c:v>6761.078125</c:v>
                </c:pt>
                <c:pt idx="76">
                  <c:v>6746.97705078125</c:v>
                </c:pt>
                <c:pt idx="77">
                  <c:v>6723.65966796875</c:v>
                </c:pt>
                <c:pt idx="78">
                  <c:v>6703.89306640625</c:v>
                </c:pt>
                <c:pt idx="79">
                  <c:v>6689.87451171875</c:v>
                </c:pt>
                <c:pt idx="80">
                  <c:v>6676.36865234375</c:v>
                </c:pt>
                <c:pt idx="81">
                  <c:v>6660.353515625</c:v>
                </c:pt>
                <c:pt idx="82">
                  <c:v>6647.66162109375</c:v>
                </c:pt>
                <c:pt idx="83">
                  <c:v>6650.6708984375</c:v>
                </c:pt>
                <c:pt idx="84">
                  <c:v>6679.20703125</c:v>
                </c:pt>
                <c:pt idx="85">
                  <c:v>6732.41064453125</c:v>
                </c:pt>
                <c:pt idx="86">
                  <c:v>6798.0791015625</c:v>
                </c:pt>
                <c:pt idx="87">
                  <c:v>6859.64697265625</c:v>
                </c:pt>
                <c:pt idx="88">
                  <c:v>6905.16650390625</c:v>
                </c:pt>
                <c:pt idx="89">
                  <c:v>6931.84130859375</c:v>
                </c:pt>
                <c:pt idx="90">
                  <c:v>6943.83056640625</c:v>
                </c:pt>
                <c:pt idx="91">
                  <c:v>6946.2568359375</c:v>
                </c:pt>
                <c:pt idx="92">
                  <c:v>6940.466796875</c:v>
                </c:pt>
                <c:pt idx="93">
                  <c:v>6923.69287109375</c:v>
                </c:pt>
                <c:pt idx="94">
                  <c:v>6892.53466796875</c:v>
                </c:pt>
                <c:pt idx="95">
                  <c:v>6847.22509765625</c:v>
                </c:pt>
                <c:pt idx="96">
                  <c:v>6793.7763671875</c:v>
                </c:pt>
                <c:pt idx="97">
                  <c:v>6742.9306640625</c:v>
                </c:pt>
                <c:pt idx="98">
                  <c:v>6706.59130859375</c:v>
                </c:pt>
                <c:pt idx="99">
                  <c:v>6693.294921875</c:v>
                </c:pt>
                <c:pt idx="100">
                  <c:v>6704.47802734375</c:v>
                </c:pt>
                <c:pt idx="101">
                  <c:v>6733.20263671875</c:v>
                </c:pt>
                <c:pt idx="102">
                  <c:v>6766.39794921875</c:v>
                </c:pt>
                <c:pt idx="103">
                  <c:v>6790.18896484375</c:v>
                </c:pt>
                <c:pt idx="104">
                  <c:v>6795.90185546875</c:v>
                </c:pt>
                <c:pt idx="105">
                  <c:v>6783.36865234375</c:v>
                </c:pt>
                <c:pt idx="106">
                  <c:v>6759.4794921875</c:v>
                </c:pt>
                <c:pt idx="107">
                  <c:v>6733.0712890625</c:v>
                </c:pt>
                <c:pt idx="108">
                  <c:v>6709.92724609375</c:v>
                </c:pt>
                <c:pt idx="109">
                  <c:v>6691.455078125</c:v>
                </c:pt>
                <c:pt idx="110">
                  <c:v>6677.373046875</c:v>
                </c:pt>
                <c:pt idx="111">
                  <c:v>6669.138671875</c:v>
                </c:pt>
                <c:pt idx="112">
                  <c:v>6670.20068359375</c:v>
                </c:pt>
                <c:pt idx="113">
                  <c:v>6682.318359375</c:v>
                </c:pt>
                <c:pt idx="114">
                  <c:v>6701.515625</c:v>
                </c:pt>
                <c:pt idx="115">
                  <c:v>6718.51513671875</c:v>
                </c:pt>
                <c:pt idx="116">
                  <c:v>6724.99365234375</c:v>
                </c:pt>
                <c:pt idx="117">
                  <c:v>6721.3251953125</c:v>
                </c:pt>
                <c:pt idx="118">
                  <c:v>6718.794921875</c:v>
                </c:pt>
                <c:pt idx="119">
                  <c:v>6732.7041015625</c:v>
                </c:pt>
                <c:pt idx="120">
                  <c:v>6770.20361328125</c:v>
                </c:pt>
                <c:pt idx="121">
                  <c:v>6822.08447265625</c:v>
                </c:pt>
                <c:pt idx="122">
                  <c:v>6865.94921875</c:v>
                </c:pt>
                <c:pt idx="123">
                  <c:v>6879.93505859375</c:v>
                </c:pt>
                <c:pt idx="124">
                  <c:v>6857.62939453125</c:v>
                </c:pt>
                <c:pt idx="125">
                  <c:v>6813.15234375</c:v>
                </c:pt>
                <c:pt idx="126">
                  <c:v>6772.31298828125</c:v>
                </c:pt>
                <c:pt idx="127">
                  <c:v>6756.12939453125</c:v>
                </c:pt>
                <c:pt idx="128">
                  <c:v>6768.60302734375</c:v>
                </c:pt>
                <c:pt idx="129">
                  <c:v>6797.02490234375</c:v>
                </c:pt>
                <c:pt idx="130">
                  <c:v>6823.27685546875</c:v>
                </c:pt>
                <c:pt idx="131">
                  <c:v>6836.5341796875</c:v>
                </c:pt>
                <c:pt idx="132">
                  <c:v>6837.79833984375</c:v>
                </c:pt>
                <c:pt idx="133">
                  <c:v>6834.27099609375</c:v>
                </c:pt>
                <c:pt idx="134">
                  <c:v>6830.02978515625</c:v>
                </c:pt>
                <c:pt idx="135">
                  <c:v>6821.765625</c:v>
                </c:pt>
                <c:pt idx="136">
                  <c:v>6802.96533203125</c:v>
                </c:pt>
                <c:pt idx="137">
                  <c:v>6772.05126953125</c:v>
                </c:pt>
                <c:pt idx="138">
                  <c:v>6736.53125</c:v>
                </c:pt>
                <c:pt idx="139">
                  <c:v>6709.06494140625</c:v>
                </c:pt>
                <c:pt idx="140">
                  <c:v>6698.724609375</c:v>
                </c:pt>
                <c:pt idx="141">
                  <c:v>6705.0205078125</c:v>
                </c:pt>
                <c:pt idx="142">
                  <c:v>6719.701171875</c:v>
                </c:pt>
                <c:pt idx="143">
                  <c:v>6734.40234375</c:v>
                </c:pt>
                <c:pt idx="144">
                  <c:v>6747.15869140625</c:v>
                </c:pt>
                <c:pt idx="145">
                  <c:v>6762.08642578125</c:v>
                </c:pt>
                <c:pt idx="146">
                  <c:v>6782.8701171875</c:v>
                </c:pt>
                <c:pt idx="147">
                  <c:v>6806.36083984375</c:v>
                </c:pt>
                <c:pt idx="148">
                  <c:v>6822.53271484375</c:v>
                </c:pt>
                <c:pt idx="149">
                  <c:v>6821.36083984375</c:v>
                </c:pt>
                <c:pt idx="150">
                  <c:v>6800.95068359375</c:v>
                </c:pt>
                <c:pt idx="151">
                  <c:v>6769.921875</c:v>
                </c:pt>
                <c:pt idx="152">
                  <c:v>6741.78271484375</c:v>
                </c:pt>
                <c:pt idx="153">
                  <c:v>6725.66064453125</c:v>
                </c:pt>
                <c:pt idx="154">
                  <c:v>6720.716796875</c:v>
                </c:pt>
                <c:pt idx="155">
                  <c:v>6718.42431640625</c:v>
                </c:pt>
                <c:pt idx="156">
                  <c:v>6710.56640625</c:v>
                </c:pt>
                <c:pt idx="157">
                  <c:v>6696.5166015625</c:v>
                </c:pt>
                <c:pt idx="158">
                  <c:v>6684.37841796875</c:v>
                </c:pt>
                <c:pt idx="159">
                  <c:v>6685.5654296875</c:v>
                </c:pt>
                <c:pt idx="160">
                  <c:v>6707.08740234375</c:v>
                </c:pt>
                <c:pt idx="161">
                  <c:v>6746.783203125</c:v>
                </c:pt>
                <c:pt idx="162">
                  <c:v>6793.935546875</c:v>
                </c:pt>
                <c:pt idx="163">
                  <c:v>6834.07861328125</c:v>
                </c:pt>
                <c:pt idx="164">
                  <c:v>6854.974609375</c:v>
                </c:pt>
                <c:pt idx="165">
                  <c:v>6851.24853515625</c:v>
                </c:pt>
                <c:pt idx="166">
                  <c:v>6826.45263671875</c:v>
                </c:pt>
                <c:pt idx="167">
                  <c:v>6792.03662109375</c:v>
                </c:pt>
                <c:pt idx="168">
                  <c:v>6763.0517578125</c:v>
                </c:pt>
                <c:pt idx="169">
                  <c:v>6751.5107421875</c:v>
                </c:pt>
                <c:pt idx="170">
                  <c:v>6760.21142578125</c:v>
                </c:pt>
                <c:pt idx="171">
                  <c:v>6780.90185546875</c:v>
                </c:pt>
                <c:pt idx="172">
                  <c:v>6798.92333984375</c:v>
                </c:pt>
                <c:pt idx="173">
                  <c:v>6802.22705078125</c:v>
                </c:pt>
                <c:pt idx="174">
                  <c:v>6788.92626953125</c:v>
                </c:pt>
                <c:pt idx="175">
                  <c:v>6767.861328125</c:v>
                </c:pt>
                <c:pt idx="176">
                  <c:v>6751.591796875</c:v>
                </c:pt>
                <c:pt idx="177">
                  <c:v>6747.22607421875</c:v>
                </c:pt>
                <c:pt idx="178">
                  <c:v>6752.3642578125</c:v>
                </c:pt>
                <c:pt idx="179">
                  <c:v>6759.2275390625</c:v>
                </c:pt>
                <c:pt idx="180">
                  <c:v>6762.8857421875</c:v>
                </c:pt>
                <c:pt idx="181">
                  <c:v>6765.771484375</c:v>
                </c:pt>
                <c:pt idx="182">
                  <c:v>6773.9365234375</c:v>
                </c:pt>
                <c:pt idx="183">
                  <c:v>6788.390625</c:v>
                </c:pt>
                <c:pt idx="184">
                  <c:v>6800.26025390625</c:v>
                </c:pt>
                <c:pt idx="185">
                  <c:v>6796.04541015625</c:v>
                </c:pt>
                <c:pt idx="186">
                  <c:v>6770.2490234375</c:v>
                </c:pt>
                <c:pt idx="187">
                  <c:v>6734.75341796875</c:v>
                </c:pt>
                <c:pt idx="188">
                  <c:v>6715.04931640625</c:v>
                </c:pt>
                <c:pt idx="189">
                  <c:v>6733.36083984375</c:v>
                </c:pt>
                <c:pt idx="190">
                  <c:v>6790.2177734375</c:v>
                </c:pt>
                <c:pt idx="191">
                  <c:v>6859.248046875</c:v>
                </c:pt>
                <c:pt idx="192">
                  <c:v>6901.2236328125</c:v>
                </c:pt>
                <c:pt idx="193">
                  <c:v>6888.921875</c:v>
                </c:pt>
                <c:pt idx="194">
                  <c:v>6825.53369140625</c:v>
                </c:pt>
                <c:pt idx="195">
                  <c:v>6743.45068359375</c:v>
                </c:pt>
                <c:pt idx="196">
                  <c:v>6684.33349609375</c:v>
                </c:pt>
                <c:pt idx="197">
                  <c:v>6674.48193359375</c:v>
                </c:pt>
                <c:pt idx="198">
                  <c:v>6711.75146484375</c:v>
                </c:pt>
                <c:pt idx="199">
                  <c:v>6770.63623046875</c:v>
                </c:pt>
                <c:pt idx="200">
                  <c:v>6819.05517578125</c:v>
                </c:pt>
                <c:pt idx="201">
                  <c:v>6834.17626953125</c:v>
                </c:pt>
                <c:pt idx="202">
                  <c:v>6808.86181640625</c:v>
                </c:pt>
                <c:pt idx="203">
                  <c:v>6749.6279296875</c:v>
                </c:pt>
                <c:pt idx="204">
                  <c:v>6672.42578125</c:v>
                </c:pt>
                <c:pt idx="205">
                  <c:v>6600.09912109375</c:v>
                </c:pt>
                <c:pt idx="206">
                  <c:v>6559.18017578125</c:v>
                </c:pt>
                <c:pt idx="207">
                  <c:v>6571.51416015625</c:v>
                </c:pt>
                <c:pt idx="208">
                  <c:v>6641.427734375</c:v>
                </c:pt>
                <c:pt idx="209">
                  <c:v>6746.9208984375</c:v>
                </c:pt>
                <c:pt idx="210">
                  <c:v>6845.01171875</c:v>
                </c:pt>
                <c:pt idx="211">
                  <c:v>6892.8642578125</c:v>
                </c:pt>
                <c:pt idx="212">
                  <c:v>6873.3193359375</c:v>
                </c:pt>
                <c:pt idx="213">
                  <c:v>6807.060546875</c:v>
                </c:pt>
                <c:pt idx="214">
                  <c:v>6740.94287109375</c:v>
                </c:pt>
                <c:pt idx="215">
                  <c:v>6718.78076171875</c:v>
                </c:pt>
                <c:pt idx="216">
                  <c:v>6754.30322265625</c:v>
                </c:pt>
                <c:pt idx="217">
                  <c:v>6824.8759765625</c:v>
                </c:pt>
                <c:pt idx="218">
                  <c:v>6889.2998046875</c:v>
                </c:pt>
                <c:pt idx="219">
                  <c:v>6915.3974609375</c:v>
                </c:pt>
                <c:pt idx="220">
                  <c:v>6897.20556640625</c:v>
                </c:pt>
                <c:pt idx="221">
                  <c:v>6851.5400390625</c:v>
                </c:pt>
                <c:pt idx="222">
                  <c:v>6800.68310546875</c:v>
                </c:pt>
                <c:pt idx="223">
                  <c:v>6757.53662109375</c:v>
                </c:pt>
                <c:pt idx="224">
                  <c:v>6724.43505859375</c:v>
                </c:pt>
                <c:pt idx="225">
                  <c:v>6702.5771484375</c:v>
                </c:pt>
                <c:pt idx="226">
                  <c:v>6699.1435546875</c:v>
                </c:pt>
                <c:pt idx="227">
                  <c:v>6722.6240234375</c:v>
                </c:pt>
                <c:pt idx="228">
                  <c:v>6770.09716796875</c:v>
                </c:pt>
                <c:pt idx="229">
                  <c:v>6820.345703125</c:v>
                </c:pt>
                <c:pt idx="230">
                  <c:v>6843.3662109375</c:v>
                </c:pt>
                <c:pt idx="231">
                  <c:v>6822.08251953125</c:v>
                </c:pt>
                <c:pt idx="232">
                  <c:v>6768.96533203125</c:v>
                </c:pt>
                <c:pt idx="233">
                  <c:v>6721.5537109375</c:v>
                </c:pt>
                <c:pt idx="234">
                  <c:v>6717.07568359375</c:v>
                </c:pt>
                <c:pt idx="235">
                  <c:v>6764.3662109375</c:v>
                </c:pt>
                <c:pt idx="236">
                  <c:v>6835.41015625</c:v>
                </c:pt>
                <c:pt idx="237">
                  <c:v>6884.33447265625</c:v>
                </c:pt>
                <c:pt idx="238">
                  <c:v>6879.8515625</c:v>
                </c:pt>
                <c:pt idx="239">
                  <c:v>6826.0654296875</c:v>
                </c:pt>
                <c:pt idx="240">
                  <c:v>6755.87841796875</c:v>
                </c:pt>
                <c:pt idx="241">
                  <c:v>6703.5166015625</c:v>
                </c:pt>
                <c:pt idx="242">
                  <c:v>6679.4580078125</c:v>
                </c:pt>
                <c:pt idx="243">
                  <c:v>6668.16943359375</c:v>
                </c:pt>
                <c:pt idx="244">
                  <c:v>6649.0458984375</c:v>
                </c:pt>
                <c:pt idx="245">
                  <c:v>6620.8505859375</c:v>
                </c:pt>
                <c:pt idx="246">
                  <c:v>6607.00390625</c:v>
                </c:pt>
                <c:pt idx="247">
                  <c:v>6635.9208984375</c:v>
                </c:pt>
                <c:pt idx="248">
                  <c:v>6712.8271484375</c:v>
                </c:pt>
                <c:pt idx="249">
                  <c:v>6807.98486328125</c:v>
                </c:pt>
                <c:pt idx="250">
                  <c:v>6873.35693359375</c:v>
                </c:pt>
                <c:pt idx="251">
                  <c:v>6876.0400390625</c:v>
                </c:pt>
                <c:pt idx="252">
                  <c:v>6822.19970703125</c:v>
                </c:pt>
                <c:pt idx="253">
                  <c:v>6752.20947265625</c:v>
                </c:pt>
                <c:pt idx="254">
                  <c:v>6710.681640625</c:v>
                </c:pt>
                <c:pt idx="255">
                  <c:v>6715.05517578125</c:v>
                </c:pt>
                <c:pt idx="256">
                  <c:v>6747.05419921875</c:v>
                </c:pt>
                <c:pt idx="257">
                  <c:v>6772.2958984375</c:v>
                </c:pt>
                <c:pt idx="258">
                  <c:v>6770.626953125</c:v>
                </c:pt>
                <c:pt idx="259">
                  <c:v>6751.9716796875</c:v>
                </c:pt>
                <c:pt idx="260">
                  <c:v>6745.5263671875</c:v>
                </c:pt>
                <c:pt idx="261">
                  <c:v>6772.57861328125</c:v>
                </c:pt>
                <c:pt idx="262">
                  <c:v>6826.3720703125</c:v>
                </c:pt>
                <c:pt idx="263">
                  <c:v>6875.822265625</c:v>
                </c:pt>
                <c:pt idx="264">
                  <c:v>6889.6962890625</c:v>
                </c:pt>
                <c:pt idx="265">
                  <c:v>6861.1982421875</c:v>
                </c:pt>
                <c:pt idx="266">
                  <c:v>6813.1611328125</c:v>
                </c:pt>
                <c:pt idx="267">
                  <c:v>6780.2919921875</c:v>
                </c:pt>
                <c:pt idx="268">
                  <c:v>6783.23388671875</c:v>
                </c:pt>
                <c:pt idx="269">
                  <c:v>6814.763671875</c:v>
                </c:pt>
                <c:pt idx="270">
                  <c:v>6847.66064453125</c:v>
                </c:pt>
                <c:pt idx="271">
                  <c:v>6856.34375</c:v>
                </c:pt>
                <c:pt idx="272">
                  <c:v>6834.6611328125</c:v>
                </c:pt>
                <c:pt idx="273">
                  <c:v>6797.09619140625</c:v>
                </c:pt>
                <c:pt idx="274">
                  <c:v>6764.83544921875</c:v>
                </c:pt>
                <c:pt idx="275">
                  <c:v>6749.45263671875</c:v>
                </c:pt>
                <c:pt idx="276">
                  <c:v>6746.8525390625</c:v>
                </c:pt>
                <c:pt idx="277">
                  <c:v>6744.2392578125</c:v>
                </c:pt>
                <c:pt idx="278">
                  <c:v>6732.35791015625</c:v>
                </c:pt>
                <c:pt idx="279">
                  <c:v>6712.59130859375</c:v>
                </c:pt>
                <c:pt idx="280">
                  <c:v>6694.43212890625</c:v>
                </c:pt>
                <c:pt idx="281">
                  <c:v>6687.19384765625</c:v>
                </c:pt>
                <c:pt idx="282">
                  <c:v>6693.380859375</c:v>
                </c:pt>
                <c:pt idx="283">
                  <c:v>6708.06787109375</c:v>
                </c:pt>
                <c:pt idx="284">
                  <c:v>6722.96337890625</c:v>
                </c:pt>
                <c:pt idx="285">
                  <c:v>6730.94482421875</c:v>
                </c:pt>
                <c:pt idx="286">
                  <c:v>6728.4560546875</c:v>
                </c:pt>
                <c:pt idx="287">
                  <c:v>6716.30322265625</c:v>
                </c:pt>
                <c:pt idx="288">
                  <c:v>6700.27294921875</c:v>
                </c:pt>
                <c:pt idx="289">
                  <c:v>6690.99267578125</c:v>
                </c:pt>
                <c:pt idx="290">
                  <c:v>6700.64599609375</c:v>
                </c:pt>
                <c:pt idx="291">
                  <c:v>6735.74755859375</c:v>
                </c:pt>
                <c:pt idx="292">
                  <c:v>6789.66259765625</c:v>
                </c:pt>
                <c:pt idx="293">
                  <c:v>6841.525390625</c:v>
                </c:pt>
                <c:pt idx="294">
                  <c:v>6865.54736328125</c:v>
                </c:pt>
                <c:pt idx="295">
                  <c:v>6847.0625</c:v>
                </c:pt>
                <c:pt idx="296">
                  <c:v>6794.82275390625</c:v>
                </c:pt>
                <c:pt idx="297">
                  <c:v>6739.43701171875</c:v>
                </c:pt>
                <c:pt idx="298">
                  <c:v>6716.56298828125</c:v>
                </c:pt>
                <c:pt idx="299">
                  <c:v>6744.67724609375</c:v>
                </c:pt>
                <c:pt idx="300">
                  <c:v>6812.2822265625</c:v>
                </c:pt>
                <c:pt idx="301">
                  <c:v>6883.78515625</c:v>
                </c:pt>
                <c:pt idx="302">
                  <c:v>6920.640625</c:v>
                </c:pt>
                <c:pt idx="303">
                  <c:v>6903.884765625</c:v>
                </c:pt>
                <c:pt idx="304">
                  <c:v>6843.546875</c:v>
                </c:pt>
                <c:pt idx="305">
                  <c:v>6769.9111328125</c:v>
                </c:pt>
                <c:pt idx="306">
                  <c:v>6713.966796875</c:v>
                </c:pt>
                <c:pt idx="307">
                  <c:v>6690.740234375</c:v>
                </c:pt>
                <c:pt idx="308">
                  <c:v>6695.55224609375</c:v>
                </c:pt>
                <c:pt idx="309">
                  <c:v>6713.234375</c:v>
                </c:pt>
                <c:pt idx="310">
                  <c:v>6731.611328125</c:v>
                </c:pt>
                <c:pt idx="311">
                  <c:v>6749.115234375</c:v>
                </c:pt>
                <c:pt idx="312">
                  <c:v>6772.11083984375</c:v>
                </c:pt>
                <c:pt idx="313">
                  <c:v>6805.4755859375</c:v>
                </c:pt>
                <c:pt idx="314">
                  <c:v>6844.34814453125</c:v>
                </c:pt>
                <c:pt idx="315">
                  <c:v>6873.41455078125</c:v>
                </c:pt>
                <c:pt idx="316">
                  <c:v>6874.5078125</c:v>
                </c:pt>
                <c:pt idx="317">
                  <c:v>6837.78564453125</c:v>
                </c:pt>
                <c:pt idx="318">
                  <c:v>6769.57421875</c:v>
                </c:pt>
                <c:pt idx="319">
                  <c:v>6691.8798828125</c:v>
                </c:pt>
                <c:pt idx="320">
                  <c:v>6633.17431640625</c:v>
                </c:pt>
                <c:pt idx="321">
                  <c:v>6614.88134765625</c:v>
                </c:pt>
                <c:pt idx="322">
                  <c:v>6640.67822265625</c:v>
                </c:pt>
                <c:pt idx="323">
                  <c:v>6694.779296875</c:v>
                </c:pt>
                <c:pt idx="324">
                  <c:v>6750.75732421875</c:v>
                </c:pt>
                <c:pt idx="325">
                  <c:v>6786.30078125</c:v>
                </c:pt>
                <c:pt idx="326">
                  <c:v>6795.17724609375</c:v>
                </c:pt>
                <c:pt idx="327">
                  <c:v>6788.7861328125</c:v>
                </c:pt>
                <c:pt idx="328">
                  <c:v>6786.12744140625</c:v>
                </c:pt>
                <c:pt idx="329">
                  <c:v>6799.0087890625</c:v>
                </c:pt>
                <c:pt idx="330">
                  <c:v>6823.08203125</c:v>
                </c:pt>
                <c:pt idx="331">
                  <c:v>6841.44873046875</c:v>
                </c:pt>
                <c:pt idx="332">
                  <c:v>6838.29248046875</c:v>
                </c:pt>
                <c:pt idx="333">
                  <c:v>6812.02392578125</c:v>
                </c:pt>
                <c:pt idx="334">
                  <c:v>6777.291015625</c:v>
                </c:pt>
                <c:pt idx="335">
                  <c:v>6753.65576171875</c:v>
                </c:pt>
                <c:pt idx="336">
                  <c:v>6749.591796875</c:v>
                </c:pt>
                <c:pt idx="337">
                  <c:v>6754.95751953125</c:v>
                </c:pt>
                <c:pt idx="338">
                  <c:v>6749.06298828125</c:v>
                </c:pt>
                <c:pt idx="339">
                  <c:v>6719.00732421875</c:v>
                </c:pt>
                <c:pt idx="340">
                  <c:v>6673.8828125</c:v>
                </c:pt>
                <c:pt idx="341">
                  <c:v>6642.45849609375</c:v>
                </c:pt>
                <c:pt idx="342">
                  <c:v>6654.20556640625</c:v>
                </c:pt>
                <c:pt idx="343">
                  <c:v>6716.7998046875</c:v>
                </c:pt>
                <c:pt idx="344">
                  <c:v>6807.03857421875</c:v>
                </c:pt>
                <c:pt idx="345">
                  <c:v>6882.93896484375</c:v>
                </c:pt>
                <c:pt idx="346">
                  <c:v>6909.34814453125</c:v>
                </c:pt>
                <c:pt idx="347">
                  <c:v>6879.36083984375</c:v>
                </c:pt>
                <c:pt idx="348">
                  <c:v>6816.88671875</c:v>
                </c:pt>
                <c:pt idx="349">
                  <c:v>6759.41064453125</c:v>
                </c:pt>
              </c:numCache>
            </c:numRef>
          </c:yVal>
          <c:smooth val="1"/>
          <c:extLst>
            <c:ext xmlns:c16="http://schemas.microsoft.com/office/drawing/2014/chart" uri="{C3380CC4-5D6E-409C-BE32-E72D297353CC}">
              <c16:uniqueId val="{00000001-0DDB-41B5-BE83-A9CFE49F3CE3}"/>
            </c:ext>
          </c:extLst>
        </c:ser>
        <c:ser>
          <c:idx val="2"/>
          <c:order val="2"/>
          <c:tx>
            <c:strRef>
              <c:f>hc_sub_007!$C$1</c:f>
              <c:strCache>
                <c:ptCount val="1"/>
                <c:pt idx="0">
                  <c:v>Coor_3</c:v>
                </c:pt>
              </c:strCache>
            </c:strRef>
          </c:tx>
          <c:spPr>
            <a:ln w="28575" cap="rnd">
              <a:solidFill>
                <a:schemeClr val="accent3"/>
              </a:solidFill>
              <a:round/>
            </a:ln>
            <a:effectLst/>
          </c:spPr>
          <c:marker>
            <c:symbol val="none"/>
          </c:marker>
          <c:yVal>
            <c:numRef>
              <c:f>hc_sub_007!$C$2:$C$351</c:f>
              <c:numCache>
                <c:formatCode>0.00000000000_ </c:formatCode>
                <c:ptCount val="350"/>
                <c:pt idx="0">
                  <c:v>6985.30126953125</c:v>
                </c:pt>
                <c:pt idx="1">
                  <c:v>7041.1796875</c:v>
                </c:pt>
                <c:pt idx="2">
                  <c:v>7144.1943359375</c:v>
                </c:pt>
                <c:pt idx="3">
                  <c:v>7248.14111328125</c:v>
                </c:pt>
                <c:pt idx="4">
                  <c:v>7304.80517578125</c:v>
                </c:pt>
                <c:pt idx="5">
                  <c:v>7291.27294921875</c:v>
                </c:pt>
                <c:pt idx="6">
                  <c:v>7219.62744140625</c:v>
                </c:pt>
                <c:pt idx="7">
                  <c:v>7125.2509765625</c:v>
                </c:pt>
                <c:pt idx="8">
                  <c:v>7044.73583984375</c:v>
                </c:pt>
                <c:pt idx="9">
                  <c:v>6998.99560546875</c:v>
                </c:pt>
                <c:pt idx="10">
                  <c:v>6989.796875</c:v>
                </c:pt>
                <c:pt idx="11">
                  <c:v>7006.45263671875</c:v>
                </c:pt>
                <c:pt idx="12">
                  <c:v>7033.83349609375</c:v>
                </c:pt>
                <c:pt idx="13">
                  <c:v>7056.43603515625</c:v>
                </c:pt>
                <c:pt idx="14">
                  <c:v>7060.48681640625</c:v>
                </c:pt>
                <c:pt idx="15">
                  <c:v>7038.642578125</c:v>
                </c:pt>
                <c:pt idx="16">
                  <c:v>6997.07177734375</c:v>
                </c:pt>
                <c:pt idx="17">
                  <c:v>6958.0224609375</c:v>
                </c:pt>
                <c:pt idx="18">
                  <c:v>6950.77783203125</c:v>
                </c:pt>
                <c:pt idx="19">
                  <c:v>6992.587890625</c:v>
                </c:pt>
                <c:pt idx="20">
                  <c:v>7072.068359375</c:v>
                </c:pt>
                <c:pt idx="21">
                  <c:v>7149.93017578125</c:v>
                </c:pt>
                <c:pt idx="22">
                  <c:v>7181.1708984375</c:v>
                </c:pt>
                <c:pt idx="23">
                  <c:v>7145.875</c:v>
                </c:pt>
                <c:pt idx="24">
                  <c:v>7066.3505859375</c:v>
                </c:pt>
                <c:pt idx="25">
                  <c:v>6995.74560546875</c:v>
                </c:pt>
                <c:pt idx="26">
                  <c:v>6983.66748046875</c:v>
                </c:pt>
                <c:pt idx="27">
                  <c:v>7042.33837890625</c:v>
                </c:pt>
                <c:pt idx="28">
                  <c:v>7137.91162109375</c:v>
                </c:pt>
                <c:pt idx="29">
                  <c:v>7213.72998046875</c:v>
                </c:pt>
                <c:pt idx="30">
                  <c:v>7228.76513671875</c:v>
                </c:pt>
                <c:pt idx="31">
                  <c:v>7183.384765625</c:v>
                </c:pt>
                <c:pt idx="32">
                  <c:v>7114.6884765625</c:v>
                </c:pt>
                <c:pt idx="33">
                  <c:v>7066.93603515625</c:v>
                </c:pt>
                <c:pt idx="34">
                  <c:v>7060.82861328125</c:v>
                </c:pt>
                <c:pt idx="35">
                  <c:v>7084.48095703125</c:v>
                </c:pt>
                <c:pt idx="36">
                  <c:v>7110.37841796875</c:v>
                </c:pt>
                <c:pt idx="37">
                  <c:v>7121.7919921875</c:v>
                </c:pt>
                <c:pt idx="38">
                  <c:v>7125.83154296875</c:v>
                </c:pt>
                <c:pt idx="39">
                  <c:v>7142.90234375</c:v>
                </c:pt>
                <c:pt idx="40">
                  <c:v>7182.83203125</c:v>
                </c:pt>
                <c:pt idx="41">
                  <c:v>7229.17724609375</c:v>
                </c:pt>
                <c:pt idx="42">
                  <c:v>7246.255859375</c:v>
                </c:pt>
                <c:pt idx="43">
                  <c:v>7204.408203125</c:v>
                </c:pt>
                <c:pt idx="44">
                  <c:v>7103.77685546875</c:v>
                </c:pt>
                <c:pt idx="45">
                  <c:v>6977.80126953125</c:v>
                </c:pt>
                <c:pt idx="46">
                  <c:v>6873.53662109375</c:v>
                </c:pt>
                <c:pt idx="47">
                  <c:v>6823.66748046875</c:v>
                </c:pt>
                <c:pt idx="48">
                  <c:v>6830.53466796875</c:v>
                </c:pt>
                <c:pt idx="49">
                  <c:v>6872.07177734375</c:v>
                </c:pt>
                <c:pt idx="50">
                  <c:v>6922.3701171875</c:v>
                </c:pt>
                <c:pt idx="51">
                  <c:v>6969.6162109375</c:v>
                </c:pt>
                <c:pt idx="52">
                  <c:v>7018.51416015625</c:v>
                </c:pt>
                <c:pt idx="53">
                  <c:v>7078.2265625</c:v>
                </c:pt>
                <c:pt idx="54">
                  <c:v>7148.26171875</c:v>
                </c:pt>
                <c:pt idx="55">
                  <c:v>7214.7119140625</c:v>
                </c:pt>
                <c:pt idx="56">
                  <c:v>7259.04248046875</c:v>
                </c:pt>
                <c:pt idx="57">
                  <c:v>7270.70654296875</c:v>
                </c:pt>
                <c:pt idx="58">
                  <c:v>7252.50732421875</c:v>
                </c:pt>
                <c:pt idx="59">
                  <c:v>7215.08056640625</c:v>
                </c:pt>
                <c:pt idx="60">
                  <c:v>7166.88525390625</c:v>
                </c:pt>
                <c:pt idx="61">
                  <c:v>7109.7158203125</c:v>
                </c:pt>
                <c:pt idx="62">
                  <c:v>7043.96484375</c:v>
                </c:pt>
                <c:pt idx="63">
                  <c:v>6978.146484375</c:v>
                </c:pt>
                <c:pt idx="64">
                  <c:v>6932.30712890625</c:v>
                </c:pt>
                <c:pt idx="65">
                  <c:v>6929.4931640625</c:v>
                </c:pt>
                <c:pt idx="66">
                  <c:v>6979.77294921875</c:v>
                </c:pt>
                <c:pt idx="67">
                  <c:v>7068.82763671875</c:v>
                </c:pt>
                <c:pt idx="68">
                  <c:v>7161.2412109375</c:v>
                </c:pt>
                <c:pt idx="69">
                  <c:v>7218.4072265625</c:v>
                </c:pt>
                <c:pt idx="70">
                  <c:v>7220.0830078125</c:v>
                </c:pt>
                <c:pt idx="71">
                  <c:v>7175.38330078125</c:v>
                </c:pt>
                <c:pt idx="72">
                  <c:v>7115.88330078125</c:v>
                </c:pt>
                <c:pt idx="73">
                  <c:v>7075.46826171875</c:v>
                </c:pt>
                <c:pt idx="74">
                  <c:v>7070.1318359375</c:v>
                </c:pt>
                <c:pt idx="75">
                  <c:v>7090.3291015625</c:v>
                </c:pt>
                <c:pt idx="76">
                  <c:v>7109.7333984375</c:v>
                </c:pt>
                <c:pt idx="77">
                  <c:v>7103.64453125</c:v>
                </c:pt>
                <c:pt idx="78">
                  <c:v>7064.92138671875</c:v>
                </c:pt>
                <c:pt idx="79">
                  <c:v>7007.9951171875</c:v>
                </c:pt>
                <c:pt idx="80">
                  <c:v>6959.71826171875</c:v>
                </c:pt>
                <c:pt idx="81">
                  <c:v>6943.75</c:v>
                </c:pt>
                <c:pt idx="82">
                  <c:v>6968.142578125</c:v>
                </c:pt>
                <c:pt idx="83">
                  <c:v>7022.62060546875</c:v>
                </c:pt>
                <c:pt idx="84">
                  <c:v>7085.57275390625</c:v>
                </c:pt>
                <c:pt idx="85">
                  <c:v>7135.3330078125</c:v>
                </c:pt>
                <c:pt idx="86">
                  <c:v>7158.990234375</c:v>
                </c:pt>
                <c:pt idx="87">
                  <c:v>7154.892578125</c:v>
                </c:pt>
                <c:pt idx="88">
                  <c:v>7129.6484375</c:v>
                </c:pt>
                <c:pt idx="89">
                  <c:v>7093.4873046875</c:v>
                </c:pt>
                <c:pt idx="90">
                  <c:v>7057.44970703125</c:v>
                </c:pt>
                <c:pt idx="91">
                  <c:v>7032.85546875</c:v>
                </c:pt>
                <c:pt idx="92">
                  <c:v>7030.61962890625</c:v>
                </c:pt>
                <c:pt idx="93">
                  <c:v>7057.875</c:v>
                </c:pt>
                <c:pt idx="94">
                  <c:v>7112.34521484375</c:v>
                </c:pt>
                <c:pt idx="95">
                  <c:v>7178.56005859375</c:v>
                </c:pt>
                <c:pt idx="96">
                  <c:v>7230.8173828125</c:v>
                </c:pt>
                <c:pt idx="97">
                  <c:v>7244.1259765625</c:v>
                </c:pt>
                <c:pt idx="98">
                  <c:v>7208.25341796875</c:v>
                </c:pt>
                <c:pt idx="99">
                  <c:v>7135.98193359375</c:v>
                </c:pt>
                <c:pt idx="100">
                  <c:v>7058.640625</c:v>
                </c:pt>
                <c:pt idx="101">
                  <c:v>7009.64208984375</c:v>
                </c:pt>
                <c:pt idx="102">
                  <c:v>7005.2451171875</c:v>
                </c:pt>
                <c:pt idx="103">
                  <c:v>7034.8837890625</c:v>
                </c:pt>
                <c:pt idx="104">
                  <c:v>7068.13232421875</c:v>
                </c:pt>
                <c:pt idx="105">
                  <c:v>7074.642578125</c:v>
                </c:pt>
                <c:pt idx="106">
                  <c:v>7044.4091796875</c:v>
                </c:pt>
                <c:pt idx="107">
                  <c:v>6994.93212890625</c:v>
                </c:pt>
                <c:pt idx="108">
                  <c:v>6960.16455078125</c:v>
                </c:pt>
                <c:pt idx="109">
                  <c:v>6968.1640625</c:v>
                </c:pt>
                <c:pt idx="110">
                  <c:v>7021.9560546875</c:v>
                </c:pt>
                <c:pt idx="111">
                  <c:v>7096.166015625</c:v>
                </c:pt>
                <c:pt idx="112">
                  <c:v>7151.810546875</c:v>
                </c:pt>
                <c:pt idx="113">
                  <c:v>7160.0146484375</c:v>
                </c:pt>
                <c:pt idx="114">
                  <c:v>7119.83251953125</c:v>
                </c:pt>
                <c:pt idx="115">
                  <c:v>7059.10302734375</c:v>
                </c:pt>
                <c:pt idx="116">
                  <c:v>7017.7744140625</c:v>
                </c:pt>
                <c:pt idx="117">
                  <c:v>7023.7587890625</c:v>
                </c:pt>
                <c:pt idx="118">
                  <c:v>7075.86767578125</c:v>
                </c:pt>
                <c:pt idx="119">
                  <c:v>7144.2294921875</c:v>
                </c:pt>
                <c:pt idx="120">
                  <c:v>7188.3447265625</c:v>
                </c:pt>
                <c:pt idx="121">
                  <c:v>7182.34765625</c:v>
                </c:pt>
                <c:pt idx="122">
                  <c:v>7132.208984375</c:v>
                </c:pt>
                <c:pt idx="123">
                  <c:v>7073.580078125</c:v>
                </c:pt>
                <c:pt idx="124">
                  <c:v>7050.138671875</c:v>
                </c:pt>
                <c:pt idx="125">
                  <c:v>7084.57568359375</c:v>
                </c:pt>
                <c:pt idx="126">
                  <c:v>7160.33056640625</c:v>
                </c:pt>
                <c:pt idx="127">
                  <c:v>7227.2275390625</c:v>
                </c:pt>
                <c:pt idx="128">
                  <c:v>7230.0595703125</c:v>
                </c:pt>
                <c:pt idx="129">
                  <c:v>7144.05029296875</c:v>
                </c:pt>
                <c:pt idx="130">
                  <c:v>6994.923828125</c:v>
                </c:pt>
                <c:pt idx="131">
                  <c:v>6849.2890625</c:v>
                </c:pt>
                <c:pt idx="132">
                  <c:v>6779.18701171875</c:v>
                </c:pt>
                <c:pt idx="133">
                  <c:v>6821.54541015625</c:v>
                </c:pt>
                <c:pt idx="134">
                  <c:v>6957.3681640625</c:v>
                </c:pt>
                <c:pt idx="135">
                  <c:v>7123.375</c:v>
                </c:pt>
                <c:pt idx="136">
                  <c:v>7248.2607421875</c:v>
                </c:pt>
                <c:pt idx="137">
                  <c:v>7290.5966796875</c:v>
                </c:pt>
                <c:pt idx="138">
                  <c:v>7255.79638671875</c:v>
                </c:pt>
                <c:pt idx="139">
                  <c:v>7184.56982421875</c:v>
                </c:pt>
                <c:pt idx="140">
                  <c:v>7123.85205078125</c:v>
                </c:pt>
                <c:pt idx="141">
                  <c:v>7100.390625</c:v>
                </c:pt>
                <c:pt idx="142">
                  <c:v>7111.8798828125</c:v>
                </c:pt>
                <c:pt idx="143">
                  <c:v>7136.41650390625</c:v>
                </c:pt>
                <c:pt idx="144">
                  <c:v>7149.50390625</c:v>
                </c:pt>
                <c:pt idx="145">
                  <c:v>7136.4501953125</c:v>
                </c:pt>
                <c:pt idx="146">
                  <c:v>7095.43115234375</c:v>
                </c:pt>
                <c:pt idx="147">
                  <c:v>7034.69091796875</c:v>
                </c:pt>
                <c:pt idx="148">
                  <c:v>6969.31884765625</c:v>
                </c:pt>
                <c:pt idx="149">
                  <c:v>6918.8720703125</c:v>
                </c:pt>
                <c:pt idx="150">
                  <c:v>6902.82568359375</c:v>
                </c:pt>
                <c:pt idx="151">
                  <c:v>6932.00634765625</c:v>
                </c:pt>
                <c:pt idx="152">
                  <c:v>6999.95556640625</c:v>
                </c:pt>
                <c:pt idx="153">
                  <c:v>7082.14794921875</c:v>
                </c:pt>
                <c:pt idx="154">
                  <c:v>7147.361328125</c:v>
                </c:pt>
                <c:pt idx="155">
                  <c:v>7175.8203125</c:v>
                </c:pt>
                <c:pt idx="156">
                  <c:v>7171.193359375</c:v>
                </c:pt>
                <c:pt idx="157">
                  <c:v>7156.09375</c:v>
                </c:pt>
                <c:pt idx="158">
                  <c:v>7153.02685546875</c:v>
                </c:pt>
                <c:pt idx="159">
                  <c:v>7165.22265625</c:v>
                </c:pt>
                <c:pt idx="160">
                  <c:v>7173.3671875</c:v>
                </c:pt>
                <c:pt idx="161">
                  <c:v>7152.14794921875</c:v>
                </c:pt>
                <c:pt idx="162">
                  <c:v>7093.9541015625</c:v>
                </c:pt>
                <c:pt idx="163">
                  <c:v>7019.95068359375</c:v>
                </c:pt>
                <c:pt idx="164">
                  <c:v>6968.0283203125</c:v>
                </c:pt>
                <c:pt idx="165">
                  <c:v>6965.9375</c:v>
                </c:pt>
                <c:pt idx="166">
                  <c:v>7010.7587890625</c:v>
                </c:pt>
                <c:pt idx="167">
                  <c:v>7071.40576171875</c:v>
                </c:pt>
                <c:pt idx="168">
                  <c:v>7112.2333984375</c:v>
                </c:pt>
                <c:pt idx="169">
                  <c:v>7118.43310546875</c:v>
                </c:pt>
                <c:pt idx="170">
                  <c:v>7102.6162109375</c:v>
                </c:pt>
                <c:pt idx="171">
                  <c:v>7088.30859375</c:v>
                </c:pt>
                <c:pt idx="172">
                  <c:v>7086.109375</c:v>
                </c:pt>
                <c:pt idx="173">
                  <c:v>7084.55224609375</c:v>
                </c:pt>
                <c:pt idx="174">
                  <c:v>7064.32861328125</c:v>
                </c:pt>
                <c:pt idx="175">
                  <c:v>7022.80859375</c:v>
                </c:pt>
                <c:pt idx="176">
                  <c:v>6985.02099609375</c:v>
                </c:pt>
                <c:pt idx="177">
                  <c:v>6987.8330078125</c:v>
                </c:pt>
                <c:pt idx="178">
                  <c:v>7047.9111328125</c:v>
                </c:pt>
                <c:pt idx="179">
                  <c:v>7140.6162109375</c:v>
                </c:pt>
                <c:pt idx="180">
                  <c:v>7210.81591796875</c:v>
                </c:pt>
                <c:pt idx="181">
                  <c:v>7211.17236328125</c:v>
                </c:pt>
                <c:pt idx="182">
                  <c:v>7139.38427734375</c:v>
                </c:pt>
                <c:pt idx="183">
                  <c:v>7043.93359375</c:v>
                </c:pt>
                <c:pt idx="184">
                  <c:v>6991.25244140625</c:v>
                </c:pt>
                <c:pt idx="185">
                  <c:v>7017.884765625</c:v>
                </c:pt>
                <c:pt idx="186">
                  <c:v>7104.13720703125</c:v>
                </c:pt>
                <c:pt idx="187">
                  <c:v>7189.73388671875</c:v>
                </c:pt>
                <c:pt idx="188">
                  <c:v>7219.34423828125</c:v>
                </c:pt>
                <c:pt idx="189">
                  <c:v>7182.66650390625</c:v>
                </c:pt>
                <c:pt idx="190">
                  <c:v>7118.60400390625</c:v>
                </c:pt>
                <c:pt idx="191">
                  <c:v>7081.87451171875</c:v>
                </c:pt>
                <c:pt idx="192">
                  <c:v>7099.71484375</c:v>
                </c:pt>
                <c:pt idx="193">
                  <c:v>7152.78857421875</c:v>
                </c:pt>
                <c:pt idx="194">
                  <c:v>7193.58642578125</c:v>
                </c:pt>
                <c:pt idx="195">
                  <c:v>7185.34033203125</c:v>
                </c:pt>
                <c:pt idx="196">
                  <c:v>7129.4052734375</c:v>
                </c:pt>
                <c:pt idx="197">
                  <c:v>7060.552734375</c:v>
                </c:pt>
                <c:pt idx="198">
                  <c:v>7016.75341796875</c:v>
                </c:pt>
                <c:pt idx="199">
                  <c:v>7009.89501953125</c:v>
                </c:pt>
                <c:pt idx="200">
                  <c:v>7020.7822265625</c:v>
                </c:pt>
                <c:pt idx="201">
                  <c:v>7019.8984375</c:v>
                </c:pt>
                <c:pt idx="202">
                  <c:v>6994.19775390625</c:v>
                </c:pt>
                <c:pt idx="203">
                  <c:v>6957.125</c:v>
                </c:pt>
                <c:pt idx="204">
                  <c:v>6935.23291015625</c:v>
                </c:pt>
                <c:pt idx="205">
                  <c:v>6945.01708984375</c:v>
                </c:pt>
                <c:pt idx="206">
                  <c:v>6980.44189453125</c:v>
                </c:pt>
                <c:pt idx="207">
                  <c:v>7020.40625</c:v>
                </c:pt>
                <c:pt idx="208">
                  <c:v>7047.29150390625</c:v>
                </c:pt>
                <c:pt idx="209">
                  <c:v>7059.134765625</c:v>
                </c:pt>
                <c:pt idx="210">
                  <c:v>7065.68505859375</c:v>
                </c:pt>
                <c:pt idx="211">
                  <c:v>7074.41845703125</c:v>
                </c:pt>
                <c:pt idx="212">
                  <c:v>7081.5595703125</c:v>
                </c:pt>
                <c:pt idx="213">
                  <c:v>7077.25146484375</c:v>
                </c:pt>
                <c:pt idx="214">
                  <c:v>7059.4541015625</c:v>
                </c:pt>
                <c:pt idx="215">
                  <c:v>7041.94140625</c:v>
                </c:pt>
                <c:pt idx="216">
                  <c:v>7046.83544921875</c:v>
                </c:pt>
                <c:pt idx="217">
                  <c:v>7086.82568359375</c:v>
                </c:pt>
                <c:pt idx="218">
                  <c:v>7152.724609375</c:v>
                </c:pt>
                <c:pt idx="219">
                  <c:v>7218.24951171875</c:v>
                </c:pt>
                <c:pt idx="220">
                  <c:v>7258.76953125</c:v>
                </c:pt>
                <c:pt idx="221">
                  <c:v>7268.04052734375</c:v>
                </c:pt>
                <c:pt idx="222">
                  <c:v>7258.4609375</c:v>
                </c:pt>
                <c:pt idx="223">
                  <c:v>7245.23095703125</c:v>
                </c:pt>
                <c:pt idx="224">
                  <c:v>7229.70703125</c:v>
                </c:pt>
                <c:pt idx="225">
                  <c:v>7198.34716796875</c:v>
                </c:pt>
                <c:pt idx="226">
                  <c:v>7139.380859375</c:v>
                </c:pt>
                <c:pt idx="227">
                  <c:v>7062.10205078125</c:v>
                </c:pt>
                <c:pt idx="228">
                  <c:v>6999.373046875</c:v>
                </c:pt>
                <c:pt idx="229">
                  <c:v>6987.3427734375</c:v>
                </c:pt>
                <c:pt idx="230">
                  <c:v>7036.6796875</c:v>
                </c:pt>
                <c:pt idx="231">
                  <c:v>7119.05712890625</c:v>
                </c:pt>
                <c:pt idx="232">
                  <c:v>7182.169921875</c:v>
                </c:pt>
                <c:pt idx="233">
                  <c:v>7184.05224609375</c:v>
                </c:pt>
                <c:pt idx="234">
                  <c:v>7121.4248046875</c:v>
                </c:pt>
                <c:pt idx="235">
                  <c:v>7030.74609375</c:v>
                </c:pt>
                <c:pt idx="236">
                  <c:v>6961.634765625</c:v>
                </c:pt>
                <c:pt idx="237">
                  <c:v>6943.27978515625</c:v>
                </c:pt>
                <c:pt idx="238">
                  <c:v>6968.60546875</c:v>
                </c:pt>
                <c:pt idx="239">
                  <c:v>7005.6796875</c:v>
                </c:pt>
                <c:pt idx="240">
                  <c:v>7024.4609375</c:v>
                </c:pt>
                <c:pt idx="241">
                  <c:v>7016.9013671875</c:v>
                </c:pt>
                <c:pt idx="242">
                  <c:v>6996.70263671875</c:v>
                </c:pt>
                <c:pt idx="243">
                  <c:v>6983.02783203125</c:v>
                </c:pt>
                <c:pt idx="244">
                  <c:v>6984.38037109375</c:v>
                </c:pt>
                <c:pt idx="245">
                  <c:v>6995.578125</c:v>
                </c:pt>
                <c:pt idx="246">
                  <c:v>7007.09228515625</c:v>
                </c:pt>
                <c:pt idx="247">
                  <c:v>7015.328125</c:v>
                </c:pt>
                <c:pt idx="248">
                  <c:v>7023.91455078125</c:v>
                </c:pt>
                <c:pt idx="249">
                  <c:v>7036.83447265625</c:v>
                </c:pt>
                <c:pt idx="250">
                  <c:v>7052.81591796875</c:v>
                </c:pt>
                <c:pt idx="251">
                  <c:v>7068.1865234375</c:v>
                </c:pt>
                <c:pt idx="252">
                  <c:v>7084.978515625</c:v>
                </c:pt>
                <c:pt idx="253">
                  <c:v>7113.623046875</c:v>
                </c:pt>
                <c:pt idx="254">
                  <c:v>7163.6865234375</c:v>
                </c:pt>
                <c:pt idx="255">
                  <c:v>7228.91455078125</c:v>
                </c:pt>
                <c:pt idx="256">
                  <c:v>7281.8310546875</c:v>
                </c:pt>
                <c:pt idx="257">
                  <c:v>7287.93896484375</c:v>
                </c:pt>
                <c:pt idx="258">
                  <c:v>7232.54150390625</c:v>
                </c:pt>
                <c:pt idx="259">
                  <c:v>7138.95947265625</c:v>
                </c:pt>
                <c:pt idx="260">
                  <c:v>7059.6708984375</c:v>
                </c:pt>
                <c:pt idx="261">
                  <c:v>7042.119140625</c:v>
                </c:pt>
                <c:pt idx="262">
                  <c:v>7093.09228515625</c:v>
                </c:pt>
                <c:pt idx="263">
                  <c:v>7170.3076171875</c:v>
                </c:pt>
                <c:pt idx="264">
                  <c:v>7210.955078125</c:v>
                </c:pt>
                <c:pt idx="265">
                  <c:v>7177.9716796875</c:v>
                </c:pt>
                <c:pt idx="266">
                  <c:v>7089.1015625</c:v>
                </c:pt>
                <c:pt idx="267">
                  <c:v>7005.29345703125</c:v>
                </c:pt>
                <c:pt idx="268">
                  <c:v>6985.888671875</c:v>
                </c:pt>
                <c:pt idx="269">
                  <c:v>7044.23974609375</c:v>
                </c:pt>
                <c:pt idx="270">
                  <c:v>7137.70361328125</c:v>
                </c:pt>
                <c:pt idx="271">
                  <c:v>7199.568359375</c:v>
                </c:pt>
                <c:pt idx="272">
                  <c:v>7188.11279296875</c:v>
                </c:pt>
                <c:pt idx="273">
                  <c:v>7115.22802734375</c:v>
                </c:pt>
                <c:pt idx="274">
                  <c:v>7033.66845703125</c:v>
                </c:pt>
                <c:pt idx="275">
                  <c:v>6994.4931640625</c:v>
                </c:pt>
                <c:pt idx="276">
                  <c:v>7008.65576171875</c:v>
                </c:pt>
                <c:pt idx="277">
                  <c:v>7041.92333984375</c:v>
                </c:pt>
                <c:pt idx="278">
                  <c:v>7045.22802734375</c:v>
                </c:pt>
                <c:pt idx="279">
                  <c:v>6995.32958984375</c:v>
                </c:pt>
                <c:pt idx="280">
                  <c:v>6914.3525390625</c:v>
                </c:pt>
                <c:pt idx="281">
                  <c:v>6854.728515625</c:v>
                </c:pt>
                <c:pt idx="282">
                  <c:v>6862.67724609375</c:v>
                </c:pt>
                <c:pt idx="283">
                  <c:v>6947.61767578125</c:v>
                </c:pt>
                <c:pt idx="284">
                  <c:v>7077.51123046875</c:v>
                </c:pt>
                <c:pt idx="285">
                  <c:v>7199.47216796875</c:v>
                </c:pt>
                <c:pt idx="286">
                  <c:v>7268.41357421875</c:v>
                </c:pt>
                <c:pt idx="287">
                  <c:v>7265.484375</c:v>
                </c:pt>
                <c:pt idx="288">
                  <c:v>7199.861328125</c:v>
                </c:pt>
                <c:pt idx="289">
                  <c:v>7099.84033203125</c:v>
                </c:pt>
                <c:pt idx="290">
                  <c:v>7002.17529296875</c:v>
                </c:pt>
                <c:pt idx="291">
                  <c:v>6942.95654296875</c:v>
                </c:pt>
                <c:pt idx="292">
                  <c:v>6947.70654296875</c:v>
                </c:pt>
                <c:pt idx="293">
                  <c:v>7019.89111328125</c:v>
                </c:pt>
                <c:pt idx="294">
                  <c:v>7133.7353515625</c:v>
                </c:pt>
                <c:pt idx="295">
                  <c:v>7240.40234375</c:v>
                </c:pt>
                <c:pt idx="296">
                  <c:v>7289.9990234375</c:v>
                </c:pt>
                <c:pt idx="297">
                  <c:v>7259.1240234375</c:v>
                </c:pt>
                <c:pt idx="298">
                  <c:v>7165.86279296875</c:v>
                </c:pt>
                <c:pt idx="299">
                  <c:v>7060.015625</c:v>
                </c:pt>
                <c:pt idx="300">
                  <c:v>6993.2900390625</c:v>
                </c:pt>
                <c:pt idx="301">
                  <c:v>6989.2841796875</c:v>
                </c:pt>
                <c:pt idx="302">
                  <c:v>7033.69140625</c:v>
                </c:pt>
                <c:pt idx="303">
                  <c:v>7089.97412109375</c:v>
                </c:pt>
                <c:pt idx="304">
                  <c:v>7126.72314453125</c:v>
                </c:pt>
                <c:pt idx="305">
                  <c:v>7135.3857421875</c:v>
                </c:pt>
                <c:pt idx="306">
                  <c:v>7126.875</c:v>
                </c:pt>
                <c:pt idx="307">
                  <c:v>7113.9794921875</c:v>
                </c:pt>
                <c:pt idx="308">
                  <c:v>7097.64892578125</c:v>
                </c:pt>
                <c:pt idx="309">
                  <c:v>7069.8173828125</c:v>
                </c:pt>
                <c:pt idx="310">
                  <c:v>7028.798828125</c:v>
                </c:pt>
                <c:pt idx="311">
                  <c:v>6990.5888671875</c:v>
                </c:pt>
                <c:pt idx="312">
                  <c:v>6982.43701171875</c:v>
                </c:pt>
                <c:pt idx="313">
                  <c:v>7021.4169921875</c:v>
                </c:pt>
                <c:pt idx="314">
                  <c:v>7095.94873046875</c:v>
                </c:pt>
                <c:pt idx="315">
                  <c:v>7168.1748046875</c:v>
                </c:pt>
                <c:pt idx="316">
                  <c:v>7198.61279296875</c:v>
                </c:pt>
                <c:pt idx="317">
                  <c:v>7175.1357421875</c:v>
                </c:pt>
                <c:pt idx="318">
                  <c:v>7122.7978515625</c:v>
                </c:pt>
                <c:pt idx="319">
                  <c:v>7085.11376953125</c:v>
                </c:pt>
                <c:pt idx="320">
                  <c:v>7090.25</c:v>
                </c:pt>
                <c:pt idx="321">
                  <c:v>7128.4892578125</c:v>
                </c:pt>
                <c:pt idx="322">
                  <c:v>7159.25439453125</c:v>
                </c:pt>
                <c:pt idx="323">
                  <c:v>7142.89013671875</c:v>
                </c:pt>
                <c:pt idx="324">
                  <c:v>7072.72314453125</c:v>
                </c:pt>
                <c:pt idx="325">
                  <c:v>6982.470703125</c:v>
                </c:pt>
                <c:pt idx="326">
                  <c:v>6923.205078125</c:v>
                </c:pt>
                <c:pt idx="327">
                  <c:v>6927.49365234375</c:v>
                </c:pt>
                <c:pt idx="328">
                  <c:v>6987.6142578125</c:v>
                </c:pt>
                <c:pt idx="329">
                  <c:v>7063.14013671875</c:v>
                </c:pt>
                <c:pt idx="330">
                  <c:v>7110.5498046875</c:v>
                </c:pt>
                <c:pt idx="331">
                  <c:v>7111.84912109375</c:v>
                </c:pt>
                <c:pt idx="332">
                  <c:v>7082.0146484375</c:v>
                </c:pt>
                <c:pt idx="333">
                  <c:v>7052.705078125</c:v>
                </c:pt>
                <c:pt idx="334">
                  <c:v>7047.31982421875</c:v>
                </c:pt>
                <c:pt idx="335">
                  <c:v>7066.6494140625</c:v>
                </c:pt>
                <c:pt idx="336">
                  <c:v>7093.48388671875</c:v>
                </c:pt>
                <c:pt idx="337">
                  <c:v>7108.97216796875</c:v>
                </c:pt>
                <c:pt idx="338">
                  <c:v>7106.0927734375</c:v>
                </c:pt>
                <c:pt idx="339">
                  <c:v>7090.91552734375</c:v>
                </c:pt>
                <c:pt idx="340">
                  <c:v>7074.076171875</c:v>
                </c:pt>
                <c:pt idx="341">
                  <c:v>7062.28662109375</c:v>
                </c:pt>
                <c:pt idx="342">
                  <c:v>7057.17626953125</c:v>
                </c:pt>
                <c:pt idx="343">
                  <c:v>7060.05517578125</c:v>
                </c:pt>
                <c:pt idx="344">
                  <c:v>7075.19775390625</c:v>
                </c:pt>
                <c:pt idx="345">
                  <c:v>7106.45703125</c:v>
                </c:pt>
                <c:pt idx="346">
                  <c:v>7149.849609375</c:v>
                </c:pt>
                <c:pt idx="347">
                  <c:v>7190.23046875</c:v>
                </c:pt>
                <c:pt idx="348">
                  <c:v>7207.650390625</c:v>
                </c:pt>
                <c:pt idx="349">
                  <c:v>7190.37939453125</c:v>
                </c:pt>
              </c:numCache>
            </c:numRef>
          </c:yVal>
          <c:smooth val="1"/>
          <c:extLst>
            <c:ext xmlns:c16="http://schemas.microsoft.com/office/drawing/2014/chart" uri="{C3380CC4-5D6E-409C-BE32-E72D297353CC}">
              <c16:uniqueId val="{00000002-0DDB-41B5-BE83-A9CFE49F3CE3}"/>
            </c:ext>
          </c:extLst>
        </c:ser>
        <c:ser>
          <c:idx val="3"/>
          <c:order val="3"/>
          <c:tx>
            <c:strRef>
              <c:f>hc_sub_007!$D$1</c:f>
              <c:strCache>
                <c:ptCount val="1"/>
                <c:pt idx="0">
                  <c:v>Coor_4</c:v>
                </c:pt>
              </c:strCache>
            </c:strRef>
          </c:tx>
          <c:spPr>
            <a:ln w="28575" cap="rnd">
              <a:solidFill>
                <a:schemeClr val="accent4"/>
              </a:solidFill>
              <a:round/>
            </a:ln>
            <a:effectLst/>
          </c:spPr>
          <c:marker>
            <c:symbol val="none"/>
          </c:marker>
          <c:yVal>
            <c:numRef>
              <c:f>hc_sub_007!$D$2:$D$351</c:f>
              <c:numCache>
                <c:formatCode>0.00000000000_ </c:formatCode>
                <c:ptCount val="350"/>
                <c:pt idx="0">
                  <c:v>6565.8857421875</c:v>
                </c:pt>
                <c:pt idx="1">
                  <c:v>6565.8388671875</c:v>
                </c:pt>
                <c:pt idx="2">
                  <c:v>6565.14990234375</c:v>
                </c:pt>
                <c:pt idx="3">
                  <c:v>6568.85546875</c:v>
                </c:pt>
                <c:pt idx="4">
                  <c:v>6575.78857421875</c:v>
                </c:pt>
                <c:pt idx="5">
                  <c:v>6576.048828125</c:v>
                </c:pt>
                <c:pt idx="6">
                  <c:v>6557.6044921875</c:v>
                </c:pt>
                <c:pt idx="7">
                  <c:v>6518.14453125</c:v>
                </c:pt>
                <c:pt idx="8">
                  <c:v>6472.134765625</c:v>
                </c:pt>
                <c:pt idx="9">
                  <c:v>6445.0625</c:v>
                </c:pt>
                <c:pt idx="10">
                  <c:v>6456.57421875</c:v>
                </c:pt>
                <c:pt idx="11">
                  <c:v>6504.29248046875</c:v>
                </c:pt>
                <c:pt idx="12">
                  <c:v>6561.72998046875</c:v>
                </c:pt>
                <c:pt idx="13">
                  <c:v>6594.29931640625</c:v>
                </c:pt>
                <c:pt idx="14">
                  <c:v>6583.3740234375</c:v>
                </c:pt>
                <c:pt idx="15">
                  <c:v>6540.7265625</c:v>
                </c:pt>
                <c:pt idx="16">
                  <c:v>6501.33154296875</c:v>
                </c:pt>
                <c:pt idx="17">
                  <c:v>6498.24951171875</c:v>
                </c:pt>
                <c:pt idx="18">
                  <c:v>6537.39697265625</c:v>
                </c:pt>
                <c:pt idx="19">
                  <c:v>6591.35888671875</c:v>
                </c:pt>
                <c:pt idx="20">
                  <c:v>6618.05126953125</c:v>
                </c:pt>
                <c:pt idx="21">
                  <c:v>6591.55859375</c:v>
                </c:pt>
                <c:pt idx="22">
                  <c:v>6522.697265625</c:v>
                </c:pt>
                <c:pt idx="23">
                  <c:v>6453.63818359375</c:v>
                </c:pt>
                <c:pt idx="24">
                  <c:v>6429.607421875</c:v>
                </c:pt>
                <c:pt idx="25">
                  <c:v>6467.59375</c:v>
                </c:pt>
                <c:pt idx="26">
                  <c:v>6544.470703125</c:v>
                </c:pt>
                <c:pt idx="27">
                  <c:v>6613.06298828125</c:v>
                </c:pt>
                <c:pt idx="28">
                  <c:v>6634.59033203125</c:v>
                </c:pt>
                <c:pt idx="29">
                  <c:v>6604.38037109375</c:v>
                </c:pt>
                <c:pt idx="30">
                  <c:v>6552.984375</c:v>
                </c:pt>
                <c:pt idx="31">
                  <c:v>6522.7685546875</c:v>
                </c:pt>
                <c:pt idx="32">
                  <c:v>6537.3916015625</c:v>
                </c:pt>
                <c:pt idx="33">
                  <c:v>6585.90673828125</c:v>
                </c:pt>
                <c:pt idx="34">
                  <c:v>6631.99169921875</c:v>
                </c:pt>
                <c:pt idx="35">
                  <c:v>6640.65234375</c:v>
                </c:pt>
                <c:pt idx="36">
                  <c:v>6602.91650390625</c:v>
                </c:pt>
                <c:pt idx="37">
                  <c:v>6541.490234375</c:v>
                </c:pt>
                <c:pt idx="38">
                  <c:v>6494.4736328125</c:v>
                </c:pt>
                <c:pt idx="39">
                  <c:v>6489.4326171875</c:v>
                </c:pt>
                <c:pt idx="40">
                  <c:v>6525.78125</c:v>
                </c:pt>
                <c:pt idx="41">
                  <c:v>6576.5029296875</c:v>
                </c:pt>
                <c:pt idx="42">
                  <c:v>6606.56298828125</c:v>
                </c:pt>
                <c:pt idx="43">
                  <c:v>6594.84130859375</c:v>
                </c:pt>
                <c:pt idx="44">
                  <c:v>6545.63671875</c:v>
                </c:pt>
                <c:pt idx="45">
                  <c:v>6484.07373046875</c:v>
                </c:pt>
                <c:pt idx="46">
                  <c:v>6440.36279296875</c:v>
                </c:pt>
                <c:pt idx="47">
                  <c:v>6433.6923828125</c:v>
                </c:pt>
                <c:pt idx="48">
                  <c:v>6464.7041015625</c:v>
                </c:pt>
                <c:pt idx="49">
                  <c:v>6518.728515625</c:v>
                </c:pt>
                <c:pt idx="50">
                  <c:v>6575.48828125</c:v>
                </c:pt>
                <c:pt idx="51">
                  <c:v>6618.6953125</c:v>
                </c:pt>
                <c:pt idx="52">
                  <c:v>6641.01806640625</c:v>
                </c:pt>
                <c:pt idx="53">
                  <c:v>6643.69873046875</c:v>
                </c:pt>
                <c:pt idx="54">
                  <c:v>6632.86572265625</c:v>
                </c:pt>
                <c:pt idx="55">
                  <c:v>6615.20166015625</c:v>
                </c:pt>
                <c:pt idx="56">
                  <c:v>6594.87109375</c:v>
                </c:pt>
                <c:pt idx="57">
                  <c:v>6572.60595703125</c:v>
                </c:pt>
                <c:pt idx="58">
                  <c:v>6547.02099609375</c:v>
                </c:pt>
                <c:pt idx="59">
                  <c:v>6517.37451171875</c:v>
                </c:pt>
                <c:pt idx="60">
                  <c:v>6486.08154296875</c:v>
                </c:pt>
                <c:pt idx="61">
                  <c:v>6459.01171875</c:v>
                </c:pt>
                <c:pt idx="62">
                  <c:v>6442.76611328125</c:v>
                </c:pt>
                <c:pt idx="63">
                  <c:v>6440.4052734375</c:v>
                </c:pt>
                <c:pt idx="64">
                  <c:v>6448.8916015625</c:v>
                </c:pt>
                <c:pt idx="65">
                  <c:v>6460.93896484375</c:v>
                </c:pt>
                <c:pt idx="66">
                  <c:v>6470.77294921875</c:v>
                </c:pt>
                <c:pt idx="67">
                  <c:v>6479.66943359375</c:v>
                </c:pt>
                <c:pt idx="68">
                  <c:v>6496.22119140625</c:v>
                </c:pt>
                <c:pt idx="69">
                  <c:v>6529.6474609375</c:v>
                </c:pt>
                <c:pt idx="70">
                  <c:v>6580.1298828125</c:v>
                </c:pt>
                <c:pt idx="71">
                  <c:v>6633.78466796875</c:v>
                </c:pt>
                <c:pt idx="72">
                  <c:v>6667.82080078125</c:v>
                </c:pt>
                <c:pt idx="73">
                  <c:v>6664.31103515625</c:v>
                </c:pt>
                <c:pt idx="74">
                  <c:v>6623.728515625</c:v>
                </c:pt>
                <c:pt idx="75">
                  <c:v>6567.892578125</c:v>
                </c:pt>
                <c:pt idx="76">
                  <c:v>6528.3701171875</c:v>
                </c:pt>
                <c:pt idx="77">
                  <c:v>6526.7724609375</c:v>
                </c:pt>
                <c:pt idx="78">
                  <c:v>6560.1767578125</c:v>
                </c:pt>
                <c:pt idx="79">
                  <c:v>6602.439453125</c:v>
                </c:pt>
                <c:pt idx="80">
                  <c:v>6621.48828125</c:v>
                </c:pt>
                <c:pt idx="81">
                  <c:v>6601.123046875</c:v>
                </c:pt>
                <c:pt idx="82">
                  <c:v>6552.10400390625</c:v>
                </c:pt>
                <c:pt idx="83">
                  <c:v>6504.54248046875</c:v>
                </c:pt>
                <c:pt idx="84">
                  <c:v>6486.92529296875</c:v>
                </c:pt>
                <c:pt idx="85">
                  <c:v>6506.75830078125</c:v>
                </c:pt>
                <c:pt idx="86">
                  <c:v>6546.59130859375</c:v>
                </c:pt>
                <c:pt idx="87">
                  <c:v>6577.83984375</c:v>
                </c:pt>
                <c:pt idx="88">
                  <c:v>6581.77880859375</c:v>
                </c:pt>
                <c:pt idx="89">
                  <c:v>6562.09326171875</c:v>
                </c:pt>
                <c:pt idx="90">
                  <c:v>6540.12890625</c:v>
                </c:pt>
                <c:pt idx="91">
                  <c:v>6537.19970703125</c:v>
                </c:pt>
                <c:pt idx="92">
                  <c:v>6557.931640625</c:v>
                </c:pt>
                <c:pt idx="93">
                  <c:v>6587.3154296875</c:v>
                </c:pt>
                <c:pt idx="94">
                  <c:v>6603.1650390625</c:v>
                </c:pt>
                <c:pt idx="95">
                  <c:v>6593.6376953125</c:v>
                </c:pt>
                <c:pt idx="96">
                  <c:v>6565.81640625</c:v>
                </c:pt>
                <c:pt idx="97">
                  <c:v>6538.75537109375</c:v>
                </c:pt>
                <c:pt idx="98">
                  <c:v>6527.0126953125</c:v>
                </c:pt>
                <c:pt idx="99">
                  <c:v>6528.38623046875</c:v>
                </c:pt>
                <c:pt idx="100">
                  <c:v>6526.2587890625</c:v>
                </c:pt>
                <c:pt idx="101">
                  <c:v>6505.03564453125</c:v>
                </c:pt>
                <c:pt idx="102">
                  <c:v>6466.15283203125</c:v>
                </c:pt>
                <c:pt idx="103">
                  <c:v>6430.85302734375</c:v>
                </c:pt>
                <c:pt idx="104">
                  <c:v>6425.9130859375</c:v>
                </c:pt>
                <c:pt idx="105">
                  <c:v>6462.228515625</c:v>
                </c:pt>
                <c:pt idx="106">
                  <c:v>6522.92919921875</c:v>
                </c:pt>
                <c:pt idx="107">
                  <c:v>6571.728515625</c:v>
                </c:pt>
                <c:pt idx="108">
                  <c:v>6577.31396484375</c:v>
                </c:pt>
                <c:pt idx="109">
                  <c:v>6536.82373046875</c:v>
                </c:pt>
                <c:pt idx="110">
                  <c:v>6480.6904296875</c:v>
                </c:pt>
                <c:pt idx="111">
                  <c:v>6453.7021484375</c:v>
                </c:pt>
                <c:pt idx="112">
                  <c:v>6484.3486328125</c:v>
                </c:pt>
                <c:pt idx="113">
                  <c:v>6563.78759765625</c:v>
                </c:pt>
                <c:pt idx="114">
                  <c:v>6649.86767578125</c:v>
                </c:pt>
                <c:pt idx="115">
                  <c:v>6694.30322265625</c:v>
                </c:pt>
                <c:pt idx="116">
                  <c:v>6674.544921875</c:v>
                </c:pt>
                <c:pt idx="117">
                  <c:v>6608.21484375</c:v>
                </c:pt>
                <c:pt idx="118">
                  <c:v>6540.12451171875</c:v>
                </c:pt>
                <c:pt idx="119">
                  <c:v>6511.31689453125</c:v>
                </c:pt>
                <c:pt idx="120">
                  <c:v>6532.2392578125</c:v>
                </c:pt>
                <c:pt idx="121">
                  <c:v>6578.78173828125</c:v>
                </c:pt>
                <c:pt idx="122">
                  <c:v>6612.93798828125</c:v>
                </c:pt>
                <c:pt idx="123">
                  <c:v>6611.76904296875</c:v>
                </c:pt>
                <c:pt idx="124">
                  <c:v>6582.6767578125</c:v>
                </c:pt>
                <c:pt idx="125">
                  <c:v>6553.95947265625</c:v>
                </c:pt>
                <c:pt idx="126">
                  <c:v>6548.97705078125</c:v>
                </c:pt>
                <c:pt idx="127">
                  <c:v>6565.11767578125</c:v>
                </c:pt>
                <c:pt idx="128">
                  <c:v>6575.11328125</c:v>
                </c:pt>
                <c:pt idx="129">
                  <c:v>6550.513671875</c:v>
                </c:pt>
                <c:pt idx="130">
                  <c:v>6488.962890625</c:v>
                </c:pt>
                <c:pt idx="131">
                  <c:v>6422.62548828125</c:v>
                </c:pt>
                <c:pt idx="132">
                  <c:v>6398.77197265625</c:v>
                </c:pt>
                <c:pt idx="133">
                  <c:v>6445.1953125</c:v>
                </c:pt>
                <c:pt idx="134">
                  <c:v>6546.1435546875</c:v>
                </c:pt>
                <c:pt idx="135">
                  <c:v>6648.21533203125</c:v>
                </c:pt>
                <c:pt idx="136">
                  <c:v>6694.04931640625</c:v>
                </c:pt>
                <c:pt idx="137">
                  <c:v>6660.6513671875</c:v>
                </c:pt>
                <c:pt idx="138">
                  <c:v>6574.86181640625</c:v>
                </c:pt>
                <c:pt idx="139">
                  <c:v>6494.564453125</c:v>
                </c:pt>
                <c:pt idx="140">
                  <c:v>6469.0234375</c:v>
                </c:pt>
                <c:pt idx="141">
                  <c:v>6506.72216796875</c:v>
                </c:pt>
                <c:pt idx="142">
                  <c:v>6573.08447265625</c:v>
                </c:pt>
                <c:pt idx="143">
                  <c:v>6618.17919921875</c:v>
                </c:pt>
                <c:pt idx="144">
                  <c:v>6612.80908203125</c:v>
                </c:pt>
                <c:pt idx="145">
                  <c:v>6566.52099609375</c:v>
                </c:pt>
                <c:pt idx="146">
                  <c:v>6515.97216796875</c:v>
                </c:pt>
                <c:pt idx="147">
                  <c:v>6494.78759765625</c:v>
                </c:pt>
                <c:pt idx="148">
                  <c:v>6508.9814453125</c:v>
                </c:pt>
                <c:pt idx="149">
                  <c:v>6535.95166015625</c:v>
                </c:pt>
                <c:pt idx="150">
                  <c:v>6545.67724609375</c:v>
                </c:pt>
                <c:pt idx="151">
                  <c:v>6525.7958984375</c:v>
                </c:pt>
                <c:pt idx="152">
                  <c:v>6490.63525390625</c:v>
                </c:pt>
                <c:pt idx="153">
                  <c:v>6468.25048828125</c:v>
                </c:pt>
                <c:pt idx="154">
                  <c:v>6477.20751953125</c:v>
                </c:pt>
                <c:pt idx="155">
                  <c:v>6512.05908203125</c:v>
                </c:pt>
                <c:pt idx="156">
                  <c:v>6548.3173828125</c:v>
                </c:pt>
                <c:pt idx="157">
                  <c:v>6561.7119140625</c:v>
                </c:pt>
                <c:pt idx="158">
                  <c:v>6545.837890625</c:v>
                </c:pt>
                <c:pt idx="159">
                  <c:v>6514.98291015625</c:v>
                </c:pt>
                <c:pt idx="160">
                  <c:v>6491.6484375</c:v>
                </c:pt>
                <c:pt idx="161">
                  <c:v>6490.09716796875</c:v>
                </c:pt>
                <c:pt idx="162">
                  <c:v>6508.8154296875</c:v>
                </c:pt>
                <c:pt idx="163">
                  <c:v>6535.962890625</c:v>
                </c:pt>
                <c:pt idx="164">
                  <c:v>6560.9375</c:v>
                </c:pt>
                <c:pt idx="165">
                  <c:v>6581.3837890625</c:v>
                </c:pt>
                <c:pt idx="166">
                  <c:v>6600.60595703125</c:v>
                </c:pt>
                <c:pt idx="167">
                  <c:v>6619.6376953125</c:v>
                </c:pt>
                <c:pt idx="168">
                  <c:v>6632.72607421875</c:v>
                </c:pt>
                <c:pt idx="169">
                  <c:v>6631.1015625</c:v>
                </c:pt>
                <c:pt idx="170">
                  <c:v>6611.73876953125</c:v>
                </c:pt>
                <c:pt idx="171">
                  <c:v>6582.81884765625</c:v>
                </c:pt>
                <c:pt idx="172">
                  <c:v>6560.25927734375</c:v>
                </c:pt>
                <c:pt idx="173">
                  <c:v>6557.3369140625</c:v>
                </c:pt>
                <c:pt idx="174">
                  <c:v>6575.353515625</c:v>
                </c:pt>
                <c:pt idx="175">
                  <c:v>6602.4833984375</c:v>
                </c:pt>
                <c:pt idx="176">
                  <c:v>6621.39013671875</c:v>
                </c:pt>
                <c:pt idx="177">
                  <c:v>6619.67626953125</c:v>
                </c:pt>
                <c:pt idx="178">
                  <c:v>6595.94775390625</c:v>
                </c:pt>
                <c:pt idx="179">
                  <c:v>6558.56103515625</c:v>
                </c:pt>
                <c:pt idx="180">
                  <c:v>6519.7158203125</c:v>
                </c:pt>
                <c:pt idx="181">
                  <c:v>6489.81396484375</c:v>
                </c:pt>
                <c:pt idx="182">
                  <c:v>6474.88671875</c:v>
                </c:pt>
                <c:pt idx="183">
                  <c:v>6476.435546875</c:v>
                </c:pt>
                <c:pt idx="184">
                  <c:v>6491.7333984375</c:v>
                </c:pt>
                <c:pt idx="185">
                  <c:v>6514.1474609375</c:v>
                </c:pt>
                <c:pt idx="186">
                  <c:v>6534.82373046875</c:v>
                </c:pt>
                <c:pt idx="187">
                  <c:v>6546.4609375</c:v>
                </c:pt>
                <c:pt idx="188">
                  <c:v>6547.22802734375</c:v>
                </c:pt>
                <c:pt idx="189">
                  <c:v>6541.30078125</c:v>
                </c:pt>
                <c:pt idx="190">
                  <c:v>6534.54248046875</c:v>
                </c:pt>
                <c:pt idx="191">
                  <c:v>6528.42529296875</c:v>
                </c:pt>
                <c:pt idx="192">
                  <c:v>6517.978515625</c:v>
                </c:pt>
                <c:pt idx="193">
                  <c:v>6496.92333984375</c:v>
                </c:pt>
                <c:pt idx="194">
                  <c:v>6466.56005859375</c:v>
                </c:pt>
                <c:pt idx="195">
                  <c:v>6440.15283203125</c:v>
                </c:pt>
                <c:pt idx="196">
                  <c:v>6436.78369140625</c:v>
                </c:pt>
                <c:pt idx="197">
                  <c:v>6467.228515625</c:v>
                </c:pt>
                <c:pt idx="198">
                  <c:v>6522.55908203125</c:v>
                </c:pt>
                <c:pt idx="199">
                  <c:v>6576.11962890625</c:v>
                </c:pt>
                <c:pt idx="200">
                  <c:v>6599.9794921875</c:v>
                </c:pt>
                <c:pt idx="201">
                  <c:v>6584.8388671875</c:v>
                </c:pt>
                <c:pt idx="202">
                  <c:v>6548.0185546875</c:v>
                </c:pt>
                <c:pt idx="203">
                  <c:v>6522.15185546875</c:v>
                </c:pt>
                <c:pt idx="204">
                  <c:v>6532.0283203125</c:v>
                </c:pt>
                <c:pt idx="205">
                  <c:v>6576.84375</c:v>
                </c:pt>
                <c:pt idx="206">
                  <c:v>6631.4072265625</c:v>
                </c:pt>
                <c:pt idx="207">
                  <c:v>6665.1416015625</c:v>
                </c:pt>
                <c:pt idx="208">
                  <c:v>6663.7255859375</c:v>
                </c:pt>
                <c:pt idx="209">
                  <c:v>6636.5498046875</c:v>
                </c:pt>
                <c:pt idx="210">
                  <c:v>6605.23681640625</c:v>
                </c:pt>
                <c:pt idx="211">
                  <c:v>6584.23388671875</c:v>
                </c:pt>
                <c:pt idx="212">
                  <c:v>6570.603515625</c:v>
                </c:pt>
                <c:pt idx="213">
                  <c:v>6551.42236328125</c:v>
                </c:pt>
                <c:pt idx="214">
                  <c:v>6521.24609375</c:v>
                </c:pt>
                <c:pt idx="215">
                  <c:v>6492.72265625</c:v>
                </c:pt>
                <c:pt idx="216">
                  <c:v>6489.1513671875</c:v>
                </c:pt>
                <c:pt idx="217">
                  <c:v>6523.8935546875</c:v>
                </c:pt>
                <c:pt idx="218">
                  <c:v>6584.2080078125</c:v>
                </c:pt>
                <c:pt idx="219">
                  <c:v>6634.94384765625</c:v>
                </c:pt>
                <c:pt idx="220">
                  <c:v>6641.6787109375</c:v>
                </c:pt>
                <c:pt idx="221">
                  <c:v>6596.30419921875</c:v>
                </c:pt>
                <c:pt idx="222">
                  <c:v>6524.78759765625</c:v>
                </c:pt>
                <c:pt idx="223">
                  <c:v>6470.099609375</c:v>
                </c:pt>
                <c:pt idx="224">
                  <c:v>6462.6064453125</c:v>
                </c:pt>
                <c:pt idx="225">
                  <c:v>6499.94384765625</c:v>
                </c:pt>
                <c:pt idx="226">
                  <c:v>6550.83349609375</c:v>
                </c:pt>
                <c:pt idx="227">
                  <c:v>6578.7197265625</c:v>
                </c:pt>
                <c:pt idx="228">
                  <c:v>6566.63525390625</c:v>
                </c:pt>
                <c:pt idx="229">
                  <c:v>6525.3837890625</c:v>
                </c:pt>
                <c:pt idx="230">
                  <c:v>6481.44921875</c:v>
                </c:pt>
                <c:pt idx="231">
                  <c:v>6456.58447265625</c:v>
                </c:pt>
                <c:pt idx="232">
                  <c:v>6455.41650390625</c:v>
                </c:pt>
                <c:pt idx="233">
                  <c:v>6468.431640625</c:v>
                </c:pt>
                <c:pt idx="234">
                  <c:v>6484.2607421875</c:v>
                </c:pt>
                <c:pt idx="235">
                  <c:v>6498.93994140625</c:v>
                </c:pt>
                <c:pt idx="236">
                  <c:v>6515.05712890625</c:v>
                </c:pt>
                <c:pt idx="237">
                  <c:v>6534.318359375</c:v>
                </c:pt>
                <c:pt idx="238">
                  <c:v>6552.7958984375</c:v>
                </c:pt>
                <c:pt idx="239">
                  <c:v>6564.2041015625</c:v>
                </c:pt>
                <c:pt idx="240">
                  <c:v>6567.447265625</c:v>
                </c:pt>
                <c:pt idx="241">
                  <c:v>6569.7373046875</c:v>
                </c:pt>
                <c:pt idx="242">
                  <c:v>6580.7060546875</c:v>
                </c:pt>
                <c:pt idx="243">
                  <c:v>6602.2275390625</c:v>
                </c:pt>
                <c:pt idx="244">
                  <c:v>6623.95458984375</c:v>
                </c:pt>
                <c:pt idx="245">
                  <c:v>6630.2373046875</c:v>
                </c:pt>
                <c:pt idx="246">
                  <c:v>6613.61865234375</c:v>
                </c:pt>
                <c:pt idx="247">
                  <c:v>6583.0927734375</c:v>
                </c:pt>
                <c:pt idx="248">
                  <c:v>6558.7763671875</c:v>
                </c:pt>
                <c:pt idx="249">
                  <c:v>6556.1982421875</c:v>
                </c:pt>
                <c:pt idx="250">
                  <c:v>6573.07373046875</c:v>
                </c:pt>
                <c:pt idx="251">
                  <c:v>6590.25048828125</c:v>
                </c:pt>
                <c:pt idx="252">
                  <c:v>6586.9287109375</c:v>
                </c:pt>
                <c:pt idx="253">
                  <c:v>6557.90673828125</c:v>
                </c:pt>
                <c:pt idx="254">
                  <c:v>6518.38427734375</c:v>
                </c:pt>
                <c:pt idx="255">
                  <c:v>6491.96044921875</c:v>
                </c:pt>
                <c:pt idx="256">
                  <c:v>6491.63037109375</c:v>
                </c:pt>
                <c:pt idx="257">
                  <c:v>6509.619140625</c:v>
                </c:pt>
                <c:pt idx="258">
                  <c:v>6524.6005859375</c:v>
                </c:pt>
                <c:pt idx="259">
                  <c:v>6520.2509765625</c:v>
                </c:pt>
                <c:pt idx="260">
                  <c:v>6499.568359375</c:v>
                </c:pt>
                <c:pt idx="261">
                  <c:v>6482.93603515625</c:v>
                </c:pt>
                <c:pt idx="262">
                  <c:v>6491.47802734375</c:v>
                </c:pt>
                <c:pt idx="263">
                  <c:v>6529.3310546875</c:v>
                </c:pt>
                <c:pt idx="264">
                  <c:v>6579.111328125</c:v>
                </c:pt>
                <c:pt idx="265">
                  <c:v>6613.88525390625</c:v>
                </c:pt>
                <c:pt idx="266">
                  <c:v>6615.82177734375</c:v>
                </c:pt>
                <c:pt idx="267">
                  <c:v>6587.19775390625</c:v>
                </c:pt>
                <c:pt idx="268">
                  <c:v>6546.57568359375</c:v>
                </c:pt>
                <c:pt idx="269">
                  <c:v>6515.00390625</c:v>
                </c:pt>
                <c:pt idx="270">
                  <c:v>6503.8291015625</c:v>
                </c:pt>
                <c:pt idx="271">
                  <c:v>6512.27490234375</c:v>
                </c:pt>
                <c:pt idx="272">
                  <c:v>6533.55322265625</c:v>
                </c:pt>
                <c:pt idx="273">
                  <c:v>6561.64794921875</c:v>
                </c:pt>
                <c:pt idx="274">
                  <c:v>6592.3984375</c:v>
                </c:pt>
                <c:pt idx="275">
                  <c:v>6619.66748046875</c:v>
                </c:pt>
                <c:pt idx="276">
                  <c:v>6632.8369140625</c:v>
                </c:pt>
                <c:pt idx="277">
                  <c:v>6620.49609375</c:v>
                </c:pt>
                <c:pt idx="278">
                  <c:v>6578.66162109375</c:v>
                </c:pt>
                <c:pt idx="279">
                  <c:v>6516.65625</c:v>
                </c:pt>
                <c:pt idx="280">
                  <c:v>6454.9658203125</c:v>
                </c:pt>
                <c:pt idx="281">
                  <c:v>6415.79541015625</c:v>
                </c:pt>
                <c:pt idx="282">
                  <c:v>6412.79052734375</c:v>
                </c:pt>
                <c:pt idx="283">
                  <c:v>6446.33642578125</c:v>
                </c:pt>
                <c:pt idx="284">
                  <c:v>6505.697265625</c:v>
                </c:pt>
                <c:pt idx="285">
                  <c:v>6574.2119140625</c:v>
                </c:pt>
                <c:pt idx="286">
                  <c:v>6633.46142578125</c:v>
                </c:pt>
                <c:pt idx="287">
                  <c:v>6666.17236328125</c:v>
                </c:pt>
                <c:pt idx="288">
                  <c:v>6660.5693359375</c:v>
                </c:pt>
                <c:pt idx="289">
                  <c:v>6617.00244140625</c:v>
                </c:pt>
                <c:pt idx="290">
                  <c:v>6552.52099609375</c:v>
                </c:pt>
                <c:pt idx="291">
                  <c:v>6496.693359375</c:v>
                </c:pt>
                <c:pt idx="292">
                  <c:v>6476.8291015625</c:v>
                </c:pt>
                <c:pt idx="293">
                  <c:v>6500.23193359375</c:v>
                </c:pt>
                <c:pt idx="294">
                  <c:v>6546.80078125</c:v>
                </c:pt>
                <c:pt idx="295">
                  <c:v>6580.3671875</c:v>
                </c:pt>
                <c:pt idx="296">
                  <c:v>6573.44873046875</c:v>
                </c:pt>
                <c:pt idx="297">
                  <c:v>6528.1259765625</c:v>
                </c:pt>
                <c:pt idx="298">
                  <c:v>6476.384765625</c:v>
                </c:pt>
                <c:pt idx="299">
                  <c:v>6457.8076171875</c:v>
                </c:pt>
                <c:pt idx="300">
                  <c:v>6490.34130859375</c:v>
                </c:pt>
                <c:pt idx="301">
                  <c:v>6556.41162109375</c:v>
                </c:pt>
                <c:pt idx="302">
                  <c:v>6615.5888671875</c:v>
                </c:pt>
                <c:pt idx="303">
                  <c:v>6634.34423828125</c:v>
                </c:pt>
                <c:pt idx="304">
                  <c:v>6609.76123046875</c:v>
                </c:pt>
                <c:pt idx="305">
                  <c:v>6568.81201171875</c:v>
                </c:pt>
                <c:pt idx="306">
                  <c:v>6544.513671875</c:v>
                </c:pt>
                <c:pt idx="307">
                  <c:v>6548.90673828125</c:v>
                </c:pt>
                <c:pt idx="308">
                  <c:v>6564.9892578125</c:v>
                </c:pt>
                <c:pt idx="309">
                  <c:v>6563.64208984375</c:v>
                </c:pt>
                <c:pt idx="310">
                  <c:v>6530.68310546875</c:v>
                </c:pt>
                <c:pt idx="311">
                  <c:v>6480.98828125</c:v>
                </c:pt>
                <c:pt idx="312">
                  <c:v>6447.84619140625</c:v>
                </c:pt>
                <c:pt idx="313">
                  <c:v>6456.72998046875</c:v>
                </c:pt>
                <c:pt idx="314">
                  <c:v>6505.5546875</c:v>
                </c:pt>
                <c:pt idx="315">
                  <c:v>6567.466796875</c:v>
                </c:pt>
                <c:pt idx="316">
                  <c:v>6612.75439453125</c:v>
                </c:pt>
                <c:pt idx="317">
                  <c:v>6630.45458984375</c:v>
                </c:pt>
                <c:pt idx="318">
                  <c:v>6631.43310546875</c:v>
                </c:pt>
                <c:pt idx="319">
                  <c:v>6631.736328125</c:v>
                </c:pt>
                <c:pt idx="320">
                  <c:v>6632.8173828125</c:v>
                </c:pt>
                <c:pt idx="321">
                  <c:v>6617.96337890625</c:v>
                </c:pt>
                <c:pt idx="322">
                  <c:v>6569.4169921875</c:v>
                </c:pt>
                <c:pt idx="323">
                  <c:v>6491.2021484375</c:v>
                </c:pt>
                <c:pt idx="324">
                  <c:v>6415.9208984375</c:v>
                </c:pt>
                <c:pt idx="325">
                  <c:v>6386.306640625</c:v>
                </c:pt>
                <c:pt idx="326">
                  <c:v>6423.99169921875</c:v>
                </c:pt>
                <c:pt idx="327">
                  <c:v>6510.2998046875</c:v>
                </c:pt>
                <c:pt idx="328">
                  <c:v>6595.8671875</c:v>
                </c:pt>
                <c:pt idx="329">
                  <c:v>6633.50634765625</c:v>
                </c:pt>
                <c:pt idx="330">
                  <c:v>6610.0830078125</c:v>
                </c:pt>
                <c:pt idx="331">
                  <c:v>6553.57763671875</c:v>
                </c:pt>
                <c:pt idx="332">
                  <c:v>6510.64501953125</c:v>
                </c:pt>
                <c:pt idx="333">
                  <c:v>6512.42724609375</c:v>
                </c:pt>
                <c:pt idx="334">
                  <c:v>6554.291015625</c:v>
                </c:pt>
                <c:pt idx="335">
                  <c:v>6603.021484375</c:v>
                </c:pt>
                <c:pt idx="336">
                  <c:v>6623.40625</c:v>
                </c:pt>
                <c:pt idx="337">
                  <c:v>6602.59375</c:v>
                </c:pt>
                <c:pt idx="338">
                  <c:v>6554.94482421875</c:v>
                </c:pt>
                <c:pt idx="339">
                  <c:v>6507.1611328125</c:v>
                </c:pt>
                <c:pt idx="340">
                  <c:v>6478.39111328125</c:v>
                </c:pt>
                <c:pt idx="341">
                  <c:v>6471.1923828125</c:v>
                </c:pt>
                <c:pt idx="342">
                  <c:v>6477.50341796875</c:v>
                </c:pt>
                <c:pt idx="343">
                  <c:v>6490.60888671875</c:v>
                </c:pt>
                <c:pt idx="344">
                  <c:v>6510.74365234375</c:v>
                </c:pt>
                <c:pt idx="345">
                  <c:v>6540.162109375</c:v>
                </c:pt>
                <c:pt idx="346">
                  <c:v>6574.5341796875</c:v>
                </c:pt>
                <c:pt idx="347">
                  <c:v>6600.98486328125</c:v>
                </c:pt>
                <c:pt idx="348">
                  <c:v>6606.23291015625</c:v>
                </c:pt>
                <c:pt idx="349">
                  <c:v>6587.96337890625</c:v>
                </c:pt>
              </c:numCache>
            </c:numRef>
          </c:yVal>
          <c:smooth val="1"/>
          <c:extLst>
            <c:ext xmlns:c16="http://schemas.microsoft.com/office/drawing/2014/chart" uri="{C3380CC4-5D6E-409C-BE32-E72D297353CC}">
              <c16:uniqueId val="{00000003-0DDB-41B5-BE83-A9CFE49F3CE3}"/>
            </c:ext>
          </c:extLst>
        </c:ser>
        <c:ser>
          <c:idx val="4"/>
          <c:order val="4"/>
          <c:tx>
            <c:strRef>
              <c:f>hc_sub_007!$E$1</c:f>
              <c:strCache>
                <c:ptCount val="1"/>
                <c:pt idx="0">
                  <c:v>Coor_5</c:v>
                </c:pt>
              </c:strCache>
            </c:strRef>
          </c:tx>
          <c:spPr>
            <a:ln w="28575" cap="rnd">
              <a:solidFill>
                <a:schemeClr val="accent5"/>
              </a:solidFill>
              <a:round/>
            </a:ln>
            <a:effectLst/>
          </c:spPr>
          <c:marker>
            <c:symbol val="none"/>
          </c:marker>
          <c:yVal>
            <c:numRef>
              <c:f>hc_sub_007!$E$2:$E$351</c:f>
              <c:numCache>
                <c:formatCode>0.00000000000_ </c:formatCode>
                <c:ptCount val="350"/>
                <c:pt idx="0">
                  <c:v>6717.21923828125</c:v>
                </c:pt>
                <c:pt idx="1">
                  <c:v>6699.52587890625</c:v>
                </c:pt>
                <c:pt idx="2">
                  <c:v>6654.48779296875</c:v>
                </c:pt>
                <c:pt idx="3">
                  <c:v>6612.51318359375</c:v>
                </c:pt>
                <c:pt idx="4">
                  <c:v>6602.64111328125</c:v>
                </c:pt>
                <c:pt idx="5">
                  <c:v>6631.962890625</c:v>
                </c:pt>
                <c:pt idx="6">
                  <c:v>6682.02490234375</c:v>
                </c:pt>
                <c:pt idx="7">
                  <c:v>6724.00146484375</c:v>
                </c:pt>
                <c:pt idx="8">
                  <c:v>6739.54833984375</c:v>
                </c:pt>
                <c:pt idx="9">
                  <c:v>6730.74365234375</c:v>
                </c:pt>
                <c:pt idx="10">
                  <c:v>6712.82177734375</c:v>
                </c:pt>
                <c:pt idx="11">
                  <c:v>6698.1669921875</c:v>
                </c:pt>
                <c:pt idx="12">
                  <c:v>6686.51123046875</c:v>
                </c:pt>
                <c:pt idx="13">
                  <c:v>6669.29541015625</c:v>
                </c:pt>
                <c:pt idx="14">
                  <c:v>6642.52392578125</c:v>
                </c:pt>
                <c:pt idx="15">
                  <c:v>6614.6357421875</c:v>
                </c:pt>
                <c:pt idx="16">
                  <c:v>6600.87646484375</c:v>
                </c:pt>
                <c:pt idx="17">
                  <c:v>6608.8056640625</c:v>
                </c:pt>
                <c:pt idx="18">
                  <c:v>6628.73291015625</c:v>
                </c:pt>
                <c:pt idx="19">
                  <c:v>6639.37890625</c:v>
                </c:pt>
                <c:pt idx="20">
                  <c:v>6625.5712890625</c:v>
                </c:pt>
                <c:pt idx="21">
                  <c:v>6593.1572265625</c:v>
                </c:pt>
                <c:pt idx="22">
                  <c:v>6567.298828125</c:v>
                </c:pt>
                <c:pt idx="23">
                  <c:v>6573.77734375</c:v>
                </c:pt>
                <c:pt idx="24">
                  <c:v>6617.69580078125</c:v>
                </c:pt>
                <c:pt idx="25">
                  <c:v>6677.21728515625</c:v>
                </c:pt>
                <c:pt idx="26">
                  <c:v>6718.35400390625</c:v>
                </c:pt>
                <c:pt idx="27">
                  <c:v>6719.7021484375</c:v>
                </c:pt>
                <c:pt idx="28">
                  <c:v>6687.60888671875</c:v>
                </c:pt>
                <c:pt idx="29">
                  <c:v>6649.7919921875</c:v>
                </c:pt>
                <c:pt idx="30">
                  <c:v>6632.85205078125</c:v>
                </c:pt>
                <c:pt idx="31">
                  <c:v>6642.00732421875</c:v>
                </c:pt>
                <c:pt idx="32">
                  <c:v>6659.26025390625</c:v>
                </c:pt>
                <c:pt idx="33">
                  <c:v>6660.81640625</c:v>
                </c:pt>
                <c:pt idx="34">
                  <c:v>6638.8193359375</c:v>
                </c:pt>
                <c:pt idx="35">
                  <c:v>6609.16748046875</c:v>
                </c:pt>
                <c:pt idx="36">
                  <c:v>6598.89599609375</c:v>
                </c:pt>
                <c:pt idx="37">
                  <c:v>6623.46044921875</c:v>
                </c:pt>
                <c:pt idx="38">
                  <c:v>6672.48193359375</c:v>
                </c:pt>
                <c:pt idx="39">
                  <c:v>6715.63134765625</c:v>
                </c:pt>
                <c:pt idx="40">
                  <c:v>6724.2763671875</c:v>
                </c:pt>
                <c:pt idx="41">
                  <c:v>6692.2578125</c:v>
                </c:pt>
                <c:pt idx="42">
                  <c:v>6640.2490234375</c:v>
                </c:pt>
                <c:pt idx="43">
                  <c:v>6601.0810546875</c:v>
                </c:pt>
                <c:pt idx="44">
                  <c:v>6597.56494140625</c:v>
                </c:pt>
                <c:pt idx="45">
                  <c:v>6628.900390625</c:v>
                </c:pt>
                <c:pt idx="46">
                  <c:v>6674.05078125</c:v>
                </c:pt>
                <c:pt idx="47">
                  <c:v>6707.51025390625</c:v>
                </c:pt>
                <c:pt idx="48">
                  <c:v>6714.9130859375</c:v>
                </c:pt>
                <c:pt idx="49">
                  <c:v>6698.24267578125</c:v>
                </c:pt>
                <c:pt idx="50">
                  <c:v>6669.75732421875</c:v>
                </c:pt>
                <c:pt idx="51">
                  <c:v>6641.96484375</c:v>
                </c:pt>
                <c:pt idx="52">
                  <c:v>6621.939453125</c:v>
                </c:pt>
                <c:pt idx="53">
                  <c:v>6612.51025390625</c:v>
                </c:pt>
                <c:pt idx="54">
                  <c:v>6616.2001953125</c:v>
                </c:pt>
                <c:pt idx="55">
                  <c:v>6636.0693359375</c:v>
                </c:pt>
                <c:pt idx="56">
                  <c:v>6671.68994140625</c:v>
                </c:pt>
                <c:pt idx="57">
                  <c:v>6714.19189453125</c:v>
                </c:pt>
                <c:pt idx="58">
                  <c:v>6746.34033203125</c:v>
                </c:pt>
                <c:pt idx="59">
                  <c:v>6750.02001953125</c:v>
                </c:pt>
                <c:pt idx="60">
                  <c:v>6717.294921875</c:v>
                </c:pt>
                <c:pt idx="61">
                  <c:v>6657.466796875</c:v>
                </c:pt>
                <c:pt idx="62">
                  <c:v>6594.4970703125</c:v>
                </c:pt>
                <c:pt idx="63">
                  <c:v>6555.43212890625</c:v>
                </c:pt>
                <c:pt idx="64">
                  <c:v>6556.52587890625</c:v>
                </c:pt>
                <c:pt idx="65">
                  <c:v>6595.29150390625</c:v>
                </c:pt>
                <c:pt idx="66">
                  <c:v>6652.77392578125</c:v>
                </c:pt>
                <c:pt idx="67">
                  <c:v>6703.9150390625</c:v>
                </c:pt>
                <c:pt idx="68">
                  <c:v>6729.3583984375</c:v>
                </c:pt>
                <c:pt idx="69">
                  <c:v>6722.29248046875</c:v>
                </c:pt>
                <c:pt idx="70">
                  <c:v>6688.072265625</c:v>
                </c:pt>
                <c:pt idx="71">
                  <c:v>6639.14306640625</c:v>
                </c:pt>
                <c:pt idx="72">
                  <c:v>6589.666015625</c:v>
                </c:pt>
                <c:pt idx="73">
                  <c:v>6552.4775390625</c:v>
                </c:pt>
                <c:pt idx="74">
                  <c:v>6537.68408203125</c:v>
                </c:pt>
                <c:pt idx="75">
                  <c:v>6550.60009765625</c:v>
                </c:pt>
                <c:pt idx="76">
                  <c:v>6588.43603515625</c:v>
                </c:pt>
                <c:pt idx="77">
                  <c:v>6638.40380859375</c:v>
                </c:pt>
                <c:pt idx="78">
                  <c:v>6681.15869140625</c:v>
                </c:pt>
                <c:pt idx="79">
                  <c:v>6700.423828125</c:v>
                </c:pt>
                <c:pt idx="80">
                  <c:v>6693.8720703125</c:v>
                </c:pt>
                <c:pt idx="81">
                  <c:v>6676.828125</c:v>
                </c:pt>
                <c:pt idx="82">
                  <c:v>6673.37451171875</c:v>
                </c:pt>
                <c:pt idx="83">
                  <c:v>6698.45361328125</c:v>
                </c:pt>
                <c:pt idx="84">
                  <c:v>6743.1806640625</c:v>
                </c:pt>
                <c:pt idx="85">
                  <c:v>6776.12353515625</c:v>
                </c:pt>
                <c:pt idx="86">
                  <c:v>6763.19970703125</c:v>
                </c:pt>
                <c:pt idx="87">
                  <c:v>6694.19775390625</c:v>
                </c:pt>
                <c:pt idx="88">
                  <c:v>6596.14453125</c:v>
                </c:pt>
                <c:pt idx="89">
                  <c:v>6520.609375</c:v>
                </c:pt>
                <c:pt idx="90">
                  <c:v>6510.5830078125</c:v>
                </c:pt>
                <c:pt idx="91">
                  <c:v>6569.48193359375</c:v>
                </c:pt>
                <c:pt idx="92">
                  <c:v>6656.12548828125</c:v>
                </c:pt>
                <c:pt idx="93">
                  <c:v>6712.06103515625</c:v>
                </c:pt>
                <c:pt idx="94">
                  <c:v>6703.126953125</c:v>
                </c:pt>
                <c:pt idx="95">
                  <c:v>6644.5751953125</c:v>
                </c:pt>
                <c:pt idx="96">
                  <c:v>6589.61083984375</c:v>
                </c:pt>
                <c:pt idx="97">
                  <c:v>6588.4677734375</c:v>
                </c:pt>
                <c:pt idx="98">
                  <c:v>6648.60400390625</c:v>
                </c:pt>
                <c:pt idx="99">
                  <c:v>6727.28515625</c:v>
                </c:pt>
                <c:pt idx="100">
                  <c:v>6763.708984375</c:v>
                </c:pt>
                <c:pt idx="101">
                  <c:v>6726.85400390625</c:v>
                </c:pt>
                <c:pt idx="102">
                  <c:v>6641.81494140625</c:v>
                </c:pt>
                <c:pt idx="103">
                  <c:v>6573.0322265625</c:v>
                </c:pt>
                <c:pt idx="104">
                  <c:v>6576.1328125</c:v>
                </c:pt>
                <c:pt idx="105">
                  <c:v>6655.07861328125</c:v>
                </c:pt>
                <c:pt idx="106">
                  <c:v>6757.869140625</c:v>
                </c:pt>
                <c:pt idx="107">
                  <c:v>6814.35693359375</c:v>
                </c:pt>
                <c:pt idx="108">
                  <c:v>6787.1416015625</c:v>
                </c:pt>
                <c:pt idx="109">
                  <c:v>6696.7353515625</c:v>
                </c:pt>
                <c:pt idx="110">
                  <c:v>6602.9482421875</c:v>
                </c:pt>
                <c:pt idx="111">
                  <c:v>6558.806640625</c:v>
                </c:pt>
                <c:pt idx="112">
                  <c:v>6573.80517578125</c:v>
                </c:pt>
                <c:pt idx="113">
                  <c:v>6613.93408203125</c:v>
                </c:pt>
                <c:pt idx="114">
                  <c:v>6635.26318359375</c:v>
                </c:pt>
                <c:pt idx="115">
                  <c:v>6621.37451171875</c:v>
                </c:pt>
                <c:pt idx="116">
                  <c:v>6593.89794921875</c:v>
                </c:pt>
                <c:pt idx="117">
                  <c:v>6589.52197265625</c:v>
                </c:pt>
                <c:pt idx="118">
                  <c:v>6625.12060546875</c:v>
                </c:pt>
                <c:pt idx="119">
                  <c:v>6681.47705078125</c:v>
                </c:pt>
                <c:pt idx="120">
                  <c:v>6718.92138671875</c:v>
                </c:pt>
                <c:pt idx="121">
                  <c:v>6710.5517578125</c:v>
                </c:pt>
                <c:pt idx="122">
                  <c:v>6664.30712890625</c:v>
                </c:pt>
                <c:pt idx="123">
                  <c:v>6615.65771484375</c:v>
                </c:pt>
                <c:pt idx="124">
                  <c:v>6598.205078125</c:v>
                </c:pt>
                <c:pt idx="125">
                  <c:v>6617.7783203125</c:v>
                </c:pt>
                <c:pt idx="126">
                  <c:v>6651.3037109375</c:v>
                </c:pt>
                <c:pt idx="127">
                  <c:v>6669.5390625</c:v>
                </c:pt>
                <c:pt idx="128">
                  <c:v>6662.431640625</c:v>
                </c:pt>
                <c:pt idx="129">
                  <c:v>6644.9462890625</c:v>
                </c:pt>
                <c:pt idx="130">
                  <c:v>6639.67578125</c:v>
                </c:pt>
                <c:pt idx="131">
                  <c:v>6653.44140625</c:v>
                </c:pt>
                <c:pt idx="132">
                  <c:v>6669.9228515625</c:v>
                </c:pt>
                <c:pt idx="133">
                  <c:v>6665.1865234375</c:v>
                </c:pt>
                <c:pt idx="134">
                  <c:v>6631.84228515625</c:v>
                </c:pt>
                <c:pt idx="135">
                  <c:v>6589.4375</c:v>
                </c:pt>
                <c:pt idx="136">
                  <c:v>6570.7939453125</c:v>
                </c:pt>
                <c:pt idx="137">
                  <c:v>6595.44091796875</c:v>
                </c:pt>
                <c:pt idx="138">
                  <c:v>6652.953125</c:v>
                </c:pt>
                <c:pt idx="139">
                  <c:v>6710.5966796875</c:v>
                </c:pt>
                <c:pt idx="140">
                  <c:v>6738.7216796875</c:v>
                </c:pt>
                <c:pt idx="141">
                  <c:v>6732.33740234375</c:v>
                </c:pt>
                <c:pt idx="142">
                  <c:v>6711.20458984375</c:v>
                </c:pt>
                <c:pt idx="143">
                  <c:v>6699.7998046875</c:v>
                </c:pt>
                <c:pt idx="144">
                  <c:v>6705.5869140625</c:v>
                </c:pt>
                <c:pt idx="145">
                  <c:v>6714.40234375</c:v>
                </c:pt>
                <c:pt idx="146">
                  <c:v>6705.68017578125</c:v>
                </c:pt>
                <c:pt idx="147">
                  <c:v>6672.638671875</c:v>
                </c:pt>
                <c:pt idx="148">
                  <c:v>6629.04638671875</c:v>
                </c:pt>
                <c:pt idx="149">
                  <c:v>6597.357421875</c:v>
                </c:pt>
                <c:pt idx="150">
                  <c:v>6590.1962890625</c:v>
                </c:pt>
                <c:pt idx="151">
                  <c:v>6602.50830078125</c:v>
                </c:pt>
                <c:pt idx="152">
                  <c:v>6620.61083984375</c:v>
                </c:pt>
                <c:pt idx="153">
                  <c:v>6637.76025390625</c:v>
                </c:pt>
                <c:pt idx="154">
                  <c:v>6659.67578125</c:v>
                </c:pt>
                <c:pt idx="155">
                  <c:v>6693.83544921875</c:v>
                </c:pt>
                <c:pt idx="156">
                  <c:v>6733.49560546875</c:v>
                </c:pt>
                <c:pt idx="157">
                  <c:v>6754.5244140625</c:v>
                </c:pt>
                <c:pt idx="158">
                  <c:v>6732.2685546875</c:v>
                </c:pt>
                <c:pt idx="159">
                  <c:v>6665.90087890625</c:v>
                </c:pt>
                <c:pt idx="160">
                  <c:v>6587.4541015625</c:v>
                </c:pt>
                <c:pt idx="161">
                  <c:v>6543.2333984375</c:v>
                </c:pt>
                <c:pt idx="162">
                  <c:v>6559.05419921875</c:v>
                </c:pt>
                <c:pt idx="163">
                  <c:v>6617.32373046875</c:v>
                </c:pt>
                <c:pt idx="164">
                  <c:v>6667.32763671875</c:v>
                </c:pt>
                <c:pt idx="165">
                  <c:v>6663.81982421875</c:v>
                </c:pt>
                <c:pt idx="166">
                  <c:v>6604.40771484375</c:v>
                </c:pt>
                <c:pt idx="167">
                  <c:v>6534.77294921875</c:v>
                </c:pt>
                <c:pt idx="168">
                  <c:v>6515.298828125</c:v>
                </c:pt>
                <c:pt idx="169">
                  <c:v>6573.96142578125</c:v>
                </c:pt>
                <c:pt idx="170">
                  <c:v>6682.517578125</c:v>
                </c:pt>
                <c:pt idx="171">
                  <c:v>6775.3974609375</c:v>
                </c:pt>
                <c:pt idx="172">
                  <c:v>6797.0986328125</c:v>
                </c:pt>
                <c:pt idx="173">
                  <c:v>6741.47998046875</c:v>
                </c:pt>
                <c:pt idx="174">
                  <c:v>6653.330078125</c:v>
                </c:pt>
                <c:pt idx="175">
                  <c:v>6592.8212890625</c:v>
                </c:pt>
                <c:pt idx="176">
                  <c:v>6592.06396484375</c:v>
                </c:pt>
                <c:pt idx="177">
                  <c:v>6637.08642578125</c:v>
                </c:pt>
                <c:pt idx="178">
                  <c:v>6686.029296875</c:v>
                </c:pt>
                <c:pt idx="179">
                  <c:v>6705.01025390625</c:v>
                </c:pt>
                <c:pt idx="180">
                  <c:v>6691.2236328125</c:v>
                </c:pt>
                <c:pt idx="181">
                  <c:v>6666.8837890625</c:v>
                </c:pt>
                <c:pt idx="182">
                  <c:v>6653.80810546875</c:v>
                </c:pt>
                <c:pt idx="183">
                  <c:v>6653.75244140625</c:v>
                </c:pt>
                <c:pt idx="184">
                  <c:v>6651.642578125</c:v>
                </c:pt>
                <c:pt idx="185">
                  <c:v>6636.203125</c:v>
                </c:pt>
                <c:pt idx="186">
                  <c:v>6616.1669921875</c:v>
                </c:pt>
                <c:pt idx="187">
                  <c:v>6614.88916015625</c:v>
                </c:pt>
                <c:pt idx="188">
                  <c:v>6647.11328125</c:v>
                </c:pt>
                <c:pt idx="189">
                  <c:v>6699.54638671875</c:v>
                </c:pt>
                <c:pt idx="190">
                  <c:v>6735.1865234375</c:v>
                </c:pt>
                <c:pt idx="191">
                  <c:v>6720.90576171875</c:v>
                </c:pt>
                <c:pt idx="192">
                  <c:v>6656.45556640625</c:v>
                </c:pt>
                <c:pt idx="193">
                  <c:v>6579.814453125</c:v>
                </c:pt>
                <c:pt idx="194">
                  <c:v>6542.2119140625</c:v>
                </c:pt>
                <c:pt idx="195">
                  <c:v>6571.1171875</c:v>
                </c:pt>
                <c:pt idx="196">
                  <c:v>6649.9443359375</c:v>
                </c:pt>
                <c:pt idx="197">
                  <c:v>6730.33447265625</c:v>
                </c:pt>
                <c:pt idx="198">
                  <c:v>6767.1455078125</c:v>
                </c:pt>
                <c:pt idx="199">
                  <c:v>6748.88671875</c:v>
                </c:pt>
                <c:pt idx="200">
                  <c:v>6701.0576171875</c:v>
                </c:pt>
                <c:pt idx="201">
                  <c:v>6662.126953125</c:v>
                </c:pt>
                <c:pt idx="202">
                  <c:v>6653.04931640625</c:v>
                </c:pt>
                <c:pt idx="203">
                  <c:v>6664.48046875</c:v>
                </c:pt>
                <c:pt idx="204">
                  <c:v>6669.751953125</c:v>
                </c:pt>
                <c:pt idx="205">
                  <c:v>6650.498046875</c:v>
                </c:pt>
                <c:pt idx="206">
                  <c:v>6612.9443359375</c:v>
                </c:pt>
                <c:pt idx="207">
                  <c:v>6582.36865234375</c:v>
                </c:pt>
                <c:pt idx="208">
                  <c:v>6581.951171875</c:v>
                </c:pt>
                <c:pt idx="209">
                  <c:v>6614.25390625</c:v>
                </c:pt>
                <c:pt idx="210">
                  <c:v>6659.87255859375</c:v>
                </c:pt>
                <c:pt idx="211">
                  <c:v>6692.83740234375</c:v>
                </c:pt>
                <c:pt idx="212">
                  <c:v>6699.2060546875</c:v>
                </c:pt>
                <c:pt idx="213">
                  <c:v>6684.275390625</c:v>
                </c:pt>
                <c:pt idx="214">
                  <c:v>6664.39501953125</c:v>
                </c:pt>
                <c:pt idx="215">
                  <c:v>6651.818359375</c:v>
                </c:pt>
                <c:pt idx="216">
                  <c:v>6645.337890625</c:v>
                </c:pt>
                <c:pt idx="217">
                  <c:v>6633.3935546875</c:v>
                </c:pt>
                <c:pt idx="218">
                  <c:v>6605.9326171875</c:v>
                </c:pt>
                <c:pt idx="219">
                  <c:v>6565.154296875</c:v>
                </c:pt>
                <c:pt idx="220">
                  <c:v>6527.14990234375</c:v>
                </c:pt>
                <c:pt idx="221">
                  <c:v>6513.591796875</c:v>
                </c:pt>
                <c:pt idx="222">
                  <c:v>6539.126953125</c:v>
                </c:pt>
                <c:pt idx="223">
                  <c:v>6601.955078125</c:v>
                </c:pt>
                <c:pt idx="224">
                  <c:v>6682.56787109375</c:v>
                </c:pt>
                <c:pt idx="225">
                  <c:v>6751.34814453125</c:v>
                </c:pt>
                <c:pt idx="226">
                  <c:v>6781.91357421875</c:v>
                </c:pt>
                <c:pt idx="227">
                  <c:v>6764.47119140625</c:v>
                </c:pt>
                <c:pt idx="228">
                  <c:v>6712.43896484375</c:v>
                </c:pt>
                <c:pt idx="229">
                  <c:v>6657.375</c:v>
                </c:pt>
                <c:pt idx="230">
                  <c:v>6632.634765625</c:v>
                </c:pt>
                <c:pt idx="231">
                  <c:v>6653.4560546875</c:v>
                </c:pt>
                <c:pt idx="232">
                  <c:v>6705.58447265625</c:v>
                </c:pt>
                <c:pt idx="233">
                  <c:v>6751.52880859375</c:v>
                </c:pt>
                <c:pt idx="234">
                  <c:v>6753.03759765625</c:v>
                </c:pt>
                <c:pt idx="235">
                  <c:v>6696.7255859375</c:v>
                </c:pt>
                <c:pt idx="236">
                  <c:v>6605.73779296875</c:v>
                </c:pt>
                <c:pt idx="237">
                  <c:v>6528.2373046875</c:v>
                </c:pt>
                <c:pt idx="238">
                  <c:v>6508.90380859375</c:v>
                </c:pt>
                <c:pt idx="239">
                  <c:v>6561.66259765625</c:v>
                </c:pt>
                <c:pt idx="240">
                  <c:v>6661.4541015625</c:v>
                </c:pt>
                <c:pt idx="241">
                  <c:v>6759.91748046875</c:v>
                </c:pt>
                <c:pt idx="242">
                  <c:v>6813.77880859375</c:v>
                </c:pt>
                <c:pt idx="243">
                  <c:v>6807.15771484375</c:v>
                </c:pt>
                <c:pt idx="244">
                  <c:v>6754.89697265625</c:v>
                </c:pt>
                <c:pt idx="245">
                  <c:v>6688.0302734375</c:v>
                </c:pt>
                <c:pt idx="246">
                  <c:v>6633.83251953125</c:v>
                </c:pt>
                <c:pt idx="247">
                  <c:v>6603.80517578125</c:v>
                </c:pt>
                <c:pt idx="248">
                  <c:v>6594.56640625</c:v>
                </c:pt>
                <c:pt idx="249">
                  <c:v>6596.79052734375</c:v>
                </c:pt>
                <c:pt idx="250">
                  <c:v>6603.544921875</c:v>
                </c:pt>
                <c:pt idx="251">
                  <c:v>6612.908203125</c:v>
                </c:pt>
                <c:pt idx="252">
                  <c:v>6625.7763671875</c:v>
                </c:pt>
                <c:pt idx="253">
                  <c:v>6642.697265625</c:v>
                </c:pt>
                <c:pt idx="254">
                  <c:v>6662.13916015625</c:v>
                </c:pt>
                <c:pt idx="255">
                  <c:v>6679.8837890625</c:v>
                </c:pt>
                <c:pt idx="256">
                  <c:v>6688.84375</c:v>
                </c:pt>
                <c:pt idx="257">
                  <c:v>6680.37060546875</c:v>
                </c:pt>
                <c:pt idx="258">
                  <c:v>6648.78271484375</c:v>
                </c:pt>
                <c:pt idx="259">
                  <c:v>6598.06298828125</c:v>
                </c:pt>
                <c:pt idx="260">
                  <c:v>6545.45751953125</c:v>
                </c:pt>
                <c:pt idx="261">
                  <c:v>6516.13330078125</c:v>
                </c:pt>
                <c:pt idx="262">
                  <c:v>6528.8134765625</c:v>
                </c:pt>
                <c:pt idx="263">
                  <c:v>6580.94970703125</c:v>
                </c:pt>
                <c:pt idx="264">
                  <c:v>6645.64208984375</c:v>
                </c:pt>
                <c:pt idx="265">
                  <c:v>6686.0517578125</c:v>
                </c:pt>
                <c:pt idx="266">
                  <c:v>6679.7421875</c:v>
                </c:pt>
                <c:pt idx="267">
                  <c:v>6635.755859375</c:v>
                </c:pt>
                <c:pt idx="268">
                  <c:v>6590.3291015625</c:v>
                </c:pt>
                <c:pt idx="269">
                  <c:v>6582.41357421875</c:v>
                </c:pt>
                <c:pt idx="270">
                  <c:v>6626.15283203125</c:v>
                </c:pt>
                <c:pt idx="271">
                  <c:v>6700.93017578125</c:v>
                </c:pt>
                <c:pt idx="272">
                  <c:v>6766.7158203125</c:v>
                </c:pt>
                <c:pt idx="273">
                  <c:v>6792.79833984375</c:v>
                </c:pt>
                <c:pt idx="274">
                  <c:v>6777.57958984375</c:v>
                </c:pt>
                <c:pt idx="275">
                  <c:v>6744.6826171875</c:v>
                </c:pt>
                <c:pt idx="276">
                  <c:v>6720.2646484375</c:v>
                </c:pt>
                <c:pt idx="277">
                  <c:v>6711.66943359375</c:v>
                </c:pt>
                <c:pt idx="278">
                  <c:v>6705.5537109375</c:v>
                </c:pt>
                <c:pt idx="279">
                  <c:v>6685.951171875</c:v>
                </c:pt>
                <c:pt idx="280">
                  <c:v>6654.70166015625</c:v>
                </c:pt>
                <c:pt idx="281">
                  <c:v>6634.1396484375</c:v>
                </c:pt>
                <c:pt idx="282">
                  <c:v>6647.66943359375</c:v>
                </c:pt>
                <c:pt idx="283">
                  <c:v>6694.478515625</c:v>
                </c:pt>
                <c:pt idx="284">
                  <c:v>6741.951171875</c:v>
                </c:pt>
                <c:pt idx="285">
                  <c:v>6745.9306640625</c:v>
                </c:pt>
                <c:pt idx="286">
                  <c:v>6685.2763671875</c:v>
                </c:pt>
                <c:pt idx="287">
                  <c:v>6583.1474609375</c:v>
                </c:pt>
                <c:pt idx="288">
                  <c:v>6495.826171875</c:v>
                </c:pt>
                <c:pt idx="289">
                  <c:v>6474.96435546875</c:v>
                </c:pt>
                <c:pt idx="290">
                  <c:v>6530.87548828125</c:v>
                </c:pt>
                <c:pt idx="291">
                  <c:v>6624.90087890625</c:v>
                </c:pt>
                <c:pt idx="292">
                  <c:v>6697.03173828125</c:v>
                </c:pt>
                <c:pt idx="293">
                  <c:v>6708.00927734375</c:v>
                </c:pt>
                <c:pt idx="294">
                  <c:v>6664.43798828125</c:v>
                </c:pt>
                <c:pt idx="295">
                  <c:v>6609.24169921875</c:v>
                </c:pt>
                <c:pt idx="296">
                  <c:v>6586.72509765625</c:v>
                </c:pt>
                <c:pt idx="297">
                  <c:v>6610.0947265625</c:v>
                </c:pt>
                <c:pt idx="298">
                  <c:v>6655.46044921875</c:v>
                </c:pt>
                <c:pt idx="299">
                  <c:v>6684.32861328125</c:v>
                </c:pt>
                <c:pt idx="300">
                  <c:v>6674.7353515625</c:v>
                </c:pt>
                <c:pt idx="301">
                  <c:v>6636.4716796875</c:v>
                </c:pt>
                <c:pt idx="302">
                  <c:v>6600.5615234375</c:v>
                </c:pt>
                <c:pt idx="303">
                  <c:v>6594.0087890625</c:v>
                </c:pt>
                <c:pt idx="304">
                  <c:v>6620.8447265625</c:v>
                </c:pt>
                <c:pt idx="305">
                  <c:v>6662.90380859375</c:v>
                </c:pt>
                <c:pt idx="306">
                  <c:v>6696.58203125</c:v>
                </c:pt>
                <c:pt idx="307">
                  <c:v>6709.9384765625</c:v>
                </c:pt>
                <c:pt idx="308">
                  <c:v>6706.85595703125</c:v>
                </c:pt>
                <c:pt idx="309">
                  <c:v>6697.80859375</c:v>
                </c:pt>
                <c:pt idx="310">
                  <c:v>6688.06787109375</c:v>
                </c:pt>
                <c:pt idx="311">
                  <c:v>6674.53369140625</c:v>
                </c:pt>
                <c:pt idx="312">
                  <c:v>6652.82666015625</c:v>
                </c:pt>
                <c:pt idx="313">
                  <c:v>6626.29296875</c:v>
                </c:pt>
                <c:pt idx="314">
                  <c:v>6607.16552734375</c:v>
                </c:pt>
                <c:pt idx="315">
                  <c:v>6607.9931640625</c:v>
                </c:pt>
                <c:pt idx="316">
                  <c:v>6630.87109375</c:v>
                </c:pt>
                <c:pt idx="317">
                  <c:v>6664.3681640625</c:v>
                </c:pt>
                <c:pt idx="318">
                  <c:v>6691.3505859375</c:v>
                </c:pt>
                <c:pt idx="319">
                  <c:v>6701.33935546875</c:v>
                </c:pt>
                <c:pt idx="320">
                  <c:v>6697.12353515625</c:v>
                </c:pt>
                <c:pt idx="321">
                  <c:v>6690.3310546875</c:v>
                </c:pt>
                <c:pt idx="322">
                  <c:v>6690.052734375</c:v>
                </c:pt>
                <c:pt idx="323">
                  <c:v>6694.28515625</c:v>
                </c:pt>
                <c:pt idx="324">
                  <c:v>6691.34912109375</c:v>
                </c:pt>
                <c:pt idx="325">
                  <c:v>6670.09228515625</c:v>
                </c:pt>
                <c:pt idx="326">
                  <c:v>6630.65771484375</c:v>
                </c:pt>
                <c:pt idx="327">
                  <c:v>6587.40087890625</c:v>
                </c:pt>
                <c:pt idx="328">
                  <c:v>6561.68701171875</c:v>
                </c:pt>
                <c:pt idx="329">
                  <c:v>6569.57958984375</c:v>
                </c:pt>
                <c:pt idx="330">
                  <c:v>6612.35888671875</c:v>
                </c:pt>
                <c:pt idx="331">
                  <c:v>6675.16162109375</c:v>
                </c:pt>
                <c:pt idx="332">
                  <c:v>6733.65771484375</c:v>
                </c:pt>
                <c:pt idx="333">
                  <c:v>6764.66748046875</c:v>
                </c:pt>
                <c:pt idx="334">
                  <c:v>6755.73876953125</c:v>
                </c:pt>
                <c:pt idx="335">
                  <c:v>6710.1123046875</c:v>
                </c:pt>
                <c:pt idx="336">
                  <c:v>6645.43017578125</c:v>
                </c:pt>
                <c:pt idx="337">
                  <c:v>6586.42529296875</c:v>
                </c:pt>
                <c:pt idx="338">
                  <c:v>6554.02294921875</c:v>
                </c:pt>
                <c:pt idx="339">
                  <c:v>6555.60595703125</c:v>
                </c:pt>
                <c:pt idx="340">
                  <c:v>6581.87890625</c:v>
                </c:pt>
                <c:pt idx="341">
                  <c:v>6613.0732421875</c:v>
                </c:pt>
                <c:pt idx="342">
                  <c:v>6631.59814453125</c:v>
                </c:pt>
                <c:pt idx="343">
                  <c:v>6633.27734375</c:v>
                </c:pt>
                <c:pt idx="344">
                  <c:v>6629.2509765625</c:v>
                </c:pt>
                <c:pt idx="345">
                  <c:v>6636.64453125</c:v>
                </c:pt>
                <c:pt idx="346">
                  <c:v>6664.3681640625</c:v>
                </c:pt>
                <c:pt idx="347">
                  <c:v>6704.59228515625</c:v>
                </c:pt>
                <c:pt idx="348">
                  <c:v>6736.744140625</c:v>
                </c:pt>
                <c:pt idx="349">
                  <c:v>6741.57470703125</c:v>
                </c:pt>
              </c:numCache>
            </c:numRef>
          </c:yVal>
          <c:smooth val="1"/>
          <c:extLst>
            <c:ext xmlns:c16="http://schemas.microsoft.com/office/drawing/2014/chart" uri="{C3380CC4-5D6E-409C-BE32-E72D297353CC}">
              <c16:uniqueId val="{00000004-0DDB-41B5-BE83-A9CFE49F3CE3}"/>
            </c:ext>
          </c:extLst>
        </c:ser>
        <c:ser>
          <c:idx val="5"/>
          <c:order val="5"/>
          <c:tx>
            <c:strRef>
              <c:f>hc_sub_007!$F$1</c:f>
              <c:strCache>
                <c:ptCount val="1"/>
                <c:pt idx="0">
                  <c:v>Coor_6</c:v>
                </c:pt>
              </c:strCache>
            </c:strRef>
          </c:tx>
          <c:spPr>
            <a:ln w="28575" cap="rnd">
              <a:solidFill>
                <a:schemeClr val="accent6"/>
              </a:solidFill>
              <a:round/>
            </a:ln>
            <a:effectLst/>
          </c:spPr>
          <c:marker>
            <c:symbol val="none"/>
          </c:marker>
          <c:yVal>
            <c:numRef>
              <c:f>hc_sub_007!$F$2:$F$351</c:f>
              <c:numCache>
                <c:formatCode>0.00000000000_ </c:formatCode>
                <c:ptCount val="350"/>
                <c:pt idx="0">
                  <c:v>7529.8115234375</c:v>
                </c:pt>
                <c:pt idx="1">
                  <c:v>7478.353515625</c:v>
                </c:pt>
                <c:pt idx="2">
                  <c:v>7424.41845703125</c:v>
                </c:pt>
                <c:pt idx="3">
                  <c:v>7397.46875</c:v>
                </c:pt>
                <c:pt idx="4">
                  <c:v>7417.734375</c:v>
                </c:pt>
                <c:pt idx="5">
                  <c:v>7482.22802734375</c:v>
                </c:pt>
                <c:pt idx="6">
                  <c:v>7564.87109375</c:v>
                </c:pt>
                <c:pt idx="7">
                  <c:v>7631.4873046875</c:v>
                </c:pt>
                <c:pt idx="8">
                  <c:v>7659.87060546875</c:v>
                </c:pt>
                <c:pt idx="9">
                  <c:v>7651.369140625</c:v>
                </c:pt>
                <c:pt idx="10">
                  <c:v>7626.4716796875</c:v>
                </c:pt>
                <c:pt idx="11">
                  <c:v>7608.427734375</c:v>
                </c:pt>
                <c:pt idx="12">
                  <c:v>7607.263671875</c:v>
                </c:pt>
                <c:pt idx="13">
                  <c:v>7615.5107421875</c:v>
                </c:pt>
                <c:pt idx="14">
                  <c:v>7617.4736328125</c:v>
                </c:pt>
                <c:pt idx="15">
                  <c:v>7603.52734375</c:v>
                </c:pt>
                <c:pt idx="16">
                  <c:v>7577.7666015625</c:v>
                </c:pt>
                <c:pt idx="17">
                  <c:v>7553.5458984375</c:v>
                </c:pt>
                <c:pt idx="18">
                  <c:v>7541.61572265625</c:v>
                </c:pt>
                <c:pt idx="19">
                  <c:v>7541.31591796875</c:v>
                </c:pt>
                <c:pt idx="20">
                  <c:v>7542.05517578125</c:v>
                </c:pt>
                <c:pt idx="21">
                  <c:v>7533.1728515625</c:v>
                </c:pt>
                <c:pt idx="22">
                  <c:v>7513.189453125</c:v>
                </c:pt>
                <c:pt idx="23">
                  <c:v>7490.42822265625</c:v>
                </c:pt>
                <c:pt idx="24">
                  <c:v>7474.9833984375</c:v>
                </c:pt>
                <c:pt idx="25">
                  <c:v>7469.88134765625</c:v>
                </c:pt>
                <c:pt idx="26">
                  <c:v>7469.9326171875</c:v>
                </c:pt>
                <c:pt idx="27">
                  <c:v>7469.537109375</c:v>
                </c:pt>
                <c:pt idx="28">
                  <c:v>7471.9150390625</c:v>
                </c:pt>
                <c:pt idx="29">
                  <c:v>7489.99267578125</c:v>
                </c:pt>
                <c:pt idx="30">
                  <c:v>7536.00537109375</c:v>
                </c:pt>
                <c:pt idx="31">
                  <c:v>7607.30419921875</c:v>
                </c:pt>
                <c:pt idx="32">
                  <c:v>7680.85546875</c:v>
                </c:pt>
                <c:pt idx="33">
                  <c:v>7723.38427734375</c:v>
                </c:pt>
                <c:pt idx="34">
                  <c:v>7711.93994140625</c:v>
                </c:pt>
                <c:pt idx="35">
                  <c:v>7650.43408203125</c:v>
                </c:pt>
                <c:pt idx="36">
                  <c:v>7569.3701171875</c:v>
                </c:pt>
                <c:pt idx="37">
                  <c:v>7507.77978515625</c:v>
                </c:pt>
                <c:pt idx="38">
                  <c:v>7489.462890625</c:v>
                </c:pt>
                <c:pt idx="39">
                  <c:v>7509.916015625</c:v>
                </c:pt>
                <c:pt idx="40">
                  <c:v>7542.5107421875</c:v>
                </c:pt>
                <c:pt idx="41">
                  <c:v>7558.68408203125</c:v>
                </c:pt>
                <c:pt idx="42">
                  <c:v>7547.43701171875</c:v>
                </c:pt>
                <c:pt idx="43">
                  <c:v>7521.0234375</c:v>
                </c:pt>
                <c:pt idx="44">
                  <c:v>7504.25927734375</c:v>
                </c:pt>
                <c:pt idx="45">
                  <c:v>7516.13671875</c:v>
                </c:pt>
                <c:pt idx="46">
                  <c:v>7556.44677734375</c:v>
                </c:pt>
                <c:pt idx="47">
                  <c:v>7605.263671875</c:v>
                </c:pt>
                <c:pt idx="48">
                  <c:v>7634.20703125</c:v>
                </c:pt>
                <c:pt idx="49">
                  <c:v>7621.908203125</c:v>
                </c:pt>
                <c:pt idx="50">
                  <c:v>7565.37841796875</c:v>
                </c:pt>
                <c:pt idx="51">
                  <c:v>7482.5361328125</c:v>
                </c:pt>
                <c:pt idx="52">
                  <c:v>7405.55615234375</c:v>
                </c:pt>
                <c:pt idx="53">
                  <c:v>7367.8349609375</c:v>
                </c:pt>
                <c:pt idx="54">
                  <c:v>7389.27978515625</c:v>
                </c:pt>
                <c:pt idx="55">
                  <c:v>7465.93505859375</c:v>
                </c:pt>
                <c:pt idx="56">
                  <c:v>7569.64404296875</c:v>
                </c:pt>
                <c:pt idx="57">
                  <c:v>7659.869140625</c:v>
                </c:pt>
                <c:pt idx="58">
                  <c:v>7703.185546875</c:v>
                </c:pt>
                <c:pt idx="59">
                  <c:v>7690.0341796875</c:v>
                </c:pt>
                <c:pt idx="60">
                  <c:v>7638.23779296875</c:v>
                </c:pt>
                <c:pt idx="61">
                  <c:v>7580.3759765625</c:v>
                </c:pt>
                <c:pt idx="62">
                  <c:v>7543.05615234375</c:v>
                </c:pt>
                <c:pt idx="63">
                  <c:v>7532.28173828125</c:v>
                </c:pt>
                <c:pt idx="64">
                  <c:v>7534.8681640625</c:v>
                </c:pt>
                <c:pt idx="65">
                  <c:v>7533.70458984375</c:v>
                </c:pt>
                <c:pt idx="66">
                  <c:v>7523.8603515625</c:v>
                </c:pt>
                <c:pt idx="67">
                  <c:v>7516.126953125</c:v>
                </c:pt>
                <c:pt idx="68">
                  <c:v>7525.33935546875</c:v>
                </c:pt>
                <c:pt idx="69">
                  <c:v>7554.0673828125</c:v>
                </c:pt>
                <c:pt idx="70">
                  <c:v>7586.68603515625</c:v>
                </c:pt>
                <c:pt idx="71">
                  <c:v>7600.2060546875</c:v>
                </c:pt>
                <c:pt idx="72">
                  <c:v>7583.53173828125</c:v>
                </c:pt>
                <c:pt idx="73">
                  <c:v>7548.64404296875</c:v>
                </c:pt>
                <c:pt idx="74">
                  <c:v>7523.1123046875</c:v>
                </c:pt>
                <c:pt idx="75">
                  <c:v>7528.8935546875</c:v>
                </c:pt>
                <c:pt idx="76">
                  <c:v>7564.4384765625</c:v>
                </c:pt>
                <c:pt idx="77">
                  <c:v>7605.1015625</c:v>
                </c:pt>
                <c:pt idx="78">
                  <c:v>7621.94140625</c:v>
                </c:pt>
                <c:pt idx="79">
                  <c:v>7603.66455078125</c:v>
                </c:pt>
                <c:pt idx="80">
                  <c:v>7563.865234375</c:v>
                </c:pt>
                <c:pt idx="81">
                  <c:v>7528.2333984375</c:v>
                </c:pt>
                <c:pt idx="82">
                  <c:v>7513.359375</c:v>
                </c:pt>
                <c:pt idx="83">
                  <c:v>7515.47900390625</c:v>
                </c:pt>
                <c:pt idx="84">
                  <c:v>7518.13232421875</c:v>
                </c:pt>
                <c:pt idx="85">
                  <c:v>7510.59423828125</c:v>
                </c:pt>
                <c:pt idx="86">
                  <c:v>7499.2978515625</c:v>
                </c:pt>
                <c:pt idx="87">
                  <c:v>7501.1640625</c:v>
                </c:pt>
                <c:pt idx="88">
                  <c:v>7524.8603515625</c:v>
                </c:pt>
                <c:pt idx="89">
                  <c:v>7558.134765625</c:v>
                </c:pt>
                <c:pt idx="90">
                  <c:v>7574.94775390625</c:v>
                </c:pt>
                <c:pt idx="91">
                  <c:v>7558.30029296875</c:v>
                </c:pt>
                <c:pt idx="92">
                  <c:v>7519.06103515625</c:v>
                </c:pt>
                <c:pt idx="93">
                  <c:v>7492.25</c:v>
                </c:pt>
                <c:pt idx="94">
                  <c:v>7510.5263671875</c:v>
                </c:pt>
                <c:pt idx="95">
                  <c:v>7575.04150390625</c:v>
                </c:pt>
                <c:pt idx="96">
                  <c:v>7648.42431640625</c:v>
                </c:pt>
                <c:pt idx="97">
                  <c:v>7678.3583984375</c:v>
                </c:pt>
                <c:pt idx="98">
                  <c:v>7635.5439453125</c:v>
                </c:pt>
                <c:pt idx="99">
                  <c:v>7537.212890625</c:v>
                </c:pt>
                <c:pt idx="100">
                  <c:v>7437.65087890625</c:v>
                </c:pt>
                <c:pt idx="101">
                  <c:v>7392.435546875</c:v>
                </c:pt>
                <c:pt idx="102">
                  <c:v>7422.97900390625</c:v>
                </c:pt>
                <c:pt idx="103">
                  <c:v>7506.6455078125</c:v>
                </c:pt>
                <c:pt idx="104">
                  <c:v>7596.9404296875</c:v>
                </c:pt>
                <c:pt idx="105">
                  <c:v>7655.607421875</c:v>
                </c:pt>
                <c:pt idx="106">
                  <c:v>7672.02880859375</c:v>
                </c:pt>
                <c:pt idx="107">
                  <c:v>7658.87841796875</c:v>
                </c:pt>
                <c:pt idx="108">
                  <c:v>7633.4384765625</c:v>
                </c:pt>
                <c:pt idx="109">
                  <c:v>7603.5986328125</c:v>
                </c:pt>
                <c:pt idx="110">
                  <c:v>7569.36669921875</c:v>
                </c:pt>
                <c:pt idx="111">
                  <c:v>7533.955078125</c:v>
                </c:pt>
                <c:pt idx="112">
                  <c:v>7509.44775390625</c:v>
                </c:pt>
                <c:pt idx="113">
                  <c:v>7508.80322265625</c:v>
                </c:pt>
                <c:pt idx="114">
                  <c:v>7531.40966796875</c:v>
                </c:pt>
                <c:pt idx="115">
                  <c:v>7557.99267578125</c:v>
                </c:pt>
                <c:pt idx="116">
                  <c:v>7563.3212890625</c:v>
                </c:pt>
                <c:pt idx="117">
                  <c:v>7538.0341796875</c:v>
                </c:pt>
                <c:pt idx="118">
                  <c:v>7500.13427734375</c:v>
                </c:pt>
                <c:pt idx="119">
                  <c:v>7483.453125</c:v>
                </c:pt>
                <c:pt idx="120">
                  <c:v>7510.09521484375</c:v>
                </c:pt>
                <c:pt idx="121">
                  <c:v>7569.33984375</c:v>
                </c:pt>
                <c:pt idx="122">
                  <c:v>7622.18994140625</c:v>
                </c:pt>
                <c:pt idx="123">
                  <c:v>7630.0673828125</c:v>
                </c:pt>
                <c:pt idx="124">
                  <c:v>7585.3037109375</c:v>
                </c:pt>
                <c:pt idx="125">
                  <c:v>7518.24560546875</c:v>
                </c:pt>
                <c:pt idx="126">
                  <c:v>7474.3583984375</c:v>
                </c:pt>
                <c:pt idx="127">
                  <c:v>7479.4873046875</c:v>
                </c:pt>
                <c:pt idx="128">
                  <c:v>7521.41064453125</c:v>
                </c:pt>
                <c:pt idx="129">
                  <c:v>7562.31396484375</c:v>
                </c:pt>
                <c:pt idx="130">
                  <c:v>7571.0478515625</c:v>
                </c:pt>
                <c:pt idx="131">
                  <c:v>7547.89208984375</c:v>
                </c:pt>
                <c:pt idx="132">
                  <c:v>7521.59033203125</c:v>
                </c:pt>
                <c:pt idx="133">
                  <c:v>7522.39990234375</c:v>
                </c:pt>
                <c:pt idx="134">
                  <c:v>7555.12353515625</c:v>
                </c:pt>
                <c:pt idx="135">
                  <c:v>7595.32421875</c:v>
                </c:pt>
                <c:pt idx="136">
                  <c:v>7611.26416015625</c:v>
                </c:pt>
                <c:pt idx="137">
                  <c:v>7591.76416015625</c:v>
                </c:pt>
                <c:pt idx="138">
                  <c:v>7555.50439453125</c:v>
                </c:pt>
                <c:pt idx="139">
                  <c:v>7533.99267578125</c:v>
                </c:pt>
                <c:pt idx="140">
                  <c:v>7543.57861328125</c:v>
                </c:pt>
                <c:pt idx="141">
                  <c:v>7571.24853515625</c:v>
                </c:pt>
                <c:pt idx="142">
                  <c:v>7586.52783203125</c:v>
                </c:pt>
                <c:pt idx="143">
                  <c:v>7568.84912109375</c:v>
                </c:pt>
                <c:pt idx="144">
                  <c:v>7526.3642578125</c:v>
                </c:pt>
                <c:pt idx="145">
                  <c:v>7489.88720703125</c:v>
                </c:pt>
                <c:pt idx="146">
                  <c:v>7487.345703125</c:v>
                </c:pt>
                <c:pt idx="147">
                  <c:v>7520.75830078125</c:v>
                </c:pt>
                <c:pt idx="148">
                  <c:v>7565.0732421875</c:v>
                </c:pt>
                <c:pt idx="149">
                  <c:v>7589.10205078125</c:v>
                </c:pt>
                <c:pt idx="150">
                  <c:v>7580.20263671875</c:v>
                </c:pt>
                <c:pt idx="151">
                  <c:v>7552.25</c:v>
                </c:pt>
                <c:pt idx="152">
                  <c:v>7531.736328125</c:v>
                </c:pt>
                <c:pt idx="153">
                  <c:v>7535.521484375</c:v>
                </c:pt>
                <c:pt idx="154">
                  <c:v>7559.4345703125</c:v>
                </c:pt>
                <c:pt idx="155">
                  <c:v>7585.61767578125</c:v>
                </c:pt>
                <c:pt idx="156">
                  <c:v>7599.40283203125</c:v>
                </c:pt>
                <c:pt idx="157">
                  <c:v>7599.28759765625</c:v>
                </c:pt>
                <c:pt idx="158">
                  <c:v>7592.1083984375</c:v>
                </c:pt>
                <c:pt idx="159">
                  <c:v>7580.80615234375</c:v>
                </c:pt>
                <c:pt idx="160">
                  <c:v>7559.318359375</c:v>
                </c:pt>
                <c:pt idx="161">
                  <c:v>7521.2646484375</c:v>
                </c:pt>
                <c:pt idx="162">
                  <c:v>7473.970703125</c:v>
                </c:pt>
                <c:pt idx="163">
                  <c:v>7441.955078125</c:v>
                </c:pt>
                <c:pt idx="164">
                  <c:v>7452.36181640625</c:v>
                </c:pt>
                <c:pt idx="165">
                  <c:v>7512.0263671875</c:v>
                </c:pt>
                <c:pt idx="166">
                  <c:v>7595.99853515625</c:v>
                </c:pt>
                <c:pt idx="167">
                  <c:v>7660.0146484375</c:v>
                </c:pt>
                <c:pt idx="168">
                  <c:v>7669.77685546875</c:v>
                </c:pt>
                <c:pt idx="169">
                  <c:v>7624.814453125</c:v>
                </c:pt>
                <c:pt idx="170">
                  <c:v>7557.86083984375</c:v>
                </c:pt>
                <c:pt idx="171">
                  <c:v>7510.14990234375</c:v>
                </c:pt>
                <c:pt idx="172">
                  <c:v>7502.50927734375</c:v>
                </c:pt>
                <c:pt idx="173">
                  <c:v>7524.884765625</c:v>
                </c:pt>
                <c:pt idx="174">
                  <c:v>7550.72900390625</c:v>
                </c:pt>
                <c:pt idx="175">
                  <c:v>7561.68701171875</c:v>
                </c:pt>
                <c:pt idx="176">
                  <c:v>7560.49169921875</c:v>
                </c:pt>
                <c:pt idx="177">
                  <c:v>7562.09130859375</c:v>
                </c:pt>
                <c:pt idx="178">
                  <c:v>7573.47705078125</c:v>
                </c:pt>
                <c:pt idx="179">
                  <c:v>7582.8583984375</c:v>
                </c:pt>
                <c:pt idx="180">
                  <c:v>7569.57275390625</c:v>
                </c:pt>
                <c:pt idx="181">
                  <c:v>7525.9638671875</c:v>
                </c:pt>
                <c:pt idx="182">
                  <c:v>7470.1015625</c:v>
                </c:pt>
                <c:pt idx="183">
                  <c:v>7435.4375</c:v>
                </c:pt>
                <c:pt idx="184">
                  <c:v>7444.41064453125</c:v>
                </c:pt>
                <c:pt idx="185">
                  <c:v>7488.767578125</c:v>
                </c:pt>
                <c:pt idx="186">
                  <c:v>7535.14892578125</c:v>
                </c:pt>
                <c:pt idx="187">
                  <c:v>7552.93798828125</c:v>
                </c:pt>
                <c:pt idx="188">
                  <c:v>7541.10791015625</c:v>
                </c:pt>
                <c:pt idx="189">
                  <c:v>7530.09814453125</c:v>
                </c:pt>
                <c:pt idx="190">
                  <c:v>7555.32373046875</c:v>
                </c:pt>
                <c:pt idx="191">
                  <c:v>7623.6904296875</c:v>
                </c:pt>
                <c:pt idx="192">
                  <c:v>7701.9072265625</c:v>
                </c:pt>
                <c:pt idx="193">
                  <c:v>7738.36376953125</c:v>
                </c:pt>
                <c:pt idx="194">
                  <c:v>7702.48388671875</c:v>
                </c:pt>
                <c:pt idx="195">
                  <c:v>7610.18212890625</c:v>
                </c:pt>
                <c:pt idx="196">
                  <c:v>7514.466796875</c:v>
                </c:pt>
                <c:pt idx="197">
                  <c:v>7468.001953125</c:v>
                </c:pt>
                <c:pt idx="198">
                  <c:v>7486.6943359375</c:v>
                </c:pt>
                <c:pt idx="199">
                  <c:v>7541.97509765625</c:v>
                </c:pt>
                <c:pt idx="200">
                  <c:v>7586.00146484375</c:v>
                </c:pt>
                <c:pt idx="201">
                  <c:v>7588.22802734375</c:v>
                </c:pt>
                <c:pt idx="202">
                  <c:v>7554.56689453125</c:v>
                </c:pt>
                <c:pt idx="203">
                  <c:v>7516.4921875</c:v>
                </c:pt>
                <c:pt idx="204">
                  <c:v>7502.30078125</c:v>
                </c:pt>
                <c:pt idx="205">
                  <c:v>7515.51123046875</c:v>
                </c:pt>
                <c:pt idx="206">
                  <c:v>7536.62646484375</c:v>
                </c:pt>
                <c:pt idx="207">
                  <c:v>7543.35205078125</c:v>
                </c:pt>
                <c:pt idx="208">
                  <c:v>7529.693359375</c:v>
                </c:pt>
                <c:pt idx="209">
                  <c:v>7507.88916015625</c:v>
                </c:pt>
                <c:pt idx="210">
                  <c:v>7494.13916015625</c:v>
                </c:pt>
                <c:pt idx="211">
                  <c:v>7493.42041015625</c:v>
                </c:pt>
                <c:pt idx="212">
                  <c:v>7497.85546875</c:v>
                </c:pt>
                <c:pt idx="213">
                  <c:v>7498.876953125</c:v>
                </c:pt>
                <c:pt idx="214">
                  <c:v>7499.8173828125</c:v>
                </c:pt>
                <c:pt idx="215">
                  <c:v>7515.19921875</c:v>
                </c:pt>
                <c:pt idx="216">
                  <c:v>7556.13525390625</c:v>
                </c:pt>
                <c:pt idx="217">
                  <c:v>7615.35009765625</c:v>
                </c:pt>
                <c:pt idx="218">
                  <c:v>7667.05029296875</c:v>
                </c:pt>
                <c:pt idx="219">
                  <c:v>7684.138671875</c:v>
                </c:pt>
                <c:pt idx="220">
                  <c:v>7659.29541015625</c:v>
                </c:pt>
                <c:pt idx="221">
                  <c:v>7611.798828125</c:v>
                </c:pt>
                <c:pt idx="222">
                  <c:v>7573.2578125</c:v>
                </c:pt>
                <c:pt idx="223">
                  <c:v>7563.29150390625</c:v>
                </c:pt>
                <c:pt idx="224">
                  <c:v>7575.078125</c:v>
                </c:pt>
                <c:pt idx="225">
                  <c:v>7582.78662109375</c:v>
                </c:pt>
                <c:pt idx="226">
                  <c:v>7564.6611328125</c:v>
                </c:pt>
                <c:pt idx="227">
                  <c:v>7522.4541015625</c:v>
                </c:pt>
                <c:pt idx="228">
                  <c:v>7480.98486328125</c:v>
                </c:pt>
                <c:pt idx="229">
                  <c:v>7468.2109375</c:v>
                </c:pt>
                <c:pt idx="230">
                  <c:v>7492.27294921875</c:v>
                </c:pt>
                <c:pt idx="231">
                  <c:v>7534.27978515625</c:v>
                </c:pt>
                <c:pt idx="232">
                  <c:v>7562.5078125</c:v>
                </c:pt>
                <c:pt idx="233">
                  <c:v>7556.36328125</c:v>
                </c:pt>
                <c:pt idx="234">
                  <c:v>7521.08837890625</c:v>
                </c:pt>
                <c:pt idx="235">
                  <c:v>7482.32373046875</c:v>
                </c:pt>
                <c:pt idx="236">
                  <c:v>7465.94140625</c:v>
                </c:pt>
                <c:pt idx="237">
                  <c:v>7479.66796875</c:v>
                </c:pt>
                <c:pt idx="238">
                  <c:v>7510.416015625</c:v>
                </c:pt>
                <c:pt idx="239">
                  <c:v>7537.9560546875</c:v>
                </c:pt>
                <c:pt idx="240">
                  <c:v>7552.72216796875</c:v>
                </c:pt>
                <c:pt idx="241">
                  <c:v>7563.1416015625</c:v>
                </c:pt>
                <c:pt idx="242">
                  <c:v>7586.94091796875</c:v>
                </c:pt>
                <c:pt idx="243">
                  <c:v>7633.66943359375</c:v>
                </c:pt>
                <c:pt idx="244">
                  <c:v>7692.294921875</c:v>
                </c:pt>
                <c:pt idx="245">
                  <c:v>7733.84130859375</c:v>
                </c:pt>
                <c:pt idx="246">
                  <c:v>7728.17236328125</c:v>
                </c:pt>
                <c:pt idx="247">
                  <c:v>7664.19580078125</c:v>
                </c:pt>
                <c:pt idx="248">
                  <c:v>7560.31787109375</c:v>
                </c:pt>
                <c:pt idx="249">
                  <c:v>7457.8740234375</c:v>
                </c:pt>
                <c:pt idx="250">
                  <c:v>7400.44775390625</c:v>
                </c:pt>
                <c:pt idx="251">
                  <c:v>7410.41455078125</c:v>
                </c:pt>
                <c:pt idx="252">
                  <c:v>7476.19775390625</c:v>
                </c:pt>
                <c:pt idx="253">
                  <c:v>7558.25439453125</c:v>
                </c:pt>
                <c:pt idx="254">
                  <c:v>7611.33642578125</c:v>
                </c:pt>
                <c:pt idx="255">
                  <c:v>7610.52880859375</c:v>
                </c:pt>
                <c:pt idx="256">
                  <c:v>7565.13916015625</c:v>
                </c:pt>
                <c:pt idx="257">
                  <c:v>7510.95068359375</c:v>
                </c:pt>
                <c:pt idx="258">
                  <c:v>7484.9990234375</c:v>
                </c:pt>
                <c:pt idx="259">
                  <c:v>7499.484375</c:v>
                </c:pt>
                <c:pt idx="260">
                  <c:v>7533.49072265625</c:v>
                </c:pt>
                <c:pt idx="261">
                  <c:v>7549.65234375</c:v>
                </c:pt>
                <c:pt idx="262">
                  <c:v>7524.70947265625</c:v>
                </c:pt>
                <c:pt idx="263">
                  <c:v>7471.12548828125</c:v>
                </c:pt>
                <c:pt idx="264">
                  <c:v>7431.76611328125</c:v>
                </c:pt>
                <c:pt idx="265">
                  <c:v>7449.10546875</c:v>
                </c:pt>
                <c:pt idx="266">
                  <c:v>7530.75341796875</c:v>
                </c:pt>
                <c:pt idx="267">
                  <c:v>7638.13525390625</c:v>
                </c:pt>
                <c:pt idx="268">
                  <c:v>7709.4091796875</c:v>
                </c:pt>
                <c:pt idx="269">
                  <c:v>7701.93701171875</c:v>
                </c:pt>
                <c:pt idx="270">
                  <c:v>7623.46044921875</c:v>
                </c:pt>
                <c:pt idx="271">
                  <c:v>7528.01611328125</c:v>
                </c:pt>
                <c:pt idx="272">
                  <c:v>7478.38330078125</c:v>
                </c:pt>
                <c:pt idx="273">
                  <c:v>7502.23291015625</c:v>
                </c:pt>
                <c:pt idx="274">
                  <c:v>7574.26123046875</c:v>
                </c:pt>
                <c:pt idx="275">
                  <c:v>7637.1298828125</c:v>
                </c:pt>
                <c:pt idx="276">
                  <c:v>7644.74267578125</c:v>
                </c:pt>
                <c:pt idx="277">
                  <c:v>7595.009765625</c:v>
                </c:pt>
                <c:pt idx="278">
                  <c:v>7528.255859375</c:v>
                </c:pt>
                <c:pt idx="279">
                  <c:v>7494.3701171875</c:v>
                </c:pt>
                <c:pt idx="280">
                  <c:v>7515.29150390625</c:v>
                </c:pt>
                <c:pt idx="281">
                  <c:v>7571.3681640625</c:v>
                </c:pt>
                <c:pt idx="282">
                  <c:v>7620.02099609375</c:v>
                </c:pt>
                <c:pt idx="283">
                  <c:v>7629.7333984375</c:v>
                </c:pt>
                <c:pt idx="284">
                  <c:v>7601.89111328125</c:v>
                </c:pt>
                <c:pt idx="285">
                  <c:v>7564.6865234375</c:v>
                </c:pt>
                <c:pt idx="286">
                  <c:v>7546.533203125</c:v>
                </c:pt>
                <c:pt idx="287">
                  <c:v>7552.0498046875</c:v>
                </c:pt>
                <c:pt idx="288">
                  <c:v>7559.8466796875</c:v>
                </c:pt>
                <c:pt idx="289">
                  <c:v>7542.54931640625</c:v>
                </c:pt>
                <c:pt idx="290">
                  <c:v>7491.6962890625</c:v>
                </c:pt>
                <c:pt idx="291">
                  <c:v>7427.33447265625</c:v>
                </c:pt>
                <c:pt idx="292">
                  <c:v>7385.2333984375</c:v>
                </c:pt>
                <c:pt idx="293">
                  <c:v>7392.13232421875</c:v>
                </c:pt>
                <c:pt idx="294">
                  <c:v>7447.48828125</c:v>
                </c:pt>
                <c:pt idx="295">
                  <c:v>7523.91064453125</c:v>
                </c:pt>
                <c:pt idx="296">
                  <c:v>7584.31396484375</c:v>
                </c:pt>
                <c:pt idx="297">
                  <c:v>7603.22314453125</c:v>
                </c:pt>
                <c:pt idx="298">
                  <c:v>7579.2685546875</c:v>
                </c:pt>
                <c:pt idx="299">
                  <c:v>7533.6376953125</c:v>
                </c:pt>
                <c:pt idx="300">
                  <c:v>7497.90283203125</c:v>
                </c:pt>
                <c:pt idx="301">
                  <c:v>7498.59716796875</c:v>
                </c:pt>
                <c:pt idx="302">
                  <c:v>7545.06298828125</c:v>
                </c:pt>
                <c:pt idx="303">
                  <c:v>7624.54833984375</c:v>
                </c:pt>
                <c:pt idx="304">
                  <c:v>7706.45263671875</c:v>
                </c:pt>
                <c:pt idx="305">
                  <c:v>7755.22998046875</c:v>
                </c:pt>
                <c:pt idx="306">
                  <c:v>7747.494140625</c:v>
                </c:pt>
                <c:pt idx="307">
                  <c:v>7684.859375</c:v>
                </c:pt>
                <c:pt idx="308">
                  <c:v>7594.03955078125</c:v>
                </c:pt>
                <c:pt idx="309">
                  <c:v>7512.3359375</c:v>
                </c:pt>
                <c:pt idx="310">
                  <c:v>7466.64990234375</c:v>
                </c:pt>
                <c:pt idx="311">
                  <c:v>7459.98486328125</c:v>
                </c:pt>
                <c:pt idx="312">
                  <c:v>7474.9609375</c:v>
                </c:pt>
                <c:pt idx="313">
                  <c:v>7491.2080078125</c:v>
                </c:pt>
                <c:pt idx="314">
                  <c:v>7502.29150390625</c:v>
                </c:pt>
                <c:pt idx="315">
                  <c:v>7517.94384765625</c:v>
                </c:pt>
                <c:pt idx="316">
                  <c:v>7549.80615234375</c:v>
                </c:pt>
                <c:pt idx="317">
                  <c:v>7593.7685546875</c:v>
                </c:pt>
                <c:pt idx="318">
                  <c:v>7626.21435546875</c:v>
                </c:pt>
                <c:pt idx="319">
                  <c:v>7620.26220703125</c:v>
                </c:pt>
                <c:pt idx="320">
                  <c:v>7570.05712890625</c:v>
                </c:pt>
                <c:pt idx="321">
                  <c:v>7501.88427734375</c:v>
                </c:pt>
                <c:pt idx="322">
                  <c:v>7459.658203125</c:v>
                </c:pt>
                <c:pt idx="323">
                  <c:v>7473.22265625</c:v>
                </c:pt>
                <c:pt idx="324">
                  <c:v>7533.798828125</c:v>
                </c:pt>
                <c:pt idx="325">
                  <c:v>7597.51611328125</c:v>
                </c:pt>
                <c:pt idx="326">
                  <c:v>7616.603515625</c:v>
                </c:pt>
                <c:pt idx="327">
                  <c:v>7575.26123046875</c:v>
                </c:pt>
                <c:pt idx="328">
                  <c:v>7502.22216796875</c:v>
                </c:pt>
                <c:pt idx="329">
                  <c:v>7449.63818359375</c:v>
                </c:pt>
                <c:pt idx="330">
                  <c:v>7454.37109375</c:v>
                </c:pt>
                <c:pt idx="331">
                  <c:v>7511.69482421875</c:v>
                </c:pt>
                <c:pt idx="332">
                  <c:v>7581.287109375</c:v>
                </c:pt>
                <c:pt idx="333">
                  <c:v>7619.46728515625</c:v>
                </c:pt>
                <c:pt idx="334">
                  <c:v>7611.1455078125</c:v>
                </c:pt>
                <c:pt idx="335">
                  <c:v>7576.54248046875</c:v>
                </c:pt>
                <c:pt idx="336">
                  <c:v>7549.515625</c:v>
                </c:pt>
                <c:pt idx="337">
                  <c:v>7547.7294921875</c:v>
                </c:pt>
                <c:pt idx="338">
                  <c:v>7560.373046875</c:v>
                </c:pt>
                <c:pt idx="339">
                  <c:v>7562.6845703125</c:v>
                </c:pt>
                <c:pt idx="340">
                  <c:v>7542.76953125</c:v>
                </c:pt>
                <c:pt idx="341">
                  <c:v>7515.71923828125</c:v>
                </c:pt>
                <c:pt idx="342">
                  <c:v>7511.61767578125</c:v>
                </c:pt>
                <c:pt idx="343">
                  <c:v>7547.4638671875</c:v>
                </c:pt>
                <c:pt idx="344">
                  <c:v>7607.8603515625</c:v>
                </c:pt>
                <c:pt idx="345">
                  <c:v>7652.5966796875</c:v>
                </c:pt>
                <c:pt idx="346">
                  <c:v>7646.5712890625</c:v>
                </c:pt>
                <c:pt idx="347">
                  <c:v>7588.14794921875</c:v>
                </c:pt>
                <c:pt idx="348">
                  <c:v>7512.51708984375</c:v>
                </c:pt>
                <c:pt idx="349">
                  <c:v>7466.6611328125</c:v>
                </c:pt>
              </c:numCache>
            </c:numRef>
          </c:yVal>
          <c:smooth val="1"/>
          <c:extLst>
            <c:ext xmlns:c16="http://schemas.microsoft.com/office/drawing/2014/chart" uri="{C3380CC4-5D6E-409C-BE32-E72D297353CC}">
              <c16:uniqueId val="{00000005-0DDB-41B5-BE83-A9CFE49F3CE3}"/>
            </c:ext>
          </c:extLst>
        </c:ser>
        <c:ser>
          <c:idx val="6"/>
          <c:order val="6"/>
          <c:tx>
            <c:strRef>
              <c:f>hc_sub_007!$G$1</c:f>
              <c:strCache>
                <c:ptCount val="1"/>
                <c:pt idx="0">
                  <c:v>Coor_7</c:v>
                </c:pt>
              </c:strCache>
            </c:strRef>
          </c:tx>
          <c:spPr>
            <a:ln w="28575" cap="rnd">
              <a:solidFill>
                <a:schemeClr val="accent1">
                  <a:lumMod val="60000"/>
                </a:schemeClr>
              </a:solidFill>
              <a:round/>
            </a:ln>
            <a:effectLst/>
          </c:spPr>
          <c:marker>
            <c:symbol val="none"/>
          </c:marker>
          <c:yVal>
            <c:numRef>
              <c:f>hc_sub_007!$G$2:$G$351</c:f>
              <c:numCache>
                <c:formatCode>0.00000000000_ </c:formatCode>
                <c:ptCount val="350"/>
                <c:pt idx="0">
                  <c:v>6258.74560546875</c:v>
                </c:pt>
                <c:pt idx="1">
                  <c:v>6246.10302734375</c:v>
                </c:pt>
                <c:pt idx="2">
                  <c:v>6229.7705078125</c:v>
                </c:pt>
                <c:pt idx="3">
                  <c:v>6221.314453125</c:v>
                </c:pt>
                <c:pt idx="4">
                  <c:v>6223.626953125</c:v>
                </c:pt>
                <c:pt idx="5">
                  <c:v>6227.9814453125</c:v>
                </c:pt>
                <c:pt idx="6">
                  <c:v>6222.31201171875</c:v>
                </c:pt>
                <c:pt idx="7">
                  <c:v>6203.64501953125</c:v>
                </c:pt>
                <c:pt idx="8">
                  <c:v>6183.34033203125</c:v>
                </c:pt>
                <c:pt idx="9">
                  <c:v>6179.54296875</c:v>
                </c:pt>
                <c:pt idx="10">
                  <c:v>6202.302734375</c:v>
                </c:pt>
                <c:pt idx="11">
                  <c:v>6243.615234375</c:v>
                </c:pt>
                <c:pt idx="12">
                  <c:v>6281.1533203125</c:v>
                </c:pt>
                <c:pt idx="13">
                  <c:v>6293.453125</c:v>
                </c:pt>
                <c:pt idx="14">
                  <c:v>6274.98828125</c:v>
                </c:pt>
                <c:pt idx="15">
                  <c:v>6239.6787109375</c:v>
                </c:pt>
                <c:pt idx="16">
                  <c:v>6210.6484375</c:v>
                </c:pt>
                <c:pt idx="17">
                  <c:v>6204.578125</c:v>
                </c:pt>
                <c:pt idx="18">
                  <c:v>6222.251953125</c:v>
                </c:pt>
                <c:pt idx="19">
                  <c:v>6250.873046875</c:v>
                </c:pt>
                <c:pt idx="20">
                  <c:v>6274.24560546875</c:v>
                </c:pt>
                <c:pt idx="21">
                  <c:v>6282.05810546875</c:v>
                </c:pt>
                <c:pt idx="22">
                  <c:v>6272.56005859375</c:v>
                </c:pt>
                <c:pt idx="23">
                  <c:v>6249.85986328125</c:v>
                </c:pt>
                <c:pt idx="24">
                  <c:v>6220.9873046875</c:v>
                </c:pt>
                <c:pt idx="25">
                  <c:v>6195.59228515625</c:v>
                </c:pt>
                <c:pt idx="26">
                  <c:v>6185.91015625</c:v>
                </c:pt>
                <c:pt idx="27">
                  <c:v>6202.791015625</c:v>
                </c:pt>
                <c:pt idx="28">
                  <c:v>6247.66259765625</c:v>
                </c:pt>
                <c:pt idx="29">
                  <c:v>6306.5380859375</c:v>
                </c:pt>
                <c:pt idx="30">
                  <c:v>6353.59130859375</c:v>
                </c:pt>
                <c:pt idx="31">
                  <c:v>6365.3828125</c:v>
                </c:pt>
                <c:pt idx="32">
                  <c:v>6337.1455078125</c:v>
                </c:pt>
                <c:pt idx="33">
                  <c:v>6288.33935546875</c:v>
                </c:pt>
                <c:pt idx="34">
                  <c:v>6251.095703125</c:v>
                </c:pt>
                <c:pt idx="35">
                  <c:v>6248.21484375</c:v>
                </c:pt>
                <c:pt idx="36">
                  <c:v>6276.62890625</c:v>
                </c:pt>
                <c:pt idx="37">
                  <c:v>6309.32568359375</c:v>
                </c:pt>
                <c:pt idx="38">
                  <c:v>6315.048828125</c:v>
                </c:pt>
                <c:pt idx="39">
                  <c:v>6281.21044921875</c:v>
                </c:pt>
                <c:pt idx="40">
                  <c:v>6222.71923828125</c:v>
                </c:pt>
                <c:pt idx="41">
                  <c:v>6170.3896484375</c:v>
                </c:pt>
                <c:pt idx="42">
                  <c:v>6148.50830078125</c:v>
                </c:pt>
                <c:pt idx="43">
                  <c:v>6159.15087890625</c:v>
                </c:pt>
                <c:pt idx="44">
                  <c:v>6184.58837890625</c:v>
                </c:pt>
                <c:pt idx="45">
                  <c:v>6204.04833984375</c:v>
                </c:pt>
                <c:pt idx="46">
                  <c:v>6209.8701171875</c:v>
                </c:pt>
                <c:pt idx="47">
                  <c:v>6209.8505859375</c:v>
                </c:pt>
                <c:pt idx="48">
                  <c:v>6215.34814453125</c:v>
                </c:pt>
                <c:pt idx="49">
                  <c:v>6227.2451171875</c:v>
                </c:pt>
                <c:pt idx="50">
                  <c:v>6233.3740234375</c:v>
                </c:pt>
                <c:pt idx="51">
                  <c:v>6220.35693359375</c:v>
                </c:pt>
                <c:pt idx="52">
                  <c:v>6189.3427734375</c:v>
                </c:pt>
                <c:pt idx="53">
                  <c:v>6160.697265625</c:v>
                </c:pt>
                <c:pt idx="54">
                  <c:v>6161.40380859375</c:v>
                </c:pt>
                <c:pt idx="55">
                  <c:v>6203.66015625</c:v>
                </c:pt>
                <c:pt idx="56">
                  <c:v>6271.60302734375</c:v>
                </c:pt>
                <c:pt idx="57">
                  <c:v>6327.9775390625</c:v>
                </c:pt>
                <c:pt idx="58">
                  <c:v>6337.65234375</c:v>
                </c:pt>
                <c:pt idx="59">
                  <c:v>6291.83984375</c:v>
                </c:pt>
                <c:pt idx="60">
                  <c:v>6215.81298828125</c:v>
                </c:pt>
                <c:pt idx="61">
                  <c:v>6154.43798828125</c:v>
                </c:pt>
                <c:pt idx="62">
                  <c:v>6145.15576171875</c:v>
                </c:pt>
                <c:pt idx="63">
                  <c:v>6196.03369140625</c:v>
                </c:pt>
                <c:pt idx="64">
                  <c:v>6282.18505859375</c:v>
                </c:pt>
                <c:pt idx="65">
                  <c:v>6361.33642578125</c:v>
                </c:pt>
                <c:pt idx="66">
                  <c:v>6397.76416015625</c:v>
                </c:pt>
                <c:pt idx="67">
                  <c:v>6380.31884765625</c:v>
                </c:pt>
                <c:pt idx="68">
                  <c:v>6325.529296875</c:v>
                </c:pt>
                <c:pt idx="69">
                  <c:v>6266.0634765625</c:v>
                </c:pt>
                <c:pt idx="70">
                  <c:v>6232.2802734375</c:v>
                </c:pt>
                <c:pt idx="71">
                  <c:v>6236.92919921875</c:v>
                </c:pt>
                <c:pt idx="72">
                  <c:v>6270.3671875</c:v>
                </c:pt>
                <c:pt idx="73">
                  <c:v>6307.9755859375</c:v>
                </c:pt>
                <c:pt idx="74">
                  <c:v>6325.26513671875</c:v>
                </c:pt>
                <c:pt idx="75">
                  <c:v>6311.9990234375</c:v>
                </c:pt>
                <c:pt idx="76">
                  <c:v>6276.87744140625</c:v>
                </c:pt>
                <c:pt idx="77">
                  <c:v>6239.70703125</c:v>
                </c:pt>
                <c:pt idx="78">
                  <c:v>6216.23046875</c:v>
                </c:pt>
                <c:pt idx="79">
                  <c:v>6206.59619140625</c:v>
                </c:pt>
                <c:pt idx="80">
                  <c:v>6196.76220703125</c:v>
                </c:pt>
                <c:pt idx="81">
                  <c:v>6172.767578125</c:v>
                </c:pt>
                <c:pt idx="82">
                  <c:v>6136.93212890625</c:v>
                </c:pt>
                <c:pt idx="83">
                  <c:v>6111.64404296875</c:v>
                </c:pt>
                <c:pt idx="84">
                  <c:v>6124.74267578125</c:v>
                </c:pt>
                <c:pt idx="85">
                  <c:v>6185.5625</c:v>
                </c:pt>
                <c:pt idx="86">
                  <c:v>6270.619140625</c:v>
                </c:pt>
                <c:pt idx="87">
                  <c:v>6333.2568359375</c:v>
                </c:pt>
                <c:pt idx="88">
                  <c:v>6333.93359375</c:v>
                </c:pt>
                <c:pt idx="89">
                  <c:v>6270.19287109375</c:v>
                </c:pt>
                <c:pt idx="90">
                  <c:v>6182.548828125</c:v>
                </c:pt>
                <c:pt idx="91">
                  <c:v>6128.82080078125</c:v>
                </c:pt>
                <c:pt idx="92">
                  <c:v>6143.63232421875</c:v>
                </c:pt>
                <c:pt idx="93">
                  <c:v>6212.93994140625</c:v>
                </c:pt>
                <c:pt idx="94">
                  <c:v>6283.92138671875</c:v>
                </c:pt>
                <c:pt idx="95">
                  <c:v>6304.25</c:v>
                </c:pt>
                <c:pt idx="96">
                  <c:v>6261.6865234375</c:v>
                </c:pt>
                <c:pt idx="97">
                  <c:v>6193.640625</c:v>
                </c:pt>
                <c:pt idx="98">
                  <c:v>6158.81884765625</c:v>
                </c:pt>
                <c:pt idx="99">
                  <c:v>6192.32421875</c:v>
                </c:pt>
                <c:pt idx="100">
                  <c:v>6278.576171875</c:v>
                </c:pt>
                <c:pt idx="101">
                  <c:v>6362.71728515625</c:v>
                </c:pt>
                <c:pt idx="102">
                  <c:v>6391.36181640625</c:v>
                </c:pt>
                <c:pt idx="103">
                  <c:v>6351.14404296875</c:v>
                </c:pt>
                <c:pt idx="104">
                  <c:v>6276.0517578125</c:v>
                </c:pt>
                <c:pt idx="105">
                  <c:v>6219.5576171875</c:v>
                </c:pt>
                <c:pt idx="106">
                  <c:v>6214.6943359375</c:v>
                </c:pt>
                <c:pt idx="107">
                  <c:v>6253.05322265625</c:v>
                </c:pt>
                <c:pt idx="108">
                  <c:v>6296.833984375</c:v>
                </c:pt>
                <c:pt idx="109">
                  <c:v>6311.2763671875</c:v>
                </c:pt>
                <c:pt idx="110">
                  <c:v>6290.02734375</c:v>
                </c:pt>
                <c:pt idx="111">
                  <c:v>6254.41748046875</c:v>
                </c:pt>
                <c:pt idx="112">
                  <c:v>6230.748046875</c:v>
                </c:pt>
                <c:pt idx="113">
                  <c:v>6227.392578125</c:v>
                </c:pt>
                <c:pt idx="114">
                  <c:v>6231.369140625</c:v>
                </c:pt>
                <c:pt idx="115">
                  <c:v>6225.17138671875</c:v>
                </c:pt>
                <c:pt idx="116">
                  <c:v>6206.39892578125</c:v>
                </c:pt>
                <c:pt idx="117">
                  <c:v>6191.103515625</c:v>
                </c:pt>
                <c:pt idx="118">
                  <c:v>6197.64208984375</c:v>
                </c:pt>
                <c:pt idx="119">
                  <c:v>6226.44189453125</c:v>
                </c:pt>
                <c:pt idx="120">
                  <c:v>6255.51220703125</c:v>
                </c:pt>
                <c:pt idx="121">
                  <c:v>6257.59716796875</c:v>
                </c:pt>
                <c:pt idx="122">
                  <c:v>6224.87158203125</c:v>
                </c:pt>
                <c:pt idx="123">
                  <c:v>6179.09228515625</c:v>
                </c:pt>
                <c:pt idx="124">
                  <c:v>6156.728515625</c:v>
                </c:pt>
                <c:pt idx="125">
                  <c:v>6180.13525390625</c:v>
                </c:pt>
                <c:pt idx="126">
                  <c:v>6238.62548828125</c:v>
                </c:pt>
                <c:pt idx="127">
                  <c:v>6295.76953125</c:v>
                </c:pt>
                <c:pt idx="128">
                  <c:v>6317.4638671875</c:v>
                </c:pt>
                <c:pt idx="129">
                  <c:v>6297.771484375</c:v>
                </c:pt>
                <c:pt idx="130">
                  <c:v>6261.396484375</c:v>
                </c:pt>
                <c:pt idx="131">
                  <c:v>6241.478515625</c:v>
                </c:pt>
                <c:pt idx="132">
                  <c:v>6252.14404296875</c:v>
                </c:pt>
                <c:pt idx="133">
                  <c:v>6279.11279296875</c:v>
                </c:pt>
                <c:pt idx="134">
                  <c:v>6295.3505859375</c:v>
                </c:pt>
                <c:pt idx="135">
                  <c:v>6286.623046875</c:v>
                </c:pt>
                <c:pt idx="136">
                  <c:v>6263.357421875</c:v>
                </c:pt>
                <c:pt idx="137">
                  <c:v>6248.0595703125</c:v>
                </c:pt>
                <c:pt idx="138">
                  <c:v>6250.36328125</c:v>
                </c:pt>
                <c:pt idx="139">
                  <c:v>6254.1640625</c:v>
                </c:pt>
                <c:pt idx="140">
                  <c:v>6231.32177734375</c:v>
                </c:pt>
                <c:pt idx="141">
                  <c:v>6172.01904296875</c:v>
                </c:pt>
                <c:pt idx="142">
                  <c:v>6104.34716796875</c:v>
                </c:pt>
                <c:pt idx="143">
                  <c:v>6081.69921875</c:v>
                </c:pt>
                <c:pt idx="144">
                  <c:v>6142.86865234375</c:v>
                </c:pt>
                <c:pt idx="145">
                  <c:v>6275.04150390625</c:v>
                </c:pt>
                <c:pt idx="146">
                  <c:v>6411.79345703125</c:v>
                </c:pt>
                <c:pt idx="147">
                  <c:v>6473.009765625</c:v>
                </c:pt>
                <c:pt idx="148">
                  <c:v>6420.16162109375</c:v>
                </c:pt>
                <c:pt idx="149">
                  <c:v>6285.7294921875</c:v>
                </c:pt>
                <c:pt idx="150">
                  <c:v>6152.9111328125</c:v>
                </c:pt>
                <c:pt idx="151">
                  <c:v>6098.7890625</c:v>
                </c:pt>
                <c:pt idx="152">
                  <c:v>6142.20849609375</c:v>
                </c:pt>
                <c:pt idx="153">
                  <c:v>6234.46435546875</c:v>
                </c:pt>
                <c:pt idx="154">
                  <c:v>6298.5869140625</c:v>
                </c:pt>
                <c:pt idx="155">
                  <c:v>6286.58984375</c:v>
                </c:pt>
                <c:pt idx="156">
                  <c:v>6211.69970703125</c:v>
                </c:pt>
                <c:pt idx="157">
                  <c:v>6133.35009765625</c:v>
                </c:pt>
                <c:pt idx="158">
                  <c:v>6109.53564453125</c:v>
                </c:pt>
                <c:pt idx="159">
                  <c:v>6154.8681640625</c:v>
                </c:pt>
                <c:pt idx="160">
                  <c:v>6235.484375</c:v>
                </c:pt>
                <c:pt idx="161">
                  <c:v>6301.021484375</c:v>
                </c:pt>
                <c:pt idx="162">
                  <c:v>6324.8369140625</c:v>
                </c:pt>
                <c:pt idx="163">
                  <c:v>6319.5244140625</c:v>
                </c:pt>
                <c:pt idx="164">
                  <c:v>6317.466796875</c:v>
                </c:pt>
                <c:pt idx="165">
                  <c:v>6335.9501953125</c:v>
                </c:pt>
                <c:pt idx="166">
                  <c:v>6358.4150390625</c:v>
                </c:pt>
                <c:pt idx="167">
                  <c:v>6348.51123046875</c:v>
                </c:pt>
                <c:pt idx="168">
                  <c:v>6284.896484375</c:v>
                </c:pt>
                <c:pt idx="169">
                  <c:v>6186.51708984375</c:v>
                </c:pt>
                <c:pt idx="170">
                  <c:v>6105.4404296875</c:v>
                </c:pt>
                <c:pt idx="171">
                  <c:v>6091.005859375</c:v>
                </c:pt>
                <c:pt idx="172">
                  <c:v>6152.951171875</c:v>
                </c:pt>
                <c:pt idx="173">
                  <c:v>6252.70458984375</c:v>
                </c:pt>
                <c:pt idx="174">
                  <c:v>6330.10693359375</c:v>
                </c:pt>
                <c:pt idx="175">
                  <c:v>6345.21044921875</c:v>
                </c:pt>
                <c:pt idx="176">
                  <c:v>6303.5771484375</c:v>
                </c:pt>
                <c:pt idx="177">
                  <c:v>6247.09716796875</c:v>
                </c:pt>
                <c:pt idx="178">
                  <c:v>6219.3017578125</c:v>
                </c:pt>
                <c:pt idx="179">
                  <c:v>6232.93017578125</c:v>
                </c:pt>
                <c:pt idx="180">
                  <c:v>6263.97265625</c:v>
                </c:pt>
                <c:pt idx="181">
                  <c:v>6274.51953125</c:v>
                </c:pt>
                <c:pt idx="182">
                  <c:v>6244.6474609375</c:v>
                </c:pt>
                <c:pt idx="183">
                  <c:v>6188.27001953125</c:v>
                </c:pt>
                <c:pt idx="184">
                  <c:v>6142.18701171875</c:v>
                </c:pt>
                <c:pt idx="185">
                  <c:v>6138.77392578125</c:v>
                </c:pt>
                <c:pt idx="186">
                  <c:v>6183.89208984375</c:v>
                </c:pt>
                <c:pt idx="187">
                  <c:v>6255.2333984375</c:v>
                </c:pt>
                <c:pt idx="188">
                  <c:v>6319.2919921875</c:v>
                </c:pt>
                <c:pt idx="189">
                  <c:v>6352.0078125</c:v>
                </c:pt>
                <c:pt idx="190">
                  <c:v>6348.42236328125</c:v>
                </c:pt>
                <c:pt idx="191">
                  <c:v>6318.0517578125</c:v>
                </c:pt>
                <c:pt idx="192">
                  <c:v>6274.17041015625</c:v>
                </c:pt>
                <c:pt idx="193">
                  <c:v>6227.35302734375</c:v>
                </c:pt>
                <c:pt idx="194">
                  <c:v>6186.35302734375</c:v>
                </c:pt>
                <c:pt idx="195">
                  <c:v>6160.93310546875</c:v>
                </c:pt>
                <c:pt idx="196">
                  <c:v>6159.869140625</c:v>
                </c:pt>
                <c:pt idx="197">
                  <c:v>6183.83642578125</c:v>
                </c:pt>
                <c:pt idx="198">
                  <c:v>6220.2373046875</c:v>
                </c:pt>
                <c:pt idx="199">
                  <c:v>6247.375</c:v>
                </c:pt>
                <c:pt idx="200">
                  <c:v>6247.630859375</c:v>
                </c:pt>
                <c:pt idx="201">
                  <c:v>6220.40380859375</c:v>
                </c:pt>
                <c:pt idx="202">
                  <c:v>6184.00439453125</c:v>
                </c:pt>
                <c:pt idx="203">
                  <c:v>6163.81103515625</c:v>
                </c:pt>
                <c:pt idx="204">
                  <c:v>6175.16064453125</c:v>
                </c:pt>
                <c:pt idx="205">
                  <c:v>6214.0234375</c:v>
                </c:pt>
                <c:pt idx="206">
                  <c:v>6262.17138671875</c:v>
                </c:pt>
                <c:pt idx="207">
                  <c:v>6301.57861328125</c:v>
                </c:pt>
                <c:pt idx="208">
                  <c:v>6325.54248046875</c:v>
                </c:pt>
                <c:pt idx="209">
                  <c:v>6337.8046875</c:v>
                </c:pt>
                <c:pt idx="210">
                  <c:v>6342.37744140625</c:v>
                </c:pt>
                <c:pt idx="211">
                  <c:v>6335.53076171875</c:v>
                </c:pt>
                <c:pt idx="212">
                  <c:v>6309.20458984375</c:v>
                </c:pt>
                <c:pt idx="213">
                  <c:v>6263.7119140625</c:v>
                </c:pt>
                <c:pt idx="214">
                  <c:v>6217.109375</c:v>
                </c:pt>
                <c:pt idx="215">
                  <c:v>6199.34228515625</c:v>
                </c:pt>
                <c:pt idx="216">
                  <c:v>6231.72509765625</c:v>
                </c:pt>
                <c:pt idx="217">
                  <c:v>6306.51220703125</c:v>
                </c:pt>
                <c:pt idx="218">
                  <c:v>6384.45361328125</c:v>
                </c:pt>
                <c:pt idx="219">
                  <c:v>6416.126953125</c:v>
                </c:pt>
                <c:pt idx="220">
                  <c:v>6374.1650390625</c:v>
                </c:pt>
                <c:pt idx="221">
                  <c:v>6273.26904296875</c:v>
                </c:pt>
                <c:pt idx="222">
                  <c:v>6162.32421875</c:v>
                </c:pt>
                <c:pt idx="223">
                  <c:v>6093.12548828125</c:v>
                </c:pt>
                <c:pt idx="224">
                  <c:v>6087.8017578125</c:v>
                </c:pt>
                <c:pt idx="225">
                  <c:v>6128.06396484375</c:v>
                </c:pt>
                <c:pt idx="226">
                  <c:v>6172.9111328125</c:v>
                </c:pt>
                <c:pt idx="227">
                  <c:v>6190.18359375</c:v>
                </c:pt>
                <c:pt idx="228">
                  <c:v>6177.90625</c:v>
                </c:pt>
                <c:pt idx="229">
                  <c:v>6160.6103515625</c:v>
                </c:pt>
                <c:pt idx="230">
                  <c:v>6165.91259765625</c:v>
                </c:pt>
                <c:pt idx="231">
                  <c:v>6201.33203125</c:v>
                </c:pt>
                <c:pt idx="232">
                  <c:v>6249.46923828125</c:v>
                </c:pt>
                <c:pt idx="233">
                  <c:v>6283.6298828125</c:v>
                </c:pt>
                <c:pt idx="234">
                  <c:v>6289.48828125</c:v>
                </c:pt>
                <c:pt idx="235">
                  <c:v>6274.6787109375</c:v>
                </c:pt>
                <c:pt idx="236">
                  <c:v>6259.5458984375</c:v>
                </c:pt>
                <c:pt idx="237">
                  <c:v>6258.435546875</c:v>
                </c:pt>
                <c:pt idx="238">
                  <c:v>6268.26123046875</c:v>
                </c:pt>
                <c:pt idx="239">
                  <c:v>6273.8779296875</c:v>
                </c:pt>
                <c:pt idx="240">
                  <c:v>6264.74755859375</c:v>
                </c:pt>
                <c:pt idx="241">
                  <c:v>6247.43603515625</c:v>
                </c:pt>
                <c:pt idx="242">
                  <c:v>6242.04638671875</c:v>
                </c:pt>
                <c:pt idx="243">
                  <c:v>6264.57080078125</c:v>
                </c:pt>
                <c:pt idx="244">
                  <c:v>6309.67138671875</c:v>
                </c:pt>
                <c:pt idx="245">
                  <c:v>6349.0341796875</c:v>
                </c:pt>
                <c:pt idx="246">
                  <c:v>6348.61669921875</c:v>
                </c:pt>
                <c:pt idx="247">
                  <c:v>6293.19189453125</c:v>
                </c:pt>
                <c:pt idx="248">
                  <c:v>6200.3232421875</c:v>
                </c:pt>
                <c:pt idx="249">
                  <c:v>6113.01318359375</c:v>
                </c:pt>
                <c:pt idx="250">
                  <c:v>6075.21630859375</c:v>
                </c:pt>
                <c:pt idx="251">
                  <c:v>6106.05029296875</c:v>
                </c:pt>
                <c:pt idx="252">
                  <c:v>6188.974609375</c:v>
                </c:pt>
                <c:pt idx="253">
                  <c:v>6281.93359375</c:v>
                </c:pt>
                <c:pt idx="254">
                  <c:v>6341.27880859375</c:v>
                </c:pt>
                <c:pt idx="255">
                  <c:v>6344.8603515625</c:v>
                </c:pt>
                <c:pt idx="256">
                  <c:v>6301.65283203125</c:v>
                </c:pt>
                <c:pt idx="257">
                  <c:v>6244.02880859375</c:v>
                </c:pt>
                <c:pt idx="258">
                  <c:v>6208.34619140625</c:v>
                </c:pt>
                <c:pt idx="259">
                  <c:v>6214.89599609375</c:v>
                </c:pt>
                <c:pt idx="260">
                  <c:v>6257.69189453125</c:v>
                </c:pt>
                <c:pt idx="261">
                  <c:v>6309.16943359375</c:v>
                </c:pt>
                <c:pt idx="262">
                  <c:v>6337.173828125</c:v>
                </c:pt>
                <c:pt idx="263">
                  <c:v>6324.900390625</c:v>
                </c:pt>
                <c:pt idx="264">
                  <c:v>6282.021484375</c:v>
                </c:pt>
                <c:pt idx="265">
                  <c:v>6239.29248046875</c:v>
                </c:pt>
                <c:pt idx="266">
                  <c:v>6228.50439453125</c:v>
                </c:pt>
                <c:pt idx="267">
                  <c:v>6259.7060546875</c:v>
                </c:pt>
                <c:pt idx="268">
                  <c:v>6311.21923828125</c:v>
                </c:pt>
                <c:pt idx="269">
                  <c:v>6341.13330078125</c:v>
                </c:pt>
                <c:pt idx="270">
                  <c:v>6314.7275390625</c:v>
                </c:pt>
                <c:pt idx="271">
                  <c:v>6230.05126953125</c:v>
                </c:pt>
                <c:pt idx="272">
                  <c:v>6123.228515625</c:v>
                </c:pt>
                <c:pt idx="273">
                  <c:v>6047.9453125</c:v>
                </c:pt>
                <c:pt idx="274">
                  <c:v>6041.79345703125</c:v>
                </c:pt>
                <c:pt idx="275">
                  <c:v>6102.37451171875</c:v>
                </c:pt>
                <c:pt idx="276">
                  <c:v>6189.95556640625</c:v>
                </c:pt>
                <c:pt idx="277">
                  <c:v>6254.76123046875</c:v>
                </c:pt>
                <c:pt idx="278">
                  <c:v>6269.267578125</c:v>
                </c:pt>
                <c:pt idx="279">
                  <c:v>6242.64306640625</c:v>
                </c:pt>
                <c:pt idx="280">
                  <c:v>6208.33447265625</c:v>
                </c:pt>
                <c:pt idx="281">
                  <c:v>6196.12841796875</c:v>
                </c:pt>
                <c:pt idx="282">
                  <c:v>6211.02099609375</c:v>
                </c:pt>
                <c:pt idx="283">
                  <c:v>6234.5546875</c:v>
                </c:pt>
                <c:pt idx="284">
                  <c:v>6245.5185546875</c:v>
                </c:pt>
                <c:pt idx="285">
                  <c:v>6241.3291015625</c:v>
                </c:pt>
                <c:pt idx="286">
                  <c:v>6241.4990234375</c:v>
                </c:pt>
                <c:pt idx="287">
                  <c:v>6270.02392578125</c:v>
                </c:pt>
                <c:pt idx="288">
                  <c:v>6331.4677734375</c:v>
                </c:pt>
                <c:pt idx="289">
                  <c:v>6401.2529296875</c:v>
                </c:pt>
                <c:pt idx="290">
                  <c:v>6439.43994140625</c:v>
                </c:pt>
                <c:pt idx="291">
                  <c:v>6418.3427734375</c:v>
                </c:pt>
                <c:pt idx="292">
                  <c:v>6342.99462890625</c:v>
                </c:pt>
                <c:pt idx="293">
                  <c:v>6248.85546875</c:v>
                </c:pt>
                <c:pt idx="294">
                  <c:v>6178.6953125</c:v>
                </c:pt>
                <c:pt idx="295">
                  <c:v>6156.150390625</c:v>
                </c:pt>
                <c:pt idx="296">
                  <c:v>6174.9013671875</c:v>
                </c:pt>
                <c:pt idx="297">
                  <c:v>6209.30517578125</c:v>
                </c:pt>
                <c:pt idx="298">
                  <c:v>6235.74658203125</c:v>
                </c:pt>
                <c:pt idx="299">
                  <c:v>6247.21533203125</c:v>
                </c:pt>
                <c:pt idx="300">
                  <c:v>6251.24755859375</c:v>
                </c:pt>
                <c:pt idx="301">
                  <c:v>6256.10595703125</c:v>
                </c:pt>
                <c:pt idx="302">
                  <c:v>6259.36767578125</c:v>
                </c:pt>
                <c:pt idx="303">
                  <c:v>6249.62744140625</c:v>
                </c:pt>
                <c:pt idx="304">
                  <c:v>6219.5009765625</c:v>
                </c:pt>
                <c:pt idx="305">
                  <c:v>6177.6123046875</c:v>
                </c:pt>
                <c:pt idx="306">
                  <c:v>6147.64208984375</c:v>
                </c:pt>
                <c:pt idx="307">
                  <c:v>6153.3154296875</c:v>
                </c:pt>
                <c:pt idx="308">
                  <c:v>6200.23974609375</c:v>
                </c:pt>
                <c:pt idx="309">
                  <c:v>6268.8232421875</c:v>
                </c:pt>
                <c:pt idx="310">
                  <c:v>6324.4736328125</c:v>
                </c:pt>
                <c:pt idx="311">
                  <c:v>6338.44482421875</c:v>
                </c:pt>
                <c:pt idx="312">
                  <c:v>6305.05712890625</c:v>
                </c:pt>
                <c:pt idx="313">
                  <c:v>6244.08056640625</c:v>
                </c:pt>
                <c:pt idx="314">
                  <c:v>6187.83544921875</c:v>
                </c:pt>
                <c:pt idx="315">
                  <c:v>6162.59814453125</c:v>
                </c:pt>
                <c:pt idx="316">
                  <c:v>6176.1826171875</c:v>
                </c:pt>
                <c:pt idx="317">
                  <c:v>6217.6591796875</c:v>
                </c:pt>
                <c:pt idx="318">
                  <c:v>6266.5380859375</c:v>
                </c:pt>
                <c:pt idx="319">
                  <c:v>6303.85888671875</c:v>
                </c:pt>
                <c:pt idx="320">
                  <c:v>6318.93505859375</c:v>
                </c:pt>
                <c:pt idx="321">
                  <c:v>6310.38916015625</c:v>
                </c:pt>
                <c:pt idx="322">
                  <c:v>6283.9375</c:v>
                </c:pt>
                <c:pt idx="323">
                  <c:v>6249.6923828125</c:v>
                </c:pt>
                <c:pt idx="324">
                  <c:v>6219.58349609375</c:v>
                </c:pt>
                <c:pt idx="325">
                  <c:v>6203.96142578125</c:v>
                </c:pt>
                <c:pt idx="326">
                  <c:v>6207.25830078125</c:v>
                </c:pt>
                <c:pt idx="327">
                  <c:v>6224.77685546875</c:v>
                </c:pt>
                <c:pt idx="328">
                  <c:v>6243.638671875</c:v>
                </c:pt>
                <c:pt idx="329">
                  <c:v>6249.056640625</c:v>
                </c:pt>
                <c:pt idx="330">
                  <c:v>6233.3212890625</c:v>
                </c:pt>
                <c:pt idx="331">
                  <c:v>6202.095703125</c:v>
                </c:pt>
                <c:pt idx="332">
                  <c:v>6173.25390625</c:v>
                </c:pt>
                <c:pt idx="333">
                  <c:v>6167.650390625</c:v>
                </c:pt>
                <c:pt idx="334">
                  <c:v>6196.45263671875</c:v>
                </c:pt>
                <c:pt idx="335">
                  <c:v>6252.57470703125</c:v>
                </c:pt>
                <c:pt idx="336">
                  <c:v>6312.16796875</c:v>
                </c:pt>
                <c:pt idx="337">
                  <c:v>6346.59912109375</c:v>
                </c:pt>
                <c:pt idx="338">
                  <c:v>6338.82763671875</c:v>
                </c:pt>
                <c:pt idx="339">
                  <c:v>6294.576171875</c:v>
                </c:pt>
                <c:pt idx="340">
                  <c:v>6240.7109375</c:v>
                </c:pt>
                <c:pt idx="341">
                  <c:v>6210.36865234375</c:v>
                </c:pt>
                <c:pt idx="342">
                  <c:v>6222.80712890625</c:v>
                </c:pt>
                <c:pt idx="343">
                  <c:v>6270.3076171875</c:v>
                </c:pt>
                <c:pt idx="344">
                  <c:v>6321.31591796875</c:v>
                </c:pt>
                <c:pt idx="345">
                  <c:v>6339.23291015625</c:v>
                </c:pt>
                <c:pt idx="346">
                  <c:v>6305.80908203125</c:v>
                </c:pt>
                <c:pt idx="347">
                  <c:v>6233.9853515625</c:v>
                </c:pt>
                <c:pt idx="348">
                  <c:v>6161.0390625</c:v>
                </c:pt>
                <c:pt idx="349">
                  <c:v>6125.69140625</c:v>
                </c:pt>
              </c:numCache>
            </c:numRef>
          </c:yVal>
          <c:smooth val="1"/>
          <c:extLst>
            <c:ext xmlns:c16="http://schemas.microsoft.com/office/drawing/2014/chart" uri="{C3380CC4-5D6E-409C-BE32-E72D297353CC}">
              <c16:uniqueId val="{00000006-0DDB-41B5-BE83-A9CFE49F3CE3}"/>
            </c:ext>
          </c:extLst>
        </c:ser>
        <c:ser>
          <c:idx val="7"/>
          <c:order val="7"/>
          <c:tx>
            <c:strRef>
              <c:f>hc_sub_007!$H$1</c:f>
              <c:strCache>
                <c:ptCount val="1"/>
                <c:pt idx="0">
                  <c:v>Coor_8</c:v>
                </c:pt>
              </c:strCache>
            </c:strRef>
          </c:tx>
          <c:spPr>
            <a:ln w="28575" cap="rnd">
              <a:solidFill>
                <a:schemeClr val="accent2">
                  <a:lumMod val="60000"/>
                </a:schemeClr>
              </a:solidFill>
              <a:round/>
            </a:ln>
            <a:effectLst/>
          </c:spPr>
          <c:marker>
            <c:symbol val="none"/>
          </c:marker>
          <c:yVal>
            <c:numRef>
              <c:f>hc_sub_007!$H$2:$H$351</c:f>
              <c:numCache>
                <c:formatCode>0.00000000000_ </c:formatCode>
                <c:ptCount val="350"/>
                <c:pt idx="0">
                  <c:v>6415.19482421875</c:v>
                </c:pt>
                <c:pt idx="1">
                  <c:v>6375.095703125</c:v>
                </c:pt>
                <c:pt idx="2">
                  <c:v>6349.60205078125</c:v>
                </c:pt>
                <c:pt idx="3">
                  <c:v>6355.30029296875</c:v>
                </c:pt>
                <c:pt idx="4">
                  <c:v>6389.32177734375</c:v>
                </c:pt>
                <c:pt idx="5">
                  <c:v>6432.16015625</c:v>
                </c:pt>
                <c:pt idx="6">
                  <c:v>6461.603515625</c:v>
                </c:pt>
                <c:pt idx="7">
                  <c:v>6466.806640625</c:v>
                </c:pt>
                <c:pt idx="8">
                  <c:v>6452.33203125</c:v>
                </c:pt>
                <c:pt idx="9">
                  <c:v>6430.744140625</c:v>
                </c:pt>
                <c:pt idx="10">
                  <c:v>6411.45458984375</c:v>
                </c:pt>
                <c:pt idx="11">
                  <c:v>6395.53759765625</c:v>
                </c:pt>
                <c:pt idx="12">
                  <c:v>6379.900390625</c:v>
                </c:pt>
                <c:pt idx="13">
                  <c:v>6365.390625</c:v>
                </c:pt>
                <c:pt idx="14">
                  <c:v>6359.98876953125</c:v>
                </c:pt>
                <c:pt idx="15">
                  <c:v>6373.0517578125</c:v>
                </c:pt>
                <c:pt idx="16">
                  <c:v>6405.32275390625</c:v>
                </c:pt>
                <c:pt idx="17">
                  <c:v>6444.1396484375</c:v>
                </c:pt>
                <c:pt idx="18">
                  <c:v>6469.603515625</c:v>
                </c:pt>
                <c:pt idx="19">
                  <c:v>6468.15625</c:v>
                </c:pt>
                <c:pt idx="20">
                  <c:v>6443.09130859375</c:v>
                </c:pt>
                <c:pt idx="21">
                  <c:v>6413.0478515625</c:v>
                </c:pt>
                <c:pt idx="22">
                  <c:v>6398.79248046875</c:v>
                </c:pt>
                <c:pt idx="23">
                  <c:v>6408.0546875</c:v>
                </c:pt>
                <c:pt idx="24">
                  <c:v>6430.13916015625</c:v>
                </c:pt>
                <c:pt idx="25">
                  <c:v>6444.5693359375</c:v>
                </c:pt>
                <c:pt idx="26">
                  <c:v>6437.064453125</c:v>
                </c:pt>
                <c:pt idx="27">
                  <c:v>6410.40234375</c:v>
                </c:pt>
                <c:pt idx="28">
                  <c:v>6381.814453125</c:v>
                </c:pt>
                <c:pt idx="29">
                  <c:v>6369.177734375</c:v>
                </c:pt>
                <c:pt idx="30">
                  <c:v>6376.97216796875</c:v>
                </c:pt>
                <c:pt idx="31">
                  <c:v>6392.95556640625</c:v>
                </c:pt>
                <c:pt idx="32">
                  <c:v>6397.94873046875</c:v>
                </c:pt>
                <c:pt idx="33">
                  <c:v>6380.93017578125</c:v>
                </c:pt>
                <c:pt idx="34">
                  <c:v>6347.810546875</c:v>
                </c:pt>
                <c:pt idx="35">
                  <c:v>6317.45166015625</c:v>
                </c:pt>
                <c:pt idx="36">
                  <c:v>6308.3916015625</c:v>
                </c:pt>
                <c:pt idx="37">
                  <c:v>6326.4736328125</c:v>
                </c:pt>
                <c:pt idx="38">
                  <c:v>6362.2177734375</c:v>
                </c:pt>
                <c:pt idx="39">
                  <c:v>6398.87890625</c:v>
                </c:pt>
                <c:pt idx="40">
                  <c:v>6424.22509765625</c:v>
                </c:pt>
                <c:pt idx="41">
                  <c:v>6437.11572265625</c:v>
                </c:pt>
                <c:pt idx="42">
                  <c:v>6444.96875</c:v>
                </c:pt>
                <c:pt idx="43">
                  <c:v>6455.5830078125</c:v>
                </c:pt>
                <c:pt idx="44">
                  <c:v>6470.591796875</c:v>
                </c:pt>
                <c:pt idx="45">
                  <c:v>6485.40625</c:v>
                </c:pt>
                <c:pt idx="46">
                  <c:v>6494.47412109375</c:v>
                </c:pt>
                <c:pt idx="47">
                  <c:v>6496.33349609375</c:v>
                </c:pt>
                <c:pt idx="48">
                  <c:v>6493.77490234375</c:v>
                </c:pt>
                <c:pt idx="49">
                  <c:v>6489.3837890625</c:v>
                </c:pt>
                <c:pt idx="50">
                  <c:v>6481.259765625</c:v>
                </c:pt>
                <c:pt idx="51">
                  <c:v>6463.72119140625</c:v>
                </c:pt>
                <c:pt idx="52">
                  <c:v>6433.224609375</c:v>
                </c:pt>
                <c:pt idx="53">
                  <c:v>6394.52392578125</c:v>
                </c:pt>
                <c:pt idx="54">
                  <c:v>6360.8896484375</c:v>
                </c:pt>
                <c:pt idx="55">
                  <c:v>6346.56005859375</c:v>
                </c:pt>
                <c:pt idx="56">
                  <c:v>6356.1875</c:v>
                </c:pt>
                <c:pt idx="57">
                  <c:v>6379.54736328125</c:v>
                </c:pt>
                <c:pt idx="58">
                  <c:v>6396.81201171875</c:v>
                </c:pt>
                <c:pt idx="59">
                  <c:v>6391.96337890625</c:v>
                </c:pt>
                <c:pt idx="60">
                  <c:v>6365.162109375</c:v>
                </c:pt>
                <c:pt idx="61">
                  <c:v>6334.50146484375</c:v>
                </c:pt>
                <c:pt idx="62">
                  <c:v>6324.54736328125</c:v>
                </c:pt>
                <c:pt idx="63">
                  <c:v>6348.71142578125</c:v>
                </c:pt>
                <c:pt idx="64">
                  <c:v>6397.77783203125</c:v>
                </c:pt>
                <c:pt idx="65">
                  <c:v>6443.5244140625</c:v>
                </c:pt>
                <c:pt idx="66">
                  <c:v>6456.2177734375</c:v>
                </c:pt>
                <c:pt idx="67">
                  <c:v>6424.791015625</c:v>
                </c:pt>
                <c:pt idx="68">
                  <c:v>6365.89111328125</c:v>
                </c:pt>
                <c:pt idx="69">
                  <c:v>6314.9833984375</c:v>
                </c:pt>
                <c:pt idx="70">
                  <c:v>6304.7041015625</c:v>
                </c:pt>
                <c:pt idx="71">
                  <c:v>6344.44384765625</c:v>
                </c:pt>
                <c:pt idx="72">
                  <c:v>6414.5361328125</c:v>
                </c:pt>
                <c:pt idx="73">
                  <c:v>6478.751953125</c:v>
                </c:pt>
                <c:pt idx="74">
                  <c:v>6506.6630859375</c:v>
                </c:pt>
                <c:pt idx="75">
                  <c:v>6491.1845703125</c:v>
                </c:pt>
                <c:pt idx="76">
                  <c:v>6450.36376953125</c:v>
                </c:pt>
                <c:pt idx="77">
                  <c:v>6413.39697265625</c:v>
                </c:pt>
                <c:pt idx="78">
                  <c:v>6401.2451171875</c:v>
                </c:pt>
                <c:pt idx="79">
                  <c:v>6414.97705078125</c:v>
                </c:pt>
                <c:pt idx="80">
                  <c:v>6438.65869140625</c:v>
                </c:pt>
                <c:pt idx="81">
                  <c:v>6453.0986328125</c:v>
                </c:pt>
                <c:pt idx="82">
                  <c:v>6449.65771484375</c:v>
                </c:pt>
                <c:pt idx="83">
                  <c:v>6434.4111328125</c:v>
                </c:pt>
                <c:pt idx="84">
                  <c:v>6420.8466796875</c:v>
                </c:pt>
                <c:pt idx="85">
                  <c:v>6417.86376953125</c:v>
                </c:pt>
                <c:pt idx="86">
                  <c:v>6422.794921875</c:v>
                </c:pt>
                <c:pt idx="87">
                  <c:v>6424.6376953125</c:v>
                </c:pt>
                <c:pt idx="88">
                  <c:v>6414.39892578125</c:v>
                </c:pt>
                <c:pt idx="89">
                  <c:v>6393.875</c:v>
                </c:pt>
                <c:pt idx="90">
                  <c:v>6375.486328125</c:v>
                </c:pt>
                <c:pt idx="91">
                  <c:v>6372.86865234375</c:v>
                </c:pt>
                <c:pt idx="92">
                  <c:v>6389.38671875</c:v>
                </c:pt>
                <c:pt idx="93">
                  <c:v>6413.77197265625</c:v>
                </c:pt>
                <c:pt idx="94">
                  <c:v>6427.04052734375</c:v>
                </c:pt>
                <c:pt idx="95">
                  <c:v>6416.3515625</c:v>
                </c:pt>
                <c:pt idx="96">
                  <c:v>6385.7900390625</c:v>
                </c:pt>
                <c:pt idx="97">
                  <c:v>6355.603515625</c:v>
                </c:pt>
                <c:pt idx="98">
                  <c:v>6349.365234375</c:v>
                </c:pt>
                <c:pt idx="99">
                  <c:v>6377.3115234375</c:v>
                </c:pt>
                <c:pt idx="100">
                  <c:v>6427.41796875</c:v>
                </c:pt>
                <c:pt idx="101">
                  <c:v>6471.0244140625</c:v>
                </c:pt>
                <c:pt idx="102">
                  <c:v>6480.0947265625</c:v>
                </c:pt>
                <c:pt idx="103">
                  <c:v>6445.1484375</c:v>
                </c:pt>
                <c:pt idx="104">
                  <c:v>6382.13916015625</c:v>
                </c:pt>
                <c:pt idx="105">
                  <c:v>6323.67431640625</c:v>
                </c:pt>
                <c:pt idx="106">
                  <c:v>6300.13916015625</c:v>
                </c:pt>
                <c:pt idx="107">
                  <c:v>6322.6416015625</c:v>
                </c:pt>
                <c:pt idx="108">
                  <c:v>6378.0908203125</c:v>
                </c:pt>
                <c:pt idx="109">
                  <c:v>6438.53125</c:v>
                </c:pt>
                <c:pt idx="110">
                  <c:v>6477.8466796875</c:v>
                </c:pt>
                <c:pt idx="111">
                  <c:v>6485.099609375</c:v>
                </c:pt>
                <c:pt idx="112">
                  <c:v>6467.15380859375</c:v>
                </c:pt>
                <c:pt idx="113">
                  <c:v>6440.8818359375</c:v>
                </c:pt>
                <c:pt idx="114">
                  <c:v>6421.57373046875</c:v>
                </c:pt>
                <c:pt idx="115">
                  <c:v>6415.201171875</c:v>
                </c:pt>
                <c:pt idx="116">
                  <c:v>6418.095703125</c:v>
                </c:pt>
                <c:pt idx="117">
                  <c:v>6422.1259765625</c:v>
                </c:pt>
                <c:pt idx="118">
                  <c:v>6420.62109375</c:v>
                </c:pt>
                <c:pt idx="119">
                  <c:v>6411.4345703125</c:v>
                </c:pt>
                <c:pt idx="120">
                  <c:v>6396.72705078125</c:v>
                </c:pt>
                <c:pt idx="121">
                  <c:v>6381.2431640625</c:v>
                </c:pt>
                <c:pt idx="122">
                  <c:v>6370.62744140625</c:v>
                </c:pt>
                <c:pt idx="123">
                  <c:v>6369.79541015625</c:v>
                </c:pt>
                <c:pt idx="124">
                  <c:v>6380.7490234375</c:v>
                </c:pt>
                <c:pt idx="125">
                  <c:v>6400.42041015625</c:v>
                </c:pt>
                <c:pt idx="126">
                  <c:v>6420.6103515625</c:v>
                </c:pt>
                <c:pt idx="127">
                  <c:v>6431.72412109375</c:v>
                </c:pt>
                <c:pt idx="128">
                  <c:v>6429.1025390625</c:v>
                </c:pt>
                <c:pt idx="129">
                  <c:v>6417.56884765625</c:v>
                </c:pt>
                <c:pt idx="130">
                  <c:v>6409.64697265625</c:v>
                </c:pt>
                <c:pt idx="131">
                  <c:v>6416.97607421875</c:v>
                </c:pt>
                <c:pt idx="132">
                  <c:v>6440.23876953125</c:v>
                </c:pt>
                <c:pt idx="133">
                  <c:v>6465.55615234375</c:v>
                </c:pt>
                <c:pt idx="134">
                  <c:v>6471.76513671875</c:v>
                </c:pt>
                <c:pt idx="135">
                  <c:v>6445.04150390625</c:v>
                </c:pt>
                <c:pt idx="136">
                  <c:v>6390.83642578125</c:v>
                </c:pt>
                <c:pt idx="137">
                  <c:v>6333.68212890625</c:v>
                </c:pt>
                <c:pt idx="138">
                  <c:v>6303.455078125</c:v>
                </c:pt>
                <c:pt idx="139">
                  <c:v>6316.6962890625</c:v>
                </c:pt>
                <c:pt idx="140">
                  <c:v>6365.80224609375</c:v>
                </c:pt>
                <c:pt idx="141">
                  <c:v>6423.80615234375</c:v>
                </c:pt>
                <c:pt idx="142">
                  <c:v>6461.46142578125</c:v>
                </c:pt>
                <c:pt idx="143">
                  <c:v>6464.67822265625</c:v>
                </c:pt>
                <c:pt idx="144">
                  <c:v>6440.6201171875</c:v>
                </c:pt>
                <c:pt idx="145">
                  <c:v>6409.49853515625</c:v>
                </c:pt>
                <c:pt idx="146">
                  <c:v>6389.505859375</c:v>
                </c:pt>
                <c:pt idx="147">
                  <c:v>6386.34228515625</c:v>
                </c:pt>
                <c:pt idx="148">
                  <c:v>6393.8251953125</c:v>
                </c:pt>
                <c:pt idx="149">
                  <c:v>6402.72900390625</c:v>
                </c:pt>
                <c:pt idx="150">
                  <c:v>6409.07373046875</c:v>
                </c:pt>
                <c:pt idx="151">
                  <c:v>6415.07275390625</c:v>
                </c:pt>
                <c:pt idx="152">
                  <c:v>6423.45263671875</c:v>
                </c:pt>
                <c:pt idx="153">
                  <c:v>6431.91455078125</c:v>
                </c:pt>
                <c:pt idx="154">
                  <c:v>6433.8642578125</c:v>
                </c:pt>
                <c:pt idx="155">
                  <c:v>6425.06201171875</c:v>
                </c:pt>
                <c:pt idx="156">
                  <c:v>6409.6669921875</c:v>
                </c:pt>
                <c:pt idx="157">
                  <c:v>6399.1162109375</c:v>
                </c:pt>
                <c:pt idx="158">
                  <c:v>6403.6142578125</c:v>
                </c:pt>
                <c:pt idx="159">
                  <c:v>6423.08349609375</c:v>
                </c:pt>
                <c:pt idx="160">
                  <c:v>6445.70654296875</c:v>
                </c:pt>
                <c:pt idx="161">
                  <c:v>6456.15185546875</c:v>
                </c:pt>
                <c:pt idx="162">
                  <c:v>6447.189453125</c:v>
                </c:pt>
                <c:pt idx="163">
                  <c:v>6425.0830078125</c:v>
                </c:pt>
                <c:pt idx="164">
                  <c:v>6404.05078125</c:v>
                </c:pt>
                <c:pt idx="165">
                  <c:v>6394.29052734375</c:v>
                </c:pt>
                <c:pt idx="166">
                  <c:v>6393.75732421875</c:v>
                </c:pt>
                <c:pt idx="167">
                  <c:v>6390.88720703125</c:v>
                </c:pt>
                <c:pt idx="168">
                  <c:v>6376.1318359375</c:v>
                </c:pt>
                <c:pt idx="169">
                  <c:v>6352.31494140625</c:v>
                </c:pt>
                <c:pt idx="170">
                  <c:v>6334.33349609375</c:v>
                </c:pt>
                <c:pt idx="171">
                  <c:v>6337.50830078125</c:v>
                </c:pt>
                <c:pt idx="172">
                  <c:v>6363.7607421875</c:v>
                </c:pt>
                <c:pt idx="173">
                  <c:v>6397.4306640625</c:v>
                </c:pt>
                <c:pt idx="174">
                  <c:v>6415.34521484375</c:v>
                </c:pt>
                <c:pt idx="175">
                  <c:v>6404.33447265625</c:v>
                </c:pt>
                <c:pt idx="176">
                  <c:v>6372.876953125</c:v>
                </c:pt>
                <c:pt idx="177">
                  <c:v>6347.3544921875</c:v>
                </c:pt>
                <c:pt idx="178">
                  <c:v>6354.71533203125</c:v>
                </c:pt>
                <c:pt idx="179">
                  <c:v>6403.53369140625</c:v>
                </c:pt>
                <c:pt idx="180">
                  <c:v>6476.759765625</c:v>
                </c:pt>
                <c:pt idx="181">
                  <c:v>6541.208984375</c:v>
                </c:pt>
                <c:pt idx="182">
                  <c:v>6567.26025390625</c:v>
                </c:pt>
                <c:pt idx="183">
                  <c:v>6545.796875</c:v>
                </c:pt>
                <c:pt idx="184">
                  <c:v>6492.06787109375</c:v>
                </c:pt>
                <c:pt idx="185">
                  <c:v>6435.2353515625</c:v>
                </c:pt>
                <c:pt idx="186">
                  <c:v>6401.1337890625</c:v>
                </c:pt>
                <c:pt idx="187">
                  <c:v>6398.794921875</c:v>
                </c:pt>
                <c:pt idx="188">
                  <c:v>6417.68017578125</c:v>
                </c:pt>
                <c:pt idx="189">
                  <c:v>6435.7744140625</c:v>
                </c:pt>
                <c:pt idx="190">
                  <c:v>6433.044921875</c:v>
                </c:pt>
                <c:pt idx="191">
                  <c:v>6402.8310546875</c:v>
                </c:pt>
                <c:pt idx="192">
                  <c:v>6355.49609375</c:v>
                </c:pt>
                <c:pt idx="193">
                  <c:v>6312.693359375</c:v>
                </c:pt>
                <c:pt idx="194">
                  <c:v>6295.23779296875</c:v>
                </c:pt>
                <c:pt idx="195">
                  <c:v>6311.044921875</c:v>
                </c:pt>
                <c:pt idx="196">
                  <c:v>6350.15625</c:v>
                </c:pt>
                <c:pt idx="197">
                  <c:v>6390.431640625</c:v>
                </c:pt>
                <c:pt idx="198">
                  <c:v>6411.1298828125</c:v>
                </c:pt>
                <c:pt idx="199">
                  <c:v>6405.98388671875</c:v>
                </c:pt>
                <c:pt idx="200">
                  <c:v>6386.76513671875</c:v>
                </c:pt>
                <c:pt idx="201">
                  <c:v>6374.28515625</c:v>
                </c:pt>
                <c:pt idx="202">
                  <c:v>6382.814453125</c:v>
                </c:pt>
                <c:pt idx="203">
                  <c:v>6409.35009765625</c:v>
                </c:pt>
                <c:pt idx="204">
                  <c:v>6436.2099609375</c:v>
                </c:pt>
                <c:pt idx="205">
                  <c:v>6445.4150390625</c:v>
                </c:pt>
                <c:pt idx="206">
                  <c:v>6433.72900390625</c:v>
                </c:pt>
                <c:pt idx="207">
                  <c:v>6415.990234375</c:v>
                </c:pt>
                <c:pt idx="208">
                  <c:v>6413.29443359375</c:v>
                </c:pt>
                <c:pt idx="209">
                  <c:v>6435.01318359375</c:v>
                </c:pt>
                <c:pt idx="210">
                  <c:v>6469.451171875</c:v>
                </c:pt>
                <c:pt idx="211">
                  <c:v>6491.7216796875</c:v>
                </c:pt>
                <c:pt idx="212">
                  <c:v>6483.5068359375</c:v>
                </c:pt>
                <c:pt idx="213">
                  <c:v>6448.9775390625</c:v>
                </c:pt>
                <c:pt idx="214">
                  <c:v>6413.2060546875</c:v>
                </c:pt>
                <c:pt idx="215">
                  <c:v>6403.04638671875</c:v>
                </c:pt>
                <c:pt idx="216">
                  <c:v>6424.978515625</c:v>
                </c:pt>
                <c:pt idx="217">
                  <c:v>6457.8525390625</c:v>
                </c:pt>
                <c:pt idx="218">
                  <c:v>6467.435546875</c:v>
                </c:pt>
                <c:pt idx="219">
                  <c:v>6432.5234375</c:v>
                </c:pt>
                <c:pt idx="220">
                  <c:v>6362.8056640625</c:v>
                </c:pt>
                <c:pt idx="221">
                  <c:v>6294.4677734375</c:v>
                </c:pt>
                <c:pt idx="222">
                  <c:v>6266.31591796875</c:v>
                </c:pt>
                <c:pt idx="223">
                  <c:v>6293.8193359375</c:v>
                </c:pt>
                <c:pt idx="224">
                  <c:v>6359.5751953125</c:v>
                </c:pt>
                <c:pt idx="225">
                  <c:v>6425.9462890625</c:v>
                </c:pt>
                <c:pt idx="226">
                  <c:v>6459.404296875</c:v>
                </c:pt>
                <c:pt idx="227">
                  <c:v>6449.02685546875</c:v>
                </c:pt>
                <c:pt idx="228">
                  <c:v>6408.11181640625</c:v>
                </c:pt>
                <c:pt idx="229">
                  <c:v>6361.49462890625</c:v>
                </c:pt>
                <c:pt idx="230">
                  <c:v>6330.42529296875</c:v>
                </c:pt>
                <c:pt idx="231">
                  <c:v>6325.3076171875</c:v>
                </c:pt>
                <c:pt idx="232">
                  <c:v>6347.38916015625</c:v>
                </c:pt>
                <c:pt idx="233">
                  <c:v>6392.86279296875</c:v>
                </c:pt>
                <c:pt idx="234">
                  <c:v>6453.32958984375</c:v>
                </c:pt>
                <c:pt idx="235">
                  <c:v>6513.42431640625</c:v>
                </c:pt>
                <c:pt idx="236">
                  <c:v>6551.84814453125</c:v>
                </c:pt>
                <c:pt idx="237">
                  <c:v>6550.00927734375</c:v>
                </c:pt>
                <c:pt idx="238">
                  <c:v>6504.470703125</c:v>
                </c:pt>
                <c:pt idx="239">
                  <c:v>6433.33203125</c:v>
                </c:pt>
                <c:pt idx="240">
                  <c:v>6369.1474609375</c:v>
                </c:pt>
                <c:pt idx="241">
                  <c:v>6341.0322265625</c:v>
                </c:pt>
                <c:pt idx="242">
                  <c:v>6357.8828125</c:v>
                </c:pt>
                <c:pt idx="243">
                  <c:v>6404.72412109375</c:v>
                </c:pt>
                <c:pt idx="244">
                  <c:v>6454.40771484375</c:v>
                </c:pt>
                <c:pt idx="245">
                  <c:v>6485.14892578125</c:v>
                </c:pt>
                <c:pt idx="246">
                  <c:v>6490.58251953125</c:v>
                </c:pt>
                <c:pt idx="247">
                  <c:v>6476.32763671875</c:v>
                </c:pt>
                <c:pt idx="248">
                  <c:v>6448.9345703125</c:v>
                </c:pt>
                <c:pt idx="249">
                  <c:v>6409.07080078125</c:v>
                </c:pt>
                <c:pt idx="250">
                  <c:v>6355.6396484375</c:v>
                </c:pt>
                <c:pt idx="251">
                  <c:v>6296.03271484375</c:v>
                </c:pt>
                <c:pt idx="252">
                  <c:v>6250.59130859375</c:v>
                </c:pt>
                <c:pt idx="253">
                  <c:v>6243.5322265625</c:v>
                </c:pt>
                <c:pt idx="254">
                  <c:v>6285.048828125</c:v>
                </c:pt>
                <c:pt idx="255">
                  <c:v>6359.00244140625</c:v>
                </c:pt>
                <c:pt idx="256">
                  <c:v>6428.44140625</c:v>
                </c:pt>
                <c:pt idx="257">
                  <c:v>6457.83251953125</c:v>
                </c:pt>
                <c:pt idx="258">
                  <c:v>6436.93359375</c:v>
                </c:pt>
                <c:pt idx="259">
                  <c:v>6388.48828125</c:v>
                </c:pt>
                <c:pt idx="260">
                  <c:v>6353.21240234375</c:v>
                </c:pt>
                <c:pt idx="261">
                  <c:v>6362.36279296875</c:v>
                </c:pt>
                <c:pt idx="262">
                  <c:v>6417.32421875</c:v>
                </c:pt>
                <c:pt idx="263">
                  <c:v>6490.1005859375</c:v>
                </c:pt>
                <c:pt idx="264">
                  <c:v>6543.0009765625</c:v>
                </c:pt>
                <c:pt idx="265">
                  <c:v>6552.44873046875</c:v>
                </c:pt>
                <c:pt idx="266">
                  <c:v>6520.6005859375</c:v>
                </c:pt>
                <c:pt idx="267">
                  <c:v>6469.07568359375</c:v>
                </c:pt>
                <c:pt idx="268">
                  <c:v>6422.34814453125</c:v>
                </c:pt>
                <c:pt idx="269">
                  <c:v>6393.982421875</c:v>
                </c:pt>
                <c:pt idx="270">
                  <c:v>6383.8779296875</c:v>
                </c:pt>
                <c:pt idx="271">
                  <c:v>6384.7744140625</c:v>
                </c:pt>
                <c:pt idx="272">
                  <c:v>6390.0517578125</c:v>
                </c:pt>
                <c:pt idx="273">
                  <c:v>6396.517578125</c:v>
                </c:pt>
                <c:pt idx="274">
                  <c:v>6402.26220703125</c:v>
                </c:pt>
                <c:pt idx="275">
                  <c:v>6404.23388671875</c:v>
                </c:pt>
                <c:pt idx="276">
                  <c:v>6399.1826171875</c:v>
                </c:pt>
                <c:pt idx="277">
                  <c:v>6387.0400390625</c:v>
                </c:pt>
                <c:pt idx="278">
                  <c:v>6372.708984375</c:v>
                </c:pt>
                <c:pt idx="279">
                  <c:v>6363.71337890625</c:v>
                </c:pt>
                <c:pt idx="280">
                  <c:v>6365.353515625</c:v>
                </c:pt>
                <c:pt idx="281">
                  <c:v>6377.5078125</c:v>
                </c:pt>
                <c:pt idx="282">
                  <c:v>6395.56787109375</c:v>
                </c:pt>
                <c:pt idx="283">
                  <c:v>6413.99365234375</c:v>
                </c:pt>
                <c:pt idx="284">
                  <c:v>6428.8134765625</c:v>
                </c:pt>
                <c:pt idx="285">
                  <c:v>6437.23291015625</c:v>
                </c:pt>
                <c:pt idx="286">
                  <c:v>6436.2158203125</c:v>
                </c:pt>
                <c:pt idx="287">
                  <c:v>6423.328125</c:v>
                </c:pt>
                <c:pt idx="288">
                  <c:v>6400.42138671875</c:v>
                </c:pt>
                <c:pt idx="289">
                  <c:v>6376.53515625</c:v>
                </c:pt>
                <c:pt idx="290">
                  <c:v>6365.4208984375</c:v>
                </c:pt>
                <c:pt idx="291">
                  <c:v>6377.255859375</c:v>
                </c:pt>
                <c:pt idx="292">
                  <c:v>6410.10009765625</c:v>
                </c:pt>
                <c:pt idx="293">
                  <c:v>6448.61376953125</c:v>
                </c:pt>
                <c:pt idx="294">
                  <c:v>6472.6376953125</c:v>
                </c:pt>
                <c:pt idx="295">
                  <c:v>6470.08837890625</c:v>
                </c:pt>
                <c:pt idx="296">
                  <c:v>6444.3330078125</c:v>
                </c:pt>
                <c:pt idx="297">
                  <c:v>6410.275390625</c:v>
                </c:pt>
                <c:pt idx="298">
                  <c:v>6382.7392578125</c:v>
                </c:pt>
                <c:pt idx="299">
                  <c:v>6367.27392578125</c:v>
                </c:pt>
                <c:pt idx="300">
                  <c:v>6360.9892578125</c:v>
                </c:pt>
                <c:pt idx="301">
                  <c:v>6361.37890625</c:v>
                </c:pt>
                <c:pt idx="302">
                  <c:v>6373.08251953125</c:v>
                </c:pt>
                <c:pt idx="303">
                  <c:v>6404.11279296875</c:v>
                </c:pt>
                <c:pt idx="304">
                  <c:v>6453.59521484375</c:v>
                </c:pt>
                <c:pt idx="305">
                  <c:v>6503.11962890625</c:v>
                </c:pt>
                <c:pt idx="306">
                  <c:v>6523.1923828125</c:v>
                </c:pt>
                <c:pt idx="307">
                  <c:v>6493.8115234375</c:v>
                </c:pt>
                <c:pt idx="308">
                  <c:v>6423.8935546875</c:v>
                </c:pt>
                <c:pt idx="309">
                  <c:v>6351.50146484375</c:v>
                </c:pt>
                <c:pt idx="310">
                  <c:v>6320.19384765625</c:v>
                </c:pt>
                <c:pt idx="311">
                  <c:v>6346.837890625</c:v>
                </c:pt>
                <c:pt idx="312">
                  <c:v>6406.08203125</c:v>
                </c:pt>
                <c:pt idx="313">
                  <c:v>6446.3828125</c:v>
                </c:pt>
                <c:pt idx="314">
                  <c:v>6428.2998046875</c:v>
                </c:pt>
                <c:pt idx="315">
                  <c:v>6356.68310546875</c:v>
                </c:pt>
                <c:pt idx="316">
                  <c:v>6280.7275390625</c:v>
                </c:pt>
                <c:pt idx="317">
                  <c:v>6259.537109375</c:v>
                </c:pt>
                <c:pt idx="318">
                  <c:v>6317.96826171875</c:v>
                </c:pt>
                <c:pt idx="319">
                  <c:v>6426.36767578125</c:v>
                </c:pt>
                <c:pt idx="320">
                  <c:v>6520.46142578125</c:v>
                </c:pt>
                <c:pt idx="321">
                  <c:v>6546.98974609375</c:v>
                </c:pt>
                <c:pt idx="322">
                  <c:v>6500.76708984375</c:v>
                </c:pt>
                <c:pt idx="323">
                  <c:v>6425.46337890625</c:v>
                </c:pt>
                <c:pt idx="324">
                  <c:v>6378.533203125</c:v>
                </c:pt>
                <c:pt idx="325">
                  <c:v>6388.048828125</c:v>
                </c:pt>
                <c:pt idx="326">
                  <c:v>6434.4638671875</c:v>
                </c:pt>
                <c:pt idx="327">
                  <c:v>6469.84912109375</c:v>
                </c:pt>
                <c:pt idx="328">
                  <c:v>6457.7626953125</c:v>
                </c:pt>
                <c:pt idx="329">
                  <c:v>6401.90478515625</c:v>
                </c:pt>
                <c:pt idx="330">
                  <c:v>6342.1240234375</c:v>
                </c:pt>
                <c:pt idx="331">
                  <c:v>6322.7763671875</c:v>
                </c:pt>
                <c:pt idx="332">
                  <c:v>6359.30029296875</c:v>
                </c:pt>
                <c:pt idx="333">
                  <c:v>6428.32763671875</c:v>
                </c:pt>
                <c:pt idx="334">
                  <c:v>6486.6689453125</c:v>
                </c:pt>
                <c:pt idx="335">
                  <c:v>6502.29638671875</c:v>
                </c:pt>
                <c:pt idx="336">
                  <c:v>6473.40185546875</c:v>
                </c:pt>
                <c:pt idx="337">
                  <c:v>6423.697265625</c:v>
                </c:pt>
                <c:pt idx="338">
                  <c:v>6381.61083984375</c:v>
                </c:pt>
                <c:pt idx="339">
                  <c:v>6361.7265625</c:v>
                </c:pt>
                <c:pt idx="340">
                  <c:v>6361.3857421875</c:v>
                </c:pt>
                <c:pt idx="341">
                  <c:v>6370.65380859375</c:v>
                </c:pt>
                <c:pt idx="342">
                  <c:v>6383.39306640625</c:v>
                </c:pt>
                <c:pt idx="343">
                  <c:v>6399.23486328125</c:v>
                </c:pt>
                <c:pt idx="344">
                  <c:v>6417.12744140625</c:v>
                </c:pt>
                <c:pt idx="345">
                  <c:v>6429.8046875</c:v>
                </c:pt>
                <c:pt idx="346">
                  <c:v>6426.93115234375</c:v>
                </c:pt>
                <c:pt idx="347">
                  <c:v>6405.03466796875</c:v>
                </c:pt>
                <c:pt idx="348">
                  <c:v>6374.36376953125</c:v>
                </c:pt>
                <c:pt idx="349">
                  <c:v>6354.46337890625</c:v>
                </c:pt>
              </c:numCache>
            </c:numRef>
          </c:yVal>
          <c:smooth val="1"/>
          <c:extLst>
            <c:ext xmlns:c16="http://schemas.microsoft.com/office/drawing/2014/chart" uri="{C3380CC4-5D6E-409C-BE32-E72D297353CC}">
              <c16:uniqueId val="{00000007-0DDB-41B5-BE83-A9CFE49F3CE3}"/>
            </c:ext>
          </c:extLst>
        </c:ser>
        <c:ser>
          <c:idx val="8"/>
          <c:order val="8"/>
          <c:tx>
            <c:strRef>
              <c:f>hc_sub_007!$I$1</c:f>
              <c:strCache>
                <c:ptCount val="1"/>
                <c:pt idx="0">
                  <c:v>Coor_9</c:v>
                </c:pt>
              </c:strCache>
            </c:strRef>
          </c:tx>
          <c:spPr>
            <a:ln w="28575" cap="rnd">
              <a:solidFill>
                <a:schemeClr val="accent3">
                  <a:lumMod val="60000"/>
                </a:schemeClr>
              </a:solidFill>
              <a:round/>
            </a:ln>
            <a:effectLst/>
          </c:spPr>
          <c:marker>
            <c:symbol val="none"/>
          </c:marker>
          <c:yVal>
            <c:numRef>
              <c:f>hc_sub_007!$I$2:$I$351</c:f>
              <c:numCache>
                <c:formatCode>0.00000000000_ </c:formatCode>
                <c:ptCount val="350"/>
                <c:pt idx="0">
                  <c:v>6463.2939453125</c:v>
                </c:pt>
                <c:pt idx="1">
                  <c:v>6485.744140625</c:v>
                </c:pt>
                <c:pt idx="2">
                  <c:v>6543.89990234375</c:v>
                </c:pt>
                <c:pt idx="3">
                  <c:v>6612.298828125</c:v>
                </c:pt>
                <c:pt idx="4">
                  <c:v>6657.73779296875</c:v>
                </c:pt>
                <c:pt idx="5">
                  <c:v>6658.0419921875</c:v>
                </c:pt>
                <c:pt idx="6">
                  <c:v>6615.923828125</c:v>
                </c:pt>
                <c:pt idx="7">
                  <c:v>6558.41748046875</c:v>
                </c:pt>
                <c:pt idx="8">
                  <c:v>6520.84521484375</c:v>
                </c:pt>
                <c:pt idx="9">
                  <c:v>6524.64599609375</c:v>
                </c:pt>
                <c:pt idx="10">
                  <c:v>6563.56591796875</c:v>
                </c:pt>
                <c:pt idx="11">
                  <c:v>6608.0234375</c:v>
                </c:pt>
                <c:pt idx="12">
                  <c:v>6625.36572265625</c:v>
                </c:pt>
                <c:pt idx="13">
                  <c:v>6602.35693359375</c:v>
                </c:pt>
                <c:pt idx="14">
                  <c:v>6554.1689453125</c:v>
                </c:pt>
                <c:pt idx="15">
                  <c:v>6513.48583984375</c:v>
                </c:pt>
                <c:pt idx="16">
                  <c:v>6507.5087890625</c:v>
                </c:pt>
                <c:pt idx="17">
                  <c:v>6539.26318359375</c:v>
                </c:pt>
                <c:pt idx="18">
                  <c:v>6586.11572265625</c:v>
                </c:pt>
                <c:pt idx="19">
                  <c:v>6615.63427734375</c:v>
                </c:pt>
                <c:pt idx="20">
                  <c:v>6606.7060546875</c:v>
                </c:pt>
                <c:pt idx="21">
                  <c:v>6561.2685546875</c:v>
                </c:pt>
                <c:pt idx="22">
                  <c:v>6500.32763671875</c:v>
                </c:pt>
                <c:pt idx="23">
                  <c:v>6449.7333984375</c:v>
                </c:pt>
                <c:pt idx="24">
                  <c:v>6427.0751953125</c:v>
                </c:pt>
                <c:pt idx="25">
                  <c:v>6437.3095703125</c:v>
                </c:pt>
                <c:pt idx="26">
                  <c:v>6476.06787109375</c:v>
                </c:pt>
                <c:pt idx="27">
                  <c:v>6534.189453125</c:v>
                </c:pt>
                <c:pt idx="28">
                  <c:v>6599.14208984375</c:v>
                </c:pt>
                <c:pt idx="29">
                  <c:v>6655.16162109375</c:v>
                </c:pt>
                <c:pt idx="30">
                  <c:v>6686.9794921875</c:v>
                </c:pt>
                <c:pt idx="31">
                  <c:v>6688.10302734375</c:v>
                </c:pt>
                <c:pt idx="32">
                  <c:v>6667.61181640625</c:v>
                </c:pt>
                <c:pt idx="33">
                  <c:v>6647.17724609375</c:v>
                </c:pt>
                <c:pt idx="34">
                  <c:v>6646.6748046875</c:v>
                </c:pt>
                <c:pt idx="35">
                  <c:v>6667.60791015625</c:v>
                </c:pt>
                <c:pt idx="36">
                  <c:v>6688.5849609375</c:v>
                </c:pt>
                <c:pt idx="37">
                  <c:v>6679.77685546875</c:v>
                </c:pt>
                <c:pt idx="38">
                  <c:v>6627.83837890625</c:v>
                </c:pt>
                <c:pt idx="39">
                  <c:v>6551.8212890625</c:v>
                </c:pt>
                <c:pt idx="40">
                  <c:v>6494.775390625</c:v>
                </c:pt>
                <c:pt idx="41">
                  <c:v>6493.7890625</c:v>
                </c:pt>
                <c:pt idx="42">
                  <c:v>6549.6181640625</c:v>
                </c:pt>
                <c:pt idx="43">
                  <c:v>6620.19970703125</c:v>
                </c:pt>
                <c:pt idx="44">
                  <c:v>6646.04248046875</c:v>
                </c:pt>
                <c:pt idx="45">
                  <c:v>6591.26513671875</c:v>
                </c:pt>
                <c:pt idx="46">
                  <c:v>6470.857421875</c:v>
                </c:pt>
                <c:pt idx="47">
                  <c:v>6343.65234375</c:v>
                </c:pt>
                <c:pt idx="48">
                  <c:v>6275.3642578125</c:v>
                </c:pt>
                <c:pt idx="49">
                  <c:v>6297.83154296875</c:v>
                </c:pt>
                <c:pt idx="50">
                  <c:v>6392.59423828125</c:v>
                </c:pt>
                <c:pt idx="51">
                  <c:v>6508.02490234375</c:v>
                </c:pt>
                <c:pt idx="52">
                  <c:v>6594.6455078125</c:v>
                </c:pt>
                <c:pt idx="53">
                  <c:v>6632.1220703125</c:v>
                </c:pt>
                <c:pt idx="54">
                  <c:v>6631.17626953125</c:v>
                </c:pt>
                <c:pt idx="55">
                  <c:v>6614.89697265625</c:v>
                </c:pt>
                <c:pt idx="56">
                  <c:v>6598.64599609375</c:v>
                </c:pt>
                <c:pt idx="57">
                  <c:v>6584.87255859375</c:v>
                </c:pt>
                <c:pt idx="58">
                  <c:v>6572.96728515625</c:v>
                </c:pt>
                <c:pt idx="59">
                  <c:v>6570.1494140625</c:v>
                </c:pt>
                <c:pt idx="60">
                  <c:v>6589.69580078125</c:v>
                </c:pt>
                <c:pt idx="61">
                  <c:v>6636.6005859375</c:v>
                </c:pt>
                <c:pt idx="62">
                  <c:v>6694.7646484375</c:v>
                </c:pt>
                <c:pt idx="63">
                  <c:v>6730.73876953125</c:v>
                </c:pt>
                <c:pt idx="64">
                  <c:v>6715.279296875</c:v>
                </c:pt>
                <c:pt idx="65">
                  <c:v>6647.27978515625</c:v>
                </c:pt>
                <c:pt idx="66">
                  <c:v>6559.96630859375</c:v>
                </c:pt>
                <c:pt idx="67">
                  <c:v>6501.61279296875</c:v>
                </c:pt>
                <c:pt idx="68">
                  <c:v>6503.0703125</c:v>
                </c:pt>
                <c:pt idx="69">
                  <c:v>6555.79736328125</c:v>
                </c:pt>
                <c:pt idx="70">
                  <c:v>6617.22509765625</c:v>
                </c:pt>
                <c:pt idx="71">
                  <c:v>6640.19775390625</c:v>
                </c:pt>
                <c:pt idx="72">
                  <c:v>6605.4345703125</c:v>
                </c:pt>
                <c:pt idx="73">
                  <c:v>6534.01611328125</c:v>
                </c:pt>
                <c:pt idx="74">
                  <c:v>6471.87841796875</c:v>
                </c:pt>
                <c:pt idx="75">
                  <c:v>6458.29296875</c:v>
                </c:pt>
                <c:pt idx="76">
                  <c:v>6500.55810546875</c:v>
                </c:pt>
                <c:pt idx="77">
                  <c:v>6571.0498046875</c:v>
                </c:pt>
                <c:pt idx="78">
                  <c:v>6626.33056640625</c:v>
                </c:pt>
                <c:pt idx="79">
                  <c:v>6633.83935546875</c:v>
                </c:pt>
                <c:pt idx="80">
                  <c:v>6589.10546875</c:v>
                </c:pt>
                <c:pt idx="81">
                  <c:v>6515.12353515625</c:v>
                </c:pt>
                <c:pt idx="82">
                  <c:v>6447.61279296875</c:v>
                </c:pt>
                <c:pt idx="83">
                  <c:v>6416.8076171875</c:v>
                </c:pt>
                <c:pt idx="84">
                  <c:v>6435.2998046875</c:v>
                </c:pt>
                <c:pt idx="85">
                  <c:v>6495.5595703125</c:v>
                </c:pt>
                <c:pt idx="86">
                  <c:v>6575.34033203125</c:v>
                </c:pt>
                <c:pt idx="87">
                  <c:v>6647.07958984375</c:v>
                </c:pt>
                <c:pt idx="88">
                  <c:v>6687.83740234375</c:v>
                </c:pt>
                <c:pt idx="89">
                  <c:v>6687.109375</c:v>
                </c:pt>
                <c:pt idx="90">
                  <c:v>6650.19873046875</c:v>
                </c:pt>
                <c:pt idx="91">
                  <c:v>6595.57666015625</c:v>
                </c:pt>
                <c:pt idx="92">
                  <c:v>6546.76953125</c:v>
                </c:pt>
                <c:pt idx="93">
                  <c:v>6522.0888671875</c:v>
                </c:pt>
                <c:pt idx="94">
                  <c:v>6527.02587890625</c:v>
                </c:pt>
                <c:pt idx="95">
                  <c:v>6552.931640625</c:v>
                </c:pt>
                <c:pt idx="96">
                  <c:v>6582.3134765625</c:v>
                </c:pt>
                <c:pt idx="97">
                  <c:v>6597.82470703125</c:v>
                </c:pt>
                <c:pt idx="98">
                  <c:v>6590.65625</c:v>
                </c:pt>
                <c:pt idx="99">
                  <c:v>6564.7705078125</c:v>
                </c:pt>
                <c:pt idx="100">
                  <c:v>6535.27685546875</c:v>
                </c:pt>
                <c:pt idx="101">
                  <c:v>6521.31201171875</c:v>
                </c:pt>
                <c:pt idx="102">
                  <c:v>6535.8818359375</c:v>
                </c:pt>
                <c:pt idx="103">
                  <c:v>6577.1279296875</c:v>
                </c:pt>
                <c:pt idx="104">
                  <c:v>6626.24267578125</c:v>
                </c:pt>
                <c:pt idx="105">
                  <c:v>6655.12548828125</c:v>
                </c:pt>
                <c:pt idx="106">
                  <c:v>6641.54638671875</c:v>
                </c:pt>
                <c:pt idx="107">
                  <c:v>6583.73876953125</c:v>
                </c:pt>
                <c:pt idx="108">
                  <c:v>6504.59814453125</c:v>
                </c:pt>
                <c:pt idx="109">
                  <c:v>6440.8271484375</c:v>
                </c:pt>
                <c:pt idx="110">
                  <c:v>6422.24658203125</c:v>
                </c:pt>
                <c:pt idx="111">
                  <c:v>6454.2255859375</c:v>
                </c:pt>
                <c:pt idx="112">
                  <c:v>6515.33251953125</c:v>
                </c:pt>
                <c:pt idx="113">
                  <c:v>6572.275390625</c:v>
                </c:pt>
                <c:pt idx="114">
                  <c:v>6601.82568359375</c:v>
                </c:pt>
                <c:pt idx="115">
                  <c:v>6604.17724609375</c:v>
                </c:pt>
                <c:pt idx="116">
                  <c:v>6598.57568359375</c:v>
                </c:pt>
                <c:pt idx="117">
                  <c:v>6605.470703125</c:v>
                </c:pt>
                <c:pt idx="118">
                  <c:v>6629.4970703125</c:v>
                </c:pt>
                <c:pt idx="119">
                  <c:v>6656.32861328125</c:v>
                </c:pt>
                <c:pt idx="120">
                  <c:v>6664.98828125</c:v>
                </c:pt>
                <c:pt idx="121">
                  <c:v>6644.9501953125</c:v>
                </c:pt>
                <c:pt idx="122">
                  <c:v>6604.21484375</c:v>
                </c:pt>
                <c:pt idx="123">
                  <c:v>6562.6630859375</c:v>
                </c:pt>
                <c:pt idx="124">
                  <c:v>6537.17919921875</c:v>
                </c:pt>
                <c:pt idx="125">
                  <c:v>6531.0458984375</c:v>
                </c:pt>
                <c:pt idx="126">
                  <c:v>6535.33447265625</c:v>
                </c:pt>
                <c:pt idx="127">
                  <c:v>6539.27783203125</c:v>
                </c:pt>
                <c:pt idx="128">
                  <c:v>6539.52197265625</c:v>
                </c:pt>
                <c:pt idx="129">
                  <c:v>6540.4912109375</c:v>
                </c:pt>
                <c:pt idx="130">
                  <c:v>6547.06689453125</c:v>
                </c:pt>
                <c:pt idx="131">
                  <c:v>6557.73828125</c:v>
                </c:pt>
                <c:pt idx="132">
                  <c:v>6565.150390625</c:v>
                </c:pt>
                <c:pt idx="133">
                  <c:v>6563.17724609375</c:v>
                </c:pt>
                <c:pt idx="134">
                  <c:v>6553.11865234375</c:v>
                </c:pt>
                <c:pt idx="135">
                  <c:v>6542.6171875</c:v>
                </c:pt>
                <c:pt idx="136">
                  <c:v>6538.38525390625</c:v>
                </c:pt>
                <c:pt idx="137">
                  <c:v>6540.25537109375</c:v>
                </c:pt>
                <c:pt idx="138">
                  <c:v>6542.9248046875</c:v>
                </c:pt>
                <c:pt idx="139">
                  <c:v>6543.8466796875</c:v>
                </c:pt>
                <c:pt idx="140">
                  <c:v>6548.8056640625</c:v>
                </c:pt>
                <c:pt idx="141">
                  <c:v>6568.0107421875</c:v>
                </c:pt>
                <c:pt idx="142">
                  <c:v>6604.6728515625</c:v>
                </c:pt>
                <c:pt idx="143">
                  <c:v>6646.53369140625</c:v>
                </c:pt>
                <c:pt idx="144">
                  <c:v>6670.0517578125</c:v>
                </c:pt>
                <c:pt idx="145">
                  <c:v>6656.4033203125</c:v>
                </c:pt>
                <c:pt idx="146">
                  <c:v>6607.0556640625</c:v>
                </c:pt>
                <c:pt idx="147">
                  <c:v>6545.21923828125</c:v>
                </c:pt>
                <c:pt idx="148">
                  <c:v>6500.40869140625</c:v>
                </c:pt>
                <c:pt idx="149">
                  <c:v>6487.8251953125</c:v>
                </c:pt>
                <c:pt idx="150">
                  <c:v>6499.4267578125</c:v>
                </c:pt>
                <c:pt idx="151">
                  <c:v>6514.07373046875</c:v>
                </c:pt>
                <c:pt idx="152">
                  <c:v>6517.70556640625</c:v>
                </c:pt>
                <c:pt idx="153">
                  <c:v>6515.556640625</c:v>
                </c:pt>
                <c:pt idx="154">
                  <c:v>6525.3369140625</c:v>
                </c:pt>
                <c:pt idx="155">
                  <c:v>6557.55419921875</c:v>
                </c:pt>
                <c:pt idx="156">
                  <c:v>6601.37646484375</c:v>
                </c:pt>
                <c:pt idx="157">
                  <c:v>6630.25</c:v>
                </c:pt>
                <c:pt idx="158">
                  <c:v>6623.81494140625</c:v>
                </c:pt>
                <c:pt idx="159">
                  <c:v>6587.07177734375</c:v>
                </c:pt>
                <c:pt idx="160">
                  <c:v>6548.68896484375</c:v>
                </c:pt>
                <c:pt idx="161">
                  <c:v>6538.07275390625</c:v>
                </c:pt>
                <c:pt idx="162">
                  <c:v>6560.1728515625</c:v>
                </c:pt>
                <c:pt idx="163">
                  <c:v>6590.48974609375</c:v>
                </c:pt>
                <c:pt idx="164">
                  <c:v>6596.11962890625</c:v>
                </c:pt>
                <c:pt idx="165">
                  <c:v>6565.7041015625</c:v>
                </c:pt>
                <c:pt idx="166">
                  <c:v>6522.052734375</c:v>
                </c:pt>
                <c:pt idx="167">
                  <c:v>6504.99072265625</c:v>
                </c:pt>
                <c:pt idx="168">
                  <c:v>6537.64306640625</c:v>
                </c:pt>
                <c:pt idx="169">
                  <c:v>6604.79833984375</c:v>
                </c:pt>
                <c:pt idx="170">
                  <c:v>6662.97314453125</c:v>
                </c:pt>
                <c:pt idx="171">
                  <c:v>6675.0947265625</c:v>
                </c:pt>
                <c:pt idx="172">
                  <c:v>6640.93115234375</c:v>
                </c:pt>
                <c:pt idx="173">
                  <c:v>6596.8515625</c:v>
                </c:pt>
                <c:pt idx="174">
                  <c:v>6584.0556640625</c:v>
                </c:pt>
                <c:pt idx="175">
                  <c:v>6611.7333984375</c:v>
                </c:pt>
                <c:pt idx="176">
                  <c:v>6647.056640625</c:v>
                </c:pt>
                <c:pt idx="177">
                  <c:v>6641.9619140625</c:v>
                </c:pt>
                <c:pt idx="178">
                  <c:v>6575.35791015625</c:v>
                </c:pt>
                <c:pt idx="179">
                  <c:v>6475.27978515625</c:v>
                </c:pt>
                <c:pt idx="180">
                  <c:v>6401.154296875</c:v>
                </c:pt>
                <c:pt idx="181">
                  <c:v>6399.18798828125</c:v>
                </c:pt>
                <c:pt idx="182">
                  <c:v>6466.53173828125</c:v>
                </c:pt>
                <c:pt idx="183">
                  <c:v>6553.26220703125</c:v>
                </c:pt>
                <c:pt idx="184">
                  <c:v>6600.63427734375</c:v>
                </c:pt>
                <c:pt idx="185">
                  <c:v>6584.90966796875</c:v>
                </c:pt>
                <c:pt idx="186">
                  <c:v>6532.2900390625</c:v>
                </c:pt>
                <c:pt idx="187">
                  <c:v>6494.6884765625</c:v>
                </c:pt>
                <c:pt idx="188">
                  <c:v>6507.6220703125</c:v>
                </c:pt>
                <c:pt idx="189">
                  <c:v>6564.40869140625</c:v>
                </c:pt>
                <c:pt idx="190">
                  <c:v>6625.4404296875</c:v>
                </c:pt>
                <c:pt idx="191">
                  <c:v>6651.8134765625</c:v>
                </c:pt>
                <c:pt idx="192">
                  <c:v>6634.1044921875</c:v>
                </c:pt>
                <c:pt idx="193">
                  <c:v>6594.06884765625</c:v>
                </c:pt>
                <c:pt idx="194">
                  <c:v>6561.70166015625</c:v>
                </c:pt>
                <c:pt idx="195">
                  <c:v>6550.2412109375</c:v>
                </c:pt>
                <c:pt idx="196">
                  <c:v>6550.59765625</c:v>
                </c:pt>
                <c:pt idx="197">
                  <c:v>6547.0087890625</c:v>
                </c:pt>
                <c:pt idx="198">
                  <c:v>6536.30908203125</c:v>
                </c:pt>
                <c:pt idx="199">
                  <c:v>6531.4208984375</c:v>
                </c:pt>
                <c:pt idx="200">
                  <c:v>6546.15234375</c:v>
                </c:pt>
                <c:pt idx="201">
                  <c:v>6577.1455078125</c:v>
                </c:pt>
                <c:pt idx="202">
                  <c:v>6602.12158203125</c:v>
                </c:pt>
                <c:pt idx="203">
                  <c:v>6598.283203125</c:v>
                </c:pt>
                <c:pt idx="204">
                  <c:v>6564.96728515625</c:v>
                </c:pt>
                <c:pt idx="205">
                  <c:v>6528.91455078125</c:v>
                </c:pt>
                <c:pt idx="206">
                  <c:v>6524.783203125</c:v>
                </c:pt>
                <c:pt idx="207">
                  <c:v>6565.66064453125</c:v>
                </c:pt>
                <c:pt idx="208">
                  <c:v>6628.63525390625</c:v>
                </c:pt>
                <c:pt idx="209">
                  <c:v>6669.25732421875</c:v>
                </c:pt>
                <c:pt idx="210">
                  <c:v>6654.93505859375</c:v>
                </c:pt>
                <c:pt idx="211">
                  <c:v>6591.05712890625</c:v>
                </c:pt>
                <c:pt idx="212">
                  <c:v>6518.79931640625</c:v>
                </c:pt>
                <c:pt idx="213">
                  <c:v>6485.97998046875</c:v>
                </c:pt>
                <c:pt idx="214">
                  <c:v>6513.400390625</c:v>
                </c:pt>
                <c:pt idx="215">
                  <c:v>6581.81689453125</c:v>
                </c:pt>
                <c:pt idx="216">
                  <c:v>6647.6376953125</c:v>
                </c:pt>
                <c:pt idx="217">
                  <c:v>6673.33447265625</c:v>
                </c:pt>
                <c:pt idx="218">
                  <c:v>6649.2763671875</c:v>
                </c:pt>
                <c:pt idx="219">
                  <c:v>6593.28515625</c:v>
                </c:pt>
                <c:pt idx="220">
                  <c:v>6532.96484375</c:v>
                </c:pt>
                <c:pt idx="221">
                  <c:v>6487.638671875</c:v>
                </c:pt>
                <c:pt idx="222">
                  <c:v>6463.091796875</c:v>
                </c:pt>
                <c:pt idx="223">
                  <c:v>6458.61669921875</c:v>
                </c:pt>
                <c:pt idx="224">
                  <c:v>6475.34521484375</c:v>
                </c:pt>
                <c:pt idx="225">
                  <c:v>6516.16552734375</c:v>
                </c:pt>
                <c:pt idx="226">
                  <c:v>6577.85107421875</c:v>
                </c:pt>
                <c:pt idx="227">
                  <c:v>6644.7109375</c:v>
                </c:pt>
                <c:pt idx="228">
                  <c:v>6692.0546875</c:v>
                </c:pt>
                <c:pt idx="229">
                  <c:v>6698.6376953125</c:v>
                </c:pt>
                <c:pt idx="230">
                  <c:v>6658.9658203125</c:v>
                </c:pt>
                <c:pt idx="231">
                  <c:v>6586.412109375</c:v>
                </c:pt>
                <c:pt idx="232">
                  <c:v>6505.80078125</c:v>
                </c:pt>
                <c:pt idx="233">
                  <c:v>6441.87255859375</c:v>
                </c:pt>
                <c:pt idx="234">
                  <c:v>6411.193359375</c:v>
                </c:pt>
                <c:pt idx="235">
                  <c:v>6419.85302734375</c:v>
                </c:pt>
                <c:pt idx="236">
                  <c:v>6463.99560546875</c:v>
                </c:pt>
                <c:pt idx="237">
                  <c:v>6530.20361328125</c:v>
                </c:pt>
                <c:pt idx="238">
                  <c:v>6596.96484375</c:v>
                </c:pt>
                <c:pt idx="239">
                  <c:v>6640.908203125</c:v>
                </c:pt>
                <c:pt idx="240">
                  <c:v>6647.9501953125</c:v>
                </c:pt>
                <c:pt idx="241">
                  <c:v>6622.74853515625</c:v>
                </c:pt>
                <c:pt idx="242">
                  <c:v>6587.46484375</c:v>
                </c:pt>
                <c:pt idx="243">
                  <c:v>6567.42578125</c:v>
                </c:pt>
                <c:pt idx="244">
                  <c:v>6572.6484375</c:v>
                </c:pt>
                <c:pt idx="245">
                  <c:v>6590.080078125</c:v>
                </c:pt>
                <c:pt idx="246">
                  <c:v>6594.68310546875</c:v>
                </c:pt>
                <c:pt idx="247">
                  <c:v>6572.08251953125</c:v>
                </c:pt>
                <c:pt idx="248">
                  <c:v>6534.2041015625</c:v>
                </c:pt>
                <c:pt idx="249">
                  <c:v>6513.119140625</c:v>
                </c:pt>
                <c:pt idx="250">
                  <c:v>6535.728515625</c:v>
                </c:pt>
                <c:pt idx="251">
                  <c:v>6598.9951171875</c:v>
                </c:pt>
                <c:pt idx="252">
                  <c:v>6667.04150390625</c:v>
                </c:pt>
                <c:pt idx="253">
                  <c:v>6694.7666015625</c:v>
                </c:pt>
                <c:pt idx="254">
                  <c:v>6660.7470703125</c:v>
                </c:pt>
                <c:pt idx="255">
                  <c:v>6583.5322265625</c:v>
                </c:pt>
                <c:pt idx="256">
                  <c:v>6508.0869140625</c:v>
                </c:pt>
                <c:pt idx="257">
                  <c:v>6473.13330078125</c:v>
                </c:pt>
                <c:pt idx="258">
                  <c:v>6485.49560546875</c:v>
                </c:pt>
                <c:pt idx="259">
                  <c:v>6521.203125</c:v>
                </c:pt>
                <c:pt idx="260">
                  <c:v>6550.29931640625</c:v>
                </c:pt>
                <c:pt idx="261">
                  <c:v>6562.64013671875</c:v>
                </c:pt>
                <c:pt idx="262">
                  <c:v>6572.2490234375</c:v>
                </c:pt>
                <c:pt idx="263">
                  <c:v>6597.6611328125</c:v>
                </c:pt>
                <c:pt idx="264">
                  <c:v>6637.595703125</c:v>
                </c:pt>
                <c:pt idx="265">
                  <c:v>6665.73486328125</c:v>
                </c:pt>
                <c:pt idx="266">
                  <c:v>6651.244140625</c:v>
                </c:pt>
                <c:pt idx="267">
                  <c:v>6587.84521484375</c:v>
                </c:pt>
                <c:pt idx="268">
                  <c:v>6505.07861328125</c:v>
                </c:pt>
                <c:pt idx="269">
                  <c:v>6449.61083984375</c:v>
                </c:pt>
                <c:pt idx="270">
                  <c:v>6450.3193359375</c:v>
                </c:pt>
                <c:pt idx="271">
                  <c:v>6495.99462890625</c:v>
                </c:pt>
                <c:pt idx="272">
                  <c:v>6545.0888671875</c:v>
                </c:pt>
                <c:pt idx="273">
                  <c:v>6560.35888671875</c:v>
                </c:pt>
                <c:pt idx="274">
                  <c:v>6539.84375</c:v>
                </c:pt>
                <c:pt idx="275">
                  <c:v>6517.95654296875</c:v>
                </c:pt>
                <c:pt idx="276">
                  <c:v>6535.06103515625</c:v>
                </c:pt>
                <c:pt idx="277">
                  <c:v>6600.41162109375</c:v>
                </c:pt>
                <c:pt idx="278">
                  <c:v>6679.4931640625</c:v>
                </c:pt>
                <c:pt idx="279">
                  <c:v>6717.25830078125</c:v>
                </c:pt>
                <c:pt idx="280">
                  <c:v>6679.63232421875</c:v>
                </c:pt>
                <c:pt idx="281">
                  <c:v>6580.76708984375</c:v>
                </c:pt>
                <c:pt idx="282">
                  <c:v>6474.85986328125</c:v>
                </c:pt>
                <c:pt idx="283">
                  <c:v>6419.16748046875</c:v>
                </c:pt>
                <c:pt idx="284">
                  <c:v>6436.52587890625</c:v>
                </c:pt>
                <c:pt idx="285">
                  <c:v>6504.44287109375</c:v>
                </c:pt>
                <c:pt idx="286">
                  <c:v>6576.02490234375</c:v>
                </c:pt>
                <c:pt idx="287">
                  <c:v>6614.12109375</c:v>
                </c:pt>
                <c:pt idx="288">
                  <c:v>6612.7138671875</c:v>
                </c:pt>
                <c:pt idx="289">
                  <c:v>6592.67236328125</c:v>
                </c:pt>
                <c:pt idx="290">
                  <c:v>6579.9130859375</c:v>
                </c:pt>
                <c:pt idx="291">
                  <c:v>6585.52685546875</c:v>
                </c:pt>
                <c:pt idx="292">
                  <c:v>6602.0146484375</c:v>
                </c:pt>
                <c:pt idx="293">
                  <c:v>6614.45458984375</c:v>
                </c:pt>
                <c:pt idx="294">
                  <c:v>6614.1357421875</c:v>
                </c:pt>
                <c:pt idx="295">
                  <c:v>6603.28662109375</c:v>
                </c:pt>
                <c:pt idx="296">
                  <c:v>6589.6455078125</c:v>
                </c:pt>
                <c:pt idx="297">
                  <c:v>6578.4541015625</c:v>
                </c:pt>
                <c:pt idx="298">
                  <c:v>6569.62451171875</c:v>
                </c:pt>
                <c:pt idx="299">
                  <c:v>6561.00048828125</c:v>
                </c:pt>
                <c:pt idx="300">
                  <c:v>6552.53271484375</c:v>
                </c:pt>
                <c:pt idx="301">
                  <c:v>6546.5146484375</c:v>
                </c:pt>
                <c:pt idx="302">
                  <c:v>6544.3798828125</c:v>
                </c:pt>
                <c:pt idx="303">
                  <c:v>6544.57666015625</c:v>
                </c:pt>
                <c:pt idx="304">
                  <c:v>6544.4853515625</c:v>
                </c:pt>
                <c:pt idx="305">
                  <c:v>6544.19287109375</c:v>
                </c:pt>
                <c:pt idx="306">
                  <c:v>6547.17724609375</c:v>
                </c:pt>
                <c:pt idx="307">
                  <c:v>6556.00390625</c:v>
                </c:pt>
                <c:pt idx="308">
                  <c:v>6567.0439453125</c:v>
                </c:pt>
                <c:pt idx="309">
                  <c:v>6570.57080078125</c:v>
                </c:pt>
                <c:pt idx="310">
                  <c:v>6558.1201171875</c:v>
                </c:pt>
                <c:pt idx="311">
                  <c:v>6531.4404296875</c:v>
                </c:pt>
                <c:pt idx="312">
                  <c:v>6504.31396484375</c:v>
                </c:pt>
                <c:pt idx="313">
                  <c:v>6493.90673828125</c:v>
                </c:pt>
                <c:pt idx="314">
                  <c:v>6507.90478515625</c:v>
                </c:pt>
                <c:pt idx="315">
                  <c:v>6538.56396484375</c:v>
                </c:pt>
                <c:pt idx="316">
                  <c:v>6569.5712890625</c:v>
                </c:pt>
                <c:pt idx="317">
                  <c:v>6590.20751953125</c:v>
                </c:pt>
                <c:pt idx="318">
                  <c:v>6604.03662109375</c:v>
                </c:pt>
                <c:pt idx="319">
                  <c:v>6623.546875</c:v>
                </c:pt>
                <c:pt idx="320">
                  <c:v>6654.931640625</c:v>
                </c:pt>
                <c:pt idx="321">
                  <c:v>6687.1552734375</c:v>
                </c:pt>
                <c:pt idx="322">
                  <c:v>6696.90966796875</c:v>
                </c:pt>
                <c:pt idx="323">
                  <c:v>6667.2548828125</c:v>
                </c:pt>
                <c:pt idx="324">
                  <c:v>6604.4990234375</c:v>
                </c:pt>
                <c:pt idx="325">
                  <c:v>6537.60791015625</c:v>
                </c:pt>
                <c:pt idx="326">
                  <c:v>6498.53369140625</c:v>
                </c:pt>
                <c:pt idx="327">
                  <c:v>6498.69091796875</c:v>
                </c:pt>
                <c:pt idx="328">
                  <c:v>6521.36572265625</c:v>
                </c:pt>
                <c:pt idx="329">
                  <c:v>6537.17822265625</c:v>
                </c:pt>
                <c:pt idx="330">
                  <c:v>6530.0166015625</c:v>
                </c:pt>
                <c:pt idx="331">
                  <c:v>6511.17529296875</c:v>
                </c:pt>
                <c:pt idx="332">
                  <c:v>6508.87158203125</c:v>
                </c:pt>
                <c:pt idx="333">
                  <c:v>6541.42724609375</c:v>
                </c:pt>
                <c:pt idx="334">
                  <c:v>6597.21337890625</c:v>
                </c:pt>
                <c:pt idx="335">
                  <c:v>6639.65234375</c:v>
                </c:pt>
                <c:pt idx="336">
                  <c:v>6634.66748046875</c:v>
                </c:pt>
                <c:pt idx="337">
                  <c:v>6578.470703125</c:v>
                </c:pt>
                <c:pt idx="338">
                  <c:v>6502.4677734375</c:v>
                </c:pt>
                <c:pt idx="339">
                  <c:v>6450.6513671875</c:v>
                </c:pt>
                <c:pt idx="340">
                  <c:v>6447.67138671875</c:v>
                </c:pt>
                <c:pt idx="341">
                  <c:v>6483.38916015625</c:v>
                </c:pt>
                <c:pt idx="342">
                  <c:v>6525.63427734375</c:v>
                </c:pt>
                <c:pt idx="343">
                  <c:v>6549.14453125</c:v>
                </c:pt>
                <c:pt idx="344">
                  <c:v>6555.53173828125</c:v>
                </c:pt>
                <c:pt idx="345">
                  <c:v>6567.6669921875</c:v>
                </c:pt>
                <c:pt idx="346">
                  <c:v>6604.4951171875</c:v>
                </c:pt>
                <c:pt idx="347">
                  <c:v>6659.3173828125</c:v>
                </c:pt>
                <c:pt idx="348">
                  <c:v>6701.35888671875</c:v>
                </c:pt>
                <c:pt idx="349">
                  <c:v>6699.98779296875</c:v>
                </c:pt>
              </c:numCache>
            </c:numRef>
          </c:yVal>
          <c:smooth val="1"/>
          <c:extLst>
            <c:ext xmlns:c16="http://schemas.microsoft.com/office/drawing/2014/chart" uri="{C3380CC4-5D6E-409C-BE32-E72D297353CC}">
              <c16:uniqueId val="{00000008-0DDB-41B5-BE83-A9CFE49F3CE3}"/>
            </c:ext>
          </c:extLst>
        </c:ser>
        <c:ser>
          <c:idx val="9"/>
          <c:order val="9"/>
          <c:tx>
            <c:strRef>
              <c:f>hc_sub_007!$J$1</c:f>
              <c:strCache>
                <c:ptCount val="1"/>
                <c:pt idx="0">
                  <c:v>Coor_10</c:v>
                </c:pt>
              </c:strCache>
            </c:strRef>
          </c:tx>
          <c:spPr>
            <a:ln w="28575" cap="rnd">
              <a:solidFill>
                <a:schemeClr val="accent4">
                  <a:lumMod val="60000"/>
                </a:schemeClr>
              </a:solidFill>
              <a:round/>
            </a:ln>
            <a:effectLst/>
          </c:spPr>
          <c:marker>
            <c:symbol val="none"/>
          </c:marker>
          <c:yVal>
            <c:numRef>
              <c:f>hc_sub_007!$J$2:$J$351</c:f>
              <c:numCache>
                <c:formatCode>0.00000000000_ </c:formatCode>
                <c:ptCount val="350"/>
                <c:pt idx="0">
                  <c:v>6468.69287109375</c:v>
                </c:pt>
                <c:pt idx="1">
                  <c:v>6443.6328125</c:v>
                </c:pt>
                <c:pt idx="2">
                  <c:v>6416.69921875</c:v>
                </c:pt>
                <c:pt idx="3">
                  <c:v>6407.6083984375</c:v>
                </c:pt>
                <c:pt idx="4">
                  <c:v>6426.03369140625</c:v>
                </c:pt>
                <c:pt idx="5">
                  <c:v>6465.53857421875</c:v>
                </c:pt>
                <c:pt idx="6">
                  <c:v>6508.9052734375</c:v>
                </c:pt>
                <c:pt idx="7">
                  <c:v>6539.703125</c:v>
                </c:pt>
                <c:pt idx="8">
                  <c:v>6550.9189453125</c:v>
                </c:pt>
                <c:pt idx="9">
                  <c:v>6545.24560546875</c:v>
                </c:pt>
                <c:pt idx="10">
                  <c:v>6529.16552734375</c:v>
                </c:pt>
                <c:pt idx="11">
                  <c:v>6507.36572265625</c:v>
                </c:pt>
                <c:pt idx="12">
                  <c:v>6481.98681640625</c:v>
                </c:pt>
                <c:pt idx="13">
                  <c:v>6455.44091796875</c:v>
                </c:pt>
                <c:pt idx="14">
                  <c:v>6432.0703125</c:v>
                </c:pt>
                <c:pt idx="15">
                  <c:v>6415.875</c:v>
                </c:pt>
                <c:pt idx="16">
                  <c:v>6406.5693359375</c:v>
                </c:pt>
                <c:pt idx="17">
                  <c:v>6398.822265625</c:v>
                </c:pt>
                <c:pt idx="18">
                  <c:v>6386.75830078125</c:v>
                </c:pt>
                <c:pt idx="19">
                  <c:v>6370.203125</c:v>
                </c:pt>
                <c:pt idx="20">
                  <c:v>6356.54736328125</c:v>
                </c:pt>
                <c:pt idx="21">
                  <c:v>6355.537109375</c:v>
                </c:pt>
                <c:pt idx="22">
                  <c:v>6371.03369140625</c:v>
                </c:pt>
                <c:pt idx="23">
                  <c:v>6397.29736328125</c:v>
                </c:pt>
                <c:pt idx="24">
                  <c:v>6423.79736328125</c:v>
                </c:pt>
                <c:pt idx="25">
                  <c:v>6444.63671875</c:v>
                </c:pt>
                <c:pt idx="26">
                  <c:v>6463.74658203125</c:v>
                </c:pt>
                <c:pt idx="27">
                  <c:v>6490.20556640625</c:v>
                </c:pt>
                <c:pt idx="28">
                  <c:v>6527.14404296875</c:v>
                </c:pt>
                <c:pt idx="29">
                  <c:v>6564.53369140625</c:v>
                </c:pt>
                <c:pt idx="30">
                  <c:v>6583.8740234375</c:v>
                </c:pt>
                <c:pt idx="31">
                  <c:v>6572.4931640625</c:v>
                </c:pt>
                <c:pt idx="32">
                  <c:v>6535.6689453125</c:v>
                </c:pt>
                <c:pt idx="33">
                  <c:v>6495.07421875</c:v>
                </c:pt>
                <c:pt idx="34">
                  <c:v>6472.98486328125</c:v>
                </c:pt>
                <c:pt idx="35">
                  <c:v>6474.41162109375</c:v>
                </c:pt>
                <c:pt idx="36">
                  <c:v>6482.529296875</c:v>
                </c:pt>
                <c:pt idx="37">
                  <c:v>6472.6767578125</c:v>
                </c:pt>
                <c:pt idx="38">
                  <c:v>6434.54296875</c:v>
                </c:pt>
                <c:pt idx="39">
                  <c:v>6384.14501953125</c:v>
                </c:pt>
                <c:pt idx="40">
                  <c:v>6354.37353515625</c:v>
                </c:pt>
                <c:pt idx="41">
                  <c:v>6370.109375</c:v>
                </c:pt>
                <c:pt idx="42">
                  <c:v>6427.18359375</c:v>
                </c:pt>
                <c:pt idx="43">
                  <c:v>6492.486328125</c:v>
                </c:pt>
                <c:pt idx="44">
                  <c:v>6526.31005859375</c:v>
                </c:pt>
                <c:pt idx="45">
                  <c:v>6510.41455078125</c:v>
                </c:pt>
                <c:pt idx="46">
                  <c:v>6460.546875</c:v>
                </c:pt>
                <c:pt idx="47">
                  <c:v>6414.11962890625</c:v>
                </c:pt>
                <c:pt idx="48">
                  <c:v>6402.76806640625</c:v>
                </c:pt>
                <c:pt idx="49">
                  <c:v>6430.5166015625</c:v>
                </c:pt>
                <c:pt idx="50">
                  <c:v>6472.97998046875</c:v>
                </c:pt>
                <c:pt idx="51">
                  <c:v>6496.44873046875</c:v>
                </c:pt>
                <c:pt idx="52">
                  <c:v>6481.359375</c:v>
                </c:pt>
                <c:pt idx="53">
                  <c:v>6433.33203125</c:v>
                </c:pt>
                <c:pt idx="54">
                  <c:v>6376.25048828125</c:v>
                </c:pt>
                <c:pt idx="55">
                  <c:v>6335.48291015625</c:v>
                </c:pt>
                <c:pt idx="56">
                  <c:v>6324.57568359375</c:v>
                </c:pt>
                <c:pt idx="57">
                  <c:v>6342.927734375</c:v>
                </c:pt>
                <c:pt idx="58">
                  <c:v>6381.8291015625</c:v>
                </c:pt>
                <c:pt idx="59">
                  <c:v>6430.9599609375</c:v>
                </c:pt>
                <c:pt idx="60">
                  <c:v>6480.3720703125</c:v>
                </c:pt>
                <c:pt idx="61">
                  <c:v>6519.6552734375</c:v>
                </c:pt>
                <c:pt idx="62">
                  <c:v>6539.18310546875</c:v>
                </c:pt>
                <c:pt idx="63">
                  <c:v>6535.0791015625</c:v>
                </c:pt>
                <c:pt idx="64">
                  <c:v>6513.86669921875</c:v>
                </c:pt>
                <c:pt idx="65">
                  <c:v>6491.01025390625</c:v>
                </c:pt>
                <c:pt idx="66">
                  <c:v>6482.22607421875</c:v>
                </c:pt>
                <c:pt idx="67">
                  <c:v>6493.31396484375</c:v>
                </c:pt>
                <c:pt idx="68">
                  <c:v>6516.5947265625</c:v>
                </c:pt>
                <c:pt idx="69">
                  <c:v>6537.08056640625</c:v>
                </c:pt>
                <c:pt idx="70">
                  <c:v>6543.36474609375</c:v>
                </c:pt>
                <c:pt idx="71">
                  <c:v>6534.26806640625</c:v>
                </c:pt>
                <c:pt idx="72">
                  <c:v>6516.3076171875</c:v>
                </c:pt>
                <c:pt idx="73">
                  <c:v>6495.427734375</c:v>
                </c:pt>
                <c:pt idx="74">
                  <c:v>6471.5068359375</c:v>
                </c:pt>
                <c:pt idx="75">
                  <c:v>6441.12158203125</c:v>
                </c:pt>
                <c:pt idx="76">
                  <c:v>6405.63525390625</c:v>
                </c:pt>
                <c:pt idx="77">
                  <c:v>6375.826171875</c:v>
                </c:pt>
                <c:pt idx="78">
                  <c:v>6366.77734375</c:v>
                </c:pt>
                <c:pt idx="79">
                  <c:v>6385.79931640625</c:v>
                </c:pt>
                <c:pt idx="80">
                  <c:v>6423.65478515625</c:v>
                </c:pt>
                <c:pt idx="81">
                  <c:v>6457.9931640625</c:v>
                </c:pt>
                <c:pt idx="82">
                  <c:v>6468.18896484375</c:v>
                </c:pt>
                <c:pt idx="83">
                  <c:v>6450.689453125</c:v>
                </c:pt>
                <c:pt idx="84">
                  <c:v>6422.43896484375</c:v>
                </c:pt>
                <c:pt idx="85">
                  <c:v>6408.81494140625</c:v>
                </c:pt>
                <c:pt idx="86">
                  <c:v>6424.7412109375</c:v>
                </c:pt>
                <c:pt idx="87">
                  <c:v>6463.189453125</c:v>
                </c:pt>
                <c:pt idx="88">
                  <c:v>6499.61474609375</c:v>
                </c:pt>
                <c:pt idx="89">
                  <c:v>6508.63720703125</c:v>
                </c:pt>
                <c:pt idx="90">
                  <c:v>6480.46142578125</c:v>
                </c:pt>
                <c:pt idx="91">
                  <c:v>6425.783203125</c:v>
                </c:pt>
                <c:pt idx="92">
                  <c:v>6367.51904296875</c:v>
                </c:pt>
                <c:pt idx="93">
                  <c:v>6327.22412109375</c:v>
                </c:pt>
                <c:pt idx="94">
                  <c:v>6316.14306640625</c:v>
                </c:pt>
                <c:pt idx="95">
                  <c:v>6334.9345703125</c:v>
                </c:pt>
                <c:pt idx="96">
                  <c:v>6378.38525390625</c:v>
                </c:pt>
                <c:pt idx="97">
                  <c:v>6438.7509765625</c:v>
                </c:pt>
                <c:pt idx="98">
                  <c:v>6505.1796875</c:v>
                </c:pt>
                <c:pt idx="99">
                  <c:v>6562.4306640625</c:v>
                </c:pt>
                <c:pt idx="100">
                  <c:v>6593.7373046875</c:v>
                </c:pt>
                <c:pt idx="101">
                  <c:v>6588.57958984375</c:v>
                </c:pt>
                <c:pt idx="102">
                  <c:v>6550.3173828125</c:v>
                </c:pt>
                <c:pt idx="103">
                  <c:v>6496.9345703125</c:v>
                </c:pt>
                <c:pt idx="104">
                  <c:v>6452.5732421875</c:v>
                </c:pt>
                <c:pt idx="105">
                  <c:v>6434.58837890625</c:v>
                </c:pt>
                <c:pt idx="106">
                  <c:v>6444.58984375</c:v>
                </c:pt>
                <c:pt idx="107">
                  <c:v>6469.2265625</c:v>
                </c:pt>
                <c:pt idx="108">
                  <c:v>6489.646484375</c:v>
                </c:pt>
                <c:pt idx="109">
                  <c:v>6493.009765625</c:v>
                </c:pt>
                <c:pt idx="110">
                  <c:v>6479.01123046875</c:v>
                </c:pt>
                <c:pt idx="111">
                  <c:v>6458.52294921875</c:v>
                </c:pt>
                <c:pt idx="112">
                  <c:v>6446.42431640625</c:v>
                </c:pt>
                <c:pt idx="113">
                  <c:v>6453.10693359375</c:v>
                </c:pt>
                <c:pt idx="114">
                  <c:v>6478.607421875</c:v>
                </c:pt>
                <c:pt idx="115">
                  <c:v>6511.52783203125</c:v>
                </c:pt>
                <c:pt idx="116">
                  <c:v>6533.3623046875</c:v>
                </c:pt>
                <c:pt idx="117">
                  <c:v>6527.2578125</c:v>
                </c:pt>
                <c:pt idx="118">
                  <c:v>6487.943359375</c:v>
                </c:pt>
                <c:pt idx="119">
                  <c:v>6427.36376953125</c:v>
                </c:pt>
                <c:pt idx="120">
                  <c:v>6371.056640625</c:v>
                </c:pt>
                <c:pt idx="121">
                  <c:v>6345.05029296875</c:v>
                </c:pt>
                <c:pt idx="122">
                  <c:v>6360.04736328125</c:v>
                </c:pt>
                <c:pt idx="123">
                  <c:v>6403.4892578125</c:v>
                </c:pt>
                <c:pt idx="124">
                  <c:v>6446.4169921875</c:v>
                </c:pt>
                <c:pt idx="125">
                  <c:v>6462.00390625</c:v>
                </c:pt>
                <c:pt idx="126">
                  <c:v>6443.37060546875</c:v>
                </c:pt>
                <c:pt idx="127">
                  <c:v>6407.62255859375</c:v>
                </c:pt>
                <c:pt idx="128">
                  <c:v>6382.68798828125</c:v>
                </c:pt>
                <c:pt idx="129">
                  <c:v>6386.6025390625</c:v>
                </c:pt>
                <c:pt idx="130">
                  <c:v>6414.986328125</c:v>
                </c:pt>
                <c:pt idx="131">
                  <c:v>6446.158203125</c:v>
                </c:pt>
                <c:pt idx="132">
                  <c:v>6459.34326171875</c:v>
                </c:pt>
                <c:pt idx="133">
                  <c:v>6451.0419921875</c:v>
                </c:pt>
                <c:pt idx="134">
                  <c:v>6436.50390625</c:v>
                </c:pt>
                <c:pt idx="135">
                  <c:v>6435.833984375</c:v>
                </c:pt>
                <c:pt idx="136">
                  <c:v>6456.92724609375</c:v>
                </c:pt>
                <c:pt idx="137">
                  <c:v>6489.529296875</c:v>
                </c:pt>
                <c:pt idx="138">
                  <c:v>6514.70166015625</c:v>
                </c:pt>
                <c:pt idx="139">
                  <c:v>6520.70947265625</c:v>
                </c:pt>
                <c:pt idx="140">
                  <c:v>6511.408203125</c:v>
                </c:pt>
                <c:pt idx="141">
                  <c:v>6500.5888671875</c:v>
                </c:pt>
                <c:pt idx="142">
                  <c:v>6498.4580078125</c:v>
                </c:pt>
                <c:pt idx="143">
                  <c:v>6502.99609375</c:v>
                </c:pt>
                <c:pt idx="144">
                  <c:v>6503.625</c:v>
                </c:pt>
                <c:pt idx="145">
                  <c:v>6492.7275390625</c:v>
                </c:pt>
                <c:pt idx="146">
                  <c:v>6473.322265625</c:v>
                </c:pt>
                <c:pt idx="147">
                  <c:v>6455.4130859375</c:v>
                </c:pt>
                <c:pt idx="148">
                  <c:v>6445.02490234375</c:v>
                </c:pt>
                <c:pt idx="149">
                  <c:v>6437.5634765625</c:v>
                </c:pt>
                <c:pt idx="150">
                  <c:v>6423.1748046875</c:v>
                </c:pt>
                <c:pt idx="151">
                  <c:v>6399.578125</c:v>
                </c:pt>
                <c:pt idx="152">
                  <c:v>6379.18798828125</c:v>
                </c:pt>
                <c:pt idx="153">
                  <c:v>6381.30029296875</c:v>
                </c:pt>
                <c:pt idx="154">
                  <c:v>6414.12744140625</c:v>
                </c:pt>
                <c:pt idx="155">
                  <c:v>6462.79931640625</c:v>
                </c:pt>
                <c:pt idx="156">
                  <c:v>6496.54248046875</c:v>
                </c:pt>
                <c:pt idx="157">
                  <c:v>6492.10986328125</c:v>
                </c:pt>
                <c:pt idx="158">
                  <c:v>6454.76220703125</c:v>
                </c:pt>
                <c:pt idx="159">
                  <c:v>6417.6337890625</c:v>
                </c:pt>
                <c:pt idx="160">
                  <c:v>6417.23095703125</c:v>
                </c:pt>
                <c:pt idx="161">
                  <c:v>6463.61376953125</c:v>
                </c:pt>
                <c:pt idx="162">
                  <c:v>6530.1630859375</c:v>
                </c:pt>
                <c:pt idx="163">
                  <c:v>6572.8798828125</c:v>
                </c:pt>
                <c:pt idx="164">
                  <c:v>6564.5712890625</c:v>
                </c:pt>
                <c:pt idx="165">
                  <c:v>6515.9189453125</c:v>
                </c:pt>
                <c:pt idx="166">
                  <c:v>6465.56884765625</c:v>
                </c:pt>
                <c:pt idx="167">
                  <c:v>6447.24951171875</c:v>
                </c:pt>
                <c:pt idx="168">
                  <c:v>6461.69140625</c:v>
                </c:pt>
                <c:pt idx="169">
                  <c:v>6477.44921875</c:v>
                </c:pt>
                <c:pt idx="170">
                  <c:v>6460.10986328125</c:v>
                </c:pt>
                <c:pt idx="171">
                  <c:v>6404.6689453125</c:v>
                </c:pt>
                <c:pt idx="172">
                  <c:v>6342.58154296875</c:v>
                </c:pt>
                <c:pt idx="173">
                  <c:v>6316.5166015625</c:v>
                </c:pt>
                <c:pt idx="174">
                  <c:v>6343.97412109375</c:v>
                </c:pt>
                <c:pt idx="175">
                  <c:v>6401.275390625</c:v>
                </c:pt>
                <c:pt idx="176">
                  <c:v>6442.5693359375</c:v>
                </c:pt>
                <c:pt idx="177">
                  <c:v>6438.4814453125</c:v>
                </c:pt>
                <c:pt idx="178">
                  <c:v>6401.65771484375</c:v>
                </c:pt>
                <c:pt idx="179">
                  <c:v>6376.95361328125</c:v>
                </c:pt>
                <c:pt idx="180">
                  <c:v>6403.8134765625</c:v>
                </c:pt>
                <c:pt idx="181">
                  <c:v>6482.07568359375</c:v>
                </c:pt>
                <c:pt idx="182">
                  <c:v>6569.80078125</c:v>
                </c:pt>
                <c:pt idx="183">
                  <c:v>6614.91357421875</c:v>
                </c:pt>
                <c:pt idx="184">
                  <c:v>6594.4443359375</c:v>
                </c:pt>
                <c:pt idx="185">
                  <c:v>6529.5439453125</c:v>
                </c:pt>
                <c:pt idx="186">
                  <c:v>6465.57177734375</c:v>
                </c:pt>
                <c:pt idx="187">
                  <c:v>6435.7470703125</c:v>
                </c:pt>
                <c:pt idx="188">
                  <c:v>6439.09423828125</c:v>
                </c:pt>
                <c:pt idx="189">
                  <c:v>6449.107421875</c:v>
                </c:pt>
                <c:pt idx="190">
                  <c:v>6442.1904296875</c:v>
                </c:pt>
                <c:pt idx="191">
                  <c:v>6418.91357421875</c:v>
                </c:pt>
                <c:pt idx="192">
                  <c:v>6399.89501953125</c:v>
                </c:pt>
                <c:pt idx="193">
                  <c:v>6402.62451171875</c:v>
                </c:pt>
                <c:pt idx="194">
                  <c:v>6422.95458984375</c:v>
                </c:pt>
                <c:pt idx="195">
                  <c:v>6439.548828125</c:v>
                </c:pt>
                <c:pt idx="196">
                  <c:v>6436.79052734375</c:v>
                </c:pt>
                <c:pt idx="197">
                  <c:v>6423.12158203125</c:v>
                </c:pt>
                <c:pt idx="198">
                  <c:v>6425.27392578125</c:v>
                </c:pt>
                <c:pt idx="199">
                  <c:v>6461.7197265625</c:v>
                </c:pt>
                <c:pt idx="200">
                  <c:v>6519.845703125</c:v>
                </c:pt>
                <c:pt idx="201">
                  <c:v>6560.4384765625</c:v>
                </c:pt>
                <c:pt idx="202">
                  <c:v>6549.326171875</c:v>
                </c:pt>
                <c:pt idx="203">
                  <c:v>6490.07177734375</c:v>
                </c:pt>
                <c:pt idx="204">
                  <c:v>6427.4677734375</c:v>
                </c:pt>
                <c:pt idx="205">
                  <c:v>6414.81982421875</c:v>
                </c:pt>
                <c:pt idx="206">
                  <c:v>6469.73388671875</c:v>
                </c:pt>
                <c:pt idx="207">
                  <c:v>6555.49658203125</c:v>
                </c:pt>
                <c:pt idx="208">
                  <c:v>6606.00390625</c:v>
                </c:pt>
                <c:pt idx="209">
                  <c:v>6576.33935546875</c:v>
                </c:pt>
                <c:pt idx="210">
                  <c:v>6478.68017578125</c:v>
                </c:pt>
                <c:pt idx="211">
                  <c:v>6373.94140625</c:v>
                </c:pt>
                <c:pt idx="212">
                  <c:v>6325.31494140625</c:v>
                </c:pt>
                <c:pt idx="213">
                  <c:v>6351.0771484375</c:v>
                </c:pt>
                <c:pt idx="214">
                  <c:v>6414.4208984375</c:v>
                </c:pt>
                <c:pt idx="215">
                  <c:v>6457.2099609375</c:v>
                </c:pt>
                <c:pt idx="216">
                  <c:v>6448.34716796875</c:v>
                </c:pt>
                <c:pt idx="217">
                  <c:v>6406.31640625</c:v>
                </c:pt>
                <c:pt idx="218">
                  <c:v>6378.34619140625</c:v>
                </c:pt>
                <c:pt idx="219">
                  <c:v>6395.83984375</c:v>
                </c:pt>
                <c:pt idx="220">
                  <c:v>6445.38623046875</c:v>
                </c:pt>
                <c:pt idx="221">
                  <c:v>6480.4716796875</c:v>
                </c:pt>
                <c:pt idx="222">
                  <c:v>6463.45068359375</c:v>
                </c:pt>
                <c:pt idx="223">
                  <c:v>6401.03369140625</c:v>
                </c:pt>
                <c:pt idx="224">
                  <c:v>6342.00146484375</c:v>
                </c:pt>
                <c:pt idx="225">
                  <c:v>6338.12451171875</c:v>
                </c:pt>
                <c:pt idx="226">
                  <c:v>6400.830078125</c:v>
                </c:pt>
                <c:pt idx="227">
                  <c:v>6490.140625</c:v>
                </c:pt>
                <c:pt idx="228">
                  <c:v>6545.6025390625</c:v>
                </c:pt>
                <c:pt idx="229">
                  <c:v>6534.03662109375</c:v>
                </c:pt>
                <c:pt idx="230">
                  <c:v>6475.17333984375</c:v>
                </c:pt>
                <c:pt idx="231">
                  <c:v>6424.70263671875</c:v>
                </c:pt>
                <c:pt idx="232">
                  <c:v>6429.1689453125</c:v>
                </c:pt>
                <c:pt idx="233">
                  <c:v>6489.455078125</c:v>
                </c:pt>
                <c:pt idx="234">
                  <c:v>6561.5107421875</c:v>
                </c:pt>
                <c:pt idx="235">
                  <c:v>6592.18798828125</c:v>
                </c:pt>
                <c:pt idx="236">
                  <c:v>6560.3125</c:v>
                </c:pt>
                <c:pt idx="237">
                  <c:v>6490.65380859375</c:v>
                </c:pt>
                <c:pt idx="238">
                  <c:v>6431.78662109375</c:v>
                </c:pt>
                <c:pt idx="239">
                  <c:v>6417.8017578125</c:v>
                </c:pt>
                <c:pt idx="240">
                  <c:v>6444.8681640625</c:v>
                </c:pt>
                <c:pt idx="241">
                  <c:v>6479.3857421875</c:v>
                </c:pt>
                <c:pt idx="242">
                  <c:v>6488.16455078125</c:v>
                </c:pt>
                <c:pt idx="243">
                  <c:v>6464.68359375</c:v>
                </c:pt>
                <c:pt idx="244">
                  <c:v>6431.1103515625</c:v>
                </c:pt>
                <c:pt idx="245">
                  <c:v>6416.962890625</c:v>
                </c:pt>
                <c:pt idx="246">
                  <c:v>6433.748046875</c:v>
                </c:pt>
                <c:pt idx="247">
                  <c:v>6466.2890625</c:v>
                </c:pt>
                <c:pt idx="248">
                  <c:v>6486.3583984375</c:v>
                </c:pt>
                <c:pt idx="249">
                  <c:v>6476.1796875</c:v>
                </c:pt>
                <c:pt idx="250">
                  <c:v>6442.728515625</c:v>
                </c:pt>
                <c:pt idx="251">
                  <c:v>6412.375</c:v>
                </c:pt>
                <c:pt idx="252">
                  <c:v>6411.044921875</c:v>
                </c:pt>
                <c:pt idx="253">
                  <c:v>6445.17919921875</c:v>
                </c:pt>
                <c:pt idx="254">
                  <c:v>6496.7626953125</c:v>
                </c:pt>
                <c:pt idx="255">
                  <c:v>6534.71875</c:v>
                </c:pt>
                <c:pt idx="256">
                  <c:v>6534.02490234375</c:v>
                </c:pt>
                <c:pt idx="257">
                  <c:v>6490.16357421875</c:v>
                </c:pt>
                <c:pt idx="258">
                  <c:v>6420.9765625</c:v>
                </c:pt>
                <c:pt idx="259">
                  <c:v>6356.24072265625</c:v>
                </c:pt>
                <c:pt idx="260">
                  <c:v>6321.88525390625</c:v>
                </c:pt>
                <c:pt idx="261">
                  <c:v>6327.6884765625</c:v>
                </c:pt>
                <c:pt idx="262">
                  <c:v>6364.54541015625</c:v>
                </c:pt>
                <c:pt idx="263">
                  <c:v>6411.888671875</c:v>
                </c:pt>
                <c:pt idx="264">
                  <c:v>6450.28076171875</c:v>
                </c:pt>
                <c:pt idx="265">
                  <c:v>6471.3427734375</c:v>
                </c:pt>
                <c:pt idx="266">
                  <c:v>6478.9658203125</c:v>
                </c:pt>
                <c:pt idx="267">
                  <c:v>6481.75732421875</c:v>
                </c:pt>
                <c:pt idx="268">
                  <c:v>6483.21484375</c:v>
                </c:pt>
                <c:pt idx="269">
                  <c:v>6478.20556640625</c:v>
                </c:pt>
                <c:pt idx="270">
                  <c:v>6459.4140625</c:v>
                </c:pt>
                <c:pt idx="271">
                  <c:v>6428.56689453125</c:v>
                </c:pt>
                <c:pt idx="272">
                  <c:v>6401.716796875</c:v>
                </c:pt>
                <c:pt idx="273">
                  <c:v>6401.31201171875</c:v>
                </c:pt>
                <c:pt idx="274">
                  <c:v>6438.79248046875</c:v>
                </c:pt>
                <c:pt idx="275">
                  <c:v>6501.27197265625</c:v>
                </c:pt>
                <c:pt idx="276">
                  <c:v>6555.28271484375</c:v>
                </c:pt>
                <c:pt idx="277">
                  <c:v>6568.146484375</c:v>
                </c:pt>
                <c:pt idx="278">
                  <c:v>6532.4091796875</c:v>
                </c:pt>
                <c:pt idx="279">
                  <c:v>6473.8837890625</c:v>
                </c:pt>
                <c:pt idx="280">
                  <c:v>6434.85693359375</c:v>
                </c:pt>
                <c:pt idx="281">
                  <c:v>6443.4775390625</c:v>
                </c:pt>
                <c:pt idx="282">
                  <c:v>6492.54541015625</c:v>
                </c:pt>
                <c:pt idx="283">
                  <c:v>6544.8466796875</c:v>
                </c:pt>
                <c:pt idx="284">
                  <c:v>6561.56591796875</c:v>
                </c:pt>
                <c:pt idx="285">
                  <c:v>6531.505859375</c:v>
                </c:pt>
                <c:pt idx="286">
                  <c:v>6477.7626953125</c:v>
                </c:pt>
                <c:pt idx="287">
                  <c:v>6436.75439453125</c:v>
                </c:pt>
                <c:pt idx="288">
                  <c:v>6427.42822265625</c:v>
                </c:pt>
                <c:pt idx="289">
                  <c:v>6436.7333984375</c:v>
                </c:pt>
                <c:pt idx="290">
                  <c:v>6433.70458984375</c:v>
                </c:pt>
                <c:pt idx="291">
                  <c:v>6399.9296875</c:v>
                </c:pt>
                <c:pt idx="292">
                  <c:v>6349.6591796875</c:v>
                </c:pt>
                <c:pt idx="293">
                  <c:v>6321.08984375</c:v>
                </c:pt>
                <c:pt idx="294">
                  <c:v>6344.8994140625</c:v>
                </c:pt>
                <c:pt idx="295">
                  <c:v>6416.17529296875</c:v>
                </c:pt>
                <c:pt idx="296">
                  <c:v>6494.07080078125</c:v>
                </c:pt>
                <c:pt idx="297">
                  <c:v>6530.8740234375</c:v>
                </c:pt>
                <c:pt idx="298">
                  <c:v>6507.54736328125</c:v>
                </c:pt>
                <c:pt idx="299">
                  <c:v>6447.12158203125</c:v>
                </c:pt>
                <c:pt idx="300">
                  <c:v>6395.4716796875</c:v>
                </c:pt>
                <c:pt idx="301">
                  <c:v>6385.78369140625</c:v>
                </c:pt>
                <c:pt idx="302">
                  <c:v>6415.79345703125</c:v>
                </c:pt>
                <c:pt idx="303">
                  <c:v>6455.15185546875</c:v>
                </c:pt>
                <c:pt idx="304">
                  <c:v>6474.427734375</c:v>
                </c:pt>
                <c:pt idx="305">
                  <c:v>6469.61376953125</c:v>
                </c:pt>
                <c:pt idx="306">
                  <c:v>6461.376953125</c:v>
                </c:pt>
                <c:pt idx="307">
                  <c:v>6471.43408203125</c:v>
                </c:pt>
                <c:pt idx="308">
                  <c:v>6498.76611328125</c:v>
                </c:pt>
                <c:pt idx="309">
                  <c:v>6518.09619140625</c:v>
                </c:pt>
                <c:pt idx="310">
                  <c:v>6502.64208984375</c:v>
                </c:pt>
                <c:pt idx="311">
                  <c:v>6450.869140625</c:v>
                </c:pt>
                <c:pt idx="312">
                  <c:v>6392.630859375</c:v>
                </c:pt>
                <c:pt idx="313">
                  <c:v>6367.77880859375</c:v>
                </c:pt>
                <c:pt idx="314">
                  <c:v>6394.548828125</c:v>
                </c:pt>
                <c:pt idx="315">
                  <c:v>6454.568359375</c:v>
                </c:pt>
                <c:pt idx="316">
                  <c:v>6507.5732421875</c:v>
                </c:pt>
                <c:pt idx="317">
                  <c:v>6523.61962890625</c:v>
                </c:pt>
                <c:pt idx="318">
                  <c:v>6505.64697265625</c:v>
                </c:pt>
                <c:pt idx="319">
                  <c:v>6483.61474609375</c:v>
                </c:pt>
                <c:pt idx="320">
                  <c:v>6485.89697265625</c:v>
                </c:pt>
                <c:pt idx="321">
                  <c:v>6513.07568359375</c:v>
                </c:pt>
                <c:pt idx="322">
                  <c:v>6536.9765625</c:v>
                </c:pt>
                <c:pt idx="323">
                  <c:v>6525.83447265625</c:v>
                </c:pt>
                <c:pt idx="324">
                  <c:v>6473.83251953125</c:v>
                </c:pt>
                <c:pt idx="325">
                  <c:v>6409.32421875</c:v>
                </c:pt>
                <c:pt idx="326">
                  <c:v>6374.07275390625</c:v>
                </c:pt>
                <c:pt idx="327">
                  <c:v>6390.3369140625</c:v>
                </c:pt>
                <c:pt idx="328">
                  <c:v>6442.81396484375</c:v>
                </c:pt>
                <c:pt idx="329">
                  <c:v>6490.072265625</c:v>
                </c:pt>
                <c:pt idx="330">
                  <c:v>6495.92724609375</c:v>
                </c:pt>
                <c:pt idx="331">
                  <c:v>6455.6337890625</c:v>
                </c:pt>
                <c:pt idx="332">
                  <c:v>6397.1318359375</c:v>
                </c:pt>
                <c:pt idx="333">
                  <c:v>6358.42138671875</c:v>
                </c:pt>
                <c:pt idx="334">
                  <c:v>6360.5126953125</c:v>
                </c:pt>
                <c:pt idx="335">
                  <c:v>6396.6064453125</c:v>
                </c:pt>
                <c:pt idx="336">
                  <c:v>6442.81494140625</c:v>
                </c:pt>
                <c:pt idx="337">
                  <c:v>6478.0771484375</c:v>
                </c:pt>
                <c:pt idx="338">
                  <c:v>6495.849609375</c:v>
                </c:pt>
                <c:pt idx="339">
                  <c:v>6500.40625</c:v>
                </c:pt>
                <c:pt idx="340">
                  <c:v>6495.45751953125</c:v>
                </c:pt>
                <c:pt idx="341">
                  <c:v>6478.5693359375</c:v>
                </c:pt>
                <c:pt idx="342">
                  <c:v>6447.1279296875</c:v>
                </c:pt>
                <c:pt idx="343">
                  <c:v>6408.669921875</c:v>
                </c:pt>
                <c:pt idx="344">
                  <c:v>6382.95068359375</c:v>
                </c:pt>
                <c:pt idx="345">
                  <c:v>6390.521484375</c:v>
                </c:pt>
                <c:pt idx="346">
                  <c:v>6435.86669921875</c:v>
                </c:pt>
                <c:pt idx="347">
                  <c:v>6499.85205078125</c:v>
                </c:pt>
                <c:pt idx="348">
                  <c:v>6549.69970703125</c:v>
                </c:pt>
                <c:pt idx="349">
                  <c:v>6560.24462890625</c:v>
                </c:pt>
              </c:numCache>
            </c:numRef>
          </c:yVal>
          <c:smooth val="1"/>
          <c:extLst>
            <c:ext xmlns:c16="http://schemas.microsoft.com/office/drawing/2014/chart" uri="{C3380CC4-5D6E-409C-BE32-E72D297353CC}">
              <c16:uniqueId val="{00000009-0DDB-41B5-BE83-A9CFE49F3CE3}"/>
            </c:ext>
          </c:extLst>
        </c:ser>
        <c:ser>
          <c:idx val="10"/>
          <c:order val="10"/>
          <c:tx>
            <c:strRef>
              <c:f>hc_sub_007!$K$1</c:f>
              <c:strCache>
                <c:ptCount val="1"/>
                <c:pt idx="0">
                  <c:v>Coor_11</c:v>
                </c:pt>
              </c:strCache>
            </c:strRef>
          </c:tx>
          <c:spPr>
            <a:ln w="28575" cap="rnd">
              <a:solidFill>
                <a:schemeClr val="accent5">
                  <a:lumMod val="60000"/>
                </a:schemeClr>
              </a:solidFill>
              <a:round/>
            </a:ln>
            <a:effectLst/>
          </c:spPr>
          <c:marker>
            <c:symbol val="none"/>
          </c:marker>
          <c:yVal>
            <c:numRef>
              <c:f>hc_sub_007!$K$2:$K$351</c:f>
              <c:numCache>
                <c:formatCode>0.00000000000_ </c:formatCode>
                <c:ptCount val="350"/>
                <c:pt idx="0">
                  <c:v>4333.43310546875</c:v>
                </c:pt>
                <c:pt idx="1">
                  <c:v>4331.240234375</c:v>
                </c:pt>
                <c:pt idx="2">
                  <c:v>4356.25927734375</c:v>
                </c:pt>
                <c:pt idx="3">
                  <c:v>4401.94091796875</c:v>
                </c:pt>
                <c:pt idx="4">
                  <c:v>4447.44677734375</c:v>
                </c:pt>
                <c:pt idx="5">
                  <c:v>4468.77099609375</c:v>
                </c:pt>
                <c:pt idx="6">
                  <c:v>4453.7744140625</c:v>
                </c:pt>
                <c:pt idx="7">
                  <c:v>4410.83154296875</c:v>
                </c:pt>
                <c:pt idx="8">
                  <c:v>4364.533203125</c:v>
                </c:pt>
                <c:pt idx="9">
                  <c:v>4340.8046875</c:v>
                </c:pt>
                <c:pt idx="10">
                  <c:v>4351.34033203125</c:v>
                </c:pt>
                <c:pt idx="11">
                  <c:v>4387.6728515625</c:v>
                </c:pt>
                <c:pt idx="12">
                  <c:v>4428.244140625</c:v>
                </c:pt>
                <c:pt idx="13">
                  <c:v>4452.77001953125</c:v>
                </c:pt>
                <c:pt idx="14">
                  <c:v>4453.716796875</c:v>
                </c:pt>
                <c:pt idx="15">
                  <c:v>4437.802734375</c:v>
                </c:pt>
                <c:pt idx="16">
                  <c:v>4418.19580078125</c:v>
                </c:pt>
                <c:pt idx="17">
                  <c:v>4404.4306640625</c:v>
                </c:pt>
                <c:pt idx="18">
                  <c:v>4397.51806640625</c:v>
                </c:pt>
                <c:pt idx="19">
                  <c:v>4392.69384765625</c:v>
                </c:pt>
                <c:pt idx="20">
                  <c:v>4386.185546875</c:v>
                </c:pt>
                <c:pt idx="21">
                  <c:v>4379.89892578125</c:v>
                </c:pt>
                <c:pt idx="22">
                  <c:v>4380.38916015625</c:v>
                </c:pt>
                <c:pt idx="23">
                  <c:v>4393.30517578125</c:v>
                </c:pt>
                <c:pt idx="24">
                  <c:v>4417.81201171875</c:v>
                </c:pt>
                <c:pt idx="25">
                  <c:v>4445.14697265625</c:v>
                </c:pt>
                <c:pt idx="26">
                  <c:v>4462.31201171875</c:v>
                </c:pt>
                <c:pt idx="27">
                  <c:v>4458.56201171875</c:v>
                </c:pt>
                <c:pt idx="28">
                  <c:v>4431.01513671875</c:v>
                </c:pt>
                <c:pt idx="29">
                  <c:v>4386.5908203125</c:v>
                </c:pt>
                <c:pt idx="30">
                  <c:v>4339.57666015625</c:v>
                </c:pt>
                <c:pt idx="31">
                  <c:v>4306.02783203125</c:v>
                </c:pt>
                <c:pt idx="32">
                  <c:v>4297.35400390625</c:v>
                </c:pt>
                <c:pt idx="33">
                  <c:v>4315.7412109375</c:v>
                </c:pt>
                <c:pt idx="34">
                  <c:v>4353.4267578125</c:v>
                </c:pt>
                <c:pt idx="35">
                  <c:v>4396.31494140625</c:v>
                </c:pt>
                <c:pt idx="36">
                  <c:v>4430.3310546875</c:v>
                </c:pt>
                <c:pt idx="37">
                  <c:v>4447.33056640625</c:v>
                </c:pt>
                <c:pt idx="38">
                  <c:v>4447.49365234375</c:v>
                </c:pt>
                <c:pt idx="39">
                  <c:v>4437.19140625</c:v>
                </c:pt>
                <c:pt idx="40">
                  <c:v>4424.0615234375</c:v>
                </c:pt>
                <c:pt idx="41">
                  <c:v>4412.6171875</c:v>
                </c:pt>
                <c:pt idx="42">
                  <c:v>4402.9658203125</c:v>
                </c:pt>
                <c:pt idx="43">
                  <c:v>4392.7744140625</c:v>
                </c:pt>
                <c:pt idx="44">
                  <c:v>4380.4404296875</c:v>
                </c:pt>
                <c:pt idx="45">
                  <c:v>4367.07080078125</c:v>
                </c:pt>
                <c:pt idx="46">
                  <c:v>4356.2998046875</c:v>
                </c:pt>
                <c:pt idx="47">
                  <c:v>4352.67138671875</c:v>
                </c:pt>
                <c:pt idx="48">
                  <c:v>4359.84130859375</c:v>
                </c:pt>
                <c:pt idx="49">
                  <c:v>4379.1640625</c:v>
                </c:pt>
                <c:pt idx="50">
                  <c:v>4408.47265625</c:v>
                </c:pt>
                <c:pt idx="51">
                  <c:v>4441.1845703125</c:v>
                </c:pt>
                <c:pt idx="52">
                  <c:v>4466.8154296875</c:v>
                </c:pt>
                <c:pt idx="53">
                  <c:v>4474.1767578125</c:v>
                </c:pt>
                <c:pt idx="54">
                  <c:v>4456.900390625</c:v>
                </c:pt>
                <c:pt idx="55">
                  <c:v>4418.45556640625</c:v>
                </c:pt>
                <c:pt idx="56">
                  <c:v>4372.7685546875</c:v>
                </c:pt>
                <c:pt idx="57">
                  <c:v>4338.65625</c:v>
                </c:pt>
                <c:pt idx="58">
                  <c:v>4330.50634765625</c:v>
                </c:pt>
                <c:pt idx="59">
                  <c:v>4350.84814453125</c:v>
                </c:pt>
                <c:pt idx="60">
                  <c:v>4389.71533203125</c:v>
                </c:pt>
                <c:pt idx="61">
                  <c:v>4431.0908203125</c:v>
                </c:pt>
                <c:pt idx="62">
                  <c:v>4461.724609375</c:v>
                </c:pt>
                <c:pt idx="63">
                  <c:v>4476.2109375</c:v>
                </c:pt>
                <c:pt idx="64">
                  <c:v>4475.6591796875</c:v>
                </c:pt>
                <c:pt idx="65">
                  <c:v>4462.666015625</c:v>
                </c:pt>
                <c:pt idx="66">
                  <c:v>4438.0263671875</c:v>
                </c:pt>
                <c:pt idx="67">
                  <c:v>4402.359375</c:v>
                </c:pt>
                <c:pt idx="68">
                  <c:v>4360.61572265625</c:v>
                </c:pt>
                <c:pt idx="69">
                  <c:v>4324.06689453125</c:v>
                </c:pt>
                <c:pt idx="70">
                  <c:v>4306.14013671875</c:v>
                </c:pt>
                <c:pt idx="71">
                  <c:v>4314.02294921875</c:v>
                </c:pt>
                <c:pt idx="72">
                  <c:v>4342.5126953125</c:v>
                </c:pt>
                <c:pt idx="73">
                  <c:v>4375.80908203125</c:v>
                </c:pt>
                <c:pt idx="74">
                  <c:v>4397.0400390625</c:v>
                </c:pt>
                <c:pt idx="75">
                  <c:v>4399.01025390625</c:v>
                </c:pt>
                <c:pt idx="76">
                  <c:v>4388.25048828125</c:v>
                </c:pt>
                <c:pt idx="77">
                  <c:v>4379.31005859375</c:v>
                </c:pt>
                <c:pt idx="78">
                  <c:v>4383.59765625</c:v>
                </c:pt>
                <c:pt idx="79">
                  <c:v>4401.052734375</c:v>
                </c:pt>
                <c:pt idx="80">
                  <c:v>4420.53662109375</c:v>
                </c:pt>
                <c:pt idx="81">
                  <c:v>4428.16845703125</c:v>
                </c:pt>
                <c:pt idx="82">
                  <c:v>4417.24560546875</c:v>
                </c:pt>
                <c:pt idx="83">
                  <c:v>4392.91845703125</c:v>
                </c:pt>
                <c:pt idx="84">
                  <c:v>4369.12646484375</c:v>
                </c:pt>
                <c:pt idx="85">
                  <c:v>4360.5849609375</c:v>
                </c:pt>
                <c:pt idx="86">
                  <c:v>4375.0224609375</c:v>
                </c:pt>
                <c:pt idx="87">
                  <c:v>4409.53369140625</c:v>
                </c:pt>
                <c:pt idx="88">
                  <c:v>4451.9541015625</c:v>
                </c:pt>
                <c:pt idx="89">
                  <c:v>4485.99658203125</c:v>
                </c:pt>
                <c:pt idx="90">
                  <c:v>4498.1826171875</c:v>
                </c:pt>
                <c:pt idx="91">
                  <c:v>4484.2509765625</c:v>
                </c:pt>
                <c:pt idx="92">
                  <c:v>4452.16357421875</c:v>
                </c:pt>
                <c:pt idx="93">
                  <c:v>4419.02685546875</c:v>
                </c:pt>
                <c:pt idx="94">
                  <c:v>4401.814453125</c:v>
                </c:pt>
                <c:pt idx="95">
                  <c:v>4406.2666015625</c:v>
                </c:pt>
                <c:pt idx="96">
                  <c:v>4421.47412109375</c:v>
                </c:pt>
                <c:pt idx="97">
                  <c:v>4425.634765625</c:v>
                </c:pt>
                <c:pt idx="98">
                  <c:v>4401.13916015625</c:v>
                </c:pt>
                <c:pt idx="99">
                  <c:v>4349.208984375</c:v>
                </c:pt>
                <c:pt idx="100">
                  <c:v>4292.6875</c:v>
                </c:pt>
                <c:pt idx="101">
                  <c:v>4262.998046875</c:v>
                </c:pt>
                <c:pt idx="102">
                  <c:v>4279.193359375</c:v>
                </c:pt>
                <c:pt idx="103">
                  <c:v>4334.0810546875</c:v>
                </c:pt>
                <c:pt idx="104">
                  <c:v>4398.21923828125</c:v>
                </c:pt>
                <c:pt idx="105">
                  <c:v>4439.38671875</c:v>
                </c:pt>
                <c:pt idx="106">
                  <c:v>4443.1748046875</c:v>
                </c:pt>
                <c:pt idx="107">
                  <c:v>4419.484375</c:v>
                </c:pt>
                <c:pt idx="108">
                  <c:v>4391.07275390625</c:v>
                </c:pt>
                <c:pt idx="109">
                  <c:v>4374.69970703125</c:v>
                </c:pt>
                <c:pt idx="110">
                  <c:v>4370.79248046875</c:v>
                </c:pt>
                <c:pt idx="111">
                  <c:v>4369.26953125</c:v>
                </c:pt>
                <c:pt idx="112">
                  <c:v>4364.423828125</c:v>
                </c:pt>
                <c:pt idx="113">
                  <c:v>4363.62939453125</c:v>
                </c:pt>
                <c:pt idx="114">
                  <c:v>4380.6279296875</c:v>
                </c:pt>
                <c:pt idx="115">
                  <c:v>4419.146484375</c:v>
                </c:pt>
                <c:pt idx="116">
                  <c:v>4463.048828125</c:v>
                </c:pt>
                <c:pt idx="117">
                  <c:v>4484.80908203125</c:v>
                </c:pt>
                <c:pt idx="118">
                  <c:v>4467.763671875</c:v>
                </c:pt>
                <c:pt idx="119">
                  <c:v>4423.45361328125</c:v>
                </c:pt>
                <c:pt idx="120">
                  <c:v>4386.95068359375</c:v>
                </c:pt>
                <c:pt idx="121">
                  <c:v>4390.63427734375</c:v>
                </c:pt>
                <c:pt idx="122">
                  <c:v>4436.2861328125</c:v>
                </c:pt>
                <c:pt idx="123">
                  <c:v>4489.380859375</c:v>
                </c:pt>
                <c:pt idx="124">
                  <c:v>4503.0234375</c:v>
                </c:pt>
                <c:pt idx="125">
                  <c:v>4454.59814453125</c:v>
                </c:pt>
                <c:pt idx="126">
                  <c:v>4366.173828125</c:v>
                </c:pt>
                <c:pt idx="127">
                  <c:v>4291.1416015625</c:v>
                </c:pt>
                <c:pt idx="128">
                  <c:v>4276.1484375</c:v>
                </c:pt>
                <c:pt idx="129">
                  <c:v>4327.53125</c:v>
                </c:pt>
                <c:pt idx="130">
                  <c:v>4408.2939453125</c:v>
                </c:pt>
                <c:pt idx="131">
                  <c:v>4467.23291015625</c:v>
                </c:pt>
                <c:pt idx="132">
                  <c:v>4476.193359375</c:v>
                </c:pt>
                <c:pt idx="133">
                  <c:v>4445.77783203125</c:v>
                </c:pt>
                <c:pt idx="134">
                  <c:v>4408.8037109375</c:v>
                </c:pt>
                <c:pt idx="135">
                  <c:v>4388.169921875</c:v>
                </c:pt>
                <c:pt idx="136">
                  <c:v>4378.2880859375</c:v>
                </c:pt>
                <c:pt idx="137">
                  <c:v>4356.2099609375</c:v>
                </c:pt>
                <c:pt idx="138">
                  <c:v>4311.42529296875</c:v>
                </c:pt>
                <c:pt idx="139">
                  <c:v>4265.685546875</c:v>
                </c:pt>
                <c:pt idx="140">
                  <c:v>4261.9228515625</c:v>
                </c:pt>
                <c:pt idx="141">
                  <c:v>4328.380859375</c:v>
                </c:pt>
                <c:pt idx="142">
                  <c:v>4447.4560546875</c:v>
                </c:pt>
                <c:pt idx="143">
                  <c:v>4557.8134765625</c:v>
                </c:pt>
                <c:pt idx="144">
                  <c:v>4592.65576171875</c:v>
                </c:pt>
                <c:pt idx="145">
                  <c:v>4527.1220703125</c:v>
                </c:pt>
                <c:pt idx="146">
                  <c:v>4398.55029296875</c:v>
                </c:pt>
                <c:pt idx="147">
                  <c:v>4282.884765625</c:v>
                </c:pt>
                <c:pt idx="148">
                  <c:v>4243.81689453125</c:v>
                </c:pt>
                <c:pt idx="149">
                  <c:v>4291.80419921875</c:v>
                </c:pt>
                <c:pt idx="150">
                  <c:v>4381.99169921875</c:v>
                </c:pt>
                <c:pt idx="151">
                  <c:v>4450.2080078125</c:v>
                </c:pt>
                <c:pt idx="152">
                  <c:v>4458.4375</c:v>
                </c:pt>
                <c:pt idx="153">
                  <c:v>4416.59375</c:v>
                </c:pt>
                <c:pt idx="154">
                  <c:v>4367.8828125</c:v>
                </c:pt>
                <c:pt idx="155">
                  <c:v>4352.9775390625</c:v>
                </c:pt>
                <c:pt idx="156">
                  <c:v>4381.69140625</c:v>
                </c:pt>
                <c:pt idx="157">
                  <c:v>4431.3134765625</c:v>
                </c:pt>
                <c:pt idx="158">
                  <c:v>4468.25830078125</c:v>
                </c:pt>
                <c:pt idx="159">
                  <c:v>4473.15087890625</c:v>
                </c:pt>
                <c:pt idx="160">
                  <c:v>4450.61865234375</c:v>
                </c:pt>
                <c:pt idx="161">
                  <c:v>4420.15771484375</c:v>
                </c:pt>
                <c:pt idx="162">
                  <c:v>4399.27685546875</c:v>
                </c:pt>
                <c:pt idx="163">
                  <c:v>4393.20166015625</c:v>
                </c:pt>
                <c:pt idx="164">
                  <c:v>4396.61962890625</c:v>
                </c:pt>
                <c:pt idx="165">
                  <c:v>4402.00927734375</c:v>
                </c:pt>
                <c:pt idx="166">
                  <c:v>4405.5830078125</c:v>
                </c:pt>
                <c:pt idx="167">
                  <c:v>4406.986328125</c:v>
                </c:pt>
                <c:pt idx="168">
                  <c:v>4406.04638671875</c:v>
                </c:pt>
                <c:pt idx="169">
                  <c:v>4401.75732421875</c:v>
                </c:pt>
                <c:pt idx="170">
                  <c:v>4394.5400390625</c:v>
                </c:pt>
                <c:pt idx="171">
                  <c:v>4388.03857421875</c:v>
                </c:pt>
                <c:pt idx="172">
                  <c:v>4386.84716796875</c:v>
                </c:pt>
                <c:pt idx="173">
                  <c:v>4391.4443359375</c:v>
                </c:pt>
                <c:pt idx="174">
                  <c:v>4395.7216796875</c:v>
                </c:pt>
                <c:pt idx="175">
                  <c:v>4390.94189453125</c:v>
                </c:pt>
                <c:pt idx="176">
                  <c:v>4373.6767578125</c:v>
                </c:pt>
                <c:pt idx="177">
                  <c:v>4350.52099609375</c:v>
                </c:pt>
                <c:pt idx="178">
                  <c:v>4334.3837890625</c:v>
                </c:pt>
                <c:pt idx="179">
                  <c:v>4334.7197265625</c:v>
                </c:pt>
                <c:pt idx="180">
                  <c:v>4350.13037109375</c:v>
                </c:pt>
                <c:pt idx="181">
                  <c:v>4370.216796875</c:v>
                </c:pt>
                <c:pt idx="182">
                  <c:v>4385.26123046875</c:v>
                </c:pt>
                <c:pt idx="183">
                  <c:v>4394.80810546875</c:v>
                </c:pt>
                <c:pt idx="184">
                  <c:v>4406.89208984375</c:v>
                </c:pt>
                <c:pt idx="185">
                  <c:v>4428.3427734375</c:v>
                </c:pt>
                <c:pt idx="186">
                  <c:v>4455.4296875</c:v>
                </c:pt>
                <c:pt idx="187">
                  <c:v>4474.48828125</c:v>
                </c:pt>
                <c:pt idx="188">
                  <c:v>4473.11572265625</c:v>
                </c:pt>
                <c:pt idx="189">
                  <c:v>4452.1083984375</c:v>
                </c:pt>
                <c:pt idx="190">
                  <c:v>4426.5185546875</c:v>
                </c:pt>
                <c:pt idx="191">
                  <c:v>4413.51416015625</c:v>
                </c:pt>
                <c:pt idx="192">
                  <c:v>4417.140625</c:v>
                </c:pt>
                <c:pt idx="193">
                  <c:v>4424.04736328125</c:v>
                </c:pt>
                <c:pt idx="194">
                  <c:v>4415.2626953125</c:v>
                </c:pt>
                <c:pt idx="195">
                  <c:v>4384.5068359375</c:v>
                </c:pt>
                <c:pt idx="196">
                  <c:v>4346.54736328125</c:v>
                </c:pt>
                <c:pt idx="197">
                  <c:v>4326.80419921875</c:v>
                </c:pt>
                <c:pt idx="198">
                  <c:v>4339.89013671875</c:v>
                </c:pt>
                <c:pt idx="199">
                  <c:v>4375.556640625</c:v>
                </c:pt>
                <c:pt idx="200">
                  <c:v>4405.3544921875</c:v>
                </c:pt>
                <c:pt idx="201">
                  <c:v>4405.7802734375</c:v>
                </c:pt>
                <c:pt idx="202">
                  <c:v>4378.70361328125</c:v>
                </c:pt>
                <c:pt idx="203">
                  <c:v>4351.0244140625</c:v>
                </c:pt>
                <c:pt idx="204">
                  <c:v>4352.6259765625</c:v>
                </c:pt>
                <c:pt idx="205">
                  <c:v>4390.55810546875</c:v>
                </c:pt>
                <c:pt idx="206">
                  <c:v>4441.46484375</c:v>
                </c:pt>
                <c:pt idx="207">
                  <c:v>4469.4765625</c:v>
                </c:pt>
                <c:pt idx="208">
                  <c:v>4455.28076171875</c:v>
                </c:pt>
                <c:pt idx="209">
                  <c:v>4412.2041015625</c:v>
                </c:pt>
                <c:pt idx="210">
                  <c:v>4375.6494140625</c:v>
                </c:pt>
                <c:pt idx="211">
                  <c:v>4374.3916015625</c:v>
                </c:pt>
                <c:pt idx="212">
                  <c:v>4407.36669921875</c:v>
                </c:pt>
                <c:pt idx="213">
                  <c:v>4444.89892578125</c:v>
                </c:pt>
                <c:pt idx="214">
                  <c:v>4452.9072265625</c:v>
                </c:pt>
                <c:pt idx="215">
                  <c:v>4419.92529296875</c:v>
                </c:pt>
                <c:pt idx="216">
                  <c:v>4365.29833984375</c:v>
                </c:pt>
                <c:pt idx="217">
                  <c:v>4323.2626953125</c:v>
                </c:pt>
                <c:pt idx="218">
                  <c:v>4317.29345703125</c:v>
                </c:pt>
                <c:pt idx="219">
                  <c:v>4345.54345703125</c:v>
                </c:pt>
                <c:pt idx="220">
                  <c:v>4386.9794921875</c:v>
                </c:pt>
                <c:pt idx="221">
                  <c:v>4419.91943359375</c:v>
                </c:pt>
                <c:pt idx="222">
                  <c:v>4435.884765625</c:v>
                </c:pt>
                <c:pt idx="223">
                  <c:v>4438.75439453125</c:v>
                </c:pt>
                <c:pt idx="224">
                  <c:v>4434.11474609375</c:v>
                </c:pt>
                <c:pt idx="225">
                  <c:v>4422.0283203125</c:v>
                </c:pt>
                <c:pt idx="226">
                  <c:v>4400.84130859375</c:v>
                </c:pt>
                <c:pt idx="227">
                  <c:v>4376.49560546875</c:v>
                </c:pt>
                <c:pt idx="228">
                  <c:v>4364.7255859375</c:v>
                </c:pt>
                <c:pt idx="229">
                  <c:v>4380.11083984375</c:v>
                </c:pt>
                <c:pt idx="230">
                  <c:v>4420.244140625</c:v>
                </c:pt>
                <c:pt idx="231">
                  <c:v>4460.95361328125</c:v>
                </c:pt>
                <c:pt idx="232">
                  <c:v>4470.87255859375</c:v>
                </c:pt>
                <c:pt idx="233">
                  <c:v>4436.1982421875</c:v>
                </c:pt>
                <c:pt idx="234">
                  <c:v>4375.0830078125</c:v>
                </c:pt>
                <c:pt idx="235">
                  <c:v>4327.34033203125</c:v>
                </c:pt>
                <c:pt idx="236">
                  <c:v>4325.2861328125</c:v>
                </c:pt>
                <c:pt idx="237">
                  <c:v>4368.52734375</c:v>
                </c:pt>
                <c:pt idx="238">
                  <c:v>4423.86572265625</c:v>
                </c:pt>
                <c:pt idx="239">
                  <c:v>4451.40185546875</c:v>
                </c:pt>
                <c:pt idx="240">
                  <c:v>4435.84912109375</c:v>
                </c:pt>
                <c:pt idx="241">
                  <c:v>4397.197265625</c:v>
                </c:pt>
                <c:pt idx="242">
                  <c:v>4371.9248046875</c:v>
                </c:pt>
                <c:pt idx="243">
                  <c:v>4380.8388671875</c:v>
                </c:pt>
                <c:pt idx="244">
                  <c:v>4411.037109375</c:v>
                </c:pt>
                <c:pt idx="245">
                  <c:v>4427.4697265625</c:v>
                </c:pt>
                <c:pt idx="246">
                  <c:v>4404.22314453125</c:v>
                </c:pt>
                <c:pt idx="247">
                  <c:v>4348.74365234375</c:v>
                </c:pt>
                <c:pt idx="248">
                  <c:v>4298.2021484375</c:v>
                </c:pt>
                <c:pt idx="249">
                  <c:v>4290.8828125</c:v>
                </c:pt>
                <c:pt idx="250">
                  <c:v>4336.42919921875</c:v>
                </c:pt>
                <c:pt idx="251">
                  <c:v>4409.21044921875</c:v>
                </c:pt>
                <c:pt idx="252">
                  <c:v>4469.064453125</c:v>
                </c:pt>
                <c:pt idx="253">
                  <c:v>4490.93505859375</c:v>
                </c:pt>
                <c:pt idx="254">
                  <c:v>4478.888671875</c:v>
                </c:pt>
                <c:pt idx="255">
                  <c:v>4455.12939453125</c:v>
                </c:pt>
                <c:pt idx="256">
                  <c:v>4436.7431640625</c:v>
                </c:pt>
                <c:pt idx="257">
                  <c:v>4422.31005859375</c:v>
                </c:pt>
                <c:pt idx="258">
                  <c:v>4399.5537109375</c:v>
                </c:pt>
                <c:pt idx="259">
                  <c:v>4364.61279296875</c:v>
                </c:pt>
                <c:pt idx="260">
                  <c:v>4332.5234375</c:v>
                </c:pt>
                <c:pt idx="261">
                  <c:v>4327.107421875</c:v>
                </c:pt>
                <c:pt idx="262">
                  <c:v>4358.55859375</c:v>
                </c:pt>
                <c:pt idx="263">
                  <c:v>4409.8173828125</c:v>
                </c:pt>
                <c:pt idx="264">
                  <c:v>4446.14501953125</c:v>
                </c:pt>
                <c:pt idx="265">
                  <c:v>4441.697265625</c:v>
                </c:pt>
                <c:pt idx="266">
                  <c:v>4400.90869140625</c:v>
                </c:pt>
                <c:pt idx="267">
                  <c:v>4355.88330078125</c:v>
                </c:pt>
                <c:pt idx="268">
                  <c:v>4341.2431640625</c:v>
                </c:pt>
                <c:pt idx="269">
                  <c:v>4367.31884765625</c:v>
                </c:pt>
                <c:pt idx="270">
                  <c:v>4413.9306640625</c:v>
                </c:pt>
                <c:pt idx="271">
                  <c:v>4449.0556640625</c:v>
                </c:pt>
                <c:pt idx="272">
                  <c:v>4455.29248046875</c:v>
                </c:pt>
                <c:pt idx="273">
                  <c:v>4441.0830078125</c:v>
                </c:pt>
                <c:pt idx="274">
                  <c:v>4428.193359375</c:v>
                </c:pt>
                <c:pt idx="275">
                  <c:v>4428.5849609375</c:v>
                </c:pt>
                <c:pt idx="276">
                  <c:v>4432.95263671875</c:v>
                </c:pt>
                <c:pt idx="277">
                  <c:v>4421.67236328125</c:v>
                </c:pt>
                <c:pt idx="278">
                  <c:v>4387.4033203125</c:v>
                </c:pt>
                <c:pt idx="279">
                  <c:v>4347.01806640625</c:v>
                </c:pt>
                <c:pt idx="280">
                  <c:v>4329.94287109375</c:v>
                </c:pt>
                <c:pt idx="281">
                  <c:v>4352.0703125</c:v>
                </c:pt>
                <c:pt idx="282">
                  <c:v>4399.02587890625</c:v>
                </c:pt>
                <c:pt idx="283">
                  <c:v>4435.591796875</c:v>
                </c:pt>
                <c:pt idx="284">
                  <c:v>4434.9462890625</c:v>
                </c:pt>
                <c:pt idx="285">
                  <c:v>4402.51025390625</c:v>
                </c:pt>
                <c:pt idx="286">
                  <c:v>4372.2353515625</c:v>
                </c:pt>
                <c:pt idx="287">
                  <c:v>4376.6474609375</c:v>
                </c:pt>
                <c:pt idx="288">
                  <c:v>4415.81591796875</c:v>
                </c:pt>
                <c:pt idx="289">
                  <c:v>4453.28466796875</c:v>
                </c:pt>
                <c:pt idx="290">
                  <c:v>4445.0400390625</c:v>
                </c:pt>
                <c:pt idx="291">
                  <c:v>4378.8486328125</c:v>
                </c:pt>
                <c:pt idx="292">
                  <c:v>4290.53125</c:v>
                </c:pt>
                <c:pt idx="293">
                  <c:v>4241.15283203125</c:v>
                </c:pt>
                <c:pt idx="294">
                  <c:v>4271.11328125</c:v>
                </c:pt>
                <c:pt idx="295">
                  <c:v>4367.1171875</c:v>
                </c:pt>
                <c:pt idx="296">
                  <c:v>4469.06201171875</c:v>
                </c:pt>
                <c:pt idx="297">
                  <c:v>4512.67041015625</c:v>
                </c:pt>
                <c:pt idx="298">
                  <c:v>4475.54931640625</c:v>
                </c:pt>
                <c:pt idx="299">
                  <c:v>4391.857421875</c:v>
                </c:pt>
                <c:pt idx="300">
                  <c:v>4325.5458984375</c:v>
                </c:pt>
                <c:pt idx="301">
                  <c:v>4323.8017578125</c:v>
                </c:pt>
                <c:pt idx="302">
                  <c:v>4385.84912109375</c:v>
                </c:pt>
                <c:pt idx="303">
                  <c:v>4468.18310546875</c:v>
                </c:pt>
                <c:pt idx="304">
                  <c:v>4518.5595703125</c:v>
                </c:pt>
                <c:pt idx="305">
                  <c:v>4511.04248046875</c:v>
                </c:pt>
                <c:pt idx="306">
                  <c:v>4457.5322265625</c:v>
                </c:pt>
                <c:pt idx="307">
                  <c:v>4392.21826171875</c:v>
                </c:pt>
                <c:pt idx="308">
                  <c:v>4345.62890625</c:v>
                </c:pt>
                <c:pt idx="309">
                  <c:v>4328.86962890625</c:v>
                </c:pt>
                <c:pt idx="310">
                  <c:v>4336.01416015625</c:v>
                </c:pt>
                <c:pt idx="311">
                  <c:v>4356.64306640625</c:v>
                </c:pt>
                <c:pt idx="312">
                  <c:v>4384.89208984375</c:v>
                </c:pt>
                <c:pt idx="313">
                  <c:v>4418.64892578125</c:v>
                </c:pt>
                <c:pt idx="314">
                  <c:v>4453.6337890625</c:v>
                </c:pt>
                <c:pt idx="315">
                  <c:v>4481.10302734375</c:v>
                </c:pt>
                <c:pt idx="316">
                  <c:v>4492.27685546875</c:v>
                </c:pt>
                <c:pt idx="317">
                  <c:v>4484.4462890625</c:v>
                </c:pt>
                <c:pt idx="318">
                  <c:v>4461.89306640625</c:v>
                </c:pt>
                <c:pt idx="319">
                  <c:v>4430.74658203125</c:v>
                </c:pt>
                <c:pt idx="320">
                  <c:v>4393.91259765625</c:v>
                </c:pt>
                <c:pt idx="321">
                  <c:v>4352.3173828125</c:v>
                </c:pt>
                <c:pt idx="322">
                  <c:v>4311.421875</c:v>
                </c:pt>
                <c:pt idx="323">
                  <c:v>4284.833984375</c:v>
                </c:pt>
                <c:pt idx="324">
                  <c:v>4288.087890625</c:v>
                </c:pt>
                <c:pt idx="325">
                  <c:v>4325.32080078125</c:v>
                </c:pt>
                <c:pt idx="326">
                  <c:v>4380.615234375</c:v>
                </c:pt>
                <c:pt idx="327">
                  <c:v>4424.49072265625</c:v>
                </c:pt>
                <c:pt idx="328">
                  <c:v>4433.6708984375</c:v>
                </c:pt>
                <c:pt idx="329">
                  <c:v>4409.2197265625</c:v>
                </c:pt>
                <c:pt idx="330">
                  <c:v>4376.90185546875</c:v>
                </c:pt>
                <c:pt idx="331">
                  <c:v>4367.166015625</c:v>
                </c:pt>
                <c:pt idx="332">
                  <c:v>4389.82421875</c:v>
                </c:pt>
                <c:pt idx="333">
                  <c:v>4424.74755859375</c:v>
                </c:pt>
                <c:pt idx="334">
                  <c:v>4437.8544921875</c:v>
                </c:pt>
                <c:pt idx="335">
                  <c:v>4410.45361328125</c:v>
                </c:pt>
                <c:pt idx="336">
                  <c:v>4357.537109375</c:v>
                </c:pt>
                <c:pt idx="337">
                  <c:v>4318.4697265625</c:v>
                </c:pt>
                <c:pt idx="338">
                  <c:v>4326.17041015625</c:v>
                </c:pt>
                <c:pt idx="339">
                  <c:v>4379.56005859375</c:v>
                </c:pt>
                <c:pt idx="340">
                  <c:v>4442.55859375</c:v>
                </c:pt>
                <c:pt idx="341">
                  <c:v>4471.6181640625</c:v>
                </c:pt>
                <c:pt idx="342">
                  <c:v>4450.0712890625</c:v>
                </c:pt>
                <c:pt idx="343">
                  <c:v>4401.34033203125</c:v>
                </c:pt>
                <c:pt idx="344">
                  <c:v>4369.97314453125</c:v>
                </c:pt>
                <c:pt idx="345">
                  <c:v>4385.70361328125</c:v>
                </c:pt>
                <c:pt idx="346">
                  <c:v>4439.60595703125</c:v>
                </c:pt>
                <c:pt idx="347">
                  <c:v>4491.40234375</c:v>
                </c:pt>
                <c:pt idx="348">
                  <c:v>4501.525390625</c:v>
                </c:pt>
                <c:pt idx="349">
                  <c:v>4461.74853515625</c:v>
                </c:pt>
              </c:numCache>
            </c:numRef>
          </c:yVal>
          <c:smooth val="1"/>
          <c:extLst>
            <c:ext xmlns:c16="http://schemas.microsoft.com/office/drawing/2014/chart" uri="{C3380CC4-5D6E-409C-BE32-E72D297353CC}">
              <c16:uniqueId val="{0000000A-0DDB-41B5-BE83-A9CFE49F3CE3}"/>
            </c:ext>
          </c:extLst>
        </c:ser>
        <c:ser>
          <c:idx val="11"/>
          <c:order val="11"/>
          <c:tx>
            <c:strRef>
              <c:f>hc_sub_007!$L$1</c:f>
              <c:strCache>
                <c:ptCount val="1"/>
                <c:pt idx="0">
                  <c:v>Coor_12</c:v>
                </c:pt>
              </c:strCache>
            </c:strRef>
          </c:tx>
          <c:spPr>
            <a:ln w="28575" cap="rnd">
              <a:solidFill>
                <a:schemeClr val="accent6">
                  <a:lumMod val="60000"/>
                </a:schemeClr>
              </a:solidFill>
              <a:round/>
            </a:ln>
            <a:effectLst/>
          </c:spPr>
          <c:marker>
            <c:symbol val="none"/>
          </c:marker>
          <c:yVal>
            <c:numRef>
              <c:f>hc_sub_007!$L$2:$L$351</c:f>
              <c:numCache>
                <c:formatCode>0.00000000000_ </c:formatCode>
                <c:ptCount val="350"/>
                <c:pt idx="0">
                  <c:v>5367.87548828125</c:v>
                </c:pt>
                <c:pt idx="1">
                  <c:v>5343.224609375</c:v>
                </c:pt>
                <c:pt idx="2">
                  <c:v>5310.19140625</c:v>
                </c:pt>
                <c:pt idx="3">
                  <c:v>5292.6259765625</c:v>
                </c:pt>
                <c:pt idx="4">
                  <c:v>5311.9072265625</c:v>
                </c:pt>
                <c:pt idx="5">
                  <c:v>5368.2861328125</c:v>
                </c:pt>
                <c:pt idx="6">
                  <c:v>5435.99072265625</c:v>
                </c:pt>
                <c:pt idx="7">
                  <c:v>5478.54052734375</c:v>
                </c:pt>
                <c:pt idx="8">
                  <c:v>5474.58984375</c:v>
                </c:pt>
                <c:pt idx="9">
                  <c:v>5434.76123046875</c:v>
                </c:pt>
                <c:pt idx="10">
                  <c:v>5395.24658203125</c:v>
                </c:pt>
                <c:pt idx="11">
                  <c:v>5391.3427734375</c:v>
                </c:pt>
                <c:pt idx="12">
                  <c:v>5430.2548828125</c:v>
                </c:pt>
                <c:pt idx="13">
                  <c:v>5484.193359375</c:v>
                </c:pt>
                <c:pt idx="14">
                  <c:v>5509.97802734375</c:v>
                </c:pt>
                <c:pt idx="15">
                  <c:v>5481.11279296875</c:v>
                </c:pt>
                <c:pt idx="16">
                  <c:v>5408.4404296875</c:v>
                </c:pt>
                <c:pt idx="17">
                  <c:v>5333.82373046875</c:v>
                </c:pt>
                <c:pt idx="18">
                  <c:v>5301.4912109375</c:v>
                </c:pt>
                <c:pt idx="19">
                  <c:v>5328.08056640625</c:v>
                </c:pt>
                <c:pt idx="20">
                  <c:v>5392.69091796875</c:v>
                </c:pt>
                <c:pt idx="21">
                  <c:v>5452.802734375</c:v>
                </c:pt>
                <c:pt idx="22">
                  <c:v>5473.13037109375</c:v>
                </c:pt>
                <c:pt idx="23">
                  <c:v>5446.56982421875</c:v>
                </c:pt>
                <c:pt idx="24">
                  <c:v>5394.25048828125</c:v>
                </c:pt>
                <c:pt idx="25">
                  <c:v>5347.8701171875</c:v>
                </c:pt>
                <c:pt idx="26">
                  <c:v>5329.05908203125</c:v>
                </c:pt>
                <c:pt idx="27">
                  <c:v>5339.6630859375</c:v>
                </c:pt>
                <c:pt idx="28">
                  <c:v>5366.251953125</c:v>
                </c:pt>
                <c:pt idx="29">
                  <c:v>5391.64794921875</c:v>
                </c:pt>
                <c:pt idx="30">
                  <c:v>5403.77587890625</c:v>
                </c:pt>
                <c:pt idx="31">
                  <c:v>5397.732421875</c:v>
                </c:pt>
                <c:pt idx="32">
                  <c:v>5373.978515625</c:v>
                </c:pt>
                <c:pt idx="33">
                  <c:v>5337.42724609375</c:v>
                </c:pt>
                <c:pt idx="34">
                  <c:v>5298.36279296875</c:v>
                </c:pt>
                <c:pt idx="35">
                  <c:v>5271.6982421875</c:v>
                </c:pt>
                <c:pt idx="36">
                  <c:v>5271.3369140625</c:v>
                </c:pt>
                <c:pt idx="37">
                  <c:v>5301.5048828125</c:v>
                </c:pt>
                <c:pt idx="38">
                  <c:v>5351.66845703125</c:v>
                </c:pt>
                <c:pt idx="39">
                  <c:v>5400.69921875</c:v>
                </c:pt>
                <c:pt idx="40">
                  <c:v>5429.150390625</c:v>
                </c:pt>
                <c:pt idx="41">
                  <c:v>5431.4052734375</c:v>
                </c:pt>
                <c:pt idx="42">
                  <c:v>5418.54248046875</c:v>
                </c:pt>
                <c:pt idx="43">
                  <c:v>5409.41943359375</c:v>
                </c:pt>
                <c:pt idx="44">
                  <c:v>5416.533203125</c:v>
                </c:pt>
                <c:pt idx="45">
                  <c:v>5437.2666015625</c:v>
                </c:pt>
                <c:pt idx="46">
                  <c:v>5456.78466796875</c:v>
                </c:pt>
                <c:pt idx="47">
                  <c:v>5459.75390625</c:v>
                </c:pt>
                <c:pt idx="48">
                  <c:v>5441.58642578125</c:v>
                </c:pt>
                <c:pt idx="49">
                  <c:v>5411.015625</c:v>
                </c:pt>
                <c:pt idx="50">
                  <c:v>5383.095703125</c:v>
                </c:pt>
                <c:pt idx="51">
                  <c:v>5368.87744140625</c:v>
                </c:pt>
                <c:pt idx="52">
                  <c:v>5369.56396484375</c:v>
                </c:pt>
                <c:pt idx="53">
                  <c:v>5378.400390625</c:v>
                </c:pt>
                <c:pt idx="54">
                  <c:v>5387.36181640625</c:v>
                </c:pt>
                <c:pt idx="55">
                  <c:v>5392.9228515625</c:v>
                </c:pt>
                <c:pt idx="56">
                  <c:v>5397.2236328125</c:v>
                </c:pt>
                <c:pt idx="57">
                  <c:v>5405.1103515625</c:v>
                </c:pt>
                <c:pt idx="58">
                  <c:v>5420.02978515625</c:v>
                </c:pt>
                <c:pt idx="59">
                  <c:v>5441.2578125</c:v>
                </c:pt>
                <c:pt idx="60">
                  <c:v>5463.134765625</c:v>
                </c:pt>
                <c:pt idx="61">
                  <c:v>5476.10400390625</c:v>
                </c:pt>
                <c:pt idx="62">
                  <c:v>5469.75244140625</c:v>
                </c:pt>
                <c:pt idx="63">
                  <c:v>5437.974609375</c:v>
                </c:pt>
                <c:pt idx="64">
                  <c:v>5384.5654296875</c:v>
                </c:pt>
                <c:pt idx="65">
                  <c:v>5325.2890625</c:v>
                </c:pt>
                <c:pt idx="66">
                  <c:v>5282.75537109375</c:v>
                </c:pt>
                <c:pt idx="67">
                  <c:v>5274.78125</c:v>
                </c:pt>
                <c:pt idx="68">
                  <c:v>5302.76513671875</c:v>
                </c:pt>
                <c:pt idx="69">
                  <c:v>5348.7978515625</c:v>
                </c:pt>
                <c:pt idx="70">
                  <c:v>5385.5009765625</c:v>
                </c:pt>
                <c:pt idx="71">
                  <c:v>5393.33984375</c:v>
                </c:pt>
                <c:pt idx="72">
                  <c:v>5373.4677734375</c:v>
                </c:pt>
                <c:pt idx="73">
                  <c:v>5346.173828125</c:v>
                </c:pt>
                <c:pt idx="74">
                  <c:v>5335.30810546875</c:v>
                </c:pt>
                <c:pt idx="75">
                  <c:v>5350.01513671875</c:v>
                </c:pt>
                <c:pt idx="76">
                  <c:v>5377.8076171875</c:v>
                </c:pt>
                <c:pt idx="77">
                  <c:v>5394.64453125</c:v>
                </c:pt>
                <c:pt idx="78">
                  <c:v>5384.3896484375</c:v>
                </c:pt>
                <c:pt idx="79">
                  <c:v>5352.4541015625</c:v>
                </c:pt>
                <c:pt idx="80">
                  <c:v>5322.7802734375</c:v>
                </c:pt>
                <c:pt idx="81">
                  <c:v>5320.40234375</c:v>
                </c:pt>
                <c:pt idx="82">
                  <c:v>5353.09033203125</c:v>
                </c:pt>
                <c:pt idx="83">
                  <c:v>5406.10107421875</c:v>
                </c:pt>
                <c:pt idx="84">
                  <c:v>5453.5234375</c:v>
                </c:pt>
                <c:pt idx="85">
                  <c:v>5476.8193359375</c:v>
                </c:pt>
                <c:pt idx="86">
                  <c:v>5476.21826171875</c:v>
                </c:pt>
                <c:pt idx="87">
                  <c:v>5467.138671875</c:v>
                </c:pt>
                <c:pt idx="88">
                  <c:v>5465.9140625</c:v>
                </c:pt>
                <c:pt idx="89">
                  <c:v>5476.8291015625</c:v>
                </c:pt>
                <c:pt idx="90">
                  <c:v>5490.0732421875</c:v>
                </c:pt>
                <c:pt idx="91">
                  <c:v>5490.63818359375</c:v>
                </c:pt>
                <c:pt idx="92">
                  <c:v>5469.8330078125</c:v>
                </c:pt>
                <c:pt idx="93">
                  <c:v>5430.46728515625</c:v>
                </c:pt>
                <c:pt idx="94">
                  <c:v>5383.2666015625</c:v>
                </c:pt>
                <c:pt idx="95">
                  <c:v>5339.28466796875</c:v>
                </c:pt>
                <c:pt idx="96">
                  <c:v>5304.93994140625</c:v>
                </c:pt>
                <c:pt idx="97">
                  <c:v>5282.22705078125</c:v>
                </c:pt>
                <c:pt idx="98">
                  <c:v>5271.43701171875</c:v>
                </c:pt>
                <c:pt idx="99">
                  <c:v>5272.38818359375</c:v>
                </c:pt>
                <c:pt idx="100">
                  <c:v>5283.29345703125</c:v>
                </c:pt>
                <c:pt idx="101">
                  <c:v>5299.97509765625</c:v>
                </c:pt>
                <c:pt idx="102">
                  <c:v>5318.04931640625</c:v>
                </c:pt>
                <c:pt idx="103">
                  <c:v>5336.90673828125</c:v>
                </c:pt>
                <c:pt idx="104">
                  <c:v>5361.07861328125</c:v>
                </c:pt>
                <c:pt idx="105">
                  <c:v>5395.96826171875</c:v>
                </c:pt>
                <c:pt idx="106">
                  <c:v>5440.396484375</c:v>
                </c:pt>
                <c:pt idx="107">
                  <c:v>5482.79833984375</c:v>
                </c:pt>
                <c:pt idx="108">
                  <c:v>5506.2861328125</c:v>
                </c:pt>
                <c:pt idx="109">
                  <c:v>5500.4765625</c:v>
                </c:pt>
                <c:pt idx="110">
                  <c:v>5471.07275390625</c:v>
                </c:pt>
                <c:pt idx="111">
                  <c:v>5438.32958984375</c:v>
                </c:pt>
                <c:pt idx="112">
                  <c:v>5423.72607421875</c:v>
                </c:pt>
                <c:pt idx="113">
                  <c:v>5434.09130859375</c:v>
                </c:pt>
                <c:pt idx="114">
                  <c:v>5455.6015625</c:v>
                </c:pt>
                <c:pt idx="115">
                  <c:v>5463.1259765625</c:v>
                </c:pt>
                <c:pt idx="116">
                  <c:v>5438.50537109375</c:v>
                </c:pt>
                <c:pt idx="117">
                  <c:v>5384.12744140625</c:v>
                </c:pt>
                <c:pt idx="118">
                  <c:v>5321.65087890625</c:v>
                </c:pt>
                <c:pt idx="119">
                  <c:v>5277.19482421875</c:v>
                </c:pt>
                <c:pt idx="120">
                  <c:v>5264.43701171875</c:v>
                </c:pt>
                <c:pt idx="121">
                  <c:v>5277.9267578125</c:v>
                </c:pt>
                <c:pt idx="122">
                  <c:v>5300.25244140625</c:v>
                </c:pt>
                <c:pt idx="123">
                  <c:v>5316.1005859375</c:v>
                </c:pt>
                <c:pt idx="124">
                  <c:v>5322.1396484375</c:v>
                </c:pt>
                <c:pt idx="125">
                  <c:v>5326.5302734375</c:v>
                </c:pt>
                <c:pt idx="126">
                  <c:v>5340.60009765625</c:v>
                </c:pt>
                <c:pt idx="127">
                  <c:v>5370.25390625</c:v>
                </c:pt>
                <c:pt idx="128">
                  <c:v>5412.75390625</c:v>
                </c:pt>
                <c:pt idx="129">
                  <c:v>5458.7841796875</c:v>
                </c:pt>
                <c:pt idx="130">
                  <c:v>5496.111328125</c:v>
                </c:pt>
                <c:pt idx="131">
                  <c:v>5512.4345703125</c:v>
                </c:pt>
                <c:pt idx="132">
                  <c:v>5498.39501953125</c:v>
                </c:pt>
                <c:pt idx="133">
                  <c:v>5452.44140625</c:v>
                </c:pt>
                <c:pt idx="134">
                  <c:v>5385.92529296875</c:v>
                </c:pt>
                <c:pt idx="135">
                  <c:v>5323.1328125</c:v>
                </c:pt>
                <c:pt idx="136">
                  <c:v>5292.2080078125</c:v>
                </c:pt>
                <c:pt idx="137">
                  <c:v>5309.7568359375</c:v>
                </c:pt>
                <c:pt idx="138">
                  <c:v>5368.97119140625</c:v>
                </c:pt>
                <c:pt idx="139">
                  <c:v>5441.14013671875</c:v>
                </c:pt>
                <c:pt idx="140">
                  <c:v>5491.66162109375</c:v>
                </c:pt>
                <c:pt idx="141">
                  <c:v>5500.34716796875</c:v>
                </c:pt>
                <c:pt idx="142">
                  <c:v>5471.642578125</c:v>
                </c:pt>
                <c:pt idx="143">
                  <c:v>5427.70703125</c:v>
                </c:pt>
                <c:pt idx="144">
                  <c:v>5390.697265625</c:v>
                </c:pt>
                <c:pt idx="145">
                  <c:v>5368.84912109375</c:v>
                </c:pt>
                <c:pt idx="146">
                  <c:v>5356.775390625</c:v>
                </c:pt>
                <c:pt idx="147">
                  <c:v>5347.3173828125</c:v>
                </c:pt>
                <c:pt idx="148">
                  <c:v>5341.97509765625</c:v>
                </c:pt>
                <c:pt idx="149">
                  <c:v>5348.912109375</c:v>
                </c:pt>
                <c:pt idx="150">
                  <c:v>5370.28173828125</c:v>
                </c:pt>
                <c:pt idx="151">
                  <c:v>5392.41552734375</c:v>
                </c:pt>
                <c:pt idx="152">
                  <c:v>5391.55908203125</c:v>
                </c:pt>
                <c:pt idx="153">
                  <c:v>5353.85546875</c:v>
                </c:pt>
                <c:pt idx="154">
                  <c:v>5293.21044921875</c:v>
                </c:pt>
                <c:pt idx="155">
                  <c:v>5248.93701171875</c:v>
                </c:pt>
                <c:pt idx="156">
                  <c:v>5260.318359375</c:v>
                </c:pt>
                <c:pt idx="157">
                  <c:v>5335.58837890625</c:v>
                </c:pt>
                <c:pt idx="158">
                  <c:v>5440.60205078125</c:v>
                </c:pt>
                <c:pt idx="159">
                  <c:v>5519.1240234375</c:v>
                </c:pt>
                <c:pt idx="160">
                  <c:v>5531.68115234375</c:v>
                </c:pt>
                <c:pt idx="161">
                  <c:v>5483.64013671875</c:v>
                </c:pt>
                <c:pt idx="162">
                  <c:v>5420.07421875</c:v>
                </c:pt>
                <c:pt idx="163">
                  <c:v>5390.638671875</c:v>
                </c:pt>
                <c:pt idx="164">
                  <c:v>5411.6796875</c:v>
                </c:pt>
                <c:pt idx="165">
                  <c:v>5455.2822265625</c:v>
                </c:pt>
                <c:pt idx="166">
                  <c:v>5473.41943359375</c:v>
                </c:pt>
                <c:pt idx="167">
                  <c:v>5437.26318359375</c:v>
                </c:pt>
                <c:pt idx="168">
                  <c:v>5360.0849609375</c:v>
                </c:pt>
                <c:pt idx="169">
                  <c:v>5286.3271484375</c:v>
                </c:pt>
                <c:pt idx="170">
                  <c:v>5257.283203125</c:v>
                </c:pt>
                <c:pt idx="171">
                  <c:v>5282.01416015625</c:v>
                </c:pt>
                <c:pt idx="172">
                  <c:v>5335.9423828125</c:v>
                </c:pt>
                <c:pt idx="173">
                  <c:v>5385.16796875</c:v>
                </c:pt>
                <c:pt idx="174">
                  <c:v>5413.34765625</c:v>
                </c:pt>
                <c:pt idx="175">
                  <c:v>5427.97509765625</c:v>
                </c:pt>
                <c:pt idx="176">
                  <c:v>5443.15576171875</c:v>
                </c:pt>
                <c:pt idx="177">
                  <c:v>5457.87548828125</c:v>
                </c:pt>
                <c:pt idx="178">
                  <c:v>5452.53955078125</c:v>
                </c:pt>
                <c:pt idx="179">
                  <c:v>5408.8232421875</c:v>
                </c:pt>
                <c:pt idx="180">
                  <c:v>5334.75830078125</c:v>
                </c:pt>
                <c:pt idx="181">
                  <c:v>5269.73876953125</c:v>
                </c:pt>
                <c:pt idx="182">
                  <c:v>5260.28076171875</c:v>
                </c:pt>
                <c:pt idx="183">
                  <c:v>5323.53955078125</c:v>
                </c:pt>
                <c:pt idx="184">
                  <c:v>5428.7578125</c:v>
                </c:pt>
                <c:pt idx="185">
                  <c:v>5514.478515625</c:v>
                </c:pt>
                <c:pt idx="186">
                  <c:v>5530.73974609375</c:v>
                </c:pt>
                <c:pt idx="187">
                  <c:v>5474.31005859375</c:v>
                </c:pt>
                <c:pt idx="188">
                  <c:v>5389.462890625</c:v>
                </c:pt>
                <c:pt idx="189">
                  <c:v>5333.77880859375</c:v>
                </c:pt>
                <c:pt idx="190">
                  <c:v>5336.01220703125</c:v>
                </c:pt>
                <c:pt idx="191">
                  <c:v>5378.65625</c:v>
                </c:pt>
                <c:pt idx="192">
                  <c:v>5417.162109375</c:v>
                </c:pt>
                <c:pt idx="193">
                  <c:v>5418.1806640625</c:v>
                </c:pt>
                <c:pt idx="194">
                  <c:v>5385.05029296875</c:v>
                </c:pt>
                <c:pt idx="195">
                  <c:v>5350.974609375</c:v>
                </c:pt>
                <c:pt idx="196">
                  <c:v>5347.85693359375</c:v>
                </c:pt>
                <c:pt idx="197">
                  <c:v>5378.3037109375</c:v>
                </c:pt>
                <c:pt idx="198">
                  <c:v>5414.1328125</c:v>
                </c:pt>
                <c:pt idx="199">
                  <c:v>5421.41943359375</c:v>
                </c:pt>
                <c:pt idx="200">
                  <c:v>5389.8740234375</c:v>
                </c:pt>
                <c:pt idx="201">
                  <c:v>5341.66064453125</c:v>
                </c:pt>
                <c:pt idx="202">
                  <c:v>5312.92236328125</c:v>
                </c:pt>
                <c:pt idx="203">
                  <c:v>5324.26318359375</c:v>
                </c:pt>
                <c:pt idx="204">
                  <c:v>5364.94091796875</c:v>
                </c:pt>
                <c:pt idx="205">
                  <c:v>5403.162109375</c:v>
                </c:pt>
                <c:pt idx="206">
                  <c:v>5412.91650390625</c:v>
                </c:pt>
                <c:pt idx="207">
                  <c:v>5394.70166015625</c:v>
                </c:pt>
                <c:pt idx="208">
                  <c:v>5373.58349609375</c:v>
                </c:pt>
                <c:pt idx="209">
                  <c:v>5377.197265625</c:v>
                </c:pt>
                <c:pt idx="210">
                  <c:v>5412.2744140625</c:v>
                </c:pt>
                <c:pt idx="211">
                  <c:v>5458.4912109375</c:v>
                </c:pt>
                <c:pt idx="212">
                  <c:v>5483.77587890625</c:v>
                </c:pt>
                <c:pt idx="213">
                  <c:v>5468.4169921875</c:v>
                </c:pt>
                <c:pt idx="214">
                  <c:v>5419.52783203125</c:v>
                </c:pt>
                <c:pt idx="215">
                  <c:v>5365.9599609375</c:v>
                </c:pt>
                <c:pt idx="216">
                  <c:v>5338.68603515625</c:v>
                </c:pt>
                <c:pt idx="217">
                  <c:v>5351.18896484375</c:v>
                </c:pt>
                <c:pt idx="218">
                  <c:v>5392.5517578125</c:v>
                </c:pt>
                <c:pt idx="219">
                  <c:v>5435.93408203125</c:v>
                </c:pt>
                <c:pt idx="220">
                  <c:v>5455.22802734375</c:v>
                </c:pt>
                <c:pt idx="221">
                  <c:v>5439.24853515625</c:v>
                </c:pt>
                <c:pt idx="222">
                  <c:v>5396.2080078125</c:v>
                </c:pt>
                <c:pt idx="223">
                  <c:v>5347.60205078125</c:v>
                </c:pt>
                <c:pt idx="224">
                  <c:v>5315.8603515625</c:v>
                </c:pt>
                <c:pt idx="225">
                  <c:v>5312.4248046875</c:v>
                </c:pt>
                <c:pt idx="226">
                  <c:v>5332.380859375</c:v>
                </c:pt>
                <c:pt idx="227">
                  <c:v>5358.68798828125</c:v>
                </c:pt>
                <c:pt idx="228">
                  <c:v>5373.97607421875</c:v>
                </c:pt>
                <c:pt idx="229">
                  <c:v>5372.7626953125</c:v>
                </c:pt>
                <c:pt idx="230">
                  <c:v>5365.357421875</c:v>
                </c:pt>
                <c:pt idx="231">
                  <c:v>5369.36376953125</c:v>
                </c:pt>
                <c:pt idx="232">
                  <c:v>5393.83056640625</c:v>
                </c:pt>
                <c:pt idx="233">
                  <c:v>5428.27392578125</c:v>
                </c:pt>
                <c:pt idx="234">
                  <c:v>5447.09033203125</c:v>
                </c:pt>
                <c:pt idx="235">
                  <c:v>5428.705078125</c:v>
                </c:pt>
                <c:pt idx="236">
                  <c:v>5375.8017578125</c:v>
                </c:pt>
                <c:pt idx="237">
                  <c:v>5319.37451171875</c:v>
                </c:pt>
                <c:pt idx="238">
                  <c:v>5300.0361328125</c:v>
                </c:pt>
                <c:pt idx="239">
                  <c:v>5338.17041015625</c:v>
                </c:pt>
                <c:pt idx="240">
                  <c:v>5415.6396484375</c:v>
                </c:pt>
                <c:pt idx="241">
                  <c:v>5485.21337890625</c:v>
                </c:pt>
                <c:pt idx="242">
                  <c:v>5503.07080078125</c:v>
                </c:pt>
                <c:pt idx="243">
                  <c:v>5460.5966796875</c:v>
                </c:pt>
                <c:pt idx="244">
                  <c:v>5390.49853515625</c:v>
                </c:pt>
                <c:pt idx="245">
                  <c:v>5341.5146484375</c:v>
                </c:pt>
                <c:pt idx="246">
                  <c:v>5341.06591796875</c:v>
                </c:pt>
                <c:pt idx="247">
                  <c:v>5375.58642578125</c:v>
                </c:pt>
                <c:pt idx="248">
                  <c:v>5404.55126953125</c:v>
                </c:pt>
                <c:pt idx="249">
                  <c:v>5396.73486328125</c:v>
                </c:pt>
                <c:pt idx="250">
                  <c:v>5358.478515625</c:v>
                </c:pt>
                <c:pt idx="251">
                  <c:v>5329.708984375</c:v>
                </c:pt>
                <c:pt idx="252">
                  <c:v>5349.97802734375</c:v>
                </c:pt>
                <c:pt idx="253">
                  <c:v>5422.22216796875</c:v>
                </c:pt>
                <c:pt idx="254">
                  <c:v>5504.90966796875</c:v>
                </c:pt>
                <c:pt idx="255">
                  <c:v>5540.662109375</c:v>
                </c:pt>
                <c:pt idx="256">
                  <c:v>5499.55859375</c:v>
                </c:pt>
                <c:pt idx="257">
                  <c:v>5402.81494140625</c:v>
                </c:pt>
                <c:pt idx="258">
                  <c:v>5307.935546875</c:v>
                </c:pt>
                <c:pt idx="259">
                  <c:v>5267.16162109375</c:v>
                </c:pt>
                <c:pt idx="260">
                  <c:v>5291.92626953125</c:v>
                </c:pt>
                <c:pt idx="261">
                  <c:v>5350.1171875</c:v>
                </c:pt>
                <c:pt idx="262">
                  <c:v>5395.75927734375</c:v>
                </c:pt>
                <c:pt idx="263">
                  <c:v>5405.08154296875</c:v>
                </c:pt>
                <c:pt idx="264">
                  <c:v>5389.83154296875</c:v>
                </c:pt>
                <c:pt idx="265">
                  <c:v>5379.62744140625</c:v>
                </c:pt>
                <c:pt idx="266">
                  <c:v>5391.515625</c:v>
                </c:pt>
                <c:pt idx="267">
                  <c:v>5414.32861328125</c:v>
                </c:pt>
                <c:pt idx="268">
                  <c:v>5420.716796875</c:v>
                </c:pt>
                <c:pt idx="269">
                  <c:v>5394.6318359375</c:v>
                </c:pt>
                <c:pt idx="270">
                  <c:v>5348.66455078125</c:v>
                </c:pt>
                <c:pt idx="271">
                  <c:v>5315.29833984375</c:v>
                </c:pt>
                <c:pt idx="272">
                  <c:v>5319.71826171875</c:v>
                </c:pt>
                <c:pt idx="273">
                  <c:v>5358.28515625</c:v>
                </c:pt>
                <c:pt idx="274">
                  <c:v>5401.72705078125</c:v>
                </c:pt>
                <c:pt idx="275">
                  <c:v>5420.27099609375</c:v>
                </c:pt>
                <c:pt idx="276">
                  <c:v>5408.6611328125</c:v>
                </c:pt>
                <c:pt idx="277">
                  <c:v>5389.2705078125</c:v>
                </c:pt>
                <c:pt idx="278">
                  <c:v>5390.8408203125</c:v>
                </c:pt>
                <c:pt idx="279">
                  <c:v>5421.76953125</c:v>
                </c:pt>
                <c:pt idx="280">
                  <c:v>5461.50244140625</c:v>
                </c:pt>
                <c:pt idx="281">
                  <c:v>5477.61865234375</c:v>
                </c:pt>
                <c:pt idx="282">
                  <c:v>5453.68359375</c:v>
                </c:pt>
                <c:pt idx="283">
                  <c:v>5403.5869140625</c:v>
                </c:pt>
                <c:pt idx="284">
                  <c:v>5359.9609375</c:v>
                </c:pt>
                <c:pt idx="285">
                  <c:v>5346.8056640625</c:v>
                </c:pt>
                <c:pt idx="286">
                  <c:v>5360.0654296875</c:v>
                </c:pt>
                <c:pt idx="287">
                  <c:v>5372.81787109375</c:v>
                </c:pt>
                <c:pt idx="288">
                  <c:v>5360.3359375</c:v>
                </c:pt>
                <c:pt idx="289">
                  <c:v>5323.1953125</c:v>
                </c:pt>
                <c:pt idx="290">
                  <c:v>5288.45849609375</c:v>
                </c:pt>
                <c:pt idx="291">
                  <c:v>5287.88623046875</c:v>
                </c:pt>
                <c:pt idx="292">
                  <c:v>5331.6611328125</c:v>
                </c:pt>
                <c:pt idx="293">
                  <c:v>5399.5576171875</c:v>
                </c:pt>
                <c:pt idx="294">
                  <c:v>5456.390625</c:v>
                </c:pt>
                <c:pt idx="295">
                  <c:v>5478.248046875</c:v>
                </c:pt>
                <c:pt idx="296">
                  <c:v>5467.8046875</c:v>
                </c:pt>
                <c:pt idx="297">
                  <c:v>5447.322265625</c:v>
                </c:pt>
                <c:pt idx="298">
                  <c:v>5437.1875</c:v>
                </c:pt>
                <c:pt idx="299">
                  <c:v>5439.26708984375</c:v>
                </c:pt>
                <c:pt idx="300">
                  <c:v>5438.6953125</c:v>
                </c:pt>
                <c:pt idx="301">
                  <c:v>5420.80908203125</c:v>
                </c:pt>
                <c:pt idx="302">
                  <c:v>5386.94482421875</c:v>
                </c:pt>
                <c:pt idx="303">
                  <c:v>5354.7890625</c:v>
                </c:pt>
                <c:pt idx="304">
                  <c:v>5343.41015625</c:v>
                </c:pt>
                <c:pt idx="305">
                  <c:v>5356.7783203125</c:v>
                </c:pt>
                <c:pt idx="306">
                  <c:v>5380.505859375</c:v>
                </c:pt>
                <c:pt idx="307">
                  <c:v>5394.4482421875</c:v>
                </c:pt>
                <c:pt idx="308">
                  <c:v>5389.7587890625</c:v>
                </c:pt>
                <c:pt idx="309">
                  <c:v>5375.44873046875</c:v>
                </c:pt>
                <c:pt idx="310">
                  <c:v>5369.115234375</c:v>
                </c:pt>
                <c:pt idx="311">
                  <c:v>5380.47021484375</c:v>
                </c:pt>
                <c:pt idx="312">
                  <c:v>5402.21142578125</c:v>
                </c:pt>
                <c:pt idx="313">
                  <c:v>5415.8955078125</c:v>
                </c:pt>
                <c:pt idx="314">
                  <c:v>5407.31298828125</c:v>
                </c:pt>
                <c:pt idx="315">
                  <c:v>5378.08349609375</c:v>
                </c:pt>
                <c:pt idx="316">
                  <c:v>5344.19189453125</c:v>
                </c:pt>
                <c:pt idx="317">
                  <c:v>5323.75048828125</c:v>
                </c:pt>
                <c:pt idx="318">
                  <c:v>5324.8837890625</c:v>
                </c:pt>
                <c:pt idx="319">
                  <c:v>5343.15478515625</c:v>
                </c:pt>
                <c:pt idx="320">
                  <c:v>5368.5546875</c:v>
                </c:pt>
                <c:pt idx="321">
                  <c:v>5393.88916015625</c:v>
                </c:pt>
                <c:pt idx="322">
                  <c:v>5416.67919921875</c:v>
                </c:pt>
                <c:pt idx="323">
                  <c:v>5434.47216796875</c:v>
                </c:pt>
                <c:pt idx="324">
                  <c:v>5440.6435546875</c:v>
                </c:pt>
                <c:pt idx="325">
                  <c:v>5427.27001953125</c:v>
                </c:pt>
                <c:pt idx="326">
                  <c:v>5393.86572265625</c:v>
                </c:pt>
                <c:pt idx="327">
                  <c:v>5353.41357421875</c:v>
                </c:pt>
                <c:pt idx="328">
                  <c:v>5327.81298828125</c:v>
                </c:pt>
                <c:pt idx="329">
                  <c:v>5333.7802734375</c:v>
                </c:pt>
                <c:pt idx="330">
                  <c:v>5369.62060546875</c:v>
                </c:pt>
                <c:pt idx="331">
                  <c:v>5414.26611328125</c:v>
                </c:pt>
                <c:pt idx="332">
                  <c:v>5440.8642578125</c:v>
                </c:pt>
                <c:pt idx="333">
                  <c:v>5435.26904296875</c:v>
                </c:pt>
                <c:pt idx="334">
                  <c:v>5405.30859375</c:v>
                </c:pt>
                <c:pt idx="335">
                  <c:v>5373.8115234375</c:v>
                </c:pt>
                <c:pt idx="336">
                  <c:v>5361.30322265625</c:v>
                </c:pt>
                <c:pt idx="337">
                  <c:v>5372.25048828125</c:v>
                </c:pt>
                <c:pt idx="338">
                  <c:v>5395.1298828125</c:v>
                </c:pt>
                <c:pt idx="339">
                  <c:v>5414.67724609375</c:v>
                </c:pt>
                <c:pt idx="340">
                  <c:v>5424.78759765625</c:v>
                </c:pt>
                <c:pt idx="341">
                  <c:v>5430.919921875</c:v>
                </c:pt>
                <c:pt idx="342">
                  <c:v>5440.89111328125</c:v>
                </c:pt>
                <c:pt idx="343">
                  <c:v>5453.525390625</c:v>
                </c:pt>
                <c:pt idx="344">
                  <c:v>5456.4970703125</c:v>
                </c:pt>
                <c:pt idx="345">
                  <c:v>5436.2822265625</c:v>
                </c:pt>
                <c:pt idx="346">
                  <c:v>5391.904296875</c:v>
                </c:pt>
                <c:pt idx="347">
                  <c:v>5340.068359375</c:v>
                </c:pt>
                <c:pt idx="348">
                  <c:v>5306.02197265625</c:v>
                </c:pt>
                <c:pt idx="349">
                  <c:v>5306.4072265625</c:v>
                </c:pt>
              </c:numCache>
            </c:numRef>
          </c:yVal>
          <c:smooth val="1"/>
          <c:extLst>
            <c:ext xmlns:c16="http://schemas.microsoft.com/office/drawing/2014/chart" uri="{C3380CC4-5D6E-409C-BE32-E72D297353CC}">
              <c16:uniqueId val="{0000000B-0DDB-41B5-BE83-A9CFE49F3CE3}"/>
            </c:ext>
          </c:extLst>
        </c:ser>
        <c:ser>
          <c:idx val="12"/>
          <c:order val="12"/>
          <c:tx>
            <c:strRef>
              <c:f>hc_sub_007!$M$1</c:f>
              <c:strCache>
                <c:ptCount val="1"/>
                <c:pt idx="0">
                  <c:v>Coor_13</c:v>
                </c:pt>
              </c:strCache>
            </c:strRef>
          </c:tx>
          <c:spPr>
            <a:ln w="28575" cap="rnd">
              <a:solidFill>
                <a:schemeClr val="accent1">
                  <a:lumMod val="80000"/>
                  <a:lumOff val="20000"/>
                </a:schemeClr>
              </a:solidFill>
              <a:round/>
            </a:ln>
            <a:effectLst/>
          </c:spPr>
          <c:marker>
            <c:symbol val="none"/>
          </c:marker>
          <c:yVal>
            <c:numRef>
              <c:f>hc_sub_007!$M$2:$M$351</c:f>
              <c:numCache>
                <c:formatCode>0.00000000000_ </c:formatCode>
                <c:ptCount val="350"/>
                <c:pt idx="0">
                  <c:v>6866.53466796875</c:v>
                </c:pt>
                <c:pt idx="1">
                  <c:v>6869.6181640625</c:v>
                </c:pt>
                <c:pt idx="2">
                  <c:v>6913.40869140625</c:v>
                </c:pt>
                <c:pt idx="3">
                  <c:v>6972.728515625</c:v>
                </c:pt>
                <c:pt idx="4">
                  <c:v>7012.0927734375</c:v>
                </c:pt>
                <c:pt idx="5">
                  <c:v>7010.21533203125</c:v>
                </c:pt>
                <c:pt idx="6">
                  <c:v>6975.015625</c:v>
                </c:pt>
                <c:pt idx="7">
                  <c:v>6937.8505859375</c:v>
                </c:pt>
                <c:pt idx="8">
                  <c:v>6930.97509765625</c:v>
                </c:pt>
                <c:pt idx="9">
                  <c:v>6964.64208984375</c:v>
                </c:pt>
                <c:pt idx="10">
                  <c:v>7020.3388671875</c:v>
                </c:pt>
                <c:pt idx="11">
                  <c:v>7064.52734375</c:v>
                </c:pt>
                <c:pt idx="12">
                  <c:v>7072.275390625</c:v>
                </c:pt>
                <c:pt idx="13">
                  <c:v>7043.568359375</c:v>
                </c:pt>
                <c:pt idx="14">
                  <c:v>7001.31103515625</c:v>
                </c:pt>
                <c:pt idx="15">
                  <c:v>6973.76611328125</c:v>
                </c:pt>
                <c:pt idx="16">
                  <c:v>6974.9375</c:v>
                </c:pt>
                <c:pt idx="17">
                  <c:v>6996.6474609375</c:v>
                </c:pt>
                <c:pt idx="18">
                  <c:v>7016.64111328125</c:v>
                </c:pt>
                <c:pt idx="19">
                  <c:v>7015.58642578125</c:v>
                </c:pt>
                <c:pt idx="20">
                  <c:v>6990.57080078125</c:v>
                </c:pt>
                <c:pt idx="21">
                  <c:v>6956.421875</c:v>
                </c:pt>
                <c:pt idx="22">
                  <c:v>6935.14990234375</c:v>
                </c:pt>
                <c:pt idx="23">
                  <c:v>6941.3173828125</c:v>
                </c:pt>
                <c:pt idx="24">
                  <c:v>6972.73583984375</c:v>
                </c:pt>
                <c:pt idx="25">
                  <c:v>7011.64697265625</c:v>
                </c:pt>
                <c:pt idx="26">
                  <c:v>7035.05615234375</c:v>
                </c:pt>
                <c:pt idx="27">
                  <c:v>7028.0185546875</c:v>
                </c:pt>
                <c:pt idx="28">
                  <c:v>6992.49853515625</c:v>
                </c:pt>
                <c:pt idx="29">
                  <c:v>6946.896484375</c:v>
                </c:pt>
                <c:pt idx="30">
                  <c:v>6916.130859375</c:v>
                </c:pt>
                <c:pt idx="31">
                  <c:v>6917.30810546875</c:v>
                </c:pt>
                <c:pt idx="32">
                  <c:v>6949.06787109375</c:v>
                </c:pt>
                <c:pt idx="33">
                  <c:v>6991.49267578125</c:v>
                </c:pt>
                <c:pt idx="34">
                  <c:v>7017.71044921875</c:v>
                </c:pt>
                <c:pt idx="35">
                  <c:v>7010.72265625</c:v>
                </c:pt>
                <c:pt idx="36">
                  <c:v>6974.6396484375</c:v>
                </c:pt>
                <c:pt idx="37">
                  <c:v>6932.23681640625</c:v>
                </c:pt>
                <c:pt idx="38">
                  <c:v>6909.79736328125</c:v>
                </c:pt>
                <c:pt idx="39">
                  <c:v>6919.54443359375</c:v>
                </c:pt>
                <c:pt idx="40">
                  <c:v>6952.28466796875</c:v>
                </c:pt>
                <c:pt idx="41">
                  <c:v>6985.638671875</c:v>
                </c:pt>
                <c:pt idx="42">
                  <c:v>7001.291015625</c:v>
                </c:pt>
                <c:pt idx="43">
                  <c:v>6997.474609375</c:v>
                </c:pt>
                <c:pt idx="44">
                  <c:v>6986.68017578125</c:v>
                </c:pt>
                <c:pt idx="45">
                  <c:v>6980.935546875</c:v>
                </c:pt>
                <c:pt idx="46">
                  <c:v>6977.98779296875</c:v>
                </c:pt>
                <c:pt idx="47">
                  <c:v>6961.71337890625</c:v>
                </c:pt>
                <c:pt idx="48">
                  <c:v>6918.2041015625</c:v>
                </c:pt>
                <c:pt idx="49">
                  <c:v>6854.58447265625</c:v>
                </c:pt>
                <c:pt idx="50">
                  <c:v>6803.11083984375</c:v>
                </c:pt>
                <c:pt idx="51">
                  <c:v>6803.49072265625</c:v>
                </c:pt>
                <c:pt idx="52">
                  <c:v>6874.24365234375</c:v>
                </c:pt>
                <c:pt idx="53">
                  <c:v>6994.72900390625</c:v>
                </c:pt>
                <c:pt idx="54">
                  <c:v>7113.47998046875</c:v>
                </c:pt>
                <c:pt idx="55">
                  <c:v>7179.1591796875</c:v>
                </c:pt>
                <c:pt idx="56">
                  <c:v>7172.6728515625</c:v>
                </c:pt>
                <c:pt idx="57">
                  <c:v>7117.14501953125</c:v>
                </c:pt>
                <c:pt idx="58">
                  <c:v>7058.70458984375</c:v>
                </c:pt>
                <c:pt idx="59">
                  <c:v>7032.9697265625</c:v>
                </c:pt>
                <c:pt idx="60">
                  <c:v>7042.4931640625</c:v>
                </c:pt>
                <c:pt idx="61">
                  <c:v>7061.09326171875</c:v>
                </c:pt>
                <c:pt idx="62">
                  <c:v>7059.55419921875</c:v>
                </c:pt>
                <c:pt idx="63">
                  <c:v>7030.884765625</c:v>
                </c:pt>
                <c:pt idx="64">
                  <c:v>6994.96240234375</c:v>
                </c:pt>
                <c:pt idx="65">
                  <c:v>6980.04931640625</c:v>
                </c:pt>
                <c:pt idx="66">
                  <c:v>6997.5244140625</c:v>
                </c:pt>
                <c:pt idx="67">
                  <c:v>7030.919921875</c:v>
                </c:pt>
                <c:pt idx="68">
                  <c:v>7047.78466796875</c:v>
                </c:pt>
                <c:pt idx="69">
                  <c:v>7024.03271484375</c:v>
                </c:pt>
                <c:pt idx="70">
                  <c:v>6961.052734375</c:v>
                </c:pt>
                <c:pt idx="71">
                  <c:v>6882.9990234375</c:v>
                </c:pt>
                <c:pt idx="72">
                  <c:v>6818.5234375</c:v>
                </c:pt>
                <c:pt idx="73">
                  <c:v>6783.04736328125</c:v>
                </c:pt>
                <c:pt idx="74">
                  <c:v>6775.076171875</c:v>
                </c:pt>
                <c:pt idx="75">
                  <c:v>6786.3544921875</c:v>
                </c:pt>
                <c:pt idx="76">
                  <c:v>6813.59814453125</c:v>
                </c:pt>
                <c:pt idx="77">
                  <c:v>6859.685546875</c:v>
                </c:pt>
                <c:pt idx="78">
                  <c:v>6923.75146484375</c:v>
                </c:pt>
                <c:pt idx="79">
                  <c:v>6991.482421875</c:v>
                </c:pt>
                <c:pt idx="80">
                  <c:v>7037.78369140625</c:v>
                </c:pt>
                <c:pt idx="81">
                  <c:v>7042.76220703125</c:v>
                </c:pt>
                <c:pt idx="82">
                  <c:v>7008.68603515625</c:v>
                </c:pt>
                <c:pt idx="83">
                  <c:v>6962.54736328125</c:v>
                </c:pt>
                <c:pt idx="84">
                  <c:v>6939.6416015625</c:v>
                </c:pt>
                <c:pt idx="85">
                  <c:v>6959.38427734375</c:v>
                </c:pt>
                <c:pt idx="86">
                  <c:v>7011.87060546875</c:v>
                </c:pt>
                <c:pt idx="87">
                  <c:v>7065.84765625</c:v>
                </c:pt>
                <c:pt idx="88">
                  <c:v>7091.8984375</c:v>
                </c:pt>
                <c:pt idx="89">
                  <c:v>7082.77880859375</c:v>
                </c:pt>
                <c:pt idx="90">
                  <c:v>7055.63427734375</c:v>
                </c:pt>
                <c:pt idx="91">
                  <c:v>7035.79638671875</c:v>
                </c:pt>
                <c:pt idx="92">
                  <c:v>7036.3203125</c:v>
                </c:pt>
                <c:pt idx="93">
                  <c:v>7049.64111328125</c:v>
                </c:pt>
                <c:pt idx="94">
                  <c:v>7056.5146484375</c:v>
                </c:pt>
                <c:pt idx="95">
                  <c:v>7042.93994140625</c:v>
                </c:pt>
                <c:pt idx="96">
                  <c:v>7010.30517578125</c:v>
                </c:pt>
                <c:pt idx="97">
                  <c:v>6971.45556640625</c:v>
                </c:pt>
                <c:pt idx="98">
                  <c:v>6938.36328125</c:v>
                </c:pt>
                <c:pt idx="99">
                  <c:v>6913.80322265625</c:v>
                </c:pt>
                <c:pt idx="100">
                  <c:v>6894.33447265625</c:v>
                </c:pt>
                <c:pt idx="101">
                  <c:v>6880.24609375</c:v>
                </c:pt>
                <c:pt idx="102">
                  <c:v>6881.05224609375</c:v>
                </c:pt>
                <c:pt idx="103">
                  <c:v>6909.23779296875</c:v>
                </c:pt>
                <c:pt idx="104">
                  <c:v>6966.595703125</c:v>
                </c:pt>
                <c:pt idx="105">
                  <c:v>7035.78076171875</c:v>
                </c:pt>
                <c:pt idx="106">
                  <c:v>7086.666015625</c:v>
                </c:pt>
                <c:pt idx="107">
                  <c:v>7094.77783203125</c:v>
                </c:pt>
                <c:pt idx="108">
                  <c:v>7058.1533203125</c:v>
                </c:pt>
                <c:pt idx="109">
                  <c:v>6999.10595703125</c:v>
                </c:pt>
                <c:pt idx="110">
                  <c:v>6949.0400390625</c:v>
                </c:pt>
                <c:pt idx="111">
                  <c:v>6927.9140625</c:v>
                </c:pt>
                <c:pt idx="112">
                  <c:v>6933.92431640625</c:v>
                </c:pt>
                <c:pt idx="113">
                  <c:v>6950.22509765625</c:v>
                </c:pt>
                <c:pt idx="114">
                  <c:v>6961.5361328125</c:v>
                </c:pt>
                <c:pt idx="115">
                  <c:v>6966.07421875</c:v>
                </c:pt>
                <c:pt idx="116">
                  <c:v>6973.37255859375</c:v>
                </c:pt>
                <c:pt idx="117">
                  <c:v>6991.29296875</c:v>
                </c:pt>
                <c:pt idx="118">
                  <c:v>7014.7734375</c:v>
                </c:pt>
                <c:pt idx="119">
                  <c:v>7026.849609375</c:v>
                </c:pt>
                <c:pt idx="120">
                  <c:v>7011.38623046875</c:v>
                </c:pt>
                <c:pt idx="121">
                  <c:v>6966.67578125</c:v>
                </c:pt>
                <c:pt idx="122">
                  <c:v>6908.37451171875</c:v>
                </c:pt>
                <c:pt idx="123">
                  <c:v>6859.40869140625</c:v>
                </c:pt>
                <c:pt idx="124">
                  <c:v>6835.25732421875</c:v>
                </c:pt>
                <c:pt idx="125">
                  <c:v>6836.24267578125</c:v>
                </c:pt>
                <c:pt idx="126">
                  <c:v>6851.84619140625</c:v>
                </c:pt>
                <c:pt idx="127">
                  <c:v>6871.87890625</c:v>
                </c:pt>
                <c:pt idx="128">
                  <c:v>6894.42041015625</c:v>
                </c:pt>
                <c:pt idx="129">
                  <c:v>6924.50634765625</c:v>
                </c:pt>
                <c:pt idx="130">
                  <c:v>6966.2265625</c:v>
                </c:pt>
                <c:pt idx="131">
                  <c:v>7016.2509765625</c:v>
                </c:pt>
                <c:pt idx="132">
                  <c:v>7064.478515625</c:v>
                </c:pt>
                <c:pt idx="133">
                  <c:v>7100.40869140625</c:v>
                </c:pt>
                <c:pt idx="134">
                  <c:v>7118.91015625</c:v>
                </c:pt>
                <c:pt idx="135">
                  <c:v>7120.64404296875</c:v>
                </c:pt>
                <c:pt idx="136">
                  <c:v>7108.310546875</c:v>
                </c:pt>
                <c:pt idx="137">
                  <c:v>7083.95654296875</c:v>
                </c:pt>
                <c:pt idx="138">
                  <c:v>7050.677734375</c:v>
                </c:pt>
                <c:pt idx="139">
                  <c:v>7016.3193359375</c:v>
                </c:pt>
                <c:pt idx="140">
                  <c:v>6993.337890625</c:v>
                </c:pt>
                <c:pt idx="141">
                  <c:v>6992.01123046875</c:v>
                </c:pt>
                <c:pt idx="142">
                  <c:v>7011.26611328125</c:v>
                </c:pt>
                <c:pt idx="143">
                  <c:v>7035.6787109375</c:v>
                </c:pt>
                <c:pt idx="144">
                  <c:v>7043.56689453125</c:v>
                </c:pt>
                <c:pt idx="145">
                  <c:v>7021.83349609375</c:v>
                </c:pt>
                <c:pt idx="146">
                  <c:v>6976.27001953125</c:v>
                </c:pt>
                <c:pt idx="147">
                  <c:v>6928.31884765625</c:v>
                </c:pt>
                <c:pt idx="148">
                  <c:v>6899.859375</c:v>
                </c:pt>
                <c:pt idx="149">
                  <c:v>6897.7802734375</c:v>
                </c:pt>
                <c:pt idx="150">
                  <c:v>6910.849609375</c:v>
                </c:pt>
                <c:pt idx="151">
                  <c:v>6921.35302734375</c:v>
                </c:pt>
                <c:pt idx="152">
                  <c:v>6921.31103515625</c:v>
                </c:pt>
                <c:pt idx="153">
                  <c:v>6918.90576171875</c:v>
                </c:pt>
                <c:pt idx="154">
                  <c:v>6929.11962890625</c:v>
                </c:pt>
                <c:pt idx="155">
                  <c:v>6956.783203125</c:v>
                </c:pt>
                <c:pt idx="156">
                  <c:v>6987.81982421875</c:v>
                </c:pt>
                <c:pt idx="157">
                  <c:v>6998.22021484375</c:v>
                </c:pt>
                <c:pt idx="158">
                  <c:v>6974.82177734375</c:v>
                </c:pt>
                <c:pt idx="159">
                  <c:v>6930.388671875</c:v>
                </c:pt>
                <c:pt idx="160">
                  <c:v>6898.4091796875</c:v>
                </c:pt>
                <c:pt idx="161">
                  <c:v>6909.06005859375</c:v>
                </c:pt>
                <c:pt idx="162">
                  <c:v>6964.16796875</c:v>
                </c:pt>
                <c:pt idx="163">
                  <c:v>7031.70263671875</c:v>
                </c:pt>
                <c:pt idx="164">
                  <c:v>7066.193359375</c:v>
                </c:pt>
                <c:pt idx="165">
                  <c:v>7041.158203125</c:v>
                </c:pt>
                <c:pt idx="166">
                  <c:v>6969.40478515625</c:v>
                </c:pt>
                <c:pt idx="167">
                  <c:v>6895.51953125</c:v>
                </c:pt>
                <c:pt idx="168">
                  <c:v>6865.69970703125</c:v>
                </c:pt>
                <c:pt idx="169">
                  <c:v>6897.017578125</c:v>
                </c:pt>
                <c:pt idx="170">
                  <c:v>6968.1171875</c:v>
                </c:pt>
                <c:pt idx="171">
                  <c:v>7036.65380859375</c:v>
                </c:pt>
                <c:pt idx="172">
                  <c:v>7068.900390625</c:v>
                </c:pt>
                <c:pt idx="173">
                  <c:v>7059.33154296875</c:v>
                </c:pt>
                <c:pt idx="174">
                  <c:v>7027.6806640625</c:v>
                </c:pt>
                <c:pt idx="175">
                  <c:v>6999.2138671875</c:v>
                </c:pt>
                <c:pt idx="176">
                  <c:v>6985.82958984375</c:v>
                </c:pt>
                <c:pt idx="177">
                  <c:v>6982.34130859375</c:v>
                </c:pt>
                <c:pt idx="178">
                  <c:v>6977.951171875</c:v>
                </c:pt>
                <c:pt idx="179">
                  <c:v>6970.19140625</c:v>
                </c:pt>
                <c:pt idx="180">
                  <c:v>6967.96142578125</c:v>
                </c:pt>
                <c:pt idx="181">
                  <c:v>6981.29296875</c:v>
                </c:pt>
                <c:pt idx="182">
                  <c:v>7008.04541015625</c:v>
                </c:pt>
                <c:pt idx="183">
                  <c:v>7030.8017578125</c:v>
                </c:pt>
                <c:pt idx="184">
                  <c:v>7028.412109375</c:v>
                </c:pt>
                <c:pt idx="185">
                  <c:v>6993.5810546875</c:v>
                </c:pt>
                <c:pt idx="186">
                  <c:v>6941.92919921875</c:v>
                </c:pt>
                <c:pt idx="187">
                  <c:v>6904.087890625</c:v>
                </c:pt>
                <c:pt idx="188">
                  <c:v>6905.69091796875</c:v>
                </c:pt>
                <c:pt idx="189">
                  <c:v>6949.767578125</c:v>
                </c:pt>
                <c:pt idx="190">
                  <c:v>7014.390625</c:v>
                </c:pt>
                <c:pt idx="191">
                  <c:v>7067.01171875</c:v>
                </c:pt>
                <c:pt idx="192">
                  <c:v>7084.802734375</c:v>
                </c:pt>
                <c:pt idx="193">
                  <c:v>7066.68603515625</c:v>
                </c:pt>
                <c:pt idx="194">
                  <c:v>7029.7490234375</c:v>
                </c:pt>
                <c:pt idx="195">
                  <c:v>6994.4404296875</c:v>
                </c:pt>
                <c:pt idx="196">
                  <c:v>6970.3642578125</c:v>
                </c:pt>
                <c:pt idx="197">
                  <c:v>6952.67236328125</c:v>
                </c:pt>
                <c:pt idx="198">
                  <c:v>6930.27734375</c:v>
                </c:pt>
                <c:pt idx="199">
                  <c:v>6898.42578125</c:v>
                </c:pt>
                <c:pt idx="200">
                  <c:v>6865.6982421875</c:v>
                </c:pt>
                <c:pt idx="201">
                  <c:v>6850.267578125</c:v>
                </c:pt>
                <c:pt idx="202">
                  <c:v>6868.09716796875</c:v>
                </c:pt>
                <c:pt idx="203">
                  <c:v>6921.11767578125</c:v>
                </c:pt>
                <c:pt idx="204">
                  <c:v>6993.1630859375</c:v>
                </c:pt>
                <c:pt idx="205">
                  <c:v>7056.39306640625</c:v>
                </c:pt>
                <c:pt idx="206">
                  <c:v>7084.7041015625</c:v>
                </c:pt>
                <c:pt idx="207">
                  <c:v>7066.818359375</c:v>
                </c:pt>
                <c:pt idx="208">
                  <c:v>7012.080078125</c:v>
                </c:pt>
                <c:pt idx="209">
                  <c:v>6945.94091796875</c:v>
                </c:pt>
                <c:pt idx="210">
                  <c:v>6897.48779296875</c:v>
                </c:pt>
                <c:pt idx="211">
                  <c:v>6885.47509765625</c:v>
                </c:pt>
                <c:pt idx="212">
                  <c:v>6910.072265625</c:v>
                </c:pt>
                <c:pt idx="213">
                  <c:v>6954.45849609375</c:v>
                </c:pt>
                <c:pt idx="214">
                  <c:v>6994.95068359375</c:v>
                </c:pt>
                <c:pt idx="215">
                  <c:v>7013.671875</c:v>
                </c:pt>
                <c:pt idx="216">
                  <c:v>7006.66943359375</c:v>
                </c:pt>
                <c:pt idx="217">
                  <c:v>6983.58642578125</c:v>
                </c:pt>
                <c:pt idx="218">
                  <c:v>6960.365234375</c:v>
                </c:pt>
                <c:pt idx="219">
                  <c:v>6950.345703125</c:v>
                </c:pt>
                <c:pt idx="220">
                  <c:v>6958.99560546875</c:v>
                </c:pt>
                <c:pt idx="221">
                  <c:v>6983.92236328125</c:v>
                </c:pt>
                <c:pt idx="222">
                  <c:v>7017.93701171875</c:v>
                </c:pt>
                <c:pt idx="223">
                  <c:v>7051.80029296875</c:v>
                </c:pt>
                <c:pt idx="224">
                  <c:v>7075.38427734375</c:v>
                </c:pt>
                <c:pt idx="225">
                  <c:v>7078.82666015625</c:v>
                </c:pt>
                <c:pt idx="226">
                  <c:v>7055.73486328125</c:v>
                </c:pt>
                <c:pt idx="227">
                  <c:v>7007.9423828125</c:v>
                </c:pt>
                <c:pt idx="228">
                  <c:v>6948.17529296875</c:v>
                </c:pt>
                <c:pt idx="229">
                  <c:v>6896.7734375</c:v>
                </c:pt>
                <c:pt idx="230">
                  <c:v>6872.42138671875</c:v>
                </c:pt>
                <c:pt idx="231">
                  <c:v>6882.03515625</c:v>
                </c:pt>
                <c:pt idx="232">
                  <c:v>6916.88232421875</c:v>
                </c:pt>
                <c:pt idx="233">
                  <c:v>6958.396484375</c:v>
                </c:pt>
                <c:pt idx="234">
                  <c:v>6990.13720703125</c:v>
                </c:pt>
                <c:pt idx="235">
                  <c:v>7007.44677734375</c:v>
                </c:pt>
                <c:pt idx="236">
                  <c:v>7017.7705078125</c:v>
                </c:pt>
                <c:pt idx="237">
                  <c:v>7031.64892578125</c:v>
                </c:pt>
                <c:pt idx="238">
                  <c:v>7051.68212890625</c:v>
                </c:pt>
                <c:pt idx="239">
                  <c:v>7068.4091796875</c:v>
                </c:pt>
                <c:pt idx="240">
                  <c:v>7066.6435546875</c:v>
                </c:pt>
                <c:pt idx="241">
                  <c:v>7037.51611328125</c:v>
                </c:pt>
                <c:pt idx="242">
                  <c:v>6986.9453125</c:v>
                </c:pt>
                <c:pt idx="243">
                  <c:v>6933.96826171875</c:v>
                </c:pt>
                <c:pt idx="244">
                  <c:v>6900.07958984375</c:v>
                </c:pt>
                <c:pt idx="245">
                  <c:v>6897.185546875</c:v>
                </c:pt>
                <c:pt idx="246">
                  <c:v>6922.18212890625</c:v>
                </c:pt>
                <c:pt idx="247">
                  <c:v>6960.65625</c:v>
                </c:pt>
                <c:pt idx="248">
                  <c:v>6995.6845703125</c:v>
                </c:pt>
                <c:pt idx="249">
                  <c:v>7015.27880859375</c:v>
                </c:pt>
                <c:pt idx="250">
                  <c:v>7014.888671875</c:v>
                </c:pt>
                <c:pt idx="251">
                  <c:v>6996.109375</c:v>
                </c:pt>
                <c:pt idx="252">
                  <c:v>6964.92236328125</c:v>
                </c:pt>
                <c:pt idx="253">
                  <c:v>6930.9677734375</c:v>
                </c:pt>
                <c:pt idx="254">
                  <c:v>6906.171875</c:v>
                </c:pt>
                <c:pt idx="255">
                  <c:v>6900.4775390625</c:v>
                </c:pt>
                <c:pt idx="256">
                  <c:v>6915.58349609375</c:v>
                </c:pt>
                <c:pt idx="257">
                  <c:v>6941.3974609375</c:v>
                </c:pt>
                <c:pt idx="258">
                  <c:v>6959.9716796875</c:v>
                </c:pt>
                <c:pt idx="259">
                  <c:v>6956.6201171875</c:v>
                </c:pt>
                <c:pt idx="260">
                  <c:v>6931.33984375</c:v>
                </c:pt>
                <c:pt idx="261">
                  <c:v>6901.50390625</c:v>
                </c:pt>
                <c:pt idx="262">
                  <c:v>6891.9990234375</c:v>
                </c:pt>
                <c:pt idx="263">
                  <c:v>6918.373046875</c:v>
                </c:pt>
                <c:pt idx="264">
                  <c:v>6974.81201171875</c:v>
                </c:pt>
                <c:pt idx="265">
                  <c:v>7036.31103515625</c:v>
                </c:pt>
                <c:pt idx="266">
                  <c:v>7074.3701171875</c:v>
                </c:pt>
                <c:pt idx="267">
                  <c:v>7075.369140625</c:v>
                </c:pt>
                <c:pt idx="268">
                  <c:v>7048.50927734375</c:v>
                </c:pt>
                <c:pt idx="269">
                  <c:v>7017.8681640625</c:v>
                </c:pt>
                <c:pt idx="270">
                  <c:v>7004.953125</c:v>
                </c:pt>
                <c:pt idx="271">
                  <c:v>7014.88916015625</c:v>
                </c:pt>
                <c:pt idx="272">
                  <c:v>7035.92431640625</c:v>
                </c:pt>
                <c:pt idx="273">
                  <c:v>7051.1396484375</c:v>
                </c:pt>
                <c:pt idx="274">
                  <c:v>7051.93701171875</c:v>
                </c:pt>
                <c:pt idx="275">
                  <c:v>7042.40966796875</c:v>
                </c:pt>
                <c:pt idx="276">
                  <c:v>7032.09814453125</c:v>
                </c:pt>
                <c:pt idx="277">
                  <c:v>7024.72119140625</c:v>
                </c:pt>
                <c:pt idx="278">
                  <c:v>7013.7041015625</c:v>
                </c:pt>
                <c:pt idx="279">
                  <c:v>6989.06396484375</c:v>
                </c:pt>
                <c:pt idx="280">
                  <c:v>6949.78759765625</c:v>
                </c:pt>
                <c:pt idx="281">
                  <c:v>6910.185546875</c:v>
                </c:pt>
                <c:pt idx="282">
                  <c:v>6892.91796875</c:v>
                </c:pt>
                <c:pt idx="283">
                  <c:v>6912.412109375</c:v>
                </c:pt>
                <c:pt idx="284">
                  <c:v>6961.23486328125</c:v>
                </c:pt>
                <c:pt idx="285">
                  <c:v>7011.173828125</c:v>
                </c:pt>
                <c:pt idx="286">
                  <c:v>7030.212890625</c:v>
                </c:pt>
                <c:pt idx="287">
                  <c:v>7004.2333984375</c:v>
                </c:pt>
                <c:pt idx="288">
                  <c:v>6947.69921875</c:v>
                </c:pt>
                <c:pt idx="289">
                  <c:v>6894.81298828125</c:v>
                </c:pt>
                <c:pt idx="290">
                  <c:v>6876.59619140625</c:v>
                </c:pt>
                <c:pt idx="291">
                  <c:v>6899.82568359375</c:v>
                </c:pt>
                <c:pt idx="292">
                  <c:v>6942.8291015625</c:v>
                </c:pt>
                <c:pt idx="293">
                  <c:v>6971.32470703125</c:v>
                </c:pt>
                <c:pt idx="294">
                  <c:v>6963.20703125</c:v>
                </c:pt>
                <c:pt idx="295">
                  <c:v>6924.7421875</c:v>
                </c:pt>
                <c:pt idx="296">
                  <c:v>6886.6552734375</c:v>
                </c:pt>
                <c:pt idx="297">
                  <c:v>6882.70458984375</c:v>
                </c:pt>
                <c:pt idx="298">
                  <c:v>6925.6416015625</c:v>
                </c:pt>
                <c:pt idx="299">
                  <c:v>6997.25341796875</c:v>
                </c:pt>
                <c:pt idx="300">
                  <c:v>7059.4296875</c:v>
                </c:pt>
                <c:pt idx="301">
                  <c:v>7078.74169921875</c:v>
                </c:pt>
                <c:pt idx="302">
                  <c:v>7047.91796875</c:v>
                </c:pt>
                <c:pt idx="303">
                  <c:v>6989.93505859375</c:v>
                </c:pt>
                <c:pt idx="304">
                  <c:v>6942.44775390625</c:v>
                </c:pt>
                <c:pt idx="305">
                  <c:v>6933.48876953125</c:v>
                </c:pt>
                <c:pt idx="306">
                  <c:v>6964.8466796875</c:v>
                </c:pt>
                <c:pt idx="307">
                  <c:v>7013.658203125</c:v>
                </c:pt>
                <c:pt idx="308">
                  <c:v>7049.9453125</c:v>
                </c:pt>
                <c:pt idx="309">
                  <c:v>7057.05859375</c:v>
                </c:pt>
                <c:pt idx="310">
                  <c:v>7040.69580078125</c:v>
                </c:pt>
                <c:pt idx="311">
                  <c:v>7021.041015625</c:v>
                </c:pt>
                <c:pt idx="312">
                  <c:v>7015.0107421875</c:v>
                </c:pt>
                <c:pt idx="313">
                  <c:v>7022.5927734375</c:v>
                </c:pt>
                <c:pt idx="314">
                  <c:v>7027.7392578125</c:v>
                </c:pt>
                <c:pt idx="315">
                  <c:v>7012.88818359375</c:v>
                </c:pt>
                <c:pt idx="316">
                  <c:v>6975.451171875</c:v>
                </c:pt>
                <c:pt idx="317">
                  <c:v>6932.74267578125</c:v>
                </c:pt>
                <c:pt idx="318">
                  <c:v>6910.486328125</c:v>
                </c:pt>
                <c:pt idx="319">
                  <c:v>6922.90869140625</c:v>
                </c:pt>
                <c:pt idx="320">
                  <c:v>6959.736328125</c:v>
                </c:pt>
                <c:pt idx="321">
                  <c:v>6991.16455078125</c:v>
                </c:pt>
                <c:pt idx="322">
                  <c:v>6988.71875</c:v>
                </c:pt>
                <c:pt idx="323">
                  <c:v>6947.458984375</c:v>
                </c:pt>
                <c:pt idx="324">
                  <c:v>6892.7958984375</c:v>
                </c:pt>
                <c:pt idx="325">
                  <c:v>6865.505859375</c:v>
                </c:pt>
                <c:pt idx="326">
                  <c:v>6894.216796875</c:v>
                </c:pt>
                <c:pt idx="327">
                  <c:v>6974.26123046875</c:v>
                </c:pt>
                <c:pt idx="328">
                  <c:v>7068.0322265625</c:v>
                </c:pt>
                <c:pt idx="329">
                  <c:v>7127.255859375</c:v>
                </c:pt>
                <c:pt idx="330">
                  <c:v>7122.42724609375</c:v>
                </c:pt>
                <c:pt idx="331">
                  <c:v>7059.89501953125</c:v>
                </c:pt>
                <c:pt idx="332">
                  <c:v>6975.974609375</c:v>
                </c:pt>
                <c:pt idx="333">
                  <c:v>6913.3115234375</c:v>
                </c:pt>
                <c:pt idx="334">
                  <c:v>6896.06787109375</c:v>
                </c:pt>
                <c:pt idx="335">
                  <c:v>6919.650390625</c:v>
                </c:pt>
                <c:pt idx="336">
                  <c:v>6959.25390625</c:v>
                </c:pt>
                <c:pt idx="337">
                  <c:v>6988.4833984375</c:v>
                </c:pt>
                <c:pt idx="338">
                  <c:v>6994.1865234375</c:v>
                </c:pt>
                <c:pt idx="339">
                  <c:v>6978.986328125</c:v>
                </c:pt>
                <c:pt idx="340">
                  <c:v>6953.49951171875</c:v>
                </c:pt>
                <c:pt idx="341">
                  <c:v>6927.14306640625</c:v>
                </c:pt>
                <c:pt idx="342">
                  <c:v>6905.03759765625</c:v>
                </c:pt>
                <c:pt idx="343">
                  <c:v>6891.21240234375</c:v>
                </c:pt>
                <c:pt idx="344">
                  <c:v>6892.103515625</c:v>
                </c:pt>
                <c:pt idx="345">
                  <c:v>6914.654296875</c:v>
                </c:pt>
                <c:pt idx="346">
                  <c:v>6959.4111328125</c:v>
                </c:pt>
                <c:pt idx="347">
                  <c:v>7015.04296875</c:v>
                </c:pt>
                <c:pt idx="348">
                  <c:v>7060.8681640625</c:v>
                </c:pt>
                <c:pt idx="349">
                  <c:v>7077.78271484375</c:v>
                </c:pt>
              </c:numCache>
            </c:numRef>
          </c:yVal>
          <c:smooth val="1"/>
          <c:extLst>
            <c:ext xmlns:c16="http://schemas.microsoft.com/office/drawing/2014/chart" uri="{C3380CC4-5D6E-409C-BE32-E72D297353CC}">
              <c16:uniqueId val="{0000000C-0DDB-41B5-BE83-A9CFE49F3CE3}"/>
            </c:ext>
          </c:extLst>
        </c:ser>
        <c:ser>
          <c:idx val="13"/>
          <c:order val="13"/>
          <c:tx>
            <c:strRef>
              <c:f>hc_sub_007!$N$1</c:f>
              <c:strCache>
                <c:ptCount val="1"/>
                <c:pt idx="0">
                  <c:v>Coor_14</c:v>
                </c:pt>
              </c:strCache>
            </c:strRef>
          </c:tx>
          <c:spPr>
            <a:ln w="28575" cap="rnd">
              <a:solidFill>
                <a:schemeClr val="accent2">
                  <a:lumMod val="80000"/>
                  <a:lumOff val="20000"/>
                </a:schemeClr>
              </a:solidFill>
              <a:round/>
            </a:ln>
            <a:effectLst/>
          </c:spPr>
          <c:marker>
            <c:symbol val="none"/>
          </c:marker>
          <c:yVal>
            <c:numRef>
              <c:f>hc_sub_007!$N$2:$N$351</c:f>
              <c:numCache>
                <c:formatCode>0.00000000000_ </c:formatCode>
                <c:ptCount val="350"/>
                <c:pt idx="0">
                  <c:v>5793.373046875</c:v>
                </c:pt>
                <c:pt idx="1">
                  <c:v>5744.10595703125</c:v>
                </c:pt>
                <c:pt idx="2">
                  <c:v>5740.27587890625</c:v>
                </c:pt>
                <c:pt idx="3">
                  <c:v>5793.220703125</c:v>
                </c:pt>
                <c:pt idx="4">
                  <c:v>5875.1826171875</c:v>
                </c:pt>
                <c:pt idx="5">
                  <c:v>5935.43310546875</c:v>
                </c:pt>
                <c:pt idx="6">
                  <c:v>5935.1484375</c:v>
                </c:pt>
                <c:pt idx="7">
                  <c:v>5875.45849609375</c:v>
                </c:pt>
                <c:pt idx="8">
                  <c:v>5797.3837890625</c:v>
                </c:pt>
                <c:pt idx="9">
                  <c:v>5753.46826171875</c:v>
                </c:pt>
                <c:pt idx="10">
                  <c:v>5772.16064453125</c:v>
                </c:pt>
                <c:pt idx="11">
                  <c:v>5840.83740234375</c:v>
                </c:pt>
                <c:pt idx="12">
                  <c:v>5918.2578125</c:v>
                </c:pt>
                <c:pt idx="13">
                  <c:v>5964.8046875</c:v>
                </c:pt>
                <c:pt idx="14">
                  <c:v>5966.76806640625</c:v>
                </c:pt>
                <c:pt idx="15">
                  <c:v>5938.0634765625</c:v>
                </c:pt>
                <c:pt idx="16">
                  <c:v>5901.98974609375</c:v>
                </c:pt>
                <c:pt idx="17">
                  <c:v>5870.7880859375</c:v>
                </c:pt>
                <c:pt idx="18">
                  <c:v>5840.02783203125</c:v>
                </c:pt>
                <c:pt idx="19">
                  <c:v>5800.26025390625</c:v>
                </c:pt>
                <c:pt idx="20">
                  <c:v>5753.1826171875</c:v>
                </c:pt>
                <c:pt idx="21">
                  <c:v>5716.521484375</c:v>
                </c:pt>
                <c:pt idx="22">
                  <c:v>5712.6611328125</c:v>
                </c:pt>
                <c:pt idx="23">
                  <c:v>5750.65087890625</c:v>
                </c:pt>
                <c:pt idx="24">
                  <c:v>5816.96240234375</c:v>
                </c:pt>
                <c:pt idx="25">
                  <c:v>5882.84619140625</c:v>
                </c:pt>
                <c:pt idx="26">
                  <c:v>5922.39892578125</c:v>
                </c:pt>
                <c:pt idx="27">
                  <c:v>5927.3369140625</c:v>
                </c:pt>
                <c:pt idx="28">
                  <c:v>5908.224609375</c:v>
                </c:pt>
                <c:pt idx="29">
                  <c:v>5883.4931640625</c:v>
                </c:pt>
                <c:pt idx="30">
                  <c:v>5866.6259765625</c:v>
                </c:pt>
                <c:pt idx="31">
                  <c:v>5861.25537109375</c:v>
                </c:pt>
                <c:pt idx="32">
                  <c:v>5865.30126953125</c:v>
                </c:pt>
                <c:pt idx="33">
                  <c:v>5877.20263671875</c:v>
                </c:pt>
                <c:pt idx="34">
                  <c:v>5896.92431640625</c:v>
                </c:pt>
                <c:pt idx="35">
                  <c:v>5921.28173828125</c:v>
                </c:pt>
                <c:pt idx="36">
                  <c:v>5940.1220703125</c:v>
                </c:pt>
                <c:pt idx="37">
                  <c:v>5939.90283203125</c:v>
                </c:pt>
                <c:pt idx="38">
                  <c:v>5914.01025390625</c:v>
                </c:pt>
                <c:pt idx="39">
                  <c:v>5871.4013671875</c:v>
                </c:pt>
                <c:pt idx="40">
                  <c:v>5834.53076171875</c:v>
                </c:pt>
                <c:pt idx="41">
                  <c:v>5825.45166015625</c:v>
                </c:pt>
                <c:pt idx="42">
                  <c:v>5849.24609375</c:v>
                </c:pt>
                <c:pt idx="43">
                  <c:v>5887.71728515625</c:v>
                </c:pt>
                <c:pt idx="44">
                  <c:v>5909.68505859375</c:v>
                </c:pt>
                <c:pt idx="45">
                  <c:v>5891.97705078125</c:v>
                </c:pt>
                <c:pt idx="46">
                  <c:v>5836.6513671875</c:v>
                </c:pt>
                <c:pt idx="47">
                  <c:v>5771.91259765625</c:v>
                </c:pt>
                <c:pt idx="48">
                  <c:v>5735.34033203125</c:v>
                </c:pt>
                <c:pt idx="49">
                  <c:v>5750.22021484375</c:v>
                </c:pt>
                <c:pt idx="50">
                  <c:v>5810.37353515625</c:v>
                </c:pt>
                <c:pt idx="51">
                  <c:v>5882.9716796875</c:v>
                </c:pt>
                <c:pt idx="52">
                  <c:v>5927.126953125</c:v>
                </c:pt>
                <c:pt idx="53">
                  <c:v>5916.58447265625</c:v>
                </c:pt>
                <c:pt idx="54">
                  <c:v>5853.40283203125</c:v>
                </c:pt>
                <c:pt idx="55">
                  <c:v>5765.9013671875</c:v>
                </c:pt>
                <c:pt idx="56">
                  <c:v>5693.4658203125</c:v>
                </c:pt>
                <c:pt idx="57">
                  <c:v>5667.29052734375</c:v>
                </c:pt>
                <c:pt idx="58">
                  <c:v>5696.86572265625</c:v>
                </c:pt>
                <c:pt idx="59">
                  <c:v>5767.7880859375</c:v>
                </c:pt>
                <c:pt idx="60">
                  <c:v>5850.4521484375</c:v>
                </c:pt>
                <c:pt idx="61">
                  <c:v>5914.41162109375</c:v>
                </c:pt>
                <c:pt idx="62">
                  <c:v>5941.48046875</c:v>
                </c:pt>
                <c:pt idx="63">
                  <c:v>5932.041015625</c:v>
                </c:pt>
                <c:pt idx="64">
                  <c:v>5902.533203125</c:v>
                </c:pt>
                <c:pt idx="65">
                  <c:v>5876.05126953125</c:v>
                </c:pt>
                <c:pt idx="66">
                  <c:v>5870.74560546875</c:v>
                </c:pt>
                <c:pt idx="67">
                  <c:v>5891.2587890625</c:v>
                </c:pt>
                <c:pt idx="68">
                  <c:v>5926.71923828125</c:v>
                </c:pt>
                <c:pt idx="69">
                  <c:v>5955.9248046875</c:v>
                </c:pt>
                <c:pt idx="70">
                  <c:v>5957.51513671875</c:v>
                </c:pt>
                <c:pt idx="71">
                  <c:v>5921.06494140625</c:v>
                </c:pt>
                <c:pt idx="72">
                  <c:v>5854.4052734375</c:v>
                </c:pt>
                <c:pt idx="73">
                  <c:v>5783.24755859375</c:v>
                </c:pt>
                <c:pt idx="74">
                  <c:v>5741.65087890625</c:v>
                </c:pt>
                <c:pt idx="75">
                  <c:v>5755.984375</c:v>
                </c:pt>
                <c:pt idx="76">
                  <c:v>5829.45947265625</c:v>
                </c:pt>
                <c:pt idx="77">
                  <c:v>5936.16845703125</c:v>
                </c:pt>
                <c:pt idx="78">
                  <c:v>6030.31591796875</c:v>
                </c:pt>
                <c:pt idx="79">
                  <c:v>6068.158203125</c:v>
                </c:pt>
                <c:pt idx="80">
                  <c:v>6031.39794921875</c:v>
                </c:pt>
                <c:pt idx="81">
                  <c:v>5937.80224609375</c:v>
                </c:pt>
                <c:pt idx="82">
                  <c:v>5831.232421875</c:v>
                </c:pt>
                <c:pt idx="83">
                  <c:v>5756.22802734375</c:v>
                </c:pt>
                <c:pt idx="84">
                  <c:v>5733.19775390625</c:v>
                </c:pt>
                <c:pt idx="85">
                  <c:v>5750.58642578125</c:v>
                </c:pt>
                <c:pt idx="86">
                  <c:v>5778.7666015625</c:v>
                </c:pt>
                <c:pt idx="87">
                  <c:v>5794.623046875</c:v>
                </c:pt>
                <c:pt idx="88">
                  <c:v>5797.83740234375</c:v>
                </c:pt>
                <c:pt idx="89">
                  <c:v>5806.44873046875</c:v>
                </c:pt>
                <c:pt idx="90">
                  <c:v>5835.9794921875</c:v>
                </c:pt>
                <c:pt idx="91">
                  <c:v>5880.2158203125</c:v>
                </c:pt>
                <c:pt idx="92">
                  <c:v>5911.15576171875</c:v>
                </c:pt>
                <c:pt idx="93">
                  <c:v>5900.212890625</c:v>
                </c:pt>
                <c:pt idx="94">
                  <c:v>5844.4091796875</c:v>
                </c:pt>
                <c:pt idx="95">
                  <c:v>5775.20263671875</c:v>
                </c:pt>
                <c:pt idx="96">
                  <c:v>5739.81494140625</c:v>
                </c:pt>
                <c:pt idx="97">
                  <c:v>5766.806640625</c:v>
                </c:pt>
                <c:pt idx="98">
                  <c:v>5841.84912109375</c:v>
                </c:pt>
                <c:pt idx="99">
                  <c:v>5913.94873046875</c:v>
                </c:pt>
                <c:pt idx="100">
                  <c:v>5930.03369140625</c:v>
                </c:pt>
                <c:pt idx="101">
                  <c:v>5873.5810546875</c:v>
                </c:pt>
                <c:pt idx="102">
                  <c:v>5778.49267578125</c:v>
                </c:pt>
                <c:pt idx="103">
                  <c:v>5706.939453125</c:v>
                </c:pt>
                <c:pt idx="104">
                  <c:v>5706.58837890625</c:v>
                </c:pt>
                <c:pt idx="105">
                  <c:v>5778.11669921875</c:v>
                </c:pt>
                <c:pt idx="106">
                  <c:v>5876.3603515625</c:v>
                </c:pt>
                <c:pt idx="107">
                  <c:v>5943.4462890625</c:v>
                </c:pt>
                <c:pt idx="108">
                  <c:v>5948.96044921875</c:v>
                </c:pt>
                <c:pt idx="109">
                  <c:v>5907.9921875</c:v>
                </c:pt>
                <c:pt idx="110">
                  <c:v>5865.43017578125</c:v>
                </c:pt>
                <c:pt idx="111">
                  <c:v>5860.2216796875</c:v>
                </c:pt>
                <c:pt idx="112">
                  <c:v>5897.18701171875</c:v>
                </c:pt>
                <c:pt idx="113">
                  <c:v>5946.578125</c:v>
                </c:pt>
                <c:pt idx="114">
                  <c:v>5969.65380859375</c:v>
                </c:pt>
                <c:pt idx="115">
                  <c:v>5949.28564453125</c:v>
                </c:pt>
                <c:pt idx="116">
                  <c:v>5902.29150390625</c:v>
                </c:pt>
                <c:pt idx="117">
                  <c:v>5865.36572265625</c:v>
                </c:pt>
                <c:pt idx="118">
                  <c:v>5866.6826171875</c:v>
                </c:pt>
                <c:pt idx="119">
                  <c:v>5905.0888671875</c:v>
                </c:pt>
                <c:pt idx="120">
                  <c:v>5951.75341796875</c:v>
                </c:pt>
                <c:pt idx="121">
                  <c:v>5971.70458984375</c:v>
                </c:pt>
                <c:pt idx="122">
                  <c:v>5948.37548828125</c:v>
                </c:pt>
                <c:pt idx="123">
                  <c:v>5893.3671875</c:v>
                </c:pt>
                <c:pt idx="124">
                  <c:v>5835.626953125</c:v>
                </c:pt>
                <c:pt idx="125">
                  <c:v>5799.47802734375</c:v>
                </c:pt>
                <c:pt idx="126">
                  <c:v>5788.2080078125</c:v>
                </c:pt>
                <c:pt idx="127">
                  <c:v>5784.71240234375</c:v>
                </c:pt>
                <c:pt idx="128">
                  <c:v>5767.6201171875</c:v>
                </c:pt>
                <c:pt idx="129">
                  <c:v>5730.20654296875</c:v>
                </c:pt>
                <c:pt idx="130">
                  <c:v>5687.89306640625</c:v>
                </c:pt>
                <c:pt idx="131">
                  <c:v>5668.740234375</c:v>
                </c:pt>
                <c:pt idx="132">
                  <c:v>5693.62060546875</c:v>
                </c:pt>
                <c:pt idx="133">
                  <c:v>5760.13916015625</c:v>
                </c:pt>
                <c:pt idx="134">
                  <c:v>5841.84716796875</c:v>
                </c:pt>
                <c:pt idx="135">
                  <c:v>5903.78369140625</c:v>
                </c:pt>
                <c:pt idx="136">
                  <c:v>5924.04248046875</c:v>
                </c:pt>
                <c:pt idx="137">
                  <c:v>5906.74755859375</c:v>
                </c:pt>
                <c:pt idx="138">
                  <c:v>5877.5576171875</c:v>
                </c:pt>
                <c:pt idx="139">
                  <c:v>5864.89501953125</c:v>
                </c:pt>
                <c:pt idx="140">
                  <c:v>5880.11474609375</c:v>
                </c:pt>
                <c:pt idx="141">
                  <c:v>5910.65380859375</c:v>
                </c:pt>
                <c:pt idx="142">
                  <c:v>5930.8662109375</c:v>
                </c:pt>
                <c:pt idx="143">
                  <c:v>5922.3046875</c:v>
                </c:pt>
                <c:pt idx="144">
                  <c:v>5888.123046875</c:v>
                </c:pt>
                <c:pt idx="145">
                  <c:v>5850.626953125</c:v>
                </c:pt>
                <c:pt idx="146">
                  <c:v>5833.85009765625</c:v>
                </c:pt>
                <c:pt idx="147">
                  <c:v>5844.7568359375</c:v>
                </c:pt>
                <c:pt idx="148">
                  <c:v>5867.9931640625</c:v>
                </c:pt>
                <c:pt idx="149">
                  <c:v>5878.642578125</c:v>
                </c:pt>
                <c:pt idx="150">
                  <c:v>5863.05810546875</c:v>
                </c:pt>
                <c:pt idx="151">
                  <c:v>5830.9833984375</c:v>
                </c:pt>
                <c:pt idx="152">
                  <c:v>5808.7099609375</c:v>
                </c:pt>
                <c:pt idx="153">
                  <c:v>5818.12255859375</c:v>
                </c:pt>
                <c:pt idx="154">
                  <c:v>5858.189453125</c:v>
                </c:pt>
                <c:pt idx="155">
                  <c:v>5904.0986328125</c:v>
                </c:pt>
                <c:pt idx="156">
                  <c:v>5925.47509765625</c:v>
                </c:pt>
                <c:pt idx="157">
                  <c:v>5909.7587890625</c:v>
                </c:pt>
                <c:pt idx="158">
                  <c:v>5872.3251953125</c:v>
                </c:pt>
                <c:pt idx="159">
                  <c:v>5845.109375</c:v>
                </c:pt>
                <c:pt idx="160">
                  <c:v>5852.34375</c:v>
                </c:pt>
                <c:pt idx="161">
                  <c:v>5892.0703125</c:v>
                </c:pt>
                <c:pt idx="162">
                  <c:v>5937.35498046875</c:v>
                </c:pt>
                <c:pt idx="163">
                  <c:v>5955.6416015625</c:v>
                </c:pt>
                <c:pt idx="164">
                  <c:v>5931.02197265625</c:v>
                </c:pt>
                <c:pt idx="165">
                  <c:v>5873.08349609375</c:v>
                </c:pt>
                <c:pt idx="166">
                  <c:v>5807.61376953125</c:v>
                </c:pt>
                <c:pt idx="167">
                  <c:v>5758.5869140625</c:v>
                </c:pt>
                <c:pt idx="168">
                  <c:v>5736.02685546875</c:v>
                </c:pt>
                <c:pt idx="169">
                  <c:v>5737.11767578125</c:v>
                </c:pt>
                <c:pt idx="170">
                  <c:v>5755.63427734375</c:v>
                </c:pt>
                <c:pt idx="171">
                  <c:v>5788.49853515625</c:v>
                </c:pt>
                <c:pt idx="172">
                  <c:v>5833.02099609375</c:v>
                </c:pt>
                <c:pt idx="173">
                  <c:v>5879.107421875</c:v>
                </c:pt>
                <c:pt idx="174">
                  <c:v>5906.919921875</c:v>
                </c:pt>
                <c:pt idx="175">
                  <c:v>5896.0927734375</c:v>
                </c:pt>
                <c:pt idx="176">
                  <c:v>5841.40283203125</c:v>
                </c:pt>
                <c:pt idx="177">
                  <c:v>5762.0361328125</c:v>
                </c:pt>
                <c:pt idx="178">
                  <c:v>5694.8837890625</c:v>
                </c:pt>
                <c:pt idx="179">
                  <c:v>5674.47900390625</c:v>
                </c:pt>
                <c:pt idx="180">
                  <c:v>5713.1748046875</c:v>
                </c:pt>
                <c:pt idx="181">
                  <c:v>5795.4970703125</c:v>
                </c:pt>
                <c:pt idx="182">
                  <c:v>5889.9033203125</c:v>
                </c:pt>
                <c:pt idx="183">
                  <c:v>5968.20458984375</c:v>
                </c:pt>
                <c:pt idx="184">
                  <c:v>6018.34130859375</c:v>
                </c:pt>
                <c:pt idx="185">
                  <c:v>6043.12890625</c:v>
                </c:pt>
                <c:pt idx="186">
                  <c:v>6049.56103515625</c:v>
                </c:pt>
                <c:pt idx="187">
                  <c:v>6039.873046875</c:v>
                </c:pt>
                <c:pt idx="188">
                  <c:v>6011.85205078125</c:v>
                </c:pt>
                <c:pt idx="189">
                  <c:v>5966.09423828125</c:v>
                </c:pt>
                <c:pt idx="190">
                  <c:v>5911.35595703125</c:v>
                </c:pt>
                <c:pt idx="191">
                  <c:v>5861.57470703125</c:v>
                </c:pt>
                <c:pt idx="192">
                  <c:v>5826.7373046875</c:v>
                </c:pt>
                <c:pt idx="193">
                  <c:v>5806.16943359375</c:v>
                </c:pt>
                <c:pt idx="194">
                  <c:v>5790.90576171875</c:v>
                </c:pt>
                <c:pt idx="195">
                  <c:v>5773.3818359375</c:v>
                </c:pt>
                <c:pt idx="196">
                  <c:v>5755.71533203125</c:v>
                </c:pt>
                <c:pt idx="197">
                  <c:v>5748.86572265625</c:v>
                </c:pt>
                <c:pt idx="198">
                  <c:v>5763.1552734375</c:v>
                </c:pt>
                <c:pt idx="199">
                  <c:v>5798.46044921875</c:v>
                </c:pt>
                <c:pt idx="200">
                  <c:v>5842.66943359375</c:v>
                </c:pt>
                <c:pt idx="201">
                  <c:v>5879.5654296875</c:v>
                </c:pt>
                <c:pt idx="202">
                  <c:v>5899.00439453125</c:v>
                </c:pt>
                <c:pt idx="203">
                  <c:v>5900.73876953125</c:v>
                </c:pt>
                <c:pt idx="204">
                  <c:v>5889.7109375</c:v>
                </c:pt>
                <c:pt idx="205">
                  <c:v>5868.8056640625</c:v>
                </c:pt>
                <c:pt idx="206">
                  <c:v>5837.07958984375</c:v>
                </c:pt>
                <c:pt idx="207">
                  <c:v>5795.41748046875</c:v>
                </c:pt>
                <c:pt idx="208">
                  <c:v>5753.27978515625</c:v>
                </c:pt>
                <c:pt idx="209">
                  <c:v>5727.97802734375</c:v>
                </c:pt>
                <c:pt idx="210">
                  <c:v>5734.45556640625</c:v>
                </c:pt>
                <c:pt idx="211">
                  <c:v>5773.12841796875</c:v>
                </c:pt>
                <c:pt idx="212">
                  <c:v>5826.79052734375</c:v>
                </c:pt>
                <c:pt idx="213">
                  <c:v>5870.9140625</c:v>
                </c:pt>
                <c:pt idx="214">
                  <c:v>5890.162109375</c:v>
                </c:pt>
                <c:pt idx="215">
                  <c:v>5887.9033203125</c:v>
                </c:pt>
                <c:pt idx="216">
                  <c:v>5880.8349609375</c:v>
                </c:pt>
                <c:pt idx="217">
                  <c:v>5883.43115234375</c:v>
                </c:pt>
                <c:pt idx="218">
                  <c:v>5895.818359375</c:v>
                </c:pt>
                <c:pt idx="219">
                  <c:v>5905.68212890625</c:v>
                </c:pt>
                <c:pt idx="220">
                  <c:v>5902.21923828125</c:v>
                </c:pt>
                <c:pt idx="221">
                  <c:v>5888.98486328125</c:v>
                </c:pt>
                <c:pt idx="222">
                  <c:v>5882.96142578125</c:v>
                </c:pt>
                <c:pt idx="223">
                  <c:v>5899.388671875</c:v>
                </c:pt>
                <c:pt idx="224">
                  <c:v>5935.31494140625</c:v>
                </c:pt>
                <c:pt idx="225">
                  <c:v>5967.2939453125</c:v>
                </c:pt>
                <c:pt idx="226">
                  <c:v>5967.33935546875</c:v>
                </c:pt>
                <c:pt idx="227">
                  <c:v>5925.3740234375</c:v>
                </c:pt>
                <c:pt idx="228">
                  <c:v>5859.794921875</c:v>
                </c:pt>
                <c:pt idx="229">
                  <c:v>5806.51416015625</c:v>
                </c:pt>
                <c:pt idx="230">
                  <c:v>5794.0966796875</c:v>
                </c:pt>
                <c:pt idx="231">
                  <c:v>5823.982421875</c:v>
                </c:pt>
                <c:pt idx="232">
                  <c:v>5870.77099609375</c:v>
                </c:pt>
                <c:pt idx="233">
                  <c:v>5901.52880859375</c:v>
                </c:pt>
                <c:pt idx="234">
                  <c:v>5898.4775390625</c:v>
                </c:pt>
                <c:pt idx="235">
                  <c:v>5868.02978515625</c:v>
                </c:pt>
                <c:pt idx="236">
                  <c:v>5831.3486328125</c:v>
                </c:pt>
                <c:pt idx="237">
                  <c:v>5806.4970703125</c:v>
                </c:pt>
                <c:pt idx="238">
                  <c:v>5797.30029296875</c:v>
                </c:pt>
                <c:pt idx="239">
                  <c:v>5796.12353515625</c:v>
                </c:pt>
                <c:pt idx="240">
                  <c:v>5794.9228515625</c:v>
                </c:pt>
                <c:pt idx="241">
                  <c:v>5792.89892578125</c:v>
                </c:pt>
                <c:pt idx="242">
                  <c:v>5794.4091796875</c:v>
                </c:pt>
                <c:pt idx="243">
                  <c:v>5801.3837890625</c:v>
                </c:pt>
                <c:pt idx="244">
                  <c:v>5809.72802734375</c:v>
                </c:pt>
                <c:pt idx="245">
                  <c:v>5814.1962890625</c:v>
                </c:pt>
                <c:pt idx="246">
                  <c:v>5816.369140625</c:v>
                </c:pt>
                <c:pt idx="247">
                  <c:v>5825.9296875</c:v>
                </c:pt>
                <c:pt idx="248">
                  <c:v>5851.50634765625</c:v>
                </c:pt>
                <c:pt idx="249">
                  <c:v>5888.5869140625</c:v>
                </c:pt>
                <c:pt idx="250">
                  <c:v>5917.1630859375</c:v>
                </c:pt>
                <c:pt idx="251">
                  <c:v>5914.66064453125</c:v>
                </c:pt>
                <c:pt idx="252">
                  <c:v>5875.5107421875</c:v>
                </c:pt>
                <c:pt idx="253">
                  <c:v>5820.38330078125</c:v>
                </c:pt>
                <c:pt idx="254">
                  <c:v>5784.47802734375</c:v>
                </c:pt>
                <c:pt idx="255">
                  <c:v>5791.48583984375</c:v>
                </c:pt>
                <c:pt idx="256">
                  <c:v>5833.55712890625</c:v>
                </c:pt>
                <c:pt idx="257">
                  <c:v>5875.03515625</c:v>
                </c:pt>
                <c:pt idx="258">
                  <c:v>5879.44140625</c:v>
                </c:pt>
                <c:pt idx="259">
                  <c:v>5839.58740234375</c:v>
                </c:pt>
                <c:pt idx="260">
                  <c:v>5786.4072265625</c:v>
                </c:pt>
                <c:pt idx="261">
                  <c:v>5767.80517578125</c:v>
                </c:pt>
                <c:pt idx="262">
                  <c:v>5812.56103515625</c:v>
                </c:pt>
                <c:pt idx="263">
                  <c:v>5906.87744140625</c:v>
                </c:pt>
                <c:pt idx="264">
                  <c:v>6002.01806640625</c:v>
                </c:pt>
                <c:pt idx="265">
                  <c:v>6047.60009765625</c:v>
                </c:pt>
                <c:pt idx="266">
                  <c:v>6025.51123046875</c:v>
                </c:pt>
                <c:pt idx="267">
                  <c:v>5959.544921875</c:v>
                </c:pt>
                <c:pt idx="268">
                  <c:v>5895.16259765625</c:v>
                </c:pt>
                <c:pt idx="269">
                  <c:v>5866.4365234375</c:v>
                </c:pt>
                <c:pt idx="270">
                  <c:v>5875.40576171875</c:v>
                </c:pt>
                <c:pt idx="271">
                  <c:v>5897.34521484375</c:v>
                </c:pt>
                <c:pt idx="272">
                  <c:v>5904.4345703125</c:v>
                </c:pt>
                <c:pt idx="273">
                  <c:v>5887.29736328125</c:v>
                </c:pt>
                <c:pt idx="274">
                  <c:v>5858.236328125</c:v>
                </c:pt>
                <c:pt idx="275">
                  <c:v>5836.5751953125</c:v>
                </c:pt>
                <c:pt idx="276">
                  <c:v>5830.72314453125</c:v>
                </c:pt>
                <c:pt idx="277">
                  <c:v>5832.27490234375</c:v>
                </c:pt>
                <c:pt idx="278">
                  <c:v>5825.654296875</c:v>
                </c:pt>
                <c:pt idx="279">
                  <c:v>5803.4892578125</c:v>
                </c:pt>
                <c:pt idx="280">
                  <c:v>5774.1865234375</c:v>
                </c:pt>
                <c:pt idx="281">
                  <c:v>5755.91796875</c:v>
                </c:pt>
                <c:pt idx="282">
                  <c:v>5762.751953125</c:v>
                </c:pt>
                <c:pt idx="283">
                  <c:v>5794.19970703125</c:v>
                </c:pt>
                <c:pt idx="284">
                  <c:v>5835.423828125</c:v>
                </c:pt>
                <c:pt idx="285">
                  <c:v>5866.51953125</c:v>
                </c:pt>
                <c:pt idx="286">
                  <c:v>5873.39697265625</c:v>
                </c:pt>
                <c:pt idx="287">
                  <c:v>5853.6435546875</c:v>
                </c:pt>
                <c:pt idx="288">
                  <c:v>5815.8486328125</c:v>
                </c:pt>
                <c:pt idx="289">
                  <c:v>5774.9130859375</c:v>
                </c:pt>
                <c:pt idx="290">
                  <c:v>5746.24462890625</c:v>
                </c:pt>
                <c:pt idx="291">
                  <c:v>5740.12744140625</c:v>
                </c:pt>
                <c:pt idx="292">
                  <c:v>5757.20947265625</c:v>
                </c:pt>
                <c:pt idx="293">
                  <c:v>5787.3828125</c:v>
                </c:pt>
                <c:pt idx="294">
                  <c:v>5814.68017578125</c:v>
                </c:pt>
                <c:pt idx="295">
                  <c:v>5827.537109375</c:v>
                </c:pt>
                <c:pt idx="296">
                  <c:v>5828.45751953125</c:v>
                </c:pt>
                <c:pt idx="297">
                  <c:v>5834.89453125</c:v>
                </c:pt>
                <c:pt idx="298">
                  <c:v>5867.91845703125</c:v>
                </c:pt>
                <c:pt idx="299">
                  <c:v>5934.80810546875</c:v>
                </c:pt>
                <c:pt idx="300">
                  <c:v>6018.46337890625</c:v>
                </c:pt>
                <c:pt idx="301">
                  <c:v>6083.59375</c:v>
                </c:pt>
                <c:pt idx="302">
                  <c:v>6097.70361328125</c:v>
                </c:pt>
                <c:pt idx="303">
                  <c:v>6052.81005859375</c:v>
                </c:pt>
                <c:pt idx="304">
                  <c:v>5971.8134765625</c:v>
                </c:pt>
                <c:pt idx="305">
                  <c:v>5894.1513671875</c:v>
                </c:pt>
                <c:pt idx="306">
                  <c:v>5850.8388671875</c:v>
                </c:pt>
                <c:pt idx="307">
                  <c:v>5846.90283203125</c:v>
                </c:pt>
                <c:pt idx="308">
                  <c:v>5863.02294921875</c:v>
                </c:pt>
                <c:pt idx="309">
                  <c:v>5873.02197265625</c:v>
                </c:pt>
                <c:pt idx="310">
                  <c:v>5862.30859375</c:v>
                </c:pt>
                <c:pt idx="311">
                  <c:v>5833.642578125</c:v>
                </c:pt>
                <c:pt idx="312">
                  <c:v>5798.8466796875</c:v>
                </c:pt>
                <c:pt idx="313">
                  <c:v>5766.9912109375</c:v>
                </c:pt>
                <c:pt idx="314">
                  <c:v>5740.775390625</c:v>
                </c:pt>
                <c:pt idx="315">
                  <c:v>5722.8447265625</c:v>
                </c:pt>
                <c:pt idx="316">
                  <c:v>5722.685546875</c:v>
                </c:pt>
                <c:pt idx="317">
                  <c:v>5753.4638671875</c:v>
                </c:pt>
                <c:pt idx="318">
                  <c:v>5818.47802734375</c:v>
                </c:pt>
                <c:pt idx="319">
                  <c:v>5899.208984375</c:v>
                </c:pt>
                <c:pt idx="320">
                  <c:v>5958.9580078125</c:v>
                </c:pt>
                <c:pt idx="321">
                  <c:v>5964.2607421875</c:v>
                </c:pt>
                <c:pt idx="322">
                  <c:v>5909.9560546875</c:v>
                </c:pt>
                <c:pt idx="323">
                  <c:v>5827.58251953125</c:v>
                </c:pt>
                <c:pt idx="324">
                  <c:v>5767.56982421875</c:v>
                </c:pt>
                <c:pt idx="325">
                  <c:v>5765.9765625</c:v>
                </c:pt>
                <c:pt idx="326">
                  <c:v>5819.76171875</c:v>
                </c:pt>
                <c:pt idx="327">
                  <c:v>5889.33154296875</c:v>
                </c:pt>
                <c:pt idx="328">
                  <c:v>5926.7529296875</c:v>
                </c:pt>
                <c:pt idx="329">
                  <c:v>5908.67578125</c:v>
                </c:pt>
                <c:pt idx="330">
                  <c:v>5850.064453125</c:v>
                </c:pt>
                <c:pt idx="331">
                  <c:v>5790.35888671875</c:v>
                </c:pt>
                <c:pt idx="332">
                  <c:v>5764.69677734375</c:v>
                </c:pt>
                <c:pt idx="333">
                  <c:v>5782.52490234375</c:v>
                </c:pt>
                <c:pt idx="334">
                  <c:v>5827.4853515625</c:v>
                </c:pt>
                <c:pt idx="335">
                  <c:v>5874.30078125</c:v>
                </c:pt>
                <c:pt idx="336">
                  <c:v>5906.2119140625</c:v>
                </c:pt>
                <c:pt idx="337">
                  <c:v>5919.662109375</c:v>
                </c:pt>
                <c:pt idx="338">
                  <c:v>5916.791015625</c:v>
                </c:pt>
                <c:pt idx="339">
                  <c:v>5897.38427734375</c:v>
                </c:pt>
                <c:pt idx="340">
                  <c:v>5860.32080078125</c:v>
                </c:pt>
                <c:pt idx="341">
                  <c:v>5812.70703125</c:v>
                </c:pt>
                <c:pt idx="342">
                  <c:v>5774.9609375</c:v>
                </c:pt>
                <c:pt idx="343">
                  <c:v>5772.30078125</c:v>
                </c:pt>
                <c:pt idx="344">
                  <c:v>5816.060546875</c:v>
                </c:pt>
                <c:pt idx="345">
                  <c:v>5889.98876953125</c:v>
                </c:pt>
                <c:pt idx="346">
                  <c:v>5955.529296875</c:v>
                </c:pt>
                <c:pt idx="347">
                  <c:v>5975.53857421875</c:v>
                </c:pt>
                <c:pt idx="348">
                  <c:v>5939.923828125</c:v>
                </c:pt>
                <c:pt idx="349">
                  <c:v>5873.3017578125</c:v>
                </c:pt>
              </c:numCache>
            </c:numRef>
          </c:yVal>
          <c:smooth val="1"/>
          <c:extLst>
            <c:ext xmlns:c16="http://schemas.microsoft.com/office/drawing/2014/chart" uri="{C3380CC4-5D6E-409C-BE32-E72D297353CC}">
              <c16:uniqueId val="{0000000D-0DDB-41B5-BE83-A9CFE49F3CE3}"/>
            </c:ext>
          </c:extLst>
        </c:ser>
        <c:ser>
          <c:idx val="14"/>
          <c:order val="14"/>
          <c:tx>
            <c:strRef>
              <c:f>hc_sub_007!$O$1</c:f>
              <c:strCache>
                <c:ptCount val="1"/>
                <c:pt idx="0">
                  <c:v>Coor_15</c:v>
                </c:pt>
              </c:strCache>
            </c:strRef>
          </c:tx>
          <c:spPr>
            <a:ln w="28575" cap="rnd">
              <a:solidFill>
                <a:schemeClr val="accent3">
                  <a:lumMod val="80000"/>
                  <a:lumOff val="20000"/>
                </a:schemeClr>
              </a:solidFill>
              <a:round/>
            </a:ln>
            <a:effectLst/>
          </c:spPr>
          <c:marker>
            <c:symbol val="none"/>
          </c:marker>
          <c:yVal>
            <c:numRef>
              <c:f>hc_sub_007!$O$2:$O$351</c:f>
              <c:numCache>
                <c:formatCode>0.00000000000_ </c:formatCode>
                <c:ptCount val="350"/>
                <c:pt idx="0">
                  <c:v>5741.5947265625</c:v>
                </c:pt>
                <c:pt idx="1">
                  <c:v>5712.3251953125</c:v>
                </c:pt>
                <c:pt idx="2">
                  <c:v>5695.0361328125</c:v>
                </c:pt>
                <c:pt idx="3">
                  <c:v>5705.35546875</c:v>
                </c:pt>
                <c:pt idx="4">
                  <c:v>5743.82666015625</c:v>
                </c:pt>
                <c:pt idx="5">
                  <c:v>5790.423828125</c:v>
                </c:pt>
                <c:pt idx="6">
                  <c:v>5814.36865234375</c:v>
                </c:pt>
                <c:pt idx="7">
                  <c:v>5794.77490234375</c:v>
                </c:pt>
                <c:pt idx="8">
                  <c:v>5737.7587890625</c:v>
                </c:pt>
                <c:pt idx="9">
                  <c:v>5676.09619140625</c:v>
                </c:pt>
                <c:pt idx="10">
                  <c:v>5649.36474609375</c:v>
                </c:pt>
                <c:pt idx="11">
                  <c:v>5677.4501953125</c:v>
                </c:pt>
                <c:pt idx="12">
                  <c:v>5746.55224609375</c:v>
                </c:pt>
                <c:pt idx="13">
                  <c:v>5818.525390625</c:v>
                </c:pt>
                <c:pt idx="14">
                  <c:v>5857.19384765625</c:v>
                </c:pt>
                <c:pt idx="15">
                  <c:v>5852.2685546875</c:v>
                </c:pt>
                <c:pt idx="16">
                  <c:v>5823.19287109375</c:v>
                </c:pt>
                <c:pt idx="17">
                  <c:v>5800.7158203125</c:v>
                </c:pt>
                <c:pt idx="18">
                  <c:v>5801.2646484375</c:v>
                </c:pt>
                <c:pt idx="19">
                  <c:v>5814.59228515625</c:v>
                </c:pt>
                <c:pt idx="20">
                  <c:v>5814.21923828125</c:v>
                </c:pt>
                <c:pt idx="21">
                  <c:v>5781.69580078125</c:v>
                </c:pt>
                <c:pt idx="22">
                  <c:v>5724.52392578125</c:v>
                </c:pt>
                <c:pt idx="23">
                  <c:v>5672.79443359375</c:v>
                </c:pt>
                <c:pt idx="24">
                  <c:v>5656.9892578125</c:v>
                </c:pt>
                <c:pt idx="25">
                  <c:v>5684.78857421875</c:v>
                </c:pt>
                <c:pt idx="26">
                  <c:v>5735.57470703125</c:v>
                </c:pt>
                <c:pt idx="27">
                  <c:v>5776.96923828125</c:v>
                </c:pt>
                <c:pt idx="28">
                  <c:v>5789.8974609375</c:v>
                </c:pt>
                <c:pt idx="29">
                  <c:v>5781.97216796875</c:v>
                </c:pt>
                <c:pt idx="30">
                  <c:v>5778.734375</c:v>
                </c:pt>
                <c:pt idx="31">
                  <c:v>5800.49169921875</c:v>
                </c:pt>
                <c:pt idx="32">
                  <c:v>5844.115234375</c:v>
                </c:pt>
                <c:pt idx="33">
                  <c:v>5884.83349609375</c:v>
                </c:pt>
                <c:pt idx="34">
                  <c:v>5896.4296875</c:v>
                </c:pt>
                <c:pt idx="35">
                  <c:v>5873.0419921875</c:v>
                </c:pt>
                <c:pt idx="36">
                  <c:v>5834.43603515625</c:v>
                </c:pt>
                <c:pt idx="37">
                  <c:v>5810.125</c:v>
                </c:pt>
                <c:pt idx="38">
                  <c:v>5815.00830078125</c:v>
                </c:pt>
                <c:pt idx="39">
                  <c:v>5836.232421875</c:v>
                </c:pt>
                <c:pt idx="40">
                  <c:v>5842.1669921875</c:v>
                </c:pt>
                <c:pt idx="41">
                  <c:v>5806.94140625</c:v>
                </c:pt>
                <c:pt idx="42">
                  <c:v>5731.79931640625</c:v>
                </c:pt>
                <c:pt idx="43">
                  <c:v>5647.04638671875</c:v>
                </c:pt>
                <c:pt idx="44">
                  <c:v>5593.17431640625</c:v>
                </c:pt>
                <c:pt idx="45">
                  <c:v>5595.05078125</c:v>
                </c:pt>
                <c:pt idx="46">
                  <c:v>5647.29736328125</c:v>
                </c:pt>
                <c:pt idx="47">
                  <c:v>5719.76123046875</c:v>
                </c:pt>
                <c:pt idx="48">
                  <c:v>5777.28662109375</c:v>
                </c:pt>
                <c:pt idx="49">
                  <c:v>5799.146484375</c:v>
                </c:pt>
                <c:pt idx="50">
                  <c:v>5786.21240234375</c:v>
                </c:pt>
                <c:pt idx="51">
                  <c:v>5754.47314453125</c:v>
                </c:pt>
                <c:pt idx="52">
                  <c:v>5722.85009765625</c:v>
                </c:pt>
                <c:pt idx="53">
                  <c:v>5704.61083984375</c:v>
                </c:pt>
                <c:pt idx="54">
                  <c:v>5705.837890625</c:v>
                </c:pt>
                <c:pt idx="55">
                  <c:v>5727.6298828125</c:v>
                </c:pt>
                <c:pt idx="56">
                  <c:v>5766.9853515625</c:v>
                </c:pt>
                <c:pt idx="57">
                  <c:v>5815.15478515625</c:v>
                </c:pt>
                <c:pt idx="58">
                  <c:v>5856.93701171875</c:v>
                </c:pt>
                <c:pt idx="59">
                  <c:v>5874.9150390625</c:v>
                </c:pt>
                <c:pt idx="60">
                  <c:v>5858.2431640625</c:v>
                </c:pt>
                <c:pt idx="61">
                  <c:v>5810.4462890625</c:v>
                </c:pt>
                <c:pt idx="62">
                  <c:v>5749.88623046875</c:v>
                </c:pt>
                <c:pt idx="63">
                  <c:v>5701.24658203125</c:v>
                </c:pt>
                <c:pt idx="64">
                  <c:v>5682.9658203125</c:v>
                </c:pt>
                <c:pt idx="65">
                  <c:v>5698.5625</c:v>
                </c:pt>
                <c:pt idx="66">
                  <c:v>5736.83203125</c:v>
                </c:pt>
                <c:pt idx="67">
                  <c:v>5779.58349609375</c:v>
                </c:pt>
                <c:pt idx="68">
                  <c:v>5810.97900390625</c:v>
                </c:pt>
                <c:pt idx="69">
                  <c:v>5823.015625</c:v>
                </c:pt>
                <c:pt idx="70">
                  <c:v>5815.8876953125</c:v>
                </c:pt>
                <c:pt idx="71">
                  <c:v>5795.7744140625</c:v>
                </c:pt>
                <c:pt idx="72">
                  <c:v>5772.77685546875</c:v>
                </c:pt>
                <c:pt idx="73">
                  <c:v>5759.0537109375</c:v>
                </c:pt>
                <c:pt idx="74">
                  <c:v>5765.15576171875</c:v>
                </c:pt>
                <c:pt idx="75">
                  <c:v>5794.03955078125</c:v>
                </c:pt>
                <c:pt idx="76">
                  <c:v>5836.029296875</c:v>
                </c:pt>
                <c:pt idx="77">
                  <c:v>5870.08837890625</c:v>
                </c:pt>
                <c:pt idx="78">
                  <c:v>5873.8046875</c:v>
                </c:pt>
                <c:pt idx="79">
                  <c:v>5837.693359375</c:v>
                </c:pt>
                <c:pt idx="80">
                  <c:v>5774.16455078125</c:v>
                </c:pt>
                <c:pt idx="81">
                  <c:v>5713.1005859375</c:v>
                </c:pt>
                <c:pt idx="82">
                  <c:v>5684.64794921875</c:v>
                </c:pt>
                <c:pt idx="83">
                  <c:v>5699.76416015625</c:v>
                </c:pt>
                <c:pt idx="84">
                  <c:v>5742.302734375</c:v>
                </c:pt>
                <c:pt idx="85">
                  <c:v>5779.46728515625</c:v>
                </c:pt>
                <c:pt idx="86">
                  <c:v>5784.51904296875</c:v>
                </c:pt>
                <c:pt idx="87">
                  <c:v>5756.10400390625</c:v>
                </c:pt>
                <c:pt idx="88">
                  <c:v>5719.97900390625</c:v>
                </c:pt>
                <c:pt idx="89">
                  <c:v>5711.0185546875</c:v>
                </c:pt>
                <c:pt idx="90">
                  <c:v>5747.60595703125</c:v>
                </c:pt>
                <c:pt idx="91">
                  <c:v>5816.4931640625</c:v>
                </c:pt>
                <c:pt idx="92">
                  <c:v>5879.224609375</c:v>
                </c:pt>
                <c:pt idx="93">
                  <c:v>5896.181640625</c:v>
                </c:pt>
                <c:pt idx="94">
                  <c:v>5851.9814453125</c:v>
                </c:pt>
                <c:pt idx="95">
                  <c:v>5765.22607421875</c:v>
                </c:pt>
                <c:pt idx="96">
                  <c:v>5676.7138671875</c:v>
                </c:pt>
                <c:pt idx="97">
                  <c:v>5624.94287109375</c:v>
                </c:pt>
                <c:pt idx="98">
                  <c:v>5625.52490234375</c:v>
                </c:pt>
                <c:pt idx="99">
                  <c:v>5666.95068359375</c:v>
                </c:pt>
                <c:pt idx="100">
                  <c:v>5722.87646484375</c:v>
                </c:pt>
                <c:pt idx="101">
                  <c:v>5770.13720703125</c:v>
                </c:pt>
                <c:pt idx="102">
                  <c:v>5799.67626953125</c:v>
                </c:pt>
                <c:pt idx="103">
                  <c:v>5814.90673828125</c:v>
                </c:pt>
                <c:pt idx="104">
                  <c:v>5822.12060546875</c:v>
                </c:pt>
                <c:pt idx="105">
                  <c:v>5822.5361328125</c:v>
                </c:pt>
                <c:pt idx="106">
                  <c:v>5812.30615234375</c:v>
                </c:pt>
                <c:pt idx="107">
                  <c:v>5788.96923828125</c:v>
                </c:pt>
                <c:pt idx="108">
                  <c:v>5757.27685546875</c:v>
                </c:pt>
                <c:pt idx="109">
                  <c:v>5728.46728515625</c:v>
                </c:pt>
                <c:pt idx="110">
                  <c:v>5713.3173828125</c:v>
                </c:pt>
                <c:pt idx="111">
                  <c:v>5714.90576171875</c:v>
                </c:pt>
                <c:pt idx="112">
                  <c:v>5727.2275390625</c:v>
                </c:pt>
                <c:pt idx="113">
                  <c:v>5740.60546875</c:v>
                </c:pt>
                <c:pt idx="114">
                  <c:v>5749.06591796875</c:v>
                </c:pt>
                <c:pt idx="115">
                  <c:v>5753.5166015625</c:v>
                </c:pt>
                <c:pt idx="116">
                  <c:v>5758.685546875</c:v>
                </c:pt>
                <c:pt idx="117">
                  <c:v>5767.49365234375</c:v>
                </c:pt>
                <c:pt idx="118">
                  <c:v>5778.54638671875</c:v>
                </c:pt>
                <c:pt idx="119">
                  <c:v>5788.98046875</c:v>
                </c:pt>
                <c:pt idx="120">
                  <c:v>5799.2109375</c:v>
                </c:pt>
                <c:pt idx="121">
                  <c:v>5813.76220703125</c:v>
                </c:pt>
                <c:pt idx="122">
                  <c:v>5835.92041015625</c:v>
                </c:pt>
                <c:pt idx="123">
                  <c:v>5860.58740234375</c:v>
                </c:pt>
                <c:pt idx="124">
                  <c:v>5873.12646484375</c:v>
                </c:pt>
                <c:pt idx="125">
                  <c:v>5858.15576171875</c:v>
                </c:pt>
                <c:pt idx="126">
                  <c:v>5813.44140625</c:v>
                </c:pt>
                <c:pt idx="127">
                  <c:v>5757.6181640625</c:v>
                </c:pt>
                <c:pt idx="128">
                  <c:v>5722.8720703125</c:v>
                </c:pt>
                <c:pt idx="129">
                  <c:v>5734.56884765625</c:v>
                </c:pt>
                <c:pt idx="130">
                  <c:v>5791.18994140625</c:v>
                </c:pt>
                <c:pt idx="131">
                  <c:v>5860.30419921875</c:v>
                </c:pt>
                <c:pt idx="132">
                  <c:v>5896.32275390625</c:v>
                </c:pt>
                <c:pt idx="133">
                  <c:v>5869.88330078125</c:v>
                </c:pt>
                <c:pt idx="134">
                  <c:v>5788.8310546875</c:v>
                </c:pt>
                <c:pt idx="135">
                  <c:v>5695.2001953125</c:v>
                </c:pt>
                <c:pt idx="136">
                  <c:v>5639.0478515625</c:v>
                </c:pt>
                <c:pt idx="137">
                  <c:v>5646.65625</c:v>
                </c:pt>
                <c:pt idx="138">
                  <c:v>5704.96337890625</c:v>
                </c:pt>
                <c:pt idx="139">
                  <c:v>5772.55810546875</c:v>
                </c:pt>
                <c:pt idx="140">
                  <c:v>5808.564453125</c:v>
                </c:pt>
                <c:pt idx="141">
                  <c:v>5798.44775390625</c:v>
                </c:pt>
                <c:pt idx="142">
                  <c:v>5759.166015625</c:v>
                </c:pt>
                <c:pt idx="143">
                  <c:v>5722.1611328125</c:v>
                </c:pt>
                <c:pt idx="144">
                  <c:v>5708.88916015625</c:v>
                </c:pt>
                <c:pt idx="145">
                  <c:v>5717.66015625</c:v>
                </c:pt>
                <c:pt idx="146">
                  <c:v>5730.14990234375</c:v>
                </c:pt>
                <c:pt idx="147">
                  <c:v>5729.955078125</c:v>
                </c:pt>
                <c:pt idx="148">
                  <c:v>5716.8427734375</c:v>
                </c:pt>
                <c:pt idx="149">
                  <c:v>5705.31005859375</c:v>
                </c:pt>
                <c:pt idx="150">
                  <c:v>5709.92041015625</c:v>
                </c:pt>
                <c:pt idx="151">
                  <c:v>5730.87109375</c:v>
                </c:pt>
                <c:pt idx="152">
                  <c:v>5752.5478515625</c:v>
                </c:pt>
                <c:pt idx="153">
                  <c:v>5756.4453125</c:v>
                </c:pt>
                <c:pt idx="154">
                  <c:v>5737.59228515625</c:v>
                </c:pt>
                <c:pt idx="155">
                  <c:v>5710.6591796875</c:v>
                </c:pt>
                <c:pt idx="156">
                  <c:v>5700.4345703125</c:v>
                </c:pt>
                <c:pt idx="157">
                  <c:v>5724.0458984375</c:v>
                </c:pt>
                <c:pt idx="158">
                  <c:v>5778.6875</c:v>
                </c:pt>
                <c:pt idx="159">
                  <c:v>5843.79931640625</c:v>
                </c:pt>
                <c:pt idx="160">
                  <c:v>5895.00927734375</c:v>
                </c:pt>
                <c:pt idx="161">
                  <c:v>5918.4794921875</c:v>
                </c:pt>
                <c:pt idx="162">
                  <c:v>5915.3466796875</c:v>
                </c:pt>
                <c:pt idx="163">
                  <c:v>5895.06689453125</c:v>
                </c:pt>
                <c:pt idx="164">
                  <c:v>5865.51220703125</c:v>
                </c:pt>
                <c:pt idx="165">
                  <c:v>5828.990234375</c:v>
                </c:pt>
                <c:pt idx="166">
                  <c:v>5786.56298828125</c:v>
                </c:pt>
                <c:pt idx="167">
                  <c:v>5744.67919921875</c:v>
                </c:pt>
                <c:pt idx="168">
                  <c:v>5715.9267578125</c:v>
                </c:pt>
                <c:pt idx="169">
                  <c:v>5711.513671875</c:v>
                </c:pt>
                <c:pt idx="170">
                  <c:v>5731.560546875</c:v>
                </c:pt>
                <c:pt idx="171">
                  <c:v>5762.44970703125</c:v>
                </c:pt>
                <c:pt idx="172">
                  <c:v>5785.12451171875</c:v>
                </c:pt>
                <c:pt idx="173">
                  <c:v>5788.7275390625</c:v>
                </c:pt>
                <c:pt idx="174">
                  <c:v>5778.62841796875</c:v>
                </c:pt>
                <c:pt idx="175">
                  <c:v>5771.75146484375</c:v>
                </c:pt>
                <c:pt idx="176">
                  <c:v>5782.36767578125</c:v>
                </c:pt>
                <c:pt idx="177">
                  <c:v>5809.6376953125</c:v>
                </c:pt>
                <c:pt idx="178">
                  <c:v>5837.22802734375</c:v>
                </c:pt>
                <c:pt idx="179">
                  <c:v>5845.6845703125</c:v>
                </c:pt>
                <c:pt idx="180">
                  <c:v>5827.7763671875</c:v>
                </c:pt>
                <c:pt idx="181">
                  <c:v>5794.36962890625</c:v>
                </c:pt>
                <c:pt idx="182">
                  <c:v>5765.900390625</c:v>
                </c:pt>
                <c:pt idx="183">
                  <c:v>5756.18310546875</c:v>
                </c:pt>
                <c:pt idx="184">
                  <c:v>5761.5498046875</c:v>
                </c:pt>
                <c:pt idx="185">
                  <c:v>5764.103515625</c:v>
                </c:pt>
                <c:pt idx="186">
                  <c:v>5746.5244140625</c:v>
                </c:pt>
                <c:pt idx="187">
                  <c:v>5706.59375</c:v>
                </c:pt>
                <c:pt idx="188">
                  <c:v>5659.89501953125</c:v>
                </c:pt>
                <c:pt idx="189">
                  <c:v>5628.6279296875</c:v>
                </c:pt>
                <c:pt idx="190">
                  <c:v>5625.466796875</c:v>
                </c:pt>
                <c:pt idx="191">
                  <c:v>5645.1328125</c:v>
                </c:pt>
                <c:pt idx="192">
                  <c:v>5669.98876953125</c:v>
                </c:pt>
                <c:pt idx="193">
                  <c:v>5684.79345703125</c:v>
                </c:pt>
                <c:pt idx="194">
                  <c:v>5688.72314453125</c:v>
                </c:pt>
                <c:pt idx="195">
                  <c:v>5695.2431640625</c:v>
                </c:pt>
                <c:pt idx="196">
                  <c:v>5720.18701171875</c:v>
                </c:pt>
                <c:pt idx="197">
                  <c:v>5767.57373046875</c:v>
                </c:pt>
                <c:pt idx="198">
                  <c:v>5824.24462890625</c:v>
                </c:pt>
                <c:pt idx="199">
                  <c:v>5867.41455078125</c:v>
                </c:pt>
                <c:pt idx="200">
                  <c:v>5879.48095703125</c:v>
                </c:pt>
                <c:pt idx="201">
                  <c:v>5859.353515625</c:v>
                </c:pt>
                <c:pt idx="202">
                  <c:v>5822.61328125</c:v>
                </c:pt>
                <c:pt idx="203">
                  <c:v>5791.18115234375</c:v>
                </c:pt>
                <c:pt idx="204">
                  <c:v>5780.27099609375</c:v>
                </c:pt>
                <c:pt idx="205">
                  <c:v>5791.33056640625</c:v>
                </c:pt>
                <c:pt idx="206">
                  <c:v>5814.4609375</c:v>
                </c:pt>
                <c:pt idx="207">
                  <c:v>5836.9521484375</c:v>
                </c:pt>
                <c:pt idx="208">
                  <c:v>5851.12109375</c:v>
                </c:pt>
                <c:pt idx="209">
                  <c:v>5856.47216796875</c:v>
                </c:pt>
                <c:pt idx="210">
                  <c:v>5856.1259765625</c:v>
                </c:pt>
                <c:pt idx="211">
                  <c:v>5851.50537109375</c:v>
                </c:pt>
                <c:pt idx="212">
                  <c:v>5839.787109375</c:v>
                </c:pt>
                <c:pt idx="213">
                  <c:v>5815.91162109375</c:v>
                </c:pt>
                <c:pt idx="214">
                  <c:v>5777.49072265625</c:v>
                </c:pt>
                <c:pt idx="215">
                  <c:v>5729.091796875</c:v>
                </c:pt>
                <c:pt idx="216">
                  <c:v>5682.9453125</c:v>
                </c:pt>
                <c:pt idx="217">
                  <c:v>5655.23828125</c:v>
                </c:pt>
                <c:pt idx="218">
                  <c:v>5659.42578125</c:v>
                </c:pt>
                <c:pt idx="219">
                  <c:v>5699.4287109375</c:v>
                </c:pt>
                <c:pt idx="220">
                  <c:v>5765.896484375</c:v>
                </c:pt>
                <c:pt idx="221">
                  <c:v>5837.7841796875</c:v>
                </c:pt>
                <c:pt idx="222">
                  <c:v>5889.5009765625</c:v>
                </c:pt>
                <c:pt idx="223">
                  <c:v>5901.1982421875</c:v>
                </c:pt>
                <c:pt idx="224">
                  <c:v>5867.689453125</c:v>
                </c:pt>
                <c:pt idx="225">
                  <c:v>5801.384765625</c:v>
                </c:pt>
                <c:pt idx="226">
                  <c:v>5727.1884765625</c:v>
                </c:pt>
                <c:pt idx="227">
                  <c:v>5671.484375</c:v>
                </c:pt>
                <c:pt idx="228">
                  <c:v>5650.7041015625</c:v>
                </c:pt>
                <c:pt idx="229">
                  <c:v>5665.263671875</c:v>
                </c:pt>
                <c:pt idx="230">
                  <c:v>5701.51953125</c:v>
                </c:pt>
                <c:pt idx="231">
                  <c:v>5739.787109375</c:v>
                </c:pt>
                <c:pt idx="232">
                  <c:v>5763.4931640625</c:v>
                </c:pt>
                <c:pt idx="233">
                  <c:v>5764.908203125</c:v>
                </c:pt>
                <c:pt idx="234">
                  <c:v>5745.966796875</c:v>
                </c:pt>
                <c:pt idx="235">
                  <c:v>5715.77294921875</c:v>
                </c:pt>
                <c:pt idx="236">
                  <c:v>5687.26806640625</c:v>
                </c:pt>
                <c:pt idx="237">
                  <c:v>5674.09912109375</c:v>
                </c:pt>
                <c:pt idx="238">
                  <c:v>5686.9873046875</c:v>
                </c:pt>
                <c:pt idx="239">
                  <c:v>5729.0244140625</c:v>
                </c:pt>
                <c:pt idx="240">
                  <c:v>5791.4990234375</c:v>
                </c:pt>
                <c:pt idx="241">
                  <c:v>5853.87548828125</c:v>
                </c:pt>
                <c:pt idx="242">
                  <c:v>5890.68115234375</c:v>
                </c:pt>
                <c:pt idx="243">
                  <c:v>5883.83935546875</c:v>
                </c:pt>
                <c:pt idx="244">
                  <c:v>5834.060546875</c:v>
                </c:pt>
                <c:pt idx="245">
                  <c:v>5763.46240234375</c:v>
                </c:pt>
                <c:pt idx="246">
                  <c:v>5705.83154296875</c:v>
                </c:pt>
                <c:pt idx="247">
                  <c:v>5688.79541015625</c:v>
                </c:pt>
                <c:pt idx="248">
                  <c:v>5718.3291015625</c:v>
                </c:pt>
                <c:pt idx="249">
                  <c:v>5775.578125</c:v>
                </c:pt>
                <c:pt idx="250">
                  <c:v>5828.51513671875</c:v>
                </c:pt>
                <c:pt idx="251">
                  <c:v>5851.208984375</c:v>
                </c:pt>
                <c:pt idx="252">
                  <c:v>5838.3544921875</c:v>
                </c:pt>
                <c:pt idx="253">
                  <c:v>5805.962890625</c:v>
                </c:pt>
                <c:pt idx="254">
                  <c:v>5778.6259765625</c:v>
                </c:pt>
                <c:pt idx="255">
                  <c:v>5772.77099609375</c:v>
                </c:pt>
                <c:pt idx="256">
                  <c:v>5787.37646484375</c:v>
                </c:pt>
                <c:pt idx="257">
                  <c:v>5807.5439453125</c:v>
                </c:pt>
                <c:pt idx="258">
                  <c:v>5816.822265625</c:v>
                </c:pt>
                <c:pt idx="259">
                  <c:v>5808.44677734375</c:v>
                </c:pt>
                <c:pt idx="260">
                  <c:v>5787.68994140625</c:v>
                </c:pt>
                <c:pt idx="261">
                  <c:v>5765.1787109375</c:v>
                </c:pt>
                <c:pt idx="262">
                  <c:v>5747.9853515625</c:v>
                </c:pt>
                <c:pt idx="263">
                  <c:v>5736.12939453125</c:v>
                </c:pt>
                <c:pt idx="264">
                  <c:v>5726.556640625</c:v>
                </c:pt>
                <c:pt idx="265">
                  <c:v>5719.7783203125</c:v>
                </c:pt>
                <c:pt idx="266">
                  <c:v>5722.05419921875</c:v>
                </c:pt>
                <c:pt idx="267">
                  <c:v>5740.2763671875</c:v>
                </c:pt>
                <c:pt idx="268">
                  <c:v>5773.72802734375</c:v>
                </c:pt>
                <c:pt idx="269">
                  <c:v>5810.5185546875</c:v>
                </c:pt>
                <c:pt idx="270">
                  <c:v>5833.23876953125</c:v>
                </c:pt>
                <c:pt idx="271">
                  <c:v>5830.69384765625</c:v>
                </c:pt>
                <c:pt idx="272">
                  <c:v>5806.84912109375</c:v>
                </c:pt>
                <c:pt idx="273">
                  <c:v>5779.39306640625</c:v>
                </c:pt>
                <c:pt idx="274">
                  <c:v>5767.99267578125</c:v>
                </c:pt>
                <c:pt idx="275">
                  <c:v>5780.431640625</c:v>
                </c:pt>
                <c:pt idx="276">
                  <c:v>5806.79833984375</c:v>
                </c:pt>
                <c:pt idx="277">
                  <c:v>5826.0341796875</c:v>
                </c:pt>
                <c:pt idx="278">
                  <c:v>5819.95068359375</c:v>
                </c:pt>
                <c:pt idx="279">
                  <c:v>5784.587890625</c:v>
                </c:pt>
                <c:pt idx="280">
                  <c:v>5731.3720703125</c:v>
                </c:pt>
                <c:pt idx="281">
                  <c:v>5678.6416015625</c:v>
                </c:pt>
                <c:pt idx="282">
                  <c:v>5640.97412109375</c:v>
                </c:pt>
                <c:pt idx="283">
                  <c:v>5624.07666015625</c:v>
                </c:pt>
                <c:pt idx="284">
                  <c:v>5627.12255859375</c:v>
                </c:pt>
                <c:pt idx="285">
                  <c:v>5647.8525390625</c:v>
                </c:pt>
                <c:pt idx="286">
                  <c:v>5684.30126953125</c:v>
                </c:pt>
                <c:pt idx="287">
                  <c:v>5731.5625</c:v>
                </c:pt>
                <c:pt idx="288">
                  <c:v>5778.09326171875</c:v>
                </c:pt>
                <c:pt idx="289">
                  <c:v>5807.62841796875</c:v>
                </c:pt>
                <c:pt idx="290">
                  <c:v>5807.99853515625</c:v>
                </c:pt>
                <c:pt idx="291">
                  <c:v>5781.03271484375</c:v>
                </c:pt>
                <c:pt idx="292">
                  <c:v>5744.916015625</c:v>
                </c:pt>
                <c:pt idx="293">
                  <c:v>5725.0771484375</c:v>
                </c:pt>
                <c:pt idx="294">
                  <c:v>5738.64453125</c:v>
                </c:pt>
                <c:pt idx="295">
                  <c:v>5783.3427734375</c:v>
                </c:pt>
                <c:pt idx="296">
                  <c:v>5839.171875</c:v>
                </c:pt>
                <c:pt idx="297">
                  <c:v>5881.8271484375</c:v>
                </c:pt>
                <c:pt idx="298">
                  <c:v>5897.970703125</c:v>
                </c:pt>
                <c:pt idx="299">
                  <c:v>5891.3076171875</c:v>
                </c:pt>
                <c:pt idx="300">
                  <c:v>5875.91845703125</c:v>
                </c:pt>
                <c:pt idx="301">
                  <c:v>5863.3271484375</c:v>
                </c:pt>
                <c:pt idx="302">
                  <c:v>5854.1396484375</c:v>
                </c:pt>
                <c:pt idx="303">
                  <c:v>5840.42578125</c:v>
                </c:pt>
                <c:pt idx="304">
                  <c:v>5815.560546875</c:v>
                </c:pt>
                <c:pt idx="305">
                  <c:v>5782.1171875</c:v>
                </c:pt>
                <c:pt idx="306">
                  <c:v>5750.73388671875</c:v>
                </c:pt>
                <c:pt idx="307">
                  <c:v>5731.31103515625</c:v>
                </c:pt>
                <c:pt idx="308">
                  <c:v>5724.8779296875</c:v>
                </c:pt>
                <c:pt idx="309">
                  <c:v>5723.75048828125</c:v>
                </c:pt>
                <c:pt idx="310">
                  <c:v>5719.8857421875</c:v>
                </c:pt>
                <c:pt idx="311">
                  <c:v>5713.5380859375</c:v>
                </c:pt>
                <c:pt idx="312">
                  <c:v>5713.685546875</c:v>
                </c:pt>
                <c:pt idx="313">
                  <c:v>5729.01318359375</c:v>
                </c:pt>
                <c:pt idx="314">
                  <c:v>5757.259765625</c:v>
                </c:pt>
                <c:pt idx="315">
                  <c:v>5783.21142578125</c:v>
                </c:pt>
                <c:pt idx="316">
                  <c:v>5788.80810546875</c:v>
                </c:pt>
                <c:pt idx="317">
                  <c:v>5768.16162109375</c:v>
                </c:pt>
                <c:pt idx="318">
                  <c:v>5734.91064453125</c:v>
                </c:pt>
                <c:pt idx="319">
                  <c:v>5714.47900390625</c:v>
                </c:pt>
                <c:pt idx="320">
                  <c:v>5725.767578125</c:v>
                </c:pt>
                <c:pt idx="321">
                  <c:v>5765.962890625</c:v>
                </c:pt>
                <c:pt idx="322">
                  <c:v>5810.6416015625</c:v>
                </c:pt>
                <c:pt idx="323">
                  <c:v>5829.98193359375</c:v>
                </c:pt>
                <c:pt idx="324">
                  <c:v>5809.48876953125</c:v>
                </c:pt>
                <c:pt idx="325">
                  <c:v>5760.0615234375</c:v>
                </c:pt>
                <c:pt idx="326">
                  <c:v>5710.337890625</c:v>
                </c:pt>
                <c:pt idx="327">
                  <c:v>5687.4541015625</c:v>
                </c:pt>
                <c:pt idx="328">
                  <c:v>5700.41943359375</c:v>
                </c:pt>
                <c:pt idx="329">
                  <c:v>5737.20556640625</c:v>
                </c:pt>
                <c:pt idx="330">
                  <c:v>5775.65576171875</c:v>
                </c:pt>
                <c:pt idx="331">
                  <c:v>5798.47021484375</c:v>
                </c:pt>
                <c:pt idx="332">
                  <c:v>5801.30224609375</c:v>
                </c:pt>
                <c:pt idx="333">
                  <c:v>5790.2451171875</c:v>
                </c:pt>
                <c:pt idx="334">
                  <c:v>5773.759765625</c:v>
                </c:pt>
                <c:pt idx="335">
                  <c:v>5757.0751953125</c:v>
                </c:pt>
                <c:pt idx="336">
                  <c:v>5742.69140625</c:v>
                </c:pt>
                <c:pt idx="337">
                  <c:v>5733.85791015625</c:v>
                </c:pt>
                <c:pt idx="338">
                  <c:v>5735.33056640625</c:v>
                </c:pt>
                <c:pt idx="339">
                  <c:v>5749.4580078125</c:v>
                </c:pt>
                <c:pt idx="340">
                  <c:v>5771.580078125</c:v>
                </c:pt>
                <c:pt idx="341">
                  <c:v>5790.65185546875</c:v>
                </c:pt>
                <c:pt idx="342">
                  <c:v>5796.60498046875</c:v>
                </c:pt>
                <c:pt idx="343">
                  <c:v>5789.09619140625</c:v>
                </c:pt>
                <c:pt idx="344">
                  <c:v>5779.591796875</c:v>
                </c:pt>
                <c:pt idx="345">
                  <c:v>5783.42822265625</c:v>
                </c:pt>
                <c:pt idx="346">
                  <c:v>5807.07666015625</c:v>
                </c:pt>
                <c:pt idx="347">
                  <c:v>5840.859375</c:v>
                </c:pt>
                <c:pt idx="348">
                  <c:v>5863.96484375</c:v>
                </c:pt>
                <c:pt idx="349">
                  <c:v>5858.98095703125</c:v>
                </c:pt>
              </c:numCache>
            </c:numRef>
          </c:yVal>
          <c:smooth val="1"/>
          <c:extLst>
            <c:ext xmlns:c16="http://schemas.microsoft.com/office/drawing/2014/chart" uri="{C3380CC4-5D6E-409C-BE32-E72D297353CC}">
              <c16:uniqueId val="{0000000E-0DDB-41B5-BE83-A9CFE49F3CE3}"/>
            </c:ext>
          </c:extLst>
        </c:ser>
        <c:ser>
          <c:idx val="15"/>
          <c:order val="15"/>
          <c:tx>
            <c:strRef>
              <c:f>hc_sub_007!$P$1</c:f>
              <c:strCache>
                <c:ptCount val="1"/>
                <c:pt idx="0">
                  <c:v>Coor_16</c:v>
                </c:pt>
              </c:strCache>
            </c:strRef>
          </c:tx>
          <c:spPr>
            <a:ln w="28575" cap="rnd">
              <a:solidFill>
                <a:schemeClr val="accent4">
                  <a:lumMod val="80000"/>
                  <a:lumOff val="20000"/>
                </a:schemeClr>
              </a:solidFill>
              <a:round/>
            </a:ln>
            <a:effectLst/>
          </c:spPr>
          <c:marker>
            <c:symbol val="none"/>
          </c:marker>
          <c:yVal>
            <c:numRef>
              <c:f>hc_sub_007!$P$2:$P$351</c:f>
              <c:numCache>
                <c:formatCode>0.00000000000_ </c:formatCode>
                <c:ptCount val="350"/>
                <c:pt idx="0">
                  <c:v>5294.18310546875</c:v>
                </c:pt>
                <c:pt idx="1">
                  <c:v>5256.66748046875</c:v>
                </c:pt>
                <c:pt idx="2">
                  <c:v>5275.90478515625</c:v>
                </c:pt>
                <c:pt idx="3">
                  <c:v>5339.97412109375</c:v>
                </c:pt>
                <c:pt idx="4">
                  <c:v>5410.9541015625</c:v>
                </c:pt>
                <c:pt idx="5">
                  <c:v>5450.1669921875</c:v>
                </c:pt>
                <c:pt idx="6">
                  <c:v>5443.92822265625</c:v>
                </c:pt>
                <c:pt idx="7">
                  <c:v>5411.61669921875</c:v>
                </c:pt>
                <c:pt idx="8">
                  <c:v>5390.5498046875</c:v>
                </c:pt>
                <c:pt idx="9">
                  <c:v>5408.72998046875</c:v>
                </c:pt>
                <c:pt idx="10">
                  <c:v>5464.92333984375</c:v>
                </c:pt>
                <c:pt idx="11">
                  <c:v>5529.76025390625</c:v>
                </c:pt>
                <c:pt idx="12">
                  <c:v>5566.255859375</c:v>
                </c:pt>
                <c:pt idx="13">
                  <c:v>5554.6181640625</c:v>
                </c:pt>
                <c:pt idx="14">
                  <c:v>5504.03759765625</c:v>
                </c:pt>
                <c:pt idx="15">
                  <c:v>5444.291015625</c:v>
                </c:pt>
                <c:pt idx="16">
                  <c:v>5404.529296875</c:v>
                </c:pt>
                <c:pt idx="17">
                  <c:v>5394.9697265625</c:v>
                </c:pt>
                <c:pt idx="18">
                  <c:v>5403.9033203125</c:v>
                </c:pt>
                <c:pt idx="19">
                  <c:v>5410.5703125</c:v>
                </c:pt>
                <c:pt idx="20">
                  <c:v>5403.076171875</c:v>
                </c:pt>
                <c:pt idx="21">
                  <c:v>5387.64111328125</c:v>
                </c:pt>
                <c:pt idx="22">
                  <c:v>5382.66552734375</c:v>
                </c:pt>
                <c:pt idx="23">
                  <c:v>5402.6162109375</c:v>
                </c:pt>
                <c:pt idx="24">
                  <c:v>5444.201171875</c:v>
                </c:pt>
                <c:pt idx="25">
                  <c:v>5485.5068359375</c:v>
                </c:pt>
                <c:pt idx="26">
                  <c:v>5499.30712890625</c:v>
                </c:pt>
                <c:pt idx="27">
                  <c:v>5471.46435546875</c:v>
                </c:pt>
                <c:pt idx="28">
                  <c:v>5411.5537109375</c:v>
                </c:pt>
                <c:pt idx="29">
                  <c:v>5348.1064453125</c:v>
                </c:pt>
                <c:pt idx="30">
                  <c:v>5311.5087890625</c:v>
                </c:pt>
                <c:pt idx="31">
                  <c:v>5316.1025390625</c:v>
                </c:pt>
                <c:pt idx="32">
                  <c:v>5353.470703125</c:v>
                </c:pt>
                <c:pt idx="33">
                  <c:v>5400.91015625</c:v>
                </c:pt>
                <c:pt idx="34">
                  <c:v>5438.31640625</c:v>
                </c:pt>
                <c:pt idx="35">
                  <c:v>5460.86279296875</c:v>
                </c:pt>
                <c:pt idx="36">
                  <c:v>5478.2529296875</c:v>
                </c:pt>
                <c:pt idx="37">
                  <c:v>5501.662109375</c:v>
                </c:pt>
                <c:pt idx="38">
                  <c:v>5529.19580078125</c:v>
                </c:pt>
                <c:pt idx="39">
                  <c:v>5542.3984375</c:v>
                </c:pt>
                <c:pt idx="40">
                  <c:v>5518.27783203125</c:v>
                </c:pt>
                <c:pt idx="41">
                  <c:v>5449.08447265625</c:v>
                </c:pt>
                <c:pt idx="42">
                  <c:v>5354.83203125</c:v>
                </c:pt>
                <c:pt idx="43">
                  <c:v>5277.28369140625</c:v>
                </c:pt>
                <c:pt idx="44">
                  <c:v>5256.8583984375</c:v>
                </c:pt>
                <c:pt idx="45">
                  <c:v>5306.78564453125</c:v>
                </c:pt>
                <c:pt idx="46">
                  <c:v>5402.2314453125</c:v>
                </c:pt>
                <c:pt idx="47">
                  <c:v>5492.9638671875</c:v>
                </c:pt>
                <c:pt idx="48">
                  <c:v>5532.40380859375</c:v>
                </c:pt>
                <c:pt idx="49">
                  <c:v>5504.65234375</c:v>
                </c:pt>
                <c:pt idx="50">
                  <c:v>5432.27294921875</c:v>
                </c:pt>
                <c:pt idx="51">
                  <c:v>5360.4931640625</c:v>
                </c:pt>
                <c:pt idx="52">
                  <c:v>5328.9580078125</c:v>
                </c:pt>
                <c:pt idx="53">
                  <c:v>5349.49755859375</c:v>
                </c:pt>
                <c:pt idx="54">
                  <c:v>5403.02880859375</c:v>
                </c:pt>
                <c:pt idx="55">
                  <c:v>5455.1298828125</c:v>
                </c:pt>
                <c:pt idx="56">
                  <c:v>5478.0419921875</c:v>
                </c:pt>
                <c:pt idx="57">
                  <c:v>5464.59765625</c:v>
                </c:pt>
                <c:pt idx="58">
                  <c:v>5427.2744140625</c:v>
                </c:pt>
                <c:pt idx="59">
                  <c:v>5386.470703125</c:v>
                </c:pt>
                <c:pt idx="60">
                  <c:v>5358.1748046875</c:v>
                </c:pt>
                <c:pt idx="61">
                  <c:v>5348.93212890625</c:v>
                </c:pt>
                <c:pt idx="62">
                  <c:v>5358.63134765625</c:v>
                </c:pt>
                <c:pt idx="63">
                  <c:v>5385.58447265625</c:v>
                </c:pt>
                <c:pt idx="64">
                  <c:v>5428.12158203125</c:v>
                </c:pt>
                <c:pt idx="65">
                  <c:v>5481.65673828125</c:v>
                </c:pt>
                <c:pt idx="66">
                  <c:v>5535.2314453125</c:v>
                </c:pt>
                <c:pt idx="67">
                  <c:v>5572.50390625</c:v>
                </c:pt>
                <c:pt idx="68">
                  <c:v>5578.4599609375</c:v>
                </c:pt>
                <c:pt idx="69">
                  <c:v>5548.06884765625</c:v>
                </c:pt>
                <c:pt idx="70">
                  <c:v>5490.8818359375</c:v>
                </c:pt>
                <c:pt idx="71">
                  <c:v>5427.87060546875</c:v>
                </c:pt>
                <c:pt idx="72">
                  <c:v>5381.779296875</c:v>
                </c:pt>
                <c:pt idx="73">
                  <c:v>5366.349609375</c:v>
                </c:pt>
                <c:pt idx="74">
                  <c:v>5380.298828125</c:v>
                </c:pt>
                <c:pt idx="75">
                  <c:v>5409.03369140625</c:v>
                </c:pt>
                <c:pt idx="76">
                  <c:v>5432.8134765625</c:v>
                </c:pt>
                <c:pt idx="77">
                  <c:v>5436.9580078125</c:v>
                </c:pt>
                <c:pt idx="78">
                  <c:v>5418.9951171875</c:v>
                </c:pt>
                <c:pt idx="79">
                  <c:v>5389.33642578125</c:v>
                </c:pt>
                <c:pt idx="80">
                  <c:v>5365.17919921875</c:v>
                </c:pt>
                <c:pt idx="81">
                  <c:v>5360.6533203125</c:v>
                </c:pt>
                <c:pt idx="82">
                  <c:v>5378.3828125</c:v>
                </c:pt>
                <c:pt idx="83">
                  <c:v>5407.3701171875</c:v>
                </c:pt>
                <c:pt idx="84">
                  <c:v>5429.037109375</c:v>
                </c:pt>
                <c:pt idx="85">
                  <c:v>5428.4736328125</c:v>
                </c:pt>
                <c:pt idx="86">
                  <c:v>5404.26416015625</c:v>
                </c:pt>
                <c:pt idx="87">
                  <c:v>5370.3369140625</c:v>
                </c:pt>
                <c:pt idx="88">
                  <c:v>5347.8642578125</c:v>
                </c:pt>
                <c:pt idx="89">
                  <c:v>5351.82763671875</c:v>
                </c:pt>
                <c:pt idx="90">
                  <c:v>5380.966796875</c:v>
                </c:pt>
                <c:pt idx="91">
                  <c:v>5418.20849609375</c:v>
                </c:pt>
                <c:pt idx="92">
                  <c:v>5441.84521484375</c:v>
                </c:pt>
                <c:pt idx="93">
                  <c:v>5440.1796875</c:v>
                </c:pt>
                <c:pt idx="94">
                  <c:v>5419.54833984375</c:v>
                </c:pt>
                <c:pt idx="95">
                  <c:v>5399.86767578125</c:v>
                </c:pt>
                <c:pt idx="96">
                  <c:v>5400.5048828125</c:v>
                </c:pt>
                <c:pt idx="97">
                  <c:v>5426.21875</c:v>
                </c:pt>
                <c:pt idx="98">
                  <c:v>5463.16796875</c:v>
                </c:pt>
                <c:pt idx="99">
                  <c:v>5488.080078125</c:v>
                </c:pt>
                <c:pt idx="100">
                  <c:v>5484.48486328125</c:v>
                </c:pt>
                <c:pt idx="101">
                  <c:v>5454.8046875</c:v>
                </c:pt>
                <c:pt idx="102">
                  <c:v>5419.7890625</c:v>
                </c:pt>
                <c:pt idx="103">
                  <c:v>5405.35205078125</c:v>
                </c:pt>
                <c:pt idx="104">
                  <c:v>5425.48974609375</c:v>
                </c:pt>
                <c:pt idx="105">
                  <c:v>5472.64990234375</c:v>
                </c:pt>
                <c:pt idx="106">
                  <c:v>5521.9453125</c:v>
                </c:pt>
                <c:pt idx="107">
                  <c:v>5546.4150390625</c:v>
                </c:pt>
                <c:pt idx="108">
                  <c:v>5533.2880859375</c:v>
                </c:pt>
                <c:pt idx="109">
                  <c:v>5490.7841796875</c:v>
                </c:pt>
                <c:pt idx="110">
                  <c:v>5441.4638671875</c:v>
                </c:pt>
                <c:pt idx="111">
                  <c:v>5407.1337890625</c:v>
                </c:pt>
                <c:pt idx="112">
                  <c:v>5395.70751953125</c:v>
                </c:pt>
                <c:pt idx="113">
                  <c:v>5398.64697265625</c:v>
                </c:pt>
                <c:pt idx="114">
                  <c:v>5399.9482421875</c:v>
                </c:pt>
                <c:pt idx="115">
                  <c:v>5389.47412109375</c:v>
                </c:pt>
                <c:pt idx="116">
                  <c:v>5370.53271484375</c:v>
                </c:pt>
                <c:pt idx="117">
                  <c:v>5356.15625</c:v>
                </c:pt>
                <c:pt idx="118">
                  <c:v>5357.2431640625</c:v>
                </c:pt>
                <c:pt idx="119">
                  <c:v>5372.25</c:v>
                </c:pt>
                <c:pt idx="120">
                  <c:v>5387.19921875</c:v>
                </c:pt>
                <c:pt idx="121">
                  <c:v>5386.79052734375</c:v>
                </c:pt>
                <c:pt idx="122">
                  <c:v>5368.162109375</c:v>
                </c:pt>
                <c:pt idx="123">
                  <c:v>5345.74169921875</c:v>
                </c:pt>
                <c:pt idx="124">
                  <c:v>5341.822265625</c:v>
                </c:pt>
                <c:pt idx="125">
                  <c:v>5368.8486328125</c:v>
                </c:pt>
                <c:pt idx="126">
                  <c:v>5417.1640625</c:v>
                </c:pt>
                <c:pt idx="127">
                  <c:v>5459.27685546875</c:v>
                </c:pt>
                <c:pt idx="128">
                  <c:v>5469.5224609375</c:v>
                </c:pt>
                <c:pt idx="129">
                  <c:v>5445.1513671875</c:v>
                </c:pt>
                <c:pt idx="130">
                  <c:v>5411.8544921875</c:v>
                </c:pt>
                <c:pt idx="131">
                  <c:v>5407.1083984375</c:v>
                </c:pt>
                <c:pt idx="132">
                  <c:v>5451.6953125</c:v>
                </c:pt>
                <c:pt idx="133">
                  <c:v>5530.33056640625</c:v>
                </c:pt>
                <c:pt idx="134">
                  <c:v>5597.49169921875</c:v>
                </c:pt>
                <c:pt idx="135">
                  <c:v>5606.63671875</c:v>
                </c:pt>
                <c:pt idx="136">
                  <c:v>5543.0224609375</c:v>
                </c:pt>
                <c:pt idx="137">
                  <c:v>5436.21923828125</c:v>
                </c:pt>
                <c:pt idx="138">
                  <c:v>5342.2412109375</c:v>
                </c:pt>
                <c:pt idx="139">
                  <c:v>5307.1923828125</c:v>
                </c:pt>
                <c:pt idx="140">
                  <c:v>5338.04150390625</c:v>
                </c:pt>
                <c:pt idx="141">
                  <c:v>5400.98486328125</c:v>
                </c:pt>
                <c:pt idx="142">
                  <c:v>5447.53076171875</c:v>
                </c:pt>
                <c:pt idx="143">
                  <c:v>5448.369140625</c:v>
                </c:pt>
                <c:pt idx="144">
                  <c:v>5410.41455078125</c:v>
                </c:pt>
                <c:pt idx="145">
                  <c:v>5366.30029296875</c:v>
                </c:pt>
                <c:pt idx="146">
                  <c:v>5346.80712890625</c:v>
                </c:pt>
                <c:pt idx="147">
                  <c:v>5358.654296875</c:v>
                </c:pt>
                <c:pt idx="148">
                  <c:v>5383.9716796875</c:v>
                </c:pt>
                <c:pt idx="149">
                  <c:v>5399.4248046875</c:v>
                </c:pt>
                <c:pt idx="150">
                  <c:v>5397.47216796875</c:v>
                </c:pt>
                <c:pt idx="151">
                  <c:v>5391.912109375</c:v>
                </c:pt>
                <c:pt idx="152">
                  <c:v>5404.02734375</c:v>
                </c:pt>
                <c:pt idx="153">
                  <c:v>5442.04833984375</c:v>
                </c:pt>
                <c:pt idx="154">
                  <c:v>5491.736328125</c:v>
                </c:pt>
                <c:pt idx="155">
                  <c:v>5525.96923828125</c:v>
                </c:pt>
                <c:pt idx="156">
                  <c:v>5525.14111328125</c:v>
                </c:pt>
                <c:pt idx="157">
                  <c:v>5491.55615234375</c:v>
                </c:pt>
                <c:pt idx="158">
                  <c:v>5446.5546875</c:v>
                </c:pt>
                <c:pt idx="159">
                  <c:v>5413.64892578125</c:v>
                </c:pt>
                <c:pt idx="160">
                  <c:v>5401.99462890625</c:v>
                </c:pt>
                <c:pt idx="161">
                  <c:v>5403.15380859375</c:v>
                </c:pt>
                <c:pt idx="162">
                  <c:v>5402.21044921875</c:v>
                </c:pt>
                <c:pt idx="163">
                  <c:v>5392.42236328125</c:v>
                </c:pt>
                <c:pt idx="164">
                  <c:v>5380.6865234375</c:v>
                </c:pt>
                <c:pt idx="165">
                  <c:v>5380.0380859375</c:v>
                </c:pt>
                <c:pt idx="166">
                  <c:v>5396.85986328125</c:v>
                </c:pt>
                <c:pt idx="167">
                  <c:v>5424.5078125</c:v>
                </c:pt>
                <c:pt idx="168">
                  <c:v>5448.634765625</c:v>
                </c:pt>
                <c:pt idx="169">
                  <c:v>5458.93896484375</c:v>
                </c:pt>
                <c:pt idx="170">
                  <c:v>5456.75927734375</c:v>
                </c:pt>
                <c:pt idx="171">
                  <c:v>5452.27099609375</c:v>
                </c:pt>
                <c:pt idx="172">
                  <c:v>5454.52734375</c:v>
                </c:pt>
                <c:pt idx="173">
                  <c:v>5463.5771484375</c:v>
                </c:pt>
                <c:pt idx="174">
                  <c:v>5471.22705078125</c:v>
                </c:pt>
                <c:pt idx="175">
                  <c:v>5468.7236328125</c:v>
                </c:pt>
                <c:pt idx="176">
                  <c:v>5453.60888671875</c:v>
                </c:pt>
                <c:pt idx="177">
                  <c:v>5429.6953125</c:v>
                </c:pt>
                <c:pt idx="178">
                  <c:v>5401.48828125</c:v>
                </c:pt>
                <c:pt idx="179">
                  <c:v>5369.98486328125</c:v>
                </c:pt>
                <c:pt idx="180">
                  <c:v>5335.05908203125</c:v>
                </c:pt>
                <c:pt idx="181">
                  <c:v>5302.1064453125</c:v>
                </c:pt>
                <c:pt idx="182">
                  <c:v>5284.89892578125</c:v>
                </c:pt>
                <c:pt idx="183">
                  <c:v>5298.85693359375</c:v>
                </c:pt>
                <c:pt idx="184">
                  <c:v>5348.0341796875</c:v>
                </c:pt>
                <c:pt idx="185">
                  <c:v>5416.77197265625</c:v>
                </c:pt>
                <c:pt idx="186">
                  <c:v>5475.36474609375</c:v>
                </c:pt>
                <c:pt idx="187">
                  <c:v>5498.21728515625</c:v>
                </c:pt>
                <c:pt idx="188">
                  <c:v>5481.62109375</c:v>
                </c:pt>
                <c:pt idx="189">
                  <c:v>5446.7265625</c:v>
                </c:pt>
                <c:pt idx="190">
                  <c:v>5424.03173828125</c:v>
                </c:pt>
                <c:pt idx="191">
                  <c:v>5430.66357421875</c:v>
                </c:pt>
                <c:pt idx="192">
                  <c:v>5458.27392578125</c:v>
                </c:pt>
                <c:pt idx="193">
                  <c:v>5481.4462890625</c:v>
                </c:pt>
                <c:pt idx="194">
                  <c:v>5479.865234375</c:v>
                </c:pt>
                <c:pt idx="195">
                  <c:v>5455.89892578125</c:v>
                </c:pt>
                <c:pt idx="196">
                  <c:v>5432.63671875</c:v>
                </c:pt>
                <c:pt idx="197">
                  <c:v>5433.57568359375</c:v>
                </c:pt>
                <c:pt idx="198">
                  <c:v>5460.85009765625</c:v>
                </c:pt>
                <c:pt idx="199">
                  <c:v>5490.9052734375</c:v>
                </c:pt>
                <c:pt idx="200">
                  <c:v>5492.53955078125</c:v>
                </c:pt>
                <c:pt idx="201">
                  <c:v>5453.49072265625</c:v>
                </c:pt>
                <c:pt idx="202">
                  <c:v>5393.6669921875</c:v>
                </c:pt>
                <c:pt idx="203">
                  <c:v>5352.8974609375</c:v>
                </c:pt>
                <c:pt idx="204">
                  <c:v>5361.26220703125</c:v>
                </c:pt>
                <c:pt idx="205">
                  <c:v>5414.58203125</c:v>
                </c:pt>
                <c:pt idx="206">
                  <c:v>5474.6201171875</c:v>
                </c:pt>
                <c:pt idx="207">
                  <c:v>5495.01904296875</c:v>
                </c:pt>
                <c:pt idx="208">
                  <c:v>5454.3515625</c:v>
                </c:pt>
                <c:pt idx="209">
                  <c:v>5372.09326171875</c:v>
                </c:pt>
                <c:pt idx="210">
                  <c:v>5296.02392578125</c:v>
                </c:pt>
                <c:pt idx="211">
                  <c:v>5270.48193359375</c:v>
                </c:pt>
                <c:pt idx="212">
                  <c:v>5308.22705078125</c:v>
                </c:pt>
                <c:pt idx="213">
                  <c:v>5384.8564453125</c:v>
                </c:pt>
                <c:pt idx="214">
                  <c:v>5457.65771484375</c:v>
                </c:pt>
                <c:pt idx="215">
                  <c:v>5493.83349609375</c:v>
                </c:pt>
                <c:pt idx="216">
                  <c:v>5488.3291015625</c:v>
                </c:pt>
                <c:pt idx="217">
                  <c:v>5461.1318359375</c:v>
                </c:pt>
                <c:pt idx="218">
                  <c:v>5439.2158203125</c:v>
                </c:pt>
                <c:pt idx="219">
                  <c:v>5437.7919921875</c:v>
                </c:pt>
                <c:pt idx="220">
                  <c:v>5453.30712890625</c:v>
                </c:pt>
                <c:pt idx="221">
                  <c:v>5470.29638671875</c:v>
                </c:pt>
                <c:pt idx="222">
                  <c:v>5474.43896484375</c:v>
                </c:pt>
                <c:pt idx="223">
                  <c:v>5461.70458984375</c:v>
                </c:pt>
                <c:pt idx="224">
                  <c:v>5438.51513671875</c:v>
                </c:pt>
                <c:pt idx="225">
                  <c:v>5415.1318359375</c:v>
                </c:pt>
                <c:pt idx="226">
                  <c:v>5398.42626953125</c:v>
                </c:pt>
                <c:pt idx="227">
                  <c:v>5388.9345703125</c:v>
                </c:pt>
                <c:pt idx="228">
                  <c:v>5382.91650390625</c:v>
                </c:pt>
                <c:pt idx="229">
                  <c:v>5376.69921875</c:v>
                </c:pt>
                <c:pt idx="230">
                  <c:v>5369.90478515625</c:v>
                </c:pt>
                <c:pt idx="231">
                  <c:v>5365.6845703125</c:v>
                </c:pt>
                <c:pt idx="232">
                  <c:v>5368.2138671875</c:v>
                </c:pt>
                <c:pt idx="233">
                  <c:v>5379.19482421875</c:v>
                </c:pt>
                <c:pt idx="234">
                  <c:v>5395.6357421875</c:v>
                </c:pt>
                <c:pt idx="235">
                  <c:v>5410.70556640625</c:v>
                </c:pt>
                <c:pt idx="236">
                  <c:v>5417.87744140625</c:v>
                </c:pt>
                <c:pt idx="237">
                  <c:v>5416.21240234375</c:v>
                </c:pt>
                <c:pt idx="238">
                  <c:v>5412.92578125</c:v>
                </c:pt>
                <c:pt idx="239">
                  <c:v>5420.11279296875</c:v>
                </c:pt>
                <c:pt idx="240">
                  <c:v>5446.2568359375</c:v>
                </c:pt>
                <c:pt idx="241">
                  <c:v>5487.80419921875</c:v>
                </c:pt>
                <c:pt idx="242">
                  <c:v>5527.77783203125</c:v>
                </c:pt>
                <c:pt idx="243">
                  <c:v>5544.62939453125</c:v>
                </c:pt>
                <c:pt idx="244">
                  <c:v>5526.93408203125</c:v>
                </c:pt>
                <c:pt idx="245">
                  <c:v>5483.6669921875</c:v>
                </c:pt>
                <c:pt idx="246">
                  <c:v>5441.03173828125</c:v>
                </c:pt>
                <c:pt idx="247">
                  <c:v>5425.736328125</c:v>
                </c:pt>
                <c:pt idx="248">
                  <c:v>5445.25244140625</c:v>
                </c:pt>
                <c:pt idx="249">
                  <c:v>5479.70458984375</c:v>
                </c:pt>
                <c:pt idx="250">
                  <c:v>5493.1796875</c:v>
                </c:pt>
                <c:pt idx="251">
                  <c:v>5458.49267578125</c:v>
                </c:pt>
                <c:pt idx="252">
                  <c:v>5378.6357421875</c:v>
                </c:pt>
                <c:pt idx="253">
                  <c:v>5288.99560546875</c:v>
                </c:pt>
                <c:pt idx="254">
                  <c:v>5237.21044921875</c:v>
                </c:pt>
                <c:pt idx="255">
                  <c:v>5253.4443359375</c:v>
                </c:pt>
                <c:pt idx="256">
                  <c:v>5331.1181640625</c:v>
                </c:pt>
                <c:pt idx="257">
                  <c:v>5431.13916015625</c:v>
                </c:pt>
                <c:pt idx="258">
                  <c:v>5506.32763671875</c:v>
                </c:pt>
                <c:pt idx="259">
                  <c:v>5528.9736328125</c:v>
                </c:pt>
                <c:pt idx="260">
                  <c:v>5503.24072265625</c:v>
                </c:pt>
                <c:pt idx="261">
                  <c:v>5455.90966796875</c:v>
                </c:pt>
                <c:pt idx="262">
                  <c:v>5414.6025390625</c:v>
                </c:pt>
                <c:pt idx="263">
                  <c:v>5390.431640625</c:v>
                </c:pt>
                <c:pt idx="264">
                  <c:v>5376.7724609375</c:v>
                </c:pt>
                <c:pt idx="265">
                  <c:v>5362.369140625</c:v>
                </c:pt>
                <c:pt idx="266">
                  <c:v>5346.078125</c:v>
                </c:pt>
                <c:pt idx="267">
                  <c:v>5340.353515625</c:v>
                </c:pt>
                <c:pt idx="268">
                  <c:v>5360.69384765625</c:v>
                </c:pt>
                <c:pt idx="269">
                  <c:v>5410.1064453125</c:v>
                </c:pt>
                <c:pt idx="270">
                  <c:v>5471.93505859375</c:v>
                </c:pt>
                <c:pt idx="271">
                  <c:v>5517.8505859375</c:v>
                </c:pt>
                <c:pt idx="272">
                  <c:v>5525.84521484375</c:v>
                </c:pt>
                <c:pt idx="273">
                  <c:v>5495.07421875</c:v>
                </c:pt>
                <c:pt idx="274">
                  <c:v>5446.4375</c:v>
                </c:pt>
                <c:pt idx="275">
                  <c:v>5408.2822265625</c:v>
                </c:pt>
                <c:pt idx="276">
                  <c:v>5397.478515625</c:v>
                </c:pt>
                <c:pt idx="277">
                  <c:v>5409.39404296875</c:v>
                </c:pt>
                <c:pt idx="278">
                  <c:v>5423.62548828125</c:v>
                </c:pt>
                <c:pt idx="279">
                  <c:v>5420.8720703125</c:v>
                </c:pt>
                <c:pt idx="280">
                  <c:v>5398.42236328125</c:v>
                </c:pt>
                <c:pt idx="281">
                  <c:v>5372.97216796875</c:v>
                </c:pt>
                <c:pt idx="282">
                  <c:v>5368.76220703125</c:v>
                </c:pt>
                <c:pt idx="283">
                  <c:v>5399.54248046875</c:v>
                </c:pt>
                <c:pt idx="284">
                  <c:v>5457.20361328125</c:v>
                </c:pt>
                <c:pt idx="285">
                  <c:v>5515.15478515625</c:v>
                </c:pt>
                <c:pt idx="286">
                  <c:v>5544.27197265625</c:v>
                </c:pt>
                <c:pt idx="287">
                  <c:v>5530.681640625</c:v>
                </c:pt>
                <c:pt idx="288">
                  <c:v>5483.67236328125</c:v>
                </c:pt>
                <c:pt idx="289">
                  <c:v>5428.982421875</c:v>
                </c:pt>
                <c:pt idx="290">
                  <c:v>5392.58154296875</c:v>
                </c:pt>
                <c:pt idx="291">
                  <c:v>5385.92626953125</c:v>
                </c:pt>
                <c:pt idx="292">
                  <c:v>5401.76806640625</c:v>
                </c:pt>
                <c:pt idx="293">
                  <c:v>5421.80712890625</c:v>
                </c:pt>
                <c:pt idx="294">
                  <c:v>5429.54443359375</c:v>
                </c:pt>
                <c:pt idx="295">
                  <c:v>5419.25927734375</c:v>
                </c:pt>
                <c:pt idx="296">
                  <c:v>5396.20068359375</c:v>
                </c:pt>
                <c:pt idx="297">
                  <c:v>5370.11669921875</c:v>
                </c:pt>
                <c:pt idx="298">
                  <c:v>5348.58154296875</c:v>
                </c:pt>
                <c:pt idx="299">
                  <c:v>5335.14794921875</c:v>
                </c:pt>
                <c:pt idx="300">
                  <c:v>5332.025390625</c:v>
                </c:pt>
                <c:pt idx="301">
                  <c:v>5342.6826171875</c:v>
                </c:pt>
                <c:pt idx="302">
                  <c:v>5370.28857421875</c:v>
                </c:pt>
                <c:pt idx="303">
                  <c:v>5412.685546875</c:v>
                </c:pt>
                <c:pt idx="304">
                  <c:v>5459.06494140625</c:v>
                </c:pt>
                <c:pt idx="305">
                  <c:v>5493.27001953125</c:v>
                </c:pt>
                <c:pt idx="306">
                  <c:v>5503.2001953125</c:v>
                </c:pt>
                <c:pt idx="307">
                  <c:v>5489.71044921875</c:v>
                </c:pt>
                <c:pt idx="308">
                  <c:v>5467.21240234375</c:v>
                </c:pt>
                <c:pt idx="309">
                  <c:v>5453.8974609375</c:v>
                </c:pt>
                <c:pt idx="310">
                  <c:v>5457.98681640625</c:v>
                </c:pt>
                <c:pt idx="311">
                  <c:v>5470.7080078125</c:v>
                </c:pt>
                <c:pt idx="312">
                  <c:v>5472.501953125</c:v>
                </c:pt>
                <c:pt idx="313">
                  <c:v>5448.859375</c:v>
                </c:pt>
                <c:pt idx="314">
                  <c:v>5403.91015625</c:v>
                </c:pt>
                <c:pt idx="315">
                  <c:v>5360.55322265625</c:v>
                </c:pt>
                <c:pt idx="316">
                  <c:v>5345.64599609375</c:v>
                </c:pt>
                <c:pt idx="317">
                  <c:v>5370.49853515625</c:v>
                </c:pt>
                <c:pt idx="318">
                  <c:v>5421.29736328125</c:v>
                </c:pt>
                <c:pt idx="319">
                  <c:v>5467.24267578125</c:v>
                </c:pt>
                <c:pt idx="320">
                  <c:v>5481.05078125</c:v>
                </c:pt>
                <c:pt idx="321">
                  <c:v>5457.03466796875</c:v>
                </c:pt>
                <c:pt idx="322">
                  <c:v>5413.7216796875</c:v>
                </c:pt>
                <c:pt idx="323">
                  <c:v>5379.55126953125</c:v>
                </c:pt>
                <c:pt idx="324">
                  <c:v>5372.748046875</c:v>
                </c:pt>
                <c:pt idx="325">
                  <c:v>5390.265625</c:v>
                </c:pt>
                <c:pt idx="326">
                  <c:v>5413.11572265625</c:v>
                </c:pt>
                <c:pt idx="327">
                  <c:v>5422.654296875</c:v>
                </c:pt>
                <c:pt idx="328">
                  <c:v>5414.52783203125</c:v>
                </c:pt>
                <c:pt idx="329">
                  <c:v>5399.89599609375</c:v>
                </c:pt>
                <c:pt idx="330">
                  <c:v>5394.28857421875</c:v>
                </c:pt>
                <c:pt idx="331">
                  <c:v>5404.17431640625</c:v>
                </c:pt>
                <c:pt idx="332">
                  <c:v>5422.35107421875</c:v>
                </c:pt>
                <c:pt idx="333">
                  <c:v>5435.322265625</c:v>
                </c:pt>
                <c:pt idx="334">
                  <c:v>5435.810546875</c:v>
                </c:pt>
                <c:pt idx="335">
                  <c:v>5429.64501953125</c:v>
                </c:pt>
                <c:pt idx="336">
                  <c:v>5431.26611328125</c:v>
                </c:pt>
                <c:pt idx="337">
                  <c:v>5451.54736328125</c:v>
                </c:pt>
                <c:pt idx="338">
                  <c:v>5487.72265625</c:v>
                </c:pt>
                <c:pt idx="339">
                  <c:v>5523.30712890625</c:v>
                </c:pt>
                <c:pt idx="340">
                  <c:v>5538.00537109375</c:v>
                </c:pt>
                <c:pt idx="341">
                  <c:v>5520.2255859375</c:v>
                </c:pt>
                <c:pt idx="342">
                  <c:v>5473.5849609375</c:v>
                </c:pt>
                <c:pt idx="343">
                  <c:v>5413.89111328125</c:v>
                </c:pt>
                <c:pt idx="344">
                  <c:v>5359.99365234375</c:v>
                </c:pt>
                <c:pt idx="345">
                  <c:v>5325.201171875</c:v>
                </c:pt>
                <c:pt idx="346">
                  <c:v>5313.916015625</c:v>
                </c:pt>
                <c:pt idx="347">
                  <c:v>5323.38916015625</c:v>
                </c:pt>
                <c:pt idx="348">
                  <c:v>5347.28125</c:v>
                </c:pt>
                <c:pt idx="349">
                  <c:v>5378.1044921875</c:v>
                </c:pt>
              </c:numCache>
            </c:numRef>
          </c:yVal>
          <c:smooth val="1"/>
          <c:extLst>
            <c:ext xmlns:c16="http://schemas.microsoft.com/office/drawing/2014/chart" uri="{C3380CC4-5D6E-409C-BE32-E72D297353CC}">
              <c16:uniqueId val="{0000000F-0DDB-41B5-BE83-A9CFE49F3CE3}"/>
            </c:ext>
          </c:extLst>
        </c:ser>
        <c:ser>
          <c:idx val="16"/>
          <c:order val="16"/>
          <c:tx>
            <c:strRef>
              <c:f>hc_sub_007!$Q$1</c:f>
              <c:strCache>
                <c:ptCount val="1"/>
                <c:pt idx="0">
                  <c:v>Coor_17</c:v>
                </c:pt>
              </c:strCache>
            </c:strRef>
          </c:tx>
          <c:spPr>
            <a:ln w="28575" cap="rnd">
              <a:solidFill>
                <a:schemeClr val="accent5">
                  <a:lumMod val="80000"/>
                  <a:lumOff val="20000"/>
                </a:schemeClr>
              </a:solidFill>
              <a:round/>
            </a:ln>
            <a:effectLst/>
          </c:spPr>
          <c:marker>
            <c:symbol val="none"/>
          </c:marker>
          <c:yVal>
            <c:numRef>
              <c:f>hc_sub_007!$Q$2:$Q$351</c:f>
              <c:numCache>
                <c:formatCode>0.00000000000_ </c:formatCode>
                <c:ptCount val="350"/>
                <c:pt idx="0">
                  <c:v>4334.54296875</c:v>
                </c:pt>
                <c:pt idx="1">
                  <c:v>4340.9716796875</c:v>
                </c:pt>
                <c:pt idx="2">
                  <c:v>4344.95654296875</c:v>
                </c:pt>
                <c:pt idx="3">
                  <c:v>4346.20263671875</c:v>
                </c:pt>
                <c:pt idx="4">
                  <c:v>4346.78076171875</c:v>
                </c:pt>
                <c:pt idx="5">
                  <c:v>4348.33642578125</c:v>
                </c:pt>
                <c:pt idx="6">
                  <c:v>4350.048828125</c:v>
                </c:pt>
                <c:pt idx="7">
                  <c:v>4349.3974609375</c:v>
                </c:pt>
                <c:pt idx="8">
                  <c:v>4345.01220703125</c:v>
                </c:pt>
                <c:pt idx="9">
                  <c:v>4338.7197265625</c:v>
                </c:pt>
                <c:pt idx="10">
                  <c:v>4334.45751953125</c:v>
                </c:pt>
                <c:pt idx="11">
                  <c:v>4334.68798828125</c:v>
                </c:pt>
                <c:pt idx="12">
                  <c:v>4337.58740234375</c:v>
                </c:pt>
                <c:pt idx="13">
                  <c:v>4338.037109375</c:v>
                </c:pt>
                <c:pt idx="14">
                  <c:v>4332.1875</c:v>
                </c:pt>
                <c:pt idx="15">
                  <c:v>4321.84033203125</c:v>
                </c:pt>
                <c:pt idx="16">
                  <c:v>4314.40087890625</c:v>
                </c:pt>
                <c:pt idx="17">
                  <c:v>4317.5302734375</c:v>
                </c:pt>
                <c:pt idx="18">
                  <c:v>4332.291015625</c:v>
                </c:pt>
                <c:pt idx="19">
                  <c:v>4350.509765625</c:v>
                </c:pt>
                <c:pt idx="20">
                  <c:v>4359.275390625</c:v>
                </c:pt>
                <c:pt idx="21">
                  <c:v>4349.89453125</c:v>
                </c:pt>
                <c:pt idx="22">
                  <c:v>4324.7265625</c:v>
                </c:pt>
                <c:pt idx="23">
                  <c:v>4296.47021484375</c:v>
                </c:pt>
                <c:pt idx="24">
                  <c:v>4280.0322265625</c:v>
                </c:pt>
                <c:pt idx="25">
                  <c:v>4282.73388671875</c:v>
                </c:pt>
                <c:pt idx="26">
                  <c:v>4299.94580078125</c:v>
                </c:pt>
                <c:pt idx="27">
                  <c:v>4319.1220703125</c:v>
                </c:pt>
                <c:pt idx="28">
                  <c:v>4329.0146484375</c:v>
                </c:pt>
                <c:pt idx="29">
                  <c:v>4327.279296875</c:v>
                </c:pt>
                <c:pt idx="30">
                  <c:v>4321.3291015625</c:v>
                </c:pt>
                <c:pt idx="31">
                  <c:v>4322.501953125</c:v>
                </c:pt>
                <c:pt idx="32">
                  <c:v>4338.173828125</c:v>
                </c:pt>
                <c:pt idx="33">
                  <c:v>4367.13427734375</c:v>
                </c:pt>
                <c:pt idx="34">
                  <c:v>4400.490234375</c:v>
                </c:pt>
                <c:pt idx="35">
                  <c:v>4426.46044921875</c:v>
                </c:pt>
                <c:pt idx="36">
                  <c:v>4435.64501953125</c:v>
                </c:pt>
                <c:pt idx="37">
                  <c:v>4424.3046875</c:v>
                </c:pt>
                <c:pt idx="38">
                  <c:v>4395.16748046875</c:v>
                </c:pt>
                <c:pt idx="39">
                  <c:v>4356.36572265625</c:v>
                </c:pt>
                <c:pt idx="40">
                  <c:v>4318.89794921875</c:v>
                </c:pt>
                <c:pt idx="41">
                  <c:v>4292.82373046875</c:v>
                </c:pt>
                <c:pt idx="42">
                  <c:v>4283.18408203125</c:v>
                </c:pt>
                <c:pt idx="43">
                  <c:v>4287.8203125</c:v>
                </c:pt>
                <c:pt idx="44">
                  <c:v>4299.09375</c:v>
                </c:pt>
                <c:pt idx="45">
                  <c:v>4309.11328125</c:v>
                </c:pt>
                <c:pt idx="46">
                  <c:v>4315.04248046875</c:v>
                </c:pt>
                <c:pt idx="47">
                  <c:v>4320.19921875</c:v>
                </c:pt>
                <c:pt idx="48">
                  <c:v>4329.58544921875</c:v>
                </c:pt>
                <c:pt idx="49">
                  <c:v>4343.2646484375</c:v>
                </c:pt>
                <c:pt idx="50">
                  <c:v>4353.59326171875</c:v>
                </c:pt>
                <c:pt idx="51">
                  <c:v>4349.79345703125</c:v>
                </c:pt>
                <c:pt idx="52">
                  <c:v>4327.18701171875</c:v>
                </c:pt>
                <c:pt idx="53">
                  <c:v>4293.6279296875</c:v>
                </c:pt>
                <c:pt idx="54">
                  <c:v>4266.8935546875</c:v>
                </c:pt>
                <c:pt idx="55">
                  <c:v>4263.70849609375</c:v>
                </c:pt>
                <c:pt idx="56">
                  <c:v>4288.31298828125</c:v>
                </c:pt>
                <c:pt idx="57">
                  <c:v>4329.61328125</c:v>
                </c:pt>
                <c:pt idx="58">
                  <c:v>4369.4267578125</c:v>
                </c:pt>
                <c:pt idx="59">
                  <c:v>4395.22802734375</c:v>
                </c:pt>
                <c:pt idx="60">
                  <c:v>4406.8974609375</c:v>
                </c:pt>
                <c:pt idx="61">
                  <c:v>4412.08349609375</c:v>
                </c:pt>
                <c:pt idx="62">
                  <c:v>4414.947265625</c:v>
                </c:pt>
                <c:pt idx="63">
                  <c:v>4409.38525390625</c:v>
                </c:pt>
                <c:pt idx="64">
                  <c:v>4384.32080078125</c:v>
                </c:pt>
                <c:pt idx="65">
                  <c:v>4337.5615234375</c:v>
                </c:pt>
                <c:pt idx="66">
                  <c:v>4285.57763671875</c:v>
                </c:pt>
                <c:pt idx="67">
                  <c:v>4258.01318359375</c:v>
                </c:pt>
                <c:pt idx="68">
                  <c:v>4277.81787109375</c:v>
                </c:pt>
                <c:pt idx="69">
                  <c:v>4341.13232421875</c:v>
                </c:pt>
                <c:pt idx="70">
                  <c:v>4413.875</c:v>
                </c:pt>
                <c:pt idx="71">
                  <c:v>4450.67138671875</c:v>
                </c:pt>
                <c:pt idx="72">
                  <c:v>4424.42333984375</c:v>
                </c:pt>
                <c:pt idx="73">
                  <c:v>4345.2880859375</c:v>
                </c:pt>
                <c:pt idx="74">
                  <c:v>4254.53955078125</c:v>
                </c:pt>
                <c:pt idx="75">
                  <c:v>4197.26708984375</c:v>
                </c:pt>
                <c:pt idx="76">
                  <c:v>4193.80078125</c:v>
                </c:pt>
                <c:pt idx="77">
                  <c:v>4230.47314453125</c:v>
                </c:pt>
                <c:pt idx="78">
                  <c:v>4275.107421875</c:v>
                </c:pt>
                <c:pt idx="79">
                  <c:v>4303.541015625</c:v>
                </c:pt>
                <c:pt idx="80">
                  <c:v>4315.83154296875</c:v>
                </c:pt>
                <c:pt idx="81">
                  <c:v>4330.322265625</c:v>
                </c:pt>
                <c:pt idx="82">
                  <c:v>4362.375</c:v>
                </c:pt>
                <c:pt idx="83">
                  <c:v>4406.86376953125</c:v>
                </c:pt>
                <c:pt idx="84">
                  <c:v>4439.5986328125</c:v>
                </c:pt>
                <c:pt idx="85">
                  <c:v>4436.4091796875</c:v>
                </c:pt>
                <c:pt idx="86">
                  <c:v>4393.69287109375</c:v>
                </c:pt>
                <c:pt idx="87">
                  <c:v>4333.1279296875</c:v>
                </c:pt>
                <c:pt idx="88">
                  <c:v>4286.654296875</c:v>
                </c:pt>
                <c:pt idx="89">
                  <c:v>4274.1240234375</c:v>
                </c:pt>
                <c:pt idx="90">
                  <c:v>4291.58154296875</c:v>
                </c:pt>
                <c:pt idx="91">
                  <c:v>4318.6171875</c:v>
                </c:pt>
                <c:pt idx="92">
                  <c:v>4337.11328125</c:v>
                </c:pt>
                <c:pt idx="93">
                  <c:v>4344.7607421875</c:v>
                </c:pt>
                <c:pt idx="94">
                  <c:v>4352.31298828125</c:v>
                </c:pt>
                <c:pt idx="95">
                  <c:v>4368.4296875</c:v>
                </c:pt>
                <c:pt idx="96">
                  <c:v>4387.07958984375</c:v>
                </c:pt>
                <c:pt idx="97">
                  <c:v>4390.123046875</c:v>
                </c:pt>
                <c:pt idx="98">
                  <c:v>4363.95556640625</c:v>
                </c:pt>
                <c:pt idx="99">
                  <c:v>4315.85009765625</c:v>
                </c:pt>
                <c:pt idx="100">
                  <c:v>4274.52490234375</c:v>
                </c:pt>
                <c:pt idx="101">
                  <c:v>4271.8671875</c:v>
                </c:pt>
                <c:pt idx="102">
                  <c:v>4318.61279296875</c:v>
                </c:pt>
                <c:pt idx="103">
                  <c:v>4392.98779296875</c:v>
                </c:pt>
                <c:pt idx="104">
                  <c:v>4452.38134765625</c:v>
                </c:pt>
                <c:pt idx="105">
                  <c:v>4460.88330078125</c:v>
                </c:pt>
                <c:pt idx="106">
                  <c:v>4413.35595703125</c:v>
                </c:pt>
                <c:pt idx="107">
                  <c:v>4338.9638671875</c:v>
                </c:pt>
                <c:pt idx="108">
                  <c:v>4281.84619140625</c:v>
                </c:pt>
                <c:pt idx="109">
                  <c:v>4272.62841796875</c:v>
                </c:pt>
                <c:pt idx="110">
                  <c:v>4310.0634765625</c:v>
                </c:pt>
                <c:pt idx="111">
                  <c:v>4364.06787109375</c:v>
                </c:pt>
                <c:pt idx="112">
                  <c:v>4396.4052734375</c:v>
                </c:pt>
                <c:pt idx="113">
                  <c:v>4384.283203125</c:v>
                </c:pt>
                <c:pt idx="114">
                  <c:v>4332.0400390625</c:v>
                </c:pt>
                <c:pt idx="115">
                  <c:v>4265.4609375</c:v>
                </c:pt>
                <c:pt idx="116">
                  <c:v>4214.64453125</c:v>
                </c:pt>
                <c:pt idx="117">
                  <c:v>4197.23291015625</c:v>
                </c:pt>
                <c:pt idx="118">
                  <c:v>4211.626953125</c:v>
                </c:pt>
                <c:pt idx="119">
                  <c:v>4242.353515625</c:v>
                </c:pt>
                <c:pt idx="120">
                  <c:v>4272.39208984375</c:v>
                </c:pt>
                <c:pt idx="121">
                  <c:v>4293.978515625</c:v>
                </c:pt>
                <c:pt idx="122">
                  <c:v>4311.35595703125</c:v>
                </c:pt>
                <c:pt idx="123">
                  <c:v>4334.3876953125</c:v>
                </c:pt>
                <c:pt idx="124">
                  <c:v>4367.83154296875</c:v>
                </c:pt>
                <c:pt idx="125">
                  <c:v>4404.1435546875</c:v>
                </c:pt>
                <c:pt idx="126">
                  <c:v>4425.8525390625</c:v>
                </c:pt>
                <c:pt idx="127">
                  <c:v>4417.27294921875</c:v>
                </c:pt>
                <c:pt idx="128">
                  <c:v>4378.099609375</c:v>
                </c:pt>
                <c:pt idx="129">
                  <c:v>4328.40625</c:v>
                </c:pt>
                <c:pt idx="130">
                  <c:v>4299.04833984375</c:v>
                </c:pt>
                <c:pt idx="131">
                  <c:v>4311.67529296875</c:v>
                </c:pt>
                <c:pt idx="132">
                  <c:v>4361.64990234375</c:v>
                </c:pt>
                <c:pt idx="133">
                  <c:v>4417.517578125</c:v>
                </c:pt>
                <c:pt idx="134">
                  <c:v>4440.27880859375</c:v>
                </c:pt>
                <c:pt idx="135">
                  <c:v>4410.92724609375</c:v>
                </c:pt>
                <c:pt idx="136">
                  <c:v>4346.615234375</c:v>
                </c:pt>
                <c:pt idx="137">
                  <c:v>4291.8876953125</c:v>
                </c:pt>
                <c:pt idx="138">
                  <c:v>4288.79443359375</c:v>
                </c:pt>
                <c:pt idx="139">
                  <c:v>4346.05224609375</c:v>
                </c:pt>
                <c:pt idx="140">
                  <c:v>4429.9296875</c:v>
                </c:pt>
                <c:pt idx="141">
                  <c:v>4484.98388671875</c:v>
                </c:pt>
                <c:pt idx="142">
                  <c:v>4471.16162109375</c:v>
                </c:pt>
                <c:pt idx="143">
                  <c:v>4391.22021484375</c:v>
                </c:pt>
                <c:pt idx="144">
                  <c:v>4288.861328125</c:v>
                </c:pt>
                <c:pt idx="145">
                  <c:v>4219.0732421875</c:v>
                </c:pt>
                <c:pt idx="146">
                  <c:v>4212.1669921875</c:v>
                </c:pt>
                <c:pt idx="147">
                  <c:v>4256.8837890625</c:v>
                </c:pt>
                <c:pt idx="148">
                  <c:v>4313.02099609375</c:v>
                </c:pt>
                <c:pt idx="149">
                  <c:v>4342.10595703125</c:v>
                </c:pt>
                <c:pt idx="150">
                  <c:v>4332.521484375</c:v>
                </c:pt>
                <c:pt idx="151">
                  <c:v>4301.8251953125</c:v>
                </c:pt>
                <c:pt idx="152">
                  <c:v>4277.77685546875</c:v>
                </c:pt>
                <c:pt idx="153">
                  <c:v>4275.4677734375</c:v>
                </c:pt>
                <c:pt idx="154">
                  <c:v>4288.775390625</c:v>
                </c:pt>
                <c:pt idx="155">
                  <c:v>4300.76220703125</c:v>
                </c:pt>
                <c:pt idx="156">
                  <c:v>4301.658203125</c:v>
                </c:pt>
                <c:pt idx="157">
                  <c:v>4297.87109375</c:v>
                </c:pt>
                <c:pt idx="158">
                  <c:v>4304.6044921875</c:v>
                </c:pt>
                <c:pt idx="159">
                  <c:v>4329.5234375</c:v>
                </c:pt>
                <c:pt idx="160">
                  <c:v>4362.70361328125</c:v>
                </c:pt>
                <c:pt idx="161">
                  <c:v>4382.455078125</c:v>
                </c:pt>
                <c:pt idx="162">
                  <c:v>4372.76171875</c:v>
                </c:pt>
                <c:pt idx="163">
                  <c:v>4337.8798828125</c:v>
                </c:pt>
                <c:pt idx="164">
                  <c:v>4301.59716796875</c:v>
                </c:pt>
                <c:pt idx="165">
                  <c:v>4290.97412109375</c:v>
                </c:pt>
                <c:pt idx="166">
                  <c:v>4316.8115234375</c:v>
                </c:pt>
                <c:pt idx="167">
                  <c:v>4365.67431640625</c:v>
                </c:pt>
                <c:pt idx="168">
                  <c:v>4409.3037109375</c:v>
                </c:pt>
                <c:pt idx="169">
                  <c:v>4424.12939453125</c:v>
                </c:pt>
                <c:pt idx="170">
                  <c:v>4406.57763671875</c:v>
                </c:pt>
                <c:pt idx="171">
                  <c:v>4373.7578125</c:v>
                </c:pt>
                <c:pt idx="172">
                  <c:v>4350.20458984375</c:v>
                </c:pt>
                <c:pt idx="173">
                  <c:v>4350.92236328125</c:v>
                </c:pt>
                <c:pt idx="174">
                  <c:v>4372.40478515625</c:v>
                </c:pt>
                <c:pt idx="175">
                  <c:v>4396.64453125</c:v>
                </c:pt>
                <c:pt idx="176">
                  <c:v>4404.06591796875</c:v>
                </c:pt>
                <c:pt idx="177">
                  <c:v>4386.16748046875</c:v>
                </c:pt>
                <c:pt idx="178">
                  <c:v>4350.09765625</c:v>
                </c:pt>
                <c:pt idx="179">
                  <c:v>4313.27685546875</c:v>
                </c:pt>
                <c:pt idx="180">
                  <c:v>4292.23388671875</c:v>
                </c:pt>
                <c:pt idx="181">
                  <c:v>4292.65673828125</c:v>
                </c:pt>
                <c:pt idx="182">
                  <c:v>4306.43994140625</c:v>
                </c:pt>
                <c:pt idx="183">
                  <c:v>4317.3349609375</c:v>
                </c:pt>
                <c:pt idx="184">
                  <c:v>4311.923828125</c:v>
                </c:pt>
                <c:pt idx="185">
                  <c:v>4289.2548828125</c:v>
                </c:pt>
                <c:pt idx="186">
                  <c:v>4262.69384765625</c:v>
                </c:pt>
                <c:pt idx="187">
                  <c:v>4251.828125</c:v>
                </c:pt>
                <c:pt idx="188">
                  <c:v>4268.82861328125</c:v>
                </c:pt>
                <c:pt idx="189">
                  <c:v>4308.3671875</c:v>
                </c:pt>
                <c:pt idx="190">
                  <c:v>4349.0546875</c:v>
                </c:pt>
                <c:pt idx="191">
                  <c:v>4366.99169921875</c:v>
                </c:pt>
                <c:pt idx="192">
                  <c:v>4352.84912109375</c:v>
                </c:pt>
                <c:pt idx="193">
                  <c:v>4319.96435546875</c:v>
                </c:pt>
                <c:pt idx="194">
                  <c:v>4296.2216796875</c:v>
                </c:pt>
                <c:pt idx="195">
                  <c:v>4304.21533203125</c:v>
                </c:pt>
                <c:pt idx="196">
                  <c:v>4343.7763671875</c:v>
                </c:pt>
                <c:pt idx="197">
                  <c:v>4390.4541015625</c:v>
                </c:pt>
                <c:pt idx="198">
                  <c:v>4412.283203125</c:v>
                </c:pt>
                <c:pt idx="199">
                  <c:v>4393.1953125</c:v>
                </c:pt>
                <c:pt idx="200">
                  <c:v>4345.63232421875</c:v>
                </c:pt>
                <c:pt idx="201">
                  <c:v>4302.4267578125</c:v>
                </c:pt>
                <c:pt idx="202">
                  <c:v>4293.54833984375</c:v>
                </c:pt>
                <c:pt idx="203">
                  <c:v>4324.9150390625</c:v>
                </c:pt>
                <c:pt idx="204">
                  <c:v>4374.9677734375</c:v>
                </c:pt>
                <c:pt idx="205">
                  <c:v>4411.1279296875</c:v>
                </c:pt>
                <c:pt idx="206">
                  <c:v>4413.24462890625</c:v>
                </c:pt>
                <c:pt idx="207">
                  <c:v>4386.4296875</c:v>
                </c:pt>
                <c:pt idx="208">
                  <c:v>4354.56591796875</c:v>
                </c:pt>
                <c:pt idx="209">
                  <c:v>4340.8916015625</c:v>
                </c:pt>
                <c:pt idx="210">
                  <c:v>4351.18701171875</c:v>
                </c:pt>
                <c:pt idx="211">
                  <c:v>4371.6611328125</c:v>
                </c:pt>
                <c:pt idx="212">
                  <c:v>4381.23974609375</c:v>
                </c:pt>
                <c:pt idx="213">
                  <c:v>4367.22216796875</c:v>
                </c:pt>
                <c:pt idx="214">
                  <c:v>4332.4365234375</c:v>
                </c:pt>
                <c:pt idx="215">
                  <c:v>4290.48974609375</c:v>
                </c:pt>
                <c:pt idx="216">
                  <c:v>4255.4140625</c:v>
                </c:pt>
                <c:pt idx="217">
                  <c:v>4234.77685546875</c:v>
                </c:pt>
                <c:pt idx="218">
                  <c:v>4230.0234375</c:v>
                </c:pt>
                <c:pt idx="219">
                  <c:v>4240.45458984375</c:v>
                </c:pt>
                <c:pt idx="220">
                  <c:v>4264.89794921875</c:v>
                </c:pt>
                <c:pt idx="221">
                  <c:v>4299.3681640625</c:v>
                </c:pt>
                <c:pt idx="222">
                  <c:v>4334.72021484375</c:v>
                </c:pt>
                <c:pt idx="223">
                  <c:v>4359.1845703125</c:v>
                </c:pt>
                <c:pt idx="224">
                  <c:v>4365.59130859375</c:v>
                </c:pt>
                <c:pt idx="225">
                  <c:v>4357.16943359375</c:v>
                </c:pt>
                <c:pt idx="226">
                  <c:v>4345.62109375</c:v>
                </c:pt>
                <c:pt idx="227">
                  <c:v>4341.7451171875</c:v>
                </c:pt>
                <c:pt idx="228">
                  <c:v>4346.39208984375</c:v>
                </c:pt>
                <c:pt idx="229">
                  <c:v>4350.3740234375</c:v>
                </c:pt>
                <c:pt idx="230">
                  <c:v>4344.34423828125</c:v>
                </c:pt>
                <c:pt idx="231">
                  <c:v>4329.99853515625</c:v>
                </c:pt>
                <c:pt idx="232">
                  <c:v>4321.45263671875</c:v>
                </c:pt>
                <c:pt idx="233">
                  <c:v>4333.7607421875</c:v>
                </c:pt>
                <c:pt idx="234">
                  <c:v>4367.7119140625</c:v>
                </c:pt>
                <c:pt idx="235">
                  <c:v>4405.20947265625</c:v>
                </c:pt>
                <c:pt idx="236">
                  <c:v>4421.70068359375</c:v>
                </c:pt>
                <c:pt idx="237">
                  <c:v>4406.99462890625</c:v>
                </c:pt>
                <c:pt idx="238">
                  <c:v>4376.52685546875</c:v>
                </c:pt>
                <c:pt idx="239">
                  <c:v>4361.09228515625</c:v>
                </c:pt>
                <c:pt idx="240">
                  <c:v>4380.83349609375</c:v>
                </c:pt>
                <c:pt idx="241">
                  <c:v>4424.29443359375</c:v>
                </c:pt>
                <c:pt idx="242">
                  <c:v>4451.8447265625</c:v>
                </c:pt>
                <c:pt idx="243">
                  <c:v>4424.22998046875</c:v>
                </c:pt>
                <c:pt idx="244">
                  <c:v>4335.5771484375</c:v>
                </c:pt>
                <c:pt idx="245">
                  <c:v>4224.08203125</c:v>
                </c:pt>
                <c:pt idx="246">
                  <c:v>4149.2919921875</c:v>
                </c:pt>
                <c:pt idx="247">
                  <c:v>4151.0693359375</c:v>
                </c:pt>
                <c:pt idx="248">
                  <c:v>4220.95849609375</c:v>
                </c:pt>
                <c:pt idx="249">
                  <c:v>4308.4755859375</c:v>
                </c:pt>
                <c:pt idx="250">
                  <c:v>4358.23291015625</c:v>
                </c:pt>
                <c:pt idx="251">
                  <c:v>4349.7275390625</c:v>
                </c:pt>
                <c:pt idx="252">
                  <c:v>4309.3623046875</c:v>
                </c:pt>
                <c:pt idx="253">
                  <c:v>4286.03662109375</c:v>
                </c:pt>
                <c:pt idx="254">
                  <c:v>4310.24072265625</c:v>
                </c:pt>
                <c:pt idx="255">
                  <c:v>4369.25390625</c:v>
                </c:pt>
                <c:pt idx="256">
                  <c:v>4417.77001953125</c:v>
                </c:pt>
                <c:pt idx="257">
                  <c:v>4414.87890625</c:v>
                </c:pt>
                <c:pt idx="258">
                  <c:v>4357.59326171875</c:v>
                </c:pt>
                <c:pt idx="259">
                  <c:v>4284.34765625</c:v>
                </c:pt>
                <c:pt idx="260">
                  <c:v>4246.052734375</c:v>
                </c:pt>
                <c:pt idx="261">
                  <c:v>4267.748046875</c:v>
                </c:pt>
                <c:pt idx="262">
                  <c:v>4330.62451171875</c:v>
                </c:pt>
                <c:pt idx="263">
                  <c:v>4387.53759765625</c:v>
                </c:pt>
                <c:pt idx="264">
                  <c:v>4399.0224609375</c:v>
                </c:pt>
                <c:pt idx="265">
                  <c:v>4361.84912109375</c:v>
                </c:pt>
                <c:pt idx="266">
                  <c:v>4309.30224609375</c:v>
                </c:pt>
                <c:pt idx="267">
                  <c:v>4284.77734375</c:v>
                </c:pt>
                <c:pt idx="268">
                  <c:v>4309.88916015625</c:v>
                </c:pt>
                <c:pt idx="269">
                  <c:v>4370.55322265625</c:v>
                </c:pt>
                <c:pt idx="270">
                  <c:v>4429.25146484375</c:v>
                </c:pt>
                <c:pt idx="271">
                  <c:v>4452.01806640625</c:v>
                </c:pt>
                <c:pt idx="272">
                  <c:v>4429.66259765625</c:v>
                </c:pt>
                <c:pt idx="273">
                  <c:v>4379.61279296875</c:v>
                </c:pt>
                <c:pt idx="274">
                  <c:v>4330.35595703125</c:v>
                </c:pt>
                <c:pt idx="275">
                  <c:v>4302.08984375</c:v>
                </c:pt>
                <c:pt idx="276">
                  <c:v>4297.1572265625</c:v>
                </c:pt>
                <c:pt idx="277">
                  <c:v>4304.25146484375</c:v>
                </c:pt>
                <c:pt idx="278">
                  <c:v>4310.10888671875</c:v>
                </c:pt>
                <c:pt idx="279">
                  <c:v>4308.91015625</c:v>
                </c:pt>
                <c:pt idx="280">
                  <c:v>4303.82177734375</c:v>
                </c:pt>
                <c:pt idx="281">
                  <c:v>4302.03955078125</c:v>
                </c:pt>
                <c:pt idx="282">
                  <c:v>4308.63427734375</c:v>
                </c:pt>
                <c:pt idx="283">
                  <c:v>4323.56787109375</c:v>
                </c:pt>
                <c:pt idx="284">
                  <c:v>4342.69384765625</c:v>
                </c:pt>
                <c:pt idx="285">
                  <c:v>4360.77685546875</c:v>
                </c:pt>
                <c:pt idx="286">
                  <c:v>4374.1318359375</c:v>
                </c:pt>
                <c:pt idx="287">
                  <c:v>4381.568359375</c:v>
                </c:pt>
                <c:pt idx="288">
                  <c:v>4383.5439453125</c:v>
                </c:pt>
                <c:pt idx="289">
                  <c:v>4380.248046875</c:v>
                </c:pt>
                <c:pt idx="290">
                  <c:v>4369.9716796875</c:v>
                </c:pt>
                <c:pt idx="291">
                  <c:v>4349.45361328125</c:v>
                </c:pt>
                <c:pt idx="292">
                  <c:v>4317.03955078125</c:v>
                </c:pt>
                <c:pt idx="293">
                  <c:v>4277.18994140625</c:v>
                </c:pt>
                <c:pt idx="294">
                  <c:v>4242.5234375</c:v>
                </c:pt>
                <c:pt idx="295">
                  <c:v>4229.79150390625</c:v>
                </c:pt>
                <c:pt idx="296">
                  <c:v>4250.17138671875</c:v>
                </c:pt>
                <c:pt idx="297">
                  <c:v>4299.67333984375</c:v>
                </c:pt>
                <c:pt idx="298">
                  <c:v>4357.62255859375</c:v>
                </c:pt>
                <c:pt idx="299">
                  <c:v>4396.86865234375</c:v>
                </c:pt>
                <c:pt idx="300">
                  <c:v>4400.5673828125</c:v>
                </c:pt>
                <c:pt idx="301">
                  <c:v>4373.85888671875</c:v>
                </c:pt>
                <c:pt idx="302">
                  <c:v>4340.70849609375</c:v>
                </c:pt>
                <c:pt idx="303">
                  <c:v>4326.634765625</c:v>
                </c:pt>
                <c:pt idx="304">
                  <c:v>4339.47021484375</c:v>
                </c:pt>
                <c:pt idx="305">
                  <c:v>4363.19580078125</c:v>
                </c:pt>
                <c:pt idx="306">
                  <c:v>4370.73046875</c:v>
                </c:pt>
                <c:pt idx="307">
                  <c:v>4346.62353515625</c:v>
                </c:pt>
                <c:pt idx="308">
                  <c:v>4301.81005859375</c:v>
                </c:pt>
                <c:pt idx="309">
                  <c:v>4267.73095703125</c:v>
                </c:pt>
                <c:pt idx="310">
                  <c:v>4273.0419921875</c:v>
                </c:pt>
                <c:pt idx="311">
                  <c:v>4320.486328125</c:v>
                </c:pt>
                <c:pt idx="312">
                  <c:v>4382.3974609375</c:v>
                </c:pt>
                <c:pt idx="313">
                  <c:v>4419.38671875</c:v>
                </c:pt>
                <c:pt idx="314">
                  <c:v>4408.6591796875</c:v>
                </c:pt>
                <c:pt idx="315">
                  <c:v>4360.55029296875</c:v>
                </c:pt>
                <c:pt idx="316">
                  <c:v>4310.7177734375</c:v>
                </c:pt>
                <c:pt idx="317">
                  <c:v>4294.060546875</c:v>
                </c:pt>
                <c:pt idx="318">
                  <c:v>4320.1201171875</c:v>
                </c:pt>
                <c:pt idx="319">
                  <c:v>4367.865234375</c:v>
                </c:pt>
                <c:pt idx="320">
                  <c:v>4402.3076171875</c:v>
                </c:pt>
                <c:pt idx="321">
                  <c:v>4399.1396484375</c:v>
                </c:pt>
                <c:pt idx="322">
                  <c:v>4359.09521484375</c:v>
                </c:pt>
                <c:pt idx="323">
                  <c:v>4303.60693359375</c:v>
                </c:pt>
                <c:pt idx="324">
                  <c:v>4258.3037109375</c:v>
                </c:pt>
                <c:pt idx="325">
                  <c:v>4238.5263671875</c:v>
                </c:pt>
                <c:pt idx="326">
                  <c:v>4246.17236328125</c:v>
                </c:pt>
                <c:pt idx="327">
                  <c:v>4275.67138671875</c:v>
                </c:pt>
                <c:pt idx="328">
                  <c:v>4319.8037109375</c:v>
                </c:pt>
                <c:pt idx="329">
                  <c:v>4369.25048828125</c:v>
                </c:pt>
                <c:pt idx="330">
                  <c:v>4409.044921875</c:v>
                </c:pt>
                <c:pt idx="331">
                  <c:v>4420.44189453125</c:v>
                </c:pt>
                <c:pt idx="332">
                  <c:v>4392.03271484375</c:v>
                </c:pt>
                <c:pt idx="333">
                  <c:v>4333.12841796875</c:v>
                </c:pt>
                <c:pt idx="334">
                  <c:v>4276.17236328125</c:v>
                </c:pt>
                <c:pt idx="335">
                  <c:v>4260.8369140625</c:v>
                </c:pt>
                <c:pt idx="336">
                  <c:v>4307.27294921875</c:v>
                </c:pt>
                <c:pt idx="337">
                  <c:v>4397.513671875</c:v>
                </c:pt>
                <c:pt idx="338">
                  <c:v>4481.302734375</c:v>
                </c:pt>
                <c:pt idx="339">
                  <c:v>4505.82470703125</c:v>
                </c:pt>
                <c:pt idx="340">
                  <c:v>4450.2646484375</c:v>
                </c:pt>
                <c:pt idx="341">
                  <c:v>4340.78271484375</c:v>
                </c:pt>
                <c:pt idx="342">
                  <c:v>4234.5107421875</c:v>
                </c:pt>
                <c:pt idx="343">
                  <c:v>4183.33984375</c:v>
                </c:pt>
                <c:pt idx="344">
                  <c:v>4202.705078125</c:v>
                </c:pt>
                <c:pt idx="345">
                  <c:v>4266.35888671875</c:v>
                </c:pt>
                <c:pt idx="346">
                  <c:v>4328.68701171875</c:v>
                </c:pt>
                <c:pt idx="347">
                  <c:v>4356.57763671875</c:v>
                </c:pt>
                <c:pt idx="348">
                  <c:v>4347.79443359375</c:v>
                </c:pt>
                <c:pt idx="349">
                  <c:v>4325.04296875</c:v>
                </c:pt>
              </c:numCache>
            </c:numRef>
          </c:yVal>
          <c:smooth val="1"/>
          <c:extLst>
            <c:ext xmlns:c16="http://schemas.microsoft.com/office/drawing/2014/chart" uri="{C3380CC4-5D6E-409C-BE32-E72D297353CC}">
              <c16:uniqueId val="{00000010-0DDB-41B5-BE83-A9CFE49F3CE3}"/>
            </c:ext>
          </c:extLst>
        </c:ser>
        <c:ser>
          <c:idx val="17"/>
          <c:order val="17"/>
          <c:tx>
            <c:strRef>
              <c:f>hc_sub_007!$R$1</c:f>
              <c:strCache>
                <c:ptCount val="1"/>
                <c:pt idx="0">
                  <c:v>Coor_18</c:v>
                </c:pt>
              </c:strCache>
            </c:strRef>
          </c:tx>
          <c:spPr>
            <a:ln w="28575" cap="rnd">
              <a:solidFill>
                <a:schemeClr val="accent6">
                  <a:lumMod val="80000"/>
                  <a:lumOff val="20000"/>
                </a:schemeClr>
              </a:solidFill>
              <a:round/>
            </a:ln>
            <a:effectLst/>
          </c:spPr>
          <c:marker>
            <c:symbol val="none"/>
          </c:marker>
          <c:yVal>
            <c:numRef>
              <c:f>hc_sub_007!$R$2:$R$351</c:f>
              <c:numCache>
                <c:formatCode>0.00000000000_ </c:formatCode>
                <c:ptCount val="350"/>
                <c:pt idx="0">
                  <c:v>6233.51318359375</c:v>
                </c:pt>
                <c:pt idx="1">
                  <c:v>6216.59716796875</c:v>
                </c:pt>
                <c:pt idx="2">
                  <c:v>6185.27099609375</c:v>
                </c:pt>
                <c:pt idx="3">
                  <c:v>6153.39306640625</c:v>
                </c:pt>
                <c:pt idx="4">
                  <c:v>6139.9892578125</c:v>
                </c:pt>
                <c:pt idx="5">
                  <c:v>6155.4775390625</c:v>
                </c:pt>
                <c:pt idx="6">
                  <c:v>6192.9599609375</c:v>
                </c:pt>
                <c:pt idx="7">
                  <c:v>6231.7373046875</c:v>
                </c:pt>
                <c:pt idx="8">
                  <c:v>6251.0087890625</c:v>
                </c:pt>
                <c:pt idx="9">
                  <c:v>6243.9482421875</c:v>
                </c:pt>
                <c:pt idx="10">
                  <c:v>6222.04052734375</c:v>
                </c:pt>
                <c:pt idx="11">
                  <c:v>6206.87646484375</c:v>
                </c:pt>
                <c:pt idx="12">
                  <c:v>6215.634765625</c:v>
                </c:pt>
                <c:pt idx="13">
                  <c:v>6250.33740234375</c:v>
                </c:pt>
                <c:pt idx="14">
                  <c:v>6297.3056640625</c:v>
                </c:pt>
                <c:pt idx="15">
                  <c:v>6335.63818359375</c:v>
                </c:pt>
                <c:pt idx="16">
                  <c:v>6348.20654296875</c:v>
                </c:pt>
                <c:pt idx="17">
                  <c:v>6328.93505859375</c:v>
                </c:pt>
                <c:pt idx="18">
                  <c:v>6284.328125</c:v>
                </c:pt>
                <c:pt idx="19">
                  <c:v>6230.81298828125</c:v>
                </c:pt>
                <c:pt idx="20">
                  <c:v>6189.791015625</c:v>
                </c:pt>
                <c:pt idx="21">
                  <c:v>6180.68115234375</c:v>
                </c:pt>
                <c:pt idx="22">
                  <c:v>6212.1875</c:v>
                </c:pt>
                <c:pt idx="23">
                  <c:v>6274.84326171875</c:v>
                </c:pt>
                <c:pt idx="24">
                  <c:v>6340.6953125</c:v>
                </c:pt>
                <c:pt idx="25">
                  <c:v>6374.376953125</c:v>
                </c:pt>
                <c:pt idx="26">
                  <c:v>6352.5556640625</c:v>
                </c:pt>
                <c:pt idx="27">
                  <c:v>6280.57666015625</c:v>
                </c:pt>
                <c:pt idx="28">
                  <c:v>6193.5625</c:v>
                </c:pt>
                <c:pt idx="29">
                  <c:v>6137.82763671875</c:v>
                </c:pt>
                <c:pt idx="30">
                  <c:v>6142.537109375</c:v>
                </c:pt>
                <c:pt idx="31">
                  <c:v>6200.435546875</c:v>
                </c:pt>
                <c:pt idx="32">
                  <c:v>6272.0625</c:v>
                </c:pt>
                <c:pt idx="33">
                  <c:v>6311.76806640625</c:v>
                </c:pt>
                <c:pt idx="34">
                  <c:v>6297.65869140625</c:v>
                </c:pt>
                <c:pt idx="35">
                  <c:v>6244.0458984375</c:v>
                </c:pt>
                <c:pt idx="36">
                  <c:v>6187.83056640625</c:v>
                </c:pt>
                <c:pt idx="37">
                  <c:v>6160.00634765625</c:v>
                </c:pt>
                <c:pt idx="38">
                  <c:v>6164.76123046875</c:v>
                </c:pt>
                <c:pt idx="39">
                  <c:v>6182.0947265625</c:v>
                </c:pt>
                <c:pt idx="40">
                  <c:v>6190.41259765625</c:v>
                </c:pt>
                <c:pt idx="41">
                  <c:v>6188.91650390625</c:v>
                </c:pt>
                <c:pt idx="42">
                  <c:v>6199.6494140625</c:v>
                </c:pt>
                <c:pt idx="43">
                  <c:v>6246.27099609375</c:v>
                </c:pt>
                <c:pt idx="44">
                  <c:v>6327.1220703125</c:v>
                </c:pt>
                <c:pt idx="45">
                  <c:v>6406.638671875</c:v>
                </c:pt>
                <c:pt idx="46">
                  <c:v>6435.44287109375</c:v>
                </c:pt>
                <c:pt idx="47">
                  <c:v>6385.92724609375</c:v>
                </c:pt>
                <c:pt idx="48">
                  <c:v>6275.95263671875</c:v>
                </c:pt>
                <c:pt idx="49">
                  <c:v>6160.71923828125</c:v>
                </c:pt>
                <c:pt idx="50">
                  <c:v>6096.98193359375</c:v>
                </c:pt>
                <c:pt idx="51">
                  <c:v>6105.66748046875</c:v>
                </c:pt>
                <c:pt idx="52">
                  <c:v>6160.90234375</c:v>
                </c:pt>
                <c:pt idx="53">
                  <c:v>6213.3818359375</c:v>
                </c:pt>
                <c:pt idx="54">
                  <c:v>6229.4287109375</c:v>
                </c:pt>
                <c:pt idx="55">
                  <c:v>6215.11767578125</c:v>
                </c:pt>
                <c:pt idx="56">
                  <c:v>6207.05615234375</c:v>
                </c:pt>
                <c:pt idx="57">
                  <c:v>6238.134765625</c:v>
                </c:pt>
                <c:pt idx="58">
                  <c:v>6306.4931640625</c:v>
                </c:pt>
                <c:pt idx="59">
                  <c:v>6373.19873046875</c:v>
                </c:pt>
                <c:pt idx="60">
                  <c:v>6390.974609375</c:v>
                </c:pt>
                <c:pt idx="61">
                  <c:v>6341.35107421875</c:v>
                </c:pt>
                <c:pt idx="62">
                  <c:v>6250.74658203125</c:v>
                </c:pt>
                <c:pt idx="63">
                  <c:v>6172.55224609375</c:v>
                </c:pt>
                <c:pt idx="64">
                  <c:v>6148.95654296875</c:v>
                </c:pt>
                <c:pt idx="65">
                  <c:v>6181.8271484375</c:v>
                </c:pt>
                <c:pt idx="66">
                  <c:v>6234.41162109375</c:v>
                </c:pt>
                <c:pt idx="67">
                  <c:v>6261.35791015625</c:v>
                </c:pt>
                <c:pt idx="68">
                  <c:v>6243.02734375</c:v>
                </c:pt>
                <c:pt idx="69">
                  <c:v>6197.88134765625</c:v>
                </c:pt>
                <c:pt idx="70">
                  <c:v>6164.93505859375</c:v>
                </c:pt>
                <c:pt idx="71">
                  <c:v>6171.7236328125</c:v>
                </c:pt>
                <c:pt idx="72">
                  <c:v>6213.50048828125</c:v>
                </c:pt>
                <c:pt idx="73">
                  <c:v>6259.0966796875</c:v>
                </c:pt>
                <c:pt idx="74">
                  <c:v>6277.1328125</c:v>
                </c:pt>
                <c:pt idx="75">
                  <c:v>6260.7734375</c:v>
                </c:pt>
                <c:pt idx="76">
                  <c:v>6231.6708984375</c:v>
                </c:pt>
                <c:pt idx="77">
                  <c:v>6221.24365234375</c:v>
                </c:pt>
                <c:pt idx="78">
                  <c:v>6245.3134765625</c:v>
                </c:pt>
                <c:pt idx="79">
                  <c:v>6292.31396484375</c:v>
                </c:pt>
                <c:pt idx="80">
                  <c:v>6333.35205078125</c:v>
                </c:pt>
                <c:pt idx="81">
                  <c:v>6344.76171875</c:v>
                </c:pt>
                <c:pt idx="82">
                  <c:v>6324.71337890625</c:v>
                </c:pt>
                <c:pt idx="83">
                  <c:v>6291.53076171875</c:v>
                </c:pt>
                <c:pt idx="84">
                  <c:v>6266.78173828125</c:v>
                </c:pt>
                <c:pt idx="85">
                  <c:v>6258.10986328125</c:v>
                </c:pt>
                <c:pt idx="86">
                  <c:v>6255.8203125</c:v>
                </c:pt>
                <c:pt idx="87">
                  <c:v>6245.0224609375</c:v>
                </c:pt>
                <c:pt idx="88">
                  <c:v>6222.02783203125</c:v>
                </c:pt>
                <c:pt idx="89">
                  <c:v>6200.3896484375</c:v>
                </c:pt>
                <c:pt idx="90">
                  <c:v>6200.82763671875</c:v>
                </c:pt>
                <c:pt idx="91">
                  <c:v>6232.81201171875</c:v>
                </c:pt>
                <c:pt idx="92">
                  <c:v>6282.90673828125</c:v>
                </c:pt>
                <c:pt idx="93">
                  <c:v>6320.2529296875</c:v>
                </c:pt>
                <c:pt idx="94">
                  <c:v>6316.5205078125</c:v>
                </c:pt>
                <c:pt idx="95">
                  <c:v>6266.2998046875</c:v>
                </c:pt>
                <c:pt idx="96">
                  <c:v>6192.88134765625</c:v>
                </c:pt>
                <c:pt idx="97">
                  <c:v>6134.4453125</c:v>
                </c:pt>
                <c:pt idx="98">
                  <c:v>6119.56396484375</c:v>
                </c:pt>
                <c:pt idx="99">
                  <c:v>6148.646484375</c:v>
                </c:pt>
                <c:pt idx="100">
                  <c:v>6194.10546875</c:v>
                </c:pt>
                <c:pt idx="101">
                  <c:v>6219.36083984375</c:v>
                </c:pt>
                <c:pt idx="102">
                  <c:v>6204.00341796875</c:v>
                </c:pt>
                <c:pt idx="103">
                  <c:v>6158.1953125</c:v>
                </c:pt>
                <c:pt idx="104">
                  <c:v>6116.47412109375</c:v>
                </c:pt>
                <c:pt idx="105">
                  <c:v>6114.8310546875</c:v>
                </c:pt>
                <c:pt idx="106">
                  <c:v>6166.181640625</c:v>
                </c:pt>
                <c:pt idx="107">
                  <c:v>6250.67333984375</c:v>
                </c:pt>
                <c:pt idx="108">
                  <c:v>6327.62841796875</c:v>
                </c:pt>
                <c:pt idx="109">
                  <c:v>6361.546875</c:v>
                </c:pt>
                <c:pt idx="110">
                  <c:v>6344.92529296875</c:v>
                </c:pt>
                <c:pt idx="111">
                  <c:v>6302.4287109375</c:v>
                </c:pt>
                <c:pt idx="112">
                  <c:v>6273.328125</c:v>
                </c:pt>
                <c:pt idx="113">
                  <c:v>6284.02099609375</c:v>
                </c:pt>
                <c:pt idx="114">
                  <c:v>6329.62158203125</c:v>
                </c:pt>
                <c:pt idx="115">
                  <c:v>6377.6240234375</c:v>
                </c:pt>
                <c:pt idx="116">
                  <c:v>6391.2705078125</c:v>
                </c:pt>
                <c:pt idx="117">
                  <c:v>6356.05908203125</c:v>
                </c:pt>
                <c:pt idx="118">
                  <c:v>6290.21630859375</c:v>
                </c:pt>
                <c:pt idx="119">
                  <c:v>6231.34619140625</c:v>
                </c:pt>
                <c:pt idx="120">
                  <c:v>6208.9365234375</c:v>
                </c:pt>
                <c:pt idx="121">
                  <c:v>6223.1708984375</c:v>
                </c:pt>
                <c:pt idx="122">
                  <c:v>6246.154296875</c:v>
                </c:pt>
                <c:pt idx="123">
                  <c:v>6244.90380859375</c:v>
                </c:pt>
                <c:pt idx="124">
                  <c:v>6208.66015625</c:v>
                </c:pt>
                <c:pt idx="125">
                  <c:v>6159.14208984375</c:v>
                </c:pt>
                <c:pt idx="126">
                  <c:v>6134.921875</c:v>
                </c:pt>
                <c:pt idx="127">
                  <c:v>6161.001953125</c:v>
                </c:pt>
                <c:pt idx="128">
                  <c:v>6226.798828125</c:v>
                </c:pt>
                <c:pt idx="129">
                  <c:v>6290.32080078125</c:v>
                </c:pt>
                <c:pt idx="130">
                  <c:v>6306.8740234375</c:v>
                </c:pt>
                <c:pt idx="131">
                  <c:v>6261.74072265625</c:v>
                </c:pt>
                <c:pt idx="132">
                  <c:v>6182.46044921875</c:v>
                </c:pt>
                <c:pt idx="133">
                  <c:v>6120.990234375</c:v>
                </c:pt>
                <c:pt idx="134">
                  <c:v>6118.22119140625</c:v>
                </c:pt>
                <c:pt idx="135">
                  <c:v>6176.412109375</c:v>
                </c:pt>
                <c:pt idx="136">
                  <c:v>6259.083984375</c:v>
                </c:pt>
                <c:pt idx="137">
                  <c:v>6317.5390625</c:v>
                </c:pt>
                <c:pt idx="138">
                  <c:v>6323.92724609375</c:v>
                </c:pt>
                <c:pt idx="139">
                  <c:v>6287.08837890625</c:v>
                </c:pt>
                <c:pt idx="140">
                  <c:v>6241.4208984375</c:v>
                </c:pt>
                <c:pt idx="141">
                  <c:v>6219.42626953125</c:v>
                </c:pt>
                <c:pt idx="142">
                  <c:v>6229.58251953125</c:v>
                </c:pt>
                <c:pt idx="143">
                  <c:v>6255.080078125</c:v>
                </c:pt>
                <c:pt idx="144">
                  <c:v>6271.5634765625</c:v>
                </c:pt>
                <c:pt idx="145">
                  <c:v>6267.64013671875</c:v>
                </c:pt>
                <c:pt idx="146">
                  <c:v>6251.57861328125</c:v>
                </c:pt>
                <c:pt idx="147">
                  <c:v>6240.521484375</c:v>
                </c:pt>
                <c:pt idx="148">
                  <c:v>6243.3193359375</c:v>
                </c:pt>
                <c:pt idx="149">
                  <c:v>6252.5537109375</c:v>
                </c:pt>
                <c:pt idx="150">
                  <c:v>6252.38232421875</c:v>
                </c:pt>
                <c:pt idx="151">
                  <c:v>6234.65234375</c:v>
                </c:pt>
                <c:pt idx="152">
                  <c:v>6208.50146484375</c:v>
                </c:pt>
                <c:pt idx="153">
                  <c:v>6194.396484375</c:v>
                </c:pt>
                <c:pt idx="154">
                  <c:v>6207.14453125</c:v>
                </c:pt>
                <c:pt idx="155">
                  <c:v>6242.20849609375</c:v>
                </c:pt>
                <c:pt idx="156">
                  <c:v>6277.33203125</c:v>
                </c:pt>
                <c:pt idx="157">
                  <c:v>6288.9365234375</c:v>
                </c:pt>
                <c:pt idx="158">
                  <c:v>6270.421875</c:v>
                </c:pt>
                <c:pt idx="159">
                  <c:v>6237.662109375</c:v>
                </c:pt>
                <c:pt idx="160">
                  <c:v>6217.146484375</c:v>
                </c:pt>
                <c:pt idx="161">
                  <c:v>6226.07080078125</c:v>
                </c:pt>
                <c:pt idx="162">
                  <c:v>6259.953125</c:v>
                </c:pt>
                <c:pt idx="163">
                  <c:v>6297.08251953125</c:v>
                </c:pt>
                <c:pt idx="164">
                  <c:v>6315.611328125</c:v>
                </c:pt>
                <c:pt idx="165">
                  <c:v>6309.341796875</c:v>
                </c:pt>
                <c:pt idx="166">
                  <c:v>6289.9697265625</c:v>
                </c:pt>
                <c:pt idx="167">
                  <c:v>6274.9501953125</c:v>
                </c:pt>
                <c:pt idx="168">
                  <c:v>6271.75341796875</c:v>
                </c:pt>
                <c:pt idx="169">
                  <c:v>6271.75146484375</c:v>
                </c:pt>
                <c:pt idx="170">
                  <c:v>6258.60498046875</c:v>
                </c:pt>
                <c:pt idx="171">
                  <c:v>6223.96044921875</c:v>
                </c:pt>
                <c:pt idx="172">
                  <c:v>6177.2861328125</c:v>
                </c:pt>
                <c:pt idx="173">
                  <c:v>6141.45849609375</c:v>
                </c:pt>
                <c:pt idx="174">
                  <c:v>6137.125</c:v>
                </c:pt>
                <c:pt idx="175">
                  <c:v>6167.6904296875</c:v>
                </c:pt>
                <c:pt idx="176">
                  <c:v>6216.2021484375</c:v>
                </c:pt>
                <c:pt idx="177">
                  <c:v>6256.248046875</c:v>
                </c:pt>
                <c:pt idx="178">
                  <c:v>6268.65966796875</c:v>
                </c:pt>
                <c:pt idx="179">
                  <c:v>6252.17578125</c:v>
                </c:pt>
                <c:pt idx="180">
                  <c:v>6221.54150390625</c:v>
                </c:pt>
                <c:pt idx="181">
                  <c:v>6196.0244140625</c:v>
                </c:pt>
                <c:pt idx="182">
                  <c:v>6187.58642578125</c:v>
                </c:pt>
                <c:pt idx="183">
                  <c:v>6196.66943359375</c:v>
                </c:pt>
                <c:pt idx="184">
                  <c:v>6216.638671875</c:v>
                </c:pt>
                <c:pt idx="185">
                  <c:v>6241.31298828125</c:v>
                </c:pt>
                <c:pt idx="186">
                  <c:v>6268.75927734375</c:v>
                </c:pt>
                <c:pt idx="187">
                  <c:v>6298.89208984375</c:v>
                </c:pt>
                <c:pt idx="188">
                  <c:v>6328.26611328125</c:v>
                </c:pt>
                <c:pt idx="189">
                  <c:v>6347.8876953125</c:v>
                </c:pt>
                <c:pt idx="190">
                  <c:v>6347.11328125</c:v>
                </c:pt>
                <c:pt idx="191">
                  <c:v>6321.31689453125</c:v>
                </c:pt>
                <c:pt idx="192">
                  <c:v>6277.38525390625</c:v>
                </c:pt>
                <c:pt idx="193">
                  <c:v>6232.1650390625</c:v>
                </c:pt>
                <c:pt idx="194">
                  <c:v>6203.8779296875</c:v>
                </c:pt>
                <c:pt idx="195">
                  <c:v>6201.66259765625</c:v>
                </c:pt>
                <c:pt idx="196">
                  <c:v>6220.076171875</c:v>
                </c:pt>
                <c:pt idx="197">
                  <c:v>6242.427734375</c:v>
                </c:pt>
                <c:pt idx="198">
                  <c:v>6251.1533203125</c:v>
                </c:pt>
                <c:pt idx="199">
                  <c:v>6238.83837890625</c:v>
                </c:pt>
                <c:pt idx="200">
                  <c:v>6212.85400390625</c:v>
                </c:pt>
                <c:pt idx="201">
                  <c:v>6190.486328125</c:v>
                </c:pt>
                <c:pt idx="202">
                  <c:v>6187.4775390625</c:v>
                </c:pt>
                <c:pt idx="203">
                  <c:v>6207.37060546875</c:v>
                </c:pt>
                <c:pt idx="204">
                  <c:v>6238.85546875</c:v>
                </c:pt>
                <c:pt idx="205">
                  <c:v>6263.294921875</c:v>
                </c:pt>
                <c:pt idx="206">
                  <c:v>6267.65771484375</c:v>
                </c:pt>
                <c:pt idx="207">
                  <c:v>6253.90185546875</c:v>
                </c:pt>
                <c:pt idx="208">
                  <c:v>6237.6962890625</c:v>
                </c:pt>
                <c:pt idx="209">
                  <c:v>6236.63037109375</c:v>
                </c:pt>
                <c:pt idx="210">
                  <c:v>6256.009765625</c:v>
                </c:pt>
                <c:pt idx="211">
                  <c:v>6283.01806640625</c:v>
                </c:pt>
                <c:pt idx="212">
                  <c:v>6294.73486328125</c:v>
                </c:pt>
                <c:pt idx="213">
                  <c:v>6275.30224609375</c:v>
                </c:pt>
                <c:pt idx="214">
                  <c:v>6229.78466796875</c:v>
                </c:pt>
                <c:pt idx="215">
                  <c:v>6183.4169921875</c:v>
                </c:pt>
                <c:pt idx="216">
                  <c:v>6165.10205078125</c:v>
                </c:pt>
                <c:pt idx="217">
                  <c:v>6186.2841796875</c:v>
                </c:pt>
                <c:pt idx="218">
                  <c:v>6231.1142578125</c:v>
                </c:pt>
                <c:pt idx="219">
                  <c:v>6266.576171875</c:v>
                </c:pt>
                <c:pt idx="220">
                  <c:v>6266.49072265625</c:v>
                </c:pt>
                <c:pt idx="221">
                  <c:v>6231.955078125</c:v>
                </c:pt>
                <c:pt idx="222">
                  <c:v>6192.20751953125</c:v>
                </c:pt>
                <c:pt idx="223">
                  <c:v>6183.90771484375</c:v>
                </c:pt>
                <c:pt idx="224">
                  <c:v>6223.39794921875</c:v>
                </c:pt>
                <c:pt idx="225">
                  <c:v>6292.73193359375</c:v>
                </c:pt>
                <c:pt idx="226">
                  <c:v>6350.6923828125</c:v>
                </c:pt>
                <c:pt idx="227">
                  <c:v>6361.3671875</c:v>
                </c:pt>
                <c:pt idx="228">
                  <c:v>6319.3291015625</c:v>
                </c:pt>
                <c:pt idx="229">
                  <c:v>6252.7685546875</c:v>
                </c:pt>
                <c:pt idx="230">
                  <c:v>6202.63623046875</c:v>
                </c:pt>
                <c:pt idx="231">
                  <c:v>6194.02392578125</c:v>
                </c:pt>
                <c:pt idx="232">
                  <c:v>6221.44384765625</c:v>
                </c:pt>
                <c:pt idx="233">
                  <c:v>6258.0390625</c:v>
                </c:pt>
                <c:pt idx="234">
                  <c:v>6279.544921875</c:v>
                </c:pt>
                <c:pt idx="235">
                  <c:v>6282.5419921875</c:v>
                </c:pt>
                <c:pt idx="236">
                  <c:v>6282.33056640625</c:v>
                </c:pt>
                <c:pt idx="237">
                  <c:v>6293.6318359375</c:v>
                </c:pt>
                <c:pt idx="238">
                  <c:v>6312.283203125</c:v>
                </c:pt>
                <c:pt idx="239">
                  <c:v>6315.33544921875</c:v>
                </c:pt>
                <c:pt idx="240">
                  <c:v>6280.87646484375</c:v>
                </c:pt>
                <c:pt idx="241">
                  <c:v>6210.962890625</c:v>
                </c:pt>
                <c:pt idx="242">
                  <c:v>6136.7802734375</c:v>
                </c:pt>
                <c:pt idx="243">
                  <c:v>6098.9755859375</c:v>
                </c:pt>
                <c:pt idx="244">
                  <c:v>6117.16455078125</c:v>
                </c:pt>
                <c:pt idx="245">
                  <c:v>6173.20947265625</c:v>
                </c:pt>
                <c:pt idx="246">
                  <c:v>6223.3203125</c:v>
                </c:pt>
                <c:pt idx="247">
                  <c:v>6231.173828125</c:v>
                </c:pt>
                <c:pt idx="248">
                  <c:v>6196.466796875</c:v>
                </c:pt>
                <c:pt idx="249">
                  <c:v>6155.681640625</c:v>
                </c:pt>
                <c:pt idx="250">
                  <c:v>6153.35205078125</c:v>
                </c:pt>
                <c:pt idx="251">
                  <c:v>6205.93115234375</c:v>
                </c:pt>
                <c:pt idx="252">
                  <c:v>6287.0615234375</c:v>
                </c:pt>
                <c:pt idx="253">
                  <c:v>6346.61767578125</c:v>
                </c:pt>
                <c:pt idx="254">
                  <c:v>6349.048828125</c:v>
                </c:pt>
                <c:pt idx="255">
                  <c:v>6300.8291015625</c:v>
                </c:pt>
                <c:pt idx="256">
                  <c:v>6245.09814453125</c:v>
                </c:pt>
                <c:pt idx="257">
                  <c:v>6227.58203125</c:v>
                </c:pt>
                <c:pt idx="258">
                  <c:v>6260.72802734375</c:v>
                </c:pt>
                <c:pt idx="259">
                  <c:v>6314.35791015625</c:v>
                </c:pt>
                <c:pt idx="260">
                  <c:v>6339.8740234375</c:v>
                </c:pt>
                <c:pt idx="261">
                  <c:v>6308.39990234375</c:v>
                </c:pt>
                <c:pt idx="262">
                  <c:v>6232.69189453125</c:v>
                </c:pt>
                <c:pt idx="263">
                  <c:v>6156.43896484375</c:v>
                </c:pt>
                <c:pt idx="264">
                  <c:v>6121.0810546875</c:v>
                </c:pt>
                <c:pt idx="265">
                  <c:v>6137.60498046875</c:v>
                </c:pt>
                <c:pt idx="266">
                  <c:v>6185.06103515625</c:v>
                </c:pt>
                <c:pt idx="267">
                  <c:v>6234.12109375</c:v>
                </c:pt>
                <c:pt idx="268">
                  <c:v>6273.02734375</c:v>
                </c:pt>
                <c:pt idx="269">
                  <c:v>6312.5048828125</c:v>
                </c:pt>
                <c:pt idx="270">
                  <c:v>6366.07470703125</c:v>
                </c:pt>
                <c:pt idx="271">
                  <c:v>6425.369140625</c:v>
                </c:pt>
                <c:pt idx="272">
                  <c:v>6455.91748046875</c:v>
                </c:pt>
                <c:pt idx="273">
                  <c:v>6421.52392578125</c:v>
                </c:pt>
                <c:pt idx="274">
                  <c:v>6318.96630859375</c:v>
                </c:pt>
                <c:pt idx="275">
                  <c:v>6192.25244140625</c:v>
                </c:pt>
                <c:pt idx="276">
                  <c:v>6109.36962890625</c:v>
                </c:pt>
                <c:pt idx="277">
                  <c:v>6114.7900390625</c:v>
                </c:pt>
                <c:pt idx="278">
                  <c:v>6193.44091796875</c:v>
                </c:pt>
                <c:pt idx="279">
                  <c:v>6276.6865234375</c:v>
                </c:pt>
                <c:pt idx="280">
                  <c:v>6290.03955078125</c:v>
                </c:pt>
                <c:pt idx="281">
                  <c:v>6209.08349609375</c:v>
                </c:pt>
                <c:pt idx="282">
                  <c:v>6081.130859375</c:v>
                </c:pt>
                <c:pt idx="283">
                  <c:v>5994.03955078125</c:v>
                </c:pt>
                <c:pt idx="284">
                  <c:v>6013.236328125</c:v>
                </c:pt>
                <c:pt idx="285">
                  <c:v>6133.01171875</c:v>
                </c:pt>
                <c:pt idx="286">
                  <c:v>6278.72802734375</c:v>
                </c:pt>
                <c:pt idx="287">
                  <c:v>6359.14306640625</c:v>
                </c:pt>
                <c:pt idx="288">
                  <c:v>6330.72705078125</c:v>
                </c:pt>
                <c:pt idx="289">
                  <c:v>6227.02783203125</c:v>
                </c:pt>
                <c:pt idx="290">
                  <c:v>6132.37890625</c:v>
                </c:pt>
                <c:pt idx="291">
                  <c:v>6120.51025390625</c:v>
                </c:pt>
                <c:pt idx="292">
                  <c:v>6203.646484375</c:v>
                </c:pt>
                <c:pt idx="293">
                  <c:v>6328.17724609375</c:v>
                </c:pt>
                <c:pt idx="294">
                  <c:v>6417.13427734375</c:v>
                </c:pt>
                <c:pt idx="295">
                  <c:v>6425.4541015625</c:v>
                </c:pt>
                <c:pt idx="296">
                  <c:v>6366.85693359375</c:v>
                </c:pt>
                <c:pt idx="297">
                  <c:v>6295.23193359375</c:v>
                </c:pt>
                <c:pt idx="298">
                  <c:v>6258.75390625</c:v>
                </c:pt>
                <c:pt idx="299">
                  <c:v>6264.16845703125</c:v>
                </c:pt>
                <c:pt idx="300">
                  <c:v>6278.01806640625</c:v>
                </c:pt>
                <c:pt idx="301">
                  <c:v>6260.91064453125</c:v>
                </c:pt>
                <c:pt idx="302">
                  <c:v>6205.0615234375</c:v>
                </c:pt>
                <c:pt idx="303">
                  <c:v>6144.1259765625</c:v>
                </c:pt>
                <c:pt idx="304">
                  <c:v>6127.5361328125</c:v>
                </c:pt>
                <c:pt idx="305">
                  <c:v>6180.1083984375</c:v>
                </c:pt>
                <c:pt idx="306">
                  <c:v>6279.10986328125</c:v>
                </c:pt>
                <c:pt idx="307">
                  <c:v>6367.0439453125</c:v>
                </c:pt>
                <c:pt idx="308">
                  <c:v>6390.75537109375</c:v>
                </c:pt>
                <c:pt idx="309">
                  <c:v>6337.74462890625</c:v>
                </c:pt>
                <c:pt idx="310">
                  <c:v>6243.40380859375</c:v>
                </c:pt>
                <c:pt idx="311">
                  <c:v>6165.1357421875</c:v>
                </c:pt>
                <c:pt idx="312">
                  <c:v>6143.39404296875</c:v>
                </c:pt>
                <c:pt idx="313">
                  <c:v>6177.67626953125</c:v>
                </c:pt>
                <c:pt idx="314">
                  <c:v>6232.6796875</c:v>
                </c:pt>
                <c:pt idx="315">
                  <c:v>6267.14111328125</c:v>
                </c:pt>
                <c:pt idx="316">
                  <c:v>6262.65673828125</c:v>
                </c:pt>
                <c:pt idx="317">
                  <c:v>6232.3798828125</c:v>
                </c:pt>
                <c:pt idx="318">
                  <c:v>6206.203125</c:v>
                </c:pt>
                <c:pt idx="319">
                  <c:v>6206.1962890625</c:v>
                </c:pt>
                <c:pt idx="320">
                  <c:v>6231.21875</c:v>
                </c:pt>
                <c:pt idx="321">
                  <c:v>6260.50390625</c:v>
                </c:pt>
                <c:pt idx="322">
                  <c:v>6271.04296875</c:v>
                </c:pt>
                <c:pt idx="323">
                  <c:v>6254.47216796875</c:v>
                </c:pt>
                <c:pt idx="324">
                  <c:v>6221.6298828125</c:v>
                </c:pt>
                <c:pt idx="325">
                  <c:v>6193.5029296875</c:v>
                </c:pt>
                <c:pt idx="326">
                  <c:v>6186.94970703125</c:v>
                </c:pt>
                <c:pt idx="327">
                  <c:v>6205.5693359375</c:v>
                </c:pt>
                <c:pt idx="328">
                  <c:v>6240.35009765625</c:v>
                </c:pt>
                <c:pt idx="329">
                  <c:v>6277.037109375</c:v>
                </c:pt>
                <c:pt idx="330">
                  <c:v>6303.607421875</c:v>
                </c:pt>
                <c:pt idx="331">
                  <c:v>6313.50048828125</c:v>
                </c:pt>
                <c:pt idx="332">
                  <c:v>6305.048828125</c:v>
                </c:pt>
                <c:pt idx="333">
                  <c:v>6280.3017578125</c:v>
                </c:pt>
                <c:pt idx="334">
                  <c:v>6245.1884765625</c:v>
                </c:pt>
                <c:pt idx="335">
                  <c:v>6209.8349609375</c:v>
                </c:pt>
                <c:pt idx="336">
                  <c:v>6186.41357421875</c:v>
                </c:pt>
                <c:pt idx="337">
                  <c:v>6183.83349609375</c:v>
                </c:pt>
                <c:pt idx="338">
                  <c:v>6202.11962890625</c:v>
                </c:pt>
                <c:pt idx="339">
                  <c:v>6230.95361328125</c:v>
                </c:pt>
                <c:pt idx="340">
                  <c:v>6254.638671875</c:v>
                </c:pt>
                <c:pt idx="341">
                  <c:v>6261.10693359375</c:v>
                </c:pt>
                <c:pt idx="342">
                  <c:v>6249.197265625</c:v>
                </c:pt>
                <c:pt idx="343">
                  <c:v>6229.1943359375</c:v>
                </c:pt>
                <c:pt idx="344">
                  <c:v>6216.1240234375</c:v>
                </c:pt>
                <c:pt idx="345">
                  <c:v>6220.2724609375</c:v>
                </c:pt>
                <c:pt idx="346">
                  <c:v>6241.1494140625</c:v>
                </c:pt>
                <c:pt idx="347">
                  <c:v>6268.49755859375</c:v>
                </c:pt>
                <c:pt idx="348">
                  <c:v>6289.072265625</c:v>
                </c:pt>
                <c:pt idx="349">
                  <c:v>6294.33837890625</c:v>
                </c:pt>
              </c:numCache>
            </c:numRef>
          </c:yVal>
          <c:smooth val="1"/>
          <c:extLst>
            <c:ext xmlns:c16="http://schemas.microsoft.com/office/drawing/2014/chart" uri="{C3380CC4-5D6E-409C-BE32-E72D297353CC}">
              <c16:uniqueId val="{00000011-0DDB-41B5-BE83-A9CFE49F3CE3}"/>
            </c:ext>
          </c:extLst>
        </c:ser>
        <c:ser>
          <c:idx val="18"/>
          <c:order val="18"/>
          <c:tx>
            <c:strRef>
              <c:f>hc_sub_007!$S$1</c:f>
              <c:strCache>
                <c:ptCount val="1"/>
                <c:pt idx="0">
                  <c:v>Coor_19</c:v>
                </c:pt>
              </c:strCache>
            </c:strRef>
          </c:tx>
          <c:spPr>
            <a:ln w="28575" cap="rnd">
              <a:solidFill>
                <a:schemeClr val="accent1">
                  <a:lumMod val="80000"/>
                </a:schemeClr>
              </a:solidFill>
              <a:round/>
            </a:ln>
            <a:effectLst/>
          </c:spPr>
          <c:marker>
            <c:symbol val="none"/>
          </c:marker>
          <c:yVal>
            <c:numRef>
              <c:f>hc_sub_007!$S$2:$S$351</c:f>
              <c:numCache>
                <c:formatCode>0.00000000000_ </c:formatCode>
                <c:ptCount val="350"/>
                <c:pt idx="0">
                  <c:v>5882.9814453125</c:v>
                </c:pt>
                <c:pt idx="1">
                  <c:v>5861.6689453125</c:v>
                </c:pt>
                <c:pt idx="2">
                  <c:v>5874.23974609375</c:v>
                </c:pt>
                <c:pt idx="3">
                  <c:v>5914.6904296875</c:v>
                </c:pt>
                <c:pt idx="4">
                  <c:v>5964.8544921875</c:v>
                </c:pt>
                <c:pt idx="5">
                  <c:v>6005.021484375</c:v>
                </c:pt>
                <c:pt idx="6">
                  <c:v>6024.20166015625</c:v>
                </c:pt>
                <c:pt idx="7">
                  <c:v>6024.76123046875</c:v>
                </c:pt>
                <c:pt idx="8">
                  <c:v>6019.5380859375</c:v>
                </c:pt>
                <c:pt idx="9">
                  <c:v>6023.10986328125</c:v>
                </c:pt>
                <c:pt idx="10">
                  <c:v>6041.58349609375</c:v>
                </c:pt>
                <c:pt idx="11">
                  <c:v>6066.6416015625</c:v>
                </c:pt>
                <c:pt idx="12">
                  <c:v>6078.54248046875</c:v>
                </c:pt>
                <c:pt idx="13">
                  <c:v>6058.39501953125</c:v>
                </c:pt>
                <c:pt idx="14">
                  <c:v>6003.50927734375</c:v>
                </c:pt>
                <c:pt idx="15">
                  <c:v>5935.130859375</c:v>
                </c:pt>
                <c:pt idx="16">
                  <c:v>5890.2939453125</c:v>
                </c:pt>
                <c:pt idx="17">
                  <c:v>5899.53955078125</c:v>
                </c:pt>
                <c:pt idx="18">
                  <c:v>5963.96142578125</c:v>
                </c:pt>
                <c:pt idx="19">
                  <c:v>6048.95361328125</c:v>
                </c:pt>
                <c:pt idx="20">
                  <c:v>6102.70849609375</c:v>
                </c:pt>
                <c:pt idx="21">
                  <c:v>6089.6982421875</c:v>
                </c:pt>
                <c:pt idx="22">
                  <c:v>6016.13330078125</c:v>
                </c:pt>
                <c:pt idx="23">
                  <c:v>5927.439453125</c:v>
                </c:pt>
                <c:pt idx="24">
                  <c:v>5877.17919921875</c:v>
                </c:pt>
                <c:pt idx="25">
                  <c:v>5888.86474609375</c:v>
                </c:pt>
                <c:pt idx="26">
                  <c:v>5939.25830078125</c:v>
                </c:pt>
                <c:pt idx="27">
                  <c:v>5976.76513671875</c:v>
                </c:pt>
                <c:pt idx="28">
                  <c:v>5961.767578125</c:v>
                </c:pt>
                <c:pt idx="29">
                  <c:v>5898.05126953125</c:v>
                </c:pt>
                <c:pt idx="30">
                  <c:v>5830.669921875</c:v>
                </c:pt>
                <c:pt idx="31">
                  <c:v>5811.6328125</c:v>
                </c:pt>
                <c:pt idx="32">
                  <c:v>5860.31982421875</c:v>
                </c:pt>
                <c:pt idx="33">
                  <c:v>5949.6640625</c:v>
                </c:pt>
                <c:pt idx="34">
                  <c:v>6028.29150390625</c:v>
                </c:pt>
                <c:pt idx="35">
                  <c:v>6059.76513671875</c:v>
                </c:pt>
                <c:pt idx="36">
                  <c:v>6046.87158203125</c:v>
                </c:pt>
                <c:pt idx="37">
                  <c:v>6022.32470703125</c:v>
                </c:pt>
                <c:pt idx="38">
                  <c:v>6015.9814453125</c:v>
                </c:pt>
                <c:pt idx="39">
                  <c:v>6028.2353515625</c:v>
                </c:pt>
                <c:pt idx="40">
                  <c:v>6032.966796875</c:v>
                </c:pt>
                <c:pt idx="41">
                  <c:v>6006.7705078125</c:v>
                </c:pt>
                <c:pt idx="42">
                  <c:v>5957.25146484375</c:v>
                </c:pt>
                <c:pt idx="43">
                  <c:v>5923.13525390625</c:v>
                </c:pt>
                <c:pt idx="44">
                  <c:v>5943.36328125</c:v>
                </c:pt>
                <c:pt idx="45">
                  <c:v>6020.4541015625</c:v>
                </c:pt>
                <c:pt idx="46">
                  <c:v>6110.572265625</c:v>
                </c:pt>
                <c:pt idx="47">
                  <c:v>6151.80712890625</c:v>
                </c:pt>
                <c:pt idx="48">
                  <c:v>6110.1640625</c:v>
                </c:pt>
                <c:pt idx="49">
                  <c:v>6006.76123046875</c:v>
                </c:pt>
                <c:pt idx="50">
                  <c:v>5903.7548828125</c:v>
                </c:pt>
                <c:pt idx="51">
                  <c:v>5859.482421875</c:v>
                </c:pt>
                <c:pt idx="52">
                  <c:v>5887.86962890625</c:v>
                </c:pt>
                <c:pt idx="53">
                  <c:v>5953.076171875</c:v>
                </c:pt>
                <c:pt idx="54">
                  <c:v>6001.30615234375</c:v>
                </c:pt>
                <c:pt idx="55">
                  <c:v>6002.20068359375</c:v>
                </c:pt>
                <c:pt idx="56">
                  <c:v>5966.60595703125</c:v>
                </c:pt>
                <c:pt idx="57">
                  <c:v>5929.3955078125</c:v>
                </c:pt>
                <c:pt idx="58">
                  <c:v>5915.80712890625</c:v>
                </c:pt>
                <c:pt idx="59">
                  <c:v>5921.9267578125</c:v>
                </c:pt>
                <c:pt idx="60">
                  <c:v>5924.93017578125</c:v>
                </c:pt>
                <c:pt idx="61">
                  <c:v>5910.93701171875</c:v>
                </c:pt>
                <c:pt idx="62">
                  <c:v>5892.7138671875</c:v>
                </c:pt>
                <c:pt idx="63">
                  <c:v>5899.6494140625</c:v>
                </c:pt>
                <c:pt idx="64">
                  <c:v>5948.69921875</c:v>
                </c:pt>
                <c:pt idx="65">
                  <c:v>6023.46142578125</c:v>
                </c:pt>
                <c:pt idx="66">
                  <c:v>6082.2578125</c:v>
                </c:pt>
                <c:pt idx="67">
                  <c:v>6090.3681640625</c:v>
                </c:pt>
                <c:pt idx="68">
                  <c:v>6049.2119140625</c:v>
                </c:pt>
                <c:pt idx="69">
                  <c:v>5996.48779296875</c:v>
                </c:pt>
                <c:pt idx="70">
                  <c:v>5975.65771484375</c:v>
                </c:pt>
                <c:pt idx="71">
                  <c:v>5999.81103515625</c:v>
                </c:pt>
                <c:pt idx="72">
                  <c:v>6040.5576171875</c:v>
                </c:pt>
                <c:pt idx="73">
                  <c:v>6051.89990234375</c:v>
                </c:pt>
                <c:pt idx="74">
                  <c:v>6009.50390625</c:v>
                </c:pt>
                <c:pt idx="75">
                  <c:v>5932.5869140625</c:v>
                </c:pt>
                <c:pt idx="76">
                  <c:v>5870.1025390625</c:v>
                </c:pt>
                <c:pt idx="77">
                  <c:v>5862.63916015625</c:v>
                </c:pt>
                <c:pt idx="78">
                  <c:v>5911.314453125</c:v>
                </c:pt>
                <c:pt idx="79">
                  <c:v>5978.4775390625</c:v>
                </c:pt>
                <c:pt idx="80">
                  <c:v>6018.25244140625</c:v>
                </c:pt>
                <c:pt idx="81">
                  <c:v>6010.91015625</c:v>
                </c:pt>
                <c:pt idx="82">
                  <c:v>5973.568359375</c:v>
                </c:pt>
                <c:pt idx="83">
                  <c:v>5941.02587890625</c:v>
                </c:pt>
                <c:pt idx="84">
                  <c:v>5935.5283203125</c:v>
                </c:pt>
                <c:pt idx="85">
                  <c:v>5951.751953125</c:v>
                </c:pt>
                <c:pt idx="86">
                  <c:v>5967.94091796875</c:v>
                </c:pt>
                <c:pt idx="87">
                  <c:v>5970.44677734375</c:v>
                </c:pt>
                <c:pt idx="88">
                  <c:v>5967.86669921875</c:v>
                </c:pt>
                <c:pt idx="89">
                  <c:v>5981.5986328125</c:v>
                </c:pt>
                <c:pt idx="90">
                  <c:v>6021.77978515625</c:v>
                </c:pt>
                <c:pt idx="91">
                  <c:v>6071.33984375</c:v>
                </c:pt>
                <c:pt idx="92">
                  <c:v>6094.26708984375</c:v>
                </c:pt>
                <c:pt idx="93">
                  <c:v>6063.15625</c:v>
                </c:pt>
                <c:pt idx="94">
                  <c:v>5983.9853515625</c:v>
                </c:pt>
                <c:pt idx="95">
                  <c:v>5897.37548828125</c:v>
                </c:pt>
                <c:pt idx="96">
                  <c:v>5853.98095703125</c:v>
                </c:pt>
                <c:pt idx="97">
                  <c:v>5881.6640625</c:v>
                </c:pt>
                <c:pt idx="98">
                  <c:v>5967.78271484375</c:v>
                </c:pt>
                <c:pt idx="99">
                  <c:v>6067.77490234375</c:v>
                </c:pt>
                <c:pt idx="100">
                  <c:v>6132.166015625</c:v>
                </c:pt>
                <c:pt idx="101">
                  <c:v>6133.02880859375</c:v>
                </c:pt>
                <c:pt idx="102">
                  <c:v>6074.6220703125</c:v>
                </c:pt>
                <c:pt idx="103">
                  <c:v>5985.8564453125</c:v>
                </c:pt>
                <c:pt idx="104">
                  <c:v>5903.16552734375</c:v>
                </c:pt>
                <c:pt idx="105">
                  <c:v>5854.431640625</c:v>
                </c:pt>
                <c:pt idx="106">
                  <c:v>5849.7978515625</c:v>
                </c:pt>
                <c:pt idx="107">
                  <c:v>5880.0439453125</c:v>
                </c:pt>
                <c:pt idx="108">
                  <c:v>5921.65087890625</c:v>
                </c:pt>
                <c:pt idx="109">
                  <c:v>5947.78857421875</c:v>
                </c:pt>
                <c:pt idx="110">
                  <c:v>5942.4658203125</c:v>
                </c:pt>
                <c:pt idx="111">
                  <c:v>5910.9931640625</c:v>
                </c:pt>
                <c:pt idx="112">
                  <c:v>5878.625</c:v>
                </c:pt>
                <c:pt idx="113">
                  <c:v>5875.0927734375</c:v>
                </c:pt>
                <c:pt idx="114">
                  <c:v>5913.486328125</c:v>
                </c:pt>
                <c:pt idx="115">
                  <c:v>5978.79052734375</c:v>
                </c:pt>
                <c:pt idx="116">
                  <c:v>6036.59423828125</c:v>
                </c:pt>
                <c:pt idx="117">
                  <c:v>6057.5390625</c:v>
                </c:pt>
                <c:pt idx="118">
                  <c:v>6039.453125</c:v>
                </c:pt>
                <c:pt idx="119">
                  <c:v>6009.078125</c:v>
                </c:pt>
                <c:pt idx="120">
                  <c:v>6000.712890625</c:v>
                </c:pt>
                <c:pt idx="121">
                  <c:v>6028.19677734375</c:v>
                </c:pt>
                <c:pt idx="122">
                  <c:v>6073.21630859375</c:v>
                </c:pt>
                <c:pt idx="123">
                  <c:v>6100.2490234375</c:v>
                </c:pt>
                <c:pt idx="124">
                  <c:v>6086.26513671875</c:v>
                </c:pt>
                <c:pt idx="125">
                  <c:v>6040.310546875</c:v>
                </c:pt>
                <c:pt idx="126">
                  <c:v>5995.9921875</c:v>
                </c:pt>
                <c:pt idx="127">
                  <c:v>5982.7626953125</c:v>
                </c:pt>
                <c:pt idx="128">
                  <c:v>6000.435546875</c:v>
                </c:pt>
                <c:pt idx="129">
                  <c:v>6019.2216796875</c:v>
                </c:pt>
                <c:pt idx="130">
                  <c:v>6005.96142578125</c:v>
                </c:pt>
                <c:pt idx="131">
                  <c:v>5954.31396484375</c:v>
                </c:pt>
                <c:pt idx="132">
                  <c:v>5892.5087890625</c:v>
                </c:pt>
                <c:pt idx="133">
                  <c:v>5861.02294921875</c:v>
                </c:pt>
                <c:pt idx="134">
                  <c:v>5878.544921875</c:v>
                </c:pt>
                <c:pt idx="135">
                  <c:v>5925.40234375</c:v>
                </c:pt>
                <c:pt idx="136">
                  <c:v>5959.37255859375</c:v>
                </c:pt>
                <c:pt idx="137">
                  <c:v>5951.2958984375</c:v>
                </c:pt>
                <c:pt idx="138">
                  <c:v>5910.53271484375</c:v>
                </c:pt>
                <c:pt idx="139">
                  <c:v>5878.28857421875</c:v>
                </c:pt>
                <c:pt idx="140">
                  <c:v>5893.69775390625</c:v>
                </c:pt>
                <c:pt idx="141">
                  <c:v>5960.60498046875</c:v>
                </c:pt>
                <c:pt idx="142">
                  <c:v>6042.61279296875</c:v>
                </c:pt>
                <c:pt idx="143">
                  <c:v>6090.4462890625</c:v>
                </c:pt>
                <c:pt idx="144">
                  <c:v>6079.0126953125</c:v>
                </c:pt>
                <c:pt idx="145">
                  <c:v>6024.1630859375</c:v>
                </c:pt>
                <c:pt idx="146">
                  <c:v>5966.88330078125</c:v>
                </c:pt>
                <c:pt idx="147">
                  <c:v>5939.91455078125</c:v>
                </c:pt>
                <c:pt idx="148">
                  <c:v>5945.29443359375</c:v>
                </c:pt>
                <c:pt idx="149">
                  <c:v>5960.181640625</c:v>
                </c:pt>
                <c:pt idx="150">
                  <c:v>5962.99462890625</c:v>
                </c:pt>
                <c:pt idx="151">
                  <c:v>5954.791015625</c:v>
                </c:pt>
                <c:pt idx="152">
                  <c:v>5956.43408203125</c:v>
                </c:pt>
                <c:pt idx="153">
                  <c:v>5984.87060546875</c:v>
                </c:pt>
                <c:pt idx="154">
                  <c:v>6031.2265625</c:v>
                </c:pt>
                <c:pt idx="155">
                  <c:v>6062.228515625</c:v>
                </c:pt>
                <c:pt idx="156">
                  <c:v>6045.8251953125</c:v>
                </c:pt>
                <c:pt idx="157">
                  <c:v>5979.92626953125</c:v>
                </c:pt>
                <c:pt idx="158">
                  <c:v>5899.283203125</c:v>
                </c:pt>
                <c:pt idx="159">
                  <c:v>5853.1455078125</c:v>
                </c:pt>
                <c:pt idx="160">
                  <c:v>5870.51708984375</c:v>
                </c:pt>
                <c:pt idx="161">
                  <c:v>5940.09228515625</c:v>
                </c:pt>
                <c:pt idx="162">
                  <c:v>6019.94677734375</c:v>
                </c:pt>
                <c:pt idx="163">
                  <c:v>6068.23583984375</c:v>
                </c:pt>
                <c:pt idx="164">
                  <c:v>6070.47802734375</c:v>
                </c:pt>
                <c:pt idx="165">
                  <c:v>6043.6640625</c:v>
                </c:pt>
                <c:pt idx="166">
                  <c:v>6017.27197265625</c:v>
                </c:pt>
                <c:pt idx="167">
                  <c:v>6009.005859375</c:v>
                </c:pt>
                <c:pt idx="168">
                  <c:v>6014.5888671875</c:v>
                </c:pt>
                <c:pt idx="169">
                  <c:v>6016.82177734375</c:v>
                </c:pt>
                <c:pt idx="170">
                  <c:v>6002.826171875</c:v>
                </c:pt>
                <c:pt idx="171">
                  <c:v>5973.76708984375</c:v>
                </c:pt>
                <c:pt idx="172">
                  <c:v>5940.70361328125</c:v>
                </c:pt>
                <c:pt idx="173">
                  <c:v>5913.47998046875</c:v>
                </c:pt>
                <c:pt idx="174">
                  <c:v>5894.4794921875</c:v>
                </c:pt>
                <c:pt idx="175">
                  <c:v>5882.15869140625</c:v>
                </c:pt>
                <c:pt idx="176">
                  <c:v>5878.47900390625</c:v>
                </c:pt>
                <c:pt idx="177">
                  <c:v>5890.53125</c:v>
                </c:pt>
                <c:pt idx="178">
                  <c:v>5923.31201171875</c:v>
                </c:pt>
                <c:pt idx="179">
                  <c:v>5970.783203125</c:v>
                </c:pt>
                <c:pt idx="180">
                  <c:v>6015.5478515625</c:v>
                </c:pt>
                <c:pt idx="181">
                  <c:v>6039.95654296875</c:v>
                </c:pt>
                <c:pt idx="182">
                  <c:v>6040.07275390625</c:v>
                </c:pt>
                <c:pt idx="183">
                  <c:v>6029.638671875</c:v>
                </c:pt>
                <c:pt idx="184">
                  <c:v>6028.853515625</c:v>
                </c:pt>
                <c:pt idx="185">
                  <c:v>6046.2119140625</c:v>
                </c:pt>
                <c:pt idx="186">
                  <c:v>6068.79736328125</c:v>
                </c:pt>
                <c:pt idx="187">
                  <c:v>6070.3828125</c:v>
                </c:pt>
                <c:pt idx="188">
                  <c:v>6032.0390625</c:v>
                </c:pt>
                <c:pt idx="189">
                  <c:v>5959.0810546875</c:v>
                </c:pt>
                <c:pt idx="190">
                  <c:v>5880.57177734375</c:v>
                </c:pt>
                <c:pt idx="191">
                  <c:v>5831.36083984375</c:v>
                </c:pt>
                <c:pt idx="192">
                  <c:v>5830.33935546875</c:v>
                </c:pt>
                <c:pt idx="193">
                  <c:v>5870.94921875</c:v>
                </c:pt>
                <c:pt idx="194">
                  <c:v>5929.5048828125</c:v>
                </c:pt>
                <c:pt idx="195">
                  <c:v>5982.8349609375</c:v>
                </c:pt>
                <c:pt idx="196">
                  <c:v>6020.77392578125</c:v>
                </c:pt>
                <c:pt idx="197">
                  <c:v>6045.34326171875</c:v>
                </c:pt>
                <c:pt idx="198">
                  <c:v>6060.623046875</c:v>
                </c:pt>
                <c:pt idx="199">
                  <c:v>6064.5556640625</c:v>
                </c:pt>
                <c:pt idx="200">
                  <c:v>6050.54541015625</c:v>
                </c:pt>
                <c:pt idx="201">
                  <c:v>6016.59326171875</c:v>
                </c:pt>
                <c:pt idx="202">
                  <c:v>5972.384765625</c:v>
                </c:pt>
                <c:pt idx="203">
                  <c:v>5936.5263671875</c:v>
                </c:pt>
                <c:pt idx="204">
                  <c:v>5925.0087890625</c:v>
                </c:pt>
                <c:pt idx="205">
                  <c:v>5939.86181640625</c:v>
                </c:pt>
                <c:pt idx="206">
                  <c:v>5967.0947265625</c:v>
                </c:pt>
                <c:pt idx="207">
                  <c:v>5985.67431640625</c:v>
                </c:pt>
                <c:pt idx="208">
                  <c:v>5980.94970703125</c:v>
                </c:pt>
                <c:pt idx="209">
                  <c:v>5953.26416015625</c:v>
                </c:pt>
                <c:pt idx="210">
                  <c:v>5916.80615234375</c:v>
                </c:pt>
                <c:pt idx="211">
                  <c:v>5890.78662109375</c:v>
                </c:pt>
                <c:pt idx="212">
                  <c:v>5889.16650390625</c:v>
                </c:pt>
                <c:pt idx="213">
                  <c:v>5914.3798828125</c:v>
                </c:pt>
                <c:pt idx="214">
                  <c:v>5956.97265625</c:v>
                </c:pt>
                <c:pt idx="215">
                  <c:v>6000.158203125</c:v>
                </c:pt>
                <c:pt idx="216">
                  <c:v>6027.232421875</c:v>
                </c:pt>
                <c:pt idx="217">
                  <c:v>6029.4345703125</c:v>
                </c:pt>
                <c:pt idx="218">
                  <c:v>6011.05859375</c:v>
                </c:pt>
                <c:pt idx="219">
                  <c:v>5988.3583984375</c:v>
                </c:pt>
                <c:pt idx="220">
                  <c:v>5981.080078125</c:v>
                </c:pt>
                <c:pt idx="221">
                  <c:v>6000.29541015625</c:v>
                </c:pt>
                <c:pt idx="222">
                  <c:v>6040.26953125</c:v>
                </c:pt>
                <c:pt idx="223">
                  <c:v>6081.0068359375</c:v>
                </c:pt>
                <c:pt idx="224">
                  <c:v>6101.08447265625</c:v>
                </c:pt>
                <c:pt idx="225">
                  <c:v>6092.11669921875</c:v>
                </c:pt>
                <c:pt idx="226">
                  <c:v>6063.80712890625</c:v>
                </c:pt>
                <c:pt idx="227">
                  <c:v>6035.12890625</c:v>
                </c:pt>
                <c:pt idx="228">
                  <c:v>6018.2705078125</c:v>
                </c:pt>
                <c:pt idx="229">
                  <c:v>6008.4560546875</c:v>
                </c:pt>
                <c:pt idx="230">
                  <c:v>5988.5078125</c:v>
                </c:pt>
                <c:pt idx="231">
                  <c:v>5944.890625</c:v>
                </c:pt>
                <c:pt idx="232">
                  <c:v>5881.953125</c:v>
                </c:pt>
                <c:pt idx="233">
                  <c:v>5821.9912109375</c:v>
                </c:pt>
                <c:pt idx="234">
                  <c:v>5790.35498046875</c:v>
                </c:pt>
                <c:pt idx="235">
                  <c:v>5797.45654296875</c:v>
                </c:pt>
                <c:pt idx="236">
                  <c:v>5832.32861328125</c:v>
                </c:pt>
                <c:pt idx="237">
                  <c:v>5872.693359375</c:v>
                </c:pt>
                <c:pt idx="238">
                  <c:v>5902.6279296875</c:v>
                </c:pt>
                <c:pt idx="239">
                  <c:v>5922.8701171875</c:v>
                </c:pt>
                <c:pt idx="240">
                  <c:v>5945.81982421875</c:v>
                </c:pt>
                <c:pt idx="241">
                  <c:v>5980.9775390625</c:v>
                </c:pt>
                <c:pt idx="242">
                  <c:v>6024.63720703125</c:v>
                </c:pt>
                <c:pt idx="243">
                  <c:v>6062.94677734375</c:v>
                </c:pt>
                <c:pt idx="244">
                  <c:v>6084.51806640625</c:v>
                </c:pt>
                <c:pt idx="245">
                  <c:v>6089.712890625</c:v>
                </c:pt>
                <c:pt idx="246">
                  <c:v>6087.220703125</c:v>
                </c:pt>
                <c:pt idx="247">
                  <c:v>6081.4052734375</c:v>
                </c:pt>
                <c:pt idx="248">
                  <c:v>6063.9404296875</c:v>
                </c:pt>
                <c:pt idx="249">
                  <c:v>6020.3173828125</c:v>
                </c:pt>
                <c:pt idx="250">
                  <c:v>5947.68017578125</c:v>
                </c:pt>
                <c:pt idx="251">
                  <c:v>5867.84423828125</c:v>
                </c:pt>
                <c:pt idx="252">
                  <c:v>5820.72607421875</c:v>
                </c:pt>
                <c:pt idx="253">
                  <c:v>5839.14599609375</c:v>
                </c:pt>
                <c:pt idx="254">
                  <c:v>5923.07568359375</c:v>
                </c:pt>
                <c:pt idx="255">
                  <c:v>6034.53173828125</c:v>
                </c:pt>
                <c:pt idx="256">
                  <c:v>6119.3837890625</c:v>
                </c:pt>
                <c:pt idx="257">
                  <c:v>6141.10791015625</c:v>
                </c:pt>
                <c:pt idx="258">
                  <c:v>6101.63671875</c:v>
                </c:pt>
                <c:pt idx="259">
                  <c:v>6034.6630859375</c:v>
                </c:pt>
                <c:pt idx="260">
                  <c:v>5978.52490234375</c:v>
                </c:pt>
                <c:pt idx="261">
                  <c:v>5951.02294921875</c:v>
                </c:pt>
                <c:pt idx="262">
                  <c:v>5944.67578125</c:v>
                </c:pt>
                <c:pt idx="263">
                  <c:v>5942.259765625</c:v>
                </c:pt>
                <c:pt idx="264">
                  <c:v>5935.755859375</c:v>
                </c:pt>
                <c:pt idx="265">
                  <c:v>5931.39208984375</c:v>
                </c:pt>
                <c:pt idx="266">
                  <c:v>5938.60693359375</c:v>
                </c:pt>
                <c:pt idx="267">
                  <c:v>5956.51904296875</c:v>
                </c:pt>
                <c:pt idx="268">
                  <c:v>5973.05908203125</c:v>
                </c:pt>
                <c:pt idx="269">
                  <c:v>5978.017578125</c:v>
                </c:pt>
                <c:pt idx="270">
                  <c:v>5975.88916015625</c:v>
                </c:pt>
                <c:pt idx="271">
                  <c:v>5983.09912109375</c:v>
                </c:pt>
                <c:pt idx="272">
                  <c:v>6009.46923828125</c:v>
                </c:pt>
                <c:pt idx="273">
                  <c:v>6041.376953125</c:v>
                </c:pt>
                <c:pt idx="274">
                  <c:v>6046.12890625</c:v>
                </c:pt>
                <c:pt idx="275">
                  <c:v>5999.15087890625</c:v>
                </c:pt>
                <c:pt idx="276">
                  <c:v>5912.5322265625</c:v>
                </c:pt>
                <c:pt idx="277">
                  <c:v>5837.12158203125</c:v>
                </c:pt>
                <c:pt idx="278">
                  <c:v>5829.56591796875</c:v>
                </c:pt>
                <c:pt idx="279">
                  <c:v>5906.4287109375</c:v>
                </c:pt>
                <c:pt idx="280">
                  <c:v>6023.06591796875</c:v>
                </c:pt>
                <c:pt idx="281">
                  <c:v>6099.31591796875</c:v>
                </c:pt>
                <c:pt idx="282">
                  <c:v>6077.1005859375</c:v>
                </c:pt>
                <c:pt idx="283">
                  <c:v>5966.6279296875</c:v>
                </c:pt>
                <c:pt idx="284">
                  <c:v>5843.1572265625</c:v>
                </c:pt>
                <c:pt idx="285">
                  <c:v>5793.560546875</c:v>
                </c:pt>
                <c:pt idx="286">
                  <c:v>5852.2060546875</c:v>
                </c:pt>
                <c:pt idx="287">
                  <c:v>5975.83740234375</c:v>
                </c:pt>
                <c:pt idx="288">
                  <c:v>6077.39990234375</c:v>
                </c:pt>
                <c:pt idx="289">
                  <c:v>6092.33740234375</c:v>
                </c:pt>
                <c:pt idx="290">
                  <c:v>6025.1943359375</c:v>
                </c:pt>
                <c:pt idx="291">
                  <c:v>5940.61865234375</c:v>
                </c:pt>
                <c:pt idx="292">
                  <c:v>5907.92138671875</c:v>
                </c:pt>
                <c:pt idx="293">
                  <c:v>5945.42236328125</c:v>
                </c:pt>
                <c:pt idx="294">
                  <c:v>6009.671875</c:v>
                </c:pt>
                <c:pt idx="295">
                  <c:v>6036.68994140625</c:v>
                </c:pt>
                <c:pt idx="296">
                  <c:v>5999.33251953125</c:v>
                </c:pt>
                <c:pt idx="297">
                  <c:v>5932.2978515625</c:v>
                </c:pt>
                <c:pt idx="298">
                  <c:v>5903.955078125</c:v>
                </c:pt>
                <c:pt idx="299">
                  <c:v>5958.6357421875</c:v>
                </c:pt>
                <c:pt idx="300">
                  <c:v>6077.23095703125</c:v>
                </c:pt>
                <c:pt idx="301">
                  <c:v>6188.48388671875</c:v>
                </c:pt>
                <c:pt idx="302">
                  <c:v>6221.7568359375</c:v>
                </c:pt>
                <c:pt idx="303">
                  <c:v>6158.9892578125</c:v>
                </c:pt>
                <c:pt idx="304">
                  <c:v>6045.498046875</c:v>
                </c:pt>
                <c:pt idx="305">
                  <c:v>5953.2900390625</c:v>
                </c:pt>
                <c:pt idx="306">
                  <c:v>5927.7705078125</c:v>
                </c:pt>
                <c:pt idx="307">
                  <c:v>5959.291015625</c:v>
                </c:pt>
                <c:pt idx="308">
                  <c:v>5998.314453125</c:v>
                </c:pt>
                <c:pt idx="309">
                  <c:v>5997.7109375</c:v>
                </c:pt>
                <c:pt idx="310">
                  <c:v>5946.95263671875</c:v>
                </c:pt>
                <c:pt idx="311">
                  <c:v>5873.93896484375</c:v>
                </c:pt>
                <c:pt idx="312">
                  <c:v>5818.6640625</c:v>
                </c:pt>
                <c:pt idx="313">
                  <c:v>5803.89599609375</c:v>
                </c:pt>
                <c:pt idx="314">
                  <c:v>5825.49609375</c:v>
                </c:pt>
                <c:pt idx="315">
                  <c:v>5864.5693359375</c:v>
                </c:pt>
                <c:pt idx="316">
                  <c:v>5905.3310546875</c:v>
                </c:pt>
                <c:pt idx="317">
                  <c:v>5941.9091796875</c:v>
                </c:pt>
                <c:pt idx="318">
                  <c:v>5972.0439453125</c:v>
                </c:pt>
                <c:pt idx="319">
                  <c:v>5989.71484375</c:v>
                </c:pt>
                <c:pt idx="320">
                  <c:v>5988.18310546875</c:v>
                </c:pt>
                <c:pt idx="321">
                  <c:v>5971.27490234375</c:v>
                </c:pt>
                <c:pt idx="322">
                  <c:v>5958.787109375</c:v>
                </c:pt>
                <c:pt idx="323">
                  <c:v>5975.0244140625</c:v>
                </c:pt>
                <c:pt idx="324">
                  <c:v>6026.1162109375</c:v>
                </c:pt>
                <c:pt idx="325">
                  <c:v>6086.15771484375</c:v>
                </c:pt>
                <c:pt idx="326">
                  <c:v>6109.04931640625</c:v>
                </c:pt>
                <c:pt idx="327">
                  <c:v>6062.2529296875</c:v>
                </c:pt>
                <c:pt idx="328">
                  <c:v>5957.572265625</c:v>
                </c:pt>
                <c:pt idx="329">
                  <c:v>5852.01171875</c:v>
                </c:pt>
                <c:pt idx="330">
                  <c:v>5813.1123046875</c:v>
                </c:pt>
                <c:pt idx="331">
                  <c:v>5871.84326171875</c:v>
                </c:pt>
                <c:pt idx="332">
                  <c:v>5998.396484375</c:v>
                </c:pt>
                <c:pt idx="333">
                  <c:v>6120.60107421875</c:v>
                </c:pt>
                <c:pt idx="334">
                  <c:v>6172.53564453125</c:v>
                </c:pt>
                <c:pt idx="335">
                  <c:v>6137.65478515625</c:v>
                </c:pt>
                <c:pt idx="336">
                  <c:v>6055.06494140625</c:v>
                </c:pt>
                <c:pt idx="337">
                  <c:v>5986.16015625</c:v>
                </c:pt>
                <c:pt idx="338">
                  <c:v>5968.75</c:v>
                </c:pt>
                <c:pt idx="339">
                  <c:v>5993.650390625</c:v>
                </c:pt>
                <c:pt idx="340">
                  <c:v>6019.1708984375</c:v>
                </c:pt>
                <c:pt idx="341">
                  <c:v>6008.7021484375</c:v>
                </c:pt>
                <c:pt idx="342">
                  <c:v>5960.06396484375</c:v>
                </c:pt>
                <c:pt idx="343">
                  <c:v>5904.48046875</c:v>
                </c:pt>
                <c:pt idx="344">
                  <c:v>5878.931640625</c:v>
                </c:pt>
                <c:pt idx="345">
                  <c:v>5896.32763671875</c:v>
                </c:pt>
                <c:pt idx="346">
                  <c:v>5937.4375</c:v>
                </c:pt>
                <c:pt idx="347">
                  <c:v>5968.9375</c:v>
                </c:pt>
                <c:pt idx="348">
                  <c:v>5970.68994140625</c:v>
                </c:pt>
                <c:pt idx="349">
                  <c:v>5949.62109375</c:v>
                </c:pt>
              </c:numCache>
            </c:numRef>
          </c:yVal>
          <c:smooth val="1"/>
          <c:extLst>
            <c:ext xmlns:c16="http://schemas.microsoft.com/office/drawing/2014/chart" uri="{C3380CC4-5D6E-409C-BE32-E72D297353CC}">
              <c16:uniqueId val="{00000012-0DDB-41B5-BE83-A9CFE49F3CE3}"/>
            </c:ext>
          </c:extLst>
        </c:ser>
        <c:ser>
          <c:idx val="19"/>
          <c:order val="19"/>
          <c:tx>
            <c:strRef>
              <c:f>hc_sub_007!$T$1</c:f>
              <c:strCache>
                <c:ptCount val="1"/>
                <c:pt idx="0">
                  <c:v>Coor_20</c:v>
                </c:pt>
              </c:strCache>
            </c:strRef>
          </c:tx>
          <c:spPr>
            <a:ln w="28575" cap="rnd">
              <a:solidFill>
                <a:schemeClr val="accent2">
                  <a:lumMod val="80000"/>
                </a:schemeClr>
              </a:solidFill>
              <a:round/>
            </a:ln>
            <a:effectLst/>
          </c:spPr>
          <c:marker>
            <c:symbol val="none"/>
          </c:marker>
          <c:yVal>
            <c:numRef>
              <c:f>hc_sub_007!$T$2:$T$351</c:f>
              <c:numCache>
                <c:formatCode>0.00000000000_ </c:formatCode>
                <c:ptCount val="350"/>
                <c:pt idx="0">
                  <c:v>7158.40576171875</c:v>
                </c:pt>
                <c:pt idx="1">
                  <c:v>7150.587890625</c:v>
                </c:pt>
                <c:pt idx="2">
                  <c:v>7168.00341796875</c:v>
                </c:pt>
                <c:pt idx="3">
                  <c:v>7197.4912109375</c:v>
                </c:pt>
                <c:pt idx="4">
                  <c:v>7218.083984375</c:v>
                </c:pt>
                <c:pt idx="5">
                  <c:v>7215.876953125</c:v>
                </c:pt>
                <c:pt idx="6">
                  <c:v>7193.71728515625</c:v>
                </c:pt>
                <c:pt idx="7">
                  <c:v>7168.9345703125</c:v>
                </c:pt>
                <c:pt idx="8">
                  <c:v>7161.10546875</c:v>
                </c:pt>
                <c:pt idx="9">
                  <c:v>7178.72119140625</c:v>
                </c:pt>
                <c:pt idx="10">
                  <c:v>7213.94775390625</c:v>
                </c:pt>
                <c:pt idx="11">
                  <c:v>7248.63525390625</c:v>
                </c:pt>
                <c:pt idx="12">
                  <c:v>7266.9462890625</c:v>
                </c:pt>
                <c:pt idx="13">
                  <c:v>7265.7236328125</c:v>
                </c:pt>
                <c:pt idx="14">
                  <c:v>7255.59521484375</c:v>
                </c:pt>
                <c:pt idx="15">
                  <c:v>7252.2177734375</c:v>
                </c:pt>
                <c:pt idx="16">
                  <c:v>7263.7802734375</c:v>
                </c:pt>
                <c:pt idx="17">
                  <c:v>7283.61572265625</c:v>
                </c:pt>
                <c:pt idx="18">
                  <c:v>7293.69970703125</c:v>
                </c:pt>
                <c:pt idx="19">
                  <c:v>7277.57666015625</c:v>
                </c:pt>
                <c:pt idx="20">
                  <c:v>7234.35546875</c:v>
                </c:pt>
                <c:pt idx="21">
                  <c:v>7183.4580078125</c:v>
                </c:pt>
                <c:pt idx="22">
                  <c:v>7154.97998046875</c:v>
                </c:pt>
                <c:pt idx="23">
                  <c:v>7170.1884765625</c:v>
                </c:pt>
                <c:pt idx="24">
                  <c:v>7224.66162109375</c:v>
                </c:pt>
                <c:pt idx="25">
                  <c:v>7286.6953125</c:v>
                </c:pt>
                <c:pt idx="26">
                  <c:v>7314.5107421875</c:v>
                </c:pt>
                <c:pt idx="27">
                  <c:v>7282.771484375</c:v>
                </c:pt>
                <c:pt idx="28">
                  <c:v>7201.080078125</c:v>
                </c:pt>
                <c:pt idx="29">
                  <c:v>7110.91845703125</c:v>
                </c:pt>
                <c:pt idx="30">
                  <c:v>7061.3857421875</c:v>
                </c:pt>
                <c:pt idx="31">
                  <c:v>7078.83056640625</c:v>
                </c:pt>
                <c:pt idx="32">
                  <c:v>7150.3740234375</c:v>
                </c:pt>
                <c:pt idx="33">
                  <c:v>7232.30126953125</c:v>
                </c:pt>
                <c:pt idx="34">
                  <c:v>7277.53173828125</c:v>
                </c:pt>
                <c:pt idx="35">
                  <c:v>7263.697265625</c:v>
                </c:pt>
                <c:pt idx="36">
                  <c:v>7203.85546875</c:v>
                </c:pt>
                <c:pt idx="37">
                  <c:v>7134.61328125</c:v>
                </c:pt>
                <c:pt idx="38">
                  <c:v>7091.77685546875</c:v>
                </c:pt>
                <c:pt idx="39">
                  <c:v>7090.51611328125</c:v>
                </c:pt>
                <c:pt idx="40">
                  <c:v>7121.51611328125</c:v>
                </c:pt>
                <c:pt idx="41">
                  <c:v>7162.189453125</c:v>
                </c:pt>
                <c:pt idx="42">
                  <c:v>7192.58642578125</c:v>
                </c:pt>
                <c:pt idx="43">
                  <c:v>7205.2685546875</c:v>
                </c:pt>
                <c:pt idx="44">
                  <c:v>7205.3603515625</c:v>
                </c:pt>
                <c:pt idx="45">
                  <c:v>7204.3671875</c:v>
                </c:pt>
                <c:pt idx="46">
                  <c:v>7213.52490234375</c:v>
                </c:pt>
                <c:pt idx="47">
                  <c:v>7239.58447265625</c:v>
                </c:pt>
                <c:pt idx="48">
                  <c:v>7282.5048828125</c:v>
                </c:pt>
                <c:pt idx="49">
                  <c:v>7334.16552734375</c:v>
                </c:pt>
                <c:pt idx="50">
                  <c:v>7379.3095703125</c:v>
                </c:pt>
                <c:pt idx="51">
                  <c:v>7400.673828125</c:v>
                </c:pt>
                <c:pt idx="52">
                  <c:v>7387.47998046875</c:v>
                </c:pt>
                <c:pt idx="53">
                  <c:v>7342.3251953125</c:v>
                </c:pt>
                <c:pt idx="54">
                  <c:v>7280.7978515625</c:v>
                </c:pt>
                <c:pt idx="55">
                  <c:v>7222.89990234375</c:v>
                </c:pt>
                <c:pt idx="56">
                  <c:v>7182.162109375</c:v>
                </c:pt>
                <c:pt idx="57">
                  <c:v>7160.81982421875</c:v>
                </c:pt>
                <c:pt idx="58">
                  <c:v>7154.3828125</c:v>
                </c:pt>
                <c:pt idx="59">
                  <c:v>7160.34521484375</c:v>
                </c:pt>
                <c:pt idx="60">
                  <c:v>7181.59130859375</c:v>
                </c:pt>
                <c:pt idx="61">
                  <c:v>7220.02099609375</c:v>
                </c:pt>
                <c:pt idx="62">
                  <c:v>7266.2470703125</c:v>
                </c:pt>
                <c:pt idx="63">
                  <c:v>7297.14501953125</c:v>
                </c:pt>
                <c:pt idx="64">
                  <c:v>7287.7490234375</c:v>
                </c:pt>
                <c:pt idx="65">
                  <c:v>7230.74755859375</c:v>
                </c:pt>
                <c:pt idx="66">
                  <c:v>7147.3154296875</c:v>
                </c:pt>
                <c:pt idx="67">
                  <c:v>7077.22216796875</c:v>
                </c:pt>
                <c:pt idx="68">
                  <c:v>7052.5703125</c:v>
                </c:pt>
                <c:pt idx="69">
                  <c:v>7074.787109375</c:v>
                </c:pt>
                <c:pt idx="70">
                  <c:v>7114.4306640625</c:v>
                </c:pt>
                <c:pt idx="71">
                  <c:v>7135.91845703125</c:v>
                </c:pt>
                <c:pt idx="72">
                  <c:v>7127.92138671875</c:v>
                </c:pt>
                <c:pt idx="73">
                  <c:v>7113.56005859375</c:v>
                </c:pt>
                <c:pt idx="74">
                  <c:v>7129.98193359375</c:v>
                </c:pt>
                <c:pt idx="75">
                  <c:v>7192.98095703125</c:v>
                </c:pt>
                <c:pt idx="76">
                  <c:v>7276.91259765625</c:v>
                </c:pt>
                <c:pt idx="77">
                  <c:v>7329.50390625</c:v>
                </c:pt>
                <c:pt idx="78">
                  <c:v>7312.4111328125</c:v>
                </c:pt>
                <c:pt idx="79">
                  <c:v>7235.1669921875</c:v>
                </c:pt>
                <c:pt idx="80">
                  <c:v>7153.015625</c:v>
                </c:pt>
                <c:pt idx="81">
                  <c:v>7127.43310546875</c:v>
                </c:pt>
                <c:pt idx="82">
                  <c:v>7179.28369140625</c:v>
                </c:pt>
                <c:pt idx="83">
                  <c:v>7272.27099609375</c:v>
                </c:pt>
                <c:pt idx="84">
                  <c:v>7340.98095703125</c:v>
                </c:pt>
                <c:pt idx="85">
                  <c:v>7341.74560546875</c:v>
                </c:pt>
                <c:pt idx="86">
                  <c:v>7285.57763671875</c:v>
                </c:pt>
                <c:pt idx="87">
                  <c:v>7226.751953125</c:v>
                </c:pt>
                <c:pt idx="88">
                  <c:v>7216.8125</c:v>
                </c:pt>
                <c:pt idx="89">
                  <c:v>7261.9970703125</c:v>
                </c:pt>
                <c:pt idx="90">
                  <c:v>7318.8173828125</c:v>
                </c:pt>
                <c:pt idx="91">
                  <c:v>7330.65869140625</c:v>
                </c:pt>
                <c:pt idx="92">
                  <c:v>7274.525390625</c:v>
                </c:pt>
                <c:pt idx="93">
                  <c:v>7179.578125</c:v>
                </c:pt>
                <c:pt idx="94">
                  <c:v>7103.47265625</c:v>
                </c:pt>
                <c:pt idx="95">
                  <c:v>7087.61767578125</c:v>
                </c:pt>
                <c:pt idx="96">
                  <c:v>7128.5703125</c:v>
                </c:pt>
                <c:pt idx="97">
                  <c:v>7187.1923828125</c:v>
                </c:pt>
                <c:pt idx="98">
                  <c:v>7224.43310546875</c:v>
                </c:pt>
                <c:pt idx="99">
                  <c:v>7231.3115234375</c:v>
                </c:pt>
                <c:pt idx="100">
                  <c:v>7228.50146484375</c:v>
                </c:pt>
                <c:pt idx="101">
                  <c:v>7239.53271484375</c:v>
                </c:pt>
                <c:pt idx="102">
                  <c:v>7264.8623046875</c:v>
                </c:pt>
                <c:pt idx="103">
                  <c:v>7281.46923828125</c:v>
                </c:pt>
                <c:pt idx="104">
                  <c:v>7267.4921875</c:v>
                </c:pt>
                <c:pt idx="105">
                  <c:v>7227.3046875</c:v>
                </c:pt>
                <c:pt idx="106">
                  <c:v>7191.66259765625</c:v>
                </c:pt>
                <c:pt idx="107">
                  <c:v>7190.89892578125</c:v>
                </c:pt>
                <c:pt idx="108">
                  <c:v>7225.14990234375</c:v>
                </c:pt>
                <c:pt idx="109">
                  <c:v>7260.0048828125</c:v>
                </c:pt>
                <c:pt idx="110">
                  <c:v>7253.98828125</c:v>
                </c:pt>
                <c:pt idx="111">
                  <c:v>7195.23876953125</c:v>
                </c:pt>
                <c:pt idx="112">
                  <c:v>7115.03271484375</c:v>
                </c:pt>
                <c:pt idx="113">
                  <c:v>7064.9677734375</c:v>
                </c:pt>
                <c:pt idx="114">
                  <c:v>7076.306640625</c:v>
                </c:pt>
                <c:pt idx="115">
                  <c:v>7136.0615234375</c:v>
                </c:pt>
                <c:pt idx="116">
                  <c:v>7200.12548828125</c:v>
                </c:pt>
                <c:pt idx="117">
                  <c:v>7231.3447265625</c:v>
                </c:pt>
                <c:pt idx="118">
                  <c:v>7228.52880859375</c:v>
                </c:pt>
                <c:pt idx="119">
                  <c:v>7220.8896484375</c:v>
                </c:pt>
                <c:pt idx="120">
                  <c:v>7233.99072265625</c:v>
                </c:pt>
                <c:pt idx="121">
                  <c:v>7259.857421875</c:v>
                </c:pt>
                <c:pt idx="122">
                  <c:v>7260.97119140625</c:v>
                </c:pt>
                <c:pt idx="123">
                  <c:v>7207.17626953125</c:v>
                </c:pt>
                <c:pt idx="124">
                  <c:v>7112.93310546875</c:v>
                </c:pt>
                <c:pt idx="125">
                  <c:v>7038.74560546875</c:v>
                </c:pt>
                <c:pt idx="126">
                  <c:v>7049.83251953125</c:v>
                </c:pt>
                <c:pt idx="127">
                  <c:v>7162.91064453125</c:v>
                </c:pt>
                <c:pt idx="128">
                  <c:v>7325.30419921875</c:v>
                </c:pt>
                <c:pt idx="129">
                  <c:v>7446.521484375</c:v>
                </c:pt>
                <c:pt idx="130">
                  <c:v>7460.138671875</c:v>
                </c:pt>
                <c:pt idx="131">
                  <c:v>7368.6064453125</c:v>
                </c:pt>
                <c:pt idx="132">
                  <c:v>7236.9462890625</c:v>
                </c:pt>
                <c:pt idx="133">
                  <c:v>7142.26318359375</c:v>
                </c:pt>
                <c:pt idx="134">
                  <c:v>7120.40576171875</c:v>
                </c:pt>
                <c:pt idx="135">
                  <c:v>7150.6591796875</c:v>
                </c:pt>
                <c:pt idx="136">
                  <c:v>7185.73828125</c:v>
                </c:pt>
                <c:pt idx="137">
                  <c:v>7196.8974609375</c:v>
                </c:pt>
                <c:pt idx="138">
                  <c:v>7194.44775390625</c:v>
                </c:pt>
                <c:pt idx="139">
                  <c:v>7208.86865234375</c:v>
                </c:pt>
                <c:pt idx="140">
                  <c:v>7253.814453125</c:v>
                </c:pt>
                <c:pt idx="141">
                  <c:v>7307.44873046875</c:v>
                </c:pt>
                <c:pt idx="142">
                  <c:v>7330.08740234375</c:v>
                </c:pt>
                <c:pt idx="143">
                  <c:v>7301.65771484375</c:v>
                </c:pt>
                <c:pt idx="144">
                  <c:v>7243.470703125</c:v>
                </c:pt>
                <c:pt idx="145">
                  <c:v>7202.58984375</c:v>
                </c:pt>
                <c:pt idx="146">
                  <c:v>7211.2109375</c:v>
                </c:pt>
                <c:pt idx="147">
                  <c:v>7257.09814453125</c:v>
                </c:pt>
                <c:pt idx="148">
                  <c:v>7292.5498046875</c:v>
                </c:pt>
                <c:pt idx="149">
                  <c:v>7275.5712890625</c:v>
                </c:pt>
                <c:pt idx="150">
                  <c:v>7207.7509765625</c:v>
                </c:pt>
                <c:pt idx="151">
                  <c:v>7135.00732421875</c:v>
                </c:pt>
                <c:pt idx="152">
                  <c:v>7109.19482421875</c:v>
                </c:pt>
                <c:pt idx="153">
                  <c:v>7143.0693359375</c:v>
                </c:pt>
                <c:pt idx="154">
                  <c:v>7197.9404296875</c:v>
                </c:pt>
                <c:pt idx="155">
                  <c:v>7215.857421875</c:v>
                </c:pt>
                <c:pt idx="156">
                  <c:v>7169.73388671875</c:v>
                </c:pt>
                <c:pt idx="157">
                  <c:v>7088.59521484375</c:v>
                </c:pt>
                <c:pt idx="158">
                  <c:v>7035.5732421875</c:v>
                </c:pt>
                <c:pt idx="159">
                  <c:v>7056.22119140625</c:v>
                </c:pt>
                <c:pt idx="160">
                  <c:v>7140.2158203125</c:v>
                </c:pt>
                <c:pt idx="161">
                  <c:v>7228.6611328125</c:v>
                </c:pt>
                <c:pt idx="162">
                  <c:v>7261.18798828125</c:v>
                </c:pt>
                <c:pt idx="163">
                  <c:v>7223.93701171875</c:v>
                </c:pt>
                <c:pt idx="164">
                  <c:v>7159.12451171875</c:v>
                </c:pt>
                <c:pt idx="165">
                  <c:v>7129.16162109375</c:v>
                </c:pt>
                <c:pt idx="166">
                  <c:v>7165.79345703125</c:v>
                </c:pt>
                <c:pt idx="167">
                  <c:v>7246.11572265625</c:v>
                </c:pt>
                <c:pt idx="168">
                  <c:v>7313.85009765625</c:v>
                </c:pt>
                <c:pt idx="169">
                  <c:v>7326.42626953125</c:v>
                </c:pt>
                <c:pt idx="170">
                  <c:v>7288.0693359375</c:v>
                </c:pt>
                <c:pt idx="171">
                  <c:v>7242.47265625</c:v>
                </c:pt>
                <c:pt idx="172">
                  <c:v>7233.291015625</c:v>
                </c:pt>
                <c:pt idx="173">
                  <c:v>7267.0419921875</c:v>
                </c:pt>
                <c:pt idx="174">
                  <c:v>7309.44140625</c:v>
                </c:pt>
                <c:pt idx="175">
                  <c:v>7316.94677734375</c:v>
                </c:pt>
                <c:pt idx="176">
                  <c:v>7275.7158203125</c:v>
                </c:pt>
                <c:pt idx="177">
                  <c:v>7214.7919921875</c:v>
                </c:pt>
                <c:pt idx="178">
                  <c:v>7182.68017578125</c:v>
                </c:pt>
                <c:pt idx="179">
                  <c:v>7207.0498046875</c:v>
                </c:pt>
                <c:pt idx="180">
                  <c:v>7270.74462890625</c:v>
                </c:pt>
                <c:pt idx="181">
                  <c:v>7323.42724609375</c:v>
                </c:pt>
                <c:pt idx="182">
                  <c:v>7319.40625</c:v>
                </c:pt>
                <c:pt idx="183">
                  <c:v>7252.06298828125</c:v>
                </c:pt>
                <c:pt idx="184">
                  <c:v>7159.0947265625</c:v>
                </c:pt>
                <c:pt idx="185">
                  <c:v>7095.9541015625</c:v>
                </c:pt>
                <c:pt idx="186">
                  <c:v>7098.24169921875</c:v>
                </c:pt>
                <c:pt idx="187">
                  <c:v>7159.94775390625</c:v>
                </c:pt>
                <c:pt idx="188">
                  <c:v>7240.61767578125</c:v>
                </c:pt>
                <c:pt idx="189">
                  <c:v>7293.25244140625</c:v>
                </c:pt>
                <c:pt idx="190">
                  <c:v>7292.181640625</c:v>
                </c:pt>
                <c:pt idx="191">
                  <c:v>7243.673828125</c:v>
                </c:pt>
                <c:pt idx="192">
                  <c:v>7176.29052734375</c:v>
                </c:pt>
                <c:pt idx="193">
                  <c:v>7121.16845703125</c:v>
                </c:pt>
                <c:pt idx="194">
                  <c:v>7096.01318359375</c:v>
                </c:pt>
                <c:pt idx="195">
                  <c:v>7100.72314453125</c:v>
                </c:pt>
                <c:pt idx="196">
                  <c:v>7123.5498046875</c:v>
                </c:pt>
                <c:pt idx="197">
                  <c:v>7151.05224609375</c:v>
                </c:pt>
                <c:pt idx="198">
                  <c:v>7175.0927734375</c:v>
                </c:pt>
                <c:pt idx="199">
                  <c:v>7193.84033203125</c:v>
                </c:pt>
                <c:pt idx="200">
                  <c:v>7208.06884765625</c:v>
                </c:pt>
                <c:pt idx="201">
                  <c:v>7216.65283203125</c:v>
                </c:pt>
                <c:pt idx="202">
                  <c:v>7215.31396484375</c:v>
                </c:pt>
                <c:pt idx="203">
                  <c:v>7200.2783203125</c:v>
                </c:pt>
                <c:pt idx="204">
                  <c:v>7174.5859375</c:v>
                </c:pt>
                <c:pt idx="205">
                  <c:v>7151.67724609375</c:v>
                </c:pt>
                <c:pt idx="206">
                  <c:v>7151.3388671875</c:v>
                </c:pt>
                <c:pt idx="207">
                  <c:v>7188.1162109375</c:v>
                </c:pt>
                <c:pt idx="208">
                  <c:v>7259.02587890625</c:v>
                </c:pt>
                <c:pt idx="209">
                  <c:v>7340.27392578125</c:v>
                </c:pt>
                <c:pt idx="210">
                  <c:v>7397.998046875</c:v>
                </c:pt>
                <c:pt idx="211">
                  <c:v>7407.83544921875</c:v>
                </c:pt>
                <c:pt idx="212">
                  <c:v>7370.10595703125</c:v>
                </c:pt>
                <c:pt idx="213">
                  <c:v>7308.91162109375</c:v>
                </c:pt>
                <c:pt idx="214">
                  <c:v>7254.8173828125</c:v>
                </c:pt>
                <c:pt idx="215">
                  <c:v>7223.73681640625</c:v>
                </c:pt>
                <c:pt idx="216">
                  <c:v>7208.322265625</c:v>
                </c:pt>
                <c:pt idx="217">
                  <c:v>7188.60546875</c:v>
                </c:pt>
                <c:pt idx="218">
                  <c:v>7152.84814453125</c:v>
                </c:pt>
                <c:pt idx="219">
                  <c:v>7110.6806640625</c:v>
                </c:pt>
                <c:pt idx="220">
                  <c:v>7086.69140625</c:v>
                </c:pt>
                <c:pt idx="221">
                  <c:v>7099.28955078125</c:v>
                </c:pt>
                <c:pt idx="222">
                  <c:v>7142.9365234375</c:v>
                </c:pt>
                <c:pt idx="223">
                  <c:v>7189.94384765625</c:v>
                </c:pt>
                <c:pt idx="224">
                  <c:v>7211.75537109375</c:v>
                </c:pt>
                <c:pt idx="225">
                  <c:v>7202.5302734375</c:v>
                </c:pt>
                <c:pt idx="226">
                  <c:v>7184.759765625</c:v>
                </c:pt>
                <c:pt idx="227">
                  <c:v>7191.02978515625</c:v>
                </c:pt>
                <c:pt idx="228">
                  <c:v>7236.12939453125</c:v>
                </c:pt>
                <c:pt idx="229">
                  <c:v>7302.48193359375</c:v>
                </c:pt>
                <c:pt idx="230">
                  <c:v>7351.41552734375</c:v>
                </c:pt>
                <c:pt idx="231">
                  <c:v>7351.609375</c:v>
                </c:pt>
                <c:pt idx="232">
                  <c:v>7301.92822265625</c:v>
                </c:pt>
                <c:pt idx="233">
                  <c:v>7230.74658203125</c:v>
                </c:pt>
                <c:pt idx="234">
                  <c:v>7173.50830078125</c:v>
                </c:pt>
                <c:pt idx="235">
                  <c:v>7147.80908203125</c:v>
                </c:pt>
                <c:pt idx="236">
                  <c:v>7146.00244140625</c:v>
                </c:pt>
                <c:pt idx="237">
                  <c:v>7149.11865234375</c:v>
                </c:pt>
                <c:pt idx="238">
                  <c:v>7147.42529296875</c:v>
                </c:pt>
                <c:pt idx="239">
                  <c:v>7148.37646484375</c:v>
                </c:pt>
                <c:pt idx="240">
                  <c:v>7165.58984375</c:v>
                </c:pt>
                <c:pt idx="241">
                  <c:v>7200.6748046875</c:v>
                </c:pt>
                <c:pt idx="242">
                  <c:v>7236.54296875</c:v>
                </c:pt>
                <c:pt idx="243">
                  <c:v>7249.990234375</c:v>
                </c:pt>
                <c:pt idx="244">
                  <c:v>7232.77783203125</c:v>
                </c:pt>
                <c:pt idx="245">
                  <c:v>7201.361328125</c:v>
                </c:pt>
                <c:pt idx="246">
                  <c:v>7184.6689453125</c:v>
                </c:pt>
                <c:pt idx="247">
                  <c:v>7199.16015625</c:v>
                </c:pt>
                <c:pt idx="248">
                  <c:v>7232.9970703125</c:v>
                </c:pt>
                <c:pt idx="249">
                  <c:v>7254.60693359375</c:v>
                </c:pt>
                <c:pt idx="250">
                  <c:v>7240.04248046875</c:v>
                </c:pt>
                <c:pt idx="251">
                  <c:v>7196.3017578125</c:v>
                </c:pt>
                <c:pt idx="252">
                  <c:v>7159.61962890625</c:v>
                </c:pt>
                <c:pt idx="253">
                  <c:v>7167.99560546875</c:v>
                </c:pt>
                <c:pt idx="254">
                  <c:v>7229.177734375</c:v>
                </c:pt>
                <c:pt idx="255">
                  <c:v>7310.2998046875</c:v>
                </c:pt>
                <c:pt idx="256">
                  <c:v>7358.82763671875</c:v>
                </c:pt>
                <c:pt idx="257">
                  <c:v>7339.66796875</c:v>
                </c:pt>
                <c:pt idx="258">
                  <c:v>7260.51708984375</c:v>
                </c:pt>
                <c:pt idx="259">
                  <c:v>7166.74755859375</c:v>
                </c:pt>
                <c:pt idx="260">
                  <c:v>7110.45703125</c:v>
                </c:pt>
                <c:pt idx="261">
                  <c:v>7116.88525390625</c:v>
                </c:pt>
                <c:pt idx="262">
                  <c:v>7171.33642578125</c:v>
                </c:pt>
                <c:pt idx="263">
                  <c:v>7232.8701171875</c:v>
                </c:pt>
                <c:pt idx="264">
                  <c:v>7261.923828125</c:v>
                </c:pt>
                <c:pt idx="265">
                  <c:v>7242.19677734375</c:v>
                </c:pt>
                <c:pt idx="266">
                  <c:v>7185.2490234375</c:v>
                </c:pt>
                <c:pt idx="267">
                  <c:v>7120.12158203125</c:v>
                </c:pt>
                <c:pt idx="268">
                  <c:v>7078.1162109375</c:v>
                </c:pt>
                <c:pt idx="269">
                  <c:v>7080.90087890625</c:v>
                </c:pt>
                <c:pt idx="270">
                  <c:v>7133.7578125</c:v>
                </c:pt>
                <c:pt idx="271">
                  <c:v>7222.8544921875</c:v>
                </c:pt>
                <c:pt idx="272">
                  <c:v>7317.55810546875</c:v>
                </c:pt>
                <c:pt idx="273">
                  <c:v>7380.7392578125</c:v>
                </c:pt>
                <c:pt idx="274">
                  <c:v>7386.33544921875</c:v>
                </c:pt>
                <c:pt idx="275">
                  <c:v>7335.59326171875</c:v>
                </c:pt>
                <c:pt idx="276">
                  <c:v>7259.51220703125</c:v>
                </c:pt>
                <c:pt idx="277">
                  <c:v>7201.7109375</c:v>
                </c:pt>
                <c:pt idx="278">
                  <c:v>7190.43994140625</c:v>
                </c:pt>
                <c:pt idx="279">
                  <c:v>7219.17822265625</c:v>
                </c:pt>
                <c:pt idx="280">
                  <c:v>7251.5087890625</c:v>
                </c:pt>
                <c:pt idx="281">
                  <c:v>7248.46240234375</c:v>
                </c:pt>
                <c:pt idx="282">
                  <c:v>7198.544921875</c:v>
                </c:pt>
                <c:pt idx="283">
                  <c:v>7127.33349609375</c:v>
                </c:pt>
                <c:pt idx="284">
                  <c:v>7078.849609375</c:v>
                </c:pt>
                <c:pt idx="285">
                  <c:v>7083.06005859375</c:v>
                </c:pt>
                <c:pt idx="286">
                  <c:v>7134.7333984375</c:v>
                </c:pt>
                <c:pt idx="287">
                  <c:v>7199.4111328125</c:v>
                </c:pt>
                <c:pt idx="288">
                  <c:v>7240.25</c:v>
                </c:pt>
                <c:pt idx="289">
                  <c:v>7243.4501953125</c:v>
                </c:pt>
                <c:pt idx="290">
                  <c:v>7222.94580078125</c:v>
                </c:pt>
                <c:pt idx="291">
                  <c:v>7203.64404296875</c:v>
                </c:pt>
                <c:pt idx="292">
                  <c:v>7200.123046875</c:v>
                </c:pt>
                <c:pt idx="293">
                  <c:v>7209.23388671875</c:v>
                </c:pt>
                <c:pt idx="294">
                  <c:v>7220.265625</c:v>
                </c:pt>
                <c:pt idx="295">
                  <c:v>7229.56982421875</c:v>
                </c:pt>
                <c:pt idx="296">
                  <c:v>7243.48779296875</c:v>
                </c:pt>
                <c:pt idx="297">
                  <c:v>7266.544921875</c:v>
                </c:pt>
                <c:pt idx="298">
                  <c:v>7288.26318359375</c:v>
                </c:pt>
                <c:pt idx="299">
                  <c:v>7285.20654296875</c:v>
                </c:pt>
                <c:pt idx="300">
                  <c:v>7240.8466796875</c:v>
                </c:pt>
                <c:pt idx="301">
                  <c:v>7166.9638671875</c:v>
                </c:pt>
                <c:pt idx="302">
                  <c:v>7104.90478515625</c:v>
                </c:pt>
                <c:pt idx="303">
                  <c:v>7100.04150390625</c:v>
                </c:pt>
                <c:pt idx="304">
                  <c:v>7166.59716796875</c:v>
                </c:pt>
                <c:pt idx="305">
                  <c:v>7271.5048828125</c:v>
                </c:pt>
                <c:pt idx="306">
                  <c:v>7353.38427734375</c:v>
                </c:pt>
                <c:pt idx="307">
                  <c:v>7364.83642578125</c:v>
                </c:pt>
                <c:pt idx="308">
                  <c:v>7306.0869140625</c:v>
                </c:pt>
                <c:pt idx="309">
                  <c:v>7223.2548828125</c:v>
                </c:pt>
                <c:pt idx="310">
                  <c:v>7172.09375</c:v>
                </c:pt>
                <c:pt idx="311">
                  <c:v>7175.6806640625</c:v>
                </c:pt>
                <c:pt idx="312">
                  <c:v>7209.4013671875</c:v>
                </c:pt>
                <c:pt idx="313">
                  <c:v>7224.4208984375</c:v>
                </c:pt>
                <c:pt idx="314">
                  <c:v>7189.8310546875</c:v>
                </c:pt>
                <c:pt idx="315">
                  <c:v>7119.21533203125</c:v>
                </c:pt>
                <c:pt idx="316">
                  <c:v>7060.837890625</c:v>
                </c:pt>
                <c:pt idx="317">
                  <c:v>7060.34130859375</c:v>
                </c:pt>
                <c:pt idx="318">
                  <c:v>7126.08154296875</c:v>
                </c:pt>
                <c:pt idx="319">
                  <c:v>7223.4462890625</c:v>
                </c:pt>
                <c:pt idx="320">
                  <c:v>7300.29052734375</c:v>
                </c:pt>
                <c:pt idx="321">
                  <c:v>7321.8564453125</c:v>
                </c:pt>
                <c:pt idx="322">
                  <c:v>7289.1015625</c:v>
                </c:pt>
                <c:pt idx="323">
                  <c:v>7230.603515625</c:v>
                </c:pt>
                <c:pt idx="324">
                  <c:v>7179.509765625</c:v>
                </c:pt>
                <c:pt idx="325">
                  <c:v>7155.341796875</c:v>
                </c:pt>
                <c:pt idx="326">
                  <c:v>7161.24462890625</c:v>
                </c:pt>
                <c:pt idx="327">
                  <c:v>7191.48681640625</c:v>
                </c:pt>
                <c:pt idx="328">
                  <c:v>7237.11572265625</c:v>
                </c:pt>
                <c:pt idx="329">
                  <c:v>7284.568359375</c:v>
                </c:pt>
                <c:pt idx="330">
                  <c:v>7313.7294921875</c:v>
                </c:pt>
                <c:pt idx="331">
                  <c:v>7304.88720703125</c:v>
                </c:pt>
                <c:pt idx="332">
                  <c:v>7254.287109375</c:v>
                </c:pt>
                <c:pt idx="333">
                  <c:v>7185.24609375</c:v>
                </c:pt>
                <c:pt idx="334">
                  <c:v>7140.33642578125</c:v>
                </c:pt>
                <c:pt idx="335">
                  <c:v>7154.25341796875</c:v>
                </c:pt>
                <c:pt idx="336">
                  <c:v>7225.5908203125</c:v>
                </c:pt>
                <c:pt idx="337">
                  <c:v>7311.3388671875</c:v>
                </c:pt>
                <c:pt idx="338">
                  <c:v>7352.890625</c:v>
                </c:pt>
                <c:pt idx="339">
                  <c:v>7317.17333984375</c:v>
                </c:pt>
                <c:pt idx="340">
                  <c:v>7222.11767578125</c:v>
                </c:pt>
                <c:pt idx="341">
                  <c:v>7125.59912109375</c:v>
                </c:pt>
                <c:pt idx="342">
                  <c:v>7084.681640625</c:v>
                </c:pt>
                <c:pt idx="343">
                  <c:v>7115.58203125</c:v>
                </c:pt>
                <c:pt idx="344">
                  <c:v>7184.63232421875</c:v>
                </c:pt>
                <c:pt idx="345">
                  <c:v>7236.31787109375</c:v>
                </c:pt>
                <c:pt idx="346">
                  <c:v>7235.6201171875</c:v>
                </c:pt>
                <c:pt idx="347">
                  <c:v>7191.66943359375</c:v>
                </c:pt>
                <c:pt idx="348">
                  <c:v>7145.92138671875</c:v>
                </c:pt>
                <c:pt idx="349">
                  <c:v>7136.8046875</c:v>
                </c:pt>
              </c:numCache>
            </c:numRef>
          </c:yVal>
          <c:smooth val="1"/>
          <c:extLst>
            <c:ext xmlns:c16="http://schemas.microsoft.com/office/drawing/2014/chart" uri="{C3380CC4-5D6E-409C-BE32-E72D297353CC}">
              <c16:uniqueId val="{00000013-0DDB-41B5-BE83-A9CFE49F3CE3}"/>
            </c:ext>
          </c:extLst>
        </c:ser>
        <c:ser>
          <c:idx val="20"/>
          <c:order val="20"/>
          <c:tx>
            <c:strRef>
              <c:f>hc_sub_007!$U$1</c:f>
              <c:strCache>
                <c:ptCount val="1"/>
                <c:pt idx="0">
                  <c:v>Coor_21</c:v>
                </c:pt>
              </c:strCache>
            </c:strRef>
          </c:tx>
          <c:spPr>
            <a:ln w="28575" cap="rnd">
              <a:solidFill>
                <a:schemeClr val="accent3">
                  <a:lumMod val="80000"/>
                </a:schemeClr>
              </a:solidFill>
              <a:round/>
            </a:ln>
            <a:effectLst/>
          </c:spPr>
          <c:marker>
            <c:symbol val="none"/>
          </c:marker>
          <c:yVal>
            <c:numRef>
              <c:f>hc_sub_007!$U$2:$U$351</c:f>
              <c:numCache>
                <c:formatCode>0.00000000000_ </c:formatCode>
                <c:ptCount val="350"/>
                <c:pt idx="0">
                  <c:v>6478.63916015625</c:v>
                </c:pt>
                <c:pt idx="1">
                  <c:v>6514.7412109375</c:v>
                </c:pt>
                <c:pt idx="2">
                  <c:v>6568.8466796875</c:v>
                </c:pt>
                <c:pt idx="3">
                  <c:v>6612.1328125</c:v>
                </c:pt>
                <c:pt idx="4">
                  <c:v>6616.1787109375</c:v>
                </c:pt>
                <c:pt idx="5">
                  <c:v>6573.2626953125</c:v>
                </c:pt>
                <c:pt idx="6">
                  <c:v>6504.21923828125</c:v>
                </c:pt>
                <c:pt idx="7">
                  <c:v>6446.86328125</c:v>
                </c:pt>
                <c:pt idx="8">
                  <c:v>6432.1015625</c:v>
                </c:pt>
                <c:pt idx="9">
                  <c:v>6464.08251953125</c:v>
                </c:pt>
                <c:pt idx="10">
                  <c:v>6517.9375</c:v>
                </c:pt>
                <c:pt idx="11">
                  <c:v>6556.14892578125</c:v>
                </c:pt>
                <c:pt idx="12">
                  <c:v>6551.92919921875</c:v>
                </c:pt>
                <c:pt idx="13">
                  <c:v>6504.39453125</c:v>
                </c:pt>
                <c:pt idx="14">
                  <c:v>6437.3310546875</c:v>
                </c:pt>
                <c:pt idx="15">
                  <c:v>6384.65576171875</c:v>
                </c:pt>
                <c:pt idx="16">
                  <c:v>6372.71875</c:v>
                </c:pt>
                <c:pt idx="17">
                  <c:v>6408.75732421875</c:v>
                </c:pt>
                <c:pt idx="18">
                  <c:v>6479.0576171875</c:v>
                </c:pt>
                <c:pt idx="19">
                  <c:v>6555.28369140625</c:v>
                </c:pt>
                <c:pt idx="20">
                  <c:v>6605.81201171875</c:v>
                </c:pt>
                <c:pt idx="21">
                  <c:v>6609.013671875</c:v>
                </c:pt>
                <c:pt idx="22">
                  <c:v>6564.41796875</c:v>
                </c:pt>
                <c:pt idx="23">
                  <c:v>6495.869140625</c:v>
                </c:pt>
                <c:pt idx="24">
                  <c:v>6441.794921875</c:v>
                </c:pt>
                <c:pt idx="25">
                  <c:v>6434.3134765625</c:v>
                </c:pt>
                <c:pt idx="26">
                  <c:v>6478.09033203125</c:v>
                </c:pt>
                <c:pt idx="27">
                  <c:v>6543.9423828125</c:v>
                </c:pt>
                <c:pt idx="28">
                  <c:v>6585.06103515625</c:v>
                </c:pt>
                <c:pt idx="29">
                  <c:v>6568.05712890625</c:v>
                </c:pt>
                <c:pt idx="30">
                  <c:v>6498.0654296875</c:v>
                </c:pt>
                <c:pt idx="31">
                  <c:v>6418.48779296875</c:v>
                </c:pt>
                <c:pt idx="32">
                  <c:v>6383.03173828125</c:v>
                </c:pt>
                <c:pt idx="33">
                  <c:v>6418.73046875</c:v>
                </c:pt>
                <c:pt idx="34">
                  <c:v>6506.90576171875</c:v>
                </c:pt>
                <c:pt idx="35">
                  <c:v>6596.64404296875</c:v>
                </c:pt>
                <c:pt idx="36">
                  <c:v>6640.8642578125</c:v>
                </c:pt>
                <c:pt idx="37">
                  <c:v>6627.60009765625</c:v>
                </c:pt>
                <c:pt idx="38">
                  <c:v>6583.1220703125</c:v>
                </c:pt>
                <c:pt idx="39">
                  <c:v>6546.24072265625</c:v>
                </c:pt>
                <c:pt idx="40">
                  <c:v>6536.15673828125</c:v>
                </c:pt>
                <c:pt idx="41">
                  <c:v>6540.54150390625</c:v>
                </c:pt>
                <c:pt idx="42">
                  <c:v>6532.4794921875</c:v>
                </c:pt>
                <c:pt idx="43">
                  <c:v>6499.76806640625</c:v>
                </c:pt>
                <c:pt idx="44">
                  <c:v>6459.43115234375</c:v>
                </c:pt>
                <c:pt idx="45">
                  <c:v>6443.54248046875</c:v>
                </c:pt>
                <c:pt idx="46">
                  <c:v>6468.38134765625</c:v>
                </c:pt>
                <c:pt idx="47">
                  <c:v>6514.96484375</c:v>
                </c:pt>
                <c:pt idx="48">
                  <c:v>6540.5029296875</c:v>
                </c:pt>
                <c:pt idx="49">
                  <c:v>6513.70703125</c:v>
                </c:pt>
                <c:pt idx="50">
                  <c:v>6444.78759765625</c:v>
                </c:pt>
                <c:pt idx="51">
                  <c:v>6383.0380859375</c:v>
                </c:pt>
                <c:pt idx="52">
                  <c:v>6380.74609375</c:v>
                </c:pt>
                <c:pt idx="53">
                  <c:v>6450.78076171875</c:v>
                </c:pt>
                <c:pt idx="54">
                  <c:v>6552.35107421875</c:v>
                </c:pt>
                <c:pt idx="55">
                  <c:v>6618.20751953125</c:v>
                </c:pt>
                <c:pt idx="56">
                  <c:v>6603.59375</c:v>
                </c:pt>
                <c:pt idx="57">
                  <c:v>6519.46240234375</c:v>
                </c:pt>
                <c:pt idx="58">
                  <c:v>6424.4501953125</c:v>
                </c:pt>
                <c:pt idx="59">
                  <c:v>6382.263671875</c:v>
                </c:pt>
                <c:pt idx="60">
                  <c:v>6417.4541015625</c:v>
                </c:pt>
                <c:pt idx="61">
                  <c:v>6502.2509765625</c:v>
                </c:pt>
                <c:pt idx="62">
                  <c:v>6581.5068359375</c:v>
                </c:pt>
                <c:pt idx="63">
                  <c:v>6613.49169921875</c:v>
                </c:pt>
                <c:pt idx="64">
                  <c:v>6594.67578125</c:v>
                </c:pt>
                <c:pt idx="65">
                  <c:v>6552.86328125</c:v>
                </c:pt>
                <c:pt idx="66">
                  <c:v>6519.64453125</c:v>
                </c:pt>
                <c:pt idx="67">
                  <c:v>6507.53515625</c:v>
                </c:pt>
                <c:pt idx="68">
                  <c:v>6508.85498046875</c:v>
                </c:pt>
                <c:pt idx="69">
                  <c:v>6511.91064453125</c:v>
                </c:pt>
                <c:pt idx="70">
                  <c:v>6515.4306640625</c:v>
                </c:pt>
                <c:pt idx="71">
                  <c:v>6526.7685546875</c:v>
                </c:pt>
                <c:pt idx="72">
                  <c:v>6547.34765625</c:v>
                </c:pt>
                <c:pt idx="73">
                  <c:v>6562.455078125</c:v>
                </c:pt>
                <c:pt idx="74">
                  <c:v>6548.7275390625</c:v>
                </c:pt>
                <c:pt idx="75">
                  <c:v>6495.11962890625</c:v>
                </c:pt>
                <c:pt idx="76">
                  <c:v>6418.458984375</c:v>
                </c:pt>
                <c:pt idx="77">
                  <c:v>6357.2529296875</c:v>
                </c:pt>
                <c:pt idx="78">
                  <c:v>6345.8388671875</c:v>
                </c:pt>
                <c:pt idx="79">
                  <c:v>6389.03369140625</c:v>
                </c:pt>
                <c:pt idx="80">
                  <c:v>6458.59033203125</c:v>
                </c:pt>
                <c:pt idx="81">
                  <c:v>6515.0810546875</c:v>
                </c:pt>
                <c:pt idx="82">
                  <c:v>6537.33642578125</c:v>
                </c:pt>
                <c:pt idx="83">
                  <c:v>6535.07177734375</c:v>
                </c:pt>
                <c:pt idx="84">
                  <c:v>6534.84716796875</c:v>
                </c:pt>
                <c:pt idx="85">
                  <c:v>6552.6171875</c:v>
                </c:pt>
                <c:pt idx="86">
                  <c:v>6577.71923828125</c:v>
                </c:pt>
                <c:pt idx="87">
                  <c:v>6582.84423828125</c:v>
                </c:pt>
                <c:pt idx="88">
                  <c:v>6551.27001953125</c:v>
                </c:pt>
                <c:pt idx="89">
                  <c:v>6496.6962890625</c:v>
                </c:pt>
                <c:pt idx="90">
                  <c:v>6456.697265625</c:v>
                </c:pt>
                <c:pt idx="91">
                  <c:v>6463.61962890625</c:v>
                </c:pt>
                <c:pt idx="92">
                  <c:v>6517.02734375</c:v>
                </c:pt>
                <c:pt idx="93">
                  <c:v>6581.73974609375</c:v>
                </c:pt>
                <c:pt idx="94">
                  <c:v>6614.521484375</c:v>
                </c:pt>
                <c:pt idx="95">
                  <c:v>6598.0751953125</c:v>
                </c:pt>
                <c:pt idx="96">
                  <c:v>6554.06103515625</c:v>
                </c:pt>
                <c:pt idx="97">
                  <c:v>6523.7294921875</c:v>
                </c:pt>
                <c:pt idx="98">
                  <c:v>6531.73388671875</c:v>
                </c:pt>
                <c:pt idx="99">
                  <c:v>6563.33935546875</c:v>
                </c:pt>
                <c:pt idx="100">
                  <c:v>6575.01416015625</c:v>
                </c:pt>
                <c:pt idx="101">
                  <c:v>6531.27294921875</c:v>
                </c:pt>
                <c:pt idx="102">
                  <c:v>6438.57666015625</c:v>
                </c:pt>
                <c:pt idx="103">
                  <c:v>6348.025390625</c:v>
                </c:pt>
                <c:pt idx="104">
                  <c:v>6322.19091796875</c:v>
                </c:pt>
                <c:pt idx="105">
                  <c:v>6389.2578125</c:v>
                </c:pt>
                <c:pt idx="106">
                  <c:v>6518.251953125</c:v>
                </c:pt>
                <c:pt idx="107">
                  <c:v>6634.48876953125</c:v>
                </c:pt>
                <c:pt idx="108">
                  <c:v>6665.76416015625</c:v>
                </c:pt>
                <c:pt idx="109">
                  <c:v>6588.34326171875</c:v>
                </c:pt>
                <c:pt idx="110">
                  <c:v>6442.4619140625</c:v>
                </c:pt>
                <c:pt idx="111">
                  <c:v>6308.1142578125</c:v>
                </c:pt>
                <c:pt idx="112">
                  <c:v>6257.78662109375</c:v>
                </c:pt>
                <c:pt idx="113">
                  <c:v>6316.033203125</c:v>
                </c:pt>
                <c:pt idx="114">
                  <c:v>6449.15625</c:v>
                </c:pt>
                <c:pt idx="115">
                  <c:v>6588.20654296875</c:v>
                </c:pt>
                <c:pt idx="116">
                  <c:v>6668.9072265625</c:v>
                </c:pt>
                <c:pt idx="117">
                  <c:v>6664.4755859375</c:v>
                </c:pt>
                <c:pt idx="118">
                  <c:v>6594.26416015625</c:v>
                </c:pt>
                <c:pt idx="119">
                  <c:v>6506.6591796875</c:v>
                </c:pt>
                <c:pt idx="120">
                  <c:v>6448.9873046875</c:v>
                </c:pt>
                <c:pt idx="121">
                  <c:v>6442.72607421875</c:v>
                </c:pt>
                <c:pt idx="122">
                  <c:v>6477.11376953125</c:v>
                </c:pt>
                <c:pt idx="123">
                  <c:v>6522.16357421875</c:v>
                </c:pt>
                <c:pt idx="124">
                  <c:v>6550.447265625</c:v>
                </c:pt>
                <c:pt idx="125">
                  <c:v>6552.75634765625</c:v>
                </c:pt>
                <c:pt idx="126">
                  <c:v>6538.31982421875</c:v>
                </c:pt>
                <c:pt idx="127">
                  <c:v>6521.93798828125</c:v>
                </c:pt>
                <c:pt idx="128">
                  <c:v>6509.89404296875</c:v>
                </c:pt>
                <c:pt idx="129">
                  <c:v>6496.7119140625</c:v>
                </c:pt>
                <c:pt idx="130">
                  <c:v>6475.19921875</c:v>
                </c:pt>
                <c:pt idx="131">
                  <c:v>6450.09619140625</c:v>
                </c:pt>
                <c:pt idx="132">
                  <c:v>6441.28759765625</c:v>
                </c:pt>
                <c:pt idx="133">
                  <c:v>6470.48828125</c:v>
                </c:pt>
                <c:pt idx="134">
                  <c:v>6540.15771484375</c:v>
                </c:pt>
                <c:pt idx="135">
                  <c:v>6622.68017578125</c:v>
                </c:pt>
                <c:pt idx="136">
                  <c:v>6672.451171875</c:v>
                </c:pt>
                <c:pt idx="137">
                  <c:v>6655.89453125</c:v>
                </c:pt>
                <c:pt idx="138">
                  <c:v>6578.15087890625</c:v>
                </c:pt>
                <c:pt idx="139">
                  <c:v>6484.47021484375</c:v>
                </c:pt>
                <c:pt idx="140">
                  <c:v>6431.84228515625</c:v>
                </c:pt>
                <c:pt idx="141">
                  <c:v>6449.61572265625</c:v>
                </c:pt>
                <c:pt idx="142">
                  <c:v>6518.19580078125</c:v>
                </c:pt>
                <c:pt idx="143">
                  <c:v>6582.8056640625</c:v>
                </c:pt>
                <c:pt idx="144">
                  <c:v>6592.9931640625</c:v>
                </c:pt>
                <c:pt idx="145">
                  <c:v>6538.48486328125</c:v>
                </c:pt>
                <c:pt idx="146">
                  <c:v>6454.48095703125</c:v>
                </c:pt>
                <c:pt idx="147">
                  <c:v>6393.19775390625</c:v>
                </c:pt>
                <c:pt idx="148">
                  <c:v>6384.724609375</c:v>
                </c:pt>
                <c:pt idx="149">
                  <c:v>6417.95703125</c:v>
                </c:pt>
                <c:pt idx="150">
                  <c:v>6455.33056640625</c:v>
                </c:pt>
                <c:pt idx="151">
                  <c:v>6467.3076171875</c:v>
                </c:pt>
                <c:pt idx="152">
                  <c:v>6456.95947265625</c:v>
                </c:pt>
                <c:pt idx="153">
                  <c:v>6454.27197265625</c:v>
                </c:pt>
                <c:pt idx="154">
                  <c:v>6485.98095703125</c:v>
                </c:pt>
                <c:pt idx="155">
                  <c:v>6547.7119140625</c:v>
                </c:pt>
                <c:pt idx="156">
                  <c:v>6603.27587890625</c:v>
                </c:pt>
                <c:pt idx="157">
                  <c:v>6612.73974609375</c:v>
                </c:pt>
                <c:pt idx="158">
                  <c:v>6566.00537109375</c:v>
                </c:pt>
                <c:pt idx="159">
                  <c:v>6493.20361328125</c:v>
                </c:pt>
                <c:pt idx="160">
                  <c:v>6442.1005859375</c:v>
                </c:pt>
                <c:pt idx="161">
                  <c:v>6440.34326171875</c:v>
                </c:pt>
                <c:pt idx="162">
                  <c:v>6473.5810546875</c:v>
                </c:pt>
                <c:pt idx="163">
                  <c:v>6498.1083984375</c:v>
                </c:pt>
                <c:pt idx="164">
                  <c:v>6478.53271484375</c:v>
                </c:pt>
                <c:pt idx="165">
                  <c:v>6420.1015625</c:v>
                </c:pt>
                <c:pt idx="166">
                  <c:v>6368.87841796875</c:v>
                </c:pt>
                <c:pt idx="167">
                  <c:v>6378.16064453125</c:v>
                </c:pt>
                <c:pt idx="168">
                  <c:v>6466.31494140625</c:v>
                </c:pt>
                <c:pt idx="169">
                  <c:v>6598.3974609375</c:v>
                </c:pt>
                <c:pt idx="170">
                  <c:v>6706.1123046875</c:v>
                </c:pt>
                <c:pt idx="171">
                  <c:v>6732.07861328125</c:v>
                </c:pt>
                <c:pt idx="172">
                  <c:v>6666.92822265625</c:v>
                </c:pt>
                <c:pt idx="173">
                  <c:v>6553.880859375</c:v>
                </c:pt>
                <c:pt idx="174">
                  <c:v>6459.32373046875</c:v>
                </c:pt>
                <c:pt idx="175">
                  <c:v>6431.0517578125</c:v>
                </c:pt>
                <c:pt idx="176">
                  <c:v>6472.02734375</c:v>
                </c:pt>
                <c:pt idx="177">
                  <c:v>6544.31494140625</c:v>
                </c:pt>
                <c:pt idx="178">
                  <c:v>6596.7978515625</c:v>
                </c:pt>
                <c:pt idx="179">
                  <c:v>6596.5146484375</c:v>
                </c:pt>
                <c:pt idx="180">
                  <c:v>6544.74560546875</c:v>
                </c:pt>
                <c:pt idx="181">
                  <c:v>6471.47998046875</c:v>
                </c:pt>
                <c:pt idx="182">
                  <c:v>6415.4228515625</c:v>
                </c:pt>
                <c:pt idx="183">
                  <c:v>6402.90380859375</c:v>
                </c:pt>
                <c:pt idx="184">
                  <c:v>6436.462890625</c:v>
                </c:pt>
                <c:pt idx="185">
                  <c:v>6496.63427734375</c:v>
                </c:pt>
                <c:pt idx="186">
                  <c:v>6553.66650390625</c:v>
                </c:pt>
                <c:pt idx="187">
                  <c:v>6582.35498046875</c:v>
                </c:pt>
                <c:pt idx="188">
                  <c:v>6572.9814453125</c:v>
                </c:pt>
                <c:pt idx="189">
                  <c:v>6533.79345703125</c:v>
                </c:pt>
                <c:pt idx="190">
                  <c:v>6484.62060546875</c:v>
                </c:pt>
                <c:pt idx="191">
                  <c:v>6445.75146484375</c:v>
                </c:pt>
                <c:pt idx="192">
                  <c:v>6428.6884765625</c:v>
                </c:pt>
                <c:pt idx="193">
                  <c:v>6433.84814453125</c:v>
                </c:pt>
                <c:pt idx="194">
                  <c:v>6455.203125</c:v>
                </c:pt>
                <c:pt idx="195">
                  <c:v>6486.77294921875</c:v>
                </c:pt>
                <c:pt idx="196">
                  <c:v>6524.970703125</c:v>
                </c:pt>
                <c:pt idx="197">
                  <c:v>6565.2265625</c:v>
                </c:pt>
                <c:pt idx="198">
                  <c:v>6597.35986328125</c:v>
                </c:pt>
                <c:pt idx="199">
                  <c:v>6606.28955078125</c:v>
                </c:pt>
                <c:pt idx="200">
                  <c:v>6580.28955078125</c:v>
                </c:pt>
                <c:pt idx="201">
                  <c:v>6521.46240234375</c:v>
                </c:pt>
                <c:pt idx="202">
                  <c:v>6449.244140625</c:v>
                </c:pt>
                <c:pt idx="203">
                  <c:v>6391.92236328125</c:v>
                </c:pt>
                <c:pt idx="204">
                  <c:v>6370.6142578125</c:v>
                </c:pt>
                <c:pt idx="205">
                  <c:v>6387.11962890625</c:v>
                </c:pt>
                <c:pt idx="206">
                  <c:v>6424.9931640625</c:v>
                </c:pt>
                <c:pt idx="207">
                  <c:v>6463.05615234375</c:v>
                </c:pt>
                <c:pt idx="208">
                  <c:v>6490.59130859375</c:v>
                </c:pt>
                <c:pt idx="209">
                  <c:v>6512.15087890625</c:v>
                </c:pt>
                <c:pt idx="210">
                  <c:v>6538.73095703125</c:v>
                </c:pt>
                <c:pt idx="211">
                  <c:v>6573.64208984375</c:v>
                </c:pt>
                <c:pt idx="212">
                  <c:v>6605.85595703125</c:v>
                </c:pt>
                <c:pt idx="213">
                  <c:v>6616.98388671875</c:v>
                </c:pt>
                <c:pt idx="214">
                  <c:v>6596.1025390625</c:v>
                </c:pt>
                <c:pt idx="215">
                  <c:v>6549.74658203125</c:v>
                </c:pt>
                <c:pt idx="216">
                  <c:v>6498.54248046875</c:v>
                </c:pt>
                <c:pt idx="217">
                  <c:v>6463.4267578125</c:v>
                </c:pt>
                <c:pt idx="218">
                  <c:v>6452.98388671875</c:v>
                </c:pt>
                <c:pt idx="219">
                  <c:v>6461.74365234375</c:v>
                </c:pt>
                <c:pt idx="220">
                  <c:v>6479.07958984375</c:v>
                </c:pt>
                <c:pt idx="221">
                  <c:v>6499.12451171875</c:v>
                </c:pt>
                <c:pt idx="222">
                  <c:v>6522.2294921875</c:v>
                </c:pt>
                <c:pt idx="223">
                  <c:v>6547.60546875</c:v>
                </c:pt>
                <c:pt idx="224">
                  <c:v>6566.1259765625</c:v>
                </c:pt>
                <c:pt idx="225">
                  <c:v>6562.72314453125</c:v>
                </c:pt>
                <c:pt idx="226">
                  <c:v>6528.58251953125</c:v>
                </c:pt>
                <c:pt idx="227">
                  <c:v>6472.83251953125</c:v>
                </c:pt>
                <c:pt idx="228">
                  <c:v>6421.83740234375</c:v>
                </c:pt>
                <c:pt idx="229">
                  <c:v>6403.859375</c:v>
                </c:pt>
                <c:pt idx="230">
                  <c:v>6429.76904296875</c:v>
                </c:pt>
                <c:pt idx="231">
                  <c:v>6485.07958984375</c:v>
                </c:pt>
                <c:pt idx="232">
                  <c:v>6540.20849609375</c:v>
                </c:pt>
                <c:pt idx="233">
                  <c:v>6571.22607421875</c:v>
                </c:pt>
                <c:pt idx="234">
                  <c:v>6574.91015625</c:v>
                </c:pt>
                <c:pt idx="235">
                  <c:v>6566.9462890625</c:v>
                </c:pt>
                <c:pt idx="236">
                  <c:v>6566.22021484375</c:v>
                </c:pt>
                <c:pt idx="237">
                  <c:v>6579.111328125</c:v>
                </c:pt>
                <c:pt idx="238">
                  <c:v>6596.33349609375</c:v>
                </c:pt>
                <c:pt idx="239">
                  <c:v>6603.0283203125</c:v>
                </c:pt>
                <c:pt idx="240">
                  <c:v>6591.4833984375</c:v>
                </c:pt>
                <c:pt idx="241">
                  <c:v>6565.03955078125</c:v>
                </c:pt>
                <c:pt idx="242">
                  <c:v>6531.439453125</c:v>
                </c:pt>
                <c:pt idx="243">
                  <c:v>6494.32373046875</c:v>
                </c:pt>
                <c:pt idx="244">
                  <c:v>6452.62109375</c:v>
                </c:pt>
                <c:pt idx="245">
                  <c:v>6408.421875</c:v>
                </c:pt>
                <c:pt idx="246">
                  <c:v>6373.8154296875</c:v>
                </c:pt>
                <c:pt idx="247">
                  <c:v>6366.728515625</c:v>
                </c:pt>
                <c:pt idx="248">
                  <c:v>6396.38232421875</c:v>
                </c:pt>
                <c:pt idx="249">
                  <c:v>6450.8251953125</c:v>
                </c:pt>
                <c:pt idx="250">
                  <c:v>6500.02197265625</c:v>
                </c:pt>
                <c:pt idx="251">
                  <c:v>6515.5029296875</c:v>
                </c:pt>
                <c:pt idx="252">
                  <c:v>6491.93603515625</c:v>
                </c:pt>
                <c:pt idx="253">
                  <c:v>6451.873046875</c:v>
                </c:pt>
                <c:pt idx="254">
                  <c:v>6427.70703125</c:v>
                </c:pt>
                <c:pt idx="255">
                  <c:v>6434.69384765625</c:v>
                </c:pt>
                <c:pt idx="256">
                  <c:v>6458.19287109375</c:v>
                </c:pt>
                <c:pt idx="257">
                  <c:v>6467.55126953125</c:v>
                </c:pt>
                <c:pt idx="258">
                  <c:v>6446.10888671875</c:v>
                </c:pt>
                <c:pt idx="259">
                  <c:v>6411.27685546875</c:v>
                </c:pt>
                <c:pt idx="260">
                  <c:v>6405.0849609375</c:v>
                </c:pt>
                <c:pt idx="261">
                  <c:v>6460.11962890625</c:v>
                </c:pt>
                <c:pt idx="262">
                  <c:v>6568.0849609375</c:v>
                </c:pt>
                <c:pt idx="263">
                  <c:v>6678.59228515625</c:v>
                </c:pt>
                <c:pt idx="264">
                  <c:v>6732.3125</c:v>
                </c:pt>
                <c:pt idx="265">
                  <c:v>6704.04443359375</c:v>
                </c:pt>
                <c:pt idx="266">
                  <c:v>6621.65234375</c:v>
                </c:pt>
                <c:pt idx="267">
                  <c:v>6545.11181640625</c:v>
                </c:pt>
                <c:pt idx="268">
                  <c:v>6521.74462890625</c:v>
                </c:pt>
                <c:pt idx="269">
                  <c:v>6552.8876953125</c:v>
                </c:pt>
                <c:pt idx="270">
                  <c:v>6597.712890625</c:v>
                </c:pt>
                <c:pt idx="271">
                  <c:v>6609.552734375</c:v>
                </c:pt>
                <c:pt idx="272">
                  <c:v>6574.0458984375</c:v>
                </c:pt>
                <c:pt idx="273">
                  <c:v>6518.25341796875</c:v>
                </c:pt>
                <c:pt idx="274">
                  <c:v>6485.05810546875</c:v>
                </c:pt>
                <c:pt idx="275">
                  <c:v>6496.080078125</c:v>
                </c:pt>
                <c:pt idx="276">
                  <c:v>6534.658203125</c:v>
                </c:pt>
                <c:pt idx="277">
                  <c:v>6561.9462890625</c:v>
                </c:pt>
                <c:pt idx="278">
                  <c:v>6550.48486328125</c:v>
                </c:pt>
                <c:pt idx="279">
                  <c:v>6505.60205078125</c:v>
                </c:pt>
                <c:pt idx="280">
                  <c:v>6457.1435546875</c:v>
                </c:pt>
                <c:pt idx="281">
                  <c:v>6430.85546875</c:v>
                </c:pt>
                <c:pt idx="282">
                  <c:v>6426.31298828125</c:v>
                </c:pt>
                <c:pt idx="283">
                  <c:v>6421.33642578125</c:v>
                </c:pt>
                <c:pt idx="284">
                  <c:v>6398.0458984375</c:v>
                </c:pt>
                <c:pt idx="285">
                  <c:v>6365.47265625</c:v>
                </c:pt>
                <c:pt idx="286">
                  <c:v>6356.24365234375</c:v>
                </c:pt>
                <c:pt idx="287">
                  <c:v>6398.17724609375</c:v>
                </c:pt>
                <c:pt idx="288">
                  <c:v>6485.0771484375</c:v>
                </c:pt>
                <c:pt idx="289">
                  <c:v>6573.55517578125</c:v>
                </c:pt>
                <c:pt idx="290">
                  <c:v>6611.51318359375</c:v>
                </c:pt>
                <c:pt idx="291">
                  <c:v>6576.814453125</c:v>
                </c:pt>
                <c:pt idx="292">
                  <c:v>6495.0625</c:v>
                </c:pt>
                <c:pt idx="293">
                  <c:v>6421.67138671875</c:v>
                </c:pt>
                <c:pt idx="294">
                  <c:v>6402.11767578125</c:v>
                </c:pt>
                <c:pt idx="295">
                  <c:v>6441.35498046875</c:v>
                </c:pt>
                <c:pt idx="296">
                  <c:v>6505.029296875</c:v>
                </c:pt>
                <c:pt idx="297">
                  <c:v>6549.00439453125</c:v>
                </c:pt>
                <c:pt idx="298">
                  <c:v>6551.9404296875</c:v>
                </c:pt>
                <c:pt idx="299">
                  <c:v>6525.7822265625</c:v>
                </c:pt>
                <c:pt idx="300">
                  <c:v>6499.40185546875</c:v>
                </c:pt>
                <c:pt idx="301">
                  <c:v>6492.7568359375</c:v>
                </c:pt>
                <c:pt idx="302">
                  <c:v>6504.25537109375</c:v>
                </c:pt>
                <c:pt idx="303">
                  <c:v>6519.47412109375</c:v>
                </c:pt>
                <c:pt idx="304">
                  <c:v>6529.41748046875</c:v>
                </c:pt>
                <c:pt idx="305">
                  <c:v>6539.19482421875</c:v>
                </c:pt>
                <c:pt idx="306">
                  <c:v>6559.0478515625</c:v>
                </c:pt>
                <c:pt idx="307">
                  <c:v>6587.87255859375</c:v>
                </c:pt>
                <c:pt idx="308">
                  <c:v>6607.34375</c:v>
                </c:pt>
                <c:pt idx="309">
                  <c:v>6594.97412109375</c:v>
                </c:pt>
                <c:pt idx="310">
                  <c:v>6545.921875</c:v>
                </c:pt>
                <c:pt idx="311">
                  <c:v>6483.39306640625</c:v>
                </c:pt>
                <c:pt idx="312">
                  <c:v>6445.83935546875</c:v>
                </c:pt>
                <c:pt idx="313">
                  <c:v>6459.072265625</c:v>
                </c:pt>
                <c:pt idx="314">
                  <c:v>6515.45849609375</c:v>
                </c:pt>
                <c:pt idx="315">
                  <c:v>6577.849609375</c:v>
                </c:pt>
                <c:pt idx="316">
                  <c:v>6606.13232421875</c:v>
                </c:pt>
                <c:pt idx="317">
                  <c:v>6585.83251953125</c:v>
                </c:pt>
                <c:pt idx="318">
                  <c:v>6536.61279296875</c:v>
                </c:pt>
                <c:pt idx="319">
                  <c:v>6494.9609375</c:v>
                </c:pt>
                <c:pt idx="320">
                  <c:v>6485.8740234375</c:v>
                </c:pt>
                <c:pt idx="321">
                  <c:v>6506.017578125</c:v>
                </c:pt>
                <c:pt idx="322">
                  <c:v>6530.0546875</c:v>
                </c:pt>
                <c:pt idx="323">
                  <c:v>6532.609375</c:v>
                </c:pt>
                <c:pt idx="324">
                  <c:v>6506.93408203125</c:v>
                </c:pt>
                <c:pt idx="325">
                  <c:v>6466.4287109375</c:v>
                </c:pt>
                <c:pt idx="326">
                  <c:v>6430.86328125</c:v>
                </c:pt>
                <c:pt idx="327">
                  <c:v>6411.2529296875</c:v>
                </c:pt>
                <c:pt idx="328">
                  <c:v>6405.99169921875</c:v>
                </c:pt>
                <c:pt idx="329">
                  <c:v>6408.84228515625</c:v>
                </c:pt>
                <c:pt idx="330">
                  <c:v>6418.4755859375</c:v>
                </c:pt>
                <c:pt idx="331">
                  <c:v>6439.31787109375</c:v>
                </c:pt>
                <c:pt idx="332">
                  <c:v>6473.39794921875</c:v>
                </c:pt>
                <c:pt idx="333">
                  <c:v>6512.62939453125</c:v>
                </c:pt>
                <c:pt idx="334">
                  <c:v>6540.92041015625</c:v>
                </c:pt>
                <c:pt idx="335">
                  <c:v>6545.83447265625</c:v>
                </c:pt>
                <c:pt idx="336">
                  <c:v>6529.5390625</c:v>
                </c:pt>
                <c:pt idx="337">
                  <c:v>6508.28125</c:v>
                </c:pt>
                <c:pt idx="338">
                  <c:v>6499.58642578125</c:v>
                </c:pt>
                <c:pt idx="339">
                  <c:v>6507.79296875</c:v>
                </c:pt>
                <c:pt idx="340">
                  <c:v>6520.83056640625</c:v>
                </c:pt>
                <c:pt idx="341">
                  <c:v>6521.6650390625</c:v>
                </c:pt>
                <c:pt idx="342">
                  <c:v>6504.7744140625</c:v>
                </c:pt>
                <c:pt idx="343">
                  <c:v>6483.029296875</c:v>
                </c:pt>
                <c:pt idx="344">
                  <c:v>6478.1953125</c:v>
                </c:pt>
                <c:pt idx="345">
                  <c:v>6502.439453125</c:v>
                </c:pt>
                <c:pt idx="346">
                  <c:v>6546.40234375</c:v>
                </c:pt>
                <c:pt idx="347">
                  <c:v>6584.35009765625</c:v>
                </c:pt>
                <c:pt idx="348">
                  <c:v>6592.81787109375</c:v>
                </c:pt>
                <c:pt idx="349">
                  <c:v>6567.912109375</c:v>
                </c:pt>
              </c:numCache>
            </c:numRef>
          </c:yVal>
          <c:smooth val="1"/>
          <c:extLst>
            <c:ext xmlns:c16="http://schemas.microsoft.com/office/drawing/2014/chart" uri="{C3380CC4-5D6E-409C-BE32-E72D297353CC}">
              <c16:uniqueId val="{00000014-0DDB-41B5-BE83-A9CFE49F3CE3}"/>
            </c:ext>
          </c:extLst>
        </c:ser>
        <c:ser>
          <c:idx val="21"/>
          <c:order val="21"/>
          <c:tx>
            <c:strRef>
              <c:f>hc_sub_007!$V$1</c:f>
              <c:strCache>
                <c:ptCount val="1"/>
                <c:pt idx="0">
                  <c:v>Coor_22</c:v>
                </c:pt>
              </c:strCache>
            </c:strRef>
          </c:tx>
          <c:spPr>
            <a:ln w="28575" cap="rnd">
              <a:solidFill>
                <a:schemeClr val="accent4">
                  <a:lumMod val="80000"/>
                </a:schemeClr>
              </a:solidFill>
              <a:round/>
            </a:ln>
            <a:effectLst/>
          </c:spPr>
          <c:marker>
            <c:symbol val="none"/>
          </c:marker>
          <c:yVal>
            <c:numRef>
              <c:f>hc_sub_007!$V$2:$V$351</c:f>
              <c:numCache>
                <c:formatCode>0.00000000000_ </c:formatCode>
                <c:ptCount val="350"/>
                <c:pt idx="0">
                  <c:v>6927.458984375</c:v>
                </c:pt>
                <c:pt idx="1">
                  <c:v>6916.75927734375</c:v>
                </c:pt>
                <c:pt idx="2">
                  <c:v>6831.3525390625</c:v>
                </c:pt>
                <c:pt idx="3">
                  <c:v>6708.5634765625</c:v>
                </c:pt>
                <c:pt idx="4">
                  <c:v>6607.2724609375</c:v>
                </c:pt>
                <c:pt idx="5">
                  <c:v>6571.390625</c:v>
                </c:pt>
                <c:pt idx="6">
                  <c:v>6606.099609375</c:v>
                </c:pt>
                <c:pt idx="7">
                  <c:v>6681.81298828125</c:v>
                </c:pt>
                <c:pt idx="8">
                  <c:v>6759.294921875</c:v>
                </c:pt>
                <c:pt idx="9">
                  <c:v>6814.9658203125</c:v>
                </c:pt>
                <c:pt idx="10">
                  <c:v>6848.64404296875</c:v>
                </c:pt>
                <c:pt idx="11">
                  <c:v>6872.37939453125</c:v>
                </c:pt>
                <c:pt idx="12">
                  <c:v>6893.9501953125</c:v>
                </c:pt>
                <c:pt idx="13">
                  <c:v>6910.0361328125</c:v>
                </c:pt>
                <c:pt idx="14">
                  <c:v>6912.65771484375</c:v>
                </c:pt>
                <c:pt idx="15">
                  <c:v>6899.71044921875</c:v>
                </c:pt>
                <c:pt idx="16">
                  <c:v>6877.84521484375</c:v>
                </c:pt>
                <c:pt idx="17">
                  <c:v>6854.96435546875</c:v>
                </c:pt>
                <c:pt idx="18">
                  <c:v>6830.806640625</c:v>
                </c:pt>
                <c:pt idx="19">
                  <c:v>6796.52685546875</c:v>
                </c:pt>
                <c:pt idx="20">
                  <c:v>6745.44091796875</c:v>
                </c:pt>
                <c:pt idx="21">
                  <c:v>6685.46240234375</c:v>
                </c:pt>
                <c:pt idx="22">
                  <c:v>6640.48583984375</c:v>
                </c:pt>
                <c:pt idx="23">
                  <c:v>6636.6845703125</c:v>
                </c:pt>
                <c:pt idx="24">
                  <c:v>6683.14453125</c:v>
                </c:pt>
                <c:pt idx="25">
                  <c:v>6762.43798828125</c:v>
                </c:pt>
                <c:pt idx="26">
                  <c:v>6839.763671875</c:v>
                </c:pt>
                <c:pt idx="27">
                  <c:v>6884.67724609375</c:v>
                </c:pt>
                <c:pt idx="28">
                  <c:v>6889.326171875</c:v>
                </c:pt>
                <c:pt idx="29">
                  <c:v>6869.982421875</c:v>
                </c:pt>
                <c:pt idx="30">
                  <c:v>6851.8916015625</c:v>
                </c:pt>
                <c:pt idx="31">
                  <c:v>6850.0556640625</c:v>
                </c:pt>
                <c:pt idx="32">
                  <c:v>6860.486328125</c:v>
                </c:pt>
                <c:pt idx="33">
                  <c:v>6866.91796875</c:v>
                </c:pt>
                <c:pt idx="34">
                  <c:v>6855.58935546875</c:v>
                </c:pt>
                <c:pt idx="35">
                  <c:v>6825.59765625</c:v>
                </c:pt>
                <c:pt idx="36">
                  <c:v>6787.69140625</c:v>
                </c:pt>
                <c:pt idx="37">
                  <c:v>6754.5546875</c:v>
                </c:pt>
                <c:pt idx="38">
                  <c:v>6731.7548828125</c:v>
                </c:pt>
                <c:pt idx="39">
                  <c:v>6716.26953125</c:v>
                </c:pt>
                <c:pt idx="40">
                  <c:v>6702.1318359375</c:v>
                </c:pt>
                <c:pt idx="41">
                  <c:v>6687.1748046875</c:v>
                </c:pt>
                <c:pt idx="42">
                  <c:v>6675.32080078125</c:v>
                </c:pt>
                <c:pt idx="43">
                  <c:v>6673.63037109375</c:v>
                </c:pt>
                <c:pt idx="44">
                  <c:v>6687.36328125</c:v>
                </c:pt>
                <c:pt idx="45">
                  <c:v>6716.5166015625</c:v>
                </c:pt>
                <c:pt idx="46">
                  <c:v>6754.8671875</c:v>
                </c:pt>
                <c:pt idx="47">
                  <c:v>6790.94189453125</c:v>
                </c:pt>
                <c:pt idx="48">
                  <c:v>6810.91845703125</c:v>
                </c:pt>
                <c:pt idx="49">
                  <c:v>6804.2880859375</c:v>
                </c:pt>
                <c:pt idx="50">
                  <c:v>6771.396484375</c:v>
                </c:pt>
                <c:pt idx="51">
                  <c:v>6728.29296875</c:v>
                </c:pt>
                <c:pt idx="52">
                  <c:v>6702.791015625</c:v>
                </c:pt>
                <c:pt idx="53">
                  <c:v>6720.06103515625</c:v>
                </c:pt>
                <c:pt idx="54">
                  <c:v>6784.7919921875</c:v>
                </c:pt>
                <c:pt idx="55">
                  <c:v>6872.927734375</c:v>
                </c:pt>
                <c:pt idx="56">
                  <c:v>6942.22119140625</c:v>
                </c:pt>
                <c:pt idx="57">
                  <c:v>6957.890625</c:v>
                </c:pt>
                <c:pt idx="58">
                  <c:v>6916.65087890625</c:v>
                </c:pt>
                <c:pt idx="59">
                  <c:v>6850.72412109375</c:v>
                </c:pt>
                <c:pt idx="60">
                  <c:v>6806.580078125</c:v>
                </c:pt>
                <c:pt idx="61">
                  <c:v>6812.31884765625</c:v>
                </c:pt>
                <c:pt idx="62">
                  <c:v>6857.7109375</c:v>
                </c:pt>
                <c:pt idx="63">
                  <c:v>6902.67724609375</c:v>
                </c:pt>
                <c:pt idx="64">
                  <c:v>6908.55908203125</c:v>
                </c:pt>
                <c:pt idx="65">
                  <c:v>6868.37841796875</c:v>
                </c:pt>
                <c:pt idx="66">
                  <c:v>6812.23974609375</c:v>
                </c:pt>
                <c:pt idx="67">
                  <c:v>6783.01318359375</c:v>
                </c:pt>
                <c:pt idx="68">
                  <c:v>6800.951171875</c:v>
                </c:pt>
                <c:pt idx="69">
                  <c:v>6845.201171875</c:v>
                </c:pt>
                <c:pt idx="70">
                  <c:v>6867.60400390625</c:v>
                </c:pt>
                <c:pt idx="71">
                  <c:v>6829.17041015625</c:v>
                </c:pt>
                <c:pt idx="72">
                  <c:v>6731.79638671875</c:v>
                </c:pt>
                <c:pt idx="73">
                  <c:v>6620.94384765625</c:v>
                </c:pt>
                <c:pt idx="74">
                  <c:v>6556.63037109375</c:v>
                </c:pt>
                <c:pt idx="75">
                  <c:v>6573.435546875</c:v>
                </c:pt>
                <c:pt idx="76">
                  <c:v>6657.81884765625</c:v>
                </c:pt>
                <c:pt idx="77">
                  <c:v>6757.908203125</c:v>
                </c:pt>
                <c:pt idx="78">
                  <c:v>6817.7734375</c:v>
                </c:pt>
                <c:pt idx="79">
                  <c:v>6812.17431640625</c:v>
                </c:pt>
                <c:pt idx="80">
                  <c:v>6759.40869140625</c:v>
                </c:pt>
                <c:pt idx="81">
                  <c:v>6706.13818359375</c:v>
                </c:pt>
                <c:pt idx="82">
                  <c:v>6696.2783203125</c:v>
                </c:pt>
                <c:pt idx="83">
                  <c:v>6744.23046875</c:v>
                </c:pt>
                <c:pt idx="84">
                  <c:v>6827.48681640625</c:v>
                </c:pt>
                <c:pt idx="85">
                  <c:v>6900.75244140625</c:v>
                </c:pt>
                <c:pt idx="86">
                  <c:v>6921.935546875</c:v>
                </c:pt>
                <c:pt idx="87">
                  <c:v>6875.53955078125</c:v>
                </c:pt>
                <c:pt idx="88">
                  <c:v>6781.6923828125</c:v>
                </c:pt>
                <c:pt idx="89">
                  <c:v>6686.578125</c:v>
                </c:pt>
                <c:pt idx="90">
                  <c:v>6639.0009765625</c:v>
                </c:pt>
                <c:pt idx="91">
                  <c:v>6664.89697265625</c:v>
                </c:pt>
                <c:pt idx="92">
                  <c:v>6753.51708984375</c:v>
                </c:pt>
                <c:pt idx="93">
                  <c:v>6863.66015625</c:v>
                </c:pt>
                <c:pt idx="94">
                  <c:v>6947.025390625</c:v>
                </c:pt>
                <c:pt idx="95">
                  <c:v>6974.73046875</c:v>
                </c:pt>
                <c:pt idx="96">
                  <c:v>6950.13818359375</c:v>
                </c:pt>
                <c:pt idx="97">
                  <c:v>6899.984375</c:v>
                </c:pt>
                <c:pt idx="98">
                  <c:v>6851.2822265625</c:v>
                </c:pt>
                <c:pt idx="99">
                  <c:v>6812.18798828125</c:v>
                </c:pt>
                <c:pt idx="100">
                  <c:v>6771.861328125</c:v>
                </c:pt>
                <c:pt idx="101">
                  <c:v>6718.71826171875</c:v>
                </c:pt>
                <c:pt idx="102">
                  <c:v>6660.498046875</c:v>
                </c:pt>
                <c:pt idx="103">
                  <c:v>6626.91845703125</c:v>
                </c:pt>
                <c:pt idx="104">
                  <c:v>6649.70068359375</c:v>
                </c:pt>
                <c:pt idx="105">
                  <c:v>6734.6435546875</c:v>
                </c:pt>
                <c:pt idx="106">
                  <c:v>6849.28369140625</c:v>
                </c:pt>
                <c:pt idx="107">
                  <c:v>6938.92578125</c:v>
                </c:pt>
                <c:pt idx="108">
                  <c:v>6961.16845703125</c:v>
                </c:pt>
                <c:pt idx="109">
                  <c:v>6913.15478515625</c:v>
                </c:pt>
                <c:pt idx="110">
                  <c:v>6830.54736328125</c:v>
                </c:pt>
                <c:pt idx="111">
                  <c:v>6759.578125</c:v>
                </c:pt>
                <c:pt idx="112">
                  <c:v>6725.1103515625</c:v>
                </c:pt>
                <c:pt idx="113">
                  <c:v>6720.123046875</c:v>
                </c:pt>
                <c:pt idx="114">
                  <c:v>6723.04052734375</c:v>
                </c:pt>
                <c:pt idx="115">
                  <c:v>6724.98388671875</c:v>
                </c:pt>
                <c:pt idx="116">
                  <c:v>6740.6083984375</c:v>
                </c:pt>
                <c:pt idx="117">
                  <c:v>6791.41796875</c:v>
                </c:pt>
                <c:pt idx="118">
                  <c:v>6876.39990234375</c:v>
                </c:pt>
                <c:pt idx="119">
                  <c:v>6958.412109375</c:v>
                </c:pt>
                <c:pt idx="120">
                  <c:v>6983.064453125</c:v>
                </c:pt>
                <c:pt idx="121">
                  <c:v>6918.72412109375</c:v>
                </c:pt>
                <c:pt idx="122">
                  <c:v>6785.79345703125</c:v>
                </c:pt>
                <c:pt idx="123">
                  <c:v>6649.1396484375</c:v>
                </c:pt>
                <c:pt idx="124">
                  <c:v>6576.17529296875</c:v>
                </c:pt>
                <c:pt idx="125">
                  <c:v>6591.37841796875</c:v>
                </c:pt>
                <c:pt idx="126">
                  <c:v>6662.12939453125</c:v>
                </c:pt>
                <c:pt idx="127">
                  <c:v>6726.5185546875</c:v>
                </c:pt>
                <c:pt idx="128">
                  <c:v>6740.830078125</c:v>
                </c:pt>
                <c:pt idx="129">
                  <c:v>6709.6328125</c:v>
                </c:pt>
                <c:pt idx="130">
                  <c:v>6676.65234375</c:v>
                </c:pt>
                <c:pt idx="131">
                  <c:v>6686.5712890625</c:v>
                </c:pt>
                <c:pt idx="132">
                  <c:v>6750.01708984375</c:v>
                </c:pt>
                <c:pt idx="133">
                  <c:v>6838.619140625</c:v>
                </c:pt>
                <c:pt idx="134">
                  <c:v>6910.34130859375</c:v>
                </c:pt>
                <c:pt idx="135">
                  <c:v>6940.88330078125</c:v>
                </c:pt>
                <c:pt idx="136">
                  <c:v>6935.13671875</c:v>
                </c:pt>
                <c:pt idx="137">
                  <c:v>6913.1328125</c:v>
                </c:pt>
                <c:pt idx="138">
                  <c:v>6887.98486328125</c:v>
                </c:pt>
                <c:pt idx="139">
                  <c:v>6858.16357421875</c:v>
                </c:pt>
                <c:pt idx="140">
                  <c:v>6819.787109375</c:v>
                </c:pt>
                <c:pt idx="141">
                  <c:v>6783.158203125</c:v>
                </c:pt>
                <c:pt idx="142">
                  <c:v>6772.513671875</c:v>
                </c:pt>
                <c:pt idx="143">
                  <c:v>6804.5361328125</c:v>
                </c:pt>
                <c:pt idx="144">
                  <c:v>6864.25341796875</c:v>
                </c:pt>
                <c:pt idx="145">
                  <c:v>6904.11865234375</c:v>
                </c:pt>
                <c:pt idx="146">
                  <c:v>6874.43896484375</c:v>
                </c:pt>
                <c:pt idx="147">
                  <c:v>6764.86767578125</c:v>
                </c:pt>
                <c:pt idx="148">
                  <c:v>6622.69580078125</c:v>
                </c:pt>
                <c:pt idx="149">
                  <c:v>6528.48974609375</c:v>
                </c:pt>
                <c:pt idx="150">
                  <c:v>6542.96044921875</c:v>
                </c:pt>
                <c:pt idx="151">
                  <c:v>6663.67236328125</c:v>
                </c:pt>
                <c:pt idx="152">
                  <c:v>6824.86181640625</c:v>
                </c:pt>
                <c:pt idx="153">
                  <c:v>6941.41845703125</c:v>
                </c:pt>
                <c:pt idx="154">
                  <c:v>6964.484375</c:v>
                </c:pt>
                <c:pt idx="155">
                  <c:v>6908.12451171875</c:v>
                </c:pt>
                <c:pt idx="156">
                  <c:v>6830.142578125</c:v>
                </c:pt>
                <c:pt idx="157">
                  <c:v>6785.5068359375</c:v>
                </c:pt>
                <c:pt idx="158">
                  <c:v>6789.56884765625</c:v>
                </c:pt>
                <c:pt idx="159">
                  <c:v>6816.54736328125</c:v>
                </c:pt>
                <c:pt idx="160">
                  <c:v>6828.48828125</c:v>
                </c:pt>
                <c:pt idx="161">
                  <c:v>6807.08544921875</c:v>
                </c:pt>
                <c:pt idx="162">
                  <c:v>6763.13330078125</c:v>
                </c:pt>
                <c:pt idx="163">
                  <c:v>6721.00439453125</c:v>
                </c:pt>
                <c:pt idx="164">
                  <c:v>6696.91357421875</c:v>
                </c:pt>
                <c:pt idx="165">
                  <c:v>6691.4091796875</c:v>
                </c:pt>
                <c:pt idx="166">
                  <c:v>6699.36767578125</c:v>
                </c:pt>
                <c:pt idx="167">
                  <c:v>6722.59716796875</c:v>
                </c:pt>
                <c:pt idx="168">
                  <c:v>6768.65087890625</c:v>
                </c:pt>
                <c:pt idx="169">
                  <c:v>6835.56640625</c:v>
                </c:pt>
                <c:pt idx="170">
                  <c:v>6899.515625</c:v>
                </c:pt>
                <c:pt idx="171">
                  <c:v>6922.86962890625</c:v>
                </c:pt>
                <c:pt idx="172">
                  <c:v>6881.71533203125</c:v>
                </c:pt>
                <c:pt idx="173">
                  <c:v>6790.97119140625</c:v>
                </c:pt>
                <c:pt idx="174">
                  <c:v>6702.4306640625</c:v>
                </c:pt>
                <c:pt idx="175">
                  <c:v>6671.5146484375</c:v>
                </c:pt>
                <c:pt idx="176">
                  <c:v>6716.06103515625</c:v>
                </c:pt>
                <c:pt idx="177">
                  <c:v>6800.68896484375</c:v>
                </c:pt>
                <c:pt idx="178">
                  <c:v>6862.208984375</c:v>
                </c:pt>
                <c:pt idx="179">
                  <c:v>6858.384765625</c:v>
                </c:pt>
                <c:pt idx="180">
                  <c:v>6801.59716796875</c:v>
                </c:pt>
                <c:pt idx="181">
                  <c:v>6749.12255859375</c:v>
                </c:pt>
                <c:pt idx="182">
                  <c:v>6756.037109375</c:v>
                </c:pt>
                <c:pt idx="183">
                  <c:v>6827.74560546875</c:v>
                </c:pt>
                <c:pt idx="184">
                  <c:v>6910.9609375</c:v>
                </c:pt>
                <c:pt idx="185">
                  <c:v>6932.27685546875</c:v>
                </c:pt>
                <c:pt idx="186">
                  <c:v>6855.5400390625</c:v>
                </c:pt>
                <c:pt idx="187">
                  <c:v>6713.5673828125</c:v>
                </c:pt>
                <c:pt idx="188">
                  <c:v>6588.974609375</c:v>
                </c:pt>
                <c:pt idx="189">
                  <c:v>6557.8076171875</c:v>
                </c:pt>
                <c:pt idx="190">
                  <c:v>6637.66064453125</c:v>
                </c:pt>
                <c:pt idx="191">
                  <c:v>6777.65087890625</c:v>
                </c:pt>
                <c:pt idx="192">
                  <c:v>6895.462890625</c:v>
                </c:pt>
                <c:pt idx="193">
                  <c:v>6932.40869140625</c:v>
                </c:pt>
                <c:pt idx="194">
                  <c:v>6886.96142578125</c:v>
                </c:pt>
                <c:pt idx="195">
                  <c:v>6806.4541015625</c:v>
                </c:pt>
                <c:pt idx="196">
                  <c:v>6748.5244140625</c:v>
                </c:pt>
                <c:pt idx="197">
                  <c:v>6743.388671875</c:v>
                </c:pt>
                <c:pt idx="198">
                  <c:v>6782.24658203125</c:v>
                </c:pt>
                <c:pt idx="199">
                  <c:v>6833.87255859375</c:v>
                </c:pt>
                <c:pt idx="200">
                  <c:v>6870.82177734375</c:v>
                </c:pt>
                <c:pt idx="201">
                  <c:v>6883.94091796875</c:v>
                </c:pt>
                <c:pt idx="202">
                  <c:v>6878.03369140625</c:v>
                </c:pt>
                <c:pt idx="203">
                  <c:v>6858.46728515625</c:v>
                </c:pt>
                <c:pt idx="204">
                  <c:v>6823.97705078125</c:v>
                </c:pt>
                <c:pt idx="205">
                  <c:v>6772.18310546875</c:v>
                </c:pt>
                <c:pt idx="206">
                  <c:v>6710.84130859375</c:v>
                </c:pt>
                <c:pt idx="207">
                  <c:v>6661.94580078125</c:v>
                </c:pt>
                <c:pt idx="208">
                  <c:v>6652.052734375</c:v>
                </c:pt>
                <c:pt idx="209">
                  <c:v>6694.50634765625</c:v>
                </c:pt>
                <c:pt idx="210">
                  <c:v>6776.92919921875</c:v>
                </c:pt>
                <c:pt idx="211">
                  <c:v>6864.25</c:v>
                </c:pt>
                <c:pt idx="212">
                  <c:v>6916.53076171875</c:v>
                </c:pt>
                <c:pt idx="213">
                  <c:v>6910.5986328125</c:v>
                </c:pt>
                <c:pt idx="214">
                  <c:v>6852.18115234375</c:v>
                </c:pt>
                <c:pt idx="215">
                  <c:v>6771.70751953125</c:v>
                </c:pt>
                <c:pt idx="216">
                  <c:v>6707.001953125</c:v>
                </c:pt>
                <c:pt idx="217">
                  <c:v>6683.2763671875</c:v>
                </c:pt>
                <c:pt idx="218">
                  <c:v>6701.41845703125</c:v>
                </c:pt>
                <c:pt idx="219">
                  <c:v>6740.3310546875</c:v>
                </c:pt>
                <c:pt idx="220">
                  <c:v>6771.2646484375</c:v>
                </c:pt>
                <c:pt idx="221">
                  <c:v>6775.7578125</c:v>
                </c:pt>
                <c:pt idx="222">
                  <c:v>6756.7998046875</c:v>
                </c:pt>
                <c:pt idx="223">
                  <c:v>6736.404296875</c:v>
                </c:pt>
                <c:pt idx="224">
                  <c:v>6740.578125</c:v>
                </c:pt>
                <c:pt idx="225">
                  <c:v>6780.6943359375</c:v>
                </c:pt>
                <c:pt idx="226">
                  <c:v>6843.49755859375</c:v>
                </c:pt>
                <c:pt idx="227">
                  <c:v>6897.29736328125</c:v>
                </c:pt>
                <c:pt idx="228">
                  <c:v>6911.43896484375</c:v>
                </c:pt>
                <c:pt idx="229">
                  <c:v>6876.58154296875</c:v>
                </c:pt>
                <c:pt idx="230">
                  <c:v>6811.81494140625</c:v>
                </c:pt>
                <c:pt idx="231">
                  <c:v>6753.1845703125</c:v>
                </c:pt>
                <c:pt idx="232">
                  <c:v>6731.12548828125</c:v>
                </c:pt>
                <c:pt idx="233">
                  <c:v>6752.234375</c:v>
                </c:pt>
                <c:pt idx="234">
                  <c:v>6797.54638671875</c:v>
                </c:pt>
                <c:pt idx="235">
                  <c:v>6837.365234375</c:v>
                </c:pt>
                <c:pt idx="236">
                  <c:v>6850.99072265625</c:v>
                </c:pt>
                <c:pt idx="237">
                  <c:v>6837.2607421875</c:v>
                </c:pt>
                <c:pt idx="238">
                  <c:v>6810.115234375</c:v>
                </c:pt>
                <c:pt idx="239">
                  <c:v>6785.19189453125</c:v>
                </c:pt>
                <c:pt idx="240">
                  <c:v>6769.2431640625</c:v>
                </c:pt>
                <c:pt idx="241">
                  <c:v>6759.810546875</c:v>
                </c:pt>
                <c:pt idx="242">
                  <c:v>6752.7431640625</c:v>
                </c:pt>
                <c:pt idx="243">
                  <c:v>6748.74658203125</c:v>
                </c:pt>
                <c:pt idx="244">
                  <c:v>6752.4443359375</c:v>
                </c:pt>
                <c:pt idx="245">
                  <c:v>6765.6728515625</c:v>
                </c:pt>
                <c:pt idx="246">
                  <c:v>6782.775390625</c:v>
                </c:pt>
                <c:pt idx="247">
                  <c:v>6793.837890625</c:v>
                </c:pt>
                <c:pt idx="248">
                  <c:v>6793.78173828125</c:v>
                </c:pt>
                <c:pt idx="249">
                  <c:v>6788.7529296875</c:v>
                </c:pt>
                <c:pt idx="250">
                  <c:v>6792.6904296875</c:v>
                </c:pt>
                <c:pt idx="251">
                  <c:v>6815.47607421875</c:v>
                </c:pt>
                <c:pt idx="252">
                  <c:v>6852.16015625</c:v>
                </c:pt>
                <c:pt idx="253">
                  <c:v>6882.89697265625</c:v>
                </c:pt>
                <c:pt idx="254">
                  <c:v>6884.8994140625</c:v>
                </c:pt>
                <c:pt idx="255">
                  <c:v>6847.84716796875</c:v>
                </c:pt>
                <c:pt idx="256">
                  <c:v>6781.2626953125</c:v>
                </c:pt>
                <c:pt idx="257">
                  <c:v>6708.81591796875</c:v>
                </c:pt>
                <c:pt idx="258">
                  <c:v>6654.6767578125</c:v>
                </c:pt>
                <c:pt idx="259">
                  <c:v>6632.31005859375</c:v>
                </c:pt>
                <c:pt idx="260">
                  <c:v>6642.4658203125</c:v>
                </c:pt>
                <c:pt idx="261">
                  <c:v>6678.56689453125</c:v>
                </c:pt>
                <c:pt idx="262">
                  <c:v>6732.24072265625</c:v>
                </c:pt>
                <c:pt idx="263">
                  <c:v>6793.912109375</c:v>
                </c:pt>
                <c:pt idx="264">
                  <c:v>6850.353515625</c:v>
                </c:pt>
                <c:pt idx="265">
                  <c:v>6885.40673828125</c:v>
                </c:pt>
                <c:pt idx="266">
                  <c:v>6887.1826171875</c:v>
                </c:pt>
                <c:pt idx="267">
                  <c:v>6857.49951171875</c:v>
                </c:pt>
                <c:pt idx="268">
                  <c:v>6814.765625</c:v>
                </c:pt>
                <c:pt idx="269">
                  <c:v>6785.17724609375</c:v>
                </c:pt>
                <c:pt idx="270">
                  <c:v>6786.66552734375</c:v>
                </c:pt>
                <c:pt idx="271">
                  <c:v>6817.09423828125</c:v>
                </c:pt>
                <c:pt idx="272">
                  <c:v>6856.03173828125</c:v>
                </c:pt>
                <c:pt idx="273">
                  <c:v>6879.078125</c:v>
                </c:pt>
                <c:pt idx="274">
                  <c:v>6873.81982421875</c:v>
                </c:pt>
                <c:pt idx="275">
                  <c:v>6845.5</c:v>
                </c:pt>
                <c:pt idx="276">
                  <c:v>6809.4091796875</c:v>
                </c:pt>
                <c:pt idx="277">
                  <c:v>6778.017578125</c:v>
                </c:pt>
                <c:pt idx="278">
                  <c:v>6754.41162109375</c:v>
                </c:pt>
                <c:pt idx="279">
                  <c:v>6736.681640625</c:v>
                </c:pt>
                <c:pt idx="280">
                  <c:v>6727.0556640625</c:v>
                </c:pt>
                <c:pt idx="281">
                  <c:v>6734.81494140625</c:v>
                </c:pt>
                <c:pt idx="282">
                  <c:v>6768.0537109375</c:v>
                </c:pt>
                <c:pt idx="283">
                  <c:v>6820.8056640625</c:v>
                </c:pt>
                <c:pt idx="284">
                  <c:v>6868.43994140625</c:v>
                </c:pt>
                <c:pt idx="285">
                  <c:v>6878.9287109375</c:v>
                </c:pt>
                <c:pt idx="286">
                  <c:v>6834.3671875</c:v>
                </c:pt>
                <c:pt idx="287">
                  <c:v>6747.05224609375</c:v>
                </c:pt>
                <c:pt idx="288">
                  <c:v>6656.54931640625</c:v>
                </c:pt>
                <c:pt idx="289">
                  <c:v>6607.638671875</c:v>
                </c:pt>
                <c:pt idx="290">
                  <c:v>6623.40673828125</c:v>
                </c:pt>
                <c:pt idx="291">
                  <c:v>6691.7353515625</c:v>
                </c:pt>
                <c:pt idx="292">
                  <c:v>6773.98681640625</c:v>
                </c:pt>
                <c:pt idx="293">
                  <c:v>6829.1904296875</c:v>
                </c:pt>
                <c:pt idx="294">
                  <c:v>6837.26953125</c:v>
                </c:pt>
                <c:pt idx="295">
                  <c:v>6807.1982421875</c:v>
                </c:pt>
                <c:pt idx="296">
                  <c:v>6767.38427734375</c:v>
                </c:pt>
                <c:pt idx="297">
                  <c:v>6746.8427734375</c:v>
                </c:pt>
                <c:pt idx="298">
                  <c:v>6759.337890625</c:v>
                </c:pt>
                <c:pt idx="299">
                  <c:v>6798.22998046875</c:v>
                </c:pt>
                <c:pt idx="300">
                  <c:v>6842.337890625</c:v>
                </c:pt>
                <c:pt idx="301">
                  <c:v>6868.16357421875</c:v>
                </c:pt>
                <c:pt idx="302">
                  <c:v>6862.64013671875</c:v>
                </c:pt>
                <c:pt idx="303">
                  <c:v>6831.30029296875</c:v>
                </c:pt>
                <c:pt idx="304">
                  <c:v>6797.7529296875</c:v>
                </c:pt>
                <c:pt idx="305">
                  <c:v>6792.59765625</c:v>
                </c:pt>
                <c:pt idx="306">
                  <c:v>6834.89892578125</c:v>
                </c:pt>
                <c:pt idx="307">
                  <c:v>6915.72802734375</c:v>
                </c:pt>
                <c:pt idx="308">
                  <c:v>6995.81494140625</c:v>
                </c:pt>
                <c:pt idx="309">
                  <c:v>7023.365234375</c:v>
                </c:pt>
                <c:pt idx="310">
                  <c:v>6964.904296875</c:v>
                </c:pt>
                <c:pt idx="311">
                  <c:v>6830.36767578125</c:v>
                </c:pt>
                <c:pt idx="312">
                  <c:v>6673.75341796875</c:v>
                </c:pt>
                <c:pt idx="313">
                  <c:v>6565.1845703125</c:v>
                </c:pt>
                <c:pt idx="314">
                  <c:v>6550.322265625</c:v>
                </c:pt>
                <c:pt idx="315">
                  <c:v>6623.68994140625</c:v>
                </c:pt>
                <c:pt idx="316">
                  <c:v>6734.3076171875</c:v>
                </c:pt>
                <c:pt idx="317">
                  <c:v>6819.76611328125</c:v>
                </c:pt>
                <c:pt idx="318">
                  <c:v>6844.76708984375</c:v>
                </c:pt>
                <c:pt idx="319">
                  <c:v>6817.62548828125</c:v>
                </c:pt>
                <c:pt idx="320">
                  <c:v>6775.3623046875</c:v>
                </c:pt>
                <c:pt idx="321">
                  <c:v>6751.52197265625</c:v>
                </c:pt>
                <c:pt idx="322">
                  <c:v>6752.46337890625</c:v>
                </c:pt>
                <c:pt idx="323">
                  <c:v>6759.02197265625</c:v>
                </c:pt>
                <c:pt idx="324">
                  <c:v>6749.07763671875</c:v>
                </c:pt>
                <c:pt idx="325">
                  <c:v>6720.27294921875</c:v>
                </c:pt>
                <c:pt idx="326">
                  <c:v>6693.7314453125</c:v>
                </c:pt>
                <c:pt idx="327">
                  <c:v>6696.69091796875</c:v>
                </c:pt>
                <c:pt idx="328">
                  <c:v>6739.60693359375</c:v>
                </c:pt>
                <c:pt idx="329">
                  <c:v>6806.91796875</c:v>
                </c:pt>
                <c:pt idx="330">
                  <c:v>6868.18603515625</c:v>
                </c:pt>
                <c:pt idx="331">
                  <c:v>6899.25634765625</c:v>
                </c:pt>
                <c:pt idx="332">
                  <c:v>6895.96142578125</c:v>
                </c:pt>
                <c:pt idx="333">
                  <c:v>6870.96923828125</c:v>
                </c:pt>
                <c:pt idx="334">
                  <c:v>6839.50146484375</c:v>
                </c:pt>
                <c:pt idx="335">
                  <c:v>6808.1591796875</c:v>
                </c:pt>
                <c:pt idx="336">
                  <c:v>6776.123046875</c:v>
                </c:pt>
                <c:pt idx="337">
                  <c:v>6745.0380859375</c:v>
                </c:pt>
                <c:pt idx="338">
                  <c:v>6725.416015625</c:v>
                </c:pt>
                <c:pt idx="339">
                  <c:v>6731.20458984375</c:v>
                </c:pt>
                <c:pt idx="340">
                  <c:v>6766.44970703125</c:v>
                </c:pt>
                <c:pt idx="341">
                  <c:v>6816.92333984375</c:v>
                </c:pt>
                <c:pt idx="342">
                  <c:v>6856.43798828125</c:v>
                </c:pt>
                <c:pt idx="343">
                  <c:v>6864.6982421875</c:v>
                </c:pt>
                <c:pt idx="344">
                  <c:v>6842.47705078125</c:v>
                </c:pt>
                <c:pt idx="345">
                  <c:v>6810.97509765625</c:v>
                </c:pt>
                <c:pt idx="346">
                  <c:v>6795.0654296875</c:v>
                </c:pt>
                <c:pt idx="347">
                  <c:v>6803.81396484375</c:v>
                </c:pt>
                <c:pt idx="348">
                  <c:v>6824.2353515625</c:v>
                </c:pt>
                <c:pt idx="349">
                  <c:v>6833.2373046875</c:v>
                </c:pt>
              </c:numCache>
            </c:numRef>
          </c:yVal>
          <c:smooth val="1"/>
          <c:extLst>
            <c:ext xmlns:c16="http://schemas.microsoft.com/office/drawing/2014/chart" uri="{C3380CC4-5D6E-409C-BE32-E72D297353CC}">
              <c16:uniqueId val="{00000015-0DDB-41B5-BE83-A9CFE49F3CE3}"/>
            </c:ext>
          </c:extLst>
        </c:ser>
        <c:ser>
          <c:idx val="22"/>
          <c:order val="22"/>
          <c:tx>
            <c:strRef>
              <c:f>hc_sub_007!$W$1</c:f>
              <c:strCache>
                <c:ptCount val="1"/>
                <c:pt idx="0">
                  <c:v>Coor_23</c:v>
                </c:pt>
              </c:strCache>
            </c:strRef>
          </c:tx>
          <c:spPr>
            <a:ln w="28575" cap="rnd">
              <a:solidFill>
                <a:schemeClr val="accent5">
                  <a:lumMod val="80000"/>
                </a:schemeClr>
              </a:solidFill>
              <a:round/>
            </a:ln>
            <a:effectLst/>
          </c:spPr>
          <c:marker>
            <c:symbol val="none"/>
          </c:marker>
          <c:yVal>
            <c:numRef>
              <c:f>hc_sub_007!$W$2:$W$351</c:f>
              <c:numCache>
                <c:formatCode>0.00000000000_ </c:formatCode>
                <c:ptCount val="350"/>
                <c:pt idx="0">
                  <c:v>7151.16455078125</c:v>
                </c:pt>
                <c:pt idx="1">
                  <c:v>7170.419921875</c:v>
                </c:pt>
                <c:pt idx="2">
                  <c:v>7215.5107421875</c:v>
                </c:pt>
                <c:pt idx="3">
                  <c:v>7259.8759765625</c:v>
                </c:pt>
                <c:pt idx="4">
                  <c:v>7273.19677734375</c:v>
                </c:pt>
                <c:pt idx="5">
                  <c:v>7241.61572265625</c:v>
                </c:pt>
                <c:pt idx="6">
                  <c:v>7180.22314453125</c:v>
                </c:pt>
                <c:pt idx="7">
                  <c:v>7127.66943359375</c:v>
                </c:pt>
                <c:pt idx="8">
                  <c:v>7123.71240234375</c:v>
                </c:pt>
                <c:pt idx="9">
                  <c:v>7182.81005859375</c:v>
                </c:pt>
                <c:pt idx="10">
                  <c:v>7281.53955078125</c:v>
                </c:pt>
                <c:pt idx="11">
                  <c:v>7370.14453125</c:v>
                </c:pt>
                <c:pt idx="12">
                  <c:v>7402.64013671875</c:v>
                </c:pt>
                <c:pt idx="13">
                  <c:v>7366.3134765625</c:v>
                </c:pt>
                <c:pt idx="14">
                  <c:v>7290.34912109375</c:v>
                </c:pt>
                <c:pt idx="15">
                  <c:v>7226.65087890625</c:v>
                </c:pt>
                <c:pt idx="16">
                  <c:v>7215.06298828125</c:v>
                </c:pt>
                <c:pt idx="17">
                  <c:v>7256.58056640625</c:v>
                </c:pt>
                <c:pt idx="18">
                  <c:v>7313.123046875</c:v>
                </c:pt>
                <c:pt idx="19">
                  <c:v>7334.10791015625</c:v>
                </c:pt>
                <c:pt idx="20">
                  <c:v>7291.41015625</c:v>
                </c:pt>
                <c:pt idx="21">
                  <c:v>7198.669921875</c:v>
                </c:pt>
                <c:pt idx="22">
                  <c:v>7102.314453125</c:v>
                </c:pt>
                <c:pt idx="23">
                  <c:v>7051.4814453125</c:v>
                </c:pt>
                <c:pt idx="24">
                  <c:v>7067.94970703125</c:v>
                </c:pt>
                <c:pt idx="25">
                  <c:v>7135.65869140625</c:v>
                </c:pt>
                <c:pt idx="26">
                  <c:v>7214.59619140625</c:v>
                </c:pt>
                <c:pt idx="27">
                  <c:v>7267.29931640625</c:v>
                </c:pt>
                <c:pt idx="28">
                  <c:v>7279.599609375</c:v>
                </c:pt>
                <c:pt idx="29">
                  <c:v>7263.82373046875</c:v>
                </c:pt>
                <c:pt idx="30">
                  <c:v>7245.8671875</c:v>
                </c:pt>
                <c:pt idx="31">
                  <c:v>7247.21435546875</c:v>
                </c:pt>
                <c:pt idx="32">
                  <c:v>7273.28759765625</c:v>
                </c:pt>
                <c:pt idx="33">
                  <c:v>7312.642578125</c:v>
                </c:pt>
                <c:pt idx="34">
                  <c:v>7344.3037109375</c:v>
                </c:pt>
                <c:pt idx="35">
                  <c:v>7347.8056640625</c:v>
                </c:pt>
                <c:pt idx="36">
                  <c:v>7312.091796875</c:v>
                </c:pt>
                <c:pt idx="37">
                  <c:v>7241.41357421875</c:v>
                </c:pt>
                <c:pt idx="38">
                  <c:v>7156.439453125</c:v>
                </c:pt>
                <c:pt idx="39">
                  <c:v>7088.24462890625</c:v>
                </c:pt>
                <c:pt idx="40">
                  <c:v>7064.96630859375</c:v>
                </c:pt>
                <c:pt idx="41">
                  <c:v>7096.1826171875</c:v>
                </c:pt>
                <c:pt idx="42">
                  <c:v>7164.5224609375</c:v>
                </c:pt>
                <c:pt idx="43">
                  <c:v>7232.3486328125</c:v>
                </c:pt>
                <c:pt idx="44">
                  <c:v>7262.40087890625</c:v>
                </c:pt>
                <c:pt idx="45">
                  <c:v>7240.65283203125</c:v>
                </c:pt>
                <c:pt idx="46">
                  <c:v>7185.955078125</c:v>
                </c:pt>
                <c:pt idx="47">
                  <c:v>7138.6630859375</c:v>
                </c:pt>
                <c:pt idx="48">
                  <c:v>7134.9345703125</c:v>
                </c:pt>
                <c:pt idx="49">
                  <c:v>7183.94287109375</c:v>
                </c:pt>
                <c:pt idx="50">
                  <c:v>7263.49755859375</c:v>
                </c:pt>
                <c:pt idx="51">
                  <c:v>7336.25537109375</c:v>
                </c:pt>
                <c:pt idx="52">
                  <c:v>7374.00634765625</c:v>
                </c:pt>
                <c:pt idx="53">
                  <c:v>7372.634765625</c:v>
                </c:pt>
                <c:pt idx="54">
                  <c:v>7348.68994140625</c:v>
                </c:pt>
                <c:pt idx="55">
                  <c:v>7322.93310546875</c:v>
                </c:pt>
                <c:pt idx="56">
                  <c:v>7305.11474609375</c:v>
                </c:pt>
                <c:pt idx="57">
                  <c:v>7291.087890625</c:v>
                </c:pt>
                <c:pt idx="58">
                  <c:v>7271.92822265625</c:v>
                </c:pt>
                <c:pt idx="59">
                  <c:v>7245.11767578125</c:v>
                </c:pt>
                <c:pt idx="60">
                  <c:v>7217.79638671875</c:v>
                </c:pt>
                <c:pt idx="61">
                  <c:v>7200.484375</c:v>
                </c:pt>
                <c:pt idx="62">
                  <c:v>7198.2744140625</c:v>
                </c:pt>
                <c:pt idx="63">
                  <c:v>7207.7001953125</c:v>
                </c:pt>
                <c:pt idx="64">
                  <c:v>7221.06201171875</c:v>
                </c:pt>
                <c:pt idx="65">
                  <c:v>7232.703125</c:v>
                </c:pt>
                <c:pt idx="66">
                  <c:v>7240.6728515625</c:v>
                </c:pt>
                <c:pt idx="67">
                  <c:v>7243</c:v>
                </c:pt>
                <c:pt idx="68">
                  <c:v>7234.2197265625</c:v>
                </c:pt>
                <c:pt idx="69">
                  <c:v>7208.0244140625</c:v>
                </c:pt>
                <c:pt idx="70">
                  <c:v>7165.29150390625</c:v>
                </c:pt>
                <c:pt idx="71">
                  <c:v>7119.80615234375</c:v>
                </c:pt>
                <c:pt idx="72">
                  <c:v>7094.09619140625</c:v>
                </c:pt>
                <c:pt idx="73">
                  <c:v>7105.9560546875</c:v>
                </c:pt>
                <c:pt idx="74">
                  <c:v>7155.37744140625</c:v>
                </c:pt>
                <c:pt idx="75">
                  <c:v>7222.94775390625</c:v>
                </c:pt>
                <c:pt idx="76">
                  <c:v>7282.06201171875</c:v>
                </c:pt>
                <c:pt idx="77">
                  <c:v>7315.681640625</c:v>
                </c:pt>
                <c:pt idx="78">
                  <c:v>7324.24658203125</c:v>
                </c:pt>
                <c:pt idx="79">
                  <c:v>7318.9638671875</c:v>
                </c:pt>
                <c:pt idx="80">
                  <c:v>7307.64013671875</c:v>
                </c:pt>
                <c:pt idx="81">
                  <c:v>7286.87109375</c:v>
                </c:pt>
                <c:pt idx="82">
                  <c:v>7248.271484375</c:v>
                </c:pt>
                <c:pt idx="83">
                  <c:v>7192.7744140625</c:v>
                </c:pt>
                <c:pt idx="84">
                  <c:v>7138.31982421875</c:v>
                </c:pt>
                <c:pt idx="85">
                  <c:v>7111.21826171875</c:v>
                </c:pt>
                <c:pt idx="86">
                  <c:v>7126.47119140625</c:v>
                </c:pt>
                <c:pt idx="87">
                  <c:v>7173.8623046875</c:v>
                </c:pt>
                <c:pt idx="88">
                  <c:v>7223.51953125</c:v>
                </c:pt>
                <c:pt idx="89">
                  <c:v>7248.29541015625</c:v>
                </c:pt>
                <c:pt idx="90">
                  <c:v>7244.802734375</c:v>
                </c:pt>
                <c:pt idx="91">
                  <c:v>7234.61083984375</c:v>
                </c:pt>
                <c:pt idx="92">
                  <c:v>7243.60888671875</c:v>
                </c:pt>
                <c:pt idx="93">
                  <c:v>7277.09521484375</c:v>
                </c:pt>
                <c:pt idx="94">
                  <c:v>7313.16943359375</c:v>
                </c:pt>
                <c:pt idx="95">
                  <c:v>7321.77783203125</c:v>
                </c:pt>
                <c:pt idx="96">
                  <c:v>7293.63330078125</c:v>
                </c:pt>
                <c:pt idx="97">
                  <c:v>7252.67529296875</c:v>
                </c:pt>
                <c:pt idx="98">
                  <c:v>7238.43994140625</c:v>
                </c:pt>
                <c:pt idx="99">
                  <c:v>7271.10595703125</c:v>
                </c:pt>
                <c:pt idx="100">
                  <c:v>7329.30126953125</c:v>
                </c:pt>
                <c:pt idx="101">
                  <c:v>7362.5771484375</c:v>
                </c:pt>
                <c:pt idx="102">
                  <c:v>7331.7314453125</c:v>
                </c:pt>
                <c:pt idx="103">
                  <c:v>7244.6572265625</c:v>
                </c:pt>
                <c:pt idx="104">
                  <c:v>7155.9189453125</c:v>
                </c:pt>
                <c:pt idx="105">
                  <c:v>7126.56689453125</c:v>
                </c:pt>
                <c:pt idx="106">
                  <c:v>7174.537109375</c:v>
                </c:pt>
                <c:pt idx="107">
                  <c:v>7256.6123046875</c:v>
                </c:pt>
                <c:pt idx="108">
                  <c:v>7299.59716796875</c:v>
                </c:pt>
                <c:pt idx="109">
                  <c:v>7258.58203125</c:v>
                </c:pt>
                <c:pt idx="110">
                  <c:v>7156.2783203125</c:v>
                </c:pt>
                <c:pt idx="111">
                  <c:v>7070.17724609375</c:v>
                </c:pt>
                <c:pt idx="112">
                  <c:v>7074.84716796875</c:v>
                </c:pt>
                <c:pt idx="113">
                  <c:v>7183.03076171875</c:v>
                </c:pt>
                <c:pt idx="114">
                  <c:v>7331.63427734375</c:v>
                </c:pt>
                <c:pt idx="115">
                  <c:v>7424.61865234375</c:v>
                </c:pt>
                <c:pt idx="116">
                  <c:v>7400.86572265625</c:v>
                </c:pt>
                <c:pt idx="117">
                  <c:v>7276.099609375</c:v>
                </c:pt>
                <c:pt idx="118">
                  <c:v>7128.57568359375</c:v>
                </c:pt>
                <c:pt idx="119">
                  <c:v>7041.57568359375</c:v>
                </c:pt>
                <c:pt idx="120">
                  <c:v>7047.30908203125</c:v>
                </c:pt>
                <c:pt idx="121">
                  <c:v>7112.765625</c:v>
                </c:pt>
                <c:pt idx="122">
                  <c:v>7173.455078125</c:v>
                </c:pt>
                <c:pt idx="123">
                  <c:v>7184.75537109375</c:v>
                </c:pt>
                <c:pt idx="124">
                  <c:v>7150.86083984375</c:v>
                </c:pt>
                <c:pt idx="125">
                  <c:v>7113.24462890625</c:v>
                </c:pt>
                <c:pt idx="126">
                  <c:v>7113.72265625</c:v>
                </c:pt>
                <c:pt idx="127">
                  <c:v>7164.2294921875</c:v>
                </c:pt>
                <c:pt idx="128">
                  <c:v>7244.69677734375</c:v>
                </c:pt>
                <c:pt idx="129">
                  <c:v>7324.30859375</c:v>
                </c:pt>
                <c:pt idx="130">
                  <c:v>7383.53564453125</c:v>
                </c:pt>
                <c:pt idx="131">
                  <c:v>7418.73583984375</c:v>
                </c:pt>
                <c:pt idx="132">
                  <c:v>7430.9248046875</c:v>
                </c:pt>
                <c:pt idx="133">
                  <c:v>7415.63720703125</c:v>
                </c:pt>
                <c:pt idx="134">
                  <c:v>7367.5107421875</c:v>
                </c:pt>
                <c:pt idx="135">
                  <c:v>7295.46826171875</c:v>
                </c:pt>
                <c:pt idx="136">
                  <c:v>7230.2841796875</c:v>
                </c:pt>
                <c:pt idx="137">
                  <c:v>7210.56982421875</c:v>
                </c:pt>
                <c:pt idx="138">
                  <c:v>7253.26708984375</c:v>
                </c:pt>
                <c:pt idx="139">
                  <c:v>7332.47021484375</c:v>
                </c:pt>
                <c:pt idx="140">
                  <c:v>7388.3603515625</c:v>
                </c:pt>
                <c:pt idx="141">
                  <c:v>7365.5625</c:v>
                </c:pt>
                <c:pt idx="142">
                  <c:v>7254.98828125</c:v>
                </c:pt>
                <c:pt idx="143">
                  <c:v>7106.8779296875</c:v>
                </c:pt>
                <c:pt idx="144">
                  <c:v>7002.14111328125</c:v>
                </c:pt>
                <c:pt idx="145">
                  <c:v>7000.07421875</c:v>
                </c:pt>
                <c:pt idx="146">
                  <c:v>7098.95458984375</c:v>
                </c:pt>
                <c:pt idx="147">
                  <c:v>7237.27587890625</c:v>
                </c:pt>
                <c:pt idx="148">
                  <c:v>7334.17919921875</c:v>
                </c:pt>
                <c:pt idx="149">
                  <c:v>7340.27490234375</c:v>
                </c:pt>
                <c:pt idx="150">
                  <c:v>7264.5673828125</c:v>
                </c:pt>
                <c:pt idx="151">
                  <c:v>7162.19580078125</c:v>
                </c:pt>
                <c:pt idx="152">
                  <c:v>7095.42529296875</c:v>
                </c:pt>
                <c:pt idx="153">
                  <c:v>7096.2197265625</c:v>
                </c:pt>
                <c:pt idx="154">
                  <c:v>7153.26025390625</c:v>
                </c:pt>
                <c:pt idx="155">
                  <c:v>7226.59814453125</c:v>
                </c:pt>
                <c:pt idx="156">
                  <c:v>7275.30517578125</c:v>
                </c:pt>
                <c:pt idx="157">
                  <c:v>7279.22021484375</c:v>
                </c:pt>
                <c:pt idx="158">
                  <c:v>7244.59423828125</c:v>
                </c:pt>
                <c:pt idx="159">
                  <c:v>7195.591796875</c:v>
                </c:pt>
                <c:pt idx="160">
                  <c:v>7160.08251953125</c:v>
                </c:pt>
                <c:pt idx="161">
                  <c:v>7157.11669921875</c:v>
                </c:pt>
                <c:pt idx="162">
                  <c:v>7189.50439453125</c:v>
                </c:pt>
                <c:pt idx="163">
                  <c:v>7242.669921875</c:v>
                </c:pt>
                <c:pt idx="164">
                  <c:v>7290.62744140625</c:v>
                </c:pt>
                <c:pt idx="165">
                  <c:v>7308.44140625</c:v>
                </c:pt>
                <c:pt idx="166">
                  <c:v>7286.4189453125</c:v>
                </c:pt>
                <c:pt idx="167">
                  <c:v>7237.6376953125</c:v>
                </c:pt>
                <c:pt idx="168">
                  <c:v>7192.126953125</c:v>
                </c:pt>
                <c:pt idx="169">
                  <c:v>7179.208984375</c:v>
                </c:pt>
                <c:pt idx="170">
                  <c:v>7208.82861328125</c:v>
                </c:pt>
                <c:pt idx="171">
                  <c:v>7265.12158203125</c:v>
                </c:pt>
                <c:pt idx="172">
                  <c:v>7317.5419921875</c:v>
                </c:pt>
                <c:pt idx="173">
                  <c:v>7341.83154296875</c:v>
                </c:pt>
                <c:pt idx="174">
                  <c:v>7335.2802734375</c:v>
                </c:pt>
                <c:pt idx="175">
                  <c:v>7314.9873046875</c:v>
                </c:pt>
                <c:pt idx="176">
                  <c:v>7301.30810546875</c:v>
                </c:pt>
                <c:pt idx="177">
                  <c:v>7300.4560546875</c:v>
                </c:pt>
                <c:pt idx="178">
                  <c:v>7300.6064453125</c:v>
                </c:pt>
                <c:pt idx="179">
                  <c:v>7284.3095703125</c:v>
                </c:pt>
                <c:pt idx="180">
                  <c:v>7246.19140625</c:v>
                </c:pt>
                <c:pt idx="181">
                  <c:v>7200.39208984375</c:v>
                </c:pt>
                <c:pt idx="182">
                  <c:v>7170.822265625</c:v>
                </c:pt>
                <c:pt idx="183">
                  <c:v>7171.8818359375</c:v>
                </c:pt>
                <c:pt idx="184">
                  <c:v>7195.591796875</c:v>
                </c:pt>
                <c:pt idx="185">
                  <c:v>7216.2119140625</c:v>
                </c:pt>
                <c:pt idx="186">
                  <c:v>7209.33447265625</c:v>
                </c:pt>
                <c:pt idx="187">
                  <c:v>7170.78271484375</c:v>
                </c:pt>
                <c:pt idx="188">
                  <c:v>7120.69970703125</c:v>
                </c:pt>
                <c:pt idx="189">
                  <c:v>7089.7880859375</c:v>
                </c:pt>
                <c:pt idx="190">
                  <c:v>7098.2080078125</c:v>
                </c:pt>
                <c:pt idx="191">
                  <c:v>7142.65771484375</c:v>
                </c:pt>
                <c:pt idx="192">
                  <c:v>7200.271484375</c:v>
                </c:pt>
                <c:pt idx="193">
                  <c:v>7245.19775390625</c:v>
                </c:pt>
                <c:pt idx="194">
                  <c:v>7265.109375</c:v>
                </c:pt>
                <c:pt idx="195">
                  <c:v>7266.31103515625</c:v>
                </c:pt>
                <c:pt idx="196">
                  <c:v>7265.4423828125</c:v>
                </c:pt>
                <c:pt idx="197">
                  <c:v>7275.33203125</c:v>
                </c:pt>
                <c:pt idx="198">
                  <c:v>7295.62646484375</c:v>
                </c:pt>
                <c:pt idx="199">
                  <c:v>7314.15673828125</c:v>
                </c:pt>
                <c:pt idx="200">
                  <c:v>7317.02392578125</c:v>
                </c:pt>
                <c:pt idx="201">
                  <c:v>7299.7236328125</c:v>
                </c:pt>
                <c:pt idx="202">
                  <c:v>7271.5830078125</c:v>
                </c:pt>
                <c:pt idx="203">
                  <c:v>7250.44482421875</c:v>
                </c:pt>
                <c:pt idx="204">
                  <c:v>7250.73974609375</c:v>
                </c:pt>
                <c:pt idx="205">
                  <c:v>7272.33837890625</c:v>
                </c:pt>
                <c:pt idx="206">
                  <c:v>7297.69775390625</c:v>
                </c:pt>
                <c:pt idx="207">
                  <c:v>7300.525390625</c:v>
                </c:pt>
                <c:pt idx="208">
                  <c:v>7262.2216796875</c:v>
                </c:pt>
                <c:pt idx="209">
                  <c:v>7186.46435546875</c:v>
                </c:pt>
                <c:pt idx="210">
                  <c:v>7101.65087890625</c:v>
                </c:pt>
                <c:pt idx="211">
                  <c:v>7047.3330078125</c:v>
                </c:pt>
                <c:pt idx="212">
                  <c:v>7051.359375</c:v>
                </c:pt>
                <c:pt idx="213">
                  <c:v>7112.16357421875</c:v>
                </c:pt>
                <c:pt idx="214">
                  <c:v>7198.9345703125</c:v>
                </c:pt>
                <c:pt idx="215">
                  <c:v>7270.89697265625</c:v>
                </c:pt>
                <c:pt idx="216">
                  <c:v>7302.97998046875</c:v>
                </c:pt>
                <c:pt idx="217">
                  <c:v>7299.54248046875</c:v>
                </c:pt>
                <c:pt idx="218">
                  <c:v>7285.994140625</c:v>
                </c:pt>
                <c:pt idx="219">
                  <c:v>7284.97412109375</c:v>
                </c:pt>
                <c:pt idx="220">
                  <c:v>7296.3095703125</c:v>
                </c:pt>
                <c:pt idx="221">
                  <c:v>7297.59814453125</c:v>
                </c:pt>
                <c:pt idx="222">
                  <c:v>7265.74560546875</c:v>
                </c:pt>
                <c:pt idx="223">
                  <c:v>7201.9375</c:v>
                </c:pt>
                <c:pt idx="224">
                  <c:v>7138.2373046875</c:v>
                </c:pt>
                <c:pt idx="225">
                  <c:v>7117.908203125</c:v>
                </c:pt>
                <c:pt idx="226">
                  <c:v>7163.11181640625</c:v>
                </c:pt>
                <c:pt idx="227">
                  <c:v>7255.26220703125</c:v>
                </c:pt>
                <c:pt idx="228">
                  <c:v>7344.66455078125</c:v>
                </c:pt>
                <c:pt idx="229">
                  <c:v>7383.31201171875</c:v>
                </c:pt>
                <c:pt idx="230">
                  <c:v>7356.21728515625</c:v>
                </c:pt>
                <c:pt idx="231">
                  <c:v>7287.70556640625</c:v>
                </c:pt>
                <c:pt idx="232">
                  <c:v>7219.24072265625</c:v>
                </c:pt>
                <c:pt idx="233">
                  <c:v>7178.0380859375</c:v>
                </c:pt>
                <c:pt idx="234">
                  <c:v>7162.091796875</c:v>
                </c:pt>
                <c:pt idx="235">
                  <c:v>7152.1318359375</c:v>
                </c:pt>
                <c:pt idx="236">
                  <c:v>7137.427734375</c:v>
                </c:pt>
                <c:pt idx="237">
                  <c:v>7130.64208984375</c:v>
                </c:pt>
                <c:pt idx="238">
                  <c:v>7157.25439453125</c:v>
                </c:pt>
                <c:pt idx="239">
                  <c:v>7228.4951171875</c:v>
                </c:pt>
                <c:pt idx="240">
                  <c:v>7322.65673828125</c:v>
                </c:pt>
                <c:pt idx="241">
                  <c:v>7393.720703125</c:v>
                </c:pt>
                <c:pt idx="242">
                  <c:v>7402.92724609375</c:v>
                </c:pt>
                <c:pt idx="243">
                  <c:v>7348.23291015625</c:v>
                </c:pt>
                <c:pt idx="244">
                  <c:v>7266.77734375</c:v>
                </c:pt>
                <c:pt idx="245">
                  <c:v>7207.19677734375</c:v>
                </c:pt>
                <c:pt idx="246">
                  <c:v>7193.6953125</c:v>
                </c:pt>
                <c:pt idx="247">
                  <c:v>7210.86328125</c:v>
                </c:pt>
                <c:pt idx="248">
                  <c:v>7220.890625</c:v>
                </c:pt>
                <c:pt idx="249">
                  <c:v>7197.7236328125</c:v>
                </c:pt>
                <c:pt idx="250">
                  <c:v>7148.9111328125</c:v>
                </c:pt>
                <c:pt idx="251">
                  <c:v>7107.21337890625</c:v>
                </c:pt>
                <c:pt idx="252">
                  <c:v>7100.5849609375</c:v>
                </c:pt>
                <c:pt idx="253">
                  <c:v>7127.8193359375</c:v>
                </c:pt>
                <c:pt idx="254">
                  <c:v>7161.61279296875</c:v>
                </c:pt>
                <c:pt idx="255">
                  <c:v>7175.92919921875</c:v>
                </c:pt>
                <c:pt idx="256">
                  <c:v>7172.26708984375</c:v>
                </c:pt>
                <c:pt idx="257">
                  <c:v>7179.74462890625</c:v>
                </c:pt>
                <c:pt idx="258">
                  <c:v>7227.142578125</c:v>
                </c:pt>
                <c:pt idx="259">
                  <c:v>7311.0810546875</c:v>
                </c:pt>
                <c:pt idx="260">
                  <c:v>7390.060546875</c:v>
                </c:pt>
                <c:pt idx="261">
                  <c:v>7413.10986328125</c:v>
                </c:pt>
                <c:pt idx="262">
                  <c:v>7361.4873046875</c:v>
                </c:pt>
                <c:pt idx="263">
                  <c:v>7268.43603515625</c:v>
                </c:pt>
                <c:pt idx="264">
                  <c:v>7198.0361328125</c:v>
                </c:pt>
                <c:pt idx="265">
                  <c:v>7197.51025390625</c:v>
                </c:pt>
                <c:pt idx="266">
                  <c:v>7260.2919921875</c:v>
                </c:pt>
                <c:pt idx="267">
                  <c:v>7330.0439453125</c:v>
                </c:pt>
                <c:pt idx="268">
                  <c:v>7343.61181640625</c:v>
                </c:pt>
                <c:pt idx="269">
                  <c:v>7279.60498046875</c:v>
                </c:pt>
                <c:pt idx="270">
                  <c:v>7174.6298828125</c:v>
                </c:pt>
                <c:pt idx="271">
                  <c:v>7095.025390625</c:v>
                </c:pt>
                <c:pt idx="272">
                  <c:v>7087.21044921875</c:v>
                </c:pt>
                <c:pt idx="273">
                  <c:v>7145.798828125</c:v>
                </c:pt>
                <c:pt idx="274">
                  <c:v>7223.01318359375</c:v>
                </c:pt>
                <c:pt idx="275">
                  <c:v>7269.14453125</c:v>
                </c:pt>
                <c:pt idx="276">
                  <c:v>7269.86865234375</c:v>
                </c:pt>
                <c:pt idx="277">
                  <c:v>7251.1103515625</c:v>
                </c:pt>
                <c:pt idx="278">
                  <c:v>7250.51806640625</c:v>
                </c:pt>
                <c:pt idx="279">
                  <c:v>7282.0888671875</c:v>
                </c:pt>
                <c:pt idx="280">
                  <c:v>7324.40380859375</c:v>
                </c:pt>
                <c:pt idx="281">
                  <c:v>7341.169921875</c:v>
                </c:pt>
                <c:pt idx="282">
                  <c:v>7314.6826171875</c:v>
                </c:pt>
                <c:pt idx="283">
                  <c:v>7262.32861328125</c:v>
                </c:pt>
                <c:pt idx="284">
                  <c:v>7221.68994140625</c:v>
                </c:pt>
                <c:pt idx="285">
                  <c:v>7217.283203125</c:v>
                </c:pt>
                <c:pt idx="286">
                  <c:v>7237.94091796875</c:v>
                </c:pt>
                <c:pt idx="287">
                  <c:v>7244.87060546875</c:v>
                </c:pt>
                <c:pt idx="288">
                  <c:v>7204.501953125</c:v>
                </c:pt>
                <c:pt idx="289">
                  <c:v>7119.23291015625</c:v>
                </c:pt>
                <c:pt idx="290">
                  <c:v>7030.52685546875</c:v>
                </c:pt>
                <c:pt idx="291">
                  <c:v>6991.06494140625</c:v>
                </c:pt>
                <c:pt idx="292">
                  <c:v>7027.27294921875</c:v>
                </c:pt>
                <c:pt idx="293">
                  <c:v>7120.74609375</c:v>
                </c:pt>
                <c:pt idx="294">
                  <c:v>7221.79541015625</c:v>
                </c:pt>
                <c:pt idx="295">
                  <c:v>7283.66064453125</c:v>
                </c:pt>
                <c:pt idx="296">
                  <c:v>7291.56298828125</c:v>
                </c:pt>
                <c:pt idx="297">
                  <c:v>7266.9111328125</c:v>
                </c:pt>
                <c:pt idx="298">
                  <c:v>7247.04052734375</c:v>
                </c:pt>
                <c:pt idx="299">
                  <c:v>7258.125</c:v>
                </c:pt>
                <c:pt idx="300">
                  <c:v>7300.697265625</c:v>
                </c:pt>
                <c:pt idx="301">
                  <c:v>7354.578125</c:v>
                </c:pt>
                <c:pt idx="302">
                  <c:v>7394.92431640625</c:v>
                </c:pt>
                <c:pt idx="303">
                  <c:v>7405.69775390625</c:v>
                </c:pt>
                <c:pt idx="304">
                  <c:v>7383.22216796875</c:v>
                </c:pt>
                <c:pt idx="305">
                  <c:v>7332.748046875</c:v>
                </c:pt>
                <c:pt idx="306">
                  <c:v>7265.2470703125</c:v>
                </c:pt>
                <c:pt idx="307">
                  <c:v>7197.34814453125</c:v>
                </c:pt>
                <c:pt idx="308">
                  <c:v>7150.4296875</c:v>
                </c:pt>
                <c:pt idx="309">
                  <c:v>7143.4931640625</c:v>
                </c:pt>
                <c:pt idx="310">
                  <c:v>7180.79345703125</c:v>
                </c:pt>
                <c:pt idx="311">
                  <c:v>7243.14208984375</c:v>
                </c:pt>
                <c:pt idx="312">
                  <c:v>7292.82421875</c:v>
                </c:pt>
                <c:pt idx="313">
                  <c:v>7293.349609375</c:v>
                </c:pt>
                <c:pt idx="314">
                  <c:v>7233.02392578125</c:v>
                </c:pt>
                <c:pt idx="315">
                  <c:v>7135.89892578125</c:v>
                </c:pt>
                <c:pt idx="316">
                  <c:v>7050.62646484375</c:v>
                </c:pt>
                <c:pt idx="317">
                  <c:v>7022.84130859375</c:v>
                </c:pt>
                <c:pt idx="318">
                  <c:v>7068.62890625</c:v>
                </c:pt>
                <c:pt idx="319">
                  <c:v>7166.29296875</c:v>
                </c:pt>
                <c:pt idx="320">
                  <c:v>7271.05908203125</c:v>
                </c:pt>
                <c:pt idx="321">
                  <c:v>7341.87451171875</c:v>
                </c:pt>
                <c:pt idx="322">
                  <c:v>7362.33837890625</c:v>
                </c:pt>
                <c:pt idx="323">
                  <c:v>7343.55322265625</c:v>
                </c:pt>
                <c:pt idx="324">
                  <c:v>7310.1826171875</c:v>
                </c:pt>
                <c:pt idx="325">
                  <c:v>7281.9521484375</c:v>
                </c:pt>
                <c:pt idx="326">
                  <c:v>7263.76513671875</c:v>
                </c:pt>
                <c:pt idx="327">
                  <c:v>7249.17041015625</c:v>
                </c:pt>
                <c:pt idx="328">
                  <c:v>7231.4794921875</c:v>
                </c:pt>
                <c:pt idx="329">
                  <c:v>7212.228515625</c:v>
                </c:pt>
                <c:pt idx="330">
                  <c:v>7200.45263671875</c:v>
                </c:pt>
                <c:pt idx="331">
                  <c:v>7204.3935546875</c:v>
                </c:pt>
                <c:pt idx="332">
                  <c:v>7223.13037109375</c:v>
                </c:pt>
                <c:pt idx="333">
                  <c:v>7245.10595703125</c:v>
                </c:pt>
                <c:pt idx="334">
                  <c:v>7254.82080078125</c:v>
                </c:pt>
                <c:pt idx="335">
                  <c:v>7242.80322265625</c:v>
                </c:pt>
                <c:pt idx="336">
                  <c:v>7211.88916015625</c:v>
                </c:pt>
                <c:pt idx="337">
                  <c:v>7175.7890625</c:v>
                </c:pt>
                <c:pt idx="338">
                  <c:v>7151.2685546875</c:v>
                </c:pt>
                <c:pt idx="339">
                  <c:v>7149.16845703125</c:v>
                </c:pt>
                <c:pt idx="340">
                  <c:v>7169.5654296875</c:v>
                </c:pt>
                <c:pt idx="341">
                  <c:v>7203.24072265625</c:v>
                </c:pt>
                <c:pt idx="342">
                  <c:v>7237.626953125</c:v>
                </c:pt>
                <c:pt idx="343">
                  <c:v>7263.19580078125</c:v>
                </c:pt>
                <c:pt idx="344">
                  <c:v>7276.75537109375</c:v>
                </c:pt>
                <c:pt idx="345">
                  <c:v>7280.59423828125</c:v>
                </c:pt>
                <c:pt idx="346">
                  <c:v>7279.0478515625</c:v>
                </c:pt>
                <c:pt idx="347">
                  <c:v>7275.20703125</c:v>
                </c:pt>
                <c:pt idx="348">
                  <c:v>7269.78515625</c:v>
                </c:pt>
                <c:pt idx="349">
                  <c:v>7262.2607421875</c:v>
                </c:pt>
              </c:numCache>
            </c:numRef>
          </c:yVal>
          <c:smooth val="1"/>
          <c:extLst>
            <c:ext xmlns:c16="http://schemas.microsoft.com/office/drawing/2014/chart" uri="{C3380CC4-5D6E-409C-BE32-E72D297353CC}">
              <c16:uniqueId val="{00000016-0DDB-41B5-BE83-A9CFE49F3CE3}"/>
            </c:ext>
          </c:extLst>
        </c:ser>
        <c:ser>
          <c:idx val="23"/>
          <c:order val="23"/>
          <c:tx>
            <c:strRef>
              <c:f>hc_sub_007!$X$1</c:f>
              <c:strCache>
                <c:ptCount val="1"/>
                <c:pt idx="0">
                  <c:v>Coor_24</c:v>
                </c:pt>
              </c:strCache>
            </c:strRef>
          </c:tx>
          <c:spPr>
            <a:ln w="28575" cap="rnd">
              <a:solidFill>
                <a:schemeClr val="accent6">
                  <a:lumMod val="80000"/>
                </a:schemeClr>
              </a:solidFill>
              <a:round/>
            </a:ln>
            <a:effectLst/>
          </c:spPr>
          <c:marker>
            <c:symbol val="none"/>
          </c:marker>
          <c:yVal>
            <c:numRef>
              <c:f>hc_sub_007!$X$2:$X$351</c:f>
              <c:numCache>
                <c:formatCode>0.00000000000_ </c:formatCode>
                <c:ptCount val="350"/>
                <c:pt idx="0">
                  <c:v>6914.921875</c:v>
                </c:pt>
                <c:pt idx="1">
                  <c:v>6895.5009765625</c:v>
                </c:pt>
                <c:pt idx="2">
                  <c:v>6846.10400390625</c:v>
                </c:pt>
                <c:pt idx="3">
                  <c:v>6789.5869140625</c:v>
                </c:pt>
                <c:pt idx="4">
                  <c:v>6757.84521484375</c:v>
                </c:pt>
                <c:pt idx="5">
                  <c:v>6769.68603515625</c:v>
                </c:pt>
                <c:pt idx="6">
                  <c:v>6816.00146484375</c:v>
                </c:pt>
                <c:pt idx="7">
                  <c:v>6864.7568359375</c:v>
                </c:pt>
                <c:pt idx="8">
                  <c:v>6883.662109375</c:v>
                </c:pt>
                <c:pt idx="9">
                  <c:v>6864.103515625</c:v>
                </c:pt>
                <c:pt idx="10">
                  <c:v>6827.77734375</c:v>
                </c:pt>
                <c:pt idx="11">
                  <c:v>6810.08935546875</c:v>
                </c:pt>
                <c:pt idx="12">
                  <c:v>6832.39404296875</c:v>
                </c:pt>
                <c:pt idx="13">
                  <c:v>6884.41845703125</c:v>
                </c:pt>
                <c:pt idx="14">
                  <c:v>6930.91552734375</c:v>
                </c:pt>
                <c:pt idx="15">
                  <c:v>6938.02978515625</c:v>
                </c:pt>
                <c:pt idx="16">
                  <c:v>6899.35791015625</c:v>
                </c:pt>
                <c:pt idx="17">
                  <c:v>6841.61376953125</c:v>
                </c:pt>
                <c:pt idx="18">
                  <c:v>6805.3212890625</c:v>
                </c:pt>
                <c:pt idx="19">
                  <c:v>6815.06884765625</c:v>
                </c:pt>
                <c:pt idx="20">
                  <c:v>6861.73876953125</c:v>
                </c:pt>
                <c:pt idx="21">
                  <c:v>6909.7412109375</c:v>
                </c:pt>
                <c:pt idx="22">
                  <c:v>6923.25146484375</c:v>
                </c:pt>
                <c:pt idx="23">
                  <c:v>6891.4990234375</c:v>
                </c:pt>
                <c:pt idx="24">
                  <c:v>6834.767578125</c:v>
                </c:pt>
                <c:pt idx="25">
                  <c:v>6788.00537109375</c:v>
                </c:pt>
                <c:pt idx="26">
                  <c:v>6775.58349609375</c:v>
                </c:pt>
                <c:pt idx="27">
                  <c:v>6796.15771484375</c:v>
                </c:pt>
                <c:pt idx="28">
                  <c:v>6827.53759765625</c:v>
                </c:pt>
                <c:pt idx="29">
                  <c:v>6845.83349609375</c:v>
                </c:pt>
                <c:pt idx="30">
                  <c:v>6843.28076171875</c:v>
                </c:pt>
                <c:pt idx="31">
                  <c:v>6831.849609375</c:v>
                </c:pt>
                <c:pt idx="32">
                  <c:v>6831.75830078125</c:v>
                </c:pt>
                <c:pt idx="33">
                  <c:v>6855.2626953125</c:v>
                </c:pt>
                <c:pt idx="34">
                  <c:v>6898.24072265625</c:v>
                </c:pt>
                <c:pt idx="35">
                  <c:v>6944.5673828125</c:v>
                </c:pt>
                <c:pt idx="36">
                  <c:v>6978.00830078125</c:v>
                </c:pt>
                <c:pt idx="37">
                  <c:v>6991.51708984375</c:v>
                </c:pt>
                <c:pt idx="38">
                  <c:v>6987.43994140625</c:v>
                </c:pt>
                <c:pt idx="39">
                  <c:v>6970.36669921875</c:v>
                </c:pt>
                <c:pt idx="40">
                  <c:v>6940.2578125</c:v>
                </c:pt>
                <c:pt idx="41">
                  <c:v>6892.6005859375</c:v>
                </c:pt>
                <c:pt idx="42">
                  <c:v>6825.93115234375</c:v>
                </c:pt>
                <c:pt idx="43">
                  <c:v>6750.43994140625</c:v>
                </c:pt>
                <c:pt idx="44">
                  <c:v>6689.63525390625</c:v>
                </c:pt>
                <c:pt idx="45">
                  <c:v>6671.44921875</c:v>
                </c:pt>
                <c:pt idx="46">
                  <c:v>6712.58837890625</c:v>
                </c:pt>
                <c:pt idx="47">
                  <c:v>6805.3447265625</c:v>
                </c:pt>
                <c:pt idx="48">
                  <c:v>6915.9150390625</c:v>
                </c:pt>
                <c:pt idx="49">
                  <c:v>6997.35009765625</c:v>
                </c:pt>
                <c:pt idx="50">
                  <c:v>7011.82080078125</c:v>
                </c:pt>
                <c:pt idx="51">
                  <c:v>6950.67626953125</c:v>
                </c:pt>
                <c:pt idx="52">
                  <c:v>6840.705078125</c:v>
                </c:pt>
                <c:pt idx="53">
                  <c:v>6731.75927734375</c:v>
                </c:pt>
                <c:pt idx="54">
                  <c:v>6671.36181640625</c:v>
                </c:pt>
                <c:pt idx="55">
                  <c:v>6680.09375</c:v>
                </c:pt>
                <c:pt idx="56">
                  <c:v>6742.12841796875</c:v>
                </c:pt>
                <c:pt idx="57">
                  <c:v>6816.8623046875</c:v>
                </c:pt>
                <c:pt idx="58">
                  <c:v>6864.7666015625</c:v>
                </c:pt>
                <c:pt idx="59">
                  <c:v>6871.3310546875</c:v>
                </c:pt>
                <c:pt idx="60">
                  <c:v>6853.8662109375</c:v>
                </c:pt>
                <c:pt idx="61">
                  <c:v>6846.99267578125</c:v>
                </c:pt>
                <c:pt idx="62">
                  <c:v>6876.81396484375</c:v>
                </c:pt>
                <c:pt idx="63">
                  <c:v>6941.37744140625</c:v>
                </c:pt>
                <c:pt idx="64">
                  <c:v>7010.59716796875</c:v>
                </c:pt>
                <c:pt idx="65">
                  <c:v>7045.408203125</c:v>
                </c:pt>
                <c:pt idx="66">
                  <c:v>7022.93115234375</c:v>
                </c:pt>
                <c:pt idx="67">
                  <c:v>6950.908203125</c:v>
                </c:pt>
                <c:pt idx="68">
                  <c:v>6862.65869140625</c:v>
                </c:pt>
                <c:pt idx="69">
                  <c:v>6797.0771484375</c:v>
                </c:pt>
                <c:pt idx="70">
                  <c:v>6777.2587890625</c:v>
                </c:pt>
                <c:pt idx="71">
                  <c:v>6800.498046875</c:v>
                </c:pt>
                <c:pt idx="72">
                  <c:v>6843.60546875</c:v>
                </c:pt>
                <c:pt idx="73">
                  <c:v>6877.86279296875</c:v>
                </c:pt>
                <c:pt idx="74">
                  <c:v>6883.90869140625</c:v>
                </c:pt>
                <c:pt idx="75">
                  <c:v>6859.47998046875</c:v>
                </c:pt>
                <c:pt idx="76">
                  <c:v>6818.46728515625</c:v>
                </c:pt>
                <c:pt idx="77">
                  <c:v>6783.630859375</c:v>
                </c:pt>
                <c:pt idx="78">
                  <c:v>6776.2568359375</c:v>
                </c:pt>
                <c:pt idx="79">
                  <c:v>6805.8515625</c:v>
                </c:pt>
                <c:pt idx="80">
                  <c:v>6863.580078125</c:v>
                </c:pt>
                <c:pt idx="81">
                  <c:v>6923.662109375</c:v>
                </c:pt>
                <c:pt idx="82">
                  <c:v>6954.740234375</c:v>
                </c:pt>
                <c:pt idx="83">
                  <c:v>6937.3974609375</c:v>
                </c:pt>
                <c:pt idx="84">
                  <c:v>6877.92724609375</c:v>
                </c:pt>
                <c:pt idx="85">
                  <c:v>6807.94970703125</c:v>
                </c:pt>
                <c:pt idx="86">
                  <c:v>6767.25048828125</c:v>
                </c:pt>
                <c:pt idx="87">
                  <c:v>6779.1884765625</c:v>
                </c:pt>
                <c:pt idx="88">
                  <c:v>6835.11767578125</c:v>
                </c:pt>
                <c:pt idx="89">
                  <c:v>6899.61279296875</c:v>
                </c:pt>
                <c:pt idx="90">
                  <c:v>6933.875</c:v>
                </c:pt>
                <c:pt idx="91">
                  <c:v>6920.98291015625</c:v>
                </c:pt>
                <c:pt idx="92">
                  <c:v>6874.78564453125</c:v>
                </c:pt>
                <c:pt idx="93">
                  <c:v>6826.5751953125</c:v>
                </c:pt>
                <c:pt idx="94">
                  <c:v>6800.876953125</c:v>
                </c:pt>
                <c:pt idx="95">
                  <c:v>6799.8486328125</c:v>
                </c:pt>
                <c:pt idx="96">
                  <c:v>6807.91650390625</c:v>
                </c:pt>
                <c:pt idx="97">
                  <c:v>6810.7119140625</c:v>
                </c:pt>
                <c:pt idx="98">
                  <c:v>6810.07373046875</c:v>
                </c:pt>
                <c:pt idx="99">
                  <c:v>6820.74560546875</c:v>
                </c:pt>
                <c:pt idx="100">
                  <c:v>6851.5859375</c:v>
                </c:pt>
                <c:pt idx="101">
                  <c:v>6889.63134765625</c:v>
                </c:pt>
                <c:pt idx="102">
                  <c:v>6904.75048828125</c:v>
                </c:pt>
                <c:pt idx="103">
                  <c:v>6874.93310546875</c:v>
                </c:pt>
                <c:pt idx="104">
                  <c:v>6811.93359375</c:v>
                </c:pt>
                <c:pt idx="105">
                  <c:v>6762.5302734375</c:v>
                </c:pt>
                <c:pt idx="106">
                  <c:v>6778.2177734375</c:v>
                </c:pt>
                <c:pt idx="107">
                  <c:v>6873.07958984375</c:v>
                </c:pt>
                <c:pt idx="108">
                  <c:v>7003.43359375</c:v>
                </c:pt>
                <c:pt idx="109">
                  <c:v>7089.958984375</c:v>
                </c:pt>
                <c:pt idx="110">
                  <c:v>7071.072265625</c:v>
                </c:pt>
                <c:pt idx="111">
                  <c:v>6949.78271484375</c:v>
                </c:pt>
                <c:pt idx="112">
                  <c:v>6797.38232421875</c:v>
                </c:pt>
                <c:pt idx="113">
                  <c:v>6707.5478515625</c:v>
                </c:pt>
                <c:pt idx="114">
                  <c:v>6731.8720703125</c:v>
                </c:pt>
                <c:pt idx="115">
                  <c:v>6843.5166015625</c:v>
                </c:pt>
                <c:pt idx="116">
                  <c:v>6956.380859375</c:v>
                </c:pt>
                <c:pt idx="117">
                  <c:v>6986.578125</c:v>
                </c:pt>
                <c:pt idx="118">
                  <c:v>6911.63818359375</c:v>
                </c:pt>
                <c:pt idx="119">
                  <c:v>6784.6162109375</c:v>
                </c:pt>
                <c:pt idx="120">
                  <c:v>6693.90283203125</c:v>
                </c:pt>
                <c:pt idx="121">
                  <c:v>6699.38916015625</c:v>
                </c:pt>
                <c:pt idx="122">
                  <c:v>6791.8515625</c:v>
                </c:pt>
                <c:pt idx="123">
                  <c:v>6903.55859375</c:v>
                </c:pt>
                <c:pt idx="124">
                  <c:v>6959.55419921875</c:v>
                </c:pt>
                <c:pt idx="125">
                  <c:v>6930.30322265625</c:v>
                </c:pt>
                <c:pt idx="126">
                  <c:v>6848.08642578125</c:v>
                </c:pt>
                <c:pt idx="127">
                  <c:v>6778.4921875</c:v>
                </c:pt>
                <c:pt idx="128">
                  <c:v>6771.23486328125</c:v>
                </c:pt>
                <c:pt idx="129">
                  <c:v>6827.01220703125</c:v>
                </c:pt>
                <c:pt idx="130">
                  <c:v>6901.9521484375</c:v>
                </c:pt>
                <c:pt idx="131">
                  <c:v>6942.2724609375</c:v>
                </c:pt>
                <c:pt idx="132">
                  <c:v>6921.6103515625</c:v>
                </c:pt>
                <c:pt idx="133">
                  <c:v>6855.412109375</c:v>
                </c:pt>
                <c:pt idx="134">
                  <c:v>6786.3134765625</c:v>
                </c:pt>
                <c:pt idx="135">
                  <c:v>6754.87353515625</c:v>
                </c:pt>
                <c:pt idx="136">
                  <c:v>6776.77783203125</c:v>
                </c:pt>
                <c:pt idx="137">
                  <c:v>6838.71337890625</c:v>
                </c:pt>
                <c:pt idx="138">
                  <c:v>6910.3818359375</c:v>
                </c:pt>
                <c:pt idx="139">
                  <c:v>6961.39453125</c:v>
                </c:pt>
                <c:pt idx="140">
                  <c:v>6973.28173828125</c:v>
                </c:pt>
                <c:pt idx="141">
                  <c:v>6943.87890625</c:v>
                </c:pt>
                <c:pt idx="142">
                  <c:v>6886.2177734375</c:v>
                </c:pt>
                <c:pt idx="143">
                  <c:v>6823.8828125</c:v>
                </c:pt>
                <c:pt idx="144">
                  <c:v>6782.7421875</c:v>
                </c:pt>
                <c:pt idx="145">
                  <c:v>6779.72265625</c:v>
                </c:pt>
                <c:pt idx="146">
                  <c:v>6813.2158203125</c:v>
                </c:pt>
                <c:pt idx="147">
                  <c:v>6862.20361328125</c:v>
                </c:pt>
                <c:pt idx="148">
                  <c:v>6897.56005859375</c:v>
                </c:pt>
                <c:pt idx="149">
                  <c:v>6900.21435546875</c:v>
                </c:pt>
                <c:pt idx="150">
                  <c:v>6873.93505859375</c:v>
                </c:pt>
                <c:pt idx="151">
                  <c:v>6842.4443359375</c:v>
                </c:pt>
                <c:pt idx="152">
                  <c:v>6831.63232421875</c:v>
                </c:pt>
                <c:pt idx="153">
                  <c:v>6849.6826171875</c:v>
                </c:pt>
                <c:pt idx="154">
                  <c:v>6880.72802734375</c:v>
                </c:pt>
                <c:pt idx="155">
                  <c:v>6897.7880859375</c:v>
                </c:pt>
                <c:pt idx="156">
                  <c:v>6885.30810546875</c:v>
                </c:pt>
                <c:pt idx="157">
                  <c:v>6853.08154296875</c:v>
                </c:pt>
                <c:pt idx="158">
                  <c:v>6829.40625</c:v>
                </c:pt>
                <c:pt idx="159">
                  <c:v>6837.8193359375</c:v>
                </c:pt>
                <c:pt idx="160">
                  <c:v>6875.73095703125</c:v>
                </c:pt>
                <c:pt idx="161">
                  <c:v>6912.96728515625</c:v>
                </c:pt>
                <c:pt idx="162">
                  <c:v>6913.1318359375</c:v>
                </c:pt>
                <c:pt idx="163">
                  <c:v>6862.39013671875</c:v>
                </c:pt>
                <c:pt idx="164">
                  <c:v>6783.35205078125</c:v>
                </c:pt>
                <c:pt idx="165">
                  <c:v>6722.2431640625</c:v>
                </c:pt>
                <c:pt idx="166">
                  <c:v>6717.69140625</c:v>
                </c:pt>
                <c:pt idx="167">
                  <c:v>6773.748046875</c:v>
                </c:pt>
                <c:pt idx="168">
                  <c:v>6856.98486328125</c:v>
                </c:pt>
                <c:pt idx="169">
                  <c:v>6919.72265625</c:v>
                </c:pt>
                <c:pt idx="170">
                  <c:v>6932.23681640625</c:v>
                </c:pt>
                <c:pt idx="171">
                  <c:v>6900.7080078125</c:v>
                </c:pt>
                <c:pt idx="172">
                  <c:v>6858.98974609375</c:v>
                </c:pt>
                <c:pt idx="173">
                  <c:v>6841.8720703125</c:v>
                </c:pt>
                <c:pt idx="174">
                  <c:v>6860.4443359375</c:v>
                </c:pt>
                <c:pt idx="175">
                  <c:v>6897.09326171875</c:v>
                </c:pt>
                <c:pt idx="176">
                  <c:v>6921.83935546875</c:v>
                </c:pt>
                <c:pt idx="177">
                  <c:v>6915.87109375</c:v>
                </c:pt>
                <c:pt idx="178">
                  <c:v>6884.142578125</c:v>
                </c:pt>
                <c:pt idx="179">
                  <c:v>6848.921875</c:v>
                </c:pt>
                <c:pt idx="180">
                  <c:v>6831.4267578125</c:v>
                </c:pt>
                <c:pt idx="181">
                  <c:v>6837.03515625</c:v>
                </c:pt>
                <c:pt idx="182">
                  <c:v>6855.0390625</c:v>
                </c:pt>
                <c:pt idx="183">
                  <c:v>6871.11474609375</c:v>
                </c:pt>
                <c:pt idx="184">
                  <c:v>6880.39892578125</c:v>
                </c:pt>
                <c:pt idx="185">
                  <c:v>6889.55419921875</c:v>
                </c:pt>
                <c:pt idx="186">
                  <c:v>6906.5244140625</c:v>
                </c:pt>
                <c:pt idx="187">
                  <c:v>6927.9267578125</c:v>
                </c:pt>
                <c:pt idx="188">
                  <c:v>6936.5966796875</c:v>
                </c:pt>
                <c:pt idx="189">
                  <c:v>6913.39794921875</c:v>
                </c:pt>
                <c:pt idx="190">
                  <c:v>6854.79443359375</c:v>
                </c:pt>
                <c:pt idx="191">
                  <c:v>6781.3974609375</c:v>
                </c:pt>
                <c:pt idx="192">
                  <c:v>6728.41650390625</c:v>
                </c:pt>
                <c:pt idx="193">
                  <c:v>6722.86181640625</c:v>
                </c:pt>
                <c:pt idx="194">
                  <c:v>6763.669921875</c:v>
                </c:pt>
                <c:pt idx="195">
                  <c:v>6820.38134765625</c:v>
                </c:pt>
                <c:pt idx="196">
                  <c:v>6853.1162109375</c:v>
                </c:pt>
                <c:pt idx="197">
                  <c:v>6840.57421875</c:v>
                </c:pt>
                <c:pt idx="198">
                  <c:v>6795.8515625</c:v>
                </c:pt>
                <c:pt idx="199">
                  <c:v>6757.81298828125</c:v>
                </c:pt>
                <c:pt idx="200">
                  <c:v>6763.35205078125</c:v>
                </c:pt>
                <c:pt idx="201">
                  <c:v>6820.2490234375</c:v>
                </c:pt>
                <c:pt idx="202">
                  <c:v>6900.5185546875</c:v>
                </c:pt>
                <c:pt idx="203">
                  <c:v>6959.5439453125</c:v>
                </c:pt>
                <c:pt idx="204">
                  <c:v>6967.369140625</c:v>
                </c:pt>
                <c:pt idx="205">
                  <c:v>6929.36865234375</c:v>
                </c:pt>
                <c:pt idx="206">
                  <c:v>6881.15771484375</c:v>
                </c:pt>
                <c:pt idx="207">
                  <c:v>6861.638671875</c:v>
                </c:pt>
                <c:pt idx="208">
                  <c:v>6884.33056640625</c:v>
                </c:pt>
                <c:pt idx="209">
                  <c:v>6928.3603515625</c:v>
                </c:pt>
                <c:pt idx="210">
                  <c:v>6955.6103515625</c:v>
                </c:pt>
                <c:pt idx="211">
                  <c:v>6940.72265625</c:v>
                </c:pt>
                <c:pt idx="212">
                  <c:v>6890.927734375</c:v>
                </c:pt>
                <c:pt idx="213">
                  <c:v>6840.51123046875</c:v>
                </c:pt>
                <c:pt idx="214">
                  <c:v>6824.1884765625</c:v>
                </c:pt>
                <c:pt idx="215">
                  <c:v>6849.93310546875</c:v>
                </c:pt>
                <c:pt idx="216">
                  <c:v>6892.3154296875</c:v>
                </c:pt>
                <c:pt idx="217">
                  <c:v>6911.73046875</c:v>
                </c:pt>
                <c:pt idx="218">
                  <c:v>6885.00830078125</c:v>
                </c:pt>
                <c:pt idx="219">
                  <c:v>6824.00830078125</c:v>
                </c:pt>
                <c:pt idx="220">
                  <c:v>6767.84521484375</c:v>
                </c:pt>
                <c:pt idx="221">
                  <c:v>6754.37255859375</c:v>
                </c:pt>
                <c:pt idx="222">
                  <c:v>6792.27099609375</c:v>
                </c:pt>
                <c:pt idx="223">
                  <c:v>6854.583984375</c:v>
                </c:pt>
                <c:pt idx="224">
                  <c:v>6898.31787109375</c:v>
                </c:pt>
                <c:pt idx="225">
                  <c:v>6895.27734375</c:v>
                </c:pt>
                <c:pt idx="226">
                  <c:v>6851.26220703125</c:v>
                </c:pt>
                <c:pt idx="227">
                  <c:v>6799.982421875</c:v>
                </c:pt>
                <c:pt idx="228">
                  <c:v>6777.11767578125</c:v>
                </c:pt>
                <c:pt idx="229">
                  <c:v>6794.400390625</c:v>
                </c:pt>
                <c:pt idx="230">
                  <c:v>6832.787109375</c:v>
                </c:pt>
                <c:pt idx="231">
                  <c:v>6858.93310546875</c:v>
                </c:pt>
                <c:pt idx="232">
                  <c:v>6851.80224609375</c:v>
                </c:pt>
                <c:pt idx="233">
                  <c:v>6819.27734375</c:v>
                </c:pt>
                <c:pt idx="234">
                  <c:v>6792.6748046875</c:v>
                </c:pt>
                <c:pt idx="235">
                  <c:v>6803.55419921875</c:v>
                </c:pt>
                <c:pt idx="236">
                  <c:v>6859.8173828125</c:v>
                </c:pt>
                <c:pt idx="237">
                  <c:v>6938.08203125</c:v>
                </c:pt>
                <c:pt idx="238">
                  <c:v>6997.46533203125</c:v>
                </c:pt>
                <c:pt idx="239">
                  <c:v>7005.1943359375</c:v>
                </c:pt>
                <c:pt idx="240">
                  <c:v>6957.04736328125</c:v>
                </c:pt>
                <c:pt idx="241">
                  <c:v>6879.83935546875</c:v>
                </c:pt>
                <c:pt idx="242">
                  <c:v>6815.18212890625</c:v>
                </c:pt>
                <c:pt idx="243">
                  <c:v>6795.22216796875</c:v>
                </c:pt>
                <c:pt idx="244">
                  <c:v>6825.0390625</c:v>
                </c:pt>
                <c:pt idx="245">
                  <c:v>6881.3740234375</c:v>
                </c:pt>
                <c:pt idx="246">
                  <c:v>6927.3330078125</c:v>
                </c:pt>
                <c:pt idx="247">
                  <c:v>6933.8486328125</c:v>
                </c:pt>
                <c:pt idx="248">
                  <c:v>6895.5966796875</c:v>
                </c:pt>
                <c:pt idx="249">
                  <c:v>6832.80810546875</c:v>
                </c:pt>
                <c:pt idx="250">
                  <c:v>6778.53173828125</c:v>
                </c:pt>
                <c:pt idx="251">
                  <c:v>6759.0302734375</c:v>
                </c:pt>
                <c:pt idx="252">
                  <c:v>6778.83544921875</c:v>
                </c:pt>
                <c:pt idx="253">
                  <c:v>6819.33154296875</c:v>
                </c:pt>
                <c:pt idx="254">
                  <c:v>6851.76220703125</c:v>
                </c:pt>
                <c:pt idx="255">
                  <c:v>6856.5634765625</c:v>
                </c:pt>
                <c:pt idx="256">
                  <c:v>6836.52392578125</c:v>
                </c:pt>
                <c:pt idx="257">
                  <c:v>6814.775390625</c:v>
                </c:pt>
                <c:pt idx="258">
                  <c:v>6818.39453125</c:v>
                </c:pt>
                <c:pt idx="259">
                  <c:v>6858.39111328125</c:v>
                </c:pt>
                <c:pt idx="260">
                  <c:v>6919.94140625</c:v>
                </c:pt>
                <c:pt idx="261">
                  <c:v>6970.27978515625</c:v>
                </c:pt>
                <c:pt idx="262">
                  <c:v>6979.5244140625</c:v>
                </c:pt>
                <c:pt idx="263">
                  <c:v>6940.4052734375</c:v>
                </c:pt>
                <c:pt idx="264">
                  <c:v>6873.24365234375</c:v>
                </c:pt>
                <c:pt idx="265">
                  <c:v>6812.703125</c:v>
                </c:pt>
                <c:pt idx="266">
                  <c:v>6785.63330078125</c:v>
                </c:pt>
                <c:pt idx="267">
                  <c:v>6795.4208984375</c:v>
                </c:pt>
                <c:pt idx="268">
                  <c:v>6823.1943359375</c:v>
                </c:pt>
                <c:pt idx="269">
                  <c:v>6843.84765625</c:v>
                </c:pt>
                <c:pt idx="270">
                  <c:v>6844.39111328125</c:v>
                </c:pt>
                <c:pt idx="271">
                  <c:v>6831.3642578125</c:v>
                </c:pt>
                <c:pt idx="272">
                  <c:v>6823.01611328125</c:v>
                </c:pt>
                <c:pt idx="273">
                  <c:v>6833.5830078125</c:v>
                </c:pt>
                <c:pt idx="274">
                  <c:v>6862.23046875</c:v>
                </c:pt>
                <c:pt idx="275">
                  <c:v>6894.56396484375</c:v>
                </c:pt>
                <c:pt idx="276">
                  <c:v>6914.2607421875</c:v>
                </c:pt>
                <c:pt idx="277">
                  <c:v>6914.75927734375</c:v>
                </c:pt>
                <c:pt idx="278">
                  <c:v>6901.87646484375</c:v>
                </c:pt>
                <c:pt idx="279">
                  <c:v>6886.3642578125</c:v>
                </c:pt>
                <c:pt idx="280">
                  <c:v>6873.71728515625</c:v>
                </c:pt>
                <c:pt idx="281">
                  <c:v>6860.2900390625</c:v>
                </c:pt>
                <c:pt idx="282">
                  <c:v>6838.82568359375</c:v>
                </c:pt>
                <c:pt idx="283">
                  <c:v>6808.169921875</c:v>
                </c:pt>
                <c:pt idx="284">
                  <c:v>6778.2412109375</c:v>
                </c:pt>
                <c:pt idx="285">
                  <c:v>6765.232421875</c:v>
                </c:pt>
                <c:pt idx="286">
                  <c:v>6780.21630859375</c:v>
                </c:pt>
                <c:pt idx="287">
                  <c:v>6819.97998046875</c:v>
                </c:pt>
                <c:pt idx="288">
                  <c:v>6867.50634765625</c:v>
                </c:pt>
                <c:pt idx="289">
                  <c:v>6902.18505859375</c:v>
                </c:pt>
                <c:pt idx="290">
                  <c:v>6912.53466796875</c:v>
                </c:pt>
                <c:pt idx="291">
                  <c:v>6902.4736328125</c:v>
                </c:pt>
                <c:pt idx="292">
                  <c:v>6887.1455078125</c:v>
                </c:pt>
                <c:pt idx="293">
                  <c:v>6881.86962890625</c:v>
                </c:pt>
                <c:pt idx="294">
                  <c:v>6892.16845703125</c:v>
                </c:pt>
                <c:pt idx="295">
                  <c:v>6911.21435546875</c:v>
                </c:pt>
                <c:pt idx="296">
                  <c:v>6925.27880859375</c:v>
                </c:pt>
                <c:pt idx="297">
                  <c:v>6922.478515625</c:v>
                </c:pt>
                <c:pt idx="298">
                  <c:v>6899.00146484375</c:v>
                </c:pt>
                <c:pt idx="299">
                  <c:v>6859.951171875</c:v>
                </c:pt>
                <c:pt idx="300">
                  <c:v>6815.99951171875</c:v>
                </c:pt>
                <c:pt idx="301">
                  <c:v>6779.00634765625</c:v>
                </c:pt>
                <c:pt idx="302">
                  <c:v>6758.81298828125</c:v>
                </c:pt>
                <c:pt idx="303">
                  <c:v>6761.318359375</c:v>
                </c:pt>
                <c:pt idx="304">
                  <c:v>6786.94970703125</c:v>
                </c:pt>
                <c:pt idx="305">
                  <c:v>6829.4892578125</c:v>
                </c:pt>
                <c:pt idx="306">
                  <c:v>6876.56494140625</c:v>
                </c:pt>
                <c:pt idx="307">
                  <c:v>6913.11572265625</c:v>
                </c:pt>
                <c:pt idx="308">
                  <c:v>6927.29150390625</c:v>
                </c:pt>
                <c:pt idx="309">
                  <c:v>6915.9921875</c:v>
                </c:pt>
                <c:pt idx="310">
                  <c:v>6886.61376953125</c:v>
                </c:pt>
                <c:pt idx="311">
                  <c:v>6853.47314453125</c:v>
                </c:pt>
                <c:pt idx="312">
                  <c:v>6830.61962890625</c:v>
                </c:pt>
                <c:pt idx="313">
                  <c:v>6825.02880859375</c:v>
                </c:pt>
                <c:pt idx="314">
                  <c:v>6833.90234375</c:v>
                </c:pt>
                <c:pt idx="315">
                  <c:v>6847.26025390625</c:v>
                </c:pt>
                <c:pt idx="316">
                  <c:v>6853.99658203125</c:v>
                </c:pt>
                <c:pt idx="317">
                  <c:v>6847.9873046875</c:v>
                </c:pt>
                <c:pt idx="318">
                  <c:v>6831.2802734375</c:v>
                </c:pt>
                <c:pt idx="319">
                  <c:v>6813.1953125</c:v>
                </c:pt>
                <c:pt idx="320">
                  <c:v>6805.99755859375</c:v>
                </c:pt>
                <c:pt idx="321">
                  <c:v>6819.03857421875</c:v>
                </c:pt>
                <c:pt idx="322">
                  <c:v>6853.68408203125</c:v>
                </c:pt>
                <c:pt idx="323">
                  <c:v>6901.2724609375</c:v>
                </c:pt>
                <c:pt idx="324">
                  <c:v>6945.49853515625</c:v>
                </c:pt>
                <c:pt idx="325">
                  <c:v>6968.93798828125</c:v>
                </c:pt>
                <c:pt idx="326">
                  <c:v>6961.1787109375</c:v>
                </c:pt>
                <c:pt idx="327">
                  <c:v>6924.45947265625</c:v>
                </c:pt>
                <c:pt idx="328">
                  <c:v>6873.28662109375</c:v>
                </c:pt>
                <c:pt idx="329">
                  <c:v>6827.50146484375</c:v>
                </c:pt>
                <c:pt idx="330">
                  <c:v>6802.28955078125</c:v>
                </c:pt>
                <c:pt idx="331">
                  <c:v>6800.943359375</c:v>
                </c:pt>
                <c:pt idx="332">
                  <c:v>6814.85693359375</c:v>
                </c:pt>
                <c:pt idx="333">
                  <c:v>6830.67919921875</c:v>
                </c:pt>
                <c:pt idx="334">
                  <c:v>6839.72216796875</c:v>
                </c:pt>
                <c:pt idx="335">
                  <c:v>6843.08837890625</c:v>
                </c:pt>
                <c:pt idx="336">
                  <c:v>6848.98876953125</c:v>
                </c:pt>
                <c:pt idx="337">
                  <c:v>6864.40185546875</c:v>
                </c:pt>
                <c:pt idx="338">
                  <c:v>6887.50390625</c:v>
                </c:pt>
                <c:pt idx="339">
                  <c:v>6906.89453125</c:v>
                </c:pt>
                <c:pt idx="340">
                  <c:v>6908.69189453125</c:v>
                </c:pt>
                <c:pt idx="341">
                  <c:v>6886.6181640625</c:v>
                </c:pt>
                <c:pt idx="342">
                  <c:v>6847.69921875</c:v>
                </c:pt>
                <c:pt idx="343">
                  <c:v>6809.12109375</c:v>
                </c:pt>
                <c:pt idx="344">
                  <c:v>6788.10546875</c:v>
                </c:pt>
                <c:pt idx="345">
                  <c:v>6791.6953125</c:v>
                </c:pt>
                <c:pt idx="346">
                  <c:v>6813.404296875</c:v>
                </c:pt>
                <c:pt idx="347">
                  <c:v>6838.70556640625</c:v>
                </c:pt>
                <c:pt idx="348">
                  <c:v>6855.0732421875</c:v>
                </c:pt>
                <c:pt idx="349">
                  <c:v>6859.34130859375</c:v>
                </c:pt>
              </c:numCache>
            </c:numRef>
          </c:yVal>
          <c:smooth val="1"/>
          <c:extLst>
            <c:ext xmlns:c16="http://schemas.microsoft.com/office/drawing/2014/chart" uri="{C3380CC4-5D6E-409C-BE32-E72D297353CC}">
              <c16:uniqueId val="{00000017-0DDB-41B5-BE83-A9CFE49F3CE3}"/>
            </c:ext>
          </c:extLst>
        </c:ser>
        <c:ser>
          <c:idx val="24"/>
          <c:order val="24"/>
          <c:tx>
            <c:strRef>
              <c:f>hc_sub_007!$Y$1</c:f>
              <c:strCache>
                <c:ptCount val="1"/>
                <c:pt idx="0">
                  <c:v>Coor_25</c:v>
                </c:pt>
              </c:strCache>
            </c:strRef>
          </c:tx>
          <c:spPr>
            <a:ln w="28575" cap="rnd">
              <a:solidFill>
                <a:schemeClr val="accent1">
                  <a:lumMod val="60000"/>
                  <a:lumOff val="40000"/>
                </a:schemeClr>
              </a:solidFill>
              <a:round/>
            </a:ln>
            <a:effectLst/>
          </c:spPr>
          <c:marker>
            <c:symbol val="none"/>
          </c:marker>
          <c:yVal>
            <c:numRef>
              <c:f>hc_sub_007!$Y$2:$Y$351</c:f>
              <c:numCache>
                <c:formatCode>0.00000000000_ </c:formatCode>
                <c:ptCount val="350"/>
                <c:pt idx="0">
                  <c:v>6355.6025390625</c:v>
                </c:pt>
                <c:pt idx="1">
                  <c:v>6375.46728515625</c:v>
                </c:pt>
                <c:pt idx="2">
                  <c:v>6377.62353515625</c:v>
                </c:pt>
                <c:pt idx="3">
                  <c:v>6361.61669921875</c:v>
                </c:pt>
                <c:pt idx="4">
                  <c:v>6341.4384765625</c:v>
                </c:pt>
                <c:pt idx="5">
                  <c:v>6331.7724609375</c:v>
                </c:pt>
                <c:pt idx="6">
                  <c:v>6334.61572265625</c:v>
                </c:pt>
                <c:pt idx="7">
                  <c:v>6338.56640625</c:v>
                </c:pt>
                <c:pt idx="8">
                  <c:v>6331.4267578125</c:v>
                </c:pt>
                <c:pt idx="9">
                  <c:v>6314.42236328125</c:v>
                </c:pt>
                <c:pt idx="10">
                  <c:v>6304.349609375</c:v>
                </c:pt>
                <c:pt idx="11">
                  <c:v>6320.37646484375</c:v>
                </c:pt>
                <c:pt idx="12">
                  <c:v>6366.0322265625</c:v>
                </c:pt>
                <c:pt idx="13">
                  <c:v>6421.96337890625</c:v>
                </c:pt>
                <c:pt idx="14">
                  <c:v>6456.69482421875</c:v>
                </c:pt>
                <c:pt idx="15">
                  <c:v>6447.875</c:v>
                </c:pt>
                <c:pt idx="16">
                  <c:v>6397.83984375</c:v>
                </c:pt>
                <c:pt idx="17">
                  <c:v>6331.97802734375</c:v>
                </c:pt>
                <c:pt idx="18">
                  <c:v>6282.12744140625</c:v>
                </c:pt>
                <c:pt idx="19">
                  <c:v>6268.2705078125</c:v>
                </c:pt>
                <c:pt idx="20">
                  <c:v>6291.27001953125</c:v>
                </c:pt>
                <c:pt idx="21">
                  <c:v>6338.7451171875</c:v>
                </c:pt>
                <c:pt idx="22">
                  <c:v>6395.5400390625</c:v>
                </c:pt>
                <c:pt idx="23">
                  <c:v>6448.8818359375</c:v>
                </c:pt>
                <c:pt idx="24">
                  <c:v>6486.40673828125</c:v>
                </c:pt>
                <c:pt idx="25">
                  <c:v>6494.07177734375</c:v>
                </c:pt>
                <c:pt idx="26">
                  <c:v>6461.39990234375</c:v>
                </c:pt>
                <c:pt idx="27">
                  <c:v>6392.72509765625</c:v>
                </c:pt>
                <c:pt idx="28">
                  <c:v>6313.82275390625</c:v>
                </c:pt>
                <c:pt idx="29">
                  <c:v>6263.50146484375</c:v>
                </c:pt>
                <c:pt idx="30">
                  <c:v>6271.17529296875</c:v>
                </c:pt>
                <c:pt idx="31">
                  <c:v>6334.98828125</c:v>
                </c:pt>
                <c:pt idx="32">
                  <c:v>6418.2119140625</c:v>
                </c:pt>
                <c:pt idx="33">
                  <c:v>6469.90966796875</c:v>
                </c:pt>
                <c:pt idx="34">
                  <c:v>6457.376953125</c:v>
                </c:pt>
                <c:pt idx="35">
                  <c:v>6387.57470703125</c:v>
                </c:pt>
                <c:pt idx="36">
                  <c:v>6301.78955078125</c:v>
                </c:pt>
                <c:pt idx="37">
                  <c:v>6247.31640625</c:v>
                </c:pt>
                <c:pt idx="38">
                  <c:v>6246.93115234375</c:v>
                </c:pt>
                <c:pt idx="39">
                  <c:v>6287.8505859375</c:v>
                </c:pt>
                <c:pt idx="40">
                  <c:v>6336.265625</c:v>
                </c:pt>
                <c:pt idx="41">
                  <c:v>6364.048828125</c:v>
                </c:pt>
                <c:pt idx="42">
                  <c:v>6366.36962890625</c:v>
                </c:pt>
                <c:pt idx="43">
                  <c:v>6358.2509765625</c:v>
                </c:pt>
                <c:pt idx="44">
                  <c:v>6356.11669921875</c:v>
                </c:pt>
                <c:pt idx="45">
                  <c:v>6361.89794921875</c:v>
                </c:pt>
                <c:pt idx="46">
                  <c:v>6363.32470703125</c:v>
                </c:pt>
                <c:pt idx="47">
                  <c:v>6348.83544921875</c:v>
                </c:pt>
                <c:pt idx="48">
                  <c:v>6322.54833984375</c:v>
                </c:pt>
                <c:pt idx="49">
                  <c:v>6304.89111328125</c:v>
                </c:pt>
                <c:pt idx="50">
                  <c:v>6317.294921875</c:v>
                </c:pt>
                <c:pt idx="51">
                  <c:v>6363.5361328125</c:v>
                </c:pt>
                <c:pt idx="52">
                  <c:v>6423.7421875</c:v>
                </c:pt>
                <c:pt idx="53">
                  <c:v>6466.9443359375</c:v>
                </c:pt>
                <c:pt idx="54">
                  <c:v>6472.865234375</c:v>
                </c:pt>
                <c:pt idx="55">
                  <c:v>6445.982421875</c:v>
                </c:pt>
                <c:pt idx="56">
                  <c:v>6410.9130859375</c:v>
                </c:pt>
                <c:pt idx="57">
                  <c:v>6392.84228515625</c:v>
                </c:pt>
                <c:pt idx="58">
                  <c:v>6398.2373046875</c:v>
                </c:pt>
                <c:pt idx="59">
                  <c:v>6410.60107421875</c:v>
                </c:pt>
                <c:pt idx="60">
                  <c:v>6404.291015625</c:v>
                </c:pt>
                <c:pt idx="61">
                  <c:v>6365.775390625</c:v>
                </c:pt>
                <c:pt idx="62">
                  <c:v>6306.38134765625</c:v>
                </c:pt>
                <c:pt idx="63">
                  <c:v>6257.02880859375</c:v>
                </c:pt>
                <c:pt idx="64">
                  <c:v>6248.38525390625</c:v>
                </c:pt>
                <c:pt idx="65">
                  <c:v>6289.90283203125</c:v>
                </c:pt>
                <c:pt idx="66">
                  <c:v>6361.734375</c:v>
                </c:pt>
                <c:pt idx="67">
                  <c:v>6424.89697265625</c:v>
                </c:pt>
                <c:pt idx="68">
                  <c:v>6443.4990234375</c:v>
                </c:pt>
                <c:pt idx="69">
                  <c:v>6405.6064453125</c:v>
                </c:pt>
                <c:pt idx="70">
                  <c:v>6330.43701171875</c:v>
                </c:pt>
                <c:pt idx="71">
                  <c:v>6257.74951171875</c:v>
                </c:pt>
                <c:pt idx="72">
                  <c:v>6225.6708984375</c:v>
                </c:pt>
                <c:pt idx="73">
                  <c:v>6249.78515625</c:v>
                </c:pt>
                <c:pt idx="74">
                  <c:v>6315.5595703125</c:v>
                </c:pt>
                <c:pt idx="75">
                  <c:v>6388.2900390625</c:v>
                </c:pt>
                <c:pt idx="76">
                  <c:v>6434.20263671875</c:v>
                </c:pt>
                <c:pt idx="77">
                  <c:v>6439.46337890625</c:v>
                </c:pt>
                <c:pt idx="78">
                  <c:v>6415.306640625</c:v>
                </c:pt>
                <c:pt idx="79">
                  <c:v>6386.79248046875</c:v>
                </c:pt>
                <c:pt idx="80">
                  <c:v>6373.89404296875</c:v>
                </c:pt>
                <c:pt idx="81">
                  <c:v>6378.7587890625</c:v>
                </c:pt>
                <c:pt idx="82">
                  <c:v>6387.98876953125</c:v>
                </c:pt>
                <c:pt idx="83">
                  <c:v>6387.0283203125</c:v>
                </c:pt>
                <c:pt idx="84">
                  <c:v>6374.17578125</c:v>
                </c:pt>
                <c:pt idx="85">
                  <c:v>6362.16552734375</c:v>
                </c:pt>
                <c:pt idx="86">
                  <c:v>6365.77880859375</c:v>
                </c:pt>
                <c:pt idx="87">
                  <c:v>6386.2578125</c:v>
                </c:pt>
                <c:pt idx="88">
                  <c:v>6406.869140625</c:v>
                </c:pt>
                <c:pt idx="89">
                  <c:v>6405.11279296875</c:v>
                </c:pt>
                <c:pt idx="90">
                  <c:v>6372.5068359375</c:v>
                </c:pt>
                <c:pt idx="91">
                  <c:v>6324.97216796875</c:v>
                </c:pt>
                <c:pt idx="92">
                  <c:v>6293.21923828125</c:v>
                </c:pt>
                <c:pt idx="93">
                  <c:v>6299.005859375</c:v>
                </c:pt>
                <c:pt idx="94">
                  <c:v>6336.2587890625</c:v>
                </c:pt>
                <c:pt idx="95">
                  <c:v>6373.97998046875</c:v>
                </c:pt>
                <c:pt idx="96">
                  <c:v>6380.82080078125</c:v>
                </c:pt>
                <c:pt idx="97">
                  <c:v>6352.4794921875</c:v>
                </c:pt>
                <c:pt idx="98">
                  <c:v>6318.552734375</c:v>
                </c:pt>
                <c:pt idx="99">
                  <c:v>6320.50341796875</c:v>
                </c:pt>
                <c:pt idx="100">
                  <c:v>6376.0625</c:v>
                </c:pt>
                <c:pt idx="101">
                  <c:v>6458.546875</c:v>
                </c:pt>
                <c:pt idx="102">
                  <c:v>6510.31494140625</c:v>
                </c:pt>
                <c:pt idx="103">
                  <c:v>6483.59912109375</c:v>
                </c:pt>
                <c:pt idx="104">
                  <c:v>6379.13818359375</c:v>
                </c:pt>
                <c:pt idx="105">
                  <c:v>6252.0986328125</c:v>
                </c:pt>
                <c:pt idx="106">
                  <c:v>6177.8720703125</c:v>
                </c:pt>
                <c:pt idx="107">
                  <c:v>6200.6435546875</c:v>
                </c:pt>
                <c:pt idx="108">
                  <c:v>6301.8447265625</c:v>
                </c:pt>
                <c:pt idx="109">
                  <c:v>6412.1748046875</c:v>
                </c:pt>
                <c:pt idx="110">
                  <c:v>6459.3515625</c:v>
                </c:pt>
                <c:pt idx="111">
                  <c:v>6417.64013671875</c:v>
                </c:pt>
                <c:pt idx="112">
                  <c:v>6324.0537109375</c:v>
                </c:pt>
                <c:pt idx="113">
                  <c:v>6250.60205078125</c:v>
                </c:pt>
                <c:pt idx="114">
                  <c:v>6253.50634765625</c:v>
                </c:pt>
                <c:pt idx="115">
                  <c:v>6335.73681640625</c:v>
                </c:pt>
                <c:pt idx="116">
                  <c:v>6447.955078125</c:v>
                </c:pt>
                <c:pt idx="117">
                  <c:v>6524.5498046875</c:v>
                </c:pt>
                <c:pt idx="118">
                  <c:v>6527.34375</c:v>
                </c:pt>
                <c:pt idx="119">
                  <c:v>6466.67333984375</c:v>
                </c:pt>
                <c:pt idx="120">
                  <c:v>6388.1025390625</c:v>
                </c:pt>
                <c:pt idx="121">
                  <c:v>6337.904296875</c:v>
                </c:pt>
                <c:pt idx="122">
                  <c:v>6333.3779296875</c:v>
                </c:pt>
                <c:pt idx="123">
                  <c:v>6357.28564453125</c:v>
                </c:pt>
                <c:pt idx="124">
                  <c:v>6376.4404296875</c:v>
                </c:pt>
                <c:pt idx="125">
                  <c:v>6367.86328125</c:v>
                </c:pt>
                <c:pt idx="126">
                  <c:v>6333.330078125</c:v>
                </c:pt>
                <c:pt idx="127">
                  <c:v>6294.29443359375</c:v>
                </c:pt>
                <c:pt idx="128">
                  <c:v>6274.1171875</c:v>
                </c:pt>
                <c:pt idx="129">
                  <c:v>6282.16162109375</c:v>
                </c:pt>
                <c:pt idx="130">
                  <c:v>6310.39111328125</c:v>
                </c:pt>
                <c:pt idx="131">
                  <c:v>6342.37060546875</c:v>
                </c:pt>
                <c:pt idx="132">
                  <c:v>6365.796875</c:v>
                </c:pt>
                <c:pt idx="133">
                  <c:v>6378.841796875</c:v>
                </c:pt>
                <c:pt idx="134">
                  <c:v>6386.9365234375</c:v>
                </c:pt>
                <c:pt idx="135">
                  <c:v>6394.45849609375</c:v>
                </c:pt>
                <c:pt idx="136">
                  <c:v>6399.06982421875</c:v>
                </c:pt>
                <c:pt idx="137">
                  <c:v>6393.42822265625</c:v>
                </c:pt>
                <c:pt idx="138">
                  <c:v>6372.5498046875</c:v>
                </c:pt>
                <c:pt idx="139">
                  <c:v>6340.43994140625</c:v>
                </c:pt>
                <c:pt idx="140">
                  <c:v>6310.14990234375</c:v>
                </c:pt>
                <c:pt idx="141">
                  <c:v>6296.54248046875</c:v>
                </c:pt>
                <c:pt idx="142">
                  <c:v>6306.87646484375</c:v>
                </c:pt>
                <c:pt idx="143">
                  <c:v>6336.306640625</c:v>
                </c:pt>
                <c:pt idx="144">
                  <c:v>6371.9306640625</c:v>
                </c:pt>
                <c:pt idx="145">
                  <c:v>6402.42431640625</c:v>
                </c:pt>
                <c:pt idx="146">
                  <c:v>6425.603515625</c:v>
                </c:pt>
                <c:pt idx="147">
                  <c:v>6447.392578125</c:v>
                </c:pt>
                <c:pt idx="148">
                  <c:v>6472.43994140625</c:v>
                </c:pt>
                <c:pt idx="149">
                  <c:v>6494.10693359375</c:v>
                </c:pt>
                <c:pt idx="150">
                  <c:v>6493.61474609375</c:v>
                </c:pt>
                <c:pt idx="151">
                  <c:v>6452.02197265625</c:v>
                </c:pt>
                <c:pt idx="152">
                  <c:v>6368.17431640625</c:v>
                </c:pt>
                <c:pt idx="153">
                  <c:v>6268.74853515625</c:v>
                </c:pt>
                <c:pt idx="154">
                  <c:v>6199.642578125</c:v>
                </c:pt>
                <c:pt idx="155">
                  <c:v>6200.46337890625</c:v>
                </c:pt>
                <c:pt idx="156">
                  <c:v>6277.3994140625</c:v>
                </c:pt>
                <c:pt idx="157">
                  <c:v>6393.72900390625</c:v>
                </c:pt>
                <c:pt idx="158">
                  <c:v>6487.1953125</c:v>
                </c:pt>
                <c:pt idx="159">
                  <c:v>6505.39697265625</c:v>
                </c:pt>
                <c:pt idx="160">
                  <c:v>6436.97900390625</c:v>
                </c:pt>
                <c:pt idx="161">
                  <c:v>6318.03173828125</c:v>
                </c:pt>
                <c:pt idx="162">
                  <c:v>6209.39306640625</c:v>
                </c:pt>
                <c:pt idx="163">
                  <c:v>6160.1494140625</c:v>
                </c:pt>
                <c:pt idx="164">
                  <c:v>6181.48388671875</c:v>
                </c:pt>
                <c:pt idx="165">
                  <c:v>6246.7783203125</c:v>
                </c:pt>
                <c:pt idx="166">
                  <c:v>6314.97314453125</c:v>
                </c:pt>
                <c:pt idx="167">
                  <c:v>6358.6513671875</c:v>
                </c:pt>
                <c:pt idx="168">
                  <c:v>6377.22998046875</c:v>
                </c:pt>
                <c:pt idx="169">
                  <c:v>6388.6845703125</c:v>
                </c:pt>
                <c:pt idx="170">
                  <c:v>6409.564453125</c:v>
                </c:pt>
                <c:pt idx="171">
                  <c:v>6440.21826171875</c:v>
                </c:pt>
                <c:pt idx="172">
                  <c:v>6465.74560546875</c:v>
                </c:pt>
                <c:pt idx="173">
                  <c:v>6469.60888671875</c:v>
                </c:pt>
                <c:pt idx="174">
                  <c:v>6447.4462890625</c:v>
                </c:pt>
                <c:pt idx="175">
                  <c:v>6410.19384765625</c:v>
                </c:pt>
                <c:pt idx="176">
                  <c:v>6375.53173828125</c:v>
                </c:pt>
                <c:pt idx="177">
                  <c:v>6355.9169921875</c:v>
                </c:pt>
                <c:pt idx="178">
                  <c:v>6352.71728515625</c:v>
                </c:pt>
                <c:pt idx="179">
                  <c:v>6359.3505859375</c:v>
                </c:pt>
                <c:pt idx="180">
                  <c:v>6368.5810546875</c:v>
                </c:pt>
                <c:pt idx="181">
                  <c:v>6376.90380859375</c:v>
                </c:pt>
                <c:pt idx="182">
                  <c:v>6383.318359375</c:v>
                </c:pt>
                <c:pt idx="183">
                  <c:v>6385.8046875</c:v>
                </c:pt>
                <c:pt idx="184">
                  <c:v>6380.6025390625</c:v>
                </c:pt>
                <c:pt idx="185">
                  <c:v>6365.72314453125</c:v>
                </c:pt>
                <c:pt idx="186">
                  <c:v>6345.0341796875</c:v>
                </c:pt>
                <c:pt idx="187">
                  <c:v>6328.04931640625</c:v>
                </c:pt>
                <c:pt idx="188">
                  <c:v>6324.43896484375</c:v>
                </c:pt>
                <c:pt idx="189">
                  <c:v>6337.451171875</c:v>
                </c:pt>
                <c:pt idx="190">
                  <c:v>6361.78857421875</c:v>
                </c:pt>
                <c:pt idx="191">
                  <c:v>6387.5712890625</c:v>
                </c:pt>
                <c:pt idx="192">
                  <c:v>6406.6181640625</c:v>
                </c:pt>
                <c:pt idx="193">
                  <c:v>6415.541015625</c:v>
                </c:pt>
                <c:pt idx="194">
                  <c:v>6413.82373046875</c:v>
                </c:pt>
                <c:pt idx="195">
                  <c:v>6400.40576171875</c:v>
                </c:pt>
                <c:pt idx="196">
                  <c:v>6373.86474609375</c:v>
                </c:pt>
                <c:pt idx="197">
                  <c:v>6337.140625</c:v>
                </c:pt>
                <c:pt idx="198">
                  <c:v>6301.7490234375</c:v>
                </c:pt>
                <c:pt idx="199">
                  <c:v>6284.9091796875</c:v>
                </c:pt>
                <c:pt idx="200">
                  <c:v>6298.5224609375</c:v>
                </c:pt>
                <c:pt idx="201">
                  <c:v>6337.2958984375</c:v>
                </c:pt>
                <c:pt idx="202">
                  <c:v>6376.7548828125</c:v>
                </c:pt>
                <c:pt idx="203">
                  <c:v>6386.02197265625</c:v>
                </c:pt>
                <c:pt idx="204">
                  <c:v>6348.65625</c:v>
                </c:pt>
                <c:pt idx="205">
                  <c:v>6276.8720703125</c:v>
                </c:pt>
                <c:pt idx="206">
                  <c:v>6207.44970703125</c:v>
                </c:pt>
                <c:pt idx="207">
                  <c:v>6180.3427734375</c:v>
                </c:pt>
                <c:pt idx="208">
                  <c:v>6213.9892578125</c:v>
                </c:pt>
                <c:pt idx="209">
                  <c:v>6294.31298828125</c:v>
                </c:pt>
                <c:pt idx="210">
                  <c:v>6384.7236328125</c:v>
                </c:pt>
                <c:pt idx="211">
                  <c:v>6449.42822265625</c:v>
                </c:pt>
                <c:pt idx="212">
                  <c:v>6473.4697265625</c:v>
                </c:pt>
                <c:pt idx="213">
                  <c:v>6466.60693359375</c:v>
                </c:pt>
                <c:pt idx="214">
                  <c:v>6450.84521484375</c:v>
                </c:pt>
                <c:pt idx="215">
                  <c:v>6442.90869140625</c:v>
                </c:pt>
                <c:pt idx="216">
                  <c:v>6444.68603515625</c:v>
                </c:pt>
                <c:pt idx="217">
                  <c:v>6446.615234375</c:v>
                </c:pt>
                <c:pt idx="218">
                  <c:v>6438.568359375</c:v>
                </c:pt>
                <c:pt idx="219">
                  <c:v>6418.4267578125</c:v>
                </c:pt>
                <c:pt idx="220">
                  <c:v>6392.5791015625</c:v>
                </c:pt>
                <c:pt idx="221">
                  <c:v>6370.18701171875</c:v>
                </c:pt>
                <c:pt idx="222">
                  <c:v>6357.3701171875</c:v>
                </c:pt>
                <c:pt idx="223">
                  <c:v>6355.5244140625</c:v>
                </c:pt>
                <c:pt idx="224">
                  <c:v>6362.9619140625</c:v>
                </c:pt>
                <c:pt idx="225">
                  <c:v>6376.341796875</c:v>
                </c:pt>
                <c:pt idx="226">
                  <c:v>6390.22607421875</c:v>
                </c:pt>
                <c:pt idx="227">
                  <c:v>6396.837890625</c:v>
                </c:pt>
                <c:pt idx="228">
                  <c:v>6389.0263671875</c:v>
                </c:pt>
                <c:pt idx="229">
                  <c:v>6366.0146484375</c:v>
                </c:pt>
                <c:pt idx="230">
                  <c:v>6337.0927734375</c:v>
                </c:pt>
                <c:pt idx="231">
                  <c:v>6318.10302734375</c:v>
                </c:pt>
                <c:pt idx="232">
                  <c:v>6320.9443359375</c:v>
                </c:pt>
                <c:pt idx="233">
                  <c:v>6343.22119140625</c:v>
                </c:pt>
                <c:pt idx="234">
                  <c:v>6367.0751953125</c:v>
                </c:pt>
                <c:pt idx="235">
                  <c:v>6370.26708984375</c:v>
                </c:pt>
                <c:pt idx="236">
                  <c:v>6342.73828125</c:v>
                </c:pt>
                <c:pt idx="237">
                  <c:v>6296.24609375</c:v>
                </c:pt>
                <c:pt idx="238">
                  <c:v>6258.599609375</c:v>
                </c:pt>
                <c:pt idx="239">
                  <c:v>6255.22705078125</c:v>
                </c:pt>
                <c:pt idx="240">
                  <c:v>6290.7978515625</c:v>
                </c:pt>
                <c:pt idx="241">
                  <c:v>6344.3583984375</c:v>
                </c:pt>
                <c:pt idx="242">
                  <c:v>6382.07861328125</c:v>
                </c:pt>
                <c:pt idx="243">
                  <c:v>6379.1806640625</c:v>
                </c:pt>
                <c:pt idx="244">
                  <c:v>6336.26416015625</c:v>
                </c:pt>
                <c:pt idx="245">
                  <c:v>6279.4677734375</c:v>
                </c:pt>
                <c:pt idx="246">
                  <c:v>6245.0244140625</c:v>
                </c:pt>
                <c:pt idx="247">
                  <c:v>6258.54541015625</c:v>
                </c:pt>
                <c:pt idx="248">
                  <c:v>6321.37548828125</c:v>
                </c:pt>
                <c:pt idx="249">
                  <c:v>6410.607421875</c:v>
                </c:pt>
                <c:pt idx="250">
                  <c:v>6490.9169921875</c:v>
                </c:pt>
                <c:pt idx="251">
                  <c:v>6530.95166015625</c:v>
                </c:pt>
                <c:pt idx="252">
                  <c:v>6516.64013671875</c:v>
                </c:pt>
                <c:pt idx="253">
                  <c:v>6456.6533203125</c:v>
                </c:pt>
                <c:pt idx="254">
                  <c:v>6378.64013671875</c:v>
                </c:pt>
                <c:pt idx="255">
                  <c:v>6317.64404296875</c:v>
                </c:pt>
                <c:pt idx="256">
                  <c:v>6300.70947265625</c:v>
                </c:pt>
                <c:pt idx="257">
                  <c:v>6334.029296875</c:v>
                </c:pt>
                <c:pt idx="258">
                  <c:v>6399.35986328125</c:v>
                </c:pt>
                <c:pt idx="259">
                  <c:v>6462.8544921875</c:v>
                </c:pt>
                <c:pt idx="260">
                  <c:v>6492.62548828125</c:v>
                </c:pt>
                <c:pt idx="261">
                  <c:v>6475.35400390625</c:v>
                </c:pt>
                <c:pt idx="262">
                  <c:v>6421.95751953125</c:v>
                </c:pt>
                <c:pt idx="263">
                  <c:v>6359.06005859375</c:v>
                </c:pt>
                <c:pt idx="264">
                  <c:v>6312.43408203125</c:v>
                </c:pt>
                <c:pt idx="265">
                  <c:v>6293.705078125</c:v>
                </c:pt>
                <c:pt idx="266">
                  <c:v>6298.35009765625</c:v>
                </c:pt>
                <c:pt idx="267">
                  <c:v>6313.994140625</c:v>
                </c:pt>
                <c:pt idx="268">
                  <c:v>6330.576171875</c:v>
                </c:pt>
                <c:pt idx="269">
                  <c:v>6344.14404296875</c:v>
                </c:pt>
                <c:pt idx="270">
                  <c:v>6353.19091796875</c:v>
                </c:pt>
                <c:pt idx="271">
                  <c:v>6353.80517578125</c:v>
                </c:pt>
                <c:pt idx="272">
                  <c:v>6340.61962890625</c:v>
                </c:pt>
                <c:pt idx="273">
                  <c:v>6313.92236328125</c:v>
                </c:pt>
                <c:pt idx="274">
                  <c:v>6285.68603515625</c:v>
                </c:pt>
                <c:pt idx="275">
                  <c:v>6276.34814453125</c:v>
                </c:pt>
                <c:pt idx="276">
                  <c:v>6301.72998046875</c:v>
                </c:pt>
                <c:pt idx="277">
                  <c:v>6359.24365234375</c:v>
                </c:pt>
                <c:pt idx="278">
                  <c:v>6425.380859375</c:v>
                </c:pt>
                <c:pt idx="279">
                  <c:v>6468.7451171875</c:v>
                </c:pt>
                <c:pt idx="280">
                  <c:v>6470.2646484375</c:v>
                </c:pt>
                <c:pt idx="281">
                  <c:v>6435.388671875</c:v>
                </c:pt>
                <c:pt idx="282">
                  <c:v>6388.5439453125</c:v>
                </c:pt>
                <c:pt idx="283">
                  <c:v>6354.10205078125</c:v>
                </c:pt>
                <c:pt idx="284">
                  <c:v>6339.1416015625</c:v>
                </c:pt>
                <c:pt idx="285">
                  <c:v>6331.8388671875</c:v>
                </c:pt>
                <c:pt idx="286">
                  <c:v>6316.2021484375</c:v>
                </c:pt>
                <c:pt idx="287">
                  <c:v>6289.94091796875</c:v>
                </c:pt>
                <c:pt idx="288">
                  <c:v>6269.3974609375</c:v>
                </c:pt>
                <c:pt idx="289">
                  <c:v>6276.49169921875</c:v>
                </c:pt>
                <c:pt idx="290">
                  <c:v>6318.34912109375</c:v>
                </c:pt>
                <c:pt idx="291">
                  <c:v>6377.2890625</c:v>
                </c:pt>
                <c:pt idx="292">
                  <c:v>6420.8544921875</c:v>
                </c:pt>
                <c:pt idx="293">
                  <c:v>6424.908203125</c:v>
                </c:pt>
                <c:pt idx="294">
                  <c:v>6391.517578125</c:v>
                </c:pt>
                <c:pt idx="295">
                  <c:v>6347.0517578125</c:v>
                </c:pt>
                <c:pt idx="296">
                  <c:v>6321.8916015625</c:v>
                </c:pt>
                <c:pt idx="297">
                  <c:v>6328.1328125</c:v>
                </c:pt>
                <c:pt idx="298">
                  <c:v>6353.17724609375</c:v>
                </c:pt>
                <c:pt idx="299">
                  <c:v>6373.80810546875</c:v>
                </c:pt>
                <c:pt idx="300">
                  <c:v>6378.2470703125</c:v>
                </c:pt>
                <c:pt idx="301">
                  <c:v>6377.09765625</c:v>
                </c:pt>
                <c:pt idx="302">
                  <c:v>6393.4228515625</c:v>
                </c:pt>
                <c:pt idx="303">
                  <c:v>6439.8564453125</c:v>
                </c:pt>
                <c:pt idx="304">
                  <c:v>6501.9892578125</c:v>
                </c:pt>
                <c:pt idx="305">
                  <c:v>6542.935546875</c:v>
                </c:pt>
                <c:pt idx="306">
                  <c:v>6527.4140625</c:v>
                </c:pt>
                <c:pt idx="307">
                  <c:v>6448.0458984375</c:v>
                </c:pt>
                <c:pt idx="308">
                  <c:v>6334.228515625</c:v>
                </c:pt>
                <c:pt idx="309">
                  <c:v>6236.4951171875</c:v>
                </c:pt>
                <c:pt idx="310">
                  <c:v>6196.8681640625</c:v>
                </c:pt>
                <c:pt idx="311">
                  <c:v>6225.1484375</c:v>
                </c:pt>
                <c:pt idx="312">
                  <c:v>6295.99853515625</c:v>
                </c:pt>
                <c:pt idx="313">
                  <c:v>6366.8798828125</c:v>
                </c:pt>
                <c:pt idx="314">
                  <c:v>6403.5869140625</c:v>
                </c:pt>
                <c:pt idx="315">
                  <c:v>6397.16015625</c:v>
                </c:pt>
                <c:pt idx="316">
                  <c:v>6363.73388671875</c:v>
                </c:pt>
                <c:pt idx="317">
                  <c:v>6330.48583984375</c:v>
                </c:pt>
                <c:pt idx="318">
                  <c:v>6318.19775390625</c:v>
                </c:pt>
                <c:pt idx="319">
                  <c:v>6330.53173828125</c:v>
                </c:pt>
                <c:pt idx="320">
                  <c:v>6354.32470703125</c:v>
                </c:pt>
                <c:pt idx="321">
                  <c:v>6368.80419921875</c:v>
                </c:pt>
                <c:pt idx="322">
                  <c:v>6358.02880859375</c:v>
                </c:pt>
                <c:pt idx="323">
                  <c:v>6320.49365234375</c:v>
                </c:pt>
                <c:pt idx="324">
                  <c:v>6271.5556640625</c:v>
                </c:pt>
                <c:pt idx="325">
                  <c:v>6237.24169921875</c:v>
                </c:pt>
                <c:pt idx="326">
                  <c:v>6241.671875</c:v>
                </c:pt>
                <c:pt idx="327">
                  <c:v>6293.892578125</c:v>
                </c:pt>
                <c:pt idx="328">
                  <c:v>6381.2314453125</c:v>
                </c:pt>
                <c:pt idx="329">
                  <c:v>6473.677734375</c:v>
                </c:pt>
                <c:pt idx="330">
                  <c:v>6537.7509765625</c:v>
                </c:pt>
                <c:pt idx="331">
                  <c:v>6552.4033203125</c:v>
                </c:pt>
                <c:pt idx="332">
                  <c:v>6517.95751953125</c:v>
                </c:pt>
                <c:pt idx="333">
                  <c:v>6453.41845703125</c:v>
                </c:pt>
                <c:pt idx="334">
                  <c:v>6384.8818359375</c:v>
                </c:pt>
                <c:pt idx="335">
                  <c:v>6332.8759765625</c:v>
                </c:pt>
                <c:pt idx="336">
                  <c:v>6305.8271484375</c:v>
                </c:pt>
                <c:pt idx="337">
                  <c:v>6301.40673828125</c:v>
                </c:pt>
                <c:pt idx="338">
                  <c:v>6312.03955078125</c:v>
                </c:pt>
                <c:pt idx="339">
                  <c:v>6329.4697265625</c:v>
                </c:pt>
                <c:pt idx="340">
                  <c:v>6346.29931640625</c:v>
                </c:pt>
                <c:pt idx="341">
                  <c:v>6356.248046875</c:v>
                </c:pt>
                <c:pt idx="342">
                  <c:v>6355.6962890625</c:v>
                </c:pt>
                <c:pt idx="343">
                  <c:v>6346.39990234375</c:v>
                </c:pt>
                <c:pt idx="344">
                  <c:v>6336.279296875</c:v>
                </c:pt>
                <c:pt idx="345">
                  <c:v>6335.5693359375</c:v>
                </c:pt>
                <c:pt idx="346">
                  <c:v>6349.60986328125</c:v>
                </c:pt>
                <c:pt idx="347">
                  <c:v>6373.58203125</c:v>
                </c:pt>
                <c:pt idx="348">
                  <c:v>6394.2626953125</c:v>
                </c:pt>
                <c:pt idx="349">
                  <c:v>6398.7333984375</c:v>
                </c:pt>
              </c:numCache>
            </c:numRef>
          </c:yVal>
          <c:smooth val="1"/>
          <c:extLst>
            <c:ext xmlns:c16="http://schemas.microsoft.com/office/drawing/2014/chart" uri="{C3380CC4-5D6E-409C-BE32-E72D297353CC}">
              <c16:uniqueId val="{00000018-0DDB-41B5-BE83-A9CFE49F3CE3}"/>
            </c:ext>
          </c:extLst>
        </c:ser>
        <c:ser>
          <c:idx val="25"/>
          <c:order val="25"/>
          <c:tx>
            <c:strRef>
              <c:f>hc_sub_007!$Z$1</c:f>
              <c:strCache>
                <c:ptCount val="1"/>
                <c:pt idx="0">
                  <c:v>Coor_26</c:v>
                </c:pt>
              </c:strCache>
            </c:strRef>
          </c:tx>
          <c:spPr>
            <a:ln w="28575" cap="rnd">
              <a:solidFill>
                <a:schemeClr val="accent2">
                  <a:lumMod val="60000"/>
                  <a:lumOff val="40000"/>
                </a:schemeClr>
              </a:solidFill>
              <a:round/>
            </a:ln>
            <a:effectLst/>
          </c:spPr>
          <c:marker>
            <c:symbol val="none"/>
          </c:marker>
          <c:yVal>
            <c:numRef>
              <c:f>hc_sub_007!$Z$2:$Z$351</c:f>
              <c:numCache>
                <c:formatCode>0.00000000000_ </c:formatCode>
                <c:ptCount val="350"/>
                <c:pt idx="0">
                  <c:v>7509.4130859375</c:v>
                </c:pt>
                <c:pt idx="1">
                  <c:v>7496.72265625</c:v>
                </c:pt>
                <c:pt idx="2">
                  <c:v>7465.82861328125</c:v>
                </c:pt>
                <c:pt idx="3">
                  <c:v>7436.90869140625</c:v>
                </c:pt>
                <c:pt idx="4">
                  <c:v>7429.65966796875</c:v>
                </c:pt>
                <c:pt idx="5">
                  <c:v>7448.484375</c:v>
                </c:pt>
                <c:pt idx="6">
                  <c:v>7480.00439453125</c:v>
                </c:pt>
                <c:pt idx="7">
                  <c:v>7504.3544921875</c:v>
                </c:pt>
                <c:pt idx="8">
                  <c:v>7510.505859375</c:v>
                </c:pt>
                <c:pt idx="9">
                  <c:v>7503.05078125</c:v>
                </c:pt>
                <c:pt idx="10">
                  <c:v>7495.4345703125</c:v>
                </c:pt>
                <c:pt idx="11">
                  <c:v>7495.96435546875</c:v>
                </c:pt>
                <c:pt idx="12">
                  <c:v>7498.6806640625</c:v>
                </c:pt>
                <c:pt idx="13">
                  <c:v>7487.021484375</c:v>
                </c:pt>
                <c:pt idx="14">
                  <c:v>7447.826171875</c:v>
                </c:pt>
                <c:pt idx="15">
                  <c:v>7385.04345703125</c:v>
                </c:pt>
                <c:pt idx="16">
                  <c:v>7322.56298828125</c:v>
                </c:pt>
                <c:pt idx="17">
                  <c:v>7293.2421875</c:v>
                </c:pt>
                <c:pt idx="18">
                  <c:v>7320.51708984375</c:v>
                </c:pt>
                <c:pt idx="19">
                  <c:v>7403.5458984375</c:v>
                </c:pt>
                <c:pt idx="20">
                  <c:v>7514.52294921875</c:v>
                </c:pt>
                <c:pt idx="21">
                  <c:v>7609.9248046875</c:v>
                </c:pt>
                <c:pt idx="22">
                  <c:v>7650.3212890625</c:v>
                </c:pt>
                <c:pt idx="23">
                  <c:v>7619.35986328125</c:v>
                </c:pt>
                <c:pt idx="24">
                  <c:v>7532.6787109375</c:v>
                </c:pt>
                <c:pt idx="25">
                  <c:v>7431.68359375</c:v>
                </c:pt>
                <c:pt idx="26">
                  <c:v>7364.0556640625</c:v>
                </c:pt>
                <c:pt idx="27">
                  <c:v>7359.9716796875</c:v>
                </c:pt>
                <c:pt idx="28">
                  <c:v>7416.6259765625</c:v>
                </c:pt>
                <c:pt idx="29">
                  <c:v>7500.40869140625</c:v>
                </c:pt>
                <c:pt idx="30">
                  <c:v>7566.4140625</c:v>
                </c:pt>
                <c:pt idx="31">
                  <c:v>7584.06787109375</c:v>
                </c:pt>
                <c:pt idx="32">
                  <c:v>7553.0986328125</c:v>
                </c:pt>
                <c:pt idx="33">
                  <c:v>7500.07421875</c:v>
                </c:pt>
                <c:pt idx="34">
                  <c:v>7458.84716796875</c:v>
                </c:pt>
                <c:pt idx="35">
                  <c:v>7449.21533203125</c:v>
                </c:pt>
                <c:pt idx="36">
                  <c:v>7468.38232421875</c:v>
                </c:pt>
                <c:pt idx="37">
                  <c:v>7499.09716796875</c:v>
                </c:pt>
                <c:pt idx="38">
                  <c:v>7525.28466796875</c:v>
                </c:pt>
                <c:pt idx="39">
                  <c:v>7541.265625</c:v>
                </c:pt>
                <c:pt idx="40">
                  <c:v>7548.16748046875</c:v>
                </c:pt>
                <c:pt idx="41">
                  <c:v>7543.88818359375</c:v>
                </c:pt>
                <c:pt idx="42">
                  <c:v>7519.318359375</c:v>
                </c:pt>
                <c:pt idx="43">
                  <c:v>7467.1669921875</c:v>
                </c:pt>
                <c:pt idx="44">
                  <c:v>7396.1689453125</c:v>
                </c:pt>
                <c:pt idx="45">
                  <c:v>7335.42626953125</c:v>
                </c:pt>
                <c:pt idx="46">
                  <c:v>7319.95166015625</c:v>
                </c:pt>
                <c:pt idx="47">
                  <c:v>7365.11474609375</c:v>
                </c:pt>
                <c:pt idx="48">
                  <c:v>7450.2919921875</c:v>
                </c:pt>
                <c:pt idx="49">
                  <c:v>7528.0302734375</c:v>
                </c:pt>
                <c:pt idx="50">
                  <c:v>7555.59765625</c:v>
                </c:pt>
                <c:pt idx="51">
                  <c:v>7526.21484375</c:v>
                </c:pt>
                <c:pt idx="52">
                  <c:v>7474.76513671875</c:v>
                </c:pt>
                <c:pt idx="53">
                  <c:v>7451.4130859375</c:v>
                </c:pt>
                <c:pt idx="54">
                  <c:v>7482.36376953125</c:v>
                </c:pt>
                <c:pt idx="55">
                  <c:v>7548.66259765625</c:v>
                </c:pt>
                <c:pt idx="56">
                  <c:v>7600.65380859375</c:v>
                </c:pt>
                <c:pt idx="57">
                  <c:v>7597.25927734375</c:v>
                </c:pt>
                <c:pt idx="58">
                  <c:v>7538.61328125</c:v>
                </c:pt>
                <c:pt idx="59">
                  <c:v>7465.3740234375</c:v>
                </c:pt>
                <c:pt idx="60">
                  <c:v>7425.06787109375</c:v>
                </c:pt>
                <c:pt idx="61">
                  <c:v>7433.11767578125</c:v>
                </c:pt>
                <c:pt idx="62">
                  <c:v>7461.009765625</c:v>
                </c:pt>
                <c:pt idx="63">
                  <c:v>7461.7958984375</c:v>
                </c:pt>
                <c:pt idx="64">
                  <c:v>7412.0166015625</c:v>
                </c:pt>
                <c:pt idx="65">
                  <c:v>7334.95361328125</c:v>
                </c:pt>
                <c:pt idx="66">
                  <c:v>7285.06787109375</c:v>
                </c:pt>
                <c:pt idx="67">
                  <c:v>7305.3974609375</c:v>
                </c:pt>
                <c:pt idx="68">
                  <c:v>7392.25244140625</c:v>
                </c:pt>
                <c:pt idx="69">
                  <c:v>7495.9990234375</c:v>
                </c:pt>
                <c:pt idx="70">
                  <c:v>7557.5712890625</c:v>
                </c:pt>
                <c:pt idx="71">
                  <c:v>7551.63330078125</c:v>
                </c:pt>
                <c:pt idx="72">
                  <c:v>7502.453125</c:v>
                </c:pt>
                <c:pt idx="73">
                  <c:v>7461.1416015625</c:v>
                </c:pt>
                <c:pt idx="74">
                  <c:v>7463.92529296875</c:v>
                </c:pt>
                <c:pt idx="75">
                  <c:v>7505.2529296875</c:v>
                </c:pt>
                <c:pt idx="76">
                  <c:v>7545.955078125</c:v>
                </c:pt>
                <c:pt idx="77">
                  <c:v>7547.63232421875</c:v>
                </c:pt>
                <c:pt idx="78">
                  <c:v>7504.17529296875</c:v>
                </c:pt>
                <c:pt idx="79">
                  <c:v>7445.650390625</c:v>
                </c:pt>
                <c:pt idx="80">
                  <c:v>7413.66455078125</c:v>
                </c:pt>
                <c:pt idx="81">
                  <c:v>7429.9765625</c:v>
                </c:pt>
                <c:pt idx="82">
                  <c:v>7483.337890625</c:v>
                </c:pt>
                <c:pt idx="83">
                  <c:v>7542.36083984375</c:v>
                </c:pt>
                <c:pt idx="84">
                  <c:v>7580.60400390625</c:v>
                </c:pt>
                <c:pt idx="85">
                  <c:v>7592.25390625</c:v>
                </c:pt>
                <c:pt idx="86">
                  <c:v>7587.83251953125</c:v>
                </c:pt>
                <c:pt idx="87">
                  <c:v>7577.82861328125</c:v>
                </c:pt>
                <c:pt idx="88">
                  <c:v>7561.4619140625</c:v>
                </c:pt>
                <c:pt idx="89">
                  <c:v>7530.63671875</c:v>
                </c:pt>
                <c:pt idx="90">
                  <c:v>7483.5224609375</c:v>
                </c:pt>
                <c:pt idx="91">
                  <c:v>7432.95068359375</c:v>
                </c:pt>
                <c:pt idx="92">
                  <c:v>7400.1337890625</c:v>
                </c:pt>
                <c:pt idx="93">
                  <c:v>7398.54052734375</c:v>
                </c:pt>
                <c:pt idx="94">
                  <c:v>7422.4892578125</c:v>
                </c:pt>
                <c:pt idx="95">
                  <c:v>7451.16943359375</c:v>
                </c:pt>
                <c:pt idx="96">
                  <c:v>7465.033203125</c:v>
                </c:pt>
                <c:pt idx="97">
                  <c:v>7460.46630859375</c:v>
                </c:pt>
                <c:pt idx="98">
                  <c:v>7450.30224609375</c:v>
                </c:pt>
                <c:pt idx="99">
                  <c:v>7450.39501953125</c:v>
                </c:pt>
                <c:pt idx="100">
                  <c:v>7464.63037109375</c:v>
                </c:pt>
                <c:pt idx="101">
                  <c:v>7481.591796875</c:v>
                </c:pt>
                <c:pt idx="102">
                  <c:v>7485.2978515625</c:v>
                </c:pt>
                <c:pt idx="103">
                  <c:v>7469.9013671875</c:v>
                </c:pt>
                <c:pt idx="104">
                  <c:v>7445.193359375</c:v>
                </c:pt>
                <c:pt idx="105">
                  <c:v>7428.4404296875</c:v>
                </c:pt>
                <c:pt idx="106">
                  <c:v>7430.21728515625</c:v>
                </c:pt>
                <c:pt idx="107">
                  <c:v>7446.59423828125</c:v>
                </c:pt>
                <c:pt idx="108">
                  <c:v>7463.55517578125</c:v>
                </c:pt>
                <c:pt idx="109">
                  <c:v>7468.4775390625</c:v>
                </c:pt>
                <c:pt idx="110">
                  <c:v>7458.1513671875</c:v>
                </c:pt>
                <c:pt idx="111">
                  <c:v>7437.564453125</c:v>
                </c:pt>
                <c:pt idx="112">
                  <c:v>7413.20263671875</c:v>
                </c:pt>
                <c:pt idx="113">
                  <c:v>7389.32568359375</c:v>
                </c:pt>
                <c:pt idx="114">
                  <c:v>7371.09716796875</c:v>
                </c:pt>
                <c:pt idx="115">
                  <c:v>7369.5078125</c:v>
                </c:pt>
                <c:pt idx="116">
                  <c:v>7399.35302734375</c:v>
                </c:pt>
                <c:pt idx="117">
                  <c:v>7467.74560546875</c:v>
                </c:pt>
                <c:pt idx="118">
                  <c:v>7561.5224609375</c:v>
                </c:pt>
                <c:pt idx="119">
                  <c:v>7646.5634765625</c:v>
                </c:pt>
                <c:pt idx="120">
                  <c:v>7684.49755859375</c:v>
                </c:pt>
                <c:pt idx="121">
                  <c:v>7657.51123046875</c:v>
                </c:pt>
                <c:pt idx="122">
                  <c:v>7582.81396484375</c:v>
                </c:pt>
                <c:pt idx="123">
                  <c:v>7503.861328125</c:v>
                </c:pt>
                <c:pt idx="124">
                  <c:v>7462.6298828125</c:v>
                </c:pt>
                <c:pt idx="125">
                  <c:v>7472.4990234375</c:v>
                </c:pt>
                <c:pt idx="126">
                  <c:v>7511.65966796875</c:v>
                </c:pt>
                <c:pt idx="127">
                  <c:v>7541.5009765625</c:v>
                </c:pt>
                <c:pt idx="128">
                  <c:v>7535.3193359375</c:v>
                </c:pt>
                <c:pt idx="129">
                  <c:v>7495.4443359375</c:v>
                </c:pt>
                <c:pt idx="130">
                  <c:v>7447.0927734375</c:v>
                </c:pt>
                <c:pt idx="131">
                  <c:v>7416.2177734375</c:v>
                </c:pt>
                <c:pt idx="132">
                  <c:v>7410.5029296875</c:v>
                </c:pt>
                <c:pt idx="133">
                  <c:v>7418.17724609375</c:v>
                </c:pt>
                <c:pt idx="134">
                  <c:v>7423.12841796875</c:v>
                </c:pt>
                <c:pt idx="135">
                  <c:v>7421.193359375</c:v>
                </c:pt>
                <c:pt idx="136">
                  <c:v>7422.84521484375</c:v>
                </c:pt>
                <c:pt idx="137">
                  <c:v>7440.7236328125</c:v>
                </c:pt>
                <c:pt idx="138">
                  <c:v>7474.37744140625</c:v>
                </c:pt>
                <c:pt idx="139">
                  <c:v>7506.97900390625</c:v>
                </c:pt>
                <c:pt idx="140">
                  <c:v>7517.8134765625</c:v>
                </c:pt>
                <c:pt idx="141">
                  <c:v>7500.04443359375</c:v>
                </c:pt>
                <c:pt idx="142">
                  <c:v>7468.189453125</c:v>
                </c:pt>
                <c:pt idx="143">
                  <c:v>7448.2841796875</c:v>
                </c:pt>
                <c:pt idx="144">
                  <c:v>7458.2841796875</c:v>
                </c:pt>
                <c:pt idx="145">
                  <c:v>7494.34521484375</c:v>
                </c:pt>
                <c:pt idx="146">
                  <c:v>7533.646484375</c:v>
                </c:pt>
                <c:pt idx="147">
                  <c:v>7550.962890625</c:v>
                </c:pt>
                <c:pt idx="148">
                  <c:v>7535.77490234375</c:v>
                </c:pt>
                <c:pt idx="149">
                  <c:v>7497.45947265625</c:v>
                </c:pt>
                <c:pt idx="150">
                  <c:v>7456.4716796875</c:v>
                </c:pt>
                <c:pt idx="151">
                  <c:v>7430.05078125</c:v>
                </c:pt>
                <c:pt idx="152">
                  <c:v>7423.40478515625</c:v>
                </c:pt>
                <c:pt idx="153">
                  <c:v>7430.88818359375</c:v>
                </c:pt>
                <c:pt idx="154">
                  <c:v>7443.19873046875</c:v>
                </c:pt>
                <c:pt idx="155">
                  <c:v>7453.4208984375</c:v>
                </c:pt>
                <c:pt idx="156">
                  <c:v>7458.40234375</c:v>
                </c:pt>
                <c:pt idx="157">
                  <c:v>7457.44140625</c:v>
                </c:pt>
                <c:pt idx="158">
                  <c:v>7451.9287109375</c:v>
                </c:pt>
                <c:pt idx="159">
                  <c:v>7446.34228515625</c:v>
                </c:pt>
                <c:pt idx="160">
                  <c:v>7447.45947265625</c:v>
                </c:pt>
                <c:pt idx="161">
                  <c:v>7459.4794921875</c:v>
                </c:pt>
                <c:pt idx="162">
                  <c:v>7477.83056640625</c:v>
                </c:pt>
                <c:pt idx="163">
                  <c:v>7488.2998046875</c:v>
                </c:pt>
                <c:pt idx="164">
                  <c:v>7475.5625</c:v>
                </c:pt>
                <c:pt idx="165">
                  <c:v>7436.95556640625</c:v>
                </c:pt>
                <c:pt idx="166">
                  <c:v>7390.509765625</c:v>
                </c:pt>
                <c:pt idx="167">
                  <c:v>7368.07568359375</c:v>
                </c:pt>
                <c:pt idx="168">
                  <c:v>7395.1845703125</c:v>
                </c:pt>
                <c:pt idx="169">
                  <c:v>7470.97802734375</c:v>
                </c:pt>
                <c:pt idx="170">
                  <c:v>7563.9765625</c:v>
                </c:pt>
                <c:pt idx="171">
                  <c:v>7629.1328125</c:v>
                </c:pt>
                <c:pt idx="172">
                  <c:v>7635.78955078125</c:v>
                </c:pt>
                <c:pt idx="173">
                  <c:v>7587.111328125</c:v>
                </c:pt>
                <c:pt idx="174">
                  <c:v>7517.06982421875</c:v>
                </c:pt>
                <c:pt idx="175">
                  <c:v>7467.25390625</c:v>
                </c:pt>
                <c:pt idx="176">
                  <c:v>7460.33251953125</c:v>
                </c:pt>
                <c:pt idx="177">
                  <c:v>7488.66943359375</c:v>
                </c:pt>
                <c:pt idx="178">
                  <c:v>7524.50390625</c:v>
                </c:pt>
                <c:pt idx="179">
                  <c:v>7541.9951171875</c:v>
                </c:pt>
                <c:pt idx="180">
                  <c:v>7533.91162109375</c:v>
                </c:pt>
                <c:pt idx="181">
                  <c:v>7511.810546875</c:v>
                </c:pt>
                <c:pt idx="182">
                  <c:v>7492.41650390625</c:v>
                </c:pt>
                <c:pt idx="183">
                  <c:v>7483.0615234375</c:v>
                </c:pt>
                <c:pt idx="184">
                  <c:v>7477.91015625</c:v>
                </c:pt>
                <c:pt idx="185">
                  <c:v>7466.44873046875</c:v>
                </c:pt>
                <c:pt idx="186">
                  <c:v>7445.4541015625</c:v>
                </c:pt>
                <c:pt idx="187">
                  <c:v>7423.712890625</c:v>
                </c:pt>
                <c:pt idx="188">
                  <c:v>7415.75634765625</c:v>
                </c:pt>
                <c:pt idx="189">
                  <c:v>7430.2822265625</c:v>
                </c:pt>
                <c:pt idx="190">
                  <c:v>7462.83935546875</c:v>
                </c:pt>
                <c:pt idx="191">
                  <c:v>7498.251953125</c:v>
                </c:pt>
                <c:pt idx="192">
                  <c:v>7520.28076171875</c:v>
                </c:pt>
                <c:pt idx="193">
                  <c:v>7520.92919921875</c:v>
                </c:pt>
                <c:pt idx="194">
                  <c:v>7503.13427734375</c:v>
                </c:pt>
                <c:pt idx="195">
                  <c:v>7476.35009765625</c:v>
                </c:pt>
                <c:pt idx="196">
                  <c:v>7449.56640625</c:v>
                </c:pt>
                <c:pt idx="197">
                  <c:v>7426.9931640625</c:v>
                </c:pt>
                <c:pt idx="198">
                  <c:v>7408.3623046875</c:v>
                </c:pt>
                <c:pt idx="199">
                  <c:v>7392.02880859375</c:v>
                </c:pt>
                <c:pt idx="200">
                  <c:v>7377.69775390625</c:v>
                </c:pt>
                <c:pt idx="201">
                  <c:v>7367.03857421875</c:v>
                </c:pt>
                <c:pt idx="202">
                  <c:v>7362.63037109375</c:v>
                </c:pt>
                <c:pt idx="203">
                  <c:v>7366.69970703125</c:v>
                </c:pt>
                <c:pt idx="204">
                  <c:v>7380.55322265625</c:v>
                </c:pt>
                <c:pt idx="205">
                  <c:v>7404.5556640625</c:v>
                </c:pt>
                <c:pt idx="206">
                  <c:v>7438.0478515625</c:v>
                </c:pt>
                <c:pt idx="207">
                  <c:v>7478.88720703125</c:v>
                </c:pt>
                <c:pt idx="208">
                  <c:v>7522.80712890625</c:v>
                </c:pt>
                <c:pt idx="209">
                  <c:v>7563.1181640625</c:v>
                </c:pt>
                <c:pt idx="210">
                  <c:v>7591.4755859375</c:v>
                </c:pt>
                <c:pt idx="211">
                  <c:v>7600.38525390625</c:v>
                </c:pt>
                <c:pt idx="212">
                  <c:v>7587.384765625</c:v>
                </c:pt>
                <c:pt idx="213">
                  <c:v>7559.1689453125</c:v>
                </c:pt>
                <c:pt idx="214">
                  <c:v>7532.19287109375</c:v>
                </c:pt>
                <c:pt idx="215">
                  <c:v>7526.62744140625</c:v>
                </c:pt>
                <c:pt idx="216">
                  <c:v>7554.25048828125</c:v>
                </c:pt>
                <c:pt idx="217">
                  <c:v>7606.49658203125</c:v>
                </c:pt>
                <c:pt idx="218">
                  <c:v>7652.03125</c:v>
                </c:pt>
                <c:pt idx="219">
                  <c:v>7649.76806640625</c:v>
                </c:pt>
                <c:pt idx="220">
                  <c:v>7573.3515625</c:v>
                </c:pt>
                <c:pt idx="221">
                  <c:v>7433.04345703125</c:v>
                </c:pt>
                <c:pt idx="222">
                  <c:v>7278.88818359375</c:v>
                </c:pt>
                <c:pt idx="223">
                  <c:v>7178.85693359375</c:v>
                </c:pt>
                <c:pt idx="224">
                  <c:v>7182.255859375</c:v>
                </c:pt>
                <c:pt idx="225">
                  <c:v>7290.4443359375</c:v>
                </c:pt>
                <c:pt idx="226">
                  <c:v>7454.30224609375</c:v>
                </c:pt>
                <c:pt idx="227">
                  <c:v>7601.19873046875</c:v>
                </c:pt>
                <c:pt idx="228">
                  <c:v>7674.68603515625</c:v>
                </c:pt>
                <c:pt idx="229">
                  <c:v>7661.82666015625</c:v>
                </c:pt>
                <c:pt idx="230">
                  <c:v>7592.2421875</c:v>
                </c:pt>
                <c:pt idx="231">
                  <c:v>7512.79296875</c:v>
                </c:pt>
                <c:pt idx="232">
                  <c:v>7457.58642578125</c:v>
                </c:pt>
                <c:pt idx="233">
                  <c:v>7433.4306640625</c:v>
                </c:pt>
                <c:pt idx="234">
                  <c:v>7426.890625</c:v>
                </c:pt>
                <c:pt idx="235">
                  <c:v>7422.60009765625</c:v>
                </c:pt>
                <c:pt idx="236">
                  <c:v>7416.33203125</c:v>
                </c:pt>
                <c:pt idx="237">
                  <c:v>7414.0341796875</c:v>
                </c:pt>
                <c:pt idx="238">
                  <c:v>7421.5205078125</c:v>
                </c:pt>
                <c:pt idx="239">
                  <c:v>7436.74267578125</c:v>
                </c:pt>
                <c:pt idx="240">
                  <c:v>7452.0166015625</c:v>
                </c:pt>
                <c:pt idx="241">
                  <c:v>7462.66015625</c:v>
                </c:pt>
                <c:pt idx="242">
                  <c:v>7471.919921875</c:v>
                </c:pt>
                <c:pt idx="243">
                  <c:v>7486.1240234375</c:v>
                </c:pt>
                <c:pt idx="244">
                  <c:v>7504.49072265625</c:v>
                </c:pt>
                <c:pt idx="245">
                  <c:v>7514.673828125</c:v>
                </c:pt>
                <c:pt idx="246">
                  <c:v>7500.8271484375</c:v>
                </c:pt>
                <c:pt idx="247">
                  <c:v>7459.111328125</c:v>
                </c:pt>
                <c:pt idx="248">
                  <c:v>7406.8974609375</c:v>
                </c:pt>
                <c:pt idx="249">
                  <c:v>7375.27392578125</c:v>
                </c:pt>
                <c:pt idx="250">
                  <c:v>7387.99658203125</c:v>
                </c:pt>
                <c:pt idx="251">
                  <c:v>7442.5322265625</c:v>
                </c:pt>
                <c:pt idx="252">
                  <c:v>7508.98779296875</c:v>
                </c:pt>
                <c:pt idx="253">
                  <c:v>7549.43505859375</c:v>
                </c:pt>
                <c:pt idx="254">
                  <c:v>7543.8671875</c:v>
                </c:pt>
                <c:pt idx="255">
                  <c:v>7503.263671875</c:v>
                </c:pt>
                <c:pt idx="256">
                  <c:v>7460.078125</c:v>
                </c:pt>
                <c:pt idx="257">
                  <c:v>7443.986328125</c:v>
                </c:pt>
                <c:pt idx="258">
                  <c:v>7461.72705078125</c:v>
                </c:pt>
                <c:pt idx="259">
                  <c:v>7495.650390625</c:v>
                </c:pt>
                <c:pt idx="260">
                  <c:v>7520.1474609375</c:v>
                </c:pt>
                <c:pt idx="261">
                  <c:v>7521.51171875</c:v>
                </c:pt>
                <c:pt idx="262">
                  <c:v>7505.72216796875</c:v>
                </c:pt>
                <c:pt idx="263">
                  <c:v>7490.03076171875</c:v>
                </c:pt>
                <c:pt idx="264">
                  <c:v>7487.572265625</c:v>
                </c:pt>
                <c:pt idx="265">
                  <c:v>7498.36474609375</c:v>
                </c:pt>
                <c:pt idx="266">
                  <c:v>7512.61474609375</c:v>
                </c:pt>
                <c:pt idx="267">
                  <c:v>7520.92333984375</c:v>
                </c:pt>
                <c:pt idx="268">
                  <c:v>7521.10791015625</c:v>
                </c:pt>
                <c:pt idx="269">
                  <c:v>7516.46435546875</c:v>
                </c:pt>
                <c:pt idx="270">
                  <c:v>7509.47509765625</c:v>
                </c:pt>
                <c:pt idx="271">
                  <c:v>7499.0244140625</c:v>
                </c:pt>
                <c:pt idx="272">
                  <c:v>7484.37841796875</c:v>
                </c:pt>
                <c:pt idx="273">
                  <c:v>7470.81591796875</c:v>
                </c:pt>
                <c:pt idx="274">
                  <c:v>7468.77978515625</c:v>
                </c:pt>
                <c:pt idx="275">
                  <c:v>7484.509765625</c:v>
                </c:pt>
                <c:pt idx="276">
                  <c:v>7509.857421875</c:v>
                </c:pt>
                <c:pt idx="277">
                  <c:v>7522.51806640625</c:v>
                </c:pt>
                <c:pt idx="278">
                  <c:v>7500.4306640625</c:v>
                </c:pt>
                <c:pt idx="279">
                  <c:v>7441.09130859375</c:v>
                </c:pt>
                <c:pt idx="280">
                  <c:v>7369.650390625</c:v>
                </c:pt>
                <c:pt idx="281">
                  <c:v>7326.32470703125</c:v>
                </c:pt>
                <c:pt idx="282">
                  <c:v>7339.76904296875</c:v>
                </c:pt>
                <c:pt idx="283">
                  <c:v>7405.60498046875</c:v>
                </c:pt>
                <c:pt idx="284">
                  <c:v>7487.12890625</c:v>
                </c:pt>
                <c:pt idx="285">
                  <c:v>7539.02734375</c:v>
                </c:pt>
                <c:pt idx="286">
                  <c:v>7537.13427734375</c:v>
                </c:pt>
                <c:pt idx="287">
                  <c:v>7492.42041015625</c:v>
                </c:pt>
                <c:pt idx="288">
                  <c:v>7439.5673828125</c:v>
                </c:pt>
                <c:pt idx="289">
                  <c:v>7410.1044921875</c:v>
                </c:pt>
                <c:pt idx="290">
                  <c:v>7411.39453125</c:v>
                </c:pt>
                <c:pt idx="291">
                  <c:v>7426.9228515625</c:v>
                </c:pt>
                <c:pt idx="292">
                  <c:v>7435.5517578125</c:v>
                </c:pt>
                <c:pt idx="293">
                  <c:v>7432.36083984375</c:v>
                </c:pt>
                <c:pt idx="294">
                  <c:v>7433.39013671875</c:v>
                </c:pt>
                <c:pt idx="295">
                  <c:v>7460.67138671875</c:v>
                </c:pt>
                <c:pt idx="296">
                  <c:v>7520.40234375</c:v>
                </c:pt>
                <c:pt idx="297">
                  <c:v>7592.60693359375</c:v>
                </c:pt>
                <c:pt idx="298">
                  <c:v>7641.1982421875</c:v>
                </c:pt>
                <c:pt idx="299">
                  <c:v>7637.22021484375</c:v>
                </c:pt>
                <c:pt idx="300">
                  <c:v>7578.18017578125</c:v>
                </c:pt>
                <c:pt idx="301">
                  <c:v>7489.96337890625</c:v>
                </c:pt>
                <c:pt idx="302">
                  <c:v>7411.06103515625</c:v>
                </c:pt>
                <c:pt idx="303">
                  <c:v>7370.95947265625</c:v>
                </c:pt>
                <c:pt idx="304">
                  <c:v>7376.8173828125</c:v>
                </c:pt>
                <c:pt idx="305">
                  <c:v>7414.81201171875</c:v>
                </c:pt>
                <c:pt idx="306">
                  <c:v>7461.99853515625</c:v>
                </c:pt>
                <c:pt idx="307">
                  <c:v>7499.12109375</c:v>
                </c:pt>
                <c:pt idx="308">
                  <c:v>7517.10986328125</c:v>
                </c:pt>
                <c:pt idx="309">
                  <c:v>7516.30078125</c:v>
                </c:pt>
                <c:pt idx="310">
                  <c:v>7502.12744140625</c:v>
                </c:pt>
                <c:pt idx="311">
                  <c:v>7481.38525390625</c:v>
                </c:pt>
                <c:pt idx="312">
                  <c:v>7460.6298828125</c:v>
                </c:pt>
                <c:pt idx="313">
                  <c:v>7445.919921875</c:v>
                </c:pt>
                <c:pt idx="314">
                  <c:v>7442.65283203125</c:v>
                </c:pt>
                <c:pt idx="315">
                  <c:v>7454.875</c:v>
                </c:pt>
                <c:pt idx="316">
                  <c:v>7483.92236328125</c:v>
                </c:pt>
                <c:pt idx="317">
                  <c:v>7526.3798828125</c:v>
                </c:pt>
                <c:pt idx="318">
                  <c:v>7572.0712890625</c:v>
                </c:pt>
                <c:pt idx="319">
                  <c:v>7604.1435546875</c:v>
                </c:pt>
                <c:pt idx="320">
                  <c:v>7603.7451171875</c:v>
                </c:pt>
                <c:pt idx="321">
                  <c:v>7559.501953125</c:v>
                </c:pt>
                <c:pt idx="322">
                  <c:v>7477.48291015625</c:v>
                </c:pt>
                <c:pt idx="323">
                  <c:v>7384.23291015625</c:v>
                </c:pt>
                <c:pt idx="324">
                  <c:v>7317.64111328125</c:v>
                </c:pt>
                <c:pt idx="325">
                  <c:v>7308.09814453125</c:v>
                </c:pt>
                <c:pt idx="326">
                  <c:v>7360.544921875</c:v>
                </c:pt>
                <c:pt idx="327">
                  <c:v>7449.71240234375</c:v>
                </c:pt>
                <c:pt idx="328">
                  <c:v>7533.28271484375</c:v>
                </c:pt>
                <c:pt idx="329">
                  <c:v>7575.4609375</c:v>
                </c:pt>
                <c:pt idx="330">
                  <c:v>7565.70458984375</c:v>
                </c:pt>
                <c:pt idx="331">
                  <c:v>7520.599609375</c:v>
                </c:pt>
                <c:pt idx="332">
                  <c:v>7469.0693359375</c:v>
                </c:pt>
                <c:pt idx="333">
                  <c:v>7432.94482421875</c:v>
                </c:pt>
                <c:pt idx="334">
                  <c:v>7417.0546875</c:v>
                </c:pt>
                <c:pt idx="335">
                  <c:v>7414.0244140625</c:v>
                </c:pt>
                <c:pt idx="336">
                  <c:v>7416.6357421875</c:v>
                </c:pt>
                <c:pt idx="337">
                  <c:v>7425.3505859375</c:v>
                </c:pt>
                <c:pt idx="338">
                  <c:v>7444.54150390625</c:v>
                </c:pt>
                <c:pt idx="339">
                  <c:v>7472.46044921875</c:v>
                </c:pt>
                <c:pt idx="340">
                  <c:v>7496.4169921875</c:v>
                </c:pt>
                <c:pt idx="341">
                  <c:v>7500.005859375</c:v>
                </c:pt>
                <c:pt idx="342">
                  <c:v>7477.55712890625</c:v>
                </c:pt>
                <c:pt idx="343">
                  <c:v>7442.8564453125</c:v>
                </c:pt>
                <c:pt idx="344">
                  <c:v>7422.55126953125</c:v>
                </c:pt>
                <c:pt idx="345">
                  <c:v>7437.287109375</c:v>
                </c:pt>
                <c:pt idx="346">
                  <c:v>7484.892578125</c:v>
                </c:pt>
                <c:pt idx="347">
                  <c:v>7539.68798828125</c:v>
                </c:pt>
                <c:pt idx="348">
                  <c:v>7569.71435546875</c:v>
                </c:pt>
                <c:pt idx="349">
                  <c:v>7559.22998046875</c:v>
                </c:pt>
              </c:numCache>
            </c:numRef>
          </c:yVal>
          <c:smooth val="1"/>
          <c:extLst>
            <c:ext xmlns:c16="http://schemas.microsoft.com/office/drawing/2014/chart" uri="{C3380CC4-5D6E-409C-BE32-E72D297353CC}">
              <c16:uniqueId val="{00000019-0DDB-41B5-BE83-A9CFE49F3CE3}"/>
            </c:ext>
          </c:extLst>
        </c:ser>
        <c:ser>
          <c:idx val="26"/>
          <c:order val="26"/>
          <c:tx>
            <c:strRef>
              <c:f>hc_sub_007!$AA$1</c:f>
              <c:strCache>
                <c:ptCount val="1"/>
                <c:pt idx="0">
                  <c:v>Coor_27</c:v>
                </c:pt>
              </c:strCache>
            </c:strRef>
          </c:tx>
          <c:spPr>
            <a:ln w="28575" cap="rnd">
              <a:solidFill>
                <a:schemeClr val="accent3">
                  <a:lumMod val="60000"/>
                  <a:lumOff val="40000"/>
                </a:schemeClr>
              </a:solidFill>
              <a:round/>
            </a:ln>
            <a:effectLst/>
          </c:spPr>
          <c:marker>
            <c:symbol val="none"/>
          </c:marker>
          <c:yVal>
            <c:numRef>
              <c:f>hc_sub_007!$AA$2:$AA$351</c:f>
              <c:numCache>
                <c:formatCode>0.00000000000_ </c:formatCode>
                <c:ptCount val="350"/>
                <c:pt idx="0">
                  <c:v>6126.1748046875</c:v>
                </c:pt>
                <c:pt idx="1">
                  <c:v>6079.109375</c:v>
                </c:pt>
                <c:pt idx="2">
                  <c:v>6075.73974609375</c:v>
                </c:pt>
                <c:pt idx="3">
                  <c:v>6109.7861328125</c:v>
                </c:pt>
                <c:pt idx="4">
                  <c:v>6149.39404296875</c:v>
                </c:pt>
                <c:pt idx="5">
                  <c:v>6162.5302734375</c:v>
                </c:pt>
                <c:pt idx="6">
                  <c:v>6141.705078125</c:v>
                </c:pt>
                <c:pt idx="7">
                  <c:v>6108.46533203125</c:v>
                </c:pt>
                <c:pt idx="8">
                  <c:v>6095.16796875</c:v>
                </c:pt>
                <c:pt idx="9">
                  <c:v>6120.02587890625</c:v>
                </c:pt>
                <c:pt idx="10">
                  <c:v>6175.7001953125</c:v>
                </c:pt>
                <c:pt idx="11">
                  <c:v>6238.7744140625</c:v>
                </c:pt>
                <c:pt idx="12">
                  <c:v>6289.25390625</c:v>
                </c:pt>
                <c:pt idx="13">
                  <c:v>6321.880859375</c:v>
                </c:pt>
                <c:pt idx="14">
                  <c:v>6340.58642578125</c:v>
                </c:pt>
                <c:pt idx="15">
                  <c:v>6344.42431640625</c:v>
                </c:pt>
                <c:pt idx="16">
                  <c:v>6321.7705078125</c:v>
                </c:pt>
                <c:pt idx="17">
                  <c:v>6261.2802734375</c:v>
                </c:pt>
                <c:pt idx="18">
                  <c:v>6170.57861328125</c:v>
                </c:pt>
                <c:pt idx="19">
                  <c:v>6083.46826171875</c:v>
                </c:pt>
                <c:pt idx="20">
                  <c:v>6044.123046875</c:v>
                </c:pt>
                <c:pt idx="21">
                  <c:v>6076.79443359375</c:v>
                </c:pt>
                <c:pt idx="22">
                  <c:v>6164.5419921875</c:v>
                </c:pt>
                <c:pt idx="23">
                  <c:v>6256.18310546875</c:v>
                </c:pt>
                <c:pt idx="24">
                  <c:v>6299.17236328125</c:v>
                </c:pt>
                <c:pt idx="25">
                  <c:v>6274.75</c:v>
                </c:pt>
                <c:pt idx="26">
                  <c:v>6208.75048828125</c:v>
                </c:pt>
                <c:pt idx="27">
                  <c:v>6150.0869140625</c:v>
                </c:pt>
                <c:pt idx="28">
                  <c:v>6134.27392578125</c:v>
                </c:pt>
                <c:pt idx="29">
                  <c:v>6160.541015625</c:v>
                </c:pt>
                <c:pt idx="30">
                  <c:v>6199.0390625</c:v>
                </c:pt>
                <c:pt idx="31">
                  <c:v>6219.642578125</c:v>
                </c:pt>
                <c:pt idx="32">
                  <c:v>6216.86767578125</c:v>
                </c:pt>
                <c:pt idx="33">
                  <c:v>6210.30078125</c:v>
                </c:pt>
                <c:pt idx="34">
                  <c:v>6221.87646484375</c:v>
                </c:pt>
                <c:pt idx="35">
                  <c:v>6251.291015625</c:v>
                </c:pt>
                <c:pt idx="36">
                  <c:v>6271.98388671875</c:v>
                </c:pt>
                <c:pt idx="37">
                  <c:v>6251.99267578125</c:v>
                </c:pt>
                <c:pt idx="38">
                  <c:v>6182.43505859375</c:v>
                </c:pt>
                <c:pt idx="39">
                  <c:v>6089.70458984375</c:v>
                </c:pt>
                <c:pt idx="40">
                  <c:v>6020.81298828125</c:v>
                </c:pt>
                <c:pt idx="41">
                  <c:v>6012.9453125</c:v>
                </c:pt>
                <c:pt idx="42">
                  <c:v>6070.12646484375</c:v>
                </c:pt>
                <c:pt idx="43">
                  <c:v>6162.99267578125</c:v>
                </c:pt>
                <c:pt idx="44">
                  <c:v>6249.10595703125</c:v>
                </c:pt>
                <c:pt idx="45">
                  <c:v>6297.00927734375</c:v>
                </c:pt>
                <c:pt idx="46">
                  <c:v>6297.98388671875</c:v>
                </c:pt>
                <c:pt idx="47">
                  <c:v>6262.25</c:v>
                </c:pt>
                <c:pt idx="48">
                  <c:v>6208.390625</c:v>
                </c:pt>
                <c:pt idx="49">
                  <c:v>6156.06201171875</c:v>
                </c:pt>
                <c:pt idx="50">
                  <c:v>6123.81884765625</c:v>
                </c:pt>
                <c:pt idx="51">
                  <c:v>6126.3291015625</c:v>
                </c:pt>
                <c:pt idx="52">
                  <c:v>6166.8125</c:v>
                </c:pt>
                <c:pt idx="53">
                  <c:v>6229.2705078125</c:v>
                </c:pt>
                <c:pt idx="54">
                  <c:v>6280.7353515625</c:v>
                </c:pt>
                <c:pt idx="55">
                  <c:v>6288.32177734375</c:v>
                </c:pt>
                <c:pt idx="56">
                  <c:v>6242.32958984375</c:v>
                </c:pt>
                <c:pt idx="57">
                  <c:v>6167.50390625</c:v>
                </c:pt>
                <c:pt idx="58">
                  <c:v>6110.22021484375</c:v>
                </c:pt>
                <c:pt idx="59">
                  <c:v>6107.5576171875</c:v>
                </c:pt>
                <c:pt idx="60">
                  <c:v>6160.38818359375</c:v>
                </c:pt>
                <c:pt idx="61">
                  <c:v>6231.9560546875</c:v>
                </c:pt>
                <c:pt idx="62">
                  <c:v>6274.58447265625</c:v>
                </c:pt>
                <c:pt idx="63">
                  <c:v>6264.61279296875</c:v>
                </c:pt>
                <c:pt idx="64">
                  <c:v>6218.34912109375</c:v>
                </c:pt>
                <c:pt idx="65">
                  <c:v>6176.63330078125</c:v>
                </c:pt>
                <c:pt idx="66">
                  <c:v>6170.97021484375</c:v>
                </c:pt>
                <c:pt idx="67">
                  <c:v>6199.07177734375</c:v>
                </c:pt>
                <c:pt idx="68">
                  <c:v>6229.44140625</c:v>
                </c:pt>
                <c:pt idx="69">
                  <c:v>6230.09423828125</c:v>
                </c:pt>
                <c:pt idx="70">
                  <c:v>6196.39306640625</c:v>
                </c:pt>
                <c:pt idx="71">
                  <c:v>6154.33837890625</c:v>
                </c:pt>
                <c:pt idx="72">
                  <c:v>6137.19140625</c:v>
                </c:pt>
                <c:pt idx="73">
                  <c:v>6156.36279296875</c:v>
                </c:pt>
                <c:pt idx="74">
                  <c:v>6192.13818359375</c:v>
                </c:pt>
                <c:pt idx="75">
                  <c:v>6212.1044921875</c:v>
                </c:pt>
                <c:pt idx="76">
                  <c:v>6200.6044921875</c:v>
                </c:pt>
                <c:pt idx="77">
                  <c:v>6172.77197265625</c:v>
                </c:pt>
                <c:pt idx="78">
                  <c:v>6160.3486328125</c:v>
                </c:pt>
                <c:pt idx="79">
                  <c:v>6181.67724609375</c:v>
                </c:pt>
                <c:pt idx="80">
                  <c:v>6222.84326171875</c:v>
                </c:pt>
                <c:pt idx="81">
                  <c:v>6247.6884765625</c:v>
                </c:pt>
                <c:pt idx="82">
                  <c:v>6229.0654296875</c:v>
                </c:pt>
                <c:pt idx="83">
                  <c:v>6174.3408203125</c:v>
                </c:pt>
                <c:pt idx="84">
                  <c:v>6122.06005859375</c:v>
                </c:pt>
                <c:pt idx="85">
                  <c:v>6111.14892578125</c:v>
                </c:pt>
                <c:pt idx="86">
                  <c:v>6148.189453125</c:v>
                </c:pt>
                <c:pt idx="87">
                  <c:v>6200.97607421875</c:v>
                </c:pt>
                <c:pt idx="88">
                  <c:v>6224.8154296875</c:v>
                </c:pt>
                <c:pt idx="89">
                  <c:v>6200.0615234375</c:v>
                </c:pt>
                <c:pt idx="90">
                  <c:v>6149.14990234375</c:v>
                </c:pt>
                <c:pt idx="91">
                  <c:v>6118.21337890625</c:v>
                </c:pt>
                <c:pt idx="92">
                  <c:v>6138.28857421875</c:v>
                </c:pt>
                <c:pt idx="93">
                  <c:v>6198.8369140625</c:v>
                </c:pt>
                <c:pt idx="94">
                  <c:v>6256.35693359375</c:v>
                </c:pt>
                <c:pt idx="95">
                  <c:v>6271.3046875</c:v>
                </c:pt>
                <c:pt idx="96">
                  <c:v>6242.197265625</c:v>
                </c:pt>
                <c:pt idx="97">
                  <c:v>6207.48193359375</c:v>
                </c:pt>
                <c:pt idx="98">
                  <c:v>6212.54638671875</c:v>
                </c:pt>
                <c:pt idx="99">
                  <c:v>6268.8681640625</c:v>
                </c:pt>
                <c:pt idx="100">
                  <c:v>6339.84521484375</c:v>
                </c:pt>
                <c:pt idx="101">
                  <c:v>6366.56103515625</c:v>
                </c:pt>
                <c:pt idx="102">
                  <c:v>6313.97265625</c:v>
                </c:pt>
                <c:pt idx="103">
                  <c:v>6200.69775390625</c:v>
                </c:pt>
                <c:pt idx="104">
                  <c:v>6088.14501953125</c:v>
                </c:pt>
                <c:pt idx="105">
                  <c:v>6036.97119140625</c:v>
                </c:pt>
                <c:pt idx="106">
                  <c:v>6064.58203125</c:v>
                </c:pt>
                <c:pt idx="107">
                  <c:v>6136.01025390625</c:v>
                </c:pt>
                <c:pt idx="108">
                  <c:v>6193.62255859375</c:v>
                </c:pt>
                <c:pt idx="109">
                  <c:v>6200.84423828125</c:v>
                </c:pt>
                <c:pt idx="110">
                  <c:v>6165.66015625</c:v>
                </c:pt>
                <c:pt idx="111">
                  <c:v>6127.62353515625</c:v>
                </c:pt>
                <c:pt idx="112">
                  <c:v>6121.87451171875</c:v>
                </c:pt>
                <c:pt idx="113">
                  <c:v>6150.8310546875</c:v>
                </c:pt>
                <c:pt idx="114">
                  <c:v>6185.685546875</c:v>
                </c:pt>
                <c:pt idx="115">
                  <c:v>6194.05224609375</c:v>
                </c:pt>
                <c:pt idx="116">
                  <c:v>6168.93115234375</c:v>
                </c:pt>
                <c:pt idx="117">
                  <c:v>6134.58251953125</c:v>
                </c:pt>
                <c:pt idx="118">
                  <c:v>6125.43115234375</c:v>
                </c:pt>
                <c:pt idx="119">
                  <c:v>6156.73974609375</c:v>
                </c:pt>
                <c:pt idx="120">
                  <c:v>6211.84521484375</c:v>
                </c:pt>
                <c:pt idx="121">
                  <c:v>6255.97607421875</c:v>
                </c:pt>
                <c:pt idx="122">
                  <c:v>6264.3359375</c:v>
                </c:pt>
                <c:pt idx="123">
                  <c:v>6240.9072265625</c:v>
                </c:pt>
                <c:pt idx="124">
                  <c:v>6213.130859375</c:v>
                </c:pt>
                <c:pt idx="125">
                  <c:v>6208.08349609375</c:v>
                </c:pt>
                <c:pt idx="126">
                  <c:v>6230.6123046875</c:v>
                </c:pt>
                <c:pt idx="127">
                  <c:v>6261.13671875</c:v>
                </c:pt>
                <c:pt idx="128">
                  <c:v>6273.65869140625</c:v>
                </c:pt>
                <c:pt idx="129">
                  <c:v>6257.80322265625</c:v>
                </c:pt>
                <c:pt idx="130">
                  <c:v>6226.3046875</c:v>
                </c:pt>
                <c:pt idx="131">
                  <c:v>6202.560546875</c:v>
                </c:pt>
                <c:pt idx="132">
                  <c:v>6199.96240234375</c:v>
                </c:pt>
                <c:pt idx="133">
                  <c:v>6211.1650390625</c:v>
                </c:pt>
                <c:pt idx="134">
                  <c:v>6216.23046875</c:v>
                </c:pt>
                <c:pt idx="135">
                  <c:v>6201.94677734375</c:v>
                </c:pt>
                <c:pt idx="136">
                  <c:v>6174.91845703125</c:v>
                </c:pt>
                <c:pt idx="137">
                  <c:v>6156.44482421875</c:v>
                </c:pt>
                <c:pt idx="138">
                  <c:v>6163.08837890625</c:v>
                </c:pt>
                <c:pt idx="139">
                  <c:v>6189.67578125</c:v>
                </c:pt>
                <c:pt idx="140">
                  <c:v>6210.26953125</c:v>
                </c:pt>
                <c:pt idx="141">
                  <c:v>6198.0830078125</c:v>
                </c:pt>
                <c:pt idx="142">
                  <c:v>6149.15478515625</c:v>
                </c:pt>
                <c:pt idx="143">
                  <c:v>6090.19580078125</c:v>
                </c:pt>
                <c:pt idx="144">
                  <c:v>6062.451171875</c:v>
                </c:pt>
                <c:pt idx="145">
                  <c:v>6092.0390625</c:v>
                </c:pt>
                <c:pt idx="146">
                  <c:v>6168.56494140625</c:v>
                </c:pt>
                <c:pt idx="147">
                  <c:v>6248.7578125</c:v>
                </c:pt>
                <c:pt idx="148">
                  <c:v>6283.9462890625</c:v>
                </c:pt>
                <c:pt idx="149">
                  <c:v>6252.66748046875</c:v>
                </c:pt>
                <c:pt idx="150">
                  <c:v>6175.62109375</c:v>
                </c:pt>
                <c:pt idx="151">
                  <c:v>6102.52294921875</c:v>
                </c:pt>
                <c:pt idx="152">
                  <c:v>6080.021484375</c:v>
                </c:pt>
                <c:pt idx="153">
                  <c:v>6122.57861328125</c:v>
                </c:pt>
                <c:pt idx="154">
                  <c:v>6205.3037109375</c:v>
                </c:pt>
                <c:pt idx="155">
                  <c:v>6281.94482421875</c:v>
                </c:pt>
                <c:pt idx="156">
                  <c:v>6314.30810546875</c:v>
                </c:pt>
                <c:pt idx="157">
                  <c:v>6293.13037109375</c:v>
                </c:pt>
                <c:pt idx="158">
                  <c:v>6238.2724609375</c:v>
                </c:pt>
                <c:pt idx="159">
                  <c:v>6181.37890625</c:v>
                </c:pt>
                <c:pt idx="160">
                  <c:v>6145.3623046875</c:v>
                </c:pt>
                <c:pt idx="161">
                  <c:v>6134.8740234375</c:v>
                </c:pt>
                <c:pt idx="162">
                  <c:v>6141.68505859375</c:v>
                </c:pt>
                <c:pt idx="163">
                  <c:v>6157.2978515625</c:v>
                </c:pt>
                <c:pt idx="164">
                  <c:v>6180.88671875</c:v>
                </c:pt>
                <c:pt idx="165">
                  <c:v>6216.28173828125</c:v>
                </c:pt>
                <c:pt idx="166">
                  <c:v>6261.94384765625</c:v>
                </c:pt>
                <c:pt idx="167">
                  <c:v>6304.21142578125</c:v>
                </c:pt>
                <c:pt idx="168">
                  <c:v>6321.53857421875</c:v>
                </c:pt>
                <c:pt idx="169">
                  <c:v>6298.1953125</c:v>
                </c:pt>
                <c:pt idx="170">
                  <c:v>6237.45751953125</c:v>
                </c:pt>
                <c:pt idx="171">
                  <c:v>6163.501953125</c:v>
                </c:pt>
                <c:pt idx="172">
                  <c:v>6109.0048828125</c:v>
                </c:pt>
                <c:pt idx="173">
                  <c:v>6096.01513671875</c:v>
                </c:pt>
                <c:pt idx="174">
                  <c:v>6123.02587890625</c:v>
                </c:pt>
                <c:pt idx="175">
                  <c:v>6167.16650390625</c:v>
                </c:pt>
                <c:pt idx="176">
                  <c:v>6199.87353515625</c:v>
                </c:pt>
                <c:pt idx="177">
                  <c:v>6205.03662109375</c:v>
                </c:pt>
                <c:pt idx="178">
                  <c:v>6187.2802734375</c:v>
                </c:pt>
                <c:pt idx="179">
                  <c:v>6165.5673828125</c:v>
                </c:pt>
                <c:pt idx="180">
                  <c:v>6157.93505859375</c:v>
                </c:pt>
                <c:pt idx="181">
                  <c:v>6169.03857421875</c:v>
                </c:pt>
                <c:pt idx="182">
                  <c:v>6189.14306640625</c:v>
                </c:pt>
                <c:pt idx="183">
                  <c:v>6203.9267578125</c:v>
                </c:pt>
                <c:pt idx="184">
                  <c:v>6206.302734375</c:v>
                </c:pt>
                <c:pt idx="185">
                  <c:v>6200.64013671875</c:v>
                </c:pt>
                <c:pt idx="186">
                  <c:v>6196.6162109375</c:v>
                </c:pt>
                <c:pt idx="187">
                  <c:v>6198.7998046875</c:v>
                </c:pt>
                <c:pt idx="188">
                  <c:v>6201.5849609375</c:v>
                </c:pt>
                <c:pt idx="189">
                  <c:v>6194.45751953125</c:v>
                </c:pt>
                <c:pt idx="190">
                  <c:v>6173.384765625</c:v>
                </c:pt>
                <c:pt idx="191">
                  <c:v>6148.15625</c:v>
                </c:pt>
                <c:pt idx="192">
                  <c:v>6137.92626953125</c:v>
                </c:pt>
                <c:pt idx="193">
                  <c:v>6156.72900390625</c:v>
                </c:pt>
                <c:pt idx="194">
                  <c:v>6199.8369140625</c:v>
                </c:pt>
                <c:pt idx="195">
                  <c:v>6242.83447265625</c:v>
                </c:pt>
                <c:pt idx="196">
                  <c:v>6256.53271484375</c:v>
                </c:pt>
                <c:pt idx="197">
                  <c:v>6228.3818359375</c:v>
                </c:pt>
                <c:pt idx="198">
                  <c:v>6174.6171875</c:v>
                </c:pt>
                <c:pt idx="199">
                  <c:v>6132.587890625</c:v>
                </c:pt>
                <c:pt idx="200">
                  <c:v>6136.6474609375</c:v>
                </c:pt>
                <c:pt idx="201">
                  <c:v>6193.58056640625</c:v>
                </c:pt>
                <c:pt idx="202">
                  <c:v>6275.158203125</c:v>
                </c:pt>
                <c:pt idx="203">
                  <c:v>6334.1953125</c:v>
                </c:pt>
                <c:pt idx="204">
                  <c:v>6334.08544921875</c:v>
                </c:pt>
                <c:pt idx="205">
                  <c:v>6272.0869140625</c:v>
                </c:pt>
                <c:pt idx="206">
                  <c:v>6180.75927734375</c:v>
                </c:pt>
                <c:pt idx="207">
                  <c:v>6107.04638671875</c:v>
                </c:pt>
                <c:pt idx="208">
                  <c:v>6083.6328125</c:v>
                </c:pt>
                <c:pt idx="209">
                  <c:v>6111.64404296875</c:v>
                </c:pt>
                <c:pt idx="210">
                  <c:v>6164.74609375</c:v>
                </c:pt>
                <c:pt idx="211">
                  <c:v>6209.416015625</c:v>
                </c:pt>
                <c:pt idx="212">
                  <c:v>6225.8623046875</c:v>
                </c:pt>
                <c:pt idx="213">
                  <c:v>6215.744140625</c:v>
                </c:pt>
                <c:pt idx="214">
                  <c:v>6194.08349609375</c:v>
                </c:pt>
                <c:pt idx="215">
                  <c:v>6174.36474609375</c:v>
                </c:pt>
                <c:pt idx="216">
                  <c:v>6159.2236328125</c:v>
                </c:pt>
                <c:pt idx="217">
                  <c:v>6142.78173828125</c:v>
                </c:pt>
                <c:pt idx="218">
                  <c:v>6120.6455078125</c:v>
                </c:pt>
                <c:pt idx="219">
                  <c:v>6098.0380859375</c:v>
                </c:pt>
                <c:pt idx="220">
                  <c:v>6089.12890625</c:v>
                </c:pt>
                <c:pt idx="221">
                  <c:v>6108.29150390625</c:v>
                </c:pt>
                <c:pt idx="222">
                  <c:v>6160.0595703125</c:v>
                </c:pt>
                <c:pt idx="223">
                  <c:v>6234.671875</c:v>
                </c:pt>
                <c:pt idx="224">
                  <c:v>6311.32275390625</c:v>
                </c:pt>
                <c:pt idx="225">
                  <c:v>6366.2822265625</c:v>
                </c:pt>
                <c:pt idx="226">
                  <c:v>6381.5166015625</c:v>
                </c:pt>
                <c:pt idx="227">
                  <c:v>6351.0751953125</c:v>
                </c:pt>
                <c:pt idx="228">
                  <c:v>6284.2431640625</c:v>
                </c:pt>
                <c:pt idx="229">
                  <c:v>6204.349609375</c:v>
                </c:pt>
                <c:pt idx="230">
                  <c:v>6141.529296875</c:v>
                </c:pt>
                <c:pt idx="231">
                  <c:v>6119.6533203125</c:v>
                </c:pt>
                <c:pt idx="232">
                  <c:v>6142.5380859375</c:v>
                </c:pt>
                <c:pt idx="233">
                  <c:v>6188.5859375</c:v>
                </c:pt>
                <c:pt idx="234">
                  <c:v>6220.830078125</c:v>
                </c:pt>
                <c:pt idx="235">
                  <c:v>6209.767578125</c:v>
                </c:pt>
                <c:pt idx="236">
                  <c:v>6155.28759765625</c:v>
                </c:pt>
                <c:pt idx="237">
                  <c:v>6091</c:v>
                </c:pt>
                <c:pt idx="238">
                  <c:v>6064.2939453125</c:v>
                </c:pt>
                <c:pt idx="239">
                  <c:v>6103.19384765625</c:v>
                </c:pt>
                <c:pt idx="240">
                  <c:v>6193.22900390625</c:v>
                </c:pt>
                <c:pt idx="241">
                  <c:v>6283.048828125</c:v>
                </c:pt>
                <c:pt idx="242">
                  <c:v>6317.55126953125</c:v>
                </c:pt>
                <c:pt idx="243">
                  <c:v>6275.9580078125</c:v>
                </c:pt>
                <c:pt idx="244">
                  <c:v>6186.6787109375</c:v>
                </c:pt>
                <c:pt idx="245">
                  <c:v>6106.89111328125</c:v>
                </c:pt>
                <c:pt idx="246">
                  <c:v>6081.33544921875</c:v>
                </c:pt>
                <c:pt idx="247">
                  <c:v>6111.3125</c:v>
                </c:pt>
                <c:pt idx="248">
                  <c:v>6157.56396484375</c:v>
                </c:pt>
                <c:pt idx="249">
                  <c:v>6174.41015625</c:v>
                </c:pt>
                <c:pt idx="250">
                  <c:v>6147.81396484375</c:v>
                </c:pt>
                <c:pt idx="251">
                  <c:v>6106.833984375</c:v>
                </c:pt>
                <c:pt idx="252">
                  <c:v>6099.30908203125</c:v>
                </c:pt>
                <c:pt idx="253">
                  <c:v>6151.5888671875</c:v>
                </c:pt>
                <c:pt idx="254">
                  <c:v>6245.09130859375</c:v>
                </c:pt>
                <c:pt idx="255">
                  <c:v>6328.767578125</c:v>
                </c:pt>
                <c:pt idx="256">
                  <c:v>6357.24951171875</c:v>
                </c:pt>
                <c:pt idx="257">
                  <c:v>6323.75244140625</c:v>
                </c:pt>
                <c:pt idx="258">
                  <c:v>6261.71142578125</c:v>
                </c:pt>
                <c:pt idx="259">
                  <c:v>6215.36962890625</c:v>
                </c:pt>
                <c:pt idx="260">
                  <c:v>6204.9677734375</c:v>
                </c:pt>
                <c:pt idx="261">
                  <c:v>6215.4951171875</c:v>
                </c:pt>
                <c:pt idx="262">
                  <c:v>6216.6875</c:v>
                </c:pt>
                <c:pt idx="263">
                  <c:v>6194.71728515625</c:v>
                </c:pt>
                <c:pt idx="264">
                  <c:v>6166.36376953125</c:v>
                </c:pt>
                <c:pt idx="265">
                  <c:v>6162.7333984375</c:v>
                </c:pt>
                <c:pt idx="266">
                  <c:v>6197.4169921875</c:v>
                </c:pt>
                <c:pt idx="267">
                  <c:v>6248.751953125</c:v>
                </c:pt>
                <c:pt idx="268">
                  <c:v>6274.0869140625</c:v>
                </c:pt>
                <c:pt idx="269">
                  <c:v>6245.4921875</c:v>
                </c:pt>
                <c:pt idx="270">
                  <c:v>6176.12548828125</c:v>
                </c:pt>
                <c:pt idx="271">
                  <c:v>6112.87744140625</c:v>
                </c:pt>
                <c:pt idx="272">
                  <c:v>6099.41455078125</c:v>
                </c:pt>
                <c:pt idx="273">
                  <c:v>6139.9716796875</c:v>
                </c:pt>
                <c:pt idx="274">
                  <c:v>6195.060546875</c:v>
                </c:pt>
                <c:pt idx="275">
                  <c:v>6213.88427734375</c:v>
                </c:pt>
                <c:pt idx="276">
                  <c:v>6176.7734375</c:v>
                </c:pt>
                <c:pt idx="277">
                  <c:v>6111.64794921875</c:v>
                </c:pt>
                <c:pt idx="278">
                  <c:v>6070.0830078125</c:v>
                </c:pt>
                <c:pt idx="279">
                  <c:v>6083.2177734375</c:v>
                </c:pt>
                <c:pt idx="280">
                  <c:v>6135.5908203125</c:v>
                </c:pt>
                <c:pt idx="281">
                  <c:v>6180.0771484375</c:v>
                </c:pt>
                <c:pt idx="282">
                  <c:v>6181.47412109375</c:v>
                </c:pt>
                <c:pt idx="283">
                  <c:v>6150.5146484375</c:v>
                </c:pt>
                <c:pt idx="284">
                  <c:v>6137.0361328125</c:v>
                </c:pt>
                <c:pt idx="285">
                  <c:v>6185.8173828125</c:v>
                </c:pt>
                <c:pt idx="286">
                  <c:v>6291.93115234375</c:v>
                </c:pt>
                <c:pt idx="287">
                  <c:v>6395.2890625</c:v>
                </c:pt>
                <c:pt idx="288">
                  <c:v>6422.63232421875</c:v>
                </c:pt>
                <c:pt idx="289">
                  <c:v>6345.15966796875</c:v>
                </c:pt>
                <c:pt idx="290">
                  <c:v>6205.07177734375</c:v>
                </c:pt>
                <c:pt idx="291">
                  <c:v>6087.93359375</c:v>
                </c:pt>
                <c:pt idx="292">
                  <c:v>6061.1640625</c:v>
                </c:pt>
                <c:pt idx="293">
                  <c:v>6126.4365234375</c:v>
                </c:pt>
                <c:pt idx="294">
                  <c:v>6222.6630859375</c:v>
                </c:pt>
                <c:pt idx="295">
                  <c:v>6275.630859375</c:v>
                </c:pt>
                <c:pt idx="296">
                  <c:v>6253.78173828125</c:v>
                </c:pt>
                <c:pt idx="297">
                  <c:v>6186.66796875</c:v>
                </c:pt>
                <c:pt idx="298">
                  <c:v>6134.650390625</c:v>
                </c:pt>
                <c:pt idx="299">
                  <c:v>6137.92333984375</c:v>
                </c:pt>
                <c:pt idx="300">
                  <c:v>6187.31005859375</c:v>
                </c:pt>
                <c:pt idx="301">
                  <c:v>6238.05224609375</c:v>
                </c:pt>
                <c:pt idx="302">
                  <c:v>6250.69970703125</c:v>
                </c:pt>
                <c:pt idx="303">
                  <c:v>6222.2216796875</c:v>
                </c:pt>
                <c:pt idx="304">
                  <c:v>6182.26953125</c:v>
                </c:pt>
                <c:pt idx="305">
                  <c:v>6161.900390625</c:v>
                </c:pt>
                <c:pt idx="306">
                  <c:v>6165.64453125</c:v>
                </c:pt>
                <c:pt idx="307">
                  <c:v>6172.2548828125</c:v>
                </c:pt>
                <c:pt idx="308">
                  <c:v>6161.19873046875</c:v>
                </c:pt>
                <c:pt idx="309">
                  <c:v>6137.44384765625</c:v>
                </c:pt>
                <c:pt idx="310">
                  <c:v>6128.9833984375</c:v>
                </c:pt>
                <c:pt idx="311">
                  <c:v>6157.98974609375</c:v>
                </c:pt>
                <c:pt idx="312">
                  <c:v>6212.998046875</c:v>
                </c:pt>
                <c:pt idx="313">
                  <c:v>6251.01953125</c:v>
                </c:pt>
                <c:pt idx="314">
                  <c:v>6232.2548828125</c:v>
                </c:pt>
                <c:pt idx="315">
                  <c:v>6158.99853515625</c:v>
                </c:pt>
                <c:pt idx="316">
                  <c:v>6082.83056640625</c:v>
                </c:pt>
                <c:pt idx="317">
                  <c:v>6068.95068359375</c:v>
                </c:pt>
                <c:pt idx="318">
                  <c:v>6143.51904296875</c:v>
                </c:pt>
                <c:pt idx="319">
                  <c:v>6267.2021484375</c:v>
                </c:pt>
                <c:pt idx="320">
                  <c:v>6359.36962890625</c:v>
                </c:pt>
                <c:pt idx="321">
                  <c:v>6356.734375</c:v>
                </c:pt>
                <c:pt idx="322">
                  <c:v>6261.20849609375</c:v>
                </c:pt>
                <c:pt idx="323">
                  <c:v>6139.05078125</c:v>
                </c:pt>
                <c:pt idx="324">
                  <c:v>6071.7607421875</c:v>
                </c:pt>
                <c:pt idx="325">
                  <c:v>6097.310546875</c:v>
                </c:pt>
                <c:pt idx="326">
                  <c:v>6187.01220703125</c:v>
                </c:pt>
                <c:pt idx="327">
                  <c:v>6273.59814453125</c:v>
                </c:pt>
                <c:pt idx="328">
                  <c:v>6304.92724609375</c:v>
                </c:pt>
                <c:pt idx="329">
                  <c:v>6279.173828125</c:v>
                </c:pt>
                <c:pt idx="330">
                  <c:v>6235.5810546875</c:v>
                </c:pt>
                <c:pt idx="331">
                  <c:v>6213.29248046875</c:v>
                </c:pt>
                <c:pt idx="332">
                  <c:v>6216.38818359375</c:v>
                </c:pt>
                <c:pt idx="333">
                  <c:v>6215.18212890625</c:v>
                </c:pt>
                <c:pt idx="334">
                  <c:v>6180.3623046875</c:v>
                </c:pt>
                <c:pt idx="335">
                  <c:v>6117.2841796875</c:v>
                </c:pt>
                <c:pt idx="336">
                  <c:v>6067.953125</c:v>
                </c:pt>
                <c:pt idx="337">
                  <c:v>6077.14306640625</c:v>
                </c:pt>
                <c:pt idx="338">
                  <c:v>6151.318359375</c:v>
                </c:pt>
                <c:pt idx="339">
                  <c:v>6246.5654296875</c:v>
                </c:pt>
                <c:pt idx="340">
                  <c:v>6298.01806640625</c:v>
                </c:pt>
                <c:pt idx="341">
                  <c:v>6268.4794921875</c:v>
                </c:pt>
                <c:pt idx="342">
                  <c:v>6177.43115234375</c:v>
                </c:pt>
                <c:pt idx="343">
                  <c:v>6087.13720703125</c:v>
                </c:pt>
                <c:pt idx="344">
                  <c:v>6056.91259765625</c:v>
                </c:pt>
                <c:pt idx="345">
                  <c:v>6101.3994140625</c:v>
                </c:pt>
                <c:pt idx="346">
                  <c:v>6184.1396484375</c:v>
                </c:pt>
                <c:pt idx="347">
                  <c:v>6248.75732421875</c:v>
                </c:pt>
                <c:pt idx="348">
                  <c:v>6261.05615234375</c:v>
                </c:pt>
                <c:pt idx="349">
                  <c:v>6229.36865234375</c:v>
                </c:pt>
              </c:numCache>
            </c:numRef>
          </c:yVal>
          <c:smooth val="1"/>
          <c:extLst>
            <c:ext xmlns:c16="http://schemas.microsoft.com/office/drawing/2014/chart" uri="{C3380CC4-5D6E-409C-BE32-E72D297353CC}">
              <c16:uniqueId val="{0000001A-0DDB-41B5-BE83-A9CFE49F3CE3}"/>
            </c:ext>
          </c:extLst>
        </c:ser>
        <c:dLbls>
          <c:showLegendKey val="0"/>
          <c:showVal val="0"/>
          <c:showCatName val="0"/>
          <c:showSerName val="0"/>
          <c:showPercent val="0"/>
          <c:showBubbleSize val="0"/>
        </c:dLbls>
        <c:axId val="1021969344"/>
        <c:axId val="1021975464"/>
      </c:scatterChart>
      <c:valAx>
        <c:axId val="1021969344"/>
        <c:scaling>
          <c:orientation val="minMax"/>
          <c:max val="350"/>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zh-CN" sz="1100" b="1" i="0" u="none" strike="noStrike" kern="1200" baseline="0">
                    <a:solidFill>
                      <a:sysClr val="windowText" lastClr="000000">
                        <a:lumMod val="65000"/>
                        <a:lumOff val="35000"/>
                      </a:sysClr>
                    </a:solidFill>
                    <a:latin typeface="Times New Roman" panose="02020603050405020304" pitchFamily="18" charset="0"/>
                    <a:cs typeface="Times New Roman" panose="02020603050405020304" pitchFamily="18" charset="0"/>
                  </a:rPr>
                  <a:t>Timepoint</a:t>
                </a:r>
                <a:endParaRPr lang="zh-CN" altLang="en-US" sz="1000" b="1" i="0" u="none" strike="noStrike" kern="1200" baseline="0">
                  <a:solidFill>
                    <a:sysClr val="windowText" lastClr="000000">
                      <a:lumMod val="65000"/>
                      <a:lumOff val="35000"/>
                    </a:sysClr>
                  </a:solidFill>
                  <a:latin typeface="Times New Roman" panose="02020603050405020304" pitchFamily="18" charset="0"/>
                  <a:cs typeface="Times New Roman" panose="02020603050405020304" pitchFamily="18" charset="0"/>
                </a:endParaRP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zh-CN"/>
            </a:p>
          </c:txPr>
        </c:title>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crossAx val="1021975464"/>
        <c:crosses val="autoZero"/>
        <c:crossBetween val="midCat"/>
      </c:valAx>
      <c:valAx>
        <c:axId val="1021975464"/>
        <c:scaling>
          <c:orientation val="minMax"/>
          <c:max val="8000"/>
          <c:min val="400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zh-CN" sz="1100" b="1" dirty="0">
                    <a:latin typeface="Times New Roman" panose="02020603050405020304" pitchFamily="18" charset="0"/>
                    <a:ea typeface="宋体" panose="02010600030101010101" pitchFamily="2" charset="-122"/>
                    <a:cs typeface="Times New Roman" panose="02020603050405020304" pitchFamily="18" charset="0"/>
                  </a:rPr>
                  <a:t>Time series value</a:t>
                </a:r>
                <a:endParaRPr lang="zh-CN" altLang="en-US" sz="1100" b="1" dirty="0">
                  <a:latin typeface="Times New Roman" panose="02020603050405020304" pitchFamily="18" charset="0"/>
                  <a:ea typeface="宋体" panose="02010600030101010101" pitchFamily="2" charset="-122"/>
                  <a:cs typeface="Times New Roman" panose="02020603050405020304" pitchFamily="18" charset="0"/>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zh-CN"/>
            </a:p>
          </c:txPr>
        </c:title>
        <c:numFmt formatCode="0_ " sourceLinked="0"/>
        <c:majorTickMark val="none"/>
        <c:minorTickMark val="none"/>
        <c:tickLblPos val="nextTo"/>
        <c:spPr>
          <a:noFill/>
          <a:ln>
            <a:solidFill>
              <a:schemeClr val="bg1">
                <a:lumMod val="85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crossAx val="1021969344"/>
        <c:crosses val="autoZero"/>
        <c:crossBetween val="midCat"/>
      </c:valAx>
      <c:spPr>
        <a:noFill/>
        <a:ln>
          <a:noFill/>
        </a:ln>
        <a:effectLst/>
      </c:spPr>
    </c:plotArea>
    <c:legend>
      <c:legendPos val="b"/>
      <c:layout>
        <c:manualLayout>
          <c:xMode val="edge"/>
          <c:yMode val="edge"/>
          <c:x val="0.20408542209090685"/>
          <c:y val="0.83310015843477814"/>
          <c:w val="0.64880597728436062"/>
          <c:h val="0.166899841565222"/>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a:noFill/>
    </a:ln>
    <a:effectLst/>
  </c:spPr>
  <c:txPr>
    <a:bodyPr/>
    <a:lstStyle/>
    <a:p>
      <a:pPr>
        <a:defRPr/>
      </a:pPr>
      <a:endParaRPr lang="zh-CN"/>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zh-CN" b="1" dirty="0" err="1">
                <a:latin typeface="Times New Roman" panose="02020603050405020304" pitchFamily="18" charset="0"/>
                <a:ea typeface="宋体" panose="02010600030101010101" pitchFamily="2" charset="-122"/>
                <a:cs typeface="Times New Roman" panose="02020603050405020304" pitchFamily="18" charset="0"/>
              </a:rPr>
              <a:t>ReHo</a:t>
            </a:r>
            <a:r>
              <a:rPr lang="en-US" altLang="zh-CN" b="1" baseline="0" dirty="0">
                <a:latin typeface="Times New Roman" panose="02020603050405020304" pitchFamily="18" charset="0"/>
                <a:ea typeface="宋体" panose="02010600030101010101" pitchFamily="2" charset="-122"/>
                <a:cs typeface="Times New Roman" panose="02020603050405020304" pitchFamily="18" charset="0"/>
              </a:rPr>
              <a:t> time series plots for one subject in np group</a:t>
            </a:r>
            <a:endParaRPr lang="zh-CN" altLang="en-US" b="1" dirty="0">
              <a:latin typeface="Times New Roman" panose="02020603050405020304" pitchFamily="18" charset="0"/>
              <a:ea typeface="宋体" panose="02010600030101010101" pitchFamily="2" charset="-122"/>
              <a:cs typeface="Times New Roman" panose="02020603050405020304" pitchFamily="18" charset="0"/>
            </a:endParaRP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zh-CN"/>
        </a:p>
      </c:txPr>
    </c:title>
    <c:autoTitleDeleted val="0"/>
    <c:plotArea>
      <c:layout/>
      <c:scatterChart>
        <c:scatterStyle val="smoothMarker"/>
        <c:varyColors val="0"/>
        <c:ser>
          <c:idx val="0"/>
          <c:order val="0"/>
          <c:tx>
            <c:strRef>
              <c:f>np_sub_003!$A$1</c:f>
              <c:strCache>
                <c:ptCount val="1"/>
                <c:pt idx="0">
                  <c:v>Coor_1</c:v>
                </c:pt>
              </c:strCache>
            </c:strRef>
          </c:tx>
          <c:spPr>
            <a:ln w="28575" cap="rnd">
              <a:solidFill>
                <a:schemeClr val="accent1"/>
              </a:solidFill>
              <a:round/>
            </a:ln>
            <a:effectLst/>
          </c:spPr>
          <c:marker>
            <c:symbol val="none"/>
          </c:marker>
          <c:yVal>
            <c:numRef>
              <c:f>np_sub_003!$A$2:$A$351</c:f>
              <c:numCache>
                <c:formatCode>0.00000000000_ </c:formatCode>
                <c:ptCount val="350"/>
                <c:pt idx="0">
                  <c:v>7768.43505859375</c:v>
                </c:pt>
                <c:pt idx="1">
                  <c:v>7761.57421875</c:v>
                </c:pt>
                <c:pt idx="2">
                  <c:v>7713.556640625</c:v>
                </c:pt>
                <c:pt idx="3">
                  <c:v>7629.8564453125</c:v>
                </c:pt>
                <c:pt idx="4">
                  <c:v>7546.78759765625</c:v>
                </c:pt>
                <c:pt idx="5">
                  <c:v>7516.00732421875</c:v>
                </c:pt>
                <c:pt idx="6">
                  <c:v>7570.8984375</c:v>
                </c:pt>
                <c:pt idx="7">
                  <c:v>7697.625</c:v>
                </c:pt>
                <c:pt idx="8">
                  <c:v>7834.99755859375</c:v>
                </c:pt>
                <c:pt idx="9">
                  <c:v>7908.521484375</c:v>
                </c:pt>
                <c:pt idx="10">
                  <c:v>7877.84228515625</c:v>
                </c:pt>
                <c:pt idx="11">
                  <c:v>7763.97265625</c:v>
                </c:pt>
                <c:pt idx="12">
                  <c:v>7635.19189453125</c:v>
                </c:pt>
                <c:pt idx="13">
                  <c:v>7560.5234375</c:v>
                </c:pt>
                <c:pt idx="14">
                  <c:v>7564.43896484375</c:v>
                </c:pt>
                <c:pt idx="15">
                  <c:v>7615.9453125</c:v>
                </c:pt>
                <c:pt idx="16">
                  <c:v>7658.9404296875</c:v>
                </c:pt>
                <c:pt idx="17">
                  <c:v>7658.90478515625</c:v>
                </c:pt>
                <c:pt idx="18">
                  <c:v>7628.84814453125</c:v>
                </c:pt>
                <c:pt idx="19">
                  <c:v>7614.7626953125</c:v>
                </c:pt>
                <c:pt idx="20">
                  <c:v>7653.689453125</c:v>
                </c:pt>
                <c:pt idx="21">
                  <c:v>7739.38525390625</c:v>
                </c:pt>
                <c:pt idx="22">
                  <c:v>7823.86279296875</c:v>
                </c:pt>
                <c:pt idx="23">
                  <c:v>7853.55126953125</c:v>
                </c:pt>
                <c:pt idx="24">
                  <c:v>7810.76123046875</c:v>
                </c:pt>
                <c:pt idx="25">
                  <c:v>7727.26318359375</c:v>
                </c:pt>
                <c:pt idx="26">
                  <c:v>7659.77978515625</c:v>
                </c:pt>
                <c:pt idx="27">
                  <c:v>7647.73095703125</c:v>
                </c:pt>
                <c:pt idx="28">
                  <c:v>7686.73828125</c:v>
                </c:pt>
                <c:pt idx="29">
                  <c:v>7737.2001953125</c:v>
                </c:pt>
                <c:pt idx="30">
                  <c:v>7758.40380859375</c:v>
                </c:pt>
                <c:pt idx="31">
                  <c:v>7739.22998046875</c:v>
                </c:pt>
                <c:pt idx="32">
                  <c:v>7701.74755859375</c:v>
                </c:pt>
                <c:pt idx="33">
                  <c:v>7678.025390625</c:v>
                </c:pt>
                <c:pt idx="34">
                  <c:v>7682.2353515625</c:v>
                </c:pt>
                <c:pt idx="35">
                  <c:v>7701.71240234375</c:v>
                </c:pt>
                <c:pt idx="36">
                  <c:v>7712.2451171875</c:v>
                </c:pt>
                <c:pt idx="37">
                  <c:v>7701.4931640625</c:v>
                </c:pt>
                <c:pt idx="38">
                  <c:v>7678.77001953125</c:v>
                </c:pt>
                <c:pt idx="39">
                  <c:v>7663.33837890625</c:v>
                </c:pt>
                <c:pt idx="40">
                  <c:v>7663.59814453125</c:v>
                </c:pt>
                <c:pt idx="41">
                  <c:v>7667.6591796875</c:v>
                </c:pt>
                <c:pt idx="42">
                  <c:v>7654.8349609375</c:v>
                </c:pt>
                <c:pt idx="43">
                  <c:v>7617.84228515625</c:v>
                </c:pt>
                <c:pt idx="44">
                  <c:v>7574.93505859375</c:v>
                </c:pt>
                <c:pt idx="45">
                  <c:v>7559.52734375</c:v>
                </c:pt>
                <c:pt idx="46">
                  <c:v>7594.7392578125</c:v>
                </c:pt>
                <c:pt idx="47">
                  <c:v>7674.0693359375</c:v>
                </c:pt>
                <c:pt idx="48">
                  <c:v>7764.76416015625</c:v>
                </c:pt>
                <c:pt idx="49">
                  <c:v>7831.25390625</c:v>
                </c:pt>
                <c:pt idx="50">
                  <c:v>7859.0673828125</c:v>
                </c:pt>
                <c:pt idx="51">
                  <c:v>7859.67529296875</c:v>
                </c:pt>
                <c:pt idx="52">
                  <c:v>7853.6806640625</c:v>
                </c:pt>
                <c:pt idx="53">
                  <c:v>7848.716796875</c:v>
                </c:pt>
                <c:pt idx="54">
                  <c:v>7832.6728515625</c:v>
                </c:pt>
                <c:pt idx="55">
                  <c:v>7788.6103515625</c:v>
                </c:pt>
                <c:pt idx="56">
                  <c:v>7717.501953125</c:v>
                </c:pt>
                <c:pt idx="57">
                  <c:v>7646.67431640625</c:v>
                </c:pt>
                <c:pt idx="58">
                  <c:v>7613.34423828125</c:v>
                </c:pt>
                <c:pt idx="59">
                  <c:v>7634.53857421875</c:v>
                </c:pt>
                <c:pt idx="60">
                  <c:v>7688.2646484375</c:v>
                </c:pt>
                <c:pt idx="61">
                  <c:v>7723.8251953125</c:v>
                </c:pt>
                <c:pt idx="62">
                  <c:v>7696.56884765625</c:v>
                </c:pt>
                <c:pt idx="63">
                  <c:v>7602.18408203125</c:v>
                </c:pt>
                <c:pt idx="64">
                  <c:v>7484.423828125</c:v>
                </c:pt>
                <c:pt idx="65">
                  <c:v>7409.22900390625</c:v>
                </c:pt>
                <c:pt idx="66">
                  <c:v>7422.90771484375</c:v>
                </c:pt>
                <c:pt idx="67">
                  <c:v>7523.35546875</c:v>
                </c:pt>
                <c:pt idx="68">
                  <c:v>7663.19580078125</c:v>
                </c:pt>
                <c:pt idx="69">
                  <c:v>7780.6533203125</c:v>
                </c:pt>
                <c:pt idx="70">
                  <c:v>7835.58544921875</c:v>
                </c:pt>
                <c:pt idx="71">
                  <c:v>7827.1806640625</c:v>
                </c:pt>
                <c:pt idx="72">
                  <c:v>7785.15771484375</c:v>
                </c:pt>
                <c:pt idx="73">
                  <c:v>7744.9423828125</c:v>
                </c:pt>
                <c:pt idx="74">
                  <c:v>7725.78515625</c:v>
                </c:pt>
                <c:pt idx="75">
                  <c:v>7724.89501953125</c:v>
                </c:pt>
                <c:pt idx="76">
                  <c:v>7727.26708984375</c:v>
                </c:pt>
                <c:pt idx="77">
                  <c:v>7720.77197265625</c:v>
                </c:pt>
                <c:pt idx="78">
                  <c:v>7705.40185546875</c:v>
                </c:pt>
                <c:pt idx="79">
                  <c:v>7692.2978515625</c:v>
                </c:pt>
                <c:pt idx="80">
                  <c:v>7695.6083984375</c:v>
                </c:pt>
                <c:pt idx="81">
                  <c:v>7723.29541015625</c:v>
                </c:pt>
                <c:pt idx="82">
                  <c:v>7771.533203125</c:v>
                </c:pt>
                <c:pt idx="83">
                  <c:v>7824.4658203125</c:v>
                </c:pt>
                <c:pt idx="84">
                  <c:v>7859.24658203125</c:v>
                </c:pt>
                <c:pt idx="85">
                  <c:v>7855.19921875</c:v>
                </c:pt>
                <c:pt idx="86">
                  <c:v>7804.28955078125</c:v>
                </c:pt>
                <c:pt idx="87">
                  <c:v>7717.9658203125</c:v>
                </c:pt>
                <c:pt idx="88">
                  <c:v>7625.224609375</c:v>
                </c:pt>
                <c:pt idx="89">
                  <c:v>7560.51708984375</c:v>
                </c:pt>
                <c:pt idx="90">
                  <c:v>7546.64453125</c:v>
                </c:pt>
                <c:pt idx="91">
                  <c:v>7582.47265625</c:v>
                </c:pt>
                <c:pt idx="92">
                  <c:v>7643.72802734375</c:v>
                </c:pt>
                <c:pt idx="93">
                  <c:v>7697.18701171875</c:v>
                </c:pt>
                <c:pt idx="94">
                  <c:v>7719.5537109375</c:v>
                </c:pt>
                <c:pt idx="95">
                  <c:v>7708.9912109375</c:v>
                </c:pt>
                <c:pt idx="96">
                  <c:v>7682.47900390625</c:v>
                </c:pt>
                <c:pt idx="97">
                  <c:v>7662.14404296875</c:v>
                </c:pt>
                <c:pt idx="98">
                  <c:v>7660.97265625</c:v>
                </c:pt>
                <c:pt idx="99">
                  <c:v>7677.44140625</c:v>
                </c:pt>
                <c:pt idx="100">
                  <c:v>7700.85693359375</c:v>
                </c:pt>
                <c:pt idx="101">
                  <c:v>7721.0341796875</c:v>
                </c:pt>
                <c:pt idx="102">
                  <c:v>7733.85595703125</c:v>
                </c:pt>
                <c:pt idx="103">
                  <c:v>7739.30810546875</c:v>
                </c:pt>
                <c:pt idx="104">
                  <c:v>7735.94677734375</c:v>
                </c:pt>
                <c:pt idx="105">
                  <c:v>7718.8095703125</c:v>
                </c:pt>
                <c:pt idx="106">
                  <c:v>7684.08056640625</c:v>
                </c:pt>
                <c:pt idx="107">
                  <c:v>7636.75732421875</c:v>
                </c:pt>
                <c:pt idx="108">
                  <c:v>7593.60205078125</c:v>
                </c:pt>
                <c:pt idx="109">
                  <c:v>7576.57470703125</c:v>
                </c:pt>
                <c:pt idx="110">
                  <c:v>7599.625</c:v>
                </c:pt>
                <c:pt idx="111">
                  <c:v>7657.9072265625</c:v>
                </c:pt>
                <c:pt idx="112">
                  <c:v>7727.84033203125</c:v>
                </c:pt>
                <c:pt idx="113">
                  <c:v>7779.1337890625</c:v>
                </c:pt>
                <c:pt idx="114">
                  <c:v>7791.3173828125</c:v>
                </c:pt>
                <c:pt idx="115">
                  <c:v>7764.041015625</c:v>
                </c:pt>
                <c:pt idx="116">
                  <c:v>7714.8740234375</c:v>
                </c:pt>
                <c:pt idx="117">
                  <c:v>7667.1357421875</c:v>
                </c:pt>
                <c:pt idx="118">
                  <c:v>7636.84814453125</c:v>
                </c:pt>
                <c:pt idx="119">
                  <c:v>7627.48046875</c:v>
                </c:pt>
                <c:pt idx="120">
                  <c:v>7634.47314453125</c:v>
                </c:pt>
                <c:pt idx="121">
                  <c:v>7653.921875</c:v>
                </c:pt>
                <c:pt idx="122">
                  <c:v>7687.125</c:v>
                </c:pt>
                <c:pt idx="123">
                  <c:v>7736.85546875</c:v>
                </c:pt>
                <c:pt idx="124">
                  <c:v>7798.8017578125</c:v>
                </c:pt>
                <c:pt idx="125">
                  <c:v>7856.49755859375</c:v>
                </c:pt>
                <c:pt idx="126">
                  <c:v>7886.16015625</c:v>
                </c:pt>
                <c:pt idx="127">
                  <c:v>7870.22412109375</c:v>
                </c:pt>
                <c:pt idx="128">
                  <c:v>7810.708984375</c:v>
                </c:pt>
                <c:pt idx="129">
                  <c:v>7731.96533203125</c:v>
                </c:pt>
                <c:pt idx="130">
                  <c:v>7668.779296875</c:v>
                </c:pt>
                <c:pt idx="131">
                  <c:v>7646.1591796875</c:v>
                </c:pt>
                <c:pt idx="132">
                  <c:v>7663.9287109375</c:v>
                </c:pt>
                <c:pt idx="133">
                  <c:v>7697.09033203125</c:v>
                </c:pt>
                <c:pt idx="134">
                  <c:v>7712.59912109375</c:v>
                </c:pt>
                <c:pt idx="135">
                  <c:v>7691.67041015625</c:v>
                </c:pt>
                <c:pt idx="136">
                  <c:v>7642.42724609375</c:v>
                </c:pt>
                <c:pt idx="137">
                  <c:v>7594.0703125</c:v>
                </c:pt>
                <c:pt idx="138">
                  <c:v>7576.61865234375</c:v>
                </c:pt>
                <c:pt idx="139">
                  <c:v>7600.45361328125</c:v>
                </c:pt>
                <c:pt idx="140">
                  <c:v>7649.86767578125</c:v>
                </c:pt>
                <c:pt idx="141">
                  <c:v>7694.6005859375</c:v>
                </c:pt>
                <c:pt idx="142">
                  <c:v>7710.447265625</c:v>
                </c:pt>
                <c:pt idx="143">
                  <c:v>7694.08203125</c:v>
                </c:pt>
                <c:pt idx="144">
                  <c:v>7662.38623046875</c:v>
                </c:pt>
                <c:pt idx="145">
                  <c:v>7638.51220703125</c:v>
                </c:pt>
                <c:pt idx="146">
                  <c:v>7636.2265625</c:v>
                </c:pt>
                <c:pt idx="147">
                  <c:v>7653.83154296875</c:v>
                </c:pt>
                <c:pt idx="148">
                  <c:v>7680.12841796875</c:v>
                </c:pt>
                <c:pt idx="149">
                  <c:v>7705.17529296875</c:v>
                </c:pt>
                <c:pt idx="150">
                  <c:v>7726.037109375</c:v>
                </c:pt>
                <c:pt idx="151">
                  <c:v>7743.78173828125</c:v>
                </c:pt>
                <c:pt idx="152">
                  <c:v>7756.72607421875</c:v>
                </c:pt>
                <c:pt idx="153">
                  <c:v>7758.27392578125</c:v>
                </c:pt>
                <c:pt idx="154">
                  <c:v>7742.70068359375</c:v>
                </c:pt>
                <c:pt idx="155">
                  <c:v>7713.63037109375</c:v>
                </c:pt>
                <c:pt idx="156">
                  <c:v>7686.00634765625</c:v>
                </c:pt>
                <c:pt idx="157">
                  <c:v>7677.294921875</c:v>
                </c:pt>
                <c:pt idx="158">
                  <c:v>7693.5712890625</c:v>
                </c:pt>
                <c:pt idx="159">
                  <c:v>7722.18310546875</c:v>
                </c:pt>
                <c:pt idx="160">
                  <c:v>7738.7861328125</c:v>
                </c:pt>
                <c:pt idx="161">
                  <c:v>7725.12451171875</c:v>
                </c:pt>
                <c:pt idx="162">
                  <c:v>7684.357421875</c:v>
                </c:pt>
                <c:pt idx="163">
                  <c:v>7641.3974609375</c:v>
                </c:pt>
                <c:pt idx="164">
                  <c:v>7626.81396484375</c:v>
                </c:pt>
                <c:pt idx="165">
                  <c:v>7655.63330078125</c:v>
                </c:pt>
                <c:pt idx="166">
                  <c:v>7716.52783203125</c:v>
                </c:pt>
                <c:pt idx="167">
                  <c:v>7778.99072265625</c:v>
                </c:pt>
                <c:pt idx="168">
                  <c:v>7812.578125</c:v>
                </c:pt>
                <c:pt idx="169">
                  <c:v>7804.06103515625</c:v>
                </c:pt>
                <c:pt idx="170">
                  <c:v>7761.45458984375</c:v>
                </c:pt>
                <c:pt idx="171">
                  <c:v>7704.990234375</c:v>
                </c:pt>
                <c:pt idx="172">
                  <c:v>7654.4033203125</c:v>
                </c:pt>
                <c:pt idx="173">
                  <c:v>7622.154296875</c:v>
                </c:pt>
                <c:pt idx="174">
                  <c:v>7614.44287109375</c:v>
                </c:pt>
                <c:pt idx="175">
                  <c:v>7634.20166015625</c:v>
                </c:pt>
                <c:pt idx="176">
                  <c:v>7679.875</c:v>
                </c:pt>
                <c:pt idx="177">
                  <c:v>7740.4765625</c:v>
                </c:pt>
                <c:pt idx="178">
                  <c:v>7793.9541015625</c:v>
                </c:pt>
                <c:pt idx="179">
                  <c:v>7814.96630859375</c:v>
                </c:pt>
                <c:pt idx="180">
                  <c:v>7789.765625</c:v>
                </c:pt>
                <c:pt idx="181">
                  <c:v>7727.55712890625</c:v>
                </c:pt>
                <c:pt idx="182">
                  <c:v>7657.8974609375</c:v>
                </c:pt>
                <c:pt idx="183">
                  <c:v>7613.60302734375</c:v>
                </c:pt>
                <c:pt idx="184">
                  <c:v>7610.4814453125</c:v>
                </c:pt>
                <c:pt idx="185">
                  <c:v>7638.7060546875</c:v>
                </c:pt>
                <c:pt idx="186">
                  <c:v>7672.111328125</c:v>
                </c:pt>
                <c:pt idx="187">
                  <c:v>7687.83349609375</c:v>
                </c:pt>
                <c:pt idx="188">
                  <c:v>7680.9609375</c:v>
                </c:pt>
                <c:pt idx="189">
                  <c:v>7663.75048828125</c:v>
                </c:pt>
                <c:pt idx="190">
                  <c:v>7652.1259765625</c:v>
                </c:pt>
                <c:pt idx="191">
                  <c:v>7652.3046875</c:v>
                </c:pt>
                <c:pt idx="192">
                  <c:v>7658.86474609375</c:v>
                </c:pt>
                <c:pt idx="193">
                  <c:v>7664.28662109375</c:v>
                </c:pt>
                <c:pt idx="194">
                  <c:v>7669.294921875</c:v>
                </c:pt>
                <c:pt idx="195">
                  <c:v>7682.98486328125</c:v>
                </c:pt>
                <c:pt idx="196">
                  <c:v>7711.94384765625</c:v>
                </c:pt>
                <c:pt idx="197">
                  <c:v>7748.8525390625</c:v>
                </c:pt>
                <c:pt idx="198">
                  <c:v>7772.7880859375</c:v>
                </c:pt>
                <c:pt idx="199">
                  <c:v>7763.48291015625</c:v>
                </c:pt>
                <c:pt idx="200">
                  <c:v>7718.765625</c:v>
                </c:pt>
                <c:pt idx="201">
                  <c:v>7660.1220703125</c:v>
                </c:pt>
                <c:pt idx="202">
                  <c:v>7620.14697265625</c:v>
                </c:pt>
                <c:pt idx="203">
                  <c:v>7620.56591796875</c:v>
                </c:pt>
                <c:pt idx="204">
                  <c:v>7657.70654296875</c:v>
                </c:pt>
                <c:pt idx="205">
                  <c:v>7706.69677734375</c:v>
                </c:pt>
                <c:pt idx="206">
                  <c:v>7740.73828125</c:v>
                </c:pt>
                <c:pt idx="207">
                  <c:v>7750.10009765625</c:v>
                </c:pt>
                <c:pt idx="208">
                  <c:v>7746.45458984375</c:v>
                </c:pt>
                <c:pt idx="209">
                  <c:v>7750.5615234375</c:v>
                </c:pt>
                <c:pt idx="210">
                  <c:v>7774.314453125</c:v>
                </c:pt>
                <c:pt idx="211">
                  <c:v>7811.248046875</c:v>
                </c:pt>
                <c:pt idx="212">
                  <c:v>7841.3076171875</c:v>
                </c:pt>
                <c:pt idx="213">
                  <c:v>7844.107421875</c:v>
                </c:pt>
                <c:pt idx="214">
                  <c:v>7810.01318359375</c:v>
                </c:pt>
                <c:pt idx="215">
                  <c:v>7742.9248046875</c:v>
                </c:pt>
                <c:pt idx="216">
                  <c:v>7656.80224609375</c:v>
                </c:pt>
                <c:pt idx="217">
                  <c:v>7571.43212890625</c:v>
                </c:pt>
                <c:pt idx="218">
                  <c:v>7509.48046875</c:v>
                </c:pt>
                <c:pt idx="219">
                  <c:v>7491.7666015625</c:v>
                </c:pt>
                <c:pt idx="220">
                  <c:v>7528.0654296875</c:v>
                </c:pt>
                <c:pt idx="221">
                  <c:v>7607.31103515625</c:v>
                </c:pt>
                <c:pt idx="222">
                  <c:v>7696.76025390625</c:v>
                </c:pt>
                <c:pt idx="223">
                  <c:v>7756.53466796875</c:v>
                </c:pt>
                <c:pt idx="224">
                  <c:v>7763.8349609375</c:v>
                </c:pt>
                <c:pt idx="225">
                  <c:v>7729.9091796875</c:v>
                </c:pt>
                <c:pt idx="226">
                  <c:v>7694.16748046875</c:v>
                </c:pt>
                <c:pt idx="227">
                  <c:v>7695.78515625</c:v>
                </c:pt>
                <c:pt idx="228">
                  <c:v>7742.22900390625</c:v>
                </c:pt>
                <c:pt idx="229">
                  <c:v>7799.880859375</c:v>
                </c:pt>
                <c:pt idx="230">
                  <c:v>7817.03564453125</c:v>
                </c:pt>
                <c:pt idx="231">
                  <c:v>7764.099609375</c:v>
                </c:pt>
                <c:pt idx="232">
                  <c:v>7660.2001953125</c:v>
                </c:pt>
                <c:pt idx="233">
                  <c:v>7563.84814453125</c:v>
                </c:pt>
                <c:pt idx="234">
                  <c:v>7532.689453125</c:v>
                </c:pt>
                <c:pt idx="235">
                  <c:v>7582.3017578125</c:v>
                </c:pt>
                <c:pt idx="236">
                  <c:v>7675.8232421875</c:v>
                </c:pt>
                <c:pt idx="237">
                  <c:v>7752.4560546875</c:v>
                </c:pt>
                <c:pt idx="238">
                  <c:v>7772.28759765625</c:v>
                </c:pt>
                <c:pt idx="239">
                  <c:v>7742.2822265625</c:v>
                </c:pt>
                <c:pt idx="240">
                  <c:v>7704.1015625</c:v>
                </c:pt>
                <c:pt idx="241">
                  <c:v>7695.642578125</c:v>
                </c:pt>
                <c:pt idx="242">
                  <c:v>7719.0849609375</c:v>
                </c:pt>
                <c:pt idx="243">
                  <c:v>7741.70654296875</c:v>
                </c:pt>
                <c:pt idx="244">
                  <c:v>7727.57763671875</c:v>
                </c:pt>
                <c:pt idx="245">
                  <c:v>7672.29296875</c:v>
                </c:pt>
                <c:pt idx="246">
                  <c:v>7610.7587890625</c:v>
                </c:pt>
                <c:pt idx="247">
                  <c:v>7591.06787109375</c:v>
                </c:pt>
                <c:pt idx="248">
                  <c:v>7636.00390625</c:v>
                </c:pt>
                <c:pt idx="249">
                  <c:v>7723.78759765625</c:v>
                </c:pt>
                <c:pt idx="250">
                  <c:v>7803.44970703125</c:v>
                </c:pt>
                <c:pt idx="251">
                  <c:v>7831.845703125</c:v>
                </c:pt>
                <c:pt idx="252">
                  <c:v>7802.68994140625</c:v>
                </c:pt>
                <c:pt idx="253">
                  <c:v>7746.07373046875</c:v>
                </c:pt>
                <c:pt idx="254">
                  <c:v>7701.783203125</c:v>
                </c:pt>
                <c:pt idx="255">
                  <c:v>7689.86572265625</c:v>
                </c:pt>
                <c:pt idx="256">
                  <c:v>7701.29248046875</c:v>
                </c:pt>
                <c:pt idx="257">
                  <c:v>7712.568359375</c:v>
                </c:pt>
                <c:pt idx="258">
                  <c:v>7708.3662109375</c:v>
                </c:pt>
                <c:pt idx="259">
                  <c:v>7692.23388671875</c:v>
                </c:pt>
                <c:pt idx="260">
                  <c:v>7678.7744140625</c:v>
                </c:pt>
                <c:pt idx="261">
                  <c:v>7677.75537109375</c:v>
                </c:pt>
                <c:pt idx="262">
                  <c:v>7685.95263671875</c:v>
                </c:pt>
                <c:pt idx="263">
                  <c:v>7692.75</c:v>
                </c:pt>
                <c:pt idx="264">
                  <c:v>7691.45947265625</c:v>
                </c:pt>
                <c:pt idx="265">
                  <c:v>7683.8671875</c:v>
                </c:pt>
                <c:pt idx="266">
                  <c:v>7674.26806640625</c:v>
                </c:pt>
                <c:pt idx="267">
                  <c:v>7661.50244140625</c:v>
                </c:pt>
                <c:pt idx="268">
                  <c:v>7640.10546875</c:v>
                </c:pt>
                <c:pt idx="269">
                  <c:v>7611.3515625</c:v>
                </c:pt>
                <c:pt idx="270">
                  <c:v>7592.12353515625</c:v>
                </c:pt>
                <c:pt idx="271">
                  <c:v>7608.138671875</c:v>
                </c:pt>
                <c:pt idx="272">
                  <c:v>7671.9072265625</c:v>
                </c:pt>
                <c:pt idx="273">
                  <c:v>7762.962890625</c:v>
                </c:pt>
                <c:pt idx="274">
                  <c:v>7831.33740234375</c:v>
                </c:pt>
                <c:pt idx="275">
                  <c:v>7828.54296875</c:v>
                </c:pt>
                <c:pt idx="276">
                  <c:v>7745.8349609375</c:v>
                </c:pt>
                <c:pt idx="277">
                  <c:v>7628.759765625</c:v>
                </c:pt>
                <c:pt idx="278">
                  <c:v>7551.9375</c:v>
                </c:pt>
                <c:pt idx="279">
                  <c:v>7568.87451171875</c:v>
                </c:pt>
                <c:pt idx="280">
                  <c:v>7673.49072265625</c:v>
                </c:pt>
                <c:pt idx="281">
                  <c:v>7803.52587890625</c:v>
                </c:pt>
                <c:pt idx="282">
                  <c:v>7884.47705078125</c:v>
                </c:pt>
                <c:pt idx="283">
                  <c:v>7880.947265625</c:v>
                </c:pt>
                <c:pt idx="284">
                  <c:v>7816.4072265625</c:v>
                </c:pt>
                <c:pt idx="285">
                  <c:v>7747.73779296875</c:v>
                </c:pt>
                <c:pt idx="286">
                  <c:v>7717.0908203125</c:v>
                </c:pt>
                <c:pt idx="287">
                  <c:v>7720.84912109375</c:v>
                </c:pt>
                <c:pt idx="288">
                  <c:v>7719.83203125</c:v>
                </c:pt>
                <c:pt idx="289">
                  <c:v>7679.734375</c:v>
                </c:pt>
                <c:pt idx="290">
                  <c:v>7605.7783203125</c:v>
                </c:pt>
                <c:pt idx="291">
                  <c:v>7541.4990234375</c:v>
                </c:pt>
                <c:pt idx="292">
                  <c:v>7532.890625</c:v>
                </c:pt>
                <c:pt idx="293">
                  <c:v>7588.89111328125</c:v>
                </c:pt>
                <c:pt idx="294">
                  <c:v>7672.15625</c:v>
                </c:pt>
                <c:pt idx="295">
                  <c:v>7728.03759765625</c:v>
                </c:pt>
                <c:pt idx="296">
                  <c:v>7727.279296875</c:v>
                </c:pt>
                <c:pt idx="297">
                  <c:v>7686.744140625</c:v>
                </c:pt>
                <c:pt idx="298">
                  <c:v>7651.72998046875</c:v>
                </c:pt>
                <c:pt idx="299">
                  <c:v>7656.1845703125</c:v>
                </c:pt>
                <c:pt idx="300">
                  <c:v>7695.26611328125</c:v>
                </c:pt>
                <c:pt idx="301">
                  <c:v>7733.04931640625</c:v>
                </c:pt>
                <c:pt idx="302">
                  <c:v>7737.29736328125</c:v>
                </c:pt>
                <c:pt idx="303">
                  <c:v>7709.9384765625</c:v>
                </c:pt>
                <c:pt idx="304">
                  <c:v>7686.09326171875</c:v>
                </c:pt>
                <c:pt idx="305">
                  <c:v>7702.20703125</c:v>
                </c:pt>
                <c:pt idx="306">
                  <c:v>7760.99755859375</c:v>
                </c:pt>
                <c:pt idx="307">
                  <c:v>7824.17919921875</c:v>
                </c:pt>
                <c:pt idx="308">
                  <c:v>7840.63525390625</c:v>
                </c:pt>
                <c:pt idx="309">
                  <c:v>7787.685546875</c:v>
                </c:pt>
                <c:pt idx="310">
                  <c:v>7691.7216796875</c:v>
                </c:pt>
                <c:pt idx="311">
                  <c:v>7611.0283203125</c:v>
                </c:pt>
                <c:pt idx="312">
                  <c:v>7593.994140625</c:v>
                </c:pt>
                <c:pt idx="313">
                  <c:v>7645.072265625</c:v>
                </c:pt>
                <c:pt idx="314">
                  <c:v>7723.7509765625</c:v>
                </c:pt>
                <c:pt idx="315">
                  <c:v>7775.328125</c:v>
                </c:pt>
                <c:pt idx="316">
                  <c:v>7768.5791015625</c:v>
                </c:pt>
                <c:pt idx="317">
                  <c:v>7712.787109375</c:v>
                </c:pt>
                <c:pt idx="318">
                  <c:v>7645.12451171875</c:v>
                </c:pt>
                <c:pt idx="319">
                  <c:v>7602.31005859375</c:v>
                </c:pt>
                <c:pt idx="320">
                  <c:v>7599.3408203125</c:v>
                </c:pt>
                <c:pt idx="321">
                  <c:v>7628.10693359375</c:v>
                </c:pt>
                <c:pt idx="322">
                  <c:v>7670.75732421875</c:v>
                </c:pt>
                <c:pt idx="323">
                  <c:v>7712.85546875</c:v>
                </c:pt>
                <c:pt idx="324">
                  <c:v>7746.24609375</c:v>
                </c:pt>
                <c:pt idx="325">
                  <c:v>7764.20751953125</c:v>
                </c:pt>
                <c:pt idx="326">
                  <c:v>7758.84228515625</c:v>
                </c:pt>
                <c:pt idx="327">
                  <c:v>7726.412109375</c:v>
                </c:pt>
                <c:pt idx="328">
                  <c:v>7675.7236328125</c:v>
                </c:pt>
                <c:pt idx="329">
                  <c:v>7629.130859375</c:v>
                </c:pt>
                <c:pt idx="330">
                  <c:v>7611.291015625</c:v>
                </c:pt>
                <c:pt idx="331">
                  <c:v>7632.50634765625</c:v>
                </c:pt>
                <c:pt idx="332">
                  <c:v>7680.166015625</c:v>
                </c:pt>
                <c:pt idx="333">
                  <c:v>7726.5078125</c:v>
                </c:pt>
                <c:pt idx="334">
                  <c:v>7747.724609375</c:v>
                </c:pt>
                <c:pt idx="335">
                  <c:v>7739.80810546875</c:v>
                </c:pt>
                <c:pt idx="336">
                  <c:v>7718.99609375</c:v>
                </c:pt>
                <c:pt idx="337">
                  <c:v>7707.26318359375</c:v>
                </c:pt>
                <c:pt idx="338">
                  <c:v>7715.16552734375</c:v>
                </c:pt>
                <c:pt idx="339">
                  <c:v>7735.564453125</c:v>
                </c:pt>
                <c:pt idx="340">
                  <c:v>7751.81103515625</c:v>
                </c:pt>
                <c:pt idx="341">
                  <c:v>7751.90234375</c:v>
                </c:pt>
                <c:pt idx="342">
                  <c:v>7736.330078125</c:v>
                </c:pt>
                <c:pt idx="343">
                  <c:v>7714.30908203125</c:v>
                </c:pt>
                <c:pt idx="344">
                  <c:v>7693.8486328125</c:v>
                </c:pt>
                <c:pt idx="345">
                  <c:v>7675.81689453125</c:v>
                </c:pt>
                <c:pt idx="346">
                  <c:v>7657.08984375</c:v>
                </c:pt>
                <c:pt idx="347">
                  <c:v>7638.40185546875</c:v>
                </c:pt>
                <c:pt idx="348">
                  <c:v>7627.83544921875</c:v>
                </c:pt>
                <c:pt idx="349">
                  <c:v>7635.31298828125</c:v>
                </c:pt>
              </c:numCache>
            </c:numRef>
          </c:yVal>
          <c:smooth val="1"/>
          <c:extLst>
            <c:ext xmlns:c16="http://schemas.microsoft.com/office/drawing/2014/chart" uri="{C3380CC4-5D6E-409C-BE32-E72D297353CC}">
              <c16:uniqueId val="{00000000-5429-4359-BD11-807CF8F8408D}"/>
            </c:ext>
          </c:extLst>
        </c:ser>
        <c:ser>
          <c:idx val="1"/>
          <c:order val="1"/>
          <c:tx>
            <c:strRef>
              <c:f>np_sub_003!$B$1</c:f>
              <c:strCache>
                <c:ptCount val="1"/>
                <c:pt idx="0">
                  <c:v>Coor_2</c:v>
                </c:pt>
              </c:strCache>
            </c:strRef>
          </c:tx>
          <c:spPr>
            <a:ln w="28575" cap="rnd">
              <a:solidFill>
                <a:schemeClr val="accent2"/>
              </a:solidFill>
              <a:round/>
            </a:ln>
            <a:effectLst/>
          </c:spPr>
          <c:marker>
            <c:symbol val="none"/>
          </c:marker>
          <c:yVal>
            <c:numRef>
              <c:f>np_sub_003!$B$2:$B$351</c:f>
              <c:numCache>
                <c:formatCode>0.00000000000_ </c:formatCode>
                <c:ptCount val="350"/>
                <c:pt idx="0">
                  <c:v>7880.3603515625</c:v>
                </c:pt>
                <c:pt idx="1">
                  <c:v>7903.12451171875</c:v>
                </c:pt>
                <c:pt idx="2">
                  <c:v>7932.517578125</c:v>
                </c:pt>
                <c:pt idx="3">
                  <c:v>7945.4140625</c:v>
                </c:pt>
                <c:pt idx="4">
                  <c:v>7928.77490234375</c:v>
                </c:pt>
                <c:pt idx="5">
                  <c:v>7892.2158203125</c:v>
                </c:pt>
                <c:pt idx="6">
                  <c:v>7862.62109375</c:v>
                </c:pt>
                <c:pt idx="7">
                  <c:v>7863.47802734375</c:v>
                </c:pt>
                <c:pt idx="8">
                  <c:v>7895.09130859375</c:v>
                </c:pt>
                <c:pt idx="9">
                  <c:v>7932.51611328125</c:v>
                </c:pt>
                <c:pt idx="10">
                  <c:v>7944.3994140625</c:v>
                </c:pt>
                <c:pt idx="11">
                  <c:v>7918.68310546875</c:v>
                </c:pt>
                <c:pt idx="12">
                  <c:v>7874.55712890625</c:v>
                </c:pt>
                <c:pt idx="13">
                  <c:v>7850.18212890625</c:v>
                </c:pt>
                <c:pt idx="14">
                  <c:v>7874.65185546875</c:v>
                </c:pt>
                <c:pt idx="15">
                  <c:v>7945.2568359375</c:v>
                </c:pt>
                <c:pt idx="16">
                  <c:v>8027.1611328125</c:v>
                </c:pt>
                <c:pt idx="17">
                  <c:v>8075.47509765625</c:v>
                </c:pt>
                <c:pt idx="18">
                  <c:v>8063.25537109375</c:v>
                </c:pt>
                <c:pt idx="19">
                  <c:v>7995.91064453125</c:v>
                </c:pt>
                <c:pt idx="20">
                  <c:v>7904.20654296875</c:v>
                </c:pt>
                <c:pt idx="21">
                  <c:v>7824.03857421875</c:v>
                </c:pt>
                <c:pt idx="22">
                  <c:v>7778.5947265625</c:v>
                </c:pt>
                <c:pt idx="23">
                  <c:v>7773</c:v>
                </c:pt>
                <c:pt idx="24">
                  <c:v>7799.7958984375</c:v>
                </c:pt>
                <c:pt idx="25">
                  <c:v>7846.4765625</c:v>
                </c:pt>
                <c:pt idx="26">
                  <c:v>7898.84912109375</c:v>
                </c:pt>
                <c:pt idx="27">
                  <c:v>7941.59033203125</c:v>
                </c:pt>
                <c:pt idx="28">
                  <c:v>7961.24658203125</c:v>
                </c:pt>
                <c:pt idx="29">
                  <c:v>7953.03173828125</c:v>
                </c:pt>
                <c:pt idx="30">
                  <c:v>7925.90185546875</c:v>
                </c:pt>
                <c:pt idx="31">
                  <c:v>7898.78857421875</c:v>
                </c:pt>
                <c:pt idx="32">
                  <c:v>7887.8564453125</c:v>
                </c:pt>
                <c:pt idx="33">
                  <c:v>7894.1103515625</c:v>
                </c:pt>
                <c:pt idx="34">
                  <c:v>7902.826171875</c:v>
                </c:pt>
                <c:pt idx="35">
                  <c:v>7897.22216796875</c:v>
                </c:pt>
                <c:pt idx="36">
                  <c:v>7875.51806640625</c:v>
                </c:pt>
                <c:pt idx="37">
                  <c:v>7855.4794921875</c:v>
                </c:pt>
                <c:pt idx="38">
                  <c:v>7860.041015625</c:v>
                </c:pt>
                <c:pt idx="39">
                  <c:v>7894.759765625</c:v>
                </c:pt>
                <c:pt idx="40">
                  <c:v>7937.51513671875</c:v>
                </c:pt>
                <c:pt idx="41">
                  <c:v>7952.80419921875</c:v>
                </c:pt>
                <c:pt idx="42">
                  <c:v>7922.10595703125</c:v>
                </c:pt>
                <c:pt idx="43">
                  <c:v>7865.517578125</c:v>
                </c:pt>
                <c:pt idx="44">
                  <c:v>7833.564453125</c:v>
                </c:pt>
                <c:pt idx="45">
                  <c:v>7871.0224609375</c:v>
                </c:pt>
                <c:pt idx="46">
                  <c:v>7978.90087890625</c:v>
                </c:pt>
                <c:pt idx="47">
                  <c:v>8105.5556640625</c:v>
                </c:pt>
                <c:pt idx="48">
                  <c:v>8177.30908203125</c:v>
                </c:pt>
                <c:pt idx="49">
                  <c:v>8148.15380859375</c:v>
                </c:pt>
                <c:pt idx="50">
                  <c:v>8031.89697265625</c:v>
                </c:pt>
                <c:pt idx="51">
                  <c:v>7892.36181640625</c:v>
                </c:pt>
                <c:pt idx="52">
                  <c:v>7799.08935546875</c:v>
                </c:pt>
                <c:pt idx="53">
                  <c:v>7782.08447265625</c:v>
                </c:pt>
                <c:pt idx="54">
                  <c:v>7818.76220703125</c:v>
                </c:pt>
                <c:pt idx="55">
                  <c:v>7859.974609375</c:v>
                </c:pt>
                <c:pt idx="56">
                  <c:v>7871.4765625</c:v>
                </c:pt>
                <c:pt idx="57">
                  <c:v>7857.064453125</c:v>
                </c:pt>
                <c:pt idx="58">
                  <c:v>7847.08203125</c:v>
                </c:pt>
                <c:pt idx="59">
                  <c:v>7865.55029296875</c:v>
                </c:pt>
                <c:pt idx="60">
                  <c:v>7905.81787109375</c:v>
                </c:pt>
                <c:pt idx="61">
                  <c:v>7935.34619140625</c:v>
                </c:pt>
                <c:pt idx="62">
                  <c:v>7924.1220703125</c:v>
                </c:pt>
                <c:pt idx="63">
                  <c:v>7871.2158203125</c:v>
                </c:pt>
                <c:pt idx="64">
                  <c:v>7806.75537109375</c:v>
                </c:pt>
                <c:pt idx="65">
                  <c:v>7768.6259765625</c:v>
                </c:pt>
                <c:pt idx="66">
                  <c:v>7774.6884765625</c:v>
                </c:pt>
                <c:pt idx="67">
                  <c:v>7813.7333984375</c:v>
                </c:pt>
                <c:pt idx="68">
                  <c:v>7860.68994140625</c:v>
                </c:pt>
                <c:pt idx="69">
                  <c:v>7900.1748046875</c:v>
                </c:pt>
                <c:pt idx="70">
                  <c:v>7936.427734375</c:v>
                </c:pt>
                <c:pt idx="71">
                  <c:v>7981.681640625</c:v>
                </c:pt>
                <c:pt idx="72">
                  <c:v>8035.74755859375</c:v>
                </c:pt>
                <c:pt idx="73">
                  <c:v>8077.91455078125</c:v>
                </c:pt>
                <c:pt idx="74">
                  <c:v>8080.7119140625</c:v>
                </c:pt>
                <c:pt idx="75">
                  <c:v>8034.236328125</c:v>
                </c:pt>
                <c:pt idx="76">
                  <c:v>7958.8447265625</c:v>
                </c:pt>
                <c:pt idx="77">
                  <c:v>7893.291015625</c:v>
                </c:pt>
                <c:pt idx="78">
                  <c:v>7866.89794921875</c:v>
                </c:pt>
                <c:pt idx="79">
                  <c:v>7878.93408203125</c:v>
                </c:pt>
                <c:pt idx="80">
                  <c:v>7902.70458984375</c:v>
                </c:pt>
                <c:pt idx="81">
                  <c:v>7910.578125</c:v>
                </c:pt>
                <c:pt idx="82">
                  <c:v>7897.943359375</c:v>
                </c:pt>
                <c:pt idx="83">
                  <c:v>7885.08203125</c:v>
                </c:pt>
                <c:pt idx="84">
                  <c:v>7895.59423828125</c:v>
                </c:pt>
                <c:pt idx="85">
                  <c:v>7931.08642578125</c:v>
                </c:pt>
                <c:pt idx="86">
                  <c:v>7965.64794921875</c:v>
                </c:pt>
                <c:pt idx="87">
                  <c:v>7966.462890625</c:v>
                </c:pt>
                <c:pt idx="88">
                  <c:v>7923.51611328125</c:v>
                </c:pt>
                <c:pt idx="89">
                  <c:v>7862.2275390625</c:v>
                </c:pt>
                <c:pt idx="90">
                  <c:v>7826.423828125</c:v>
                </c:pt>
                <c:pt idx="91">
                  <c:v>7844.16259765625</c:v>
                </c:pt>
                <c:pt idx="92">
                  <c:v>7904.12841796875</c:v>
                </c:pt>
                <c:pt idx="93">
                  <c:v>7962.53564453125</c:v>
                </c:pt>
                <c:pt idx="94">
                  <c:v>7975.84326171875</c:v>
                </c:pt>
                <c:pt idx="95">
                  <c:v>7933.63134765625</c:v>
                </c:pt>
                <c:pt idx="96">
                  <c:v>7865.92578125</c:v>
                </c:pt>
                <c:pt idx="97">
                  <c:v>7819.89501953125</c:v>
                </c:pt>
                <c:pt idx="98">
                  <c:v>7824.8916015625</c:v>
                </c:pt>
                <c:pt idx="99">
                  <c:v>7872.83154296875</c:v>
                </c:pt>
                <c:pt idx="100">
                  <c:v>7927.31689453125</c:v>
                </c:pt>
                <c:pt idx="101">
                  <c:v>7951.9013671875</c:v>
                </c:pt>
                <c:pt idx="102">
                  <c:v>7934.47021484375</c:v>
                </c:pt>
                <c:pt idx="103">
                  <c:v>7890.63916015625</c:v>
                </c:pt>
                <c:pt idx="104">
                  <c:v>7847.564453125</c:v>
                </c:pt>
                <c:pt idx="105">
                  <c:v>7824.26708984375</c:v>
                </c:pt>
                <c:pt idx="106">
                  <c:v>7824.046875</c:v>
                </c:pt>
                <c:pt idx="107">
                  <c:v>7841.3125</c:v>
                </c:pt>
                <c:pt idx="108">
                  <c:v>7872.2490234375</c:v>
                </c:pt>
                <c:pt idx="109">
                  <c:v>7917.43115234375</c:v>
                </c:pt>
                <c:pt idx="110">
                  <c:v>7974.56494140625</c:v>
                </c:pt>
                <c:pt idx="111">
                  <c:v>8030.494140625</c:v>
                </c:pt>
                <c:pt idx="112">
                  <c:v>8062.90869140625</c:v>
                </c:pt>
                <c:pt idx="113">
                  <c:v>8052.92919921875</c:v>
                </c:pt>
                <c:pt idx="114">
                  <c:v>7998.92138671875</c:v>
                </c:pt>
                <c:pt idx="115">
                  <c:v>7919.81494140625</c:v>
                </c:pt>
                <c:pt idx="116">
                  <c:v>7844.80029296875</c:v>
                </c:pt>
                <c:pt idx="117">
                  <c:v>7797.55908203125</c:v>
                </c:pt>
                <c:pt idx="118">
                  <c:v>7786.9736328125</c:v>
                </c:pt>
                <c:pt idx="119">
                  <c:v>7809.4296875</c:v>
                </c:pt>
                <c:pt idx="120">
                  <c:v>7857.18408203125</c:v>
                </c:pt>
                <c:pt idx="121">
                  <c:v>7922.9248046875</c:v>
                </c:pt>
                <c:pt idx="122">
                  <c:v>7996.3798828125</c:v>
                </c:pt>
                <c:pt idx="123">
                  <c:v>8058.76708984375</c:v>
                </c:pt>
                <c:pt idx="124">
                  <c:v>8084.830078125</c:v>
                </c:pt>
                <c:pt idx="125">
                  <c:v>8055.693359375</c:v>
                </c:pt>
                <c:pt idx="126">
                  <c:v>7974.3408203125</c:v>
                </c:pt>
                <c:pt idx="127">
                  <c:v>7870.1708984375</c:v>
                </c:pt>
                <c:pt idx="128">
                  <c:v>7785.84912109375</c:v>
                </c:pt>
                <c:pt idx="129">
                  <c:v>7753.755859375</c:v>
                </c:pt>
                <c:pt idx="130">
                  <c:v>7778.61962890625</c:v>
                </c:pt>
                <c:pt idx="131">
                  <c:v>7838.85400390625</c:v>
                </c:pt>
                <c:pt idx="132">
                  <c:v>7904.39794921875</c:v>
                </c:pt>
                <c:pt idx="133">
                  <c:v>7955.9013671875</c:v>
                </c:pt>
                <c:pt idx="134">
                  <c:v>7990.11328125</c:v>
                </c:pt>
                <c:pt idx="135">
                  <c:v>8009.498046875</c:v>
                </c:pt>
                <c:pt idx="136">
                  <c:v>8008.8271484375</c:v>
                </c:pt>
                <c:pt idx="137">
                  <c:v>7974.427734375</c:v>
                </c:pt>
                <c:pt idx="138">
                  <c:v>7899.60546875</c:v>
                </c:pt>
                <c:pt idx="139">
                  <c:v>7802.7939453125</c:v>
                </c:pt>
                <c:pt idx="140">
                  <c:v>7728.7607421875</c:v>
                </c:pt>
                <c:pt idx="141">
                  <c:v>7724.88720703125</c:v>
                </c:pt>
                <c:pt idx="142">
                  <c:v>7805.998046875</c:v>
                </c:pt>
                <c:pt idx="143">
                  <c:v>7934.65869140625</c:v>
                </c:pt>
                <c:pt idx="144">
                  <c:v>8036.5224609375</c:v>
                </c:pt>
                <c:pt idx="145">
                  <c:v>8045.55419921875</c:v>
                </c:pt>
                <c:pt idx="146">
                  <c:v>7949.935546875</c:v>
                </c:pt>
                <c:pt idx="147">
                  <c:v>7805.35986328125</c:v>
                </c:pt>
                <c:pt idx="148">
                  <c:v>7703.17431640625</c:v>
                </c:pt>
                <c:pt idx="149">
                  <c:v>7712.4599609375</c:v>
                </c:pt>
                <c:pt idx="150">
                  <c:v>7834.66796875</c:v>
                </c:pt>
                <c:pt idx="151">
                  <c:v>8002.00830078125</c:v>
                </c:pt>
                <c:pt idx="152">
                  <c:v>8121.1494140625</c:v>
                </c:pt>
                <c:pt idx="153">
                  <c:v>8132.74267578125</c:v>
                </c:pt>
                <c:pt idx="154">
                  <c:v>8046.87744140625</c:v>
                </c:pt>
                <c:pt idx="155">
                  <c:v>7931.8095703125</c:v>
                </c:pt>
                <c:pt idx="156">
                  <c:v>7865.57421875</c:v>
                </c:pt>
                <c:pt idx="157">
                  <c:v>7884.58935546875</c:v>
                </c:pt>
                <c:pt idx="158">
                  <c:v>7963.48876953125</c:v>
                </c:pt>
                <c:pt idx="159">
                  <c:v>8037.2880859375</c:v>
                </c:pt>
                <c:pt idx="160">
                  <c:v>8047.81103515625</c:v>
                </c:pt>
                <c:pt idx="161">
                  <c:v>7981.4228515625</c:v>
                </c:pt>
                <c:pt idx="162">
                  <c:v>7873.84765625</c:v>
                </c:pt>
                <c:pt idx="163">
                  <c:v>7782.33349609375</c:v>
                </c:pt>
                <c:pt idx="164">
                  <c:v>7747.5048828125</c:v>
                </c:pt>
                <c:pt idx="165">
                  <c:v>7771.73193359375</c:v>
                </c:pt>
                <c:pt idx="166">
                  <c:v>7826.1298828125</c:v>
                </c:pt>
                <c:pt idx="167">
                  <c:v>7876.64990234375</c:v>
                </c:pt>
                <c:pt idx="168">
                  <c:v>7907.39892578125</c:v>
                </c:pt>
                <c:pt idx="169">
                  <c:v>7924.56103515625</c:v>
                </c:pt>
                <c:pt idx="170">
                  <c:v>7941.5615234375</c:v>
                </c:pt>
                <c:pt idx="171">
                  <c:v>7961.1328125</c:v>
                </c:pt>
                <c:pt idx="172">
                  <c:v>7970.91552734375</c:v>
                </c:pt>
                <c:pt idx="173">
                  <c:v>7956.162109375</c:v>
                </c:pt>
                <c:pt idx="174">
                  <c:v>7917.3203125</c:v>
                </c:pt>
                <c:pt idx="175">
                  <c:v>7875.3095703125</c:v>
                </c:pt>
                <c:pt idx="176">
                  <c:v>7857.6025390625</c:v>
                </c:pt>
                <c:pt idx="177">
                  <c:v>7875.43359375</c:v>
                </c:pt>
                <c:pt idx="178">
                  <c:v>7911.7744140625</c:v>
                </c:pt>
                <c:pt idx="179">
                  <c:v>7932.4375</c:v>
                </c:pt>
                <c:pt idx="180">
                  <c:v>7913.6611328125</c:v>
                </c:pt>
                <c:pt idx="181">
                  <c:v>7864.32275390625</c:v>
                </c:pt>
                <c:pt idx="182">
                  <c:v>7822.94677734375</c:v>
                </c:pt>
                <c:pt idx="183">
                  <c:v>7828.9833984375</c:v>
                </c:pt>
                <c:pt idx="184">
                  <c:v>7889.5576171875</c:v>
                </c:pt>
                <c:pt idx="185">
                  <c:v>7968.9970703125</c:v>
                </c:pt>
                <c:pt idx="186">
                  <c:v>8012.27099609375</c:v>
                </c:pt>
                <c:pt idx="187">
                  <c:v>7986.55908203125</c:v>
                </c:pt>
                <c:pt idx="188">
                  <c:v>7908.9326171875</c:v>
                </c:pt>
                <c:pt idx="189">
                  <c:v>7836.76611328125</c:v>
                </c:pt>
                <c:pt idx="190">
                  <c:v>7825.82421875</c:v>
                </c:pt>
                <c:pt idx="191">
                  <c:v>7887.20654296875</c:v>
                </c:pt>
                <c:pt idx="192">
                  <c:v>7977.06640625</c:v>
                </c:pt>
                <c:pt idx="193">
                  <c:v>8028.7216796875</c:v>
                </c:pt>
                <c:pt idx="194">
                  <c:v>8003.63525390625</c:v>
                </c:pt>
                <c:pt idx="195">
                  <c:v>7921.92724609375</c:v>
                </c:pt>
                <c:pt idx="196">
                  <c:v>7847.93603515625</c:v>
                </c:pt>
                <c:pt idx="197">
                  <c:v>7840.96826171875</c:v>
                </c:pt>
                <c:pt idx="198">
                  <c:v>7908.87646484375</c:v>
                </c:pt>
                <c:pt idx="199">
                  <c:v>8000.50341796875</c:v>
                </c:pt>
                <c:pt idx="200">
                  <c:v>8043.2529296875</c:v>
                </c:pt>
                <c:pt idx="201">
                  <c:v>7997.26416015625</c:v>
                </c:pt>
                <c:pt idx="202">
                  <c:v>7885.11572265625</c:v>
                </c:pt>
                <c:pt idx="203">
                  <c:v>7775.27099609375</c:v>
                </c:pt>
                <c:pt idx="204">
                  <c:v>7733.03857421875</c:v>
                </c:pt>
                <c:pt idx="205">
                  <c:v>7776.66357421875</c:v>
                </c:pt>
                <c:pt idx="206">
                  <c:v>7870.18408203125</c:v>
                </c:pt>
                <c:pt idx="207">
                  <c:v>7954.93505859375</c:v>
                </c:pt>
                <c:pt idx="208">
                  <c:v>7992.4111328125</c:v>
                </c:pt>
                <c:pt idx="209">
                  <c:v>7985.34228515625</c:v>
                </c:pt>
                <c:pt idx="210">
                  <c:v>7964.2578125</c:v>
                </c:pt>
                <c:pt idx="211">
                  <c:v>7955.31689453125</c:v>
                </c:pt>
                <c:pt idx="212">
                  <c:v>7958.30126953125</c:v>
                </c:pt>
                <c:pt idx="213">
                  <c:v>7951.99169921875</c:v>
                </c:pt>
                <c:pt idx="214">
                  <c:v>7919.18310546875</c:v>
                </c:pt>
                <c:pt idx="215">
                  <c:v>7867.14599609375</c:v>
                </c:pt>
                <c:pt idx="216">
                  <c:v>7824.7353515625</c:v>
                </c:pt>
                <c:pt idx="217">
                  <c:v>7818.77197265625</c:v>
                </c:pt>
                <c:pt idx="218">
                  <c:v>7850.7080078125</c:v>
                </c:pt>
                <c:pt idx="219">
                  <c:v>7894.18701171875</c:v>
                </c:pt>
                <c:pt idx="220">
                  <c:v>7915.91064453125</c:v>
                </c:pt>
                <c:pt idx="221">
                  <c:v>7902.2412109375</c:v>
                </c:pt>
                <c:pt idx="222">
                  <c:v>7869.33544921875</c:v>
                </c:pt>
                <c:pt idx="223">
                  <c:v>7848.77294921875</c:v>
                </c:pt>
                <c:pt idx="224">
                  <c:v>7861.18603515625</c:v>
                </c:pt>
                <c:pt idx="225">
                  <c:v>7899.873046875</c:v>
                </c:pt>
                <c:pt idx="226">
                  <c:v>7937.3427734375</c:v>
                </c:pt>
                <c:pt idx="227">
                  <c:v>7948.419921875</c:v>
                </c:pt>
                <c:pt idx="228">
                  <c:v>7930.38330078125</c:v>
                </c:pt>
                <c:pt idx="229">
                  <c:v>7904.0859375</c:v>
                </c:pt>
                <c:pt idx="230">
                  <c:v>7896.298828125</c:v>
                </c:pt>
                <c:pt idx="231">
                  <c:v>7918.513671875</c:v>
                </c:pt>
                <c:pt idx="232">
                  <c:v>7959.0615234375</c:v>
                </c:pt>
                <c:pt idx="233">
                  <c:v>7993.44189453125</c:v>
                </c:pt>
                <c:pt idx="234">
                  <c:v>8003.03955078125</c:v>
                </c:pt>
                <c:pt idx="235">
                  <c:v>7987.0869140625</c:v>
                </c:pt>
                <c:pt idx="236">
                  <c:v>7959.9482421875</c:v>
                </c:pt>
                <c:pt idx="237">
                  <c:v>7938.27294921875</c:v>
                </c:pt>
                <c:pt idx="238">
                  <c:v>7929.4990234375</c:v>
                </c:pt>
                <c:pt idx="239">
                  <c:v>7929.83984375</c:v>
                </c:pt>
                <c:pt idx="240">
                  <c:v>7930.6953125</c:v>
                </c:pt>
                <c:pt idx="241">
                  <c:v>7926.0537109375</c:v>
                </c:pt>
                <c:pt idx="242">
                  <c:v>7914.76953125</c:v>
                </c:pt>
                <c:pt idx="243">
                  <c:v>7897.94140625</c:v>
                </c:pt>
                <c:pt idx="244">
                  <c:v>7876.24072265625</c:v>
                </c:pt>
                <c:pt idx="245">
                  <c:v>7850.76513671875</c:v>
                </c:pt>
                <c:pt idx="246">
                  <c:v>7825.9638671875</c:v>
                </c:pt>
                <c:pt idx="247">
                  <c:v>7810.08642578125</c:v>
                </c:pt>
                <c:pt idx="248">
                  <c:v>7810.83447265625</c:v>
                </c:pt>
                <c:pt idx="249">
                  <c:v>7829.21826171875</c:v>
                </c:pt>
                <c:pt idx="250">
                  <c:v>7857.42626953125</c:v>
                </c:pt>
                <c:pt idx="251">
                  <c:v>7883.6064453125</c:v>
                </c:pt>
                <c:pt idx="252">
                  <c:v>7900.2265625</c:v>
                </c:pt>
                <c:pt idx="253">
                  <c:v>7909.0283203125</c:v>
                </c:pt>
                <c:pt idx="254">
                  <c:v>7918.21826171875</c:v>
                </c:pt>
                <c:pt idx="255">
                  <c:v>7934.28173828125</c:v>
                </c:pt>
                <c:pt idx="256">
                  <c:v>7955.5673828125</c:v>
                </c:pt>
                <c:pt idx="257">
                  <c:v>7973.12939453125</c:v>
                </c:pt>
                <c:pt idx="258">
                  <c:v>7977.75341796875</c:v>
                </c:pt>
                <c:pt idx="259">
                  <c:v>7966.72119140625</c:v>
                </c:pt>
                <c:pt idx="260">
                  <c:v>7944.6123046875</c:v>
                </c:pt>
                <c:pt idx="261">
                  <c:v>7918.4208984375</c:v>
                </c:pt>
                <c:pt idx="262">
                  <c:v>7892.63623046875</c:v>
                </c:pt>
                <c:pt idx="263">
                  <c:v>7869.39990234375</c:v>
                </c:pt>
                <c:pt idx="264">
                  <c:v>7852.90185546875</c:v>
                </c:pt>
                <c:pt idx="265">
                  <c:v>7851.8291015625</c:v>
                </c:pt>
                <c:pt idx="266">
                  <c:v>7874.7255859375</c:v>
                </c:pt>
                <c:pt idx="267">
                  <c:v>7920.33349609375</c:v>
                </c:pt>
                <c:pt idx="268">
                  <c:v>7971.755859375</c:v>
                </c:pt>
                <c:pt idx="269">
                  <c:v>8002.431640625</c:v>
                </c:pt>
                <c:pt idx="270">
                  <c:v>7992.75341796875</c:v>
                </c:pt>
                <c:pt idx="271">
                  <c:v>7945.904296875</c:v>
                </c:pt>
                <c:pt idx="272">
                  <c:v>7889.50341796875</c:v>
                </c:pt>
                <c:pt idx="273">
                  <c:v>7859.12744140625</c:v>
                </c:pt>
                <c:pt idx="274">
                  <c:v>7873.9560546875</c:v>
                </c:pt>
                <c:pt idx="275">
                  <c:v>7922.2919921875</c:v>
                </c:pt>
                <c:pt idx="276">
                  <c:v>7968.578125</c:v>
                </c:pt>
                <c:pt idx="277">
                  <c:v>7977.84375</c:v>
                </c:pt>
                <c:pt idx="278">
                  <c:v>7940.19921875</c:v>
                </c:pt>
                <c:pt idx="279">
                  <c:v>7877.67578125</c:v>
                </c:pt>
                <c:pt idx="280">
                  <c:v>7828.703125</c:v>
                </c:pt>
                <c:pt idx="281">
                  <c:v>7821.83642578125</c:v>
                </c:pt>
                <c:pt idx="282">
                  <c:v>7857.5556640625</c:v>
                </c:pt>
                <c:pt idx="283">
                  <c:v>7910.0263671875</c:v>
                </c:pt>
                <c:pt idx="284">
                  <c:v>7945.763671875</c:v>
                </c:pt>
                <c:pt idx="285">
                  <c:v>7944.8515625</c:v>
                </c:pt>
                <c:pt idx="286">
                  <c:v>7910.6025390625</c:v>
                </c:pt>
                <c:pt idx="287">
                  <c:v>7863.6708984375</c:v>
                </c:pt>
                <c:pt idx="288">
                  <c:v>7827.7216796875</c:v>
                </c:pt>
                <c:pt idx="289">
                  <c:v>7817.54150390625</c:v>
                </c:pt>
                <c:pt idx="290">
                  <c:v>7835.685546875</c:v>
                </c:pt>
                <c:pt idx="291">
                  <c:v>7875.96923828125</c:v>
                </c:pt>
                <c:pt idx="292">
                  <c:v>7928.19384765625</c:v>
                </c:pt>
                <c:pt idx="293">
                  <c:v>7980.53173828125</c:v>
                </c:pt>
                <c:pt idx="294">
                  <c:v>8020.50048828125</c:v>
                </c:pt>
                <c:pt idx="295">
                  <c:v>8037.35888671875</c:v>
                </c:pt>
                <c:pt idx="296">
                  <c:v>8026.45361328125</c:v>
                </c:pt>
                <c:pt idx="297">
                  <c:v>7992.4833984375</c:v>
                </c:pt>
                <c:pt idx="298">
                  <c:v>7948.0341796875</c:v>
                </c:pt>
                <c:pt idx="299">
                  <c:v>7907.17333984375</c:v>
                </c:pt>
                <c:pt idx="300">
                  <c:v>7878.30078125</c:v>
                </c:pt>
                <c:pt idx="301">
                  <c:v>7861.48095703125</c:v>
                </c:pt>
                <c:pt idx="302">
                  <c:v>7851.90283203125</c:v>
                </c:pt>
                <c:pt idx="303">
                  <c:v>7846.00146484375</c:v>
                </c:pt>
                <c:pt idx="304">
                  <c:v>7844.70751953125</c:v>
                </c:pt>
                <c:pt idx="305">
                  <c:v>7851.14990234375</c:v>
                </c:pt>
                <c:pt idx="306">
                  <c:v>7865.35205078125</c:v>
                </c:pt>
                <c:pt idx="307">
                  <c:v>7881.30029296875</c:v>
                </c:pt>
                <c:pt idx="308">
                  <c:v>7889.7548828125</c:v>
                </c:pt>
                <c:pt idx="309">
                  <c:v>7885.11279296875</c:v>
                </c:pt>
                <c:pt idx="310">
                  <c:v>7870.95166015625</c:v>
                </c:pt>
                <c:pt idx="311">
                  <c:v>7859.6796875</c:v>
                </c:pt>
                <c:pt idx="312">
                  <c:v>7866.080078125</c:v>
                </c:pt>
                <c:pt idx="313">
                  <c:v>7898.8046875</c:v>
                </c:pt>
                <c:pt idx="314">
                  <c:v>7954.82421875</c:v>
                </c:pt>
                <c:pt idx="315">
                  <c:v>8019.44482421875</c:v>
                </c:pt>
                <c:pt idx="316">
                  <c:v>8071.28466796875</c:v>
                </c:pt>
                <c:pt idx="317">
                  <c:v>8089.86083984375</c:v>
                </c:pt>
                <c:pt idx="318">
                  <c:v>8063.39599609375</c:v>
                </c:pt>
                <c:pt idx="319">
                  <c:v>7994.68505859375</c:v>
                </c:pt>
                <c:pt idx="320">
                  <c:v>7902.51318359375</c:v>
                </c:pt>
                <c:pt idx="321">
                  <c:v>7816.373046875</c:v>
                </c:pt>
                <c:pt idx="322">
                  <c:v>7764.7451171875</c:v>
                </c:pt>
                <c:pt idx="323">
                  <c:v>7761.6337890625</c:v>
                </c:pt>
                <c:pt idx="324">
                  <c:v>7799.18115234375</c:v>
                </c:pt>
                <c:pt idx="325">
                  <c:v>7852.251953125</c:v>
                </c:pt>
                <c:pt idx="326">
                  <c:v>7893.61181640625</c:v>
                </c:pt>
                <c:pt idx="327">
                  <c:v>7910.34375</c:v>
                </c:pt>
                <c:pt idx="328">
                  <c:v>7910.0546875</c:v>
                </c:pt>
                <c:pt idx="329">
                  <c:v>7912.064453125</c:v>
                </c:pt>
                <c:pt idx="330">
                  <c:v>7929.98681640625</c:v>
                </c:pt>
                <c:pt idx="331">
                  <c:v>7959.2548828125</c:v>
                </c:pt>
                <c:pt idx="332">
                  <c:v>7979.873046875</c:v>
                </c:pt>
                <c:pt idx="333">
                  <c:v>7972.8359375</c:v>
                </c:pt>
                <c:pt idx="334">
                  <c:v>7937.33740234375</c:v>
                </c:pt>
                <c:pt idx="335">
                  <c:v>7894.48779296875</c:v>
                </c:pt>
                <c:pt idx="336">
                  <c:v>7873.45166015625</c:v>
                </c:pt>
                <c:pt idx="337">
                  <c:v>7889.943359375</c:v>
                </c:pt>
                <c:pt idx="338">
                  <c:v>7933.5751953125</c:v>
                </c:pt>
                <c:pt idx="339">
                  <c:v>7974.1201171875</c:v>
                </c:pt>
                <c:pt idx="340">
                  <c:v>7982.27001953125</c:v>
                </c:pt>
                <c:pt idx="341">
                  <c:v>7949.46142578125</c:v>
                </c:pt>
                <c:pt idx="342">
                  <c:v>7892.431640625</c:v>
                </c:pt>
                <c:pt idx="343">
                  <c:v>7840.26513671875</c:v>
                </c:pt>
                <c:pt idx="344">
                  <c:v>7814.787109375</c:v>
                </c:pt>
                <c:pt idx="345">
                  <c:v>7819.0078125</c:v>
                </c:pt>
                <c:pt idx="346">
                  <c:v>7840.5078125</c:v>
                </c:pt>
                <c:pt idx="347">
                  <c:v>7864.4072265625</c:v>
                </c:pt>
                <c:pt idx="348">
                  <c:v>7884.07470703125</c:v>
                </c:pt>
                <c:pt idx="349">
                  <c:v>7901.671875</c:v>
                </c:pt>
              </c:numCache>
            </c:numRef>
          </c:yVal>
          <c:smooth val="1"/>
          <c:extLst>
            <c:ext xmlns:c16="http://schemas.microsoft.com/office/drawing/2014/chart" uri="{C3380CC4-5D6E-409C-BE32-E72D297353CC}">
              <c16:uniqueId val="{00000001-5429-4359-BD11-807CF8F8408D}"/>
            </c:ext>
          </c:extLst>
        </c:ser>
        <c:ser>
          <c:idx val="2"/>
          <c:order val="2"/>
          <c:tx>
            <c:strRef>
              <c:f>np_sub_003!$C$1</c:f>
              <c:strCache>
                <c:ptCount val="1"/>
                <c:pt idx="0">
                  <c:v>Coor_3</c:v>
                </c:pt>
              </c:strCache>
            </c:strRef>
          </c:tx>
          <c:spPr>
            <a:ln w="28575" cap="rnd">
              <a:solidFill>
                <a:schemeClr val="accent3"/>
              </a:solidFill>
              <a:round/>
            </a:ln>
            <a:effectLst/>
          </c:spPr>
          <c:marker>
            <c:symbol val="none"/>
          </c:marker>
          <c:yVal>
            <c:numRef>
              <c:f>np_sub_003!$C$2:$C$351</c:f>
              <c:numCache>
                <c:formatCode>0.00000000000_ </c:formatCode>
                <c:ptCount val="350"/>
                <c:pt idx="0">
                  <c:v>7670.29052734375</c:v>
                </c:pt>
                <c:pt idx="1">
                  <c:v>7628.1943359375</c:v>
                </c:pt>
                <c:pt idx="2">
                  <c:v>7600.18701171875</c:v>
                </c:pt>
                <c:pt idx="3">
                  <c:v>7601.1259765625</c:v>
                </c:pt>
                <c:pt idx="4">
                  <c:v>7621.080078125</c:v>
                </c:pt>
                <c:pt idx="5">
                  <c:v>7635.65087890625</c:v>
                </c:pt>
                <c:pt idx="6">
                  <c:v>7627.8056640625</c:v>
                </c:pt>
                <c:pt idx="7">
                  <c:v>7602.41015625</c:v>
                </c:pt>
                <c:pt idx="8">
                  <c:v>7581.11669921875</c:v>
                </c:pt>
                <c:pt idx="9">
                  <c:v>7582.32421875</c:v>
                </c:pt>
                <c:pt idx="10">
                  <c:v>7603.89599609375</c:v>
                </c:pt>
                <c:pt idx="11">
                  <c:v>7624.12744140625</c:v>
                </c:pt>
                <c:pt idx="12">
                  <c:v>7620.7705078125</c:v>
                </c:pt>
                <c:pt idx="13">
                  <c:v>7592.13427734375</c:v>
                </c:pt>
                <c:pt idx="14">
                  <c:v>7561.826171875</c:v>
                </c:pt>
                <c:pt idx="15">
                  <c:v>7561.90576171875</c:v>
                </c:pt>
                <c:pt idx="16">
                  <c:v>7607.13037109375</c:v>
                </c:pt>
                <c:pt idx="17">
                  <c:v>7680.79541015625</c:v>
                </c:pt>
                <c:pt idx="18">
                  <c:v>7743.88671875</c:v>
                </c:pt>
                <c:pt idx="19">
                  <c:v>7761.14892578125</c:v>
                </c:pt>
                <c:pt idx="20">
                  <c:v>7724.75390625</c:v>
                </c:pt>
                <c:pt idx="21">
                  <c:v>7658.5546875</c:v>
                </c:pt>
                <c:pt idx="22">
                  <c:v>7600.90185546875</c:v>
                </c:pt>
                <c:pt idx="23">
                  <c:v>7579.4736328125</c:v>
                </c:pt>
                <c:pt idx="24">
                  <c:v>7595.8818359375</c:v>
                </c:pt>
                <c:pt idx="25">
                  <c:v>7628.9521484375</c:v>
                </c:pt>
                <c:pt idx="26">
                  <c:v>7651.685546875</c:v>
                </c:pt>
                <c:pt idx="27">
                  <c:v>7648.78125</c:v>
                </c:pt>
                <c:pt idx="28">
                  <c:v>7623.92578125</c:v>
                </c:pt>
                <c:pt idx="29">
                  <c:v>7594.88818359375</c:v>
                </c:pt>
                <c:pt idx="30">
                  <c:v>7582.07568359375</c:v>
                </c:pt>
                <c:pt idx="31">
                  <c:v>7597.84814453125</c:v>
                </c:pt>
                <c:pt idx="32">
                  <c:v>7640.8349609375</c:v>
                </c:pt>
                <c:pt idx="33">
                  <c:v>7696.109375</c:v>
                </c:pt>
                <c:pt idx="34">
                  <c:v>7740.7041015625</c:v>
                </c:pt>
                <c:pt idx="35">
                  <c:v>7753.427734375</c:v>
                </c:pt>
                <c:pt idx="36">
                  <c:v>7725.974609375</c:v>
                </c:pt>
                <c:pt idx="37">
                  <c:v>7669.51171875</c:v>
                </c:pt>
                <c:pt idx="38">
                  <c:v>7610.8603515625</c:v>
                </c:pt>
                <c:pt idx="39">
                  <c:v>7577.77392578125</c:v>
                </c:pt>
                <c:pt idx="40">
                  <c:v>7581.22607421875</c:v>
                </c:pt>
                <c:pt idx="41">
                  <c:v>7607.26708984375</c:v>
                </c:pt>
                <c:pt idx="42">
                  <c:v>7626.2158203125</c:v>
                </c:pt>
                <c:pt idx="43">
                  <c:v>7614.537109375</c:v>
                </c:pt>
                <c:pt idx="44">
                  <c:v>7573.8828125</c:v>
                </c:pt>
                <c:pt idx="45">
                  <c:v>7532.056640625</c:v>
                </c:pt>
                <c:pt idx="46">
                  <c:v>7523.55859375</c:v>
                </c:pt>
                <c:pt idx="47">
                  <c:v>7563.490234375</c:v>
                </c:pt>
                <c:pt idx="48">
                  <c:v>7634.87109375</c:v>
                </c:pt>
                <c:pt idx="49">
                  <c:v>7699.81689453125</c:v>
                </c:pt>
                <c:pt idx="50">
                  <c:v>7726.45947265625</c:v>
                </c:pt>
                <c:pt idx="51">
                  <c:v>7710.8115234375</c:v>
                </c:pt>
                <c:pt idx="52">
                  <c:v>7676.64111328125</c:v>
                </c:pt>
                <c:pt idx="53">
                  <c:v>7654.0302734375</c:v>
                </c:pt>
                <c:pt idx="54">
                  <c:v>7654.39306640625</c:v>
                </c:pt>
                <c:pt idx="55">
                  <c:v>7662.224609375</c:v>
                </c:pt>
                <c:pt idx="56">
                  <c:v>7649.759765625</c:v>
                </c:pt>
                <c:pt idx="57">
                  <c:v>7601.8291015625</c:v>
                </c:pt>
                <c:pt idx="58">
                  <c:v>7530.29296875</c:v>
                </c:pt>
                <c:pt idx="59">
                  <c:v>7466.72412109375</c:v>
                </c:pt>
                <c:pt idx="60">
                  <c:v>7440.28076171875</c:v>
                </c:pt>
                <c:pt idx="61">
                  <c:v>7459.23291015625</c:v>
                </c:pt>
                <c:pt idx="62">
                  <c:v>7510.0478515625</c:v>
                </c:pt>
                <c:pt idx="63">
                  <c:v>7572.00927734375</c:v>
                </c:pt>
                <c:pt idx="64">
                  <c:v>7632.50390625</c:v>
                </c:pt>
                <c:pt idx="65">
                  <c:v>7689.48388671875</c:v>
                </c:pt>
                <c:pt idx="66">
                  <c:v>7741.30908203125</c:v>
                </c:pt>
                <c:pt idx="67">
                  <c:v>7777.01318359375</c:v>
                </c:pt>
                <c:pt idx="68">
                  <c:v>7779.7666015625</c:v>
                </c:pt>
                <c:pt idx="69">
                  <c:v>7742.82373046875</c:v>
                </c:pt>
                <c:pt idx="70">
                  <c:v>7683.1015625</c:v>
                </c:pt>
                <c:pt idx="71">
                  <c:v>7636.6318359375</c:v>
                </c:pt>
                <c:pt idx="72">
                  <c:v>7634.85009765625</c:v>
                </c:pt>
                <c:pt idx="73">
                  <c:v>7678.8984375</c:v>
                </c:pt>
                <c:pt idx="74">
                  <c:v>7734.17724609375</c:v>
                </c:pt>
                <c:pt idx="75">
                  <c:v>7753.1240234375</c:v>
                </c:pt>
                <c:pt idx="76">
                  <c:v>7711.1455078125</c:v>
                </c:pt>
                <c:pt idx="77">
                  <c:v>7627.97265625</c:v>
                </c:pt>
                <c:pt idx="78">
                  <c:v>7556.15234375</c:v>
                </c:pt>
                <c:pt idx="79">
                  <c:v>7543.59619140625</c:v>
                </c:pt>
                <c:pt idx="80">
                  <c:v>7598.08251953125</c:v>
                </c:pt>
                <c:pt idx="81">
                  <c:v>7681.04345703125</c:v>
                </c:pt>
                <c:pt idx="82">
                  <c:v>7735.64404296875</c:v>
                </c:pt>
                <c:pt idx="83">
                  <c:v>7727.634765625</c:v>
                </c:pt>
                <c:pt idx="84">
                  <c:v>7667.8720703125</c:v>
                </c:pt>
                <c:pt idx="85">
                  <c:v>7600.3095703125</c:v>
                </c:pt>
                <c:pt idx="86">
                  <c:v>7566.44970703125</c:v>
                </c:pt>
                <c:pt idx="87">
                  <c:v>7574.89208984375</c:v>
                </c:pt>
                <c:pt idx="88">
                  <c:v>7599.060546875</c:v>
                </c:pt>
                <c:pt idx="89">
                  <c:v>7602.7587890625</c:v>
                </c:pt>
                <c:pt idx="90">
                  <c:v>7571.32421875</c:v>
                </c:pt>
                <c:pt idx="91">
                  <c:v>7523.1962890625</c:v>
                </c:pt>
                <c:pt idx="92">
                  <c:v>7493.984375</c:v>
                </c:pt>
                <c:pt idx="93">
                  <c:v>7507.60693359375</c:v>
                </c:pt>
                <c:pt idx="94">
                  <c:v>7558.31689453125</c:v>
                </c:pt>
                <c:pt idx="95">
                  <c:v>7616.89892578125</c:v>
                </c:pt>
                <c:pt idx="96">
                  <c:v>7653.89990234375</c:v>
                </c:pt>
                <c:pt idx="97">
                  <c:v>7659.8193359375</c:v>
                </c:pt>
                <c:pt idx="98">
                  <c:v>7646.7861328125</c:v>
                </c:pt>
                <c:pt idx="99">
                  <c:v>7633.22705078125</c:v>
                </c:pt>
                <c:pt idx="100">
                  <c:v>7627.14208984375</c:v>
                </c:pt>
                <c:pt idx="101">
                  <c:v>7623.0439453125</c:v>
                </c:pt>
                <c:pt idx="102">
                  <c:v>7613.70556640625</c:v>
                </c:pt>
                <c:pt idx="103">
                  <c:v>7603.5947265625</c:v>
                </c:pt>
                <c:pt idx="104">
                  <c:v>7609.1123046875</c:v>
                </c:pt>
                <c:pt idx="105">
                  <c:v>7643.18701171875</c:v>
                </c:pt>
                <c:pt idx="106">
                  <c:v>7697.41455078125</c:v>
                </c:pt>
                <c:pt idx="107">
                  <c:v>7739.5869140625</c:v>
                </c:pt>
                <c:pt idx="108">
                  <c:v>7733.1259765625</c:v>
                </c:pt>
                <c:pt idx="109">
                  <c:v>7666.2119140625</c:v>
                </c:pt>
                <c:pt idx="110">
                  <c:v>7567.87646484375</c:v>
                </c:pt>
                <c:pt idx="111">
                  <c:v>7495.5888671875</c:v>
                </c:pt>
                <c:pt idx="112">
                  <c:v>7499.50537109375</c:v>
                </c:pt>
                <c:pt idx="113">
                  <c:v>7587.10546875</c:v>
                </c:pt>
                <c:pt idx="114">
                  <c:v>7713.82177734375</c:v>
                </c:pt>
                <c:pt idx="115">
                  <c:v>7808.19921875</c:v>
                </c:pt>
                <c:pt idx="116">
                  <c:v>7816.0703125</c:v>
                </c:pt>
                <c:pt idx="117">
                  <c:v>7734.55126953125</c:v>
                </c:pt>
                <c:pt idx="118">
                  <c:v>7613.31982421875</c:v>
                </c:pt>
                <c:pt idx="119">
                  <c:v>7522.81982421875</c:v>
                </c:pt>
                <c:pt idx="120">
                  <c:v>7511.072265625</c:v>
                </c:pt>
                <c:pt idx="121">
                  <c:v>7577.34912109375</c:v>
                </c:pt>
                <c:pt idx="122">
                  <c:v>7678.2275390625</c:v>
                </c:pt>
                <c:pt idx="123">
                  <c:v>7759.1044921875</c:v>
                </c:pt>
                <c:pt idx="124">
                  <c:v>7788.05322265625</c:v>
                </c:pt>
                <c:pt idx="125">
                  <c:v>7769.65185546875</c:v>
                </c:pt>
                <c:pt idx="126">
                  <c:v>7732.375</c:v>
                </c:pt>
                <c:pt idx="127">
                  <c:v>7702.1416015625</c:v>
                </c:pt>
                <c:pt idx="128">
                  <c:v>7683.0185546875</c:v>
                </c:pt>
                <c:pt idx="129">
                  <c:v>7658.70654296875</c:v>
                </c:pt>
                <c:pt idx="130">
                  <c:v>7611.64697265625</c:v>
                </c:pt>
                <c:pt idx="131">
                  <c:v>7543.21923828125</c:v>
                </c:pt>
                <c:pt idx="132">
                  <c:v>7478.2978515625</c:v>
                </c:pt>
                <c:pt idx="133">
                  <c:v>7449.99462890625</c:v>
                </c:pt>
                <c:pt idx="134">
                  <c:v>7475.8828125</c:v>
                </c:pt>
                <c:pt idx="135">
                  <c:v>7543.64453125</c:v>
                </c:pt>
                <c:pt idx="136">
                  <c:v>7617.109375</c:v>
                </c:pt>
                <c:pt idx="137">
                  <c:v>7658.55419921875</c:v>
                </c:pt>
                <c:pt idx="138">
                  <c:v>7651.45849609375</c:v>
                </c:pt>
                <c:pt idx="139">
                  <c:v>7608.236328125</c:v>
                </c:pt>
                <c:pt idx="140">
                  <c:v>7559.03759765625</c:v>
                </c:pt>
                <c:pt idx="141">
                  <c:v>7531.3115234375</c:v>
                </c:pt>
                <c:pt idx="142">
                  <c:v>7535.14990234375</c:v>
                </c:pt>
                <c:pt idx="143">
                  <c:v>7563.08544921875</c:v>
                </c:pt>
                <c:pt idx="144">
                  <c:v>7600.97021484375</c:v>
                </c:pt>
                <c:pt idx="145">
                  <c:v>7638.80908203125</c:v>
                </c:pt>
                <c:pt idx="146">
                  <c:v>7672.80810546875</c:v>
                </c:pt>
                <c:pt idx="147">
                  <c:v>7699.44091796875</c:v>
                </c:pt>
                <c:pt idx="148">
                  <c:v>7710.14794921875</c:v>
                </c:pt>
                <c:pt idx="149">
                  <c:v>7694.35986328125</c:v>
                </c:pt>
                <c:pt idx="150">
                  <c:v>7649.8583984375</c:v>
                </c:pt>
                <c:pt idx="151">
                  <c:v>7591.1357421875</c:v>
                </c:pt>
                <c:pt idx="152">
                  <c:v>7546.27685546875</c:v>
                </c:pt>
                <c:pt idx="153">
                  <c:v>7541.82275390625</c:v>
                </c:pt>
                <c:pt idx="154">
                  <c:v>7585.5703125</c:v>
                </c:pt>
                <c:pt idx="155">
                  <c:v>7660.21240234375</c:v>
                </c:pt>
                <c:pt idx="156">
                  <c:v>7733.05859375</c:v>
                </c:pt>
                <c:pt idx="157">
                  <c:v>7774.96923828125</c:v>
                </c:pt>
                <c:pt idx="158">
                  <c:v>7775.05078125</c:v>
                </c:pt>
                <c:pt idx="159">
                  <c:v>7741.9384765625</c:v>
                </c:pt>
                <c:pt idx="160">
                  <c:v>7693.623046875</c:v>
                </c:pt>
                <c:pt idx="161">
                  <c:v>7646.03515625</c:v>
                </c:pt>
                <c:pt idx="162">
                  <c:v>7609.130859375</c:v>
                </c:pt>
                <c:pt idx="163">
                  <c:v>7590.21044921875</c:v>
                </c:pt>
                <c:pt idx="164">
                  <c:v>7596.63525390625</c:v>
                </c:pt>
                <c:pt idx="165">
                  <c:v>7631.53076171875</c:v>
                </c:pt>
                <c:pt idx="166">
                  <c:v>7685.1298828125</c:v>
                </c:pt>
                <c:pt idx="167">
                  <c:v>7732.0068359375</c:v>
                </c:pt>
                <c:pt idx="168">
                  <c:v>7741.98876953125</c:v>
                </c:pt>
                <c:pt idx="169">
                  <c:v>7700.61865234375</c:v>
                </c:pt>
                <c:pt idx="170">
                  <c:v>7623.92431640625</c:v>
                </c:pt>
                <c:pt idx="171">
                  <c:v>7553.1142578125</c:v>
                </c:pt>
                <c:pt idx="172">
                  <c:v>7529.19384765625</c:v>
                </c:pt>
                <c:pt idx="173">
                  <c:v>7564.52392578125</c:v>
                </c:pt>
                <c:pt idx="174">
                  <c:v>7633.224609375</c:v>
                </c:pt>
                <c:pt idx="175">
                  <c:v>7689.25390625</c:v>
                </c:pt>
                <c:pt idx="176">
                  <c:v>7699.29833984375</c:v>
                </c:pt>
                <c:pt idx="177">
                  <c:v>7665.06884765625</c:v>
                </c:pt>
                <c:pt idx="178">
                  <c:v>7617.45166015625</c:v>
                </c:pt>
                <c:pt idx="179">
                  <c:v>7587.83642578125</c:v>
                </c:pt>
                <c:pt idx="180">
                  <c:v>7581.14990234375</c:v>
                </c:pt>
                <c:pt idx="181">
                  <c:v>7574.10986328125</c:v>
                </c:pt>
                <c:pt idx="182">
                  <c:v>7540.82421875</c:v>
                </c:pt>
                <c:pt idx="183">
                  <c:v>7483.564453125</c:v>
                </c:pt>
                <c:pt idx="184">
                  <c:v>7440.22021484375</c:v>
                </c:pt>
                <c:pt idx="185">
                  <c:v>7458.21728515625</c:v>
                </c:pt>
                <c:pt idx="186">
                  <c:v>7553.42041015625</c:v>
                </c:pt>
                <c:pt idx="187">
                  <c:v>7687.76220703125</c:v>
                </c:pt>
                <c:pt idx="188">
                  <c:v>7787.19091796875</c:v>
                </c:pt>
                <c:pt idx="189">
                  <c:v>7790.3330078125</c:v>
                </c:pt>
                <c:pt idx="190">
                  <c:v>7692.7626953125</c:v>
                </c:pt>
                <c:pt idx="191">
                  <c:v>7553.009765625</c:v>
                </c:pt>
                <c:pt idx="192">
                  <c:v>7454.47705078125</c:v>
                </c:pt>
                <c:pt idx="193">
                  <c:v>7450.6279296875</c:v>
                </c:pt>
                <c:pt idx="194">
                  <c:v>7533.1044921875</c:v>
                </c:pt>
                <c:pt idx="195">
                  <c:v>7644.29248046875</c:v>
                </c:pt>
                <c:pt idx="196">
                  <c:v>7721.9638671875</c:v>
                </c:pt>
                <c:pt idx="197">
                  <c:v>7740.724609375</c:v>
                </c:pt>
                <c:pt idx="198">
                  <c:v>7720.47900390625</c:v>
                </c:pt>
                <c:pt idx="199">
                  <c:v>7700.1025390625</c:v>
                </c:pt>
                <c:pt idx="200">
                  <c:v>7701.65380859375</c:v>
                </c:pt>
                <c:pt idx="201">
                  <c:v>7715.20751953125</c:v>
                </c:pt>
                <c:pt idx="202">
                  <c:v>7714.41796875</c:v>
                </c:pt>
                <c:pt idx="203">
                  <c:v>7686.17138671875</c:v>
                </c:pt>
                <c:pt idx="204">
                  <c:v>7646.62939453125</c:v>
                </c:pt>
                <c:pt idx="205">
                  <c:v>7629.06787109375</c:v>
                </c:pt>
                <c:pt idx="206">
                  <c:v>7654.12158203125</c:v>
                </c:pt>
                <c:pt idx="207">
                  <c:v>7708.6318359375</c:v>
                </c:pt>
                <c:pt idx="208">
                  <c:v>7752.30712890625</c:v>
                </c:pt>
                <c:pt idx="209">
                  <c:v>7748.05126953125</c:v>
                </c:pt>
                <c:pt idx="210">
                  <c:v>7691.8251953125</c:v>
                </c:pt>
                <c:pt idx="211">
                  <c:v>7617.76416015625</c:v>
                </c:pt>
                <c:pt idx="212">
                  <c:v>7573.85400390625</c:v>
                </c:pt>
                <c:pt idx="213">
                  <c:v>7586.638671875</c:v>
                </c:pt>
                <c:pt idx="214">
                  <c:v>7641.76171875</c:v>
                </c:pt>
                <c:pt idx="215">
                  <c:v>7694.54541015625</c:v>
                </c:pt>
                <c:pt idx="216">
                  <c:v>7701.99267578125</c:v>
                </c:pt>
                <c:pt idx="217">
                  <c:v>7652.349609375</c:v>
                </c:pt>
                <c:pt idx="218">
                  <c:v>7571.66796875</c:v>
                </c:pt>
                <c:pt idx="219">
                  <c:v>7504.6171875</c:v>
                </c:pt>
                <c:pt idx="220">
                  <c:v>7484.8291015625</c:v>
                </c:pt>
                <c:pt idx="221">
                  <c:v>7515.400390625</c:v>
                </c:pt>
                <c:pt idx="222">
                  <c:v>7570.70458984375</c:v>
                </c:pt>
                <c:pt idx="223">
                  <c:v>7615.23388671875</c:v>
                </c:pt>
                <c:pt idx="224">
                  <c:v>7625.2041015625</c:v>
                </c:pt>
                <c:pt idx="225">
                  <c:v>7599.7216796875</c:v>
                </c:pt>
                <c:pt idx="226">
                  <c:v>7557.26513671875</c:v>
                </c:pt>
                <c:pt idx="227">
                  <c:v>7522.54833984375</c:v>
                </c:pt>
                <c:pt idx="228">
                  <c:v>7512.78564453125</c:v>
                </c:pt>
                <c:pt idx="229">
                  <c:v>7530.4482421875</c:v>
                </c:pt>
                <c:pt idx="230">
                  <c:v>7564.79736328125</c:v>
                </c:pt>
                <c:pt idx="231">
                  <c:v>7600.013671875</c:v>
                </c:pt>
                <c:pt idx="232">
                  <c:v>7625.091796875</c:v>
                </c:pt>
                <c:pt idx="233">
                  <c:v>7640.04833984375</c:v>
                </c:pt>
                <c:pt idx="234">
                  <c:v>7654.6845703125</c:v>
                </c:pt>
                <c:pt idx="235">
                  <c:v>7680.19775390625</c:v>
                </c:pt>
                <c:pt idx="236">
                  <c:v>7718.79931640625</c:v>
                </c:pt>
                <c:pt idx="237">
                  <c:v>7758.962890625</c:v>
                </c:pt>
                <c:pt idx="238">
                  <c:v>7781.06640625</c:v>
                </c:pt>
                <c:pt idx="239">
                  <c:v>7770.80615234375</c:v>
                </c:pt>
                <c:pt idx="240">
                  <c:v>7730.89892578125</c:v>
                </c:pt>
                <c:pt idx="241">
                  <c:v>7681.2919921875</c:v>
                </c:pt>
                <c:pt idx="242">
                  <c:v>7645.98974609375</c:v>
                </c:pt>
                <c:pt idx="243">
                  <c:v>7635.4599609375</c:v>
                </c:pt>
                <c:pt idx="244">
                  <c:v>7638.51513671875</c:v>
                </c:pt>
                <c:pt idx="245">
                  <c:v>7631.4912109375</c:v>
                </c:pt>
                <c:pt idx="246">
                  <c:v>7599.03076171875</c:v>
                </c:pt>
                <c:pt idx="247">
                  <c:v>7550.34716796875</c:v>
                </c:pt>
                <c:pt idx="248">
                  <c:v>7516.640625</c:v>
                </c:pt>
                <c:pt idx="249">
                  <c:v>7529.24609375</c:v>
                </c:pt>
                <c:pt idx="250">
                  <c:v>7593.83642578125</c:v>
                </c:pt>
                <c:pt idx="251">
                  <c:v>7680.86767578125</c:v>
                </c:pt>
                <c:pt idx="252">
                  <c:v>7741.58349609375</c:v>
                </c:pt>
                <c:pt idx="253">
                  <c:v>7739.9013671875</c:v>
                </c:pt>
                <c:pt idx="254">
                  <c:v>7677.810546875</c:v>
                </c:pt>
                <c:pt idx="255">
                  <c:v>7595.6787109375</c:v>
                </c:pt>
                <c:pt idx="256">
                  <c:v>7546.6259765625</c:v>
                </c:pt>
                <c:pt idx="257">
                  <c:v>7562.6298828125</c:v>
                </c:pt>
                <c:pt idx="258">
                  <c:v>7635.46875</c:v>
                </c:pt>
                <c:pt idx="259">
                  <c:v>7724.36572265625</c:v>
                </c:pt>
                <c:pt idx="260">
                  <c:v>7783.13916015625</c:v>
                </c:pt>
                <c:pt idx="261">
                  <c:v>7787.16943359375</c:v>
                </c:pt>
                <c:pt idx="262">
                  <c:v>7742.93212890625</c:v>
                </c:pt>
                <c:pt idx="263">
                  <c:v>7677.0322265625</c:v>
                </c:pt>
                <c:pt idx="264">
                  <c:v>7615.951171875</c:v>
                </c:pt>
                <c:pt idx="265">
                  <c:v>7571.85888671875</c:v>
                </c:pt>
                <c:pt idx="266">
                  <c:v>7542.3466796875</c:v>
                </c:pt>
                <c:pt idx="267">
                  <c:v>7520.25439453125</c:v>
                </c:pt>
                <c:pt idx="268">
                  <c:v>7503.314453125</c:v>
                </c:pt>
                <c:pt idx="269">
                  <c:v>7495.9755859375</c:v>
                </c:pt>
                <c:pt idx="270">
                  <c:v>7503.75</c:v>
                </c:pt>
                <c:pt idx="271">
                  <c:v>7526.46240234375</c:v>
                </c:pt>
                <c:pt idx="272">
                  <c:v>7556.52197265625</c:v>
                </c:pt>
                <c:pt idx="273">
                  <c:v>7583.1875</c:v>
                </c:pt>
                <c:pt idx="274">
                  <c:v>7598.89501953125</c:v>
                </c:pt>
                <c:pt idx="275">
                  <c:v>7602.89404296875</c:v>
                </c:pt>
                <c:pt idx="276">
                  <c:v>7600.44482421875</c:v>
                </c:pt>
                <c:pt idx="277">
                  <c:v>7599.30859375</c:v>
                </c:pt>
                <c:pt idx="278">
                  <c:v>7606.30908203125</c:v>
                </c:pt>
                <c:pt idx="279">
                  <c:v>7625.30908203125</c:v>
                </c:pt>
                <c:pt idx="280">
                  <c:v>7656.2431640625</c:v>
                </c:pt>
                <c:pt idx="281">
                  <c:v>7694.6865234375</c:v>
                </c:pt>
                <c:pt idx="282">
                  <c:v>7732.43115234375</c:v>
                </c:pt>
                <c:pt idx="283">
                  <c:v>7759.970703125</c:v>
                </c:pt>
                <c:pt idx="284">
                  <c:v>7770.513671875</c:v>
                </c:pt>
                <c:pt idx="285">
                  <c:v>7763.28271484375</c:v>
                </c:pt>
                <c:pt idx="286">
                  <c:v>7743.482421875</c:v>
                </c:pt>
                <c:pt idx="287">
                  <c:v>7718.4638671875</c:v>
                </c:pt>
                <c:pt idx="288">
                  <c:v>7692.712890625</c:v>
                </c:pt>
                <c:pt idx="289">
                  <c:v>7665.6591796875</c:v>
                </c:pt>
                <c:pt idx="290">
                  <c:v>7634.3046875</c:v>
                </c:pt>
                <c:pt idx="291">
                  <c:v>7598.75830078125</c:v>
                </c:pt>
                <c:pt idx="292">
                  <c:v>7566.01513671875</c:v>
                </c:pt>
                <c:pt idx="293">
                  <c:v>7548.232421875</c:v>
                </c:pt>
                <c:pt idx="294">
                  <c:v>7555.75537109375</c:v>
                </c:pt>
                <c:pt idx="295">
                  <c:v>7589.25341796875</c:v>
                </c:pt>
                <c:pt idx="296">
                  <c:v>7636.455078125</c:v>
                </c:pt>
                <c:pt idx="297">
                  <c:v>7676.296875</c:v>
                </c:pt>
                <c:pt idx="298">
                  <c:v>7688.78466796875</c:v>
                </c:pt>
                <c:pt idx="299">
                  <c:v>7665.40478515625</c:v>
                </c:pt>
                <c:pt idx="300">
                  <c:v>7614.48828125</c:v>
                </c:pt>
                <c:pt idx="301">
                  <c:v>7558.42724609375</c:v>
                </c:pt>
                <c:pt idx="302">
                  <c:v>7523.5810546875</c:v>
                </c:pt>
                <c:pt idx="303">
                  <c:v>7527.39208984375</c:v>
                </c:pt>
                <c:pt idx="304">
                  <c:v>7569.0380859375</c:v>
                </c:pt>
                <c:pt idx="305">
                  <c:v>7628.958984375</c:v>
                </c:pt>
                <c:pt idx="306">
                  <c:v>7678.52783203125</c:v>
                </c:pt>
                <c:pt idx="307">
                  <c:v>7695.41552734375</c:v>
                </c:pt>
                <c:pt idx="308">
                  <c:v>7675.95458984375</c:v>
                </c:pt>
                <c:pt idx="309">
                  <c:v>7636.4326171875</c:v>
                </c:pt>
                <c:pt idx="310">
                  <c:v>7601.6533203125</c:v>
                </c:pt>
                <c:pt idx="311">
                  <c:v>7587.91845703125</c:v>
                </c:pt>
                <c:pt idx="312">
                  <c:v>7592.46484375</c:v>
                </c:pt>
                <c:pt idx="313">
                  <c:v>7597.74462890625</c:v>
                </c:pt>
                <c:pt idx="314">
                  <c:v>7588.11474609375</c:v>
                </c:pt>
                <c:pt idx="315">
                  <c:v>7566.1591796875</c:v>
                </c:pt>
                <c:pt idx="316">
                  <c:v>7554.61767578125</c:v>
                </c:pt>
                <c:pt idx="317">
                  <c:v>7580.13671875</c:v>
                </c:pt>
                <c:pt idx="318">
                  <c:v>7649.8984375</c:v>
                </c:pt>
                <c:pt idx="319">
                  <c:v>7739.82421875</c:v>
                </c:pt>
                <c:pt idx="320">
                  <c:v>7806.09912109375</c:v>
                </c:pt>
                <c:pt idx="321">
                  <c:v>7814.1826171875</c:v>
                </c:pt>
                <c:pt idx="322">
                  <c:v>7764.45849609375</c:v>
                </c:pt>
                <c:pt idx="323">
                  <c:v>7693.97607421875</c:v>
                </c:pt>
                <c:pt idx="324">
                  <c:v>7650.630859375</c:v>
                </c:pt>
                <c:pt idx="325">
                  <c:v>7657.5517578125</c:v>
                </c:pt>
                <c:pt idx="326">
                  <c:v>7694.50244140625</c:v>
                </c:pt>
                <c:pt idx="327">
                  <c:v>7711.67529296875</c:v>
                </c:pt>
                <c:pt idx="328">
                  <c:v>7667.068359375</c:v>
                </c:pt>
                <c:pt idx="329">
                  <c:v>7560.15625</c:v>
                </c:pt>
                <c:pt idx="330">
                  <c:v>7436.4228515625</c:v>
                </c:pt>
                <c:pt idx="331">
                  <c:v>7358.74755859375</c:v>
                </c:pt>
                <c:pt idx="332">
                  <c:v>7366.30859375</c:v>
                </c:pt>
                <c:pt idx="333">
                  <c:v>7450.66015625</c:v>
                </c:pt>
                <c:pt idx="334">
                  <c:v>7565.125</c:v>
                </c:pt>
                <c:pt idx="335">
                  <c:v>7658.42626953125</c:v>
                </c:pt>
                <c:pt idx="336">
                  <c:v>7706.3291015625</c:v>
                </c:pt>
                <c:pt idx="337">
                  <c:v>7718.8203125</c:v>
                </c:pt>
                <c:pt idx="338">
                  <c:v>7721.0732421875</c:v>
                </c:pt>
                <c:pt idx="339">
                  <c:v>7726.9365234375</c:v>
                </c:pt>
                <c:pt idx="340">
                  <c:v>7727.734375</c:v>
                </c:pt>
                <c:pt idx="341">
                  <c:v>7704.47607421875</c:v>
                </c:pt>
                <c:pt idx="342">
                  <c:v>7651.1337890625</c:v>
                </c:pt>
                <c:pt idx="343">
                  <c:v>7587.4697265625</c:v>
                </c:pt>
                <c:pt idx="344">
                  <c:v>7549.138671875</c:v>
                </c:pt>
                <c:pt idx="345">
                  <c:v>7562.18896484375</c:v>
                </c:pt>
                <c:pt idx="346">
                  <c:v>7622.3505859375</c:v>
                </c:pt>
                <c:pt idx="347">
                  <c:v>7695.90771484375</c:v>
                </c:pt>
                <c:pt idx="348">
                  <c:v>7741.86962890625</c:v>
                </c:pt>
                <c:pt idx="349">
                  <c:v>7738.703125</c:v>
                </c:pt>
              </c:numCache>
            </c:numRef>
          </c:yVal>
          <c:smooth val="1"/>
          <c:extLst>
            <c:ext xmlns:c16="http://schemas.microsoft.com/office/drawing/2014/chart" uri="{C3380CC4-5D6E-409C-BE32-E72D297353CC}">
              <c16:uniqueId val="{00000002-5429-4359-BD11-807CF8F8408D}"/>
            </c:ext>
          </c:extLst>
        </c:ser>
        <c:ser>
          <c:idx val="3"/>
          <c:order val="3"/>
          <c:tx>
            <c:strRef>
              <c:f>np_sub_003!$D$1</c:f>
              <c:strCache>
                <c:ptCount val="1"/>
                <c:pt idx="0">
                  <c:v>Coor_4</c:v>
                </c:pt>
              </c:strCache>
            </c:strRef>
          </c:tx>
          <c:spPr>
            <a:ln w="28575" cap="rnd">
              <a:solidFill>
                <a:schemeClr val="accent4"/>
              </a:solidFill>
              <a:round/>
            </a:ln>
            <a:effectLst/>
          </c:spPr>
          <c:marker>
            <c:symbol val="none"/>
          </c:marker>
          <c:yVal>
            <c:numRef>
              <c:f>np_sub_003!$D$2:$D$351</c:f>
              <c:numCache>
                <c:formatCode>0.00000000000_ </c:formatCode>
                <c:ptCount val="350"/>
                <c:pt idx="0">
                  <c:v>7414.8642578125</c:v>
                </c:pt>
                <c:pt idx="1">
                  <c:v>7391.52001953125</c:v>
                </c:pt>
                <c:pt idx="2">
                  <c:v>7352.8798828125</c:v>
                </c:pt>
                <c:pt idx="3">
                  <c:v>7331.95556640625</c:v>
                </c:pt>
                <c:pt idx="4">
                  <c:v>7347.65234375</c:v>
                </c:pt>
                <c:pt idx="5">
                  <c:v>7386.00244140625</c:v>
                </c:pt>
                <c:pt idx="6">
                  <c:v>7409.4638671875</c:v>
                </c:pt>
                <c:pt idx="7">
                  <c:v>7387.748046875</c:v>
                </c:pt>
                <c:pt idx="8">
                  <c:v>7324.7001953125</c:v>
                </c:pt>
                <c:pt idx="9">
                  <c:v>7258.38525390625</c:v>
                </c:pt>
                <c:pt idx="10">
                  <c:v>7233.73828125</c:v>
                </c:pt>
                <c:pt idx="11">
                  <c:v>7269.90087890625</c:v>
                </c:pt>
                <c:pt idx="12">
                  <c:v>7348.27587890625</c:v>
                </c:pt>
                <c:pt idx="13">
                  <c:v>7429.33154296875</c:v>
                </c:pt>
                <c:pt idx="14">
                  <c:v>7482.20556640625</c:v>
                </c:pt>
                <c:pt idx="15">
                  <c:v>7501.94287109375</c:v>
                </c:pt>
                <c:pt idx="16">
                  <c:v>7502.07177734375</c:v>
                </c:pt>
                <c:pt idx="17">
                  <c:v>7493.013671875</c:v>
                </c:pt>
                <c:pt idx="18">
                  <c:v>7468.865234375</c:v>
                </c:pt>
                <c:pt idx="19">
                  <c:v>7415.8857421875</c:v>
                </c:pt>
                <c:pt idx="20">
                  <c:v>7334.34814453125</c:v>
                </c:pt>
                <c:pt idx="21">
                  <c:v>7251.38916015625</c:v>
                </c:pt>
                <c:pt idx="22">
                  <c:v>7209.333984375</c:v>
                </c:pt>
                <c:pt idx="23">
                  <c:v>7235.97216796875</c:v>
                </c:pt>
                <c:pt idx="24">
                  <c:v>7320.8369140625</c:v>
                </c:pt>
                <c:pt idx="25">
                  <c:v>7418.546875</c:v>
                </c:pt>
                <c:pt idx="26">
                  <c:v>7478.6015625</c:v>
                </c:pt>
                <c:pt idx="27">
                  <c:v>7479.0615234375</c:v>
                </c:pt>
                <c:pt idx="28">
                  <c:v>7438.173828125</c:v>
                </c:pt>
                <c:pt idx="29">
                  <c:v>7396.13232421875</c:v>
                </c:pt>
                <c:pt idx="30">
                  <c:v>7383.19775390625</c:v>
                </c:pt>
                <c:pt idx="31">
                  <c:v>7400.08447265625</c:v>
                </c:pt>
                <c:pt idx="32">
                  <c:v>7424.3330078125</c:v>
                </c:pt>
                <c:pt idx="33">
                  <c:v>7433.724609375</c:v>
                </c:pt>
                <c:pt idx="34">
                  <c:v>7424.56494140625</c:v>
                </c:pt>
                <c:pt idx="35">
                  <c:v>7409.5869140625</c:v>
                </c:pt>
                <c:pt idx="36">
                  <c:v>7400.04150390625</c:v>
                </c:pt>
                <c:pt idx="37">
                  <c:v>7390.9541015625</c:v>
                </c:pt>
                <c:pt idx="38">
                  <c:v>7364.83837890625</c:v>
                </c:pt>
                <c:pt idx="39">
                  <c:v>7311.21484375</c:v>
                </c:pt>
                <c:pt idx="40">
                  <c:v>7243.7578125</c:v>
                </c:pt>
                <c:pt idx="41">
                  <c:v>7197.8486328125</c:v>
                </c:pt>
                <c:pt idx="42">
                  <c:v>7208.0078125</c:v>
                </c:pt>
                <c:pt idx="43">
                  <c:v>7282.3291015625</c:v>
                </c:pt>
                <c:pt idx="44">
                  <c:v>7394.25146484375</c:v>
                </c:pt>
                <c:pt idx="45">
                  <c:v>7498.1982421875</c:v>
                </c:pt>
                <c:pt idx="46">
                  <c:v>7556.89794921875</c:v>
                </c:pt>
                <c:pt idx="47">
                  <c:v>7560.18994140625</c:v>
                </c:pt>
                <c:pt idx="48">
                  <c:v>7523.66455078125</c:v>
                </c:pt>
                <c:pt idx="49">
                  <c:v>7472.052734375</c:v>
                </c:pt>
                <c:pt idx="50">
                  <c:v>7422.57470703125</c:v>
                </c:pt>
                <c:pt idx="51">
                  <c:v>7380.001953125</c:v>
                </c:pt>
                <c:pt idx="52">
                  <c:v>7343.00244140625</c:v>
                </c:pt>
                <c:pt idx="53">
                  <c:v>7312.2822265625</c:v>
                </c:pt>
                <c:pt idx="54">
                  <c:v>7292.33642578125</c:v>
                </c:pt>
                <c:pt idx="55">
                  <c:v>7287.09912109375</c:v>
                </c:pt>
                <c:pt idx="56">
                  <c:v>7296.03662109375</c:v>
                </c:pt>
                <c:pt idx="57">
                  <c:v>7315.34716796875</c:v>
                </c:pt>
                <c:pt idx="58">
                  <c:v>7341.99267578125</c:v>
                </c:pt>
                <c:pt idx="59">
                  <c:v>7374.5498046875</c:v>
                </c:pt>
                <c:pt idx="60">
                  <c:v>7408.8193359375</c:v>
                </c:pt>
                <c:pt idx="61">
                  <c:v>7433.52880859375</c:v>
                </c:pt>
                <c:pt idx="62">
                  <c:v>7433.720703125</c:v>
                </c:pt>
                <c:pt idx="63">
                  <c:v>7402.61572265625</c:v>
                </c:pt>
                <c:pt idx="64">
                  <c:v>7352.65771484375</c:v>
                </c:pt>
                <c:pt idx="65">
                  <c:v>7313.59326171875</c:v>
                </c:pt>
                <c:pt idx="66">
                  <c:v>7314.64208984375</c:v>
                </c:pt>
                <c:pt idx="67">
                  <c:v>7362.28173828125</c:v>
                </c:pt>
                <c:pt idx="68">
                  <c:v>7431.73486328125</c:v>
                </c:pt>
                <c:pt idx="69">
                  <c:v>7481.32080078125</c:v>
                </c:pt>
                <c:pt idx="70">
                  <c:v>7480.53125</c:v>
                </c:pt>
                <c:pt idx="71">
                  <c:v>7430.529296875</c:v>
                </c:pt>
                <c:pt idx="72">
                  <c:v>7361.078125</c:v>
                </c:pt>
                <c:pt idx="73">
                  <c:v>7307.04541015625</c:v>
                </c:pt>
                <c:pt idx="74">
                  <c:v>7284.42529296875</c:v>
                </c:pt>
                <c:pt idx="75">
                  <c:v>7285.33837890625</c:v>
                </c:pt>
                <c:pt idx="76">
                  <c:v>7293.97705078125</c:v>
                </c:pt>
                <c:pt idx="77">
                  <c:v>7306.5009765625</c:v>
                </c:pt>
                <c:pt idx="78">
                  <c:v>7334.8359375</c:v>
                </c:pt>
                <c:pt idx="79">
                  <c:v>7390.298828125</c:v>
                </c:pt>
                <c:pt idx="80">
                  <c:v>7463.46484375</c:v>
                </c:pt>
                <c:pt idx="81">
                  <c:v>7522.2138671875</c:v>
                </c:pt>
                <c:pt idx="82">
                  <c:v>7534.05517578125</c:v>
                </c:pt>
                <c:pt idx="83">
                  <c:v>7495.12841796875</c:v>
                </c:pt>
                <c:pt idx="84">
                  <c:v>7438.79443359375</c:v>
                </c:pt>
                <c:pt idx="85">
                  <c:v>7411.97705078125</c:v>
                </c:pt>
                <c:pt idx="86">
                  <c:v>7435.80908203125</c:v>
                </c:pt>
                <c:pt idx="87">
                  <c:v>7483.70361328125</c:v>
                </c:pt>
                <c:pt idx="88">
                  <c:v>7498.42333984375</c:v>
                </c:pt>
                <c:pt idx="89">
                  <c:v>7437.7822265625</c:v>
                </c:pt>
                <c:pt idx="90">
                  <c:v>7312.85205078125</c:v>
                </c:pt>
                <c:pt idx="91">
                  <c:v>7186.01806640625</c:v>
                </c:pt>
                <c:pt idx="92">
                  <c:v>7127.79931640625</c:v>
                </c:pt>
                <c:pt idx="93">
                  <c:v>7165.49853515625</c:v>
                </c:pt>
                <c:pt idx="94">
                  <c:v>7264.509765625</c:v>
                </c:pt>
                <c:pt idx="95">
                  <c:v>7357.15380859375</c:v>
                </c:pt>
                <c:pt idx="96">
                  <c:v>7395.2626953125</c:v>
                </c:pt>
                <c:pt idx="97">
                  <c:v>7383.73388671875</c:v>
                </c:pt>
                <c:pt idx="98">
                  <c:v>7368.8349609375</c:v>
                </c:pt>
                <c:pt idx="99">
                  <c:v>7393.16845703125</c:v>
                </c:pt>
                <c:pt idx="100">
                  <c:v>7456.58349609375</c:v>
                </c:pt>
                <c:pt idx="101">
                  <c:v>7516.052734375</c:v>
                </c:pt>
                <c:pt idx="102">
                  <c:v>7523.4375</c:v>
                </c:pt>
                <c:pt idx="103">
                  <c:v>7467.7275390625</c:v>
                </c:pt>
                <c:pt idx="104">
                  <c:v>7385.2568359375</c:v>
                </c:pt>
                <c:pt idx="105">
                  <c:v>7329.70751953125</c:v>
                </c:pt>
                <c:pt idx="106">
                  <c:v>7328.43212890625</c:v>
                </c:pt>
                <c:pt idx="107">
                  <c:v>7362.7646484375</c:v>
                </c:pt>
                <c:pt idx="108">
                  <c:v>7388.37060546875</c:v>
                </c:pt>
                <c:pt idx="109">
                  <c:v>7376.6396484375</c:v>
                </c:pt>
                <c:pt idx="110">
                  <c:v>7340.23583984375</c:v>
                </c:pt>
                <c:pt idx="111">
                  <c:v>7320.43408203125</c:v>
                </c:pt>
                <c:pt idx="112">
                  <c:v>7347.69189453125</c:v>
                </c:pt>
                <c:pt idx="113">
                  <c:v>7410.427734375</c:v>
                </c:pt>
                <c:pt idx="114">
                  <c:v>7459.97900390625</c:v>
                </c:pt>
                <c:pt idx="115">
                  <c:v>7448.64501953125</c:v>
                </c:pt>
                <c:pt idx="116">
                  <c:v>7369.5283203125</c:v>
                </c:pt>
                <c:pt idx="117">
                  <c:v>7265.48388671875</c:v>
                </c:pt>
                <c:pt idx="118">
                  <c:v>7200.1943359375</c:v>
                </c:pt>
                <c:pt idx="119">
                  <c:v>7214.7763671875</c:v>
                </c:pt>
                <c:pt idx="120">
                  <c:v>7303.009765625</c:v>
                </c:pt>
                <c:pt idx="121">
                  <c:v>7420.82177734375</c:v>
                </c:pt>
                <c:pt idx="122">
                  <c:v>7517.79931640625</c:v>
                </c:pt>
                <c:pt idx="123">
                  <c:v>7564.234375</c:v>
                </c:pt>
                <c:pt idx="124">
                  <c:v>7556.62548828125</c:v>
                </c:pt>
                <c:pt idx="125">
                  <c:v>7506.1826171875</c:v>
                </c:pt>
                <c:pt idx="126">
                  <c:v>7427.74267578125</c:v>
                </c:pt>
                <c:pt idx="127">
                  <c:v>7339.9541015625</c:v>
                </c:pt>
                <c:pt idx="128">
                  <c:v>7270.53369140625</c:v>
                </c:pt>
                <c:pt idx="129">
                  <c:v>7251.697265625</c:v>
                </c:pt>
                <c:pt idx="130">
                  <c:v>7300.56640625</c:v>
                </c:pt>
                <c:pt idx="131">
                  <c:v>7398.34326171875</c:v>
                </c:pt>
                <c:pt idx="132">
                  <c:v>7490.5185546875</c:v>
                </c:pt>
                <c:pt idx="133">
                  <c:v>7516.89697265625</c:v>
                </c:pt>
                <c:pt idx="134">
                  <c:v>7454.18017578125</c:v>
                </c:pt>
                <c:pt idx="135">
                  <c:v>7338.2802734375</c:v>
                </c:pt>
                <c:pt idx="136">
                  <c:v>7244.763671875</c:v>
                </c:pt>
                <c:pt idx="137">
                  <c:v>7237.51513671875</c:v>
                </c:pt>
                <c:pt idx="138">
                  <c:v>7322.48046875</c:v>
                </c:pt>
                <c:pt idx="139">
                  <c:v>7442.0556640625</c:v>
                </c:pt>
                <c:pt idx="140">
                  <c:v>7515.615234375</c:v>
                </c:pt>
                <c:pt idx="141">
                  <c:v>7496.23291015625</c:v>
                </c:pt>
                <c:pt idx="142">
                  <c:v>7401.48193359375</c:v>
                </c:pt>
                <c:pt idx="143">
                  <c:v>7296.94775390625</c:v>
                </c:pt>
                <c:pt idx="144">
                  <c:v>7247.7177734375</c:v>
                </c:pt>
                <c:pt idx="145">
                  <c:v>7275.90234375</c:v>
                </c:pt>
                <c:pt idx="146">
                  <c:v>7354.0126953125</c:v>
                </c:pt>
                <c:pt idx="147">
                  <c:v>7433.390625</c:v>
                </c:pt>
                <c:pt idx="148">
                  <c:v>7480.34423828125</c:v>
                </c:pt>
                <c:pt idx="149">
                  <c:v>7491.18359375</c:v>
                </c:pt>
                <c:pt idx="150">
                  <c:v>7479.5419921875</c:v>
                </c:pt>
                <c:pt idx="151">
                  <c:v>7453.9931640625</c:v>
                </c:pt>
                <c:pt idx="152">
                  <c:v>7409.53271484375</c:v>
                </c:pt>
                <c:pt idx="153">
                  <c:v>7339.9765625</c:v>
                </c:pt>
                <c:pt idx="154">
                  <c:v>7256.50048828125</c:v>
                </c:pt>
                <c:pt idx="155">
                  <c:v>7191.04296875</c:v>
                </c:pt>
                <c:pt idx="156">
                  <c:v>7177.71142578125</c:v>
                </c:pt>
                <c:pt idx="157">
                  <c:v>7226.81689453125</c:v>
                </c:pt>
                <c:pt idx="158">
                  <c:v>7314.49267578125</c:v>
                </c:pt>
                <c:pt idx="159">
                  <c:v>7398.11279296875</c:v>
                </c:pt>
                <c:pt idx="160">
                  <c:v>7445.39794921875</c:v>
                </c:pt>
                <c:pt idx="161">
                  <c:v>7453.34765625</c:v>
                </c:pt>
                <c:pt idx="162">
                  <c:v>7442.52587890625</c:v>
                </c:pt>
                <c:pt idx="163">
                  <c:v>7434.0966796875</c:v>
                </c:pt>
                <c:pt idx="164">
                  <c:v>7431.5224609375</c:v>
                </c:pt>
                <c:pt idx="165">
                  <c:v>7423.0888671875</c:v>
                </c:pt>
                <c:pt idx="166">
                  <c:v>7400.9951171875</c:v>
                </c:pt>
                <c:pt idx="167">
                  <c:v>7376.6728515625</c:v>
                </c:pt>
                <c:pt idx="168">
                  <c:v>7375.27685546875</c:v>
                </c:pt>
                <c:pt idx="169">
                  <c:v>7412.23095703125</c:v>
                </c:pt>
                <c:pt idx="170">
                  <c:v>7473.04052734375</c:v>
                </c:pt>
                <c:pt idx="171">
                  <c:v>7517.02294921875</c:v>
                </c:pt>
                <c:pt idx="172">
                  <c:v>7505.62646484375</c:v>
                </c:pt>
                <c:pt idx="173">
                  <c:v>7433.65625</c:v>
                </c:pt>
                <c:pt idx="174">
                  <c:v>7337.1025390625</c:v>
                </c:pt>
                <c:pt idx="175">
                  <c:v>7269.259765625</c:v>
                </c:pt>
                <c:pt idx="176">
                  <c:v>7262.8623046875</c:v>
                </c:pt>
                <c:pt idx="177">
                  <c:v>7307.91943359375</c:v>
                </c:pt>
                <c:pt idx="178">
                  <c:v>7362.50537109375</c:v>
                </c:pt>
                <c:pt idx="179">
                  <c:v>7387.119140625</c:v>
                </c:pt>
                <c:pt idx="180">
                  <c:v>7374.56689453125</c:v>
                </c:pt>
                <c:pt idx="181">
                  <c:v>7351.87890625</c:v>
                </c:pt>
                <c:pt idx="182">
                  <c:v>7354.26123046875</c:v>
                </c:pt>
                <c:pt idx="183">
                  <c:v>7393.6328125</c:v>
                </c:pt>
                <c:pt idx="184">
                  <c:v>7447.572265625</c:v>
                </c:pt>
                <c:pt idx="185">
                  <c:v>7476.75048828125</c:v>
                </c:pt>
                <c:pt idx="186">
                  <c:v>7455.68115234375</c:v>
                </c:pt>
                <c:pt idx="187">
                  <c:v>7392.03466796875</c:v>
                </c:pt>
                <c:pt idx="188">
                  <c:v>7320.5234375</c:v>
                </c:pt>
                <c:pt idx="189">
                  <c:v>7278.1904296875</c:v>
                </c:pt>
                <c:pt idx="190">
                  <c:v>7281.2607421875</c:v>
                </c:pt>
                <c:pt idx="191">
                  <c:v>7319.744140625</c:v>
                </c:pt>
                <c:pt idx="192">
                  <c:v>7369.98486328125</c:v>
                </c:pt>
                <c:pt idx="193">
                  <c:v>7411.85986328125</c:v>
                </c:pt>
                <c:pt idx="194">
                  <c:v>7436.8544921875</c:v>
                </c:pt>
                <c:pt idx="195">
                  <c:v>7444.1357421875</c:v>
                </c:pt>
                <c:pt idx="196">
                  <c:v>7432.89697265625</c:v>
                </c:pt>
                <c:pt idx="197">
                  <c:v>7400.76611328125</c:v>
                </c:pt>
                <c:pt idx="198">
                  <c:v>7349.984375</c:v>
                </c:pt>
                <c:pt idx="199">
                  <c:v>7293.93017578125</c:v>
                </c:pt>
                <c:pt idx="200">
                  <c:v>7255.30615234375</c:v>
                </c:pt>
                <c:pt idx="201">
                  <c:v>7254.77880859375</c:v>
                </c:pt>
                <c:pt idx="202">
                  <c:v>7297.82080078125</c:v>
                </c:pt>
                <c:pt idx="203">
                  <c:v>7369.7998046875</c:v>
                </c:pt>
                <c:pt idx="204">
                  <c:v>7443.08251953125</c:v>
                </c:pt>
                <c:pt idx="205">
                  <c:v>7490.986328125</c:v>
                </c:pt>
                <c:pt idx="206">
                  <c:v>7499.36962890625</c:v>
                </c:pt>
                <c:pt idx="207">
                  <c:v>7470.04248046875</c:v>
                </c:pt>
                <c:pt idx="208">
                  <c:v>7416.919921875</c:v>
                </c:pt>
                <c:pt idx="209">
                  <c:v>7359.66552734375</c:v>
                </c:pt>
                <c:pt idx="210">
                  <c:v>7318.15966796875</c:v>
                </c:pt>
                <c:pt idx="211">
                  <c:v>7307.60595703125</c:v>
                </c:pt>
                <c:pt idx="212">
                  <c:v>7333.189453125</c:v>
                </c:pt>
                <c:pt idx="213">
                  <c:v>7385.93701171875</c:v>
                </c:pt>
                <c:pt idx="214">
                  <c:v>7444.056640625</c:v>
                </c:pt>
                <c:pt idx="215">
                  <c:v>7482.2705078125</c:v>
                </c:pt>
                <c:pt idx="216">
                  <c:v>7485.4345703125</c:v>
                </c:pt>
                <c:pt idx="217">
                  <c:v>7457.5234375</c:v>
                </c:pt>
                <c:pt idx="218">
                  <c:v>7418.47021484375</c:v>
                </c:pt>
                <c:pt idx="219">
                  <c:v>7389.83154296875</c:v>
                </c:pt>
                <c:pt idx="220">
                  <c:v>7379.3427734375</c:v>
                </c:pt>
                <c:pt idx="221">
                  <c:v>7376.23876953125</c:v>
                </c:pt>
                <c:pt idx="222">
                  <c:v>7361.34521484375</c:v>
                </c:pt>
                <c:pt idx="223">
                  <c:v>7324.32275390625</c:v>
                </c:pt>
                <c:pt idx="224">
                  <c:v>7274.5048828125</c:v>
                </c:pt>
                <c:pt idx="225">
                  <c:v>7236.677734375</c:v>
                </c:pt>
                <c:pt idx="226">
                  <c:v>7234.88720703125</c:v>
                </c:pt>
                <c:pt idx="227">
                  <c:v>7276.48046875</c:v>
                </c:pt>
                <c:pt idx="228">
                  <c:v>7347.73486328125</c:v>
                </c:pt>
                <c:pt idx="229">
                  <c:v>7422.9443359375</c:v>
                </c:pt>
                <c:pt idx="230">
                  <c:v>7478.85791015625</c:v>
                </c:pt>
                <c:pt idx="231">
                  <c:v>7504</c:v>
                </c:pt>
                <c:pt idx="232">
                  <c:v>7498.54736328125</c:v>
                </c:pt>
                <c:pt idx="233">
                  <c:v>7468.79931640625</c:v>
                </c:pt>
                <c:pt idx="234">
                  <c:v>7423.2802734375</c:v>
                </c:pt>
                <c:pt idx="235">
                  <c:v>7373.23876953125</c:v>
                </c:pt>
                <c:pt idx="236">
                  <c:v>7333.83984375</c:v>
                </c:pt>
                <c:pt idx="237">
                  <c:v>7320.5498046875</c:v>
                </c:pt>
                <c:pt idx="238">
                  <c:v>7340.2001953125</c:v>
                </c:pt>
                <c:pt idx="239">
                  <c:v>7383.14111328125</c:v>
                </c:pt>
                <c:pt idx="240">
                  <c:v>7424.685546875</c:v>
                </c:pt>
                <c:pt idx="241">
                  <c:v>7437.93359375</c:v>
                </c:pt>
                <c:pt idx="242">
                  <c:v>7410.69140625</c:v>
                </c:pt>
                <c:pt idx="243">
                  <c:v>7354.63427734375</c:v>
                </c:pt>
                <c:pt idx="244">
                  <c:v>7299.439453125</c:v>
                </c:pt>
                <c:pt idx="245">
                  <c:v>7275.2421875</c:v>
                </c:pt>
                <c:pt idx="246">
                  <c:v>7295.04052734375</c:v>
                </c:pt>
                <c:pt idx="247">
                  <c:v>7348.3583984375</c:v>
                </c:pt>
                <c:pt idx="248">
                  <c:v>7409.10888671875</c:v>
                </c:pt>
                <c:pt idx="249">
                  <c:v>7451.0634765625</c:v>
                </c:pt>
                <c:pt idx="250">
                  <c:v>7460.58642578125</c:v>
                </c:pt>
                <c:pt idx="251">
                  <c:v>7440.1259765625</c:v>
                </c:pt>
                <c:pt idx="252">
                  <c:v>7403.11083984375</c:v>
                </c:pt>
                <c:pt idx="253">
                  <c:v>7365.5751953125</c:v>
                </c:pt>
                <c:pt idx="254">
                  <c:v>7339.5146484375</c:v>
                </c:pt>
                <c:pt idx="255">
                  <c:v>7329.74658203125</c:v>
                </c:pt>
                <c:pt idx="256">
                  <c:v>7333.6357421875</c:v>
                </c:pt>
                <c:pt idx="257">
                  <c:v>7343.01904296875</c:v>
                </c:pt>
                <c:pt idx="258">
                  <c:v>7348.38232421875</c:v>
                </c:pt>
                <c:pt idx="259">
                  <c:v>7344.60693359375</c:v>
                </c:pt>
                <c:pt idx="260">
                  <c:v>7335.4462890625</c:v>
                </c:pt>
                <c:pt idx="261">
                  <c:v>7332.955078125</c:v>
                </c:pt>
                <c:pt idx="262">
                  <c:v>7350.5615234375</c:v>
                </c:pt>
                <c:pt idx="263">
                  <c:v>7393.3095703125</c:v>
                </c:pt>
                <c:pt idx="264">
                  <c:v>7451.9833984375</c:v>
                </c:pt>
                <c:pt idx="265">
                  <c:v>7505.98779296875</c:v>
                </c:pt>
                <c:pt idx="266">
                  <c:v>7533.7548828125</c:v>
                </c:pt>
                <c:pt idx="267">
                  <c:v>7523.87255859375</c:v>
                </c:pt>
                <c:pt idx="268">
                  <c:v>7479.76611328125</c:v>
                </c:pt>
                <c:pt idx="269">
                  <c:v>7415.94140625</c:v>
                </c:pt>
                <c:pt idx="270">
                  <c:v>7349.9921875</c:v>
                </c:pt>
                <c:pt idx="271">
                  <c:v>7296.52001953125</c:v>
                </c:pt>
                <c:pt idx="272">
                  <c:v>7265.54736328125</c:v>
                </c:pt>
                <c:pt idx="273">
                  <c:v>7262.9677734375</c:v>
                </c:pt>
                <c:pt idx="274">
                  <c:v>7289.23193359375</c:v>
                </c:pt>
                <c:pt idx="275">
                  <c:v>7336.18359375</c:v>
                </c:pt>
                <c:pt idx="276">
                  <c:v>7386.56591796875</c:v>
                </c:pt>
                <c:pt idx="277">
                  <c:v>7420.556640625</c:v>
                </c:pt>
                <c:pt idx="278">
                  <c:v>7427.65087890625</c:v>
                </c:pt>
                <c:pt idx="279">
                  <c:v>7415.3310546875</c:v>
                </c:pt>
                <c:pt idx="280">
                  <c:v>7405.59619140625</c:v>
                </c:pt>
                <c:pt idx="281">
                  <c:v>7418.78662109375</c:v>
                </c:pt>
                <c:pt idx="282">
                  <c:v>7455.36865234375</c:v>
                </c:pt>
                <c:pt idx="283">
                  <c:v>7490.58447265625</c:v>
                </c:pt>
                <c:pt idx="284">
                  <c:v>7488.9248046875</c:v>
                </c:pt>
                <c:pt idx="285">
                  <c:v>7430.16259765625</c:v>
                </c:pt>
                <c:pt idx="286">
                  <c:v>7328.15576171875</c:v>
                </c:pt>
                <c:pt idx="287">
                  <c:v>7227.09375</c:v>
                </c:pt>
                <c:pt idx="288">
                  <c:v>7175.86279296875</c:v>
                </c:pt>
                <c:pt idx="289">
                  <c:v>7197.71484375</c:v>
                </c:pt>
                <c:pt idx="290">
                  <c:v>7276.4951171875</c:v>
                </c:pt>
                <c:pt idx="291">
                  <c:v>7368.767578125</c:v>
                </c:pt>
                <c:pt idx="292">
                  <c:v>7432.41015625</c:v>
                </c:pt>
                <c:pt idx="293">
                  <c:v>7451.0283203125</c:v>
                </c:pt>
                <c:pt idx="294">
                  <c:v>7438.08740234375</c:v>
                </c:pt>
                <c:pt idx="295">
                  <c:v>7420.63916015625</c:v>
                </c:pt>
                <c:pt idx="296">
                  <c:v>7417.02685546875</c:v>
                </c:pt>
                <c:pt idx="297">
                  <c:v>7425.2578125</c:v>
                </c:pt>
                <c:pt idx="298">
                  <c:v>7428.49609375</c:v>
                </c:pt>
                <c:pt idx="299">
                  <c:v>7410.67333984375</c:v>
                </c:pt>
                <c:pt idx="300">
                  <c:v>7369.22900390625</c:v>
                </c:pt>
                <c:pt idx="301">
                  <c:v>7316.6513671875</c:v>
                </c:pt>
                <c:pt idx="302">
                  <c:v>7272.27978515625</c:v>
                </c:pt>
                <c:pt idx="303">
                  <c:v>7252.0869140625</c:v>
                </c:pt>
                <c:pt idx="304">
                  <c:v>7262.9521484375</c:v>
                </c:pt>
                <c:pt idx="305">
                  <c:v>7302.40478515625</c:v>
                </c:pt>
                <c:pt idx="306">
                  <c:v>7360.89990234375</c:v>
                </c:pt>
                <c:pt idx="307">
                  <c:v>7424.36376953125</c:v>
                </c:pt>
                <c:pt idx="308">
                  <c:v>7477.49609375</c:v>
                </c:pt>
                <c:pt idx="309">
                  <c:v>7508.87158203125</c:v>
                </c:pt>
                <c:pt idx="310">
                  <c:v>7516.1474609375</c:v>
                </c:pt>
                <c:pt idx="311">
                  <c:v>7507.0830078125</c:v>
                </c:pt>
                <c:pt idx="312">
                  <c:v>7493.703125</c:v>
                </c:pt>
                <c:pt idx="313">
                  <c:v>7482.66748046875</c:v>
                </c:pt>
                <c:pt idx="314">
                  <c:v>7469.55322265625</c:v>
                </c:pt>
                <c:pt idx="315">
                  <c:v>7442.96630859375</c:v>
                </c:pt>
                <c:pt idx="316">
                  <c:v>7396.3798828125</c:v>
                </c:pt>
                <c:pt idx="317">
                  <c:v>7337.9296875</c:v>
                </c:pt>
                <c:pt idx="318">
                  <c:v>7288.681640625</c:v>
                </c:pt>
                <c:pt idx="319">
                  <c:v>7269.03125</c:v>
                </c:pt>
                <c:pt idx="320">
                  <c:v>7283.63134765625</c:v>
                </c:pt>
                <c:pt idx="321">
                  <c:v>7317.703125</c:v>
                </c:pt>
                <c:pt idx="322">
                  <c:v>7348.65869140625</c:v>
                </c:pt>
                <c:pt idx="323">
                  <c:v>7363.64599609375</c:v>
                </c:pt>
                <c:pt idx="324">
                  <c:v>7367.828125</c:v>
                </c:pt>
                <c:pt idx="325">
                  <c:v>7375.80908203125</c:v>
                </c:pt>
                <c:pt idx="326">
                  <c:v>7393.78955078125</c:v>
                </c:pt>
                <c:pt idx="327">
                  <c:v>7409.31982421875</c:v>
                </c:pt>
                <c:pt idx="328">
                  <c:v>7399.8984375</c:v>
                </c:pt>
                <c:pt idx="329">
                  <c:v>7354.8759765625</c:v>
                </c:pt>
                <c:pt idx="330">
                  <c:v>7291.650390625</c:v>
                </c:pt>
                <c:pt idx="331">
                  <c:v>7249.6328125</c:v>
                </c:pt>
                <c:pt idx="332">
                  <c:v>7263.30322265625</c:v>
                </c:pt>
                <c:pt idx="333">
                  <c:v>7334.390625</c:v>
                </c:pt>
                <c:pt idx="334">
                  <c:v>7426.3720703125</c:v>
                </c:pt>
                <c:pt idx="335">
                  <c:v>7487.994140625</c:v>
                </c:pt>
                <c:pt idx="336">
                  <c:v>7489.13671875</c:v>
                </c:pt>
                <c:pt idx="337">
                  <c:v>7441.4150390625</c:v>
                </c:pt>
                <c:pt idx="338">
                  <c:v>7387.24462890625</c:v>
                </c:pt>
                <c:pt idx="339">
                  <c:v>7366.041015625</c:v>
                </c:pt>
                <c:pt idx="340">
                  <c:v>7384.4951171875</c:v>
                </c:pt>
                <c:pt idx="341">
                  <c:v>7414.32177734375</c:v>
                </c:pt>
                <c:pt idx="342">
                  <c:v>7418.3583984375</c:v>
                </c:pt>
                <c:pt idx="343">
                  <c:v>7382.9482421875</c:v>
                </c:pt>
                <c:pt idx="344">
                  <c:v>7329.984375</c:v>
                </c:pt>
                <c:pt idx="345">
                  <c:v>7299.2919921875</c:v>
                </c:pt>
                <c:pt idx="346">
                  <c:v>7316.43017578125</c:v>
                </c:pt>
                <c:pt idx="347">
                  <c:v>7372.36328125</c:v>
                </c:pt>
                <c:pt idx="348">
                  <c:v>7430.857421875</c:v>
                </c:pt>
                <c:pt idx="349">
                  <c:v>7456.4755859375</c:v>
                </c:pt>
              </c:numCache>
            </c:numRef>
          </c:yVal>
          <c:smooth val="1"/>
          <c:extLst>
            <c:ext xmlns:c16="http://schemas.microsoft.com/office/drawing/2014/chart" uri="{C3380CC4-5D6E-409C-BE32-E72D297353CC}">
              <c16:uniqueId val="{00000003-5429-4359-BD11-807CF8F8408D}"/>
            </c:ext>
          </c:extLst>
        </c:ser>
        <c:ser>
          <c:idx val="4"/>
          <c:order val="4"/>
          <c:tx>
            <c:strRef>
              <c:f>np_sub_003!$E$1</c:f>
              <c:strCache>
                <c:ptCount val="1"/>
                <c:pt idx="0">
                  <c:v>Coor_5</c:v>
                </c:pt>
              </c:strCache>
            </c:strRef>
          </c:tx>
          <c:spPr>
            <a:ln w="28575" cap="rnd">
              <a:solidFill>
                <a:schemeClr val="accent5"/>
              </a:solidFill>
              <a:round/>
            </a:ln>
            <a:effectLst/>
          </c:spPr>
          <c:marker>
            <c:symbol val="none"/>
          </c:marker>
          <c:yVal>
            <c:numRef>
              <c:f>np_sub_003!$E$2:$E$351</c:f>
              <c:numCache>
                <c:formatCode>0.00000000000_ </c:formatCode>
                <c:ptCount val="350"/>
                <c:pt idx="0">
                  <c:v>8057.66796875</c:v>
                </c:pt>
                <c:pt idx="1">
                  <c:v>8050.51416015625</c:v>
                </c:pt>
                <c:pt idx="2">
                  <c:v>8012.8876953125</c:v>
                </c:pt>
                <c:pt idx="3">
                  <c:v>7975.3876953125</c:v>
                </c:pt>
                <c:pt idx="4">
                  <c:v>7974.9462890625</c:v>
                </c:pt>
                <c:pt idx="5">
                  <c:v>8023.67333984375</c:v>
                </c:pt>
                <c:pt idx="6">
                  <c:v>8094.42529296875</c:v>
                </c:pt>
                <c:pt idx="7">
                  <c:v>8137.31396484375</c:v>
                </c:pt>
                <c:pt idx="8">
                  <c:v>8116.720703125</c:v>
                </c:pt>
                <c:pt idx="9">
                  <c:v>8040.41845703125</c:v>
                </c:pt>
                <c:pt idx="10">
                  <c:v>7956.75</c:v>
                </c:pt>
                <c:pt idx="11">
                  <c:v>7920.25244140625</c:v>
                </c:pt>
                <c:pt idx="12">
                  <c:v>7951.50732421875</c:v>
                </c:pt>
                <c:pt idx="13">
                  <c:v>8022.5556640625</c:v>
                </c:pt>
                <c:pt idx="14">
                  <c:v>8079.59521484375</c:v>
                </c:pt>
                <c:pt idx="15">
                  <c:v>8085.251953125</c:v>
                </c:pt>
                <c:pt idx="16">
                  <c:v>8047.03857421875</c:v>
                </c:pt>
                <c:pt idx="17">
                  <c:v>8009.59716796875</c:v>
                </c:pt>
                <c:pt idx="18">
                  <c:v>8017.2021484375</c:v>
                </c:pt>
                <c:pt idx="19">
                  <c:v>8076.58740234375</c:v>
                </c:pt>
                <c:pt idx="20">
                  <c:v>8149.5751953125</c:v>
                </c:pt>
                <c:pt idx="21">
                  <c:v>8181.0791015625</c:v>
                </c:pt>
                <c:pt idx="22">
                  <c:v>8140.34716796875</c:v>
                </c:pt>
                <c:pt idx="23">
                  <c:v>8043.79931640625</c:v>
                </c:pt>
                <c:pt idx="24">
                  <c:v>7943.27099609375</c:v>
                </c:pt>
                <c:pt idx="25">
                  <c:v>7890.40185546875</c:v>
                </c:pt>
                <c:pt idx="26">
                  <c:v>7904.62841796875</c:v>
                </c:pt>
                <c:pt idx="27">
                  <c:v>7966.54248046875</c:v>
                </c:pt>
                <c:pt idx="28">
                  <c:v>8036.943359375</c:v>
                </c:pt>
                <c:pt idx="29">
                  <c:v>8083.29541015625</c:v>
                </c:pt>
                <c:pt idx="30">
                  <c:v>8093.7880859375</c:v>
                </c:pt>
                <c:pt idx="31">
                  <c:v>8073.45703125</c:v>
                </c:pt>
                <c:pt idx="32">
                  <c:v>8032.50830078125</c:v>
                </c:pt>
                <c:pt idx="33">
                  <c:v>7980.36474609375</c:v>
                </c:pt>
                <c:pt idx="34">
                  <c:v>7928.919921875</c:v>
                </c:pt>
                <c:pt idx="35">
                  <c:v>7896.42431640625</c:v>
                </c:pt>
                <c:pt idx="36">
                  <c:v>7901.85107421875</c:v>
                </c:pt>
                <c:pt idx="37">
                  <c:v>7950.24560546875</c:v>
                </c:pt>
                <c:pt idx="38">
                  <c:v>8021.701171875</c:v>
                </c:pt>
                <c:pt idx="39">
                  <c:v>8077.4365234375</c:v>
                </c:pt>
                <c:pt idx="40">
                  <c:v>8083.3408203125</c:v>
                </c:pt>
                <c:pt idx="41">
                  <c:v>8035.15478515625</c:v>
                </c:pt>
                <c:pt idx="42">
                  <c:v>7965.03125</c:v>
                </c:pt>
                <c:pt idx="43">
                  <c:v>7922.01220703125</c:v>
                </c:pt>
                <c:pt idx="44">
                  <c:v>7939.326171875</c:v>
                </c:pt>
                <c:pt idx="45">
                  <c:v>8012.47265625</c:v>
                </c:pt>
                <c:pt idx="46">
                  <c:v>8104.107421875</c:v>
                </c:pt>
                <c:pt idx="47">
                  <c:v>8171.02001953125</c:v>
                </c:pt>
                <c:pt idx="48">
                  <c:v>8191.86572265625</c:v>
                </c:pt>
                <c:pt idx="49">
                  <c:v>8175.29052734375</c:v>
                </c:pt>
                <c:pt idx="50">
                  <c:v>8145.14501953125</c:v>
                </c:pt>
                <c:pt idx="51">
                  <c:v>8117.86767578125</c:v>
                </c:pt>
                <c:pt idx="52">
                  <c:v>8091.59423828125</c:v>
                </c:pt>
                <c:pt idx="53">
                  <c:v>8054.3916015625</c:v>
                </c:pt>
                <c:pt idx="54">
                  <c:v>8001.73681640625</c:v>
                </c:pt>
                <c:pt idx="55">
                  <c:v>7946.1328125</c:v>
                </c:pt>
                <c:pt idx="56">
                  <c:v>7910.13427734375</c:v>
                </c:pt>
                <c:pt idx="57">
                  <c:v>7909.5546875</c:v>
                </c:pt>
                <c:pt idx="58">
                  <c:v>7942.02001953125</c:v>
                </c:pt>
                <c:pt idx="59">
                  <c:v>7990.2724609375</c:v>
                </c:pt>
                <c:pt idx="60">
                  <c:v>8035.82373046875</c:v>
                </c:pt>
                <c:pt idx="61">
                  <c:v>8069.84619140625</c:v>
                </c:pt>
                <c:pt idx="62">
                  <c:v>8092.38232421875</c:v>
                </c:pt>
                <c:pt idx="63">
                  <c:v>8103.3359375</c:v>
                </c:pt>
                <c:pt idx="64">
                  <c:v>8096.896484375</c:v>
                </c:pt>
                <c:pt idx="65">
                  <c:v>8066.92333984375</c:v>
                </c:pt>
                <c:pt idx="66">
                  <c:v>8018.33154296875</c:v>
                </c:pt>
                <c:pt idx="67">
                  <c:v>7971.35791015625</c:v>
                </c:pt>
                <c:pt idx="68">
                  <c:v>7950.67138671875</c:v>
                </c:pt>
                <c:pt idx="69">
                  <c:v>7965.97314453125</c:v>
                </c:pt>
                <c:pt idx="70">
                  <c:v>8001.20751953125</c:v>
                </c:pt>
                <c:pt idx="71">
                  <c:v>8024.634765625</c:v>
                </c:pt>
                <c:pt idx="72">
                  <c:v>8014.3603515625</c:v>
                </c:pt>
                <c:pt idx="73">
                  <c:v>7978.6591796875</c:v>
                </c:pt>
                <c:pt idx="74">
                  <c:v>7952.27685546875</c:v>
                </c:pt>
                <c:pt idx="75">
                  <c:v>7969.1123046875</c:v>
                </c:pt>
                <c:pt idx="76">
                  <c:v>8032.626953125</c:v>
                </c:pt>
                <c:pt idx="77">
                  <c:v>8109.279296875</c:v>
                </c:pt>
                <c:pt idx="78">
                  <c:v>8152.3154296875</c:v>
                </c:pt>
                <c:pt idx="79">
                  <c:v>8137.56201171875</c:v>
                </c:pt>
                <c:pt idx="80">
                  <c:v>8081.60986328125</c:v>
                </c:pt>
                <c:pt idx="81">
                  <c:v>8026.61181640625</c:v>
                </c:pt>
                <c:pt idx="82">
                  <c:v>8004.0966796875</c:v>
                </c:pt>
                <c:pt idx="83">
                  <c:v>8008.7587890625</c:v>
                </c:pt>
                <c:pt idx="84">
                  <c:v>8005.4541015625</c:v>
                </c:pt>
                <c:pt idx="85">
                  <c:v>7964.21826171875</c:v>
                </c:pt>
                <c:pt idx="86">
                  <c:v>7893.0400390625</c:v>
                </c:pt>
                <c:pt idx="87">
                  <c:v>7838.47021484375</c:v>
                </c:pt>
                <c:pt idx="88">
                  <c:v>7850.8232421875</c:v>
                </c:pt>
                <c:pt idx="89">
                  <c:v>7941.57373046875</c:v>
                </c:pt>
                <c:pt idx="90">
                  <c:v>8068.98046875</c:v>
                </c:pt>
                <c:pt idx="91">
                  <c:v>8165.765625</c:v>
                </c:pt>
                <c:pt idx="92">
                  <c:v>8187.74560546875</c:v>
                </c:pt>
                <c:pt idx="93">
                  <c:v>8144.23291015625</c:v>
                </c:pt>
                <c:pt idx="94">
                  <c:v>8085.6123046875</c:v>
                </c:pt>
                <c:pt idx="95">
                  <c:v>8059.095703125</c:v>
                </c:pt>
                <c:pt idx="96">
                  <c:v>8070.31494140625</c:v>
                </c:pt>
                <c:pt idx="97">
                  <c:v>8083.23291015625</c:v>
                </c:pt>
                <c:pt idx="98">
                  <c:v>8057.8818359375</c:v>
                </c:pt>
                <c:pt idx="99">
                  <c:v>7992.50244140625</c:v>
                </c:pt>
                <c:pt idx="100">
                  <c:v>7932.12646484375</c:v>
                </c:pt>
                <c:pt idx="101">
                  <c:v>7933.90478515625</c:v>
                </c:pt>
                <c:pt idx="102">
                  <c:v>8016.9931640625</c:v>
                </c:pt>
                <c:pt idx="103">
                  <c:v>8139.59130859375</c:v>
                </c:pt>
                <c:pt idx="104">
                  <c:v>8224.607421875</c:v>
                </c:pt>
                <c:pt idx="105">
                  <c:v>8215.54296875</c:v>
                </c:pt>
                <c:pt idx="106">
                  <c:v>8118.68115234375</c:v>
                </c:pt>
                <c:pt idx="107">
                  <c:v>7997.9921875</c:v>
                </c:pt>
                <c:pt idx="108">
                  <c:v>7926.9765625</c:v>
                </c:pt>
                <c:pt idx="109">
                  <c:v>7935.71728515625</c:v>
                </c:pt>
                <c:pt idx="110">
                  <c:v>7994.0078125</c:v>
                </c:pt>
                <c:pt idx="111">
                  <c:v>8041.11572265625</c:v>
                </c:pt>
                <c:pt idx="112">
                  <c:v>8035.3662109375</c:v>
                </c:pt>
                <c:pt idx="113">
                  <c:v>7983.02099609375</c:v>
                </c:pt>
                <c:pt idx="114">
                  <c:v>7925.9140625</c:v>
                </c:pt>
                <c:pt idx="115">
                  <c:v>7902.646484375</c:v>
                </c:pt>
                <c:pt idx="116">
                  <c:v>7918.4921875</c:v>
                </c:pt>
                <c:pt idx="117">
                  <c:v>7948.33447265625</c:v>
                </c:pt>
                <c:pt idx="118">
                  <c:v>7966.0849609375</c:v>
                </c:pt>
                <c:pt idx="119">
                  <c:v>7971.01904296875</c:v>
                </c:pt>
                <c:pt idx="120">
                  <c:v>7986.14111328125</c:v>
                </c:pt>
                <c:pt idx="121">
                  <c:v>8030.90625</c:v>
                </c:pt>
                <c:pt idx="122">
                  <c:v>8095.2158203125</c:v>
                </c:pt>
                <c:pt idx="123">
                  <c:v>8141.13134765625</c:v>
                </c:pt>
                <c:pt idx="124">
                  <c:v>8133.43212890625</c:v>
                </c:pt>
                <c:pt idx="125">
                  <c:v>8072.7265625</c:v>
                </c:pt>
                <c:pt idx="126">
                  <c:v>8000.35400390625</c:v>
                </c:pt>
                <c:pt idx="127">
                  <c:v>7967.80615234375</c:v>
                </c:pt>
                <c:pt idx="128">
                  <c:v>7994.8525390625</c:v>
                </c:pt>
                <c:pt idx="129">
                  <c:v>8052.2265625</c:v>
                </c:pt>
                <c:pt idx="130">
                  <c:v>8085.322265625</c:v>
                </c:pt>
                <c:pt idx="131">
                  <c:v>8060.59521484375</c:v>
                </c:pt>
                <c:pt idx="132">
                  <c:v>7995.90966796875</c:v>
                </c:pt>
                <c:pt idx="133">
                  <c:v>7948.1689453125</c:v>
                </c:pt>
                <c:pt idx="134">
                  <c:v>7966.8857421875</c:v>
                </c:pt>
                <c:pt idx="135">
                  <c:v>8051.50927734375</c:v>
                </c:pt>
                <c:pt idx="136">
                  <c:v>8148.35888671875</c:v>
                </c:pt>
                <c:pt idx="137">
                  <c:v>8190.90673828125</c:v>
                </c:pt>
                <c:pt idx="138">
                  <c:v>8151.29736328125</c:v>
                </c:pt>
                <c:pt idx="139">
                  <c:v>8061.26171875</c:v>
                </c:pt>
                <c:pt idx="140">
                  <c:v>7985.37255859375</c:v>
                </c:pt>
                <c:pt idx="141">
                  <c:v>7968.59375</c:v>
                </c:pt>
                <c:pt idx="142">
                  <c:v>8001.11767578125</c:v>
                </c:pt>
                <c:pt idx="143">
                  <c:v>8029.2548828125</c:v>
                </c:pt>
                <c:pt idx="144">
                  <c:v>8003.34423828125</c:v>
                </c:pt>
                <c:pt idx="145">
                  <c:v>7923.30322265625</c:v>
                </c:pt>
                <c:pt idx="146">
                  <c:v>7844.17333984375</c:v>
                </c:pt>
                <c:pt idx="147">
                  <c:v>7836.12841796875</c:v>
                </c:pt>
                <c:pt idx="148">
                  <c:v>7929.7509765625</c:v>
                </c:pt>
                <c:pt idx="149">
                  <c:v>8088.9287109375</c:v>
                </c:pt>
                <c:pt idx="150">
                  <c:v>8232.056640625</c:v>
                </c:pt>
                <c:pt idx="151">
                  <c:v>8285.3359375</c:v>
                </c:pt>
                <c:pt idx="152">
                  <c:v>8229.0322265625</c:v>
                </c:pt>
                <c:pt idx="153">
                  <c:v>8105.13818359375</c:v>
                </c:pt>
                <c:pt idx="154">
                  <c:v>7985.0625</c:v>
                </c:pt>
                <c:pt idx="155">
                  <c:v>7923.98828125</c:v>
                </c:pt>
                <c:pt idx="156">
                  <c:v>7933.86181640625</c:v>
                </c:pt>
                <c:pt idx="157">
                  <c:v>7988.51171875</c:v>
                </c:pt>
                <c:pt idx="158">
                  <c:v>8049.55419921875</c:v>
                </c:pt>
                <c:pt idx="159">
                  <c:v>8090.18505859375</c:v>
                </c:pt>
                <c:pt idx="160">
                  <c:v>8102.0595703125</c:v>
                </c:pt>
                <c:pt idx="161">
                  <c:v>8087.81640625</c:v>
                </c:pt>
                <c:pt idx="162">
                  <c:v>8052.3115234375</c:v>
                </c:pt>
                <c:pt idx="163">
                  <c:v>8001.826171875</c:v>
                </c:pt>
                <c:pt idx="164">
                  <c:v>7948.69189453125</c:v>
                </c:pt>
                <c:pt idx="165">
                  <c:v>7911.7236328125</c:v>
                </c:pt>
                <c:pt idx="166">
                  <c:v>7907.3232421875</c:v>
                </c:pt>
                <c:pt idx="167">
                  <c:v>7937.04736328125</c:v>
                </c:pt>
                <c:pt idx="168">
                  <c:v>7983.369140625</c:v>
                </c:pt>
                <c:pt idx="169">
                  <c:v>8019.7451171875</c:v>
                </c:pt>
                <c:pt idx="170">
                  <c:v>8028.54833984375</c:v>
                </c:pt>
                <c:pt idx="171">
                  <c:v>8012.603515625</c:v>
                </c:pt>
                <c:pt idx="172">
                  <c:v>7990.67578125</c:v>
                </c:pt>
                <c:pt idx="173">
                  <c:v>7980.818359375</c:v>
                </c:pt>
                <c:pt idx="174">
                  <c:v>7986.03173828125</c:v>
                </c:pt>
                <c:pt idx="175">
                  <c:v>7994.64892578125</c:v>
                </c:pt>
                <c:pt idx="176">
                  <c:v>7994.6455078125</c:v>
                </c:pt>
                <c:pt idx="177">
                  <c:v>7988.287109375</c:v>
                </c:pt>
                <c:pt idx="178">
                  <c:v>7992.73681640625</c:v>
                </c:pt>
                <c:pt idx="179">
                  <c:v>8024.5927734375</c:v>
                </c:pt>
                <c:pt idx="180">
                  <c:v>8081.3466796875</c:v>
                </c:pt>
                <c:pt idx="181">
                  <c:v>8136.98291015625</c:v>
                </c:pt>
                <c:pt idx="182">
                  <c:v>8158.0654296875</c:v>
                </c:pt>
                <c:pt idx="183">
                  <c:v>8129.2021484375</c:v>
                </c:pt>
                <c:pt idx="184">
                  <c:v>8067.60107421875</c:v>
                </c:pt>
                <c:pt idx="185">
                  <c:v>8013.734375</c:v>
                </c:pt>
                <c:pt idx="186">
                  <c:v>8003.6669921875</c:v>
                </c:pt>
                <c:pt idx="187">
                  <c:v>8043.50341796875</c:v>
                </c:pt>
                <c:pt idx="188">
                  <c:v>8105.4013671875</c:v>
                </c:pt>
                <c:pt idx="189">
                  <c:v>8148.2548828125</c:v>
                </c:pt>
                <c:pt idx="190">
                  <c:v>8147.30078125</c:v>
                </c:pt>
                <c:pt idx="191">
                  <c:v>8110.373046875</c:v>
                </c:pt>
                <c:pt idx="192">
                  <c:v>8069.23388671875</c:v>
                </c:pt>
                <c:pt idx="193">
                  <c:v>8053.623046875</c:v>
                </c:pt>
                <c:pt idx="194">
                  <c:v>8068.33203125</c:v>
                </c:pt>
                <c:pt idx="195">
                  <c:v>8090.35546875</c:v>
                </c:pt>
                <c:pt idx="196">
                  <c:v>8087.26953125</c:v>
                </c:pt>
                <c:pt idx="197">
                  <c:v>8042.18408203125</c:v>
                </c:pt>
                <c:pt idx="198">
                  <c:v>7966.75048828125</c:v>
                </c:pt>
                <c:pt idx="199">
                  <c:v>7893.6435546875</c:v>
                </c:pt>
                <c:pt idx="200">
                  <c:v>7855.1982421875</c:v>
                </c:pt>
                <c:pt idx="201">
                  <c:v>7863.77490234375</c:v>
                </c:pt>
                <c:pt idx="202">
                  <c:v>7906.41796875</c:v>
                </c:pt>
                <c:pt idx="203">
                  <c:v>7955.19580078125</c:v>
                </c:pt>
                <c:pt idx="204">
                  <c:v>7984.408203125</c:v>
                </c:pt>
                <c:pt idx="205">
                  <c:v>7983.43017578125</c:v>
                </c:pt>
                <c:pt idx="206">
                  <c:v>7959.2919921875</c:v>
                </c:pt>
                <c:pt idx="207">
                  <c:v>7930.51708984375</c:v>
                </c:pt>
                <c:pt idx="208">
                  <c:v>7917.7177734375</c:v>
                </c:pt>
                <c:pt idx="209">
                  <c:v>7935.451171875</c:v>
                </c:pt>
                <c:pt idx="210">
                  <c:v>7986.91552734375</c:v>
                </c:pt>
                <c:pt idx="211">
                  <c:v>8061.58837890625</c:v>
                </c:pt>
                <c:pt idx="212">
                  <c:v>8136.66845703125</c:v>
                </c:pt>
                <c:pt idx="213">
                  <c:v>8183.7958984375</c:v>
                </c:pt>
                <c:pt idx="214">
                  <c:v>8180.671875</c:v>
                </c:pt>
                <c:pt idx="215">
                  <c:v>8123.25537109375</c:v>
                </c:pt>
                <c:pt idx="216">
                  <c:v>8031.5166015625</c:v>
                </c:pt>
                <c:pt idx="217">
                  <c:v>7943.509765625</c:v>
                </c:pt>
                <c:pt idx="218">
                  <c:v>7898.79296875</c:v>
                </c:pt>
                <c:pt idx="219">
                  <c:v>7919.1494140625</c:v>
                </c:pt>
                <c:pt idx="220">
                  <c:v>7997.1953125</c:v>
                </c:pt>
                <c:pt idx="221">
                  <c:v>8099.5595703125</c:v>
                </c:pt>
                <c:pt idx="222">
                  <c:v>8183.13037109375</c:v>
                </c:pt>
                <c:pt idx="223">
                  <c:v>8215.552734375</c:v>
                </c:pt>
                <c:pt idx="224">
                  <c:v>8189.22216796875</c:v>
                </c:pt>
                <c:pt idx="225">
                  <c:v>8122.22802734375</c:v>
                </c:pt>
                <c:pt idx="226">
                  <c:v>8047.1484375</c:v>
                </c:pt>
                <c:pt idx="227">
                  <c:v>7994.65673828125</c:v>
                </c:pt>
                <c:pt idx="228">
                  <c:v>7980.5419921875</c:v>
                </c:pt>
                <c:pt idx="229">
                  <c:v>8001.732421875</c:v>
                </c:pt>
                <c:pt idx="230">
                  <c:v>8041.55224609375</c:v>
                </c:pt>
                <c:pt idx="231">
                  <c:v>8079.87451171875</c:v>
                </c:pt>
                <c:pt idx="232">
                  <c:v>8102.19140625</c:v>
                </c:pt>
                <c:pt idx="233">
                  <c:v>8103.35107421875</c:v>
                </c:pt>
                <c:pt idx="234">
                  <c:v>8085.501953125</c:v>
                </c:pt>
                <c:pt idx="235">
                  <c:v>8053.26171875</c:v>
                </c:pt>
                <c:pt idx="236">
                  <c:v>8010.3427734375</c:v>
                </c:pt>
                <c:pt idx="237">
                  <c:v>7959.9873046875</c:v>
                </c:pt>
                <c:pt idx="238">
                  <c:v>7908.06591796875</c:v>
                </c:pt>
                <c:pt idx="239">
                  <c:v>7865.0810546875</c:v>
                </c:pt>
                <c:pt idx="240">
                  <c:v>7843.84228515625</c:v>
                </c:pt>
                <c:pt idx="241">
                  <c:v>7853.13232421875</c:v>
                </c:pt>
                <c:pt idx="242">
                  <c:v>7891.578125</c:v>
                </c:pt>
                <c:pt idx="243">
                  <c:v>7946.85791015625</c:v>
                </c:pt>
                <c:pt idx="244">
                  <c:v>8001.93359375</c:v>
                </c:pt>
                <c:pt idx="245">
                  <c:v>8044.50244140625</c:v>
                </c:pt>
                <c:pt idx="246">
                  <c:v>8072.76123046875</c:v>
                </c:pt>
                <c:pt idx="247">
                  <c:v>8092.904296875</c:v>
                </c:pt>
                <c:pt idx="248">
                  <c:v>8110.3193359375</c:v>
                </c:pt>
                <c:pt idx="249">
                  <c:v>8122.064453125</c:v>
                </c:pt>
                <c:pt idx="250">
                  <c:v>8117.83154296875</c:v>
                </c:pt>
                <c:pt idx="251">
                  <c:v>8089.7841796875</c:v>
                </c:pt>
                <c:pt idx="252">
                  <c:v>8043.48486328125</c:v>
                </c:pt>
                <c:pt idx="253">
                  <c:v>7999.66552734375</c:v>
                </c:pt>
                <c:pt idx="254">
                  <c:v>7982.86669921875</c:v>
                </c:pt>
                <c:pt idx="255">
                  <c:v>8003.7900390625</c:v>
                </c:pt>
                <c:pt idx="256">
                  <c:v>8048.85791015625</c:v>
                </c:pt>
                <c:pt idx="257">
                  <c:v>8086.68896484375</c:v>
                </c:pt>
                <c:pt idx="258">
                  <c:v>8088.7763671875</c:v>
                </c:pt>
                <c:pt idx="259">
                  <c:v>8049.94970703125</c:v>
                </c:pt>
                <c:pt idx="260">
                  <c:v>7992.9541015625</c:v>
                </c:pt>
                <c:pt idx="261">
                  <c:v>7952.72607421875</c:v>
                </c:pt>
                <c:pt idx="262">
                  <c:v>7951.591796875</c:v>
                </c:pt>
                <c:pt idx="263">
                  <c:v>7984.21337890625</c:v>
                </c:pt>
                <c:pt idx="264">
                  <c:v>8024.02197265625</c:v>
                </c:pt>
                <c:pt idx="265">
                  <c:v>8045.94921875</c:v>
                </c:pt>
                <c:pt idx="266">
                  <c:v>8046.91455078125</c:v>
                </c:pt>
                <c:pt idx="267">
                  <c:v>8046.84814453125</c:v>
                </c:pt>
                <c:pt idx="268">
                  <c:v>8068.779296875</c:v>
                </c:pt>
                <c:pt idx="269">
                  <c:v>8114.32763671875</c:v>
                </c:pt>
                <c:pt idx="270">
                  <c:v>8156.0615234375</c:v>
                </c:pt>
                <c:pt idx="271">
                  <c:v>8155.52685546875</c:v>
                </c:pt>
                <c:pt idx="272">
                  <c:v>8094.62890625</c:v>
                </c:pt>
                <c:pt idx="273">
                  <c:v>7995.5107421875</c:v>
                </c:pt>
                <c:pt idx="274">
                  <c:v>7911.06396484375</c:v>
                </c:pt>
                <c:pt idx="275">
                  <c:v>7890.40771484375</c:v>
                </c:pt>
                <c:pt idx="276">
                  <c:v>7943.9814453125</c:v>
                </c:pt>
                <c:pt idx="277">
                  <c:v>8034.86865234375</c:v>
                </c:pt>
                <c:pt idx="278">
                  <c:v>8104.0361328125</c:v>
                </c:pt>
                <c:pt idx="279">
                  <c:v>8111.44140625</c:v>
                </c:pt>
                <c:pt idx="280">
                  <c:v>8062.5068359375</c:v>
                </c:pt>
                <c:pt idx="281">
                  <c:v>8000.388671875</c:v>
                </c:pt>
                <c:pt idx="282">
                  <c:v>7970.69384765625</c:v>
                </c:pt>
                <c:pt idx="283">
                  <c:v>7986.40087890625</c:v>
                </c:pt>
                <c:pt idx="284">
                  <c:v>8020.1572265625</c:v>
                </c:pt>
                <c:pt idx="285">
                  <c:v>8029.20556640625</c:v>
                </c:pt>
                <c:pt idx="286">
                  <c:v>7992.3095703125</c:v>
                </c:pt>
                <c:pt idx="287">
                  <c:v>7928.72900390625</c:v>
                </c:pt>
                <c:pt idx="288">
                  <c:v>7883.90625</c:v>
                </c:pt>
                <c:pt idx="289">
                  <c:v>7893.40771484375</c:v>
                </c:pt>
                <c:pt idx="290">
                  <c:v>7954.22119140625</c:v>
                </c:pt>
                <c:pt idx="291">
                  <c:v>8026.6630859375</c:v>
                </c:pt>
                <c:pt idx="292">
                  <c:v>8065.57373046875</c:v>
                </c:pt>
                <c:pt idx="293">
                  <c:v>8055.86669921875</c:v>
                </c:pt>
                <c:pt idx="294">
                  <c:v>8023.85205078125</c:v>
                </c:pt>
                <c:pt idx="295">
                  <c:v>8015.07470703125</c:v>
                </c:pt>
                <c:pt idx="296">
                  <c:v>8056.26416015625</c:v>
                </c:pt>
                <c:pt idx="297">
                  <c:v>8131.8515625</c:v>
                </c:pt>
                <c:pt idx="298">
                  <c:v>8194.095703125</c:v>
                </c:pt>
                <c:pt idx="299">
                  <c:v>8199.234375</c:v>
                </c:pt>
                <c:pt idx="300">
                  <c:v>8141.40283203125</c:v>
                </c:pt>
                <c:pt idx="301">
                  <c:v>8057.7880859375</c:v>
                </c:pt>
                <c:pt idx="302">
                  <c:v>8001.09228515625</c:v>
                </c:pt>
                <c:pt idx="303">
                  <c:v>8000.8212890625</c:v>
                </c:pt>
                <c:pt idx="304">
                  <c:v>8043.220703125</c:v>
                </c:pt>
                <c:pt idx="305">
                  <c:v>8084.51416015625</c:v>
                </c:pt>
                <c:pt idx="306">
                  <c:v>8085.91455078125</c:v>
                </c:pt>
                <c:pt idx="307">
                  <c:v>8042.458984375</c:v>
                </c:pt>
                <c:pt idx="308">
                  <c:v>7983.73779296875</c:v>
                </c:pt>
                <c:pt idx="309">
                  <c:v>7947.62890625</c:v>
                </c:pt>
                <c:pt idx="310">
                  <c:v>7949.48681640625</c:v>
                </c:pt>
                <c:pt idx="311">
                  <c:v>7971.93359375</c:v>
                </c:pt>
                <c:pt idx="312">
                  <c:v>7982.8134765625</c:v>
                </c:pt>
                <c:pt idx="313">
                  <c:v>7965.55078125</c:v>
                </c:pt>
                <c:pt idx="314">
                  <c:v>7936.033203125</c:v>
                </c:pt>
                <c:pt idx="315">
                  <c:v>7931.17041015625</c:v>
                </c:pt>
                <c:pt idx="316">
                  <c:v>7977.515625</c:v>
                </c:pt>
                <c:pt idx="317">
                  <c:v>8065.02099609375</c:v>
                </c:pt>
                <c:pt idx="318">
                  <c:v>8147.84228515625</c:v>
                </c:pt>
                <c:pt idx="319">
                  <c:v>8173.48095703125</c:v>
                </c:pt>
                <c:pt idx="320">
                  <c:v>8119.5888671875</c:v>
                </c:pt>
                <c:pt idx="321">
                  <c:v>8011.40869140625</c:v>
                </c:pt>
                <c:pt idx="322">
                  <c:v>7906.876953125</c:v>
                </c:pt>
                <c:pt idx="323">
                  <c:v>7859.9072265625</c:v>
                </c:pt>
                <c:pt idx="324">
                  <c:v>7887.6767578125</c:v>
                </c:pt>
                <c:pt idx="325">
                  <c:v>7963.82080078125</c:v>
                </c:pt>
                <c:pt idx="326">
                  <c:v>8040.13134765625</c:v>
                </c:pt>
                <c:pt idx="327">
                  <c:v>8079.51708984375</c:v>
                </c:pt>
                <c:pt idx="328">
                  <c:v>8076.9326171875</c:v>
                </c:pt>
                <c:pt idx="329">
                  <c:v>8055.8818359375</c:v>
                </c:pt>
                <c:pt idx="330">
                  <c:v>8046.501953125</c:v>
                </c:pt>
                <c:pt idx="331">
                  <c:v>8063.16015625</c:v>
                </c:pt>
                <c:pt idx="332">
                  <c:v>8097.12890625</c:v>
                </c:pt>
                <c:pt idx="333">
                  <c:v>8126.77197265625</c:v>
                </c:pt>
                <c:pt idx="334">
                  <c:v>8134.78662109375</c:v>
                </c:pt>
                <c:pt idx="335">
                  <c:v>8118.8515625</c:v>
                </c:pt>
                <c:pt idx="336">
                  <c:v>8089.412109375</c:v>
                </c:pt>
                <c:pt idx="337">
                  <c:v>8059.17626953125</c:v>
                </c:pt>
                <c:pt idx="338">
                  <c:v>8034.27197265625</c:v>
                </c:pt>
                <c:pt idx="339">
                  <c:v>8013.62548828125</c:v>
                </c:pt>
                <c:pt idx="340">
                  <c:v>7994.95654296875</c:v>
                </c:pt>
                <c:pt idx="341">
                  <c:v>7980.2509765625</c:v>
                </c:pt>
                <c:pt idx="342">
                  <c:v>7975.037109375</c:v>
                </c:pt>
                <c:pt idx="343">
                  <c:v>7982.25048828125</c:v>
                </c:pt>
                <c:pt idx="344">
                  <c:v>7996.9521484375</c:v>
                </c:pt>
                <c:pt idx="345">
                  <c:v>8007.68701171875</c:v>
                </c:pt>
                <c:pt idx="346">
                  <c:v>8004.45263671875</c:v>
                </c:pt>
                <c:pt idx="347">
                  <c:v>7987.1171875</c:v>
                </c:pt>
                <c:pt idx="348">
                  <c:v>7967.078125</c:v>
                </c:pt>
                <c:pt idx="349">
                  <c:v>7960.02587890625</c:v>
                </c:pt>
              </c:numCache>
            </c:numRef>
          </c:yVal>
          <c:smooth val="1"/>
          <c:extLst>
            <c:ext xmlns:c16="http://schemas.microsoft.com/office/drawing/2014/chart" uri="{C3380CC4-5D6E-409C-BE32-E72D297353CC}">
              <c16:uniqueId val="{00000004-5429-4359-BD11-807CF8F8408D}"/>
            </c:ext>
          </c:extLst>
        </c:ser>
        <c:ser>
          <c:idx val="5"/>
          <c:order val="5"/>
          <c:tx>
            <c:strRef>
              <c:f>np_sub_003!$F$1</c:f>
              <c:strCache>
                <c:ptCount val="1"/>
                <c:pt idx="0">
                  <c:v>Coor_6</c:v>
                </c:pt>
              </c:strCache>
            </c:strRef>
          </c:tx>
          <c:spPr>
            <a:ln w="28575" cap="rnd">
              <a:solidFill>
                <a:schemeClr val="accent6"/>
              </a:solidFill>
              <a:round/>
            </a:ln>
            <a:effectLst/>
          </c:spPr>
          <c:marker>
            <c:symbol val="none"/>
          </c:marker>
          <c:yVal>
            <c:numRef>
              <c:f>np_sub_003!$F$2:$F$351</c:f>
              <c:numCache>
                <c:formatCode>0.00000000000_ </c:formatCode>
                <c:ptCount val="350"/>
                <c:pt idx="0">
                  <c:v>7772.822265625</c:v>
                </c:pt>
                <c:pt idx="1">
                  <c:v>7842.07470703125</c:v>
                </c:pt>
                <c:pt idx="2">
                  <c:v>7935.615234375</c:v>
                </c:pt>
                <c:pt idx="3">
                  <c:v>7991.7314453125</c:v>
                </c:pt>
                <c:pt idx="4">
                  <c:v>7969.34423828125</c:v>
                </c:pt>
                <c:pt idx="5">
                  <c:v>7879.96826171875</c:v>
                </c:pt>
                <c:pt idx="6">
                  <c:v>7781.701171875</c:v>
                </c:pt>
                <c:pt idx="7">
                  <c:v>7737.9560546875</c:v>
                </c:pt>
                <c:pt idx="8">
                  <c:v>7771.45751953125</c:v>
                </c:pt>
                <c:pt idx="9">
                  <c:v>7848.5869140625</c:v>
                </c:pt>
                <c:pt idx="10">
                  <c:v>7906.12353515625</c:v>
                </c:pt>
                <c:pt idx="11">
                  <c:v>7899.6328125</c:v>
                </c:pt>
                <c:pt idx="12">
                  <c:v>7836.21923828125</c:v>
                </c:pt>
                <c:pt idx="13">
                  <c:v>7767.1572265625</c:v>
                </c:pt>
                <c:pt idx="14">
                  <c:v>7747.587890625</c:v>
                </c:pt>
                <c:pt idx="15">
                  <c:v>7795.5595703125</c:v>
                </c:pt>
                <c:pt idx="16">
                  <c:v>7881.52197265625</c:v>
                </c:pt>
                <c:pt idx="17">
                  <c:v>7953.92578125</c:v>
                </c:pt>
                <c:pt idx="18">
                  <c:v>7978.23828125</c:v>
                </c:pt>
                <c:pt idx="19">
                  <c:v>7958.20556640625</c:v>
                </c:pt>
                <c:pt idx="20">
                  <c:v>7925.1806640625</c:v>
                </c:pt>
                <c:pt idx="21">
                  <c:v>7908.240234375</c:v>
                </c:pt>
                <c:pt idx="22">
                  <c:v>7911.888671875</c:v>
                </c:pt>
                <c:pt idx="23">
                  <c:v>7918.73095703125</c:v>
                </c:pt>
                <c:pt idx="24">
                  <c:v>7911.275390625</c:v>
                </c:pt>
                <c:pt idx="25">
                  <c:v>7890.8564453125</c:v>
                </c:pt>
                <c:pt idx="26">
                  <c:v>7876.1484375</c:v>
                </c:pt>
                <c:pt idx="27">
                  <c:v>7883.703125</c:v>
                </c:pt>
                <c:pt idx="28">
                  <c:v>7909.84912109375</c:v>
                </c:pt>
                <c:pt idx="29">
                  <c:v>7931.82080078125</c:v>
                </c:pt>
                <c:pt idx="30">
                  <c:v>7927.79248046875</c:v>
                </c:pt>
                <c:pt idx="31">
                  <c:v>7897.40771484375</c:v>
                </c:pt>
                <c:pt idx="32">
                  <c:v>7863.12060546875</c:v>
                </c:pt>
                <c:pt idx="33">
                  <c:v>7849.8701171875</c:v>
                </c:pt>
                <c:pt idx="34">
                  <c:v>7860.9326171875</c:v>
                </c:pt>
                <c:pt idx="35">
                  <c:v>7872.70556640625</c:v>
                </c:pt>
                <c:pt idx="36">
                  <c:v>7855.27783203125</c:v>
                </c:pt>
                <c:pt idx="37">
                  <c:v>7802.31591796875</c:v>
                </c:pt>
                <c:pt idx="38">
                  <c:v>7743.57421875</c:v>
                </c:pt>
                <c:pt idx="39">
                  <c:v>7726.25732421875</c:v>
                </c:pt>
                <c:pt idx="40">
                  <c:v>7777.61767578125</c:v>
                </c:pt>
                <c:pt idx="41">
                  <c:v>7878.6064453125</c:v>
                </c:pt>
                <c:pt idx="42">
                  <c:v>7971.6845703125</c:v>
                </c:pt>
                <c:pt idx="43">
                  <c:v>7999.48095703125</c:v>
                </c:pt>
                <c:pt idx="44">
                  <c:v>7945.9560546875</c:v>
                </c:pt>
                <c:pt idx="45">
                  <c:v>7848.6455078125</c:v>
                </c:pt>
                <c:pt idx="46">
                  <c:v>7772.26953125</c:v>
                </c:pt>
                <c:pt idx="47">
                  <c:v>7763.40234375</c:v>
                </c:pt>
                <c:pt idx="48">
                  <c:v>7819.74072265625</c:v>
                </c:pt>
                <c:pt idx="49">
                  <c:v>7895.4365234375</c:v>
                </c:pt>
                <c:pt idx="50">
                  <c:v>7936.2041015625</c:v>
                </c:pt>
                <c:pt idx="51">
                  <c:v>7916.63671875</c:v>
                </c:pt>
                <c:pt idx="52">
                  <c:v>7853.17822265625</c:v>
                </c:pt>
                <c:pt idx="53">
                  <c:v>7786.8818359375</c:v>
                </c:pt>
                <c:pt idx="54">
                  <c:v>7752.8251953125</c:v>
                </c:pt>
                <c:pt idx="55">
                  <c:v>7760.1396484375</c:v>
                </c:pt>
                <c:pt idx="56">
                  <c:v>7794.57421875</c:v>
                </c:pt>
                <c:pt idx="57">
                  <c:v>7836.19384765625</c:v>
                </c:pt>
                <c:pt idx="58">
                  <c:v>7874.61767578125</c:v>
                </c:pt>
                <c:pt idx="59">
                  <c:v>7910.0185546875</c:v>
                </c:pt>
                <c:pt idx="60">
                  <c:v>7942.8623046875</c:v>
                </c:pt>
                <c:pt idx="61">
                  <c:v>7965.31494140625</c:v>
                </c:pt>
                <c:pt idx="62">
                  <c:v>7964.25439453125</c:v>
                </c:pt>
                <c:pt idx="63">
                  <c:v>7933.72314453125</c:v>
                </c:pt>
                <c:pt idx="64">
                  <c:v>7885.01318359375</c:v>
                </c:pt>
                <c:pt idx="65">
                  <c:v>7843.90673828125</c:v>
                </c:pt>
                <c:pt idx="66">
                  <c:v>7835.41943359375</c:v>
                </c:pt>
                <c:pt idx="67">
                  <c:v>7867.0263671875</c:v>
                </c:pt>
                <c:pt idx="68">
                  <c:v>7922.8486328125</c:v>
                </c:pt>
                <c:pt idx="69">
                  <c:v>7972.83984375</c:v>
                </c:pt>
                <c:pt idx="70">
                  <c:v>7990.10888671875</c:v>
                </c:pt>
                <c:pt idx="71">
                  <c:v>7964.75634765625</c:v>
                </c:pt>
                <c:pt idx="72">
                  <c:v>7906.77685546875</c:v>
                </c:pt>
                <c:pt idx="73">
                  <c:v>7838.9384765625</c:v>
                </c:pt>
                <c:pt idx="74">
                  <c:v>7786.05615234375</c:v>
                </c:pt>
                <c:pt idx="75">
                  <c:v>7766.4609375</c:v>
                </c:pt>
                <c:pt idx="76">
                  <c:v>7787.33740234375</c:v>
                </c:pt>
                <c:pt idx="77">
                  <c:v>7842.85546875</c:v>
                </c:pt>
                <c:pt idx="78">
                  <c:v>7914.787109375</c:v>
                </c:pt>
                <c:pt idx="79">
                  <c:v>7977.1708984375</c:v>
                </c:pt>
                <c:pt idx="80">
                  <c:v>8005.89501953125</c:v>
                </c:pt>
                <c:pt idx="81">
                  <c:v>7990.06884765625</c:v>
                </c:pt>
                <c:pt idx="82">
                  <c:v>7938.40185546875</c:v>
                </c:pt>
                <c:pt idx="83">
                  <c:v>7874.9365234375</c:v>
                </c:pt>
                <c:pt idx="84">
                  <c:v>7825.1494140625</c:v>
                </c:pt>
                <c:pt idx="85">
                  <c:v>7800.892578125</c:v>
                </c:pt>
                <c:pt idx="86">
                  <c:v>7794.654296875</c:v>
                </c:pt>
                <c:pt idx="87">
                  <c:v>7787.58251953125</c:v>
                </c:pt>
                <c:pt idx="88">
                  <c:v>7765.72607421875</c:v>
                </c:pt>
                <c:pt idx="89">
                  <c:v>7732.5888671875</c:v>
                </c:pt>
                <c:pt idx="90">
                  <c:v>7708.48681640625</c:v>
                </c:pt>
                <c:pt idx="91">
                  <c:v>7716.7470703125</c:v>
                </c:pt>
                <c:pt idx="92">
                  <c:v>7766.39697265625</c:v>
                </c:pt>
                <c:pt idx="93">
                  <c:v>7843.57568359375</c:v>
                </c:pt>
                <c:pt idx="94">
                  <c:v>7917.814453125</c:v>
                </c:pt>
                <c:pt idx="95">
                  <c:v>7959.1845703125</c:v>
                </c:pt>
                <c:pt idx="96">
                  <c:v>7955.28271484375</c:v>
                </c:pt>
                <c:pt idx="97">
                  <c:v>7917.4912109375</c:v>
                </c:pt>
                <c:pt idx="98">
                  <c:v>7873.05419921875</c:v>
                </c:pt>
                <c:pt idx="99">
                  <c:v>7848.22119140625</c:v>
                </c:pt>
                <c:pt idx="100">
                  <c:v>7852.78369140625</c:v>
                </c:pt>
                <c:pt idx="101">
                  <c:v>7875.2421875</c:v>
                </c:pt>
                <c:pt idx="102">
                  <c:v>7891.509765625</c:v>
                </c:pt>
                <c:pt idx="103">
                  <c:v>7882.08349609375</c:v>
                </c:pt>
                <c:pt idx="104">
                  <c:v>7847.14794921875</c:v>
                </c:pt>
                <c:pt idx="105">
                  <c:v>7809.43115234375</c:v>
                </c:pt>
                <c:pt idx="106">
                  <c:v>7801.36376953125</c:v>
                </c:pt>
                <c:pt idx="107">
                  <c:v>7843.2060546875</c:v>
                </c:pt>
                <c:pt idx="108">
                  <c:v>7926.1171875</c:v>
                </c:pt>
                <c:pt idx="109">
                  <c:v>8013.0078125</c:v>
                </c:pt>
                <c:pt idx="110">
                  <c:v>8059.287109375</c:v>
                </c:pt>
                <c:pt idx="111">
                  <c:v>8041.4501953125</c:v>
                </c:pt>
                <c:pt idx="112">
                  <c:v>7973.880859375</c:v>
                </c:pt>
                <c:pt idx="113">
                  <c:v>7900.44287109375</c:v>
                </c:pt>
                <c:pt idx="114">
                  <c:v>7864.76025390625</c:v>
                </c:pt>
                <c:pt idx="115">
                  <c:v>7879.62841796875</c:v>
                </c:pt>
                <c:pt idx="116">
                  <c:v>7918.509765625</c:v>
                </c:pt>
                <c:pt idx="117">
                  <c:v>7936.79736328125</c:v>
                </c:pt>
                <c:pt idx="118">
                  <c:v>7907.7705078125</c:v>
                </c:pt>
                <c:pt idx="119">
                  <c:v>7845.47314453125</c:v>
                </c:pt>
                <c:pt idx="120">
                  <c:v>7795.3662109375</c:v>
                </c:pt>
                <c:pt idx="121">
                  <c:v>7798.35498046875</c:v>
                </c:pt>
                <c:pt idx="122">
                  <c:v>7855.78857421875</c:v>
                </c:pt>
                <c:pt idx="123">
                  <c:v>7924.04931640625</c:v>
                </c:pt>
                <c:pt idx="124">
                  <c:v>7945.11962890625</c:v>
                </c:pt>
                <c:pt idx="125">
                  <c:v>7890.71044921875</c:v>
                </c:pt>
                <c:pt idx="126">
                  <c:v>7785.46142578125</c:v>
                </c:pt>
                <c:pt idx="127">
                  <c:v>7690.0859375</c:v>
                </c:pt>
                <c:pt idx="128">
                  <c:v>7656.8828125</c:v>
                </c:pt>
                <c:pt idx="129">
                  <c:v>7692.4794921875</c:v>
                </c:pt>
                <c:pt idx="130">
                  <c:v>7757.27294921875</c:v>
                </c:pt>
                <c:pt idx="131">
                  <c:v>7801.33837890625</c:v>
                </c:pt>
                <c:pt idx="132">
                  <c:v>7806.58544921875</c:v>
                </c:pt>
                <c:pt idx="133">
                  <c:v>7799.61767578125</c:v>
                </c:pt>
                <c:pt idx="134">
                  <c:v>7824.23291015625</c:v>
                </c:pt>
                <c:pt idx="135">
                  <c:v>7897.01708984375</c:v>
                </c:pt>
                <c:pt idx="136">
                  <c:v>7985.04638671875</c:v>
                </c:pt>
                <c:pt idx="137">
                  <c:v>8027.40771484375</c:v>
                </c:pt>
                <c:pt idx="138">
                  <c:v>7985.365234375</c:v>
                </c:pt>
                <c:pt idx="139">
                  <c:v>7880.0859375</c:v>
                </c:pt>
                <c:pt idx="140">
                  <c:v>7784.369140625</c:v>
                </c:pt>
                <c:pt idx="141">
                  <c:v>7771.1328125</c:v>
                </c:pt>
                <c:pt idx="142">
                  <c:v>7857.45751953125</c:v>
                </c:pt>
                <c:pt idx="143">
                  <c:v>7988.81201171875</c:v>
                </c:pt>
                <c:pt idx="144">
                  <c:v>8077.66650390625</c:v>
                </c:pt>
                <c:pt idx="145">
                  <c:v>8067.74853515625</c:v>
                </c:pt>
                <c:pt idx="146">
                  <c:v>7974.2861328125</c:v>
                </c:pt>
                <c:pt idx="147">
                  <c:v>7869.1123046875</c:v>
                </c:pt>
                <c:pt idx="148">
                  <c:v>7823.02685546875</c:v>
                </c:pt>
                <c:pt idx="149">
                  <c:v>7851.4765625</c:v>
                </c:pt>
                <c:pt idx="150">
                  <c:v>7906.33251953125</c:v>
                </c:pt>
                <c:pt idx="151">
                  <c:v>7919.06103515625</c:v>
                </c:pt>
                <c:pt idx="152">
                  <c:v>7859.318359375</c:v>
                </c:pt>
                <c:pt idx="153">
                  <c:v>7761.18017578125</c:v>
                </c:pt>
                <c:pt idx="154">
                  <c:v>7696.1279296875</c:v>
                </c:pt>
                <c:pt idx="155">
                  <c:v>7715.279296875</c:v>
                </c:pt>
                <c:pt idx="156">
                  <c:v>7807.95556640625</c:v>
                </c:pt>
                <c:pt idx="157">
                  <c:v>7909.89404296875</c:v>
                </c:pt>
                <c:pt idx="158">
                  <c:v>7953.9345703125</c:v>
                </c:pt>
                <c:pt idx="159">
                  <c:v>7921.94384765625</c:v>
                </c:pt>
                <c:pt idx="160">
                  <c:v>7856.47314453125</c:v>
                </c:pt>
                <c:pt idx="161">
                  <c:v>7823.701171875</c:v>
                </c:pt>
                <c:pt idx="162">
                  <c:v>7858.4384765625</c:v>
                </c:pt>
                <c:pt idx="163">
                  <c:v>7935.6962890625</c:v>
                </c:pt>
                <c:pt idx="164">
                  <c:v>7991.15966796875</c:v>
                </c:pt>
                <c:pt idx="165">
                  <c:v>7973.45947265625</c:v>
                </c:pt>
                <c:pt idx="166">
                  <c:v>7886.20068359375</c:v>
                </c:pt>
                <c:pt idx="167">
                  <c:v>7786.72509765625</c:v>
                </c:pt>
                <c:pt idx="168">
                  <c:v>7743.2734375</c:v>
                </c:pt>
                <c:pt idx="169">
                  <c:v>7784.46923828125</c:v>
                </c:pt>
                <c:pt idx="170">
                  <c:v>7879.6953125</c:v>
                </c:pt>
                <c:pt idx="171">
                  <c:v>7963.64990234375</c:v>
                </c:pt>
                <c:pt idx="172">
                  <c:v>7984.27783203125</c:v>
                </c:pt>
                <c:pt idx="173">
                  <c:v>7937.115234375</c:v>
                </c:pt>
                <c:pt idx="174">
                  <c:v>7862.1513671875</c:v>
                </c:pt>
                <c:pt idx="175">
                  <c:v>7809.3916015625</c:v>
                </c:pt>
                <c:pt idx="176">
                  <c:v>7802.06591796875</c:v>
                </c:pt>
                <c:pt idx="177">
                  <c:v>7825.087890625</c:v>
                </c:pt>
                <c:pt idx="178">
                  <c:v>7844.14599609375</c:v>
                </c:pt>
                <c:pt idx="179">
                  <c:v>7836.86376953125</c:v>
                </c:pt>
                <c:pt idx="180">
                  <c:v>7810.322265625</c:v>
                </c:pt>
                <c:pt idx="181">
                  <c:v>7792.71484375</c:v>
                </c:pt>
                <c:pt idx="182">
                  <c:v>7808.33154296875</c:v>
                </c:pt>
                <c:pt idx="183">
                  <c:v>7857.01953125</c:v>
                </c:pt>
                <c:pt idx="184">
                  <c:v>7913.57568359375</c:v>
                </c:pt>
                <c:pt idx="185">
                  <c:v>7945.7138671875</c:v>
                </c:pt>
                <c:pt idx="186">
                  <c:v>7935.619140625</c:v>
                </c:pt>
                <c:pt idx="187">
                  <c:v>7889.6259765625</c:v>
                </c:pt>
                <c:pt idx="188">
                  <c:v>7831.6123046875</c:v>
                </c:pt>
                <c:pt idx="189">
                  <c:v>7787.8779296875</c:v>
                </c:pt>
                <c:pt idx="190">
                  <c:v>7775.083984375</c:v>
                </c:pt>
                <c:pt idx="191">
                  <c:v>7797.1015625</c:v>
                </c:pt>
                <c:pt idx="192">
                  <c:v>7848.1494140625</c:v>
                </c:pt>
                <c:pt idx="193">
                  <c:v>7916.21875</c:v>
                </c:pt>
                <c:pt idx="194">
                  <c:v>7984.23876953125</c:v>
                </c:pt>
                <c:pt idx="195">
                  <c:v>8031.79931640625</c:v>
                </c:pt>
                <c:pt idx="196">
                  <c:v>8041.201171875</c:v>
                </c:pt>
                <c:pt idx="197">
                  <c:v>8006.8427734375</c:v>
                </c:pt>
                <c:pt idx="198">
                  <c:v>7941.25390625</c:v>
                </c:pt>
                <c:pt idx="199">
                  <c:v>7870.9521484375</c:v>
                </c:pt>
                <c:pt idx="200">
                  <c:v>7822.19091796875</c:v>
                </c:pt>
                <c:pt idx="201">
                  <c:v>7805.43603515625</c:v>
                </c:pt>
                <c:pt idx="202">
                  <c:v>7810.1396484375</c:v>
                </c:pt>
                <c:pt idx="203">
                  <c:v>7814.70849609375</c:v>
                </c:pt>
                <c:pt idx="204">
                  <c:v>7804.890625</c:v>
                </c:pt>
                <c:pt idx="205">
                  <c:v>7786.47900390625</c:v>
                </c:pt>
                <c:pt idx="206">
                  <c:v>7781.66650390625</c:v>
                </c:pt>
                <c:pt idx="207">
                  <c:v>7810.74658203125</c:v>
                </c:pt>
                <c:pt idx="208">
                  <c:v>7872.7783203125</c:v>
                </c:pt>
                <c:pt idx="209">
                  <c:v>7940.787109375</c:v>
                </c:pt>
                <c:pt idx="210">
                  <c:v>7976.896484375</c:v>
                </c:pt>
                <c:pt idx="211">
                  <c:v>7957.78076171875</c:v>
                </c:pt>
                <c:pt idx="212">
                  <c:v>7892.32275390625</c:v>
                </c:pt>
                <c:pt idx="213">
                  <c:v>7818.1201171875</c:v>
                </c:pt>
                <c:pt idx="214">
                  <c:v>7778.26708984375</c:v>
                </c:pt>
                <c:pt idx="215">
                  <c:v>7793.95068359375</c:v>
                </c:pt>
                <c:pt idx="216">
                  <c:v>7851.490234375</c:v>
                </c:pt>
                <c:pt idx="217">
                  <c:v>7912.3173828125</c:v>
                </c:pt>
                <c:pt idx="218">
                  <c:v>7938.53076171875</c:v>
                </c:pt>
                <c:pt idx="219">
                  <c:v>7916.4560546875</c:v>
                </c:pt>
                <c:pt idx="220">
                  <c:v>7863.00537109375</c:v>
                </c:pt>
                <c:pt idx="221">
                  <c:v>7812.2021484375</c:v>
                </c:pt>
                <c:pt idx="222">
                  <c:v>7792.57421875</c:v>
                </c:pt>
                <c:pt idx="223">
                  <c:v>7810.93994140625</c:v>
                </c:pt>
                <c:pt idx="224">
                  <c:v>7851.958984375</c:v>
                </c:pt>
                <c:pt idx="225">
                  <c:v>7891.21435546875</c:v>
                </c:pt>
                <c:pt idx="226">
                  <c:v>7911.18798828125</c:v>
                </c:pt>
                <c:pt idx="227">
                  <c:v>7909.61376953125</c:v>
                </c:pt>
                <c:pt idx="228">
                  <c:v>7896.7666015625</c:v>
                </c:pt>
                <c:pt idx="229">
                  <c:v>7886.09423828125</c:v>
                </c:pt>
                <c:pt idx="230">
                  <c:v>7885.59423828125</c:v>
                </c:pt>
                <c:pt idx="231">
                  <c:v>7894.6083984375</c:v>
                </c:pt>
                <c:pt idx="232">
                  <c:v>7905.8349609375</c:v>
                </c:pt>
                <c:pt idx="233">
                  <c:v>7909.57568359375</c:v>
                </c:pt>
                <c:pt idx="234">
                  <c:v>7897.900390625</c:v>
                </c:pt>
                <c:pt idx="235">
                  <c:v>7868.26953125</c:v>
                </c:pt>
                <c:pt idx="236">
                  <c:v>7826.47900390625</c:v>
                </c:pt>
                <c:pt idx="237">
                  <c:v>7787.25390625</c:v>
                </c:pt>
                <c:pt idx="238">
                  <c:v>7769.9267578125</c:v>
                </c:pt>
                <c:pt idx="239">
                  <c:v>7788.90087890625</c:v>
                </c:pt>
                <c:pt idx="240">
                  <c:v>7843.33837890625</c:v>
                </c:pt>
                <c:pt idx="241">
                  <c:v>7913.5595703125</c:v>
                </c:pt>
                <c:pt idx="242">
                  <c:v>7969.10595703125</c:v>
                </c:pt>
                <c:pt idx="243">
                  <c:v>7985.53662109375</c:v>
                </c:pt>
                <c:pt idx="244">
                  <c:v>7959.43798828125</c:v>
                </c:pt>
                <c:pt idx="245">
                  <c:v>7910.48583984375</c:v>
                </c:pt>
                <c:pt idx="246">
                  <c:v>7867.74365234375</c:v>
                </c:pt>
                <c:pt idx="247">
                  <c:v>7849.26171875</c:v>
                </c:pt>
                <c:pt idx="248">
                  <c:v>7850.1044921875</c:v>
                </c:pt>
                <c:pt idx="249">
                  <c:v>7848.4541015625</c:v>
                </c:pt>
                <c:pt idx="250">
                  <c:v>7825.61767578125</c:v>
                </c:pt>
                <c:pt idx="251">
                  <c:v>7784.23193359375</c:v>
                </c:pt>
                <c:pt idx="252">
                  <c:v>7749.34765625</c:v>
                </c:pt>
                <c:pt idx="253">
                  <c:v>7750.1689453125</c:v>
                </c:pt>
                <c:pt idx="254">
                  <c:v>7796.09814453125</c:v>
                </c:pt>
                <c:pt idx="255">
                  <c:v>7866.5244140625</c:v>
                </c:pt>
                <c:pt idx="256">
                  <c:v>7923.921875</c:v>
                </c:pt>
                <c:pt idx="257">
                  <c:v>7941.33544921875</c:v>
                </c:pt>
                <c:pt idx="258">
                  <c:v>7922.9052734375</c:v>
                </c:pt>
                <c:pt idx="259">
                  <c:v>7900.3564453125</c:v>
                </c:pt>
                <c:pt idx="260">
                  <c:v>7906.91748046875</c:v>
                </c:pt>
                <c:pt idx="261">
                  <c:v>7948.59765625</c:v>
                </c:pt>
                <c:pt idx="262">
                  <c:v>7996.103515625</c:v>
                </c:pt>
                <c:pt idx="263">
                  <c:v>8005.3701171875</c:v>
                </c:pt>
                <c:pt idx="264">
                  <c:v>7952.123046875</c:v>
                </c:pt>
                <c:pt idx="265">
                  <c:v>7853.9140625</c:v>
                </c:pt>
                <c:pt idx="266">
                  <c:v>7761.64404296875</c:v>
                </c:pt>
                <c:pt idx="267">
                  <c:v>7725.61181640625</c:v>
                </c:pt>
                <c:pt idx="268">
                  <c:v>7760.8525390625</c:v>
                </c:pt>
                <c:pt idx="269">
                  <c:v>7837.46630859375</c:v>
                </c:pt>
                <c:pt idx="270">
                  <c:v>7902.8544921875</c:v>
                </c:pt>
                <c:pt idx="271">
                  <c:v>7918.853515625</c:v>
                </c:pt>
                <c:pt idx="272">
                  <c:v>7886.1630859375</c:v>
                </c:pt>
                <c:pt idx="273">
                  <c:v>7839.07958984375</c:v>
                </c:pt>
                <c:pt idx="274">
                  <c:v>7816.61767578125</c:v>
                </c:pt>
                <c:pt idx="275">
                  <c:v>7833.39453125</c:v>
                </c:pt>
                <c:pt idx="276">
                  <c:v>7872.064453125</c:v>
                </c:pt>
                <c:pt idx="277">
                  <c:v>7900.90087890625</c:v>
                </c:pt>
                <c:pt idx="278">
                  <c:v>7900.3955078125</c:v>
                </c:pt>
                <c:pt idx="279">
                  <c:v>7877.123046875</c:v>
                </c:pt>
                <c:pt idx="280">
                  <c:v>7855.119140625</c:v>
                </c:pt>
                <c:pt idx="281">
                  <c:v>7853.9384765625</c:v>
                </c:pt>
                <c:pt idx="282">
                  <c:v>7872.68310546875</c:v>
                </c:pt>
                <c:pt idx="283">
                  <c:v>7892.908203125</c:v>
                </c:pt>
                <c:pt idx="284">
                  <c:v>7896.599609375</c:v>
                </c:pt>
                <c:pt idx="285">
                  <c:v>7882.75927734375</c:v>
                </c:pt>
                <c:pt idx="286">
                  <c:v>7867.94140625</c:v>
                </c:pt>
                <c:pt idx="287">
                  <c:v>7870.384765625</c:v>
                </c:pt>
                <c:pt idx="288">
                  <c:v>7891.75830078125</c:v>
                </c:pt>
                <c:pt idx="289">
                  <c:v>7912.86962890625</c:v>
                </c:pt>
                <c:pt idx="290">
                  <c:v>7908.048828125</c:v>
                </c:pt>
                <c:pt idx="291">
                  <c:v>7867.1240234375</c:v>
                </c:pt>
                <c:pt idx="292">
                  <c:v>7807.0146484375</c:v>
                </c:pt>
                <c:pt idx="293">
                  <c:v>7762.6845703125</c:v>
                </c:pt>
                <c:pt idx="294">
                  <c:v>7763.3173828125</c:v>
                </c:pt>
                <c:pt idx="295">
                  <c:v>7811.203125</c:v>
                </c:pt>
                <c:pt idx="296">
                  <c:v>7878.9892578125</c:v>
                </c:pt>
                <c:pt idx="297">
                  <c:v>7927.2900390625</c:v>
                </c:pt>
                <c:pt idx="298">
                  <c:v>7929.986328125</c:v>
                </c:pt>
                <c:pt idx="299">
                  <c:v>7889.75830078125</c:v>
                </c:pt>
                <c:pt idx="300">
                  <c:v>7834.3447265625</c:v>
                </c:pt>
                <c:pt idx="301">
                  <c:v>7797.8486328125</c:v>
                </c:pt>
                <c:pt idx="302">
                  <c:v>7800.69091796875</c:v>
                </c:pt>
                <c:pt idx="303">
                  <c:v>7840.5810546875</c:v>
                </c:pt>
                <c:pt idx="304">
                  <c:v>7897.64208984375</c:v>
                </c:pt>
                <c:pt idx="305">
                  <c:v>7947.44091796875</c:v>
                </c:pt>
                <c:pt idx="306">
                  <c:v>7972.6318359375</c:v>
                </c:pt>
                <c:pt idx="307">
                  <c:v>7967.84130859375</c:v>
                </c:pt>
                <c:pt idx="308">
                  <c:v>7938.46875</c:v>
                </c:pt>
                <c:pt idx="309">
                  <c:v>7897.138671875</c:v>
                </c:pt>
                <c:pt idx="310">
                  <c:v>7860.14306640625</c:v>
                </c:pt>
                <c:pt idx="311">
                  <c:v>7843.35595703125</c:v>
                </c:pt>
                <c:pt idx="312">
                  <c:v>7856.45703125</c:v>
                </c:pt>
                <c:pt idx="313">
                  <c:v>7896.77734375</c:v>
                </c:pt>
                <c:pt idx="314">
                  <c:v>7946.95458984375</c:v>
                </c:pt>
                <c:pt idx="315">
                  <c:v>7980.24169921875</c:v>
                </c:pt>
                <c:pt idx="316">
                  <c:v>7972.90869140625</c:v>
                </c:pt>
                <c:pt idx="317">
                  <c:v>7917.65966796875</c:v>
                </c:pt>
                <c:pt idx="318">
                  <c:v>7829.8330078125</c:v>
                </c:pt>
                <c:pt idx="319">
                  <c:v>7741.6630859375</c:v>
                </c:pt>
                <c:pt idx="320">
                  <c:v>7687.06494140625</c:v>
                </c:pt>
                <c:pt idx="321">
                  <c:v>7685.36083984375</c:v>
                </c:pt>
                <c:pt idx="322">
                  <c:v>7733.0400390625</c:v>
                </c:pt>
                <c:pt idx="323">
                  <c:v>7807.58251953125</c:v>
                </c:pt>
                <c:pt idx="324">
                  <c:v>7880.16357421875</c:v>
                </c:pt>
                <c:pt idx="325">
                  <c:v>7929.35888671875</c:v>
                </c:pt>
                <c:pt idx="326">
                  <c:v>7948.47119140625</c:v>
                </c:pt>
                <c:pt idx="327">
                  <c:v>7943.8740234375</c:v>
                </c:pt>
                <c:pt idx="328">
                  <c:v>7927.27587890625</c:v>
                </c:pt>
                <c:pt idx="329">
                  <c:v>7907.65087890625</c:v>
                </c:pt>
                <c:pt idx="330">
                  <c:v>7887.55029296875</c:v>
                </c:pt>
                <c:pt idx="331">
                  <c:v>7864.89697265625</c:v>
                </c:pt>
                <c:pt idx="332">
                  <c:v>7837.84375</c:v>
                </c:pt>
                <c:pt idx="333">
                  <c:v>7808.8662109375</c:v>
                </c:pt>
                <c:pt idx="334">
                  <c:v>7785.361328125</c:v>
                </c:pt>
                <c:pt idx="335">
                  <c:v>7776.5478515625</c:v>
                </c:pt>
                <c:pt idx="336">
                  <c:v>7788.70458984375</c:v>
                </c:pt>
                <c:pt idx="337">
                  <c:v>7821.5341796875</c:v>
                </c:pt>
                <c:pt idx="338">
                  <c:v>7867.58349609375</c:v>
                </c:pt>
                <c:pt idx="339">
                  <c:v>7914.87255859375</c:v>
                </c:pt>
                <c:pt idx="340">
                  <c:v>7951.29931640625</c:v>
                </c:pt>
                <c:pt idx="341">
                  <c:v>7968.76806640625</c:v>
                </c:pt>
                <c:pt idx="342">
                  <c:v>7965.435546875</c:v>
                </c:pt>
                <c:pt idx="343">
                  <c:v>7945.53271484375</c:v>
                </c:pt>
                <c:pt idx="344">
                  <c:v>7917.23974609375</c:v>
                </c:pt>
                <c:pt idx="345">
                  <c:v>7889.62646484375</c:v>
                </c:pt>
                <c:pt idx="346">
                  <c:v>7869.720703125</c:v>
                </c:pt>
                <c:pt idx="347">
                  <c:v>7860.56982421875</c:v>
                </c:pt>
                <c:pt idx="348">
                  <c:v>7860.83251953125</c:v>
                </c:pt>
                <c:pt idx="349">
                  <c:v>7866.03515625</c:v>
                </c:pt>
              </c:numCache>
            </c:numRef>
          </c:yVal>
          <c:smooth val="1"/>
          <c:extLst>
            <c:ext xmlns:c16="http://schemas.microsoft.com/office/drawing/2014/chart" uri="{C3380CC4-5D6E-409C-BE32-E72D297353CC}">
              <c16:uniqueId val="{00000005-5429-4359-BD11-807CF8F8408D}"/>
            </c:ext>
          </c:extLst>
        </c:ser>
        <c:ser>
          <c:idx val="6"/>
          <c:order val="6"/>
          <c:tx>
            <c:strRef>
              <c:f>np_sub_003!$G$1</c:f>
              <c:strCache>
                <c:ptCount val="1"/>
                <c:pt idx="0">
                  <c:v>Coor_7</c:v>
                </c:pt>
              </c:strCache>
            </c:strRef>
          </c:tx>
          <c:spPr>
            <a:ln w="28575" cap="rnd">
              <a:solidFill>
                <a:schemeClr val="accent1">
                  <a:lumMod val="60000"/>
                </a:schemeClr>
              </a:solidFill>
              <a:round/>
            </a:ln>
            <a:effectLst/>
          </c:spPr>
          <c:marker>
            <c:symbol val="none"/>
          </c:marker>
          <c:yVal>
            <c:numRef>
              <c:f>np_sub_003!$G$2:$G$351</c:f>
              <c:numCache>
                <c:formatCode>0.00000000000_ </c:formatCode>
                <c:ptCount val="350"/>
                <c:pt idx="0">
                  <c:v>6561.7119140625</c:v>
                </c:pt>
                <c:pt idx="1">
                  <c:v>6599.279296875</c:v>
                </c:pt>
                <c:pt idx="2">
                  <c:v>6618.28564453125</c:v>
                </c:pt>
                <c:pt idx="3">
                  <c:v>6591.46142578125</c:v>
                </c:pt>
                <c:pt idx="4">
                  <c:v>6520.94580078125</c:v>
                </c:pt>
                <c:pt idx="5">
                  <c:v>6445.12841796875</c:v>
                </c:pt>
                <c:pt idx="6">
                  <c:v>6417.26025390625</c:v>
                </c:pt>
                <c:pt idx="7">
                  <c:v>6468.7724609375</c:v>
                </c:pt>
                <c:pt idx="8">
                  <c:v>6584.04638671875</c:v>
                </c:pt>
                <c:pt idx="9">
                  <c:v>6706.7607421875</c:v>
                </c:pt>
                <c:pt idx="10">
                  <c:v>6774.93408203125</c:v>
                </c:pt>
                <c:pt idx="11">
                  <c:v>6760.09033203125</c:v>
                </c:pt>
                <c:pt idx="12">
                  <c:v>6682.734375</c:v>
                </c:pt>
                <c:pt idx="13">
                  <c:v>6594.26123046875</c:v>
                </c:pt>
                <c:pt idx="14">
                  <c:v>6540.44580078125</c:v>
                </c:pt>
                <c:pt idx="15">
                  <c:v>6534.1171875</c:v>
                </c:pt>
                <c:pt idx="16">
                  <c:v>6555.421875</c:v>
                </c:pt>
                <c:pt idx="17">
                  <c:v>6575.39990234375</c:v>
                </c:pt>
                <c:pt idx="18">
                  <c:v>6581.1572265625</c:v>
                </c:pt>
                <c:pt idx="19">
                  <c:v>6582.21142578125</c:v>
                </c:pt>
                <c:pt idx="20">
                  <c:v>6595.287109375</c:v>
                </c:pt>
                <c:pt idx="21">
                  <c:v>6623.349609375</c:v>
                </c:pt>
                <c:pt idx="22">
                  <c:v>6648.59619140625</c:v>
                </c:pt>
                <c:pt idx="23">
                  <c:v>6645.89990234375</c:v>
                </c:pt>
                <c:pt idx="24">
                  <c:v>6604.88525390625</c:v>
                </c:pt>
                <c:pt idx="25">
                  <c:v>6541.12060546875</c:v>
                </c:pt>
                <c:pt idx="26">
                  <c:v>6486.2197265625</c:v>
                </c:pt>
                <c:pt idx="27">
                  <c:v>6464.6220703125</c:v>
                </c:pt>
                <c:pt idx="28">
                  <c:v>6476.08447265625</c:v>
                </c:pt>
                <c:pt idx="29">
                  <c:v>6498.08056640625</c:v>
                </c:pt>
                <c:pt idx="30">
                  <c:v>6505.6796875</c:v>
                </c:pt>
                <c:pt idx="31">
                  <c:v>6492.1826171875</c:v>
                </c:pt>
                <c:pt idx="32">
                  <c:v>6473.62060546875</c:v>
                </c:pt>
                <c:pt idx="33">
                  <c:v>6474.033203125</c:v>
                </c:pt>
                <c:pt idx="34">
                  <c:v>6504.41845703125</c:v>
                </c:pt>
                <c:pt idx="35">
                  <c:v>6553.158203125</c:v>
                </c:pt>
                <c:pt idx="36">
                  <c:v>6595.76171875</c:v>
                </c:pt>
                <c:pt idx="37">
                  <c:v>6615.4375</c:v>
                </c:pt>
                <c:pt idx="38">
                  <c:v>6616.90087890625</c:v>
                </c:pt>
                <c:pt idx="39">
                  <c:v>6621.37109375</c:v>
                </c:pt>
                <c:pt idx="40">
                  <c:v>6646.296875</c:v>
                </c:pt>
                <c:pt idx="41">
                  <c:v>6686.34326171875</c:v>
                </c:pt>
                <c:pt idx="42">
                  <c:v>6712.0322265625</c:v>
                </c:pt>
                <c:pt idx="43">
                  <c:v>6689.13818359375</c:v>
                </c:pt>
                <c:pt idx="44">
                  <c:v>6605.69091796875</c:v>
                </c:pt>
                <c:pt idx="45">
                  <c:v>6486.6337890625</c:v>
                </c:pt>
                <c:pt idx="46">
                  <c:v>6384.1328125</c:v>
                </c:pt>
                <c:pt idx="47">
                  <c:v>6348.421875</c:v>
                </c:pt>
                <c:pt idx="48">
                  <c:v>6397.8623046875</c:v>
                </c:pt>
                <c:pt idx="49">
                  <c:v>6507.80859375</c:v>
                </c:pt>
                <c:pt idx="50">
                  <c:v>6625.47900390625</c:v>
                </c:pt>
                <c:pt idx="51">
                  <c:v>6701.00341796875</c:v>
                </c:pt>
                <c:pt idx="52">
                  <c:v>6714.6826171875</c:v>
                </c:pt>
                <c:pt idx="53">
                  <c:v>6683.76953125</c:v>
                </c:pt>
                <c:pt idx="54">
                  <c:v>6646.07763671875</c:v>
                </c:pt>
                <c:pt idx="55">
                  <c:v>6632.78662109375</c:v>
                </c:pt>
                <c:pt idx="56">
                  <c:v>6648.9697265625</c:v>
                </c:pt>
                <c:pt idx="57">
                  <c:v>6673.92578125</c:v>
                </c:pt>
                <c:pt idx="58">
                  <c:v>6679.2080078125</c:v>
                </c:pt>
                <c:pt idx="59">
                  <c:v>6650.2998046875</c:v>
                </c:pt>
                <c:pt idx="60">
                  <c:v>6596.328125</c:v>
                </c:pt>
                <c:pt idx="61">
                  <c:v>6541.7587890625</c:v>
                </c:pt>
                <c:pt idx="62">
                  <c:v>6507.52587890625</c:v>
                </c:pt>
                <c:pt idx="63">
                  <c:v>6496.47998046875</c:v>
                </c:pt>
                <c:pt idx="64">
                  <c:v>6494.0634765625</c:v>
                </c:pt>
                <c:pt idx="65">
                  <c:v>6482.82275390625</c:v>
                </c:pt>
                <c:pt idx="66">
                  <c:v>6458.41748046875</c:v>
                </c:pt>
                <c:pt idx="67">
                  <c:v>6433.81005859375</c:v>
                </c:pt>
                <c:pt idx="68">
                  <c:v>6428.16162109375</c:v>
                </c:pt>
                <c:pt idx="69">
                  <c:v>6449.8037109375</c:v>
                </c:pt>
                <c:pt idx="70">
                  <c:v>6487.9423828125</c:v>
                </c:pt>
                <c:pt idx="71">
                  <c:v>6520.8095703125</c:v>
                </c:pt>
                <c:pt idx="72">
                  <c:v>6534.14404296875</c:v>
                </c:pt>
                <c:pt idx="73">
                  <c:v>6534.50634765625</c:v>
                </c:pt>
                <c:pt idx="74">
                  <c:v>6545.2138671875</c:v>
                </c:pt>
                <c:pt idx="75">
                  <c:v>6586.62255859375</c:v>
                </c:pt>
                <c:pt idx="76">
                  <c:v>6655.94482421875</c:v>
                </c:pt>
                <c:pt idx="77">
                  <c:v>6723.560546875</c:v>
                </c:pt>
                <c:pt idx="78">
                  <c:v>6750.65771484375</c:v>
                </c:pt>
                <c:pt idx="79">
                  <c:v>6716.298828125</c:v>
                </c:pt>
                <c:pt idx="80">
                  <c:v>6634.00830078125</c:v>
                </c:pt>
                <c:pt idx="81">
                  <c:v>6545.275390625</c:v>
                </c:pt>
                <c:pt idx="82">
                  <c:v>6494.38134765625</c:v>
                </c:pt>
                <c:pt idx="83">
                  <c:v>6502.35986328125</c:v>
                </c:pt>
                <c:pt idx="84">
                  <c:v>6557.49169921875</c:v>
                </c:pt>
                <c:pt idx="85">
                  <c:v>6626.59228515625</c:v>
                </c:pt>
                <c:pt idx="86">
                  <c:v>6676.52880859375</c:v>
                </c:pt>
                <c:pt idx="87">
                  <c:v>6690.3369140625</c:v>
                </c:pt>
                <c:pt idx="88">
                  <c:v>6669.587890625</c:v>
                </c:pt>
                <c:pt idx="89">
                  <c:v>6626.54638671875</c:v>
                </c:pt>
                <c:pt idx="90">
                  <c:v>6575.70068359375</c:v>
                </c:pt>
                <c:pt idx="91">
                  <c:v>6530.462890625</c:v>
                </c:pt>
                <c:pt idx="92">
                  <c:v>6502.82275390625</c:v>
                </c:pt>
                <c:pt idx="93">
                  <c:v>6500.37939453125</c:v>
                </c:pt>
                <c:pt idx="94">
                  <c:v>6519.95068359375</c:v>
                </c:pt>
                <c:pt idx="95">
                  <c:v>6544.3056640625</c:v>
                </c:pt>
                <c:pt idx="96">
                  <c:v>6549.537109375</c:v>
                </c:pt>
                <c:pt idx="97">
                  <c:v>6522.109375</c:v>
                </c:pt>
                <c:pt idx="98">
                  <c:v>6473.58203125</c:v>
                </c:pt>
                <c:pt idx="99">
                  <c:v>6438.65380859375</c:v>
                </c:pt>
                <c:pt idx="100">
                  <c:v>6453.23974609375</c:v>
                </c:pt>
                <c:pt idx="101">
                  <c:v>6526.29931640625</c:v>
                </c:pt>
                <c:pt idx="102">
                  <c:v>6627.4306640625</c:v>
                </c:pt>
                <c:pt idx="103">
                  <c:v>6702.830078125</c:v>
                </c:pt>
                <c:pt idx="104">
                  <c:v>6710.6953125</c:v>
                </c:pt>
                <c:pt idx="105">
                  <c:v>6650.5400390625</c:v>
                </c:pt>
                <c:pt idx="106">
                  <c:v>6563.71142578125</c:v>
                </c:pt>
                <c:pt idx="107">
                  <c:v>6503.888671875</c:v>
                </c:pt>
                <c:pt idx="108">
                  <c:v>6499.77392578125</c:v>
                </c:pt>
                <c:pt idx="109">
                  <c:v>6538.37939453125</c:v>
                </c:pt>
                <c:pt idx="110">
                  <c:v>6580.669921875</c:v>
                </c:pt>
                <c:pt idx="111">
                  <c:v>6595.248046875</c:v>
                </c:pt>
                <c:pt idx="112">
                  <c:v>6581.7890625</c:v>
                </c:pt>
                <c:pt idx="113">
                  <c:v>6565.67333984375</c:v>
                </c:pt>
                <c:pt idx="114">
                  <c:v>6570.3779296875</c:v>
                </c:pt>
                <c:pt idx="115">
                  <c:v>6593.16259765625</c:v>
                </c:pt>
                <c:pt idx="116">
                  <c:v>6606.21435546875</c:v>
                </c:pt>
                <c:pt idx="117">
                  <c:v>6582.572265625</c:v>
                </c:pt>
                <c:pt idx="118">
                  <c:v>6523.7626953125</c:v>
                </c:pt>
                <c:pt idx="119">
                  <c:v>6463.76416015625</c:v>
                </c:pt>
                <c:pt idx="120">
                  <c:v>6444.10302734375</c:v>
                </c:pt>
                <c:pt idx="121">
                  <c:v>6480.306640625</c:v>
                </c:pt>
                <c:pt idx="122">
                  <c:v>6548.4150390625</c:v>
                </c:pt>
                <c:pt idx="123">
                  <c:v>6603.93701171875</c:v>
                </c:pt>
                <c:pt idx="124">
                  <c:v>6618.087890625</c:v>
                </c:pt>
                <c:pt idx="125">
                  <c:v>6600.9443359375</c:v>
                </c:pt>
                <c:pt idx="126">
                  <c:v>6591.66357421875</c:v>
                </c:pt>
                <c:pt idx="127">
                  <c:v>6623.578125</c:v>
                </c:pt>
                <c:pt idx="128">
                  <c:v>6693.36865234375</c:v>
                </c:pt>
                <c:pt idx="129">
                  <c:v>6760.4287109375</c:v>
                </c:pt>
                <c:pt idx="130">
                  <c:v>6777.37890625</c:v>
                </c:pt>
                <c:pt idx="131">
                  <c:v>6726.74267578125</c:v>
                </c:pt>
                <c:pt idx="132">
                  <c:v>6633.91455078125</c:v>
                </c:pt>
                <c:pt idx="133">
                  <c:v>6546.58935546875</c:v>
                </c:pt>
                <c:pt idx="134">
                  <c:v>6498.6494140625</c:v>
                </c:pt>
                <c:pt idx="135">
                  <c:v>6488.53369140625</c:v>
                </c:pt>
                <c:pt idx="136">
                  <c:v>6488.6669921875</c:v>
                </c:pt>
                <c:pt idx="137">
                  <c:v>6475.619140625</c:v>
                </c:pt>
                <c:pt idx="138">
                  <c:v>6453.4970703125</c:v>
                </c:pt>
                <c:pt idx="139">
                  <c:v>6449.9873046875</c:v>
                </c:pt>
                <c:pt idx="140">
                  <c:v>6488.95263671875</c:v>
                </c:pt>
                <c:pt idx="141">
                  <c:v>6564.12060546875</c:v>
                </c:pt>
                <c:pt idx="142">
                  <c:v>6637.595703125</c:v>
                </c:pt>
                <c:pt idx="143">
                  <c:v>6665.67236328125</c:v>
                </c:pt>
                <c:pt idx="144">
                  <c:v>6631.2158203125</c:v>
                </c:pt>
                <c:pt idx="145">
                  <c:v>6556.36474609375</c:v>
                </c:pt>
                <c:pt idx="146">
                  <c:v>6485.7412109375</c:v>
                </c:pt>
                <c:pt idx="147">
                  <c:v>6454.35400390625</c:v>
                </c:pt>
                <c:pt idx="148">
                  <c:v>6465.79736328125</c:v>
                </c:pt>
                <c:pt idx="149">
                  <c:v>6496.38427734375</c:v>
                </c:pt>
                <c:pt idx="150">
                  <c:v>6518.95263671875</c:v>
                </c:pt>
                <c:pt idx="151">
                  <c:v>6525.02880859375</c:v>
                </c:pt>
                <c:pt idx="152">
                  <c:v>6527.72021484375</c:v>
                </c:pt>
                <c:pt idx="153">
                  <c:v>6545.501953125</c:v>
                </c:pt>
                <c:pt idx="154">
                  <c:v>6582.982421875</c:v>
                </c:pt>
                <c:pt idx="155">
                  <c:v>6625.54931640625</c:v>
                </c:pt>
                <c:pt idx="156">
                  <c:v>6651.330078125</c:v>
                </c:pt>
                <c:pt idx="157">
                  <c:v>6648.83544921875</c:v>
                </c:pt>
                <c:pt idx="158">
                  <c:v>6625.0419921875</c:v>
                </c:pt>
                <c:pt idx="159">
                  <c:v>6598.37158203125</c:v>
                </c:pt>
                <c:pt idx="160">
                  <c:v>6584.30322265625</c:v>
                </c:pt>
                <c:pt idx="161">
                  <c:v>6586.306640625</c:v>
                </c:pt>
                <c:pt idx="162">
                  <c:v>6598.1083984375</c:v>
                </c:pt>
                <c:pt idx="163">
                  <c:v>6612.40576171875</c:v>
                </c:pt>
                <c:pt idx="164">
                  <c:v>6626.41748046875</c:v>
                </c:pt>
                <c:pt idx="165">
                  <c:v>6639.7763671875</c:v>
                </c:pt>
                <c:pt idx="166">
                  <c:v>6649.1357421875</c:v>
                </c:pt>
                <c:pt idx="167">
                  <c:v>6647.2734375</c:v>
                </c:pt>
                <c:pt idx="168">
                  <c:v>6629.11083984375</c:v>
                </c:pt>
                <c:pt idx="169">
                  <c:v>6598.71240234375</c:v>
                </c:pt>
                <c:pt idx="170">
                  <c:v>6568.912109375</c:v>
                </c:pt>
                <c:pt idx="171">
                  <c:v>6551.85888671875</c:v>
                </c:pt>
                <c:pt idx="172">
                  <c:v>6548.35693359375</c:v>
                </c:pt>
                <c:pt idx="173">
                  <c:v>6546.65771484375</c:v>
                </c:pt>
                <c:pt idx="174">
                  <c:v>6533.60693359375</c:v>
                </c:pt>
                <c:pt idx="175">
                  <c:v>6509.150390625</c:v>
                </c:pt>
                <c:pt idx="176">
                  <c:v>6490.359375</c:v>
                </c:pt>
                <c:pt idx="177">
                  <c:v>6498.94384765625</c:v>
                </c:pt>
                <c:pt idx="178">
                  <c:v>6540.857421875</c:v>
                </c:pt>
                <c:pt idx="179">
                  <c:v>6595.25146484375</c:v>
                </c:pt>
                <c:pt idx="180">
                  <c:v>6624.279296875</c:v>
                </c:pt>
                <c:pt idx="181">
                  <c:v>6598.82861328125</c:v>
                </c:pt>
                <c:pt idx="182">
                  <c:v>6521.53662109375</c:v>
                </c:pt>
                <c:pt idx="183">
                  <c:v>6429.19189453125</c:v>
                </c:pt>
                <c:pt idx="184">
                  <c:v>6371.693359375</c:v>
                </c:pt>
                <c:pt idx="185">
                  <c:v>6382.13232421875</c:v>
                </c:pt>
                <c:pt idx="186">
                  <c:v>6458.51416015625</c:v>
                </c:pt>
                <c:pt idx="187">
                  <c:v>6567.97021484375</c:v>
                </c:pt>
                <c:pt idx="188">
                  <c:v>6667.69384765625</c:v>
                </c:pt>
                <c:pt idx="189">
                  <c:v>6726.65673828125</c:v>
                </c:pt>
                <c:pt idx="190">
                  <c:v>6735.31103515625</c:v>
                </c:pt>
                <c:pt idx="191">
                  <c:v>6702.09619140625</c:v>
                </c:pt>
                <c:pt idx="192">
                  <c:v>6644.70263671875</c:v>
                </c:pt>
                <c:pt idx="193">
                  <c:v>6583.68310546875</c:v>
                </c:pt>
                <c:pt idx="194">
                  <c:v>6539.09375</c:v>
                </c:pt>
                <c:pt idx="195">
                  <c:v>6525.95849609375</c:v>
                </c:pt>
                <c:pt idx="196">
                  <c:v>6546.98046875</c:v>
                </c:pt>
                <c:pt idx="197">
                  <c:v>6587.62255859375</c:v>
                </c:pt>
                <c:pt idx="198">
                  <c:v>6621.00341796875</c:v>
                </c:pt>
                <c:pt idx="199">
                  <c:v>6623.50732421875</c:v>
                </c:pt>
                <c:pt idx="200">
                  <c:v>6591.4873046875</c:v>
                </c:pt>
                <c:pt idx="201">
                  <c:v>6545.373046875</c:v>
                </c:pt>
                <c:pt idx="202">
                  <c:v>6515.66796875</c:v>
                </c:pt>
                <c:pt idx="203">
                  <c:v>6520.23779296875</c:v>
                </c:pt>
                <c:pt idx="204">
                  <c:v>6550.98193359375</c:v>
                </c:pt>
                <c:pt idx="205">
                  <c:v>6581.5322265625</c:v>
                </c:pt>
                <c:pt idx="206">
                  <c:v>6590.130859375</c:v>
                </c:pt>
                <c:pt idx="207">
                  <c:v>6578.1513671875</c:v>
                </c:pt>
                <c:pt idx="208">
                  <c:v>6567.513671875</c:v>
                </c:pt>
                <c:pt idx="209">
                  <c:v>6578.41259765625</c:v>
                </c:pt>
                <c:pt idx="210">
                  <c:v>6607.02197265625</c:v>
                </c:pt>
                <c:pt idx="211">
                  <c:v>6624.55322265625</c:v>
                </c:pt>
                <c:pt idx="212">
                  <c:v>6601.29248046875</c:v>
                </c:pt>
                <c:pt idx="213">
                  <c:v>6536.40380859375</c:v>
                </c:pt>
                <c:pt idx="214">
                  <c:v>6466.6103515625</c:v>
                </c:pt>
                <c:pt idx="215">
                  <c:v>6442.56201171875</c:v>
                </c:pt>
                <c:pt idx="216">
                  <c:v>6489.0546875</c:v>
                </c:pt>
                <c:pt idx="217">
                  <c:v>6581.12890625</c:v>
                </c:pt>
                <c:pt idx="218">
                  <c:v>6657.8828125</c:v>
                </c:pt>
                <c:pt idx="219">
                  <c:v>6666.22705078125</c:v>
                </c:pt>
                <c:pt idx="220">
                  <c:v>6601.6591796875</c:v>
                </c:pt>
                <c:pt idx="221">
                  <c:v>6513.58935546875</c:v>
                </c:pt>
                <c:pt idx="222">
                  <c:v>6469.654296875</c:v>
                </c:pt>
                <c:pt idx="223">
                  <c:v>6505.64208984375</c:v>
                </c:pt>
                <c:pt idx="224">
                  <c:v>6599.20751953125</c:v>
                </c:pt>
                <c:pt idx="225">
                  <c:v>6687.05615234375</c:v>
                </c:pt>
                <c:pt idx="226">
                  <c:v>6711.576171875</c:v>
                </c:pt>
                <c:pt idx="227">
                  <c:v>6660.9443359375</c:v>
                </c:pt>
                <c:pt idx="228">
                  <c:v>6573.48876953125</c:v>
                </c:pt>
                <c:pt idx="229">
                  <c:v>6506.005859375</c:v>
                </c:pt>
                <c:pt idx="230">
                  <c:v>6492.87548828125</c:v>
                </c:pt>
                <c:pt idx="231">
                  <c:v>6526.99853515625</c:v>
                </c:pt>
                <c:pt idx="232">
                  <c:v>6573.36669921875</c:v>
                </c:pt>
                <c:pt idx="233">
                  <c:v>6599.7255859375</c:v>
                </c:pt>
                <c:pt idx="234">
                  <c:v>6598.0087890625</c:v>
                </c:pt>
                <c:pt idx="235">
                  <c:v>6581.99853515625</c:v>
                </c:pt>
                <c:pt idx="236">
                  <c:v>6568.57861328125</c:v>
                </c:pt>
                <c:pt idx="237">
                  <c:v>6562.3974609375</c:v>
                </c:pt>
                <c:pt idx="238">
                  <c:v>6557.0478515625</c:v>
                </c:pt>
                <c:pt idx="239">
                  <c:v>6548.14697265625</c:v>
                </c:pt>
                <c:pt idx="240">
                  <c:v>6542.2431640625</c:v>
                </c:pt>
                <c:pt idx="241">
                  <c:v>6550.76123046875</c:v>
                </c:pt>
                <c:pt idx="242">
                  <c:v>6574.501953125</c:v>
                </c:pt>
                <c:pt idx="243">
                  <c:v>6595.45068359375</c:v>
                </c:pt>
                <c:pt idx="244">
                  <c:v>6587.42138671875</c:v>
                </c:pt>
                <c:pt idx="245">
                  <c:v>6539.4287109375</c:v>
                </c:pt>
                <c:pt idx="246">
                  <c:v>6471.76611328125</c:v>
                </c:pt>
                <c:pt idx="247">
                  <c:v>6428.1328125</c:v>
                </c:pt>
                <c:pt idx="248">
                  <c:v>6446.25927734375</c:v>
                </c:pt>
                <c:pt idx="249">
                  <c:v>6528.4951171875</c:v>
                </c:pt>
                <c:pt idx="250">
                  <c:v>6635.9580078125</c:v>
                </c:pt>
                <c:pt idx="251">
                  <c:v>6712.42041015625</c:v>
                </c:pt>
                <c:pt idx="252">
                  <c:v>6720.8857421875</c:v>
                </c:pt>
                <c:pt idx="253">
                  <c:v>6665.8740234375</c:v>
                </c:pt>
                <c:pt idx="254">
                  <c:v>6585.890625</c:v>
                </c:pt>
                <c:pt idx="255">
                  <c:v>6523.8447265625</c:v>
                </c:pt>
                <c:pt idx="256">
                  <c:v>6499.2587890625</c:v>
                </c:pt>
                <c:pt idx="257">
                  <c:v>6502.50732421875</c:v>
                </c:pt>
                <c:pt idx="258">
                  <c:v>6512.0029296875</c:v>
                </c:pt>
                <c:pt idx="259">
                  <c:v>6516.96337890625</c:v>
                </c:pt>
                <c:pt idx="260">
                  <c:v>6525.89501953125</c:v>
                </c:pt>
                <c:pt idx="261">
                  <c:v>6555.06591796875</c:v>
                </c:pt>
                <c:pt idx="262">
                  <c:v>6609.02880859375</c:v>
                </c:pt>
                <c:pt idx="263">
                  <c:v>6671.443359375</c:v>
                </c:pt>
                <c:pt idx="264">
                  <c:v>6714.61376953125</c:v>
                </c:pt>
                <c:pt idx="265">
                  <c:v>6719.60791015625</c:v>
                </c:pt>
                <c:pt idx="266">
                  <c:v>6689.9736328125</c:v>
                </c:pt>
                <c:pt idx="267">
                  <c:v>6647.9345703125</c:v>
                </c:pt>
                <c:pt idx="268">
                  <c:v>6616.791015625</c:v>
                </c:pt>
                <c:pt idx="269">
                  <c:v>6604.13671875</c:v>
                </c:pt>
                <c:pt idx="270">
                  <c:v>6598.80908203125</c:v>
                </c:pt>
                <c:pt idx="271">
                  <c:v>6582.59423828125</c:v>
                </c:pt>
                <c:pt idx="272">
                  <c:v>6546.1787109375</c:v>
                </c:pt>
                <c:pt idx="273">
                  <c:v>6496.8232421875</c:v>
                </c:pt>
                <c:pt idx="274">
                  <c:v>6453.13623046875</c:v>
                </c:pt>
                <c:pt idx="275">
                  <c:v>6432.49560546875</c:v>
                </c:pt>
                <c:pt idx="276">
                  <c:v>6440.82275390625</c:v>
                </c:pt>
                <c:pt idx="277">
                  <c:v>6470.6494140625</c:v>
                </c:pt>
                <c:pt idx="278">
                  <c:v>6506.48681640625</c:v>
                </c:pt>
                <c:pt idx="279">
                  <c:v>6532.68603515625</c:v>
                </c:pt>
                <c:pt idx="280">
                  <c:v>6539.98095703125</c:v>
                </c:pt>
                <c:pt idx="281">
                  <c:v>6529.59521484375</c:v>
                </c:pt>
                <c:pt idx="282">
                  <c:v>6514.36376953125</c:v>
                </c:pt>
                <c:pt idx="283">
                  <c:v>6514.9375</c:v>
                </c:pt>
                <c:pt idx="284">
                  <c:v>6549.458984375</c:v>
                </c:pt>
                <c:pt idx="285">
                  <c:v>6619.638671875</c:v>
                </c:pt>
                <c:pt idx="286">
                  <c:v>6702.09375</c:v>
                </c:pt>
                <c:pt idx="287">
                  <c:v>6754.60791015625</c:v>
                </c:pt>
                <c:pt idx="288">
                  <c:v>6738.7177734375</c:v>
                </c:pt>
                <c:pt idx="289">
                  <c:v>6646.8486328125</c:v>
                </c:pt>
                <c:pt idx="290">
                  <c:v>6514.68994140625</c:v>
                </c:pt>
                <c:pt idx="291">
                  <c:v>6406.03125</c:v>
                </c:pt>
                <c:pt idx="292">
                  <c:v>6375.86474609375</c:v>
                </c:pt>
                <c:pt idx="293">
                  <c:v>6435.14990234375</c:v>
                </c:pt>
                <c:pt idx="294">
                  <c:v>6542.68359375</c:v>
                </c:pt>
                <c:pt idx="295">
                  <c:v>6632.13427734375</c:v>
                </c:pt>
                <c:pt idx="296">
                  <c:v>6656.86767578125</c:v>
                </c:pt>
                <c:pt idx="297">
                  <c:v>6620.9033203125</c:v>
                </c:pt>
                <c:pt idx="298">
                  <c:v>6573.14013671875</c:v>
                </c:pt>
                <c:pt idx="299">
                  <c:v>6568.5703125</c:v>
                </c:pt>
                <c:pt idx="300">
                  <c:v>6624.96533203125</c:v>
                </c:pt>
                <c:pt idx="301">
                  <c:v>6707.4873046875</c:v>
                </c:pt>
                <c:pt idx="302">
                  <c:v>6753.19189453125</c:v>
                </c:pt>
                <c:pt idx="303">
                  <c:v>6717.64599609375</c:v>
                </c:pt>
                <c:pt idx="304">
                  <c:v>6609.2392578125</c:v>
                </c:pt>
                <c:pt idx="305">
                  <c:v>6485.86181640625</c:v>
                </c:pt>
                <c:pt idx="306">
                  <c:v>6416.38818359375</c:v>
                </c:pt>
                <c:pt idx="307">
                  <c:v>6434.93017578125</c:v>
                </c:pt>
                <c:pt idx="308">
                  <c:v>6520.189453125</c:v>
                </c:pt>
                <c:pt idx="309">
                  <c:v>6613.01416015625</c:v>
                </c:pt>
                <c:pt idx="310">
                  <c:v>6657.58935546875</c:v>
                </c:pt>
                <c:pt idx="311">
                  <c:v>6636.22705078125</c:v>
                </c:pt>
                <c:pt idx="312">
                  <c:v>6574.89013671875</c:v>
                </c:pt>
                <c:pt idx="313">
                  <c:v>6519.33984375</c:v>
                </c:pt>
                <c:pt idx="314">
                  <c:v>6502.25244140625</c:v>
                </c:pt>
                <c:pt idx="315">
                  <c:v>6525.0947265625</c:v>
                </c:pt>
                <c:pt idx="316">
                  <c:v>6564.47998046875</c:v>
                </c:pt>
                <c:pt idx="317">
                  <c:v>6593.63134765625</c:v>
                </c:pt>
                <c:pt idx="318">
                  <c:v>6600.41162109375</c:v>
                </c:pt>
                <c:pt idx="319">
                  <c:v>6589.67724609375</c:v>
                </c:pt>
                <c:pt idx="320">
                  <c:v>6572.4091796875</c:v>
                </c:pt>
                <c:pt idx="321">
                  <c:v>6554.27392578125</c:v>
                </c:pt>
                <c:pt idx="322">
                  <c:v>6534.205078125</c:v>
                </c:pt>
                <c:pt idx="323">
                  <c:v>6512.43798828125</c:v>
                </c:pt>
                <c:pt idx="324">
                  <c:v>6497.822265625</c:v>
                </c:pt>
                <c:pt idx="325">
                  <c:v>6504.78955078125</c:v>
                </c:pt>
                <c:pt idx="326">
                  <c:v>6540.505859375</c:v>
                </c:pt>
                <c:pt idx="327">
                  <c:v>6593.24462890625</c:v>
                </c:pt>
                <c:pt idx="328">
                  <c:v>6634.18798828125</c:v>
                </c:pt>
                <c:pt idx="329">
                  <c:v>6634.783203125</c:v>
                </c:pt>
                <c:pt idx="330">
                  <c:v>6588.30859375</c:v>
                </c:pt>
                <c:pt idx="331">
                  <c:v>6518.7783203125</c:v>
                </c:pt>
                <c:pt idx="332">
                  <c:v>6468.1953125</c:v>
                </c:pt>
                <c:pt idx="333">
                  <c:v>6469.24267578125</c:v>
                </c:pt>
                <c:pt idx="334">
                  <c:v>6522.4619140625</c:v>
                </c:pt>
                <c:pt idx="335">
                  <c:v>6595.0498046875</c:v>
                </c:pt>
                <c:pt idx="336">
                  <c:v>6643.205078125</c:v>
                </c:pt>
                <c:pt idx="337">
                  <c:v>6642.50927734375</c:v>
                </c:pt>
                <c:pt idx="338">
                  <c:v>6604.35205078125</c:v>
                </c:pt>
                <c:pt idx="339">
                  <c:v>6566.26123046875</c:v>
                </c:pt>
                <c:pt idx="340">
                  <c:v>6563.14892578125</c:v>
                </c:pt>
                <c:pt idx="341">
                  <c:v>6600.74169921875</c:v>
                </c:pt>
                <c:pt idx="342">
                  <c:v>6650.9736328125</c:v>
                </c:pt>
                <c:pt idx="343">
                  <c:v>6672.849609375</c:v>
                </c:pt>
                <c:pt idx="344">
                  <c:v>6643.30810546875</c:v>
                </c:pt>
                <c:pt idx="345">
                  <c:v>6575.16845703125</c:v>
                </c:pt>
                <c:pt idx="346">
                  <c:v>6508.90478515625</c:v>
                </c:pt>
                <c:pt idx="347">
                  <c:v>6484.43115234375</c:v>
                </c:pt>
                <c:pt idx="348">
                  <c:v>6513.66259765625</c:v>
                </c:pt>
                <c:pt idx="349">
                  <c:v>6573.572265625</c:v>
                </c:pt>
              </c:numCache>
            </c:numRef>
          </c:yVal>
          <c:smooth val="1"/>
          <c:extLst>
            <c:ext xmlns:c16="http://schemas.microsoft.com/office/drawing/2014/chart" uri="{C3380CC4-5D6E-409C-BE32-E72D297353CC}">
              <c16:uniqueId val="{00000006-5429-4359-BD11-807CF8F8408D}"/>
            </c:ext>
          </c:extLst>
        </c:ser>
        <c:ser>
          <c:idx val="7"/>
          <c:order val="7"/>
          <c:tx>
            <c:strRef>
              <c:f>np_sub_003!$H$1</c:f>
              <c:strCache>
                <c:ptCount val="1"/>
                <c:pt idx="0">
                  <c:v>Coor_8</c:v>
                </c:pt>
              </c:strCache>
            </c:strRef>
          </c:tx>
          <c:spPr>
            <a:ln w="28575" cap="rnd">
              <a:solidFill>
                <a:schemeClr val="accent2">
                  <a:lumMod val="60000"/>
                </a:schemeClr>
              </a:solidFill>
              <a:round/>
            </a:ln>
            <a:effectLst/>
          </c:spPr>
          <c:marker>
            <c:symbol val="none"/>
          </c:marker>
          <c:yVal>
            <c:numRef>
              <c:f>np_sub_003!$H$2:$H$351</c:f>
              <c:numCache>
                <c:formatCode>0.00000000000_ </c:formatCode>
                <c:ptCount val="350"/>
                <c:pt idx="0">
                  <c:v>7432.98291015625</c:v>
                </c:pt>
                <c:pt idx="1">
                  <c:v>7439.4814453125</c:v>
                </c:pt>
                <c:pt idx="2">
                  <c:v>7476.40380859375</c:v>
                </c:pt>
                <c:pt idx="3">
                  <c:v>7517.05712890625</c:v>
                </c:pt>
                <c:pt idx="4">
                  <c:v>7530.47314453125</c:v>
                </c:pt>
                <c:pt idx="5">
                  <c:v>7505.060546875</c:v>
                </c:pt>
                <c:pt idx="6">
                  <c:v>7456.90380859375</c:v>
                </c:pt>
                <c:pt idx="7">
                  <c:v>7417.22265625</c:v>
                </c:pt>
                <c:pt idx="8">
                  <c:v>7410.29541015625</c:v>
                </c:pt>
                <c:pt idx="9">
                  <c:v>7439.26318359375</c:v>
                </c:pt>
                <c:pt idx="10">
                  <c:v>7488.60009765625</c:v>
                </c:pt>
                <c:pt idx="11">
                  <c:v>7537.52734375</c:v>
                </c:pt>
                <c:pt idx="12">
                  <c:v>7571.4052734375</c:v>
                </c:pt>
                <c:pt idx="13">
                  <c:v>7583.509765625</c:v>
                </c:pt>
                <c:pt idx="14">
                  <c:v>7570.8310546875</c:v>
                </c:pt>
                <c:pt idx="15">
                  <c:v>7532.91552734375</c:v>
                </c:pt>
                <c:pt idx="16">
                  <c:v>7477.24169921875</c:v>
                </c:pt>
                <c:pt idx="17">
                  <c:v>7424.4453125</c:v>
                </c:pt>
                <c:pt idx="18">
                  <c:v>7403.30615234375</c:v>
                </c:pt>
                <c:pt idx="19">
                  <c:v>7433.6904296875</c:v>
                </c:pt>
                <c:pt idx="20">
                  <c:v>7508.65869140625</c:v>
                </c:pt>
                <c:pt idx="21">
                  <c:v>7591.7861328125</c:v>
                </c:pt>
                <c:pt idx="22">
                  <c:v>7636.04638671875</c:v>
                </c:pt>
                <c:pt idx="23">
                  <c:v>7613.2265625</c:v>
                </c:pt>
                <c:pt idx="24">
                  <c:v>7532.7529296875</c:v>
                </c:pt>
                <c:pt idx="25">
                  <c:v>7435.60107421875</c:v>
                </c:pt>
                <c:pt idx="26">
                  <c:v>7367.85498046875</c:v>
                </c:pt>
                <c:pt idx="27">
                  <c:v>7353.76318359375</c:v>
                </c:pt>
                <c:pt idx="28">
                  <c:v>7387.0712890625</c:v>
                </c:pt>
                <c:pt idx="29">
                  <c:v>7443.33935546875</c:v>
                </c:pt>
                <c:pt idx="30">
                  <c:v>7499.36181640625</c:v>
                </c:pt>
                <c:pt idx="31">
                  <c:v>7542.98046875</c:v>
                </c:pt>
                <c:pt idx="32">
                  <c:v>7568.9013671875</c:v>
                </c:pt>
                <c:pt idx="33">
                  <c:v>7570.86865234375</c:v>
                </c:pt>
                <c:pt idx="34">
                  <c:v>7543.07080078125</c:v>
                </c:pt>
                <c:pt idx="35">
                  <c:v>7491.595703125</c:v>
                </c:pt>
                <c:pt idx="36">
                  <c:v>7442.435546875</c:v>
                </c:pt>
                <c:pt idx="37">
                  <c:v>7431.634765625</c:v>
                </c:pt>
                <c:pt idx="38">
                  <c:v>7478.9189453125</c:v>
                </c:pt>
                <c:pt idx="39">
                  <c:v>7564.92138671875</c:v>
                </c:pt>
                <c:pt idx="40">
                  <c:v>7635.080078125</c:v>
                </c:pt>
                <c:pt idx="41">
                  <c:v>7634.15576171875</c:v>
                </c:pt>
                <c:pt idx="42">
                  <c:v>7548.41552734375</c:v>
                </c:pt>
                <c:pt idx="43">
                  <c:v>7421.54296875</c:v>
                </c:pt>
                <c:pt idx="44">
                  <c:v>7327.6708984375</c:v>
                </c:pt>
                <c:pt idx="45">
                  <c:v>7318.86767578125</c:v>
                </c:pt>
                <c:pt idx="46">
                  <c:v>7387.12890625</c:v>
                </c:pt>
                <c:pt idx="47">
                  <c:v>7471.8955078125</c:v>
                </c:pt>
                <c:pt idx="48">
                  <c:v>7508.533203125</c:v>
                </c:pt>
                <c:pt idx="49">
                  <c:v>7479.48583984375</c:v>
                </c:pt>
                <c:pt idx="50">
                  <c:v>7426.5009765625</c:v>
                </c:pt>
                <c:pt idx="51">
                  <c:v>7413.45068359375</c:v>
                </c:pt>
                <c:pt idx="52">
                  <c:v>7470.06005859375</c:v>
                </c:pt>
                <c:pt idx="53">
                  <c:v>7563.38037109375</c:v>
                </c:pt>
                <c:pt idx="54">
                  <c:v>7621.744140625</c:v>
                </c:pt>
                <c:pt idx="55">
                  <c:v>7592.81640625</c:v>
                </c:pt>
                <c:pt idx="56">
                  <c:v>7488.74462890625</c:v>
                </c:pt>
                <c:pt idx="57">
                  <c:v>7381.125</c:v>
                </c:pt>
                <c:pt idx="58">
                  <c:v>7348.7626953125</c:v>
                </c:pt>
                <c:pt idx="59">
                  <c:v>7418.98095703125</c:v>
                </c:pt>
                <c:pt idx="60">
                  <c:v>7547.9091796875</c:v>
                </c:pt>
                <c:pt idx="61">
                  <c:v>7653.6162109375</c:v>
                </c:pt>
                <c:pt idx="62">
                  <c:v>7674.71142578125</c:v>
                </c:pt>
                <c:pt idx="63">
                  <c:v>7609.3759765625</c:v>
                </c:pt>
                <c:pt idx="64">
                  <c:v>7508.40087890625</c:v>
                </c:pt>
                <c:pt idx="65">
                  <c:v>7433.19189453125</c:v>
                </c:pt>
                <c:pt idx="66">
                  <c:v>7414.5576171875</c:v>
                </c:pt>
                <c:pt idx="67">
                  <c:v>7441.8212890625</c:v>
                </c:pt>
                <c:pt idx="68">
                  <c:v>7483.24658203125</c:v>
                </c:pt>
                <c:pt idx="69">
                  <c:v>7514.14404296875</c:v>
                </c:pt>
                <c:pt idx="70">
                  <c:v>7528.4404296875</c:v>
                </c:pt>
                <c:pt idx="71">
                  <c:v>7529.8046875</c:v>
                </c:pt>
                <c:pt idx="72">
                  <c:v>7518.43310546875</c:v>
                </c:pt>
                <c:pt idx="73">
                  <c:v>7490.5146484375</c:v>
                </c:pt>
                <c:pt idx="74">
                  <c:v>7450.2705078125</c:v>
                </c:pt>
                <c:pt idx="75">
                  <c:v>7417.99462890625</c:v>
                </c:pt>
                <c:pt idx="76">
                  <c:v>7419.5185546875</c:v>
                </c:pt>
                <c:pt idx="77">
                  <c:v>7462.05224609375</c:v>
                </c:pt>
                <c:pt idx="78">
                  <c:v>7519.1455078125</c:v>
                </c:pt>
                <c:pt idx="79">
                  <c:v>7544.208984375</c:v>
                </c:pt>
                <c:pt idx="80">
                  <c:v>7507.5439453125</c:v>
                </c:pt>
                <c:pt idx="81">
                  <c:v>7427.34619140625</c:v>
                </c:pt>
                <c:pt idx="82">
                  <c:v>7364.62060546875</c:v>
                </c:pt>
                <c:pt idx="83">
                  <c:v>7379.57958984375</c:v>
                </c:pt>
                <c:pt idx="84">
                  <c:v>7481.1904296875</c:v>
                </c:pt>
                <c:pt idx="85">
                  <c:v>7611.95703125</c:v>
                </c:pt>
                <c:pt idx="86">
                  <c:v>7684.92431640625</c:v>
                </c:pt>
                <c:pt idx="87">
                  <c:v>7647.640625</c:v>
                </c:pt>
                <c:pt idx="88">
                  <c:v>7523.455078125</c:v>
                </c:pt>
                <c:pt idx="89">
                  <c:v>7395.96044921875</c:v>
                </c:pt>
                <c:pt idx="90">
                  <c:v>7346.94970703125</c:v>
                </c:pt>
                <c:pt idx="91">
                  <c:v>7396.08740234375</c:v>
                </c:pt>
                <c:pt idx="92">
                  <c:v>7489.94580078125</c:v>
                </c:pt>
                <c:pt idx="93">
                  <c:v>7548.599609375</c:v>
                </c:pt>
                <c:pt idx="94">
                  <c:v>7531.4892578125</c:v>
                </c:pt>
                <c:pt idx="95">
                  <c:v>7468.82421875</c:v>
                </c:pt>
                <c:pt idx="96">
                  <c:v>7433.330078125</c:v>
                </c:pt>
                <c:pt idx="97">
                  <c:v>7476.1630859375</c:v>
                </c:pt>
                <c:pt idx="98">
                  <c:v>7580.13134765625</c:v>
                </c:pt>
                <c:pt idx="99">
                  <c:v>7669.07568359375</c:v>
                </c:pt>
                <c:pt idx="100">
                  <c:v>7666.42919921875</c:v>
                </c:pt>
                <c:pt idx="101">
                  <c:v>7556.29443359375</c:v>
                </c:pt>
                <c:pt idx="102">
                  <c:v>7398.73193359375</c:v>
                </c:pt>
                <c:pt idx="103">
                  <c:v>7287.75244140625</c:v>
                </c:pt>
                <c:pt idx="104">
                  <c:v>7285.1533203125</c:v>
                </c:pt>
                <c:pt idx="105">
                  <c:v>7380.275390625</c:v>
                </c:pt>
                <c:pt idx="106">
                  <c:v>7503.13232421875</c:v>
                </c:pt>
                <c:pt idx="107">
                  <c:v>7576.60400390625</c:v>
                </c:pt>
                <c:pt idx="108">
                  <c:v>7566.298828125</c:v>
                </c:pt>
                <c:pt idx="109">
                  <c:v>7493.88037109375</c:v>
                </c:pt>
                <c:pt idx="110">
                  <c:v>7411.51708984375</c:v>
                </c:pt>
                <c:pt idx="111">
                  <c:v>7363.6884765625</c:v>
                </c:pt>
                <c:pt idx="112">
                  <c:v>7365.88818359375</c:v>
                </c:pt>
                <c:pt idx="113">
                  <c:v>7409.3828125</c:v>
                </c:pt>
                <c:pt idx="114">
                  <c:v>7478.07080078125</c:v>
                </c:pt>
                <c:pt idx="115">
                  <c:v>7557.8896484375</c:v>
                </c:pt>
                <c:pt idx="116">
                  <c:v>7633.09423828125</c:v>
                </c:pt>
                <c:pt idx="117">
                  <c:v>7680.80712890625</c:v>
                </c:pt>
                <c:pt idx="118">
                  <c:v>7677.76220703125</c:v>
                </c:pt>
                <c:pt idx="119">
                  <c:v>7618.71533203125</c:v>
                </c:pt>
                <c:pt idx="120">
                  <c:v>7529.6572265625</c:v>
                </c:pt>
                <c:pt idx="121">
                  <c:v>7458.3955078125</c:v>
                </c:pt>
                <c:pt idx="122">
                  <c:v>7443.34130859375</c:v>
                </c:pt>
                <c:pt idx="123">
                  <c:v>7482.9287109375</c:v>
                </c:pt>
                <c:pt idx="124">
                  <c:v>7532.419921875</c:v>
                </c:pt>
                <c:pt idx="125">
                  <c:v>7535.38427734375</c:v>
                </c:pt>
                <c:pt idx="126">
                  <c:v>7468.47265625</c:v>
                </c:pt>
                <c:pt idx="127">
                  <c:v>7364.47900390625</c:v>
                </c:pt>
                <c:pt idx="128">
                  <c:v>7293.17333984375</c:v>
                </c:pt>
                <c:pt idx="129">
                  <c:v>7311.833984375</c:v>
                </c:pt>
                <c:pt idx="130">
                  <c:v>7422.02001953125</c:v>
                </c:pt>
                <c:pt idx="131">
                  <c:v>7565.58251953125</c:v>
                </c:pt>
                <c:pt idx="132">
                  <c:v>7663.37646484375</c:v>
                </c:pt>
                <c:pt idx="133">
                  <c:v>7667.869140625</c:v>
                </c:pt>
                <c:pt idx="134">
                  <c:v>7591.18408203125</c:v>
                </c:pt>
                <c:pt idx="135">
                  <c:v>7490.109375</c:v>
                </c:pt>
                <c:pt idx="136">
                  <c:v>7422.67919921875</c:v>
                </c:pt>
                <c:pt idx="137">
                  <c:v>7410.7119140625</c:v>
                </c:pt>
                <c:pt idx="138">
                  <c:v>7434.7099609375</c:v>
                </c:pt>
                <c:pt idx="139">
                  <c:v>7459.9287109375</c:v>
                </c:pt>
                <c:pt idx="140">
                  <c:v>7468.41259765625</c:v>
                </c:pt>
                <c:pt idx="141">
                  <c:v>7470.1865234375</c:v>
                </c:pt>
                <c:pt idx="142">
                  <c:v>7486.9580078125</c:v>
                </c:pt>
                <c:pt idx="143">
                  <c:v>7525.5771484375</c:v>
                </c:pt>
                <c:pt idx="144">
                  <c:v>7566.17919921875</c:v>
                </c:pt>
                <c:pt idx="145">
                  <c:v>7576.0615234375</c:v>
                </c:pt>
                <c:pt idx="146">
                  <c:v>7537.650390625</c:v>
                </c:pt>
                <c:pt idx="147">
                  <c:v>7466.61181640625</c:v>
                </c:pt>
                <c:pt idx="148">
                  <c:v>7404.10888671875</c:v>
                </c:pt>
                <c:pt idx="149">
                  <c:v>7388.18994140625</c:v>
                </c:pt>
                <c:pt idx="150">
                  <c:v>7426.0185546875</c:v>
                </c:pt>
                <c:pt idx="151">
                  <c:v>7488.00341796875</c:v>
                </c:pt>
                <c:pt idx="152">
                  <c:v>7528.10400390625</c:v>
                </c:pt>
                <c:pt idx="153">
                  <c:v>7515.35107421875</c:v>
                </c:pt>
                <c:pt idx="154">
                  <c:v>7454.36328125</c:v>
                </c:pt>
                <c:pt idx="155">
                  <c:v>7381.73046875</c:v>
                </c:pt>
                <c:pt idx="156">
                  <c:v>7342.41455078125</c:v>
                </c:pt>
                <c:pt idx="157">
                  <c:v>7362.8310546875</c:v>
                </c:pt>
                <c:pt idx="158">
                  <c:v>7437.205078125</c:v>
                </c:pt>
                <c:pt idx="159">
                  <c:v>7533.26513671875</c:v>
                </c:pt>
                <c:pt idx="160">
                  <c:v>7611.140625</c:v>
                </c:pt>
                <c:pt idx="161">
                  <c:v>7643.32666015625</c:v>
                </c:pt>
                <c:pt idx="162">
                  <c:v>7625.6748046875</c:v>
                </c:pt>
                <c:pt idx="163">
                  <c:v>7575.9853515625</c:v>
                </c:pt>
                <c:pt idx="164">
                  <c:v>7522.98876953125</c:v>
                </c:pt>
                <c:pt idx="165">
                  <c:v>7491.79248046875</c:v>
                </c:pt>
                <c:pt idx="166">
                  <c:v>7492.35595703125</c:v>
                </c:pt>
                <c:pt idx="167">
                  <c:v>7516.0546875</c:v>
                </c:pt>
                <c:pt idx="168">
                  <c:v>7542.09130859375</c:v>
                </c:pt>
                <c:pt idx="169">
                  <c:v>7550.72216796875</c:v>
                </c:pt>
                <c:pt idx="170">
                  <c:v>7535.8828125</c:v>
                </c:pt>
                <c:pt idx="171">
                  <c:v>7509.0517578125</c:v>
                </c:pt>
                <c:pt idx="172">
                  <c:v>7490.99072265625</c:v>
                </c:pt>
                <c:pt idx="173">
                  <c:v>7496.24755859375</c:v>
                </c:pt>
                <c:pt idx="174">
                  <c:v>7521.29150390625</c:v>
                </c:pt>
                <c:pt idx="175">
                  <c:v>7545.5771484375</c:v>
                </c:pt>
                <c:pt idx="176">
                  <c:v>7545.7900390625</c:v>
                </c:pt>
                <c:pt idx="177">
                  <c:v>7513.23486328125</c:v>
                </c:pt>
                <c:pt idx="178">
                  <c:v>7461.0673828125</c:v>
                </c:pt>
                <c:pt idx="179">
                  <c:v>7415.23583984375</c:v>
                </c:pt>
                <c:pt idx="180">
                  <c:v>7395.640625</c:v>
                </c:pt>
                <c:pt idx="181">
                  <c:v>7402.23291015625</c:v>
                </c:pt>
                <c:pt idx="182">
                  <c:v>7417.384765625</c:v>
                </c:pt>
                <c:pt idx="183">
                  <c:v>7422.86279296875</c:v>
                </c:pt>
                <c:pt idx="184">
                  <c:v>7417.349609375</c:v>
                </c:pt>
                <c:pt idx="185">
                  <c:v>7419.0537109375</c:v>
                </c:pt>
                <c:pt idx="186">
                  <c:v>7449.59521484375</c:v>
                </c:pt>
                <c:pt idx="187">
                  <c:v>7511.2294921875</c:v>
                </c:pt>
                <c:pt idx="188">
                  <c:v>7576.6435546875</c:v>
                </c:pt>
                <c:pt idx="189">
                  <c:v>7602.26513671875</c:v>
                </c:pt>
                <c:pt idx="190">
                  <c:v>7557.9296875</c:v>
                </c:pt>
                <c:pt idx="191">
                  <c:v>7451.751953125</c:v>
                </c:pt>
                <c:pt idx="192">
                  <c:v>7330.767578125</c:v>
                </c:pt>
                <c:pt idx="193">
                  <c:v>7254.880859375</c:v>
                </c:pt>
                <c:pt idx="194">
                  <c:v>7261.32421875</c:v>
                </c:pt>
                <c:pt idx="195">
                  <c:v>7344.02880859375</c:v>
                </c:pt>
                <c:pt idx="196">
                  <c:v>7461.345703125</c:v>
                </c:pt>
                <c:pt idx="197">
                  <c:v>7564.80322265625</c:v>
                </c:pt>
                <c:pt idx="198">
                  <c:v>7627.0859375</c:v>
                </c:pt>
                <c:pt idx="199">
                  <c:v>7650.08056640625</c:v>
                </c:pt>
                <c:pt idx="200">
                  <c:v>7650.9208984375</c:v>
                </c:pt>
                <c:pt idx="201">
                  <c:v>7641.2451171875</c:v>
                </c:pt>
                <c:pt idx="202">
                  <c:v>7618.4658203125</c:v>
                </c:pt>
                <c:pt idx="203">
                  <c:v>7575.47119140625</c:v>
                </c:pt>
                <c:pt idx="204">
                  <c:v>7517.76904296875</c:v>
                </c:pt>
                <c:pt idx="205">
                  <c:v>7469.85498046875</c:v>
                </c:pt>
                <c:pt idx="206">
                  <c:v>7461.85693359375</c:v>
                </c:pt>
                <c:pt idx="207">
                  <c:v>7505.50244140625</c:v>
                </c:pt>
                <c:pt idx="208">
                  <c:v>7579.5908203125</c:v>
                </c:pt>
                <c:pt idx="209">
                  <c:v>7639.275390625</c:v>
                </c:pt>
                <c:pt idx="210">
                  <c:v>7644.6875</c:v>
                </c:pt>
                <c:pt idx="211">
                  <c:v>7588.099609375</c:v>
                </c:pt>
                <c:pt idx="212">
                  <c:v>7498.82958984375</c:v>
                </c:pt>
                <c:pt idx="213">
                  <c:v>7422.0166015625</c:v>
                </c:pt>
                <c:pt idx="214">
                  <c:v>7387.74267578125</c:v>
                </c:pt>
                <c:pt idx="215">
                  <c:v>7394.076171875</c:v>
                </c:pt>
                <c:pt idx="216">
                  <c:v>7415.66650390625</c:v>
                </c:pt>
                <c:pt idx="217">
                  <c:v>7428.50830078125</c:v>
                </c:pt>
                <c:pt idx="218">
                  <c:v>7428.986328125</c:v>
                </c:pt>
                <c:pt idx="219">
                  <c:v>7431.6337890625</c:v>
                </c:pt>
                <c:pt idx="220">
                  <c:v>7449.45068359375</c:v>
                </c:pt>
                <c:pt idx="221">
                  <c:v>7476.2275390625</c:v>
                </c:pt>
                <c:pt idx="222">
                  <c:v>7488.3857421875</c:v>
                </c:pt>
                <c:pt idx="223">
                  <c:v>7465.9697265625</c:v>
                </c:pt>
                <c:pt idx="224">
                  <c:v>7414.24365234375</c:v>
                </c:pt>
                <c:pt idx="225">
                  <c:v>7365.23974609375</c:v>
                </c:pt>
                <c:pt idx="226">
                  <c:v>7355.22802734375</c:v>
                </c:pt>
                <c:pt idx="227">
                  <c:v>7395.54443359375</c:v>
                </c:pt>
                <c:pt idx="228">
                  <c:v>7461.6689453125</c:v>
                </c:pt>
                <c:pt idx="229">
                  <c:v>7511.40966796875</c:v>
                </c:pt>
                <c:pt idx="230">
                  <c:v>7518.61474609375</c:v>
                </c:pt>
                <c:pt idx="231">
                  <c:v>7494.63427734375</c:v>
                </c:pt>
                <c:pt idx="232">
                  <c:v>7478.74560546875</c:v>
                </c:pt>
                <c:pt idx="233">
                  <c:v>7504.25537109375</c:v>
                </c:pt>
                <c:pt idx="234">
                  <c:v>7568.0390625</c:v>
                </c:pt>
                <c:pt idx="235">
                  <c:v>7629.66748046875</c:v>
                </c:pt>
                <c:pt idx="236">
                  <c:v>7642.4775390625</c:v>
                </c:pt>
                <c:pt idx="237">
                  <c:v>7592.2470703125</c:v>
                </c:pt>
                <c:pt idx="238">
                  <c:v>7511.78955078125</c:v>
                </c:pt>
                <c:pt idx="239">
                  <c:v>7458.45361328125</c:v>
                </c:pt>
                <c:pt idx="240">
                  <c:v>7471.27978515625</c:v>
                </c:pt>
                <c:pt idx="241">
                  <c:v>7541.09814453125</c:v>
                </c:pt>
                <c:pt idx="242">
                  <c:v>7616.7109375</c:v>
                </c:pt>
                <c:pt idx="243">
                  <c:v>7641.853515625</c:v>
                </c:pt>
                <c:pt idx="244">
                  <c:v>7594.1357421875</c:v>
                </c:pt>
                <c:pt idx="245">
                  <c:v>7497.26806640625</c:v>
                </c:pt>
                <c:pt idx="246">
                  <c:v>7400.3349609375</c:v>
                </c:pt>
                <c:pt idx="247">
                  <c:v>7343.388671875</c:v>
                </c:pt>
                <c:pt idx="248">
                  <c:v>7336.45361328125</c:v>
                </c:pt>
                <c:pt idx="249">
                  <c:v>7364.41650390625</c:v>
                </c:pt>
                <c:pt idx="250">
                  <c:v>7407.49169921875</c:v>
                </c:pt>
                <c:pt idx="251">
                  <c:v>7456.076171875</c:v>
                </c:pt>
                <c:pt idx="252">
                  <c:v>7508.02197265625</c:v>
                </c:pt>
                <c:pt idx="253">
                  <c:v>7555.53369140625</c:v>
                </c:pt>
                <c:pt idx="254">
                  <c:v>7579.41943359375</c:v>
                </c:pt>
                <c:pt idx="255">
                  <c:v>7560.52978515625</c:v>
                </c:pt>
                <c:pt idx="256">
                  <c:v>7499.70703125</c:v>
                </c:pt>
                <c:pt idx="257">
                  <c:v>7426.4443359375</c:v>
                </c:pt>
                <c:pt idx="258">
                  <c:v>7384.19873046875</c:v>
                </c:pt>
                <c:pt idx="259">
                  <c:v>7400.8544921875</c:v>
                </c:pt>
                <c:pt idx="260">
                  <c:v>7467.67236328125</c:v>
                </c:pt>
                <c:pt idx="261">
                  <c:v>7544.97412109375</c:v>
                </c:pt>
                <c:pt idx="262">
                  <c:v>7591.1318359375</c:v>
                </c:pt>
                <c:pt idx="263">
                  <c:v>7591.673828125</c:v>
                </c:pt>
                <c:pt idx="264">
                  <c:v>7565.10107421875</c:v>
                </c:pt>
                <c:pt idx="265">
                  <c:v>7541.962890625</c:v>
                </c:pt>
                <c:pt idx="266">
                  <c:v>7536.646484375</c:v>
                </c:pt>
                <c:pt idx="267">
                  <c:v>7536.96337890625</c:v>
                </c:pt>
                <c:pt idx="268">
                  <c:v>7519.939453125</c:v>
                </c:pt>
                <c:pt idx="269">
                  <c:v>7478.07275390625</c:v>
                </c:pt>
                <c:pt idx="270">
                  <c:v>7430.5341796875</c:v>
                </c:pt>
                <c:pt idx="271">
                  <c:v>7407.57861328125</c:v>
                </c:pt>
                <c:pt idx="272">
                  <c:v>7421.66748046875</c:v>
                </c:pt>
                <c:pt idx="273">
                  <c:v>7452.5439453125</c:v>
                </c:pt>
                <c:pt idx="274">
                  <c:v>7462.35009765625</c:v>
                </c:pt>
                <c:pt idx="275">
                  <c:v>7429.83251953125</c:v>
                </c:pt>
                <c:pt idx="276">
                  <c:v>7373.6435546875</c:v>
                </c:pt>
                <c:pt idx="277">
                  <c:v>7341.8046875</c:v>
                </c:pt>
                <c:pt idx="278">
                  <c:v>7372.95849609375</c:v>
                </c:pt>
                <c:pt idx="279">
                  <c:v>7460.908203125</c:v>
                </c:pt>
                <c:pt idx="280">
                  <c:v>7553.8837890625</c:v>
                </c:pt>
                <c:pt idx="281">
                  <c:v>7592.3662109375</c:v>
                </c:pt>
                <c:pt idx="282">
                  <c:v>7556.5400390625</c:v>
                </c:pt>
                <c:pt idx="283">
                  <c:v>7484.5498046875</c:v>
                </c:pt>
                <c:pt idx="284">
                  <c:v>7445.03662109375</c:v>
                </c:pt>
                <c:pt idx="285">
                  <c:v>7484.36767578125</c:v>
                </c:pt>
                <c:pt idx="286">
                  <c:v>7589.92822265625</c:v>
                </c:pt>
                <c:pt idx="287">
                  <c:v>7698.359375</c:v>
                </c:pt>
                <c:pt idx="288">
                  <c:v>7741.8251953125</c:v>
                </c:pt>
                <c:pt idx="289">
                  <c:v>7695.7373046875</c:v>
                </c:pt>
                <c:pt idx="290">
                  <c:v>7591.80810546875</c:v>
                </c:pt>
                <c:pt idx="291">
                  <c:v>7489.45263671875</c:v>
                </c:pt>
                <c:pt idx="292">
                  <c:v>7431.4287109375</c:v>
                </c:pt>
                <c:pt idx="293">
                  <c:v>7419.330078125</c:v>
                </c:pt>
                <c:pt idx="294">
                  <c:v>7424.712890625</c:v>
                </c:pt>
                <c:pt idx="295">
                  <c:v>7420.921875</c:v>
                </c:pt>
                <c:pt idx="296">
                  <c:v>7405.5908203125</c:v>
                </c:pt>
                <c:pt idx="297">
                  <c:v>7395.86328125</c:v>
                </c:pt>
                <c:pt idx="298">
                  <c:v>7404.91796875</c:v>
                </c:pt>
                <c:pt idx="299">
                  <c:v>7424.91259765625</c:v>
                </c:pt>
                <c:pt idx="300">
                  <c:v>7433.6845703125</c:v>
                </c:pt>
                <c:pt idx="301">
                  <c:v>7418.70068359375</c:v>
                </c:pt>
                <c:pt idx="302">
                  <c:v>7394.39794921875</c:v>
                </c:pt>
                <c:pt idx="303">
                  <c:v>7394.3583984375</c:v>
                </c:pt>
                <c:pt idx="304">
                  <c:v>7442.8984375</c:v>
                </c:pt>
                <c:pt idx="305">
                  <c:v>7530.482421875</c:v>
                </c:pt>
                <c:pt idx="306">
                  <c:v>7615.533203125</c:v>
                </c:pt>
                <c:pt idx="307">
                  <c:v>7652.96240234375</c:v>
                </c:pt>
                <c:pt idx="308">
                  <c:v>7626.57763671875</c:v>
                </c:pt>
                <c:pt idx="309">
                  <c:v>7559.01611328125</c:v>
                </c:pt>
                <c:pt idx="310">
                  <c:v>7491.990234375</c:v>
                </c:pt>
                <c:pt idx="311">
                  <c:v>7454.57080078125</c:v>
                </c:pt>
                <c:pt idx="312">
                  <c:v>7446.134765625</c:v>
                </c:pt>
                <c:pt idx="313">
                  <c:v>7446.2939453125</c:v>
                </c:pt>
                <c:pt idx="314">
                  <c:v>7439.92529296875</c:v>
                </c:pt>
                <c:pt idx="315">
                  <c:v>7433.0830078125</c:v>
                </c:pt>
                <c:pt idx="316">
                  <c:v>7445.5556640625</c:v>
                </c:pt>
                <c:pt idx="317">
                  <c:v>7488.2978515625</c:v>
                </c:pt>
                <c:pt idx="318">
                  <c:v>7548.07763671875</c:v>
                </c:pt>
                <c:pt idx="319">
                  <c:v>7594.63525390625</c:v>
                </c:pt>
                <c:pt idx="320">
                  <c:v>7604.38037109375</c:v>
                </c:pt>
                <c:pt idx="321">
                  <c:v>7578.99169921875</c:v>
                </c:pt>
                <c:pt idx="322">
                  <c:v>7541.8974609375</c:v>
                </c:pt>
                <c:pt idx="323">
                  <c:v>7516.18408203125</c:v>
                </c:pt>
                <c:pt idx="324">
                  <c:v>7504.82763671875</c:v>
                </c:pt>
                <c:pt idx="325">
                  <c:v>7491.88671875</c:v>
                </c:pt>
                <c:pt idx="326">
                  <c:v>7463.18408203125</c:v>
                </c:pt>
                <c:pt idx="327">
                  <c:v>7425.783203125</c:v>
                </c:pt>
                <c:pt idx="328">
                  <c:v>7405.67138671875</c:v>
                </c:pt>
                <c:pt idx="329">
                  <c:v>7423.42138671875</c:v>
                </c:pt>
                <c:pt idx="330">
                  <c:v>7469.87646484375</c:v>
                </c:pt>
                <c:pt idx="331">
                  <c:v>7506.77978515625</c:v>
                </c:pt>
                <c:pt idx="332">
                  <c:v>7496.33935546875</c:v>
                </c:pt>
                <c:pt idx="333">
                  <c:v>7436.513671875</c:v>
                </c:pt>
                <c:pt idx="334">
                  <c:v>7370.1396484375</c:v>
                </c:pt>
                <c:pt idx="335">
                  <c:v>7355.66455078125</c:v>
                </c:pt>
                <c:pt idx="336">
                  <c:v>7420.00830078125</c:v>
                </c:pt>
                <c:pt idx="337">
                  <c:v>7531.89208984375</c:v>
                </c:pt>
                <c:pt idx="338">
                  <c:v>7620.07177734375</c:v>
                </c:pt>
                <c:pt idx="339">
                  <c:v>7625.1435546875</c:v>
                </c:pt>
                <c:pt idx="340">
                  <c:v>7545.20166015625</c:v>
                </c:pt>
                <c:pt idx="341">
                  <c:v>7438.8369140625</c:v>
                </c:pt>
                <c:pt idx="342">
                  <c:v>7382.1484375</c:v>
                </c:pt>
                <c:pt idx="343">
                  <c:v>7412.89306640625</c:v>
                </c:pt>
                <c:pt idx="344">
                  <c:v>7504.8583984375</c:v>
                </c:pt>
                <c:pt idx="345">
                  <c:v>7591.0283203125</c:v>
                </c:pt>
                <c:pt idx="346">
                  <c:v>7615.47314453125</c:v>
                </c:pt>
                <c:pt idx="347">
                  <c:v>7572.55029296875</c:v>
                </c:pt>
                <c:pt idx="348">
                  <c:v>7504.5263671875</c:v>
                </c:pt>
                <c:pt idx="349">
                  <c:v>7463.3701171875</c:v>
                </c:pt>
              </c:numCache>
            </c:numRef>
          </c:yVal>
          <c:smooth val="1"/>
          <c:extLst>
            <c:ext xmlns:c16="http://schemas.microsoft.com/office/drawing/2014/chart" uri="{C3380CC4-5D6E-409C-BE32-E72D297353CC}">
              <c16:uniqueId val="{00000007-5429-4359-BD11-807CF8F8408D}"/>
            </c:ext>
          </c:extLst>
        </c:ser>
        <c:ser>
          <c:idx val="8"/>
          <c:order val="8"/>
          <c:tx>
            <c:strRef>
              <c:f>np_sub_003!$I$1</c:f>
              <c:strCache>
                <c:ptCount val="1"/>
                <c:pt idx="0">
                  <c:v>Coor_9</c:v>
                </c:pt>
              </c:strCache>
            </c:strRef>
          </c:tx>
          <c:spPr>
            <a:ln w="28575" cap="rnd">
              <a:solidFill>
                <a:schemeClr val="accent3">
                  <a:lumMod val="60000"/>
                </a:schemeClr>
              </a:solidFill>
              <a:round/>
            </a:ln>
            <a:effectLst/>
          </c:spPr>
          <c:marker>
            <c:symbol val="none"/>
          </c:marker>
          <c:yVal>
            <c:numRef>
              <c:f>np_sub_003!$I$2:$I$351</c:f>
              <c:numCache>
                <c:formatCode>0.00000000000_ </c:formatCode>
                <c:ptCount val="350"/>
                <c:pt idx="0">
                  <c:v>7351.92578125</c:v>
                </c:pt>
                <c:pt idx="1">
                  <c:v>7358.93359375</c:v>
                </c:pt>
                <c:pt idx="2">
                  <c:v>7338.2958984375</c:v>
                </c:pt>
                <c:pt idx="3">
                  <c:v>7292.16259765625</c:v>
                </c:pt>
                <c:pt idx="4">
                  <c:v>7242.94384765625</c:v>
                </c:pt>
                <c:pt idx="5">
                  <c:v>7219.58154296875</c:v>
                </c:pt>
                <c:pt idx="6">
                  <c:v>7237.6767578125</c:v>
                </c:pt>
                <c:pt idx="7">
                  <c:v>7288.048828125</c:v>
                </c:pt>
                <c:pt idx="8">
                  <c:v>7342.5673828125</c:v>
                </c:pt>
                <c:pt idx="9">
                  <c:v>7373.2744140625</c:v>
                </c:pt>
                <c:pt idx="10">
                  <c:v>7370.74560546875</c:v>
                </c:pt>
                <c:pt idx="11">
                  <c:v>7348.22998046875</c:v>
                </c:pt>
                <c:pt idx="12">
                  <c:v>7329.076171875</c:v>
                </c:pt>
                <c:pt idx="13">
                  <c:v>7327.822265625</c:v>
                </c:pt>
                <c:pt idx="14">
                  <c:v>7339.97119140625</c:v>
                </c:pt>
                <c:pt idx="15">
                  <c:v>7348.21923828125</c:v>
                </c:pt>
                <c:pt idx="16">
                  <c:v>7339.46923828125</c:v>
                </c:pt>
                <c:pt idx="17">
                  <c:v>7318.14501953125</c:v>
                </c:pt>
                <c:pt idx="18">
                  <c:v>7304.21142578125</c:v>
                </c:pt>
                <c:pt idx="19">
                  <c:v>7316.84716796875</c:v>
                </c:pt>
                <c:pt idx="20">
                  <c:v>7356.791015625</c:v>
                </c:pt>
                <c:pt idx="21">
                  <c:v>7402.2646484375</c:v>
                </c:pt>
                <c:pt idx="22">
                  <c:v>7423.1123046875</c:v>
                </c:pt>
                <c:pt idx="23">
                  <c:v>7403.30419921875</c:v>
                </c:pt>
                <c:pt idx="24">
                  <c:v>7354.6376953125</c:v>
                </c:pt>
                <c:pt idx="25">
                  <c:v>7310.412109375</c:v>
                </c:pt>
                <c:pt idx="26">
                  <c:v>7302.76611328125</c:v>
                </c:pt>
                <c:pt idx="27">
                  <c:v>7339.923828125</c:v>
                </c:pt>
                <c:pt idx="28">
                  <c:v>7400.0791015625</c:v>
                </c:pt>
                <c:pt idx="29">
                  <c:v>7446.53857421875</c:v>
                </c:pt>
                <c:pt idx="30">
                  <c:v>7453.14404296875</c:v>
                </c:pt>
                <c:pt idx="31">
                  <c:v>7421.6005859375</c:v>
                </c:pt>
                <c:pt idx="32">
                  <c:v>7378.5126953125</c:v>
                </c:pt>
                <c:pt idx="33">
                  <c:v>7354.888671875</c:v>
                </c:pt>
                <c:pt idx="34">
                  <c:v>7363.35595703125</c:v>
                </c:pt>
                <c:pt idx="35">
                  <c:v>7389.39208984375</c:v>
                </c:pt>
                <c:pt idx="36">
                  <c:v>7402.25634765625</c:v>
                </c:pt>
                <c:pt idx="37">
                  <c:v>7377.21142578125</c:v>
                </c:pt>
                <c:pt idx="38">
                  <c:v>7313.29541015625</c:v>
                </c:pt>
                <c:pt idx="39">
                  <c:v>7234.9267578125</c:v>
                </c:pt>
                <c:pt idx="40">
                  <c:v>7177.24609375</c:v>
                </c:pt>
                <c:pt idx="41">
                  <c:v>7165.646484375</c:v>
                </c:pt>
                <c:pt idx="42">
                  <c:v>7202.47412109375</c:v>
                </c:pt>
                <c:pt idx="43">
                  <c:v>7267.83251953125</c:v>
                </c:pt>
                <c:pt idx="44">
                  <c:v>7332.06982421875</c:v>
                </c:pt>
                <c:pt idx="45">
                  <c:v>7371.306640625</c:v>
                </c:pt>
                <c:pt idx="46">
                  <c:v>7377.43408203125</c:v>
                </c:pt>
                <c:pt idx="47">
                  <c:v>7358.767578125</c:v>
                </c:pt>
                <c:pt idx="48">
                  <c:v>7333.0234375</c:v>
                </c:pt>
                <c:pt idx="49">
                  <c:v>7317.361328125</c:v>
                </c:pt>
                <c:pt idx="50">
                  <c:v>7320.3701171875</c:v>
                </c:pt>
                <c:pt idx="51">
                  <c:v>7339.18798828125</c:v>
                </c:pt>
                <c:pt idx="52">
                  <c:v>7362.61376953125</c:v>
                </c:pt>
                <c:pt idx="53">
                  <c:v>7378.52685546875</c:v>
                </c:pt>
                <c:pt idx="54">
                  <c:v>7381.65966796875</c:v>
                </c:pt>
                <c:pt idx="55">
                  <c:v>7376.89404296875</c:v>
                </c:pt>
                <c:pt idx="56">
                  <c:v>7375.201171875</c:v>
                </c:pt>
                <c:pt idx="57">
                  <c:v>7383.97509765625</c:v>
                </c:pt>
                <c:pt idx="58">
                  <c:v>7398.2451171875</c:v>
                </c:pt>
                <c:pt idx="59">
                  <c:v>7400.2509765625</c:v>
                </c:pt>
                <c:pt idx="60">
                  <c:v>7370.0859375</c:v>
                </c:pt>
                <c:pt idx="61">
                  <c:v>7301.94482421875</c:v>
                </c:pt>
                <c:pt idx="62">
                  <c:v>7214.68212890625</c:v>
                </c:pt>
                <c:pt idx="63">
                  <c:v>7147.173828125</c:v>
                </c:pt>
                <c:pt idx="64">
                  <c:v>7138.43115234375</c:v>
                </c:pt>
                <c:pt idx="65">
                  <c:v>7203.60107421875</c:v>
                </c:pt>
                <c:pt idx="66">
                  <c:v>7321.6142578125</c:v>
                </c:pt>
                <c:pt idx="67">
                  <c:v>7444.00537109375</c:v>
                </c:pt>
                <c:pt idx="68">
                  <c:v>7520.84521484375</c:v>
                </c:pt>
                <c:pt idx="69">
                  <c:v>7527.96435546875</c:v>
                </c:pt>
                <c:pt idx="70">
                  <c:v>7478.31982421875</c:v>
                </c:pt>
                <c:pt idx="71">
                  <c:v>7410.697265625</c:v>
                </c:pt>
                <c:pt idx="72">
                  <c:v>7363.9482421875</c:v>
                </c:pt>
                <c:pt idx="73">
                  <c:v>7354.12109375</c:v>
                </c:pt>
                <c:pt idx="74">
                  <c:v>7368.93212890625</c:v>
                </c:pt>
                <c:pt idx="75">
                  <c:v>7381.4765625</c:v>
                </c:pt>
                <c:pt idx="76">
                  <c:v>7372.01806640625</c:v>
                </c:pt>
                <c:pt idx="77">
                  <c:v>7342.193359375</c:v>
                </c:pt>
                <c:pt idx="78">
                  <c:v>7312.513671875</c:v>
                </c:pt>
                <c:pt idx="79">
                  <c:v>7306.26171875</c:v>
                </c:pt>
                <c:pt idx="80">
                  <c:v>7331.9033203125</c:v>
                </c:pt>
                <c:pt idx="81">
                  <c:v>7376.13623046875</c:v>
                </c:pt>
                <c:pt idx="82">
                  <c:v>7411.5947265625</c:v>
                </c:pt>
                <c:pt idx="83">
                  <c:v>7413.38525390625</c:v>
                </c:pt>
                <c:pt idx="84">
                  <c:v>7373.6494140625</c:v>
                </c:pt>
                <c:pt idx="85">
                  <c:v>7305.75390625</c:v>
                </c:pt>
                <c:pt idx="86">
                  <c:v>7236.79443359375</c:v>
                </c:pt>
                <c:pt idx="87">
                  <c:v>7193.73828125</c:v>
                </c:pt>
                <c:pt idx="88">
                  <c:v>7191.03662109375</c:v>
                </c:pt>
                <c:pt idx="89">
                  <c:v>7225.40478515625</c:v>
                </c:pt>
                <c:pt idx="90">
                  <c:v>7279.0751953125</c:v>
                </c:pt>
                <c:pt idx="91">
                  <c:v>7328.8642578125</c:v>
                </c:pt>
                <c:pt idx="92">
                  <c:v>7356.46826171875</c:v>
                </c:pt>
                <c:pt idx="93">
                  <c:v>7355.59912109375</c:v>
                </c:pt>
                <c:pt idx="94">
                  <c:v>7333.32421875</c:v>
                </c:pt>
                <c:pt idx="95">
                  <c:v>7305.50537109375</c:v>
                </c:pt>
                <c:pt idx="96">
                  <c:v>7288.794921875</c:v>
                </c:pt>
                <c:pt idx="97">
                  <c:v>7293.13427734375</c:v>
                </c:pt>
                <c:pt idx="98">
                  <c:v>7318.30126953125</c:v>
                </c:pt>
                <c:pt idx="99">
                  <c:v>7355.7099609375</c:v>
                </c:pt>
                <c:pt idx="100">
                  <c:v>7393.72802734375</c:v>
                </c:pt>
                <c:pt idx="101">
                  <c:v>7423.0380859375</c:v>
                </c:pt>
                <c:pt idx="102">
                  <c:v>7439.2236328125</c:v>
                </c:pt>
                <c:pt idx="103">
                  <c:v>7442.12939453125</c:v>
                </c:pt>
                <c:pt idx="104">
                  <c:v>7433.751953125</c:v>
                </c:pt>
                <c:pt idx="105">
                  <c:v>7416.79638671875</c:v>
                </c:pt>
                <c:pt idx="106">
                  <c:v>7394.58984375</c:v>
                </c:pt>
                <c:pt idx="107">
                  <c:v>7371.32373046875</c:v>
                </c:pt>
                <c:pt idx="108">
                  <c:v>7351.3212890625</c:v>
                </c:pt>
                <c:pt idx="109">
                  <c:v>7337.322265625</c:v>
                </c:pt>
                <c:pt idx="110">
                  <c:v>7329.2294921875</c:v>
                </c:pt>
                <c:pt idx="111">
                  <c:v>7324.72705078125</c:v>
                </c:pt>
                <c:pt idx="112">
                  <c:v>7321.42919921875</c:v>
                </c:pt>
                <c:pt idx="113">
                  <c:v>7318.51318359375</c:v>
                </c:pt>
                <c:pt idx="114">
                  <c:v>7315.98486328125</c:v>
                </c:pt>
                <c:pt idx="115">
                  <c:v>7312.0859375</c:v>
                </c:pt>
                <c:pt idx="116">
                  <c:v>7301.8369140625</c:v>
                </c:pt>
                <c:pt idx="117">
                  <c:v>7279.625</c:v>
                </c:pt>
                <c:pt idx="118">
                  <c:v>7245.4599609375</c:v>
                </c:pt>
                <c:pt idx="119">
                  <c:v>7210.36181640625</c:v>
                </c:pt>
                <c:pt idx="120">
                  <c:v>7195.130859375</c:v>
                </c:pt>
                <c:pt idx="121">
                  <c:v>7220.44970703125</c:v>
                </c:pt>
                <c:pt idx="122">
                  <c:v>7292.8798828125</c:v>
                </c:pt>
                <c:pt idx="123">
                  <c:v>7395.91748046875</c:v>
                </c:pt>
                <c:pt idx="124">
                  <c:v>7493.70068359375</c:v>
                </c:pt>
                <c:pt idx="125">
                  <c:v>7547.447265625</c:v>
                </c:pt>
                <c:pt idx="126">
                  <c:v>7535.974609375</c:v>
                </c:pt>
                <c:pt idx="127">
                  <c:v>7468.025390625</c:v>
                </c:pt>
                <c:pt idx="128">
                  <c:v>7378.4658203125</c:v>
                </c:pt>
                <c:pt idx="129">
                  <c:v>7310.11474609375</c:v>
                </c:pt>
                <c:pt idx="130">
                  <c:v>7291.67333984375</c:v>
                </c:pt>
                <c:pt idx="131">
                  <c:v>7324.2080078125</c:v>
                </c:pt>
                <c:pt idx="132">
                  <c:v>7383.029296875</c:v>
                </c:pt>
                <c:pt idx="133">
                  <c:v>7432.5361328125</c:v>
                </c:pt>
                <c:pt idx="134">
                  <c:v>7444.7666015625</c:v>
                </c:pt>
                <c:pt idx="135">
                  <c:v>7411.69384765625</c:v>
                </c:pt>
                <c:pt idx="136">
                  <c:v>7346.2265625</c:v>
                </c:pt>
                <c:pt idx="137">
                  <c:v>7273.53759765625</c:v>
                </c:pt>
                <c:pt idx="138">
                  <c:v>7218.69873046875</c:v>
                </c:pt>
                <c:pt idx="139">
                  <c:v>7196.8583984375</c:v>
                </c:pt>
                <c:pt idx="140">
                  <c:v>7209.4013671875</c:v>
                </c:pt>
                <c:pt idx="141">
                  <c:v>7246.033203125</c:v>
                </c:pt>
                <c:pt idx="142">
                  <c:v>7290.44970703125</c:v>
                </c:pt>
                <c:pt idx="143">
                  <c:v>7326.7763671875</c:v>
                </c:pt>
                <c:pt idx="144">
                  <c:v>7344.65380859375</c:v>
                </c:pt>
                <c:pt idx="145">
                  <c:v>7341.9111328125</c:v>
                </c:pt>
                <c:pt idx="146">
                  <c:v>7324.57373046875</c:v>
                </c:pt>
                <c:pt idx="147">
                  <c:v>7304.39404296875</c:v>
                </c:pt>
                <c:pt idx="148">
                  <c:v>7294.3837890625</c:v>
                </c:pt>
                <c:pt idx="149">
                  <c:v>7303.31396484375</c:v>
                </c:pt>
                <c:pt idx="150">
                  <c:v>7330.9658203125</c:v>
                </c:pt>
                <c:pt idx="151">
                  <c:v>7366.61474609375</c:v>
                </c:pt>
                <c:pt idx="152">
                  <c:v>7392.8486328125</c:v>
                </c:pt>
                <c:pt idx="153">
                  <c:v>7394.57421875</c:v>
                </c:pt>
                <c:pt idx="154">
                  <c:v>7369.40283203125</c:v>
                </c:pt>
                <c:pt idx="155">
                  <c:v>7332.88720703125</c:v>
                </c:pt>
                <c:pt idx="156">
                  <c:v>7313.07373046875</c:v>
                </c:pt>
                <c:pt idx="157">
                  <c:v>7334.65185546875</c:v>
                </c:pt>
                <c:pt idx="158">
                  <c:v>7400.810546875</c:v>
                </c:pt>
                <c:pt idx="159">
                  <c:v>7485.13720703125</c:v>
                </c:pt>
                <c:pt idx="160">
                  <c:v>7541.9384765625</c:v>
                </c:pt>
                <c:pt idx="161">
                  <c:v>7531.86279296875</c:v>
                </c:pt>
                <c:pt idx="162">
                  <c:v>7447.88720703125</c:v>
                </c:pt>
                <c:pt idx="163">
                  <c:v>7323.642578125</c:v>
                </c:pt>
                <c:pt idx="164">
                  <c:v>7215.98486328125</c:v>
                </c:pt>
                <c:pt idx="165">
                  <c:v>7171.1845703125</c:v>
                </c:pt>
                <c:pt idx="166">
                  <c:v>7196.90625</c:v>
                </c:pt>
                <c:pt idx="167">
                  <c:v>7259.765625</c:v>
                </c:pt>
                <c:pt idx="168">
                  <c:v>7310.8388671875</c:v>
                </c:pt>
                <c:pt idx="169">
                  <c:v>7321.03515625</c:v>
                </c:pt>
                <c:pt idx="170">
                  <c:v>7300.29052734375</c:v>
                </c:pt>
                <c:pt idx="171">
                  <c:v>7286.16650390625</c:v>
                </c:pt>
                <c:pt idx="172">
                  <c:v>7310.78466796875</c:v>
                </c:pt>
                <c:pt idx="173">
                  <c:v>7372.21533203125</c:v>
                </c:pt>
                <c:pt idx="174">
                  <c:v>7433.59814453125</c:v>
                </c:pt>
                <c:pt idx="175">
                  <c:v>7451.6123046875</c:v>
                </c:pt>
                <c:pt idx="176">
                  <c:v>7412.10400390625</c:v>
                </c:pt>
                <c:pt idx="177">
                  <c:v>7343.892578125</c:v>
                </c:pt>
                <c:pt idx="178">
                  <c:v>7298.306640625</c:v>
                </c:pt>
                <c:pt idx="179">
                  <c:v>7309.453125</c:v>
                </c:pt>
                <c:pt idx="180">
                  <c:v>7366.5966796875</c:v>
                </c:pt>
                <c:pt idx="181">
                  <c:v>7421.5</c:v>
                </c:pt>
                <c:pt idx="182">
                  <c:v>7426.05078125</c:v>
                </c:pt>
                <c:pt idx="183">
                  <c:v>7370.75830078125</c:v>
                </c:pt>
                <c:pt idx="184">
                  <c:v>7293.06787109375</c:v>
                </c:pt>
                <c:pt idx="185">
                  <c:v>7248.07568359375</c:v>
                </c:pt>
                <c:pt idx="186">
                  <c:v>7264.60400390625</c:v>
                </c:pt>
                <c:pt idx="187">
                  <c:v>7322.1044921875</c:v>
                </c:pt>
                <c:pt idx="188">
                  <c:v>7367.68896484375</c:v>
                </c:pt>
                <c:pt idx="189">
                  <c:v>7360.162109375</c:v>
                </c:pt>
                <c:pt idx="190">
                  <c:v>7305.39892578125</c:v>
                </c:pt>
                <c:pt idx="191">
                  <c:v>7253.46435546875</c:v>
                </c:pt>
                <c:pt idx="192">
                  <c:v>7258.404296875</c:v>
                </c:pt>
                <c:pt idx="193">
                  <c:v>7332.3212890625</c:v>
                </c:pt>
                <c:pt idx="194">
                  <c:v>7431.14599609375</c:v>
                </c:pt>
                <c:pt idx="195">
                  <c:v>7485.10107421875</c:v>
                </c:pt>
                <c:pt idx="196">
                  <c:v>7451.23974609375</c:v>
                </c:pt>
                <c:pt idx="197">
                  <c:v>7347.19677734375</c:v>
                </c:pt>
                <c:pt idx="198">
                  <c:v>7239.30126953125</c:v>
                </c:pt>
                <c:pt idx="199">
                  <c:v>7193.7724609375</c:v>
                </c:pt>
                <c:pt idx="200">
                  <c:v>7228.62744140625</c:v>
                </c:pt>
                <c:pt idx="201">
                  <c:v>7303.3154296875</c:v>
                </c:pt>
                <c:pt idx="202">
                  <c:v>7353.36962890625</c:v>
                </c:pt>
                <c:pt idx="203">
                  <c:v>7342.20263671875</c:v>
                </c:pt>
                <c:pt idx="204">
                  <c:v>7289.26904296875</c:v>
                </c:pt>
                <c:pt idx="205">
                  <c:v>7253.0166015625</c:v>
                </c:pt>
                <c:pt idx="206">
                  <c:v>7282.796875</c:v>
                </c:pt>
                <c:pt idx="207">
                  <c:v>7377.859375</c:v>
                </c:pt>
                <c:pt idx="208">
                  <c:v>7485.353515625</c:v>
                </c:pt>
                <c:pt idx="209">
                  <c:v>7538.45361328125</c:v>
                </c:pt>
                <c:pt idx="210">
                  <c:v>7504.96533203125</c:v>
                </c:pt>
                <c:pt idx="211">
                  <c:v>7409.712890625</c:v>
                </c:pt>
                <c:pt idx="212">
                  <c:v>7315.099609375</c:v>
                </c:pt>
                <c:pt idx="213">
                  <c:v>7276.0888671875</c:v>
                </c:pt>
                <c:pt idx="214">
                  <c:v>7303.73486328125</c:v>
                </c:pt>
                <c:pt idx="215">
                  <c:v>7362.72021484375</c:v>
                </c:pt>
                <c:pt idx="216">
                  <c:v>7401.52685546875</c:v>
                </c:pt>
                <c:pt idx="217">
                  <c:v>7390.37890625</c:v>
                </c:pt>
                <c:pt idx="218">
                  <c:v>7339.10302734375</c:v>
                </c:pt>
                <c:pt idx="219">
                  <c:v>7284.7744140625</c:v>
                </c:pt>
                <c:pt idx="220">
                  <c:v>7262.0390625</c:v>
                </c:pt>
                <c:pt idx="221">
                  <c:v>7279.7001953125</c:v>
                </c:pt>
                <c:pt idx="222">
                  <c:v>7319.1650390625</c:v>
                </c:pt>
                <c:pt idx="223">
                  <c:v>7352.1884765625</c:v>
                </c:pt>
                <c:pt idx="224">
                  <c:v>7361.91064453125</c:v>
                </c:pt>
                <c:pt idx="225">
                  <c:v>7351.703125</c:v>
                </c:pt>
                <c:pt idx="226">
                  <c:v>7338.07177734375</c:v>
                </c:pt>
                <c:pt idx="227">
                  <c:v>7336.06884765625</c:v>
                </c:pt>
                <c:pt idx="228">
                  <c:v>7349.17626953125</c:v>
                </c:pt>
                <c:pt idx="229">
                  <c:v>7369.61083984375</c:v>
                </c:pt>
                <c:pt idx="230">
                  <c:v>7386.03369140625</c:v>
                </c:pt>
                <c:pt idx="231">
                  <c:v>7391.22412109375</c:v>
                </c:pt>
                <c:pt idx="232">
                  <c:v>7384.56884765625</c:v>
                </c:pt>
                <c:pt idx="233">
                  <c:v>7369.6416015625</c:v>
                </c:pt>
                <c:pt idx="234">
                  <c:v>7350.53515625</c:v>
                </c:pt>
                <c:pt idx="235">
                  <c:v>7329.935546875</c:v>
                </c:pt>
                <c:pt idx="236">
                  <c:v>7309.20361328125</c:v>
                </c:pt>
                <c:pt idx="237">
                  <c:v>7289.15673828125</c:v>
                </c:pt>
                <c:pt idx="238">
                  <c:v>7270.74658203125</c:v>
                </c:pt>
                <c:pt idx="239">
                  <c:v>7255.873046875</c:v>
                </c:pt>
                <c:pt idx="240">
                  <c:v>7248.25927734375</c:v>
                </c:pt>
                <c:pt idx="241">
                  <c:v>7253.04931640625</c:v>
                </c:pt>
                <c:pt idx="242">
                  <c:v>7273.69482421875</c:v>
                </c:pt>
                <c:pt idx="243">
                  <c:v>7307.115234375</c:v>
                </c:pt>
                <c:pt idx="244">
                  <c:v>7341.20458984375</c:v>
                </c:pt>
                <c:pt idx="245">
                  <c:v>7359.0439453125</c:v>
                </c:pt>
                <c:pt idx="246">
                  <c:v>7349.68994140625</c:v>
                </c:pt>
                <c:pt idx="247">
                  <c:v>7318.96630859375</c:v>
                </c:pt>
                <c:pt idx="248">
                  <c:v>7290.91162109375</c:v>
                </c:pt>
                <c:pt idx="249">
                  <c:v>7295.39599609375</c:v>
                </c:pt>
                <c:pt idx="250">
                  <c:v>7347.6728515625</c:v>
                </c:pt>
                <c:pt idx="251">
                  <c:v>7433.65673828125</c:v>
                </c:pt>
                <c:pt idx="252">
                  <c:v>7513.1943359375</c:v>
                </c:pt>
                <c:pt idx="253">
                  <c:v>7542.06298828125</c:v>
                </c:pt>
                <c:pt idx="254">
                  <c:v>7499.58984375</c:v>
                </c:pt>
                <c:pt idx="255">
                  <c:v>7403.2197265625</c:v>
                </c:pt>
                <c:pt idx="256">
                  <c:v>7299.22607421875</c:v>
                </c:pt>
                <c:pt idx="257">
                  <c:v>7235.03173828125</c:v>
                </c:pt>
                <c:pt idx="258">
                  <c:v>7231.5546875</c:v>
                </c:pt>
                <c:pt idx="259">
                  <c:v>7273.9326171875</c:v>
                </c:pt>
                <c:pt idx="260">
                  <c:v>7325.771484375</c:v>
                </c:pt>
                <c:pt idx="261">
                  <c:v>7355.56298828125</c:v>
                </c:pt>
                <c:pt idx="262">
                  <c:v>7356.18408203125</c:v>
                </c:pt>
                <c:pt idx="263">
                  <c:v>7344.78857421875</c:v>
                </c:pt>
                <c:pt idx="264">
                  <c:v>7345.4375</c:v>
                </c:pt>
                <c:pt idx="265">
                  <c:v>7368.97802734375</c:v>
                </c:pt>
                <c:pt idx="266">
                  <c:v>7405.15869140625</c:v>
                </c:pt>
                <c:pt idx="267">
                  <c:v>7431.41552734375</c:v>
                </c:pt>
                <c:pt idx="268">
                  <c:v>7430.01318359375</c:v>
                </c:pt>
                <c:pt idx="269">
                  <c:v>7399.99658203125</c:v>
                </c:pt>
                <c:pt idx="270">
                  <c:v>7355.91943359375</c:v>
                </c:pt>
                <c:pt idx="271">
                  <c:v>7316.1806640625</c:v>
                </c:pt>
                <c:pt idx="272">
                  <c:v>7291.16259765625</c:v>
                </c:pt>
                <c:pt idx="273">
                  <c:v>7279.927734375</c:v>
                </c:pt>
                <c:pt idx="274">
                  <c:v>7276.17529296875</c:v>
                </c:pt>
                <c:pt idx="275">
                  <c:v>7276.6240234375</c:v>
                </c:pt>
                <c:pt idx="276">
                  <c:v>7284.01953125</c:v>
                </c:pt>
                <c:pt idx="277">
                  <c:v>7302.623046875</c:v>
                </c:pt>
                <c:pt idx="278">
                  <c:v>7331.06103515625</c:v>
                </c:pt>
                <c:pt idx="279">
                  <c:v>7359.70263671875</c:v>
                </c:pt>
                <c:pt idx="280">
                  <c:v>7375.6455078125</c:v>
                </c:pt>
                <c:pt idx="281">
                  <c:v>7371.59765625</c:v>
                </c:pt>
                <c:pt idx="282">
                  <c:v>7351.341796875</c:v>
                </c:pt>
                <c:pt idx="283">
                  <c:v>7327.02734375</c:v>
                </c:pt>
                <c:pt idx="284">
                  <c:v>7310.13916015625</c:v>
                </c:pt>
                <c:pt idx="285">
                  <c:v>7303.2138671875</c:v>
                </c:pt>
                <c:pt idx="286">
                  <c:v>7298.94677734375</c:v>
                </c:pt>
                <c:pt idx="287">
                  <c:v>7287.5517578125</c:v>
                </c:pt>
                <c:pt idx="288">
                  <c:v>7266.64501953125</c:v>
                </c:pt>
                <c:pt idx="289">
                  <c:v>7245.654296875</c:v>
                </c:pt>
                <c:pt idx="290">
                  <c:v>7240.697265625</c:v>
                </c:pt>
                <c:pt idx="291">
                  <c:v>7263.083984375</c:v>
                </c:pt>
                <c:pt idx="292">
                  <c:v>7309.73388671875</c:v>
                </c:pt>
                <c:pt idx="293">
                  <c:v>7362.9267578125</c:v>
                </c:pt>
                <c:pt idx="294">
                  <c:v>7400.4521484375</c:v>
                </c:pt>
                <c:pt idx="295">
                  <c:v>7409.759765625</c:v>
                </c:pt>
                <c:pt idx="296">
                  <c:v>7396.5224609375</c:v>
                </c:pt>
                <c:pt idx="297">
                  <c:v>7381.41845703125</c:v>
                </c:pt>
                <c:pt idx="298">
                  <c:v>7386.716796875</c:v>
                </c:pt>
                <c:pt idx="299">
                  <c:v>7421.19775390625</c:v>
                </c:pt>
                <c:pt idx="300">
                  <c:v>7473.220703125</c:v>
                </c:pt>
                <c:pt idx="301">
                  <c:v>7516.56396484375</c:v>
                </c:pt>
                <c:pt idx="302">
                  <c:v>7525.38671875</c:v>
                </c:pt>
                <c:pt idx="303">
                  <c:v>7488.90087890625</c:v>
                </c:pt>
                <c:pt idx="304">
                  <c:v>7416.875</c:v>
                </c:pt>
                <c:pt idx="305">
                  <c:v>7333.33935546875</c:v>
                </c:pt>
                <c:pt idx="306">
                  <c:v>7263.4267578125</c:v>
                </c:pt>
                <c:pt idx="307">
                  <c:v>7222.021484375</c:v>
                </c:pt>
                <c:pt idx="308">
                  <c:v>7210.4970703125</c:v>
                </c:pt>
                <c:pt idx="309">
                  <c:v>7221.5654296875</c:v>
                </c:pt>
                <c:pt idx="310">
                  <c:v>7246.81689453125</c:v>
                </c:pt>
                <c:pt idx="311">
                  <c:v>7280.8369140625</c:v>
                </c:pt>
                <c:pt idx="312">
                  <c:v>7319.7939453125</c:v>
                </c:pt>
                <c:pt idx="313">
                  <c:v>7357.525390625</c:v>
                </c:pt>
                <c:pt idx="314">
                  <c:v>7384.19384765625</c:v>
                </c:pt>
                <c:pt idx="315">
                  <c:v>7389.98876953125</c:v>
                </c:pt>
                <c:pt idx="316">
                  <c:v>7371.5341796875</c:v>
                </c:pt>
                <c:pt idx="317">
                  <c:v>7335.77685546875</c:v>
                </c:pt>
                <c:pt idx="318">
                  <c:v>7297.66015625</c:v>
                </c:pt>
                <c:pt idx="319">
                  <c:v>7272.60693359375</c:v>
                </c:pt>
                <c:pt idx="320">
                  <c:v>7268.8427734375</c:v>
                </c:pt>
                <c:pt idx="321">
                  <c:v>7284.60400390625</c:v>
                </c:pt>
                <c:pt idx="322">
                  <c:v>7311.40478515625</c:v>
                </c:pt>
                <c:pt idx="323">
                  <c:v>7340.09130859375</c:v>
                </c:pt>
                <c:pt idx="324">
                  <c:v>7364.9755859375</c:v>
                </c:pt>
                <c:pt idx="325">
                  <c:v>7383.86767578125</c:v>
                </c:pt>
                <c:pt idx="326">
                  <c:v>7395.68310546875</c:v>
                </c:pt>
                <c:pt idx="327">
                  <c:v>7399.03564453125</c:v>
                </c:pt>
                <c:pt idx="328">
                  <c:v>7393.3740234375</c:v>
                </c:pt>
                <c:pt idx="329">
                  <c:v>7380.880859375</c:v>
                </c:pt>
                <c:pt idx="330">
                  <c:v>7366.04248046875</c:v>
                </c:pt>
                <c:pt idx="331">
                  <c:v>7352.05322265625</c:v>
                </c:pt>
                <c:pt idx="332">
                  <c:v>7337.0888671875</c:v>
                </c:pt>
                <c:pt idx="333">
                  <c:v>7314.94970703125</c:v>
                </c:pt>
                <c:pt idx="334">
                  <c:v>7281.45263671875</c:v>
                </c:pt>
                <c:pt idx="335">
                  <c:v>7242.34326171875</c:v>
                </c:pt>
                <c:pt idx="336">
                  <c:v>7215.353515625</c:v>
                </c:pt>
                <c:pt idx="337">
                  <c:v>7222.0078125</c:v>
                </c:pt>
                <c:pt idx="338">
                  <c:v>7272.66259765625</c:v>
                </c:pt>
                <c:pt idx="339">
                  <c:v>7355.0009765625</c:v>
                </c:pt>
                <c:pt idx="340">
                  <c:v>7435.90380859375</c:v>
                </c:pt>
                <c:pt idx="341">
                  <c:v>7478.16552734375</c:v>
                </c:pt>
                <c:pt idx="342">
                  <c:v>7462.60107421875</c:v>
                </c:pt>
                <c:pt idx="343">
                  <c:v>7400.8798828125</c:v>
                </c:pt>
                <c:pt idx="344">
                  <c:v>7329.61376953125</c:v>
                </c:pt>
                <c:pt idx="345">
                  <c:v>7288.6259765625</c:v>
                </c:pt>
                <c:pt idx="346">
                  <c:v>7297.318359375</c:v>
                </c:pt>
                <c:pt idx="347">
                  <c:v>7344.46875</c:v>
                </c:pt>
                <c:pt idx="348">
                  <c:v>7397.57958984375</c:v>
                </c:pt>
                <c:pt idx="349">
                  <c:v>7424.6357421875</c:v>
                </c:pt>
              </c:numCache>
            </c:numRef>
          </c:yVal>
          <c:smooth val="1"/>
          <c:extLst>
            <c:ext xmlns:c16="http://schemas.microsoft.com/office/drawing/2014/chart" uri="{C3380CC4-5D6E-409C-BE32-E72D297353CC}">
              <c16:uniqueId val="{00000008-5429-4359-BD11-807CF8F8408D}"/>
            </c:ext>
          </c:extLst>
        </c:ser>
        <c:ser>
          <c:idx val="9"/>
          <c:order val="9"/>
          <c:tx>
            <c:strRef>
              <c:f>np_sub_003!$J$1</c:f>
              <c:strCache>
                <c:ptCount val="1"/>
                <c:pt idx="0">
                  <c:v>Coor_10</c:v>
                </c:pt>
              </c:strCache>
            </c:strRef>
          </c:tx>
          <c:spPr>
            <a:ln w="28575" cap="rnd">
              <a:solidFill>
                <a:schemeClr val="accent4">
                  <a:lumMod val="60000"/>
                </a:schemeClr>
              </a:solidFill>
              <a:round/>
            </a:ln>
            <a:effectLst/>
          </c:spPr>
          <c:marker>
            <c:symbol val="none"/>
          </c:marker>
          <c:yVal>
            <c:numRef>
              <c:f>np_sub_003!$J$2:$J$351</c:f>
              <c:numCache>
                <c:formatCode>0.00000000000_ </c:formatCode>
                <c:ptCount val="350"/>
                <c:pt idx="0">
                  <c:v>6834.0380859375</c:v>
                </c:pt>
                <c:pt idx="1">
                  <c:v>6806.1923828125</c:v>
                </c:pt>
                <c:pt idx="2">
                  <c:v>6794.330078125</c:v>
                </c:pt>
                <c:pt idx="3">
                  <c:v>6815.5703125</c:v>
                </c:pt>
                <c:pt idx="4">
                  <c:v>6866.970703125</c:v>
                </c:pt>
                <c:pt idx="5">
                  <c:v>6927.1298828125</c:v>
                </c:pt>
                <c:pt idx="6">
                  <c:v>6971.74072265625</c:v>
                </c:pt>
                <c:pt idx="7">
                  <c:v>6990.0126953125</c:v>
                </c:pt>
                <c:pt idx="8">
                  <c:v>6988.548828125</c:v>
                </c:pt>
                <c:pt idx="9">
                  <c:v>6980.51513671875</c:v>
                </c:pt>
                <c:pt idx="10">
                  <c:v>6970.91357421875</c:v>
                </c:pt>
                <c:pt idx="11">
                  <c:v>6951.849609375</c:v>
                </c:pt>
                <c:pt idx="12">
                  <c:v>6912.1748046875</c:v>
                </c:pt>
                <c:pt idx="13">
                  <c:v>6852.26611328125</c:v>
                </c:pt>
                <c:pt idx="14">
                  <c:v>6789.39208984375</c:v>
                </c:pt>
                <c:pt idx="15">
                  <c:v>6747.1943359375</c:v>
                </c:pt>
                <c:pt idx="16">
                  <c:v>6737.35986328125</c:v>
                </c:pt>
                <c:pt idx="17">
                  <c:v>6749.556640625</c:v>
                </c:pt>
                <c:pt idx="18">
                  <c:v>6759.4833984375</c:v>
                </c:pt>
                <c:pt idx="19">
                  <c:v>6749.38232421875</c:v>
                </c:pt>
                <c:pt idx="20">
                  <c:v>6723.92529296875</c:v>
                </c:pt>
                <c:pt idx="21">
                  <c:v>6707.4130859375</c:v>
                </c:pt>
                <c:pt idx="22">
                  <c:v>6723.6767578125</c:v>
                </c:pt>
                <c:pt idx="23">
                  <c:v>6775.044921875</c:v>
                </c:pt>
                <c:pt idx="24">
                  <c:v>6838.22119140625</c:v>
                </c:pt>
                <c:pt idx="25">
                  <c:v>6881.208984375</c:v>
                </c:pt>
                <c:pt idx="26">
                  <c:v>6887.8447265625</c:v>
                </c:pt>
                <c:pt idx="27">
                  <c:v>6869.830078125</c:v>
                </c:pt>
                <c:pt idx="28">
                  <c:v>6856.23046875</c:v>
                </c:pt>
                <c:pt idx="29">
                  <c:v>6868.951171875</c:v>
                </c:pt>
                <c:pt idx="30">
                  <c:v>6904.328125</c:v>
                </c:pt>
                <c:pt idx="31">
                  <c:v>6935.9697265625</c:v>
                </c:pt>
                <c:pt idx="32">
                  <c:v>6936.58056640625</c:v>
                </c:pt>
                <c:pt idx="33">
                  <c:v>6900.99658203125</c:v>
                </c:pt>
                <c:pt idx="34">
                  <c:v>6851.72900390625</c:v>
                </c:pt>
                <c:pt idx="35">
                  <c:v>6822.466796875</c:v>
                </c:pt>
                <c:pt idx="36">
                  <c:v>6832.55419921875</c:v>
                </c:pt>
                <c:pt idx="37">
                  <c:v>6872.361328125</c:v>
                </c:pt>
                <c:pt idx="38">
                  <c:v>6910.6494140625</c:v>
                </c:pt>
                <c:pt idx="39">
                  <c:v>6917.96630859375</c:v>
                </c:pt>
                <c:pt idx="40">
                  <c:v>6888.31494140625</c:v>
                </c:pt>
                <c:pt idx="41">
                  <c:v>6843.376953125</c:v>
                </c:pt>
                <c:pt idx="42">
                  <c:v>6816.95166015625</c:v>
                </c:pt>
                <c:pt idx="43">
                  <c:v>6831.2958984375</c:v>
                </c:pt>
                <c:pt idx="44">
                  <c:v>6881.7431640625</c:v>
                </c:pt>
                <c:pt idx="45">
                  <c:v>6939.1845703125</c:v>
                </c:pt>
                <c:pt idx="46">
                  <c:v>6967.82763671875</c:v>
                </c:pt>
                <c:pt idx="47">
                  <c:v>6946.65380859375</c:v>
                </c:pt>
                <c:pt idx="48">
                  <c:v>6882.03125</c:v>
                </c:pt>
                <c:pt idx="49">
                  <c:v>6804.9306640625</c:v>
                </c:pt>
                <c:pt idx="50">
                  <c:v>6754.61865234375</c:v>
                </c:pt>
                <c:pt idx="51">
                  <c:v>6757.29296875</c:v>
                </c:pt>
                <c:pt idx="52">
                  <c:v>6810.60009765625</c:v>
                </c:pt>
                <c:pt idx="53">
                  <c:v>6882.7529296875</c:v>
                </c:pt>
                <c:pt idx="54">
                  <c:v>6928.337890625</c:v>
                </c:pt>
                <c:pt idx="55">
                  <c:v>6913.9013671875</c:v>
                </c:pt>
                <c:pt idx="56">
                  <c:v>6839.32421875</c:v>
                </c:pt>
                <c:pt idx="57">
                  <c:v>6741.07470703125</c:v>
                </c:pt>
                <c:pt idx="58">
                  <c:v>6672.85205078125</c:v>
                </c:pt>
                <c:pt idx="59">
                  <c:v>6673.6376953125</c:v>
                </c:pt>
                <c:pt idx="60">
                  <c:v>6743.1904296875</c:v>
                </c:pt>
                <c:pt idx="61">
                  <c:v>6842.12890625</c:v>
                </c:pt>
                <c:pt idx="62">
                  <c:v>6917.875</c:v>
                </c:pt>
                <c:pt idx="63">
                  <c:v>6939.26025390625</c:v>
                </c:pt>
                <c:pt idx="64">
                  <c:v>6915.3125</c:v>
                </c:pt>
                <c:pt idx="65">
                  <c:v>6884.443359375</c:v>
                </c:pt>
                <c:pt idx="66">
                  <c:v>6882.08837890625</c:v>
                </c:pt>
                <c:pt idx="67">
                  <c:v>6911.51611328125</c:v>
                </c:pt>
                <c:pt idx="68">
                  <c:v>6940.73193359375</c:v>
                </c:pt>
                <c:pt idx="69">
                  <c:v>6928.55419921875</c:v>
                </c:pt>
                <c:pt idx="70">
                  <c:v>6860.03759765625</c:v>
                </c:pt>
                <c:pt idx="71">
                  <c:v>6763.31982421875</c:v>
                </c:pt>
                <c:pt idx="72">
                  <c:v>6693.6064453125</c:v>
                </c:pt>
                <c:pt idx="73">
                  <c:v>6695.130859375</c:v>
                </c:pt>
                <c:pt idx="74">
                  <c:v>6769.10791015625</c:v>
                </c:pt>
                <c:pt idx="75">
                  <c:v>6871.533203125</c:v>
                </c:pt>
                <c:pt idx="76">
                  <c:v>6942.4169921875</c:v>
                </c:pt>
                <c:pt idx="77">
                  <c:v>6945.0078125</c:v>
                </c:pt>
                <c:pt idx="78">
                  <c:v>6887.2412109375</c:v>
                </c:pt>
                <c:pt idx="79">
                  <c:v>6812.10986328125</c:v>
                </c:pt>
                <c:pt idx="80">
                  <c:v>6766.75634765625</c:v>
                </c:pt>
                <c:pt idx="81">
                  <c:v>6773.88427734375</c:v>
                </c:pt>
                <c:pt idx="82">
                  <c:v>6824.0751953125</c:v>
                </c:pt>
                <c:pt idx="83">
                  <c:v>6889.6796875</c:v>
                </c:pt>
                <c:pt idx="84">
                  <c:v>6945.41552734375</c:v>
                </c:pt>
                <c:pt idx="85">
                  <c:v>6979.39111328125</c:v>
                </c:pt>
                <c:pt idx="86">
                  <c:v>6989.955078125</c:v>
                </c:pt>
                <c:pt idx="87">
                  <c:v>6976.89990234375</c:v>
                </c:pt>
                <c:pt idx="88">
                  <c:v>6938.6240234375</c:v>
                </c:pt>
                <c:pt idx="89">
                  <c:v>6878.36279296875</c:v>
                </c:pt>
                <c:pt idx="90">
                  <c:v>6811.51904296875</c:v>
                </c:pt>
                <c:pt idx="91">
                  <c:v>6763.43017578125</c:v>
                </c:pt>
                <c:pt idx="92">
                  <c:v>6755.40673828125</c:v>
                </c:pt>
                <c:pt idx="93">
                  <c:v>6788.814453125</c:v>
                </c:pt>
                <c:pt idx="94">
                  <c:v>6841.13134765625</c:v>
                </c:pt>
                <c:pt idx="95">
                  <c:v>6879.623046875</c:v>
                </c:pt>
                <c:pt idx="96">
                  <c:v>6883.90576171875</c:v>
                </c:pt>
                <c:pt idx="97">
                  <c:v>6860.3525390625</c:v>
                </c:pt>
                <c:pt idx="98">
                  <c:v>6836.5625</c:v>
                </c:pt>
                <c:pt idx="99">
                  <c:v>6839.31884765625</c:v>
                </c:pt>
                <c:pt idx="100">
                  <c:v>6872.61669921875</c:v>
                </c:pt>
                <c:pt idx="101">
                  <c:v>6912.7724609375</c:v>
                </c:pt>
                <c:pt idx="102">
                  <c:v>6924.802734375</c:v>
                </c:pt>
                <c:pt idx="103">
                  <c:v>6888.12548828125</c:v>
                </c:pt>
                <c:pt idx="104">
                  <c:v>6812.599609375</c:v>
                </c:pt>
                <c:pt idx="105">
                  <c:v>6733.26953125</c:v>
                </c:pt>
                <c:pt idx="106">
                  <c:v>6687.90478515625</c:v>
                </c:pt>
                <c:pt idx="107">
                  <c:v>6693.61328125</c:v>
                </c:pt>
                <c:pt idx="108">
                  <c:v>6738.5947265625</c:v>
                </c:pt>
                <c:pt idx="109">
                  <c:v>6793.4267578125</c:v>
                </c:pt>
                <c:pt idx="110">
                  <c:v>6832.337890625</c:v>
                </c:pt>
                <c:pt idx="111">
                  <c:v>6848.85986328125</c:v>
                </c:pt>
                <c:pt idx="112">
                  <c:v>6855.74462890625</c:v>
                </c:pt>
                <c:pt idx="113">
                  <c:v>6871.09130859375</c:v>
                </c:pt>
                <c:pt idx="114">
                  <c:v>6902.15966796875</c:v>
                </c:pt>
                <c:pt idx="115">
                  <c:v>6938.8876953125</c:v>
                </c:pt>
                <c:pt idx="116">
                  <c:v>6961.1787109375</c:v>
                </c:pt>
                <c:pt idx="117">
                  <c:v>6953.91796875</c:v>
                </c:pt>
                <c:pt idx="118">
                  <c:v>6918.56689453125</c:v>
                </c:pt>
                <c:pt idx="119">
                  <c:v>6873.13671875</c:v>
                </c:pt>
                <c:pt idx="120">
                  <c:v>6840.755859375</c:v>
                </c:pt>
                <c:pt idx="121">
                  <c:v>6834.837890625</c:v>
                </c:pt>
                <c:pt idx="122">
                  <c:v>6850.92626953125</c:v>
                </c:pt>
                <c:pt idx="123">
                  <c:v>6870.53466796875</c:v>
                </c:pt>
                <c:pt idx="124">
                  <c:v>6874.1875</c:v>
                </c:pt>
                <c:pt idx="125">
                  <c:v>6854.837890625</c:v>
                </c:pt>
                <c:pt idx="126">
                  <c:v>6822.7646484375</c:v>
                </c:pt>
                <c:pt idx="127">
                  <c:v>6798.8935546875</c:v>
                </c:pt>
                <c:pt idx="128">
                  <c:v>6801.17626953125</c:v>
                </c:pt>
                <c:pt idx="129">
                  <c:v>6833.10595703125</c:v>
                </c:pt>
                <c:pt idx="130">
                  <c:v>6881.63818359375</c:v>
                </c:pt>
                <c:pt idx="131">
                  <c:v>6925.22216796875</c:v>
                </c:pt>
                <c:pt idx="132">
                  <c:v>6945.974609375</c:v>
                </c:pt>
                <c:pt idx="133">
                  <c:v>6937.94677734375</c:v>
                </c:pt>
                <c:pt idx="134">
                  <c:v>6907.11279296875</c:v>
                </c:pt>
                <c:pt idx="135">
                  <c:v>6865.0205078125</c:v>
                </c:pt>
                <c:pt idx="136">
                  <c:v>6822.0341796875</c:v>
                </c:pt>
                <c:pt idx="137">
                  <c:v>6784.91064453125</c:v>
                </c:pt>
                <c:pt idx="138">
                  <c:v>6758.61083984375</c:v>
                </c:pt>
                <c:pt idx="139">
                  <c:v>6748.24169921875</c:v>
                </c:pt>
                <c:pt idx="140">
                  <c:v>6757.45703125</c:v>
                </c:pt>
                <c:pt idx="141">
                  <c:v>6784.025390625</c:v>
                </c:pt>
                <c:pt idx="142">
                  <c:v>6817.353515625</c:v>
                </c:pt>
                <c:pt idx="143">
                  <c:v>6842.3544921875</c:v>
                </c:pt>
                <c:pt idx="144">
                  <c:v>6848.828125</c:v>
                </c:pt>
                <c:pt idx="145">
                  <c:v>6839.81884765625</c:v>
                </c:pt>
                <c:pt idx="146">
                  <c:v>6831.50537109375</c:v>
                </c:pt>
                <c:pt idx="147">
                  <c:v>6842.767578125</c:v>
                </c:pt>
                <c:pt idx="148">
                  <c:v>6880.73486328125</c:v>
                </c:pt>
                <c:pt idx="149">
                  <c:v>6932.81591796875</c:v>
                </c:pt>
                <c:pt idx="150">
                  <c:v>6972.005859375</c:v>
                </c:pt>
                <c:pt idx="151">
                  <c:v>6973.009765625</c:v>
                </c:pt>
                <c:pt idx="152">
                  <c:v>6928.72509765625</c:v>
                </c:pt>
                <c:pt idx="153">
                  <c:v>6856.02197265625</c:v>
                </c:pt>
                <c:pt idx="154">
                  <c:v>6787.00048828125</c:v>
                </c:pt>
                <c:pt idx="155">
                  <c:v>6751.58056640625</c:v>
                </c:pt>
                <c:pt idx="156">
                  <c:v>6762.37744140625</c:v>
                </c:pt>
                <c:pt idx="157">
                  <c:v>6810.23095703125</c:v>
                </c:pt>
                <c:pt idx="158">
                  <c:v>6871.236328125</c:v>
                </c:pt>
                <c:pt idx="159">
                  <c:v>6919.45263671875</c:v>
                </c:pt>
                <c:pt idx="160">
                  <c:v>6937.861328125</c:v>
                </c:pt>
                <c:pt idx="161">
                  <c:v>6923.23046875</c:v>
                </c:pt>
                <c:pt idx="162">
                  <c:v>6884.8076171875</c:v>
                </c:pt>
                <c:pt idx="163">
                  <c:v>6839.08154296875</c:v>
                </c:pt>
                <c:pt idx="164">
                  <c:v>6802.8984375</c:v>
                </c:pt>
                <c:pt idx="165">
                  <c:v>6786.79296875</c:v>
                </c:pt>
                <c:pt idx="166">
                  <c:v>6790.7607421875</c:v>
                </c:pt>
                <c:pt idx="167">
                  <c:v>6804.92626953125</c:v>
                </c:pt>
                <c:pt idx="168">
                  <c:v>6815.91455078125</c:v>
                </c:pt>
                <c:pt idx="169">
                  <c:v>6816.033203125</c:v>
                </c:pt>
                <c:pt idx="170">
                  <c:v>6809.3369140625</c:v>
                </c:pt>
                <c:pt idx="171">
                  <c:v>6809.51708984375</c:v>
                </c:pt>
                <c:pt idx="172">
                  <c:v>6829.97021484375</c:v>
                </c:pt>
                <c:pt idx="173">
                  <c:v>6872.60791015625</c:v>
                </c:pt>
                <c:pt idx="174">
                  <c:v>6923.82373046875</c:v>
                </c:pt>
                <c:pt idx="175">
                  <c:v>6961.27197265625</c:v>
                </c:pt>
                <c:pt idx="176">
                  <c:v>6967.04052734375</c:v>
                </c:pt>
                <c:pt idx="177">
                  <c:v>6937.90234375</c:v>
                </c:pt>
                <c:pt idx="178">
                  <c:v>6885.77197265625</c:v>
                </c:pt>
                <c:pt idx="179">
                  <c:v>6829.3056640625</c:v>
                </c:pt>
                <c:pt idx="180">
                  <c:v>6784.09912109375</c:v>
                </c:pt>
                <c:pt idx="181">
                  <c:v>6758.6298828125</c:v>
                </c:pt>
                <c:pt idx="182">
                  <c:v>6756.61181640625</c:v>
                </c:pt>
                <c:pt idx="183">
                  <c:v>6780.08447265625</c:v>
                </c:pt>
                <c:pt idx="184">
                  <c:v>6827.60693359375</c:v>
                </c:pt>
                <c:pt idx="185">
                  <c:v>6888.4697265625</c:v>
                </c:pt>
                <c:pt idx="186">
                  <c:v>6940.380859375</c:v>
                </c:pt>
                <c:pt idx="187">
                  <c:v>6957.40478515625</c:v>
                </c:pt>
                <c:pt idx="188">
                  <c:v>6926.17431640625</c:v>
                </c:pt>
                <c:pt idx="189">
                  <c:v>6858.8916015625</c:v>
                </c:pt>
                <c:pt idx="190">
                  <c:v>6790.71240234375</c:v>
                </c:pt>
                <c:pt idx="191">
                  <c:v>6759.60498046875</c:v>
                </c:pt>
                <c:pt idx="192">
                  <c:v>6781.18798828125</c:v>
                </c:pt>
                <c:pt idx="193">
                  <c:v>6837.212890625</c:v>
                </c:pt>
                <c:pt idx="194">
                  <c:v>6887.73486328125</c:v>
                </c:pt>
                <c:pt idx="195">
                  <c:v>6899.244140625</c:v>
                </c:pt>
                <c:pt idx="196">
                  <c:v>6868.1318359375</c:v>
                </c:pt>
                <c:pt idx="197">
                  <c:v>6821.8017578125</c:v>
                </c:pt>
                <c:pt idx="198">
                  <c:v>6796.8935546875</c:v>
                </c:pt>
                <c:pt idx="199">
                  <c:v>6811.86279296875</c:v>
                </c:pt>
                <c:pt idx="200">
                  <c:v>6855.10595703125</c:v>
                </c:pt>
                <c:pt idx="201">
                  <c:v>6896.70068359375</c:v>
                </c:pt>
                <c:pt idx="202">
                  <c:v>6912.6123046875</c:v>
                </c:pt>
                <c:pt idx="203">
                  <c:v>6900.97265625</c:v>
                </c:pt>
                <c:pt idx="204">
                  <c:v>6878.20361328125</c:v>
                </c:pt>
                <c:pt idx="205">
                  <c:v>6860.8212890625</c:v>
                </c:pt>
                <c:pt idx="206">
                  <c:v>6850.83349609375</c:v>
                </c:pt>
                <c:pt idx="207">
                  <c:v>6838.1767578125</c:v>
                </c:pt>
                <c:pt idx="208">
                  <c:v>6816.9091796875</c:v>
                </c:pt>
                <c:pt idx="209">
                  <c:v>6798.18408203125</c:v>
                </c:pt>
                <c:pt idx="210">
                  <c:v>6805.142578125</c:v>
                </c:pt>
                <c:pt idx="211">
                  <c:v>6851.56689453125</c:v>
                </c:pt>
                <c:pt idx="212">
                  <c:v>6922.666015625</c:v>
                </c:pt>
                <c:pt idx="213">
                  <c:v>6977.28515625</c:v>
                </c:pt>
                <c:pt idx="214">
                  <c:v>6974.00634765625</c:v>
                </c:pt>
                <c:pt idx="215">
                  <c:v>6902.615234375</c:v>
                </c:pt>
                <c:pt idx="216">
                  <c:v>6795.60302734375</c:v>
                </c:pt>
                <c:pt idx="217">
                  <c:v>6708.67919921875</c:v>
                </c:pt>
                <c:pt idx="218">
                  <c:v>6683.74609375</c:v>
                </c:pt>
                <c:pt idx="219">
                  <c:v>6722.2841796875</c:v>
                </c:pt>
                <c:pt idx="220">
                  <c:v>6789.119140625</c:v>
                </c:pt>
                <c:pt idx="221">
                  <c:v>6842.291015625</c:v>
                </c:pt>
                <c:pt idx="222">
                  <c:v>6864.12353515625</c:v>
                </c:pt>
                <c:pt idx="223">
                  <c:v>6868.7001953125</c:v>
                </c:pt>
                <c:pt idx="224">
                  <c:v>6881.5341796875</c:v>
                </c:pt>
                <c:pt idx="225">
                  <c:v>6910.8359375</c:v>
                </c:pt>
                <c:pt idx="226">
                  <c:v>6936.4931640625</c:v>
                </c:pt>
                <c:pt idx="227">
                  <c:v>6927.0556640625</c:v>
                </c:pt>
                <c:pt idx="228">
                  <c:v>6870.302734375</c:v>
                </c:pt>
                <c:pt idx="229">
                  <c:v>6790.40673828125</c:v>
                </c:pt>
                <c:pt idx="230">
                  <c:v>6735.2705078125</c:v>
                </c:pt>
                <c:pt idx="231">
                  <c:v>6742.49365234375</c:v>
                </c:pt>
                <c:pt idx="232">
                  <c:v>6810.7802734375</c:v>
                </c:pt>
                <c:pt idx="233">
                  <c:v>6899.9384765625</c:v>
                </c:pt>
                <c:pt idx="234">
                  <c:v>6959.8359375</c:v>
                </c:pt>
                <c:pt idx="235">
                  <c:v>6965.60205078125</c:v>
                </c:pt>
                <c:pt idx="236">
                  <c:v>6931.8759765625</c:v>
                </c:pt>
                <c:pt idx="237">
                  <c:v>6896.33349609375</c:v>
                </c:pt>
                <c:pt idx="238">
                  <c:v>6887.4306640625</c:v>
                </c:pt>
                <c:pt idx="239">
                  <c:v>6902.98974609375</c:v>
                </c:pt>
                <c:pt idx="240">
                  <c:v>6915.9833984375</c:v>
                </c:pt>
                <c:pt idx="241">
                  <c:v>6900.8369140625</c:v>
                </c:pt>
                <c:pt idx="242">
                  <c:v>6857.083984375</c:v>
                </c:pt>
                <c:pt idx="243">
                  <c:v>6810.5</c:v>
                </c:pt>
                <c:pt idx="244">
                  <c:v>6791.33984375</c:v>
                </c:pt>
                <c:pt idx="245">
                  <c:v>6808.4599609375</c:v>
                </c:pt>
                <c:pt idx="246">
                  <c:v>6841.1669921875</c:v>
                </c:pt>
                <c:pt idx="247">
                  <c:v>6855.69580078125</c:v>
                </c:pt>
                <c:pt idx="248">
                  <c:v>6832.94140625</c:v>
                </c:pt>
                <c:pt idx="249">
                  <c:v>6785.001953125</c:v>
                </c:pt>
                <c:pt idx="250">
                  <c:v>6747.1337890625</c:v>
                </c:pt>
                <c:pt idx="251">
                  <c:v>6751.11376953125</c:v>
                </c:pt>
                <c:pt idx="252">
                  <c:v>6800.33349609375</c:v>
                </c:pt>
                <c:pt idx="253">
                  <c:v>6865.42333984375</c:v>
                </c:pt>
                <c:pt idx="254">
                  <c:v>6903.73046875</c:v>
                </c:pt>
                <c:pt idx="255">
                  <c:v>6888.6962890625</c:v>
                </c:pt>
                <c:pt idx="256">
                  <c:v>6828.65234375</c:v>
                </c:pt>
                <c:pt idx="257">
                  <c:v>6762.5556640625</c:v>
                </c:pt>
                <c:pt idx="258">
                  <c:v>6735.99169921875</c:v>
                </c:pt>
                <c:pt idx="259">
                  <c:v>6773.23193359375</c:v>
                </c:pt>
                <c:pt idx="260">
                  <c:v>6862.5361328125</c:v>
                </c:pt>
                <c:pt idx="261">
                  <c:v>6962.76123046875</c:v>
                </c:pt>
                <c:pt idx="262">
                  <c:v>7026.34814453125</c:v>
                </c:pt>
                <c:pt idx="263">
                  <c:v>7024.89013671875</c:v>
                </c:pt>
                <c:pt idx="264">
                  <c:v>6963.04150390625</c:v>
                </c:pt>
                <c:pt idx="265">
                  <c:v>6873.8798828125</c:v>
                </c:pt>
                <c:pt idx="266">
                  <c:v>6799.36962890625</c:v>
                </c:pt>
                <c:pt idx="267">
                  <c:v>6767.64794921875</c:v>
                </c:pt>
                <c:pt idx="268">
                  <c:v>6780.15380859375</c:v>
                </c:pt>
                <c:pt idx="269">
                  <c:v>6815.3857421875</c:v>
                </c:pt>
                <c:pt idx="270">
                  <c:v>6845.7080078125</c:v>
                </c:pt>
                <c:pt idx="271">
                  <c:v>6855.46044921875</c:v>
                </c:pt>
                <c:pt idx="272">
                  <c:v>6848.1923828125</c:v>
                </c:pt>
                <c:pt idx="273">
                  <c:v>6838.951171875</c:v>
                </c:pt>
                <c:pt idx="274">
                  <c:v>6838.77001953125</c:v>
                </c:pt>
                <c:pt idx="275">
                  <c:v>6844.48974609375</c:v>
                </c:pt>
                <c:pt idx="276">
                  <c:v>6842.67626953125</c:v>
                </c:pt>
                <c:pt idx="277">
                  <c:v>6824.52734375</c:v>
                </c:pt>
                <c:pt idx="278">
                  <c:v>6798.5673828125</c:v>
                </c:pt>
                <c:pt idx="279">
                  <c:v>6788.48486328125</c:v>
                </c:pt>
                <c:pt idx="280">
                  <c:v>6815.27587890625</c:v>
                </c:pt>
                <c:pt idx="281">
                  <c:v>6876.978515625</c:v>
                </c:pt>
                <c:pt idx="282">
                  <c:v>6943.6611328125</c:v>
                </c:pt>
                <c:pt idx="283">
                  <c:v>6974.96044921875</c:v>
                </c:pt>
                <c:pt idx="284">
                  <c:v>6949.40087890625</c:v>
                </c:pt>
                <c:pt idx="285">
                  <c:v>6883.36083984375</c:v>
                </c:pt>
                <c:pt idx="286">
                  <c:v>6823.14453125</c:v>
                </c:pt>
                <c:pt idx="287">
                  <c:v>6813.3271484375</c:v>
                </c:pt>
                <c:pt idx="288">
                  <c:v>6863.56884765625</c:v>
                </c:pt>
                <c:pt idx="289">
                  <c:v>6939.0966796875</c:v>
                </c:pt>
                <c:pt idx="290">
                  <c:v>6983.54541015625</c:v>
                </c:pt>
                <c:pt idx="291">
                  <c:v>6958.7333984375</c:v>
                </c:pt>
                <c:pt idx="292">
                  <c:v>6872.67919921875</c:v>
                </c:pt>
                <c:pt idx="293">
                  <c:v>6775.21484375</c:v>
                </c:pt>
                <c:pt idx="294">
                  <c:v>6724.15966796875</c:v>
                </c:pt>
                <c:pt idx="295">
                  <c:v>6746.30224609375</c:v>
                </c:pt>
                <c:pt idx="296">
                  <c:v>6820.58642578125</c:v>
                </c:pt>
                <c:pt idx="297">
                  <c:v>6894.05126953125</c:v>
                </c:pt>
                <c:pt idx="298">
                  <c:v>6917.564453125</c:v>
                </c:pt>
                <c:pt idx="299">
                  <c:v>6875.763671875</c:v>
                </c:pt>
                <c:pt idx="300">
                  <c:v>6792.2353515625</c:v>
                </c:pt>
                <c:pt idx="301">
                  <c:v>6710.107421875</c:v>
                </c:pt>
                <c:pt idx="302">
                  <c:v>6664.70947265625</c:v>
                </c:pt>
                <c:pt idx="303">
                  <c:v>6667.1806640625</c:v>
                </c:pt>
                <c:pt idx="304">
                  <c:v>6706.51025390625</c:v>
                </c:pt>
                <c:pt idx="305">
                  <c:v>6763.1884765625</c:v>
                </c:pt>
                <c:pt idx="306">
                  <c:v>6821.6318359375</c:v>
                </c:pt>
                <c:pt idx="307">
                  <c:v>6873.646484375</c:v>
                </c:pt>
                <c:pt idx="308">
                  <c:v>6914.89404296875</c:v>
                </c:pt>
                <c:pt idx="309">
                  <c:v>6941.59619140625</c:v>
                </c:pt>
                <c:pt idx="310">
                  <c:v>6951.90869140625</c:v>
                </c:pt>
                <c:pt idx="311">
                  <c:v>6949.654296875</c:v>
                </c:pt>
                <c:pt idx="312">
                  <c:v>6944.59765625</c:v>
                </c:pt>
                <c:pt idx="313">
                  <c:v>6946.59375</c:v>
                </c:pt>
                <c:pt idx="314">
                  <c:v>6957.42431640625</c:v>
                </c:pt>
                <c:pt idx="315">
                  <c:v>6967.53564453125</c:v>
                </c:pt>
                <c:pt idx="316">
                  <c:v>6961.66162109375</c:v>
                </c:pt>
                <c:pt idx="317">
                  <c:v>6930.04736328125</c:v>
                </c:pt>
                <c:pt idx="318">
                  <c:v>6877.01513671875</c:v>
                </c:pt>
                <c:pt idx="319">
                  <c:v>6820.21533203125</c:v>
                </c:pt>
                <c:pt idx="320">
                  <c:v>6780.83056640625</c:v>
                </c:pt>
                <c:pt idx="321">
                  <c:v>6771.552734375</c:v>
                </c:pt>
                <c:pt idx="322">
                  <c:v>6790.33056640625</c:v>
                </c:pt>
                <c:pt idx="323">
                  <c:v>6823.2255859375</c:v>
                </c:pt>
                <c:pt idx="324">
                  <c:v>6853.33349609375</c:v>
                </c:pt>
                <c:pt idx="325">
                  <c:v>6869.41650390625</c:v>
                </c:pt>
                <c:pt idx="326">
                  <c:v>6869.42333984375</c:v>
                </c:pt>
                <c:pt idx="327">
                  <c:v>6858.326171875</c:v>
                </c:pt>
                <c:pt idx="328">
                  <c:v>6843.13134765625</c:v>
                </c:pt>
                <c:pt idx="329">
                  <c:v>6828.6142578125</c:v>
                </c:pt>
                <c:pt idx="330">
                  <c:v>6815.8056640625</c:v>
                </c:pt>
                <c:pt idx="331">
                  <c:v>6803.32080078125</c:v>
                </c:pt>
                <c:pt idx="332">
                  <c:v>6790.34326171875</c:v>
                </c:pt>
                <c:pt idx="333">
                  <c:v>6779.40771484375</c:v>
                </c:pt>
                <c:pt idx="334">
                  <c:v>6776.953125</c:v>
                </c:pt>
                <c:pt idx="335">
                  <c:v>6790.33544921875</c:v>
                </c:pt>
                <c:pt idx="336">
                  <c:v>6822.13525390625</c:v>
                </c:pt>
                <c:pt idx="337">
                  <c:v>6865.28466796875</c:v>
                </c:pt>
                <c:pt idx="338">
                  <c:v>6903.546875</c:v>
                </c:pt>
                <c:pt idx="339">
                  <c:v>6919.236328125</c:v>
                </c:pt>
                <c:pt idx="340">
                  <c:v>6904.62451171875</c:v>
                </c:pt>
                <c:pt idx="341">
                  <c:v>6869.2109375</c:v>
                </c:pt>
                <c:pt idx="342">
                  <c:v>6836.16064453125</c:v>
                </c:pt>
                <c:pt idx="343">
                  <c:v>6828.29248046875</c:v>
                </c:pt>
                <c:pt idx="344">
                  <c:v>6852.34765625</c:v>
                </c:pt>
                <c:pt idx="345">
                  <c:v>6893.06298828125</c:v>
                </c:pt>
                <c:pt idx="346">
                  <c:v>6922.5517578125</c:v>
                </c:pt>
                <c:pt idx="347">
                  <c:v>6919.32080078125</c:v>
                </c:pt>
                <c:pt idx="348">
                  <c:v>6883.42578125</c:v>
                </c:pt>
                <c:pt idx="349">
                  <c:v>6836.43994140625</c:v>
                </c:pt>
              </c:numCache>
            </c:numRef>
          </c:yVal>
          <c:smooth val="1"/>
          <c:extLst>
            <c:ext xmlns:c16="http://schemas.microsoft.com/office/drawing/2014/chart" uri="{C3380CC4-5D6E-409C-BE32-E72D297353CC}">
              <c16:uniqueId val="{00000009-5429-4359-BD11-807CF8F8408D}"/>
            </c:ext>
          </c:extLst>
        </c:ser>
        <c:ser>
          <c:idx val="10"/>
          <c:order val="10"/>
          <c:tx>
            <c:strRef>
              <c:f>np_sub_003!$K$1</c:f>
              <c:strCache>
                <c:ptCount val="1"/>
                <c:pt idx="0">
                  <c:v>Coor_11</c:v>
                </c:pt>
              </c:strCache>
            </c:strRef>
          </c:tx>
          <c:spPr>
            <a:ln w="28575" cap="rnd">
              <a:solidFill>
                <a:schemeClr val="accent5">
                  <a:lumMod val="60000"/>
                </a:schemeClr>
              </a:solidFill>
              <a:round/>
            </a:ln>
            <a:effectLst/>
          </c:spPr>
          <c:marker>
            <c:symbol val="none"/>
          </c:marker>
          <c:yVal>
            <c:numRef>
              <c:f>np_sub_003!$K$2:$K$351</c:f>
              <c:numCache>
                <c:formatCode>0.00000000000_ </c:formatCode>
                <c:ptCount val="350"/>
                <c:pt idx="0">
                  <c:v>6936.66748046875</c:v>
                </c:pt>
                <c:pt idx="1">
                  <c:v>6936.67041015625</c:v>
                </c:pt>
                <c:pt idx="2">
                  <c:v>6889.0185546875</c:v>
                </c:pt>
                <c:pt idx="3">
                  <c:v>6810.6259765625</c:v>
                </c:pt>
                <c:pt idx="4">
                  <c:v>6744.50439453125</c:v>
                </c:pt>
                <c:pt idx="5">
                  <c:v>6731.9462890625</c:v>
                </c:pt>
                <c:pt idx="6">
                  <c:v>6783.197265625</c:v>
                </c:pt>
                <c:pt idx="7">
                  <c:v>6868.58056640625</c:v>
                </c:pt>
                <c:pt idx="8">
                  <c:v>6937.52880859375</c:v>
                </c:pt>
                <c:pt idx="9">
                  <c:v>6952.2138671875</c:v>
                </c:pt>
                <c:pt idx="10">
                  <c:v>6911.60986328125</c:v>
                </c:pt>
                <c:pt idx="11">
                  <c:v>6849.24462890625</c:v>
                </c:pt>
                <c:pt idx="12">
                  <c:v>6807.74462890625</c:v>
                </c:pt>
                <c:pt idx="13">
                  <c:v>6809.90869140625</c:v>
                </c:pt>
                <c:pt idx="14">
                  <c:v>6846.9306640625</c:v>
                </c:pt>
                <c:pt idx="15">
                  <c:v>6889.77880859375</c:v>
                </c:pt>
                <c:pt idx="16">
                  <c:v>6912.04296875</c:v>
                </c:pt>
                <c:pt idx="17">
                  <c:v>6905.85546875</c:v>
                </c:pt>
                <c:pt idx="18">
                  <c:v>6880.84716796875</c:v>
                </c:pt>
                <c:pt idx="19">
                  <c:v>6851.22021484375</c:v>
                </c:pt>
                <c:pt idx="20">
                  <c:v>6824.6259765625</c:v>
                </c:pt>
                <c:pt idx="21">
                  <c:v>6802.083984375</c:v>
                </c:pt>
                <c:pt idx="22">
                  <c:v>6785.95263671875</c:v>
                </c:pt>
                <c:pt idx="23">
                  <c:v>6784.81103515625</c:v>
                </c:pt>
                <c:pt idx="24">
                  <c:v>6807.662109375</c:v>
                </c:pt>
                <c:pt idx="25">
                  <c:v>6851.6435546875</c:v>
                </c:pt>
                <c:pt idx="26">
                  <c:v>6896.0634765625</c:v>
                </c:pt>
                <c:pt idx="27">
                  <c:v>6912.17041015625</c:v>
                </c:pt>
                <c:pt idx="28">
                  <c:v>6884.48828125</c:v>
                </c:pt>
                <c:pt idx="29">
                  <c:v>6827.390625</c:v>
                </c:pt>
                <c:pt idx="30">
                  <c:v>6781.3095703125</c:v>
                </c:pt>
                <c:pt idx="31">
                  <c:v>6787.57275390625</c:v>
                </c:pt>
                <c:pt idx="32">
                  <c:v>6858.37353515625</c:v>
                </c:pt>
                <c:pt idx="33">
                  <c:v>6964.3349609375</c:v>
                </c:pt>
                <c:pt idx="34">
                  <c:v>7050.70263671875</c:v>
                </c:pt>
                <c:pt idx="35">
                  <c:v>7072.3271484375</c:v>
                </c:pt>
                <c:pt idx="36">
                  <c:v>7023.17822265625</c:v>
                </c:pt>
                <c:pt idx="37">
                  <c:v>6939.4794921875</c:v>
                </c:pt>
                <c:pt idx="38">
                  <c:v>6874.41015625</c:v>
                </c:pt>
                <c:pt idx="39">
                  <c:v>6862.5751953125</c:v>
                </c:pt>
                <c:pt idx="40">
                  <c:v>6899.09619140625</c:v>
                </c:pt>
                <c:pt idx="41">
                  <c:v>6946.77587890625</c:v>
                </c:pt>
                <c:pt idx="42">
                  <c:v>6964.375</c:v>
                </c:pt>
                <c:pt idx="43">
                  <c:v>6934.86962890625</c:v>
                </c:pt>
                <c:pt idx="44">
                  <c:v>6874.34423828125</c:v>
                </c:pt>
                <c:pt idx="45">
                  <c:v>6817.41259765625</c:v>
                </c:pt>
                <c:pt idx="46">
                  <c:v>6791.7626953125</c:v>
                </c:pt>
                <c:pt idx="47">
                  <c:v>6800.6142578125</c:v>
                </c:pt>
                <c:pt idx="48">
                  <c:v>6824.34375</c:v>
                </c:pt>
                <c:pt idx="49">
                  <c:v>6837.9638671875</c:v>
                </c:pt>
                <c:pt idx="50">
                  <c:v>6830.47119140625</c:v>
                </c:pt>
                <c:pt idx="51">
                  <c:v>6812.169921875</c:v>
                </c:pt>
                <c:pt idx="52">
                  <c:v>6805.6455078125</c:v>
                </c:pt>
                <c:pt idx="53">
                  <c:v>6827.59326171875</c:v>
                </c:pt>
                <c:pt idx="54">
                  <c:v>6874.47265625</c:v>
                </c:pt>
                <c:pt idx="55">
                  <c:v>6921.84521484375</c:v>
                </c:pt>
                <c:pt idx="56">
                  <c:v>6938.15087890625</c:v>
                </c:pt>
                <c:pt idx="57">
                  <c:v>6904.53759765625</c:v>
                </c:pt>
                <c:pt idx="58">
                  <c:v>6828.5546875</c:v>
                </c:pt>
                <c:pt idx="59">
                  <c:v>6742.88916015625</c:v>
                </c:pt>
                <c:pt idx="60">
                  <c:v>6688.8876953125</c:v>
                </c:pt>
                <c:pt idx="61">
                  <c:v>6693.5625</c:v>
                </c:pt>
                <c:pt idx="62">
                  <c:v>6753.28173828125</c:v>
                </c:pt>
                <c:pt idx="63">
                  <c:v>6834.35595703125</c:v>
                </c:pt>
                <c:pt idx="64">
                  <c:v>6891.4326171875</c:v>
                </c:pt>
                <c:pt idx="65">
                  <c:v>6893.89111328125</c:v>
                </c:pt>
                <c:pt idx="66">
                  <c:v>6844.791015625</c:v>
                </c:pt>
                <c:pt idx="67">
                  <c:v>6780.45263671875</c:v>
                </c:pt>
                <c:pt idx="68">
                  <c:v>6750.021484375</c:v>
                </c:pt>
                <c:pt idx="69">
                  <c:v>6786.70458984375</c:v>
                </c:pt>
                <c:pt idx="70">
                  <c:v>6887.794921875</c:v>
                </c:pt>
                <c:pt idx="71">
                  <c:v>7015.32861328125</c:v>
                </c:pt>
                <c:pt idx="72">
                  <c:v>7116.501953125</c:v>
                </c:pt>
                <c:pt idx="73">
                  <c:v>7151.1474609375</c:v>
                </c:pt>
                <c:pt idx="74">
                  <c:v>7110.240234375</c:v>
                </c:pt>
                <c:pt idx="75">
                  <c:v>7016.29736328125</c:v>
                </c:pt>
                <c:pt idx="76">
                  <c:v>6908.2646484375</c:v>
                </c:pt>
                <c:pt idx="77">
                  <c:v>6821.9677734375</c:v>
                </c:pt>
                <c:pt idx="78">
                  <c:v>6777.3544921875</c:v>
                </c:pt>
                <c:pt idx="79">
                  <c:v>6776.880859375</c:v>
                </c:pt>
                <c:pt idx="80">
                  <c:v>6811.47509765625</c:v>
                </c:pt>
                <c:pt idx="81">
                  <c:v>6867.21826171875</c:v>
                </c:pt>
                <c:pt idx="82">
                  <c:v>6928.51513671875</c:v>
                </c:pt>
                <c:pt idx="83">
                  <c:v>6978.60986328125</c:v>
                </c:pt>
                <c:pt idx="84">
                  <c:v>7001.1904296875</c:v>
                </c:pt>
                <c:pt idx="85">
                  <c:v>6985.30419921875</c:v>
                </c:pt>
                <c:pt idx="86">
                  <c:v>6931.7578125</c:v>
                </c:pt>
                <c:pt idx="87">
                  <c:v>6856.29052734375</c:v>
                </c:pt>
                <c:pt idx="88">
                  <c:v>6785.677734375</c:v>
                </c:pt>
                <c:pt idx="89">
                  <c:v>6746.97900390625</c:v>
                </c:pt>
                <c:pt idx="90">
                  <c:v>6754.63818359375</c:v>
                </c:pt>
                <c:pt idx="91">
                  <c:v>6802.16552734375</c:v>
                </c:pt>
                <c:pt idx="92">
                  <c:v>6863.50341796875</c:v>
                </c:pt>
                <c:pt idx="93">
                  <c:v>6904.693359375</c:v>
                </c:pt>
                <c:pt idx="94">
                  <c:v>6901.1435546875</c:v>
                </c:pt>
                <c:pt idx="95">
                  <c:v>6852.07275390625</c:v>
                </c:pt>
                <c:pt idx="96">
                  <c:v>6783.68115234375</c:v>
                </c:pt>
                <c:pt idx="97">
                  <c:v>6737.25</c:v>
                </c:pt>
                <c:pt idx="98">
                  <c:v>6746.447265625</c:v>
                </c:pt>
                <c:pt idx="99">
                  <c:v>6815.63720703125</c:v>
                </c:pt>
                <c:pt idx="100">
                  <c:v>6912.822265625</c:v>
                </c:pt>
                <c:pt idx="101">
                  <c:v>6984.13720703125</c:v>
                </c:pt>
                <c:pt idx="102">
                  <c:v>6983.92333984375</c:v>
                </c:pt>
                <c:pt idx="103">
                  <c:v>6903.1865234375</c:v>
                </c:pt>
                <c:pt idx="104">
                  <c:v>6777.93603515625</c:v>
                </c:pt>
                <c:pt idx="105">
                  <c:v>6670.2392578125</c:v>
                </c:pt>
                <c:pt idx="106">
                  <c:v>6632.533203125</c:v>
                </c:pt>
                <c:pt idx="107">
                  <c:v>6677.70166015625</c:v>
                </c:pt>
                <c:pt idx="108">
                  <c:v>6774.5263671875</c:v>
                </c:pt>
                <c:pt idx="109">
                  <c:v>6871.1728515625</c:v>
                </c:pt>
                <c:pt idx="110">
                  <c:v>6929.931640625</c:v>
                </c:pt>
                <c:pt idx="111">
                  <c:v>6948.6796875</c:v>
                </c:pt>
                <c:pt idx="112">
                  <c:v>6954.55322265625</c:v>
                </c:pt>
                <c:pt idx="113">
                  <c:v>6976.10498046875</c:v>
                </c:pt>
                <c:pt idx="114">
                  <c:v>7016.2724609375</c:v>
                </c:pt>
                <c:pt idx="115">
                  <c:v>7047.595703125</c:v>
                </c:pt>
                <c:pt idx="116">
                  <c:v>7033.80029296875</c:v>
                </c:pt>
                <c:pt idx="117">
                  <c:v>6961.2353515625</c:v>
                </c:pt>
                <c:pt idx="118">
                  <c:v>6855.58837890625</c:v>
                </c:pt>
                <c:pt idx="119">
                  <c:v>6769.94384765625</c:v>
                </c:pt>
                <c:pt idx="120">
                  <c:v>6751.64892578125</c:v>
                </c:pt>
                <c:pt idx="121">
                  <c:v>6811.25830078125</c:v>
                </c:pt>
                <c:pt idx="122">
                  <c:v>6915.39013671875</c:v>
                </c:pt>
                <c:pt idx="123">
                  <c:v>7007.96826171875</c:v>
                </c:pt>
                <c:pt idx="124">
                  <c:v>7044.4423828125</c:v>
                </c:pt>
                <c:pt idx="125">
                  <c:v>7015.65478515625</c:v>
                </c:pt>
                <c:pt idx="126">
                  <c:v>6947.0517578125</c:v>
                </c:pt>
                <c:pt idx="127">
                  <c:v>6877.0908203125</c:v>
                </c:pt>
                <c:pt idx="128">
                  <c:v>6832.1328125</c:v>
                </c:pt>
                <c:pt idx="129">
                  <c:v>6814.80712890625</c:v>
                </c:pt>
                <c:pt idx="130">
                  <c:v>6810.705078125</c:v>
                </c:pt>
                <c:pt idx="131">
                  <c:v>6804.68115234375</c:v>
                </c:pt>
                <c:pt idx="132">
                  <c:v>6793.02197265625</c:v>
                </c:pt>
                <c:pt idx="133">
                  <c:v>6783.5498046875</c:v>
                </c:pt>
                <c:pt idx="134">
                  <c:v>6786.29638671875</c:v>
                </c:pt>
                <c:pt idx="135">
                  <c:v>6803.921875</c:v>
                </c:pt>
                <c:pt idx="136">
                  <c:v>6829.46923828125</c:v>
                </c:pt>
                <c:pt idx="137">
                  <c:v>6851.94091796875</c:v>
                </c:pt>
                <c:pt idx="138">
                  <c:v>6864.11083984375</c:v>
                </c:pt>
                <c:pt idx="139">
                  <c:v>6866.376953125</c:v>
                </c:pt>
                <c:pt idx="140">
                  <c:v>6864.7099609375</c:v>
                </c:pt>
                <c:pt idx="141">
                  <c:v>6865.53857421875</c:v>
                </c:pt>
                <c:pt idx="142">
                  <c:v>6871.8486328125</c:v>
                </c:pt>
                <c:pt idx="143">
                  <c:v>6882.57470703125</c:v>
                </c:pt>
                <c:pt idx="144">
                  <c:v>6894.20068359375</c:v>
                </c:pt>
                <c:pt idx="145">
                  <c:v>6902.3408203125</c:v>
                </c:pt>
                <c:pt idx="146">
                  <c:v>6902.39697265625</c:v>
                </c:pt>
                <c:pt idx="147">
                  <c:v>6890.30322265625</c:v>
                </c:pt>
                <c:pt idx="148">
                  <c:v>6864.62451171875</c:v>
                </c:pt>
                <c:pt idx="149">
                  <c:v>6829.537109375</c:v>
                </c:pt>
                <c:pt idx="150">
                  <c:v>6796.18408203125</c:v>
                </c:pt>
                <c:pt idx="151">
                  <c:v>6779.8037109375</c:v>
                </c:pt>
                <c:pt idx="152">
                  <c:v>6792.4931640625</c:v>
                </c:pt>
                <c:pt idx="153">
                  <c:v>6834.9619140625</c:v>
                </c:pt>
                <c:pt idx="154">
                  <c:v>6892.5830078125</c:v>
                </c:pt>
                <c:pt idx="155">
                  <c:v>6939.6884765625</c:v>
                </c:pt>
                <c:pt idx="156">
                  <c:v>6951.63623046875</c:v>
                </c:pt>
                <c:pt idx="157">
                  <c:v>6919.0556640625</c:v>
                </c:pt>
                <c:pt idx="158">
                  <c:v>6855.9990234375</c:v>
                </c:pt>
                <c:pt idx="159">
                  <c:v>6795.71875</c:v>
                </c:pt>
                <c:pt idx="160">
                  <c:v>6774.2099609375</c:v>
                </c:pt>
                <c:pt idx="161">
                  <c:v>6809.4755859375</c:v>
                </c:pt>
                <c:pt idx="162">
                  <c:v>6888.7529296875</c:v>
                </c:pt>
                <c:pt idx="163">
                  <c:v>6973.02587890625</c:v>
                </c:pt>
                <c:pt idx="164">
                  <c:v>7018.341796875</c:v>
                </c:pt>
                <c:pt idx="165">
                  <c:v>7002.11083984375</c:v>
                </c:pt>
                <c:pt idx="166">
                  <c:v>6937.57275390625</c:v>
                </c:pt>
                <c:pt idx="167">
                  <c:v>6865.69189453125</c:v>
                </c:pt>
                <c:pt idx="168">
                  <c:v>6828.41552734375</c:v>
                </c:pt>
                <c:pt idx="169">
                  <c:v>6840.826171875</c:v>
                </c:pt>
                <c:pt idx="170">
                  <c:v>6881.94140625</c:v>
                </c:pt>
                <c:pt idx="171">
                  <c:v>6911.56298828125</c:v>
                </c:pt>
                <c:pt idx="172">
                  <c:v>6901.53271484375</c:v>
                </c:pt>
                <c:pt idx="173">
                  <c:v>6858.033203125</c:v>
                </c:pt>
                <c:pt idx="174">
                  <c:v>6817.10205078125</c:v>
                </c:pt>
                <c:pt idx="175">
                  <c:v>6815.5400390625</c:v>
                </c:pt>
                <c:pt idx="176">
                  <c:v>6859.216796875</c:v>
                </c:pt>
                <c:pt idx="177">
                  <c:v>6914.52294921875</c:v>
                </c:pt>
                <c:pt idx="178">
                  <c:v>6932.01708984375</c:v>
                </c:pt>
                <c:pt idx="179">
                  <c:v>6885.93798828125</c:v>
                </c:pt>
                <c:pt idx="180">
                  <c:v>6798.98974609375</c:v>
                </c:pt>
                <c:pt idx="181">
                  <c:v>6730.9912109375</c:v>
                </c:pt>
                <c:pt idx="182">
                  <c:v>6736.994140625</c:v>
                </c:pt>
                <c:pt idx="183">
                  <c:v>6824.9814453125</c:v>
                </c:pt>
                <c:pt idx="184">
                  <c:v>6945.6416015625</c:v>
                </c:pt>
                <c:pt idx="185">
                  <c:v>7023.88623046875</c:v>
                </c:pt>
                <c:pt idx="186">
                  <c:v>7010.46728515625</c:v>
                </c:pt>
                <c:pt idx="187">
                  <c:v>6916.25146484375</c:v>
                </c:pt>
                <c:pt idx="188">
                  <c:v>6804.06640625</c:v>
                </c:pt>
                <c:pt idx="189">
                  <c:v>6744.42138671875</c:v>
                </c:pt>
                <c:pt idx="190">
                  <c:v>6767.90673828125</c:v>
                </c:pt>
                <c:pt idx="191">
                  <c:v>6848.490234375</c:v>
                </c:pt>
                <c:pt idx="192">
                  <c:v>6927.71044921875</c:v>
                </c:pt>
                <c:pt idx="193">
                  <c:v>6959.06005859375</c:v>
                </c:pt>
                <c:pt idx="194">
                  <c:v>6938.3828125</c:v>
                </c:pt>
                <c:pt idx="195">
                  <c:v>6899.2451171875</c:v>
                </c:pt>
                <c:pt idx="196">
                  <c:v>6880.49853515625</c:v>
                </c:pt>
                <c:pt idx="197">
                  <c:v>6893.79833984375</c:v>
                </c:pt>
                <c:pt idx="198">
                  <c:v>6916.3935546875</c:v>
                </c:pt>
                <c:pt idx="199">
                  <c:v>6912.560546875</c:v>
                </c:pt>
                <c:pt idx="200">
                  <c:v>6864.37646484375</c:v>
                </c:pt>
                <c:pt idx="201">
                  <c:v>6786.90625</c:v>
                </c:pt>
                <c:pt idx="202">
                  <c:v>6717.2919921875</c:v>
                </c:pt>
                <c:pt idx="203">
                  <c:v>6688.41650390625</c:v>
                </c:pt>
                <c:pt idx="204">
                  <c:v>6708.3642578125</c:v>
                </c:pt>
                <c:pt idx="205">
                  <c:v>6759.68115234375</c:v>
                </c:pt>
                <c:pt idx="206">
                  <c:v>6815.34375</c:v>
                </c:pt>
                <c:pt idx="207">
                  <c:v>6856.43017578125</c:v>
                </c:pt>
                <c:pt idx="208">
                  <c:v>6878.57666015625</c:v>
                </c:pt>
                <c:pt idx="209">
                  <c:v>6886.41259765625</c:v>
                </c:pt>
                <c:pt idx="210">
                  <c:v>6885.2724609375</c:v>
                </c:pt>
                <c:pt idx="211">
                  <c:v>6878.94970703125</c:v>
                </c:pt>
                <c:pt idx="212">
                  <c:v>6873.34814453125</c:v>
                </c:pt>
                <c:pt idx="213">
                  <c:v>6878.4638671875</c:v>
                </c:pt>
                <c:pt idx="214">
                  <c:v>6902.97900390625</c:v>
                </c:pt>
                <c:pt idx="215">
                  <c:v>6944.82177734375</c:v>
                </c:pt>
                <c:pt idx="216">
                  <c:v>6987.66796875</c:v>
                </c:pt>
                <c:pt idx="217">
                  <c:v>7009.87158203125</c:v>
                </c:pt>
                <c:pt idx="218">
                  <c:v>7000.80517578125</c:v>
                </c:pt>
                <c:pt idx="219">
                  <c:v>6970.822265625</c:v>
                </c:pt>
                <c:pt idx="220">
                  <c:v>6944.32568359375</c:v>
                </c:pt>
                <c:pt idx="221">
                  <c:v>6939.49560546875</c:v>
                </c:pt>
                <c:pt idx="222">
                  <c:v>6951.197265625</c:v>
                </c:pt>
                <c:pt idx="223">
                  <c:v>6953.1240234375</c:v>
                </c:pt>
                <c:pt idx="224">
                  <c:v>6920.0029296875</c:v>
                </c:pt>
                <c:pt idx="225">
                  <c:v>6852.71533203125</c:v>
                </c:pt>
                <c:pt idx="226">
                  <c:v>6784.27294921875</c:v>
                </c:pt>
                <c:pt idx="227">
                  <c:v>6758.54248046875</c:v>
                </c:pt>
                <c:pt idx="228">
                  <c:v>6796.130859375</c:v>
                </c:pt>
                <c:pt idx="229">
                  <c:v>6874.38818359375</c:v>
                </c:pt>
                <c:pt idx="230">
                  <c:v>6939.50634765625</c:v>
                </c:pt>
                <c:pt idx="231">
                  <c:v>6944.068359375</c:v>
                </c:pt>
                <c:pt idx="232">
                  <c:v>6882.43798828125</c:v>
                </c:pt>
                <c:pt idx="233">
                  <c:v>6796.42578125</c:v>
                </c:pt>
                <c:pt idx="234">
                  <c:v>6745.62939453125</c:v>
                </c:pt>
                <c:pt idx="235">
                  <c:v>6763.943359375</c:v>
                </c:pt>
                <c:pt idx="236">
                  <c:v>6834.7099609375</c:v>
                </c:pt>
                <c:pt idx="237">
                  <c:v>6903.00830078125</c:v>
                </c:pt>
                <c:pt idx="238">
                  <c:v>6915.59423828125</c:v>
                </c:pt>
                <c:pt idx="239">
                  <c:v>6858.59716796875</c:v>
                </c:pt>
                <c:pt idx="240">
                  <c:v>6765.7822265625</c:v>
                </c:pt>
                <c:pt idx="241">
                  <c:v>6693.0107421875</c:v>
                </c:pt>
                <c:pt idx="242">
                  <c:v>6679.4052734375</c:v>
                </c:pt>
                <c:pt idx="243">
                  <c:v>6723.77880859375</c:v>
                </c:pt>
                <c:pt idx="244">
                  <c:v>6791.3447265625</c:v>
                </c:pt>
                <c:pt idx="245">
                  <c:v>6842.42822265625</c:v>
                </c:pt>
                <c:pt idx="246">
                  <c:v>6860.07861328125</c:v>
                </c:pt>
                <c:pt idx="247">
                  <c:v>6857.2001953125</c:v>
                </c:pt>
                <c:pt idx="248">
                  <c:v>6861.162109375</c:v>
                </c:pt>
                <c:pt idx="249">
                  <c:v>6890.24755859375</c:v>
                </c:pt>
                <c:pt idx="250">
                  <c:v>6939.90283203125</c:v>
                </c:pt>
                <c:pt idx="251">
                  <c:v>6986.9130859375</c:v>
                </c:pt>
                <c:pt idx="252">
                  <c:v>7005.859375</c:v>
                </c:pt>
                <c:pt idx="253">
                  <c:v>6985.14013671875</c:v>
                </c:pt>
                <c:pt idx="254">
                  <c:v>6932.9423828125</c:v>
                </c:pt>
                <c:pt idx="255">
                  <c:v>6872.03125</c:v>
                </c:pt>
                <c:pt idx="256">
                  <c:v>6828.63427734375</c:v>
                </c:pt>
                <c:pt idx="257">
                  <c:v>6821.5341796875</c:v>
                </c:pt>
                <c:pt idx="258">
                  <c:v>6854.8623046875</c:v>
                </c:pt>
                <c:pt idx="259">
                  <c:v>6915.98876953125</c:v>
                </c:pt>
                <c:pt idx="260">
                  <c:v>6979.54052734375</c:v>
                </c:pt>
                <c:pt idx="261">
                  <c:v>7017.79345703125</c:v>
                </c:pt>
                <c:pt idx="262">
                  <c:v>7014.40283203125</c:v>
                </c:pt>
                <c:pt idx="263">
                  <c:v>6974.2568359375</c:v>
                </c:pt>
                <c:pt idx="264">
                  <c:v>6921.78125</c:v>
                </c:pt>
                <c:pt idx="265">
                  <c:v>6886.2001953125</c:v>
                </c:pt>
                <c:pt idx="266">
                  <c:v>6881.98876953125</c:v>
                </c:pt>
                <c:pt idx="267">
                  <c:v>6898.34228515625</c:v>
                </c:pt>
                <c:pt idx="268">
                  <c:v>6906.7939453125</c:v>
                </c:pt>
                <c:pt idx="269">
                  <c:v>6883.0224609375</c:v>
                </c:pt>
                <c:pt idx="270">
                  <c:v>6827.0595703125</c:v>
                </c:pt>
                <c:pt idx="271">
                  <c:v>6765.7255859375</c:v>
                </c:pt>
                <c:pt idx="272">
                  <c:v>6733.96826171875</c:v>
                </c:pt>
                <c:pt idx="273">
                  <c:v>6748.55859375</c:v>
                </c:pt>
                <c:pt idx="274">
                  <c:v>6794.740234375</c:v>
                </c:pt>
                <c:pt idx="275">
                  <c:v>6837.24072265625</c:v>
                </c:pt>
                <c:pt idx="276">
                  <c:v>6847.8857421875</c:v>
                </c:pt>
                <c:pt idx="277">
                  <c:v>6828.1259765625</c:v>
                </c:pt>
                <c:pt idx="278">
                  <c:v>6807.8408203125</c:v>
                </c:pt>
                <c:pt idx="279">
                  <c:v>6820.31201171875</c:v>
                </c:pt>
                <c:pt idx="280">
                  <c:v>6872.78564453125</c:v>
                </c:pt>
                <c:pt idx="281">
                  <c:v>6936.68701171875</c:v>
                </c:pt>
                <c:pt idx="282">
                  <c:v>6966.76220703125</c:v>
                </c:pt>
                <c:pt idx="283">
                  <c:v>6935.47900390625</c:v>
                </c:pt>
                <c:pt idx="284">
                  <c:v>6856.10595703125</c:v>
                </c:pt>
                <c:pt idx="285">
                  <c:v>6775.78271484375</c:v>
                </c:pt>
                <c:pt idx="286">
                  <c:v>6742.8466796875</c:v>
                </c:pt>
                <c:pt idx="287">
                  <c:v>6772.814453125</c:v>
                </c:pt>
                <c:pt idx="288">
                  <c:v>6838.74365234375</c:v>
                </c:pt>
                <c:pt idx="289">
                  <c:v>6892.9462890625</c:v>
                </c:pt>
                <c:pt idx="290">
                  <c:v>6902.90625</c:v>
                </c:pt>
                <c:pt idx="291">
                  <c:v>6873.6142578125</c:v>
                </c:pt>
                <c:pt idx="292">
                  <c:v>6839.7109375</c:v>
                </c:pt>
                <c:pt idx="293">
                  <c:v>6834.82421875</c:v>
                </c:pt>
                <c:pt idx="294">
                  <c:v>6863.29150390625</c:v>
                </c:pt>
                <c:pt idx="295">
                  <c:v>6897.095703125</c:v>
                </c:pt>
                <c:pt idx="296">
                  <c:v>6900.33740234375</c:v>
                </c:pt>
                <c:pt idx="297">
                  <c:v>6861.3154296875</c:v>
                </c:pt>
                <c:pt idx="298">
                  <c:v>6805.88916015625</c:v>
                </c:pt>
                <c:pt idx="299">
                  <c:v>6780.3720703125</c:v>
                </c:pt>
                <c:pt idx="300">
                  <c:v>6816.28173828125</c:v>
                </c:pt>
                <c:pt idx="301">
                  <c:v>6904.013671875</c:v>
                </c:pt>
                <c:pt idx="302">
                  <c:v>6996.349609375</c:v>
                </c:pt>
                <c:pt idx="303">
                  <c:v>7040.2763671875</c:v>
                </c:pt>
                <c:pt idx="304">
                  <c:v>7014.044921875</c:v>
                </c:pt>
                <c:pt idx="305">
                  <c:v>6942.1796875</c:v>
                </c:pt>
                <c:pt idx="306">
                  <c:v>6877.365234375</c:v>
                </c:pt>
                <c:pt idx="307">
                  <c:v>6862.58154296875</c:v>
                </c:pt>
                <c:pt idx="308">
                  <c:v>6901.21142578125</c:v>
                </c:pt>
                <c:pt idx="309">
                  <c:v>6956.6240234375</c:v>
                </c:pt>
                <c:pt idx="310">
                  <c:v>6980.88671875</c:v>
                </c:pt>
                <c:pt idx="311">
                  <c:v>6951.041015625</c:v>
                </c:pt>
                <c:pt idx="312">
                  <c:v>6886.2998046875</c:v>
                </c:pt>
                <c:pt idx="313">
                  <c:v>6833.84130859375</c:v>
                </c:pt>
                <c:pt idx="314">
                  <c:v>6833.78515625</c:v>
                </c:pt>
                <c:pt idx="315">
                  <c:v>6888.76416015625</c:v>
                </c:pt>
                <c:pt idx="316">
                  <c:v>6959.8525390625</c:v>
                </c:pt>
                <c:pt idx="317">
                  <c:v>6991.72119140625</c:v>
                </c:pt>
                <c:pt idx="318">
                  <c:v>6949.45849609375</c:v>
                </c:pt>
                <c:pt idx="319">
                  <c:v>6841.91845703125</c:v>
                </c:pt>
                <c:pt idx="320">
                  <c:v>6716.3876953125</c:v>
                </c:pt>
                <c:pt idx="321">
                  <c:v>6629.18896484375</c:v>
                </c:pt>
                <c:pt idx="322">
                  <c:v>6612.50634765625</c:v>
                </c:pt>
                <c:pt idx="323">
                  <c:v>6658.8896484375</c:v>
                </c:pt>
                <c:pt idx="324">
                  <c:v>6731.69921875</c:v>
                </c:pt>
                <c:pt idx="325">
                  <c:v>6792.07177734375</c:v>
                </c:pt>
                <c:pt idx="326">
                  <c:v>6823.05615234375</c:v>
                </c:pt>
                <c:pt idx="327">
                  <c:v>6835.3681640625</c:v>
                </c:pt>
                <c:pt idx="328">
                  <c:v>6853.10595703125</c:v>
                </c:pt>
                <c:pt idx="329">
                  <c:v>6891.55322265625</c:v>
                </c:pt>
                <c:pt idx="330">
                  <c:v>6943.5498046875</c:v>
                </c:pt>
                <c:pt idx="331">
                  <c:v>6983.7080078125</c:v>
                </c:pt>
                <c:pt idx="332">
                  <c:v>6986.71630859375</c:v>
                </c:pt>
                <c:pt idx="333">
                  <c:v>6946.349609375</c:v>
                </c:pt>
                <c:pt idx="334">
                  <c:v>6881.828125</c:v>
                </c:pt>
                <c:pt idx="335">
                  <c:v>6827.18115234375</c:v>
                </c:pt>
                <c:pt idx="336">
                  <c:v>6810.7373046875</c:v>
                </c:pt>
                <c:pt idx="337">
                  <c:v>6838.12109375</c:v>
                </c:pt>
                <c:pt idx="338">
                  <c:v>6889.46484375</c:v>
                </c:pt>
                <c:pt idx="339">
                  <c:v>6932.19140625</c:v>
                </c:pt>
                <c:pt idx="340">
                  <c:v>6940.9970703125</c:v>
                </c:pt>
                <c:pt idx="341">
                  <c:v>6912.64794921875</c:v>
                </c:pt>
                <c:pt idx="342">
                  <c:v>6866.94140625</c:v>
                </c:pt>
                <c:pt idx="343">
                  <c:v>6833.947265625</c:v>
                </c:pt>
                <c:pt idx="344">
                  <c:v>6835.7607421875</c:v>
                </c:pt>
                <c:pt idx="345">
                  <c:v>6873.77099609375</c:v>
                </c:pt>
                <c:pt idx="346">
                  <c:v>6928.541015625</c:v>
                </c:pt>
                <c:pt idx="347">
                  <c:v>6971.6142578125</c:v>
                </c:pt>
                <c:pt idx="348">
                  <c:v>6981.6708984375</c:v>
                </c:pt>
                <c:pt idx="349">
                  <c:v>6955.484375</c:v>
                </c:pt>
              </c:numCache>
            </c:numRef>
          </c:yVal>
          <c:smooth val="1"/>
          <c:extLst>
            <c:ext xmlns:c16="http://schemas.microsoft.com/office/drawing/2014/chart" uri="{C3380CC4-5D6E-409C-BE32-E72D297353CC}">
              <c16:uniqueId val="{0000000A-5429-4359-BD11-807CF8F8408D}"/>
            </c:ext>
          </c:extLst>
        </c:ser>
        <c:ser>
          <c:idx val="11"/>
          <c:order val="11"/>
          <c:tx>
            <c:strRef>
              <c:f>np_sub_003!$L$1</c:f>
              <c:strCache>
                <c:ptCount val="1"/>
                <c:pt idx="0">
                  <c:v>Coor_12</c:v>
                </c:pt>
              </c:strCache>
            </c:strRef>
          </c:tx>
          <c:spPr>
            <a:ln w="28575" cap="rnd">
              <a:solidFill>
                <a:schemeClr val="accent6">
                  <a:lumMod val="60000"/>
                </a:schemeClr>
              </a:solidFill>
              <a:round/>
            </a:ln>
            <a:effectLst/>
          </c:spPr>
          <c:marker>
            <c:symbol val="none"/>
          </c:marker>
          <c:yVal>
            <c:numRef>
              <c:f>np_sub_003!$L$2:$L$351</c:f>
              <c:numCache>
                <c:formatCode>0.00000000000_ </c:formatCode>
                <c:ptCount val="350"/>
                <c:pt idx="0">
                  <c:v>5957.0322265625</c:v>
                </c:pt>
                <c:pt idx="1">
                  <c:v>5987.34033203125</c:v>
                </c:pt>
                <c:pt idx="2">
                  <c:v>6040.53369140625</c:v>
                </c:pt>
                <c:pt idx="3">
                  <c:v>6085.1396484375</c:v>
                </c:pt>
                <c:pt idx="4">
                  <c:v>6088.35791015625</c:v>
                </c:pt>
                <c:pt idx="5">
                  <c:v>6042.02880859375</c:v>
                </c:pt>
                <c:pt idx="6">
                  <c:v>5974.73486328125</c:v>
                </c:pt>
                <c:pt idx="7">
                  <c:v>5936.92724609375</c:v>
                </c:pt>
                <c:pt idx="8">
                  <c:v>5965.93017578125</c:v>
                </c:pt>
                <c:pt idx="9">
                  <c:v>6055.4541015625</c:v>
                </c:pt>
                <c:pt idx="10">
                  <c:v>6154.33837890625</c:v>
                </c:pt>
                <c:pt idx="11">
                  <c:v>6199.08837890625</c:v>
                </c:pt>
                <c:pt idx="12">
                  <c:v>6158.58740234375</c:v>
                </c:pt>
                <c:pt idx="13">
                  <c:v>6057.90771484375</c:v>
                </c:pt>
                <c:pt idx="14">
                  <c:v>5962.0546875</c:v>
                </c:pt>
                <c:pt idx="15">
                  <c:v>5930.369140625</c:v>
                </c:pt>
                <c:pt idx="16">
                  <c:v>5975.17236328125</c:v>
                </c:pt>
                <c:pt idx="17">
                  <c:v>6055.515625</c:v>
                </c:pt>
                <c:pt idx="18">
                  <c:v>6110.072265625</c:v>
                </c:pt>
                <c:pt idx="19">
                  <c:v>6103.142578125</c:v>
                </c:pt>
                <c:pt idx="20">
                  <c:v>6048.3828125</c:v>
                </c:pt>
                <c:pt idx="21">
                  <c:v>5993.49609375</c:v>
                </c:pt>
                <c:pt idx="22">
                  <c:v>5980.35888671875</c:v>
                </c:pt>
                <c:pt idx="23">
                  <c:v>6013.513671875</c:v>
                </c:pt>
                <c:pt idx="24">
                  <c:v>6061.12451171875</c:v>
                </c:pt>
                <c:pt idx="25">
                  <c:v>6084.63232421875</c:v>
                </c:pt>
                <c:pt idx="26">
                  <c:v>6070.29638671875</c:v>
                </c:pt>
                <c:pt idx="27">
                  <c:v>6036.462890625</c:v>
                </c:pt>
                <c:pt idx="28">
                  <c:v>6013.06787109375</c:v>
                </c:pt>
                <c:pt idx="29">
                  <c:v>6014.05224609375</c:v>
                </c:pt>
                <c:pt idx="30">
                  <c:v>6028.00732421875</c:v>
                </c:pt>
                <c:pt idx="31">
                  <c:v>6034.11572265625</c:v>
                </c:pt>
                <c:pt idx="32">
                  <c:v>6026.4111328125</c:v>
                </c:pt>
                <c:pt idx="33">
                  <c:v>6021.6240234375</c:v>
                </c:pt>
                <c:pt idx="34">
                  <c:v>6041.64501953125</c:v>
                </c:pt>
                <c:pt idx="35">
                  <c:v>6086.62744140625</c:v>
                </c:pt>
                <c:pt idx="36">
                  <c:v>6125.69384765625</c:v>
                </c:pt>
                <c:pt idx="37">
                  <c:v>6117.94482421875</c:v>
                </c:pt>
                <c:pt idx="38">
                  <c:v>6048.65625</c:v>
                </c:pt>
                <c:pt idx="39">
                  <c:v>5949.03173828125</c:v>
                </c:pt>
                <c:pt idx="40">
                  <c:v>5878.876953125</c:v>
                </c:pt>
                <c:pt idx="41">
                  <c:v>5882.458984375</c:v>
                </c:pt>
                <c:pt idx="42">
                  <c:v>5952.51611328125</c:v>
                </c:pt>
                <c:pt idx="43">
                  <c:v>6033.587890625</c:v>
                </c:pt>
                <c:pt idx="44">
                  <c:v>6064.81201171875</c:v>
                </c:pt>
                <c:pt idx="45">
                  <c:v>6029.10791015625</c:v>
                </c:pt>
                <c:pt idx="46">
                  <c:v>5968.49072265625</c:v>
                </c:pt>
                <c:pt idx="47">
                  <c:v>5951.4228515625</c:v>
                </c:pt>
                <c:pt idx="48">
                  <c:v>6016.970703125</c:v>
                </c:pt>
                <c:pt idx="49">
                  <c:v>6140.15625</c:v>
                </c:pt>
                <c:pt idx="50">
                  <c:v>6246.6845703125</c:v>
                </c:pt>
                <c:pt idx="51">
                  <c:v>6266.0576171875</c:v>
                </c:pt>
                <c:pt idx="52">
                  <c:v>6181.8564453125</c:v>
                </c:pt>
                <c:pt idx="53">
                  <c:v>6041.0634765625</c:v>
                </c:pt>
                <c:pt idx="54">
                  <c:v>5917.611328125</c:v>
                </c:pt>
                <c:pt idx="55">
                  <c:v>5860.99072265625</c:v>
                </c:pt>
                <c:pt idx="56">
                  <c:v>5869.9404296875</c:v>
                </c:pt>
                <c:pt idx="57">
                  <c:v>5907.80908203125</c:v>
                </c:pt>
                <c:pt idx="58">
                  <c:v>5941.21240234375</c:v>
                </c:pt>
                <c:pt idx="59">
                  <c:v>5966.68017578125</c:v>
                </c:pt>
                <c:pt idx="60">
                  <c:v>6004.05517578125</c:v>
                </c:pt>
                <c:pt idx="61">
                  <c:v>6066.62255859375</c:v>
                </c:pt>
                <c:pt idx="62">
                  <c:v>6138.39697265625</c:v>
                </c:pt>
                <c:pt idx="63">
                  <c:v>6181.3076171875</c:v>
                </c:pt>
                <c:pt idx="64">
                  <c:v>6166.9169921875</c:v>
                </c:pt>
                <c:pt idx="65">
                  <c:v>6104.201171875</c:v>
                </c:pt>
                <c:pt idx="66">
                  <c:v>6037.380859375</c:v>
                </c:pt>
                <c:pt idx="67">
                  <c:v>6013.52294921875</c:v>
                </c:pt>
                <c:pt idx="68">
                  <c:v>6046.08642578125</c:v>
                </c:pt>
                <c:pt idx="69">
                  <c:v>6104.6201171875</c:v>
                </c:pt>
                <c:pt idx="70">
                  <c:v>6139.0849609375</c:v>
                </c:pt>
                <c:pt idx="71">
                  <c:v>6118.6220703125</c:v>
                </c:pt>
                <c:pt idx="72">
                  <c:v>6053.43115234375</c:v>
                </c:pt>
                <c:pt idx="73">
                  <c:v>5983.6513671875</c:v>
                </c:pt>
                <c:pt idx="74">
                  <c:v>5946.85498046875</c:v>
                </c:pt>
                <c:pt idx="75">
                  <c:v>5952.04150390625</c:v>
                </c:pt>
                <c:pt idx="76">
                  <c:v>5979.8037109375</c:v>
                </c:pt>
                <c:pt idx="77">
                  <c:v>6004.392578125</c:v>
                </c:pt>
                <c:pt idx="78">
                  <c:v>6015.43701171875</c:v>
                </c:pt>
                <c:pt idx="79">
                  <c:v>6020.43701171875</c:v>
                </c:pt>
                <c:pt idx="80">
                  <c:v>6029.15673828125</c:v>
                </c:pt>
                <c:pt idx="81">
                  <c:v>6038.36474609375</c:v>
                </c:pt>
                <c:pt idx="82">
                  <c:v>6033.81640625</c:v>
                </c:pt>
                <c:pt idx="83">
                  <c:v>6007.95751953125</c:v>
                </c:pt>
                <c:pt idx="84">
                  <c:v>5974.5869140625</c:v>
                </c:pt>
                <c:pt idx="85">
                  <c:v>5962.83056640625</c:v>
                </c:pt>
                <c:pt idx="86">
                  <c:v>5992.212890625</c:v>
                </c:pt>
                <c:pt idx="87">
                  <c:v>6050.58154296875</c:v>
                </c:pt>
                <c:pt idx="88">
                  <c:v>6097.498046875</c:v>
                </c:pt>
                <c:pt idx="89">
                  <c:v>6094.65185546875</c:v>
                </c:pt>
                <c:pt idx="90">
                  <c:v>6039.5322265625</c:v>
                </c:pt>
                <c:pt idx="91">
                  <c:v>5972.296875</c:v>
                </c:pt>
                <c:pt idx="92">
                  <c:v>5946.30078125</c:v>
                </c:pt>
                <c:pt idx="93">
                  <c:v>5984.12841796875</c:v>
                </c:pt>
                <c:pt idx="94">
                  <c:v>6056.03173828125</c:v>
                </c:pt>
                <c:pt idx="95">
                  <c:v>6101.61865234375</c:v>
                </c:pt>
                <c:pt idx="96">
                  <c:v>6079.97021484375</c:v>
                </c:pt>
                <c:pt idx="97">
                  <c:v>6007.55908203125</c:v>
                </c:pt>
                <c:pt idx="98">
                  <c:v>5950.41796875</c:v>
                </c:pt>
                <c:pt idx="99">
                  <c:v>5973.1044921875</c:v>
                </c:pt>
                <c:pt idx="100">
                  <c:v>6083.48095703125</c:v>
                </c:pt>
                <c:pt idx="101">
                  <c:v>6218.54833984375</c:v>
                </c:pt>
                <c:pt idx="102">
                  <c:v>6285.8955078125</c:v>
                </c:pt>
                <c:pt idx="103">
                  <c:v>6231.26513671875</c:v>
                </c:pt>
                <c:pt idx="104">
                  <c:v>6080.75634765625</c:v>
                </c:pt>
                <c:pt idx="105">
                  <c:v>5924.5234375</c:v>
                </c:pt>
                <c:pt idx="106">
                  <c:v>5853.595703125</c:v>
                </c:pt>
                <c:pt idx="107">
                  <c:v>5897.29296875</c:v>
                </c:pt>
                <c:pt idx="108">
                  <c:v>6007.46142578125</c:v>
                </c:pt>
                <c:pt idx="109">
                  <c:v>6098.89599609375</c:v>
                </c:pt>
                <c:pt idx="110">
                  <c:v>6112.5341796875</c:v>
                </c:pt>
                <c:pt idx="111">
                  <c:v>6052.8447265625</c:v>
                </c:pt>
                <c:pt idx="112">
                  <c:v>5974.03271484375</c:v>
                </c:pt>
                <c:pt idx="113">
                  <c:v>5931.08935546875</c:v>
                </c:pt>
                <c:pt idx="114">
                  <c:v>5937.70751953125</c:v>
                </c:pt>
                <c:pt idx="115">
                  <c:v>5963.92138671875</c:v>
                </c:pt>
                <c:pt idx="116">
                  <c:v>5971.3544921875</c:v>
                </c:pt>
                <c:pt idx="117">
                  <c:v>5952.97216796875</c:v>
                </c:pt>
                <c:pt idx="118">
                  <c:v>5942.16845703125</c:v>
                </c:pt>
                <c:pt idx="119">
                  <c:v>5983.34228515625</c:v>
                </c:pt>
                <c:pt idx="120">
                  <c:v>6089.09765625</c:v>
                </c:pt>
                <c:pt idx="121">
                  <c:v>6220.6181640625</c:v>
                </c:pt>
                <c:pt idx="122">
                  <c:v>6308.83984375</c:v>
                </c:pt>
                <c:pt idx="123">
                  <c:v>6301.08251953125</c:v>
                </c:pt>
                <c:pt idx="124">
                  <c:v>6197.70361328125</c:v>
                </c:pt>
                <c:pt idx="125">
                  <c:v>6051.65380859375</c:v>
                </c:pt>
                <c:pt idx="126">
                  <c:v>5932.7177734375</c:v>
                </c:pt>
                <c:pt idx="127">
                  <c:v>5884.0869140625</c:v>
                </c:pt>
                <c:pt idx="128">
                  <c:v>5902.04638671875</c:v>
                </c:pt>
                <c:pt idx="129">
                  <c:v>5949.423828125</c:v>
                </c:pt>
                <c:pt idx="130">
                  <c:v>5987.7265625</c:v>
                </c:pt>
                <c:pt idx="131">
                  <c:v>6001.8505859375</c:v>
                </c:pt>
                <c:pt idx="132">
                  <c:v>6001.48193359375</c:v>
                </c:pt>
                <c:pt idx="133">
                  <c:v>6003.96728515625</c:v>
                </c:pt>
                <c:pt idx="134">
                  <c:v>6016.66455078125</c:v>
                </c:pt>
                <c:pt idx="135">
                  <c:v>6033.15234375</c:v>
                </c:pt>
                <c:pt idx="136">
                  <c:v>6042.880859375</c:v>
                </c:pt>
                <c:pt idx="137">
                  <c:v>6042.16259765625</c:v>
                </c:pt>
                <c:pt idx="138">
                  <c:v>6035.630859375</c:v>
                </c:pt>
                <c:pt idx="139">
                  <c:v>6028.58203125</c:v>
                </c:pt>
                <c:pt idx="140">
                  <c:v>6020.15283203125</c:v>
                </c:pt>
                <c:pt idx="141">
                  <c:v>6005.8828125</c:v>
                </c:pt>
                <c:pt idx="142">
                  <c:v>5987.50927734375</c:v>
                </c:pt>
                <c:pt idx="143">
                  <c:v>5978.82080078125</c:v>
                </c:pt>
                <c:pt idx="144">
                  <c:v>5998.4990234375</c:v>
                </c:pt>
                <c:pt idx="145">
                  <c:v>6053.16015625</c:v>
                </c:pt>
                <c:pt idx="146">
                  <c:v>6125.06787109375</c:v>
                </c:pt>
                <c:pt idx="147">
                  <c:v>6177.94580078125</c:v>
                </c:pt>
                <c:pt idx="148">
                  <c:v>6180.19140625</c:v>
                </c:pt>
                <c:pt idx="149">
                  <c:v>6128.955078125</c:v>
                </c:pt>
                <c:pt idx="150">
                  <c:v>6055.220703125</c:v>
                </c:pt>
                <c:pt idx="151">
                  <c:v>6003.55029296875</c:v>
                </c:pt>
                <c:pt idx="152">
                  <c:v>6000.509765625</c:v>
                </c:pt>
                <c:pt idx="153">
                  <c:v>6036.013671875</c:v>
                </c:pt>
                <c:pt idx="154">
                  <c:v>6072.60205078125</c:v>
                </c:pt>
                <c:pt idx="155">
                  <c:v>6075.53662109375</c:v>
                </c:pt>
                <c:pt idx="156">
                  <c:v>6039.5341796875</c:v>
                </c:pt>
                <c:pt idx="157">
                  <c:v>5990.49609375</c:v>
                </c:pt>
                <c:pt idx="158">
                  <c:v>5961.28955078125</c:v>
                </c:pt>
                <c:pt idx="159">
                  <c:v>5962.62939453125</c:v>
                </c:pt>
                <c:pt idx="160">
                  <c:v>5974.66943359375</c:v>
                </c:pt>
                <c:pt idx="161">
                  <c:v>5967.4287109375</c:v>
                </c:pt>
                <c:pt idx="162">
                  <c:v>5932.73583984375</c:v>
                </c:pt>
                <c:pt idx="163">
                  <c:v>5898.662109375</c:v>
                </c:pt>
                <c:pt idx="164">
                  <c:v>5910.58154296875</c:v>
                </c:pt>
                <c:pt idx="165">
                  <c:v>5991.36962890625</c:v>
                </c:pt>
                <c:pt idx="166">
                  <c:v>6113.44091796875</c:v>
                </c:pt>
                <c:pt idx="167">
                  <c:v>6209.1513671875</c:v>
                </c:pt>
                <c:pt idx="168">
                  <c:v>6216.54345703125</c:v>
                </c:pt>
                <c:pt idx="169">
                  <c:v>6127.41748046875</c:v>
                </c:pt>
                <c:pt idx="170">
                  <c:v>5999.35400390625</c:v>
                </c:pt>
                <c:pt idx="171">
                  <c:v>5918.9130859375</c:v>
                </c:pt>
                <c:pt idx="172">
                  <c:v>5940.97607421875</c:v>
                </c:pt>
                <c:pt idx="173">
                  <c:v>6049.30908203125</c:v>
                </c:pt>
                <c:pt idx="174">
                  <c:v>6168.7646484375</c:v>
                </c:pt>
                <c:pt idx="175">
                  <c:v>6220.4296875</c:v>
                </c:pt>
                <c:pt idx="176">
                  <c:v>6177.83203125</c:v>
                </c:pt>
                <c:pt idx="177">
                  <c:v>6081.55615234375</c:v>
                </c:pt>
                <c:pt idx="178">
                  <c:v>6002.45068359375</c:v>
                </c:pt>
                <c:pt idx="179">
                  <c:v>5984.1904296875</c:v>
                </c:pt>
                <c:pt idx="180">
                  <c:v>6011.75146484375</c:v>
                </c:pt>
                <c:pt idx="181">
                  <c:v>6030.48291015625</c:v>
                </c:pt>
                <c:pt idx="182">
                  <c:v>5998.54833984375</c:v>
                </c:pt>
                <c:pt idx="183">
                  <c:v>5927.6826171875</c:v>
                </c:pt>
                <c:pt idx="184">
                  <c:v>5876.67138671875</c:v>
                </c:pt>
                <c:pt idx="185">
                  <c:v>5901.42333984375</c:v>
                </c:pt>
                <c:pt idx="186">
                  <c:v>6002.8115234375</c:v>
                </c:pt>
                <c:pt idx="187">
                  <c:v>6117.3828125</c:v>
                </c:pt>
                <c:pt idx="188">
                  <c:v>6162.216796875</c:v>
                </c:pt>
                <c:pt idx="189">
                  <c:v>6100.4072265625</c:v>
                </c:pt>
                <c:pt idx="190">
                  <c:v>5974.51416015625</c:v>
                </c:pt>
                <c:pt idx="191">
                  <c:v>5878.67822265625</c:v>
                </c:pt>
                <c:pt idx="192">
                  <c:v>5888.37060546875</c:v>
                </c:pt>
                <c:pt idx="193">
                  <c:v>6001.60693359375</c:v>
                </c:pt>
                <c:pt idx="194">
                  <c:v>6138.2998046875</c:v>
                </c:pt>
                <c:pt idx="195">
                  <c:v>6199.873046875</c:v>
                </c:pt>
                <c:pt idx="196">
                  <c:v>6144.00634765625</c:v>
                </c:pt>
                <c:pt idx="197">
                  <c:v>6016.8828125</c:v>
                </c:pt>
                <c:pt idx="198">
                  <c:v>5917.83349609375</c:v>
                </c:pt>
                <c:pt idx="199">
                  <c:v>5923.56103515625</c:v>
                </c:pt>
                <c:pt idx="200">
                  <c:v>6030.23046875</c:v>
                </c:pt>
                <c:pt idx="201">
                  <c:v>6157.45556640625</c:v>
                </c:pt>
                <c:pt idx="202">
                  <c:v>6210.1103515625</c:v>
                </c:pt>
                <c:pt idx="203">
                  <c:v>6149.7431640625</c:v>
                </c:pt>
                <c:pt idx="204">
                  <c:v>6021.26806640625</c:v>
                </c:pt>
                <c:pt idx="205">
                  <c:v>5916.34716796875</c:v>
                </c:pt>
                <c:pt idx="206">
                  <c:v>5903.65869140625</c:v>
                </c:pt>
                <c:pt idx="207">
                  <c:v>5980.11962890625</c:v>
                </c:pt>
                <c:pt idx="208">
                  <c:v>6078.66357421875</c:v>
                </c:pt>
                <c:pt idx="209">
                  <c:v>6123.412109375</c:v>
                </c:pt>
                <c:pt idx="210">
                  <c:v>6087.57177734375</c:v>
                </c:pt>
                <c:pt idx="211">
                  <c:v>6009.923828125</c:v>
                </c:pt>
                <c:pt idx="212">
                  <c:v>5960.03369140625</c:v>
                </c:pt>
                <c:pt idx="213">
                  <c:v>5982.04150390625</c:v>
                </c:pt>
                <c:pt idx="214">
                  <c:v>6061.408203125</c:v>
                </c:pt>
                <c:pt idx="215">
                  <c:v>6138.642578125</c:v>
                </c:pt>
                <c:pt idx="216">
                  <c:v>6156.67578125</c:v>
                </c:pt>
                <c:pt idx="217">
                  <c:v>6103.77490234375</c:v>
                </c:pt>
                <c:pt idx="218">
                  <c:v>6019.751953125</c:v>
                </c:pt>
                <c:pt idx="219">
                  <c:v>5963.10595703125</c:v>
                </c:pt>
                <c:pt idx="220">
                  <c:v>5966.29296875</c:v>
                </c:pt>
                <c:pt idx="221">
                  <c:v>6013.34326171875</c:v>
                </c:pt>
                <c:pt idx="222">
                  <c:v>6055.005859375</c:v>
                </c:pt>
                <c:pt idx="223">
                  <c:v>6047.80078125</c:v>
                </c:pt>
                <c:pt idx="224">
                  <c:v>5986.845703125</c:v>
                </c:pt>
                <c:pt idx="225">
                  <c:v>5909.11279296875</c:v>
                </c:pt>
                <c:pt idx="226">
                  <c:v>5866.74951171875</c:v>
                </c:pt>
                <c:pt idx="227">
                  <c:v>5891.197265625</c:v>
                </c:pt>
                <c:pt idx="228">
                  <c:v>5973.3583984375</c:v>
                </c:pt>
                <c:pt idx="229">
                  <c:v>6071.640625</c:v>
                </c:pt>
                <c:pt idx="230">
                  <c:v>6139.8056640625</c:v>
                </c:pt>
                <c:pt idx="231">
                  <c:v>6154.4267578125</c:v>
                </c:pt>
                <c:pt idx="232">
                  <c:v>6124.6181640625</c:v>
                </c:pt>
                <c:pt idx="233">
                  <c:v>6080.5078125</c:v>
                </c:pt>
                <c:pt idx="234">
                  <c:v>6051.0830078125</c:v>
                </c:pt>
                <c:pt idx="235">
                  <c:v>6047.2490234375</c:v>
                </c:pt>
                <c:pt idx="236">
                  <c:v>6060.064453125</c:v>
                </c:pt>
                <c:pt idx="237">
                  <c:v>6072.529296875</c:v>
                </c:pt>
                <c:pt idx="238">
                  <c:v>6074.30126953125</c:v>
                </c:pt>
                <c:pt idx="239">
                  <c:v>6068.04736328125</c:v>
                </c:pt>
                <c:pt idx="240">
                  <c:v>6063.54931640625</c:v>
                </c:pt>
                <c:pt idx="241">
                  <c:v>6065.48828125</c:v>
                </c:pt>
                <c:pt idx="242">
                  <c:v>6065.92919921875</c:v>
                </c:pt>
                <c:pt idx="243">
                  <c:v>6048.96923828125</c:v>
                </c:pt>
                <c:pt idx="244">
                  <c:v>6005.1767578125</c:v>
                </c:pt>
                <c:pt idx="245">
                  <c:v>5944.53173828125</c:v>
                </c:pt>
                <c:pt idx="246">
                  <c:v>5895.9111328125</c:v>
                </c:pt>
                <c:pt idx="247">
                  <c:v>5890.40087890625</c:v>
                </c:pt>
                <c:pt idx="248">
                  <c:v>5938.7041015625</c:v>
                </c:pt>
                <c:pt idx="249">
                  <c:v>6019.62060546875</c:v>
                </c:pt>
                <c:pt idx="250">
                  <c:v>6090.4658203125</c:v>
                </c:pt>
                <c:pt idx="251">
                  <c:v>6114.4921875</c:v>
                </c:pt>
                <c:pt idx="252">
                  <c:v>6086.41015625</c:v>
                </c:pt>
                <c:pt idx="253">
                  <c:v>6036.484375</c:v>
                </c:pt>
                <c:pt idx="254">
                  <c:v>6008.55517578125</c:v>
                </c:pt>
                <c:pt idx="255">
                  <c:v>6027.27197265625</c:v>
                </c:pt>
                <c:pt idx="256">
                  <c:v>6079.2705078125</c:v>
                </c:pt>
                <c:pt idx="257">
                  <c:v>6123.4013671875</c:v>
                </c:pt>
                <c:pt idx="258">
                  <c:v>6122.87109375</c:v>
                </c:pt>
                <c:pt idx="259">
                  <c:v>6074.40576171875</c:v>
                </c:pt>
                <c:pt idx="260">
                  <c:v>6011.08349609375</c:v>
                </c:pt>
                <c:pt idx="261">
                  <c:v>5976.0224609375</c:v>
                </c:pt>
                <c:pt idx="262">
                  <c:v>5987.7431640625</c:v>
                </c:pt>
                <c:pt idx="263">
                  <c:v>6025.45751953125</c:v>
                </c:pt>
                <c:pt idx="264">
                  <c:v>6046.9140625</c:v>
                </c:pt>
                <c:pt idx="265">
                  <c:v>6024.8203125</c:v>
                </c:pt>
                <c:pt idx="266">
                  <c:v>5971.8955078125</c:v>
                </c:pt>
                <c:pt idx="267">
                  <c:v>5932.98876953125</c:v>
                </c:pt>
                <c:pt idx="268">
                  <c:v>5949.30419921875</c:v>
                </c:pt>
                <c:pt idx="269">
                  <c:v>6023.13818359375</c:v>
                </c:pt>
                <c:pt idx="270">
                  <c:v>6112.193359375</c:v>
                </c:pt>
                <c:pt idx="271">
                  <c:v>6159.322265625</c:v>
                </c:pt>
                <c:pt idx="272">
                  <c:v>6135.03173828125</c:v>
                </c:pt>
                <c:pt idx="273">
                  <c:v>6059.48291015625</c:v>
                </c:pt>
                <c:pt idx="274">
                  <c:v>5986.89697265625</c:v>
                </c:pt>
                <c:pt idx="275">
                  <c:v>5965.0859375</c:v>
                </c:pt>
                <c:pt idx="276">
                  <c:v>6002</c:v>
                </c:pt>
                <c:pt idx="277">
                  <c:v>6064.439453125</c:v>
                </c:pt>
                <c:pt idx="278">
                  <c:v>6107.44677734375</c:v>
                </c:pt>
                <c:pt idx="279">
                  <c:v>6108.7509765625</c:v>
                </c:pt>
                <c:pt idx="280">
                  <c:v>6080.59521484375</c:v>
                </c:pt>
                <c:pt idx="281">
                  <c:v>6052.02392578125</c:v>
                </c:pt>
                <c:pt idx="282">
                  <c:v>6039.93408203125</c:v>
                </c:pt>
                <c:pt idx="283">
                  <c:v>6035.37109375</c:v>
                </c:pt>
                <c:pt idx="284">
                  <c:v>6016.40283203125</c:v>
                </c:pt>
                <c:pt idx="285">
                  <c:v>5974.3603515625</c:v>
                </c:pt>
                <c:pt idx="286">
                  <c:v>5928.03466796875</c:v>
                </c:pt>
                <c:pt idx="287">
                  <c:v>5911.26513671875</c:v>
                </c:pt>
                <c:pt idx="288">
                  <c:v>5943.58056640625</c:v>
                </c:pt>
                <c:pt idx="289">
                  <c:v>6009.759765625</c:v>
                </c:pt>
                <c:pt idx="290">
                  <c:v>6067.77392578125</c:v>
                </c:pt>
                <c:pt idx="291">
                  <c:v>6080.59716796875</c:v>
                </c:pt>
                <c:pt idx="292">
                  <c:v>6046.3037109375</c:v>
                </c:pt>
                <c:pt idx="293">
                  <c:v>6000.98828125</c:v>
                </c:pt>
                <c:pt idx="294">
                  <c:v>5990.84375</c:v>
                </c:pt>
                <c:pt idx="295">
                  <c:v>6035.15380859375</c:v>
                </c:pt>
                <c:pt idx="296">
                  <c:v>6109.84033203125</c:v>
                </c:pt>
                <c:pt idx="297">
                  <c:v>6164.86865234375</c:v>
                </c:pt>
                <c:pt idx="298">
                  <c:v>6161.77490234375</c:v>
                </c:pt>
                <c:pt idx="299">
                  <c:v>6101.900390625</c:v>
                </c:pt>
                <c:pt idx="300">
                  <c:v>6023.99658203125</c:v>
                </c:pt>
                <c:pt idx="301">
                  <c:v>5974.451171875</c:v>
                </c:pt>
                <c:pt idx="302">
                  <c:v>5974.189453125</c:v>
                </c:pt>
                <c:pt idx="303">
                  <c:v>6007.13134765625</c:v>
                </c:pt>
                <c:pt idx="304">
                  <c:v>6036.625</c:v>
                </c:pt>
                <c:pt idx="305">
                  <c:v>6034.572265625</c:v>
                </c:pt>
                <c:pt idx="306">
                  <c:v>6000.2939453125</c:v>
                </c:pt>
                <c:pt idx="307">
                  <c:v>5957.03857421875</c:v>
                </c:pt>
                <c:pt idx="308">
                  <c:v>5932.59375</c:v>
                </c:pt>
                <c:pt idx="309">
                  <c:v>5941.095703125</c:v>
                </c:pt>
                <c:pt idx="310">
                  <c:v>5978.548828125</c:v>
                </c:pt>
                <c:pt idx="311">
                  <c:v>6031.08935546875</c:v>
                </c:pt>
                <c:pt idx="312">
                  <c:v>6085.33203125</c:v>
                </c:pt>
                <c:pt idx="313">
                  <c:v>6131.86328125</c:v>
                </c:pt>
                <c:pt idx="314">
                  <c:v>6162.34130859375</c:v>
                </c:pt>
                <c:pt idx="315">
                  <c:v>6167.6455078125</c:v>
                </c:pt>
                <c:pt idx="316">
                  <c:v>6142.3125</c:v>
                </c:pt>
                <c:pt idx="317">
                  <c:v>6092.12451171875</c:v>
                </c:pt>
                <c:pt idx="318">
                  <c:v>6036.20947265625</c:v>
                </c:pt>
                <c:pt idx="319">
                  <c:v>5998.564453125</c:v>
                </c:pt>
                <c:pt idx="320">
                  <c:v>5993.5859375</c:v>
                </c:pt>
                <c:pt idx="321">
                  <c:v>6016.767578125</c:v>
                </c:pt>
                <c:pt idx="322">
                  <c:v>6048.47314453125</c:v>
                </c:pt>
                <c:pt idx="323">
                  <c:v>6067.99072265625</c:v>
                </c:pt>
                <c:pt idx="324">
                  <c:v>6066.45947265625</c:v>
                </c:pt>
                <c:pt idx="325">
                  <c:v>6048.6806640625</c:v>
                </c:pt>
                <c:pt idx="326">
                  <c:v>6024.05615234375</c:v>
                </c:pt>
                <c:pt idx="327">
                  <c:v>5996.61767578125</c:v>
                </c:pt>
                <c:pt idx="328">
                  <c:v>5964.2294921875</c:v>
                </c:pt>
                <c:pt idx="329">
                  <c:v>5927.4150390625</c:v>
                </c:pt>
                <c:pt idx="330">
                  <c:v>5897.86328125</c:v>
                </c:pt>
                <c:pt idx="331">
                  <c:v>5895.70458984375</c:v>
                </c:pt>
                <c:pt idx="332">
                  <c:v>5934.74755859375</c:v>
                </c:pt>
                <c:pt idx="333">
                  <c:v>6007.26123046875</c:v>
                </c:pt>
                <c:pt idx="334">
                  <c:v>6082.8671875</c:v>
                </c:pt>
                <c:pt idx="335">
                  <c:v>6125.765625</c:v>
                </c:pt>
                <c:pt idx="336">
                  <c:v>6118.90625</c:v>
                </c:pt>
                <c:pt idx="337">
                  <c:v>6076.31689453125</c:v>
                </c:pt>
                <c:pt idx="338">
                  <c:v>6032.857421875</c:v>
                </c:pt>
                <c:pt idx="339">
                  <c:v>6018.36767578125</c:v>
                </c:pt>
                <c:pt idx="340">
                  <c:v>6036.0654296875</c:v>
                </c:pt>
                <c:pt idx="341">
                  <c:v>6062.16259765625</c:v>
                </c:pt>
                <c:pt idx="342">
                  <c:v>6066.8544921875</c:v>
                </c:pt>
                <c:pt idx="343">
                  <c:v>6039.720703125</c:v>
                </c:pt>
                <c:pt idx="344">
                  <c:v>5999.10888671875</c:v>
                </c:pt>
                <c:pt idx="345">
                  <c:v>5978.07177734375</c:v>
                </c:pt>
                <c:pt idx="346">
                  <c:v>5998.2490234375</c:v>
                </c:pt>
                <c:pt idx="347">
                  <c:v>6052.44482421875</c:v>
                </c:pt>
                <c:pt idx="348">
                  <c:v>6109.30322265625</c:v>
                </c:pt>
                <c:pt idx="349">
                  <c:v>6135.84228515625</c:v>
                </c:pt>
              </c:numCache>
            </c:numRef>
          </c:yVal>
          <c:smooth val="1"/>
          <c:extLst>
            <c:ext xmlns:c16="http://schemas.microsoft.com/office/drawing/2014/chart" uri="{C3380CC4-5D6E-409C-BE32-E72D297353CC}">
              <c16:uniqueId val="{0000000B-5429-4359-BD11-807CF8F8408D}"/>
            </c:ext>
          </c:extLst>
        </c:ser>
        <c:ser>
          <c:idx val="12"/>
          <c:order val="12"/>
          <c:tx>
            <c:strRef>
              <c:f>np_sub_003!$M$1</c:f>
              <c:strCache>
                <c:ptCount val="1"/>
                <c:pt idx="0">
                  <c:v>Coor_13</c:v>
                </c:pt>
              </c:strCache>
            </c:strRef>
          </c:tx>
          <c:spPr>
            <a:ln w="28575" cap="rnd">
              <a:solidFill>
                <a:schemeClr val="accent1">
                  <a:lumMod val="80000"/>
                  <a:lumOff val="20000"/>
                </a:schemeClr>
              </a:solidFill>
              <a:round/>
            </a:ln>
            <a:effectLst/>
          </c:spPr>
          <c:marker>
            <c:symbol val="none"/>
          </c:marker>
          <c:yVal>
            <c:numRef>
              <c:f>np_sub_003!$M$2:$M$351</c:f>
              <c:numCache>
                <c:formatCode>0.00000000000_ </c:formatCode>
                <c:ptCount val="350"/>
                <c:pt idx="0">
                  <c:v>7367.55078125</c:v>
                </c:pt>
                <c:pt idx="1">
                  <c:v>7315.7861328125</c:v>
                </c:pt>
                <c:pt idx="2">
                  <c:v>7273.80029296875</c:v>
                </c:pt>
                <c:pt idx="3">
                  <c:v>7269.578125</c:v>
                </c:pt>
                <c:pt idx="4">
                  <c:v>7312.03369140625</c:v>
                </c:pt>
                <c:pt idx="5">
                  <c:v>7386.88330078125</c:v>
                </c:pt>
                <c:pt idx="6">
                  <c:v>7465.81689453125</c:v>
                </c:pt>
                <c:pt idx="7">
                  <c:v>7520.67919921875</c:v>
                </c:pt>
                <c:pt idx="8">
                  <c:v>7533.6689453125</c:v>
                </c:pt>
                <c:pt idx="9">
                  <c:v>7500.59375</c:v>
                </c:pt>
                <c:pt idx="10">
                  <c:v>7430.06982421875</c:v>
                </c:pt>
                <c:pt idx="11">
                  <c:v>7341.8505859375</c:v>
                </c:pt>
                <c:pt idx="12">
                  <c:v>7263.4716796875</c:v>
                </c:pt>
                <c:pt idx="13">
                  <c:v>7222.15087890625</c:v>
                </c:pt>
                <c:pt idx="14">
                  <c:v>7232.32080078125</c:v>
                </c:pt>
                <c:pt idx="15">
                  <c:v>7285.6357421875</c:v>
                </c:pt>
                <c:pt idx="16">
                  <c:v>7352.525390625</c:v>
                </c:pt>
                <c:pt idx="17">
                  <c:v>7397.9599609375</c:v>
                </c:pt>
                <c:pt idx="18">
                  <c:v>7402.82958984375</c:v>
                </c:pt>
                <c:pt idx="19">
                  <c:v>7375.91064453125</c:v>
                </c:pt>
                <c:pt idx="20">
                  <c:v>7346.662109375</c:v>
                </c:pt>
                <c:pt idx="21">
                  <c:v>7343.2900390625</c:v>
                </c:pt>
                <c:pt idx="22">
                  <c:v>7372.333984375</c:v>
                </c:pt>
                <c:pt idx="23">
                  <c:v>7415.21923828125</c:v>
                </c:pt>
                <c:pt idx="24">
                  <c:v>7443.80224609375</c:v>
                </c:pt>
                <c:pt idx="25">
                  <c:v>7441.79541015625</c:v>
                </c:pt>
                <c:pt idx="26">
                  <c:v>7414.89208984375</c:v>
                </c:pt>
                <c:pt idx="27">
                  <c:v>7382.77099609375</c:v>
                </c:pt>
                <c:pt idx="28">
                  <c:v>7361.7666015625</c:v>
                </c:pt>
                <c:pt idx="29">
                  <c:v>7354.15576171875</c:v>
                </c:pt>
                <c:pt idx="30">
                  <c:v>7352.5546875</c:v>
                </c:pt>
                <c:pt idx="31">
                  <c:v>7353.07470703125</c:v>
                </c:pt>
                <c:pt idx="32">
                  <c:v>7362.55712890625</c:v>
                </c:pt>
                <c:pt idx="33">
                  <c:v>7391.369140625</c:v>
                </c:pt>
                <c:pt idx="34">
                  <c:v>7438.29248046875</c:v>
                </c:pt>
                <c:pt idx="35">
                  <c:v>7483.5234375</c:v>
                </c:pt>
                <c:pt idx="36">
                  <c:v>7499.875</c:v>
                </c:pt>
                <c:pt idx="37">
                  <c:v>7475.19873046875</c:v>
                </c:pt>
                <c:pt idx="38">
                  <c:v>7426.40625</c:v>
                </c:pt>
                <c:pt idx="39">
                  <c:v>7390.0048828125</c:v>
                </c:pt>
                <c:pt idx="40">
                  <c:v>7393.62158203125</c:v>
                </c:pt>
                <c:pt idx="41">
                  <c:v>7431.1376953125</c:v>
                </c:pt>
                <c:pt idx="42">
                  <c:v>7463.86767578125</c:v>
                </c:pt>
                <c:pt idx="43">
                  <c:v>7449.96435546875</c:v>
                </c:pt>
                <c:pt idx="44">
                  <c:v>7379.9462890625</c:v>
                </c:pt>
                <c:pt idx="45">
                  <c:v>7288.93701171875</c:v>
                </c:pt>
                <c:pt idx="46">
                  <c:v>7233.5126953125</c:v>
                </c:pt>
                <c:pt idx="47">
                  <c:v>7249.72119140625</c:v>
                </c:pt>
                <c:pt idx="48">
                  <c:v>7325.13916015625</c:v>
                </c:pt>
                <c:pt idx="49">
                  <c:v>7407.52197265625</c:v>
                </c:pt>
                <c:pt idx="50">
                  <c:v>7443.45947265625</c:v>
                </c:pt>
                <c:pt idx="51">
                  <c:v>7416.439453125</c:v>
                </c:pt>
                <c:pt idx="52">
                  <c:v>7354.701171875</c:v>
                </c:pt>
                <c:pt idx="53">
                  <c:v>7304.46142578125</c:v>
                </c:pt>
                <c:pt idx="54">
                  <c:v>7292.22509765625</c:v>
                </c:pt>
                <c:pt idx="55">
                  <c:v>7307.5517578125</c:v>
                </c:pt>
                <c:pt idx="56">
                  <c:v>7318.86572265625</c:v>
                </c:pt>
                <c:pt idx="57">
                  <c:v>7306.23046875</c:v>
                </c:pt>
                <c:pt idx="58">
                  <c:v>7281.14208984375</c:v>
                </c:pt>
                <c:pt idx="59">
                  <c:v>7275.84619140625</c:v>
                </c:pt>
                <c:pt idx="60">
                  <c:v>7312.14306640625</c:v>
                </c:pt>
                <c:pt idx="61">
                  <c:v>7377.98388671875</c:v>
                </c:pt>
                <c:pt idx="62">
                  <c:v>7433.4716796875</c:v>
                </c:pt>
                <c:pt idx="63">
                  <c:v>7442.13525390625</c:v>
                </c:pt>
                <c:pt idx="64">
                  <c:v>7401.0986328125</c:v>
                </c:pt>
                <c:pt idx="65">
                  <c:v>7344.34228515625</c:v>
                </c:pt>
                <c:pt idx="66">
                  <c:v>7316.0947265625</c:v>
                </c:pt>
                <c:pt idx="67">
                  <c:v>7336.662109375</c:v>
                </c:pt>
                <c:pt idx="68">
                  <c:v>7388.94287109375</c:v>
                </c:pt>
                <c:pt idx="69">
                  <c:v>7435.72509765625</c:v>
                </c:pt>
                <c:pt idx="70">
                  <c:v>7451.5732421875</c:v>
                </c:pt>
                <c:pt idx="71">
                  <c:v>7441.5107421875</c:v>
                </c:pt>
                <c:pt idx="72">
                  <c:v>7431.36669921875</c:v>
                </c:pt>
                <c:pt idx="73">
                  <c:v>7440.0791015625</c:v>
                </c:pt>
                <c:pt idx="74">
                  <c:v>7460.01318359375</c:v>
                </c:pt>
                <c:pt idx="75">
                  <c:v>7463.7724609375</c:v>
                </c:pt>
                <c:pt idx="76">
                  <c:v>7431.94580078125</c:v>
                </c:pt>
                <c:pt idx="77">
                  <c:v>7376.8642578125</c:v>
                </c:pt>
                <c:pt idx="78">
                  <c:v>7339.78369140625</c:v>
                </c:pt>
                <c:pt idx="79">
                  <c:v>7361.12646484375</c:v>
                </c:pt>
                <c:pt idx="80">
                  <c:v>7446.64501953125</c:v>
                </c:pt>
                <c:pt idx="81">
                  <c:v>7556.96923828125</c:v>
                </c:pt>
                <c:pt idx="82">
                  <c:v>7630.06640625</c:v>
                </c:pt>
                <c:pt idx="83">
                  <c:v>7620.6396484375</c:v>
                </c:pt>
                <c:pt idx="84">
                  <c:v>7527.98876953125</c:v>
                </c:pt>
                <c:pt idx="85">
                  <c:v>7393.68701171875</c:v>
                </c:pt>
                <c:pt idx="86">
                  <c:v>7273.46240234375</c:v>
                </c:pt>
                <c:pt idx="87">
                  <c:v>7205.1484375</c:v>
                </c:pt>
                <c:pt idx="88">
                  <c:v>7193.81982421875</c:v>
                </c:pt>
                <c:pt idx="89">
                  <c:v>7219.3583984375</c:v>
                </c:pt>
                <c:pt idx="90">
                  <c:v>7255.2412109375</c:v>
                </c:pt>
                <c:pt idx="91">
                  <c:v>7282.99853515625</c:v>
                </c:pt>
                <c:pt idx="92">
                  <c:v>7295.3427734375</c:v>
                </c:pt>
                <c:pt idx="93">
                  <c:v>7292.30615234375</c:v>
                </c:pt>
                <c:pt idx="94">
                  <c:v>7278.42333984375</c:v>
                </c:pt>
                <c:pt idx="95">
                  <c:v>7263.50244140625</c:v>
                </c:pt>
                <c:pt idx="96">
                  <c:v>7262.3857421875</c:v>
                </c:pt>
                <c:pt idx="97">
                  <c:v>7288.65576171875</c:v>
                </c:pt>
                <c:pt idx="98">
                  <c:v>7344.15576171875</c:v>
                </c:pt>
                <c:pt idx="99">
                  <c:v>7413.0029296875</c:v>
                </c:pt>
                <c:pt idx="100">
                  <c:v>7467.6728515625</c:v>
                </c:pt>
                <c:pt idx="101">
                  <c:v>7485.29638671875</c:v>
                </c:pt>
                <c:pt idx="102">
                  <c:v>7462.78466796875</c:v>
                </c:pt>
                <c:pt idx="103">
                  <c:v>7418.79052734375</c:v>
                </c:pt>
                <c:pt idx="104">
                  <c:v>7380.34130859375</c:v>
                </c:pt>
                <c:pt idx="105">
                  <c:v>7364.2568359375</c:v>
                </c:pt>
                <c:pt idx="106">
                  <c:v>7367.66015625</c:v>
                </c:pt>
                <c:pt idx="107">
                  <c:v>7374.30615234375</c:v>
                </c:pt>
                <c:pt idx="108">
                  <c:v>7370.517578125</c:v>
                </c:pt>
                <c:pt idx="109">
                  <c:v>7357.16650390625</c:v>
                </c:pt>
                <c:pt idx="110">
                  <c:v>7348.28662109375</c:v>
                </c:pt>
                <c:pt idx="111">
                  <c:v>7358.501953125</c:v>
                </c:pt>
                <c:pt idx="112">
                  <c:v>7390.3857421875</c:v>
                </c:pt>
                <c:pt idx="113">
                  <c:v>7431.92822265625</c:v>
                </c:pt>
                <c:pt idx="114">
                  <c:v>7465.13330078125</c:v>
                </c:pt>
                <c:pt idx="115">
                  <c:v>7477.81689453125</c:v>
                </c:pt>
                <c:pt idx="116">
                  <c:v>7469.36767578125</c:v>
                </c:pt>
                <c:pt idx="117">
                  <c:v>7447.64599609375</c:v>
                </c:pt>
                <c:pt idx="118">
                  <c:v>7421.759765625</c:v>
                </c:pt>
                <c:pt idx="119">
                  <c:v>7397.5693359375</c:v>
                </c:pt>
                <c:pt idx="120">
                  <c:v>7378.42529296875</c:v>
                </c:pt>
                <c:pt idx="121">
                  <c:v>7367.970703125</c:v>
                </c:pt>
                <c:pt idx="122">
                  <c:v>7370.3876953125</c:v>
                </c:pt>
                <c:pt idx="123">
                  <c:v>7387.05224609375</c:v>
                </c:pt>
                <c:pt idx="124">
                  <c:v>7413.015625</c:v>
                </c:pt>
                <c:pt idx="125">
                  <c:v>7437.34130859375</c:v>
                </c:pt>
                <c:pt idx="126">
                  <c:v>7447.7412109375</c:v>
                </c:pt>
                <c:pt idx="127">
                  <c:v>7436.1298828125</c:v>
                </c:pt>
                <c:pt idx="128">
                  <c:v>7401.53125</c:v>
                </c:pt>
                <c:pt idx="129">
                  <c:v>7349.98046875</c:v>
                </c:pt>
                <c:pt idx="130">
                  <c:v>7293.61181640625</c:v>
                </c:pt>
                <c:pt idx="131">
                  <c:v>7249.8818359375</c:v>
                </c:pt>
                <c:pt idx="132">
                  <c:v>7238.47509765625</c:v>
                </c:pt>
                <c:pt idx="133">
                  <c:v>7272.8486328125</c:v>
                </c:pt>
                <c:pt idx="134">
                  <c:v>7348.3427734375</c:v>
                </c:pt>
                <c:pt idx="135">
                  <c:v>7435.66943359375</c:v>
                </c:pt>
                <c:pt idx="136">
                  <c:v>7489.57421875</c:v>
                </c:pt>
                <c:pt idx="137">
                  <c:v>7473.30908203125</c:v>
                </c:pt>
                <c:pt idx="138">
                  <c:v>7385.45166015625</c:v>
                </c:pt>
                <c:pt idx="139">
                  <c:v>7268.63623046875</c:v>
                </c:pt>
                <c:pt idx="140">
                  <c:v>7188.7314453125</c:v>
                </c:pt>
                <c:pt idx="141">
                  <c:v>7194.14501953125</c:v>
                </c:pt>
                <c:pt idx="142">
                  <c:v>7282.4873046875</c:v>
                </c:pt>
                <c:pt idx="143">
                  <c:v>7400.2548828125</c:v>
                </c:pt>
                <c:pt idx="144">
                  <c:v>7478.65234375</c:v>
                </c:pt>
                <c:pt idx="145">
                  <c:v>7481.12158203125</c:v>
                </c:pt>
                <c:pt idx="146">
                  <c:v>7427.44287109375</c:v>
                </c:pt>
                <c:pt idx="147">
                  <c:v>7375.64599609375</c:v>
                </c:pt>
                <c:pt idx="148">
                  <c:v>7375.10986328125</c:v>
                </c:pt>
                <c:pt idx="149">
                  <c:v>7427.12646484375</c:v>
                </c:pt>
                <c:pt idx="150">
                  <c:v>7484.02392578125</c:v>
                </c:pt>
                <c:pt idx="151">
                  <c:v>7487.84716796875</c:v>
                </c:pt>
                <c:pt idx="152">
                  <c:v>7418.13818359375</c:v>
                </c:pt>
                <c:pt idx="153">
                  <c:v>7310.82568359375</c:v>
                </c:pt>
                <c:pt idx="154">
                  <c:v>7232.93994140625</c:v>
                </c:pt>
                <c:pt idx="155">
                  <c:v>7232.8564453125</c:v>
                </c:pt>
                <c:pt idx="156">
                  <c:v>7304.8994140625</c:v>
                </c:pt>
                <c:pt idx="157">
                  <c:v>7395.3671875</c:v>
                </c:pt>
                <c:pt idx="158">
                  <c:v>7444.119140625</c:v>
                </c:pt>
                <c:pt idx="159">
                  <c:v>7428.5185546875</c:v>
                </c:pt>
                <c:pt idx="160">
                  <c:v>7376.25</c:v>
                </c:pt>
                <c:pt idx="161">
                  <c:v>7339.4482421875</c:v>
                </c:pt>
                <c:pt idx="162">
                  <c:v>7352.94677734375</c:v>
                </c:pt>
                <c:pt idx="163">
                  <c:v>7409.9208984375</c:v>
                </c:pt>
                <c:pt idx="164">
                  <c:v>7471.77197265625</c:v>
                </c:pt>
                <c:pt idx="165">
                  <c:v>7500.78857421875</c:v>
                </c:pt>
                <c:pt idx="166">
                  <c:v>7487.4560546875</c:v>
                </c:pt>
                <c:pt idx="167">
                  <c:v>7451.771484375</c:v>
                </c:pt>
                <c:pt idx="168">
                  <c:v>7421.25634765625</c:v>
                </c:pt>
                <c:pt idx="169">
                  <c:v>7407.1171875</c:v>
                </c:pt>
                <c:pt idx="170">
                  <c:v>7398.998046875</c:v>
                </c:pt>
                <c:pt idx="171">
                  <c:v>7380.6376953125</c:v>
                </c:pt>
                <c:pt idx="172">
                  <c:v>7350.1513671875</c:v>
                </c:pt>
                <c:pt idx="173">
                  <c:v>7325.525390625</c:v>
                </c:pt>
                <c:pt idx="174">
                  <c:v>7329.88134765625</c:v>
                </c:pt>
                <c:pt idx="175">
                  <c:v>7369.23779296875</c:v>
                </c:pt>
                <c:pt idx="176">
                  <c:v>7422.2255859375</c:v>
                </c:pt>
                <c:pt idx="177">
                  <c:v>7451.34033203125</c:v>
                </c:pt>
                <c:pt idx="178">
                  <c:v>7427.89599609375</c:v>
                </c:pt>
                <c:pt idx="179">
                  <c:v>7352.28076171875</c:v>
                </c:pt>
                <c:pt idx="180">
                  <c:v>7255.2666015625</c:v>
                </c:pt>
                <c:pt idx="181">
                  <c:v>7180.40673828125</c:v>
                </c:pt>
                <c:pt idx="182">
                  <c:v>7160.17041015625</c:v>
                </c:pt>
                <c:pt idx="183">
                  <c:v>7200.64697265625</c:v>
                </c:pt>
                <c:pt idx="184">
                  <c:v>7281.87353515625</c:v>
                </c:pt>
                <c:pt idx="185">
                  <c:v>7370.572265625</c:v>
                </c:pt>
                <c:pt idx="186">
                  <c:v>7436.62646484375</c:v>
                </c:pt>
                <c:pt idx="187">
                  <c:v>7465.41259765625</c:v>
                </c:pt>
                <c:pt idx="188">
                  <c:v>7461.91552734375</c:v>
                </c:pt>
                <c:pt idx="189">
                  <c:v>7445.95068359375</c:v>
                </c:pt>
                <c:pt idx="190">
                  <c:v>7440.37744140625</c:v>
                </c:pt>
                <c:pt idx="191">
                  <c:v>7457.11083984375</c:v>
                </c:pt>
                <c:pt idx="192">
                  <c:v>7488.4111328125</c:v>
                </c:pt>
                <c:pt idx="193">
                  <c:v>7510.197265625</c:v>
                </c:pt>
                <c:pt idx="194">
                  <c:v>7497.66259765625</c:v>
                </c:pt>
                <c:pt idx="195">
                  <c:v>7444.15087890625</c:v>
                </c:pt>
                <c:pt idx="196">
                  <c:v>7369.404296875</c:v>
                </c:pt>
                <c:pt idx="197">
                  <c:v>7308.9013671875</c:v>
                </c:pt>
                <c:pt idx="198">
                  <c:v>7289.91650390625</c:v>
                </c:pt>
                <c:pt idx="199">
                  <c:v>7311.73486328125</c:v>
                </c:pt>
                <c:pt idx="200">
                  <c:v>7346.35791015625</c:v>
                </c:pt>
                <c:pt idx="201">
                  <c:v>7360.86474609375</c:v>
                </c:pt>
                <c:pt idx="202">
                  <c:v>7344.49853515625</c:v>
                </c:pt>
                <c:pt idx="203">
                  <c:v>7317.93359375</c:v>
                </c:pt>
                <c:pt idx="204">
                  <c:v>7315.4013671875</c:v>
                </c:pt>
                <c:pt idx="205">
                  <c:v>7352.97412109375</c:v>
                </c:pt>
                <c:pt idx="206">
                  <c:v>7409.666015625</c:v>
                </c:pt>
                <c:pt idx="207">
                  <c:v>7439.58154296875</c:v>
                </c:pt>
                <c:pt idx="208">
                  <c:v>7408.35986328125</c:v>
                </c:pt>
                <c:pt idx="209">
                  <c:v>7325.49267578125</c:v>
                </c:pt>
                <c:pt idx="210">
                  <c:v>7244.578125</c:v>
                </c:pt>
                <c:pt idx="211">
                  <c:v>7227.52978515625</c:v>
                </c:pt>
                <c:pt idx="212">
                  <c:v>7297.9990234375</c:v>
                </c:pt>
                <c:pt idx="213">
                  <c:v>7419.9296875</c:v>
                </c:pt>
                <c:pt idx="214">
                  <c:v>7519.580078125</c:v>
                </c:pt>
                <c:pt idx="215">
                  <c:v>7536.359375</c:v>
                </c:pt>
                <c:pt idx="216">
                  <c:v>7465.2822265625</c:v>
                </c:pt>
                <c:pt idx="217">
                  <c:v>7359.69482421875</c:v>
                </c:pt>
                <c:pt idx="218">
                  <c:v>7292.7548828125</c:v>
                </c:pt>
                <c:pt idx="219">
                  <c:v>7306.72021484375</c:v>
                </c:pt>
                <c:pt idx="220">
                  <c:v>7386.91357421875</c:v>
                </c:pt>
                <c:pt idx="221">
                  <c:v>7477.14013671875</c:v>
                </c:pt>
                <c:pt idx="222">
                  <c:v>7521.98291015625</c:v>
                </c:pt>
                <c:pt idx="223">
                  <c:v>7503.22021484375</c:v>
                </c:pt>
                <c:pt idx="224">
                  <c:v>7445.3115234375</c:v>
                </c:pt>
                <c:pt idx="225">
                  <c:v>7390.4091796875</c:v>
                </c:pt>
                <c:pt idx="226">
                  <c:v>7365.5927734375</c:v>
                </c:pt>
                <c:pt idx="227">
                  <c:v>7367.47802734375</c:v>
                </c:pt>
                <c:pt idx="228">
                  <c:v>7372.5888671875</c:v>
                </c:pt>
                <c:pt idx="229">
                  <c:v>7361.115234375</c:v>
                </c:pt>
                <c:pt idx="230">
                  <c:v>7333.470703125</c:v>
                </c:pt>
                <c:pt idx="231">
                  <c:v>7307.94775390625</c:v>
                </c:pt>
                <c:pt idx="232">
                  <c:v>7304.27734375</c:v>
                </c:pt>
                <c:pt idx="233">
                  <c:v>7328.05712890625</c:v>
                </c:pt>
                <c:pt idx="234">
                  <c:v>7367.880859375</c:v>
                </c:pt>
                <c:pt idx="235">
                  <c:v>7405.24462890625</c:v>
                </c:pt>
                <c:pt idx="236">
                  <c:v>7427.5888671875</c:v>
                </c:pt>
                <c:pt idx="237">
                  <c:v>7434.27978515625</c:v>
                </c:pt>
                <c:pt idx="238">
                  <c:v>7432.6025390625</c:v>
                </c:pt>
                <c:pt idx="239">
                  <c:v>7428.771484375</c:v>
                </c:pt>
                <c:pt idx="240">
                  <c:v>7421.5703125</c:v>
                </c:pt>
                <c:pt idx="241">
                  <c:v>7402.9599609375</c:v>
                </c:pt>
                <c:pt idx="242">
                  <c:v>7364.6953125</c:v>
                </c:pt>
                <c:pt idx="243">
                  <c:v>7306.54541015625</c:v>
                </c:pt>
                <c:pt idx="244">
                  <c:v>7241.21337890625</c:v>
                </c:pt>
                <c:pt idx="245">
                  <c:v>7192.4775390625</c:v>
                </c:pt>
                <c:pt idx="246">
                  <c:v>7185.6982421875</c:v>
                </c:pt>
                <c:pt idx="247">
                  <c:v>7233.681640625</c:v>
                </c:pt>
                <c:pt idx="248">
                  <c:v>7325.13134765625</c:v>
                </c:pt>
                <c:pt idx="249">
                  <c:v>7424.46240234375</c:v>
                </c:pt>
                <c:pt idx="250">
                  <c:v>7487.2265625</c:v>
                </c:pt>
                <c:pt idx="251">
                  <c:v>7485.2578125</c:v>
                </c:pt>
                <c:pt idx="252">
                  <c:v>7426.27392578125</c:v>
                </c:pt>
                <c:pt idx="253">
                  <c:v>7352.52099609375</c:v>
                </c:pt>
                <c:pt idx="254">
                  <c:v>7315.42529296875</c:v>
                </c:pt>
                <c:pt idx="255">
                  <c:v>7340.99365234375</c:v>
                </c:pt>
                <c:pt idx="256">
                  <c:v>7410.35791015625</c:v>
                </c:pt>
                <c:pt idx="257">
                  <c:v>7471.6845703125</c:v>
                </c:pt>
                <c:pt idx="258">
                  <c:v>7477.416015625</c:v>
                </c:pt>
                <c:pt idx="259">
                  <c:v>7420.54541015625</c:v>
                </c:pt>
                <c:pt idx="260">
                  <c:v>7342.115234375</c:v>
                </c:pt>
                <c:pt idx="261">
                  <c:v>7302.43505859375</c:v>
                </c:pt>
                <c:pt idx="262">
                  <c:v>7336.25732421875</c:v>
                </c:pt>
                <c:pt idx="263">
                  <c:v>7425.6064453125</c:v>
                </c:pt>
                <c:pt idx="264">
                  <c:v>7511.57470703125</c:v>
                </c:pt>
                <c:pt idx="265">
                  <c:v>7536.935546875</c:v>
                </c:pt>
                <c:pt idx="266">
                  <c:v>7487.6513671875</c:v>
                </c:pt>
                <c:pt idx="267">
                  <c:v>7402.15625</c:v>
                </c:pt>
                <c:pt idx="268">
                  <c:v>7342.1376953125</c:v>
                </c:pt>
                <c:pt idx="269">
                  <c:v>7347.79736328125</c:v>
                </c:pt>
                <c:pt idx="270">
                  <c:v>7411.259765625</c:v>
                </c:pt>
                <c:pt idx="271">
                  <c:v>7486.23974609375</c:v>
                </c:pt>
                <c:pt idx="272">
                  <c:v>7523.61181640625</c:v>
                </c:pt>
                <c:pt idx="273">
                  <c:v>7504.13916015625</c:v>
                </c:pt>
                <c:pt idx="274">
                  <c:v>7444.99658203125</c:v>
                </c:pt>
                <c:pt idx="275">
                  <c:v>7379.56591796875</c:v>
                </c:pt>
                <c:pt idx="276">
                  <c:v>7330.52490234375</c:v>
                </c:pt>
                <c:pt idx="277">
                  <c:v>7298.27294921875</c:v>
                </c:pt>
                <c:pt idx="278">
                  <c:v>7270.66650390625</c:v>
                </c:pt>
                <c:pt idx="279">
                  <c:v>7241.34130859375</c:v>
                </c:pt>
                <c:pt idx="280">
                  <c:v>7218.5400390625</c:v>
                </c:pt>
                <c:pt idx="281">
                  <c:v>7217.4208984375</c:v>
                </c:pt>
                <c:pt idx="282">
                  <c:v>7244.74462890625</c:v>
                </c:pt>
                <c:pt idx="283">
                  <c:v>7290.947265625</c:v>
                </c:pt>
                <c:pt idx="284">
                  <c:v>7336.44140625</c:v>
                </c:pt>
                <c:pt idx="285">
                  <c:v>7365.35107421875</c:v>
                </c:pt>
                <c:pt idx="286">
                  <c:v>7373.95166015625</c:v>
                </c:pt>
                <c:pt idx="287">
                  <c:v>7367.75390625</c:v>
                </c:pt>
                <c:pt idx="288">
                  <c:v>7352.9609375</c:v>
                </c:pt>
                <c:pt idx="289">
                  <c:v>7332.83447265625</c:v>
                </c:pt>
                <c:pt idx="290">
                  <c:v>7312.69482421875</c:v>
                </c:pt>
                <c:pt idx="291">
                  <c:v>7306.09130859375</c:v>
                </c:pt>
                <c:pt idx="292">
                  <c:v>7331.36865234375</c:v>
                </c:pt>
                <c:pt idx="293">
                  <c:v>7396.943359375</c:v>
                </c:pt>
                <c:pt idx="294">
                  <c:v>7487.015625</c:v>
                </c:pt>
                <c:pt idx="295">
                  <c:v>7563.359375</c:v>
                </c:pt>
                <c:pt idx="296">
                  <c:v>7587.21240234375</c:v>
                </c:pt>
                <c:pt idx="297">
                  <c:v>7546.94482421875</c:v>
                </c:pt>
                <c:pt idx="298">
                  <c:v>7468.82080078125</c:v>
                </c:pt>
                <c:pt idx="299">
                  <c:v>7399.34228515625</c:v>
                </c:pt>
                <c:pt idx="300">
                  <c:v>7370.80078125</c:v>
                </c:pt>
                <c:pt idx="301">
                  <c:v>7377.30859375</c:v>
                </c:pt>
                <c:pt idx="302">
                  <c:v>7381.97021484375</c:v>
                </c:pt>
                <c:pt idx="303">
                  <c:v>7350.783203125</c:v>
                </c:pt>
                <c:pt idx="304">
                  <c:v>7285.7236328125</c:v>
                </c:pt>
                <c:pt idx="305">
                  <c:v>7228.4384765625</c:v>
                </c:pt>
                <c:pt idx="306">
                  <c:v>7229.2890625</c:v>
                </c:pt>
                <c:pt idx="307">
                  <c:v>7305.5341796875</c:v>
                </c:pt>
                <c:pt idx="308">
                  <c:v>7422.81103515625</c:v>
                </c:pt>
                <c:pt idx="309">
                  <c:v>7516.357421875</c:v>
                </c:pt>
                <c:pt idx="310">
                  <c:v>7536.57373046875</c:v>
                </c:pt>
                <c:pt idx="311">
                  <c:v>7483.72119140625</c:v>
                </c:pt>
                <c:pt idx="312">
                  <c:v>7405.14306640625</c:v>
                </c:pt>
                <c:pt idx="313">
                  <c:v>7358.26513671875</c:v>
                </c:pt>
                <c:pt idx="314">
                  <c:v>7369.13671875</c:v>
                </c:pt>
                <c:pt idx="315">
                  <c:v>7418.0595703125</c:v>
                </c:pt>
                <c:pt idx="316">
                  <c:v>7460.50634765625</c:v>
                </c:pt>
                <c:pt idx="317">
                  <c:v>7463.3388671875</c:v>
                </c:pt>
                <c:pt idx="318">
                  <c:v>7426.52392578125</c:v>
                </c:pt>
                <c:pt idx="319">
                  <c:v>7375.76123046875</c:v>
                </c:pt>
                <c:pt idx="320">
                  <c:v>7336.9560546875</c:v>
                </c:pt>
                <c:pt idx="321">
                  <c:v>7316.91015625</c:v>
                </c:pt>
                <c:pt idx="322">
                  <c:v>7305.59619140625</c:v>
                </c:pt>
                <c:pt idx="323">
                  <c:v>7293.81689453125</c:v>
                </c:pt>
                <c:pt idx="324">
                  <c:v>7286.31494140625</c:v>
                </c:pt>
                <c:pt idx="325">
                  <c:v>7296.63525390625</c:v>
                </c:pt>
                <c:pt idx="326">
                  <c:v>7329.36376953125</c:v>
                </c:pt>
                <c:pt idx="327">
                  <c:v>7368.982421875</c:v>
                </c:pt>
                <c:pt idx="328">
                  <c:v>7389.02001953125</c:v>
                </c:pt>
                <c:pt idx="329">
                  <c:v>7375.40234375</c:v>
                </c:pt>
                <c:pt idx="330">
                  <c:v>7342.44189453125</c:v>
                </c:pt>
                <c:pt idx="331">
                  <c:v>7324.24658203125</c:v>
                </c:pt>
                <c:pt idx="332">
                  <c:v>7345.85546875</c:v>
                </c:pt>
                <c:pt idx="333">
                  <c:v>7398.27734375</c:v>
                </c:pt>
                <c:pt idx="334">
                  <c:v>7441.04638671875</c:v>
                </c:pt>
                <c:pt idx="335">
                  <c:v>7433.64013671875</c:v>
                </c:pt>
                <c:pt idx="336">
                  <c:v>7371.40673828125</c:v>
                </c:pt>
                <c:pt idx="337">
                  <c:v>7295.18603515625</c:v>
                </c:pt>
                <c:pt idx="338">
                  <c:v>7263.611328125</c:v>
                </c:pt>
                <c:pt idx="339">
                  <c:v>7307.81396484375</c:v>
                </c:pt>
                <c:pt idx="340">
                  <c:v>7404.32568359375</c:v>
                </c:pt>
                <c:pt idx="341">
                  <c:v>7489.13916015625</c:v>
                </c:pt>
                <c:pt idx="342">
                  <c:v>7503.77880859375</c:v>
                </c:pt>
                <c:pt idx="343">
                  <c:v>7438.55517578125</c:v>
                </c:pt>
                <c:pt idx="344">
                  <c:v>7339.896484375</c:v>
                </c:pt>
                <c:pt idx="345">
                  <c:v>7276.41796875</c:v>
                </c:pt>
                <c:pt idx="346">
                  <c:v>7289.94921875</c:v>
                </c:pt>
                <c:pt idx="347">
                  <c:v>7368.208984375</c:v>
                </c:pt>
                <c:pt idx="348">
                  <c:v>7457.7431640625</c:v>
                </c:pt>
                <c:pt idx="349">
                  <c:v>7504.5302734375</c:v>
                </c:pt>
              </c:numCache>
            </c:numRef>
          </c:yVal>
          <c:smooth val="1"/>
          <c:extLst>
            <c:ext xmlns:c16="http://schemas.microsoft.com/office/drawing/2014/chart" uri="{C3380CC4-5D6E-409C-BE32-E72D297353CC}">
              <c16:uniqueId val="{0000000C-5429-4359-BD11-807CF8F8408D}"/>
            </c:ext>
          </c:extLst>
        </c:ser>
        <c:ser>
          <c:idx val="13"/>
          <c:order val="13"/>
          <c:tx>
            <c:strRef>
              <c:f>np_sub_003!$N$1</c:f>
              <c:strCache>
                <c:ptCount val="1"/>
                <c:pt idx="0">
                  <c:v>Coor_14</c:v>
                </c:pt>
              </c:strCache>
            </c:strRef>
          </c:tx>
          <c:spPr>
            <a:ln w="28575" cap="rnd">
              <a:solidFill>
                <a:schemeClr val="accent2">
                  <a:lumMod val="80000"/>
                  <a:lumOff val="20000"/>
                </a:schemeClr>
              </a:solidFill>
              <a:round/>
            </a:ln>
            <a:effectLst/>
          </c:spPr>
          <c:marker>
            <c:symbol val="none"/>
          </c:marker>
          <c:yVal>
            <c:numRef>
              <c:f>np_sub_003!$N$2:$N$351</c:f>
              <c:numCache>
                <c:formatCode>0.00000000000_ </c:formatCode>
                <c:ptCount val="350"/>
                <c:pt idx="0">
                  <c:v>7780.1181640625</c:v>
                </c:pt>
                <c:pt idx="1">
                  <c:v>7819.576171875</c:v>
                </c:pt>
                <c:pt idx="2">
                  <c:v>7852.32470703125</c:v>
                </c:pt>
                <c:pt idx="3">
                  <c:v>7852.71240234375</c:v>
                </c:pt>
                <c:pt idx="4">
                  <c:v>7811.55810546875</c:v>
                </c:pt>
                <c:pt idx="5">
                  <c:v>7747.4111328125</c:v>
                </c:pt>
                <c:pt idx="6">
                  <c:v>7698.169921875</c:v>
                </c:pt>
                <c:pt idx="7">
                  <c:v>7696.3115234375</c:v>
                </c:pt>
                <c:pt idx="8">
                  <c:v>7744.57861328125</c:v>
                </c:pt>
                <c:pt idx="9">
                  <c:v>7810.681640625</c:v>
                </c:pt>
                <c:pt idx="10">
                  <c:v>7846.94140625</c:v>
                </c:pt>
                <c:pt idx="11">
                  <c:v>7822.52490234375</c:v>
                </c:pt>
                <c:pt idx="12">
                  <c:v>7745.85400390625</c:v>
                </c:pt>
                <c:pt idx="13">
                  <c:v>7660.9267578125</c:v>
                </c:pt>
                <c:pt idx="14">
                  <c:v>7619.51953125</c:v>
                </c:pt>
                <c:pt idx="15">
                  <c:v>7648.154296875</c:v>
                </c:pt>
                <c:pt idx="16">
                  <c:v>7731.9375</c:v>
                </c:pt>
                <c:pt idx="17">
                  <c:v>7824.99267578125</c:v>
                </c:pt>
                <c:pt idx="18">
                  <c:v>7878.82177734375</c:v>
                </c:pt>
                <c:pt idx="19">
                  <c:v>7869.04443359375</c:v>
                </c:pt>
                <c:pt idx="20">
                  <c:v>7804.46875</c:v>
                </c:pt>
                <c:pt idx="21">
                  <c:v>7716.2978515625</c:v>
                </c:pt>
                <c:pt idx="22">
                  <c:v>7638.2216796875</c:v>
                </c:pt>
                <c:pt idx="23">
                  <c:v>7591.35302734375</c:v>
                </c:pt>
                <c:pt idx="24">
                  <c:v>7580.94921875</c:v>
                </c:pt>
                <c:pt idx="25">
                  <c:v>7601.94580078125</c:v>
                </c:pt>
                <c:pt idx="26">
                  <c:v>7645.52685546875</c:v>
                </c:pt>
                <c:pt idx="27">
                  <c:v>7701.6748046875</c:v>
                </c:pt>
                <c:pt idx="28">
                  <c:v>7758.6689453125</c:v>
                </c:pt>
                <c:pt idx="29">
                  <c:v>7803.734375</c:v>
                </c:pt>
                <c:pt idx="30">
                  <c:v>7827.00439453125</c:v>
                </c:pt>
                <c:pt idx="31">
                  <c:v>7826.50537109375</c:v>
                </c:pt>
                <c:pt idx="32">
                  <c:v>7809.7734375</c:v>
                </c:pt>
                <c:pt idx="33">
                  <c:v>7790.07373046875</c:v>
                </c:pt>
                <c:pt idx="34">
                  <c:v>7779.5751953125</c:v>
                </c:pt>
                <c:pt idx="35">
                  <c:v>7784.09326171875</c:v>
                </c:pt>
                <c:pt idx="36">
                  <c:v>7802.2138671875</c:v>
                </c:pt>
                <c:pt idx="37">
                  <c:v>7827.7900390625</c:v>
                </c:pt>
                <c:pt idx="38">
                  <c:v>7852.72802734375</c:v>
                </c:pt>
                <c:pt idx="39">
                  <c:v>7868.3427734375</c:v>
                </c:pt>
                <c:pt idx="40">
                  <c:v>7866.39013671875</c:v>
                </c:pt>
                <c:pt idx="41">
                  <c:v>7841.78662109375</c:v>
                </c:pt>
                <c:pt idx="42">
                  <c:v>7796.734375</c:v>
                </c:pt>
                <c:pt idx="43">
                  <c:v>7742.8544921875</c:v>
                </c:pt>
                <c:pt idx="44">
                  <c:v>7697.77685546875</c:v>
                </c:pt>
                <c:pt idx="45">
                  <c:v>7676.5458984375</c:v>
                </c:pt>
                <c:pt idx="46">
                  <c:v>7683.1298828125</c:v>
                </c:pt>
                <c:pt idx="47">
                  <c:v>7708.4814453125</c:v>
                </c:pt>
                <c:pt idx="48">
                  <c:v>7737.10595703125</c:v>
                </c:pt>
                <c:pt idx="49">
                  <c:v>7757.24951171875</c:v>
                </c:pt>
                <c:pt idx="50">
                  <c:v>7766.64697265625</c:v>
                </c:pt>
                <c:pt idx="51">
                  <c:v>7769.48876953125</c:v>
                </c:pt>
                <c:pt idx="52">
                  <c:v>7768.15673828125</c:v>
                </c:pt>
                <c:pt idx="53">
                  <c:v>7758.29638671875</c:v>
                </c:pt>
                <c:pt idx="54">
                  <c:v>7733.0400390625</c:v>
                </c:pt>
                <c:pt idx="55">
                  <c:v>7693.42626953125</c:v>
                </c:pt>
                <c:pt idx="56">
                  <c:v>7654.95751953125</c:v>
                </c:pt>
                <c:pt idx="57">
                  <c:v>7641.76025390625</c:v>
                </c:pt>
                <c:pt idx="58">
                  <c:v>7669.88134765625</c:v>
                </c:pt>
                <c:pt idx="59">
                  <c:v>7731.8408203125</c:v>
                </c:pt>
                <c:pt idx="60">
                  <c:v>7796.142578125</c:v>
                </c:pt>
                <c:pt idx="61">
                  <c:v>7825.306640625</c:v>
                </c:pt>
                <c:pt idx="62">
                  <c:v>7801.2666015625</c:v>
                </c:pt>
                <c:pt idx="63">
                  <c:v>7739.552734375</c:v>
                </c:pt>
                <c:pt idx="64">
                  <c:v>7680.47900390625</c:v>
                </c:pt>
                <c:pt idx="65">
                  <c:v>7662.2958984375</c:v>
                </c:pt>
                <c:pt idx="66">
                  <c:v>7695.2783203125</c:v>
                </c:pt>
                <c:pt idx="67">
                  <c:v>7755.7763671875</c:v>
                </c:pt>
                <c:pt idx="68">
                  <c:v>7804.68310546875</c:v>
                </c:pt>
                <c:pt idx="69">
                  <c:v>7816.4853515625</c:v>
                </c:pt>
                <c:pt idx="70">
                  <c:v>7797.10302734375</c:v>
                </c:pt>
                <c:pt idx="71">
                  <c:v>7777.3037109375</c:v>
                </c:pt>
                <c:pt idx="72">
                  <c:v>7787.064453125</c:v>
                </c:pt>
                <c:pt idx="73">
                  <c:v>7830.60693359375</c:v>
                </c:pt>
                <c:pt idx="74">
                  <c:v>7881.1220703125</c:v>
                </c:pt>
                <c:pt idx="75">
                  <c:v>7899.25537109375</c:v>
                </c:pt>
                <c:pt idx="76">
                  <c:v>7861.7578125</c:v>
                </c:pt>
                <c:pt idx="77">
                  <c:v>7779.513671875</c:v>
                </c:pt>
                <c:pt idx="78">
                  <c:v>7692.251953125</c:v>
                </c:pt>
                <c:pt idx="79">
                  <c:v>7643.9970703125</c:v>
                </c:pt>
                <c:pt idx="80">
                  <c:v>7656.251953125</c:v>
                </c:pt>
                <c:pt idx="81">
                  <c:v>7716.26416015625</c:v>
                </c:pt>
                <c:pt idx="82">
                  <c:v>7786.4638671875</c:v>
                </c:pt>
                <c:pt idx="83">
                  <c:v>7827.2333984375</c:v>
                </c:pt>
                <c:pt idx="84">
                  <c:v>7818.12939453125</c:v>
                </c:pt>
                <c:pt idx="85">
                  <c:v>7765.9951171875</c:v>
                </c:pt>
                <c:pt idx="86">
                  <c:v>7697.9853515625</c:v>
                </c:pt>
                <c:pt idx="87">
                  <c:v>7646.0595703125</c:v>
                </c:pt>
                <c:pt idx="88">
                  <c:v>7632.09716796875</c:v>
                </c:pt>
                <c:pt idx="89">
                  <c:v>7659.84326171875</c:v>
                </c:pt>
                <c:pt idx="90">
                  <c:v>7715.15185546875</c:v>
                </c:pt>
                <c:pt idx="91">
                  <c:v>7772.7587890625</c:v>
                </c:pt>
                <c:pt idx="92">
                  <c:v>7806.76025390625</c:v>
                </c:pt>
                <c:pt idx="93">
                  <c:v>7801.61376953125</c:v>
                </c:pt>
                <c:pt idx="94">
                  <c:v>7759.8671875</c:v>
                </c:pt>
                <c:pt idx="95">
                  <c:v>7702.7451171875</c:v>
                </c:pt>
                <c:pt idx="96">
                  <c:v>7661.765625</c:v>
                </c:pt>
                <c:pt idx="97">
                  <c:v>7663.95263671875</c:v>
                </c:pt>
                <c:pt idx="98">
                  <c:v>7717.59326171875</c:v>
                </c:pt>
                <c:pt idx="99">
                  <c:v>7806.49755859375</c:v>
                </c:pt>
                <c:pt idx="100">
                  <c:v>7896.75146484375</c:v>
                </c:pt>
                <c:pt idx="101">
                  <c:v>7952.8515625</c:v>
                </c:pt>
                <c:pt idx="102">
                  <c:v>7954.44287109375</c:v>
                </c:pt>
                <c:pt idx="103">
                  <c:v>7904.470703125</c:v>
                </c:pt>
                <c:pt idx="104">
                  <c:v>7824.8818359375</c:v>
                </c:pt>
                <c:pt idx="105">
                  <c:v>7743.50146484375</c:v>
                </c:pt>
                <c:pt idx="106">
                  <c:v>7680.48828125</c:v>
                </c:pt>
                <c:pt idx="107">
                  <c:v>7641.97119140625</c:v>
                </c:pt>
                <c:pt idx="108">
                  <c:v>7623.0302734375</c:v>
                </c:pt>
                <c:pt idx="109">
                  <c:v>7616.1298828125</c:v>
                </c:pt>
                <c:pt idx="110">
                  <c:v>7618.380859375</c:v>
                </c:pt>
                <c:pt idx="111">
                  <c:v>7632.974609375</c:v>
                </c:pt>
                <c:pt idx="112">
                  <c:v>7664.80859375</c:v>
                </c:pt>
                <c:pt idx="113">
                  <c:v>7714.287109375</c:v>
                </c:pt>
                <c:pt idx="114">
                  <c:v>7773.9892578125</c:v>
                </c:pt>
                <c:pt idx="115">
                  <c:v>7830.376953125</c:v>
                </c:pt>
                <c:pt idx="116">
                  <c:v>7869.20068359375</c:v>
                </c:pt>
                <c:pt idx="117">
                  <c:v>7881.21875</c:v>
                </c:pt>
                <c:pt idx="118">
                  <c:v>7865.33984375</c:v>
                </c:pt>
                <c:pt idx="119">
                  <c:v>7828.357421875</c:v>
                </c:pt>
                <c:pt idx="120">
                  <c:v>7782.29150390625</c:v>
                </c:pt>
                <c:pt idx="121">
                  <c:v>7740.75732421875</c:v>
                </c:pt>
                <c:pt idx="122">
                  <c:v>7715.17822265625</c:v>
                </c:pt>
                <c:pt idx="123">
                  <c:v>7711.18408203125</c:v>
                </c:pt>
                <c:pt idx="124">
                  <c:v>7726.10205078125</c:v>
                </c:pt>
                <c:pt idx="125">
                  <c:v>7749.26611328125</c:v>
                </c:pt>
                <c:pt idx="126">
                  <c:v>7766.50390625</c:v>
                </c:pt>
                <c:pt idx="127">
                  <c:v>7767.8271484375</c:v>
                </c:pt>
                <c:pt idx="128">
                  <c:v>7754.2236328125</c:v>
                </c:pt>
                <c:pt idx="129">
                  <c:v>7738.37255859375</c:v>
                </c:pt>
                <c:pt idx="130">
                  <c:v>7736.99853515625</c:v>
                </c:pt>
                <c:pt idx="131">
                  <c:v>7758.4736328125</c:v>
                </c:pt>
                <c:pt idx="132">
                  <c:v>7794.07177734375</c:v>
                </c:pt>
                <c:pt idx="133">
                  <c:v>7820.52685546875</c:v>
                </c:pt>
                <c:pt idx="134">
                  <c:v>7814.4248046875</c:v>
                </c:pt>
                <c:pt idx="135">
                  <c:v>7769.775390625</c:v>
                </c:pt>
                <c:pt idx="136">
                  <c:v>7705.89599609375</c:v>
                </c:pt>
                <c:pt idx="137">
                  <c:v>7657.94384765625</c:v>
                </c:pt>
                <c:pt idx="138">
                  <c:v>7654.486328125</c:v>
                </c:pt>
                <c:pt idx="139">
                  <c:v>7697.0361328125</c:v>
                </c:pt>
                <c:pt idx="140">
                  <c:v>7756.8828125</c:v>
                </c:pt>
                <c:pt idx="141">
                  <c:v>7793.24072265625</c:v>
                </c:pt>
                <c:pt idx="142">
                  <c:v>7781.1806640625</c:v>
                </c:pt>
                <c:pt idx="143">
                  <c:v>7729.6357421875</c:v>
                </c:pt>
                <c:pt idx="144">
                  <c:v>7675.966796875</c:v>
                </c:pt>
                <c:pt idx="145">
                  <c:v>7660.2919921875</c:v>
                </c:pt>
                <c:pt idx="146">
                  <c:v>7697.857421875</c:v>
                </c:pt>
                <c:pt idx="147">
                  <c:v>7769.4091796875</c:v>
                </c:pt>
                <c:pt idx="148">
                  <c:v>7836.1435546875</c:v>
                </c:pt>
                <c:pt idx="149">
                  <c:v>7867.37939453125</c:v>
                </c:pt>
                <c:pt idx="150">
                  <c:v>7859.84912109375</c:v>
                </c:pt>
                <c:pt idx="151">
                  <c:v>7834.7119140625</c:v>
                </c:pt>
                <c:pt idx="152">
                  <c:v>7816.33544921875</c:v>
                </c:pt>
                <c:pt idx="153">
                  <c:v>7811.162109375</c:v>
                </c:pt>
                <c:pt idx="154">
                  <c:v>7804.20947265625</c:v>
                </c:pt>
                <c:pt idx="155">
                  <c:v>7775.576171875</c:v>
                </c:pt>
                <c:pt idx="156">
                  <c:v>7722.31298828125</c:v>
                </c:pt>
                <c:pt idx="157">
                  <c:v>7666.23388671875</c:v>
                </c:pt>
                <c:pt idx="158">
                  <c:v>7639.791015625</c:v>
                </c:pt>
                <c:pt idx="159">
                  <c:v>7660.640625</c:v>
                </c:pt>
                <c:pt idx="160">
                  <c:v>7715.65625</c:v>
                </c:pt>
                <c:pt idx="161">
                  <c:v>7768.318359375</c:v>
                </c:pt>
                <c:pt idx="162">
                  <c:v>7784.86767578125</c:v>
                </c:pt>
                <c:pt idx="163">
                  <c:v>7759.31640625</c:v>
                </c:pt>
                <c:pt idx="164">
                  <c:v>7717.8330078125</c:v>
                </c:pt>
                <c:pt idx="165">
                  <c:v>7698.890625</c:v>
                </c:pt>
                <c:pt idx="166">
                  <c:v>7724.31982421875</c:v>
                </c:pt>
                <c:pt idx="167">
                  <c:v>7783.119140625</c:v>
                </c:pt>
                <c:pt idx="168">
                  <c:v>7839.640625</c:v>
                </c:pt>
                <c:pt idx="169">
                  <c:v>7859.05126953125</c:v>
                </c:pt>
                <c:pt idx="170">
                  <c:v>7830.61474609375</c:v>
                </c:pt>
                <c:pt idx="171">
                  <c:v>7772.46923828125</c:v>
                </c:pt>
                <c:pt idx="172">
                  <c:v>7716.62646484375</c:v>
                </c:pt>
                <c:pt idx="173">
                  <c:v>7687.388671875</c:v>
                </c:pt>
                <c:pt idx="174">
                  <c:v>7689.23828125</c:v>
                </c:pt>
                <c:pt idx="175">
                  <c:v>7710.66650390625</c:v>
                </c:pt>
                <c:pt idx="176">
                  <c:v>7737.39501953125</c:v>
                </c:pt>
                <c:pt idx="177">
                  <c:v>7762.66796875</c:v>
                </c:pt>
                <c:pt idx="178">
                  <c:v>7787.26904296875</c:v>
                </c:pt>
                <c:pt idx="179">
                  <c:v>7811.99658203125</c:v>
                </c:pt>
                <c:pt idx="180">
                  <c:v>7831.3720703125</c:v>
                </c:pt>
                <c:pt idx="181">
                  <c:v>7834.8916015625</c:v>
                </c:pt>
                <c:pt idx="182">
                  <c:v>7814.48095703125</c:v>
                </c:pt>
                <c:pt idx="183">
                  <c:v>7771.310546875</c:v>
                </c:pt>
                <c:pt idx="184">
                  <c:v>7716.326171875</c:v>
                </c:pt>
                <c:pt idx="185">
                  <c:v>7664.732421875</c:v>
                </c:pt>
                <c:pt idx="186">
                  <c:v>7629.39111328125</c:v>
                </c:pt>
                <c:pt idx="187">
                  <c:v>7617.6533203125</c:v>
                </c:pt>
                <c:pt idx="188">
                  <c:v>7631.8662109375</c:v>
                </c:pt>
                <c:pt idx="189">
                  <c:v>7670.4404296875</c:v>
                </c:pt>
                <c:pt idx="190">
                  <c:v>7727.212890625</c:v>
                </c:pt>
                <c:pt idx="191">
                  <c:v>7790.39697265625</c:v>
                </c:pt>
                <c:pt idx="192">
                  <c:v>7844.37744140625</c:v>
                </c:pt>
                <c:pt idx="193">
                  <c:v>7875.40478515625</c:v>
                </c:pt>
                <c:pt idx="194">
                  <c:v>7877.95361328125</c:v>
                </c:pt>
                <c:pt idx="195">
                  <c:v>7856.73681640625</c:v>
                </c:pt>
                <c:pt idx="196">
                  <c:v>7822.58154296875</c:v>
                </c:pt>
                <c:pt idx="197">
                  <c:v>7785.80224609375</c:v>
                </c:pt>
                <c:pt idx="198">
                  <c:v>7752.9267578125</c:v>
                </c:pt>
                <c:pt idx="199">
                  <c:v>7728.947265625</c:v>
                </c:pt>
                <c:pt idx="200">
                  <c:v>7720.89404296875</c:v>
                </c:pt>
                <c:pt idx="201">
                  <c:v>7736.15673828125</c:v>
                </c:pt>
                <c:pt idx="202">
                  <c:v>7774.0537109375</c:v>
                </c:pt>
                <c:pt idx="203">
                  <c:v>7817.70751953125</c:v>
                </c:pt>
                <c:pt idx="204">
                  <c:v>7836.8076171875</c:v>
                </c:pt>
                <c:pt idx="205">
                  <c:v>7804.884765625</c:v>
                </c:pt>
                <c:pt idx="206">
                  <c:v>7721.50244140625</c:v>
                </c:pt>
                <c:pt idx="207">
                  <c:v>7621.5341796875</c:v>
                </c:pt>
                <c:pt idx="208">
                  <c:v>7559.69140625</c:v>
                </c:pt>
                <c:pt idx="209">
                  <c:v>7576.4677734375</c:v>
                </c:pt>
                <c:pt idx="210">
                  <c:v>7668.21435546875</c:v>
                </c:pt>
                <c:pt idx="211">
                  <c:v>7784.69384765625</c:v>
                </c:pt>
                <c:pt idx="212">
                  <c:v>7859.17919921875</c:v>
                </c:pt>
                <c:pt idx="213">
                  <c:v>7851.8037109375</c:v>
                </c:pt>
                <c:pt idx="214">
                  <c:v>7775.46875</c:v>
                </c:pt>
                <c:pt idx="215">
                  <c:v>7685.3798828125</c:v>
                </c:pt>
                <c:pt idx="216">
                  <c:v>7640.0849609375</c:v>
                </c:pt>
                <c:pt idx="217">
                  <c:v>7663.07763671875</c:v>
                </c:pt>
                <c:pt idx="218">
                  <c:v>7732.7392578125</c:v>
                </c:pt>
                <c:pt idx="219">
                  <c:v>7805.517578125</c:v>
                </c:pt>
                <c:pt idx="220">
                  <c:v>7851.24462890625</c:v>
                </c:pt>
                <c:pt idx="221">
                  <c:v>7871.35009765625</c:v>
                </c:pt>
                <c:pt idx="222">
                  <c:v>7886.81689453125</c:v>
                </c:pt>
                <c:pt idx="223">
                  <c:v>7909.23681640625</c:v>
                </c:pt>
                <c:pt idx="224">
                  <c:v>7922.82080078125</c:v>
                </c:pt>
                <c:pt idx="225">
                  <c:v>7895.35888671875</c:v>
                </c:pt>
                <c:pt idx="226">
                  <c:v>7810.134765625</c:v>
                </c:pt>
                <c:pt idx="227">
                  <c:v>7690.85107421875</c:v>
                </c:pt>
                <c:pt idx="228">
                  <c:v>7595.171875</c:v>
                </c:pt>
                <c:pt idx="229">
                  <c:v>7577.5048828125</c:v>
                </c:pt>
                <c:pt idx="230">
                  <c:v>7647.89892578125</c:v>
                </c:pt>
                <c:pt idx="231">
                  <c:v>7759.5517578125</c:v>
                </c:pt>
                <c:pt idx="232">
                  <c:v>7836.998046875</c:v>
                </c:pt>
                <c:pt idx="233">
                  <c:v>7826.271484375</c:v>
                </c:pt>
                <c:pt idx="234">
                  <c:v>7731.2861328125</c:v>
                </c:pt>
                <c:pt idx="235">
                  <c:v>7610.6640625</c:v>
                </c:pt>
                <c:pt idx="236">
                  <c:v>7538.14794921875</c:v>
                </c:pt>
                <c:pt idx="237">
                  <c:v>7555.32080078125</c:v>
                </c:pt>
                <c:pt idx="238">
                  <c:v>7648.7705078125</c:v>
                </c:pt>
                <c:pt idx="239">
                  <c:v>7764.2421875</c:v>
                </c:pt>
                <c:pt idx="240">
                  <c:v>7844.00341796875</c:v>
                </c:pt>
                <c:pt idx="241">
                  <c:v>7860.2529296875</c:v>
                </c:pt>
                <c:pt idx="242">
                  <c:v>7824.6201171875</c:v>
                </c:pt>
                <c:pt idx="243">
                  <c:v>7773.14306640625</c:v>
                </c:pt>
                <c:pt idx="244">
                  <c:v>7741.5888671875</c:v>
                </c:pt>
                <c:pt idx="245">
                  <c:v>7747.677734375</c:v>
                </c:pt>
                <c:pt idx="246">
                  <c:v>7787.16748046875</c:v>
                </c:pt>
                <c:pt idx="247">
                  <c:v>7840.259765625</c:v>
                </c:pt>
                <c:pt idx="248">
                  <c:v>7881.44970703125</c:v>
                </c:pt>
                <c:pt idx="249">
                  <c:v>7889.06982421875</c:v>
                </c:pt>
                <c:pt idx="250">
                  <c:v>7854.07275390625</c:v>
                </c:pt>
                <c:pt idx="251">
                  <c:v>7786.474609375</c:v>
                </c:pt>
                <c:pt idx="252">
                  <c:v>7714.701171875</c:v>
                </c:pt>
                <c:pt idx="253">
                  <c:v>7673.8427734375</c:v>
                </c:pt>
                <c:pt idx="254">
                  <c:v>7685.9521484375</c:v>
                </c:pt>
                <c:pt idx="255">
                  <c:v>7744.0458984375</c:v>
                </c:pt>
                <c:pt idx="256">
                  <c:v>7812.6162109375</c:v>
                </c:pt>
                <c:pt idx="257">
                  <c:v>7847.65966796875</c:v>
                </c:pt>
                <c:pt idx="258">
                  <c:v>7824.49560546875</c:v>
                </c:pt>
                <c:pt idx="259">
                  <c:v>7754.0751953125</c:v>
                </c:pt>
                <c:pt idx="260">
                  <c:v>7675.4560546875</c:v>
                </c:pt>
                <c:pt idx="261">
                  <c:v>7629.4541015625</c:v>
                </c:pt>
                <c:pt idx="262">
                  <c:v>7632.705078125</c:v>
                </c:pt>
                <c:pt idx="263">
                  <c:v>7670.74365234375</c:v>
                </c:pt>
                <c:pt idx="264">
                  <c:v>7713.51904296875</c:v>
                </c:pt>
                <c:pt idx="265">
                  <c:v>7739.30859375</c:v>
                </c:pt>
                <c:pt idx="266">
                  <c:v>7747.6171875</c:v>
                </c:pt>
                <c:pt idx="267">
                  <c:v>7752.40087890625</c:v>
                </c:pt>
                <c:pt idx="268">
                  <c:v>7764.234375</c:v>
                </c:pt>
                <c:pt idx="269">
                  <c:v>7778.84912109375</c:v>
                </c:pt>
                <c:pt idx="270">
                  <c:v>7782.4462890625</c:v>
                </c:pt>
                <c:pt idx="271">
                  <c:v>7767.97509765625</c:v>
                </c:pt>
                <c:pt idx="272">
                  <c:v>7745.9521484375</c:v>
                </c:pt>
                <c:pt idx="273">
                  <c:v>7738.09814453125</c:v>
                </c:pt>
                <c:pt idx="274">
                  <c:v>7758.07373046875</c:v>
                </c:pt>
                <c:pt idx="275">
                  <c:v>7796.5087890625</c:v>
                </c:pt>
                <c:pt idx="276">
                  <c:v>7825.2255859375</c:v>
                </c:pt>
                <c:pt idx="277">
                  <c:v>7819.28466796875</c:v>
                </c:pt>
                <c:pt idx="278">
                  <c:v>7779.1259765625</c:v>
                </c:pt>
                <c:pt idx="279">
                  <c:v>7733.287109375</c:v>
                </c:pt>
                <c:pt idx="280">
                  <c:v>7717.4736328125</c:v>
                </c:pt>
                <c:pt idx="281">
                  <c:v>7745.736328125</c:v>
                </c:pt>
                <c:pt idx="282">
                  <c:v>7797.22705078125</c:v>
                </c:pt>
                <c:pt idx="283">
                  <c:v>7830.27392578125</c:v>
                </c:pt>
                <c:pt idx="284">
                  <c:v>7813.615234375</c:v>
                </c:pt>
                <c:pt idx="285">
                  <c:v>7750.4853515625</c:v>
                </c:pt>
                <c:pt idx="286">
                  <c:v>7676.69775390625</c:v>
                </c:pt>
                <c:pt idx="287">
                  <c:v>7634.517578125</c:v>
                </c:pt>
                <c:pt idx="288">
                  <c:v>7643.07177734375</c:v>
                </c:pt>
                <c:pt idx="289">
                  <c:v>7687.9287109375</c:v>
                </c:pt>
                <c:pt idx="290">
                  <c:v>7736.265625</c:v>
                </c:pt>
                <c:pt idx="291">
                  <c:v>7763.50146484375</c:v>
                </c:pt>
                <c:pt idx="292">
                  <c:v>7769.29541015625</c:v>
                </c:pt>
                <c:pt idx="293">
                  <c:v>7771.3115234375</c:v>
                </c:pt>
                <c:pt idx="294">
                  <c:v>7784.50634765625</c:v>
                </c:pt>
                <c:pt idx="295">
                  <c:v>7805.361328125</c:v>
                </c:pt>
                <c:pt idx="296">
                  <c:v>7815.0087890625</c:v>
                </c:pt>
                <c:pt idx="297">
                  <c:v>7798.01220703125</c:v>
                </c:pt>
                <c:pt idx="298">
                  <c:v>7759.65283203125</c:v>
                </c:pt>
                <c:pt idx="299">
                  <c:v>7725.796875</c:v>
                </c:pt>
                <c:pt idx="300">
                  <c:v>7724.33984375</c:v>
                </c:pt>
                <c:pt idx="301">
                  <c:v>7762.95166015625</c:v>
                </c:pt>
                <c:pt idx="302">
                  <c:v>7821.19091796875</c:v>
                </c:pt>
                <c:pt idx="303">
                  <c:v>7863.484375</c:v>
                </c:pt>
                <c:pt idx="304">
                  <c:v>7862.9580078125</c:v>
                </c:pt>
                <c:pt idx="305">
                  <c:v>7818.22705078125</c:v>
                </c:pt>
                <c:pt idx="306">
                  <c:v>7751.76953125</c:v>
                </c:pt>
                <c:pt idx="307">
                  <c:v>7693.26611328125</c:v>
                </c:pt>
                <c:pt idx="308">
                  <c:v>7661.83154296875</c:v>
                </c:pt>
                <c:pt idx="309">
                  <c:v>7659.5380859375</c:v>
                </c:pt>
                <c:pt idx="310">
                  <c:v>7677.72265625</c:v>
                </c:pt>
                <c:pt idx="311">
                  <c:v>7707.37548828125</c:v>
                </c:pt>
                <c:pt idx="312">
                  <c:v>7743.78271484375</c:v>
                </c:pt>
                <c:pt idx="313">
                  <c:v>7783.1611328125</c:v>
                </c:pt>
                <c:pt idx="314">
                  <c:v>7817.40234375</c:v>
                </c:pt>
                <c:pt idx="315">
                  <c:v>7834.44482421875</c:v>
                </c:pt>
                <c:pt idx="316">
                  <c:v>7825.392578125</c:v>
                </c:pt>
                <c:pt idx="317">
                  <c:v>7791.978515625</c:v>
                </c:pt>
                <c:pt idx="318">
                  <c:v>7746.72412109375</c:v>
                </c:pt>
                <c:pt idx="319">
                  <c:v>7704.6005859375</c:v>
                </c:pt>
                <c:pt idx="320">
                  <c:v>7673.125</c:v>
                </c:pt>
                <c:pt idx="321">
                  <c:v>7649.837890625</c:v>
                </c:pt>
                <c:pt idx="322">
                  <c:v>7629.697265625</c:v>
                </c:pt>
                <c:pt idx="323">
                  <c:v>7615.55126953125</c:v>
                </c:pt>
                <c:pt idx="324">
                  <c:v>7621.0947265625</c:v>
                </c:pt>
                <c:pt idx="325">
                  <c:v>7661.57470703125</c:v>
                </c:pt>
                <c:pt idx="326">
                  <c:v>7738.43505859375</c:v>
                </c:pt>
                <c:pt idx="327">
                  <c:v>7830.8017578125</c:v>
                </c:pt>
                <c:pt idx="328">
                  <c:v>7902.8544921875</c:v>
                </c:pt>
                <c:pt idx="329">
                  <c:v>7924.13037109375</c:v>
                </c:pt>
                <c:pt idx="330">
                  <c:v>7889.0615234375</c:v>
                </c:pt>
                <c:pt idx="331">
                  <c:v>7821.41259765625</c:v>
                </c:pt>
                <c:pt idx="332">
                  <c:v>7759.736328125</c:v>
                </c:pt>
                <c:pt idx="333">
                  <c:v>7733.64892578125</c:v>
                </c:pt>
                <c:pt idx="334">
                  <c:v>7747.23828125</c:v>
                </c:pt>
                <c:pt idx="335">
                  <c:v>7780.36376953125</c:v>
                </c:pt>
                <c:pt idx="336">
                  <c:v>7805.466796875</c:v>
                </c:pt>
                <c:pt idx="337">
                  <c:v>7806.849609375</c:v>
                </c:pt>
                <c:pt idx="338">
                  <c:v>7788.830078125</c:v>
                </c:pt>
                <c:pt idx="339">
                  <c:v>7768.52294921875</c:v>
                </c:pt>
                <c:pt idx="340">
                  <c:v>7760.525390625</c:v>
                </c:pt>
                <c:pt idx="341">
                  <c:v>7765.81982421875</c:v>
                </c:pt>
                <c:pt idx="342">
                  <c:v>7772.69091796875</c:v>
                </c:pt>
                <c:pt idx="343">
                  <c:v>7767.609375</c:v>
                </c:pt>
                <c:pt idx="344">
                  <c:v>7746.759765625</c:v>
                </c:pt>
                <c:pt idx="345">
                  <c:v>7719.310546875</c:v>
                </c:pt>
                <c:pt idx="346">
                  <c:v>7700.533203125</c:v>
                </c:pt>
                <c:pt idx="347">
                  <c:v>7700.6279296875</c:v>
                </c:pt>
                <c:pt idx="348">
                  <c:v>7717.75</c:v>
                </c:pt>
                <c:pt idx="349">
                  <c:v>7739.9248046875</c:v>
                </c:pt>
              </c:numCache>
            </c:numRef>
          </c:yVal>
          <c:smooth val="1"/>
          <c:extLst>
            <c:ext xmlns:c16="http://schemas.microsoft.com/office/drawing/2014/chart" uri="{C3380CC4-5D6E-409C-BE32-E72D297353CC}">
              <c16:uniqueId val="{0000000D-5429-4359-BD11-807CF8F8408D}"/>
            </c:ext>
          </c:extLst>
        </c:ser>
        <c:ser>
          <c:idx val="14"/>
          <c:order val="14"/>
          <c:tx>
            <c:strRef>
              <c:f>np_sub_003!$O$1</c:f>
              <c:strCache>
                <c:ptCount val="1"/>
                <c:pt idx="0">
                  <c:v>Coor_15</c:v>
                </c:pt>
              </c:strCache>
            </c:strRef>
          </c:tx>
          <c:spPr>
            <a:ln w="28575" cap="rnd">
              <a:solidFill>
                <a:schemeClr val="accent3">
                  <a:lumMod val="80000"/>
                  <a:lumOff val="20000"/>
                </a:schemeClr>
              </a:solidFill>
              <a:round/>
            </a:ln>
            <a:effectLst/>
          </c:spPr>
          <c:marker>
            <c:symbol val="none"/>
          </c:marker>
          <c:yVal>
            <c:numRef>
              <c:f>np_sub_003!$O$2:$O$351</c:f>
              <c:numCache>
                <c:formatCode>0.00000000000_ </c:formatCode>
                <c:ptCount val="350"/>
                <c:pt idx="0">
                  <c:v>6940.69482421875</c:v>
                </c:pt>
                <c:pt idx="1">
                  <c:v>7010.45849609375</c:v>
                </c:pt>
                <c:pt idx="2">
                  <c:v>7101.90869140625</c:v>
                </c:pt>
                <c:pt idx="3">
                  <c:v>7157.4697265625</c:v>
                </c:pt>
                <c:pt idx="4">
                  <c:v>7138.9091796875</c:v>
                </c:pt>
                <c:pt idx="5">
                  <c:v>7057.88427734375</c:v>
                </c:pt>
                <c:pt idx="6">
                  <c:v>6969.30810546875</c:v>
                </c:pt>
                <c:pt idx="7">
                  <c:v>6930.49072265625</c:v>
                </c:pt>
                <c:pt idx="8">
                  <c:v>6957.29638671875</c:v>
                </c:pt>
                <c:pt idx="9">
                  <c:v>7012.69384765625</c:v>
                </c:pt>
                <c:pt idx="10">
                  <c:v>7038.224609375</c:v>
                </c:pt>
                <c:pt idx="11">
                  <c:v>7004.103515625</c:v>
                </c:pt>
                <c:pt idx="12">
                  <c:v>6937.2568359375</c:v>
                </c:pt>
                <c:pt idx="13">
                  <c:v>6902.951171875</c:v>
                </c:pt>
                <c:pt idx="14">
                  <c:v>6952.626953125</c:v>
                </c:pt>
                <c:pt idx="15">
                  <c:v>7078.69580078125</c:v>
                </c:pt>
                <c:pt idx="16">
                  <c:v>7213.146484375</c:v>
                </c:pt>
                <c:pt idx="17">
                  <c:v>7273.16845703125</c:v>
                </c:pt>
                <c:pt idx="18">
                  <c:v>7220.072265625</c:v>
                </c:pt>
                <c:pt idx="19">
                  <c:v>7086.95947265625</c:v>
                </c:pt>
                <c:pt idx="20">
                  <c:v>6954.5341796875</c:v>
                </c:pt>
                <c:pt idx="21">
                  <c:v>6894.1103515625</c:v>
                </c:pt>
                <c:pt idx="22">
                  <c:v>6920.91845703125</c:v>
                </c:pt>
                <c:pt idx="23">
                  <c:v>6990.994140625</c:v>
                </c:pt>
                <c:pt idx="24">
                  <c:v>7040.18310546875</c:v>
                </c:pt>
                <c:pt idx="25">
                  <c:v>7032.4287109375</c:v>
                </c:pt>
                <c:pt idx="26">
                  <c:v>6980.65673828125</c:v>
                </c:pt>
                <c:pt idx="27">
                  <c:v>6928.35498046875</c:v>
                </c:pt>
                <c:pt idx="28">
                  <c:v>6911.49462890625</c:v>
                </c:pt>
                <c:pt idx="29">
                  <c:v>6933.21142578125</c:v>
                </c:pt>
                <c:pt idx="30">
                  <c:v>6969.12841796875</c:v>
                </c:pt>
                <c:pt idx="31">
                  <c:v>6993.8173828125</c:v>
                </c:pt>
                <c:pt idx="32">
                  <c:v>7002.56298828125</c:v>
                </c:pt>
                <c:pt idx="33">
                  <c:v>7009.984375</c:v>
                </c:pt>
                <c:pt idx="34">
                  <c:v>7029.802734375</c:v>
                </c:pt>
                <c:pt idx="35">
                  <c:v>7057.06103515625</c:v>
                </c:pt>
                <c:pt idx="36">
                  <c:v>7070.63623046875</c:v>
                </c:pt>
                <c:pt idx="37">
                  <c:v>7053.98828125</c:v>
                </c:pt>
                <c:pt idx="38">
                  <c:v>7014.37255859375</c:v>
                </c:pt>
                <c:pt idx="39">
                  <c:v>6981.369140625</c:v>
                </c:pt>
                <c:pt idx="40">
                  <c:v>6984.03271484375</c:v>
                </c:pt>
                <c:pt idx="41">
                  <c:v>7025.7041015625</c:v>
                </c:pt>
                <c:pt idx="42">
                  <c:v>7078.7236328125</c:v>
                </c:pt>
                <c:pt idx="43">
                  <c:v>7104.84521484375</c:v>
                </c:pt>
                <c:pt idx="44">
                  <c:v>7085.1240234375</c:v>
                </c:pt>
                <c:pt idx="45">
                  <c:v>7034.63818359375</c:v>
                </c:pt>
                <c:pt idx="46">
                  <c:v>6989.9052734375</c:v>
                </c:pt>
                <c:pt idx="47">
                  <c:v>6979.63818359375</c:v>
                </c:pt>
                <c:pt idx="48">
                  <c:v>7003.05224609375</c:v>
                </c:pt>
                <c:pt idx="49">
                  <c:v>7033.0224609375</c:v>
                </c:pt>
                <c:pt idx="50">
                  <c:v>7040.2548828125</c:v>
                </c:pt>
                <c:pt idx="51">
                  <c:v>7017.49169921875</c:v>
                </c:pt>
                <c:pt idx="52">
                  <c:v>6983.92041015625</c:v>
                </c:pt>
                <c:pt idx="53">
                  <c:v>6967.5771484375</c:v>
                </c:pt>
                <c:pt idx="54">
                  <c:v>6982.00537109375</c:v>
                </c:pt>
                <c:pt idx="55">
                  <c:v>7016.96826171875</c:v>
                </c:pt>
                <c:pt idx="56">
                  <c:v>7049.51953125</c:v>
                </c:pt>
                <c:pt idx="57">
                  <c:v>7063.80908203125</c:v>
                </c:pt>
                <c:pt idx="58">
                  <c:v>7061.568359375</c:v>
                </c:pt>
                <c:pt idx="59">
                  <c:v>7055.22998046875</c:v>
                </c:pt>
                <c:pt idx="60">
                  <c:v>7052.25537109375</c:v>
                </c:pt>
                <c:pt idx="61">
                  <c:v>7046.99072265625</c:v>
                </c:pt>
                <c:pt idx="62">
                  <c:v>7028.3173828125</c:v>
                </c:pt>
                <c:pt idx="63">
                  <c:v>6995.2802734375</c:v>
                </c:pt>
                <c:pt idx="64">
                  <c:v>6964.12548828125</c:v>
                </c:pt>
                <c:pt idx="65">
                  <c:v>6957.39892578125</c:v>
                </c:pt>
                <c:pt idx="66">
                  <c:v>6982.96728515625</c:v>
                </c:pt>
                <c:pt idx="67">
                  <c:v>7022.14892578125</c:v>
                </c:pt>
                <c:pt idx="68">
                  <c:v>7040.34912109375</c:v>
                </c:pt>
                <c:pt idx="69">
                  <c:v>7014.4345703125</c:v>
                </c:pt>
                <c:pt idx="70">
                  <c:v>6954.93017578125</c:v>
                </c:pt>
                <c:pt idx="71">
                  <c:v>6902.82177734375</c:v>
                </c:pt>
                <c:pt idx="72">
                  <c:v>6900.41650390625</c:v>
                </c:pt>
                <c:pt idx="73">
                  <c:v>6957.701171875</c:v>
                </c:pt>
                <c:pt idx="74">
                  <c:v>7041.31884765625</c:v>
                </c:pt>
                <c:pt idx="75">
                  <c:v>7096.78515625</c:v>
                </c:pt>
                <c:pt idx="76">
                  <c:v>7088.43408203125</c:v>
                </c:pt>
                <c:pt idx="77">
                  <c:v>7026.7822265625</c:v>
                </c:pt>
                <c:pt idx="78">
                  <c:v>6961.84423828125</c:v>
                </c:pt>
                <c:pt idx="79">
                  <c:v>6946.8662109375</c:v>
                </c:pt>
                <c:pt idx="80">
                  <c:v>6999.580078125</c:v>
                </c:pt>
                <c:pt idx="81">
                  <c:v>7089.7470703125</c:v>
                </c:pt>
                <c:pt idx="82">
                  <c:v>7161.4306640625</c:v>
                </c:pt>
                <c:pt idx="83">
                  <c:v>7172.373046875</c:v>
                </c:pt>
                <c:pt idx="84">
                  <c:v>7121.17431640625</c:v>
                </c:pt>
                <c:pt idx="85">
                  <c:v>7043.89208984375</c:v>
                </c:pt>
                <c:pt idx="86">
                  <c:v>6985.48193359375</c:v>
                </c:pt>
                <c:pt idx="87">
                  <c:v>6969.26953125</c:v>
                </c:pt>
                <c:pt idx="88">
                  <c:v>6986.4462890625</c:v>
                </c:pt>
                <c:pt idx="89">
                  <c:v>7010.09912109375</c:v>
                </c:pt>
                <c:pt idx="90">
                  <c:v>7019.4345703125</c:v>
                </c:pt>
                <c:pt idx="91">
                  <c:v>7014.21240234375</c:v>
                </c:pt>
                <c:pt idx="92">
                  <c:v>7009.77978515625</c:v>
                </c:pt>
                <c:pt idx="93">
                  <c:v>7019.6201171875</c:v>
                </c:pt>
                <c:pt idx="94">
                  <c:v>7041.4345703125</c:v>
                </c:pt>
                <c:pt idx="95">
                  <c:v>7058.15625</c:v>
                </c:pt>
                <c:pt idx="96">
                  <c:v>7052.1162109375</c:v>
                </c:pt>
                <c:pt idx="97">
                  <c:v>7020.11865234375</c:v>
                </c:pt>
                <c:pt idx="98">
                  <c:v>6977.29931640625</c:v>
                </c:pt>
                <c:pt idx="99">
                  <c:v>6947.09423828125</c:v>
                </c:pt>
                <c:pt idx="100">
                  <c:v>6945.24462890625</c:v>
                </c:pt>
                <c:pt idx="101">
                  <c:v>6969.46435546875</c:v>
                </c:pt>
                <c:pt idx="102">
                  <c:v>7001.431640625</c:v>
                </c:pt>
                <c:pt idx="103">
                  <c:v>7018.8466796875</c:v>
                </c:pt>
                <c:pt idx="104">
                  <c:v>7009.15478515625</c:v>
                </c:pt>
                <c:pt idx="105">
                  <c:v>6976.6142578125</c:v>
                </c:pt>
                <c:pt idx="106">
                  <c:v>6939.39306640625</c:v>
                </c:pt>
                <c:pt idx="107">
                  <c:v>6919.23974609375</c:v>
                </c:pt>
                <c:pt idx="108">
                  <c:v>6929.70458984375</c:v>
                </c:pt>
                <c:pt idx="109">
                  <c:v>6968.921875</c:v>
                </c:pt>
                <c:pt idx="110">
                  <c:v>7020.42822265625</c:v>
                </c:pt>
                <c:pt idx="111">
                  <c:v>7061.6689453125</c:v>
                </c:pt>
                <c:pt idx="112">
                  <c:v>7076.048828125</c:v>
                </c:pt>
                <c:pt idx="113">
                  <c:v>7062.12451171875</c:v>
                </c:pt>
                <c:pt idx="114">
                  <c:v>7034.42138671875</c:v>
                </c:pt>
                <c:pt idx="115">
                  <c:v>7014.78466796875</c:v>
                </c:pt>
                <c:pt idx="116">
                  <c:v>7019.08935546875</c:v>
                </c:pt>
                <c:pt idx="117">
                  <c:v>7047.6533203125</c:v>
                </c:pt>
                <c:pt idx="118">
                  <c:v>7085.7666015625</c:v>
                </c:pt>
                <c:pt idx="119">
                  <c:v>7113.978515625</c:v>
                </c:pt>
                <c:pt idx="120">
                  <c:v>7120.8359375</c:v>
                </c:pt>
                <c:pt idx="121">
                  <c:v>7108.9765625</c:v>
                </c:pt>
                <c:pt idx="122">
                  <c:v>7090.60498046875</c:v>
                </c:pt>
                <c:pt idx="123">
                  <c:v>7076.58251953125</c:v>
                </c:pt>
                <c:pt idx="124">
                  <c:v>7068.18359375</c:v>
                </c:pt>
                <c:pt idx="125">
                  <c:v>7057.9765625</c:v>
                </c:pt>
                <c:pt idx="126">
                  <c:v>7038.4140625</c:v>
                </c:pt>
                <c:pt idx="127">
                  <c:v>7010.18017578125</c:v>
                </c:pt>
                <c:pt idx="128">
                  <c:v>6982.68994140625</c:v>
                </c:pt>
                <c:pt idx="129">
                  <c:v>6966.19091796875</c:v>
                </c:pt>
                <c:pt idx="130">
                  <c:v>6962.51220703125</c:v>
                </c:pt>
                <c:pt idx="131">
                  <c:v>6963.021484375</c:v>
                </c:pt>
                <c:pt idx="132">
                  <c:v>6956.232421875</c:v>
                </c:pt>
                <c:pt idx="133">
                  <c:v>6938.89697265625</c:v>
                </c:pt>
                <c:pt idx="134">
                  <c:v>6920.85888671875</c:v>
                </c:pt>
                <c:pt idx="135">
                  <c:v>6918.71630859375</c:v>
                </c:pt>
                <c:pt idx="136">
                  <c:v>6942.6689453125</c:v>
                </c:pt>
                <c:pt idx="137">
                  <c:v>6986.92724609375</c:v>
                </c:pt>
                <c:pt idx="138">
                  <c:v>7031.63037109375</c:v>
                </c:pt>
                <c:pt idx="139">
                  <c:v>7055.232421875</c:v>
                </c:pt>
                <c:pt idx="140">
                  <c:v>7048.22998046875</c:v>
                </c:pt>
                <c:pt idx="141">
                  <c:v>7018.38623046875</c:v>
                </c:pt>
                <c:pt idx="142">
                  <c:v>6984.56396484375</c:v>
                </c:pt>
                <c:pt idx="143">
                  <c:v>6964.7939453125</c:v>
                </c:pt>
                <c:pt idx="144">
                  <c:v>6967.38134765625</c:v>
                </c:pt>
                <c:pt idx="145">
                  <c:v>6989.80078125</c:v>
                </c:pt>
                <c:pt idx="146">
                  <c:v>7023.24267578125</c:v>
                </c:pt>
                <c:pt idx="147">
                  <c:v>7057.26904296875</c:v>
                </c:pt>
                <c:pt idx="148">
                  <c:v>7081.53857421875</c:v>
                </c:pt>
                <c:pt idx="149">
                  <c:v>7086.4990234375</c:v>
                </c:pt>
                <c:pt idx="150">
                  <c:v>7066.669921875</c:v>
                </c:pt>
                <c:pt idx="151">
                  <c:v>7026.47607421875</c:v>
                </c:pt>
                <c:pt idx="152">
                  <c:v>6983.32763671875</c:v>
                </c:pt>
                <c:pt idx="153">
                  <c:v>6961.9462890625</c:v>
                </c:pt>
                <c:pt idx="154">
                  <c:v>6980.1162109375</c:v>
                </c:pt>
                <c:pt idx="155">
                  <c:v>7034.6259765625</c:v>
                </c:pt>
                <c:pt idx="156">
                  <c:v>7099.0595703125</c:v>
                </c:pt>
                <c:pt idx="157">
                  <c:v>7138.09716796875</c:v>
                </c:pt>
                <c:pt idx="158">
                  <c:v>7130.326171875</c:v>
                </c:pt>
                <c:pt idx="159">
                  <c:v>7083.380859375</c:v>
                </c:pt>
                <c:pt idx="160">
                  <c:v>7029.20166015625</c:v>
                </c:pt>
                <c:pt idx="161">
                  <c:v>7001.576171875</c:v>
                </c:pt>
                <c:pt idx="162">
                  <c:v>7012.0302734375</c:v>
                </c:pt>
                <c:pt idx="163">
                  <c:v>7042.2275390625</c:v>
                </c:pt>
                <c:pt idx="164">
                  <c:v>7058.8583984375</c:v>
                </c:pt>
                <c:pt idx="165">
                  <c:v>7039.646484375</c:v>
                </c:pt>
                <c:pt idx="166">
                  <c:v>6990.36474609375</c:v>
                </c:pt>
                <c:pt idx="167">
                  <c:v>6939.82421875</c:v>
                </c:pt>
                <c:pt idx="168">
                  <c:v>6917.24658203125</c:v>
                </c:pt>
                <c:pt idx="169">
                  <c:v>6930.32177734375</c:v>
                </c:pt>
                <c:pt idx="170">
                  <c:v>6961.3486328125</c:v>
                </c:pt>
                <c:pt idx="171">
                  <c:v>6983.939453125</c:v>
                </c:pt>
                <c:pt idx="172">
                  <c:v>6985.99755859375</c:v>
                </c:pt>
                <c:pt idx="173">
                  <c:v>6979.7138671875</c:v>
                </c:pt>
                <c:pt idx="174">
                  <c:v>6990.205078125</c:v>
                </c:pt>
                <c:pt idx="175">
                  <c:v>7032.15234375</c:v>
                </c:pt>
                <c:pt idx="176">
                  <c:v>7093.8447265625</c:v>
                </c:pt>
                <c:pt idx="177">
                  <c:v>7142.25732421875</c:v>
                </c:pt>
                <c:pt idx="178">
                  <c:v>7145.88232421875</c:v>
                </c:pt>
                <c:pt idx="179">
                  <c:v>7097.76904296875</c:v>
                </c:pt>
                <c:pt idx="180">
                  <c:v>7021.01171875</c:v>
                </c:pt>
                <c:pt idx="181">
                  <c:v>6952.71728515625</c:v>
                </c:pt>
                <c:pt idx="182">
                  <c:v>6919.0537109375</c:v>
                </c:pt>
                <c:pt idx="183">
                  <c:v>6920.20947265625</c:v>
                </c:pt>
                <c:pt idx="184">
                  <c:v>6935.5234375</c:v>
                </c:pt>
                <c:pt idx="185">
                  <c:v>6943.08642578125</c:v>
                </c:pt>
                <c:pt idx="186">
                  <c:v>6937.55615234375</c:v>
                </c:pt>
                <c:pt idx="187">
                  <c:v>6932.65673828125</c:v>
                </c:pt>
                <c:pt idx="188">
                  <c:v>6947.7724609375</c:v>
                </c:pt>
                <c:pt idx="189">
                  <c:v>6990.3818359375</c:v>
                </c:pt>
                <c:pt idx="190">
                  <c:v>7048.34326171875</c:v>
                </c:pt>
                <c:pt idx="191">
                  <c:v>7097.3662109375</c:v>
                </c:pt>
                <c:pt idx="192">
                  <c:v>7117.1171875</c:v>
                </c:pt>
                <c:pt idx="193">
                  <c:v>7103.703125</c:v>
                </c:pt>
                <c:pt idx="194">
                  <c:v>7070.31494140625</c:v>
                </c:pt>
                <c:pt idx="195">
                  <c:v>7037.24072265625</c:v>
                </c:pt>
                <c:pt idx="196">
                  <c:v>7019.486328125</c:v>
                </c:pt>
                <c:pt idx="197">
                  <c:v>7020.1123046875</c:v>
                </c:pt>
                <c:pt idx="198">
                  <c:v>7031.77978515625</c:v>
                </c:pt>
                <c:pt idx="199">
                  <c:v>7043.23681640625</c:v>
                </c:pt>
                <c:pt idx="200">
                  <c:v>7045.8017578125</c:v>
                </c:pt>
                <c:pt idx="201">
                  <c:v>7037.0234375</c:v>
                </c:pt>
                <c:pt idx="202">
                  <c:v>7021.39453125</c:v>
                </c:pt>
                <c:pt idx="203">
                  <c:v>7008.708984375</c:v>
                </c:pt>
                <c:pt idx="204">
                  <c:v>7010.0126953125</c:v>
                </c:pt>
                <c:pt idx="205">
                  <c:v>7031.41845703125</c:v>
                </c:pt>
                <c:pt idx="206">
                  <c:v>7068.3037109375</c:v>
                </c:pt>
                <c:pt idx="207">
                  <c:v>7104.38134765625</c:v>
                </c:pt>
                <c:pt idx="208">
                  <c:v>7118.68798828125</c:v>
                </c:pt>
                <c:pt idx="209">
                  <c:v>7098.12158203125</c:v>
                </c:pt>
                <c:pt idx="210">
                  <c:v>7047.6142578125</c:v>
                </c:pt>
                <c:pt idx="211">
                  <c:v>6989.6328125</c:v>
                </c:pt>
                <c:pt idx="212">
                  <c:v>6951.35302734375</c:v>
                </c:pt>
                <c:pt idx="213">
                  <c:v>6947.3017578125</c:v>
                </c:pt>
                <c:pt idx="214">
                  <c:v>6969.857421875</c:v>
                </c:pt>
                <c:pt idx="215">
                  <c:v>6995.130859375</c:v>
                </c:pt>
                <c:pt idx="216">
                  <c:v>7000.33251953125</c:v>
                </c:pt>
                <c:pt idx="217">
                  <c:v>6979.67138671875</c:v>
                </c:pt>
                <c:pt idx="218">
                  <c:v>6946.77099609375</c:v>
                </c:pt>
                <c:pt idx="219">
                  <c:v>6922.35009765625</c:v>
                </c:pt>
                <c:pt idx="220">
                  <c:v>6917.84814453125</c:v>
                </c:pt>
                <c:pt idx="221">
                  <c:v>6928.72607421875</c:v>
                </c:pt>
                <c:pt idx="222">
                  <c:v>6942.50537109375</c:v>
                </c:pt>
                <c:pt idx="223">
                  <c:v>6953.36181640625</c:v>
                </c:pt>
                <c:pt idx="224">
                  <c:v>6968.9287109375</c:v>
                </c:pt>
                <c:pt idx="225">
                  <c:v>7001.78125</c:v>
                </c:pt>
                <c:pt idx="226">
                  <c:v>7052.53466796875</c:v>
                </c:pt>
                <c:pt idx="227">
                  <c:v>7100.88720703125</c:v>
                </c:pt>
                <c:pt idx="228">
                  <c:v>7115.98876953125</c:v>
                </c:pt>
                <c:pt idx="229">
                  <c:v>7081.0546875</c:v>
                </c:pt>
                <c:pt idx="230">
                  <c:v>7012.70458984375</c:v>
                </c:pt>
                <c:pt idx="231">
                  <c:v>6956.40283203125</c:v>
                </c:pt>
                <c:pt idx="232">
                  <c:v>6956.95556640625</c:v>
                </c:pt>
                <c:pt idx="233">
                  <c:v>7024.13623046875</c:v>
                </c:pt>
                <c:pt idx="234">
                  <c:v>7120.548828125</c:v>
                </c:pt>
                <c:pt idx="235">
                  <c:v>7184.205078125</c:v>
                </c:pt>
                <c:pt idx="236">
                  <c:v>7171.84228515625</c:v>
                </c:pt>
                <c:pt idx="237">
                  <c:v>7091.3427734375</c:v>
                </c:pt>
                <c:pt idx="238">
                  <c:v>6997.73291015625</c:v>
                </c:pt>
                <c:pt idx="239">
                  <c:v>6953.9521484375</c:v>
                </c:pt>
                <c:pt idx="240">
                  <c:v>6984.845703125</c:v>
                </c:pt>
                <c:pt idx="241">
                  <c:v>7059.05419921875</c:v>
                </c:pt>
                <c:pt idx="242">
                  <c:v>7112.95947265625</c:v>
                </c:pt>
                <c:pt idx="243">
                  <c:v>7098.798828125</c:v>
                </c:pt>
                <c:pt idx="244">
                  <c:v>7020.357421875</c:v>
                </c:pt>
                <c:pt idx="245">
                  <c:v>6929.18017578125</c:v>
                </c:pt>
                <c:pt idx="246">
                  <c:v>6884.75439453125</c:v>
                </c:pt>
                <c:pt idx="247">
                  <c:v>6909.89404296875</c:v>
                </c:pt>
                <c:pt idx="248">
                  <c:v>6975.7548828125</c:v>
                </c:pt>
                <c:pt idx="249">
                  <c:v>7027.18798828125</c:v>
                </c:pt>
                <c:pt idx="250">
                  <c:v>7027.38623046875</c:v>
                </c:pt>
                <c:pt idx="251">
                  <c:v>6986.14111328125</c:v>
                </c:pt>
                <c:pt idx="252">
                  <c:v>6949.81005859375</c:v>
                </c:pt>
                <c:pt idx="253">
                  <c:v>6961.9619140625</c:v>
                </c:pt>
                <c:pt idx="254">
                  <c:v>7026.7548828125</c:v>
                </c:pt>
                <c:pt idx="255">
                  <c:v>7104.27392578125</c:v>
                </c:pt>
                <c:pt idx="256">
                  <c:v>7141.00537109375</c:v>
                </c:pt>
                <c:pt idx="257">
                  <c:v>7110.7216796875</c:v>
                </c:pt>
                <c:pt idx="258">
                  <c:v>7033.4970703125</c:v>
                </c:pt>
                <c:pt idx="259">
                  <c:v>6958.90478515625</c:v>
                </c:pt>
                <c:pt idx="260">
                  <c:v>6928.1865234375</c:v>
                </c:pt>
                <c:pt idx="261">
                  <c:v>6946.017578125</c:v>
                </c:pt>
                <c:pt idx="262">
                  <c:v>6983.16455078125</c:v>
                </c:pt>
                <c:pt idx="263">
                  <c:v>7005.32861328125</c:v>
                </c:pt>
                <c:pt idx="264">
                  <c:v>7002.5087890625</c:v>
                </c:pt>
                <c:pt idx="265">
                  <c:v>6994.28125</c:v>
                </c:pt>
                <c:pt idx="266">
                  <c:v>7007.80859375</c:v>
                </c:pt>
                <c:pt idx="267">
                  <c:v>7048.8671875</c:v>
                </c:pt>
                <c:pt idx="268">
                  <c:v>7092.01171875</c:v>
                </c:pt>
                <c:pt idx="269">
                  <c:v>7099.57275390625</c:v>
                </c:pt>
                <c:pt idx="270">
                  <c:v>7054.34716796875</c:v>
                </c:pt>
                <c:pt idx="271">
                  <c:v>6978.4638671875</c:v>
                </c:pt>
                <c:pt idx="272">
                  <c:v>6921.31787109375</c:v>
                </c:pt>
                <c:pt idx="273">
                  <c:v>6924.29345703125</c:v>
                </c:pt>
                <c:pt idx="274">
                  <c:v>6989.06494140625</c:v>
                </c:pt>
                <c:pt idx="275">
                  <c:v>7074.14599609375</c:v>
                </c:pt>
                <c:pt idx="276">
                  <c:v>7122.83349609375</c:v>
                </c:pt>
                <c:pt idx="277">
                  <c:v>7101.93017578125</c:v>
                </c:pt>
                <c:pt idx="278">
                  <c:v>7023.14697265625</c:v>
                </c:pt>
                <c:pt idx="279">
                  <c:v>6933.02880859375</c:v>
                </c:pt>
                <c:pt idx="280">
                  <c:v>6880.88818359375</c:v>
                </c:pt>
                <c:pt idx="281">
                  <c:v>6889.01171875</c:v>
                </c:pt>
                <c:pt idx="282">
                  <c:v>6944.90234375</c:v>
                </c:pt>
                <c:pt idx="283">
                  <c:v>7016.81201171875</c:v>
                </c:pt>
                <c:pt idx="284">
                  <c:v>7076.97021484375</c:v>
                </c:pt>
                <c:pt idx="285">
                  <c:v>7114.42822265625</c:v>
                </c:pt>
                <c:pt idx="286">
                  <c:v>7131.3505859375</c:v>
                </c:pt>
                <c:pt idx="287">
                  <c:v>7131.275390625</c:v>
                </c:pt>
                <c:pt idx="288">
                  <c:v>7112.84619140625</c:v>
                </c:pt>
                <c:pt idx="289">
                  <c:v>7074.7431640625</c:v>
                </c:pt>
                <c:pt idx="290">
                  <c:v>7025.2353515625</c:v>
                </c:pt>
                <c:pt idx="291">
                  <c:v>6984.51708984375</c:v>
                </c:pt>
                <c:pt idx="292">
                  <c:v>6974.44091796875</c:v>
                </c:pt>
                <c:pt idx="293">
                  <c:v>7002.375</c:v>
                </c:pt>
                <c:pt idx="294">
                  <c:v>7052.6396484375</c:v>
                </c:pt>
                <c:pt idx="295">
                  <c:v>7094.0625</c:v>
                </c:pt>
                <c:pt idx="296">
                  <c:v>7099.5078125</c:v>
                </c:pt>
                <c:pt idx="297">
                  <c:v>7063.388671875</c:v>
                </c:pt>
                <c:pt idx="298">
                  <c:v>7004.40673828125</c:v>
                </c:pt>
                <c:pt idx="299">
                  <c:v>6951.97998046875</c:v>
                </c:pt>
                <c:pt idx="300">
                  <c:v>6926.88330078125</c:v>
                </c:pt>
                <c:pt idx="301">
                  <c:v>6930.04638671875</c:v>
                </c:pt>
                <c:pt idx="302">
                  <c:v>6946.16455078125</c:v>
                </c:pt>
                <c:pt idx="303">
                  <c:v>6957.32080078125</c:v>
                </c:pt>
                <c:pt idx="304">
                  <c:v>6955.42724609375</c:v>
                </c:pt>
                <c:pt idx="305">
                  <c:v>6945.19677734375</c:v>
                </c:pt>
                <c:pt idx="306">
                  <c:v>6937.91845703125</c:v>
                </c:pt>
                <c:pt idx="307">
                  <c:v>6942.8564453125</c:v>
                </c:pt>
                <c:pt idx="308">
                  <c:v>6962.8330078125</c:v>
                </c:pt>
                <c:pt idx="309">
                  <c:v>6995.11279296875</c:v>
                </c:pt>
                <c:pt idx="310">
                  <c:v>7034.00146484375</c:v>
                </c:pt>
                <c:pt idx="311">
                  <c:v>7071.7451171875</c:v>
                </c:pt>
                <c:pt idx="312">
                  <c:v>7098.33544921875</c:v>
                </c:pt>
                <c:pt idx="313">
                  <c:v>7103.619140625</c:v>
                </c:pt>
                <c:pt idx="314">
                  <c:v>7083.2216796875</c:v>
                </c:pt>
                <c:pt idx="315">
                  <c:v>7044.68701171875</c:v>
                </c:pt>
                <c:pt idx="316">
                  <c:v>7007.37353515625</c:v>
                </c:pt>
                <c:pt idx="317">
                  <c:v>6992.94287109375</c:v>
                </c:pt>
                <c:pt idx="318">
                  <c:v>7011.048828125</c:v>
                </c:pt>
                <c:pt idx="319">
                  <c:v>7050.5400390625</c:v>
                </c:pt>
                <c:pt idx="320">
                  <c:v>7084.30908203125</c:v>
                </c:pt>
                <c:pt idx="321">
                  <c:v>7086.40283203125</c:v>
                </c:pt>
                <c:pt idx="322">
                  <c:v>7050.14892578125</c:v>
                </c:pt>
                <c:pt idx="323">
                  <c:v>6994.068359375</c:v>
                </c:pt>
                <c:pt idx="324">
                  <c:v>6950.5576171875</c:v>
                </c:pt>
                <c:pt idx="325">
                  <c:v>6944.8828125</c:v>
                </c:pt>
                <c:pt idx="326">
                  <c:v>6979.25927734375</c:v>
                </c:pt>
                <c:pt idx="327">
                  <c:v>7032.96630859375</c:v>
                </c:pt>
                <c:pt idx="328">
                  <c:v>7077.4794921875</c:v>
                </c:pt>
                <c:pt idx="329">
                  <c:v>7094.845703125</c:v>
                </c:pt>
                <c:pt idx="330">
                  <c:v>7086.14697265625</c:v>
                </c:pt>
                <c:pt idx="331">
                  <c:v>7065.55419921875</c:v>
                </c:pt>
                <c:pt idx="332">
                  <c:v>7046.77587890625</c:v>
                </c:pt>
                <c:pt idx="333">
                  <c:v>7033.62548828125</c:v>
                </c:pt>
                <c:pt idx="334">
                  <c:v>7021.47314453125</c:v>
                </c:pt>
                <c:pt idx="335">
                  <c:v>7006.31396484375</c:v>
                </c:pt>
                <c:pt idx="336">
                  <c:v>6991.7626953125</c:v>
                </c:pt>
                <c:pt idx="337">
                  <c:v>6986.794921875</c:v>
                </c:pt>
                <c:pt idx="338">
                  <c:v>6996.03466796875</c:v>
                </c:pt>
                <c:pt idx="339">
                  <c:v>7011.8046875</c:v>
                </c:pt>
                <c:pt idx="340">
                  <c:v>7016.4794921875</c:v>
                </c:pt>
                <c:pt idx="341">
                  <c:v>6995.11767578125</c:v>
                </c:pt>
                <c:pt idx="342">
                  <c:v>6949.10791015625</c:v>
                </c:pt>
                <c:pt idx="343">
                  <c:v>6899.41650390625</c:v>
                </c:pt>
                <c:pt idx="344">
                  <c:v>6875.302734375</c:v>
                </c:pt>
                <c:pt idx="345">
                  <c:v>6895.4677734375</c:v>
                </c:pt>
                <c:pt idx="346">
                  <c:v>6954.89794921875</c:v>
                </c:pt>
                <c:pt idx="347">
                  <c:v>7027.029296875</c:v>
                </c:pt>
                <c:pt idx="348">
                  <c:v>7079.95751953125</c:v>
                </c:pt>
                <c:pt idx="349">
                  <c:v>7095.48291015625</c:v>
                </c:pt>
              </c:numCache>
            </c:numRef>
          </c:yVal>
          <c:smooth val="1"/>
          <c:extLst>
            <c:ext xmlns:c16="http://schemas.microsoft.com/office/drawing/2014/chart" uri="{C3380CC4-5D6E-409C-BE32-E72D297353CC}">
              <c16:uniqueId val="{0000000E-5429-4359-BD11-807CF8F8408D}"/>
            </c:ext>
          </c:extLst>
        </c:ser>
        <c:ser>
          <c:idx val="15"/>
          <c:order val="15"/>
          <c:tx>
            <c:strRef>
              <c:f>np_sub_003!$P$1</c:f>
              <c:strCache>
                <c:ptCount val="1"/>
                <c:pt idx="0">
                  <c:v>Coor_16</c:v>
                </c:pt>
              </c:strCache>
            </c:strRef>
          </c:tx>
          <c:spPr>
            <a:ln w="28575" cap="rnd">
              <a:solidFill>
                <a:schemeClr val="accent4">
                  <a:lumMod val="80000"/>
                  <a:lumOff val="20000"/>
                </a:schemeClr>
              </a:solidFill>
              <a:round/>
            </a:ln>
            <a:effectLst/>
          </c:spPr>
          <c:marker>
            <c:symbol val="none"/>
          </c:marker>
          <c:yVal>
            <c:numRef>
              <c:f>np_sub_003!$P$2:$P$351</c:f>
              <c:numCache>
                <c:formatCode>0.00000000000_ </c:formatCode>
                <c:ptCount val="350"/>
                <c:pt idx="0">
                  <c:v>6591.77783203125</c:v>
                </c:pt>
                <c:pt idx="1">
                  <c:v>6616.533203125</c:v>
                </c:pt>
                <c:pt idx="2">
                  <c:v>6635.72607421875</c:v>
                </c:pt>
                <c:pt idx="3">
                  <c:v>6631.6689453125</c:v>
                </c:pt>
                <c:pt idx="4">
                  <c:v>6601.6103515625</c:v>
                </c:pt>
                <c:pt idx="5">
                  <c:v>6563.10009765625</c:v>
                </c:pt>
                <c:pt idx="6">
                  <c:v>6542.828125</c:v>
                </c:pt>
                <c:pt idx="7">
                  <c:v>6556.3896484375</c:v>
                </c:pt>
                <c:pt idx="8">
                  <c:v>6595.1748046875</c:v>
                </c:pt>
                <c:pt idx="9">
                  <c:v>6631.951171875</c:v>
                </c:pt>
                <c:pt idx="10">
                  <c:v>6641.67041015625</c:v>
                </c:pt>
                <c:pt idx="11">
                  <c:v>6620.9365234375</c:v>
                </c:pt>
                <c:pt idx="12">
                  <c:v>6590.01953125</c:v>
                </c:pt>
                <c:pt idx="13">
                  <c:v>6575.57373046875</c:v>
                </c:pt>
                <c:pt idx="14">
                  <c:v>6588.5302734375</c:v>
                </c:pt>
                <c:pt idx="15">
                  <c:v>6615.8583984375</c:v>
                </c:pt>
                <c:pt idx="16">
                  <c:v>6632.9345703125</c:v>
                </c:pt>
                <c:pt idx="17">
                  <c:v>6625.2373046875</c:v>
                </c:pt>
                <c:pt idx="18">
                  <c:v>6599.85009765625</c:v>
                </c:pt>
                <c:pt idx="19">
                  <c:v>6576.45556640625</c:v>
                </c:pt>
                <c:pt idx="20">
                  <c:v>6566.44091796875</c:v>
                </c:pt>
                <c:pt idx="21">
                  <c:v>6560.35986328125</c:v>
                </c:pt>
                <c:pt idx="22">
                  <c:v>6537.2021484375</c:v>
                </c:pt>
                <c:pt idx="23">
                  <c:v>6488.75634765625</c:v>
                </c:pt>
                <c:pt idx="24">
                  <c:v>6436.53076171875</c:v>
                </c:pt>
                <c:pt idx="25">
                  <c:v>6422.5078125</c:v>
                </c:pt>
                <c:pt idx="26">
                  <c:v>6476.8603515625</c:v>
                </c:pt>
                <c:pt idx="27">
                  <c:v>6587.70166015625</c:v>
                </c:pt>
                <c:pt idx="28">
                  <c:v>6700.10400390625</c:v>
                </c:pt>
                <c:pt idx="29">
                  <c:v>6750.0400390625</c:v>
                </c:pt>
                <c:pt idx="30">
                  <c:v>6710.00830078125</c:v>
                </c:pt>
                <c:pt idx="31">
                  <c:v>6611.10595703125</c:v>
                </c:pt>
                <c:pt idx="32">
                  <c:v>6522.6083984375</c:v>
                </c:pt>
                <c:pt idx="33">
                  <c:v>6502.8583984375</c:v>
                </c:pt>
                <c:pt idx="34">
                  <c:v>6558.33349609375</c:v>
                </c:pt>
                <c:pt idx="35">
                  <c:v>6641.91552734375</c:v>
                </c:pt>
                <c:pt idx="36">
                  <c:v>6690.82275390625</c:v>
                </c:pt>
                <c:pt idx="37">
                  <c:v>6673.8154296875</c:v>
                </c:pt>
                <c:pt idx="38">
                  <c:v>6611.05615234375</c:v>
                </c:pt>
                <c:pt idx="39">
                  <c:v>6553.05322265625</c:v>
                </c:pt>
                <c:pt idx="40">
                  <c:v>6538.18310546875</c:v>
                </c:pt>
                <c:pt idx="41">
                  <c:v>6564.2177734375</c:v>
                </c:pt>
                <c:pt idx="42">
                  <c:v>6595.7216796875</c:v>
                </c:pt>
                <c:pt idx="43">
                  <c:v>6598.40380859375</c:v>
                </c:pt>
                <c:pt idx="44">
                  <c:v>6569.7265625</c:v>
                </c:pt>
                <c:pt idx="45">
                  <c:v>6539.982421875</c:v>
                </c:pt>
                <c:pt idx="46">
                  <c:v>6544.45751953125</c:v>
                </c:pt>
                <c:pt idx="47">
                  <c:v>6591.92578125</c:v>
                </c:pt>
                <c:pt idx="48">
                  <c:v>6656.7890625</c:v>
                </c:pt>
                <c:pt idx="49">
                  <c:v>6700.72998046875</c:v>
                </c:pt>
                <c:pt idx="50">
                  <c:v>6704.0654296875</c:v>
                </c:pt>
                <c:pt idx="51">
                  <c:v>6679.369140625</c:v>
                </c:pt>
                <c:pt idx="52">
                  <c:v>6656.35107421875</c:v>
                </c:pt>
                <c:pt idx="53">
                  <c:v>6652.52978515625</c:v>
                </c:pt>
                <c:pt idx="54">
                  <c:v>6656.3896484375</c:v>
                </c:pt>
                <c:pt idx="55">
                  <c:v>6638.21142578125</c:v>
                </c:pt>
                <c:pt idx="56">
                  <c:v>6579.08203125</c:v>
                </c:pt>
                <c:pt idx="57">
                  <c:v>6492.4931640625</c:v>
                </c:pt>
                <c:pt idx="58">
                  <c:v>6419.2275390625</c:v>
                </c:pt>
                <c:pt idx="59">
                  <c:v>6399.05322265625</c:v>
                </c:pt>
                <c:pt idx="60">
                  <c:v>6442.14111328125</c:v>
                </c:pt>
                <c:pt idx="61">
                  <c:v>6522.7021484375</c:v>
                </c:pt>
                <c:pt idx="62">
                  <c:v>6598.3349609375</c:v>
                </c:pt>
                <c:pt idx="63">
                  <c:v>6638.01953125</c:v>
                </c:pt>
                <c:pt idx="64">
                  <c:v>6636.94970703125</c:v>
                </c:pt>
                <c:pt idx="65">
                  <c:v>6610.1572265625</c:v>
                </c:pt>
                <c:pt idx="66">
                  <c:v>6575.46337890625</c:v>
                </c:pt>
                <c:pt idx="67">
                  <c:v>6542.9462890625</c:v>
                </c:pt>
                <c:pt idx="68">
                  <c:v>6518.06103515625</c:v>
                </c:pt>
                <c:pt idx="69">
                  <c:v>6509.92041015625</c:v>
                </c:pt>
                <c:pt idx="70">
                  <c:v>6530.90087890625</c:v>
                </c:pt>
                <c:pt idx="71">
                  <c:v>6584.07861328125</c:v>
                </c:pt>
                <c:pt idx="72">
                  <c:v>6650.58349609375</c:v>
                </c:pt>
                <c:pt idx="73">
                  <c:v>6693.39453125</c:v>
                </c:pt>
                <c:pt idx="74">
                  <c:v>6681.021484375</c:v>
                </c:pt>
                <c:pt idx="75">
                  <c:v>6614.5966796875</c:v>
                </c:pt>
                <c:pt idx="76">
                  <c:v>6534.14990234375</c:v>
                </c:pt>
                <c:pt idx="77">
                  <c:v>6493.84912109375</c:v>
                </c:pt>
                <c:pt idx="78">
                  <c:v>6521.99609375</c:v>
                </c:pt>
                <c:pt idx="79">
                  <c:v>6597.30712890625</c:v>
                </c:pt>
                <c:pt idx="80">
                  <c:v>6663.056640625</c:v>
                </c:pt>
                <c:pt idx="81">
                  <c:v>6670.90625</c:v>
                </c:pt>
                <c:pt idx="82">
                  <c:v>6620.58837890625</c:v>
                </c:pt>
                <c:pt idx="83">
                  <c:v>6562.40966796875</c:v>
                </c:pt>
                <c:pt idx="84">
                  <c:v>6558.05810546875</c:v>
                </c:pt>
                <c:pt idx="85">
                  <c:v>6629.32080078125</c:v>
                </c:pt>
                <c:pt idx="86">
                  <c:v>6735.900390625</c:v>
                </c:pt>
                <c:pt idx="87">
                  <c:v>6801.94482421875</c:v>
                </c:pt>
                <c:pt idx="88">
                  <c:v>6772.5458984375</c:v>
                </c:pt>
                <c:pt idx="89">
                  <c:v>6656.90283203125</c:v>
                </c:pt>
                <c:pt idx="90">
                  <c:v>6524.21240234375</c:v>
                </c:pt>
                <c:pt idx="91">
                  <c:v>6454.603515625</c:v>
                </c:pt>
                <c:pt idx="92">
                  <c:v>6482.03662109375</c:v>
                </c:pt>
                <c:pt idx="93">
                  <c:v>6571.85107421875</c:v>
                </c:pt>
                <c:pt idx="94">
                  <c:v>6648.583984375</c:v>
                </c:pt>
                <c:pt idx="95">
                  <c:v>6651.5634765625</c:v>
                </c:pt>
                <c:pt idx="96">
                  <c:v>6576.32666015625</c:v>
                </c:pt>
                <c:pt idx="97">
                  <c:v>6473.0263671875</c:v>
                </c:pt>
                <c:pt idx="98">
                  <c:v>6406.7607421875</c:v>
                </c:pt>
                <c:pt idx="99">
                  <c:v>6412.09521484375</c:v>
                </c:pt>
                <c:pt idx="100">
                  <c:v>6474.83837890625</c:v>
                </c:pt>
                <c:pt idx="101">
                  <c:v>6550.31201171875</c:v>
                </c:pt>
                <c:pt idx="102">
                  <c:v>6599.466796875</c:v>
                </c:pt>
                <c:pt idx="103">
                  <c:v>6613.78857421875</c:v>
                </c:pt>
                <c:pt idx="104">
                  <c:v>6612.73486328125</c:v>
                </c:pt>
                <c:pt idx="105">
                  <c:v>6620.6103515625</c:v>
                </c:pt>
                <c:pt idx="106">
                  <c:v>6644.22216796875</c:v>
                </c:pt>
                <c:pt idx="107">
                  <c:v>6668.57421875</c:v>
                </c:pt>
                <c:pt idx="108">
                  <c:v>6671.22705078125</c:v>
                </c:pt>
                <c:pt idx="109">
                  <c:v>6641.55322265625</c:v>
                </c:pt>
                <c:pt idx="110">
                  <c:v>6589.603515625</c:v>
                </c:pt>
                <c:pt idx="111">
                  <c:v>6539.50439453125</c:v>
                </c:pt>
                <c:pt idx="112">
                  <c:v>6514.291015625</c:v>
                </c:pt>
                <c:pt idx="113">
                  <c:v>6523.47412109375</c:v>
                </c:pt>
                <c:pt idx="114">
                  <c:v>6560.1162109375</c:v>
                </c:pt>
                <c:pt idx="115">
                  <c:v>6606.50244140625</c:v>
                </c:pt>
                <c:pt idx="116">
                  <c:v>6643.12841796875</c:v>
                </c:pt>
                <c:pt idx="117">
                  <c:v>6656.462890625</c:v>
                </c:pt>
                <c:pt idx="118">
                  <c:v>6643.61083984375</c:v>
                </c:pt>
                <c:pt idx="119">
                  <c:v>6613.29736328125</c:v>
                </c:pt>
                <c:pt idx="120">
                  <c:v>6582.34814453125</c:v>
                </c:pt>
                <c:pt idx="121">
                  <c:v>6567.63427734375</c:v>
                </c:pt>
                <c:pt idx="122">
                  <c:v>6576.42626953125</c:v>
                </c:pt>
                <c:pt idx="123">
                  <c:v>6601.01708984375</c:v>
                </c:pt>
                <c:pt idx="124">
                  <c:v>6622.5048828125</c:v>
                </c:pt>
                <c:pt idx="125">
                  <c:v>6622.75732421875</c:v>
                </c:pt>
                <c:pt idx="126">
                  <c:v>6596.919921875</c:v>
                </c:pt>
                <c:pt idx="127">
                  <c:v>6557.24951171875</c:v>
                </c:pt>
                <c:pt idx="128">
                  <c:v>6524.98486328125</c:v>
                </c:pt>
                <c:pt idx="129">
                  <c:v>6516.13330078125</c:v>
                </c:pt>
                <c:pt idx="130">
                  <c:v>6531.91259765625</c:v>
                </c:pt>
                <c:pt idx="131">
                  <c:v>6560.68115234375</c:v>
                </c:pt>
                <c:pt idx="132">
                  <c:v>6588.6611328125</c:v>
                </c:pt>
                <c:pt idx="133">
                  <c:v>6609.78759765625</c:v>
                </c:pt>
                <c:pt idx="134">
                  <c:v>6626.6181640625</c:v>
                </c:pt>
                <c:pt idx="135">
                  <c:v>6642.9140625</c:v>
                </c:pt>
                <c:pt idx="136">
                  <c:v>6656.1767578125</c:v>
                </c:pt>
                <c:pt idx="137">
                  <c:v>6658.08203125</c:v>
                </c:pt>
                <c:pt idx="138">
                  <c:v>6642.720703125</c:v>
                </c:pt>
                <c:pt idx="139">
                  <c:v>6614.4189453125</c:v>
                </c:pt>
                <c:pt idx="140">
                  <c:v>6586.66748046875</c:v>
                </c:pt>
                <c:pt idx="141">
                  <c:v>6571.923828125</c:v>
                </c:pt>
                <c:pt idx="142">
                  <c:v>6571.20458984375</c:v>
                </c:pt>
                <c:pt idx="143">
                  <c:v>6573.58740234375</c:v>
                </c:pt>
                <c:pt idx="144">
                  <c:v>6567.04150390625</c:v>
                </c:pt>
                <c:pt idx="145">
                  <c:v>6551.09765625</c:v>
                </c:pt>
                <c:pt idx="146">
                  <c:v>6539.0224609375</c:v>
                </c:pt>
                <c:pt idx="147">
                  <c:v>6546.00390625</c:v>
                </c:pt>
                <c:pt idx="148">
                  <c:v>6573.09716796875</c:v>
                </c:pt>
                <c:pt idx="149">
                  <c:v>6602.13623046875</c:v>
                </c:pt>
                <c:pt idx="150">
                  <c:v>6608.49365234375</c:v>
                </c:pt>
                <c:pt idx="151">
                  <c:v>6582.646484375</c:v>
                </c:pt>
                <c:pt idx="152">
                  <c:v>6541.96630859375</c:v>
                </c:pt>
                <c:pt idx="153">
                  <c:v>6520.4501953125</c:v>
                </c:pt>
                <c:pt idx="154">
                  <c:v>6542.28076171875</c:v>
                </c:pt>
                <c:pt idx="155">
                  <c:v>6600.11767578125</c:v>
                </c:pt>
                <c:pt idx="156">
                  <c:v>6657.26123046875</c:v>
                </c:pt>
                <c:pt idx="157">
                  <c:v>6674.29345703125</c:v>
                </c:pt>
                <c:pt idx="158">
                  <c:v>6640.14697265625</c:v>
                </c:pt>
                <c:pt idx="159">
                  <c:v>6582.29736328125</c:v>
                </c:pt>
                <c:pt idx="160">
                  <c:v>6546.4375</c:v>
                </c:pt>
                <c:pt idx="161">
                  <c:v>6560.607421875</c:v>
                </c:pt>
                <c:pt idx="162">
                  <c:v>6612.22900390625</c:v>
                </c:pt>
                <c:pt idx="163">
                  <c:v>6657.0986328125</c:v>
                </c:pt>
                <c:pt idx="164">
                  <c:v>6654.03857421875</c:v>
                </c:pt>
                <c:pt idx="165">
                  <c:v>6597.96484375</c:v>
                </c:pt>
                <c:pt idx="166">
                  <c:v>6524.80908203125</c:v>
                </c:pt>
                <c:pt idx="167">
                  <c:v>6483.98046875</c:v>
                </c:pt>
                <c:pt idx="168">
                  <c:v>6500.04248046875</c:v>
                </c:pt>
                <c:pt idx="169">
                  <c:v>6554.0810546875</c:v>
                </c:pt>
                <c:pt idx="170">
                  <c:v>6599.5888671875</c:v>
                </c:pt>
                <c:pt idx="171">
                  <c:v>6600.181640625</c:v>
                </c:pt>
                <c:pt idx="172">
                  <c:v>6559.11572265625</c:v>
                </c:pt>
                <c:pt idx="173">
                  <c:v>6517.193359375</c:v>
                </c:pt>
                <c:pt idx="174">
                  <c:v>6520.71337890625</c:v>
                </c:pt>
                <c:pt idx="175">
                  <c:v>6584.5888671875</c:v>
                </c:pt>
                <c:pt idx="176">
                  <c:v>6679.20947265625</c:v>
                </c:pt>
                <c:pt idx="177">
                  <c:v>6750.86279296875</c:v>
                </c:pt>
                <c:pt idx="178">
                  <c:v>6759.7080078125</c:v>
                </c:pt>
                <c:pt idx="179">
                  <c:v>6706.6376953125</c:v>
                </c:pt>
                <c:pt idx="180">
                  <c:v>6629.9130859375</c:v>
                </c:pt>
                <c:pt idx="181">
                  <c:v>6575.89892578125</c:v>
                </c:pt>
                <c:pt idx="182">
                  <c:v>6566.98388671875</c:v>
                </c:pt>
                <c:pt idx="183">
                  <c:v>6590.02734375</c:v>
                </c:pt>
                <c:pt idx="184">
                  <c:v>6611.56298828125</c:v>
                </c:pt>
                <c:pt idx="185">
                  <c:v>6605.69580078125</c:v>
                </c:pt>
                <c:pt idx="186">
                  <c:v>6572.6298828125</c:v>
                </c:pt>
                <c:pt idx="187">
                  <c:v>6535.0126953125</c:v>
                </c:pt>
                <c:pt idx="188">
                  <c:v>6517.28271484375</c:v>
                </c:pt>
                <c:pt idx="189">
                  <c:v>6525.67431640625</c:v>
                </c:pt>
                <c:pt idx="190">
                  <c:v>6544.5498046875</c:v>
                </c:pt>
                <c:pt idx="191">
                  <c:v>6550.96142578125</c:v>
                </c:pt>
                <c:pt idx="192">
                  <c:v>6535.0634765625</c:v>
                </c:pt>
                <c:pt idx="193">
                  <c:v>6509.95068359375</c:v>
                </c:pt>
                <c:pt idx="194">
                  <c:v>6503.0302734375</c:v>
                </c:pt>
                <c:pt idx="195">
                  <c:v>6535.19970703125</c:v>
                </c:pt>
                <c:pt idx="196">
                  <c:v>6603.220703125</c:v>
                </c:pt>
                <c:pt idx="197">
                  <c:v>6678.45458984375</c:v>
                </c:pt>
                <c:pt idx="198">
                  <c:v>6723.4853515625</c:v>
                </c:pt>
                <c:pt idx="199">
                  <c:v>6715.5908203125</c:v>
                </c:pt>
                <c:pt idx="200">
                  <c:v>6661.19677734375</c:v>
                </c:pt>
                <c:pt idx="201">
                  <c:v>6591.53173828125</c:v>
                </c:pt>
                <c:pt idx="202">
                  <c:v>6542.39404296875</c:v>
                </c:pt>
                <c:pt idx="203">
                  <c:v>6531.6201171875</c:v>
                </c:pt>
                <c:pt idx="204">
                  <c:v>6549.33349609375</c:v>
                </c:pt>
                <c:pt idx="205">
                  <c:v>6567.35205078125</c:v>
                </c:pt>
                <c:pt idx="206">
                  <c:v>6561.03662109375</c:v>
                </c:pt>
                <c:pt idx="207">
                  <c:v>6528.28369140625</c:v>
                </c:pt>
                <c:pt idx="208">
                  <c:v>6492.23046875</c:v>
                </c:pt>
                <c:pt idx="209">
                  <c:v>6485.47509765625</c:v>
                </c:pt>
                <c:pt idx="210">
                  <c:v>6526.5361328125</c:v>
                </c:pt>
                <c:pt idx="211">
                  <c:v>6604.89990234375</c:v>
                </c:pt>
                <c:pt idx="212">
                  <c:v>6685.22412109375</c:v>
                </c:pt>
                <c:pt idx="213">
                  <c:v>6728.16015625</c:v>
                </c:pt>
                <c:pt idx="214">
                  <c:v>6713.98486328125</c:v>
                </c:pt>
                <c:pt idx="215">
                  <c:v>6653.75146484375</c:v>
                </c:pt>
                <c:pt idx="216">
                  <c:v>6581.6591796875</c:v>
                </c:pt>
                <c:pt idx="217">
                  <c:v>6534.9111328125</c:v>
                </c:pt>
                <c:pt idx="218">
                  <c:v>6534.5029296875</c:v>
                </c:pt>
                <c:pt idx="219">
                  <c:v>6577.65771484375</c:v>
                </c:pt>
                <c:pt idx="220">
                  <c:v>6643.33740234375</c:v>
                </c:pt>
                <c:pt idx="221">
                  <c:v>6704.1123046875</c:v>
                </c:pt>
                <c:pt idx="222">
                  <c:v>6736.392578125</c:v>
                </c:pt>
                <c:pt idx="223">
                  <c:v>6725.8291015625</c:v>
                </c:pt>
                <c:pt idx="224">
                  <c:v>6669.87841796875</c:v>
                </c:pt>
                <c:pt idx="225">
                  <c:v>6579.97509765625</c:v>
                </c:pt>
                <c:pt idx="226">
                  <c:v>6481.8896484375</c:v>
                </c:pt>
                <c:pt idx="227">
                  <c:v>6409.89501953125</c:v>
                </c:pt>
                <c:pt idx="228">
                  <c:v>6392.99658203125</c:v>
                </c:pt>
                <c:pt idx="229">
                  <c:v>6438.7607421875</c:v>
                </c:pt>
                <c:pt idx="230">
                  <c:v>6525.60791015625</c:v>
                </c:pt>
                <c:pt idx="231">
                  <c:v>6611.60888671875</c:v>
                </c:pt>
                <c:pt idx="232">
                  <c:v>6657.03076171875</c:v>
                </c:pt>
                <c:pt idx="233">
                  <c:v>6646.98681640625</c:v>
                </c:pt>
                <c:pt idx="234">
                  <c:v>6598.7919921875</c:v>
                </c:pt>
                <c:pt idx="235">
                  <c:v>6548.6806640625</c:v>
                </c:pt>
                <c:pt idx="236">
                  <c:v>6527.37939453125</c:v>
                </c:pt>
                <c:pt idx="237">
                  <c:v>6542.0087890625</c:v>
                </c:pt>
                <c:pt idx="238">
                  <c:v>6576.4267578125</c:v>
                </c:pt>
                <c:pt idx="239">
                  <c:v>6607.52587890625</c:v>
                </c:pt>
                <c:pt idx="240">
                  <c:v>6623.0673828125</c:v>
                </c:pt>
                <c:pt idx="241">
                  <c:v>6626.94775390625</c:v>
                </c:pt>
                <c:pt idx="242">
                  <c:v>6629.6552734375</c:v>
                </c:pt>
                <c:pt idx="243">
                  <c:v>6634.6494140625</c:v>
                </c:pt>
                <c:pt idx="244">
                  <c:v>6634.17626953125</c:v>
                </c:pt>
                <c:pt idx="245">
                  <c:v>6618.47265625</c:v>
                </c:pt>
                <c:pt idx="246">
                  <c:v>6589.14453125</c:v>
                </c:pt>
                <c:pt idx="247">
                  <c:v>6562.84033203125</c:v>
                </c:pt>
                <c:pt idx="248">
                  <c:v>6559.775390625</c:v>
                </c:pt>
                <c:pt idx="249">
                  <c:v>6585.93505859375</c:v>
                </c:pt>
                <c:pt idx="250">
                  <c:v>6624.9716796875</c:v>
                </c:pt>
                <c:pt idx="251">
                  <c:v>6648.7041015625</c:v>
                </c:pt>
                <c:pt idx="252">
                  <c:v>6639.15234375</c:v>
                </c:pt>
                <c:pt idx="253">
                  <c:v>6603.9814453125</c:v>
                </c:pt>
                <c:pt idx="254">
                  <c:v>6571.36083984375</c:v>
                </c:pt>
                <c:pt idx="255">
                  <c:v>6567.060546875</c:v>
                </c:pt>
                <c:pt idx="256">
                  <c:v>6592.14794921875</c:v>
                </c:pt>
                <c:pt idx="257">
                  <c:v>6620.3935546875</c:v>
                </c:pt>
                <c:pt idx="258">
                  <c:v>6618.85400390625</c:v>
                </c:pt>
                <c:pt idx="259">
                  <c:v>6575.677734375</c:v>
                </c:pt>
                <c:pt idx="260">
                  <c:v>6512.26171875</c:v>
                </c:pt>
                <c:pt idx="261">
                  <c:v>6468.9189453125</c:v>
                </c:pt>
                <c:pt idx="262">
                  <c:v>6474.69970703125</c:v>
                </c:pt>
                <c:pt idx="263">
                  <c:v>6525.3544921875</c:v>
                </c:pt>
                <c:pt idx="264">
                  <c:v>6587.25439453125</c:v>
                </c:pt>
                <c:pt idx="265">
                  <c:v>6624.16455078125</c:v>
                </c:pt>
                <c:pt idx="266">
                  <c:v>6625.1611328125</c:v>
                </c:pt>
                <c:pt idx="267">
                  <c:v>6611.01416015625</c:v>
                </c:pt>
                <c:pt idx="268">
                  <c:v>6614.01806640625</c:v>
                </c:pt>
                <c:pt idx="269">
                  <c:v>6648.07470703125</c:v>
                </c:pt>
                <c:pt idx="270">
                  <c:v>6693.97314453125</c:v>
                </c:pt>
                <c:pt idx="271">
                  <c:v>6712.58349609375</c:v>
                </c:pt>
                <c:pt idx="272">
                  <c:v>6676.0166015625</c:v>
                </c:pt>
                <c:pt idx="273">
                  <c:v>6592.068359375</c:v>
                </c:pt>
                <c:pt idx="274">
                  <c:v>6502.25146484375</c:v>
                </c:pt>
                <c:pt idx="275">
                  <c:v>6454.27294921875</c:v>
                </c:pt>
                <c:pt idx="276">
                  <c:v>6469.5146484375</c:v>
                </c:pt>
                <c:pt idx="277">
                  <c:v>6529.55419921875</c:v>
                </c:pt>
                <c:pt idx="278">
                  <c:v>6590.86962890625</c:v>
                </c:pt>
                <c:pt idx="279">
                  <c:v>6615.748046875</c:v>
                </c:pt>
                <c:pt idx="280">
                  <c:v>6596.4326171875</c:v>
                </c:pt>
                <c:pt idx="281">
                  <c:v>6556.21240234375</c:v>
                </c:pt>
                <c:pt idx="282">
                  <c:v>6529.25048828125</c:v>
                </c:pt>
                <c:pt idx="283">
                  <c:v>6535.90234375</c:v>
                </c:pt>
                <c:pt idx="284">
                  <c:v>6571.44580078125</c:v>
                </c:pt>
                <c:pt idx="285">
                  <c:v>6614.087890625</c:v>
                </c:pt>
                <c:pt idx="286">
                  <c:v>6643.373046875</c:v>
                </c:pt>
                <c:pt idx="287">
                  <c:v>6653.87060546875</c:v>
                </c:pt>
                <c:pt idx="288">
                  <c:v>6654.837890625</c:v>
                </c:pt>
                <c:pt idx="289">
                  <c:v>6658.44482421875</c:v>
                </c:pt>
                <c:pt idx="290">
                  <c:v>6667.47998046875</c:v>
                </c:pt>
                <c:pt idx="291">
                  <c:v>6672.50048828125</c:v>
                </c:pt>
                <c:pt idx="292">
                  <c:v>6660.05908203125</c:v>
                </c:pt>
                <c:pt idx="293">
                  <c:v>6624.9541015625</c:v>
                </c:pt>
                <c:pt idx="294">
                  <c:v>6576.78271484375</c:v>
                </c:pt>
                <c:pt idx="295">
                  <c:v>6535.60693359375</c:v>
                </c:pt>
                <c:pt idx="296">
                  <c:v>6519.5048828125</c:v>
                </c:pt>
                <c:pt idx="297">
                  <c:v>6532.46435546875</c:v>
                </c:pt>
                <c:pt idx="298">
                  <c:v>6561.001953125</c:v>
                </c:pt>
                <c:pt idx="299">
                  <c:v>6582.34375</c:v>
                </c:pt>
                <c:pt idx="300">
                  <c:v>6579.49658203125</c:v>
                </c:pt>
                <c:pt idx="301">
                  <c:v>6553.6328125</c:v>
                </c:pt>
                <c:pt idx="302">
                  <c:v>6525.0087890625</c:v>
                </c:pt>
                <c:pt idx="303">
                  <c:v>6520.361328125</c:v>
                </c:pt>
                <c:pt idx="304">
                  <c:v>6553.73779296875</c:v>
                </c:pt>
                <c:pt idx="305">
                  <c:v>6613.46240234375</c:v>
                </c:pt>
                <c:pt idx="306">
                  <c:v>6665.6572265625</c:v>
                </c:pt>
                <c:pt idx="307">
                  <c:v>6674.55908203125</c:v>
                </c:pt>
                <c:pt idx="308">
                  <c:v>6627.625</c:v>
                </c:pt>
                <c:pt idx="309">
                  <c:v>6547.91796875</c:v>
                </c:pt>
                <c:pt idx="310">
                  <c:v>6482.89453125</c:v>
                </c:pt>
                <c:pt idx="311">
                  <c:v>6474.5576171875</c:v>
                </c:pt>
                <c:pt idx="312">
                  <c:v>6530.32568359375</c:v>
                </c:pt>
                <c:pt idx="313">
                  <c:v>6615.7119140625</c:v>
                </c:pt>
                <c:pt idx="314">
                  <c:v>6675.96728515625</c:v>
                </c:pt>
                <c:pt idx="315">
                  <c:v>6673.0849609375</c:v>
                </c:pt>
                <c:pt idx="316">
                  <c:v>6612.23974609375</c:v>
                </c:pt>
                <c:pt idx="317">
                  <c:v>6537.9814453125</c:v>
                </c:pt>
                <c:pt idx="318">
                  <c:v>6502.0712890625</c:v>
                </c:pt>
                <c:pt idx="319">
                  <c:v>6526.0986328125</c:v>
                </c:pt>
                <c:pt idx="320">
                  <c:v>6586.6748046875</c:v>
                </c:pt>
                <c:pt idx="321">
                  <c:v>6634.5673828125</c:v>
                </c:pt>
                <c:pt idx="322">
                  <c:v>6633.52197265625</c:v>
                </c:pt>
                <c:pt idx="323">
                  <c:v>6589.1455078125</c:v>
                </c:pt>
                <c:pt idx="324">
                  <c:v>6545.3466796875</c:v>
                </c:pt>
                <c:pt idx="325">
                  <c:v>6550.47216796875</c:v>
                </c:pt>
                <c:pt idx="326">
                  <c:v>6618.6826171875</c:v>
                </c:pt>
                <c:pt idx="327">
                  <c:v>6716.1826171875</c:v>
                </c:pt>
                <c:pt idx="328">
                  <c:v>6783.2548828125</c:v>
                </c:pt>
                <c:pt idx="329">
                  <c:v>6775.94677734375</c:v>
                </c:pt>
                <c:pt idx="330">
                  <c:v>6696.54541015625</c:v>
                </c:pt>
                <c:pt idx="331">
                  <c:v>6590.77197265625</c:v>
                </c:pt>
                <c:pt idx="332">
                  <c:v>6514.89599609375</c:v>
                </c:pt>
                <c:pt idx="333">
                  <c:v>6498.0302734375</c:v>
                </c:pt>
                <c:pt idx="334">
                  <c:v>6527.08056640625</c:v>
                </c:pt>
                <c:pt idx="335">
                  <c:v>6563.23779296875</c:v>
                </c:pt>
                <c:pt idx="336">
                  <c:v>6574.68115234375</c:v>
                </c:pt>
                <c:pt idx="337">
                  <c:v>6559.1396484375</c:v>
                </c:pt>
                <c:pt idx="338">
                  <c:v>6539.94970703125</c:v>
                </c:pt>
                <c:pt idx="339">
                  <c:v>6541.31689453125</c:v>
                </c:pt>
                <c:pt idx="340">
                  <c:v>6564.763671875</c:v>
                </c:pt>
                <c:pt idx="341">
                  <c:v>6586.62744140625</c:v>
                </c:pt>
                <c:pt idx="342">
                  <c:v>6578.51318359375</c:v>
                </c:pt>
                <c:pt idx="343">
                  <c:v>6533.60595703125</c:v>
                </c:pt>
                <c:pt idx="344">
                  <c:v>6476.8994140625</c:v>
                </c:pt>
                <c:pt idx="345">
                  <c:v>6450.1142578125</c:v>
                </c:pt>
                <c:pt idx="346">
                  <c:v>6481.9931640625</c:v>
                </c:pt>
                <c:pt idx="347">
                  <c:v>6566.13720703125</c:v>
                </c:pt>
                <c:pt idx="348">
                  <c:v>6662.96337890625</c:v>
                </c:pt>
                <c:pt idx="349">
                  <c:v>6724.5068359375</c:v>
                </c:pt>
              </c:numCache>
            </c:numRef>
          </c:yVal>
          <c:smooth val="1"/>
          <c:extLst>
            <c:ext xmlns:c16="http://schemas.microsoft.com/office/drawing/2014/chart" uri="{C3380CC4-5D6E-409C-BE32-E72D297353CC}">
              <c16:uniqueId val="{0000000F-5429-4359-BD11-807CF8F8408D}"/>
            </c:ext>
          </c:extLst>
        </c:ser>
        <c:ser>
          <c:idx val="16"/>
          <c:order val="16"/>
          <c:tx>
            <c:strRef>
              <c:f>np_sub_003!$Q$1</c:f>
              <c:strCache>
                <c:ptCount val="1"/>
                <c:pt idx="0">
                  <c:v>Coor_17</c:v>
                </c:pt>
              </c:strCache>
            </c:strRef>
          </c:tx>
          <c:spPr>
            <a:ln w="28575" cap="rnd">
              <a:solidFill>
                <a:schemeClr val="accent5">
                  <a:lumMod val="80000"/>
                  <a:lumOff val="20000"/>
                </a:schemeClr>
              </a:solidFill>
              <a:round/>
            </a:ln>
            <a:effectLst/>
          </c:spPr>
          <c:marker>
            <c:symbol val="none"/>
          </c:marker>
          <c:yVal>
            <c:numRef>
              <c:f>np_sub_003!$Q$2:$Q$351</c:f>
              <c:numCache>
                <c:formatCode>0.00000000000_ </c:formatCode>
                <c:ptCount val="350"/>
                <c:pt idx="0">
                  <c:v>5514.65869140625</c:v>
                </c:pt>
                <c:pt idx="1">
                  <c:v>5519.125</c:v>
                </c:pt>
                <c:pt idx="2">
                  <c:v>5491.6416015625</c:v>
                </c:pt>
                <c:pt idx="3">
                  <c:v>5454.4697265625</c:v>
                </c:pt>
                <c:pt idx="4">
                  <c:v>5441.673828125</c:v>
                </c:pt>
                <c:pt idx="5">
                  <c:v>5473.50341796875</c:v>
                </c:pt>
                <c:pt idx="6">
                  <c:v>5537.21923828125</c:v>
                </c:pt>
                <c:pt idx="7">
                  <c:v>5590.72412109375</c:v>
                </c:pt>
                <c:pt idx="8">
                  <c:v>5589.3994140625</c:v>
                </c:pt>
                <c:pt idx="9">
                  <c:v>5518.34228515625</c:v>
                </c:pt>
                <c:pt idx="10">
                  <c:v>5406.1455078125</c:v>
                </c:pt>
                <c:pt idx="11">
                  <c:v>5308.30810546875</c:v>
                </c:pt>
                <c:pt idx="12">
                  <c:v>5270.4619140625</c:v>
                </c:pt>
                <c:pt idx="13">
                  <c:v>5297.3662109375</c:v>
                </c:pt>
                <c:pt idx="14">
                  <c:v>5350.529296875</c:v>
                </c:pt>
                <c:pt idx="15">
                  <c:v>5376.87548828125</c:v>
                </c:pt>
                <c:pt idx="16">
                  <c:v>5347.96240234375</c:v>
                </c:pt>
                <c:pt idx="17">
                  <c:v>5281.10888671875</c:v>
                </c:pt>
                <c:pt idx="18">
                  <c:v>5226.861328125</c:v>
                </c:pt>
                <c:pt idx="19">
                  <c:v>5231.8544921875</c:v>
                </c:pt>
                <c:pt idx="20">
                  <c:v>5304.0859375</c:v>
                </c:pt>
                <c:pt idx="21">
                  <c:v>5405.611328125</c:v>
                </c:pt>
                <c:pt idx="22">
                  <c:v>5477.51806640625</c:v>
                </c:pt>
                <c:pt idx="23">
                  <c:v>5478.9287109375</c:v>
                </c:pt>
                <c:pt idx="24">
                  <c:v>5412.623046875</c:v>
                </c:pt>
                <c:pt idx="25">
                  <c:v>5320.6376953125</c:v>
                </c:pt>
                <c:pt idx="26">
                  <c:v>5255.06884765625</c:v>
                </c:pt>
                <c:pt idx="27">
                  <c:v>5245.849609375</c:v>
                </c:pt>
                <c:pt idx="28">
                  <c:v>5287.14599609375</c:v>
                </c:pt>
                <c:pt idx="29">
                  <c:v>5348.74462890625</c:v>
                </c:pt>
                <c:pt idx="30">
                  <c:v>5400.80029296875</c:v>
                </c:pt>
                <c:pt idx="31">
                  <c:v>5432.70556640625</c:v>
                </c:pt>
                <c:pt idx="32">
                  <c:v>5453.91162109375</c:v>
                </c:pt>
                <c:pt idx="33">
                  <c:v>5479.3935546875</c:v>
                </c:pt>
                <c:pt idx="34">
                  <c:v>5513.37255859375</c:v>
                </c:pt>
                <c:pt idx="35">
                  <c:v>5544.38671875</c:v>
                </c:pt>
                <c:pt idx="36">
                  <c:v>5554.6064453125</c:v>
                </c:pt>
                <c:pt idx="37">
                  <c:v>5535.0556640625</c:v>
                </c:pt>
                <c:pt idx="38">
                  <c:v>5494.51123046875</c:v>
                </c:pt>
                <c:pt idx="39">
                  <c:v>5455.3115234375</c:v>
                </c:pt>
                <c:pt idx="40">
                  <c:v>5439.21435546875</c:v>
                </c:pt>
                <c:pt idx="41">
                  <c:v>5453.30859375</c:v>
                </c:pt>
                <c:pt idx="42">
                  <c:v>5485.390625</c:v>
                </c:pt>
                <c:pt idx="43">
                  <c:v>5511.42333984375</c:v>
                </c:pt>
                <c:pt idx="44">
                  <c:v>5509.90771484375</c:v>
                </c:pt>
                <c:pt idx="45">
                  <c:v>5474.23095703125</c:v>
                </c:pt>
                <c:pt idx="46">
                  <c:v>5416.08544921875</c:v>
                </c:pt>
                <c:pt idx="47">
                  <c:v>5358.798828125</c:v>
                </c:pt>
                <c:pt idx="48">
                  <c:v>5325.05224609375</c:v>
                </c:pt>
                <c:pt idx="49">
                  <c:v>5325.9228515625</c:v>
                </c:pt>
                <c:pt idx="50">
                  <c:v>5356.689453125</c:v>
                </c:pt>
                <c:pt idx="51">
                  <c:v>5400.69091796875</c:v>
                </c:pt>
                <c:pt idx="52">
                  <c:v>5438.2646484375</c:v>
                </c:pt>
                <c:pt idx="53">
                  <c:v>5455.55224609375</c:v>
                </c:pt>
                <c:pt idx="54">
                  <c:v>5448.787109375</c:v>
                </c:pt>
                <c:pt idx="55">
                  <c:v>5422.81298828125</c:v>
                </c:pt>
                <c:pt idx="56">
                  <c:v>5386.099609375</c:v>
                </c:pt>
                <c:pt idx="57">
                  <c:v>5346.22021484375</c:v>
                </c:pt>
                <c:pt idx="58">
                  <c:v>5308.6181640625</c:v>
                </c:pt>
                <c:pt idx="59">
                  <c:v>5278.4267578125</c:v>
                </c:pt>
                <c:pt idx="60">
                  <c:v>5262.4609375</c:v>
                </c:pt>
                <c:pt idx="61">
                  <c:v>5268.29150390625</c:v>
                </c:pt>
                <c:pt idx="62">
                  <c:v>5299.91943359375</c:v>
                </c:pt>
                <c:pt idx="63">
                  <c:v>5352.91357421875</c:v>
                </c:pt>
                <c:pt idx="64">
                  <c:v>5413.32373046875</c:v>
                </c:pt>
                <c:pt idx="65">
                  <c:v>5462.68603515625</c:v>
                </c:pt>
                <c:pt idx="66">
                  <c:v>5487.15380859375</c:v>
                </c:pt>
                <c:pt idx="67">
                  <c:v>5485.26025390625</c:v>
                </c:pt>
                <c:pt idx="68">
                  <c:v>5468.85546875</c:v>
                </c:pt>
                <c:pt idx="69">
                  <c:v>5455.71435546875</c:v>
                </c:pt>
                <c:pt idx="70">
                  <c:v>5457.83154296875</c:v>
                </c:pt>
                <c:pt idx="71">
                  <c:v>5472.7470703125</c:v>
                </c:pt>
                <c:pt idx="72">
                  <c:v>5483.96826171875</c:v>
                </c:pt>
                <c:pt idx="73">
                  <c:v>5471.16064453125</c:v>
                </c:pt>
                <c:pt idx="74">
                  <c:v>5424.4697265625</c:v>
                </c:pt>
                <c:pt idx="75">
                  <c:v>5354.080078125</c:v>
                </c:pt>
                <c:pt idx="76">
                  <c:v>5288.216796875</c:v>
                </c:pt>
                <c:pt idx="77">
                  <c:v>5259.3642578125</c:v>
                </c:pt>
                <c:pt idx="78">
                  <c:v>5285.82861328125</c:v>
                </c:pt>
                <c:pt idx="79">
                  <c:v>5359.455078125</c:v>
                </c:pt>
                <c:pt idx="80">
                  <c:v>5447.599609375</c:v>
                </c:pt>
                <c:pt idx="81">
                  <c:v>5509.43115234375</c:v>
                </c:pt>
                <c:pt idx="82">
                  <c:v>5517.80712890625</c:v>
                </c:pt>
                <c:pt idx="83">
                  <c:v>5473.90771484375</c:v>
                </c:pt>
                <c:pt idx="84">
                  <c:v>5405.6630859375</c:v>
                </c:pt>
                <c:pt idx="85">
                  <c:v>5350.86865234375</c:v>
                </c:pt>
                <c:pt idx="86">
                  <c:v>5335.623046875</c:v>
                </c:pt>
                <c:pt idx="87">
                  <c:v>5361.6552734375</c:v>
                </c:pt>
                <c:pt idx="88">
                  <c:v>5409.8544921875</c:v>
                </c:pt>
                <c:pt idx="89">
                  <c:v>5455.98583984375</c:v>
                </c:pt>
                <c:pt idx="90">
                  <c:v>5486.2802734375</c:v>
                </c:pt>
                <c:pt idx="91">
                  <c:v>5501.63525390625</c:v>
                </c:pt>
                <c:pt idx="92">
                  <c:v>5508.86669921875</c:v>
                </c:pt>
                <c:pt idx="93">
                  <c:v>5508.3349609375</c:v>
                </c:pt>
                <c:pt idx="94">
                  <c:v>5490.34423828125</c:v>
                </c:pt>
                <c:pt idx="95">
                  <c:v>5445.03515625</c:v>
                </c:pt>
                <c:pt idx="96">
                  <c:v>5377.8125</c:v>
                </c:pt>
                <c:pt idx="97">
                  <c:v>5315.474609375</c:v>
                </c:pt>
                <c:pt idx="98">
                  <c:v>5293.802734375</c:v>
                </c:pt>
                <c:pt idx="99">
                  <c:v>5332.37744140625</c:v>
                </c:pt>
                <c:pt idx="100">
                  <c:v>5415.0029296875</c:v>
                </c:pt>
                <c:pt idx="101">
                  <c:v>5493.24267578125</c:v>
                </c:pt>
                <c:pt idx="102">
                  <c:v>5514.94384765625</c:v>
                </c:pt>
                <c:pt idx="103">
                  <c:v>5460.0810546875</c:v>
                </c:pt>
                <c:pt idx="104">
                  <c:v>5358.15673828125</c:v>
                </c:pt>
                <c:pt idx="105">
                  <c:v>5272.3515625</c:v>
                </c:pt>
                <c:pt idx="106">
                  <c:v>5258.94091796875</c:v>
                </c:pt>
                <c:pt idx="107">
                  <c:v>5329.2109375</c:v>
                </c:pt>
                <c:pt idx="108">
                  <c:v>5440.75927734375</c:v>
                </c:pt>
                <c:pt idx="109">
                  <c:v>5525.0146484375</c:v>
                </c:pt>
                <c:pt idx="110">
                  <c:v>5532.31298828125</c:v>
                </c:pt>
                <c:pt idx="111">
                  <c:v>5463.5751953125</c:v>
                </c:pt>
                <c:pt idx="112">
                  <c:v>5367.4267578125</c:v>
                </c:pt>
                <c:pt idx="113">
                  <c:v>5306.12109375</c:v>
                </c:pt>
                <c:pt idx="114">
                  <c:v>5314.7763671875</c:v>
                </c:pt>
                <c:pt idx="115">
                  <c:v>5381.34716796875</c:v>
                </c:pt>
                <c:pt idx="116">
                  <c:v>5458.55419921875</c:v>
                </c:pt>
                <c:pt idx="117">
                  <c:v>5496.60302734375</c:v>
                </c:pt>
                <c:pt idx="118">
                  <c:v>5473.2412109375</c:v>
                </c:pt>
                <c:pt idx="119">
                  <c:v>5402.8427734375</c:v>
                </c:pt>
                <c:pt idx="120">
                  <c:v>5322.76611328125</c:v>
                </c:pt>
                <c:pt idx="121">
                  <c:v>5269.86572265625</c:v>
                </c:pt>
                <c:pt idx="122">
                  <c:v>5263.04150390625</c:v>
                </c:pt>
                <c:pt idx="123">
                  <c:v>5299.54541015625</c:v>
                </c:pt>
                <c:pt idx="124">
                  <c:v>5362.015625</c:v>
                </c:pt>
                <c:pt idx="125">
                  <c:v>5428.2626953125</c:v>
                </c:pt>
                <c:pt idx="126">
                  <c:v>5478.44384765625</c:v>
                </c:pt>
                <c:pt idx="127">
                  <c:v>5499.39599609375</c:v>
                </c:pt>
                <c:pt idx="128">
                  <c:v>5487.9326171875</c:v>
                </c:pt>
                <c:pt idx="129">
                  <c:v>5452.70068359375</c:v>
                </c:pt>
                <c:pt idx="130">
                  <c:v>5411.7802734375</c:v>
                </c:pt>
                <c:pt idx="131">
                  <c:v>5384.62109375</c:v>
                </c:pt>
                <c:pt idx="132">
                  <c:v>5381.81201171875</c:v>
                </c:pt>
                <c:pt idx="133">
                  <c:v>5399.66162109375</c:v>
                </c:pt>
                <c:pt idx="134">
                  <c:v>5424.26123046875</c:v>
                </c:pt>
                <c:pt idx="135">
                  <c:v>5442.42822265625</c:v>
                </c:pt>
                <c:pt idx="136">
                  <c:v>5450.8671875</c:v>
                </c:pt>
                <c:pt idx="137">
                  <c:v>5455.9013671875</c:v>
                </c:pt>
                <c:pt idx="138">
                  <c:v>5464.23779296875</c:v>
                </c:pt>
                <c:pt idx="139">
                  <c:v>5473.583984375</c:v>
                </c:pt>
                <c:pt idx="140">
                  <c:v>5472.79296875</c:v>
                </c:pt>
                <c:pt idx="141">
                  <c:v>5452.90283203125</c:v>
                </c:pt>
                <c:pt idx="142">
                  <c:v>5419.6748046875</c:v>
                </c:pt>
                <c:pt idx="143">
                  <c:v>5394.86865234375</c:v>
                </c:pt>
                <c:pt idx="144">
                  <c:v>5401.69189453125</c:v>
                </c:pt>
                <c:pt idx="145">
                  <c:v>5443.82177734375</c:v>
                </c:pt>
                <c:pt idx="146">
                  <c:v>5495.40185546875</c:v>
                </c:pt>
                <c:pt idx="147">
                  <c:v>5513.4267578125</c:v>
                </c:pt>
                <c:pt idx="148">
                  <c:v>5467.16943359375</c:v>
                </c:pt>
                <c:pt idx="149">
                  <c:v>5364.3857421875</c:v>
                </c:pt>
                <c:pt idx="150">
                  <c:v>5253.48388671875</c:v>
                </c:pt>
                <c:pt idx="151">
                  <c:v>5196.595703125</c:v>
                </c:pt>
                <c:pt idx="152">
                  <c:v>5229.734375</c:v>
                </c:pt>
                <c:pt idx="153">
                  <c:v>5337.09716796875</c:v>
                </c:pt>
                <c:pt idx="154">
                  <c:v>5458.2666015625</c:v>
                </c:pt>
                <c:pt idx="155">
                  <c:v>5524.935546875</c:v>
                </c:pt>
                <c:pt idx="156">
                  <c:v>5503.38134765625</c:v>
                </c:pt>
                <c:pt idx="157">
                  <c:v>5414.80224609375</c:v>
                </c:pt>
                <c:pt idx="158">
                  <c:v>5320.55419921875</c:v>
                </c:pt>
                <c:pt idx="159">
                  <c:v>5282.6845703125</c:v>
                </c:pt>
                <c:pt idx="160">
                  <c:v>5325.8134765625</c:v>
                </c:pt>
                <c:pt idx="161">
                  <c:v>5424.23193359375</c:v>
                </c:pt>
                <c:pt idx="162">
                  <c:v>5520.5888671875</c:v>
                </c:pt>
                <c:pt idx="163">
                  <c:v>5562.216796875</c:v>
                </c:pt>
                <c:pt idx="164">
                  <c:v>5531.31689453125</c:v>
                </c:pt>
                <c:pt idx="165">
                  <c:v>5451.244140625</c:v>
                </c:pt>
                <c:pt idx="166">
                  <c:v>5367.66455078125</c:v>
                </c:pt>
                <c:pt idx="167">
                  <c:v>5318.95068359375</c:v>
                </c:pt>
                <c:pt idx="168">
                  <c:v>5315.22119140625</c:v>
                </c:pt>
                <c:pt idx="169">
                  <c:v>5337.861328125</c:v>
                </c:pt>
                <c:pt idx="170">
                  <c:v>5357.17529296875</c:v>
                </c:pt>
                <c:pt idx="171">
                  <c:v>5354.521484375</c:v>
                </c:pt>
                <c:pt idx="172">
                  <c:v>5333.76953125</c:v>
                </c:pt>
                <c:pt idx="173">
                  <c:v>5315.43408203125</c:v>
                </c:pt>
                <c:pt idx="174">
                  <c:v>5319.26806640625</c:v>
                </c:pt>
                <c:pt idx="175">
                  <c:v>5348.88525390625</c:v>
                </c:pt>
                <c:pt idx="176">
                  <c:v>5389.919921875</c:v>
                </c:pt>
                <c:pt idx="177">
                  <c:v>5422.775390625</c:v>
                </c:pt>
                <c:pt idx="178">
                  <c:v>5439.65283203125</c:v>
                </c:pt>
                <c:pt idx="179">
                  <c:v>5451.8056640625</c:v>
                </c:pt>
                <c:pt idx="180">
                  <c:v>5480.0654296875</c:v>
                </c:pt>
                <c:pt idx="181">
                  <c:v>5534.93408203125</c:v>
                </c:pt>
                <c:pt idx="182">
                  <c:v>5601.89794921875</c:v>
                </c:pt>
                <c:pt idx="183">
                  <c:v>5645.26806640625</c:v>
                </c:pt>
                <c:pt idx="184">
                  <c:v>5630.44775390625</c:v>
                </c:pt>
                <c:pt idx="185">
                  <c:v>5549.693359375</c:v>
                </c:pt>
                <c:pt idx="186">
                  <c:v>5431.86376953125</c:v>
                </c:pt>
                <c:pt idx="187">
                  <c:v>5327.0830078125</c:v>
                </c:pt>
                <c:pt idx="188">
                  <c:v>5275.6572265625</c:v>
                </c:pt>
                <c:pt idx="189">
                  <c:v>5283.19873046875</c:v>
                </c:pt>
                <c:pt idx="190">
                  <c:v>5320.29736328125</c:v>
                </c:pt>
                <c:pt idx="191">
                  <c:v>5347.15771484375</c:v>
                </c:pt>
                <c:pt idx="192">
                  <c:v>5344.66357421875</c:v>
                </c:pt>
                <c:pt idx="193">
                  <c:v>5328.20361328125</c:v>
                </c:pt>
                <c:pt idx="194">
                  <c:v>5333.662109375</c:v>
                </c:pt>
                <c:pt idx="195">
                  <c:v>5386.513671875</c:v>
                </c:pt>
                <c:pt idx="196">
                  <c:v>5478.1201171875</c:v>
                </c:pt>
                <c:pt idx="197">
                  <c:v>5567.74267578125</c:v>
                </c:pt>
                <c:pt idx="198">
                  <c:v>5608.84423828125</c:v>
                </c:pt>
                <c:pt idx="199">
                  <c:v>5579.68505859375</c:v>
                </c:pt>
                <c:pt idx="200">
                  <c:v>5495.60595703125</c:v>
                </c:pt>
                <c:pt idx="201">
                  <c:v>5395.37939453125</c:v>
                </c:pt>
                <c:pt idx="202">
                  <c:v>5314.1376953125</c:v>
                </c:pt>
                <c:pt idx="203">
                  <c:v>5264.4658203125</c:v>
                </c:pt>
                <c:pt idx="204">
                  <c:v>5238.57275390625</c:v>
                </c:pt>
                <c:pt idx="205">
                  <c:v>5226.0244140625</c:v>
                </c:pt>
                <c:pt idx="206">
                  <c:v>5229.04248046875</c:v>
                </c:pt>
                <c:pt idx="207">
                  <c:v>5261.0126953125</c:v>
                </c:pt>
                <c:pt idx="208">
                  <c:v>5329.8193359375</c:v>
                </c:pt>
                <c:pt idx="209">
                  <c:v>5421.8603515625</c:v>
                </c:pt>
                <c:pt idx="210">
                  <c:v>5502.7578125</c:v>
                </c:pt>
                <c:pt idx="211">
                  <c:v>5536.7646484375</c:v>
                </c:pt>
                <c:pt idx="212">
                  <c:v>5510.70751953125</c:v>
                </c:pt>
                <c:pt idx="213">
                  <c:v>5443.7236328125</c:v>
                </c:pt>
                <c:pt idx="214">
                  <c:v>5374.9140625</c:v>
                </c:pt>
                <c:pt idx="215">
                  <c:v>5338.25</c:v>
                </c:pt>
                <c:pt idx="216">
                  <c:v>5343.40185546875</c:v>
                </c:pt>
                <c:pt idx="217">
                  <c:v>5375.45849609375</c:v>
                </c:pt>
                <c:pt idx="218">
                  <c:v>5411.05419921875</c:v>
                </c:pt>
                <c:pt idx="219">
                  <c:v>5436.31787109375</c:v>
                </c:pt>
                <c:pt idx="220">
                  <c:v>5452.7314453125</c:v>
                </c:pt>
                <c:pt idx="221">
                  <c:v>5468.74072265625</c:v>
                </c:pt>
                <c:pt idx="222">
                  <c:v>5487.03076171875</c:v>
                </c:pt>
                <c:pt idx="223">
                  <c:v>5499.69140625</c:v>
                </c:pt>
                <c:pt idx="224">
                  <c:v>5495.060546875</c:v>
                </c:pt>
                <c:pt idx="225">
                  <c:v>5469.13427734375</c:v>
                </c:pt>
                <c:pt idx="226">
                  <c:v>5430.7958984375</c:v>
                </c:pt>
                <c:pt idx="227">
                  <c:v>5396.28857421875</c:v>
                </c:pt>
                <c:pt idx="228">
                  <c:v>5378.154296875</c:v>
                </c:pt>
                <c:pt idx="229">
                  <c:v>5378.205078125</c:v>
                </c:pt>
                <c:pt idx="230">
                  <c:v>5389.58447265625</c:v>
                </c:pt>
                <c:pt idx="231">
                  <c:v>5404.41748046875</c:v>
                </c:pt>
                <c:pt idx="232">
                  <c:v>5419.07275390625</c:v>
                </c:pt>
                <c:pt idx="233">
                  <c:v>5432.6259765625</c:v>
                </c:pt>
                <c:pt idx="234">
                  <c:v>5441.7275390625</c:v>
                </c:pt>
                <c:pt idx="235">
                  <c:v>5439.041015625</c:v>
                </c:pt>
                <c:pt idx="236">
                  <c:v>5418.6982421875</c:v>
                </c:pt>
                <c:pt idx="237">
                  <c:v>5384.3232421875</c:v>
                </c:pt>
                <c:pt idx="238">
                  <c:v>5351.06005859375</c:v>
                </c:pt>
                <c:pt idx="239">
                  <c:v>5337.333984375</c:v>
                </c:pt>
                <c:pt idx="240">
                  <c:v>5351.501953125</c:v>
                </c:pt>
                <c:pt idx="241">
                  <c:v>5384.4677734375</c:v>
                </c:pt>
                <c:pt idx="242">
                  <c:v>5415.66357421875</c:v>
                </c:pt>
                <c:pt idx="243">
                  <c:v>5428.8154296875</c:v>
                </c:pt>
                <c:pt idx="244">
                  <c:v>5424.8955078125</c:v>
                </c:pt>
                <c:pt idx="245">
                  <c:v>5420.90576171875</c:v>
                </c:pt>
                <c:pt idx="246">
                  <c:v>5434.3642578125</c:v>
                </c:pt>
                <c:pt idx="247">
                  <c:v>5465.67431640625</c:v>
                </c:pt>
                <c:pt idx="248">
                  <c:v>5493.41259765625</c:v>
                </c:pt>
                <c:pt idx="249">
                  <c:v>5488.06396484375</c:v>
                </c:pt>
                <c:pt idx="250">
                  <c:v>5435.06005859375</c:v>
                </c:pt>
                <c:pt idx="251">
                  <c:v>5349.8466796875</c:v>
                </c:pt>
                <c:pt idx="252">
                  <c:v>5272.71923828125</c:v>
                </c:pt>
                <c:pt idx="253">
                  <c:v>5245.65087890625</c:v>
                </c:pt>
                <c:pt idx="254">
                  <c:v>5286.2861328125</c:v>
                </c:pt>
                <c:pt idx="255">
                  <c:v>5376.240234375</c:v>
                </c:pt>
                <c:pt idx="256">
                  <c:v>5470.9453125</c:v>
                </c:pt>
                <c:pt idx="257">
                  <c:v>5524.2353515625</c:v>
                </c:pt>
                <c:pt idx="258">
                  <c:v>5512.46435546875</c:v>
                </c:pt>
                <c:pt idx="259">
                  <c:v>5444.88232421875</c:v>
                </c:pt>
                <c:pt idx="260">
                  <c:v>5356.36962890625</c:v>
                </c:pt>
                <c:pt idx="261">
                  <c:v>5288.515625</c:v>
                </c:pt>
                <c:pt idx="262">
                  <c:v>5269.802734375</c:v>
                </c:pt>
                <c:pt idx="263">
                  <c:v>5304.2568359375</c:v>
                </c:pt>
                <c:pt idx="264">
                  <c:v>5372.6904296875</c:v>
                </c:pt>
                <c:pt idx="265">
                  <c:v>5444.6484375</c:v>
                </c:pt>
                <c:pt idx="266">
                  <c:v>5494.4658203125</c:v>
                </c:pt>
                <c:pt idx="267">
                  <c:v>5512.9443359375</c:v>
                </c:pt>
                <c:pt idx="268">
                  <c:v>5508.22021484375</c:v>
                </c:pt>
                <c:pt idx="269">
                  <c:v>5495.54443359375</c:v>
                </c:pt>
                <c:pt idx="270">
                  <c:v>5483.20068359375</c:v>
                </c:pt>
                <c:pt idx="271">
                  <c:v>5465.47216796875</c:v>
                </c:pt>
                <c:pt idx="272">
                  <c:v>5429.40966796875</c:v>
                </c:pt>
                <c:pt idx="273">
                  <c:v>5371.4326171875</c:v>
                </c:pt>
                <c:pt idx="274">
                  <c:v>5310.1044921875</c:v>
                </c:pt>
                <c:pt idx="275">
                  <c:v>5281.54345703125</c:v>
                </c:pt>
                <c:pt idx="276">
                  <c:v>5316.0859375</c:v>
                </c:pt>
                <c:pt idx="277">
                  <c:v>5411.1357421875</c:v>
                </c:pt>
                <c:pt idx="278">
                  <c:v>5522.2333984375</c:v>
                </c:pt>
                <c:pt idx="279">
                  <c:v>5584.224609375</c:v>
                </c:pt>
                <c:pt idx="280">
                  <c:v>5552.3427734375</c:v>
                </c:pt>
                <c:pt idx="281">
                  <c:v>5435.4267578125</c:v>
                </c:pt>
                <c:pt idx="282">
                  <c:v>5295.53271484375</c:v>
                </c:pt>
                <c:pt idx="283">
                  <c:v>5210.76513671875</c:v>
                </c:pt>
                <c:pt idx="284">
                  <c:v>5225.490234375</c:v>
                </c:pt>
                <c:pt idx="285">
                  <c:v>5322.90771484375</c:v>
                </c:pt>
                <c:pt idx="286">
                  <c:v>5439.65380859375</c:v>
                </c:pt>
                <c:pt idx="287">
                  <c:v>5511.28662109375</c:v>
                </c:pt>
                <c:pt idx="288">
                  <c:v>5514.70068359375</c:v>
                </c:pt>
                <c:pt idx="289">
                  <c:v>5476.7294921875</c:v>
                </c:pt>
                <c:pt idx="290">
                  <c:v>5445.0673828125</c:v>
                </c:pt>
                <c:pt idx="291">
                  <c:v>5446.88134765625</c:v>
                </c:pt>
                <c:pt idx="292">
                  <c:v>5468.833984375</c:v>
                </c:pt>
                <c:pt idx="293">
                  <c:v>5473.302734375</c:v>
                </c:pt>
                <c:pt idx="294">
                  <c:v>5435.24658203125</c:v>
                </c:pt>
                <c:pt idx="295">
                  <c:v>5367.4677734375</c:v>
                </c:pt>
                <c:pt idx="296">
                  <c:v>5312.55908203125</c:v>
                </c:pt>
                <c:pt idx="297">
                  <c:v>5308.4208984375</c:v>
                </c:pt>
                <c:pt idx="298">
                  <c:v>5356.74169921875</c:v>
                </c:pt>
                <c:pt idx="299">
                  <c:v>5421.31884765625</c:v>
                </c:pt>
                <c:pt idx="300">
                  <c:v>5457.80126953125</c:v>
                </c:pt>
                <c:pt idx="301">
                  <c:v>5449.74609375</c:v>
                </c:pt>
                <c:pt idx="302">
                  <c:v>5420.42919921875</c:v>
                </c:pt>
                <c:pt idx="303">
                  <c:v>5410.3330078125</c:v>
                </c:pt>
                <c:pt idx="304">
                  <c:v>5439.3798828125</c:v>
                </c:pt>
                <c:pt idx="305">
                  <c:v>5486.31591796875</c:v>
                </c:pt>
                <c:pt idx="306">
                  <c:v>5503.6875</c:v>
                </c:pt>
                <c:pt idx="307">
                  <c:v>5457.19482421875</c:v>
                </c:pt>
                <c:pt idx="308">
                  <c:v>5357.4345703125</c:v>
                </c:pt>
                <c:pt idx="309">
                  <c:v>5257.439453125</c:v>
                </c:pt>
                <c:pt idx="310">
                  <c:v>5216.6396484375</c:v>
                </c:pt>
                <c:pt idx="311">
                  <c:v>5258.615234375</c:v>
                </c:pt>
                <c:pt idx="312">
                  <c:v>5354.7978515625</c:v>
                </c:pt>
                <c:pt idx="313">
                  <c:v>5445.68505859375</c:v>
                </c:pt>
                <c:pt idx="314">
                  <c:v>5482.3056640625</c:v>
                </c:pt>
                <c:pt idx="315">
                  <c:v>5456.537109375</c:v>
                </c:pt>
                <c:pt idx="316">
                  <c:v>5399.64306640625</c:v>
                </c:pt>
                <c:pt idx="317">
                  <c:v>5353.93896484375</c:v>
                </c:pt>
                <c:pt idx="318">
                  <c:v>5341.8232421875</c:v>
                </c:pt>
                <c:pt idx="319">
                  <c:v>5355.14111328125</c:v>
                </c:pt>
                <c:pt idx="320">
                  <c:v>5369.2451171875</c:v>
                </c:pt>
                <c:pt idx="321">
                  <c:v>5366.74072265625</c:v>
                </c:pt>
                <c:pt idx="322">
                  <c:v>5351.0732421875</c:v>
                </c:pt>
                <c:pt idx="323">
                  <c:v>5341.50634765625</c:v>
                </c:pt>
                <c:pt idx="324">
                  <c:v>5357.04931640625</c:v>
                </c:pt>
                <c:pt idx="325">
                  <c:v>5403.7568359375</c:v>
                </c:pt>
                <c:pt idx="326">
                  <c:v>5473.54150390625</c:v>
                </c:pt>
                <c:pt idx="327">
                  <c:v>5551.1240234375</c:v>
                </c:pt>
                <c:pt idx="328">
                  <c:v>5620.19580078125</c:v>
                </c:pt>
                <c:pt idx="329">
                  <c:v>5664.4013671875</c:v>
                </c:pt>
                <c:pt idx="330">
                  <c:v>5667.09130859375</c:v>
                </c:pt>
                <c:pt idx="331">
                  <c:v>5616.4365234375</c:v>
                </c:pt>
                <c:pt idx="332">
                  <c:v>5516.0595703125</c:v>
                </c:pt>
                <c:pt idx="333">
                  <c:v>5392.4482421875</c:v>
                </c:pt>
                <c:pt idx="334">
                  <c:v>5288.8525390625</c:v>
                </c:pt>
                <c:pt idx="335">
                  <c:v>5244.6982421875</c:v>
                </c:pt>
                <c:pt idx="336">
                  <c:v>5272.56298828125</c:v>
                </c:pt>
                <c:pt idx="337">
                  <c:v>5349.65283203125</c:v>
                </c:pt>
                <c:pt idx="338">
                  <c:v>5431.66357421875</c:v>
                </c:pt>
                <c:pt idx="339">
                  <c:v>5480.19287109375</c:v>
                </c:pt>
                <c:pt idx="340">
                  <c:v>5484.08203125</c:v>
                </c:pt>
                <c:pt idx="341">
                  <c:v>5459.65087890625</c:v>
                </c:pt>
                <c:pt idx="342">
                  <c:v>5431.46044921875</c:v>
                </c:pt>
                <c:pt idx="343">
                  <c:v>5410.50439453125</c:v>
                </c:pt>
                <c:pt idx="344">
                  <c:v>5387.8798828125</c:v>
                </c:pt>
                <c:pt idx="345">
                  <c:v>5348.21240234375</c:v>
                </c:pt>
                <c:pt idx="346">
                  <c:v>5290.0078125</c:v>
                </c:pt>
                <c:pt idx="347">
                  <c:v>5234.1474609375</c:v>
                </c:pt>
                <c:pt idx="348">
                  <c:v>5211.89306640625</c:v>
                </c:pt>
                <c:pt idx="349">
                  <c:v>5241.369140625</c:v>
                </c:pt>
              </c:numCache>
            </c:numRef>
          </c:yVal>
          <c:smooth val="1"/>
          <c:extLst>
            <c:ext xmlns:c16="http://schemas.microsoft.com/office/drawing/2014/chart" uri="{C3380CC4-5D6E-409C-BE32-E72D297353CC}">
              <c16:uniqueId val="{00000010-5429-4359-BD11-807CF8F8408D}"/>
            </c:ext>
          </c:extLst>
        </c:ser>
        <c:ser>
          <c:idx val="17"/>
          <c:order val="17"/>
          <c:tx>
            <c:strRef>
              <c:f>np_sub_003!$R$1</c:f>
              <c:strCache>
                <c:ptCount val="1"/>
                <c:pt idx="0">
                  <c:v>Coor_18</c:v>
                </c:pt>
              </c:strCache>
            </c:strRef>
          </c:tx>
          <c:spPr>
            <a:ln w="28575" cap="rnd">
              <a:solidFill>
                <a:schemeClr val="accent6">
                  <a:lumMod val="80000"/>
                  <a:lumOff val="20000"/>
                </a:schemeClr>
              </a:solidFill>
              <a:round/>
            </a:ln>
            <a:effectLst/>
          </c:spPr>
          <c:marker>
            <c:symbol val="none"/>
          </c:marker>
          <c:yVal>
            <c:numRef>
              <c:f>np_sub_003!$R$2:$R$351</c:f>
              <c:numCache>
                <c:formatCode>0.00000000000_ </c:formatCode>
                <c:ptCount val="350"/>
                <c:pt idx="0">
                  <c:v>7166.51708984375</c:v>
                </c:pt>
                <c:pt idx="1">
                  <c:v>7178.267578125</c:v>
                </c:pt>
                <c:pt idx="2">
                  <c:v>7131.77392578125</c:v>
                </c:pt>
                <c:pt idx="3">
                  <c:v>7046.76904296875</c:v>
                </c:pt>
                <c:pt idx="4">
                  <c:v>6967.9052734375</c:v>
                </c:pt>
                <c:pt idx="5">
                  <c:v>6937.4013671875</c:v>
                </c:pt>
                <c:pt idx="6">
                  <c:v>6968.849609375</c:v>
                </c:pt>
                <c:pt idx="7">
                  <c:v>7040.14453125</c:v>
                </c:pt>
                <c:pt idx="8">
                  <c:v>7109.60400390625</c:v>
                </c:pt>
                <c:pt idx="9">
                  <c:v>7142.9248046875</c:v>
                </c:pt>
                <c:pt idx="10">
                  <c:v>7131.98876953125</c:v>
                </c:pt>
                <c:pt idx="11">
                  <c:v>7094.1630859375</c:v>
                </c:pt>
                <c:pt idx="12">
                  <c:v>7055.8095703125</c:v>
                </c:pt>
                <c:pt idx="13">
                  <c:v>7034.24609375</c:v>
                </c:pt>
                <c:pt idx="14">
                  <c:v>7030.87548828125</c:v>
                </c:pt>
                <c:pt idx="15">
                  <c:v>7037.28857421875</c:v>
                </c:pt>
                <c:pt idx="16">
                  <c:v>7045.6953125</c:v>
                </c:pt>
                <c:pt idx="17">
                  <c:v>7053.5322265625</c:v>
                </c:pt>
                <c:pt idx="18">
                  <c:v>7059.6015625</c:v>
                </c:pt>
                <c:pt idx="19">
                  <c:v>7058.05029296875</c:v>
                </c:pt>
                <c:pt idx="20">
                  <c:v>7038.60693359375</c:v>
                </c:pt>
                <c:pt idx="21">
                  <c:v>6995.0791015625</c:v>
                </c:pt>
                <c:pt idx="22">
                  <c:v>6935.30078125</c:v>
                </c:pt>
                <c:pt idx="23">
                  <c:v>6882.697265625</c:v>
                </c:pt>
                <c:pt idx="24">
                  <c:v>6865.5</c:v>
                </c:pt>
                <c:pt idx="25">
                  <c:v>6899.65283203125</c:v>
                </c:pt>
                <c:pt idx="26">
                  <c:v>6977.24169921875</c:v>
                </c:pt>
                <c:pt idx="27">
                  <c:v>7068.97802734375</c:v>
                </c:pt>
                <c:pt idx="28">
                  <c:v>7139.49365234375</c:v>
                </c:pt>
                <c:pt idx="29">
                  <c:v>7165.56982421875</c:v>
                </c:pt>
                <c:pt idx="30">
                  <c:v>7146.228515625</c:v>
                </c:pt>
                <c:pt idx="31">
                  <c:v>7100.00244140625</c:v>
                </c:pt>
                <c:pt idx="32">
                  <c:v>7053.13623046875</c:v>
                </c:pt>
                <c:pt idx="33">
                  <c:v>7026.85107421875</c:v>
                </c:pt>
                <c:pt idx="34">
                  <c:v>7030.072265625</c:v>
                </c:pt>
                <c:pt idx="35">
                  <c:v>7059.03369140625</c:v>
                </c:pt>
                <c:pt idx="36">
                  <c:v>7101.31884765625</c:v>
                </c:pt>
                <c:pt idx="37">
                  <c:v>7141.259765625</c:v>
                </c:pt>
                <c:pt idx="38">
                  <c:v>7164.96826171875</c:v>
                </c:pt>
                <c:pt idx="39">
                  <c:v>7164.2685546875</c:v>
                </c:pt>
                <c:pt idx="40">
                  <c:v>7138.6904296875</c:v>
                </c:pt>
                <c:pt idx="41">
                  <c:v>7094.6279296875</c:v>
                </c:pt>
                <c:pt idx="42">
                  <c:v>7042.03515625</c:v>
                </c:pt>
                <c:pt idx="43">
                  <c:v>6990.89111328125</c:v>
                </c:pt>
                <c:pt idx="44">
                  <c:v>6949.96533203125</c:v>
                </c:pt>
                <c:pt idx="45">
                  <c:v>6928.0654296875</c:v>
                </c:pt>
                <c:pt idx="46">
                  <c:v>6934.73388671875</c:v>
                </c:pt>
                <c:pt idx="47">
                  <c:v>6976.8134765625</c:v>
                </c:pt>
                <c:pt idx="48">
                  <c:v>7051.02734375</c:v>
                </c:pt>
                <c:pt idx="49">
                  <c:v>7138.1337890625</c:v>
                </c:pt>
                <c:pt idx="50">
                  <c:v>7205.99267578125</c:v>
                </c:pt>
                <c:pt idx="51">
                  <c:v>7223.79541015625</c:v>
                </c:pt>
                <c:pt idx="52">
                  <c:v>7180.5185546875</c:v>
                </c:pt>
                <c:pt idx="53">
                  <c:v>7094.7646484375</c:v>
                </c:pt>
                <c:pt idx="54">
                  <c:v>7006.75537109375</c:v>
                </c:pt>
                <c:pt idx="55">
                  <c:v>6955.294921875</c:v>
                </c:pt>
                <c:pt idx="56">
                  <c:v>6954.39892578125</c:v>
                </c:pt>
                <c:pt idx="57">
                  <c:v>6986.15087890625</c:v>
                </c:pt>
                <c:pt idx="58">
                  <c:v>7015.49951171875</c:v>
                </c:pt>
                <c:pt idx="59">
                  <c:v>7016.54638671875</c:v>
                </c:pt>
                <c:pt idx="60">
                  <c:v>6990.91162109375</c:v>
                </c:pt>
                <c:pt idx="61">
                  <c:v>6964.431640625</c:v>
                </c:pt>
                <c:pt idx="62">
                  <c:v>6964.95458984375</c:v>
                </c:pt>
                <c:pt idx="63">
                  <c:v>6998.61767578125</c:v>
                </c:pt>
                <c:pt idx="64">
                  <c:v>7043.26708984375</c:v>
                </c:pt>
                <c:pt idx="65">
                  <c:v>7064.4130859375</c:v>
                </c:pt>
                <c:pt idx="66">
                  <c:v>7041.66015625</c:v>
                </c:pt>
                <c:pt idx="67">
                  <c:v>6985.51025390625</c:v>
                </c:pt>
                <c:pt idx="68">
                  <c:v>6931.86865234375</c:v>
                </c:pt>
                <c:pt idx="69">
                  <c:v>6918.39306640625</c:v>
                </c:pt>
                <c:pt idx="70">
                  <c:v>6959.943359375</c:v>
                </c:pt>
                <c:pt idx="71">
                  <c:v>7040.09130859375</c:v>
                </c:pt>
                <c:pt idx="72">
                  <c:v>7123.12353515625</c:v>
                </c:pt>
                <c:pt idx="73">
                  <c:v>7176.4296875</c:v>
                </c:pt>
                <c:pt idx="74">
                  <c:v>7187.45556640625</c:v>
                </c:pt>
                <c:pt idx="75">
                  <c:v>7165.5546875</c:v>
                </c:pt>
                <c:pt idx="76">
                  <c:v>7130.88623046875</c:v>
                </c:pt>
                <c:pt idx="77">
                  <c:v>7100.55419921875</c:v>
                </c:pt>
                <c:pt idx="78">
                  <c:v>7081.3759765625</c:v>
                </c:pt>
                <c:pt idx="79">
                  <c:v>7071.55615234375</c:v>
                </c:pt>
                <c:pt idx="80">
                  <c:v>7066.861328125</c:v>
                </c:pt>
                <c:pt idx="81">
                  <c:v>7065.35791015625</c:v>
                </c:pt>
                <c:pt idx="82">
                  <c:v>7068.04345703125</c:v>
                </c:pt>
                <c:pt idx="83">
                  <c:v>7076.58740234375</c:v>
                </c:pt>
                <c:pt idx="84">
                  <c:v>7090.7177734375</c:v>
                </c:pt>
                <c:pt idx="85">
                  <c:v>7106.736328125</c:v>
                </c:pt>
                <c:pt idx="86">
                  <c:v>7117.4423828125</c:v>
                </c:pt>
                <c:pt idx="87">
                  <c:v>7113.85107421875</c:v>
                </c:pt>
                <c:pt idx="88">
                  <c:v>7089.29150390625</c:v>
                </c:pt>
                <c:pt idx="89">
                  <c:v>7045.02099609375</c:v>
                </c:pt>
                <c:pt idx="90">
                  <c:v>6993.78466796875</c:v>
                </c:pt>
                <c:pt idx="91">
                  <c:v>6956.77197265625</c:v>
                </c:pt>
                <c:pt idx="92">
                  <c:v>6952.82275390625</c:v>
                </c:pt>
                <c:pt idx="93">
                  <c:v>6985.2802734375</c:v>
                </c:pt>
                <c:pt idx="94">
                  <c:v>7036.1787109375</c:v>
                </c:pt>
                <c:pt idx="95">
                  <c:v>7074.47265625</c:v>
                </c:pt>
                <c:pt idx="96">
                  <c:v>7075.2021484375</c:v>
                </c:pt>
                <c:pt idx="97">
                  <c:v>7036.9453125</c:v>
                </c:pt>
                <c:pt idx="98">
                  <c:v>6984.05517578125</c:v>
                </c:pt>
                <c:pt idx="99">
                  <c:v>6950.37939453125</c:v>
                </c:pt>
                <c:pt idx="100">
                  <c:v>6955.42333984375</c:v>
                </c:pt>
                <c:pt idx="101">
                  <c:v>6990.79296875</c:v>
                </c:pt>
                <c:pt idx="102">
                  <c:v>7027.69580078125</c:v>
                </c:pt>
                <c:pt idx="103">
                  <c:v>7039.9521484375</c:v>
                </c:pt>
                <c:pt idx="104">
                  <c:v>7024.29541015625</c:v>
                </c:pt>
                <c:pt idx="105">
                  <c:v>7001.4970703125</c:v>
                </c:pt>
                <c:pt idx="106">
                  <c:v>6997.37451171875</c:v>
                </c:pt>
                <c:pt idx="107">
                  <c:v>7019.6181640625</c:v>
                </c:pt>
                <c:pt idx="108">
                  <c:v>7050.45654296875</c:v>
                </c:pt>
                <c:pt idx="109">
                  <c:v>7062.33935546875</c:v>
                </c:pt>
                <c:pt idx="110">
                  <c:v>7044.1416015625</c:v>
                </c:pt>
                <c:pt idx="111">
                  <c:v>7015.33642578125</c:v>
                </c:pt>
                <c:pt idx="112">
                  <c:v>7014.15966796875</c:v>
                </c:pt>
                <c:pt idx="113">
                  <c:v>7066.91455078125</c:v>
                </c:pt>
                <c:pt idx="114">
                  <c:v>7162.2158203125</c:v>
                </c:pt>
                <c:pt idx="115">
                  <c:v>7252.015625</c:v>
                </c:pt>
                <c:pt idx="116">
                  <c:v>7281.40185546875</c:v>
                </c:pt>
                <c:pt idx="117">
                  <c:v>7226.5458984375</c:v>
                </c:pt>
                <c:pt idx="118">
                  <c:v>7112.869140625</c:v>
                </c:pt>
                <c:pt idx="119">
                  <c:v>6999.517578125</c:v>
                </c:pt>
                <c:pt idx="120">
                  <c:v>6941.09033203125</c:v>
                </c:pt>
                <c:pt idx="121">
                  <c:v>6954.068359375</c:v>
                </c:pt>
                <c:pt idx="122">
                  <c:v>7011.15380859375</c:v>
                </c:pt>
                <c:pt idx="123">
                  <c:v>7065.453125</c:v>
                </c:pt>
                <c:pt idx="124">
                  <c:v>7084.751953125</c:v>
                </c:pt>
                <c:pt idx="125">
                  <c:v>7070.33935546875</c:v>
                </c:pt>
                <c:pt idx="126">
                  <c:v>7048.384765625</c:v>
                </c:pt>
                <c:pt idx="127">
                  <c:v>7043.41259765625</c:v>
                </c:pt>
                <c:pt idx="128">
                  <c:v>7056.236328125</c:v>
                </c:pt>
                <c:pt idx="129">
                  <c:v>7063.72607421875</c:v>
                </c:pt>
                <c:pt idx="130">
                  <c:v>7039.8759765625</c:v>
                </c:pt>
                <c:pt idx="131">
                  <c:v>6981.00390625</c:v>
                </c:pt>
                <c:pt idx="132">
                  <c:v>6914.890625</c:v>
                </c:pt>
                <c:pt idx="133">
                  <c:v>6885.75830078125</c:v>
                </c:pt>
                <c:pt idx="134">
                  <c:v>6924.72216796875</c:v>
                </c:pt>
                <c:pt idx="135">
                  <c:v>7025.947265625</c:v>
                </c:pt>
                <c:pt idx="136">
                  <c:v>7145.173828125</c:v>
                </c:pt>
                <c:pt idx="137">
                  <c:v>7222.69091796875</c:v>
                </c:pt>
                <c:pt idx="138">
                  <c:v>7217.16650390625</c:v>
                </c:pt>
                <c:pt idx="139">
                  <c:v>7129.93896484375</c:v>
                </c:pt>
                <c:pt idx="140">
                  <c:v>7005.1728515625</c:v>
                </c:pt>
                <c:pt idx="141">
                  <c:v>6905.70068359375</c:v>
                </c:pt>
                <c:pt idx="142">
                  <c:v>6878.63720703125</c:v>
                </c:pt>
                <c:pt idx="143">
                  <c:v>6930.7421875</c:v>
                </c:pt>
                <c:pt idx="144">
                  <c:v>7027.58349609375</c:v>
                </c:pt>
                <c:pt idx="145">
                  <c:v>7116.2734375</c:v>
                </c:pt>
                <c:pt idx="146">
                  <c:v>7157.28125</c:v>
                </c:pt>
                <c:pt idx="147">
                  <c:v>7145.4287109375</c:v>
                </c:pt>
                <c:pt idx="148">
                  <c:v>7107.38818359375</c:v>
                </c:pt>
                <c:pt idx="149">
                  <c:v>7078.6748046875</c:v>
                </c:pt>
                <c:pt idx="150">
                  <c:v>7076.95849609375</c:v>
                </c:pt>
                <c:pt idx="151">
                  <c:v>7090.8232421875</c:v>
                </c:pt>
                <c:pt idx="152">
                  <c:v>7091.6923828125</c:v>
                </c:pt>
                <c:pt idx="153">
                  <c:v>7059.36328125</c:v>
                </c:pt>
                <c:pt idx="154">
                  <c:v>7001.16162109375</c:v>
                </c:pt>
                <c:pt idx="155">
                  <c:v>6949.3642578125</c:v>
                </c:pt>
                <c:pt idx="156">
                  <c:v>6938.20654296875</c:v>
                </c:pt>
                <c:pt idx="157">
                  <c:v>6977.8759765625</c:v>
                </c:pt>
                <c:pt idx="158">
                  <c:v>7045.6494140625</c:v>
                </c:pt>
                <c:pt idx="159">
                  <c:v>7101.25341796875</c:v>
                </c:pt>
                <c:pt idx="160">
                  <c:v>7114.697265625</c:v>
                </c:pt>
                <c:pt idx="161">
                  <c:v>7085.2900390625</c:v>
                </c:pt>
                <c:pt idx="162">
                  <c:v>7038.0185546875</c:v>
                </c:pt>
                <c:pt idx="163">
                  <c:v>7001.87890625</c:v>
                </c:pt>
                <c:pt idx="164">
                  <c:v>6988.86328125</c:v>
                </c:pt>
                <c:pt idx="165">
                  <c:v>6990.53076171875</c:v>
                </c:pt>
                <c:pt idx="166">
                  <c:v>6993.064453125</c:v>
                </c:pt>
                <c:pt idx="167">
                  <c:v>6995.3427734375</c:v>
                </c:pt>
                <c:pt idx="168">
                  <c:v>7012.119140625</c:v>
                </c:pt>
                <c:pt idx="169">
                  <c:v>7058.23583984375</c:v>
                </c:pt>
                <c:pt idx="170">
                  <c:v>7127.970703125</c:v>
                </c:pt>
                <c:pt idx="171">
                  <c:v>7189.8701171875</c:v>
                </c:pt>
                <c:pt idx="172">
                  <c:v>7205.3984375</c:v>
                </c:pt>
                <c:pt idx="173">
                  <c:v>7158.90283203125</c:v>
                </c:pt>
                <c:pt idx="174">
                  <c:v>7074.55078125</c:v>
                </c:pt>
                <c:pt idx="175">
                  <c:v>7004.12841796875</c:v>
                </c:pt>
                <c:pt idx="176">
                  <c:v>6992.18017578125</c:v>
                </c:pt>
                <c:pt idx="177">
                  <c:v>7043.873046875</c:v>
                </c:pt>
                <c:pt idx="178">
                  <c:v>7120.24365234375</c:v>
                </c:pt>
                <c:pt idx="179">
                  <c:v>7165.08544921875</c:v>
                </c:pt>
                <c:pt idx="180">
                  <c:v>7143.68212890625</c:v>
                </c:pt>
                <c:pt idx="181">
                  <c:v>7064.97900390625</c:v>
                </c:pt>
                <c:pt idx="182">
                  <c:v>6972.2158203125</c:v>
                </c:pt>
                <c:pt idx="183">
                  <c:v>6911.32373046875</c:v>
                </c:pt>
                <c:pt idx="184">
                  <c:v>6901.98291015625</c:v>
                </c:pt>
                <c:pt idx="185">
                  <c:v>6931.57666015625</c:v>
                </c:pt>
                <c:pt idx="186">
                  <c:v>6972.48583984375</c:v>
                </c:pt>
                <c:pt idx="187">
                  <c:v>7005.36328125</c:v>
                </c:pt>
                <c:pt idx="188">
                  <c:v>7029.1962890625</c:v>
                </c:pt>
                <c:pt idx="189">
                  <c:v>7052.95263671875</c:v>
                </c:pt>
                <c:pt idx="190">
                  <c:v>7080.00732421875</c:v>
                </c:pt>
                <c:pt idx="191">
                  <c:v>7101.21826171875</c:v>
                </c:pt>
                <c:pt idx="192">
                  <c:v>7102.626953125</c:v>
                </c:pt>
                <c:pt idx="193">
                  <c:v>7079.38720703125</c:v>
                </c:pt>
                <c:pt idx="194">
                  <c:v>7042.06201171875</c:v>
                </c:pt>
                <c:pt idx="195">
                  <c:v>7009.2587890625</c:v>
                </c:pt>
                <c:pt idx="196">
                  <c:v>6993.7421875</c:v>
                </c:pt>
                <c:pt idx="197">
                  <c:v>6995.087890625</c:v>
                </c:pt>
                <c:pt idx="198">
                  <c:v>7005.1904296875</c:v>
                </c:pt>
                <c:pt idx="199">
                  <c:v>7020.1796875</c:v>
                </c:pt>
                <c:pt idx="200">
                  <c:v>7045.80908203125</c:v>
                </c:pt>
                <c:pt idx="201">
                  <c:v>7089.68359375</c:v>
                </c:pt>
                <c:pt idx="202">
                  <c:v>7147.07666015625</c:v>
                </c:pt>
                <c:pt idx="203">
                  <c:v>7194.9248046875</c:v>
                </c:pt>
                <c:pt idx="204">
                  <c:v>7202.80322265625</c:v>
                </c:pt>
                <c:pt idx="205">
                  <c:v>7154.7275390625</c:v>
                </c:pt>
                <c:pt idx="206">
                  <c:v>7064.619140625</c:v>
                </c:pt>
                <c:pt idx="207">
                  <c:v>6971.64453125</c:v>
                </c:pt>
                <c:pt idx="208">
                  <c:v>6917.2216796875</c:v>
                </c:pt>
                <c:pt idx="209">
                  <c:v>6920.306640625</c:v>
                </c:pt>
                <c:pt idx="210">
                  <c:v>6968.88916015625</c:v>
                </c:pt>
                <c:pt idx="211">
                  <c:v>7032.3447265625</c:v>
                </c:pt>
                <c:pt idx="212">
                  <c:v>7082.92333984375</c:v>
                </c:pt>
                <c:pt idx="213">
                  <c:v>7109.134765625</c:v>
                </c:pt>
                <c:pt idx="214">
                  <c:v>7113.20849609375</c:v>
                </c:pt>
                <c:pt idx="215">
                  <c:v>7099.86767578125</c:v>
                </c:pt>
                <c:pt idx="216">
                  <c:v>7070.32958984375</c:v>
                </c:pt>
                <c:pt idx="217">
                  <c:v>7027.853515625</c:v>
                </c:pt>
                <c:pt idx="218">
                  <c:v>6987.07861328125</c:v>
                </c:pt>
                <c:pt idx="219">
                  <c:v>6973.09423828125</c:v>
                </c:pt>
                <c:pt idx="220">
                  <c:v>7004.9609375</c:v>
                </c:pt>
                <c:pt idx="221">
                  <c:v>7075.07275390625</c:v>
                </c:pt>
                <c:pt idx="222">
                  <c:v>7144.3525390625</c:v>
                </c:pt>
                <c:pt idx="223">
                  <c:v>7163.67529296875</c:v>
                </c:pt>
                <c:pt idx="224">
                  <c:v>7109.990234375</c:v>
                </c:pt>
                <c:pt idx="225">
                  <c:v>7009.71484375</c:v>
                </c:pt>
                <c:pt idx="226">
                  <c:v>6927.4560546875</c:v>
                </c:pt>
                <c:pt idx="227">
                  <c:v>6923.3623046875</c:v>
                </c:pt>
                <c:pt idx="228">
                  <c:v>7008.2705078125</c:v>
                </c:pt>
                <c:pt idx="229">
                  <c:v>7130.8671875</c:v>
                </c:pt>
                <c:pt idx="230">
                  <c:v>7209.2568359375</c:v>
                </c:pt>
                <c:pt idx="231">
                  <c:v>7186.29638671875</c:v>
                </c:pt>
                <c:pt idx="232">
                  <c:v>7069.34619140625</c:v>
                </c:pt>
                <c:pt idx="233">
                  <c:v>6925.72412109375</c:v>
                </c:pt>
                <c:pt idx="234">
                  <c:v>6837.50927734375</c:v>
                </c:pt>
                <c:pt idx="235">
                  <c:v>6848.61962890625</c:v>
                </c:pt>
                <c:pt idx="236">
                  <c:v>6941.23974609375</c:v>
                </c:pt>
                <c:pt idx="237">
                  <c:v>7055.314453125</c:v>
                </c:pt>
                <c:pt idx="238">
                  <c:v>7132.9658203125</c:v>
                </c:pt>
                <c:pt idx="239">
                  <c:v>7153.70947265625</c:v>
                </c:pt>
                <c:pt idx="240">
                  <c:v>7137.19873046875</c:v>
                </c:pt>
                <c:pt idx="241">
                  <c:v>7117.20751953125</c:v>
                </c:pt>
                <c:pt idx="242">
                  <c:v>7111.5244140625</c:v>
                </c:pt>
                <c:pt idx="243">
                  <c:v>7111.78759765625</c:v>
                </c:pt>
                <c:pt idx="244">
                  <c:v>7097.89697265625</c:v>
                </c:pt>
                <c:pt idx="245">
                  <c:v>7061.0205078125</c:v>
                </c:pt>
                <c:pt idx="246">
                  <c:v>7014.111328125</c:v>
                </c:pt>
                <c:pt idx="247">
                  <c:v>6981.79150390625</c:v>
                </c:pt>
                <c:pt idx="248">
                  <c:v>6979.92333984375</c:v>
                </c:pt>
                <c:pt idx="249">
                  <c:v>7003.1826171875</c:v>
                </c:pt>
                <c:pt idx="250">
                  <c:v>7030.71240234375</c:v>
                </c:pt>
                <c:pt idx="251">
                  <c:v>7043.75048828125</c:v>
                </c:pt>
                <c:pt idx="252">
                  <c:v>7039.45849609375</c:v>
                </c:pt>
                <c:pt idx="253">
                  <c:v>7029.7822265625</c:v>
                </c:pt>
                <c:pt idx="254">
                  <c:v>7028.05517578125</c:v>
                </c:pt>
                <c:pt idx="255">
                  <c:v>7036.53515625</c:v>
                </c:pt>
                <c:pt idx="256">
                  <c:v>7046.17626953125</c:v>
                </c:pt>
                <c:pt idx="257">
                  <c:v>7048.02001953125</c:v>
                </c:pt>
                <c:pt idx="258">
                  <c:v>7044.65234375</c:v>
                </c:pt>
                <c:pt idx="259">
                  <c:v>7050.041015625</c:v>
                </c:pt>
                <c:pt idx="260">
                  <c:v>7076.7421875</c:v>
                </c:pt>
                <c:pt idx="261">
                  <c:v>7121.42626953125</c:v>
                </c:pt>
                <c:pt idx="262">
                  <c:v>7162.244140625</c:v>
                </c:pt>
                <c:pt idx="263">
                  <c:v>7172.2080078125</c:v>
                </c:pt>
                <c:pt idx="264">
                  <c:v>7139.20849609375</c:v>
                </c:pt>
                <c:pt idx="265">
                  <c:v>7076.91845703125</c:v>
                </c:pt>
                <c:pt idx="266">
                  <c:v>7017.17578125</c:v>
                </c:pt>
                <c:pt idx="267">
                  <c:v>6988.646484375</c:v>
                </c:pt>
                <c:pt idx="268">
                  <c:v>6997.33740234375</c:v>
                </c:pt>
                <c:pt idx="269">
                  <c:v>7023.42724609375</c:v>
                </c:pt>
                <c:pt idx="270">
                  <c:v>7036.73095703125</c:v>
                </c:pt>
                <c:pt idx="271">
                  <c:v>7019.3291015625</c:v>
                </c:pt>
                <c:pt idx="272">
                  <c:v>6978.83203125</c:v>
                </c:pt>
                <c:pt idx="273">
                  <c:v>6942.8828125</c:v>
                </c:pt>
                <c:pt idx="274">
                  <c:v>6939.22900390625</c:v>
                </c:pt>
                <c:pt idx="275">
                  <c:v>6975.81982421875</c:v>
                </c:pt>
                <c:pt idx="276">
                  <c:v>7034.87451171875</c:v>
                </c:pt>
                <c:pt idx="277">
                  <c:v>7084.65185546875</c:v>
                </c:pt>
                <c:pt idx="278">
                  <c:v>7100.35107421875</c:v>
                </c:pt>
                <c:pt idx="279">
                  <c:v>7079.755859375</c:v>
                </c:pt>
                <c:pt idx="280">
                  <c:v>7043.43505859375</c:v>
                </c:pt>
                <c:pt idx="281">
                  <c:v>7020.1064453125</c:v>
                </c:pt>
                <c:pt idx="282">
                  <c:v>7027.53173828125</c:v>
                </c:pt>
                <c:pt idx="283">
                  <c:v>7061.6796875</c:v>
                </c:pt>
                <c:pt idx="284">
                  <c:v>7100.74609375</c:v>
                </c:pt>
                <c:pt idx="285">
                  <c:v>7120.48681640625</c:v>
                </c:pt>
                <c:pt idx="286">
                  <c:v>7110.09326171875</c:v>
                </c:pt>
                <c:pt idx="287">
                  <c:v>7078.1494140625</c:v>
                </c:pt>
                <c:pt idx="288">
                  <c:v>7045.474609375</c:v>
                </c:pt>
                <c:pt idx="289">
                  <c:v>7030.685546875</c:v>
                </c:pt>
                <c:pt idx="290">
                  <c:v>7038.82861328125</c:v>
                </c:pt>
                <c:pt idx="291">
                  <c:v>7060.51513671875</c:v>
                </c:pt>
                <c:pt idx="292">
                  <c:v>7080.9345703125</c:v>
                </c:pt>
                <c:pt idx="293">
                  <c:v>7091.0166015625</c:v>
                </c:pt>
                <c:pt idx="294">
                  <c:v>7092.02490234375</c:v>
                </c:pt>
                <c:pt idx="295">
                  <c:v>7090.68359375</c:v>
                </c:pt>
                <c:pt idx="296">
                  <c:v>7089.82568359375</c:v>
                </c:pt>
                <c:pt idx="297">
                  <c:v>7083.2958984375</c:v>
                </c:pt>
                <c:pt idx="298">
                  <c:v>7060.275390625</c:v>
                </c:pt>
                <c:pt idx="299">
                  <c:v>7016.13671875</c:v>
                </c:pt>
                <c:pt idx="300">
                  <c:v>6960.89599609375</c:v>
                </c:pt>
                <c:pt idx="301">
                  <c:v>6917.37744140625</c:v>
                </c:pt>
                <c:pt idx="302">
                  <c:v>6908.87548828125</c:v>
                </c:pt>
                <c:pt idx="303">
                  <c:v>6944.39794921875</c:v>
                </c:pt>
                <c:pt idx="304">
                  <c:v>7011.88623046875</c:v>
                </c:pt>
                <c:pt idx="305">
                  <c:v>7084.26123046875</c:v>
                </c:pt>
                <c:pt idx="306">
                  <c:v>7133.99609375</c:v>
                </c:pt>
                <c:pt idx="307">
                  <c:v>7146.40234375</c:v>
                </c:pt>
                <c:pt idx="308">
                  <c:v>7123.82177734375</c:v>
                </c:pt>
                <c:pt idx="309">
                  <c:v>7080.32275390625</c:v>
                </c:pt>
                <c:pt idx="310">
                  <c:v>7032.88330078125</c:v>
                </c:pt>
                <c:pt idx="311">
                  <c:v>6995.537109375</c:v>
                </c:pt>
                <c:pt idx="312">
                  <c:v>6978.1240234375</c:v>
                </c:pt>
                <c:pt idx="313">
                  <c:v>6986.3662109375</c:v>
                </c:pt>
                <c:pt idx="314">
                  <c:v>7019.78955078125</c:v>
                </c:pt>
                <c:pt idx="315">
                  <c:v>7068.41259765625</c:v>
                </c:pt>
                <c:pt idx="316">
                  <c:v>7113.14306640625</c:v>
                </c:pt>
                <c:pt idx="317">
                  <c:v>7133.54150390625</c:v>
                </c:pt>
                <c:pt idx="318">
                  <c:v>7120.107421875</c:v>
                </c:pt>
                <c:pt idx="319">
                  <c:v>7082.2587890625</c:v>
                </c:pt>
                <c:pt idx="320">
                  <c:v>7044.06298828125</c:v>
                </c:pt>
                <c:pt idx="321">
                  <c:v>7028.400390625</c:v>
                </c:pt>
                <c:pt idx="322">
                  <c:v>7040.21044921875</c:v>
                </c:pt>
                <c:pt idx="323">
                  <c:v>7062.06103515625</c:v>
                </c:pt>
                <c:pt idx="324">
                  <c:v>7067.041015625</c:v>
                </c:pt>
                <c:pt idx="325">
                  <c:v>7040.41650390625</c:v>
                </c:pt>
                <c:pt idx="326">
                  <c:v>6993.4931640625</c:v>
                </c:pt>
                <c:pt idx="327">
                  <c:v>6957.8388671875</c:v>
                </c:pt>
                <c:pt idx="328">
                  <c:v>6962.75341796875</c:v>
                </c:pt>
                <c:pt idx="329">
                  <c:v>7012.3701171875</c:v>
                </c:pt>
                <c:pt idx="330">
                  <c:v>7080.08544921875</c:v>
                </c:pt>
                <c:pt idx="331">
                  <c:v>7125.52734375</c:v>
                </c:pt>
                <c:pt idx="332">
                  <c:v>7122.2568359375</c:v>
                </c:pt>
                <c:pt idx="333">
                  <c:v>7076.0771484375</c:v>
                </c:pt>
                <c:pt idx="334">
                  <c:v>7020.671875</c:v>
                </c:pt>
                <c:pt idx="335">
                  <c:v>6994.0888671875</c:v>
                </c:pt>
                <c:pt idx="336">
                  <c:v>7013.333984375</c:v>
                </c:pt>
                <c:pt idx="337">
                  <c:v>7064.84326171875</c:v>
                </c:pt>
                <c:pt idx="338">
                  <c:v>7116.080078125</c:v>
                </c:pt>
                <c:pt idx="339">
                  <c:v>7138.14501953125</c:v>
                </c:pt>
                <c:pt idx="340">
                  <c:v>7122.7041015625</c:v>
                </c:pt>
                <c:pt idx="341">
                  <c:v>7082.79345703125</c:v>
                </c:pt>
                <c:pt idx="342">
                  <c:v>7040.02587890625</c:v>
                </c:pt>
                <c:pt idx="343">
                  <c:v>7009.849609375</c:v>
                </c:pt>
                <c:pt idx="344">
                  <c:v>6995.4482421875</c:v>
                </c:pt>
                <c:pt idx="345">
                  <c:v>6992.03515625</c:v>
                </c:pt>
                <c:pt idx="346">
                  <c:v>6994.921875</c:v>
                </c:pt>
                <c:pt idx="347">
                  <c:v>7003.435546875</c:v>
                </c:pt>
                <c:pt idx="348">
                  <c:v>7018.3896484375</c:v>
                </c:pt>
                <c:pt idx="349">
                  <c:v>7037.40234375</c:v>
                </c:pt>
              </c:numCache>
            </c:numRef>
          </c:yVal>
          <c:smooth val="1"/>
          <c:extLst>
            <c:ext xmlns:c16="http://schemas.microsoft.com/office/drawing/2014/chart" uri="{C3380CC4-5D6E-409C-BE32-E72D297353CC}">
              <c16:uniqueId val="{00000011-5429-4359-BD11-807CF8F8408D}"/>
            </c:ext>
          </c:extLst>
        </c:ser>
        <c:ser>
          <c:idx val="18"/>
          <c:order val="18"/>
          <c:tx>
            <c:strRef>
              <c:f>np_sub_003!$S$1</c:f>
              <c:strCache>
                <c:ptCount val="1"/>
                <c:pt idx="0">
                  <c:v>Coor_19</c:v>
                </c:pt>
              </c:strCache>
            </c:strRef>
          </c:tx>
          <c:spPr>
            <a:ln w="28575" cap="rnd">
              <a:solidFill>
                <a:schemeClr val="accent1">
                  <a:lumMod val="80000"/>
                </a:schemeClr>
              </a:solidFill>
              <a:round/>
            </a:ln>
            <a:effectLst/>
          </c:spPr>
          <c:marker>
            <c:symbol val="none"/>
          </c:marker>
          <c:yVal>
            <c:numRef>
              <c:f>np_sub_003!$S$2:$S$351</c:f>
              <c:numCache>
                <c:formatCode>0.00000000000_ </c:formatCode>
                <c:ptCount val="350"/>
                <c:pt idx="0">
                  <c:v>6209.34423828125</c:v>
                </c:pt>
                <c:pt idx="1">
                  <c:v>6216.29248046875</c:v>
                </c:pt>
                <c:pt idx="2">
                  <c:v>6191.0908203125</c:v>
                </c:pt>
                <c:pt idx="3">
                  <c:v>6144.8818359375</c:v>
                </c:pt>
                <c:pt idx="4">
                  <c:v>6102.38720703125</c:v>
                </c:pt>
                <c:pt idx="5">
                  <c:v>6085.109375</c:v>
                </c:pt>
                <c:pt idx="6">
                  <c:v>6096.32958984375</c:v>
                </c:pt>
                <c:pt idx="7">
                  <c:v>6119.951171875</c:v>
                </c:pt>
                <c:pt idx="8">
                  <c:v>6134.41162109375</c:v>
                </c:pt>
                <c:pt idx="9">
                  <c:v>6130.33642578125</c:v>
                </c:pt>
                <c:pt idx="10">
                  <c:v>6117.07421875</c:v>
                </c:pt>
                <c:pt idx="11">
                  <c:v>6112.3876953125</c:v>
                </c:pt>
                <c:pt idx="12">
                  <c:v>6124.13720703125</c:v>
                </c:pt>
                <c:pt idx="13">
                  <c:v>6140.4248046875</c:v>
                </c:pt>
                <c:pt idx="14">
                  <c:v>6138.15966796875</c:v>
                </c:pt>
                <c:pt idx="15">
                  <c:v>6104.19482421875</c:v>
                </c:pt>
                <c:pt idx="16">
                  <c:v>6051.25244140625</c:v>
                </c:pt>
                <c:pt idx="17">
                  <c:v>6013.54638671875</c:v>
                </c:pt>
                <c:pt idx="18">
                  <c:v>6023.08935546875</c:v>
                </c:pt>
                <c:pt idx="19">
                  <c:v>6084.27197265625</c:v>
                </c:pt>
                <c:pt idx="20">
                  <c:v>6167.36083984375</c:v>
                </c:pt>
                <c:pt idx="21">
                  <c:v>6227.6005859375</c:v>
                </c:pt>
                <c:pt idx="22">
                  <c:v>6236.32373046875</c:v>
                </c:pt>
                <c:pt idx="23">
                  <c:v>6200.32421875</c:v>
                </c:pt>
                <c:pt idx="24">
                  <c:v>6154.4052734375</c:v>
                </c:pt>
                <c:pt idx="25">
                  <c:v>6133.025390625</c:v>
                </c:pt>
                <c:pt idx="26">
                  <c:v>6143.5849609375</c:v>
                </c:pt>
                <c:pt idx="27">
                  <c:v>6162.5888671875</c:v>
                </c:pt>
                <c:pt idx="28">
                  <c:v>6157.578125</c:v>
                </c:pt>
                <c:pt idx="29">
                  <c:v>6116.92626953125</c:v>
                </c:pt>
                <c:pt idx="30">
                  <c:v>6063.05615234375</c:v>
                </c:pt>
                <c:pt idx="31">
                  <c:v>6037.6201171875</c:v>
                </c:pt>
                <c:pt idx="32">
                  <c:v>6069.4267578125</c:v>
                </c:pt>
                <c:pt idx="33">
                  <c:v>6149.79833984375</c:v>
                </c:pt>
                <c:pt idx="34">
                  <c:v>6234.76123046875</c:v>
                </c:pt>
                <c:pt idx="35">
                  <c:v>6273.3251953125</c:v>
                </c:pt>
                <c:pt idx="36">
                  <c:v>6241.736328125</c:v>
                </c:pt>
                <c:pt idx="37">
                  <c:v>6159.53857421875</c:v>
                </c:pt>
                <c:pt idx="38">
                  <c:v>6076.912109375</c:v>
                </c:pt>
                <c:pt idx="39">
                  <c:v>6043.1015625</c:v>
                </c:pt>
                <c:pt idx="40">
                  <c:v>6077.7060546875</c:v>
                </c:pt>
                <c:pt idx="41">
                  <c:v>6162.4228515625</c:v>
                </c:pt>
                <c:pt idx="42">
                  <c:v>6255.37255859375</c:v>
                </c:pt>
                <c:pt idx="43">
                  <c:v>6315.572265625</c:v>
                </c:pt>
                <c:pt idx="44">
                  <c:v>6321.4345703125</c:v>
                </c:pt>
                <c:pt idx="45">
                  <c:v>6274.8173828125</c:v>
                </c:pt>
                <c:pt idx="46">
                  <c:v>6193.42578125</c:v>
                </c:pt>
                <c:pt idx="47">
                  <c:v>6100.4375</c:v>
                </c:pt>
                <c:pt idx="48">
                  <c:v>6018.068359375</c:v>
                </c:pt>
                <c:pt idx="49">
                  <c:v>5965.33056640625</c:v>
                </c:pt>
                <c:pt idx="50">
                  <c:v>5956.07470703125</c:v>
                </c:pt>
                <c:pt idx="51">
                  <c:v>5994.66845703125</c:v>
                </c:pt>
                <c:pt idx="52">
                  <c:v>6071.27099609375</c:v>
                </c:pt>
                <c:pt idx="53">
                  <c:v>6161.58154296875</c:v>
                </c:pt>
                <c:pt idx="54">
                  <c:v>6234.1298828125</c:v>
                </c:pt>
                <c:pt idx="55">
                  <c:v>6262.919921875</c:v>
                </c:pt>
                <c:pt idx="56">
                  <c:v>6238.86181640625</c:v>
                </c:pt>
                <c:pt idx="57">
                  <c:v>6173.43994140625</c:v>
                </c:pt>
                <c:pt idx="58">
                  <c:v>6092.5537109375</c:v>
                </c:pt>
                <c:pt idx="59">
                  <c:v>6024.20703125</c:v>
                </c:pt>
                <c:pt idx="60">
                  <c:v>5986.8837890625</c:v>
                </c:pt>
                <c:pt idx="61">
                  <c:v>5984.302734375</c:v>
                </c:pt>
                <c:pt idx="62">
                  <c:v>6007.99072265625</c:v>
                </c:pt>
                <c:pt idx="63">
                  <c:v>6044.6845703125</c:v>
                </c:pt>
                <c:pt idx="64">
                  <c:v>6083.4736328125</c:v>
                </c:pt>
                <c:pt idx="65">
                  <c:v>6118.787109375</c:v>
                </c:pt>
                <c:pt idx="66">
                  <c:v>6148.60595703125</c:v>
                </c:pt>
                <c:pt idx="67">
                  <c:v>6170.6142578125</c:v>
                </c:pt>
                <c:pt idx="68">
                  <c:v>6180.22607421875</c:v>
                </c:pt>
                <c:pt idx="69">
                  <c:v>6172.802734375</c:v>
                </c:pt>
                <c:pt idx="70">
                  <c:v>6148.8271484375</c:v>
                </c:pt>
                <c:pt idx="71">
                  <c:v>6117.81982421875</c:v>
                </c:pt>
                <c:pt idx="72">
                  <c:v>6096.70703125</c:v>
                </c:pt>
                <c:pt idx="73">
                  <c:v>6101.85986328125</c:v>
                </c:pt>
                <c:pt idx="74">
                  <c:v>6138.94287109375</c:v>
                </c:pt>
                <c:pt idx="75">
                  <c:v>6197.43701171875</c:v>
                </c:pt>
                <c:pt idx="76">
                  <c:v>6254.5927734375</c:v>
                </c:pt>
                <c:pt idx="77">
                  <c:v>6287.4736328125</c:v>
                </c:pt>
                <c:pt idx="78">
                  <c:v>6285.81591796875</c:v>
                </c:pt>
                <c:pt idx="79">
                  <c:v>6257.2587890625</c:v>
                </c:pt>
                <c:pt idx="80">
                  <c:v>6221.41015625</c:v>
                </c:pt>
                <c:pt idx="81">
                  <c:v>6196.9248046875</c:v>
                </c:pt>
                <c:pt idx="82">
                  <c:v>6190.5625</c:v>
                </c:pt>
                <c:pt idx="83">
                  <c:v>6195.3671875</c:v>
                </c:pt>
                <c:pt idx="84">
                  <c:v>6198.09423828125</c:v>
                </c:pt>
                <c:pt idx="85">
                  <c:v>6189.34130859375</c:v>
                </c:pt>
                <c:pt idx="86">
                  <c:v>6168.6123046875</c:v>
                </c:pt>
                <c:pt idx="87">
                  <c:v>6141.546875</c:v>
                </c:pt>
                <c:pt idx="88">
                  <c:v>6113.244140625</c:v>
                </c:pt>
                <c:pt idx="89">
                  <c:v>6084.42041015625</c:v>
                </c:pt>
                <c:pt idx="90">
                  <c:v>6053.80419921875</c:v>
                </c:pt>
                <c:pt idx="91">
                  <c:v>6023.90380859375</c:v>
                </c:pt>
                <c:pt idx="92">
                  <c:v>6003.736328125</c:v>
                </c:pt>
                <c:pt idx="93">
                  <c:v>6004.55078125</c:v>
                </c:pt>
                <c:pt idx="94">
                  <c:v>6030.96826171875</c:v>
                </c:pt>
                <c:pt idx="95">
                  <c:v>6074.69482421875</c:v>
                </c:pt>
                <c:pt idx="96">
                  <c:v>6116.787109375</c:v>
                </c:pt>
                <c:pt idx="97">
                  <c:v>6138.078125</c:v>
                </c:pt>
                <c:pt idx="98">
                  <c:v>6130.9521484375</c:v>
                </c:pt>
                <c:pt idx="99">
                  <c:v>6104.361328125</c:v>
                </c:pt>
                <c:pt idx="100">
                  <c:v>6078.71630859375</c:v>
                </c:pt>
                <c:pt idx="101">
                  <c:v>6074.20361328125</c:v>
                </c:pt>
                <c:pt idx="102">
                  <c:v>6099.9169921875</c:v>
                </c:pt>
                <c:pt idx="103">
                  <c:v>6149.64208984375</c:v>
                </c:pt>
                <c:pt idx="104">
                  <c:v>6205.267578125</c:v>
                </c:pt>
                <c:pt idx="105">
                  <c:v>6244.71826171875</c:v>
                </c:pt>
                <c:pt idx="106">
                  <c:v>6250.4287109375</c:v>
                </c:pt>
                <c:pt idx="107">
                  <c:v>6215.81298828125</c:v>
                </c:pt>
                <c:pt idx="108">
                  <c:v>6148.52685546875</c:v>
                </c:pt>
                <c:pt idx="109">
                  <c:v>6069.3740234375</c:v>
                </c:pt>
                <c:pt idx="110">
                  <c:v>6005.849609375</c:v>
                </c:pt>
                <c:pt idx="111">
                  <c:v>5981.2666015625</c:v>
                </c:pt>
                <c:pt idx="112">
                  <c:v>6003.89453125</c:v>
                </c:pt>
                <c:pt idx="113">
                  <c:v>6062.4814453125</c:v>
                </c:pt>
                <c:pt idx="114">
                  <c:v>6132.00390625</c:v>
                </c:pt>
                <c:pt idx="115">
                  <c:v>6187.06396484375</c:v>
                </c:pt>
                <c:pt idx="116">
                  <c:v>6214.59326171875</c:v>
                </c:pt>
                <c:pt idx="117">
                  <c:v>6217.548828125</c:v>
                </c:pt>
                <c:pt idx="118">
                  <c:v>6207.9150390625</c:v>
                </c:pt>
                <c:pt idx="119">
                  <c:v>6195.59521484375</c:v>
                </c:pt>
                <c:pt idx="120">
                  <c:v>6182.70361328125</c:v>
                </c:pt>
                <c:pt idx="121">
                  <c:v>6167.51171875</c:v>
                </c:pt>
                <c:pt idx="122">
                  <c:v>6153.10107421875</c:v>
                </c:pt>
                <c:pt idx="123">
                  <c:v>6150.873046875</c:v>
                </c:pt>
                <c:pt idx="124">
                  <c:v>6173.3603515625</c:v>
                </c:pt>
                <c:pt idx="125">
                  <c:v>6221.09423828125</c:v>
                </c:pt>
                <c:pt idx="126">
                  <c:v>6275.4404296875</c:v>
                </c:pt>
                <c:pt idx="127">
                  <c:v>6306.13916015625</c:v>
                </c:pt>
                <c:pt idx="128">
                  <c:v>6290.40576171875</c:v>
                </c:pt>
                <c:pt idx="129">
                  <c:v>6229.619140625</c:v>
                </c:pt>
                <c:pt idx="130">
                  <c:v>6149.8076171875</c:v>
                </c:pt>
                <c:pt idx="131">
                  <c:v>6084.32666015625</c:v>
                </c:pt>
                <c:pt idx="132">
                  <c:v>6051.72607421875</c:v>
                </c:pt>
                <c:pt idx="133">
                  <c:v>6046.2939453125</c:v>
                </c:pt>
                <c:pt idx="134">
                  <c:v>6048.5556640625</c:v>
                </c:pt>
                <c:pt idx="135">
                  <c:v>6046.0888671875</c:v>
                </c:pt>
                <c:pt idx="136">
                  <c:v>6045.82470703125</c:v>
                </c:pt>
                <c:pt idx="137">
                  <c:v>6066.0634765625</c:v>
                </c:pt>
                <c:pt idx="138">
                  <c:v>6114.478515625</c:v>
                </c:pt>
                <c:pt idx="139">
                  <c:v>6172.115234375</c:v>
                </c:pt>
                <c:pt idx="140">
                  <c:v>6200.21142578125</c:v>
                </c:pt>
                <c:pt idx="141">
                  <c:v>6168.0029296875</c:v>
                </c:pt>
                <c:pt idx="142">
                  <c:v>6080.6025390625</c:v>
                </c:pt>
                <c:pt idx="143">
                  <c:v>5983.12109375</c:v>
                </c:pt>
                <c:pt idx="144">
                  <c:v>5934.2333984375</c:v>
                </c:pt>
                <c:pt idx="145">
                  <c:v>5966.587890625</c:v>
                </c:pt>
                <c:pt idx="146">
                  <c:v>6063.16845703125</c:v>
                </c:pt>
                <c:pt idx="147">
                  <c:v>6167.814453125</c:v>
                </c:pt>
                <c:pt idx="148">
                  <c:v>6222.64697265625</c:v>
                </c:pt>
                <c:pt idx="149">
                  <c:v>6205.087890625</c:v>
                </c:pt>
                <c:pt idx="150">
                  <c:v>6138.35205078125</c:v>
                </c:pt>
                <c:pt idx="151">
                  <c:v>6070.33203125</c:v>
                </c:pt>
                <c:pt idx="152">
                  <c:v>6039.48095703125</c:v>
                </c:pt>
                <c:pt idx="153">
                  <c:v>6053.88818359375</c:v>
                </c:pt>
                <c:pt idx="154">
                  <c:v>6096.23486328125</c:v>
                </c:pt>
                <c:pt idx="155">
                  <c:v>6145.23681640625</c:v>
                </c:pt>
                <c:pt idx="156">
                  <c:v>6192.294921875</c:v>
                </c:pt>
                <c:pt idx="157">
                  <c:v>6239.59326171875</c:v>
                </c:pt>
                <c:pt idx="158">
                  <c:v>6284.9111328125</c:v>
                </c:pt>
                <c:pt idx="159">
                  <c:v>6311.37841796875</c:v>
                </c:pt>
                <c:pt idx="160">
                  <c:v>6295.66650390625</c:v>
                </c:pt>
                <c:pt idx="161">
                  <c:v>6230.01171875</c:v>
                </c:pt>
                <c:pt idx="162">
                  <c:v>6138.4580078125</c:v>
                </c:pt>
                <c:pt idx="163">
                  <c:v>6069.82568359375</c:v>
                </c:pt>
                <c:pt idx="164">
                  <c:v>6068.3291015625</c:v>
                </c:pt>
                <c:pt idx="165">
                  <c:v>6142.15185546875</c:v>
                </c:pt>
                <c:pt idx="166">
                  <c:v>6254.05224609375</c:v>
                </c:pt>
                <c:pt idx="167">
                  <c:v>6342.35791015625</c:v>
                </c:pt>
                <c:pt idx="168">
                  <c:v>6358.00146484375</c:v>
                </c:pt>
                <c:pt idx="169">
                  <c:v>6291.74755859375</c:v>
                </c:pt>
                <c:pt idx="170">
                  <c:v>6174.3046875</c:v>
                </c:pt>
                <c:pt idx="171">
                  <c:v>6052.8818359375</c:v>
                </c:pt>
                <c:pt idx="172">
                  <c:v>5963.80517578125</c:v>
                </c:pt>
                <c:pt idx="173">
                  <c:v>5919.9248046875</c:v>
                </c:pt>
                <c:pt idx="174">
                  <c:v>5916.47900390625</c:v>
                </c:pt>
                <c:pt idx="175">
                  <c:v>5943.96728515625</c:v>
                </c:pt>
                <c:pt idx="176">
                  <c:v>5994.22216796875</c:v>
                </c:pt>
                <c:pt idx="177">
                  <c:v>6056.521484375</c:v>
                </c:pt>
                <c:pt idx="178">
                  <c:v>6112.7880859375</c:v>
                </c:pt>
                <c:pt idx="179">
                  <c:v>6142.41162109375</c:v>
                </c:pt>
                <c:pt idx="180">
                  <c:v>6136.537109375</c:v>
                </c:pt>
                <c:pt idx="181">
                  <c:v>6109.40234375</c:v>
                </c:pt>
                <c:pt idx="182">
                  <c:v>6093.25439453125</c:v>
                </c:pt>
                <c:pt idx="183">
                  <c:v>6116.28125</c:v>
                </c:pt>
                <c:pt idx="184">
                  <c:v>6179.1337890625</c:v>
                </c:pt>
                <c:pt idx="185">
                  <c:v>6250.04736328125</c:v>
                </c:pt>
                <c:pt idx="186">
                  <c:v>6285.56298828125</c:v>
                </c:pt>
                <c:pt idx="187">
                  <c:v>6262.9853515625</c:v>
                </c:pt>
                <c:pt idx="188">
                  <c:v>6199.45166015625</c:v>
                </c:pt>
                <c:pt idx="189">
                  <c:v>6141.337890625</c:v>
                </c:pt>
                <c:pt idx="190">
                  <c:v>6130.6689453125</c:v>
                </c:pt>
                <c:pt idx="191">
                  <c:v>6173.82568359375</c:v>
                </c:pt>
                <c:pt idx="192">
                  <c:v>6236.728515625</c:v>
                </c:pt>
                <c:pt idx="193">
                  <c:v>6270.119140625</c:v>
                </c:pt>
                <c:pt idx="194">
                  <c:v>6245.1123046875</c:v>
                </c:pt>
                <c:pt idx="195">
                  <c:v>6171.72119140625</c:v>
                </c:pt>
                <c:pt idx="196">
                  <c:v>6087.5048828125</c:v>
                </c:pt>
                <c:pt idx="197">
                  <c:v>6027.61669921875</c:v>
                </c:pt>
                <c:pt idx="198">
                  <c:v>6001.447265625</c:v>
                </c:pt>
                <c:pt idx="199">
                  <c:v>5993.697265625</c:v>
                </c:pt>
                <c:pt idx="200">
                  <c:v>5986.01611328125</c:v>
                </c:pt>
                <c:pt idx="201">
                  <c:v>5978.03564453125</c:v>
                </c:pt>
                <c:pt idx="202">
                  <c:v>5988.31689453125</c:v>
                </c:pt>
                <c:pt idx="203">
                  <c:v>6034.49560546875</c:v>
                </c:pt>
                <c:pt idx="204">
                  <c:v>6111.12109375</c:v>
                </c:pt>
                <c:pt idx="205">
                  <c:v>6186.529296875</c:v>
                </c:pt>
                <c:pt idx="206">
                  <c:v>6223.79150390625</c:v>
                </c:pt>
                <c:pt idx="207">
                  <c:v>6209.40869140625</c:v>
                </c:pt>
                <c:pt idx="208">
                  <c:v>6165.48046875</c:v>
                </c:pt>
                <c:pt idx="209">
                  <c:v>6133.912109375</c:v>
                </c:pt>
                <c:pt idx="210">
                  <c:v>6144.37744140625</c:v>
                </c:pt>
                <c:pt idx="211">
                  <c:v>6191.67333984375</c:v>
                </c:pt>
                <c:pt idx="212">
                  <c:v>6240.8095703125</c:v>
                </c:pt>
                <c:pt idx="213">
                  <c:v>6255.49267578125</c:v>
                </c:pt>
                <c:pt idx="214">
                  <c:v>6226.46728515625</c:v>
                </c:pt>
                <c:pt idx="215">
                  <c:v>6176.65673828125</c:v>
                </c:pt>
                <c:pt idx="216">
                  <c:v>6139.8203125</c:v>
                </c:pt>
                <c:pt idx="217">
                  <c:v>6131.79638671875</c:v>
                </c:pt>
                <c:pt idx="218">
                  <c:v>6139.4140625</c:v>
                </c:pt>
                <c:pt idx="219">
                  <c:v>6136.51708984375</c:v>
                </c:pt>
                <c:pt idx="220">
                  <c:v>6112.5576171875</c:v>
                </c:pt>
                <c:pt idx="221">
                  <c:v>6087.42578125</c:v>
                </c:pt>
                <c:pt idx="222">
                  <c:v>6097.25537109375</c:v>
                </c:pt>
                <c:pt idx="223">
                  <c:v>6161.07373046875</c:v>
                </c:pt>
                <c:pt idx="224">
                  <c:v>6256.29443359375</c:v>
                </c:pt>
                <c:pt idx="225">
                  <c:v>6326.11669921875</c:v>
                </c:pt>
                <c:pt idx="226">
                  <c:v>6316.91455078125</c:v>
                </c:pt>
                <c:pt idx="227">
                  <c:v>6218.5068359375</c:v>
                </c:pt>
                <c:pt idx="228">
                  <c:v>6075.79638671875</c:v>
                </c:pt>
                <c:pt idx="229">
                  <c:v>5961.11328125</c:v>
                </c:pt>
                <c:pt idx="230">
                  <c:v>5926.70068359375</c:v>
                </c:pt>
                <c:pt idx="231">
                  <c:v>5972.26171875</c:v>
                </c:pt>
                <c:pt idx="232">
                  <c:v>6050.84130859375</c:v>
                </c:pt>
                <c:pt idx="233">
                  <c:v>6106.76318359375</c:v>
                </c:pt>
                <c:pt idx="234">
                  <c:v>6115.33447265625</c:v>
                </c:pt>
                <c:pt idx="235">
                  <c:v>6094.42431640625</c:v>
                </c:pt>
                <c:pt idx="236">
                  <c:v>6081.8017578125</c:v>
                </c:pt>
                <c:pt idx="237">
                  <c:v>6099.619140625</c:v>
                </c:pt>
                <c:pt idx="238">
                  <c:v>6136.31298828125</c:v>
                </c:pt>
                <c:pt idx="239">
                  <c:v>6159.94873046875</c:v>
                </c:pt>
                <c:pt idx="240">
                  <c:v>6149.80419921875</c:v>
                </c:pt>
                <c:pt idx="241">
                  <c:v>6117.71142578125</c:v>
                </c:pt>
                <c:pt idx="242">
                  <c:v>6099.9169921875</c:v>
                </c:pt>
                <c:pt idx="243">
                  <c:v>6125.89404296875</c:v>
                </c:pt>
                <c:pt idx="244">
                  <c:v>6190.7412109375</c:v>
                </c:pt>
                <c:pt idx="245">
                  <c:v>6255.37890625</c:v>
                </c:pt>
                <c:pt idx="246">
                  <c:v>6275.62158203125</c:v>
                </c:pt>
                <c:pt idx="247">
                  <c:v>6236.7451171875</c:v>
                </c:pt>
                <c:pt idx="248">
                  <c:v>6165.10400390625</c:v>
                </c:pt>
                <c:pt idx="249">
                  <c:v>6107.07666015625</c:v>
                </c:pt>
                <c:pt idx="250">
                  <c:v>6092.6015625</c:v>
                </c:pt>
                <c:pt idx="251">
                  <c:v>6113.244140625</c:v>
                </c:pt>
                <c:pt idx="252">
                  <c:v>6132.451171875</c:v>
                </c:pt>
                <c:pt idx="253">
                  <c:v>6118.69921875</c:v>
                </c:pt>
                <c:pt idx="254">
                  <c:v>6073.33740234375</c:v>
                </c:pt>
                <c:pt idx="255">
                  <c:v>6029.806640625</c:v>
                </c:pt>
                <c:pt idx="256">
                  <c:v>6025.43310546875</c:v>
                </c:pt>
                <c:pt idx="257">
                  <c:v>6070.1357421875</c:v>
                </c:pt>
                <c:pt idx="258">
                  <c:v>6138.5888671875</c:v>
                </c:pt>
                <c:pt idx="259">
                  <c:v>6191.849609375</c:v>
                </c:pt>
                <c:pt idx="260">
                  <c:v>6209.0361328125</c:v>
                </c:pt>
                <c:pt idx="261">
                  <c:v>6201.3359375</c:v>
                </c:pt>
                <c:pt idx="262">
                  <c:v>6196.705078125</c:v>
                </c:pt>
                <c:pt idx="263">
                  <c:v>6210.01904296875</c:v>
                </c:pt>
                <c:pt idx="264">
                  <c:v>6226.78955078125</c:v>
                </c:pt>
                <c:pt idx="265">
                  <c:v>6216.609375</c:v>
                </c:pt>
                <c:pt idx="266">
                  <c:v>6165.1650390625</c:v>
                </c:pt>
                <c:pt idx="267">
                  <c:v>6095.15185546875</c:v>
                </c:pt>
                <c:pt idx="268">
                  <c:v>6054.11474609375</c:v>
                </c:pt>
                <c:pt idx="269">
                  <c:v>6075.96630859375</c:v>
                </c:pt>
                <c:pt idx="270">
                  <c:v>6148.17529296875</c:v>
                </c:pt>
                <c:pt idx="271">
                  <c:v>6215.3271484375</c:v>
                </c:pt>
                <c:pt idx="272">
                  <c:v>6220.7353515625</c:v>
                </c:pt>
                <c:pt idx="273">
                  <c:v>6154.30517578125</c:v>
                </c:pt>
                <c:pt idx="274">
                  <c:v>6066.02734375</c:v>
                </c:pt>
                <c:pt idx="275">
                  <c:v>6030.0341796875</c:v>
                </c:pt>
                <c:pt idx="276">
                  <c:v>6084.90869140625</c:v>
                </c:pt>
                <c:pt idx="277">
                  <c:v>6198.15283203125</c:v>
                </c:pt>
                <c:pt idx="278">
                  <c:v>6286.2197265625</c:v>
                </c:pt>
                <c:pt idx="279">
                  <c:v>6277.5498046875</c:v>
                </c:pt>
                <c:pt idx="280">
                  <c:v>6169.82373046875</c:v>
                </c:pt>
                <c:pt idx="281">
                  <c:v>6034.70263671875</c:v>
                </c:pt>
                <c:pt idx="282">
                  <c:v>5963.98193359375</c:v>
                </c:pt>
                <c:pt idx="283">
                  <c:v>5998.51416015625</c:v>
                </c:pt>
                <c:pt idx="284">
                  <c:v>6096.68994140625</c:v>
                </c:pt>
                <c:pt idx="285">
                  <c:v>6168.82958984375</c:v>
                </c:pt>
                <c:pt idx="286">
                  <c:v>6150.9501953125</c:v>
                </c:pt>
                <c:pt idx="287">
                  <c:v>6058.583984375</c:v>
                </c:pt>
                <c:pt idx="288">
                  <c:v>5976.0849609375</c:v>
                </c:pt>
                <c:pt idx="289">
                  <c:v>5988.291015625</c:v>
                </c:pt>
                <c:pt idx="290">
                  <c:v>6108.60595703125</c:v>
                </c:pt>
                <c:pt idx="291">
                  <c:v>6262.02392578125</c:v>
                </c:pt>
                <c:pt idx="292">
                  <c:v>6338.8779296875</c:v>
                </c:pt>
                <c:pt idx="293">
                  <c:v>6278.75390625</c:v>
                </c:pt>
                <c:pt idx="294">
                  <c:v>6119.130859375</c:v>
                </c:pt>
                <c:pt idx="295">
                  <c:v>5970.0751953125</c:v>
                </c:pt>
                <c:pt idx="296">
                  <c:v>5933.7822265625</c:v>
                </c:pt>
                <c:pt idx="297">
                  <c:v>6030.51220703125</c:v>
                </c:pt>
                <c:pt idx="298">
                  <c:v>6186.94580078125</c:v>
                </c:pt>
                <c:pt idx="299">
                  <c:v>6294.0810546875</c:v>
                </c:pt>
                <c:pt idx="300">
                  <c:v>6288.533203125</c:v>
                </c:pt>
                <c:pt idx="301">
                  <c:v>6194.9677734375</c:v>
                </c:pt>
                <c:pt idx="302">
                  <c:v>6099.81298828125</c:v>
                </c:pt>
                <c:pt idx="303">
                  <c:v>6080.35107421875</c:v>
                </c:pt>
                <c:pt idx="304">
                  <c:v>6146.07177734375</c:v>
                </c:pt>
                <c:pt idx="305">
                  <c:v>6236.361328125</c:v>
                </c:pt>
                <c:pt idx="306">
                  <c:v>6272.57421875</c:v>
                </c:pt>
                <c:pt idx="307">
                  <c:v>6220.84326171875</c:v>
                </c:pt>
                <c:pt idx="308">
                  <c:v>6116.64208984375</c:v>
                </c:pt>
                <c:pt idx="309">
                  <c:v>6034.88232421875</c:v>
                </c:pt>
                <c:pt idx="310">
                  <c:v>6032.158203125</c:v>
                </c:pt>
                <c:pt idx="311">
                  <c:v>6106.80078125</c:v>
                </c:pt>
                <c:pt idx="312">
                  <c:v>6204.947265625</c:v>
                </c:pt>
                <c:pt idx="313">
                  <c:v>6263.490234375</c:v>
                </c:pt>
                <c:pt idx="314">
                  <c:v>6254.1943359375</c:v>
                </c:pt>
                <c:pt idx="315">
                  <c:v>6196.72265625</c:v>
                </c:pt>
                <c:pt idx="316">
                  <c:v>6135.82666015625</c:v>
                </c:pt>
                <c:pt idx="317">
                  <c:v>6105.37744140625</c:v>
                </c:pt>
                <c:pt idx="318">
                  <c:v>6108.09814453125</c:v>
                </c:pt>
                <c:pt idx="319">
                  <c:v>6122.87060546875</c:v>
                </c:pt>
                <c:pt idx="320">
                  <c:v>6128.0078125</c:v>
                </c:pt>
                <c:pt idx="321">
                  <c:v>6118.564453125</c:v>
                </c:pt>
                <c:pt idx="322">
                  <c:v>6104.8876953125</c:v>
                </c:pt>
                <c:pt idx="323">
                  <c:v>6097.76025390625</c:v>
                </c:pt>
                <c:pt idx="324">
                  <c:v>6096.20849609375</c:v>
                </c:pt>
                <c:pt idx="325">
                  <c:v>6089.22265625</c:v>
                </c:pt>
                <c:pt idx="326">
                  <c:v>6068.544921875</c:v>
                </c:pt>
                <c:pt idx="327">
                  <c:v>6039.6064453125</c:v>
                </c:pt>
                <c:pt idx="328">
                  <c:v>6020.177734375</c:v>
                </c:pt>
                <c:pt idx="329">
                  <c:v>6027.8046875</c:v>
                </c:pt>
                <c:pt idx="330">
                  <c:v>6066.841796875</c:v>
                </c:pt>
                <c:pt idx="331">
                  <c:v>6125.4912109375</c:v>
                </c:pt>
                <c:pt idx="332">
                  <c:v>6184.11474609375</c:v>
                </c:pt>
                <c:pt idx="333">
                  <c:v>6226.96923828125</c:v>
                </c:pt>
                <c:pt idx="334">
                  <c:v>6248.17919921875</c:v>
                </c:pt>
                <c:pt idx="335">
                  <c:v>6249.29345703125</c:v>
                </c:pt>
                <c:pt idx="336">
                  <c:v>6233.3251953125</c:v>
                </c:pt>
                <c:pt idx="337">
                  <c:v>6201.9453125</c:v>
                </c:pt>
                <c:pt idx="338">
                  <c:v>6157.77490234375</c:v>
                </c:pt>
                <c:pt idx="339">
                  <c:v>6107.91259765625</c:v>
                </c:pt>
                <c:pt idx="340">
                  <c:v>6063.6904296875</c:v>
                </c:pt>
                <c:pt idx="341">
                  <c:v>6035.912109375</c:v>
                </c:pt>
                <c:pt idx="342">
                  <c:v>6029.69287109375</c:v>
                </c:pt>
                <c:pt idx="343">
                  <c:v>6043.5126953125</c:v>
                </c:pt>
                <c:pt idx="344">
                  <c:v>6072.73388671875</c:v>
                </c:pt>
                <c:pt idx="345">
                  <c:v>6113.3037109375</c:v>
                </c:pt>
                <c:pt idx="346">
                  <c:v>6161.43603515625</c:v>
                </c:pt>
                <c:pt idx="347">
                  <c:v>6209.85888671875</c:v>
                </c:pt>
                <c:pt idx="348">
                  <c:v>6245.86181640625</c:v>
                </c:pt>
                <c:pt idx="349">
                  <c:v>6255.69775390625</c:v>
                </c:pt>
              </c:numCache>
            </c:numRef>
          </c:yVal>
          <c:smooth val="1"/>
          <c:extLst>
            <c:ext xmlns:c16="http://schemas.microsoft.com/office/drawing/2014/chart" uri="{C3380CC4-5D6E-409C-BE32-E72D297353CC}">
              <c16:uniqueId val="{00000012-5429-4359-BD11-807CF8F8408D}"/>
            </c:ext>
          </c:extLst>
        </c:ser>
        <c:ser>
          <c:idx val="19"/>
          <c:order val="19"/>
          <c:tx>
            <c:strRef>
              <c:f>np_sub_003!$T$1</c:f>
              <c:strCache>
                <c:ptCount val="1"/>
                <c:pt idx="0">
                  <c:v>Coor_20</c:v>
                </c:pt>
              </c:strCache>
            </c:strRef>
          </c:tx>
          <c:spPr>
            <a:ln w="28575" cap="rnd">
              <a:solidFill>
                <a:schemeClr val="accent2">
                  <a:lumMod val="80000"/>
                </a:schemeClr>
              </a:solidFill>
              <a:round/>
            </a:ln>
            <a:effectLst/>
          </c:spPr>
          <c:marker>
            <c:symbol val="none"/>
          </c:marker>
          <c:yVal>
            <c:numRef>
              <c:f>np_sub_003!$T$2:$T$351</c:f>
              <c:numCache>
                <c:formatCode>0.00000000000_ </c:formatCode>
                <c:ptCount val="350"/>
                <c:pt idx="0">
                  <c:v>6212.66943359375</c:v>
                </c:pt>
                <c:pt idx="1">
                  <c:v>6184.26611328125</c:v>
                </c:pt>
                <c:pt idx="2">
                  <c:v>6198.5693359375</c:v>
                </c:pt>
                <c:pt idx="3">
                  <c:v>6247.64111328125</c:v>
                </c:pt>
                <c:pt idx="4">
                  <c:v>6301.92626953125</c:v>
                </c:pt>
                <c:pt idx="5">
                  <c:v>6331.89306640625</c:v>
                </c:pt>
                <c:pt idx="6">
                  <c:v>6328.33251953125</c:v>
                </c:pt>
                <c:pt idx="7">
                  <c:v>6306.42138671875</c:v>
                </c:pt>
                <c:pt idx="8">
                  <c:v>6291.71484375</c:v>
                </c:pt>
                <c:pt idx="9">
                  <c:v>6299.86669921875</c:v>
                </c:pt>
                <c:pt idx="10">
                  <c:v>6325.568359375</c:v>
                </c:pt>
                <c:pt idx="11">
                  <c:v>6348.07275390625</c:v>
                </c:pt>
                <c:pt idx="12">
                  <c:v>6347.86669921875</c:v>
                </c:pt>
                <c:pt idx="13">
                  <c:v>6321.5380859375</c:v>
                </c:pt>
                <c:pt idx="14">
                  <c:v>6284.474609375</c:v>
                </c:pt>
                <c:pt idx="15">
                  <c:v>6260.4990234375</c:v>
                </c:pt>
                <c:pt idx="16">
                  <c:v>6266.31982421875</c:v>
                </c:pt>
                <c:pt idx="17">
                  <c:v>6300.974609375</c:v>
                </c:pt>
                <c:pt idx="18">
                  <c:v>6346.125</c:v>
                </c:pt>
                <c:pt idx="19">
                  <c:v>6376.2177734375</c:v>
                </c:pt>
                <c:pt idx="20">
                  <c:v>6372.5537109375</c:v>
                </c:pt>
                <c:pt idx="21">
                  <c:v>6334.0615234375</c:v>
                </c:pt>
                <c:pt idx="22">
                  <c:v>6279.40869140625</c:v>
                </c:pt>
                <c:pt idx="23">
                  <c:v>6238.7373046875</c:v>
                </c:pt>
                <c:pt idx="24">
                  <c:v>6237.98828125</c:v>
                </c:pt>
                <c:pt idx="25">
                  <c:v>6283.1796875</c:v>
                </c:pt>
                <c:pt idx="26">
                  <c:v>6353.8193359375</c:v>
                </c:pt>
                <c:pt idx="27">
                  <c:v>6411.3330078125</c:v>
                </c:pt>
                <c:pt idx="28">
                  <c:v>6420.09423828125</c:v>
                </c:pt>
                <c:pt idx="29">
                  <c:v>6369.6982421875</c:v>
                </c:pt>
                <c:pt idx="30">
                  <c:v>6284.0595703125</c:v>
                </c:pt>
                <c:pt idx="31">
                  <c:v>6209.5888671875</c:v>
                </c:pt>
                <c:pt idx="32">
                  <c:v>6188.029296875</c:v>
                </c:pt>
                <c:pt idx="33">
                  <c:v>6230.64208984375</c:v>
                </c:pt>
                <c:pt idx="34">
                  <c:v>6310.79833984375</c:v>
                </c:pt>
                <c:pt idx="35">
                  <c:v>6380.32373046875</c:v>
                </c:pt>
                <c:pt idx="36">
                  <c:v>6398.9580078125</c:v>
                </c:pt>
                <c:pt idx="37">
                  <c:v>6357.52978515625</c:v>
                </c:pt>
                <c:pt idx="38">
                  <c:v>6280.29638671875</c:v>
                </c:pt>
                <c:pt idx="39">
                  <c:v>6206.7529296875</c:v>
                </c:pt>
                <c:pt idx="40">
                  <c:v>6166.95263671875</c:v>
                </c:pt>
                <c:pt idx="41">
                  <c:v>6167.11962890625</c:v>
                </c:pt>
                <c:pt idx="42">
                  <c:v>6192.99658203125</c:v>
                </c:pt>
                <c:pt idx="43">
                  <c:v>6224.9033203125</c:v>
                </c:pt>
                <c:pt idx="44">
                  <c:v>6251.40234375</c:v>
                </c:pt>
                <c:pt idx="45">
                  <c:v>6272.25341796875</c:v>
                </c:pt>
                <c:pt idx="46">
                  <c:v>6291.55126953125</c:v>
                </c:pt>
                <c:pt idx="47">
                  <c:v>6309.62646484375</c:v>
                </c:pt>
                <c:pt idx="48">
                  <c:v>6321.53857421875</c:v>
                </c:pt>
                <c:pt idx="49">
                  <c:v>6322.68212890625</c:v>
                </c:pt>
                <c:pt idx="50">
                  <c:v>6315.19482421875</c:v>
                </c:pt>
                <c:pt idx="51">
                  <c:v>6308.49462890625</c:v>
                </c:pt>
                <c:pt idx="52">
                  <c:v>6312.99267578125</c:v>
                </c:pt>
                <c:pt idx="53">
                  <c:v>6332.27685546875</c:v>
                </c:pt>
                <c:pt idx="54">
                  <c:v>6360.1826171875</c:v>
                </c:pt>
                <c:pt idx="55">
                  <c:v>6384.6455078125</c:v>
                </c:pt>
                <c:pt idx="56">
                  <c:v>6394.6044921875</c:v>
                </c:pt>
                <c:pt idx="57">
                  <c:v>6384.5869140625</c:v>
                </c:pt>
                <c:pt idx="58">
                  <c:v>6354.93994140625</c:v>
                </c:pt>
                <c:pt idx="59">
                  <c:v>6310.123046875</c:v>
                </c:pt>
                <c:pt idx="60">
                  <c:v>6258.42724609375</c:v>
                </c:pt>
                <c:pt idx="61">
                  <c:v>6213.12451171875</c:v>
                </c:pt>
                <c:pt idx="62">
                  <c:v>6191.25927734375</c:v>
                </c:pt>
                <c:pt idx="63">
                  <c:v>6206.77880859375</c:v>
                </c:pt>
                <c:pt idx="64">
                  <c:v>6260.11474609375</c:v>
                </c:pt>
                <c:pt idx="65">
                  <c:v>6331.953125</c:v>
                </c:pt>
                <c:pt idx="66">
                  <c:v>6388.7861328125</c:v>
                </c:pt>
                <c:pt idx="67">
                  <c:v>6400.23779296875</c:v>
                </c:pt>
                <c:pt idx="68">
                  <c:v>6358.3232421875</c:v>
                </c:pt>
                <c:pt idx="69">
                  <c:v>6284.96533203125</c:v>
                </c:pt>
                <c:pt idx="70">
                  <c:v>6220.62548828125</c:v>
                </c:pt>
                <c:pt idx="71">
                  <c:v>6200.00439453125</c:v>
                </c:pt>
                <c:pt idx="72">
                  <c:v>6230.72216796875</c:v>
                </c:pt>
                <c:pt idx="73">
                  <c:v>6289.6669921875</c:v>
                </c:pt>
                <c:pt idx="74">
                  <c:v>6339.48583984375</c:v>
                </c:pt>
                <c:pt idx="75">
                  <c:v>6353.42578125</c:v>
                </c:pt>
                <c:pt idx="76">
                  <c:v>6331.05615234375</c:v>
                </c:pt>
                <c:pt idx="77">
                  <c:v>6294.6982421875</c:v>
                </c:pt>
                <c:pt idx="78">
                  <c:v>6270.88818359375</c:v>
                </c:pt>
                <c:pt idx="79">
                  <c:v>6271.80615234375</c:v>
                </c:pt>
                <c:pt idx="80">
                  <c:v>6290.29296875</c:v>
                </c:pt>
                <c:pt idx="81">
                  <c:v>6310.3662109375</c:v>
                </c:pt>
                <c:pt idx="82">
                  <c:v>6322.65380859375</c:v>
                </c:pt>
                <c:pt idx="83">
                  <c:v>6330.92041015625</c:v>
                </c:pt>
                <c:pt idx="84">
                  <c:v>6344.30517578125</c:v>
                </c:pt>
                <c:pt idx="85">
                  <c:v>6362.89013671875</c:v>
                </c:pt>
                <c:pt idx="86">
                  <c:v>6370.87255859375</c:v>
                </c:pt>
                <c:pt idx="87">
                  <c:v>6345.962890625</c:v>
                </c:pt>
                <c:pt idx="88">
                  <c:v>6279.73095703125</c:v>
                </c:pt>
                <c:pt idx="89">
                  <c:v>6192.66796875</c:v>
                </c:pt>
                <c:pt idx="90">
                  <c:v>6129.19873046875</c:v>
                </c:pt>
                <c:pt idx="91">
                  <c:v>6131.95458984375</c:v>
                </c:pt>
                <c:pt idx="92">
                  <c:v>6211.27734375</c:v>
                </c:pt>
                <c:pt idx="93">
                  <c:v>6332.18701171875</c:v>
                </c:pt>
                <c:pt idx="94">
                  <c:v>6430.9638671875</c:v>
                </c:pt>
                <c:pt idx="95">
                  <c:v>6453.1240234375</c:v>
                </c:pt>
                <c:pt idx="96">
                  <c:v>6388.34619140625</c:v>
                </c:pt>
                <c:pt idx="97">
                  <c:v>6278.1689453125</c:v>
                </c:pt>
                <c:pt idx="98">
                  <c:v>6189.9345703125</c:v>
                </c:pt>
                <c:pt idx="99">
                  <c:v>6173.66650390625</c:v>
                </c:pt>
                <c:pt idx="100">
                  <c:v>6230.80712890625</c:v>
                </c:pt>
                <c:pt idx="101">
                  <c:v>6315.8828125</c:v>
                </c:pt>
                <c:pt idx="102">
                  <c:v>6369.2998046875</c:v>
                </c:pt>
                <c:pt idx="103">
                  <c:v>6357.873046875</c:v>
                </c:pt>
                <c:pt idx="104">
                  <c:v>6294.83740234375</c:v>
                </c:pt>
                <c:pt idx="105">
                  <c:v>6226.5078125</c:v>
                </c:pt>
                <c:pt idx="106">
                  <c:v>6197.03759765625</c:v>
                </c:pt>
                <c:pt idx="107">
                  <c:v>6217.98583984375</c:v>
                </c:pt>
                <c:pt idx="108">
                  <c:v>6264.5078125</c:v>
                </c:pt>
                <c:pt idx="109">
                  <c:v>6299.05126953125</c:v>
                </c:pt>
                <c:pt idx="110">
                  <c:v>6302.58740234375</c:v>
                </c:pt>
                <c:pt idx="111">
                  <c:v>6288.5107421875</c:v>
                </c:pt>
                <c:pt idx="112">
                  <c:v>6288.8798828125</c:v>
                </c:pt>
                <c:pt idx="113">
                  <c:v>6324.95166015625</c:v>
                </c:pt>
                <c:pt idx="114">
                  <c:v>6386.4521484375</c:v>
                </c:pt>
                <c:pt idx="115">
                  <c:v>6436.92529296875</c:v>
                </c:pt>
                <c:pt idx="116">
                  <c:v>6441.53369140625</c:v>
                </c:pt>
                <c:pt idx="117">
                  <c:v>6395.48046875</c:v>
                </c:pt>
                <c:pt idx="118">
                  <c:v>6330.22412109375</c:v>
                </c:pt>
                <c:pt idx="119">
                  <c:v>6291.7060546875</c:v>
                </c:pt>
                <c:pt idx="120">
                  <c:v>6306.5517578125</c:v>
                </c:pt>
                <c:pt idx="121">
                  <c:v>6361.6875</c:v>
                </c:pt>
                <c:pt idx="122">
                  <c:v>6412.80126953125</c:v>
                </c:pt>
                <c:pt idx="123">
                  <c:v>6415.4609375</c:v>
                </c:pt>
                <c:pt idx="124">
                  <c:v>6356.1826171875</c:v>
                </c:pt>
                <c:pt idx="125">
                  <c:v>6261.466796875</c:v>
                </c:pt>
                <c:pt idx="126">
                  <c:v>6179.5048828125</c:v>
                </c:pt>
                <c:pt idx="127">
                  <c:v>6148.69140625</c:v>
                </c:pt>
                <c:pt idx="128">
                  <c:v>6174.9765625</c:v>
                </c:pt>
                <c:pt idx="129">
                  <c:v>6231.8935546875</c:v>
                </c:pt>
                <c:pt idx="130">
                  <c:v>6280.3486328125</c:v>
                </c:pt>
                <c:pt idx="131">
                  <c:v>6292.91796875</c:v>
                </c:pt>
                <c:pt idx="132">
                  <c:v>6267.19873046875</c:v>
                </c:pt>
                <c:pt idx="133">
                  <c:v>6222.66748046875</c:v>
                </c:pt>
                <c:pt idx="134">
                  <c:v>6186.60498046875</c:v>
                </c:pt>
                <c:pt idx="135">
                  <c:v>6179.29931640625</c:v>
                </c:pt>
                <c:pt idx="136">
                  <c:v>6205.87451171875</c:v>
                </c:pt>
                <c:pt idx="137">
                  <c:v>6256.2919921875</c:v>
                </c:pt>
                <c:pt idx="138">
                  <c:v>6311.2275390625</c:v>
                </c:pt>
                <c:pt idx="139">
                  <c:v>6350.81640625</c:v>
                </c:pt>
                <c:pt idx="140">
                  <c:v>6363.48876953125</c:v>
                </c:pt>
                <c:pt idx="141">
                  <c:v>6351.5634765625</c:v>
                </c:pt>
                <c:pt idx="142">
                  <c:v>6330.0283203125</c:v>
                </c:pt>
                <c:pt idx="143">
                  <c:v>6317.4755859375</c:v>
                </c:pt>
                <c:pt idx="144">
                  <c:v>6323.53466796875</c:v>
                </c:pt>
                <c:pt idx="145">
                  <c:v>6341.34765625</c:v>
                </c:pt>
                <c:pt idx="146">
                  <c:v>6351.89697265625</c:v>
                </c:pt>
                <c:pt idx="147">
                  <c:v>6338.7099609375</c:v>
                </c:pt>
                <c:pt idx="148">
                  <c:v>6302.44287109375</c:v>
                </c:pt>
                <c:pt idx="149">
                  <c:v>6263.10791015625</c:v>
                </c:pt>
                <c:pt idx="150">
                  <c:v>6246.34326171875</c:v>
                </c:pt>
                <c:pt idx="151">
                  <c:v>6263.2451171875</c:v>
                </c:pt>
                <c:pt idx="152">
                  <c:v>6300.013671875</c:v>
                </c:pt>
                <c:pt idx="153">
                  <c:v>6327.23681640625</c:v>
                </c:pt>
                <c:pt idx="154">
                  <c:v>6323.00341796875</c:v>
                </c:pt>
                <c:pt idx="155">
                  <c:v>6291.73681640625</c:v>
                </c:pt>
                <c:pt idx="156">
                  <c:v>6262.6025390625</c:v>
                </c:pt>
                <c:pt idx="157">
                  <c:v>6267.11279296875</c:v>
                </c:pt>
                <c:pt idx="158">
                  <c:v>6312.869140625</c:v>
                </c:pt>
                <c:pt idx="159">
                  <c:v>6374.67578125</c:v>
                </c:pt>
                <c:pt idx="160">
                  <c:v>6411.2216796875</c:v>
                </c:pt>
                <c:pt idx="161">
                  <c:v>6395.197265625</c:v>
                </c:pt>
                <c:pt idx="162">
                  <c:v>6333.66064453125</c:v>
                </c:pt>
                <c:pt idx="163">
                  <c:v>6262.986328125</c:v>
                </c:pt>
                <c:pt idx="164">
                  <c:v>6222.8388671875</c:v>
                </c:pt>
                <c:pt idx="165">
                  <c:v>6229.802734375</c:v>
                </c:pt>
                <c:pt idx="166">
                  <c:v>6270.4404296875</c:v>
                </c:pt>
                <c:pt idx="167">
                  <c:v>6316.8408203125</c:v>
                </c:pt>
                <c:pt idx="168">
                  <c:v>6349.57275390625</c:v>
                </c:pt>
                <c:pt idx="169">
                  <c:v>6368.55517578125</c:v>
                </c:pt>
                <c:pt idx="170">
                  <c:v>6384.66845703125</c:v>
                </c:pt>
                <c:pt idx="171">
                  <c:v>6402.43359375</c:v>
                </c:pt>
                <c:pt idx="172">
                  <c:v>6411.28076171875</c:v>
                </c:pt>
                <c:pt idx="173">
                  <c:v>6393.8232421875</c:v>
                </c:pt>
                <c:pt idx="174">
                  <c:v>6343.00341796875</c:v>
                </c:pt>
                <c:pt idx="175">
                  <c:v>6271.35888671875</c:v>
                </c:pt>
                <c:pt idx="176">
                  <c:v>6202.908203125</c:v>
                </c:pt>
                <c:pt idx="177">
                  <c:v>6154.62109375</c:v>
                </c:pt>
                <c:pt idx="178">
                  <c:v>6124.74169921875</c:v>
                </c:pt>
                <c:pt idx="179">
                  <c:v>6099.42236328125</c:v>
                </c:pt>
                <c:pt idx="180">
                  <c:v>6071.984375</c:v>
                </c:pt>
                <c:pt idx="181">
                  <c:v>6056.27392578125</c:v>
                </c:pt>
                <c:pt idx="182">
                  <c:v>6079.4443359375</c:v>
                </c:pt>
                <c:pt idx="183">
                  <c:v>6157.728515625</c:v>
                </c:pt>
                <c:pt idx="184">
                  <c:v>6275.5029296875</c:v>
                </c:pt>
                <c:pt idx="185">
                  <c:v>6387.74755859375</c:v>
                </c:pt>
                <c:pt idx="186">
                  <c:v>6447.58740234375</c:v>
                </c:pt>
                <c:pt idx="187">
                  <c:v>6439.0263671875</c:v>
                </c:pt>
                <c:pt idx="188">
                  <c:v>6388.857421875</c:v>
                </c:pt>
                <c:pt idx="189">
                  <c:v>6347.23095703125</c:v>
                </c:pt>
                <c:pt idx="190">
                  <c:v>6351.21533203125</c:v>
                </c:pt>
                <c:pt idx="191">
                  <c:v>6399.36083984375</c:v>
                </c:pt>
                <c:pt idx="192">
                  <c:v>6456.2392578125</c:v>
                </c:pt>
                <c:pt idx="193">
                  <c:v>6481.7177734375</c:v>
                </c:pt>
                <c:pt idx="194">
                  <c:v>6460.46484375</c:v>
                </c:pt>
                <c:pt idx="195">
                  <c:v>6408.6279296875</c:v>
                </c:pt>
                <c:pt idx="196">
                  <c:v>6354.83154296875</c:v>
                </c:pt>
                <c:pt idx="197">
                  <c:v>6314.0517578125</c:v>
                </c:pt>
                <c:pt idx="198">
                  <c:v>6277.49951171875</c:v>
                </c:pt>
                <c:pt idx="199">
                  <c:v>6226.345703125</c:v>
                </c:pt>
                <c:pt idx="200">
                  <c:v>6155.8564453125</c:v>
                </c:pt>
                <c:pt idx="201">
                  <c:v>6087.71875</c:v>
                </c:pt>
                <c:pt idx="202">
                  <c:v>6059.033203125</c:v>
                </c:pt>
                <c:pt idx="203">
                  <c:v>6096.63037109375</c:v>
                </c:pt>
                <c:pt idx="204">
                  <c:v>6197.3447265625</c:v>
                </c:pt>
                <c:pt idx="205">
                  <c:v>6329.05126953125</c:v>
                </c:pt>
                <c:pt idx="206">
                  <c:v>6449.69873046875</c:v>
                </c:pt>
                <c:pt idx="207">
                  <c:v>6528.1787109375</c:v>
                </c:pt>
                <c:pt idx="208">
                  <c:v>6552.53369140625</c:v>
                </c:pt>
                <c:pt idx="209">
                  <c:v>6524.52880859375</c:v>
                </c:pt>
                <c:pt idx="210">
                  <c:v>6451.47265625</c:v>
                </c:pt>
                <c:pt idx="211">
                  <c:v>6345.4521484375</c:v>
                </c:pt>
                <c:pt idx="212">
                  <c:v>6228.83056640625</c:v>
                </c:pt>
                <c:pt idx="213">
                  <c:v>6135.17529296875</c:v>
                </c:pt>
                <c:pt idx="214">
                  <c:v>6097.4326171875</c:v>
                </c:pt>
                <c:pt idx="215">
                  <c:v>6128.27978515625</c:v>
                </c:pt>
                <c:pt idx="216">
                  <c:v>6208.48193359375</c:v>
                </c:pt>
                <c:pt idx="217">
                  <c:v>6295.8505859375</c:v>
                </c:pt>
                <c:pt idx="218">
                  <c:v>6351.1572265625</c:v>
                </c:pt>
                <c:pt idx="219">
                  <c:v>6361.94580078125</c:v>
                </c:pt>
                <c:pt idx="220">
                  <c:v>6345.287109375</c:v>
                </c:pt>
                <c:pt idx="221">
                  <c:v>6327.51513671875</c:v>
                </c:pt>
                <c:pt idx="222">
                  <c:v>6318.80224609375</c:v>
                </c:pt>
                <c:pt idx="223">
                  <c:v>6305.30322265625</c:v>
                </c:pt>
                <c:pt idx="224">
                  <c:v>6266.2236328125</c:v>
                </c:pt>
                <c:pt idx="225">
                  <c:v>6200.28857421875</c:v>
                </c:pt>
                <c:pt idx="226">
                  <c:v>6136.2001953125</c:v>
                </c:pt>
                <c:pt idx="227">
                  <c:v>6114.580078125</c:v>
                </c:pt>
                <c:pt idx="228">
                  <c:v>6154.4912109375</c:v>
                </c:pt>
                <c:pt idx="229">
                  <c:v>6233.47314453125</c:v>
                </c:pt>
                <c:pt idx="230">
                  <c:v>6301.0029296875</c:v>
                </c:pt>
                <c:pt idx="231">
                  <c:v>6317.45556640625</c:v>
                </c:pt>
                <c:pt idx="232">
                  <c:v>6287.30810546875</c:v>
                </c:pt>
                <c:pt idx="233">
                  <c:v>6257.4365234375</c:v>
                </c:pt>
                <c:pt idx="234">
                  <c:v>6278.98095703125</c:v>
                </c:pt>
                <c:pt idx="235">
                  <c:v>6362.3212890625</c:v>
                </c:pt>
                <c:pt idx="236">
                  <c:v>6462.81005859375</c:v>
                </c:pt>
                <c:pt idx="237">
                  <c:v>6511.7802734375</c:v>
                </c:pt>
                <c:pt idx="238">
                  <c:v>6470.638671875</c:v>
                </c:pt>
                <c:pt idx="239">
                  <c:v>6365.416015625</c:v>
                </c:pt>
                <c:pt idx="240">
                  <c:v>6272.515625</c:v>
                </c:pt>
                <c:pt idx="241">
                  <c:v>6263.9365234375</c:v>
                </c:pt>
                <c:pt idx="242">
                  <c:v>6352.49267578125</c:v>
                </c:pt>
                <c:pt idx="243">
                  <c:v>6478.80126953125</c:v>
                </c:pt>
                <c:pt idx="244">
                  <c:v>6550.79541015625</c:v>
                </c:pt>
                <c:pt idx="245">
                  <c:v>6507.30859375</c:v>
                </c:pt>
                <c:pt idx="246">
                  <c:v>6359.951171875</c:v>
                </c:pt>
                <c:pt idx="247">
                  <c:v>6184.505859375</c:v>
                </c:pt>
                <c:pt idx="248">
                  <c:v>6070.2626953125</c:v>
                </c:pt>
                <c:pt idx="249">
                  <c:v>6064.49267578125</c:v>
                </c:pt>
                <c:pt idx="250">
                  <c:v>6149.2783203125</c:v>
                </c:pt>
                <c:pt idx="251">
                  <c:v>6261.8095703125</c:v>
                </c:pt>
                <c:pt idx="252">
                  <c:v>6338.58056640625</c:v>
                </c:pt>
                <c:pt idx="253">
                  <c:v>6351.1484375</c:v>
                </c:pt>
                <c:pt idx="254">
                  <c:v>6312.64013671875</c:v>
                </c:pt>
                <c:pt idx="255">
                  <c:v>6257.83984375</c:v>
                </c:pt>
                <c:pt idx="256">
                  <c:v>6216.49462890625</c:v>
                </c:pt>
                <c:pt idx="257">
                  <c:v>6198.89111328125</c:v>
                </c:pt>
                <c:pt idx="258">
                  <c:v>6199.14306640625</c:v>
                </c:pt>
                <c:pt idx="259">
                  <c:v>6207.83642578125</c:v>
                </c:pt>
                <c:pt idx="260">
                  <c:v>6221.76806640625</c:v>
                </c:pt>
                <c:pt idx="261">
                  <c:v>6244.51416015625</c:v>
                </c:pt>
                <c:pt idx="262">
                  <c:v>6280.169921875</c:v>
                </c:pt>
                <c:pt idx="263">
                  <c:v>6326.67919921875</c:v>
                </c:pt>
                <c:pt idx="264">
                  <c:v>6373.50830078125</c:v>
                </c:pt>
                <c:pt idx="265">
                  <c:v>6404.53173828125</c:v>
                </c:pt>
                <c:pt idx="266">
                  <c:v>6404.5625</c:v>
                </c:pt>
                <c:pt idx="267">
                  <c:v>6367.25048828125</c:v>
                </c:pt>
                <c:pt idx="268">
                  <c:v>6301.3515625</c:v>
                </c:pt>
                <c:pt idx="269">
                  <c:v>6231.34765625</c:v>
                </c:pt>
                <c:pt idx="270">
                  <c:v>6189.1708984375</c:v>
                </c:pt>
                <c:pt idx="271">
                  <c:v>6198.4228515625</c:v>
                </c:pt>
                <c:pt idx="272">
                  <c:v>6259.05810546875</c:v>
                </c:pt>
                <c:pt idx="273">
                  <c:v>6343.470703125</c:v>
                </c:pt>
                <c:pt idx="274">
                  <c:v>6409.67626953125</c:v>
                </c:pt>
                <c:pt idx="275">
                  <c:v>6425.63427734375</c:v>
                </c:pt>
                <c:pt idx="276">
                  <c:v>6389.08447265625</c:v>
                </c:pt>
                <c:pt idx="277">
                  <c:v>6328.3076171875</c:v>
                </c:pt>
                <c:pt idx="278">
                  <c:v>6282.0322265625</c:v>
                </c:pt>
                <c:pt idx="279">
                  <c:v>6272.43359375</c:v>
                </c:pt>
                <c:pt idx="280">
                  <c:v>6291.27197265625</c:v>
                </c:pt>
                <c:pt idx="281">
                  <c:v>6309.81689453125</c:v>
                </c:pt>
                <c:pt idx="282">
                  <c:v>6304.7822265625</c:v>
                </c:pt>
                <c:pt idx="283">
                  <c:v>6279.45166015625</c:v>
                </c:pt>
                <c:pt idx="284">
                  <c:v>6262.30224609375</c:v>
                </c:pt>
                <c:pt idx="285">
                  <c:v>6283.0478515625</c:v>
                </c:pt>
                <c:pt idx="286">
                  <c:v>6344.45849609375</c:v>
                </c:pt>
                <c:pt idx="287">
                  <c:v>6412.8955078125</c:v>
                </c:pt>
                <c:pt idx="288">
                  <c:v>6437.17333984375</c:v>
                </c:pt>
                <c:pt idx="289">
                  <c:v>6383.96826171875</c:v>
                </c:pt>
                <c:pt idx="290">
                  <c:v>6264.86328125</c:v>
                </c:pt>
                <c:pt idx="291">
                  <c:v>6135.1025390625</c:v>
                </c:pt>
                <c:pt idx="292">
                  <c:v>6063.49462890625</c:v>
                </c:pt>
                <c:pt idx="293">
                  <c:v>6092.4599609375</c:v>
                </c:pt>
                <c:pt idx="294">
                  <c:v>6213.36767578125</c:v>
                </c:pt>
                <c:pt idx="295">
                  <c:v>6371.60791015625</c:v>
                </c:pt>
                <c:pt idx="296">
                  <c:v>6496.78662109375</c:v>
                </c:pt>
                <c:pt idx="297">
                  <c:v>6538.927734375</c:v>
                </c:pt>
                <c:pt idx="298">
                  <c:v>6490.1953125</c:v>
                </c:pt>
                <c:pt idx="299">
                  <c:v>6382.30419921875</c:v>
                </c:pt>
                <c:pt idx="300">
                  <c:v>6264.51123046875</c:v>
                </c:pt>
                <c:pt idx="301">
                  <c:v>6176.84521484375</c:v>
                </c:pt>
                <c:pt idx="302">
                  <c:v>6133.58984375</c:v>
                </c:pt>
                <c:pt idx="303">
                  <c:v>6124.30517578125</c:v>
                </c:pt>
                <c:pt idx="304">
                  <c:v>6128.9033203125</c:v>
                </c:pt>
                <c:pt idx="305">
                  <c:v>6135.501953125</c:v>
                </c:pt>
                <c:pt idx="306">
                  <c:v>6148.88330078125</c:v>
                </c:pt>
                <c:pt idx="307">
                  <c:v>6184.0498046875</c:v>
                </c:pt>
                <c:pt idx="308">
                  <c:v>6249.84130859375</c:v>
                </c:pt>
                <c:pt idx="309">
                  <c:v>6335.333984375</c:v>
                </c:pt>
                <c:pt idx="310">
                  <c:v>6410.84765625</c:v>
                </c:pt>
                <c:pt idx="311">
                  <c:v>6445.220703125</c:v>
                </c:pt>
                <c:pt idx="312">
                  <c:v>6427.9931640625</c:v>
                </c:pt>
                <c:pt idx="313">
                  <c:v>6379.271484375</c:v>
                </c:pt>
                <c:pt idx="314">
                  <c:v>6337.44140625</c:v>
                </c:pt>
                <c:pt idx="315">
                  <c:v>6331.5712890625</c:v>
                </c:pt>
                <c:pt idx="316">
                  <c:v>6358.91748046875</c:v>
                </c:pt>
                <c:pt idx="317">
                  <c:v>6386.4375</c:v>
                </c:pt>
                <c:pt idx="318">
                  <c:v>6377.70361328125</c:v>
                </c:pt>
                <c:pt idx="319">
                  <c:v>6325.58203125</c:v>
                </c:pt>
                <c:pt idx="320">
                  <c:v>6263.82666015625</c:v>
                </c:pt>
                <c:pt idx="321">
                  <c:v>6245.09765625</c:v>
                </c:pt>
                <c:pt idx="322">
                  <c:v>6299.4111328125</c:v>
                </c:pt>
                <c:pt idx="323">
                  <c:v>6404.83544921875</c:v>
                </c:pt>
                <c:pt idx="324">
                  <c:v>6495.6640625</c:v>
                </c:pt>
                <c:pt idx="325">
                  <c:v>6505.48974609375</c:v>
                </c:pt>
                <c:pt idx="326">
                  <c:v>6414.61474609375</c:v>
                </c:pt>
                <c:pt idx="327">
                  <c:v>6265.84912109375</c:v>
                </c:pt>
                <c:pt idx="328">
                  <c:v>6135.68896484375</c:v>
                </c:pt>
                <c:pt idx="329">
                  <c:v>6081.9609375</c:v>
                </c:pt>
                <c:pt idx="330">
                  <c:v>6107.30029296875</c:v>
                </c:pt>
                <c:pt idx="331">
                  <c:v>6165.224609375</c:v>
                </c:pt>
                <c:pt idx="332">
                  <c:v>6201.86962890625</c:v>
                </c:pt>
                <c:pt idx="333">
                  <c:v>6198.677734375</c:v>
                </c:pt>
                <c:pt idx="334">
                  <c:v>6181.99853515625</c:v>
                </c:pt>
                <c:pt idx="335">
                  <c:v>6193.84716796875</c:v>
                </c:pt>
                <c:pt idx="336">
                  <c:v>6250.45458984375</c:v>
                </c:pt>
                <c:pt idx="337">
                  <c:v>6324.806640625</c:v>
                </c:pt>
                <c:pt idx="338">
                  <c:v>6368.38232421875</c:v>
                </c:pt>
                <c:pt idx="339">
                  <c:v>6353.48681640625</c:v>
                </c:pt>
                <c:pt idx="340">
                  <c:v>6299.62353515625</c:v>
                </c:pt>
                <c:pt idx="341">
                  <c:v>6260.3330078125</c:v>
                </c:pt>
                <c:pt idx="342">
                  <c:v>6280.1689453125</c:v>
                </c:pt>
                <c:pt idx="343">
                  <c:v>6356.93359375</c:v>
                </c:pt>
                <c:pt idx="344">
                  <c:v>6440.66943359375</c:v>
                </c:pt>
                <c:pt idx="345">
                  <c:v>6471.03955078125</c:v>
                </c:pt>
                <c:pt idx="346">
                  <c:v>6423.48583984375</c:v>
                </c:pt>
                <c:pt idx="347">
                  <c:v>6327.62353515625</c:v>
                </c:pt>
                <c:pt idx="348">
                  <c:v>6244.07080078125</c:v>
                </c:pt>
                <c:pt idx="349">
                  <c:v>6219.1826171875</c:v>
                </c:pt>
              </c:numCache>
            </c:numRef>
          </c:yVal>
          <c:smooth val="1"/>
          <c:extLst>
            <c:ext xmlns:c16="http://schemas.microsoft.com/office/drawing/2014/chart" uri="{C3380CC4-5D6E-409C-BE32-E72D297353CC}">
              <c16:uniqueId val="{00000013-5429-4359-BD11-807CF8F8408D}"/>
            </c:ext>
          </c:extLst>
        </c:ser>
        <c:ser>
          <c:idx val="20"/>
          <c:order val="20"/>
          <c:tx>
            <c:strRef>
              <c:f>np_sub_003!$U$1</c:f>
              <c:strCache>
                <c:ptCount val="1"/>
                <c:pt idx="0">
                  <c:v>Coor_21</c:v>
                </c:pt>
              </c:strCache>
            </c:strRef>
          </c:tx>
          <c:spPr>
            <a:ln w="28575" cap="rnd">
              <a:solidFill>
                <a:schemeClr val="accent3">
                  <a:lumMod val="80000"/>
                </a:schemeClr>
              </a:solidFill>
              <a:round/>
            </a:ln>
            <a:effectLst/>
          </c:spPr>
          <c:marker>
            <c:symbol val="none"/>
          </c:marker>
          <c:yVal>
            <c:numRef>
              <c:f>np_sub_003!$U$2:$U$351</c:f>
              <c:numCache>
                <c:formatCode>0.00000000000_ </c:formatCode>
                <c:ptCount val="350"/>
                <c:pt idx="0">
                  <c:v>7167.951171875</c:v>
                </c:pt>
                <c:pt idx="1">
                  <c:v>7177.4873046875</c:v>
                </c:pt>
                <c:pt idx="2">
                  <c:v>7176.900390625</c:v>
                </c:pt>
                <c:pt idx="3">
                  <c:v>7157.36962890625</c:v>
                </c:pt>
                <c:pt idx="4">
                  <c:v>7125.8369140625</c:v>
                </c:pt>
                <c:pt idx="5">
                  <c:v>7104.91796875</c:v>
                </c:pt>
                <c:pt idx="6">
                  <c:v>7117.0908203125</c:v>
                </c:pt>
                <c:pt idx="7">
                  <c:v>7163.974609375</c:v>
                </c:pt>
                <c:pt idx="8">
                  <c:v>7218.58642578125</c:v>
                </c:pt>
                <c:pt idx="9">
                  <c:v>7240.44189453125</c:v>
                </c:pt>
                <c:pt idx="10">
                  <c:v>7205.05322265625</c:v>
                </c:pt>
                <c:pt idx="11">
                  <c:v>7125.6337890625</c:v>
                </c:pt>
                <c:pt idx="12">
                  <c:v>7048.20751953125</c:v>
                </c:pt>
                <c:pt idx="13">
                  <c:v>7020.99462890625</c:v>
                </c:pt>
                <c:pt idx="14">
                  <c:v>7059.8466796875</c:v>
                </c:pt>
                <c:pt idx="15">
                  <c:v>7136.22412109375</c:v>
                </c:pt>
                <c:pt idx="16">
                  <c:v>7197.74658203125</c:v>
                </c:pt>
                <c:pt idx="17">
                  <c:v>7206.03271484375</c:v>
                </c:pt>
                <c:pt idx="18">
                  <c:v>7162.82421875</c:v>
                </c:pt>
                <c:pt idx="19">
                  <c:v>7104.7451171875</c:v>
                </c:pt>
                <c:pt idx="20">
                  <c:v>7072.2392578125</c:v>
                </c:pt>
                <c:pt idx="21">
                  <c:v>7078.65673828125</c:v>
                </c:pt>
                <c:pt idx="22">
                  <c:v>7104.2939453125</c:v>
                </c:pt>
                <c:pt idx="23">
                  <c:v>7118.498046875</c:v>
                </c:pt>
                <c:pt idx="24">
                  <c:v>7109.15283203125</c:v>
                </c:pt>
                <c:pt idx="25">
                  <c:v>7093.1767578125</c:v>
                </c:pt>
                <c:pt idx="26">
                  <c:v>7098.9384765625</c:v>
                </c:pt>
                <c:pt idx="27">
                  <c:v>7136.814453125</c:v>
                </c:pt>
                <c:pt idx="28">
                  <c:v>7185.37255859375</c:v>
                </c:pt>
                <c:pt idx="29">
                  <c:v>7207.53857421875</c:v>
                </c:pt>
                <c:pt idx="30">
                  <c:v>7184.39404296875</c:v>
                </c:pt>
                <c:pt idx="31">
                  <c:v>7137.02392578125</c:v>
                </c:pt>
                <c:pt idx="32">
                  <c:v>7114.80615234375</c:v>
                </c:pt>
                <c:pt idx="33">
                  <c:v>7156.27392578125</c:v>
                </c:pt>
                <c:pt idx="34">
                  <c:v>7253.25732421875</c:v>
                </c:pt>
                <c:pt idx="35">
                  <c:v>7349.17431640625</c:v>
                </c:pt>
                <c:pt idx="36">
                  <c:v>7376.46044921875</c:v>
                </c:pt>
                <c:pt idx="37">
                  <c:v>7306.4716796875</c:v>
                </c:pt>
                <c:pt idx="38">
                  <c:v>7173.50341796875</c:v>
                </c:pt>
                <c:pt idx="39">
                  <c:v>7053.17919921875</c:v>
                </c:pt>
                <c:pt idx="40">
                  <c:v>7010.2158203125</c:v>
                </c:pt>
                <c:pt idx="41">
                  <c:v>7054.20166015625</c:v>
                </c:pt>
                <c:pt idx="42">
                  <c:v>7135.9296875</c:v>
                </c:pt>
                <c:pt idx="43">
                  <c:v>7185.896484375</c:v>
                </c:pt>
                <c:pt idx="44">
                  <c:v>7165.1611328125</c:v>
                </c:pt>
                <c:pt idx="45">
                  <c:v>7090.869140625</c:v>
                </c:pt>
                <c:pt idx="46">
                  <c:v>7019.50927734375</c:v>
                </c:pt>
                <c:pt idx="47">
                  <c:v>7003.181640625</c:v>
                </c:pt>
                <c:pt idx="48">
                  <c:v>7052.77294921875</c:v>
                </c:pt>
                <c:pt idx="49">
                  <c:v>7133.9892578125</c:v>
                </c:pt>
                <c:pt idx="50">
                  <c:v>7195.755859375</c:v>
                </c:pt>
                <c:pt idx="51">
                  <c:v>7207.0830078125</c:v>
                </c:pt>
                <c:pt idx="52">
                  <c:v>7175.19140625</c:v>
                </c:pt>
                <c:pt idx="53">
                  <c:v>7134.68603515625</c:v>
                </c:pt>
                <c:pt idx="54">
                  <c:v>7119.6650390625</c:v>
                </c:pt>
                <c:pt idx="55">
                  <c:v>7140.82568359375</c:v>
                </c:pt>
                <c:pt idx="56">
                  <c:v>7182.2177734375</c:v>
                </c:pt>
                <c:pt idx="57">
                  <c:v>7215.7822265625</c:v>
                </c:pt>
                <c:pt idx="58">
                  <c:v>7220.07275390625</c:v>
                </c:pt>
                <c:pt idx="59">
                  <c:v>7190.29931640625</c:v>
                </c:pt>
                <c:pt idx="60">
                  <c:v>7136.5068359375</c:v>
                </c:pt>
                <c:pt idx="61">
                  <c:v>7075.70166015625</c:v>
                </c:pt>
                <c:pt idx="62">
                  <c:v>7025.1796875</c:v>
                </c:pt>
                <c:pt idx="63">
                  <c:v>6999.3876953125</c:v>
                </c:pt>
                <c:pt idx="64">
                  <c:v>7007.8271484375</c:v>
                </c:pt>
                <c:pt idx="65">
                  <c:v>7051.62451171875</c:v>
                </c:pt>
                <c:pt idx="66">
                  <c:v>7120.36328125</c:v>
                </c:pt>
                <c:pt idx="67">
                  <c:v>7193.41796875</c:v>
                </c:pt>
                <c:pt idx="68">
                  <c:v>7247.75927734375</c:v>
                </c:pt>
                <c:pt idx="69">
                  <c:v>7268.7109375</c:v>
                </c:pt>
                <c:pt idx="70">
                  <c:v>7256.69873046875</c:v>
                </c:pt>
                <c:pt idx="71">
                  <c:v>7225.28759765625</c:v>
                </c:pt>
                <c:pt idx="72">
                  <c:v>7192.15185546875</c:v>
                </c:pt>
                <c:pt idx="73">
                  <c:v>7169.61962890625</c:v>
                </c:pt>
                <c:pt idx="74">
                  <c:v>7160.86328125</c:v>
                </c:pt>
                <c:pt idx="75">
                  <c:v>7162.5439453125</c:v>
                </c:pt>
                <c:pt idx="76">
                  <c:v>7169.63330078125</c:v>
                </c:pt>
                <c:pt idx="77">
                  <c:v>7177.69287109375</c:v>
                </c:pt>
                <c:pt idx="78">
                  <c:v>7181.88427734375</c:v>
                </c:pt>
                <c:pt idx="79">
                  <c:v>7176.05615234375</c:v>
                </c:pt>
                <c:pt idx="80">
                  <c:v>7155.25732421875</c:v>
                </c:pt>
                <c:pt idx="81">
                  <c:v>7120.9189453125</c:v>
                </c:pt>
                <c:pt idx="82">
                  <c:v>7083.9140625</c:v>
                </c:pt>
                <c:pt idx="83">
                  <c:v>7061.08203125</c:v>
                </c:pt>
                <c:pt idx="84">
                  <c:v>7065.85400390625</c:v>
                </c:pt>
                <c:pt idx="85">
                  <c:v>7099.0419921875</c:v>
                </c:pt>
                <c:pt idx="86">
                  <c:v>7146.7421875</c:v>
                </c:pt>
                <c:pt idx="87">
                  <c:v>7187.47998046875</c:v>
                </c:pt>
                <c:pt idx="88">
                  <c:v>7204.0107421875</c:v>
                </c:pt>
                <c:pt idx="89">
                  <c:v>7192.02099609375</c:v>
                </c:pt>
                <c:pt idx="90">
                  <c:v>7160.66748046875</c:v>
                </c:pt>
                <c:pt idx="91">
                  <c:v>7125.896484375</c:v>
                </c:pt>
                <c:pt idx="92">
                  <c:v>7101.8212890625</c:v>
                </c:pt>
                <c:pt idx="93">
                  <c:v>7095.1806640625</c:v>
                </c:pt>
                <c:pt idx="94">
                  <c:v>7104.35498046875</c:v>
                </c:pt>
                <c:pt idx="95">
                  <c:v>7121.36474609375</c:v>
                </c:pt>
                <c:pt idx="96">
                  <c:v>7135.0703125</c:v>
                </c:pt>
                <c:pt idx="97">
                  <c:v>7135.34521484375</c:v>
                </c:pt>
                <c:pt idx="98">
                  <c:v>7118.404296875</c:v>
                </c:pt>
                <c:pt idx="99">
                  <c:v>7091.4521484375</c:v>
                </c:pt>
                <c:pt idx="100">
                  <c:v>7072.59521484375</c:v>
                </c:pt>
                <c:pt idx="101">
                  <c:v>7083.017578125</c:v>
                </c:pt>
                <c:pt idx="102">
                  <c:v>7133.60888671875</c:v>
                </c:pt>
                <c:pt idx="103">
                  <c:v>7214.04248046875</c:v>
                </c:pt>
                <c:pt idx="104">
                  <c:v>7293.19873046875</c:v>
                </c:pt>
                <c:pt idx="105">
                  <c:v>7333.498046875</c:v>
                </c:pt>
                <c:pt idx="106">
                  <c:v>7311.8486328125</c:v>
                </c:pt>
                <c:pt idx="107">
                  <c:v>7234.017578125</c:v>
                </c:pt>
                <c:pt idx="108">
                  <c:v>7132.53662109375</c:v>
                </c:pt>
                <c:pt idx="109">
                  <c:v>7049.00537109375</c:v>
                </c:pt>
                <c:pt idx="110">
                  <c:v>7012.0712890625</c:v>
                </c:pt>
                <c:pt idx="111">
                  <c:v>7024.7255859375</c:v>
                </c:pt>
                <c:pt idx="112">
                  <c:v>7067.3193359375</c:v>
                </c:pt>
                <c:pt idx="113">
                  <c:v>7111.8740234375</c:v>
                </c:pt>
                <c:pt idx="114">
                  <c:v>7137.01904296875</c:v>
                </c:pt>
                <c:pt idx="115">
                  <c:v>7135.23046875</c:v>
                </c:pt>
                <c:pt idx="116">
                  <c:v>7111.5634765625</c:v>
                </c:pt>
                <c:pt idx="117">
                  <c:v>7078.81005859375</c:v>
                </c:pt>
                <c:pt idx="118">
                  <c:v>7053.6123046875</c:v>
                </c:pt>
                <c:pt idx="119">
                  <c:v>7053.451171875</c:v>
                </c:pt>
                <c:pt idx="120">
                  <c:v>7091.4638671875</c:v>
                </c:pt>
                <c:pt idx="121">
                  <c:v>7168.388671875</c:v>
                </c:pt>
                <c:pt idx="122">
                  <c:v>7266.40771484375</c:v>
                </c:pt>
                <c:pt idx="123">
                  <c:v>7352.0615234375</c:v>
                </c:pt>
                <c:pt idx="124">
                  <c:v>7390.67236328125</c:v>
                </c:pt>
                <c:pt idx="125">
                  <c:v>7365.51953125</c:v>
                </c:pt>
                <c:pt idx="126">
                  <c:v>7289.046875</c:v>
                </c:pt>
                <c:pt idx="127">
                  <c:v>7196.9189453125</c:v>
                </c:pt>
                <c:pt idx="128">
                  <c:v>7127.3388671875</c:v>
                </c:pt>
                <c:pt idx="129">
                  <c:v>7099.1572265625</c:v>
                </c:pt>
                <c:pt idx="130">
                  <c:v>7103.73486328125</c:v>
                </c:pt>
                <c:pt idx="131">
                  <c:v>7115.57568359375</c:v>
                </c:pt>
                <c:pt idx="132">
                  <c:v>7112.853515625</c:v>
                </c:pt>
                <c:pt idx="133">
                  <c:v>7092.07373046875</c:v>
                </c:pt>
                <c:pt idx="134">
                  <c:v>7066.65478515625</c:v>
                </c:pt>
                <c:pt idx="135">
                  <c:v>7052.51904296875</c:v>
                </c:pt>
                <c:pt idx="136">
                  <c:v>7053.89892578125</c:v>
                </c:pt>
                <c:pt idx="137">
                  <c:v>7061.353515625</c:v>
                </c:pt>
                <c:pt idx="138">
                  <c:v>7062.8095703125</c:v>
                </c:pt>
                <c:pt idx="139">
                  <c:v>7056.974609375</c:v>
                </c:pt>
                <c:pt idx="140">
                  <c:v>7056.43310546875</c:v>
                </c:pt>
                <c:pt idx="141">
                  <c:v>7076.8740234375</c:v>
                </c:pt>
                <c:pt idx="142">
                  <c:v>7121.2919921875</c:v>
                </c:pt>
                <c:pt idx="143">
                  <c:v>7173.14111328125</c:v>
                </c:pt>
                <c:pt idx="144">
                  <c:v>7205.6279296875</c:v>
                </c:pt>
                <c:pt idx="145">
                  <c:v>7201.08154296875</c:v>
                </c:pt>
                <c:pt idx="146">
                  <c:v>7165.49560546875</c:v>
                </c:pt>
                <c:pt idx="147">
                  <c:v>7126.27734375</c:v>
                </c:pt>
                <c:pt idx="148">
                  <c:v>7113.916015625</c:v>
                </c:pt>
                <c:pt idx="149">
                  <c:v>7140.6962890625</c:v>
                </c:pt>
                <c:pt idx="150">
                  <c:v>7192.0908203125</c:v>
                </c:pt>
                <c:pt idx="151">
                  <c:v>7237.10498046875</c:v>
                </c:pt>
                <c:pt idx="152">
                  <c:v>7249.9013671875</c:v>
                </c:pt>
                <c:pt idx="153">
                  <c:v>7227.04296875</c:v>
                </c:pt>
                <c:pt idx="154">
                  <c:v>7188.34423828125</c:v>
                </c:pt>
                <c:pt idx="155">
                  <c:v>7161.48779296875</c:v>
                </c:pt>
                <c:pt idx="156">
                  <c:v>7162.0302734375</c:v>
                </c:pt>
                <c:pt idx="157">
                  <c:v>7183.08349609375</c:v>
                </c:pt>
                <c:pt idx="158">
                  <c:v>7201.43212890625</c:v>
                </c:pt>
                <c:pt idx="159">
                  <c:v>7195.13330078125</c:v>
                </c:pt>
                <c:pt idx="160">
                  <c:v>7159.95458984375</c:v>
                </c:pt>
                <c:pt idx="161">
                  <c:v>7113.3037109375</c:v>
                </c:pt>
                <c:pt idx="162">
                  <c:v>7083.083984375</c:v>
                </c:pt>
                <c:pt idx="163">
                  <c:v>7088.93310546875</c:v>
                </c:pt>
                <c:pt idx="164">
                  <c:v>7128.166015625</c:v>
                </c:pt>
                <c:pt idx="165">
                  <c:v>7175.6416015625</c:v>
                </c:pt>
                <c:pt idx="166">
                  <c:v>7198.072265625</c:v>
                </c:pt>
                <c:pt idx="167">
                  <c:v>7174.30908203125</c:v>
                </c:pt>
                <c:pt idx="168">
                  <c:v>7109.3203125</c:v>
                </c:pt>
                <c:pt idx="169">
                  <c:v>7033.07470703125</c:v>
                </c:pt>
                <c:pt idx="170">
                  <c:v>6984.41796875</c:v>
                </c:pt>
                <c:pt idx="171">
                  <c:v>6989.12255859375</c:v>
                </c:pt>
                <c:pt idx="172">
                  <c:v>7045.140625</c:v>
                </c:pt>
                <c:pt idx="173">
                  <c:v>7124.0771484375</c:v>
                </c:pt>
                <c:pt idx="174">
                  <c:v>7188.1689453125</c:v>
                </c:pt>
                <c:pt idx="175">
                  <c:v>7212.42626953125</c:v>
                </c:pt>
                <c:pt idx="176">
                  <c:v>7198.25732421875</c:v>
                </c:pt>
                <c:pt idx="177">
                  <c:v>7170.24267578125</c:v>
                </c:pt>
                <c:pt idx="178">
                  <c:v>7158.50732421875</c:v>
                </c:pt>
                <c:pt idx="179">
                  <c:v>7178.35888671875</c:v>
                </c:pt>
                <c:pt idx="180">
                  <c:v>7220.3955078125</c:v>
                </c:pt>
                <c:pt idx="181">
                  <c:v>7257.1474609375</c:v>
                </c:pt>
                <c:pt idx="182">
                  <c:v>7261.3662109375</c:v>
                </c:pt>
                <c:pt idx="183">
                  <c:v>7223.7421875</c:v>
                </c:pt>
                <c:pt idx="184">
                  <c:v>7158.79736328125</c:v>
                </c:pt>
                <c:pt idx="185">
                  <c:v>7095.896484375</c:v>
                </c:pt>
                <c:pt idx="186">
                  <c:v>7061.8984375</c:v>
                </c:pt>
                <c:pt idx="187">
                  <c:v>7066.58837890625</c:v>
                </c:pt>
                <c:pt idx="188">
                  <c:v>7099.23291015625</c:v>
                </c:pt>
                <c:pt idx="189">
                  <c:v>7137.033203125</c:v>
                </c:pt>
                <c:pt idx="190">
                  <c:v>7159.1611328125</c:v>
                </c:pt>
                <c:pt idx="191">
                  <c:v>7157.7587890625</c:v>
                </c:pt>
                <c:pt idx="192">
                  <c:v>7140.25</c:v>
                </c:pt>
                <c:pt idx="193">
                  <c:v>7122.91845703125</c:v>
                </c:pt>
                <c:pt idx="194">
                  <c:v>7120.373046875</c:v>
                </c:pt>
                <c:pt idx="195">
                  <c:v>7136.9638671875</c:v>
                </c:pt>
                <c:pt idx="196">
                  <c:v>7164.447265625</c:v>
                </c:pt>
                <c:pt idx="197">
                  <c:v>7186.6650390625</c:v>
                </c:pt>
                <c:pt idx="198">
                  <c:v>7188.51025390625</c:v>
                </c:pt>
                <c:pt idx="199">
                  <c:v>7164.466796875</c:v>
                </c:pt>
                <c:pt idx="200">
                  <c:v>7122.27099609375</c:v>
                </c:pt>
                <c:pt idx="201">
                  <c:v>7079.689453125</c:v>
                </c:pt>
                <c:pt idx="202">
                  <c:v>7055.94580078125</c:v>
                </c:pt>
                <c:pt idx="203">
                  <c:v>7062.201171875</c:v>
                </c:pt>
                <c:pt idx="204">
                  <c:v>7096</c:v>
                </c:pt>
                <c:pt idx="205">
                  <c:v>7142.42431640625</c:v>
                </c:pt>
                <c:pt idx="206">
                  <c:v>7181.14794921875</c:v>
                </c:pt>
                <c:pt idx="207">
                  <c:v>7195.76904296875</c:v>
                </c:pt>
                <c:pt idx="208">
                  <c:v>7181.2041015625</c:v>
                </c:pt>
                <c:pt idx="209">
                  <c:v>7146.29052734375</c:v>
                </c:pt>
                <c:pt idx="210">
                  <c:v>7110.7802734375</c:v>
                </c:pt>
                <c:pt idx="211">
                  <c:v>7097.52392578125</c:v>
                </c:pt>
                <c:pt idx="212">
                  <c:v>7121.97216796875</c:v>
                </c:pt>
                <c:pt idx="213">
                  <c:v>7182.66259765625</c:v>
                </c:pt>
                <c:pt idx="214">
                  <c:v>7257.68994140625</c:v>
                </c:pt>
                <c:pt idx="215">
                  <c:v>7311.4169921875</c:v>
                </c:pt>
                <c:pt idx="216">
                  <c:v>7311.27294921875</c:v>
                </c:pt>
                <c:pt idx="217">
                  <c:v>7247.52294921875</c:v>
                </c:pt>
                <c:pt idx="218">
                  <c:v>7143.990234375</c:v>
                </c:pt>
                <c:pt idx="219">
                  <c:v>7049.986328125</c:v>
                </c:pt>
                <c:pt idx="220">
                  <c:v>7014.2734375</c:v>
                </c:pt>
                <c:pt idx="221">
                  <c:v>7054.9541015625</c:v>
                </c:pt>
                <c:pt idx="222">
                  <c:v>7145.119140625</c:v>
                </c:pt>
                <c:pt idx="223">
                  <c:v>7226.47412109375</c:v>
                </c:pt>
                <c:pt idx="224">
                  <c:v>7245.015625</c:v>
                </c:pt>
                <c:pt idx="225">
                  <c:v>7186.29150390625</c:v>
                </c:pt>
                <c:pt idx="226">
                  <c:v>7085.7177734375</c:v>
                </c:pt>
                <c:pt idx="227">
                  <c:v>7005.2861328125</c:v>
                </c:pt>
                <c:pt idx="228">
                  <c:v>6991.70703125</c:v>
                </c:pt>
                <c:pt idx="229">
                  <c:v>7045.2314453125</c:v>
                </c:pt>
                <c:pt idx="230">
                  <c:v>7121.6650390625</c:v>
                </c:pt>
                <c:pt idx="231">
                  <c:v>7166.2119140625</c:v>
                </c:pt>
                <c:pt idx="232">
                  <c:v>7154.15380859375</c:v>
                </c:pt>
                <c:pt idx="233">
                  <c:v>7108.0263671875</c:v>
                </c:pt>
                <c:pt idx="234">
                  <c:v>7078.53759765625</c:v>
                </c:pt>
                <c:pt idx="235">
                  <c:v>7103.9970703125</c:v>
                </c:pt>
                <c:pt idx="236">
                  <c:v>7179.4541015625</c:v>
                </c:pt>
                <c:pt idx="237">
                  <c:v>7259.265625</c:v>
                </c:pt>
                <c:pt idx="238">
                  <c:v>7291.078125</c:v>
                </c:pt>
                <c:pt idx="239">
                  <c:v>7255.0771484375</c:v>
                </c:pt>
                <c:pt idx="240">
                  <c:v>7178.51708984375</c:v>
                </c:pt>
                <c:pt idx="241">
                  <c:v>7114.7802734375</c:v>
                </c:pt>
                <c:pt idx="242">
                  <c:v>7103.4560546875</c:v>
                </c:pt>
                <c:pt idx="243">
                  <c:v>7141.95166015625</c:v>
                </c:pt>
                <c:pt idx="244">
                  <c:v>7189.59033203125</c:v>
                </c:pt>
                <c:pt idx="245">
                  <c:v>7199.93115234375</c:v>
                </c:pt>
                <c:pt idx="246">
                  <c:v>7156.03759765625</c:v>
                </c:pt>
                <c:pt idx="247">
                  <c:v>7082.4228515625</c:v>
                </c:pt>
                <c:pt idx="248">
                  <c:v>7026.15625</c:v>
                </c:pt>
                <c:pt idx="249">
                  <c:v>7022.85009765625</c:v>
                </c:pt>
                <c:pt idx="250">
                  <c:v>7073.1630859375</c:v>
                </c:pt>
                <c:pt idx="251">
                  <c:v>7145.61181640625</c:v>
                </c:pt>
                <c:pt idx="252">
                  <c:v>7200.9404296875</c:v>
                </c:pt>
                <c:pt idx="253">
                  <c:v>7218.30712890625</c:v>
                </c:pt>
                <c:pt idx="254">
                  <c:v>7204.71826171875</c:v>
                </c:pt>
                <c:pt idx="255">
                  <c:v>7183.70068359375</c:v>
                </c:pt>
                <c:pt idx="256">
                  <c:v>7174.720703125</c:v>
                </c:pt>
                <c:pt idx="257">
                  <c:v>7179.7138671875</c:v>
                </c:pt>
                <c:pt idx="258">
                  <c:v>7185.2509765625</c:v>
                </c:pt>
                <c:pt idx="259">
                  <c:v>7176.0810546875</c:v>
                </c:pt>
                <c:pt idx="260">
                  <c:v>7148.29736328125</c:v>
                </c:pt>
                <c:pt idx="261">
                  <c:v>7112.6767578125</c:v>
                </c:pt>
                <c:pt idx="262">
                  <c:v>7087.3076171875</c:v>
                </c:pt>
                <c:pt idx="263">
                  <c:v>7086.00048828125</c:v>
                </c:pt>
                <c:pt idx="264">
                  <c:v>7110.3173828125</c:v>
                </c:pt>
                <c:pt idx="265">
                  <c:v>7149.09423828125</c:v>
                </c:pt>
                <c:pt idx="266">
                  <c:v>7184.302734375</c:v>
                </c:pt>
                <c:pt idx="267">
                  <c:v>7199.49560546875</c:v>
                </c:pt>
                <c:pt idx="268">
                  <c:v>7187.1806640625</c:v>
                </c:pt>
                <c:pt idx="269">
                  <c:v>7152.55712890625</c:v>
                </c:pt>
                <c:pt idx="270">
                  <c:v>7111.97412109375</c:v>
                </c:pt>
                <c:pt idx="271">
                  <c:v>7085.8359375</c:v>
                </c:pt>
                <c:pt idx="272">
                  <c:v>7088.2646484375</c:v>
                </c:pt>
                <c:pt idx="273">
                  <c:v>7118.65966796875</c:v>
                </c:pt>
                <c:pt idx="274">
                  <c:v>7160.748046875</c:v>
                </c:pt>
                <c:pt idx="275">
                  <c:v>7191.07177734375</c:v>
                </c:pt>
                <c:pt idx="276">
                  <c:v>7192.65966796875</c:v>
                </c:pt>
                <c:pt idx="277">
                  <c:v>7165.3603515625</c:v>
                </c:pt>
                <c:pt idx="278">
                  <c:v>7125.82470703125</c:v>
                </c:pt>
                <c:pt idx="279">
                  <c:v>7096.95849609375</c:v>
                </c:pt>
                <c:pt idx="280">
                  <c:v>7093.94873046875</c:v>
                </c:pt>
                <c:pt idx="281">
                  <c:v>7116.115234375</c:v>
                </c:pt>
                <c:pt idx="282">
                  <c:v>7149.21728515625</c:v>
                </c:pt>
                <c:pt idx="283">
                  <c:v>7175.28564453125</c:v>
                </c:pt>
                <c:pt idx="284">
                  <c:v>7182.5126953125</c:v>
                </c:pt>
                <c:pt idx="285">
                  <c:v>7169.34130859375</c:v>
                </c:pt>
                <c:pt idx="286">
                  <c:v>7142.40234375</c:v>
                </c:pt>
                <c:pt idx="287">
                  <c:v>7112.17431640625</c:v>
                </c:pt>
                <c:pt idx="288">
                  <c:v>7089.8662109375</c:v>
                </c:pt>
                <c:pt idx="289">
                  <c:v>7085.48779296875</c:v>
                </c:pt>
                <c:pt idx="290">
                  <c:v>7104.8623046875</c:v>
                </c:pt>
                <c:pt idx="291">
                  <c:v>7145.1015625</c:v>
                </c:pt>
                <c:pt idx="292">
                  <c:v>7192.013671875</c:v>
                </c:pt>
                <c:pt idx="293">
                  <c:v>7224.1494140625</c:v>
                </c:pt>
                <c:pt idx="294">
                  <c:v>7224.0625</c:v>
                </c:pt>
                <c:pt idx="295">
                  <c:v>7190.5244140625</c:v>
                </c:pt>
                <c:pt idx="296">
                  <c:v>7142.2001953125</c:v>
                </c:pt>
                <c:pt idx="297">
                  <c:v>7107.89453125</c:v>
                </c:pt>
                <c:pt idx="298">
                  <c:v>7108.4140625</c:v>
                </c:pt>
                <c:pt idx="299">
                  <c:v>7142.51123046875</c:v>
                </c:pt>
                <c:pt idx="300">
                  <c:v>7187.56689453125</c:v>
                </c:pt>
                <c:pt idx="301">
                  <c:v>7215.07958984375</c:v>
                </c:pt>
                <c:pt idx="302">
                  <c:v>7209.7919921875</c:v>
                </c:pt>
                <c:pt idx="303">
                  <c:v>7178.494140625</c:v>
                </c:pt>
                <c:pt idx="304">
                  <c:v>7142.70263671875</c:v>
                </c:pt>
                <c:pt idx="305">
                  <c:v>7121.90234375</c:v>
                </c:pt>
                <c:pt idx="306">
                  <c:v>7120.7216796875</c:v>
                </c:pt>
                <c:pt idx="307">
                  <c:v>7129.048828125</c:v>
                </c:pt>
                <c:pt idx="308">
                  <c:v>7132.9228515625</c:v>
                </c:pt>
                <c:pt idx="309">
                  <c:v>7125.76611328125</c:v>
                </c:pt>
                <c:pt idx="310">
                  <c:v>7110.95849609375</c:v>
                </c:pt>
                <c:pt idx="311">
                  <c:v>7095.765625</c:v>
                </c:pt>
                <c:pt idx="312">
                  <c:v>7084.45703125</c:v>
                </c:pt>
                <c:pt idx="313">
                  <c:v>7077.87060546875</c:v>
                </c:pt>
                <c:pt idx="314">
                  <c:v>7078.66943359375</c:v>
                </c:pt>
                <c:pt idx="315">
                  <c:v>7094.4541015625</c:v>
                </c:pt>
                <c:pt idx="316">
                  <c:v>7132.29931640625</c:v>
                </c:pt>
                <c:pt idx="317">
                  <c:v>7187.626953125</c:v>
                </c:pt>
                <c:pt idx="318">
                  <c:v>7238.59375</c:v>
                </c:pt>
                <c:pt idx="319">
                  <c:v>7255.333984375</c:v>
                </c:pt>
                <c:pt idx="320">
                  <c:v>7221.0927734375</c:v>
                </c:pt>
                <c:pt idx="321">
                  <c:v>7149.64111328125</c:v>
                </c:pt>
                <c:pt idx="322">
                  <c:v>7082.5166015625</c:v>
                </c:pt>
                <c:pt idx="323">
                  <c:v>7063.65771484375</c:v>
                </c:pt>
                <c:pt idx="324">
                  <c:v>7107.822265625</c:v>
                </c:pt>
                <c:pt idx="325">
                  <c:v>7186.9482421875</c:v>
                </c:pt>
                <c:pt idx="326">
                  <c:v>7247.2041015625</c:v>
                </c:pt>
                <c:pt idx="327">
                  <c:v>7246.32080078125</c:v>
                </c:pt>
                <c:pt idx="328">
                  <c:v>7184.0078125</c:v>
                </c:pt>
                <c:pt idx="329">
                  <c:v>7102.09716796875</c:v>
                </c:pt>
                <c:pt idx="330">
                  <c:v>7053.67431640625</c:v>
                </c:pt>
                <c:pt idx="331">
                  <c:v>7064.47705078125</c:v>
                </c:pt>
                <c:pt idx="332">
                  <c:v>7116.08349609375</c:v>
                </c:pt>
                <c:pt idx="333">
                  <c:v>7163.3828125</c:v>
                </c:pt>
                <c:pt idx="334">
                  <c:v>7171.81787109375</c:v>
                </c:pt>
                <c:pt idx="335">
                  <c:v>7144.4345703125</c:v>
                </c:pt>
                <c:pt idx="336">
                  <c:v>7117.2529296875</c:v>
                </c:pt>
                <c:pt idx="337">
                  <c:v>7127.1376953125</c:v>
                </c:pt>
                <c:pt idx="338">
                  <c:v>7178.5390625</c:v>
                </c:pt>
                <c:pt idx="339">
                  <c:v>7236.4072265625</c:v>
                </c:pt>
                <c:pt idx="340">
                  <c:v>7251.68212890625</c:v>
                </c:pt>
                <c:pt idx="341">
                  <c:v>7199.79052734375</c:v>
                </c:pt>
                <c:pt idx="342">
                  <c:v>7102.1982421875</c:v>
                </c:pt>
                <c:pt idx="343">
                  <c:v>7014.15478515625</c:v>
                </c:pt>
                <c:pt idx="344">
                  <c:v>6987.65283203125</c:v>
                </c:pt>
                <c:pt idx="345">
                  <c:v>7036.91796875</c:v>
                </c:pt>
                <c:pt idx="346">
                  <c:v>7130.857421875</c:v>
                </c:pt>
                <c:pt idx="347">
                  <c:v>7216.0751953125</c:v>
                </c:pt>
                <c:pt idx="348">
                  <c:v>7252.06787109375</c:v>
                </c:pt>
                <c:pt idx="349">
                  <c:v>7233.46923828125</c:v>
                </c:pt>
              </c:numCache>
            </c:numRef>
          </c:yVal>
          <c:smooth val="1"/>
          <c:extLst>
            <c:ext xmlns:c16="http://schemas.microsoft.com/office/drawing/2014/chart" uri="{C3380CC4-5D6E-409C-BE32-E72D297353CC}">
              <c16:uniqueId val="{00000014-5429-4359-BD11-807CF8F8408D}"/>
            </c:ext>
          </c:extLst>
        </c:ser>
        <c:ser>
          <c:idx val="21"/>
          <c:order val="21"/>
          <c:tx>
            <c:strRef>
              <c:f>np_sub_003!$V$1</c:f>
              <c:strCache>
                <c:ptCount val="1"/>
                <c:pt idx="0">
                  <c:v>Coor_22</c:v>
                </c:pt>
              </c:strCache>
            </c:strRef>
          </c:tx>
          <c:spPr>
            <a:ln w="28575" cap="rnd">
              <a:solidFill>
                <a:schemeClr val="accent4">
                  <a:lumMod val="80000"/>
                </a:schemeClr>
              </a:solidFill>
              <a:round/>
            </a:ln>
            <a:effectLst/>
          </c:spPr>
          <c:marker>
            <c:symbol val="none"/>
          </c:marker>
          <c:yVal>
            <c:numRef>
              <c:f>np_sub_003!$V$2:$V$351</c:f>
              <c:numCache>
                <c:formatCode>0.00000000000_ </c:formatCode>
                <c:ptCount val="350"/>
                <c:pt idx="0">
                  <c:v>7858.48486328125</c:v>
                </c:pt>
                <c:pt idx="1">
                  <c:v>7880.166015625</c:v>
                </c:pt>
                <c:pt idx="2">
                  <c:v>7845.80908203125</c:v>
                </c:pt>
                <c:pt idx="3">
                  <c:v>7776.673828125</c:v>
                </c:pt>
                <c:pt idx="4">
                  <c:v>7713.69775390625</c:v>
                </c:pt>
                <c:pt idx="5">
                  <c:v>7684.802734375</c:v>
                </c:pt>
                <c:pt idx="6">
                  <c:v>7685.11767578125</c:v>
                </c:pt>
                <c:pt idx="7">
                  <c:v>7686.89892578125</c:v>
                </c:pt>
                <c:pt idx="8">
                  <c:v>7669.78857421875</c:v>
                </c:pt>
                <c:pt idx="9">
                  <c:v>7643.3447265625</c:v>
                </c:pt>
                <c:pt idx="10">
                  <c:v>7639.75732421875</c:v>
                </c:pt>
                <c:pt idx="11">
                  <c:v>7681.27587890625</c:v>
                </c:pt>
                <c:pt idx="12">
                  <c:v>7751.4052734375</c:v>
                </c:pt>
                <c:pt idx="13">
                  <c:v>7798.77880859375</c:v>
                </c:pt>
                <c:pt idx="14">
                  <c:v>7775.83740234375</c:v>
                </c:pt>
                <c:pt idx="15">
                  <c:v>7682.6923828125</c:v>
                </c:pt>
                <c:pt idx="16">
                  <c:v>7577.7216796875</c:v>
                </c:pt>
                <c:pt idx="17">
                  <c:v>7540.609375</c:v>
                </c:pt>
                <c:pt idx="18">
                  <c:v>7612.55859375</c:v>
                </c:pt>
                <c:pt idx="19">
                  <c:v>7760.095703125</c:v>
                </c:pt>
                <c:pt idx="20">
                  <c:v>7893.5146484375</c:v>
                </c:pt>
                <c:pt idx="21">
                  <c:v>7929.046875</c:v>
                </c:pt>
                <c:pt idx="22">
                  <c:v>7848.60302734375</c:v>
                </c:pt>
                <c:pt idx="23">
                  <c:v>7711.54736328125</c:v>
                </c:pt>
                <c:pt idx="24">
                  <c:v>7609.88037109375</c:v>
                </c:pt>
                <c:pt idx="25">
                  <c:v>7602.099609375</c:v>
                </c:pt>
                <c:pt idx="26">
                  <c:v>7676.5107421875</c:v>
                </c:pt>
                <c:pt idx="27">
                  <c:v>7769.65185546875</c:v>
                </c:pt>
                <c:pt idx="28">
                  <c:v>7820.869140625</c:v>
                </c:pt>
                <c:pt idx="29">
                  <c:v>7816.7861328125</c:v>
                </c:pt>
                <c:pt idx="30">
                  <c:v>7791.12060546875</c:v>
                </c:pt>
                <c:pt idx="31">
                  <c:v>7784.9208984375</c:v>
                </c:pt>
                <c:pt idx="32">
                  <c:v>7805.4833984375</c:v>
                </c:pt>
                <c:pt idx="33">
                  <c:v>7821.06689453125</c:v>
                </c:pt>
                <c:pt idx="34">
                  <c:v>7795.04052734375</c:v>
                </c:pt>
                <c:pt idx="35">
                  <c:v>7727.072265625</c:v>
                </c:pt>
                <c:pt idx="36">
                  <c:v>7662.1708984375</c:v>
                </c:pt>
                <c:pt idx="37">
                  <c:v>7656.74609375</c:v>
                </c:pt>
                <c:pt idx="38">
                  <c:v>7729.650390625</c:v>
                </c:pt>
                <c:pt idx="39">
                  <c:v>7841.14794921875</c:v>
                </c:pt>
                <c:pt idx="40">
                  <c:v>7920.1875</c:v>
                </c:pt>
                <c:pt idx="41">
                  <c:v>7919.09765625</c:v>
                </c:pt>
                <c:pt idx="42">
                  <c:v>7850.37744140625</c:v>
                </c:pt>
                <c:pt idx="43">
                  <c:v>7774.244140625</c:v>
                </c:pt>
                <c:pt idx="44">
                  <c:v>7746.80810546875</c:v>
                </c:pt>
                <c:pt idx="45">
                  <c:v>7772.3447265625</c:v>
                </c:pt>
                <c:pt idx="46">
                  <c:v>7800.32421875</c:v>
                </c:pt>
                <c:pt idx="47">
                  <c:v>7770.48876953125</c:v>
                </c:pt>
                <c:pt idx="48">
                  <c:v>7668.6181640625</c:v>
                </c:pt>
                <c:pt idx="49">
                  <c:v>7545.8857421875</c:v>
                </c:pt>
                <c:pt idx="50">
                  <c:v>7484.27490234375</c:v>
                </c:pt>
                <c:pt idx="51">
                  <c:v>7534.7529296875</c:v>
                </c:pt>
                <c:pt idx="52">
                  <c:v>7677.17236328125</c:v>
                </c:pt>
                <c:pt idx="53">
                  <c:v>7833.1005859375</c:v>
                </c:pt>
                <c:pt idx="54">
                  <c:v>7920.36865234375</c:v>
                </c:pt>
                <c:pt idx="55">
                  <c:v>7906.21484375</c:v>
                </c:pt>
                <c:pt idx="56">
                  <c:v>7819.873046875</c:v>
                </c:pt>
                <c:pt idx="57">
                  <c:v>7720.189453125</c:v>
                </c:pt>
                <c:pt idx="58">
                  <c:v>7649.24267578125</c:v>
                </c:pt>
                <c:pt idx="59">
                  <c:v>7610.109375</c:v>
                </c:pt>
                <c:pt idx="60">
                  <c:v>7582.19580078125</c:v>
                </c:pt>
                <c:pt idx="61">
                  <c:v>7554.138671875</c:v>
                </c:pt>
                <c:pt idx="62">
                  <c:v>7541.236328125</c:v>
                </c:pt>
                <c:pt idx="63">
                  <c:v>7571.4150390625</c:v>
                </c:pt>
                <c:pt idx="64">
                  <c:v>7654.072265625</c:v>
                </c:pt>
                <c:pt idx="65">
                  <c:v>7762.18701171875</c:v>
                </c:pt>
                <c:pt idx="66">
                  <c:v>7846.091796875</c:v>
                </c:pt>
                <c:pt idx="67">
                  <c:v>7868.7265625</c:v>
                </c:pt>
                <c:pt idx="68">
                  <c:v>7832.82666015625</c:v>
                </c:pt>
                <c:pt idx="69">
                  <c:v>7777.2890625</c:v>
                </c:pt>
                <c:pt idx="70">
                  <c:v>7746.4052734375</c:v>
                </c:pt>
                <c:pt idx="71">
                  <c:v>7758.16650390625</c:v>
                </c:pt>
                <c:pt idx="72">
                  <c:v>7797.0078125</c:v>
                </c:pt>
                <c:pt idx="73">
                  <c:v>7833.8515625</c:v>
                </c:pt>
                <c:pt idx="74">
                  <c:v>7852.77490234375</c:v>
                </c:pt>
                <c:pt idx="75">
                  <c:v>7859.86767578125</c:v>
                </c:pt>
                <c:pt idx="76">
                  <c:v>7868.28955078125</c:v>
                </c:pt>
                <c:pt idx="77">
                  <c:v>7876.65380859375</c:v>
                </c:pt>
                <c:pt idx="78">
                  <c:v>7864.1884765625</c:v>
                </c:pt>
                <c:pt idx="79">
                  <c:v>7809.87060546875</c:v>
                </c:pt>
                <c:pt idx="80">
                  <c:v>7718.8681640625</c:v>
                </c:pt>
                <c:pt idx="81">
                  <c:v>7630.31298828125</c:v>
                </c:pt>
                <c:pt idx="82">
                  <c:v>7595.06005859375</c:v>
                </c:pt>
                <c:pt idx="83">
                  <c:v>7638.4375</c:v>
                </c:pt>
                <c:pt idx="84">
                  <c:v>7737.90576171875</c:v>
                </c:pt>
                <c:pt idx="85">
                  <c:v>7835.27685546875</c:v>
                </c:pt>
                <c:pt idx="86">
                  <c:v>7875.66796875</c:v>
                </c:pt>
                <c:pt idx="87">
                  <c:v>7843.64892578125</c:v>
                </c:pt>
                <c:pt idx="88">
                  <c:v>7769.42919921875</c:v>
                </c:pt>
                <c:pt idx="89">
                  <c:v>7702.177734375</c:v>
                </c:pt>
                <c:pt idx="90">
                  <c:v>7673.330078125</c:v>
                </c:pt>
                <c:pt idx="91">
                  <c:v>7678.736328125</c:v>
                </c:pt>
                <c:pt idx="92">
                  <c:v>7690.90234375</c:v>
                </c:pt>
                <c:pt idx="93">
                  <c:v>7687.2763671875</c:v>
                </c:pt>
                <c:pt idx="94">
                  <c:v>7669.0615234375</c:v>
                </c:pt>
                <c:pt idx="95">
                  <c:v>7655.95849609375</c:v>
                </c:pt>
                <c:pt idx="96">
                  <c:v>7664.525390625</c:v>
                </c:pt>
                <c:pt idx="97">
                  <c:v>7691.4580078125</c:v>
                </c:pt>
                <c:pt idx="98">
                  <c:v>7716.82958984375</c:v>
                </c:pt>
                <c:pt idx="99">
                  <c:v>7723.01806640625</c:v>
                </c:pt>
                <c:pt idx="100">
                  <c:v>7710.8291015625</c:v>
                </c:pt>
                <c:pt idx="101">
                  <c:v>7697.74755859375</c:v>
                </c:pt>
                <c:pt idx="102">
                  <c:v>7700.51708984375</c:v>
                </c:pt>
                <c:pt idx="103">
                  <c:v>7719.00146484375</c:v>
                </c:pt>
                <c:pt idx="104">
                  <c:v>7736.90625</c:v>
                </c:pt>
                <c:pt idx="105">
                  <c:v>7738.814453125</c:v>
                </c:pt>
                <c:pt idx="106">
                  <c:v>7727.18505859375</c:v>
                </c:pt>
                <c:pt idx="107">
                  <c:v>7722.3056640625</c:v>
                </c:pt>
                <c:pt idx="108">
                  <c:v>7743.68505859375</c:v>
                </c:pt>
                <c:pt idx="109">
                  <c:v>7789.1748046875</c:v>
                </c:pt>
                <c:pt idx="110">
                  <c:v>7831.7216796875</c:v>
                </c:pt>
                <c:pt idx="111">
                  <c:v>7839.0830078125</c:v>
                </c:pt>
                <c:pt idx="112">
                  <c:v>7801.30810546875</c:v>
                </c:pt>
                <c:pt idx="113">
                  <c:v>7742.46630859375</c:v>
                </c:pt>
                <c:pt idx="114">
                  <c:v>7704.92138671875</c:v>
                </c:pt>
                <c:pt idx="115">
                  <c:v>7717.14990234375</c:v>
                </c:pt>
                <c:pt idx="116">
                  <c:v>7770.52587890625</c:v>
                </c:pt>
                <c:pt idx="117">
                  <c:v>7824.28076171875</c:v>
                </c:pt>
                <c:pt idx="118">
                  <c:v>7835.6328125</c:v>
                </c:pt>
                <c:pt idx="119">
                  <c:v>7792.0224609375</c:v>
                </c:pt>
                <c:pt idx="120">
                  <c:v>7720.72509765625</c:v>
                </c:pt>
                <c:pt idx="121">
                  <c:v>7668.9609375</c:v>
                </c:pt>
                <c:pt idx="122">
                  <c:v>7670.326171875</c:v>
                </c:pt>
                <c:pt idx="123">
                  <c:v>7722.8505859375</c:v>
                </c:pt>
                <c:pt idx="124">
                  <c:v>7793.59765625</c:v>
                </c:pt>
                <c:pt idx="125">
                  <c:v>7843.794921875</c:v>
                </c:pt>
                <c:pt idx="126">
                  <c:v>7854.02294921875</c:v>
                </c:pt>
                <c:pt idx="127">
                  <c:v>7831.53076171875</c:v>
                </c:pt>
                <c:pt idx="128">
                  <c:v>7797.556640625</c:v>
                </c:pt>
                <c:pt idx="129">
                  <c:v>7767.8466796875</c:v>
                </c:pt>
                <c:pt idx="130">
                  <c:v>7742.609375</c:v>
                </c:pt>
                <c:pt idx="131">
                  <c:v>7712.09521484375</c:v>
                </c:pt>
                <c:pt idx="132">
                  <c:v>7670.60400390625</c:v>
                </c:pt>
                <c:pt idx="133">
                  <c:v>7625.90283203125</c:v>
                </c:pt>
                <c:pt idx="134">
                  <c:v>7596.4033203125</c:v>
                </c:pt>
                <c:pt idx="135">
                  <c:v>7599.033203125</c:v>
                </c:pt>
                <c:pt idx="136">
                  <c:v>7637.55224609375</c:v>
                </c:pt>
                <c:pt idx="137">
                  <c:v>7699.44091796875</c:v>
                </c:pt>
                <c:pt idx="138">
                  <c:v>7762.30029296875</c:v>
                </c:pt>
                <c:pt idx="139">
                  <c:v>7804.4404296875</c:v>
                </c:pt>
                <c:pt idx="140">
                  <c:v>7813.37841796875</c:v>
                </c:pt>
                <c:pt idx="141">
                  <c:v>7789.27734375</c:v>
                </c:pt>
                <c:pt idx="142">
                  <c:v>7743.9482421875</c:v>
                </c:pt>
                <c:pt idx="143">
                  <c:v>7697.0234375</c:v>
                </c:pt>
                <c:pt idx="144">
                  <c:v>7669.9365234375</c:v>
                </c:pt>
                <c:pt idx="145">
                  <c:v>7678.1083984375</c:v>
                </c:pt>
                <c:pt idx="146">
                  <c:v>7723.35498046875</c:v>
                </c:pt>
                <c:pt idx="147">
                  <c:v>7790.53564453125</c:v>
                </c:pt>
                <c:pt idx="148">
                  <c:v>7851.95068359375</c:v>
                </c:pt>
                <c:pt idx="149">
                  <c:v>7879.19873046875</c:v>
                </c:pt>
                <c:pt idx="150">
                  <c:v>7857.25927734375</c:v>
                </c:pt>
                <c:pt idx="151">
                  <c:v>7793.22412109375</c:v>
                </c:pt>
                <c:pt idx="152">
                  <c:v>7714.3154296875</c:v>
                </c:pt>
                <c:pt idx="153">
                  <c:v>7655.416015625</c:v>
                </c:pt>
                <c:pt idx="154">
                  <c:v>7641.9658203125</c:v>
                </c:pt>
                <c:pt idx="155">
                  <c:v>7676.6669921875</c:v>
                </c:pt>
                <c:pt idx="156">
                  <c:v>7736.97509765625</c:v>
                </c:pt>
                <c:pt idx="157">
                  <c:v>7785.6484375</c:v>
                </c:pt>
                <c:pt idx="158">
                  <c:v>7790.427734375</c:v>
                </c:pt>
                <c:pt idx="159">
                  <c:v>7743.548828125</c:v>
                </c:pt>
                <c:pt idx="160">
                  <c:v>7669.89013671875</c:v>
                </c:pt>
                <c:pt idx="161">
                  <c:v>7616.57080078125</c:v>
                </c:pt>
                <c:pt idx="162">
                  <c:v>7626.55126953125</c:v>
                </c:pt>
                <c:pt idx="163">
                  <c:v>7709.90380859375</c:v>
                </c:pt>
                <c:pt idx="164">
                  <c:v>7831.28857421875</c:v>
                </c:pt>
                <c:pt idx="165">
                  <c:v>7925.22412109375</c:v>
                </c:pt>
                <c:pt idx="166">
                  <c:v>7933.7001953125</c:v>
                </c:pt>
                <c:pt idx="167">
                  <c:v>7843.9677734375</c:v>
                </c:pt>
                <c:pt idx="168">
                  <c:v>7700.72705078125</c:v>
                </c:pt>
                <c:pt idx="169">
                  <c:v>7581.615234375</c:v>
                </c:pt>
                <c:pt idx="170">
                  <c:v>7549.74462890625</c:v>
                </c:pt>
                <c:pt idx="171">
                  <c:v>7614.5029296875</c:v>
                </c:pt>
                <c:pt idx="172">
                  <c:v>7727.90576171875</c:v>
                </c:pt>
                <c:pt idx="173">
                  <c:v>7819.4462890625</c:v>
                </c:pt>
                <c:pt idx="174">
                  <c:v>7844.6806640625</c:v>
                </c:pt>
                <c:pt idx="175">
                  <c:v>7812.5908203125</c:v>
                </c:pt>
                <c:pt idx="176">
                  <c:v>7772.59033203125</c:v>
                </c:pt>
                <c:pt idx="177">
                  <c:v>7772.41259765625</c:v>
                </c:pt>
                <c:pt idx="178">
                  <c:v>7819.8779296875</c:v>
                </c:pt>
                <c:pt idx="179">
                  <c:v>7877.69970703125</c:v>
                </c:pt>
                <c:pt idx="180">
                  <c:v>7894.1416015625</c:v>
                </c:pt>
                <c:pt idx="181">
                  <c:v>7844.36083984375</c:v>
                </c:pt>
                <c:pt idx="182">
                  <c:v>7749.7236328125</c:v>
                </c:pt>
                <c:pt idx="183">
                  <c:v>7660.8916015625</c:v>
                </c:pt>
                <c:pt idx="184">
                  <c:v>7619.560546875</c:v>
                </c:pt>
                <c:pt idx="185">
                  <c:v>7629.84033203125</c:v>
                </c:pt>
                <c:pt idx="186">
                  <c:v>7660.86767578125</c:v>
                </c:pt>
                <c:pt idx="187">
                  <c:v>7676.00537109375</c:v>
                </c:pt>
                <c:pt idx="188">
                  <c:v>7663.01513671875</c:v>
                </c:pt>
                <c:pt idx="189">
                  <c:v>7640.73828125</c:v>
                </c:pt>
                <c:pt idx="190">
                  <c:v>7639.03369140625</c:v>
                </c:pt>
                <c:pt idx="191">
                  <c:v>7671.2109375</c:v>
                </c:pt>
                <c:pt idx="192">
                  <c:v>7723.0166015625</c:v>
                </c:pt>
                <c:pt idx="193">
                  <c:v>7766.26708984375</c:v>
                </c:pt>
                <c:pt idx="194">
                  <c:v>7783.296875</c:v>
                </c:pt>
                <c:pt idx="195">
                  <c:v>7779.83154296875</c:v>
                </c:pt>
                <c:pt idx="196">
                  <c:v>7775.65087890625</c:v>
                </c:pt>
                <c:pt idx="197">
                  <c:v>7783.23876953125</c:v>
                </c:pt>
                <c:pt idx="198">
                  <c:v>7795.43310546875</c:v>
                </c:pt>
                <c:pt idx="199">
                  <c:v>7794.14599609375</c:v>
                </c:pt>
                <c:pt idx="200">
                  <c:v>7771.7822265625</c:v>
                </c:pt>
                <c:pt idx="201">
                  <c:v>7743.92529296875</c:v>
                </c:pt>
                <c:pt idx="202">
                  <c:v>7738.7783203125</c:v>
                </c:pt>
                <c:pt idx="203">
                  <c:v>7770.3017578125</c:v>
                </c:pt>
                <c:pt idx="204">
                  <c:v>7818.92822265625</c:v>
                </c:pt>
                <c:pt idx="205">
                  <c:v>7840.09765625</c:v>
                </c:pt>
                <c:pt idx="206">
                  <c:v>7798.13623046875</c:v>
                </c:pt>
                <c:pt idx="207">
                  <c:v>7699.84228515625</c:v>
                </c:pt>
                <c:pt idx="208">
                  <c:v>7598.88818359375</c:v>
                </c:pt>
                <c:pt idx="209">
                  <c:v>7563.16943359375</c:v>
                </c:pt>
                <c:pt idx="210">
                  <c:v>7626.62060546875</c:v>
                </c:pt>
                <c:pt idx="211">
                  <c:v>7761.0625</c:v>
                </c:pt>
                <c:pt idx="212">
                  <c:v>7890.384765625</c:v>
                </c:pt>
                <c:pt idx="213">
                  <c:v>7938.48779296875</c:v>
                </c:pt>
                <c:pt idx="214">
                  <c:v>7877.658203125</c:v>
                </c:pt>
                <c:pt idx="215">
                  <c:v>7744.23779296875</c:v>
                </c:pt>
                <c:pt idx="216">
                  <c:v>7612.66943359375</c:v>
                </c:pt>
                <c:pt idx="217">
                  <c:v>7548.23583984375</c:v>
                </c:pt>
                <c:pt idx="218">
                  <c:v>7571.306640625</c:v>
                </c:pt>
                <c:pt idx="219">
                  <c:v>7654.1904296875</c:v>
                </c:pt>
                <c:pt idx="220">
                  <c:v>7746.888671875</c:v>
                </c:pt>
                <c:pt idx="221">
                  <c:v>7809.70703125</c:v>
                </c:pt>
                <c:pt idx="222">
                  <c:v>7830.8583984375</c:v>
                </c:pt>
                <c:pt idx="223">
                  <c:v>7822.39599609375</c:v>
                </c:pt>
                <c:pt idx="224">
                  <c:v>7803.96142578125</c:v>
                </c:pt>
                <c:pt idx="225">
                  <c:v>7788.94677734375</c:v>
                </c:pt>
                <c:pt idx="226">
                  <c:v>7780.7607421875</c:v>
                </c:pt>
                <c:pt idx="227">
                  <c:v>7776.68212890625</c:v>
                </c:pt>
                <c:pt idx="228">
                  <c:v>7772.4169921875</c:v>
                </c:pt>
                <c:pt idx="229">
                  <c:v>7763.8037109375</c:v>
                </c:pt>
                <c:pt idx="230">
                  <c:v>7747.45947265625</c:v>
                </c:pt>
                <c:pt idx="231">
                  <c:v>7723.279296875</c:v>
                </c:pt>
                <c:pt idx="232">
                  <c:v>7697.8701171875</c:v>
                </c:pt>
                <c:pt idx="233">
                  <c:v>7684.38720703125</c:v>
                </c:pt>
                <c:pt idx="234">
                  <c:v>7695.787109375</c:v>
                </c:pt>
                <c:pt idx="235">
                  <c:v>7734.68212890625</c:v>
                </c:pt>
                <c:pt idx="236">
                  <c:v>7787.78662109375</c:v>
                </c:pt>
                <c:pt idx="237">
                  <c:v>7830.97705078125</c:v>
                </c:pt>
                <c:pt idx="238">
                  <c:v>7842.89306640625</c:v>
                </c:pt>
                <c:pt idx="239">
                  <c:v>7817.619140625</c:v>
                </c:pt>
                <c:pt idx="240">
                  <c:v>7767.015625</c:v>
                </c:pt>
                <c:pt idx="241">
                  <c:v>7711.27685546875</c:v>
                </c:pt>
                <c:pt idx="242">
                  <c:v>7665.61376953125</c:v>
                </c:pt>
                <c:pt idx="243">
                  <c:v>7633.6142578125</c:v>
                </c:pt>
                <c:pt idx="244">
                  <c:v>7611.5703125</c:v>
                </c:pt>
                <c:pt idx="245">
                  <c:v>7598.41455078125</c:v>
                </c:pt>
                <c:pt idx="246">
                  <c:v>7601.24462890625</c:v>
                </c:pt>
                <c:pt idx="247">
                  <c:v>7630.7177734375</c:v>
                </c:pt>
                <c:pt idx="248">
                  <c:v>7689.87158203125</c:v>
                </c:pt>
                <c:pt idx="249">
                  <c:v>7766.072265625</c:v>
                </c:pt>
                <c:pt idx="250">
                  <c:v>7833.6494140625</c:v>
                </c:pt>
                <c:pt idx="251">
                  <c:v>7866.369140625</c:v>
                </c:pt>
                <c:pt idx="252">
                  <c:v>7851.46337890625</c:v>
                </c:pt>
                <c:pt idx="253">
                  <c:v>7796.240234375</c:v>
                </c:pt>
                <c:pt idx="254">
                  <c:v>7724.087890625</c:v>
                </c:pt>
                <c:pt idx="255">
                  <c:v>7663.6298828125</c:v>
                </c:pt>
                <c:pt idx="256">
                  <c:v>7637.552734375</c:v>
                </c:pt>
                <c:pt idx="257">
                  <c:v>7655.5205078125</c:v>
                </c:pt>
                <c:pt idx="258">
                  <c:v>7712.037109375</c:v>
                </c:pt>
                <c:pt idx="259">
                  <c:v>7788.53125</c:v>
                </c:pt>
                <c:pt idx="260">
                  <c:v>7859.42529296875</c:v>
                </c:pt>
                <c:pt idx="261">
                  <c:v>7901.65576171875</c:v>
                </c:pt>
                <c:pt idx="262">
                  <c:v>7904.60498046875</c:v>
                </c:pt>
                <c:pt idx="263">
                  <c:v>7874.7509765625</c:v>
                </c:pt>
                <c:pt idx="264">
                  <c:v>7830.64453125</c:v>
                </c:pt>
                <c:pt idx="265">
                  <c:v>7790.203125</c:v>
                </c:pt>
                <c:pt idx="266">
                  <c:v>7759.26025390625</c:v>
                </c:pt>
                <c:pt idx="267">
                  <c:v>7731.06396484375</c:v>
                </c:pt>
                <c:pt idx="268">
                  <c:v>7698.2197265625</c:v>
                </c:pt>
                <c:pt idx="269">
                  <c:v>7667.09716796875</c:v>
                </c:pt>
                <c:pt idx="270">
                  <c:v>7660.1416015625</c:v>
                </c:pt>
                <c:pt idx="271">
                  <c:v>7699.88134765625</c:v>
                </c:pt>
                <c:pt idx="272">
                  <c:v>7784.60888671875</c:v>
                </c:pt>
                <c:pt idx="273">
                  <c:v>7876.3642578125</c:v>
                </c:pt>
                <c:pt idx="274">
                  <c:v>7916.0234375</c:v>
                </c:pt>
                <c:pt idx="275">
                  <c:v>7860.078125</c:v>
                </c:pt>
                <c:pt idx="276">
                  <c:v>7714.30078125</c:v>
                </c:pt>
                <c:pt idx="277">
                  <c:v>7537.75048828125</c:v>
                </c:pt>
                <c:pt idx="278">
                  <c:v>7410.38037109375</c:v>
                </c:pt>
                <c:pt idx="279">
                  <c:v>7384.87255859375</c:v>
                </c:pt>
                <c:pt idx="280">
                  <c:v>7456.666015625</c:v>
                </c:pt>
                <c:pt idx="281">
                  <c:v>7573.53466796875</c:v>
                </c:pt>
                <c:pt idx="282">
                  <c:v>7676.37646484375</c:v>
                </c:pt>
                <c:pt idx="283">
                  <c:v>7739.24169921875</c:v>
                </c:pt>
                <c:pt idx="284">
                  <c:v>7778.32958984375</c:v>
                </c:pt>
                <c:pt idx="285">
                  <c:v>7825.58837890625</c:v>
                </c:pt>
                <c:pt idx="286">
                  <c:v>7891.64697265625</c:v>
                </c:pt>
                <c:pt idx="287">
                  <c:v>7951.013671875</c:v>
                </c:pt>
                <c:pt idx="288">
                  <c:v>7962.81787109375</c:v>
                </c:pt>
                <c:pt idx="289">
                  <c:v>7909.2578125</c:v>
                </c:pt>
                <c:pt idx="290">
                  <c:v>7817.6650390625</c:v>
                </c:pt>
                <c:pt idx="291">
                  <c:v>7744.98974609375</c:v>
                </c:pt>
                <c:pt idx="292">
                  <c:v>7735.22021484375</c:v>
                </c:pt>
                <c:pt idx="293">
                  <c:v>7784.21728515625</c:v>
                </c:pt>
                <c:pt idx="294">
                  <c:v>7841.9052734375</c:v>
                </c:pt>
                <c:pt idx="295">
                  <c:v>7851.64453125</c:v>
                </c:pt>
                <c:pt idx="296">
                  <c:v>7795.6298828125</c:v>
                </c:pt>
                <c:pt idx="297">
                  <c:v>7709.32421875</c:v>
                </c:pt>
                <c:pt idx="298">
                  <c:v>7652.7626953125</c:v>
                </c:pt>
                <c:pt idx="299">
                  <c:v>7661.9482421875</c:v>
                </c:pt>
                <c:pt idx="300">
                  <c:v>7720.1552734375</c:v>
                </c:pt>
                <c:pt idx="301">
                  <c:v>7772.77783203125</c:v>
                </c:pt>
                <c:pt idx="302">
                  <c:v>7773.427734375</c:v>
                </c:pt>
                <c:pt idx="303">
                  <c:v>7723.01220703125</c:v>
                </c:pt>
                <c:pt idx="304">
                  <c:v>7669.07373046875</c:v>
                </c:pt>
                <c:pt idx="305">
                  <c:v>7665.4091796875</c:v>
                </c:pt>
                <c:pt idx="306">
                  <c:v>7724.9384765625</c:v>
                </c:pt>
                <c:pt idx="307">
                  <c:v>7804.8447265625</c:v>
                </c:pt>
                <c:pt idx="308">
                  <c:v>7837.0947265625</c:v>
                </c:pt>
                <c:pt idx="309">
                  <c:v>7780.7802734375</c:v>
                </c:pt>
                <c:pt idx="310">
                  <c:v>7655.1572265625</c:v>
                </c:pt>
                <c:pt idx="311">
                  <c:v>7527.7666015625</c:v>
                </c:pt>
                <c:pt idx="312">
                  <c:v>7467.56982421875</c:v>
                </c:pt>
                <c:pt idx="313">
                  <c:v>7499.65771484375</c:v>
                </c:pt>
                <c:pt idx="314">
                  <c:v>7594.857421875</c:v>
                </c:pt>
                <c:pt idx="315">
                  <c:v>7698.41259765625</c:v>
                </c:pt>
                <c:pt idx="316">
                  <c:v>7771.44140625</c:v>
                </c:pt>
                <c:pt idx="317">
                  <c:v>7811.703125</c:v>
                </c:pt>
                <c:pt idx="318">
                  <c:v>7840.6142578125</c:v>
                </c:pt>
                <c:pt idx="319">
                  <c:v>7872.8974609375</c:v>
                </c:pt>
                <c:pt idx="320">
                  <c:v>7898.5068359375</c:v>
                </c:pt>
                <c:pt idx="321">
                  <c:v>7893.2080078125</c:v>
                </c:pt>
                <c:pt idx="322">
                  <c:v>7846.9326171875</c:v>
                </c:pt>
                <c:pt idx="323">
                  <c:v>7782.046875</c:v>
                </c:pt>
                <c:pt idx="324">
                  <c:v>7741.9482421875</c:v>
                </c:pt>
                <c:pt idx="325">
                  <c:v>7756.84765625</c:v>
                </c:pt>
                <c:pt idx="326">
                  <c:v>7815.3193359375</c:v>
                </c:pt>
                <c:pt idx="327">
                  <c:v>7867.8349609375</c:v>
                </c:pt>
                <c:pt idx="328">
                  <c:v>7863.06640625</c:v>
                </c:pt>
                <c:pt idx="329">
                  <c:v>7789.86767578125</c:v>
                </c:pt>
                <c:pt idx="330">
                  <c:v>7690.916015625</c:v>
                </c:pt>
                <c:pt idx="331">
                  <c:v>7634.7275390625</c:v>
                </c:pt>
                <c:pt idx="332">
                  <c:v>7665.27880859375</c:v>
                </c:pt>
                <c:pt idx="333">
                  <c:v>7766.95849609375</c:v>
                </c:pt>
                <c:pt idx="334">
                  <c:v>7872.1220703125</c:v>
                </c:pt>
                <c:pt idx="335">
                  <c:v>7906.7607421875</c:v>
                </c:pt>
                <c:pt idx="336">
                  <c:v>7841.2890625</c:v>
                </c:pt>
                <c:pt idx="337">
                  <c:v>7709.8369140625</c:v>
                </c:pt>
                <c:pt idx="338">
                  <c:v>7585.12744140625</c:v>
                </c:pt>
                <c:pt idx="339">
                  <c:v>7528.54931640625</c:v>
                </c:pt>
                <c:pt idx="340">
                  <c:v>7551.84375</c:v>
                </c:pt>
                <c:pt idx="341">
                  <c:v>7616.291015625</c:v>
                </c:pt>
                <c:pt idx="342">
                  <c:v>7666.61083984375</c:v>
                </c:pt>
                <c:pt idx="343">
                  <c:v>7672.20751953125</c:v>
                </c:pt>
                <c:pt idx="344">
                  <c:v>7645.626953125</c:v>
                </c:pt>
                <c:pt idx="345">
                  <c:v>7627.359375</c:v>
                </c:pt>
                <c:pt idx="346">
                  <c:v>7651.572265625</c:v>
                </c:pt>
                <c:pt idx="347">
                  <c:v>7719.69580078125</c:v>
                </c:pt>
                <c:pt idx="348">
                  <c:v>7800.3701171875</c:v>
                </c:pt>
                <c:pt idx="349">
                  <c:v>7853.2158203125</c:v>
                </c:pt>
              </c:numCache>
            </c:numRef>
          </c:yVal>
          <c:smooth val="1"/>
          <c:extLst>
            <c:ext xmlns:c16="http://schemas.microsoft.com/office/drawing/2014/chart" uri="{C3380CC4-5D6E-409C-BE32-E72D297353CC}">
              <c16:uniqueId val="{00000015-5429-4359-BD11-807CF8F8408D}"/>
            </c:ext>
          </c:extLst>
        </c:ser>
        <c:ser>
          <c:idx val="22"/>
          <c:order val="22"/>
          <c:tx>
            <c:strRef>
              <c:f>np_sub_003!$W$1</c:f>
              <c:strCache>
                <c:ptCount val="1"/>
                <c:pt idx="0">
                  <c:v>Coor_23</c:v>
                </c:pt>
              </c:strCache>
            </c:strRef>
          </c:tx>
          <c:spPr>
            <a:ln w="28575" cap="rnd">
              <a:solidFill>
                <a:schemeClr val="accent5">
                  <a:lumMod val="80000"/>
                </a:schemeClr>
              </a:solidFill>
              <a:round/>
            </a:ln>
            <a:effectLst/>
          </c:spPr>
          <c:marker>
            <c:symbol val="none"/>
          </c:marker>
          <c:yVal>
            <c:numRef>
              <c:f>np_sub_003!$W$2:$W$351</c:f>
              <c:numCache>
                <c:formatCode>0.00000000000_ </c:formatCode>
                <c:ptCount val="350"/>
                <c:pt idx="0">
                  <c:v>5688.46435546875</c:v>
                </c:pt>
                <c:pt idx="1">
                  <c:v>5752.5947265625</c:v>
                </c:pt>
                <c:pt idx="2">
                  <c:v>5849.6845703125</c:v>
                </c:pt>
                <c:pt idx="3">
                  <c:v>5924.7392578125</c:v>
                </c:pt>
                <c:pt idx="4">
                  <c:v>5932.4140625</c:v>
                </c:pt>
                <c:pt idx="5">
                  <c:v>5868.81494140625</c:v>
                </c:pt>
                <c:pt idx="6">
                  <c:v>5775.35986328125</c:v>
                </c:pt>
                <c:pt idx="7">
                  <c:v>5709.9033203125</c:v>
                </c:pt>
                <c:pt idx="8">
                  <c:v>5705.19287109375</c:v>
                </c:pt>
                <c:pt idx="9">
                  <c:v>5745.82470703125</c:v>
                </c:pt>
                <c:pt idx="10">
                  <c:v>5782.13671875</c:v>
                </c:pt>
                <c:pt idx="11">
                  <c:v>5771.31494140625</c:v>
                </c:pt>
                <c:pt idx="12">
                  <c:v>5713.8828125</c:v>
                </c:pt>
                <c:pt idx="13">
                  <c:v>5655.93798828125</c:v>
                </c:pt>
                <c:pt idx="14">
                  <c:v>5653.6591796875</c:v>
                </c:pt>
                <c:pt idx="15">
                  <c:v>5726.92041015625</c:v>
                </c:pt>
                <c:pt idx="16">
                  <c:v>5838.99609375</c:v>
                </c:pt>
                <c:pt idx="17">
                  <c:v>5920.107421875</c:v>
                </c:pt>
                <c:pt idx="18">
                  <c:v>5918.23583984375</c:v>
                </c:pt>
                <c:pt idx="19">
                  <c:v>5838.3388671875</c:v>
                </c:pt>
                <c:pt idx="20">
                  <c:v>5739.2392578125</c:v>
                </c:pt>
                <c:pt idx="21">
                  <c:v>5690.1884765625</c:v>
                </c:pt>
                <c:pt idx="22">
                  <c:v>5720.6240234375</c:v>
                </c:pt>
                <c:pt idx="23">
                  <c:v>5801.623046875</c:v>
                </c:pt>
                <c:pt idx="24">
                  <c:v>5871.9794921875</c:v>
                </c:pt>
                <c:pt idx="25">
                  <c:v>5886.49755859375</c:v>
                </c:pt>
                <c:pt idx="26">
                  <c:v>5847.58984375</c:v>
                </c:pt>
                <c:pt idx="27">
                  <c:v>5796.615234375</c:v>
                </c:pt>
                <c:pt idx="28">
                  <c:v>5775.1875</c:v>
                </c:pt>
                <c:pt idx="29">
                  <c:v>5790.60986328125</c:v>
                </c:pt>
                <c:pt idx="30">
                  <c:v>5814.0810546875</c:v>
                </c:pt>
                <c:pt idx="31">
                  <c:v>5810.8896484375</c:v>
                </c:pt>
                <c:pt idx="32">
                  <c:v>5774.1923828125</c:v>
                </c:pt>
                <c:pt idx="33">
                  <c:v>5731.74951171875</c:v>
                </c:pt>
                <c:pt idx="34">
                  <c:v>5719.72119140625</c:v>
                </c:pt>
                <c:pt idx="35">
                  <c:v>5747.38671875</c:v>
                </c:pt>
                <c:pt idx="36">
                  <c:v>5785.232421875</c:v>
                </c:pt>
                <c:pt idx="37">
                  <c:v>5788.56884765625</c:v>
                </c:pt>
                <c:pt idx="38">
                  <c:v>5737.25537109375</c:v>
                </c:pt>
                <c:pt idx="39">
                  <c:v>5656.9111328125</c:v>
                </c:pt>
                <c:pt idx="40">
                  <c:v>5601.95751953125</c:v>
                </c:pt>
                <c:pt idx="41">
                  <c:v>5613.46875</c:v>
                </c:pt>
                <c:pt idx="42">
                  <c:v>5686.951171875</c:v>
                </c:pt>
                <c:pt idx="43">
                  <c:v>5777.3642578125</c:v>
                </c:pt>
                <c:pt idx="44">
                  <c:v>5837.13134765625</c:v>
                </c:pt>
                <c:pt idx="45">
                  <c:v>5854.56396484375</c:v>
                </c:pt>
                <c:pt idx="46">
                  <c:v>5859.60400390625</c:v>
                </c:pt>
                <c:pt idx="47">
                  <c:v>5891.87890625</c:v>
                </c:pt>
                <c:pt idx="48">
                  <c:v>5958.95947265625</c:v>
                </c:pt>
                <c:pt idx="49">
                  <c:v>6021.990234375</c:v>
                </c:pt>
                <c:pt idx="50">
                  <c:v>6023.2060546875</c:v>
                </c:pt>
                <c:pt idx="51">
                  <c:v>5934.13818359375</c:v>
                </c:pt>
                <c:pt idx="52">
                  <c:v>5784.8037109375</c:v>
                </c:pt>
                <c:pt idx="53">
                  <c:v>5648.66015625</c:v>
                </c:pt>
                <c:pt idx="54">
                  <c:v>5593.6767578125</c:v>
                </c:pt>
                <c:pt idx="55">
                  <c:v>5636.91259765625</c:v>
                </c:pt>
                <c:pt idx="56">
                  <c:v>5736.4853515625</c:v>
                </c:pt>
                <c:pt idx="57">
                  <c:v>5824.515625</c:v>
                </c:pt>
                <c:pt idx="58">
                  <c:v>5853.23095703125</c:v>
                </c:pt>
                <c:pt idx="59">
                  <c:v>5819.41015625</c:v>
                </c:pt>
                <c:pt idx="60">
                  <c:v>5753.51708984375</c:v>
                </c:pt>
                <c:pt idx="61">
                  <c:v>5689.46435546875</c:v>
                </c:pt>
                <c:pt idx="62">
                  <c:v>5643.451171875</c:v>
                </c:pt>
                <c:pt idx="63">
                  <c:v>5616.84033203125</c:v>
                </c:pt>
                <c:pt idx="64">
                  <c:v>5613.06884765625</c:v>
                </c:pt>
                <c:pt idx="65">
                  <c:v>5645.7958984375</c:v>
                </c:pt>
                <c:pt idx="66">
                  <c:v>5726.32568359375</c:v>
                </c:pt>
                <c:pt idx="67">
                  <c:v>5841.7158203125</c:v>
                </c:pt>
                <c:pt idx="68">
                  <c:v>5947.96337890625</c:v>
                </c:pt>
                <c:pt idx="69">
                  <c:v>5991.72314453125</c:v>
                </c:pt>
                <c:pt idx="70">
                  <c:v>5947.9189453125</c:v>
                </c:pt>
                <c:pt idx="71">
                  <c:v>5842.9599609375</c:v>
                </c:pt>
                <c:pt idx="72">
                  <c:v>5741.40234375</c:v>
                </c:pt>
                <c:pt idx="73">
                  <c:v>5702.697265625</c:v>
                </c:pt>
                <c:pt idx="74">
                  <c:v>5740.18310546875</c:v>
                </c:pt>
                <c:pt idx="75">
                  <c:v>5814.3486328125</c:v>
                </c:pt>
                <c:pt idx="76">
                  <c:v>5865.63720703125</c:v>
                </c:pt>
                <c:pt idx="77">
                  <c:v>5860.41748046875</c:v>
                </c:pt>
                <c:pt idx="78">
                  <c:v>5813.60498046875</c:v>
                </c:pt>
                <c:pt idx="79">
                  <c:v>5771.185546875</c:v>
                </c:pt>
                <c:pt idx="80">
                  <c:v>5768.935546875</c:v>
                </c:pt>
                <c:pt idx="81">
                  <c:v>5802.38623046875</c:v>
                </c:pt>
                <c:pt idx="82">
                  <c:v>5832.322265625</c:v>
                </c:pt>
                <c:pt idx="83">
                  <c:v>5819.69921875</c:v>
                </c:pt>
                <c:pt idx="84">
                  <c:v>5759.73095703125</c:v>
                </c:pt>
                <c:pt idx="85">
                  <c:v>5686.85107421875</c:v>
                </c:pt>
                <c:pt idx="86">
                  <c:v>5647.5673828125</c:v>
                </c:pt>
                <c:pt idx="87">
                  <c:v>5664.69482421875</c:v>
                </c:pt>
                <c:pt idx="88">
                  <c:v>5722.04638671875</c:v>
                </c:pt>
                <c:pt idx="89">
                  <c:v>5779.93798828125</c:v>
                </c:pt>
                <c:pt idx="90">
                  <c:v>5806.15625</c:v>
                </c:pt>
                <c:pt idx="91">
                  <c:v>5796.259765625</c:v>
                </c:pt>
                <c:pt idx="92">
                  <c:v>5769.14306640625</c:v>
                </c:pt>
                <c:pt idx="93">
                  <c:v>5746.2578125</c:v>
                </c:pt>
                <c:pt idx="94">
                  <c:v>5735.43505859375</c:v>
                </c:pt>
                <c:pt idx="95">
                  <c:v>5732.67578125</c:v>
                </c:pt>
                <c:pt idx="96">
                  <c:v>5736.20556640625</c:v>
                </c:pt>
                <c:pt idx="97">
                  <c:v>5755.13232421875</c:v>
                </c:pt>
                <c:pt idx="98">
                  <c:v>5801.376953125</c:v>
                </c:pt>
                <c:pt idx="99">
                  <c:v>5871.77685546875</c:v>
                </c:pt>
                <c:pt idx="100">
                  <c:v>5939.4912109375</c:v>
                </c:pt>
                <c:pt idx="101">
                  <c:v>5967.47705078125</c:v>
                </c:pt>
                <c:pt idx="102">
                  <c:v>5936.58447265625</c:v>
                </c:pt>
                <c:pt idx="103">
                  <c:v>5865.00439453125</c:v>
                </c:pt>
                <c:pt idx="104">
                  <c:v>5799.86328125</c:v>
                </c:pt>
                <c:pt idx="105">
                  <c:v>5783.87939453125</c:v>
                </c:pt>
                <c:pt idx="106">
                  <c:v>5821.939453125</c:v>
                </c:pt>
                <c:pt idx="107">
                  <c:v>5874.82275390625</c:v>
                </c:pt>
                <c:pt idx="108">
                  <c:v>5886.90673828125</c:v>
                </c:pt>
                <c:pt idx="109">
                  <c:v>5827.51806640625</c:v>
                </c:pt>
                <c:pt idx="110">
                  <c:v>5714.2158203125</c:v>
                </c:pt>
                <c:pt idx="111">
                  <c:v>5600.236328125</c:v>
                </c:pt>
                <c:pt idx="112">
                  <c:v>5536.494140625</c:v>
                </c:pt>
                <c:pt idx="113">
                  <c:v>5537.9609375</c:v>
                </c:pt>
                <c:pt idx="114">
                  <c:v>5579.4921875</c:v>
                </c:pt>
                <c:pt idx="115">
                  <c:v>5621.810546875</c:v>
                </c:pt>
                <c:pt idx="116">
                  <c:v>5644.685546875</c:v>
                </c:pt>
                <c:pt idx="117">
                  <c:v>5660.36279296875</c:v>
                </c:pt>
                <c:pt idx="118">
                  <c:v>5698.1025390625</c:v>
                </c:pt>
                <c:pt idx="119">
                  <c:v>5774.6728515625</c:v>
                </c:pt>
                <c:pt idx="120">
                  <c:v>5876.02734375</c:v>
                </c:pt>
                <c:pt idx="121">
                  <c:v>5964.73828125</c:v>
                </c:pt>
                <c:pt idx="122">
                  <c:v>6006.09033203125</c:v>
                </c:pt>
                <c:pt idx="123">
                  <c:v>5991.40380859375</c:v>
                </c:pt>
                <c:pt idx="124">
                  <c:v>5941.0302734375</c:v>
                </c:pt>
                <c:pt idx="125">
                  <c:v>5886.87646484375</c:v>
                </c:pt>
                <c:pt idx="126">
                  <c:v>5849.99365234375</c:v>
                </c:pt>
                <c:pt idx="127">
                  <c:v>5830.439453125</c:v>
                </c:pt>
                <c:pt idx="128">
                  <c:v>5814.6083984375</c:v>
                </c:pt>
                <c:pt idx="129">
                  <c:v>5790.90966796875</c:v>
                </c:pt>
                <c:pt idx="130">
                  <c:v>5759.9375</c:v>
                </c:pt>
                <c:pt idx="131">
                  <c:v>5732.41064453125</c:v>
                </c:pt>
                <c:pt idx="132">
                  <c:v>5719.400390625</c:v>
                </c:pt>
                <c:pt idx="133">
                  <c:v>5724.56884765625</c:v>
                </c:pt>
                <c:pt idx="134">
                  <c:v>5743.962890625</c:v>
                </c:pt>
                <c:pt idx="135">
                  <c:v>5770.80908203125</c:v>
                </c:pt>
                <c:pt idx="136">
                  <c:v>5798.9013671875</c:v>
                </c:pt>
                <c:pt idx="137">
                  <c:v>5821.62255859375</c:v>
                </c:pt>
                <c:pt idx="138">
                  <c:v>5829.93212890625</c:v>
                </c:pt>
                <c:pt idx="139">
                  <c:v>5814.69873046875</c:v>
                </c:pt>
                <c:pt idx="140">
                  <c:v>5774.052734375</c:v>
                </c:pt>
                <c:pt idx="141">
                  <c:v>5719.7099609375</c:v>
                </c:pt>
                <c:pt idx="142">
                  <c:v>5674.67041015625</c:v>
                </c:pt>
                <c:pt idx="143">
                  <c:v>5660.98486328125</c:v>
                </c:pt>
                <c:pt idx="144">
                  <c:v>5685.39111328125</c:v>
                </c:pt>
                <c:pt idx="145">
                  <c:v>5734.11767578125</c:v>
                </c:pt>
                <c:pt idx="146">
                  <c:v>5782.02685546875</c:v>
                </c:pt>
                <c:pt idx="147">
                  <c:v>5809.86376953125</c:v>
                </c:pt>
                <c:pt idx="148">
                  <c:v>5816.375</c:v>
                </c:pt>
                <c:pt idx="149">
                  <c:v>5815.72021484375</c:v>
                </c:pt>
                <c:pt idx="150">
                  <c:v>5822.50390625</c:v>
                </c:pt>
                <c:pt idx="151">
                  <c:v>5837.08544921875</c:v>
                </c:pt>
                <c:pt idx="152">
                  <c:v>5843.8369140625</c:v>
                </c:pt>
                <c:pt idx="153">
                  <c:v>5824.40087890625</c:v>
                </c:pt>
                <c:pt idx="154">
                  <c:v>5775.3447265625</c:v>
                </c:pt>
                <c:pt idx="155">
                  <c:v>5715.4130859375</c:v>
                </c:pt>
                <c:pt idx="156">
                  <c:v>5675.4638671875</c:v>
                </c:pt>
                <c:pt idx="157">
                  <c:v>5677.9189453125</c:v>
                </c:pt>
                <c:pt idx="158">
                  <c:v>5721.10693359375</c:v>
                </c:pt>
                <c:pt idx="159">
                  <c:v>5780.38720703125</c:v>
                </c:pt>
                <c:pt idx="160">
                  <c:v>5825.24658203125</c:v>
                </c:pt>
                <c:pt idx="161">
                  <c:v>5839.65673828125</c:v>
                </c:pt>
                <c:pt idx="162">
                  <c:v>5831.00927734375</c:v>
                </c:pt>
                <c:pt idx="163">
                  <c:v>5821.98486328125</c:v>
                </c:pt>
                <c:pt idx="164">
                  <c:v>5832.3837890625</c:v>
                </c:pt>
                <c:pt idx="165">
                  <c:v>5864.517578125</c:v>
                </c:pt>
                <c:pt idx="166">
                  <c:v>5901.85107421875</c:v>
                </c:pt>
                <c:pt idx="167">
                  <c:v>5920.13134765625</c:v>
                </c:pt>
                <c:pt idx="168">
                  <c:v>5901.72216796875</c:v>
                </c:pt>
                <c:pt idx="169">
                  <c:v>5843.4404296875</c:v>
                </c:pt>
                <c:pt idx="170">
                  <c:v>5755.01025390625</c:v>
                </c:pt>
                <c:pt idx="171">
                  <c:v>5652.8408203125</c:v>
                </c:pt>
                <c:pt idx="172">
                  <c:v>5555.888671875</c:v>
                </c:pt>
                <c:pt idx="173">
                  <c:v>5485.765625</c:v>
                </c:pt>
                <c:pt idx="174">
                  <c:v>5466.89111328125</c:v>
                </c:pt>
                <c:pt idx="175">
                  <c:v>5520.70068359375</c:v>
                </c:pt>
                <c:pt idx="176">
                  <c:v>5652.96875</c:v>
                </c:pt>
                <c:pt idx="177">
                  <c:v>5841.3837890625</c:v>
                </c:pt>
                <c:pt idx="178">
                  <c:v>6034.390625</c:v>
                </c:pt>
                <c:pt idx="179">
                  <c:v>6167.53955078125</c:v>
                </c:pt>
                <c:pt idx="180">
                  <c:v>6192.2099609375</c:v>
                </c:pt>
                <c:pt idx="181">
                  <c:v>6101.40576171875</c:v>
                </c:pt>
                <c:pt idx="182">
                  <c:v>5936.2646484375</c:v>
                </c:pt>
                <c:pt idx="183">
                  <c:v>5767.06396484375</c:v>
                </c:pt>
                <c:pt idx="184">
                  <c:v>5657.9482421875</c:v>
                </c:pt>
                <c:pt idx="185">
                  <c:v>5635.2783203125</c:v>
                </c:pt>
                <c:pt idx="186">
                  <c:v>5677.9306640625</c:v>
                </c:pt>
                <c:pt idx="187">
                  <c:v>5734.67822265625</c:v>
                </c:pt>
                <c:pt idx="188">
                  <c:v>5757.31884765625</c:v>
                </c:pt>
                <c:pt idx="189">
                  <c:v>5729.1455078125</c:v>
                </c:pt>
                <c:pt idx="190">
                  <c:v>5672.2060546875</c:v>
                </c:pt>
                <c:pt idx="191">
                  <c:v>5630.67138671875</c:v>
                </c:pt>
                <c:pt idx="192">
                  <c:v>5642.07421875</c:v>
                </c:pt>
                <c:pt idx="193">
                  <c:v>5714.22998046875</c:v>
                </c:pt>
                <c:pt idx="194">
                  <c:v>5820.45751953125</c:v>
                </c:pt>
                <c:pt idx="195">
                  <c:v>5913.8466796875</c:v>
                </c:pt>
                <c:pt idx="196">
                  <c:v>5950.95166015625</c:v>
                </c:pt>
                <c:pt idx="197">
                  <c:v>5912.05126953125</c:v>
                </c:pt>
                <c:pt idx="198">
                  <c:v>5809.19921875</c:v>
                </c:pt>
                <c:pt idx="199">
                  <c:v>5680.4326171875</c:v>
                </c:pt>
                <c:pt idx="200">
                  <c:v>5574.1708984375</c:v>
                </c:pt>
                <c:pt idx="201">
                  <c:v>5530.310546875</c:v>
                </c:pt>
                <c:pt idx="202">
                  <c:v>5564.72216796875</c:v>
                </c:pt>
                <c:pt idx="203">
                  <c:v>5662.92724609375</c:v>
                </c:pt>
                <c:pt idx="204">
                  <c:v>5786.36669921875</c:v>
                </c:pt>
                <c:pt idx="205">
                  <c:v>5889.91943359375</c:v>
                </c:pt>
                <c:pt idx="206">
                  <c:v>5943.126953125</c:v>
                </c:pt>
                <c:pt idx="207">
                  <c:v>5943.76611328125</c:v>
                </c:pt>
                <c:pt idx="208">
                  <c:v>5915.1220703125</c:v>
                </c:pt>
                <c:pt idx="209">
                  <c:v>5887.89501953125</c:v>
                </c:pt>
                <c:pt idx="210">
                  <c:v>5878.46435546875</c:v>
                </c:pt>
                <c:pt idx="211">
                  <c:v>5878.97021484375</c:v>
                </c:pt>
                <c:pt idx="212">
                  <c:v>5866.99951171875</c:v>
                </c:pt>
                <c:pt idx="213">
                  <c:v>5827.91943359375</c:v>
                </c:pt>
                <c:pt idx="214">
                  <c:v>5772.06005859375</c:v>
                </c:pt>
                <c:pt idx="215">
                  <c:v>5731.4599609375</c:v>
                </c:pt>
                <c:pt idx="216">
                  <c:v>5736.2548828125</c:v>
                </c:pt>
                <c:pt idx="217">
                  <c:v>5787.89404296875</c:v>
                </c:pt>
                <c:pt idx="218">
                  <c:v>5851.23046875</c:v>
                </c:pt>
                <c:pt idx="219">
                  <c:v>5874.84130859375</c:v>
                </c:pt>
                <c:pt idx="220">
                  <c:v>5827.2900390625</c:v>
                </c:pt>
                <c:pt idx="221">
                  <c:v>5723.06103515625</c:v>
                </c:pt>
                <c:pt idx="222">
                  <c:v>5617.478515625</c:v>
                </c:pt>
                <c:pt idx="223">
                  <c:v>5571.9609375</c:v>
                </c:pt>
                <c:pt idx="224">
                  <c:v>5613.27587890625</c:v>
                </c:pt>
                <c:pt idx="225">
                  <c:v>5715.77392578125</c:v>
                </c:pt>
                <c:pt idx="226">
                  <c:v>5819.36279296875</c:v>
                </c:pt>
                <c:pt idx="227">
                  <c:v>5870.193359375</c:v>
                </c:pt>
                <c:pt idx="228">
                  <c:v>5855.03759765625</c:v>
                </c:pt>
                <c:pt idx="229">
                  <c:v>5805.8193359375</c:v>
                </c:pt>
                <c:pt idx="230">
                  <c:v>5773.0146484375</c:v>
                </c:pt>
                <c:pt idx="231">
                  <c:v>5788.50341796875</c:v>
                </c:pt>
                <c:pt idx="232">
                  <c:v>5844.12939453125</c:v>
                </c:pt>
                <c:pt idx="233">
                  <c:v>5899.0048828125</c:v>
                </c:pt>
                <c:pt idx="234">
                  <c:v>5907.78662109375</c:v>
                </c:pt>
                <c:pt idx="235">
                  <c:v>5849.44775390625</c:v>
                </c:pt>
                <c:pt idx="236">
                  <c:v>5738.927734375</c:v>
                </c:pt>
                <c:pt idx="237">
                  <c:v>5617.81201171875</c:v>
                </c:pt>
                <c:pt idx="238">
                  <c:v>5533.095703125</c:v>
                </c:pt>
                <c:pt idx="239">
                  <c:v>5516.95556640625</c:v>
                </c:pt>
                <c:pt idx="240">
                  <c:v>5575.70947265625</c:v>
                </c:pt>
                <c:pt idx="241">
                  <c:v>5689.3349609375</c:v>
                </c:pt>
                <c:pt idx="242">
                  <c:v>5819.42431640625</c:v>
                </c:pt>
                <c:pt idx="243">
                  <c:v>5923.09814453125</c:v>
                </c:pt>
                <c:pt idx="244">
                  <c:v>5969.57568359375</c:v>
                </c:pt>
                <c:pt idx="245">
                  <c:v>5953.3740234375</c:v>
                </c:pt>
                <c:pt idx="246">
                  <c:v>5896.53271484375</c:v>
                </c:pt>
                <c:pt idx="247">
                  <c:v>5836.21875</c:v>
                </c:pt>
                <c:pt idx="248">
                  <c:v>5803.26513671875</c:v>
                </c:pt>
                <c:pt idx="249">
                  <c:v>5805</c:v>
                </c:pt>
                <c:pt idx="250">
                  <c:v>5824.46044921875</c:v>
                </c:pt>
                <c:pt idx="251">
                  <c:v>5836.57373046875</c:v>
                </c:pt>
                <c:pt idx="252">
                  <c:v>5828.53857421875</c:v>
                </c:pt>
                <c:pt idx="253">
                  <c:v>5807.86279296875</c:v>
                </c:pt>
                <c:pt idx="254">
                  <c:v>5791.75830078125</c:v>
                </c:pt>
                <c:pt idx="255">
                  <c:v>5787.95361328125</c:v>
                </c:pt>
                <c:pt idx="256">
                  <c:v>5785.212890625</c:v>
                </c:pt>
                <c:pt idx="257">
                  <c:v>5763.685546875</c:v>
                </c:pt>
                <c:pt idx="258">
                  <c:v>5716.7861328125</c:v>
                </c:pt>
                <c:pt idx="259">
                  <c:v>5663.9443359375</c:v>
                </c:pt>
                <c:pt idx="260">
                  <c:v>5639.572265625</c:v>
                </c:pt>
                <c:pt idx="261">
                  <c:v>5664.52490234375</c:v>
                </c:pt>
                <c:pt idx="262">
                  <c:v>5724.27978515625</c:v>
                </c:pt>
                <c:pt idx="263">
                  <c:v>5775.82275390625</c:v>
                </c:pt>
                <c:pt idx="264">
                  <c:v>5782.087890625</c:v>
                </c:pt>
                <c:pt idx="265">
                  <c:v>5747.15087890625</c:v>
                </c:pt>
                <c:pt idx="266">
                  <c:v>5720.2470703125</c:v>
                </c:pt>
                <c:pt idx="267">
                  <c:v>5759.43994140625</c:v>
                </c:pt>
                <c:pt idx="268">
                  <c:v>5879.884765625</c:v>
                </c:pt>
                <c:pt idx="269">
                  <c:v>6028.74609375</c:v>
                </c:pt>
                <c:pt idx="270">
                  <c:v>6112.2373046875</c:v>
                </c:pt>
                <c:pt idx="271">
                  <c:v>6060.32861328125</c:v>
                </c:pt>
                <c:pt idx="272">
                  <c:v>5882.47021484375</c:v>
                </c:pt>
                <c:pt idx="273">
                  <c:v>5670.228515625</c:v>
                </c:pt>
                <c:pt idx="274">
                  <c:v>5540.4912109375</c:v>
                </c:pt>
                <c:pt idx="275">
                  <c:v>5557.86181640625</c:v>
                </c:pt>
                <c:pt idx="276">
                  <c:v>5691.96923828125</c:v>
                </c:pt>
                <c:pt idx="277">
                  <c:v>5840.66455078125</c:v>
                </c:pt>
                <c:pt idx="278">
                  <c:v>5901.89453125</c:v>
                </c:pt>
                <c:pt idx="279">
                  <c:v>5842.09228515625</c:v>
                </c:pt>
                <c:pt idx="280">
                  <c:v>5713.27197265625</c:v>
                </c:pt>
                <c:pt idx="281">
                  <c:v>5610.134765625</c:v>
                </c:pt>
                <c:pt idx="282">
                  <c:v>5601.6689453125</c:v>
                </c:pt>
                <c:pt idx="283">
                  <c:v>5686.916015625</c:v>
                </c:pt>
                <c:pt idx="284">
                  <c:v>5802.87109375</c:v>
                </c:pt>
                <c:pt idx="285">
                  <c:v>5873.0927734375</c:v>
                </c:pt>
                <c:pt idx="286">
                  <c:v>5859.02685546875</c:v>
                </c:pt>
                <c:pt idx="287">
                  <c:v>5779.60888671875</c:v>
                </c:pt>
                <c:pt idx="288">
                  <c:v>5691.48876953125</c:v>
                </c:pt>
                <c:pt idx="289">
                  <c:v>5649.38330078125</c:v>
                </c:pt>
                <c:pt idx="290">
                  <c:v>5674.6572265625</c:v>
                </c:pt>
                <c:pt idx="291">
                  <c:v>5748.6123046875</c:v>
                </c:pt>
                <c:pt idx="292">
                  <c:v>5828.2978515625</c:v>
                </c:pt>
                <c:pt idx="293">
                  <c:v>5871.33935546875</c:v>
                </c:pt>
                <c:pt idx="294">
                  <c:v>5856.64697265625</c:v>
                </c:pt>
                <c:pt idx="295">
                  <c:v>5793.99951171875</c:v>
                </c:pt>
                <c:pt idx="296">
                  <c:v>5720.32763671875</c:v>
                </c:pt>
                <c:pt idx="297">
                  <c:v>5683.12451171875</c:v>
                </c:pt>
                <c:pt idx="298">
                  <c:v>5715.53466796875</c:v>
                </c:pt>
                <c:pt idx="299">
                  <c:v>5814.4736328125</c:v>
                </c:pt>
                <c:pt idx="300">
                  <c:v>5936.72607421875</c:v>
                </c:pt>
                <c:pt idx="301">
                  <c:v>6020.8974609375</c:v>
                </c:pt>
                <c:pt idx="302">
                  <c:v>6025.67724609375</c:v>
                </c:pt>
                <c:pt idx="303">
                  <c:v>5959.1650390625</c:v>
                </c:pt>
                <c:pt idx="304">
                  <c:v>5875.216796875</c:v>
                </c:pt>
                <c:pt idx="305">
                  <c:v>5834.755859375</c:v>
                </c:pt>
                <c:pt idx="306">
                  <c:v>5858.2314453125</c:v>
                </c:pt>
                <c:pt idx="307">
                  <c:v>5906.51904296875</c:v>
                </c:pt>
                <c:pt idx="308">
                  <c:v>5908.91162109375</c:v>
                </c:pt>
                <c:pt idx="309">
                  <c:v>5820.08740234375</c:v>
                </c:pt>
                <c:pt idx="310">
                  <c:v>5662.09326171875</c:v>
                </c:pt>
                <c:pt idx="311">
                  <c:v>5515.6201171875</c:v>
                </c:pt>
                <c:pt idx="312">
                  <c:v>5463.65185546875</c:v>
                </c:pt>
                <c:pt idx="313">
                  <c:v>5529.80029296875</c:v>
                </c:pt>
                <c:pt idx="314">
                  <c:v>5660.41259765625</c:v>
                </c:pt>
                <c:pt idx="315">
                  <c:v>5766.03466796875</c:v>
                </c:pt>
                <c:pt idx="316">
                  <c:v>5789.8916015625</c:v>
                </c:pt>
                <c:pt idx="317">
                  <c:v>5748.19921875</c:v>
                </c:pt>
                <c:pt idx="318">
                  <c:v>5709.52099609375</c:v>
                </c:pt>
                <c:pt idx="319">
                  <c:v>5730.822265625</c:v>
                </c:pt>
                <c:pt idx="320">
                  <c:v>5804.6484375</c:v>
                </c:pt>
                <c:pt idx="321">
                  <c:v>5863.37890625</c:v>
                </c:pt>
                <c:pt idx="322">
                  <c:v>5838.61181640625</c:v>
                </c:pt>
                <c:pt idx="323">
                  <c:v>5726.00244140625</c:v>
                </c:pt>
                <c:pt idx="324">
                  <c:v>5599.025390625</c:v>
                </c:pt>
                <c:pt idx="325">
                  <c:v>5556.388671875</c:v>
                </c:pt>
                <c:pt idx="326">
                  <c:v>5643.71728515625</c:v>
                </c:pt>
                <c:pt idx="327">
                  <c:v>5813.703125</c:v>
                </c:pt>
                <c:pt idx="328">
                  <c:v>5959.33349609375</c:v>
                </c:pt>
                <c:pt idx="329">
                  <c:v>5995.3828125</c:v>
                </c:pt>
                <c:pt idx="330">
                  <c:v>5923.09130859375</c:v>
                </c:pt>
                <c:pt idx="331">
                  <c:v>5825.712890625</c:v>
                </c:pt>
                <c:pt idx="332">
                  <c:v>5798.56640625</c:v>
                </c:pt>
                <c:pt idx="333">
                  <c:v>5870.5791015625</c:v>
                </c:pt>
                <c:pt idx="334">
                  <c:v>5981.09326171875</c:v>
                </c:pt>
                <c:pt idx="335">
                  <c:v>6030.32763671875</c:v>
                </c:pt>
                <c:pt idx="336">
                  <c:v>5961.8037109375</c:v>
                </c:pt>
                <c:pt idx="337">
                  <c:v>5809.48583984375</c:v>
                </c:pt>
                <c:pt idx="338">
                  <c:v>5671.8828125</c:v>
                </c:pt>
                <c:pt idx="339">
                  <c:v>5634.9541015625</c:v>
                </c:pt>
                <c:pt idx="340">
                  <c:v>5706.35009765625</c:v>
                </c:pt>
                <c:pt idx="341">
                  <c:v>5812.77880859375</c:v>
                </c:pt>
                <c:pt idx="342">
                  <c:v>5860.3017578125</c:v>
                </c:pt>
                <c:pt idx="343">
                  <c:v>5807.50244140625</c:v>
                </c:pt>
                <c:pt idx="344">
                  <c:v>5693.75537109375</c:v>
                </c:pt>
                <c:pt idx="345">
                  <c:v>5603.4404296875</c:v>
                </c:pt>
                <c:pt idx="346">
                  <c:v>5598.529296875</c:v>
                </c:pt>
                <c:pt idx="347">
                  <c:v>5674.373046875</c:v>
                </c:pt>
                <c:pt idx="348">
                  <c:v>5770.77880859375</c:v>
                </c:pt>
                <c:pt idx="349">
                  <c:v>5824.05419921875</c:v>
                </c:pt>
              </c:numCache>
            </c:numRef>
          </c:yVal>
          <c:smooth val="1"/>
          <c:extLst>
            <c:ext xmlns:c16="http://schemas.microsoft.com/office/drawing/2014/chart" uri="{C3380CC4-5D6E-409C-BE32-E72D297353CC}">
              <c16:uniqueId val="{00000016-5429-4359-BD11-807CF8F8408D}"/>
            </c:ext>
          </c:extLst>
        </c:ser>
        <c:ser>
          <c:idx val="23"/>
          <c:order val="23"/>
          <c:tx>
            <c:strRef>
              <c:f>np_sub_003!$X$1</c:f>
              <c:strCache>
                <c:ptCount val="1"/>
                <c:pt idx="0">
                  <c:v>Coor_24</c:v>
                </c:pt>
              </c:strCache>
            </c:strRef>
          </c:tx>
          <c:spPr>
            <a:ln w="28575" cap="rnd">
              <a:solidFill>
                <a:schemeClr val="accent6">
                  <a:lumMod val="80000"/>
                </a:schemeClr>
              </a:solidFill>
              <a:round/>
            </a:ln>
            <a:effectLst/>
          </c:spPr>
          <c:marker>
            <c:symbol val="none"/>
          </c:marker>
          <c:yVal>
            <c:numRef>
              <c:f>np_sub_003!$X$2:$X$351</c:f>
              <c:numCache>
                <c:formatCode>0.00000000000_ </c:formatCode>
                <c:ptCount val="350"/>
                <c:pt idx="0">
                  <c:v>7533.25048828125</c:v>
                </c:pt>
                <c:pt idx="1">
                  <c:v>7539.5302734375</c:v>
                </c:pt>
                <c:pt idx="2">
                  <c:v>7512.74853515625</c:v>
                </c:pt>
                <c:pt idx="3">
                  <c:v>7462.9130859375</c:v>
                </c:pt>
                <c:pt idx="4">
                  <c:v>7421.59814453125</c:v>
                </c:pt>
                <c:pt idx="5">
                  <c:v>7420.23291015625</c:v>
                </c:pt>
                <c:pt idx="6">
                  <c:v>7464.6201171875</c:v>
                </c:pt>
                <c:pt idx="7">
                  <c:v>7526.42724609375</c:v>
                </c:pt>
                <c:pt idx="8">
                  <c:v>7560.79736328125</c:v>
                </c:pt>
                <c:pt idx="9">
                  <c:v>7538.71533203125</c:v>
                </c:pt>
                <c:pt idx="10">
                  <c:v>7469.82470703125</c:v>
                </c:pt>
                <c:pt idx="11">
                  <c:v>7397.3310546875</c:v>
                </c:pt>
                <c:pt idx="12">
                  <c:v>7367.765625</c:v>
                </c:pt>
                <c:pt idx="13">
                  <c:v>7398.16552734375</c:v>
                </c:pt>
                <c:pt idx="14">
                  <c:v>7465.5634765625</c:v>
                </c:pt>
                <c:pt idx="15">
                  <c:v>7526.2392578125</c:v>
                </c:pt>
                <c:pt idx="16">
                  <c:v>7548.814453125</c:v>
                </c:pt>
                <c:pt idx="17">
                  <c:v>7534.8798828125</c:v>
                </c:pt>
                <c:pt idx="18">
                  <c:v>7511.80029296875</c:v>
                </c:pt>
                <c:pt idx="19">
                  <c:v>7505.50634765625</c:v>
                </c:pt>
                <c:pt idx="20">
                  <c:v>7517.23095703125</c:v>
                </c:pt>
                <c:pt idx="21">
                  <c:v>7524.0185546875</c:v>
                </c:pt>
                <c:pt idx="22">
                  <c:v>7502.080078125</c:v>
                </c:pt>
                <c:pt idx="23">
                  <c:v>7452.2373046875</c:v>
                </c:pt>
                <c:pt idx="24">
                  <c:v>7404.55517578125</c:v>
                </c:pt>
                <c:pt idx="25">
                  <c:v>7396.63037109375</c:v>
                </c:pt>
                <c:pt idx="26">
                  <c:v>7442.46728515625</c:v>
                </c:pt>
                <c:pt idx="27">
                  <c:v>7517.595703125</c:v>
                </c:pt>
                <c:pt idx="28">
                  <c:v>7573.70849609375</c:v>
                </c:pt>
                <c:pt idx="29">
                  <c:v>7572.658203125</c:v>
                </c:pt>
                <c:pt idx="30">
                  <c:v>7514.1650390625</c:v>
                </c:pt>
                <c:pt idx="31">
                  <c:v>7436.43408203125</c:v>
                </c:pt>
                <c:pt idx="32">
                  <c:v>7389.76953125</c:v>
                </c:pt>
                <c:pt idx="33">
                  <c:v>7403.333984375</c:v>
                </c:pt>
                <c:pt idx="34">
                  <c:v>7468.88134765625</c:v>
                </c:pt>
                <c:pt idx="35">
                  <c:v>7550.81396484375</c:v>
                </c:pt>
                <c:pt idx="36">
                  <c:v>7611.91162109375</c:v>
                </c:pt>
                <c:pt idx="37">
                  <c:v>7634.37255859375</c:v>
                </c:pt>
                <c:pt idx="38">
                  <c:v>7622.7783203125</c:v>
                </c:pt>
                <c:pt idx="39">
                  <c:v>7591.6337890625</c:v>
                </c:pt>
                <c:pt idx="40">
                  <c:v>7551.33740234375</c:v>
                </c:pt>
                <c:pt idx="41">
                  <c:v>7504.451171875</c:v>
                </c:pt>
                <c:pt idx="42">
                  <c:v>7452.5458984375</c:v>
                </c:pt>
                <c:pt idx="43">
                  <c:v>7403.978515625</c:v>
                </c:pt>
                <c:pt idx="44">
                  <c:v>7373.2021484375</c:v>
                </c:pt>
                <c:pt idx="45">
                  <c:v>7371.423828125</c:v>
                </c:pt>
                <c:pt idx="46">
                  <c:v>7397.353515625</c:v>
                </c:pt>
                <c:pt idx="47">
                  <c:v>7437.14404296875</c:v>
                </c:pt>
                <c:pt idx="48">
                  <c:v>7474.25927734375</c:v>
                </c:pt>
                <c:pt idx="49">
                  <c:v>7500.88916015625</c:v>
                </c:pt>
                <c:pt idx="50">
                  <c:v>7520.98876953125</c:v>
                </c:pt>
                <c:pt idx="51">
                  <c:v>7542.5166015625</c:v>
                </c:pt>
                <c:pt idx="52">
                  <c:v>7566.1572265625</c:v>
                </c:pt>
                <c:pt idx="53">
                  <c:v>7581.1201171875</c:v>
                </c:pt>
                <c:pt idx="54">
                  <c:v>7572.46337890625</c:v>
                </c:pt>
                <c:pt idx="55">
                  <c:v>7534.24951171875</c:v>
                </c:pt>
                <c:pt idx="56">
                  <c:v>7477.4091796875</c:v>
                </c:pt>
                <c:pt idx="57">
                  <c:v>7425.17041015625</c:v>
                </c:pt>
                <c:pt idx="58">
                  <c:v>7398.87744140625</c:v>
                </c:pt>
                <c:pt idx="59">
                  <c:v>7404.69970703125</c:v>
                </c:pt>
                <c:pt idx="60">
                  <c:v>7430.9365234375</c:v>
                </c:pt>
                <c:pt idx="61">
                  <c:v>7457.3681640625</c:v>
                </c:pt>
                <c:pt idx="62">
                  <c:v>7469.205078125</c:v>
                </c:pt>
                <c:pt idx="63">
                  <c:v>7465.525390625</c:v>
                </c:pt>
                <c:pt idx="64">
                  <c:v>7457.0947265625</c:v>
                </c:pt>
                <c:pt idx="65">
                  <c:v>7456.56005859375</c:v>
                </c:pt>
                <c:pt idx="66">
                  <c:v>7468.8974609375</c:v>
                </c:pt>
                <c:pt idx="67">
                  <c:v>7488.6259765625</c:v>
                </c:pt>
                <c:pt idx="68">
                  <c:v>7504.64892578125</c:v>
                </c:pt>
                <c:pt idx="69">
                  <c:v>7508.39208984375</c:v>
                </c:pt>
                <c:pt idx="70">
                  <c:v>7499.5263671875</c:v>
                </c:pt>
                <c:pt idx="71">
                  <c:v>7486.03515625</c:v>
                </c:pt>
                <c:pt idx="72">
                  <c:v>7479.25634765625</c:v>
                </c:pt>
                <c:pt idx="73">
                  <c:v>7487.1884765625</c:v>
                </c:pt>
                <c:pt idx="74">
                  <c:v>7509.8544921875</c:v>
                </c:pt>
                <c:pt idx="75">
                  <c:v>7539.1640625</c:v>
                </c:pt>
                <c:pt idx="76">
                  <c:v>7563.369140625</c:v>
                </c:pt>
                <c:pt idx="77">
                  <c:v>7573.71044921875</c:v>
                </c:pt>
                <c:pt idx="78">
                  <c:v>7569.2509765625</c:v>
                </c:pt>
                <c:pt idx="79">
                  <c:v>7556.49267578125</c:v>
                </c:pt>
                <c:pt idx="80">
                  <c:v>7543.5458984375</c:v>
                </c:pt>
                <c:pt idx="81">
                  <c:v>7532.7978515625</c:v>
                </c:pt>
                <c:pt idx="82">
                  <c:v>7518.06787109375</c:v>
                </c:pt>
                <c:pt idx="83">
                  <c:v>7489.69921875</c:v>
                </c:pt>
                <c:pt idx="84">
                  <c:v>7444.8486328125</c:v>
                </c:pt>
                <c:pt idx="85">
                  <c:v>7394.9853515625</c:v>
                </c:pt>
                <c:pt idx="86">
                  <c:v>7363.09716796875</c:v>
                </c:pt>
                <c:pt idx="87">
                  <c:v>7370.23828125</c:v>
                </c:pt>
                <c:pt idx="88">
                  <c:v>7419.9365234375</c:v>
                </c:pt>
                <c:pt idx="89">
                  <c:v>7492.3525390625</c:v>
                </c:pt>
                <c:pt idx="90">
                  <c:v>7554.13037109375</c:v>
                </c:pt>
                <c:pt idx="91">
                  <c:v>7578.388671875</c:v>
                </c:pt>
                <c:pt idx="92">
                  <c:v>7560.9921875</c:v>
                </c:pt>
                <c:pt idx="93">
                  <c:v>7521.2880859375</c:v>
                </c:pt>
                <c:pt idx="94">
                  <c:v>7486.89697265625</c:v>
                </c:pt>
                <c:pt idx="95">
                  <c:v>7474.23779296875</c:v>
                </c:pt>
                <c:pt idx="96">
                  <c:v>7479.443359375</c:v>
                </c:pt>
                <c:pt idx="97">
                  <c:v>7485.70703125</c:v>
                </c:pt>
                <c:pt idx="98">
                  <c:v>7479.8212890625</c:v>
                </c:pt>
                <c:pt idx="99">
                  <c:v>7463.66796875</c:v>
                </c:pt>
                <c:pt idx="100">
                  <c:v>7451.4541015625</c:v>
                </c:pt>
                <c:pt idx="101">
                  <c:v>7456.02490234375</c:v>
                </c:pt>
                <c:pt idx="102">
                  <c:v>7476.8701171875</c:v>
                </c:pt>
                <c:pt idx="103">
                  <c:v>7500.4609375</c:v>
                </c:pt>
                <c:pt idx="104">
                  <c:v>7512.2412109375</c:v>
                </c:pt>
                <c:pt idx="105">
                  <c:v>7509.048828125</c:v>
                </c:pt>
                <c:pt idx="106">
                  <c:v>7500.4609375</c:v>
                </c:pt>
                <c:pt idx="107">
                  <c:v>7497.86572265625</c:v>
                </c:pt>
                <c:pt idx="108">
                  <c:v>7501.7626953125</c:v>
                </c:pt>
                <c:pt idx="109">
                  <c:v>7500.0224609375</c:v>
                </c:pt>
                <c:pt idx="110">
                  <c:v>7480.095703125</c:v>
                </c:pt>
                <c:pt idx="111">
                  <c:v>7444.6875</c:v>
                </c:pt>
                <c:pt idx="112">
                  <c:v>7415.5634765625</c:v>
                </c:pt>
                <c:pt idx="113">
                  <c:v>7419.15673828125</c:v>
                </c:pt>
                <c:pt idx="114">
                  <c:v>7463.70703125</c:v>
                </c:pt>
                <c:pt idx="115">
                  <c:v>7526.96435546875</c:v>
                </c:pt>
                <c:pt idx="116">
                  <c:v>7567.14453125</c:v>
                </c:pt>
                <c:pt idx="117">
                  <c:v>7551.7578125</c:v>
                </c:pt>
                <c:pt idx="118">
                  <c:v>7483.50048828125</c:v>
                </c:pt>
                <c:pt idx="119">
                  <c:v>7402.63525390625</c:v>
                </c:pt>
                <c:pt idx="120">
                  <c:v>7362.0458984375</c:v>
                </c:pt>
                <c:pt idx="121">
                  <c:v>7391.8291015625</c:v>
                </c:pt>
                <c:pt idx="122">
                  <c:v>7478.72265625</c:v>
                </c:pt>
                <c:pt idx="123">
                  <c:v>7575.11669921875</c:v>
                </c:pt>
                <c:pt idx="124">
                  <c:v>7630.8330078125</c:v>
                </c:pt>
                <c:pt idx="125">
                  <c:v>7624.734375</c:v>
                </c:pt>
                <c:pt idx="126">
                  <c:v>7574.44677734375</c:v>
                </c:pt>
                <c:pt idx="127">
                  <c:v>7519.3515625</c:v>
                </c:pt>
                <c:pt idx="128">
                  <c:v>7491.23486328125</c:v>
                </c:pt>
                <c:pt idx="129">
                  <c:v>7494.3291015625</c:v>
                </c:pt>
                <c:pt idx="130">
                  <c:v>7507.58837890625</c:v>
                </c:pt>
                <c:pt idx="131">
                  <c:v>7504.90869140625</c:v>
                </c:pt>
                <c:pt idx="132">
                  <c:v>7476.76318359375</c:v>
                </c:pt>
                <c:pt idx="133">
                  <c:v>7437.60107421875</c:v>
                </c:pt>
                <c:pt idx="134">
                  <c:v>7415.06005859375</c:v>
                </c:pt>
                <c:pt idx="135">
                  <c:v>7429.98388671875</c:v>
                </c:pt>
                <c:pt idx="136">
                  <c:v>7481.45263671875</c:v>
                </c:pt>
                <c:pt idx="137">
                  <c:v>7546.197265625</c:v>
                </c:pt>
                <c:pt idx="138">
                  <c:v>7591.75830078125</c:v>
                </c:pt>
                <c:pt idx="139">
                  <c:v>7594.61865234375</c:v>
                </c:pt>
                <c:pt idx="140">
                  <c:v>7552.71240234375</c:v>
                </c:pt>
                <c:pt idx="141">
                  <c:v>7485.89013671875</c:v>
                </c:pt>
                <c:pt idx="142">
                  <c:v>7424.779296875</c:v>
                </c:pt>
                <c:pt idx="143">
                  <c:v>7394.4267578125</c:v>
                </c:pt>
                <c:pt idx="144">
                  <c:v>7401.580078125</c:v>
                </c:pt>
                <c:pt idx="145">
                  <c:v>7432.58837890625</c:v>
                </c:pt>
                <c:pt idx="146">
                  <c:v>7463.177734375</c:v>
                </c:pt>
                <c:pt idx="147">
                  <c:v>7474.35693359375</c:v>
                </c:pt>
                <c:pt idx="148">
                  <c:v>7464.416015625</c:v>
                </c:pt>
                <c:pt idx="149">
                  <c:v>7448.8154296875</c:v>
                </c:pt>
                <c:pt idx="150">
                  <c:v>7447.654296875</c:v>
                </c:pt>
                <c:pt idx="151">
                  <c:v>7469.47412109375</c:v>
                </c:pt>
                <c:pt idx="152">
                  <c:v>7503.6201171875</c:v>
                </c:pt>
                <c:pt idx="153">
                  <c:v>7527.6533203125</c:v>
                </c:pt>
                <c:pt idx="154">
                  <c:v>7524.8447265625</c:v>
                </c:pt>
                <c:pt idx="155">
                  <c:v>7498.2470703125</c:v>
                </c:pt>
                <c:pt idx="156">
                  <c:v>7469.6142578125</c:v>
                </c:pt>
                <c:pt idx="157">
                  <c:v>7463.0234375</c:v>
                </c:pt>
                <c:pt idx="158">
                  <c:v>7485.63330078125</c:v>
                </c:pt>
                <c:pt idx="159">
                  <c:v>7521.173828125</c:v>
                </c:pt>
                <c:pt idx="160">
                  <c:v>7542.130859375</c:v>
                </c:pt>
                <c:pt idx="161">
                  <c:v>7531.49560546875</c:v>
                </c:pt>
                <c:pt idx="162">
                  <c:v>7496.6962890625</c:v>
                </c:pt>
                <c:pt idx="163">
                  <c:v>7464.20166015625</c:v>
                </c:pt>
                <c:pt idx="164">
                  <c:v>7458.86181640625</c:v>
                </c:pt>
                <c:pt idx="165">
                  <c:v>7484.61767578125</c:v>
                </c:pt>
                <c:pt idx="166">
                  <c:v>7522.12353515625</c:v>
                </c:pt>
                <c:pt idx="167">
                  <c:v>7544.8232421875</c:v>
                </c:pt>
                <c:pt idx="168">
                  <c:v>7539.779296875</c:v>
                </c:pt>
                <c:pt idx="169">
                  <c:v>7515.98779296875</c:v>
                </c:pt>
                <c:pt idx="170">
                  <c:v>7494.0126953125</c:v>
                </c:pt>
                <c:pt idx="171">
                  <c:v>7486.94384765625</c:v>
                </c:pt>
                <c:pt idx="172">
                  <c:v>7489.85546875</c:v>
                </c:pt>
                <c:pt idx="173">
                  <c:v>7486.908203125</c:v>
                </c:pt>
                <c:pt idx="174">
                  <c:v>7469.09130859375</c:v>
                </c:pt>
                <c:pt idx="175">
                  <c:v>7445.68994140625</c:v>
                </c:pt>
                <c:pt idx="176">
                  <c:v>7437.95703125</c:v>
                </c:pt>
                <c:pt idx="177">
                  <c:v>7459.634765625</c:v>
                </c:pt>
                <c:pt idx="178">
                  <c:v>7501.62939453125</c:v>
                </c:pt>
                <c:pt idx="179">
                  <c:v>7535.6552734375</c:v>
                </c:pt>
                <c:pt idx="180">
                  <c:v>7535.58984375</c:v>
                </c:pt>
                <c:pt idx="181">
                  <c:v>7499.32958984375</c:v>
                </c:pt>
                <c:pt idx="182">
                  <c:v>7452.32275390625</c:v>
                </c:pt>
                <c:pt idx="183">
                  <c:v>7428.7001953125</c:v>
                </c:pt>
                <c:pt idx="184">
                  <c:v>7444.83935546875</c:v>
                </c:pt>
                <c:pt idx="185">
                  <c:v>7487.0009765625</c:v>
                </c:pt>
                <c:pt idx="186">
                  <c:v>7523.212890625</c:v>
                </c:pt>
                <c:pt idx="187">
                  <c:v>7529.3955078125</c:v>
                </c:pt>
                <c:pt idx="188">
                  <c:v>7507.88427734375</c:v>
                </c:pt>
                <c:pt idx="189">
                  <c:v>7483.251953125</c:v>
                </c:pt>
                <c:pt idx="190">
                  <c:v>7479.78564453125</c:v>
                </c:pt>
                <c:pt idx="191">
                  <c:v>7500.443359375</c:v>
                </c:pt>
                <c:pt idx="192">
                  <c:v>7525.35400390625</c:v>
                </c:pt>
                <c:pt idx="193">
                  <c:v>7530.59912109375</c:v>
                </c:pt>
                <c:pt idx="194">
                  <c:v>7510.275390625</c:v>
                </c:pt>
                <c:pt idx="195">
                  <c:v>7482.1875</c:v>
                </c:pt>
                <c:pt idx="196">
                  <c:v>7472.10400390625</c:v>
                </c:pt>
                <c:pt idx="197">
                  <c:v>7490.5400390625</c:v>
                </c:pt>
                <c:pt idx="198">
                  <c:v>7522.72998046875</c:v>
                </c:pt>
                <c:pt idx="199">
                  <c:v>7540.9130859375</c:v>
                </c:pt>
                <c:pt idx="200">
                  <c:v>7528.3525390625</c:v>
                </c:pt>
                <c:pt idx="201">
                  <c:v>7493.97900390625</c:v>
                </c:pt>
                <c:pt idx="202">
                  <c:v>7464.53955078125</c:v>
                </c:pt>
                <c:pt idx="203">
                  <c:v>7460.8056640625</c:v>
                </c:pt>
                <c:pt idx="204">
                  <c:v>7478.5791015625</c:v>
                </c:pt>
                <c:pt idx="205">
                  <c:v>7491.43505859375</c:v>
                </c:pt>
                <c:pt idx="206">
                  <c:v>7473.46142578125</c:v>
                </c:pt>
                <c:pt idx="207">
                  <c:v>7422.79541015625</c:v>
                </c:pt>
                <c:pt idx="208">
                  <c:v>7365.71337890625</c:v>
                </c:pt>
                <c:pt idx="209">
                  <c:v>7337.390625</c:v>
                </c:pt>
                <c:pt idx="210">
                  <c:v>7355.21923828125</c:v>
                </c:pt>
                <c:pt idx="211">
                  <c:v>7406.7275390625</c:v>
                </c:pt>
                <c:pt idx="212">
                  <c:v>7461.5283203125</c:v>
                </c:pt>
                <c:pt idx="213">
                  <c:v>7496.25830078125</c:v>
                </c:pt>
                <c:pt idx="214">
                  <c:v>7510.88818359375</c:v>
                </c:pt>
                <c:pt idx="215">
                  <c:v>7523.0244140625</c:v>
                </c:pt>
                <c:pt idx="216">
                  <c:v>7546.58740234375</c:v>
                </c:pt>
                <c:pt idx="217">
                  <c:v>7575.13623046875</c:v>
                </c:pt>
                <c:pt idx="218">
                  <c:v>7585.95068359375</c:v>
                </c:pt>
                <c:pt idx="219">
                  <c:v>7562.271484375</c:v>
                </c:pt>
                <c:pt idx="220">
                  <c:v>7514.05908203125</c:v>
                </c:pt>
                <c:pt idx="221">
                  <c:v>7477.36669921875</c:v>
                </c:pt>
                <c:pt idx="222">
                  <c:v>7489.71142578125</c:v>
                </c:pt>
                <c:pt idx="223">
                  <c:v>7559.4619140625</c:v>
                </c:pt>
                <c:pt idx="224">
                  <c:v>7653.83642578125</c:v>
                </c:pt>
                <c:pt idx="225">
                  <c:v>7716.73974609375</c:v>
                </c:pt>
                <c:pt idx="226">
                  <c:v>7704.783203125</c:v>
                </c:pt>
                <c:pt idx="227">
                  <c:v>7615.7197265625</c:v>
                </c:pt>
                <c:pt idx="228">
                  <c:v>7489.19775390625</c:v>
                </c:pt>
                <c:pt idx="229">
                  <c:v>7380.37353515625</c:v>
                </c:pt>
                <c:pt idx="230">
                  <c:v>7326.21142578125</c:v>
                </c:pt>
                <c:pt idx="231">
                  <c:v>7327.77294921875</c:v>
                </c:pt>
                <c:pt idx="232">
                  <c:v>7358.10986328125</c:v>
                </c:pt>
                <c:pt idx="233">
                  <c:v>7386.29296875</c:v>
                </c:pt>
                <c:pt idx="234">
                  <c:v>7398.353515625</c:v>
                </c:pt>
                <c:pt idx="235">
                  <c:v>7401.484375</c:v>
                </c:pt>
                <c:pt idx="236">
                  <c:v>7412.32568359375</c:v>
                </c:pt>
                <c:pt idx="237">
                  <c:v>7441.3505859375</c:v>
                </c:pt>
                <c:pt idx="238">
                  <c:v>7485.45263671875</c:v>
                </c:pt>
                <c:pt idx="239">
                  <c:v>7531.8779296875</c:v>
                </c:pt>
                <c:pt idx="240">
                  <c:v>7567.45166015625</c:v>
                </c:pt>
                <c:pt idx="241">
                  <c:v>7584.84619140625</c:v>
                </c:pt>
                <c:pt idx="242">
                  <c:v>7582.6337890625</c:v>
                </c:pt>
                <c:pt idx="243">
                  <c:v>7562.18359375</c:v>
                </c:pt>
                <c:pt idx="244">
                  <c:v>7526.271484375</c:v>
                </c:pt>
                <c:pt idx="245">
                  <c:v>7480.82421875</c:v>
                </c:pt>
                <c:pt idx="246">
                  <c:v>7436.763671875</c:v>
                </c:pt>
                <c:pt idx="247">
                  <c:v>7408.056640625</c:v>
                </c:pt>
                <c:pt idx="248">
                  <c:v>7405.513671875</c:v>
                </c:pt>
                <c:pt idx="249">
                  <c:v>7430.1962890625</c:v>
                </c:pt>
                <c:pt idx="250">
                  <c:v>7471.35693359375</c:v>
                </c:pt>
                <c:pt idx="251">
                  <c:v>7510.81201171875</c:v>
                </c:pt>
                <c:pt idx="252">
                  <c:v>7531.265625</c:v>
                </c:pt>
                <c:pt idx="253">
                  <c:v>7523.92626953125</c:v>
                </c:pt>
                <c:pt idx="254">
                  <c:v>7491.9404296875</c:v>
                </c:pt>
                <c:pt idx="255">
                  <c:v>7448.9599609375</c:v>
                </c:pt>
                <c:pt idx="256">
                  <c:v>7414.08544921875</c:v>
                </c:pt>
                <c:pt idx="257">
                  <c:v>7404.810546875</c:v>
                </c:pt>
                <c:pt idx="258">
                  <c:v>7429.67333984375</c:v>
                </c:pt>
                <c:pt idx="259">
                  <c:v>7483.13916015625</c:v>
                </c:pt>
                <c:pt idx="260">
                  <c:v>7545.98779296875</c:v>
                </c:pt>
                <c:pt idx="261">
                  <c:v>7593.04248046875</c:v>
                </c:pt>
                <c:pt idx="262">
                  <c:v>7605.79248046875</c:v>
                </c:pt>
                <c:pt idx="263">
                  <c:v>7582.9296875</c:v>
                </c:pt>
                <c:pt idx="264">
                  <c:v>7541.26171875</c:v>
                </c:pt>
                <c:pt idx="265">
                  <c:v>7504.94140625</c:v>
                </c:pt>
                <c:pt idx="266">
                  <c:v>7489.4609375</c:v>
                </c:pt>
                <c:pt idx="267">
                  <c:v>7491.78955078125</c:v>
                </c:pt>
                <c:pt idx="268">
                  <c:v>7494.578125</c:v>
                </c:pt>
                <c:pt idx="269">
                  <c:v>7481.98046875</c:v>
                </c:pt>
                <c:pt idx="270">
                  <c:v>7455.041015625</c:v>
                </c:pt>
                <c:pt idx="271">
                  <c:v>7433.80322265625</c:v>
                </c:pt>
                <c:pt idx="272">
                  <c:v>7442.92236328125</c:v>
                </c:pt>
                <c:pt idx="273">
                  <c:v>7490.77734375</c:v>
                </c:pt>
                <c:pt idx="274">
                  <c:v>7558.3857421875</c:v>
                </c:pt>
                <c:pt idx="275">
                  <c:v>7608.2197265625</c:v>
                </c:pt>
                <c:pt idx="276">
                  <c:v>7608.29150390625</c:v>
                </c:pt>
                <c:pt idx="277">
                  <c:v>7554.7421875</c:v>
                </c:pt>
                <c:pt idx="278">
                  <c:v>7476.234375</c:v>
                </c:pt>
                <c:pt idx="279">
                  <c:v>7416.14111328125</c:v>
                </c:pt>
                <c:pt idx="280">
                  <c:v>7404.5712890625</c:v>
                </c:pt>
                <c:pt idx="281">
                  <c:v>7439.65185546875</c:v>
                </c:pt>
                <c:pt idx="282">
                  <c:v>7490.75244140625</c:v>
                </c:pt>
                <c:pt idx="283">
                  <c:v>7520.58447265625</c:v>
                </c:pt>
                <c:pt idx="284">
                  <c:v>7510.06494140625</c:v>
                </c:pt>
                <c:pt idx="285">
                  <c:v>7468.8408203125</c:v>
                </c:pt>
                <c:pt idx="286">
                  <c:v>7425.52392578125</c:v>
                </c:pt>
                <c:pt idx="287">
                  <c:v>7406.25927734375</c:v>
                </c:pt>
                <c:pt idx="288">
                  <c:v>7417.615234375</c:v>
                </c:pt>
                <c:pt idx="289">
                  <c:v>7445.20654296875</c:v>
                </c:pt>
                <c:pt idx="290">
                  <c:v>7467.19970703125</c:v>
                </c:pt>
                <c:pt idx="291">
                  <c:v>7471.310546875</c:v>
                </c:pt>
                <c:pt idx="292">
                  <c:v>7462.494140625</c:v>
                </c:pt>
                <c:pt idx="293">
                  <c:v>7456.49365234375</c:v>
                </c:pt>
                <c:pt idx="294">
                  <c:v>7465.31005859375</c:v>
                </c:pt>
                <c:pt idx="295">
                  <c:v>7486.40380859375</c:v>
                </c:pt>
                <c:pt idx="296">
                  <c:v>7504.1943359375</c:v>
                </c:pt>
                <c:pt idx="297">
                  <c:v>7502.85498046875</c:v>
                </c:pt>
                <c:pt idx="298">
                  <c:v>7480.6552734375</c:v>
                </c:pt>
                <c:pt idx="299">
                  <c:v>7454.439453125</c:v>
                </c:pt>
                <c:pt idx="300">
                  <c:v>7449.611328125</c:v>
                </c:pt>
                <c:pt idx="301">
                  <c:v>7481.6123046875</c:v>
                </c:pt>
                <c:pt idx="302">
                  <c:v>7541.92626953125</c:v>
                </c:pt>
                <c:pt idx="303">
                  <c:v>7599.765625</c:v>
                </c:pt>
                <c:pt idx="304">
                  <c:v>7620.38037109375</c:v>
                </c:pt>
                <c:pt idx="305">
                  <c:v>7588.8544921875</c:v>
                </c:pt>
                <c:pt idx="306">
                  <c:v>7522.869140625</c:v>
                </c:pt>
                <c:pt idx="307">
                  <c:v>7463.8701171875</c:v>
                </c:pt>
                <c:pt idx="308">
                  <c:v>7450.45068359375</c:v>
                </c:pt>
                <c:pt idx="309">
                  <c:v>7491.06689453125</c:v>
                </c:pt>
                <c:pt idx="310">
                  <c:v>7555.59521484375</c:v>
                </c:pt>
                <c:pt idx="311">
                  <c:v>7593.646484375</c:v>
                </c:pt>
                <c:pt idx="312">
                  <c:v>7568.978515625</c:v>
                </c:pt>
                <c:pt idx="313">
                  <c:v>7486.70849609375</c:v>
                </c:pt>
                <c:pt idx="314">
                  <c:v>7393.2373046875</c:v>
                </c:pt>
                <c:pt idx="315">
                  <c:v>7346.98681640625</c:v>
                </c:pt>
                <c:pt idx="316">
                  <c:v>7378.95166015625</c:v>
                </c:pt>
                <c:pt idx="317">
                  <c:v>7470.513671875</c:v>
                </c:pt>
                <c:pt idx="318">
                  <c:v>7564.8798828125</c:v>
                </c:pt>
                <c:pt idx="319">
                  <c:v>7605.00048828125</c:v>
                </c:pt>
                <c:pt idx="320">
                  <c:v>7571.646484375</c:v>
                </c:pt>
                <c:pt idx="321">
                  <c:v>7494.79638671875</c:v>
                </c:pt>
                <c:pt idx="322">
                  <c:v>7430.47705078125</c:v>
                </c:pt>
                <c:pt idx="323">
                  <c:v>7420.119140625</c:v>
                </c:pt>
                <c:pt idx="324">
                  <c:v>7461.97607421875</c:v>
                </c:pt>
                <c:pt idx="325">
                  <c:v>7514.94873046875</c:v>
                </c:pt>
                <c:pt idx="326">
                  <c:v>7531.1103515625</c:v>
                </c:pt>
                <c:pt idx="327">
                  <c:v>7492.3017578125</c:v>
                </c:pt>
                <c:pt idx="328">
                  <c:v>7423.75634765625</c:v>
                </c:pt>
                <c:pt idx="329">
                  <c:v>7375.30908203125</c:v>
                </c:pt>
                <c:pt idx="330">
                  <c:v>7384.767578125</c:v>
                </c:pt>
                <c:pt idx="331">
                  <c:v>7450.58740234375</c:v>
                </c:pt>
                <c:pt idx="332">
                  <c:v>7533.24072265625</c:v>
                </c:pt>
                <c:pt idx="333">
                  <c:v>7583.16259765625</c:v>
                </c:pt>
                <c:pt idx="334">
                  <c:v>7574.26123046875</c:v>
                </c:pt>
                <c:pt idx="335">
                  <c:v>7519.33154296875</c:v>
                </c:pt>
                <c:pt idx="336">
                  <c:v>7458.0986328125</c:v>
                </c:pt>
                <c:pt idx="337">
                  <c:v>7428.47802734375</c:v>
                </c:pt>
                <c:pt idx="338">
                  <c:v>7442.28466796875</c:v>
                </c:pt>
                <c:pt idx="339">
                  <c:v>7481.3017578125</c:v>
                </c:pt>
                <c:pt idx="340">
                  <c:v>7513.8212890625</c:v>
                </c:pt>
                <c:pt idx="341">
                  <c:v>7517.7646484375</c:v>
                </c:pt>
                <c:pt idx="342">
                  <c:v>7493.9365234375</c:v>
                </c:pt>
                <c:pt idx="343">
                  <c:v>7462.078125</c:v>
                </c:pt>
                <c:pt idx="344">
                  <c:v>7445.10302734375</c:v>
                </c:pt>
                <c:pt idx="345">
                  <c:v>7453.8759765625</c:v>
                </c:pt>
                <c:pt idx="346">
                  <c:v>7482.30029296875</c:v>
                </c:pt>
                <c:pt idx="347">
                  <c:v>7513.8681640625</c:v>
                </c:pt>
                <c:pt idx="348">
                  <c:v>7533.21630859375</c:v>
                </c:pt>
                <c:pt idx="349">
                  <c:v>7534.4951171875</c:v>
                </c:pt>
              </c:numCache>
            </c:numRef>
          </c:yVal>
          <c:smooth val="1"/>
          <c:extLst>
            <c:ext xmlns:c16="http://schemas.microsoft.com/office/drawing/2014/chart" uri="{C3380CC4-5D6E-409C-BE32-E72D297353CC}">
              <c16:uniqueId val="{00000017-5429-4359-BD11-807CF8F8408D}"/>
            </c:ext>
          </c:extLst>
        </c:ser>
        <c:ser>
          <c:idx val="24"/>
          <c:order val="24"/>
          <c:tx>
            <c:strRef>
              <c:f>np_sub_003!$Y$1</c:f>
              <c:strCache>
                <c:ptCount val="1"/>
                <c:pt idx="0">
                  <c:v>Coor_25</c:v>
                </c:pt>
              </c:strCache>
            </c:strRef>
          </c:tx>
          <c:spPr>
            <a:ln w="28575" cap="rnd">
              <a:solidFill>
                <a:schemeClr val="accent1">
                  <a:lumMod val="60000"/>
                  <a:lumOff val="40000"/>
                </a:schemeClr>
              </a:solidFill>
              <a:round/>
            </a:ln>
            <a:effectLst/>
          </c:spPr>
          <c:marker>
            <c:symbol val="none"/>
          </c:marker>
          <c:yVal>
            <c:numRef>
              <c:f>np_sub_003!$Y$2:$Y$351</c:f>
              <c:numCache>
                <c:formatCode>0.00000000000_ </c:formatCode>
                <c:ptCount val="350"/>
                <c:pt idx="0">
                  <c:v>7035.9970703125</c:v>
                </c:pt>
                <c:pt idx="1">
                  <c:v>7043.94140625</c:v>
                </c:pt>
                <c:pt idx="2">
                  <c:v>7057.52783203125</c:v>
                </c:pt>
                <c:pt idx="3">
                  <c:v>7077.73291015625</c:v>
                </c:pt>
                <c:pt idx="4">
                  <c:v>7094.341796875</c:v>
                </c:pt>
                <c:pt idx="5">
                  <c:v>7092.583984375</c:v>
                </c:pt>
                <c:pt idx="6">
                  <c:v>7064.818359375</c:v>
                </c:pt>
                <c:pt idx="7">
                  <c:v>7017.3681640625</c:v>
                </c:pt>
                <c:pt idx="8">
                  <c:v>6966.52197265625</c:v>
                </c:pt>
                <c:pt idx="9">
                  <c:v>6927.04736328125</c:v>
                </c:pt>
                <c:pt idx="10">
                  <c:v>6903.11474609375</c:v>
                </c:pt>
                <c:pt idx="11">
                  <c:v>6889.34619140625</c:v>
                </c:pt>
                <c:pt idx="12">
                  <c:v>6880.49853515625</c:v>
                </c:pt>
                <c:pt idx="13">
                  <c:v>6880.12109375</c:v>
                </c:pt>
                <c:pt idx="14">
                  <c:v>6898.91455078125</c:v>
                </c:pt>
                <c:pt idx="15">
                  <c:v>6942.67822265625</c:v>
                </c:pt>
                <c:pt idx="16">
                  <c:v>7000.01953125</c:v>
                </c:pt>
                <c:pt idx="17">
                  <c:v>7042.24951171875</c:v>
                </c:pt>
                <c:pt idx="18">
                  <c:v>7039.20166015625</c:v>
                </c:pt>
                <c:pt idx="19">
                  <c:v>6981.51953125</c:v>
                </c:pt>
                <c:pt idx="20">
                  <c:v>6892.85009765625</c:v>
                </c:pt>
                <c:pt idx="21">
                  <c:v>6820.8173828125</c:v>
                </c:pt>
                <c:pt idx="22">
                  <c:v>6810.26513671875</c:v>
                </c:pt>
                <c:pt idx="23">
                  <c:v>6875.3935546875</c:v>
                </c:pt>
                <c:pt idx="24">
                  <c:v>6989.2490234375</c:v>
                </c:pt>
                <c:pt idx="25">
                  <c:v>7097.9716796875</c:v>
                </c:pt>
                <c:pt idx="26">
                  <c:v>7151.09814453125</c:v>
                </c:pt>
                <c:pt idx="27">
                  <c:v>7129.2265625</c:v>
                </c:pt>
                <c:pt idx="28">
                  <c:v>7052.82373046875</c:v>
                </c:pt>
                <c:pt idx="29">
                  <c:v>6968.376953125</c:v>
                </c:pt>
                <c:pt idx="30">
                  <c:v>6921.685546875</c:v>
                </c:pt>
                <c:pt idx="31">
                  <c:v>6934.26611328125</c:v>
                </c:pt>
                <c:pt idx="32">
                  <c:v>6995.02587890625</c:v>
                </c:pt>
                <c:pt idx="33">
                  <c:v>7069.404296875</c:v>
                </c:pt>
                <c:pt idx="34">
                  <c:v>7118.8291015625</c:v>
                </c:pt>
                <c:pt idx="35">
                  <c:v>7119.494140625</c:v>
                </c:pt>
                <c:pt idx="36">
                  <c:v>7071.78564453125</c:v>
                </c:pt>
                <c:pt idx="37">
                  <c:v>6997.517578125</c:v>
                </c:pt>
                <c:pt idx="38">
                  <c:v>6927.98095703125</c:v>
                </c:pt>
                <c:pt idx="39">
                  <c:v>6889.2255859375</c:v>
                </c:pt>
                <c:pt idx="40">
                  <c:v>6891.29638671875</c:v>
                </c:pt>
                <c:pt idx="41">
                  <c:v>6925.70068359375</c:v>
                </c:pt>
                <c:pt idx="42">
                  <c:v>6971.416015625</c:v>
                </c:pt>
                <c:pt idx="43">
                  <c:v>7005.9287109375</c:v>
                </c:pt>
                <c:pt idx="44">
                  <c:v>7015.7265625</c:v>
                </c:pt>
                <c:pt idx="45">
                  <c:v>7001.38134765625</c:v>
                </c:pt>
                <c:pt idx="46">
                  <c:v>6975.369140625</c:v>
                </c:pt>
                <c:pt idx="47">
                  <c:v>6954.4013671875</c:v>
                </c:pt>
                <c:pt idx="48">
                  <c:v>6950.44140625</c:v>
                </c:pt>
                <c:pt idx="49">
                  <c:v>6964.763671875</c:v>
                </c:pt>
                <c:pt idx="50">
                  <c:v>6987.70849609375</c:v>
                </c:pt>
                <c:pt idx="51">
                  <c:v>7004.2041015625</c:v>
                </c:pt>
                <c:pt idx="52">
                  <c:v>7002.5771484375</c:v>
                </c:pt>
                <c:pt idx="53">
                  <c:v>6982.35400390625</c:v>
                </c:pt>
                <c:pt idx="54">
                  <c:v>6956.41796875</c:v>
                </c:pt>
                <c:pt idx="55">
                  <c:v>6944.94287109375</c:v>
                </c:pt>
                <c:pt idx="56">
                  <c:v>6962.9423828125</c:v>
                </c:pt>
                <c:pt idx="57">
                  <c:v>7008.1748046875</c:v>
                </c:pt>
                <c:pt idx="58">
                  <c:v>7058.009765625</c:v>
                </c:pt>
                <c:pt idx="59">
                  <c:v>7079.89208984375</c:v>
                </c:pt>
                <c:pt idx="60">
                  <c:v>7051.31103515625</c:v>
                </c:pt>
                <c:pt idx="61">
                  <c:v>6977.07275390625</c:v>
                </c:pt>
                <c:pt idx="62">
                  <c:v>6890.92431640625</c:v>
                </c:pt>
                <c:pt idx="63">
                  <c:v>6837.60107421875</c:v>
                </c:pt>
                <c:pt idx="64">
                  <c:v>6845.19384765625</c:v>
                </c:pt>
                <c:pt idx="65">
                  <c:v>6906.29736328125</c:v>
                </c:pt>
                <c:pt idx="66">
                  <c:v>6982.13818359375</c:v>
                </c:pt>
                <c:pt idx="67">
                  <c:v>7028.26806640625</c:v>
                </c:pt>
                <c:pt idx="68">
                  <c:v>7024.37060546875</c:v>
                </c:pt>
                <c:pt idx="69">
                  <c:v>6986.7421875</c:v>
                </c:pt>
                <c:pt idx="70">
                  <c:v>6954.2236328125</c:v>
                </c:pt>
                <c:pt idx="71">
                  <c:v>6958.19921875</c:v>
                </c:pt>
                <c:pt idx="72">
                  <c:v>6999.5166015625</c:v>
                </c:pt>
                <c:pt idx="73">
                  <c:v>7049.759765625</c:v>
                </c:pt>
                <c:pt idx="74">
                  <c:v>7075.03369140625</c:v>
                </c:pt>
                <c:pt idx="75">
                  <c:v>7062.57373046875</c:v>
                </c:pt>
                <c:pt idx="76">
                  <c:v>7028.62939453125</c:v>
                </c:pt>
                <c:pt idx="77">
                  <c:v>7001.9716796875</c:v>
                </c:pt>
                <c:pt idx="78">
                  <c:v>6997.96826171875</c:v>
                </c:pt>
                <c:pt idx="79">
                  <c:v>7006.1181640625</c:v>
                </c:pt>
                <c:pt idx="80">
                  <c:v>7002.15673828125</c:v>
                </c:pt>
                <c:pt idx="81">
                  <c:v>6974.013671875</c:v>
                </c:pt>
                <c:pt idx="82">
                  <c:v>6937.7724609375</c:v>
                </c:pt>
                <c:pt idx="83">
                  <c:v>6927.3759765625</c:v>
                </c:pt>
                <c:pt idx="84">
                  <c:v>6964.57275390625</c:v>
                </c:pt>
                <c:pt idx="85">
                  <c:v>7034.4306640625</c:v>
                </c:pt>
                <c:pt idx="86">
                  <c:v>7089.6123046875</c:v>
                </c:pt>
                <c:pt idx="87">
                  <c:v>7083.84619140625</c:v>
                </c:pt>
                <c:pt idx="88">
                  <c:v>7009.64892578125</c:v>
                </c:pt>
                <c:pt idx="89">
                  <c:v>6909.123046875</c:v>
                </c:pt>
                <c:pt idx="90">
                  <c:v>6846.26611328125</c:v>
                </c:pt>
                <c:pt idx="91">
                  <c:v>6860.05615234375</c:v>
                </c:pt>
                <c:pt idx="92">
                  <c:v>6934.525390625</c:v>
                </c:pt>
                <c:pt idx="93">
                  <c:v>7010.3525390625</c:v>
                </c:pt>
                <c:pt idx="94">
                  <c:v>7030.31982421875</c:v>
                </c:pt>
                <c:pt idx="95">
                  <c:v>6983.681640625</c:v>
                </c:pt>
                <c:pt idx="96">
                  <c:v>6914.42138671875</c:v>
                </c:pt>
                <c:pt idx="97">
                  <c:v>6886.2939453125</c:v>
                </c:pt>
                <c:pt idx="98">
                  <c:v>6931.72314453125</c:v>
                </c:pt>
                <c:pt idx="99">
                  <c:v>7024.720703125</c:v>
                </c:pt>
                <c:pt idx="100">
                  <c:v>7099.38134765625</c:v>
                </c:pt>
                <c:pt idx="101">
                  <c:v>7099.7919921875</c:v>
                </c:pt>
                <c:pt idx="102">
                  <c:v>7022.6982421875</c:v>
                </c:pt>
                <c:pt idx="103">
                  <c:v>6920.19873046875</c:v>
                </c:pt>
                <c:pt idx="104">
                  <c:v>6861.10693359375</c:v>
                </c:pt>
                <c:pt idx="105">
                  <c:v>6881.33935546875</c:v>
                </c:pt>
                <c:pt idx="106">
                  <c:v>6960.962890625</c:v>
                </c:pt>
                <c:pt idx="107">
                  <c:v>7043.53955078125</c:v>
                </c:pt>
                <c:pt idx="108">
                  <c:v>7080.326171875</c:v>
                </c:pt>
                <c:pt idx="109">
                  <c:v>7064.068359375</c:v>
                </c:pt>
                <c:pt idx="110">
                  <c:v>7027.60400390625</c:v>
                </c:pt>
                <c:pt idx="111">
                  <c:v>7011.5908203125</c:v>
                </c:pt>
                <c:pt idx="112">
                  <c:v>7029.46484375</c:v>
                </c:pt>
                <c:pt idx="113">
                  <c:v>7057.88427734375</c:v>
                </c:pt>
                <c:pt idx="114">
                  <c:v>7058.7314453125</c:v>
                </c:pt>
                <c:pt idx="115">
                  <c:v>7013.12158203125</c:v>
                </c:pt>
                <c:pt idx="116">
                  <c:v>6939.30126953125</c:v>
                </c:pt>
                <c:pt idx="117">
                  <c:v>6880.486328125</c:v>
                </c:pt>
                <c:pt idx="118">
                  <c:v>6873.03515625</c:v>
                </c:pt>
                <c:pt idx="119">
                  <c:v>6920.111328125</c:v>
                </c:pt>
                <c:pt idx="120">
                  <c:v>6990.29052734375</c:v>
                </c:pt>
                <c:pt idx="121">
                  <c:v>7040.4091796875</c:v>
                </c:pt>
                <c:pt idx="122">
                  <c:v>7044.044921875</c:v>
                </c:pt>
                <c:pt idx="123">
                  <c:v>7004.921875</c:v>
                </c:pt>
                <c:pt idx="124">
                  <c:v>6948.240234375</c:v>
                </c:pt>
                <c:pt idx="125">
                  <c:v>6900.15966796875</c:v>
                </c:pt>
                <c:pt idx="126">
                  <c:v>6872.7158203125</c:v>
                </c:pt>
                <c:pt idx="127">
                  <c:v>6864.125</c:v>
                </c:pt>
                <c:pt idx="128">
                  <c:v>6870.29541015625</c:v>
                </c:pt>
                <c:pt idx="129">
                  <c:v>6894.58935546875</c:v>
                </c:pt>
                <c:pt idx="130">
                  <c:v>6945.9931640625</c:v>
                </c:pt>
                <c:pt idx="131">
                  <c:v>7027.17236328125</c:v>
                </c:pt>
                <c:pt idx="132">
                  <c:v>7123.34228515625</c:v>
                </c:pt>
                <c:pt idx="133">
                  <c:v>7202.8505859375</c:v>
                </c:pt>
                <c:pt idx="134">
                  <c:v>7231.33447265625</c:v>
                </c:pt>
                <c:pt idx="135">
                  <c:v>7190.79296875</c:v>
                </c:pt>
                <c:pt idx="136">
                  <c:v>7091.08984375</c:v>
                </c:pt>
                <c:pt idx="137">
                  <c:v>6966.54931640625</c:v>
                </c:pt>
                <c:pt idx="138">
                  <c:v>6860.07568359375</c:v>
                </c:pt>
                <c:pt idx="139">
                  <c:v>6804.369140625</c:v>
                </c:pt>
                <c:pt idx="140">
                  <c:v>6810.07470703125</c:v>
                </c:pt>
                <c:pt idx="141">
                  <c:v>6865.1689453125</c:v>
                </c:pt>
                <c:pt idx="142">
                  <c:v>6943.25537109375</c:v>
                </c:pt>
                <c:pt idx="143">
                  <c:v>7015.03125</c:v>
                </c:pt>
                <c:pt idx="144">
                  <c:v>7057.93115234375</c:v>
                </c:pt>
                <c:pt idx="145">
                  <c:v>7061.77490234375</c:v>
                </c:pt>
                <c:pt idx="146">
                  <c:v>7030.3984375</c:v>
                </c:pt>
                <c:pt idx="147">
                  <c:v>6979.69677734375</c:v>
                </c:pt>
                <c:pt idx="148">
                  <c:v>6932.19189453125</c:v>
                </c:pt>
                <c:pt idx="149">
                  <c:v>6908.76025390625</c:v>
                </c:pt>
                <c:pt idx="150">
                  <c:v>6919.85693359375</c:v>
                </c:pt>
                <c:pt idx="151">
                  <c:v>6960.17236328125</c:v>
                </c:pt>
                <c:pt idx="152">
                  <c:v>7010.2978515625</c:v>
                </c:pt>
                <c:pt idx="153">
                  <c:v>7045.86865234375</c:v>
                </c:pt>
                <c:pt idx="154">
                  <c:v>7050.22900390625</c:v>
                </c:pt>
                <c:pt idx="155">
                  <c:v>7023.720703125</c:v>
                </c:pt>
                <c:pt idx="156">
                  <c:v>6983.70556640625</c:v>
                </c:pt>
                <c:pt idx="157">
                  <c:v>6954.50439453125</c:v>
                </c:pt>
                <c:pt idx="158">
                  <c:v>6952.796875</c:v>
                </c:pt>
                <c:pt idx="159">
                  <c:v>6977.513671875</c:v>
                </c:pt>
                <c:pt idx="160">
                  <c:v>7011.0048828125</c:v>
                </c:pt>
                <c:pt idx="161">
                  <c:v>7031.15380859375</c:v>
                </c:pt>
                <c:pt idx="162">
                  <c:v>7026.56591796875</c:v>
                </c:pt>
                <c:pt idx="163">
                  <c:v>7004.33837890625</c:v>
                </c:pt>
                <c:pt idx="164">
                  <c:v>6984.638671875</c:v>
                </c:pt>
                <c:pt idx="165">
                  <c:v>6985.5185546875</c:v>
                </c:pt>
                <c:pt idx="166">
                  <c:v>7008.67041015625</c:v>
                </c:pt>
                <c:pt idx="167">
                  <c:v>7036.6259765625</c:v>
                </c:pt>
                <c:pt idx="168">
                  <c:v>7043.9072265625</c:v>
                </c:pt>
                <c:pt idx="169">
                  <c:v>7014.52001953125</c:v>
                </c:pt>
                <c:pt idx="170">
                  <c:v>6953.45458984375</c:v>
                </c:pt>
                <c:pt idx="171">
                  <c:v>6884.2421875</c:v>
                </c:pt>
                <c:pt idx="172">
                  <c:v>6834.8193359375</c:v>
                </c:pt>
                <c:pt idx="173">
                  <c:v>6822.11962890625</c:v>
                </c:pt>
                <c:pt idx="174">
                  <c:v>6845.759765625</c:v>
                </c:pt>
                <c:pt idx="175">
                  <c:v>6893.26318359375</c:v>
                </c:pt>
                <c:pt idx="176">
                  <c:v>6950.3115234375</c:v>
                </c:pt>
                <c:pt idx="177">
                  <c:v>7006.900390625</c:v>
                </c:pt>
                <c:pt idx="178">
                  <c:v>7055.7861328125</c:v>
                </c:pt>
                <c:pt idx="179">
                  <c:v>7087.8779296875</c:v>
                </c:pt>
                <c:pt idx="180">
                  <c:v>7092.40576171875</c:v>
                </c:pt>
                <c:pt idx="181">
                  <c:v>7064.56396484375</c:v>
                </c:pt>
                <c:pt idx="182">
                  <c:v>7014.490234375</c:v>
                </c:pt>
                <c:pt idx="183">
                  <c:v>6967.44580078125</c:v>
                </c:pt>
                <c:pt idx="184">
                  <c:v>6950.78515625</c:v>
                </c:pt>
                <c:pt idx="185">
                  <c:v>6974.86474609375</c:v>
                </c:pt>
                <c:pt idx="186">
                  <c:v>7022.56982421875</c:v>
                </c:pt>
                <c:pt idx="187">
                  <c:v>7057.9375</c:v>
                </c:pt>
                <c:pt idx="188">
                  <c:v>7050.3125</c:v>
                </c:pt>
                <c:pt idx="189">
                  <c:v>6997.32177734375</c:v>
                </c:pt>
                <c:pt idx="190">
                  <c:v>6928.9404296875</c:v>
                </c:pt>
                <c:pt idx="191">
                  <c:v>6888.08642578125</c:v>
                </c:pt>
                <c:pt idx="192">
                  <c:v>6901.03515625</c:v>
                </c:pt>
                <c:pt idx="193">
                  <c:v>6959.31982421875</c:v>
                </c:pt>
                <c:pt idx="194">
                  <c:v>7026.66650390625</c:v>
                </c:pt>
                <c:pt idx="195">
                  <c:v>7065.662109375</c:v>
                </c:pt>
                <c:pt idx="196">
                  <c:v>7063.978515625</c:v>
                </c:pt>
                <c:pt idx="197">
                  <c:v>7040.63818359375</c:v>
                </c:pt>
                <c:pt idx="198">
                  <c:v>7028.44189453125</c:v>
                </c:pt>
                <c:pt idx="199">
                  <c:v>7046.8173828125</c:v>
                </c:pt>
                <c:pt idx="200">
                  <c:v>7085.90771484375</c:v>
                </c:pt>
                <c:pt idx="201">
                  <c:v>7113.189453125</c:v>
                </c:pt>
                <c:pt idx="202">
                  <c:v>7096.49755859375</c:v>
                </c:pt>
                <c:pt idx="203">
                  <c:v>7025.95361328125</c:v>
                </c:pt>
                <c:pt idx="204">
                  <c:v>6920.03564453125</c:v>
                </c:pt>
                <c:pt idx="205">
                  <c:v>6814.1484375</c:v>
                </c:pt>
                <c:pt idx="206">
                  <c:v>6742.18798828125</c:v>
                </c:pt>
                <c:pt idx="207">
                  <c:v>6723.55078125</c:v>
                </c:pt>
                <c:pt idx="208">
                  <c:v>6760.349609375</c:v>
                </c:pt>
                <c:pt idx="209">
                  <c:v>6840.744140625</c:v>
                </c:pt>
                <c:pt idx="210">
                  <c:v>6942.35498046875</c:v>
                </c:pt>
                <c:pt idx="211">
                  <c:v>7034.97314453125</c:v>
                </c:pt>
                <c:pt idx="212">
                  <c:v>7087.09814453125</c:v>
                </c:pt>
                <c:pt idx="213">
                  <c:v>7079.11767578125</c:v>
                </c:pt>
                <c:pt idx="214">
                  <c:v>7017.73876953125</c:v>
                </c:pt>
                <c:pt idx="215">
                  <c:v>6939.75048828125</c:v>
                </c:pt>
                <c:pt idx="216">
                  <c:v>6896.6796875</c:v>
                </c:pt>
                <c:pt idx="217">
                  <c:v>6925.22802734375</c:v>
                </c:pt>
                <c:pt idx="218">
                  <c:v>7021.5908203125</c:v>
                </c:pt>
                <c:pt idx="219">
                  <c:v>7138.89697265625</c:v>
                </c:pt>
                <c:pt idx="220">
                  <c:v>7212.796875</c:v>
                </c:pt>
                <c:pt idx="221">
                  <c:v>7200.10400390625</c:v>
                </c:pt>
                <c:pt idx="222">
                  <c:v>7104.8662109375</c:v>
                </c:pt>
                <c:pt idx="223">
                  <c:v>6974.23779296875</c:v>
                </c:pt>
                <c:pt idx="224">
                  <c:v>6867.80322265625</c:v>
                </c:pt>
                <c:pt idx="225">
                  <c:v>6822.49267578125</c:v>
                </c:pt>
                <c:pt idx="226">
                  <c:v>6836.94873046875</c:v>
                </c:pt>
                <c:pt idx="227">
                  <c:v>6883.21240234375</c:v>
                </c:pt>
                <c:pt idx="228">
                  <c:v>6932.91064453125</c:v>
                </c:pt>
                <c:pt idx="229">
                  <c:v>6976.0107421875</c:v>
                </c:pt>
                <c:pt idx="230">
                  <c:v>7018.9912109375</c:v>
                </c:pt>
                <c:pt idx="231">
                  <c:v>7067.7841796875</c:v>
                </c:pt>
                <c:pt idx="232">
                  <c:v>7113.28125</c:v>
                </c:pt>
                <c:pt idx="233">
                  <c:v>7133.640625</c:v>
                </c:pt>
                <c:pt idx="234">
                  <c:v>7111.86328125</c:v>
                </c:pt>
                <c:pt idx="235">
                  <c:v>7053.029296875</c:v>
                </c:pt>
                <c:pt idx="236">
                  <c:v>6985.2705078125</c:v>
                </c:pt>
                <c:pt idx="237">
                  <c:v>6942.12109375</c:v>
                </c:pt>
                <c:pt idx="238">
                  <c:v>6939.705078125</c:v>
                </c:pt>
                <c:pt idx="239">
                  <c:v>6966.798828125</c:v>
                </c:pt>
                <c:pt idx="240">
                  <c:v>6995.41845703125</c:v>
                </c:pt>
                <c:pt idx="241">
                  <c:v>7002.94384765625</c:v>
                </c:pt>
                <c:pt idx="242">
                  <c:v>6987.8408203125</c:v>
                </c:pt>
                <c:pt idx="243">
                  <c:v>6966.984375</c:v>
                </c:pt>
                <c:pt idx="244">
                  <c:v>6958.17138671875</c:v>
                </c:pt>
                <c:pt idx="245">
                  <c:v>6963.4794921875</c:v>
                </c:pt>
                <c:pt idx="246">
                  <c:v>6967.7529296875</c:v>
                </c:pt>
                <c:pt idx="247">
                  <c:v>6953.1572265625</c:v>
                </c:pt>
                <c:pt idx="248">
                  <c:v>6916.87255859375</c:v>
                </c:pt>
                <c:pt idx="249">
                  <c:v>6876.2763671875</c:v>
                </c:pt>
                <c:pt idx="250">
                  <c:v>6856.5556640625</c:v>
                </c:pt>
                <c:pt idx="251">
                  <c:v>6870.67626953125</c:v>
                </c:pt>
                <c:pt idx="252">
                  <c:v>6908.3994140625</c:v>
                </c:pt>
                <c:pt idx="253">
                  <c:v>6943.92138671875</c:v>
                </c:pt>
                <c:pt idx="254">
                  <c:v>6956.43994140625</c:v>
                </c:pt>
                <c:pt idx="255">
                  <c:v>6947.12939453125</c:v>
                </c:pt>
                <c:pt idx="256">
                  <c:v>6938.47607421875</c:v>
                </c:pt>
                <c:pt idx="257">
                  <c:v>6955.94140625</c:v>
                </c:pt>
                <c:pt idx="258">
                  <c:v>7006.23095703125</c:v>
                </c:pt>
                <c:pt idx="259">
                  <c:v>7069.591796875</c:v>
                </c:pt>
                <c:pt idx="260">
                  <c:v>7112.8759765625</c:v>
                </c:pt>
                <c:pt idx="261">
                  <c:v>7113.8564453125</c:v>
                </c:pt>
                <c:pt idx="262">
                  <c:v>7078.1962890625</c:v>
                </c:pt>
                <c:pt idx="263">
                  <c:v>7035.736328125</c:v>
                </c:pt>
                <c:pt idx="264">
                  <c:v>7018.41650390625</c:v>
                </c:pt>
                <c:pt idx="265">
                  <c:v>7036.27880859375</c:v>
                </c:pt>
                <c:pt idx="266">
                  <c:v>7069.74267578125</c:v>
                </c:pt>
                <c:pt idx="267">
                  <c:v>7084.26025390625</c:v>
                </c:pt>
                <c:pt idx="268">
                  <c:v>7056.67919921875</c:v>
                </c:pt>
                <c:pt idx="269">
                  <c:v>6993.681640625</c:v>
                </c:pt>
                <c:pt idx="270">
                  <c:v>6928.3876953125</c:v>
                </c:pt>
                <c:pt idx="271">
                  <c:v>6897.31201171875</c:v>
                </c:pt>
                <c:pt idx="272">
                  <c:v>6914.40185546875</c:v>
                </c:pt>
                <c:pt idx="273">
                  <c:v>6961.09912109375</c:v>
                </c:pt>
                <c:pt idx="274">
                  <c:v>6999.62646484375</c:v>
                </c:pt>
                <c:pt idx="275">
                  <c:v>6999.755859375</c:v>
                </c:pt>
                <c:pt idx="276">
                  <c:v>6959.70849609375</c:v>
                </c:pt>
                <c:pt idx="277">
                  <c:v>6906.494140625</c:v>
                </c:pt>
                <c:pt idx="278">
                  <c:v>6876.25341796875</c:v>
                </c:pt>
                <c:pt idx="279">
                  <c:v>6889.4951171875</c:v>
                </c:pt>
                <c:pt idx="280">
                  <c:v>6938.9951171875</c:v>
                </c:pt>
                <c:pt idx="281">
                  <c:v>6997.8056640625</c:v>
                </c:pt>
                <c:pt idx="282">
                  <c:v>7039.59521484375</c:v>
                </c:pt>
                <c:pt idx="283">
                  <c:v>7055.14990234375</c:v>
                </c:pt>
                <c:pt idx="284">
                  <c:v>7053.36181640625</c:v>
                </c:pt>
                <c:pt idx="285">
                  <c:v>7048.234375</c:v>
                </c:pt>
                <c:pt idx="286">
                  <c:v>7044.45849609375</c:v>
                </c:pt>
                <c:pt idx="287">
                  <c:v>7034.16796875</c:v>
                </c:pt>
                <c:pt idx="288">
                  <c:v>7006.978515625</c:v>
                </c:pt>
                <c:pt idx="289">
                  <c:v>6963.46923828125</c:v>
                </c:pt>
                <c:pt idx="290">
                  <c:v>6919.171875</c:v>
                </c:pt>
                <c:pt idx="291">
                  <c:v>6894.4853515625</c:v>
                </c:pt>
                <c:pt idx="292">
                  <c:v>6898.66015625</c:v>
                </c:pt>
                <c:pt idx="293">
                  <c:v>6921.89599609375</c:v>
                </c:pt>
                <c:pt idx="294">
                  <c:v>6943.26123046875</c:v>
                </c:pt>
                <c:pt idx="295">
                  <c:v>6948.49755859375</c:v>
                </c:pt>
                <c:pt idx="296">
                  <c:v>6942.591796875</c:v>
                </c:pt>
                <c:pt idx="297">
                  <c:v>6945.56591796875</c:v>
                </c:pt>
                <c:pt idx="298">
                  <c:v>6974.00439453125</c:v>
                </c:pt>
                <c:pt idx="299">
                  <c:v>7023.66748046875</c:v>
                </c:pt>
                <c:pt idx="300">
                  <c:v>7068.87451171875</c:v>
                </c:pt>
                <c:pt idx="301">
                  <c:v>7080.95947265625</c:v>
                </c:pt>
                <c:pt idx="302">
                  <c:v>7051.6796875</c:v>
                </c:pt>
                <c:pt idx="303">
                  <c:v>7001.97314453125</c:v>
                </c:pt>
                <c:pt idx="304">
                  <c:v>6967.3505859375</c:v>
                </c:pt>
                <c:pt idx="305">
                  <c:v>6970.2998046875</c:v>
                </c:pt>
                <c:pt idx="306">
                  <c:v>7001.685546875</c:v>
                </c:pt>
                <c:pt idx="307">
                  <c:v>7027.05712890625</c:v>
                </c:pt>
                <c:pt idx="308">
                  <c:v>7014.13037109375</c:v>
                </c:pt>
                <c:pt idx="309">
                  <c:v>6960.16015625</c:v>
                </c:pt>
                <c:pt idx="310">
                  <c:v>6897.05126953125</c:v>
                </c:pt>
                <c:pt idx="311">
                  <c:v>6869.1650390625</c:v>
                </c:pt>
                <c:pt idx="312">
                  <c:v>6900.44140625</c:v>
                </c:pt>
                <c:pt idx="313">
                  <c:v>6976.205078125</c:v>
                </c:pt>
                <c:pt idx="314">
                  <c:v>7053.650390625</c:v>
                </c:pt>
                <c:pt idx="315">
                  <c:v>7092.548828125</c:v>
                </c:pt>
                <c:pt idx="316">
                  <c:v>7082.25927734375</c:v>
                </c:pt>
                <c:pt idx="317">
                  <c:v>7044.849609375</c:v>
                </c:pt>
                <c:pt idx="318">
                  <c:v>7013.69384765625</c:v>
                </c:pt>
                <c:pt idx="319">
                  <c:v>7006.11376953125</c:v>
                </c:pt>
                <c:pt idx="320">
                  <c:v>7012.13671875</c:v>
                </c:pt>
                <c:pt idx="321">
                  <c:v>7007.0478515625</c:v>
                </c:pt>
                <c:pt idx="322">
                  <c:v>6975.63427734375</c:v>
                </c:pt>
                <c:pt idx="323">
                  <c:v>6927.20849609375</c:v>
                </c:pt>
                <c:pt idx="324">
                  <c:v>6889.279296875</c:v>
                </c:pt>
                <c:pt idx="325">
                  <c:v>6886.0048828125</c:v>
                </c:pt>
                <c:pt idx="326">
                  <c:v>6919.68505859375</c:v>
                </c:pt>
                <c:pt idx="327">
                  <c:v>6969.92822265625</c:v>
                </c:pt>
                <c:pt idx="328">
                  <c:v>7009.7470703125</c:v>
                </c:pt>
                <c:pt idx="329">
                  <c:v>7024.25048828125</c:v>
                </c:pt>
                <c:pt idx="330">
                  <c:v>7017.10595703125</c:v>
                </c:pt>
                <c:pt idx="331">
                  <c:v>7001.82861328125</c:v>
                </c:pt>
                <c:pt idx="332">
                  <c:v>6988.11767578125</c:v>
                </c:pt>
                <c:pt idx="333">
                  <c:v>6976.244140625</c:v>
                </c:pt>
                <c:pt idx="334">
                  <c:v>6963.267578125</c:v>
                </c:pt>
                <c:pt idx="335">
                  <c:v>6952.73193359375</c:v>
                </c:pt>
                <c:pt idx="336">
                  <c:v>6956.037109375</c:v>
                </c:pt>
                <c:pt idx="337">
                  <c:v>6982.10595703125</c:v>
                </c:pt>
                <c:pt idx="338">
                  <c:v>7024.40869140625</c:v>
                </c:pt>
                <c:pt idx="339">
                  <c:v>7058.947265625</c:v>
                </c:pt>
                <c:pt idx="340">
                  <c:v>7058.45947265625</c:v>
                </c:pt>
                <c:pt idx="341">
                  <c:v>7013.5830078125</c:v>
                </c:pt>
                <c:pt idx="342">
                  <c:v>6943.86572265625</c:v>
                </c:pt>
                <c:pt idx="343">
                  <c:v>6887.92529296875</c:v>
                </c:pt>
                <c:pt idx="344">
                  <c:v>6878.271484375</c:v>
                </c:pt>
                <c:pt idx="345">
                  <c:v>6919.0595703125</c:v>
                </c:pt>
                <c:pt idx="346">
                  <c:v>6983.564453125</c:v>
                </c:pt>
                <c:pt idx="347">
                  <c:v>7033.25341796875</c:v>
                </c:pt>
                <c:pt idx="348">
                  <c:v>7043.96533203125</c:v>
                </c:pt>
                <c:pt idx="349">
                  <c:v>7019.85888671875</c:v>
                </c:pt>
              </c:numCache>
            </c:numRef>
          </c:yVal>
          <c:smooth val="1"/>
          <c:extLst>
            <c:ext xmlns:c16="http://schemas.microsoft.com/office/drawing/2014/chart" uri="{C3380CC4-5D6E-409C-BE32-E72D297353CC}">
              <c16:uniqueId val="{00000018-5429-4359-BD11-807CF8F8408D}"/>
            </c:ext>
          </c:extLst>
        </c:ser>
        <c:ser>
          <c:idx val="25"/>
          <c:order val="25"/>
          <c:tx>
            <c:strRef>
              <c:f>np_sub_003!$Z$1</c:f>
              <c:strCache>
                <c:ptCount val="1"/>
                <c:pt idx="0">
                  <c:v>Coor_26</c:v>
                </c:pt>
              </c:strCache>
            </c:strRef>
          </c:tx>
          <c:spPr>
            <a:ln w="28575" cap="rnd">
              <a:solidFill>
                <a:schemeClr val="accent2">
                  <a:lumMod val="60000"/>
                  <a:lumOff val="40000"/>
                </a:schemeClr>
              </a:solidFill>
              <a:round/>
            </a:ln>
            <a:effectLst/>
          </c:spPr>
          <c:marker>
            <c:symbol val="none"/>
          </c:marker>
          <c:yVal>
            <c:numRef>
              <c:f>np_sub_003!$Z$2:$Z$351</c:f>
              <c:numCache>
                <c:formatCode>0.00000000000_ </c:formatCode>
                <c:ptCount val="350"/>
                <c:pt idx="0">
                  <c:v>8528.728515625</c:v>
                </c:pt>
                <c:pt idx="1">
                  <c:v>8516.6328125</c:v>
                </c:pt>
                <c:pt idx="2">
                  <c:v>8516.0517578125</c:v>
                </c:pt>
                <c:pt idx="3">
                  <c:v>8534.0654296875</c:v>
                </c:pt>
                <c:pt idx="4">
                  <c:v>8562.2314453125</c:v>
                </c:pt>
                <c:pt idx="5">
                  <c:v>8582.5634765625</c:v>
                </c:pt>
                <c:pt idx="6">
                  <c:v>8582.587890625</c:v>
                </c:pt>
                <c:pt idx="7">
                  <c:v>8566.326171875</c:v>
                </c:pt>
                <c:pt idx="8">
                  <c:v>8550.8232421875</c:v>
                </c:pt>
                <c:pt idx="9">
                  <c:v>8550.3232421875</c:v>
                </c:pt>
                <c:pt idx="10">
                  <c:v>8561.8271484375</c:v>
                </c:pt>
                <c:pt idx="11">
                  <c:v>8565.7177734375</c:v>
                </c:pt>
                <c:pt idx="12">
                  <c:v>8542.552734375</c:v>
                </c:pt>
                <c:pt idx="13">
                  <c:v>8492.4775390625</c:v>
                </c:pt>
                <c:pt idx="14">
                  <c:v>8439.994140625</c:v>
                </c:pt>
                <c:pt idx="15">
                  <c:v>8418.1943359375</c:v>
                </c:pt>
                <c:pt idx="16">
                  <c:v>8443.9658203125</c:v>
                </c:pt>
                <c:pt idx="17">
                  <c:v>8504.3095703125</c:v>
                </c:pt>
                <c:pt idx="18">
                  <c:v>8565.64453125</c:v>
                </c:pt>
                <c:pt idx="19">
                  <c:v>8599.21875</c:v>
                </c:pt>
                <c:pt idx="20">
                  <c:v>8602.1220703125</c:v>
                </c:pt>
                <c:pt idx="21">
                  <c:v>8596.619140625</c:v>
                </c:pt>
                <c:pt idx="22">
                  <c:v>8608.4287109375</c:v>
                </c:pt>
                <c:pt idx="23">
                  <c:v>8642.1787109375</c:v>
                </c:pt>
                <c:pt idx="24">
                  <c:v>8674.8740234375</c:v>
                </c:pt>
                <c:pt idx="25">
                  <c:v>8673.37890625</c:v>
                </c:pt>
                <c:pt idx="26">
                  <c:v>8622.025390625</c:v>
                </c:pt>
                <c:pt idx="27">
                  <c:v>8537.9814453125</c:v>
                </c:pt>
                <c:pt idx="28">
                  <c:v>8461.859375</c:v>
                </c:pt>
                <c:pt idx="29">
                  <c:v>8430.763671875</c:v>
                </c:pt>
                <c:pt idx="30">
                  <c:v>8454.365234375</c:v>
                </c:pt>
                <c:pt idx="31">
                  <c:v>8511.1220703125</c:v>
                </c:pt>
                <c:pt idx="32">
                  <c:v>8565.3466796875</c:v>
                </c:pt>
                <c:pt idx="33">
                  <c:v>8590.4228515625</c:v>
                </c:pt>
                <c:pt idx="34">
                  <c:v>8581.2958984375</c:v>
                </c:pt>
                <c:pt idx="35">
                  <c:v>8550.390625</c:v>
                </c:pt>
                <c:pt idx="36">
                  <c:v>8514.6826171875</c:v>
                </c:pt>
                <c:pt idx="37">
                  <c:v>8486.1376953125</c:v>
                </c:pt>
                <c:pt idx="38">
                  <c:v>8470.904296875</c:v>
                </c:pt>
                <c:pt idx="39">
                  <c:v>8472.7060546875</c:v>
                </c:pt>
                <c:pt idx="40">
                  <c:v>8492.802734375</c:v>
                </c:pt>
                <c:pt idx="41">
                  <c:v>8525.0224609375</c:v>
                </c:pt>
                <c:pt idx="42">
                  <c:v>8552.6572265625</c:v>
                </c:pt>
                <c:pt idx="43">
                  <c:v>8554.837890625</c:v>
                </c:pt>
                <c:pt idx="44">
                  <c:v>8521.4287109375</c:v>
                </c:pt>
                <c:pt idx="45">
                  <c:v>8465.2470703125</c:v>
                </c:pt>
                <c:pt idx="46">
                  <c:v>8419.0859375</c:v>
                </c:pt>
                <c:pt idx="47">
                  <c:v>8415.802734375</c:v>
                </c:pt>
                <c:pt idx="48">
                  <c:v>8464.3583984375</c:v>
                </c:pt>
                <c:pt idx="49">
                  <c:v>8540.412109375</c:v>
                </c:pt>
                <c:pt idx="50">
                  <c:v>8600.560546875</c:v>
                </c:pt>
                <c:pt idx="51">
                  <c:v>8611.3447265625</c:v>
                </c:pt>
                <c:pt idx="52">
                  <c:v>8572.1201171875</c:v>
                </c:pt>
                <c:pt idx="53">
                  <c:v>8514.978515625</c:v>
                </c:pt>
                <c:pt idx="54">
                  <c:v>8482.12890625</c:v>
                </c:pt>
                <c:pt idx="55">
                  <c:v>8497.7958984375</c:v>
                </c:pt>
                <c:pt idx="56">
                  <c:v>8554.6689453125</c:v>
                </c:pt>
                <c:pt idx="57">
                  <c:v>8622.556640625</c:v>
                </c:pt>
                <c:pt idx="58">
                  <c:v>8669.9697265625</c:v>
                </c:pt>
                <c:pt idx="59">
                  <c:v>8681.5400390625</c:v>
                </c:pt>
                <c:pt idx="60">
                  <c:v>8660.6064453125</c:v>
                </c:pt>
                <c:pt idx="61">
                  <c:v>8619.908203125</c:v>
                </c:pt>
                <c:pt idx="62">
                  <c:v>8571.794921875</c:v>
                </c:pt>
                <c:pt idx="63">
                  <c:v>8526.1845703125</c:v>
                </c:pt>
                <c:pt idx="64">
                  <c:v>8494.259765625</c:v>
                </c:pt>
                <c:pt idx="65">
                  <c:v>8489.1484375</c:v>
                </c:pt>
                <c:pt idx="66">
                  <c:v>8518.361328125</c:v>
                </c:pt>
                <c:pt idx="67">
                  <c:v>8572.9482421875</c:v>
                </c:pt>
                <c:pt idx="68">
                  <c:v>8624.87890625</c:v>
                </c:pt>
                <c:pt idx="69">
                  <c:v>8639.7451171875</c:v>
                </c:pt>
                <c:pt idx="70">
                  <c:v>8599.1455078125</c:v>
                </c:pt>
                <c:pt idx="71">
                  <c:v>8516.939453125</c:v>
                </c:pt>
                <c:pt idx="72">
                  <c:v>8435.4267578125</c:v>
                </c:pt>
                <c:pt idx="73">
                  <c:v>8401.265625</c:v>
                </c:pt>
                <c:pt idx="74">
                  <c:v>8436.203125</c:v>
                </c:pt>
                <c:pt idx="75">
                  <c:v>8522.482421875</c:v>
                </c:pt>
                <c:pt idx="76">
                  <c:v>8613.0556640625</c:v>
                </c:pt>
                <c:pt idx="77">
                  <c:v>8659.763671875</c:v>
                </c:pt>
                <c:pt idx="78">
                  <c:v>8640.837890625</c:v>
                </c:pt>
                <c:pt idx="79">
                  <c:v>8570.62890625</c:v>
                </c:pt>
                <c:pt idx="80">
                  <c:v>8487.2236328125</c:v>
                </c:pt>
                <c:pt idx="81">
                  <c:v>8427.994140625</c:v>
                </c:pt>
                <c:pt idx="82">
                  <c:v>8409.333984375</c:v>
                </c:pt>
                <c:pt idx="83">
                  <c:v>8422.0986328125</c:v>
                </c:pt>
                <c:pt idx="84">
                  <c:v>8443.0908203125</c:v>
                </c:pt>
                <c:pt idx="85">
                  <c:v>8453.2119140625</c:v>
                </c:pt>
                <c:pt idx="86">
                  <c:v>8450.11328125</c:v>
                </c:pt>
                <c:pt idx="87">
                  <c:v>8447.794921875</c:v>
                </c:pt>
                <c:pt idx="88">
                  <c:v>8464.2353515625</c:v>
                </c:pt>
                <c:pt idx="89">
                  <c:v>8505.673828125</c:v>
                </c:pt>
                <c:pt idx="90">
                  <c:v>8558.6259765625</c:v>
                </c:pt>
                <c:pt idx="91">
                  <c:v>8596.35546875</c:v>
                </c:pt>
                <c:pt idx="92">
                  <c:v>8597.095703125</c:v>
                </c:pt>
                <c:pt idx="93">
                  <c:v>8562.2529296875</c:v>
                </c:pt>
                <c:pt idx="94">
                  <c:v>8520.5283203125</c:v>
                </c:pt>
                <c:pt idx="95">
                  <c:v>8511.8515625</c:v>
                </c:pt>
                <c:pt idx="96">
                  <c:v>8559.412109375</c:v>
                </c:pt>
                <c:pt idx="97">
                  <c:v>8649.1083984375</c:v>
                </c:pt>
                <c:pt idx="98">
                  <c:v>8733.5458984375</c:v>
                </c:pt>
                <c:pt idx="99">
                  <c:v>8761.4853515625</c:v>
                </c:pt>
                <c:pt idx="100">
                  <c:v>8713.7763671875</c:v>
                </c:pt>
                <c:pt idx="101">
                  <c:v>8619.1201171875</c:v>
                </c:pt>
                <c:pt idx="102">
                  <c:v>8535.6201171875</c:v>
                </c:pt>
                <c:pt idx="103">
                  <c:v>8509.591796875</c:v>
                </c:pt>
                <c:pt idx="104">
                  <c:v>8542.107421875</c:v>
                </c:pt>
                <c:pt idx="105">
                  <c:v>8589.8095703125</c:v>
                </c:pt>
                <c:pt idx="106">
                  <c:v>8600.630859375</c:v>
                </c:pt>
                <c:pt idx="107">
                  <c:v>8556.650390625</c:v>
                </c:pt>
                <c:pt idx="108">
                  <c:v>8488.9921875</c:v>
                </c:pt>
                <c:pt idx="109">
                  <c:v>8451.13671875</c:v>
                </c:pt>
                <c:pt idx="110">
                  <c:v>8471.482421875</c:v>
                </c:pt>
                <c:pt idx="111">
                  <c:v>8525.029296875</c:v>
                </c:pt>
                <c:pt idx="112">
                  <c:v>8550.4794921875</c:v>
                </c:pt>
                <c:pt idx="113">
                  <c:v>8501.9296875</c:v>
                </c:pt>
                <c:pt idx="114">
                  <c:v>8393.5888671875</c:v>
                </c:pt>
                <c:pt idx="115">
                  <c:v>8298.1884765625</c:v>
                </c:pt>
                <c:pt idx="116">
                  <c:v>8295.4296875</c:v>
                </c:pt>
                <c:pt idx="117">
                  <c:v>8408.3115234375</c:v>
                </c:pt>
                <c:pt idx="118">
                  <c:v>8578.1494140625</c:v>
                </c:pt>
                <c:pt idx="119">
                  <c:v>8701.2529296875</c:v>
                </c:pt>
                <c:pt idx="120">
                  <c:v>8702.25</c:v>
                </c:pt>
                <c:pt idx="121">
                  <c:v>8589.1845703125</c:v>
                </c:pt>
                <c:pt idx="122">
                  <c:v>8448.1904296875</c:v>
                </c:pt>
                <c:pt idx="123">
                  <c:v>8381.6005859375</c:v>
                </c:pt>
                <c:pt idx="124">
                  <c:v>8436.21875</c:v>
                </c:pt>
                <c:pt idx="125">
                  <c:v>8574.6904296875</c:v>
                </c:pt>
                <c:pt idx="126">
                  <c:v>8708.173828125</c:v>
                </c:pt>
                <c:pt idx="127">
                  <c:v>8761.5849609375</c:v>
                </c:pt>
                <c:pt idx="128">
                  <c:v>8720.8134765625</c:v>
                </c:pt>
                <c:pt idx="129">
                  <c:v>8630.0556640625</c:v>
                </c:pt>
                <c:pt idx="130">
                  <c:v>8548.9365234375</c:v>
                </c:pt>
                <c:pt idx="131">
                  <c:v>8508.5146484375</c:v>
                </c:pt>
                <c:pt idx="132">
                  <c:v>8499.966796875</c:v>
                </c:pt>
                <c:pt idx="133">
                  <c:v>8497.8115234375</c:v>
                </c:pt>
                <c:pt idx="134">
                  <c:v>8490.3017578125</c:v>
                </c:pt>
                <c:pt idx="135">
                  <c:v>8487.8388671875</c:v>
                </c:pt>
                <c:pt idx="136">
                  <c:v>8504.8154296875</c:v>
                </c:pt>
                <c:pt idx="137">
                  <c:v>8536.771484375</c:v>
                </c:pt>
                <c:pt idx="138">
                  <c:v>8558.4873046875</c:v>
                </c:pt>
                <c:pt idx="139">
                  <c:v>8547.0283203125</c:v>
                </c:pt>
                <c:pt idx="140">
                  <c:v>8507.775390625</c:v>
                </c:pt>
                <c:pt idx="141">
                  <c:v>8476.33203125</c:v>
                </c:pt>
                <c:pt idx="142">
                  <c:v>8490.4892578125</c:v>
                </c:pt>
                <c:pt idx="143">
                  <c:v>8555.0908203125</c:v>
                </c:pt>
                <c:pt idx="144">
                  <c:v>8631.8046875</c:v>
                </c:pt>
                <c:pt idx="145">
                  <c:v>8665.796875</c:v>
                </c:pt>
                <c:pt idx="146">
                  <c:v>8628.892578125</c:v>
                </c:pt>
                <c:pt idx="147">
                  <c:v>8542.8525390625</c:v>
                </c:pt>
                <c:pt idx="148">
                  <c:v>8462.1796875</c:v>
                </c:pt>
                <c:pt idx="149">
                  <c:v>8430.4375</c:v>
                </c:pt>
                <c:pt idx="150">
                  <c:v>8447.4111328125</c:v>
                </c:pt>
                <c:pt idx="151">
                  <c:v>8475.3720703125</c:v>
                </c:pt>
                <c:pt idx="152">
                  <c:v>8478.4677734375</c:v>
                </c:pt>
                <c:pt idx="153">
                  <c:v>8459.4736328125</c:v>
                </c:pt>
                <c:pt idx="154">
                  <c:v>8459.53515625</c:v>
                </c:pt>
                <c:pt idx="155">
                  <c:v>8518.7900390625</c:v>
                </c:pt>
                <c:pt idx="156">
                  <c:v>8631.4873046875</c:v>
                </c:pt>
                <c:pt idx="157">
                  <c:v>8736.82421875</c:v>
                </c:pt>
                <c:pt idx="158">
                  <c:v>8758.32421875</c:v>
                </c:pt>
                <c:pt idx="159">
                  <c:v>8663.30859375</c:v>
                </c:pt>
                <c:pt idx="160">
                  <c:v>8494.787109375</c:v>
                </c:pt>
                <c:pt idx="161">
                  <c:v>8347.9541015625</c:v>
                </c:pt>
                <c:pt idx="162">
                  <c:v>8306.8955078125</c:v>
                </c:pt>
                <c:pt idx="163">
                  <c:v>8388.5751953125</c:v>
                </c:pt>
                <c:pt idx="164">
                  <c:v>8535.326171875</c:v>
                </c:pt>
                <c:pt idx="165">
                  <c:v>8658.9794921875</c:v>
                </c:pt>
                <c:pt idx="166">
                  <c:v>8700.935546875</c:v>
                </c:pt>
                <c:pt idx="167">
                  <c:v>8663.5048828125</c:v>
                </c:pt>
                <c:pt idx="168">
                  <c:v>8594.00390625</c:v>
                </c:pt>
                <c:pt idx="169">
                  <c:v>8541.009765625</c:v>
                </c:pt>
                <c:pt idx="170">
                  <c:v>8520.6416015625</c:v>
                </c:pt>
                <c:pt idx="171">
                  <c:v>8516.96875</c:v>
                </c:pt>
                <c:pt idx="172">
                  <c:v>8509.177734375</c:v>
                </c:pt>
                <c:pt idx="173">
                  <c:v>8496.8798828125</c:v>
                </c:pt>
                <c:pt idx="174">
                  <c:v>8500.580078125</c:v>
                </c:pt>
                <c:pt idx="175">
                  <c:v>8539.1591796875</c:v>
                </c:pt>
                <c:pt idx="176">
                  <c:v>8607.021484375</c:v>
                </c:pt>
                <c:pt idx="177">
                  <c:v>8672.4609375</c:v>
                </c:pt>
                <c:pt idx="178">
                  <c:v>8698.7099609375</c:v>
                </c:pt>
                <c:pt idx="179">
                  <c:v>8669.1943359375</c:v>
                </c:pt>
                <c:pt idx="180">
                  <c:v>8596.337890625</c:v>
                </c:pt>
                <c:pt idx="181">
                  <c:v>8509.103515625</c:v>
                </c:pt>
                <c:pt idx="182">
                  <c:v>8432.83203125</c:v>
                </c:pt>
                <c:pt idx="183">
                  <c:v>8379.0419921875</c:v>
                </c:pt>
                <c:pt idx="184">
                  <c:v>8350.55859375</c:v>
                </c:pt>
                <c:pt idx="185">
                  <c:v>8351.6513671875</c:v>
                </c:pt>
                <c:pt idx="186">
                  <c:v>8389.150390625</c:v>
                </c:pt>
                <c:pt idx="187">
                  <c:v>8461.8095703125</c:v>
                </c:pt>
                <c:pt idx="188">
                  <c:v>8549.638671875</c:v>
                </c:pt>
                <c:pt idx="189">
                  <c:v>8617.595703125</c:v>
                </c:pt>
                <c:pt idx="190">
                  <c:v>8635.37890625</c:v>
                </c:pt>
                <c:pt idx="191">
                  <c:v>8598.74609375</c:v>
                </c:pt>
                <c:pt idx="192">
                  <c:v>8533.779296875</c:v>
                </c:pt>
                <c:pt idx="193">
                  <c:v>8478.70703125</c:v>
                </c:pt>
                <c:pt idx="194">
                  <c:v>8457.2236328125</c:v>
                </c:pt>
                <c:pt idx="195">
                  <c:v>8465.11328125</c:v>
                </c:pt>
                <c:pt idx="196">
                  <c:v>8480.6318359375</c:v>
                </c:pt>
                <c:pt idx="197">
                  <c:v>8488.2939453125</c:v>
                </c:pt>
                <c:pt idx="198">
                  <c:v>8494.0029296875</c:v>
                </c:pt>
                <c:pt idx="199">
                  <c:v>8517.693359375</c:v>
                </c:pt>
                <c:pt idx="200">
                  <c:v>8570.7236328125</c:v>
                </c:pt>
                <c:pt idx="201">
                  <c:v>8639.8701171875</c:v>
                </c:pt>
                <c:pt idx="202">
                  <c:v>8694.3212890625</c:v>
                </c:pt>
                <c:pt idx="203">
                  <c:v>8710.8427734375</c:v>
                </c:pt>
                <c:pt idx="204">
                  <c:v>8694.408203125</c:v>
                </c:pt>
                <c:pt idx="205">
                  <c:v>8674.0029296875</c:v>
                </c:pt>
                <c:pt idx="206">
                  <c:v>8675.08984375</c:v>
                </c:pt>
                <c:pt idx="207">
                  <c:v>8692.4130859375</c:v>
                </c:pt>
                <c:pt idx="208">
                  <c:v>8689.2099609375</c:v>
                </c:pt>
                <c:pt idx="209">
                  <c:v>8627.501953125</c:v>
                </c:pt>
                <c:pt idx="210">
                  <c:v>8506.4638671875</c:v>
                </c:pt>
                <c:pt idx="211">
                  <c:v>8375.755859375</c:v>
                </c:pt>
                <c:pt idx="212">
                  <c:v>8308.421875</c:v>
                </c:pt>
                <c:pt idx="213">
                  <c:v>8350.2255859375</c:v>
                </c:pt>
                <c:pt idx="214">
                  <c:v>8482.9658203125</c:v>
                </c:pt>
                <c:pt idx="215">
                  <c:v>8630.8212890625</c:v>
                </c:pt>
                <c:pt idx="216">
                  <c:v>8707.134765625</c:v>
                </c:pt>
                <c:pt idx="217">
                  <c:v>8668.8310546875</c:v>
                </c:pt>
                <c:pt idx="218">
                  <c:v>8540.537109375</c:v>
                </c:pt>
                <c:pt idx="219">
                  <c:v>8393.6103515625</c:v>
                </c:pt>
                <c:pt idx="220">
                  <c:v>8298.1533203125</c:v>
                </c:pt>
                <c:pt idx="221">
                  <c:v>8283.212890625</c:v>
                </c:pt>
                <c:pt idx="222">
                  <c:v>8330.33203125</c:v>
                </c:pt>
                <c:pt idx="223">
                  <c:v>8398.5107421875</c:v>
                </c:pt>
                <c:pt idx="224">
                  <c:v>8456.7724609375</c:v>
                </c:pt>
                <c:pt idx="225">
                  <c:v>8499.58203125</c:v>
                </c:pt>
                <c:pt idx="226">
                  <c:v>8538.2138671875</c:v>
                </c:pt>
                <c:pt idx="227">
                  <c:v>8581.037109375</c:v>
                </c:pt>
                <c:pt idx="228">
                  <c:v>8621.8818359375</c:v>
                </c:pt>
                <c:pt idx="229">
                  <c:v>8645.2587890625</c:v>
                </c:pt>
                <c:pt idx="230">
                  <c:v>8641.32421875</c:v>
                </c:pt>
                <c:pt idx="231">
                  <c:v>8615.943359375</c:v>
                </c:pt>
                <c:pt idx="232">
                  <c:v>8587.158203125</c:v>
                </c:pt>
                <c:pt idx="233">
                  <c:v>8571.9140625</c:v>
                </c:pt>
                <c:pt idx="234">
                  <c:v>8574.740234375</c:v>
                </c:pt>
                <c:pt idx="235">
                  <c:v>8587.220703125</c:v>
                </c:pt>
                <c:pt idx="236">
                  <c:v>8597.23046875</c:v>
                </c:pt>
                <c:pt idx="237">
                  <c:v>8599.1806640625</c:v>
                </c:pt>
                <c:pt idx="238">
                  <c:v>8596.8271484375</c:v>
                </c:pt>
                <c:pt idx="239">
                  <c:v>8597.3486328125</c:v>
                </c:pt>
                <c:pt idx="240">
                  <c:v>8602.560546875</c:v>
                </c:pt>
                <c:pt idx="241">
                  <c:v>8604.82421875</c:v>
                </c:pt>
                <c:pt idx="242">
                  <c:v>8591.0009765625</c:v>
                </c:pt>
                <c:pt idx="243">
                  <c:v>8551.734375</c:v>
                </c:pt>
                <c:pt idx="244">
                  <c:v>8489.943359375</c:v>
                </c:pt>
                <c:pt idx="245">
                  <c:v>8423.1435546875</c:v>
                </c:pt>
                <c:pt idx="246">
                  <c:v>8377.7099609375</c:v>
                </c:pt>
                <c:pt idx="247">
                  <c:v>8377.166015625</c:v>
                </c:pt>
                <c:pt idx="248">
                  <c:v>8429.6611328125</c:v>
                </c:pt>
                <c:pt idx="249">
                  <c:v>8521.0087890625</c:v>
                </c:pt>
                <c:pt idx="250">
                  <c:v>8618.150390625</c:v>
                </c:pt>
                <c:pt idx="251">
                  <c:v>8683.216796875</c:v>
                </c:pt>
                <c:pt idx="252">
                  <c:v>8691.9853515625</c:v>
                </c:pt>
                <c:pt idx="253">
                  <c:v>8646.416015625</c:v>
                </c:pt>
                <c:pt idx="254">
                  <c:v>8573.0322265625</c:v>
                </c:pt>
                <c:pt idx="255">
                  <c:v>8507.265625</c:v>
                </c:pt>
                <c:pt idx="256">
                  <c:v>8473.4111328125</c:v>
                </c:pt>
                <c:pt idx="257">
                  <c:v>8473.212890625</c:v>
                </c:pt>
                <c:pt idx="258">
                  <c:v>8490.029296875</c:v>
                </c:pt>
                <c:pt idx="259">
                  <c:v>8504.064453125</c:v>
                </c:pt>
                <c:pt idx="260">
                  <c:v>8506.2421875</c:v>
                </c:pt>
                <c:pt idx="261">
                  <c:v>8500.548828125</c:v>
                </c:pt>
                <c:pt idx="262">
                  <c:v>8495.16015625</c:v>
                </c:pt>
                <c:pt idx="263">
                  <c:v>8492.3310546875</c:v>
                </c:pt>
                <c:pt idx="264">
                  <c:v>8487.2900390625</c:v>
                </c:pt>
                <c:pt idx="265">
                  <c:v>8477.01171875</c:v>
                </c:pt>
                <c:pt idx="266">
                  <c:v>8469.2919921875</c:v>
                </c:pt>
                <c:pt idx="267">
                  <c:v>8481.173828125</c:v>
                </c:pt>
                <c:pt idx="268">
                  <c:v>8525.3046875</c:v>
                </c:pt>
                <c:pt idx="269">
                  <c:v>8595.13671875</c:v>
                </c:pt>
                <c:pt idx="270">
                  <c:v>8663.1357421875</c:v>
                </c:pt>
                <c:pt idx="271">
                  <c:v>8696.419921875</c:v>
                </c:pt>
                <c:pt idx="272">
                  <c:v>8679.08203125</c:v>
                </c:pt>
                <c:pt idx="273">
                  <c:v>8623.5068359375</c:v>
                </c:pt>
                <c:pt idx="274">
                  <c:v>8561.0537109375</c:v>
                </c:pt>
                <c:pt idx="275">
                  <c:v>8519.4453125</c:v>
                </c:pt>
                <c:pt idx="276">
                  <c:v>8505.3515625</c:v>
                </c:pt>
                <c:pt idx="277">
                  <c:v>8505.8525390625</c:v>
                </c:pt>
                <c:pt idx="278">
                  <c:v>8505.646484375</c:v>
                </c:pt>
                <c:pt idx="279">
                  <c:v>8502.986328125</c:v>
                </c:pt>
                <c:pt idx="280">
                  <c:v>8509.107421875</c:v>
                </c:pt>
                <c:pt idx="281">
                  <c:v>8532.1552734375</c:v>
                </c:pt>
                <c:pt idx="282">
                  <c:v>8562.322265625</c:v>
                </c:pt>
                <c:pt idx="283">
                  <c:v>8575.0244140625</c:v>
                </c:pt>
                <c:pt idx="284">
                  <c:v>8552.1171875</c:v>
                </c:pt>
                <c:pt idx="285">
                  <c:v>8502.4326171875</c:v>
                </c:pt>
                <c:pt idx="286">
                  <c:v>8460.373046875</c:v>
                </c:pt>
                <c:pt idx="287">
                  <c:v>8459.4033203125</c:v>
                </c:pt>
                <c:pt idx="288">
                  <c:v>8501.2177734375</c:v>
                </c:pt>
                <c:pt idx="289">
                  <c:v>8549.1328125</c:v>
                </c:pt>
                <c:pt idx="290">
                  <c:v>8556.2099609375</c:v>
                </c:pt>
                <c:pt idx="291">
                  <c:v>8508.1669921875</c:v>
                </c:pt>
                <c:pt idx="292">
                  <c:v>8444.3876953125</c:v>
                </c:pt>
                <c:pt idx="293">
                  <c:v>8434.2568359375</c:v>
                </c:pt>
                <c:pt idx="294">
                  <c:v>8521.9892578125</c:v>
                </c:pt>
                <c:pt idx="295">
                  <c:v>8682.2353515625</c:v>
                </c:pt>
                <c:pt idx="296">
                  <c:v>8825.1357421875</c:v>
                </c:pt>
                <c:pt idx="297">
                  <c:v>8853.25</c:v>
                </c:pt>
                <c:pt idx="298">
                  <c:v>8731.1953125</c:v>
                </c:pt>
                <c:pt idx="299">
                  <c:v>8515.8271484375</c:v>
                </c:pt>
                <c:pt idx="300">
                  <c:v>8322.3505859375</c:v>
                </c:pt>
                <c:pt idx="301">
                  <c:v>8249.525390625</c:v>
                </c:pt>
                <c:pt idx="302">
                  <c:v>8317.8955078125</c:v>
                </c:pt>
                <c:pt idx="303">
                  <c:v>8464.4501953125</c:v>
                </c:pt>
                <c:pt idx="304">
                  <c:v>8593.9931640625</c:v>
                </c:pt>
                <c:pt idx="305">
                  <c:v>8645.802734375</c:v>
                </c:pt>
                <c:pt idx="306">
                  <c:v>8626.1298828125</c:v>
                </c:pt>
                <c:pt idx="307">
                  <c:v>8587.203125</c:v>
                </c:pt>
                <c:pt idx="308">
                  <c:v>8575.8349609375</c:v>
                </c:pt>
                <c:pt idx="309">
                  <c:v>8595.4853515625</c:v>
                </c:pt>
                <c:pt idx="310">
                  <c:v>8610.0986328125</c:v>
                </c:pt>
                <c:pt idx="311">
                  <c:v>8581.5234375</c:v>
                </c:pt>
                <c:pt idx="312">
                  <c:v>8506.0439453125</c:v>
                </c:pt>
                <c:pt idx="313">
                  <c:v>8419.62109375</c:v>
                </c:pt>
                <c:pt idx="314">
                  <c:v>8369.9248046875</c:v>
                </c:pt>
                <c:pt idx="315">
                  <c:v>8380.5283203125</c:v>
                </c:pt>
                <c:pt idx="316">
                  <c:v>8436.5341796875</c:v>
                </c:pt>
                <c:pt idx="317">
                  <c:v>8500.56640625</c:v>
                </c:pt>
                <c:pt idx="318">
                  <c:v>8542.74609375</c:v>
                </c:pt>
                <c:pt idx="319">
                  <c:v>8559.4208984375</c:v>
                </c:pt>
                <c:pt idx="320">
                  <c:v>8568.294921875</c:v>
                </c:pt>
                <c:pt idx="321">
                  <c:v>8588.583984375</c:v>
                </c:pt>
                <c:pt idx="322">
                  <c:v>8625.03515625</c:v>
                </c:pt>
                <c:pt idx="323">
                  <c:v>8667.2021484375</c:v>
                </c:pt>
                <c:pt idx="324">
                  <c:v>8699.6220703125</c:v>
                </c:pt>
                <c:pt idx="325">
                  <c:v>8710.4091796875</c:v>
                </c:pt>
                <c:pt idx="326">
                  <c:v>8691.5947265625</c:v>
                </c:pt>
                <c:pt idx="327">
                  <c:v>8636.41796875</c:v>
                </c:pt>
                <c:pt idx="328">
                  <c:v>8542.9775390625</c:v>
                </c:pt>
                <c:pt idx="329">
                  <c:v>8425.0986328125</c:v>
                </c:pt>
                <c:pt idx="330">
                  <c:v>8318.9609375</c:v>
                </c:pt>
                <c:pt idx="331">
                  <c:v>8272.1953125</c:v>
                </c:pt>
                <c:pt idx="332">
                  <c:v>8315.7998046875</c:v>
                </c:pt>
                <c:pt idx="333">
                  <c:v>8437.44921875</c:v>
                </c:pt>
                <c:pt idx="334">
                  <c:v>8579.849609375</c:v>
                </c:pt>
                <c:pt idx="335">
                  <c:v>8671.8212890625</c:v>
                </c:pt>
                <c:pt idx="336">
                  <c:v>8673.5283203125</c:v>
                </c:pt>
                <c:pt idx="337">
                  <c:v>8602.8349609375</c:v>
                </c:pt>
                <c:pt idx="338">
                  <c:v>8521.25</c:v>
                </c:pt>
                <c:pt idx="339">
                  <c:v>8488.337890625</c:v>
                </c:pt>
                <c:pt idx="340">
                  <c:v>8518.705078125</c:v>
                </c:pt>
                <c:pt idx="341">
                  <c:v>8574.6298828125</c:v>
                </c:pt>
                <c:pt idx="342">
                  <c:v>8599.607421875</c:v>
                </c:pt>
                <c:pt idx="343">
                  <c:v>8565.650390625</c:v>
                </c:pt>
                <c:pt idx="344">
                  <c:v>8496.4208984375</c:v>
                </c:pt>
                <c:pt idx="345">
                  <c:v>8448.0341796875</c:v>
                </c:pt>
                <c:pt idx="346">
                  <c:v>8463.6337890625</c:v>
                </c:pt>
                <c:pt idx="347">
                  <c:v>8538.5673828125</c:v>
                </c:pt>
                <c:pt idx="348">
                  <c:v>8623.677734375</c:v>
                </c:pt>
                <c:pt idx="349">
                  <c:v>8663.060546875</c:v>
                </c:pt>
              </c:numCache>
            </c:numRef>
          </c:yVal>
          <c:smooth val="1"/>
          <c:extLst>
            <c:ext xmlns:c16="http://schemas.microsoft.com/office/drawing/2014/chart" uri="{C3380CC4-5D6E-409C-BE32-E72D297353CC}">
              <c16:uniqueId val="{00000019-5429-4359-BD11-807CF8F8408D}"/>
            </c:ext>
          </c:extLst>
        </c:ser>
        <c:ser>
          <c:idx val="26"/>
          <c:order val="26"/>
          <c:tx>
            <c:strRef>
              <c:f>np_sub_003!$AA$1</c:f>
              <c:strCache>
                <c:ptCount val="1"/>
                <c:pt idx="0">
                  <c:v>Coor_27</c:v>
                </c:pt>
              </c:strCache>
            </c:strRef>
          </c:tx>
          <c:spPr>
            <a:ln w="28575" cap="rnd">
              <a:solidFill>
                <a:schemeClr val="accent3">
                  <a:lumMod val="60000"/>
                  <a:lumOff val="40000"/>
                </a:schemeClr>
              </a:solidFill>
              <a:round/>
            </a:ln>
            <a:effectLst/>
          </c:spPr>
          <c:marker>
            <c:symbol val="none"/>
          </c:marker>
          <c:yVal>
            <c:numRef>
              <c:f>np_sub_003!$AA$2:$AA$351</c:f>
              <c:numCache>
                <c:formatCode>0.00000000000_ </c:formatCode>
                <c:ptCount val="350"/>
                <c:pt idx="0">
                  <c:v>7110.49560546875</c:v>
                </c:pt>
                <c:pt idx="1">
                  <c:v>7162.35107421875</c:v>
                </c:pt>
                <c:pt idx="2">
                  <c:v>7179.7744140625</c:v>
                </c:pt>
                <c:pt idx="3">
                  <c:v>7142.8349609375</c:v>
                </c:pt>
                <c:pt idx="4">
                  <c:v>7065.521484375</c:v>
                </c:pt>
                <c:pt idx="5">
                  <c:v>6989.5595703125</c:v>
                </c:pt>
                <c:pt idx="6">
                  <c:v>6956.92041015625</c:v>
                </c:pt>
                <c:pt idx="7">
                  <c:v>6980.57373046875</c:v>
                </c:pt>
                <c:pt idx="8">
                  <c:v>7035.3740234375</c:v>
                </c:pt>
                <c:pt idx="9">
                  <c:v>7076.17431640625</c:v>
                </c:pt>
                <c:pt idx="10">
                  <c:v>7069.65869140625</c:v>
                </c:pt>
                <c:pt idx="11">
                  <c:v>7016.2548828125</c:v>
                </c:pt>
                <c:pt idx="12">
                  <c:v>6946.8037109375</c:v>
                </c:pt>
                <c:pt idx="13">
                  <c:v>6898.51171875</c:v>
                </c:pt>
                <c:pt idx="14">
                  <c:v>6890.0732421875</c:v>
                </c:pt>
                <c:pt idx="15">
                  <c:v>6914.56884765625</c:v>
                </c:pt>
                <c:pt idx="16">
                  <c:v>6952.72509765625</c:v>
                </c:pt>
                <c:pt idx="17">
                  <c:v>6992.2197265625</c:v>
                </c:pt>
                <c:pt idx="18">
                  <c:v>7035.14111328125</c:v>
                </c:pt>
                <c:pt idx="19">
                  <c:v>7087.9404296875</c:v>
                </c:pt>
                <c:pt idx="20">
                  <c:v>7145.0673828125</c:v>
                </c:pt>
                <c:pt idx="21">
                  <c:v>7183.93212890625</c:v>
                </c:pt>
                <c:pt idx="22">
                  <c:v>7178.876953125</c:v>
                </c:pt>
                <c:pt idx="23">
                  <c:v>7124.02783203125</c:v>
                </c:pt>
                <c:pt idx="24">
                  <c:v>7044.89990234375</c:v>
                </c:pt>
                <c:pt idx="25">
                  <c:v>6986.0166015625</c:v>
                </c:pt>
                <c:pt idx="26">
                  <c:v>6981.21044921875</c:v>
                </c:pt>
                <c:pt idx="27">
                  <c:v>7028.76123046875</c:v>
                </c:pt>
                <c:pt idx="28">
                  <c:v>7091.5478515625</c:v>
                </c:pt>
                <c:pt idx="29">
                  <c:v>7123.59521484375</c:v>
                </c:pt>
                <c:pt idx="30">
                  <c:v>7103.53271484375</c:v>
                </c:pt>
                <c:pt idx="31">
                  <c:v>7049.44482421875</c:v>
                </c:pt>
                <c:pt idx="32">
                  <c:v>7003.75048828125</c:v>
                </c:pt>
                <c:pt idx="33">
                  <c:v>7000.0595703125</c:v>
                </c:pt>
                <c:pt idx="34">
                  <c:v>7037.88427734375</c:v>
                </c:pt>
                <c:pt idx="35">
                  <c:v>7084.5712890625</c:v>
                </c:pt>
                <c:pt idx="36">
                  <c:v>7102.14990234375</c:v>
                </c:pt>
                <c:pt idx="37">
                  <c:v>7077.302734375</c:v>
                </c:pt>
                <c:pt idx="38">
                  <c:v>7030.85693359375</c:v>
                </c:pt>
                <c:pt idx="39">
                  <c:v>7000.04931640625</c:v>
                </c:pt>
                <c:pt idx="40">
                  <c:v>7008.5771484375</c:v>
                </c:pt>
                <c:pt idx="41">
                  <c:v>7048.60107421875</c:v>
                </c:pt>
                <c:pt idx="42">
                  <c:v>7088.50146484375</c:v>
                </c:pt>
                <c:pt idx="43">
                  <c:v>7099.11767578125</c:v>
                </c:pt>
                <c:pt idx="44">
                  <c:v>7076.65869140625</c:v>
                </c:pt>
                <c:pt idx="45">
                  <c:v>7043.90185546875</c:v>
                </c:pt>
                <c:pt idx="46">
                  <c:v>7029.5078125</c:v>
                </c:pt>
                <c:pt idx="47">
                  <c:v>7043.12841796875</c:v>
                </c:pt>
                <c:pt idx="48">
                  <c:v>7067.11181640625</c:v>
                </c:pt>
                <c:pt idx="49">
                  <c:v>7071.6904296875</c:v>
                </c:pt>
                <c:pt idx="50">
                  <c:v>7041.1494140625</c:v>
                </c:pt>
                <c:pt idx="51">
                  <c:v>6989.32861328125</c:v>
                </c:pt>
                <c:pt idx="52">
                  <c:v>6951.22607421875</c:v>
                </c:pt>
                <c:pt idx="53">
                  <c:v>6956.60693359375</c:v>
                </c:pt>
                <c:pt idx="54">
                  <c:v>7006.0439453125</c:v>
                </c:pt>
                <c:pt idx="55">
                  <c:v>7068.31396484375</c:v>
                </c:pt>
                <c:pt idx="56">
                  <c:v>7101.72998046875</c:v>
                </c:pt>
                <c:pt idx="57">
                  <c:v>7083.7080078125</c:v>
                </c:pt>
                <c:pt idx="58">
                  <c:v>7026.6982421875</c:v>
                </c:pt>
                <c:pt idx="59">
                  <c:v>6969.05908203125</c:v>
                </c:pt>
                <c:pt idx="60">
                  <c:v>6948.1708984375</c:v>
                </c:pt>
                <c:pt idx="61">
                  <c:v>6975.72607421875</c:v>
                </c:pt>
                <c:pt idx="62">
                  <c:v>7032.52001953125</c:v>
                </c:pt>
                <c:pt idx="63">
                  <c:v>7084.83642578125</c:v>
                </c:pt>
                <c:pt idx="64">
                  <c:v>7108.73046875</c:v>
                </c:pt>
                <c:pt idx="65">
                  <c:v>7103.94873046875</c:v>
                </c:pt>
                <c:pt idx="66">
                  <c:v>7088.57421875</c:v>
                </c:pt>
                <c:pt idx="67">
                  <c:v>7080.7939453125</c:v>
                </c:pt>
                <c:pt idx="68">
                  <c:v>7083.48095703125</c:v>
                </c:pt>
                <c:pt idx="69">
                  <c:v>7083.8115234375</c:v>
                </c:pt>
                <c:pt idx="70">
                  <c:v>7067.3037109375</c:v>
                </c:pt>
                <c:pt idx="71">
                  <c:v>7033.87841796875</c:v>
                </c:pt>
                <c:pt idx="72">
                  <c:v>7001.9814453125</c:v>
                </c:pt>
                <c:pt idx="73">
                  <c:v>6996.388671875</c:v>
                </c:pt>
                <c:pt idx="74">
                  <c:v>7028.490234375</c:v>
                </c:pt>
                <c:pt idx="75">
                  <c:v>7084.28369140625</c:v>
                </c:pt>
                <c:pt idx="76">
                  <c:v>7130.18603515625</c:v>
                </c:pt>
                <c:pt idx="77">
                  <c:v>7133.83154296875</c:v>
                </c:pt>
                <c:pt idx="78">
                  <c:v>7085.90576171875</c:v>
                </c:pt>
                <c:pt idx="79">
                  <c:v>7007.873046875</c:v>
                </c:pt>
                <c:pt idx="80">
                  <c:v>6939.9462890625</c:v>
                </c:pt>
                <c:pt idx="81">
                  <c:v>6917.03369140625</c:v>
                </c:pt>
                <c:pt idx="82">
                  <c:v>6948.30126953125</c:v>
                </c:pt>
                <c:pt idx="83">
                  <c:v>7013.19287109375</c:v>
                </c:pt>
                <c:pt idx="84">
                  <c:v>7075.625</c:v>
                </c:pt>
                <c:pt idx="85">
                  <c:v>7106.36865234375</c:v>
                </c:pt>
                <c:pt idx="86">
                  <c:v>7099.09619140625</c:v>
                </c:pt>
                <c:pt idx="87">
                  <c:v>7070.66845703125</c:v>
                </c:pt>
                <c:pt idx="88">
                  <c:v>7046.93603515625</c:v>
                </c:pt>
                <c:pt idx="89">
                  <c:v>7044.43212890625</c:v>
                </c:pt>
                <c:pt idx="90">
                  <c:v>7060.12109375</c:v>
                </c:pt>
                <c:pt idx="91">
                  <c:v>7075.31396484375</c:v>
                </c:pt>
                <c:pt idx="92">
                  <c:v>7070.35009765625</c:v>
                </c:pt>
                <c:pt idx="93">
                  <c:v>7039.80322265625</c:v>
                </c:pt>
                <c:pt idx="94">
                  <c:v>6997.94287109375</c:v>
                </c:pt>
                <c:pt idx="95">
                  <c:v>6970.6728515625</c:v>
                </c:pt>
                <c:pt idx="96">
                  <c:v>6978.970703125</c:v>
                </c:pt>
                <c:pt idx="97">
                  <c:v>7024.49951171875</c:v>
                </c:pt>
                <c:pt idx="98">
                  <c:v>7086.99169921875</c:v>
                </c:pt>
                <c:pt idx="99">
                  <c:v>7135.728515625</c:v>
                </c:pt>
                <c:pt idx="100">
                  <c:v>7148.26904296875</c:v>
                </c:pt>
                <c:pt idx="101">
                  <c:v>7124.42041015625</c:v>
                </c:pt>
                <c:pt idx="102">
                  <c:v>7085.873046875</c:v>
                </c:pt>
                <c:pt idx="103">
                  <c:v>7061.07421875</c:v>
                </c:pt>
                <c:pt idx="104">
                  <c:v>7065.03369140625</c:v>
                </c:pt>
                <c:pt idx="105">
                  <c:v>7088.00048828125</c:v>
                </c:pt>
                <c:pt idx="106">
                  <c:v>7101.6875</c:v>
                </c:pt>
                <c:pt idx="107">
                  <c:v>7079.7646484375</c:v>
                </c:pt>
                <c:pt idx="108">
                  <c:v>7018.69580078125</c:v>
                </c:pt>
                <c:pt idx="109">
                  <c:v>6943.5869140625</c:v>
                </c:pt>
                <c:pt idx="110">
                  <c:v>6893.43994140625</c:v>
                </c:pt>
                <c:pt idx="111">
                  <c:v>6894.95068359375</c:v>
                </c:pt>
                <c:pt idx="112">
                  <c:v>6943.15380859375</c:v>
                </c:pt>
                <c:pt idx="113">
                  <c:v>7003.50927734375</c:v>
                </c:pt>
                <c:pt idx="114">
                  <c:v>7035.21240234375</c:v>
                </c:pt>
                <c:pt idx="115">
                  <c:v>7019.92333984375</c:v>
                </c:pt>
                <c:pt idx="116">
                  <c:v>6975.369140625</c:v>
                </c:pt>
                <c:pt idx="117">
                  <c:v>6943.48974609375</c:v>
                </c:pt>
                <c:pt idx="118">
                  <c:v>6961.00390625</c:v>
                </c:pt>
                <c:pt idx="119">
                  <c:v>7033.1591796875</c:v>
                </c:pt>
                <c:pt idx="120">
                  <c:v>7129.240234375</c:v>
                </c:pt>
                <c:pt idx="121">
                  <c:v>7202.67529296875</c:v>
                </c:pt>
                <c:pt idx="122">
                  <c:v>7220.96044921875</c:v>
                </c:pt>
                <c:pt idx="123">
                  <c:v>7184.26611328125</c:v>
                </c:pt>
                <c:pt idx="124">
                  <c:v>7120.970703125</c:v>
                </c:pt>
                <c:pt idx="125">
                  <c:v>7065.74072265625</c:v>
                </c:pt>
                <c:pt idx="126">
                  <c:v>7037.697265625</c:v>
                </c:pt>
                <c:pt idx="127">
                  <c:v>7033.89599609375</c:v>
                </c:pt>
                <c:pt idx="128">
                  <c:v>7039.7119140625</c:v>
                </c:pt>
                <c:pt idx="129">
                  <c:v>7044.41552734375</c:v>
                </c:pt>
                <c:pt idx="130">
                  <c:v>7047.9970703125</c:v>
                </c:pt>
                <c:pt idx="131">
                  <c:v>7055.06396484375</c:v>
                </c:pt>
                <c:pt idx="132">
                  <c:v>7064.12744140625</c:v>
                </c:pt>
                <c:pt idx="133">
                  <c:v>7064.60791015625</c:v>
                </c:pt>
                <c:pt idx="134">
                  <c:v>7045.9462890625</c:v>
                </c:pt>
                <c:pt idx="135">
                  <c:v>7010.68994140625</c:v>
                </c:pt>
                <c:pt idx="136">
                  <c:v>6978.033203125</c:v>
                </c:pt>
                <c:pt idx="137">
                  <c:v>6971.62353515625</c:v>
                </c:pt>
                <c:pt idx="138">
                  <c:v>6999.736328125</c:v>
                </c:pt>
                <c:pt idx="139">
                  <c:v>7044.61474609375</c:v>
                </c:pt>
                <c:pt idx="140">
                  <c:v>7072.2900390625</c:v>
                </c:pt>
                <c:pt idx="141">
                  <c:v>7057.931640625</c:v>
                </c:pt>
                <c:pt idx="142">
                  <c:v>7007.81884765625</c:v>
                </c:pt>
                <c:pt idx="143">
                  <c:v>6959.53369140625</c:v>
                </c:pt>
                <c:pt idx="144">
                  <c:v>6957.73046875</c:v>
                </c:pt>
                <c:pt idx="145">
                  <c:v>7021.89404296875</c:v>
                </c:pt>
                <c:pt idx="146">
                  <c:v>7129.6689453125</c:v>
                </c:pt>
                <c:pt idx="147">
                  <c:v>7228.4833984375</c:v>
                </c:pt>
                <c:pt idx="148">
                  <c:v>7267.50146484375</c:v>
                </c:pt>
                <c:pt idx="149">
                  <c:v>7227.45556640625</c:v>
                </c:pt>
                <c:pt idx="150">
                  <c:v>7128.58056640625</c:v>
                </c:pt>
                <c:pt idx="151">
                  <c:v>7013.9169921875</c:v>
                </c:pt>
                <c:pt idx="152">
                  <c:v>6922.77587890625</c:v>
                </c:pt>
                <c:pt idx="153">
                  <c:v>6873.64599609375</c:v>
                </c:pt>
                <c:pt idx="154">
                  <c:v>6865.19677734375</c:v>
                </c:pt>
                <c:pt idx="155">
                  <c:v>6888.44091796875</c:v>
                </c:pt>
                <c:pt idx="156">
                  <c:v>6935.9453125</c:v>
                </c:pt>
                <c:pt idx="157">
                  <c:v>7000.353515625</c:v>
                </c:pt>
                <c:pt idx="158">
                  <c:v>7067.22021484375</c:v>
                </c:pt>
                <c:pt idx="159">
                  <c:v>7113.9208984375</c:v>
                </c:pt>
                <c:pt idx="160">
                  <c:v>7120.63427734375</c:v>
                </c:pt>
                <c:pt idx="161">
                  <c:v>7086.4423828125</c:v>
                </c:pt>
                <c:pt idx="162">
                  <c:v>7035.7734375</c:v>
                </c:pt>
                <c:pt idx="163">
                  <c:v>7005.99169921875</c:v>
                </c:pt>
                <c:pt idx="164">
                  <c:v>7022.20947265625</c:v>
                </c:pt>
                <c:pt idx="165">
                  <c:v>7077.59521484375</c:v>
                </c:pt>
                <c:pt idx="166">
                  <c:v>7135.41455078125</c:v>
                </c:pt>
                <c:pt idx="167">
                  <c:v>7153.2626953125</c:v>
                </c:pt>
                <c:pt idx="168">
                  <c:v>7112.64892578125</c:v>
                </c:pt>
                <c:pt idx="169">
                  <c:v>7032.3623046875</c:v>
                </c:pt>
                <c:pt idx="170">
                  <c:v>6955.99609375</c:v>
                </c:pt>
                <c:pt idx="171">
                  <c:v>6923.318359375</c:v>
                </c:pt>
                <c:pt idx="172">
                  <c:v>6946.56787109375</c:v>
                </c:pt>
                <c:pt idx="173">
                  <c:v>7007.5673828125</c:v>
                </c:pt>
                <c:pt idx="174">
                  <c:v>7074.68017578125</c:v>
                </c:pt>
                <c:pt idx="175">
                  <c:v>7124.1181640625</c:v>
                </c:pt>
                <c:pt idx="176">
                  <c:v>7149.2783203125</c:v>
                </c:pt>
                <c:pt idx="177">
                  <c:v>7154.140625</c:v>
                </c:pt>
                <c:pt idx="178">
                  <c:v>7140.8662109375</c:v>
                </c:pt>
                <c:pt idx="179">
                  <c:v>7105.39013671875</c:v>
                </c:pt>
                <c:pt idx="180">
                  <c:v>7045.52685546875</c:v>
                </c:pt>
                <c:pt idx="181">
                  <c:v>6972.80517578125</c:v>
                </c:pt>
                <c:pt idx="182">
                  <c:v>6914.31884765625</c:v>
                </c:pt>
                <c:pt idx="183">
                  <c:v>6899.06201171875</c:v>
                </c:pt>
                <c:pt idx="184">
                  <c:v>6937.5751953125</c:v>
                </c:pt>
                <c:pt idx="185">
                  <c:v>7011.47216796875</c:v>
                </c:pt>
                <c:pt idx="186">
                  <c:v>7083.13525390625</c:v>
                </c:pt>
                <c:pt idx="187">
                  <c:v>7120.1025390625</c:v>
                </c:pt>
                <c:pt idx="188">
                  <c:v>7116.32421875</c:v>
                </c:pt>
                <c:pt idx="189">
                  <c:v>7094.0078125</c:v>
                </c:pt>
                <c:pt idx="190">
                  <c:v>7084.515625</c:v>
                </c:pt>
                <c:pt idx="191">
                  <c:v>7103.04150390625</c:v>
                </c:pt>
                <c:pt idx="192">
                  <c:v>7136.623046875</c:v>
                </c:pt>
                <c:pt idx="193">
                  <c:v>7154.552734375</c:v>
                </c:pt>
                <c:pt idx="194">
                  <c:v>7132.8271484375</c:v>
                </c:pt>
                <c:pt idx="195">
                  <c:v>7073.58837890625</c:v>
                </c:pt>
                <c:pt idx="196">
                  <c:v>7004.77587890625</c:v>
                </c:pt>
                <c:pt idx="197">
                  <c:v>6960.625</c:v>
                </c:pt>
                <c:pt idx="198">
                  <c:v>6958.0185546875</c:v>
                </c:pt>
                <c:pt idx="199">
                  <c:v>6986.154296875</c:v>
                </c:pt>
                <c:pt idx="200">
                  <c:v>7016.26611328125</c:v>
                </c:pt>
                <c:pt idx="201">
                  <c:v>7023.1103515625</c:v>
                </c:pt>
                <c:pt idx="202">
                  <c:v>7002.04345703125</c:v>
                </c:pt>
                <c:pt idx="203">
                  <c:v>6970.0478515625</c:v>
                </c:pt>
                <c:pt idx="204">
                  <c:v>6951.61572265625</c:v>
                </c:pt>
                <c:pt idx="205">
                  <c:v>6961.0380859375</c:v>
                </c:pt>
                <c:pt idx="206">
                  <c:v>6993.8935546875</c:v>
                </c:pt>
                <c:pt idx="207">
                  <c:v>7032.49560546875</c:v>
                </c:pt>
                <c:pt idx="208">
                  <c:v>7059.6572265625</c:v>
                </c:pt>
                <c:pt idx="209">
                  <c:v>7070.00341796875</c:v>
                </c:pt>
                <c:pt idx="210">
                  <c:v>7071.203125</c:v>
                </c:pt>
                <c:pt idx="211">
                  <c:v>7075.54052734375</c:v>
                </c:pt>
                <c:pt idx="212">
                  <c:v>7088.97705078125</c:v>
                </c:pt>
                <c:pt idx="213">
                  <c:v>7105.79296875</c:v>
                </c:pt>
                <c:pt idx="214">
                  <c:v>7112.23388671875</c:v>
                </c:pt>
                <c:pt idx="215">
                  <c:v>7096.20068359375</c:v>
                </c:pt>
                <c:pt idx="216">
                  <c:v>7056.25927734375</c:v>
                </c:pt>
                <c:pt idx="217">
                  <c:v>7004.16259765625</c:v>
                </c:pt>
                <c:pt idx="218">
                  <c:v>6959.4755859375</c:v>
                </c:pt>
                <c:pt idx="219">
                  <c:v>6939.74462890625</c:v>
                </c:pt>
                <c:pt idx="220">
                  <c:v>6952.0556640625</c:v>
                </c:pt>
                <c:pt idx="221">
                  <c:v>6990.58740234375</c:v>
                </c:pt>
                <c:pt idx="222">
                  <c:v>7040.94873046875</c:v>
                </c:pt>
                <c:pt idx="223">
                  <c:v>7088.05712890625</c:v>
                </c:pt>
                <c:pt idx="224">
                  <c:v>7122.56201171875</c:v>
                </c:pt>
                <c:pt idx="225">
                  <c:v>7142.37353515625</c:v>
                </c:pt>
                <c:pt idx="226">
                  <c:v>7149.572265625</c:v>
                </c:pt>
                <c:pt idx="227">
                  <c:v>7146.185546875</c:v>
                </c:pt>
                <c:pt idx="228">
                  <c:v>7132.64794921875</c:v>
                </c:pt>
                <c:pt idx="229">
                  <c:v>7109.93310546875</c:v>
                </c:pt>
                <c:pt idx="230">
                  <c:v>7082.67138671875</c:v>
                </c:pt>
                <c:pt idx="231">
                  <c:v>7059.275390625</c:v>
                </c:pt>
                <c:pt idx="232">
                  <c:v>7047.56591796875</c:v>
                </c:pt>
                <c:pt idx="233">
                  <c:v>7048.7958984375</c:v>
                </c:pt>
                <c:pt idx="234">
                  <c:v>7055.41162109375</c:v>
                </c:pt>
                <c:pt idx="235">
                  <c:v>7055.705078125</c:v>
                </c:pt>
                <c:pt idx="236">
                  <c:v>7042.830078125</c:v>
                </c:pt>
                <c:pt idx="237">
                  <c:v>7021.1796875</c:v>
                </c:pt>
                <c:pt idx="238">
                  <c:v>7004.06640625</c:v>
                </c:pt>
                <c:pt idx="239">
                  <c:v>7003.21728515625</c:v>
                </c:pt>
                <c:pt idx="240">
                  <c:v>7017.83740234375</c:v>
                </c:pt>
                <c:pt idx="241">
                  <c:v>7032.68603515625</c:v>
                </c:pt>
                <c:pt idx="242">
                  <c:v>7028.38134765625</c:v>
                </c:pt>
                <c:pt idx="243">
                  <c:v>6997.24658203125</c:v>
                </c:pt>
                <c:pt idx="244">
                  <c:v>6952.36083984375</c:v>
                </c:pt>
                <c:pt idx="245">
                  <c:v>6921.3876953125</c:v>
                </c:pt>
                <c:pt idx="246">
                  <c:v>6928.0888671875</c:v>
                </c:pt>
                <c:pt idx="247">
                  <c:v>6974.6298828125</c:v>
                </c:pt>
                <c:pt idx="248">
                  <c:v>7038.3984375</c:v>
                </c:pt>
                <c:pt idx="249">
                  <c:v>7086.755859375</c:v>
                </c:pt>
                <c:pt idx="250">
                  <c:v>7099.4443359375</c:v>
                </c:pt>
                <c:pt idx="251">
                  <c:v>7081.9541015625</c:v>
                </c:pt>
                <c:pt idx="252">
                  <c:v>7059.56201171875</c:v>
                </c:pt>
                <c:pt idx="253">
                  <c:v>7056.45556640625</c:v>
                </c:pt>
                <c:pt idx="254">
                  <c:v>7076.0703125</c:v>
                </c:pt>
                <c:pt idx="255">
                  <c:v>7098.14501953125</c:v>
                </c:pt>
                <c:pt idx="256">
                  <c:v>7095.1748046875</c:v>
                </c:pt>
                <c:pt idx="257">
                  <c:v>7055.76953125</c:v>
                </c:pt>
                <c:pt idx="258">
                  <c:v>6996.642578125</c:v>
                </c:pt>
                <c:pt idx="259">
                  <c:v>6953.31640625</c:v>
                </c:pt>
                <c:pt idx="260">
                  <c:v>6955.73876953125</c:v>
                </c:pt>
                <c:pt idx="261">
                  <c:v>7006.55322265625</c:v>
                </c:pt>
                <c:pt idx="262">
                  <c:v>7077.97998046875</c:v>
                </c:pt>
                <c:pt idx="263">
                  <c:v>7129.59326171875</c:v>
                </c:pt>
                <c:pt idx="264">
                  <c:v>7134.1982421875</c:v>
                </c:pt>
                <c:pt idx="265">
                  <c:v>7093.763671875</c:v>
                </c:pt>
                <c:pt idx="266">
                  <c:v>7035.35107421875</c:v>
                </c:pt>
                <c:pt idx="267">
                  <c:v>6991.65869140625</c:v>
                </c:pt>
                <c:pt idx="268">
                  <c:v>6981.02685546875</c:v>
                </c:pt>
                <c:pt idx="269">
                  <c:v>7000.3837890625</c:v>
                </c:pt>
                <c:pt idx="270">
                  <c:v>7033.71826171875</c:v>
                </c:pt>
                <c:pt idx="271">
                  <c:v>7067.10791015625</c:v>
                </c:pt>
                <c:pt idx="272">
                  <c:v>7097.77099609375</c:v>
                </c:pt>
                <c:pt idx="273">
                  <c:v>7130.927734375</c:v>
                </c:pt>
                <c:pt idx="274">
                  <c:v>7168.73974609375</c:v>
                </c:pt>
                <c:pt idx="275">
                  <c:v>7201.8662109375</c:v>
                </c:pt>
                <c:pt idx="276">
                  <c:v>7211.7265625</c:v>
                </c:pt>
                <c:pt idx="277">
                  <c:v>7182.73046875</c:v>
                </c:pt>
                <c:pt idx="278">
                  <c:v>7115.56396484375</c:v>
                </c:pt>
                <c:pt idx="279">
                  <c:v>7031.19384765625</c:v>
                </c:pt>
                <c:pt idx="280">
                  <c:v>6961.486328125</c:v>
                </c:pt>
                <c:pt idx="281">
                  <c:v>6931.63330078125</c:v>
                </c:pt>
                <c:pt idx="282">
                  <c:v>6945.4267578125</c:v>
                </c:pt>
                <c:pt idx="283">
                  <c:v>6982.96728515625</c:v>
                </c:pt>
                <c:pt idx="284">
                  <c:v>7012.72265625</c:v>
                </c:pt>
                <c:pt idx="285">
                  <c:v>7010.89501953125</c:v>
                </c:pt>
                <c:pt idx="286">
                  <c:v>6976.404296875</c:v>
                </c:pt>
                <c:pt idx="287">
                  <c:v>6932.1845703125</c:v>
                </c:pt>
                <c:pt idx="288">
                  <c:v>6911.51123046875</c:v>
                </c:pt>
                <c:pt idx="289">
                  <c:v>6937.0869140625</c:v>
                </c:pt>
                <c:pt idx="290">
                  <c:v>7005.3330078125</c:v>
                </c:pt>
                <c:pt idx="291">
                  <c:v>7085.83203125</c:v>
                </c:pt>
                <c:pt idx="292">
                  <c:v>7137.23876953125</c:v>
                </c:pt>
                <c:pt idx="293">
                  <c:v>7131.0234375</c:v>
                </c:pt>
                <c:pt idx="294">
                  <c:v>7069.08544921875</c:v>
                </c:pt>
                <c:pt idx="295">
                  <c:v>6984.1962890625</c:v>
                </c:pt>
                <c:pt idx="296">
                  <c:v>6922.1884765625</c:v>
                </c:pt>
                <c:pt idx="297">
                  <c:v>6915.99560546875</c:v>
                </c:pt>
                <c:pt idx="298">
                  <c:v>6967.05615234375</c:v>
                </c:pt>
                <c:pt idx="299">
                  <c:v>7045.45654296875</c:v>
                </c:pt>
                <c:pt idx="300">
                  <c:v>7108.720703125</c:v>
                </c:pt>
                <c:pt idx="301">
                  <c:v>7127.53076171875</c:v>
                </c:pt>
                <c:pt idx="302">
                  <c:v>7102.3994140625</c:v>
                </c:pt>
                <c:pt idx="303">
                  <c:v>7061.24072265625</c:v>
                </c:pt>
                <c:pt idx="304">
                  <c:v>7040.06201171875</c:v>
                </c:pt>
                <c:pt idx="305">
                  <c:v>7059.572265625</c:v>
                </c:pt>
                <c:pt idx="306">
                  <c:v>7112.5341796875</c:v>
                </c:pt>
                <c:pt idx="307">
                  <c:v>7169.16162109375</c:v>
                </c:pt>
                <c:pt idx="308">
                  <c:v>7196.08056640625</c:v>
                </c:pt>
                <c:pt idx="309">
                  <c:v>7176.18017578125</c:v>
                </c:pt>
                <c:pt idx="310">
                  <c:v>7117.17578125</c:v>
                </c:pt>
                <c:pt idx="311">
                  <c:v>7044.85302734375</c:v>
                </c:pt>
                <c:pt idx="312">
                  <c:v>6986.92041015625</c:v>
                </c:pt>
                <c:pt idx="313">
                  <c:v>6958.46826171875</c:v>
                </c:pt>
                <c:pt idx="314">
                  <c:v>6957.541015625</c:v>
                </c:pt>
                <c:pt idx="315">
                  <c:v>6971.6376953125</c:v>
                </c:pt>
                <c:pt idx="316">
                  <c:v>6988.84619140625</c:v>
                </c:pt>
                <c:pt idx="317">
                  <c:v>7005.31591796875</c:v>
                </c:pt>
                <c:pt idx="318">
                  <c:v>7024.69775390625</c:v>
                </c:pt>
                <c:pt idx="319">
                  <c:v>7051.54638671875</c:v>
                </c:pt>
                <c:pt idx="320">
                  <c:v>7084.7919921875</c:v>
                </c:pt>
                <c:pt idx="321">
                  <c:v>7116.5634765625</c:v>
                </c:pt>
                <c:pt idx="322">
                  <c:v>7136.9306640625</c:v>
                </c:pt>
                <c:pt idx="323">
                  <c:v>7140.36328125</c:v>
                </c:pt>
                <c:pt idx="324">
                  <c:v>7128.5107421875</c:v>
                </c:pt>
                <c:pt idx="325">
                  <c:v>7107.1396484375</c:v>
                </c:pt>
                <c:pt idx="326">
                  <c:v>7080.06982421875</c:v>
                </c:pt>
                <c:pt idx="327">
                  <c:v>7045.7490234375</c:v>
                </c:pt>
                <c:pt idx="328">
                  <c:v>7000.21484375</c:v>
                </c:pt>
                <c:pt idx="329">
                  <c:v>6944.82373046875</c:v>
                </c:pt>
                <c:pt idx="330">
                  <c:v>6892.35498046875</c:v>
                </c:pt>
                <c:pt idx="331">
                  <c:v>6864.98486328125</c:v>
                </c:pt>
                <c:pt idx="332">
                  <c:v>6882.978515625</c:v>
                </c:pt>
                <c:pt idx="333">
                  <c:v>6950.26318359375</c:v>
                </c:pt>
                <c:pt idx="334">
                  <c:v>7046.89501953125</c:v>
                </c:pt>
                <c:pt idx="335">
                  <c:v>7135.2763671875</c:v>
                </c:pt>
                <c:pt idx="336">
                  <c:v>7178.314453125</c:v>
                </c:pt>
                <c:pt idx="337">
                  <c:v>7159.25830078125</c:v>
                </c:pt>
                <c:pt idx="338">
                  <c:v>7090.91845703125</c:v>
                </c:pt>
                <c:pt idx="339">
                  <c:v>7008.24462890625</c:v>
                </c:pt>
                <c:pt idx="340">
                  <c:v>6948.8349609375</c:v>
                </c:pt>
                <c:pt idx="341">
                  <c:v>6933.59130859375</c:v>
                </c:pt>
                <c:pt idx="342">
                  <c:v>6959.0634765625</c:v>
                </c:pt>
                <c:pt idx="343">
                  <c:v>7004.6943359375</c:v>
                </c:pt>
                <c:pt idx="344">
                  <c:v>7048.234375</c:v>
                </c:pt>
                <c:pt idx="345">
                  <c:v>7078.14306640625</c:v>
                </c:pt>
                <c:pt idx="346">
                  <c:v>7095.5537109375</c:v>
                </c:pt>
                <c:pt idx="347">
                  <c:v>7106.95703125</c:v>
                </c:pt>
                <c:pt idx="348">
                  <c:v>7115.31494140625</c:v>
                </c:pt>
                <c:pt idx="349">
                  <c:v>7117.19091796875</c:v>
                </c:pt>
              </c:numCache>
            </c:numRef>
          </c:yVal>
          <c:smooth val="1"/>
          <c:extLst>
            <c:ext xmlns:c16="http://schemas.microsoft.com/office/drawing/2014/chart" uri="{C3380CC4-5D6E-409C-BE32-E72D297353CC}">
              <c16:uniqueId val="{0000001A-5429-4359-BD11-807CF8F8408D}"/>
            </c:ext>
          </c:extLst>
        </c:ser>
        <c:dLbls>
          <c:showLegendKey val="0"/>
          <c:showVal val="0"/>
          <c:showCatName val="0"/>
          <c:showSerName val="0"/>
          <c:showPercent val="0"/>
          <c:showBubbleSize val="0"/>
        </c:dLbls>
        <c:axId val="1133794536"/>
        <c:axId val="1133789856"/>
      </c:scatterChart>
      <c:valAx>
        <c:axId val="1133794536"/>
        <c:scaling>
          <c:orientation val="minMax"/>
          <c:max val="350"/>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zh-CN" sz="1100" b="1">
                    <a:latin typeface="Times New Roman" panose="02020603050405020304" pitchFamily="18" charset="0"/>
                    <a:cs typeface="Times New Roman" panose="02020603050405020304" pitchFamily="18" charset="0"/>
                  </a:rPr>
                  <a:t>Timepoint</a:t>
                </a:r>
                <a:endParaRPr lang="zh-CN" altLang="en-US" sz="1100" b="1">
                  <a:latin typeface="Times New Roman" panose="02020603050405020304" pitchFamily="18" charset="0"/>
                  <a:cs typeface="Times New Roman" panose="02020603050405020304" pitchFamily="18" charset="0"/>
                </a:endParaRP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zh-CN"/>
            </a:p>
          </c:txPr>
        </c:title>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crossAx val="1133789856"/>
        <c:crosses val="autoZero"/>
        <c:crossBetween val="midCat"/>
      </c:valAx>
      <c:valAx>
        <c:axId val="1133789856"/>
        <c:scaling>
          <c:orientation val="minMax"/>
          <c:max val="9000"/>
          <c:min val="500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zh-CN" sz="1100" b="1" dirty="0">
                    <a:latin typeface="Times New Roman" panose="02020603050405020304" pitchFamily="18" charset="0"/>
                    <a:ea typeface="宋体" panose="02010600030101010101" pitchFamily="2" charset="-122"/>
                    <a:cs typeface="Times New Roman" panose="02020603050405020304" pitchFamily="18" charset="0"/>
                  </a:rPr>
                  <a:t>Time series value</a:t>
                </a:r>
                <a:endParaRPr lang="zh-CN" altLang="en-US" sz="1100" b="1" dirty="0">
                  <a:latin typeface="Times New Roman" panose="02020603050405020304" pitchFamily="18" charset="0"/>
                  <a:ea typeface="宋体" panose="02010600030101010101" pitchFamily="2" charset="-122"/>
                  <a:cs typeface="Times New Roman" panose="02020603050405020304" pitchFamily="18" charset="0"/>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zh-CN"/>
            </a:p>
          </c:txPr>
        </c:title>
        <c:numFmt formatCode="0_ " sourceLinked="0"/>
        <c:majorTickMark val="none"/>
        <c:minorTickMark val="none"/>
        <c:tickLblPos val="nextTo"/>
        <c:spPr>
          <a:noFill/>
          <a:ln>
            <a:solidFill>
              <a:schemeClr val="bg2">
                <a:lumMod val="90000"/>
              </a:schemeClr>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crossAx val="1133794536"/>
        <c:crosses val="autoZero"/>
        <c:crossBetween val="midCat"/>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a:noFill/>
    </a:ln>
    <a:effectLst/>
  </c:spPr>
  <c:txPr>
    <a:bodyPr/>
    <a:lstStyle/>
    <a:p>
      <a:pPr>
        <a:defRPr/>
      </a:pPr>
      <a:endParaRPr lang="zh-CN"/>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9EDD9F6-7DB3-77B8-FC87-9969CAD7C581}"/>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842D9C06-6418-AFE4-7202-64DFB77EE22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C2AD8E46-95B8-B941-AB42-9AECAE250976}"/>
              </a:ext>
            </a:extLst>
          </p:cNvPr>
          <p:cNvSpPr>
            <a:spLocks noGrp="1"/>
          </p:cNvSpPr>
          <p:nvPr>
            <p:ph type="dt" sz="half" idx="10"/>
          </p:nvPr>
        </p:nvSpPr>
        <p:spPr/>
        <p:txBody>
          <a:bodyPr/>
          <a:lstStyle/>
          <a:p>
            <a:fld id="{3F599A6E-F3DD-46C1-87ED-5406E99CF1C6}" type="datetimeFigureOut">
              <a:rPr lang="zh-CN" altLang="en-US" smtClean="0"/>
              <a:t>2024/10/7</a:t>
            </a:fld>
            <a:endParaRPr lang="zh-CN" altLang="en-US"/>
          </a:p>
        </p:txBody>
      </p:sp>
      <p:sp>
        <p:nvSpPr>
          <p:cNvPr id="5" name="页脚占位符 4">
            <a:extLst>
              <a:ext uri="{FF2B5EF4-FFF2-40B4-BE49-F238E27FC236}">
                <a16:creationId xmlns:a16="http://schemas.microsoft.com/office/drawing/2014/main" id="{38AD4C9C-5256-8AD2-4C53-9866F70E0EB9}"/>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E3DF8D31-CBAE-1CB0-DA72-F0D509EE9A4A}"/>
              </a:ext>
            </a:extLst>
          </p:cNvPr>
          <p:cNvSpPr>
            <a:spLocks noGrp="1"/>
          </p:cNvSpPr>
          <p:nvPr>
            <p:ph type="sldNum" sz="quarter" idx="12"/>
          </p:nvPr>
        </p:nvSpPr>
        <p:spPr/>
        <p:txBody>
          <a:body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13613931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D3B605A-8EB7-7C7E-D895-493334F9AD57}"/>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974911A5-1601-5D80-CD73-EA3E1EB73F66}"/>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82A42B2-E2F4-F003-B5DE-B7478EA88A8C}"/>
              </a:ext>
            </a:extLst>
          </p:cNvPr>
          <p:cNvSpPr>
            <a:spLocks noGrp="1"/>
          </p:cNvSpPr>
          <p:nvPr>
            <p:ph type="dt" sz="half" idx="10"/>
          </p:nvPr>
        </p:nvSpPr>
        <p:spPr/>
        <p:txBody>
          <a:bodyPr/>
          <a:lstStyle/>
          <a:p>
            <a:fld id="{3F599A6E-F3DD-46C1-87ED-5406E99CF1C6}" type="datetimeFigureOut">
              <a:rPr lang="zh-CN" altLang="en-US" smtClean="0"/>
              <a:t>2024/10/7</a:t>
            </a:fld>
            <a:endParaRPr lang="zh-CN" altLang="en-US"/>
          </a:p>
        </p:txBody>
      </p:sp>
      <p:sp>
        <p:nvSpPr>
          <p:cNvPr id="5" name="页脚占位符 4">
            <a:extLst>
              <a:ext uri="{FF2B5EF4-FFF2-40B4-BE49-F238E27FC236}">
                <a16:creationId xmlns:a16="http://schemas.microsoft.com/office/drawing/2014/main" id="{8182524A-C2E1-1900-DAF2-4A6AC344AA6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86695319-CE20-907E-0EB0-CE6F47CC1C94}"/>
              </a:ext>
            </a:extLst>
          </p:cNvPr>
          <p:cNvSpPr>
            <a:spLocks noGrp="1"/>
          </p:cNvSpPr>
          <p:nvPr>
            <p:ph type="sldNum" sz="quarter" idx="12"/>
          </p:nvPr>
        </p:nvSpPr>
        <p:spPr/>
        <p:txBody>
          <a:body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6836398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AA1AFF60-FC85-DACF-F029-4B5B8857F6DA}"/>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ADFC059E-3539-F9CD-C62C-826C8A1C4A35}"/>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404ECEB9-EDD2-DA34-8FA0-FC5517644BD4}"/>
              </a:ext>
            </a:extLst>
          </p:cNvPr>
          <p:cNvSpPr>
            <a:spLocks noGrp="1"/>
          </p:cNvSpPr>
          <p:nvPr>
            <p:ph type="dt" sz="half" idx="10"/>
          </p:nvPr>
        </p:nvSpPr>
        <p:spPr/>
        <p:txBody>
          <a:bodyPr/>
          <a:lstStyle/>
          <a:p>
            <a:fld id="{3F599A6E-F3DD-46C1-87ED-5406E99CF1C6}" type="datetimeFigureOut">
              <a:rPr lang="zh-CN" altLang="en-US" smtClean="0"/>
              <a:t>2024/10/7</a:t>
            </a:fld>
            <a:endParaRPr lang="zh-CN" altLang="en-US"/>
          </a:p>
        </p:txBody>
      </p:sp>
      <p:sp>
        <p:nvSpPr>
          <p:cNvPr id="5" name="页脚占位符 4">
            <a:extLst>
              <a:ext uri="{FF2B5EF4-FFF2-40B4-BE49-F238E27FC236}">
                <a16:creationId xmlns:a16="http://schemas.microsoft.com/office/drawing/2014/main" id="{4A120908-D644-2582-0198-4530CFF5DC57}"/>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5D530E6D-E646-C799-A92E-262224A120DE}"/>
              </a:ext>
            </a:extLst>
          </p:cNvPr>
          <p:cNvSpPr>
            <a:spLocks noGrp="1"/>
          </p:cNvSpPr>
          <p:nvPr>
            <p:ph type="sldNum" sz="quarter" idx="12"/>
          </p:nvPr>
        </p:nvSpPr>
        <p:spPr/>
        <p:txBody>
          <a:body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34350643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E35719A-8AB5-E1B1-AF5B-0845862EFB7D}"/>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D14F7E0F-52C7-71E7-D880-8F8153EAF8E6}"/>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CC72779F-B40A-C9E4-5561-EFF1E31585FC}"/>
              </a:ext>
            </a:extLst>
          </p:cNvPr>
          <p:cNvSpPr>
            <a:spLocks noGrp="1"/>
          </p:cNvSpPr>
          <p:nvPr>
            <p:ph type="dt" sz="half" idx="10"/>
          </p:nvPr>
        </p:nvSpPr>
        <p:spPr/>
        <p:txBody>
          <a:bodyPr/>
          <a:lstStyle/>
          <a:p>
            <a:fld id="{3F599A6E-F3DD-46C1-87ED-5406E99CF1C6}" type="datetimeFigureOut">
              <a:rPr lang="zh-CN" altLang="en-US" smtClean="0"/>
              <a:t>2024/10/7</a:t>
            </a:fld>
            <a:endParaRPr lang="zh-CN" altLang="en-US"/>
          </a:p>
        </p:txBody>
      </p:sp>
      <p:sp>
        <p:nvSpPr>
          <p:cNvPr id="5" name="页脚占位符 4">
            <a:extLst>
              <a:ext uri="{FF2B5EF4-FFF2-40B4-BE49-F238E27FC236}">
                <a16:creationId xmlns:a16="http://schemas.microsoft.com/office/drawing/2014/main" id="{7BB9E80C-0258-260C-02EF-6D7DD50687D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D1FD44F-C13A-E922-8EFB-BDC10185743A}"/>
              </a:ext>
            </a:extLst>
          </p:cNvPr>
          <p:cNvSpPr>
            <a:spLocks noGrp="1"/>
          </p:cNvSpPr>
          <p:nvPr>
            <p:ph type="sldNum" sz="quarter" idx="12"/>
          </p:nvPr>
        </p:nvSpPr>
        <p:spPr/>
        <p:txBody>
          <a:body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3086081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2893991-0322-2469-2D74-35C12BE83CDB}"/>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12CB6649-C212-EDAD-E214-F63F23D78ED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E399660C-DF24-02DF-A45A-90C30DEABD21}"/>
              </a:ext>
            </a:extLst>
          </p:cNvPr>
          <p:cNvSpPr>
            <a:spLocks noGrp="1"/>
          </p:cNvSpPr>
          <p:nvPr>
            <p:ph type="dt" sz="half" idx="10"/>
          </p:nvPr>
        </p:nvSpPr>
        <p:spPr/>
        <p:txBody>
          <a:bodyPr/>
          <a:lstStyle/>
          <a:p>
            <a:fld id="{3F599A6E-F3DD-46C1-87ED-5406E99CF1C6}" type="datetimeFigureOut">
              <a:rPr lang="zh-CN" altLang="en-US" smtClean="0"/>
              <a:t>2024/10/7</a:t>
            </a:fld>
            <a:endParaRPr lang="zh-CN" altLang="en-US"/>
          </a:p>
        </p:txBody>
      </p:sp>
      <p:sp>
        <p:nvSpPr>
          <p:cNvPr id="5" name="页脚占位符 4">
            <a:extLst>
              <a:ext uri="{FF2B5EF4-FFF2-40B4-BE49-F238E27FC236}">
                <a16:creationId xmlns:a16="http://schemas.microsoft.com/office/drawing/2014/main" id="{909EF1B6-099A-84E4-CE70-24C7D1582EB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052D940-6A33-5225-E30F-2675EF50A5F2}"/>
              </a:ext>
            </a:extLst>
          </p:cNvPr>
          <p:cNvSpPr>
            <a:spLocks noGrp="1"/>
          </p:cNvSpPr>
          <p:nvPr>
            <p:ph type="sldNum" sz="quarter" idx="12"/>
          </p:nvPr>
        </p:nvSpPr>
        <p:spPr/>
        <p:txBody>
          <a:body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34435269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01801A2-7ADC-1746-00E5-EA586A6863F3}"/>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7BC9B3B3-724E-9F63-E086-9E24B1AF1721}"/>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6BB1714E-D165-C649-2F3E-A9450412B6A3}"/>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B406BA80-7ABC-E0B1-EA14-A12C195AA3AF}"/>
              </a:ext>
            </a:extLst>
          </p:cNvPr>
          <p:cNvSpPr>
            <a:spLocks noGrp="1"/>
          </p:cNvSpPr>
          <p:nvPr>
            <p:ph type="dt" sz="half" idx="10"/>
          </p:nvPr>
        </p:nvSpPr>
        <p:spPr/>
        <p:txBody>
          <a:bodyPr/>
          <a:lstStyle/>
          <a:p>
            <a:fld id="{3F599A6E-F3DD-46C1-87ED-5406E99CF1C6}" type="datetimeFigureOut">
              <a:rPr lang="zh-CN" altLang="en-US" smtClean="0"/>
              <a:t>2024/10/7</a:t>
            </a:fld>
            <a:endParaRPr lang="zh-CN" altLang="en-US"/>
          </a:p>
        </p:txBody>
      </p:sp>
      <p:sp>
        <p:nvSpPr>
          <p:cNvPr id="6" name="页脚占位符 5">
            <a:extLst>
              <a:ext uri="{FF2B5EF4-FFF2-40B4-BE49-F238E27FC236}">
                <a16:creationId xmlns:a16="http://schemas.microsoft.com/office/drawing/2014/main" id="{329ED4C9-44BD-F610-A51D-FEBDB2FA48B6}"/>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2A3E2636-5022-F55C-E729-C3763BD7C95E}"/>
              </a:ext>
            </a:extLst>
          </p:cNvPr>
          <p:cNvSpPr>
            <a:spLocks noGrp="1"/>
          </p:cNvSpPr>
          <p:nvPr>
            <p:ph type="sldNum" sz="quarter" idx="12"/>
          </p:nvPr>
        </p:nvSpPr>
        <p:spPr/>
        <p:txBody>
          <a:body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24788849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2D137E0-E08D-054A-7D2A-BCF97316E86A}"/>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1772F7AE-342C-8893-496A-044AF0D59BF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C9E189A4-D8B9-629E-9B50-FF51B955ED83}"/>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11080E61-6F99-9C82-04A1-021559B9D14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860C9B49-7569-F3B2-BF5B-C36B714367C7}"/>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2BD90688-136F-2C46-2A33-4343FCE8A067}"/>
              </a:ext>
            </a:extLst>
          </p:cNvPr>
          <p:cNvSpPr>
            <a:spLocks noGrp="1"/>
          </p:cNvSpPr>
          <p:nvPr>
            <p:ph type="dt" sz="half" idx="10"/>
          </p:nvPr>
        </p:nvSpPr>
        <p:spPr/>
        <p:txBody>
          <a:bodyPr/>
          <a:lstStyle/>
          <a:p>
            <a:fld id="{3F599A6E-F3DD-46C1-87ED-5406E99CF1C6}" type="datetimeFigureOut">
              <a:rPr lang="zh-CN" altLang="en-US" smtClean="0"/>
              <a:t>2024/10/7</a:t>
            </a:fld>
            <a:endParaRPr lang="zh-CN" altLang="en-US"/>
          </a:p>
        </p:txBody>
      </p:sp>
      <p:sp>
        <p:nvSpPr>
          <p:cNvPr id="8" name="页脚占位符 7">
            <a:extLst>
              <a:ext uri="{FF2B5EF4-FFF2-40B4-BE49-F238E27FC236}">
                <a16:creationId xmlns:a16="http://schemas.microsoft.com/office/drawing/2014/main" id="{7A58ED40-1A76-54E0-E4FA-325FA5B92C31}"/>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E002520D-80CB-5BF5-3BA1-2746EC4DBD5D}"/>
              </a:ext>
            </a:extLst>
          </p:cNvPr>
          <p:cNvSpPr>
            <a:spLocks noGrp="1"/>
          </p:cNvSpPr>
          <p:nvPr>
            <p:ph type="sldNum" sz="quarter" idx="12"/>
          </p:nvPr>
        </p:nvSpPr>
        <p:spPr/>
        <p:txBody>
          <a:body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5168194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D18D64C-AA9A-92F9-4824-E6D7FA927BF0}"/>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8E71F9F9-0C4B-3C92-20DC-A4B32F23492A}"/>
              </a:ext>
            </a:extLst>
          </p:cNvPr>
          <p:cNvSpPr>
            <a:spLocks noGrp="1"/>
          </p:cNvSpPr>
          <p:nvPr>
            <p:ph type="dt" sz="half" idx="10"/>
          </p:nvPr>
        </p:nvSpPr>
        <p:spPr/>
        <p:txBody>
          <a:bodyPr/>
          <a:lstStyle/>
          <a:p>
            <a:fld id="{3F599A6E-F3DD-46C1-87ED-5406E99CF1C6}" type="datetimeFigureOut">
              <a:rPr lang="zh-CN" altLang="en-US" smtClean="0"/>
              <a:t>2024/10/7</a:t>
            </a:fld>
            <a:endParaRPr lang="zh-CN" altLang="en-US"/>
          </a:p>
        </p:txBody>
      </p:sp>
      <p:sp>
        <p:nvSpPr>
          <p:cNvPr id="4" name="页脚占位符 3">
            <a:extLst>
              <a:ext uri="{FF2B5EF4-FFF2-40B4-BE49-F238E27FC236}">
                <a16:creationId xmlns:a16="http://schemas.microsoft.com/office/drawing/2014/main" id="{8D4B39C5-380C-64D2-DD9B-6A9E0498B4FA}"/>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FFA1EFAB-8D84-3146-E1D1-402FDD958B2F}"/>
              </a:ext>
            </a:extLst>
          </p:cNvPr>
          <p:cNvSpPr>
            <a:spLocks noGrp="1"/>
          </p:cNvSpPr>
          <p:nvPr>
            <p:ph type="sldNum" sz="quarter" idx="12"/>
          </p:nvPr>
        </p:nvSpPr>
        <p:spPr/>
        <p:txBody>
          <a:body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7419398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1DD9A40F-C70F-4428-A28B-993D5589FF7A}"/>
              </a:ext>
            </a:extLst>
          </p:cNvPr>
          <p:cNvSpPr>
            <a:spLocks noGrp="1"/>
          </p:cNvSpPr>
          <p:nvPr>
            <p:ph type="dt" sz="half" idx="10"/>
          </p:nvPr>
        </p:nvSpPr>
        <p:spPr/>
        <p:txBody>
          <a:bodyPr/>
          <a:lstStyle/>
          <a:p>
            <a:fld id="{3F599A6E-F3DD-46C1-87ED-5406E99CF1C6}" type="datetimeFigureOut">
              <a:rPr lang="zh-CN" altLang="en-US" smtClean="0"/>
              <a:t>2024/10/7</a:t>
            </a:fld>
            <a:endParaRPr lang="zh-CN" altLang="en-US"/>
          </a:p>
        </p:txBody>
      </p:sp>
      <p:sp>
        <p:nvSpPr>
          <p:cNvPr id="3" name="页脚占位符 2">
            <a:extLst>
              <a:ext uri="{FF2B5EF4-FFF2-40B4-BE49-F238E27FC236}">
                <a16:creationId xmlns:a16="http://schemas.microsoft.com/office/drawing/2014/main" id="{0622A28E-D917-7E4A-A943-A9B6B12BA3E0}"/>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21DFD8B0-DDAF-839B-A23E-16AA79AB9A6C}"/>
              </a:ext>
            </a:extLst>
          </p:cNvPr>
          <p:cNvSpPr>
            <a:spLocks noGrp="1"/>
          </p:cNvSpPr>
          <p:nvPr>
            <p:ph type="sldNum" sz="quarter" idx="12"/>
          </p:nvPr>
        </p:nvSpPr>
        <p:spPr/>
        <p:txBody>
          <a:body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2924997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50EABA6-6077-6AED-446E-FB24F2255792}"/>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49F47C30-74EE-FF2A-B599-8F16A8B3574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6777A799-9B3A-3FBB-6AD9-C3EF87C5228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0877B140-F8CB-E05F-E5C9-2E3994C83656}"/>
              </a:ext>
            </a:extLst>
          </p:cNvPr>
          <p:cNvSpPr>
            <a:spLocks noGrp="1"/>
          </p:cNvSpPr>
          <p:nvPr>
            <p:ph type="dt" sz="half" idx="10"/>
          </p:nvPr>
        </p:nvSpPr>
        <p:spPr/>
        <p:txBody>
          <a:bodyPr/>
          <a:lstStyle/>
          <a:p>
            <a:fld id="{3F599A6E-F3DD-46C1-87ED-5406E99CF1C6}" type="datetimeFigureOut">
              <a:rPr lang="zh-CN" altLang="en-US" smtClean="0"/>
              <a:t>2024/10/7</a:t>
            </a:fld>
            <a:endParaRPr lang="zh-CN" altLang="en-US"/>
          </a:p>
        </p:txBody>
      </p:sp>
      <p:sp>
        <p:nvSpPr>
          <p:cNvPr id="6" name="页脚占位符 5">
            <a:extLst>
              <a:ext uri="{FF2B5EF4-FFF2-40B4-BE49-F238E27FC236}">
                <a16:creationId xmlns:a16="http://schemas.microsoft.com/office/drawing/2014/main" id="{B1295D32-CFB1-8B28-6CC5-8459FA4F6EBB}"/>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37814526-70D0-FEC3-5A9C-AF7239E4A468}"/>
              </a:ext>
            </a:extLst>
          </p:cNvPr>
          <p:cNvSpPr>
            <a:spLocks noGrp="1"/>
          </p:cNvSpPr>
          <p:nvPr>
            <p:ph type="sldNum" sz="quarter" idx="12"/>
          </p:nvPr>
        </p:nvSpPr>
        <p:spPr/>
        <p:txBody>
          <a:body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21156392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CE04288-9417-85F4-72BC-D7A8B5045B74}"/>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9C19EA35-BF70-4E5D-C53A-71D2BEBCD31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9FE0A5D9-900D-3770-D025-31B9173FF00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42E3D1C1-9D12-31D1-4D34-60C65F0764A3}"/>
              </a:ext>
            </a:extLst>
          </p:cNvPr>
          <p:cNvSpPr>
            <a:spLocks noGrp="1"/>
          </p:cNvSpPr>
          <p:nvPr>
            <p:ph type="dt" sz="half" idx="10"/>
          </p:nvPr>
        </p:nvSpPr>
        <p:spPr/>
        <p:txBody>
          <a:bodyPr/>
          <a:lstStyle/>
          <a:p>
            <a:fld id="{3F599A6E-F3DD-46C1-87ED-5406E99CF1C6}" type="datetimeFigureOut">
              <a:rPr lang="zh-CN" altLang="en-US" smtClean="0"/>
              <a:t>2024/10/7</a:t>
            </a:fld>
            <a:endParaRPr lang="zh-CN" altLang="en-US"/>
          </a:p>
        </p:txBody>
      </p:sp>
      <p:sp>
        <p:nvSpPr>
          <p:cNvPr id="6" name="页脚占位符 5">
            <a:extLst>
              <a:ext uri="{FF2B5EF4-FFF2-40B4-BE49-F238E27FC236}">
                <a16:creationId xmlns:a16="http://schemas.microsoft.com/office/drawing/2014/main" id="{ECD63966-C3F2-64C5-549E-AFC661B788C2}"/>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59D989D2-49EB-0DC7-0A1D-DB02970F7743}"/>
              </a:ext>
            </a:extLst>
          </p:cNvPr>
          <p:cNvSpPr>
            <a:spLocks noGrp="1"/>
          </p:cNvSpPr>
          <p:nvPr>
            <p:ph type="sldNum" sz="quarter" idx="12"/>
          </p:nvPr>
        </p:nvSpPr>
        <p:spPr/>
        <p:txBody>
          <a:body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37276237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03754422-954C-22DE-8EFB-4DB65897682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8E1362C7-EB65-71A7-9EB3-F05511DA5E3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F1C7288-3525-36CB-6143-6A2B7D5A546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F599A6E-F3DD-46C1-87ED-5406E99CF1C6}" type="datetimeFigureOut">
              <a:rPr lang="zh-CN" altLang="en-US" smtClean="0"/>
              <a:t>2024/10/7</a:t>
            </a:fld>
            <a:endParaRPr lang="zh-CN" altLang="en-US"/>
          </a:p>
        </p:txBody>
      </p:sp>
      <p:sp>
        <p:nvSpPr>
          <p:cNvPr id="5" name="页脚占位符 4">
            <a:extLst>
              <a:ext uri="{FF2B5EF4-FFF2-40B4-BE49-F238E27FC236}">
                <a16:creationId xmlns:a16="http://schemas.microsoft.com/office/drawing/2014/main" id="{E9ACA10C-0BBE-3FF1-8DB8-A12CC7E3AD7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3344142A-7BEC-4310-4BCF-42085FCEBB3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74C6FEE-3450-41F6-AE1F-F8810098C07F}" type="slidenum">
              <a:rPr lang="zh-CN" altLang="en-US" smtClean="0"/>
              <a:t>‹#›</a:t>
            </a:fld>
            <a:endParaRPr lang="zh-CN" altLang="en-US"/>
          </a:p>
        </p:txBody>
      </p:sp>
    </p:spTree>
    <p:extLst>
      <p:ext uri="{BB962C8B-B14F-4D97-AF65-F5344CB8AC3E}">
        <p14:creationId xmlns:p14="http://schemas.microsoft.com/office/powerpoint/2010/main" val="792044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19D1CD6-613E-543A-7AAE-42F31C3C7EE4}"/>
              </a:ext>
            </a:extLst>
          </p:cNvPr>
          <p:cNvSpPr>
            <a:spLocks noGrp="1"/>
          </p:cNvSpPr>
          <p:nvPr>
            <p:ph type="ctrTitle"/>
          </p:nvPr>
        </p:nvSpPr>
        <p:spPr/>
        <p:txBody>
          <a:bodyPr/>
          <a:lstStyle/>
          <a:p>
            <a:r>
              <a:rPr lang="en-US" altLang="zh-CN" dirty="0"/>
              <a:t>27 time series plots</a:t>
            </a:r>
            <a:endParaRPr lang="zh-CN" altLang="en-US" dirty="0"/>
          </a:p>
        </p:txBody>
      </p:sp>
    </p:spTree>
    <p:extLst>
      <p:ext uri="{BB962C8B-B14F-4D97-AF65-F5344CB8AC3E}">
        <p14:creationId xmlns:p14="http://schemas.microsoft.com/office/powerpoint/2010/main" val="25382607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AEB5483-27C4-3CD4-227E-AB1F6278D1B8}"/>
              </a:ext>
            </a:extLst>
          </p:cNvPr>
          <p:cNvSpPr>
            <a:spLocks noGrp="1"/>
          </p:cNvSpPr>
          <p:nvPr>
            <p:ph type="title"/>
          </p:nvPr>
        </p:nvSpPr>
        <p:spPr/>
        <p:txBody>
          <a:bodyPr>
            <a:normAutofit/>
          </a:bodyPr>
          <a:lstStyle/>
          <a:p>
            <a:r>
              <a:rPr lang="en-US" altLang="zh-CN" sz="2800" dirty="0">
                <a:latin typeface="Times New Roman" panose="02020603050405020304" pitchFamily="18" charset="0"/>
                <a:ea typeface="+mn-ea"/>
                <a:cs typeface="Times New Roman" panose="02020603050405020304" pitchFamily="18" charset="0"/>
              </a:rPr>
              <a:t>Legends correspond to coordinates</a:t>
            </a:r>
            <a:endParaRPr lang="zh-CN" altLang="en-US" sz="2800" dirty="0">
              <a:latin typeface="Times New Roman" panose="02020603050405020304" pitchFamily="18" charset="0"/>
              <a:ea typeface="+mn-ea"/>
              <a:cs typeface="Times New Roman" panose="02020603050405020304" pitchFamily="18" charset="0"/>
            </a:endParaRPr>
          </a:p>
        </p:txBody>
      </p:sp>
      <p:graphicFrame>
        <p:nvGraphicFramePr>
          <p:cNvPr id="4" name="内容占位符 3">
            <a:extLst>
              <a:ext uri="{FF2B5EF4-FFF2-40B4-BE49-F238E27FC236}">
                <a16:creationId xmlns:a16="http://schemas.microsoft.com/office/drawing/2014/main" id="{DC28393C-DF53-48E7-3967-B910D1E67407}"/>
              </a:ext>
            </a:extLst>
          </p:cNvPr>
          <p:cNvGraphicFramePr>
            <a:graphicFrameLocks noGrp="1"/>
          </p:cNvGraphicFramePr>
          <p:nvPr>
            <p:ph idx="1"/>
            <p:extLst>
              <p:ext uri="{D42A27DB-BD31-4B8C-83A1-F6EECF244321}">
                <p14:modId xmlns:p14="http://schemas.microsoft.com/office/powerpoint/2010/main" val="3554707928"/>
              </p:ext>
            </p:extLst>
          </p:nvPr>
        </p:nvGraphicFramePr>
        <p:xfrm>
          <a:off x="1920175" y="1690688"/>
          <a:ext cx="2743202" cy="4895179"/>
        </p:xfrm>
        <a:graphic>
          <a:graphicData uri="http://schemas.openxmlformats.org/drawingml/2006/table">
            <a:tbl>
              <a:tblPr>
                <a:tableStyleId>{2D5ABB26-0587-4C30-8999-92F81FD0307C}</a:tableStyleId>
              </a:tblPr>
              <a:tblGrid>
                <a:gridCol w="1006765">
                  <a:extLst>
                    <a:ext uri="{9D8B030D-6E8A-4147-A177-3AD203B41FA5}">
                      <a16:colId xmlns:a16="http://schemas.microsoft.com/office/drawing/2014/main" val="2167425253"/>
                    </a:ext>
                  </a:extLst>
                </a:gridCol>
                <a:gridCol w="1736437">
                  <a:extLst>
                    <a:ext uri="{9D8B030D-6E8A-4147-A177-3AD203B41FA5}">
                      <a16:colId xmlns:a16="http://schemas.microsoft.com/office/drawing/2014/main" val="4004854689"/>
                    </a:ext>
                  </a:extLst>
                </a:gridCol>
              </a:tblGrid>
              <a:tr h="234169">
                <a:tc>
                  <a:txBody>
                    <a:bodyPr/>
                    <a:lstStyle/>
                    <a:p>
                      <a:pPr algn="l" fontAlgn="b"/>
                      <a:r>
                        <a:rPr lang="en-US" altLang="zh-CN" sz="1100" b="0" u="none" strike="noStrike" dirty="0">
                          <a:solidFill>
                            <a:srgbClr val="000000"/>
                          </a:solidFill>
                          <a:effectLst/>
                        </a:rPr>
                        <a:t> legend </a:t>
                      </a:r>
                      <a:endParaRPr lang="zh-CN"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1100" b="0" u="none" strike="noStrike" dirty="0" err="1">
                          <a:effectLst/>
                        </a:rPr>
                        <a:t>XYZ</a:t>
                      </a:r>
                      <a:r>
                        <a:rPr lang="en-US" altLang="zh-CN" sz="1100" b="0" u="none" strike="noStrike" dirty="0" err="1">
                          <a:effectLst/>
                        </a:rPr>
                        <a:t>coordinates</a:t>
                      </a:r>
                      <a:endParaRPr lang="zh-CN" altLang="en-US" sz="11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87678450"/>
                  </a:ext>
                </a:extLst>
              </a:tr>
              <a:tr h="141112">
                <a:tc>
                  <a:txBody>
                    <a:bodyPr/>
                    <a:lstStyle/>
                    <a:p>
                      <a:pPr algn="l" fontAlgn="b"/>
                      <a:r>
                        <a:rPr lang="en-US" sz="1000" u="none" strike="noStrike">
                          <a:effectLst/>
                        </a:rPr>
                        <a:t>Coor_1</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dirty="0">
                          <a:effectLst/>
                        </a:rPr>
                        <a:t>-21,12,-6</a:t>
                      </a:r>
                      <a:endParaRPr lang="en-US" altLang="zh-CN" sz="1000" b="0" i="0" u="none" strike="noStrike" dirty="0">
                        <a:solidFill>
                          <a:srgbClr val="FF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41019627"/>
                  </a:ext>
                </a:extLst>
              </a:tr>
              <a:tr h="141112">
                <a:tc>
                  <a:txBody>
                    <a:bodyPr/>
                    <a:lstStyle/>
                    <a:p>
                      <a:pPr algn="l" fontAlgn="b"/>
                      <a:r>
                        <a:rPr lang="en-US" sz="1000" u="none" strike="noStrike">
                          <a:effectLst/>
                        </a:rPr>
                        <a:t>Coor_2</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21,9,-6</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92350498"/>
                  </a:ext>
                </a:extLst>
              </a:tr>
              <a:tr h="141112">
                <a:tc>
                  <a:txBody>
                    <a:bodyPr/>
                    <a:lstStyle/>
                    <a:p>
                      <a:pPr algn="l" fontAlgn="b"/>
                      <a:r>
                        <a:rPr lang="en-US" sz="1000" u="none" strike="noStrike">
                          <a:effectLst/>
                        </a:rPr>
                        <a:t>Coor_3</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dirty="0">
                          <a:effectLst/>
                        </a:rPr>
                        <a:t>-21,9,-9</a:t>
                      </a:r>
                      <a:endParaRPr lang="en-US" altLang="zh-CN"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00022851"/>
                  </a:ext>
                </a:extLst>
              </a:tr>
              <a:tr h="141112">
                <a:tc>
                  <a:txBody>
                    <a:bodyPr/>
                    <a:lstStyle/>
                    <a:p>
                      <a:pPr algn="l" fontAlgn="b"/>
                      <a:r>
                        <a:rPr lang="en-US" sz="1000" u="none" strike="noStrike">
                          <a:effectLst/>
                        </a:rPr>
                        <a:t>Coor_4</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dirty="0">
                          <a:effectLst/>
                        </a:rPr>
                        <a:t>-21,9,-3</a:t>
                      </a:r>
                      <a:endParaRPr lang="en-US" altLang="zh-CN"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09443918"/>
                  </a:ext>
                </a:extLst>
              </a:tr>
              <a:tr h="141112">
                <a:tc>
                  <a:txBody>
                    <a:bodyPr/>
                    <a:lstStyle/>
                    <a:p>
                      <a:pPr algn="l" fontAlgn="b"/>
                      <a:r>
                        <a:rPr lang="en-US" sz="1000" u="none" strike="noStrike">
                          <a:effectLst/>
                        </a:rPr>
                        <a:t>Coor_5</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21,12,-9</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1999407"/>
                  </a:ext>
                </a:extLst>
              </a:tr>
              <a:tr h="141112">
                <a:tc>
                  <a:txBody>
                    <a:bodyPr/>
                    <a:lstStyle/>
                    <a:p>
                      <a:pPr algn="l" fontAlgn="b"/>
                      <a:r>
                        <a:rPr lang="en-US" sz="1000" u="none" strike="noStrike">
                          <a:effectLst/>
                        </a:rPr>
                        <a:t>Coor_6</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21,12,-3</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02185060"/>
                  </a:ext>
                </a:extLst>
              </a:tr>
              <a:tr h="141112">
                <a:tc>
                  <a:txBody>
                    <a:bodyPr/>
                    <a:lstStyle/>
                    <a:p>
                      <a:pPr algn="l" fontAlgn="b"/>
                      <a:r>
                        <a:rPr lang="en-US" sz="1000" u="none" strike="noStrike">
                          <a:effectLst/>
                        </a:rPr>
                        <a:t>Coor_7</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dirty="0">
                          <a:effectLst/>
                        </a:rPr>
                        <a:t>-21,15,-6</a:t>
                      </a:r>
                      <a:endParaRPr lang="en-US" altLang="zh-CN"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49675213"/>
                  </a:ext>
                </a:extLst>
              </a:tr>
              <a:tr h="141112">
                <a:tc>
                  <a:txBody>
                    <a:bodyPr/>
                    <a:lstStyle/>
                    <a:p>
                      <a:pPr algn="l" fontAlgn="b"/>
                      <a:r>
                        <a:rPr lang="en-US" sz="1000" u="none" strike="noStrike">
                          <a:effectLst/>
                        </a:rPr>
                        <a:t>Coor_8</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dirty="0">
                          <a:effectLst/>
                        </a:rPr>
                        <a:t>-21,15,-9</a:t>
                      </a:r>
                      <a:endParaRPr lang="en-US" altLang="zh-CN"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266292476"/>
                  </a:ext>
                </a:extLst>
              </a:tr>
              <a:tr h="141112">
                <a:tc>
                  <a:txBody>
                    <a:bodyPr/>
                    <a:lstStyle/>
                    <a:p>
                      <a:pPr algn="l" fontAlgn="b"/>
                      <a:r>
                        <a:rPr lang="en-US" sz="1000" u="none" strike="noStrike">
                          <a:effectLst/>
                        </a:rPr>
                        <a:t>Coor_9</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dirty="0">
                          <a:effectLst/>
                        </a:rPr>
                        <a:t>-21,15,-3</a:t>
                      </a:r>
                      <a:endParaRPr lang="en-US" altLang="zh-CN"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4424525"/>
                  </a:ext>
                </a:extLst>
              </a:tr>
              <a:tr h="193414">
                <a:tc>
                  <a:txBody>
                    <a:bodyPr/>
                    <a:lstStyle/>
                    <a:p>
                      <a:pPr algn="l" fontAlgn="b"/>
                      <a:endParaRPr lang="zh-CN" alt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zh-CN"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34838415"/>
                  </a:ext>
                </a:extLst>
              </a:tr>
              <a:tr h="141112">
                <a:tc>
                  <a:txBody>
                    <a:bodyPr/>
                    <a:lstStyle/>
                    <a:p>
                      <a:pPr algn="l" fontAlgn="b"/>
                      <a:r>
                        <a:rPr lang="en-US" sz="1000" u="none" strike="noStrike">
                          <a:effectLst/>
                        </a:rPr>
                        <a:t>Coor_10</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dirty="0">
                          <a:effectLst/>
                        </a:rPr>
                        <a:t>-18,12,-6</a:t>
                      </a:r>
                      <a:endParaRPr lang="en-US" altLang="zh-CN"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31855800"/>
                  </a:ext>
                </a:extLst>
              </a:tr>
              <a:tr h="141112">
                <a:tc>
                  <a:txBody>
                    <a:bodyPr/>
                    <a:lstStyle/>
                    <a:p>
                      <a:pPr algn="l" fontAlgn="b"/>
                      <a:r>
                        <a:rPr lang="en-US" sz="1000" u="none" strike="noStrike">
                          <a:effectLst/>
                        </a:rPr>
                        <a:t>Coor_11</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18,12,-9</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32955767"/>
                  </a:ext>
                </a:extLst>
              </a:tr>
              <a:tr h="141112">
                <a:tc>
                  <a:txBody>
                    <a:bodyPr/>
                    <a:lstStyle/>
                    <a:p>
                      <a:pPr algn="l" fontAlgn="b"/>
                      <a:r>
                        <a:rPr lang="en-US" sz="1000" u="none" strike="noStrike">
                          <a:effectLst/>
                        </a:rPr>
                        <a:t>Coor_12</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18,12,-3</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18134852"/>
                  </a:ext>
                </a:extLst>
              </a:tr>
              <a:tr h="141112">
                <a:tc>
                  <a:txBody>
                    <a:bodyPr/>
                    <a:lstStyle/>
                    <a:p>
                      <a:pPr algn="l" fontAlgn="b"/>
                      <a:r>
                        <a:rPr lang="en-US" sz="1000" u="none" strike="noStrike">
                          <a:effectLst/>
                        </a:rPr>
                        <a:t>Coor_13</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dirty="0">
                          <a:effectLst/>
                        </a:rPr>
                        <a:t>-18,9,-6</a:t>
                      </a:r>
                      <a:endParaRPr lang="en-US" altLang="zh-CN"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85683050"/>
                  </a:ext>
                </a:extLst>
              </a:tr>
              <a:tr h="141112">
                <a:tc>
                  <a:txBody>
                    <a:bodyPr/>
                    <a:lstStyle/>
                    <a:p>
                      <a:pPr algn="l" fontAlgn="b"/>
                      <a:r>
                        <a:rPr lang="en-US" sz="1000" u="none" strike="noStrike">
                          <a:effectLst/>
                        </a:rPr>
                        <a:t>Coor_14</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18,9,-9</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72010641"/>
                  </a:ext>
                </a:extLst>
              </a:tr>
              <a:tr h="141112">
                <a:tc>
                  <a:txBody>
                    <a:bodyPr/>
                    <a:lstStyle/>
                    <a:p>
                      <a:pPr algn="l" fontAlgn="b"/>
                      <a:r>
                        <a:rPr lang="en-US" sz="1000" u="none" strike="noStrike">
                          <a:effectLst/>
                        </a:rPr>
                        <a:t>Coor_15</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18,9,-3</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65456794"/>
                  </a:ext>
                </a:extLst>
              </a:tr>
              <a:tr h="141112">
                <a:tc>
                  <a:txBody>
                    <a:bodyPr/>
                    <a:lstStyle/>
                    <a:p>
                      <a:pPr algn="l" fontAlgn="b"/>
                      <a:r>
                        <a:rPr lang="en-US" sz="1000" u="none" strike="noStrike">
                          <a:effectLst/>
                        </a:rPr>
                        <a:t>Coor_16</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18,15,-6</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65622383"/>
                  </a:ext>
                </a:extLst>
              </a:tr>
              <a:tr h="141112">
                <a:tc>
                  <a:txBody>
                    <a:bodyPr/>
                    <a:lstStyle/>
                    <a:p>
                      <a:pPr algn="l" fontAlgn="b"/>
                      <a:r>
                        <a:rPr lang="en-US" sz="1000" u="none" strike="noStrike">
                          <a:effectLst/>
                        </a:rPr>
                        <a:t>Coor_17</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18,15,-9</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44295120"/>
                  </a:ext>
                </a:extLst>
              </a:tr>
              <a:tr h="141112">
                <a:tc>
                  <a:txBody>
                    <a:bodyPr/>
                    <a:lstStyle/>
                    <a:p>
                      <a:pPr algn="l" fontAlgn="b"/>
                      <a:r>
                        <a:rPr lang="en-US" sz="1000" u="none" strike="noStrike">
                          <a:effectLst/>
                        </a:rPr>
                        <a:t>Coor_18</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18,15,-3</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93107708"/>
                  </a:ext>
                </a:extLst>
              </a:tr>
              <a:tr h="141112">
                <a:tc>
                  <a:txBody>
                    <a:bodyPr/>
                    <a:lstStyle/>
                    <a:p>
                      <a:pPr algn="l" fontAlgn="b"/>
                      <a:endParaRPr lang="zh-CN" alt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zh-CN" alt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04334805"/>
                  </a:ext>
                </a:extLst>
              </a:tr>
              <a:tr h="141112">
                <a:tc>
                  <a:txBody>
                    <a:bodyPr/>
                    <a:lstStyle/>
                    <a:p>
                      <a:pPr algn="l" fontAlgn="b"/>
                      <a:r>
                        <a:rPr lang="en-US" sz="1000" u="none" strike="noStrike">
                          <a:effectLst/>
                        </a:rPr>
                        <a:t>Coor_19</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24,12,-6</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25093583"/>
                  </a:ext>
                </a:extLst>
              </a:tr>
              <a:tr h="141112">
                <a:tc>
                  <a:txBody>
                    <a:bodyPr/>
                    <a:lstStyle/>
                    <a:p>
                      <a:pPr algn="l" fontAlgn="b"/>
                      <a:r>
                        <a:rPr lang="en-US" sz="1000" u="none" strike="noStrike">
                          <a:effectLst/>
                        </a:rPr>
                        <a:t>Coor_20</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24,12,-9</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19330509"/>
                  </a:ext>
                </a:extLst>
              </a:tr>
              <a:tr h="141112">
                <a:tc>
                  <a:txBody>
                    <a:bodyPr/>
                    <a:lstStyle/>
                    <a:p>
                      <a:pPr algn="l" fontAlgn="b"/>
                      <a:r>
                        <a:rPr lang="en-US" sz="1000" u="none" strike="noStrike">
                          <a:effectLst/>
                        </a:rPr>
                        <a:t>Coor_21</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dirty="0">
                          <a:effectLst/>
                        </a:rPr>
                        <a:t>-24,12,-3</a:t>
                      </a:r>
                      <a:endParaRPr lang="en-US" altLang="zh-CN"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11779439"/>
                  </a:ext>
                </a:extLst>
              </a:tr>
              <a:tr h="141112">
                <a:tc>
                  <a:txBody>
                    <a:bodyPr/>
                    <a:lstStyle/>
                    <a:p>
                      <a:pPr algn="l" fontAlgn="b"/>
                      <a:r>
                        <a:rPr lang="en-US" sz="1000" u="none" strike="noStrike">
                          <a:effectLst/>
                        </a:rPr>
                        <a:t>Coor_22</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24,9,-6</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12450098"/>
                  </a:ext>
                </a:extLst>
              </a:tr>
              <a:tr h="141112">
                <a:tc>
                  <a:txBody>
                    <a:bodyPr/>
                    <a:lstStyle/>
                    <a:p>
                      <a:pPr algn="l" fontAlgn="b"/>
                      <a:r>
                        <a:rPr lang="en-US" sz="1000" u="none" strike="noStrike">
                          <a:effectLst/>
                        </a:rPr>
                        <a:t>Coor_23</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24,9,-9</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59686597"/>
                  </a:ext>
                </a:extLst>
              </a:tr>
              <a:tr h="141112">
                <a:tc>
                  <a:txBody>
                    <a:bodyPr/>
                    <a:lstStyle/>
                    <a:p>
                      <a:pPr algn="l" fontAlgn="b"/>
                      <a:r>
                        <a:rPr lang="en-US" sz="1000" u="none" strike="noStrike">
                          <a:effectLst/>
                        </a:rPr>
                        <a:t>Coor_24</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24,9,-3</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193349"/>
                  </a:ext>
                </a:extLst>
              </a:tr>
              <a:tr h="141112">
                <a:tc>
                  <a:txBody>
                    <a:bodyPr/>
                    <a:lstStyle/>
                    <a:p>
                      <a:pPr algn="l" fontAlgn="b"/>
                      <a:r>
                        <a:rPr lang="en-US" sz="1000" u="none" strike="noStrike">
                          <a:effectLst/>
                        </a:rPr>
                        <a:t>Coor_25</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24,15,-6</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02027998"/>
                  </a:ext>
                </a:extLst>
              </a:tr>
              <a:tr h="141112">
                <a:tc>
                  <a:txBody>
                    <a:bodyPr/>
                    <a:lstStyle/>
                    <a:p>
                      <a:pPr algn="l" fontAlgn="b"/>
                      <a:r>
                        <a:rPr lang="en-US" sz="1000" u="none" strike="noStrike">
                          <a:effectLst/>
                        </a:rPr>
                        <a:t>Coor_26</a:t>
                      </a:r>
                      <a:endParaRPr lang="en-US"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a:effectLst/>
                        </a:rPr>
                        <a:t>-24,15,-9</a:t>
                      </a:r>
                      <a:endParaRPr lang="en-US" altLang="zh-CN" sz="1000" b="0" i="0" u="none" strike="noStrike">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34545855"/>
                  </a:ext>
                </a:extLst>
              </a:tr>
              <a:tr h="141112">
                <a:tc>
                  <a:txBody>
                    <a:bodyPr/>
                    <a:lstStyle/>
                    <a:p>
                      <a:pPr algn="l" fontAlgn="b"/>
                      <a:r>
                        <a:rPr lang="en-US" sz="1000" u="none" strike="noStrike" dirty="0">
                          <a:effectLst/>
                        </a:rPr>
                        <a:t>Coor_27</a:t>
                      </a:r>
                      <a:endParaRPr lang="en-US"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altLang="zh-CN" sz="1000" u="none" strike="noStrike" dirty="0">
                          <a:effectLst/>
                        </a:rPr>
                        <a:t>-24,15,-3</a:t>
                      </a:r>
                      <a:endParaRPr lang="en-US" altLang="zh-CN" sz="1000" b="0" i="0" u="none" strike="noStrike" dirty="0">
                        <a:solidFill>
                          <a:srgbClr val="000000"/>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7157" marR="7157" marT="7157"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4518716"/>
                  </a:ext>
                </a:extLst>
              </a:tr>
            </a:tbl>
          </a:graphicData>
        </a:graphic>
      </p:graphicFrame>
      <p:sp>
        <p:nvSpPr>
          <p:cNvPr id="3" name="文本框 2">
            <a:extLst>
              <a:ext uri="{FF2B5EF4-FFF2-40B4-BE49-F238E27FC236}">
                <a16:creationId xmlns:a16="http://schemas.microsoft.com/office/drawing/2014/main" id="{4BAEA42B-EA4E-D04D-1B1E-EA75C8955864}"/>
              </a:ext>
            </a:extLst>
          </p:cNvPr>
          <p:cNvSpPr txBox="1"/>
          <p:nvPr/>
        </p:nvSpPr>
        <p:spPr>
          <a:xfrm>
            <a:off x="5548544" y="1690688"/>
            <a:ext cx="6486236" cy="4266809"/>
          </a:xfrm>
          <a:prstGeom prst="rect">
            <a:avLst/>
          </a:prstGeom>
          <a:noFill/>
        </p:spPr>
        <p:txBody>
          <a:bodyPr wrap="square" rtlCol="0">
            <a:spAutoFit/>
          </a:bodyPr>
          <a:lstStyle/>
          <a:p>
            <a:pPr>
              <a:lnSpc>
                <a:spcPct val="170000"/>
              </a:lnSpc>
            </a:pPr>
            <a:r>
              <a:rPr lang="en-US" altLang="zh-CN" sz="1800" dirty="0">
                <a:latin typeface="Times New Roman" panose="02020603050405020304" pitchFamily="18" charset="0"/>
                <a:cs typeface="Times New Roman" panose="02020603050405020304" pitchFamily="18" charset="0"/>
              </a:rPr>
              <a:t>The peak points of ANOVA in the SFB show significant differences in ReHo: -21,12, -6. The surrounding voxel coordinates are defined with the peak point. Since the data dimension is 3×3×3, the surrounding voxel coordinates x, y and z are combined with +3 and -3 respectively, and 26 surrounding coordinates were finally obtained. The time series values of each subject were extracted with 27 coordinates. The ReHo time series curve is presented this time, and each group presents one subject’s (CP group: cp_sub_001; NP group : np_sub_003; HC group: hc_sub_007)</a:t>
            </a:r>
          </a:p>
        </p:txBody>
      </p:sp>
    </p:spTree>
    <p:extLst>
      <p:ext uri="{BB962C8B-B14F-4D97-AF65-F5344CB8AC3E}">
        <p14:creationId xmlns:p14="http://schemas.microsoft.com/office/powerpoint/2010/main" val="21794128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图表 3">
            <a:extLst>
              <a:ext uri="{FF2B5EF4-FFF2-40B4-BE49-F238E27FC236}">
                <a16:creationId xmlns:a16="http://schemas.microsoft.com/office/drawing/2014/main" id="{CFA9AB14-29D5-CB2F-0F9B-FFEDC8439B43}"/>
              </a:ext>
            </a:extLst>
          </p:cNvPr>
          <p:cNvGraphicFramePr>
            <a:graphicFrameLocks/>
          </p:cNvGraphicFramePr>
          <p:nvPr>
            <p:extLst>
              <p:ext uri="{D42A27DB-BD31-4B8C-83A1-F6EECF244321}">
                <p14:modId xmlns:p14="http://schemas.microsoft.com/office/powerpoint/2010/main" val="2104359622"/>
              </p:ext>
            </p:extLst>
          </p:nvPr>
        </p:nvGraphicFramePr>
        <p:xfrm>
          <a:off x="959643" y="1276350"/>
          <a:ext cx="10272714" cy="4305299"/>
        </p:xfrm>
        <a:graphic>
          <a:graphicData uri="http://schemas.openxmlformats.org/drawingml/2006/chart">
            <c:chart xmlns:c="http://schemas.openxmlformats.org/drawingml/2006/chart" xmlns:r="http://schemas.openxmlformats.org/officeDocument/2006/relationships" r:id="rId2"/>
          </a:graphicData>
        </a:graphic>
      </p:graphicFrame>
      <p:sp>
        <p:nvSpPr>
          <p:cNvPr id="6" name="文本框 5">
            <a:extLst>
              <a:ext uri="{FF2B5EF4-FFF2-40B4-BE49-F238E27FC236}">
                <a16:creationId xmlns:a16="http://schemas.microsoft.com/office/drawing/2014/main" id="{0FF44949-5871-D220-9DC7-EC6D781EE772}"/>
              </a:ext>
            </a:extLst>
          </p:cNvPr>
          <p:cNvSpPr txBox="1"/>
          <p:nvPr/>
        </p:nvSpPr>
        <p:spPr>
          <a:xfrm>
            <a:off x="1369381" y="290289"/>
            <a:ext cx="6094520" cy="400110"/>
          </a:xfrm>
          <a:prstGeom prst="rect">
            <a:avLst/>
          </a:prstGeom>
          <a:noFill/>
        </p:spPr>
        <p:txBody>
          <a:bodyPr wrap="square">
            <a:spAutoFit/>
          </a:bodyPr>
          <a:lstStyle/>
          <a:p>
            <a:r>
              <a:rPr lang="en-US" altLang="zh-CN" sz="2000" b="1" dirty="0"/>
              <a:t>cp_sub_001</a:t>
            </a:r>
            <a:endParaRPr lang="zh-CN" altLang="en-US" sz="2000" b="1" dirty="0"/>
          </a:p>
        </p:txBody>
      </p:sp>
    </p:spTree>
    <p:extLst>
      <p:ext uri="{BB962C8B-B14F-4D97-AF65-F5344CB8AC3E}">
        <p14:creationId xmlns:p14="http://schemas.microsoft.com/office/powerpoint/2010/main" val="36831591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图表 3">
            <a:extLst>
              <a:ext uri="{FF2B5EF4-FFF2-40B4-BE49-F238E27FC236}">
                <a16:creationId xmlns:a16="http://schemas.microsoft.com/office/drawing/2014/main" id="{94B7AA6F-9E88-8157-B7DE-8917EA52A801}"/>
              </a:ext>
            </a:extLst>
          </p:cNvPr>
          <p:cNvGraphicFramePr>
            <a:graphicFrameLocks/>
          </p:cNvGraphicFramePr>
          <p:nvPr>
            <p:extLst>
              <p:ext uri="{D42A27DB-BD31-4B8C-83A1-F6EECF244321}">
                <p14:modId xmlns:p14="http://schemas.microsoft.com/office/powerpoint/2010/main" val="686449940"/>
              </p:ext>
            </p:extLst>
          </p:nvPr>
        </p:nvGraphicFramePr>
        <p:xfrm>
          <a:off x="950118" y="1281112"/>
          <a:ext cx="10291764" cy="4622537"/>
        </p:xfrm>
        <a:graphic>
          <a:graphicData uri="http://schemas.openxmlformats.org/drawingml/2006/chart">
            <c:chart xmlns:c="http://schemas.openxmlformats.org/drawingml/2006/chart" xmlns:r="http://schemas.openxmlformats.org/officeDocument/2006/relationships" r:id="rId2"/>
          </a:graphicData>
        </a:graphic>
      </p:graphicFrame>
      <p:sp>
        <p:nvSpPr>
          <p:cNvPr id="3" name="文本框 2">
            <a:extLst>
              <a:ext uri="{FF2B5EF4-FFF2-40B4-BE49-F238E27FC236}">
                <a16:creationId xmlns:a16="http://schemas.microsoft.com/office/drawing/2014/main" id="{D0B46EF6-19E3-04E9-6D46-B035EC15A65A}"/>
              </a:ext>
            </a:extLst>
          </p:cNvPr>
          <p:cNvSpPr txBox="1"/>
          <p:nvPr/>
        </p:nvSpPr>
        <p:spPr>
          <a:xfrm>
            <a:off x="1191827" y="432331"/>
            <a:ext cx="6094520" cy="400110"/>
          </a:xfrm>
          <a:prstGeom prst="rect">
            <a:avLst/>
          </a:prstGeom>
          <a:noFill/>
        </p:spPr>
        <p:txBody>
          <a:bodyPr wrap="square">
            <a:spAutoFit/>
          </a:bodyPr>
          <a:lstStyle/>
          <a:p>
            <a:r>
              <a:rPr lang="en-US" altLang="zh-CN" sz="2000" b="1" dirty="0"/>
              <a:t>hc_sub_007</a:t>
            </a:r>
            <a:endParaRPr lang="zh-CN" altLang="en-US" sz="2000" b="1" dirty="0"/>
          </a:p>
        </p:txBody>
      </p:sp>
    </p:spTree>
    <p:extLst>
      <p:ext uri="{BB962C8B-B14F-4D97-AF65-F5344CB8AC3E}">
        <p14:creationId xmlns:p14="http://schemas.microsoft.com/office/powerpoint/2010/main" val="31524263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aphicFrame>
        <p:nvGraphicFramePr>
          <p:cNvPr id="4" name="图表 3">
            <a:extLst>
              <a:ext uri="{FF2B5EF4-FFF2-40B4-BE49-F238E27FC236}">
                <a16:creationId xmlns:a16="http://schemas.microsoft.com/office/drawing/2014/main" id="{532EA3F4-5710-218F-102C-49711A7809B9}"/>
              </a:ext>
            </a:extLst>
          </p:cNvPr>
          <p:cNvGraphicFramePr>
            <a:graphicFrameLocks/>
          </p:cNvGraphicFramePr>
          <p:nvPr>
            <p:extLst>
              <p:ext uri="{D42A27DB-BD31-4B8C-83A1-F6EECF244321}">
                <p14:modId xmlns:p14="http://schemas.microsoft.com/office/powerpoint/2010/main" val="887356832"/>
              </p:ext>
            </p:extLst>
          </p:nvPr>
        </p:nvGraphicFramePr>
        <p:xfrm>
          <a:off x="959643" y="1271587"/>
          <a:ext cx="10272714" cy="4314825"/>
        </p:xfrm>
        <a:graphic>
          <a:graphicData uri="http://schemas.openxmlformats.org/drawingml/2006/chart">
            <c:chart xmlns:c="http://schemas.openxmlformats.org/drawingml/2006/chart" xmlns:r="http://schemas.openxmlformats.org/officeDocument/2006/relationships" r:id="rId2"/>
          </a:graphicData>
        </a:graphic>
      </p:graphicFrame>
      <p:sp>
        <p:nvSpPr>
          <p:cNvPr id="3" name="文本框 2">
            <a:extLst>
              <a:ext uri="{FF2B5EF4-FFF2-40B4-BE49-F238E27FC236}">
                <a16:creationId xmlns:a16="http://schemas.microsoft.com/office/drawing/2014/main" id="{E3A5A4A6-E898-EB03-3562-4E8A5B43172A}"/>
              </a:ext>
            </a:extLst>
          </p:cNvPr>
          <p:cNvSpPr txBox="1"/>
          <p:nvPr/>
        </p:nvSpPr>
        <p:spPr>
          <a:xfrm>
            <a:off x="1209583" y="432331"/>
            <a:ext cx="6094520" cy="400110"/>
          </a:xfrm>
          <a:prstGeom prst="rect">
            <a:avLst/>
          </a:prstGeom>
          <a:noFill/>
        </p:spPr>
        <p:txBody>
          <a:bodyPr wrap="square">
            <a:spAutoFit/>
          </a:bodyPr>
          <a:lstStyle/>
          <a:p>
            <a:r>
              <a:rPr lang="en-US" altLang="zh-CN" sz="2000" b="1" dirty="0"/>
              <a:t>np_sub_003</a:t>
            </a:r>
            <a:endParaRPr lang="zh-CN" altLang="en-US" sz="2000" b="1" dirty="0"/>
          </a:p>
        </p:txBody>
      </p:sp>
    </p:spTree>
    <p:extLst>
      <p:ext uri="{BB962C8B-B14F-4D97-AF65-F5344CB8AC3E}">
        <p14:creationId xmlns:p14="http://schemas.microsoft.com/office/powerpoint/2010/main" val="3241943939"/>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7</TotalTime>
  <Words>379</Words>
  <Application>Microsoft Office PowerPoint</Application>
  <PresentationFormat>宽屏</PresentationFormat>
  <Paragraphs>71</Paragraphs>
  <Slides>5</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5</vt:i4>
      </vt:variant>
    </vt:vector>
  </HeadingPairs>
  <TitlesOfParts>
    <vt:vector size="10" baseType="lpstr">
      <vt:lpstr>等线</vt:lpstr>
      <vt:lpstr>等线 Light</vt:lpstr>
      <vt:lpstr>Arial</vt:lpstr>
      <vt:lpstr>Times New Roman</vt:lpstr>
      <vt:lpstr>Office 主题​​</vt:lpstr>
      <vt:lpstr>27 time series plots</vt:lpstr>
      <vt:lpstr>Legends correspond to coordinates</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nhkj_020</dc:creator>
  <cp:lastModifiedBy>hy song</cp:lastModifiedBy>
  <cp:revision>11</cp:revision>
  <dcterms:created xsi:type="dcterms:W3CDTF">2024-09-04T02:30:21Z</dcterms:created>
  <dcterms:modified xsi:type="dcterms:W3CDTF">2024-10-07T14:47:28Z</dcterms:modified>
</cp:coreProperties>
</file>